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87" r:id="rId2"/>
    <p:sldId id="283" r:id="rId3"/>
    <p:sldId id="299" r:id="rId4"/>
    <p:sldId id="298" r:id="rId5"/>
    <p:sldId id="295" r:id="rId6"/>
    <p:sldId id="297" r:id="rId7"/>
    <p:sldId id="286" r:id="rId8"/>
    <p:sldId id="294" r:id="rId9"/>
    <p:sldId id="300" r:id="rId10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0828"/>
    <a:srgbClr val="343D99"/>
    <a:srgbClr val="BEC100"/>
    <a:srgbClr val="00CBFF"/>
    <a:srgbClr val="FF8AFF"/>
    <a:srgbClr val="F5F508"/>
    <a:srgbClr val="0303FF"/>
    <a:srgbClr val="7093CB"/>
    <a:srgbClr val="F2766D"/>
    <a:srgbClr val="2CB3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7239" autoAdjust="0"/>
  </p:normalViewPr>
  <p:slideViewPr>
    <p:cSldViewPr snapToGrid="0">
      <p:cViewPr>
        <p:scale>
          <a:sx n="124" d="100"/>
          <a:sy n="124" d="100"/>
        </p:scale>
        <p:origin x="912" y="-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u Yang" userId="441cbc80b47c62c4" providerId="LiveId" clId="{8749CBF5-DF4F-A845-A43D-2FFE576160BA}"/>
    <pc:docChg chg="undo custSel modSld">
      <pc:chgData name="Zhu Yang" userId="441cbc80b47c62c4" providerId="LiveId" clId="{8749CBF5-DF4F-A845-A43D-2FFE576160BA}" dt="2021-02-19T07:45:02.289" v="3" actId="207"/>
      <pc:docMkLst>
        <pc:docMk/>
      </pc:docMkLst>
      <pc:sldChg chg="modSp mod">
        <pc:chgData name="Zhu Yang" userId="441cbc80b47c62c4" providerId="LiveId" clId="{8749CBF5-DF4F-A845-A43D-2FFE576160BA}" dt="2021-02-19T07:45:02.289" v="3" actId="207"/>
        <pc:sldMkLst>
          <pc:docMk/>
          <pc:sldMk cId="1983028065" sldId="271"/>
        </pc:sldMkLst>
        <pc:spChg chg="mod">
          <ac:chgData name="Zhu Yang" userId="441cbc80b47c62c4" providerId="LiveId" clId="{8749CBF5-DF4F-A845-A43D-2FFE576160BA}" dt="2021-02-19T07:45:02.289" v="3" actId="207"/>
          <ac:spMkLst>
            <pc:docMk/>
            <pc:sldMk cId="1983028065" sldId="271"/>
            <ac:spMk id="18" creationId="{00000000-0000-0000-0000-000000000000}"/>
          </ac:spMkLst>
        </pc:spChg>
        <pc:spChg chg="mod">
          <ac:chgData name="Zhu Yang" userId="441cbc80b47c62c4" providerId="LiveId" clId="{8749CBF5-DF4F-A845-A43D-2FFE576160BA}" dt="2021-02-19T07:45:02.289" v="3" actId="207"/>
          <ac:spMkLst>
            <pc:docMk/>
            <pc:sldMk cId="1983028065" sldId="271"/>
            <ac:spMk id="19" creationId="{00000000-0000-0000-0000-000000000000}"/>
          </ac:spMkLst>
        </pc:spChg>
        <pc:spChg chg="mod">
          <ac:chgData name="Zhu Yang" userId="441cbc80b47c62c4" providerId="LiveId" clId="{8749CBF5-DF4F-A845-A43D-2FFE576160BA}" dt="2021-02-19T07:45:02.289" v="3" actId="207"/>
          <ac:spMkLst>
            <pc:docMk/>
            <pc:sldMk cId="1983028065" sldId="271"/>
            <ac:spMk id="20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4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5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6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7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8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29" creationId="{00000000-0000-0000-0000-000000000000}"/>
          </ac:spMkLst>
        </pc:spChg>
        <pc:spChg chg="mod">
          <ac:chgData name="Zhu Yang" userId="441cbc80b47c62c4" providerId="LiveId" clId="{8749CBF5-DF4F-A845-A43D-2FFE576160BA}" dt="2021-02-19T07:44:52.399" v="2" actId="207"/>
          <ac:spMkLst>
            <pc:docMk/>
            <pc:sldMk cId="1983028065" sldId="271"/>
            <ac:spMk id="33" creationId="{00000000-0000-0000-0000-000000000000}"/>
          </ac:spMkLst>
        </pc:spChg>
      </pc:sldChg>
    </pc:docChg>
  </pc:docChgLst>
  <pc:docChgLst>
    <pc:chgData name="Zhu Yang" userId="441cbc80b47c62c4" providerId="LiveId" clId="{C15727B5-5B3E-9448-9120-E8F6F18E8915}"/>
    <pc:docChg chg="custSel modSld">
      <pc:chgData name="Zhu Yang" userId="441cbc80b47c62c4" providerId="LiveId" clId="{C15727B5-5B3E-9448-9120-E8F6F18E8915}" dt="2020-12-26T07:10:43.088" v="59" actId="20577"/>
      <pc:docMkLst>
        <pc:docMk/>
      </pc:docMkLst>
      <pc:sldChg chg="addSp delSp modSp mod">
        <pc:chgData name="Zhu Yang" userId="441cbc80b47c62c4" providerId="LiveId" clId="{C15727B5-5B3E-9448-9120-E8F6F18E8915}" dt="2020-12-26T07:10:43.088" v="59" actId="20577"/>
        <pc:sldMkLst>
          <pc:docMk/>
          <pc:sldMk cId="2224966784" sldId="258"/>
        </pc:sldMkLst>
        <pc:spChg chg="del">
          <ac:chgData name="Zhu Yang" userId="441cbc80b47c62c4" providerId="LiveId" clId="{C15727B5-5B3E-9448-9120-E8F6F18E8915}" dt="2020-12-26T07:09:13.454" v="50" actId="478"/>
          <ac:spMkLst>
            <pc:docMk/>
            <pc:sldMk cId="2224966784" sldId="258"/>
            <ac:spMk id="6" creationId="{00000000-0000-0000-0000-000000000000}"/>
          </ac:spMkLst>
        </pc:spChg>
        <pc:spChg chg="add mod">
          <ac:chgData name="Zhu Yang" userId="441cbc80b47c62c4" providerId="LiveId" clId="{C15727B5-5B3E-9448-9120-E8F6F18E8915}" dt="2020-12-26T07:08:52.056" v="38" actId="20577"/>
          <ac:spMkLst>
            <pc:docMk/>
            <pc:sldMk cId="2224966784" sldId="258"/>
            <ac:spMk id="7" creationId="{03DC5FE2-CFE7-9C4D-8AE6-FD7EC0F20CE4}"/>
          </ac:spMkLst>
        </pc:spChg>
        <pc:spChg chg="add mod">
          <ac:chgData name="Zhu Yang" userId="441cbc80b47c62c4" providerId="LiveId" clId="{C15727B5-5B3E-9448-9120-E8F6F18E8915}" dt="2020-12-26T07:10:43.088" v="59" actId="20577"/>
          <ac:spMkLst>
            <pc:docMk/>
            <pc:sldMk cId="2224966784" sldId="258"/>
            <ac:spMk id="47" creationId="{10BA2C7C-F132-2D47-9A10-001516A6BDA8}"/>
          </ac:spMkLst>
        </pc:spChg>
        <pc:spChg chg="add mod">
          <ac:chgData name="Zhu Yang" userId="441cbc80b47c62c4" providerId="LiveId" clId="{C15727B5-5B3E-9448-9120-E8F6F18E8915}" dt="2020-12-26T07:10:27.511" v="56" actId="20577"/>
          <ac:spMkLst>
            <pc:docMk/>
            <pc:sldMk cId="2224966784" sldId="258"/>
            <ac:spMk id="57" creationId="{BE29FE37-52A9-CA4D-A253-1C121467961A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yang\OneDrive\sync\work\SKLP\Manuscripts\Macaca\Materials\volcan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07185185185185"/>
          <c:y val="7.7611111111111117E-2"/>
          <c:w val="0.8231640740740741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Normal (2)'!$B$1</c:f>
              <c:strCache>
                <c:ptCount val="1"/>
                <c:pt idx="0">
                  <c:v>Normal.vip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Normal (2)'!$A$2:$A$986</c:f>
              <c:numCache>
                <c:formatCode>General</c:formatCode>
                <c:ptCount val="985"/>
                <c:pt idx="0">
                  <c:v>8.5523203787535099E-2</c:v>
                </c:pt>
                <c:pt idx="1">
                  <c:v>-0.180497954150624</c:v>
                </c:pt>
                <c:pt idx="2">
                  <c:v>-0.21659576200349001</c:v>
                </c:pt>
                <c:pt idx="3">
                  <c:v>0.37147191586716899</c:v>
                </c:pt>
                <c:pt idx="4">
                  <c:v>0.12266705676680099</c:v>
                </c:pt>
                <c:pt idx="5">
                  <c:v>0.41390381082004801</c:v>
                </c:pt>
                <c:pt idx="6">
                  <c:v>-4.7712732806657401E-2</c:v>
                </c:pt>
                <c:pt idx="7">
                  <c:v>0.50171721721981299</c:v>
                </c:pt>
                <c:pt idx="8">
                  <c:v>1.2028568308160299</c:v>
                </c:pt>
                <c:pt idx="9">
                  <c:v>0.44497292927606302</c:v>
                </c:pt>
                <c:pt idx="10">
                  <c:v>0.111553879961085</c:v>
                </c:pt>
                <c:pt idx="11">
                  <c:v>0.18502558660361701</c:v>
                </c:pt>
                <c:pt idx="12">
                  <c:v>-0.22986845384697399</c:v>
                </c:pt>
                <c:pt idx="13">
                  <c:v>0.28266637424955698</c:v>
                </c:pt>
                <c:pt idx="14">
                  <c:v>-0.14361224151075699</c:v>
                </c:pt>
                <c:pt idx="15">
                  <c:v>4.5276973634284498E-2</c:v>
                </c:pt>
                <c:pt idx="16">
                  <c:v>0.53634990737989297</c:v>
                </c:pt>
                <c:pt idx="17">
                  <c:v>0.13306490001226601</c:v>
                </c:pt>
                <c:pt idx="18">
                  <c:v>0.156090492568037</c:v>
                </c:pt>
                <c:pt idx="19">
                  <c:v>-7.7085201664487003E-3</c:v>
                </c:pt>
                <c:pt idx="20">
                  <c:v>-6.8142466174205399E-2</c:v>
                </c:pt>
                <c:pt idx="21">
                  <c:v>-0.222544775024798</c:v>
                </c:pt>
                <c:pt idx="22">
                  <c:v>0.35771715734147302</c:v>
                </c:pt>
                <c:pt idx="23">
                  <c:v>6.4558181858135099E-3</c:v>
                </c:pt>
                <c:pt idx="24">
                  <c:v>0.77420107533178795</c:v>
                </c:pt>
                <c:pt idx="25">
                  <c:v>-0.55034066720441199</c:v>
                </c:pt>
                <c:pt idx="26">
                  <c:v>1.1203480099954399</c:v>
                </c:pt>
                <c:pt idx="27">
                  <c:v>0.78019998018296499</c:v>
                </c:pt>
                <c:pt idx="28">
                  <c:v>0.33541486464446302</c:v>
                </c:pt>
                <c:pt idx="29">
                  <c:v>-0.127543859149677</c:v>
                </c:pt>
                <c:pt idx="30">
                  <c:v>-0.100071488476749</c:v>
                </c:pt>
                <c:pt idx="31">
                  <c:v>0.40518784572104499</c:v>
                </c:pt>
                <c:pt idx="32">
                  <c:v>-0.11649869283361</c:v>
                </c:pt>
                <c:pt idx="33">
                  <c:v>-0.26708604133694802</c:v>
                </c:pt>
                <c:pt idx="34">
                  <c:v>-0.57519304249480596</c:v>
                </c:pt>
                <c:pt idx="35">
                  <c:v>-0.26199493802753598</c:v>
                </c:pt>
                <c:pt idx="36">
                  <c:v>-0.52260879518937797</c:v>
                </c:pt>
                <c:pt idx="37">
                  <c:v>0.32117730636917202</c:v>
                </c:pt>
                <c:pt idx="38">
                  <c:v>0.36204276274736502</c:v>
                </c:pt>
                <c:pt idx="39">
                  <c:v>0.108405331045808</c:v>
                </c:pt>
                <c:pt idx="40">
                  <c:v>8.9752690680977798E-2</c:v>
                </c:pt>
                <c:pt idx="41">
                  <c:v>4.4864260402515798E-3</c:v>
                </c:pt>
                <c:pt idx="42">
                  <c:v>8.9752690680977798E-2</c:v>
                </c:pt>
                <c:pt idx="43">
                  <c:v>8.9752690680977798E-2</c:v>
                </c:pt>
                <c:pt idx="44">
                  <c:v>0.41246891478235898</c:v>
                </c:pt>
                <c:pt idx="45">
                  <c:v>0.41246891478235898</c:v>
                </c:pt>
                <c:pt idx="46">
                  <c:v>8.9752690680977798E-2</c:v>
                </c:pt>
                <c:pt idx="47">
                  <c:v>0.35645722511975902</c:v>
                </c:pt>
                <c:pt idx="48">
                  <c:v>8.5347649884834204E-2</c:v>
                </c:pt>
                <c:pt idx="49">
                  <c:v>0.18197534644295499</c:v>
                </c:pt>
                <c:pt idx="50">
                  <c:v>0.199566970640706</c:v>
                </c:pt>
                <c:pt idx="51">
                  <c:v>-0.409849767736092</c:v>
                </c:pt>
                <c:pt idx="52">
                  <c:v>0.286554914808063</c:v>
                </c:pt>
                <c:pt idx="53">
                  <c:v>-0.16006031435011001</c:v>
                </c:pt>
                <c:pt idx="54">
                  <c:v>4.4544779712702501E-2</c:v>
                </c:pt>
                <c:pt idx="55">
                  <c:v>-0.37071593259054803</c:v>
                </c:pt>
                <c:pt idx="56">
                  <c:v>0.34389915079657701</c:v>
                </c:pt>
                <c:pt idx="57">
                  <c:v>-5.9720187950252503E-2</c:v>
                </c:pt>
                <c:pt idx="58">
                  <c:v>0.14395592526909901</c:v>
                </c:pt>
                <c:pt idx="59">
                  <c:v>0.15482465251597699</c:v>
                </c:pt>
                <c:pt idx="60">
                  <c:v>-0.149953366171275</c:v>
                </c:pt>
                <c:pt idx="61">
                  <c:v>0.26099656838869201</c:v>
                </c:pt>
                <c:pt idx="62">
                  <c:v>0.118793312326374</c:v>
                </c:pt>
                <c:pt idx="63">
                  <c:v>0.18597173382462601</c:v>
                </c:pt>
                <c:pt idx="64">
                  <c:v>0.46444742678969297</c:v>
                </c:pt>
                <c:pt idx="65">
                  <c:v>-0.21323080827294</c:v>
                </c:pt>
                <c:pt idx="66">
                  <c:v>0.34389915079657701</c:v>
                </c:pt>
                <c:pt idx="67">
                  <c:v>0.14514469710181399</c:v>
                </c:pt>
                <c:pt idx="68">
                  <c:v>0.14268685831741301</c:v>
                </c:pt>
                <c:pt idx="69">
                  <c:v>7.2611993691241605E-2</c:v>
                </c:pt>
                <c:pt idx="70">
                  <c:v>-0.10766300214472201</c:v>
                </c:pt>
                <c:pt idx="71">
                  <c:v>0.35466078735703599</c:v>
                </c:pt>
                <c:pt idx="72">
                  <c:v>-0.180497954150624</c:v>
                </c:pt>
                <c:pt idx="73">
                  <c:v>0.383527245269981</c:v>
                </c:pt>
                <c:pt idx="74">
                  <c:v>-0.345268581345967</c:v>
                </c:pt>
                <c:pt idx="75">
                  <c:v>-0.259424323680917</c:v>
                </c:pt>
                <c:pt idx="76">
                  <c:v>-0.209857891469895</c:v>
                </c:pt>
                <c:pt idx="77">
                  <c:v>-5.7202529226048397E-2</c:v>
                </c:pt>
                <c:pt idx="78">
                  <c:v>-7.8504681029820403E-2</c:v>
                </c:pt>
                <c:pt idx="79">
                  <c:v>-0.17407942534557599</c:v>
                </c:pt>
                <c:pt idx="80">
                  <c:v>-2.5093983579114201E-2</c:v>
                </c:pt>
                <c:pt idx="81">
                  <c:v>-0.28062461926601301</c:v>
                </c:pt>
                <c:pt idx="82">
                  <c:v>-0.28885560643765801</c:v>
                </c:pt>
                <c:pt idx="83">
                  <c:v>-0.568589560217173</c:v>
                </c:pt>
                <c:pt idx="84">
                  <c:v>-0.31507338456756601</c:v>
                </c:pt>
                <c:pt idx="85">
                  <c:v>-0.13483036807644</c:v>
                </c:pt>
                <c:pt idx="86">
                  <c:v>-1.3534745189303501E-2</c:v>
                </c:pt>
                <c:pt idx="87">
                  <c:v>0.44758807142264201</c:v>
                </c:pt>
                <c:pt idx="88">
                  <c:v>-0.50951616954729695</c:v>
                </c:pt>
                <c:pt idx="89">
                  <c:v>-0.37049231443203201</c:v>
                </c:pt>
                <c:pt idx="90">
                  <c:v>1.2235521159683699E-2</c:v>
                </c:pt>
                <c:pt idx="91">
                  <c:v>-7.0275983468488706E-2</c:v>
                </c:pt>
                <c:pt idx="92">
                  <c:v>-0.17711141931518101</c:v>
                </c:pt>
                <c:pt idx="93">
                  <c:v>-0.49421513680880103</c:v>
                </c:pt>
                <c:pt idx="94">
                  <c:v>-1.8621898188188501E-2</c:v>
                </c:pt>
                <c:pt idx="95">
                  <c:v>0.15341036939223399</c:v>
                </c:pt>
                <c:pt idx="96">
                  <c:v>-0.42542466991199102</c:v>
                </c:pt>
                <c:pt idx="97">
                  <c:v>-0.50951616954729695</c:v>
                </c:pt>
                <c:pt idx="98">
                  <c:v>0.34389915079657701</c:v>
                </c:pt>
                <c:pt idx="99">
                  <c:v>0.28949114626630901</c:v>
                </c:pt>
                <c:pt idx="100">
                  <c:v>0.46427590878196601</c:v>
                </c:pt>
                <c:pt idx="101">
                  <c:v>8.7713141246232307E-2</c:v>
                </c:pt>
                <c:pt idx="102">
                  <c:v>0.17764072364817499</c:v>
                </c:pt>
                <c:pt idx="103">
                  <c:v>-9.5412518282478903E-2</c:v>
                </c:pt>
                <c:pt idx="104">
                  <c:v>0.57969285194896703</c:v>
                </c:pt>
                <c:pt idx="105">
                  <c:v>0.105616037879117</c:v>
                </c:pt>
                <c:pt idx="106">
                  <c:v>7.0306424095703396E-2</c:v>
                </c:pt>
                <c:pt idx="107">
                  <c:v>0.43186815100704601</c:v>
                </c:pt>
                <c:pt idx="108">
                  <c:v>-0.13770567107894199</c:v>
                </c:pt>
                <c:pt idx="109">
                  <c:v>-0.14794035360278099</c:v>
                </c:pt>
                <c:pt idx="110">
                  <c:v>0.55735675573073995</c:v>
                </c:pt>
                <c:pt idx="111">
                  <c:v>-0.243248247185641</c:v>
                </c:pt>
                <c:pt idx="112">
                  <c:v>-6.8142466174205399E-2</c:v>
                </c:pt>
                <c:pt idx="113">
                  <c:v>0.29224084855860599</c:v>
                </c:pt>
                <c:pt idx="114">
                  <c:v>-0.22218348650032799</c:v>
                </c:pt>
                <c:pt idx="115">
                  <c:v>-2.1771603183273602E-2</c:v>
                </c:pt>
                <c:pt idx="116">
                  <c:v>0.24323533327618799</c:v>
                </c:pt>
                <c:pt idx="117">
                  <c:v>0.46385538902352802</c:v>
                </c:pt>
                <c:pt idx="118">
                  <c:v>-7.7776343786618907E-2</c:v>
                </c:pt>
                <c:pt idx="119">
                  <c:v>0.11190955997935299</c:v>
                </c:pt>
                <c:pt idx="120">
                  <c:v>-0.40016955595516002</c:v>
                </c:pt>
                <c:pt idx="121">
                  <c:v>0.51024261480634503</c:v>
                </c:pt>
                <c:pt idx="122">
                  <c:v>0.29679638615945803</c:v>
                </c:pt>
                <c:pt idx="123">
                  <c:v>7.2551856358115605E-2</c:v>
                </c:pt>
                <c:pt idx="124">
                  <c:v>0.18885902781892799</c:v>
                </c:pt>
                <c:pt idx="125">
                  <c:v>7.2483647568956497E-3</c:v>
                </c:pt>
                <c:pt idx="126">
                  <c:v>0.51232907599301103</c:v>
                </c:pt>
                <c:pt idx="127">
                  <c:v>-0.45956757503298401</c:v>
                </c:pt>
                <c:pt idx="128">
                  <c:v>0.36375405385134502</c:v>
                </c:pt>
                <c:pt idx="129">
                  <c:v>-0.18275823788831599</c:v>
                </c:pt>
                <c:pt idx="130">
                  <c:v>6.5056378837150299E-3</c:v>
                </c:pt>
                <c:pt idx="131">
                  <c:v>0.14009637387844501</c:v>
                </c:pt>
                <c:pt idx="132">
                  <c:v>4.0041479318097602E-2</c:v>
                </c:pt>
                <c:pt idx="133">
                  <c:v>-0.47675515683569403</c:v>
                </c:pt>
                <c:pt idx="134">
                  <c:v>-0.200176834079872</c:v>
                </c:pt>
                <c:pt idx="135">
                  <c:v>6.2825998538538597E-2</c:v>
                </c:pt>
                <c:pt idx="136">
                  <c:v>-0.21117587278684</c:v>
                </c:pt>
                <c:pt idx="137">
                  <c:v>-0.58977207080861105</c:v>
                </c:pt>
                <c:pt idx="138">
                  <c:v>-0.52561740795698697</c:v>
                </c:pt>
                <c:pt idx="139">
                  <c:v>-0.27500298341689999</c:v>
                </c:pt>
                <c:pt idx="140">
                  <c:v>-0.114453734067949</c:v>
                </c:pt>
                <c:pt idx="141">
                  <c:v>5.7757039613326303E-2</c:v>
                </c:pt>
                <c:pt idx="142">
                  <c:v>-0.38038073989951099</c:v>
                </c:pt>
                <c:pt idx="143">
                  <c:v>0.54078841351418105</c:v>
                </c:pt>
                <c:pt idx="144">
                  <c:v>-0.14361224151075699</c:v>
                </c:pt>
                <c:pt idx="145">
                  <c:v>0.15326710670394</c:v>
                </c:pt>
                <c:pt idx="146">
                  <c:v>-0.109660645440235</c:v>
                </c:pt>
                <c:pt idx="147">
                  <c:v>0.13068346313206899</c:v>
                </c:pt>
                <c:pt idx="148">
                  <c:v>6.7653580975415795E-2</c:v>
                </c:pt>
                <c:pt idx="149">
                  <c:v>-6.0593819527247197E-2</c:v>
                </c:pt>
                <c:pt idx="150">
                  <c:v>-1.5337048487767299E-2</c:v>
                </c:pt>
                <c:pt idx="151">
                  <c:v>-0.30074186208690701</c:v>
                </c:pt>
                <c:pt idx="152">
                  <c:v>-0.30074186208690701</c:v>
                </c:pt>
                <c:pt idx="153">
                  <c:v>-0.43416226195399099</c:v>
                </c:pt>
                <c:pt idx="154">
                  <c:v>-4.1259491529002199E-2</c:v>
                </c:pt>
                <c:pt idx="155">
                  <c:v>-4.1259491529002199E-2</c:v>
                </c:pt>
                <c:pt idx="156">
                  <c:v>-1.63415816842899E-2</c:v>
                </c:pt>
                <c:pt idx="157">
                  <c:v>-0.48478921271368403</c:v>
                </c:pt>
                <c:pt idx="158">
                  <c:v>-0.23296044273340899</c:v>
                </c:pt>
                <c:pt idx="159">
                  <c:v>-0.30222145862935801</c:v>
                </c:pt>
                <c:pt idx="160">
                  <c:v>-0.48478921271368403</c:v>
                </c:pt>
                <c:pt idx="161">
                  <c:v>-0.20457539374461101</c:v>
                </c:pt>
                <c:pt idx="162">
                  <c:v>-0.14916012494647199</c:v>
                </c:pt>
                <c:pt idx="163">
                  <c:v>-0.61287445838270904</c:v>
                </c:pt>
                <c:pt idx="164">
                  <c:v>0.119360437627577</c:v>
                </c:pt>
                <c:pt idx="165">
                  <c:v>0.108405331045808</c:v>
                </c:pt>
                <c:pt idx="166">
                  <c:v>-0.28035636273971098</c:v>
                </c:pt>
                <c:pt idx="167">
                  <c:v>0.12551639863351</c:v>
                </c:pt>
                <c:pt idx="168">
                  <c:v>1.53021524705348E-2</c:v>
                </c:pt>
                <c:pt idx="169">
                  <c:v>-8.8855178299399998E-2</c:v>
                </c:pt>
                <c:pt idx="170">
                  <c:v>0.246543226158563</c:v>
                </c:pt>
                <c:pt idx="171">
                  <c:v>0.57255932568576895</c:v>
                </c:pt>
                <c:pt idx="172">
                  <c:v>-9.4408309719717698E-2</c:v>
                </c:pt>
                <c:pt idx="173">
                  <c:v>0.28067193477779701</c:v>
                </c:pt>
                <c:pt idx="174">
                  <c:v>0.16549905120439801</c:v>
                </c:pt>
                <c:pt idx="175">
                  <c:v>-1.5337048487767299E-2</c:v>
                </c:pt>
                <c:pt idx="176">
                  <c:v>0.43186815100704601</c:v>
                </c:pt>
                <c:pt idx="177">
                  <c:v>-3.4875467932761001E-2</c:v>
                </c:pt>
                <c:pt idx="178">
                  <c:v>-5.5408108254659298E-2</c:v>
                </c:pt>
                <c:pt idx="179">
                  <c:v>-0.22436178361296</c:v>
                </c:pt>
                <c:pt idx="180">
                  <c:v>-0.16655581052601301</c:v>
                </c:pt>
                <c:pt idx="181">
                  <c:v>-0.27569747391750898</c:v>
                </c:pt>
                <c:pt idx="182">
                  <c:v>0.11883059691525701</c:v>
                </c:pt>
                <c:pt idx="183">
                  <c:v>6.0348954701086199E-2</c:v>
                </c:pt>
                <c:pt idx="184">
                  <c:v>-0.19916728148198301</c:v>
                </c:pt>
                <c:pt idx="185">
                  <c:v>1.99198667948122E-2</c:v>
                </c:pt>
                <c:pt idx="186">
                  <c:v>-0.49421513680880103</c:v>
                </c:pt>
                <c:pt idx="187">
                  <c:v>0.44758807142264201</c:v>
                </c:pt>
                <c:pt idx="188">
                  <c:v>-1.9976405340284099E-2</c:v>
                </c:pt>
                <c:pt idx="189">
                  <c:v>0.27286418204652202</c:v>
                </c:pt>
                <c:pt idx="190">
                  <c:v>-0.32294715698090998</c:v>
                </c:pt>
                <c:pt idx="191">
                  <c:v>0.51634793706590298</c:v>
                </c:pt>
                <c:pt idx="192">
                  <c:v>0.18326349093335401</c:v>
                </c:pt>
                <c:pt idx="193">
                  <c:v>-0.136673887818936</c:v>
                </c:pt>
                <c:pt idx="194">
                  <c:v>-6.53620850495676E-2</c:v>
                </c:pt>
                <c:pt idx="195">
                  <c:v>-6.7320940466548199E-2</c:v>
                </c:pt>
                <c:pt idx="196">
                  <c:v>0.16853067089785401</c:v>
                </c:pt>
                <c:pt idx="197">
                  <c:v>8.2962255519465594E-2</c:v>
                </c:pt>
                <c:pt idx="198">
                  <c:v>0.487598716967937</c:v>
                </c:pt>
                <c:pt idx="199">
                  <c:v>-9.6965665085896796E-2</c:v>
                </c:pt>
                <c:pt idx="200">
                  <c:v>-9.6965665085896796E-2</c:v>
                </c:pt>
                <c:pt idx="201">
                  <c:v>-0.14696444494923599</c:v>
                </c:pt>
                <c:pt idx="202">
                  <c:v>-0.14696444494923599</c:v>
                </c:pt>
                <c:pt idx="203">
                  <c:v>-0.14696444494923599</c:v>
                </c:pt>
                <c:pt idx="204">
                  <c:v>-0.25682205787949702</c:v>
                </c:pt>
                <c:pt idx="205">
                  <c:v>-0.25682205787949702</c:v>
                </c:pt>
                <c:pt idx="206">
                  <c:v>-0.118541077087362</c:v>
                </c:pt>
                <c:pt idx="207">
                  <c:v>-0.118541077087362</c:v>
                </c:pt>
                <c:pt idx="208">
                  <c:v>-0.159057502030791</c:v>
                </c:pt>
                <c:pt idx="209">
                  <c:v>-0.159057502030791</c:v>
                </c:pt>
                <c:pt idx="210">
                  <c:v>-0.131153507919753</c:v>
                </c:pt>
                <c:pt idx="211">
                  <c:v>-0.32887951781706298</c:v>
                </c:pt>
                <c:pt idx="212">
                  <c:v>-0.32887951781706298</c:v>
                </c:pt>
                <c:pt idx="213">
                  <c:v>-2.5093983579114201E-2</c:v>
                </c:pt>
                <c:pt idx="214">
                  <c:v>-0.16009094569358001</c:v>
                </c:pt>
                <c:pt idx="215">
                  <c:v>-0.30753092696897699</c:v>
                </c:pt>
                <c:pt idx="216">
                  <c:v>-0.31512092673000502</c:v>
                </c:pt>
                <c:pt idx="217">
                  <c:v>-0.28062461926601301</c:v>
                </c:pt>
                <c:pt idx="218">
                  <c:v>-0.240881673588068</c:v>
                </c:pt>
                <c:pt idx="219">
                  <c:v>-0.299462439522034</c:v>
                </c:pt>
                <c:pt idx="220">
                  <c:v>-0.30491155546024301</c:v>
                </c:pt>
                <c:pt idx="221">
                  <c:v>-2.3788361836381899E-2</c:v>
                </c:pt>
                <c:pt idx="222">
                  <c:v>0.51635153727874195</c:v>
                </c:pt>
                <c:pt idx="223">
                  <c:v>-0.15519358519578</c:v>
                </c:pt>
                <c:pt idx="224">
                  <c:v>9.8116121742374607E-2</c:v>
                </c:pt>
                <c:pt idx="225">
                  <c:v>-6.28095416176033E-3</c:v>
                </c:pt>
                <c:pt idx="226">
                  <c:v>0.50448852589645998</c:v>
                </c:pt>
                <c:pt idx="227">
                  <c:v>0.20280650457433799</c:v>
                </c:pt>
                <c:pt idx="228">
                  <c:v>0.56898324287531099</c:v>
                </c:pt>
                <c:pt idx="229">
                  <c:v>9.3059751312338804E-2</c:v>
                </c:pt>
                <c:pt idx="230">
                  <c:v>-0.17350114616623</c:v>
                </c:pt>
                <c:pt idx="231">
                  <c:v>-3.73264307459465E-2</c:v>
                </c:pt>
                <c:pt idx="232">
                  <c:v>-6.4883900287423801E-2</c:v>
                </c:pt>
                <c:pt idx="233">
                  <c:v>-9.7092619697116203E-2</c:v>
                </c:pt>
                <c:pt idx="234">
                  <c:v>-0.19674287214547501</c:v>
                </c:pt>
                <c:pt idx="235">
                  <c:v>-5.2127361514197702E-2</c:v>
                </c:pt>
                <c:pt idx="236">
                  <c:v>-9.3327984336428799E-4</c:v>
                </c:pt>
                <c:pt idx="237">
                  <c:v>-9.9695150226284904E-2</c:v>
                </c:pt>
                <c:pt idx="238">
                  <c:v>8.7165680337116594E-2</c:v>
                </c:pt>
                <c:pt idx="239">
                  <c:v>0.110704976707498</c:v>
                </c:pt>
                <c:pt idx="240">
                  <c:v>0.15529198433166899</c:v>
                </c:pt>
                <c:pt idx="241">
                  <c:v>2.5104430589553001E-2</c:v>
                </c:pt>
                <c:pt idx="242">
                  <c:v>0.20686262309894299</c:v>
                </c:pt>
                <c:pt idx="243">
                  <c:v>-0.10771336299303801</c:v>
                </c:pt>
                <c:pt idx="244">
                  <c:v>0.16881798087548899</c:v>
                </c:pt>
                <c:pt idx="245">
                  <c:v>-0.51203805322873297</c:v>
                </c:pt>
                <c:pt idx="246">
                  <c:v>-0.12988987113152001</c:v>
                </c:pt>
                <c:pt idx="247">
                  <c:v>-0.48394547298808099</c:v>
                </c:pt>
                <c:pt idx="248">
                  <c:v>-3.37141930059238E-2</c:v>
                </c:pt>
                <c:pt idx="249">
                  <c:v>3.9678837147275901E-2</c:v>
                </c:pt>
                <c:pt idx="250">
                  <c:v>3.4895156923433902E-2</c:v>
                </c:pt>
                <c:pt idx="251">
                  <c:v>-0.253882507351197</c:v>
                </c:pt>
                <c:pt idx="252">
                  <c:v>-6.6970989167491293E-2</c:v>
                </c:pt>
                <c:pt idx="253">
                  <c:v>0.11669387228773601</c:v>
                </c:pt>
                <c:pt idx="254">
                  <c:v>0.51164534590478405</c:v>
                </c:pt>
                <c:pt idx="255">
                  <c:v>-0.22717214914917699</c:v>
                </c:pt>
                <c:pt idx="256">
                  <c:v>0.14009113914719001</c:v>
                </c:pt>
                <c:pt idx="257">
                  <c:v>-0.34272012360724102</c:v>
                </c:pt>
                <c:pt idx="258">
                  <c:v>-0.18210811219245701</c:v>
                </c:pt>
                <c:pt idx="259">
                  <c:v>-9.7748022987630703E-2</c:v>
                </c:pt>
                <c:pt idx="260">
                  <c:v>-0.16257195661341201</c:v>
                </c:pt>
                <c:pt idx="261">
                  <c:v>-7.7898950479600895E-2</c:v>
                </c:pt>
                <c:pt idx="262">
                  <c:v>-1.8500698168062199E-2</c:v>
                </c:pt>
                <c:pt idx="263">
                  <c:v>-0.175637489128394</c:v>
                </c:pt>
                <c:pt idx="264">
                  <c:v>-0.31259053478008803</c:v>
                </c:pt>
                <c:pt idx="265">
                  <c:v>-8.5253861464473904E-2</c:v>
                </c:pt>
                <c:pt idx="266">
                  <c:v>0.45823194607231899</c:v>
                </c:pt>
                <c:pt idx="267">
                  <c:v>0.16881798087548899</c:v>
                </c:pt>
                <c:pt idx="268">
                  <c:v>0.46652216188261397</c:v>
                </c:pt>
                <c:pt idx="269">
                  <c:v>-8.6061966295888095E-2</c:v>
                </c:pt>
                <c:pt idx="270">
                  <c:v>-0.43721101516388899</c:v>
                </c:pt>
                <c:pt idx="271">
                  <c:v>7.5378150296924698E-2</c:v>
                </c:pt>
                <c:pt idx="272">
                  <c:v>-0.37331824103296601</c:v>
                </c:pt>
                <c:pt idx="273">
                  <c:v>0.40836490400596598</c:v>
                </c:pt>
                <c:pt idx="274">
                  <c:v>-0.528801096393828</c:v>
                </c:pt>
                <c:pt idx="275">
                  <c:v>-9.5112504907141501E-2</c:v>
                </c:pt>
                <c:pt idx="276">
                  <c:v>0.42087351243258603</c:v>
                </c:pt>
                <c:pt idx="277">
                  <c:v>2.0678529376928899E-2</c:v>
                </c:pt>
                <c:pt idx="278">
                  <c:v>0.125275801853589</c:v>
                </c:pt>
                <c:pt idx="279">
                  <c:v>0.137627425206059</c:v>
                </c:pt>
                <c:pt idx="280">
                  <c:v>-0.12720728426980901</c:v>
                </c:pt>
                <c:pt idx="281">
                  <c:v>0.56152477143318702</c:v>
                </c:pt>
                <c:pt idx="282">
                  <c:v>-0.35170871011121202</c:v>
                </c:pt>
                <c:pt idx="283">
                  <c:v>2.98225944817836E-2</c:v>
                </c:pt>
                <c:pt idx="284">
                  <c:v>-0.11098223289086399</c:v>
                </c:pt>
                <c:pt idx="285">
                  <c:v>-0.287764995027117</c:v>
                </c:pt>
                <c:pt idx="286">
                  <c:v>-0.16515451030598299</c:v>
                </c:pt>
                <c:pt idx="287">
                  <c:v>-0.30885491341812199</c:v>
                </c:pt>
                <c:pt idx="288">
                  <c:v>-0.27733337937230701</c:v>
                </c:pt>
                <c:pt idx="289">
                  <c:v>-0.18399951537180601</c:v>
                </c:pt>
                <c:pt idx="290">
                  <c:v>-0.14133103530274899</c:v>
                </c:pt>
                <c:pt idx="291">
                  <c:v>-0.55937187604012295</c:v>
                </c:pt>
                <c:pt idx="292">
                  <c:v>-0.20538603403149</c:v>
                </c:pt>
                <c:pt idx="293">
                  <c:v>-0.16389765677967599</c:v>
                </c:pt>
                <c:pt idx="294">
                  <c:v>-0.17636364612892499</c:v>
                </c:pt>
                <c:pt idx="295">
                  <c:v>-0.22361736021506201</c:v>
                </c:pt>
                <c:pt idx="296">
                  <c:v>-0.34788344048700798</c:v>
                </c:pt>
                <c:pt idx="297">
                  <c:v>-6.6876330831282499E-2</c:v>
                </c:pt>
                <c:pt idx="298">
                  <c:v>8.4808472939179799E-2</c:v>
                </c:pt>
                <c:pt idx="299">
                  <c:v>-3.96553599396023E-2</c:v>
                </c:pt>
                <c:pt idx="300">
                  <c:v>-0.52708496138799699</c:v>
                </c:pt>
                <c:pt idx="301">
                  <c:v>-0.38922465075804402</c:v>
                </c:pt>
                <c:pt idx="302">
                  <c:v>3.0847199509337699E-2</c:v>
                </c:pt>
                <c:pt idx="303">
                  <c:v>-0.59358369644847597</c:v>
                </c:pt>
                <c:pt idx="304">
                  <c:v>-3.9171292447128997E-2</c:v>
                </c:pt>
                <c:pt idx="305">
                  <c:v>-0.40834002963320898</c:v>
                </c:pt>
                <c:pt idx="306">
                  <c:v>-0.13460316745589099</c:v>
                </c:pt>
                <c:pt idx="307">
                  <c:v>-0.4465248708763</c:v>
                </c:pt>
                <c:pt idx="308">
                  <c:v>2.4542592381290701E-3</c:v>
                </c:pt>
                <c:pt idx="309">
                  <c:v>-0.34817257726621997</c:v>
                </c:pt>
                <c:pt idx="310">
                  <c:v>-0.14133103530274899</c:v>
                </c:pt>
                <c:pt idx="311">
                  <c:v>-0.42641599538796499</c:v>
                </c:pt>
                <c:pt idx="312">
                  <c:v>-0.253882507351197</c:v>
                </c:pt>
                <c:pt idx="313">
                  <c:v>0.17513381046014601</c:v>
                </c:pt>
                <c:pt idx="314">
                  <c:v>-0.29015229433374901</c:v>
                </c:pt>
                <c:pt idx="315">
                  <c:v>-1.0999284180975E-2</c:v>
                </c:pt>
                <c:pt idx="316">
                  <c:v>-0.40444805514237597</c:v>
                </c:pt>
                <c:pt idx="317">
                  <c:v>-0.11245117532860099</c:v>
                </c:pt>
                <c:pt idx="318">
                  <c:v>-0.11368300513346299</c:v>
                </c:pt>
                <c:pt idx="319">
                  <c:v>-4.4686656070230299E-2</c:v>
                </c:pt>
                <c:pt idx="320">
                  <c:v>0.155798785037779</c:v>
                </c:pt>
                <c:pt idx="321">
                  <c:v>-2.7877441842989799E-2</c:v>
                </c:pt>
                <c:pt idx="322">
                  <c:v>7.3781095403690697E-2</c:v>
                </c:pt>
                <c:pt idx="323">
                  <c:v>-0.27733337937230701</c:v>
                </c:pt>
                <c:pt idx="324">
                  <c:v>0.26082164321781998</c:v>
                </c:pt>
                <c:pt idx="325">
                  <c:v>3.6668387062322601E-3</c:v>
                </c:pt>
                <c:pt idx="326">
                  <c:v>2.1255994721440699E-2</c:v>
                </c:pt>
                <c:pt idx="327">
                  <c:v>-0.188945669807078</c:v>
                </c:pt>
                <c:pt idx="328">
                  <c:v>0.35950543047286398</c:v>
                </c:pt>
                <c:pt idx="329">
                  <c:v>2.5104430589553001E-2</c:v>
                </c:pt>
                <c:pt idx="330">
                  <c:v>-0.37884673815730302</c:v>
                </c:pt>
                <c:pt idx="331">
                  <c:v>-0.13247530127305401</c:v>
                </c:pt>
                <c:pt idx="332">
                  <c:v>-0.18912061372212499</c:v>
                </c:pt>
                <c:pt idx="333">
                  <c:v>0.46678397836298102</c:v>
                </c:pt>
                <c:pt idx="334">
                  <c:v>0.151831925098462</c:v>
                </c:pt>
                <c:pt idx="335">
                  <c:v>-4.4212764647121802E-2</c:v>
                </c:pt>
                <c:pt idx="336">
                  <c:v>-0.15509843229905401</c:v>
                </c:pt>
                <c:pt idx="337">
                  <c:v>-0.28143708862078298</c:v>
                </c:pt>
                <c:pt idx="338">
                  <c:v>6.1397984721233097E-2</c:v>
                </c:pt>
                <c:pt idx="339">
                  <c:v>-3.0341818651892002E-3</c:v>
                </c:pt>
                <c:pt idx="340">
                  <c:v>-0.24554483602586799</c:v>
                </c:pt>
                <c:pt idx="341">
                  <c:v>1.4105968944766401E-2</c:v>
                </c:pt>
                <c:pt idx="342">
                  <c:v>0.18077029190872501</c:v>
                </c:pt>
                <c:pt idx="343">
                  <c:v>-1.06615911477473E-2</c:v>
                </c:pt>
                <c:pt idx="344">
                  <c:v>-0.169508502544712</c:v>
                </c:pt>
                <c:pt idx="345">
                  <c:v>2.3911544875354199E-2</c:v>
                </c:pt>
                <c:pt idx="346">
                  <c:v>-4.72567513567912E-2</c:v>
                </c:pt>
                <c:pt idx="347">
                  <c:v>3.2179721130344202E-2</c:v>
                </c:pt>
                <c:pt idx="348">
                  <c:v>6.0913428226537399E-2</c:v>
                </c:pt>
                <c:pt idx="349">
                  <c:v>2.2121568309028498E-2</c:v>
                </c:pt>
                <c:pt idx="350">
                  <c:v>0.27163553975854399</c:v>
                </c:pt>
                <c:pt idx="351">
                  <c:v>-0.164617766112265</c:v>
                </c:pt>
                <c:pt idx="352">
                  <c:v>0.38206393055369298</c:v>
                </c:pt>
                <c:pt idx="353">
                  <c:v>-3.3586045441846998E-2</c:v>
                </c:pt>
                <c:pt idx="354">
                  <c:v>0.38118611115950801</c:v>
                </c:pt>
                <c:pt idx="355">
                  <c:v>-3.37141930059238E-2</c:v>
                </c:pt>
                <c:pt idx="356">
                  <c:v>0.56975790926004199</c:v>
                </c:pt>
                <c:pt idx="357">
                  <c:v>-0.49757912898006901</c:v>
                </c:pt>
                <c:pt idx="358">
                  <c:v>-0.2444370587751</c:v>
                </c:pt>
                <c:pt idx="359">
                  <c:v>0.15529198433166899</c:v>
                </c:pt>
                <c:pt idx="360">
                  <c:v>0.22931170199862599</c:v>
                </c:pt>
                <c:pt idx="361">
                  <c:v>-1.7801643586052799E-2</c:v>
                </c:pt>
                <c:pt idx="362">
                  <c:v>6.4924924286103899E-2</c:v>
                </c:pt>
                <c:pt idx="363">
                  <c:v>-0.25022779661938799</c:v>
                </c:pt>
                <c:pt idx="364">
                  <c:v>4.1806739524473599E-3</c:v>
                </c:pt>
                <c:pt idx="365">
                  <c:v>0.21550026544421</c:v>
                </c:pt>
                <c:pt idx="366">
                  <c:v>-0.52965104530811102</c:v>
                </c:pt>
                <c:pt idx="367">
                  <c:v>2.9004754030841598E-3</c:v>
                </c:pt>
                <c:pt idx="368">
                  <c:v>6.0809364598470299E-2</c:v>
                </c:pt>
                <c:pt idx="369">
                  <c:v>0.10568722316231</c:v>
                </c:pt>
                <c:pt idx="370">
                  <c:v>0.20659472255060399</c:v>
                </c:pt>
                <c:pt idx="371">
                  <c:v>0.50448852589645998</c:v>
                </c:pt>
                <c:pt idx="372">
                  <c:v>0.15529198433166899</c:v>
                </c:pt>
                <c:pt idx="373">
                  <c:v>0.20280650457433799</c:v>
                </c:pt>
                <c:pt idx="374">
                  <c:v>-0.17933770084571901</c:v>
                </c:pt>
                <c:pt idx="375">
                  <c:v>-0.17670182863207801</c:v>
                </c:pt>
                <c:pt idx="376">
                  <c:v>-0.59886449966171695</c:v>
                </c:pt>
                <c:pt idx="377">
                  <c:v>-0.141951052692498</c:v>
                </c:pt>
                <c:pt idx="378">
                  <c:v>1.5511144778475899E-2</c:v>
                </c:pt>
                <c:pt idx="379">
                  <c:v>-0.37097758187177099</c:v>
                </c:pt>
                <c:pt idx="380">
                  <c:v>-0.33271370188329102</c:v>
                </c:pt>
                <c:pt idx="381">
                  <c:v>0.67950747375974596</c:v>
                </c:pt>
                <c:pt idx="382">
                  <c:v>0.343391338216474</c:v>
                </c:pt>
                <c:pt idx="383">
                  <c:v>-0.14077894077425901</c:v>
                </c:pt>
                <c:pt idx="384">
                  <c:v>0.17435304293569101</c:v>
                </c:pt>
                <c:pt idx="385">
                  <c:v>-0.46270969928141398</c:v>
                </c:pt>
                <c:pt idx="386">
                  <c:v>0.39737028190646201</c:v>
                </c:pt>
                <c:pt idx="387">
                  <c:v>2.3446147733243501E-2</c:v>
                </c:pt>
                <c:pt idx="388">
                  <c:v>0.70517131156864998</c:v>
                </c:pt>
                <c:pt idx="389">
                  <c:v>-0.55767798367142996</c:v>
                </c:pt>
                <c:pt idx="390">
                  <c:v>-0.55767798367142996</c:v>
                </c:pt>
                <c:pt idx="391">
                  <c:v>-0.430856109106242</c:v>
                </c:pt>
                <c:pt idx="392">
                  <c:v>-0.430856109106242</c:v>
                </c:pt>
                <c:pt idx="393">
                  <c:v>-0.44277325903605902</c:v>
                </c:pt>
                <c:pt idx="394">
                  <c:v>-0.44277325903605902</c:v>
                </c:pt>
                <c:pt idx="395">
                  <c:v>-0.47451740101189899</c:v>
                </c:pt>
                <c:pt idx="396">
                  <c:v>-0.26038277910247698</c:v>
                </c:pt>
                <c:pt idx="397">
                  <c:v>-0.49612488980570801</c:v>
                </c:pt>
                <c:pt idx="398">
                  <c:v>-0.49612488980570801</c:v>
                </c:pt>
                <c:pt idx="399">
                  <c:v>-0.28336969969841302</c:v>
                </c:pt>
                <c:pt idx="400">
                  <c:v>-0.28336969969841302</c:v>
                </c:pt>
                <c:pt idx="401">
                  <c:v>-0.17976844456654201</c:v>
                </c:pt>
                <c:pt idx="402">
                  <c:v>-0.17976844456654201</c:v>
                </c:pt>
                <c:pt idx="403">
                  <c:v>-0.20711890712462</c:v>
                </c:pt>
                <c:pt idx="404">
                  <c:v>-0.207332351198521</c:v>
                </c:pt>
                <c:pt idx="405">
                  <c:v>-0.28102468616432402</c:v>
                </c:pt>
                <c:pt idx="406">
                  <c:v>-0.18112986456375599</c:v>
                </c:pt>
                <c:pt idx="407">
                  <c:v>-0.103511663729451</c:v>
                </c:pt>
                <c:pt idx="408">
                  <c:v>-0.22219652582890201</c:v>
                </c:pt>
                <c:pt idx="409">
                  <c:v>-9.1610498630843196E-2</c:v>
                </c:pt>
                <c:pt idx="410">
                  <c:v>-0.33427445181755899</c:v>
                </c:pt>
                <c:pt idx="411">
                  <c:v>-6.9272006648439605E-2</c:v>
                </c:pt>
                <c:pt idx="412">
                  <c:v>-0.50398887059104402</c:v>
                </c:pt>
                <c:pt idx="413">
                  <c:v>-0.297426721692026</c:v>
                </c:pt>
                <c:pt idx="414">
                  <c:v>-0.43647947940749299</c:v>
                </c:pt>
                <c:pt idx="415">
                  <c:v>6.4980496355674502E-2</c:v>
                </c:pt>
                <c:pt idx="416">
                  <c:v>-1.93779918530349E-2</c:v>
                </c:pt>
                <c:pt idx="417">
                  <c:v>-0.60867728270201704</c:v>
                </c:pt>
                <c:pt idx="418">
                  <c:v>-0.43141573273428602</c:v>
                </c:pt>
                <c:pt idx="419">
                  <c:v>-0.257182920325565</c:v>
                </c:pt>
                <c:pt idx="420">
                  <c:v>0.11334067518891699</c:v>
                </c:pt>
                <c:pt idx="421">
                  <c:v>-0.86212989838008802</c:v>
                </c:pt>
                <c:pt idx="422">
                  <c:v>0.23845281176111</c:v>
                </c:pt>
                <c:pt idx="423">
                  <c:v>-0.74278716363054398</c:v>
                </c:pt>
                <c:pt idx="424">
                  <c:v>0.13983079940877599</c:v>
                </c:pt>
                <c:pt idx="425">
                  <c:v>-0.216819634672615</c:v>
                </c:pt>
                <c:pt idx="426">
                  <c:v>-0.394576991949392</c:v>
                </c:pt>
                <c:pt idx="427">
                  <c:v>0.102539049011048</c:v>
                </c:pt>
                <c:pt idx="428">
                  <c:v>0.213864843244819</c:v>
                </c:pt>
                <c:pt idx="429">
                  <c:v>-4.44808125434639E-2</c:v>
                </c:pt>
                <c:pt idx="430">
                  <c:v>0.134760163881364</c:v>
                </c:pt>
                <c:pt idx="431">
                  <c:v>9.2576722992530492E-3</c:v>
                </c:pt>
                <c:pt idx="432">
                  <c:v>0.18004895882081601</c:v>
                </c:pt>
                <c:pt idx="433">
                  <c:v>5.6082035383656199E-2</c:v>
                </c:pt>
                <c:pt idx="434">
                  <c:v>-0.449552610665157</c:v>
                </c:pt>
                <c:pt idx="435">
                  <c:v>-0.449552610665157</c:v>
                </c:pt>
                <c:pt idx="436">
                  <c:v>-7.0506449170163701E-2</c:v>
                </c:pt>
                <c:pt idx="437">
                  <c:v>-0.41796590486922303</c:v>
                </c:pt>
                <c:pt idx="438">
                  <c:v>0.23525572170981701</c:v>
                </c:pt>
                <c:pt idx="439">
                  <c:v>0.200892730035691</c:v>
                </c:pt>
                <c:pt idx="440">
                  <c:v>0.35692125539139602</c:v>
                </c:pt>
                <c:pt idx="441">
                  <c:v>0.15305831300279699</c:v>
                </c:pt>
                <c:pt idx="442">
                  <c:v>-0.19398012276235799</c:v>
                </c:pt>
                <c:pt idx="443">
                  <c:v>0.35480920829759999</c:v>
                </c:pt>
                <c:pt idx="444">
                  <c:v>0.32075958883967498</c:v>
                </c:pt>
                <c:pt idx="445">
                  <c:v>0.77455558916962697</c:v>
                </c:pt>
                <c:pt idx="446">
                  <c:v>0.25950516487706399</c:v>
                </c:pt>
                <c:pt idx="447">
                  <c:v>0.32498423850163</c:v>
                </c:pt>
                <c:pt idx="448">
                  <c:v>-0.22000675978329201</c:v>
                </c:pt>
                <c:pt idx="449">
                  <c:v>0.109025809488332</c:v>
                </c:pt>
                <c:pt idx="450">
                  <c:v>8.4792889828898405E-2</c:v>
                </c:pt>
                <c:pt idx="451">
                  <c:v>5.9252811452042399E-2</c:v>
                </c:pt>
                <c:pt idx="452">
                  <c:v>-0.180354380613306</c:v>
                </c:pt>
                <c:pt idx="453">
                  <c:v>0.13850289613542199</c:v>
                </c:pt>
                <c:pt idx="454">
                  <c:v>-0.15081581419833101</c:v>
                </c:pt>
                <c:pt idx="455">
                  <c:v>-0.14306686770014701</c:v>
                </c:pt>
                <c:pt idx="456">
                  <c:v>-0.15953738378684501</c:v>
                </c:pt>
                <c:pt idx="457">
                  <c:v>-0.132166150385507</c:v>
                </c:pt>
                <c:pt idx="458">
                  <c:v>-0.44910223038658698</c:v>
                </c:pt>
                <c:pt idx="459">
                  <c:v>-0.17975937148715901</c:v>
                </c:pt>
                <c:pt idx="460">
                  <c:v>-0.29087179427498899</c:v>
                </c:pt>
                <c:pt idx="461">
                  <c:v>-0.150858414990135</c:v>
                </c:pt>
                <c:pt idx="462">
                  <c:v>-0.52899184850219005</c:v>
                </c:pt>
                <c:pt idx="463">
                  <c:v>-0.34447173639354101</c:v>
                </c:pt>
                <c:pt idx="464">
                  <c:v>0.19328969128002099</c:v>
                </c:pt>
                <c:pt idx="465">
                  <c:v>-0.49035331487598899</c:v>
                </c:pt>
                <c:pt idx="466">
                  <c:v>-0.22738150807048599</c:v>
                </c:pt>
                <c:pt idx="467">
                  <c:v>-0.45634015246166199</c:v>
                </c:pt>
                <c:pt idx="468">
                  <c:v>-9.1984928648705805E-2</c:v>
                </c:pt>
                <c:pt idx="469">
                  <c:v>3.5356443996839099E-2</c:v>
                </c:pt>
                <c:pt idx="470">
                  <c:v>-0.51839372000941397</c:v>
                </c:pt>
                <c:pt idx="471">
                  <c:v>9.7083994131551596E-2</c:v>
                </c:pt>
                <c:pt idx="472">
                  <c:v>-0.45533306985129601</c:v>
                </c:pt>
                <c:pt idx="473">
                  <c:v>-0.16849166023027301</c:v>
                </c:pt>
                <c:pt idx="474">
                  <c:v>-0.31199314801585298</c:v>
                </c:pt>
                <c:pt idx="475">
                  <c:v>-0.22085355599201101</c:v>
                </c:pt>
                <c:pt idx="476">
                  <c:v>-0.13407553488295601</c:v>
                </c:pt>
                <c:pt idx="477">
                  <c:v>-0.37515733558480902</c:v>
                </c:pt>
                <c:pt idx="478">
                  <c:v>-0.40904094308832001</c:v>
                </c:pt>
                <c:pt idx="479">
                  <c:v>-0.410025325782433</c:v>
                </c:pt>
                <c:pt idx="480">
                  <c:v>-0.2444156961449</c:v>
                </c:pt>
                <c:pt idx="481">
                  <c:v>-0.26274604927081702</c:v>
                </c:pt>
                <c:pt idx="482">
                  <c:v>-0.188536533354519</c:v>
                </c:pt>
                <c:pt idx="483">
                  <c:v>-0.30097719040184401</c:v>
                </c:pt>
                <c:pt idx="484">
                  <c:v>0.11253503326828999</c:v>
                </c:pt>
                <c:pt idx="485">
                  <c:v>-0.52700709116442601</c:v>
                </c:pt>
                <c:pt idx="486">
                  <c:v>-0.105398440959647</c:v>
                </c:pt>
                <c:pt idx="487">
                  <c:v>0.36672529469619403</c:v>
                </c:pt>
                <c:pt idx="488">
                  <c:v>-2.9956868620692198E-3</c:v>
                </c:pt>
                <c:pt idx="489">
                  <c:v>-0.103572923687356</c:v>
                </c:pt>
                <c:pt idx="490">
                  <c:v>9.1126825125537506E-2</c:v>
                </c:pt>
                <c:pt idx="491">
                  <c:v>5.2272819787630799E-2</c:v>
                </c:pt>
                <c:pt idx="492">
                  <c:v>-0.176080976504631</c:v>
                </c:pt>
                <c:pt idx="493">
                  <c:v>-7.2335338405198193E-2</c:v>
                </c:pt>
                <c:pt idx="494">
                  <c:v>-0.221961454911237</c:v>
                </c:pt>
                <c:pt idx="495">
                  <c:v>2.5396900077678499E-2</c:v>
                </c:pt>
                <c:pt idx="496">
                  <c:v>8.5136424935948599E-2</c:v>
                </c:pt>
                <c:pt idx="497">
                  <c:v>0.22560090731104901</c:v>
                </c:pt>
                <c:pt idx="498">
                  <c:v>-0.31528788440537597</c:v>
                </c:pt>
                <c:pt idx="499">
                  <c:v>-1.1813907255219301E-2</c:v>
                </c:pt>
                <c:pt idx="500">
                  <c:v>0.13648926404692599</c:v>
                </c:pt>
                <c:pt idx="501">
                  <c:v>0.41627840921082598</c:v>
                </c:pt>
                <c:pt idx="502">
                  <c:v>-0.42578052288989199</c:v>
                </c:pt>
                <c:pt idx="503">
                  <c:v>3.2033470756682399E-2</c:v>
                </c:pt>
                <c:pt idx="504">
                  <c:v>-5.7890007502577098E-2</c:v>
                </c:pt>
                <c:pt idx="505">
                  <c:v>-0.35635012417050599</c:v>
                </c:pt>
                <c:pt idx="506">
                  <c:v>-3.3680241779143902E-2</c:v>
                </c:pt>
                <c:pt idx="507">
                  <c:v>-0.34067418871667199</c:v>
                </c:pt>
                <c:pt idx="508">
                  <c:v>-0.16943331229734801</c:v>
                </c:pt>
                <c:pt idx="509">
                  <c:v>-2.4864554229690399E-2</c:v>
                </c:pt>
                <c:pt idx="510">
                  <c:v>-0.112630708628954</c:v>
                </c:pt>
                <c:pt idx="511">
                  <c:v>-0.30368971935212002</c:v>
                </c:pt>
                <c:pt idx="512">
                  <c:v>-0.39280803026945799</c:v>
                </c:pt>
                <c:pt idx="513">
                  <c:v>6.0040215819089603E-2</c:v>
                </c:pt>
                <c:pt idx="514">
                  <c:v>-0.23499647082807501</c:v>
                </c:pt>
                <c:pt idx="515">
                  <c:v>-0.27251431923886998</c:v>
                </c:pt>
                <c:pt idx="516">
                  <c:v>-3.6642106893516102E-2</c:v>
                </c:pt>
                <c:pt idx="517">
                  <c:v>-4.7109961321225802E-2</c:v>
                </c:pt>
                <c:pt idx="518">
                  <c:v>0.32571055784931002</c:v>
                </c:pt>
                <c:pt idx="519">
                  <c:v>-1.8120664568175199E-2</c:v>
                </c:pt>
                <c:pt idx="520">
                  <c:v>9.9557184757731301E-2</c:v>
                </c:pt>
                <c:pt idx="521">
                  <c:v>-0.45068297821749298</c:v>
                </c:pt>
                <c:pt idx="522">
                  <c:v>4.65930378838312E-2</c:v>
                </c:pt>
                <c:pt idx="523">
                  <c:v>-0.39072527964839598</c:v>
                </c:pt>
                <c:pt idx="524">
                  <c:v>1.02642277246124</c:v>
                </c:pt>
                <c:pt idx="525">
                  <c:v>-5.7926801625946697E-2</c:v>
                </c:pt>
                <c:pt idx="526">
                  <c:v>-9.9031247149250198E-2</c:v>
                </c:pt>
                <c:pt idx="527">
                  <c:v>-0.34648213786161702</c:v>
                </c:pt>
                <c:pt idx="528">
                  <c:v>-0.32393809075807001</c:v>
                </c:pt>
                <c:pt idx="529">
                  <c:v>-0.13314411108260299</c:v>
                </c:pt>
                <c:pt idx="530">
                  <c:v>-0.26650395139341299</c:v>
                </c:pt>
                <c:pt idx="531">
                  <c:v>0.30935228512095703</c:v>
                </c:pt>
                <c:pt idx="532">
                  <c:v>-0.41422189753829097</c:v>
                </c:pt>
                <c:pt idx="533">
                  <c:v>-0.14419035976526701</c:v>
                </c:pt>
                <c:pt idx="534">
                  <c:v>-0.34688162006914602</c:v>
                </c:pt>
                <c:pt idx="535">
                  <c:v>-0.43384917651542099</c:v>
                </c:pt>
                <c:pt idx="536">
                  <c:v>-0.46451868508722699</c:v>
                </c:pt>
                <c:pt idx="537">
                  <c:v>0.11772454458116299</c:v>
                </c:pt>
                <c:pt idx="538">
                  <c:v>0.38527848838587703</c:v>
                </c:pt>
                <c:pt idx="539">
                  <c:v>0.21060672272959099</c:v>
                </c:pt>
                <c:pt idx="540">
                  <c:v>0.150535117814107</c:v>
                </c:pt>
                <c:pt idx="541">
                  <c:v>-0.234287081786169</c:v>
                </c:pt>
                <c:pt idx="542">
                  <c:v>-0.17984697744421099</c:v>
                </c:pt>
                <c:pt idx="543">
                  <c:v>0.37341306739154001</c:v>
                </c:pt>
                <c:pt idx="544">
                  <c:v>-0.52167202641049104</c:v>
                </c:pt>
                <c:pt idx="545">
                  <c:v>3.7602324680799097E-2</c:v>
                </c:pt>
                <c:pt idx="546">
                  <c:v>-7.9406811129281399E-2</c:v>
                </c:pt>
                <c:pt idx="547">
                  <c:v>-0.156692787498871</c:v>
                </c:pt>
                <c:pt idx="548">
                  <c:v>-0.40301760700142503</c:v>
                </c:pt>
                <c:pt idx="549">
                  <c:v>-0.37970024044572298</c:v>
                </c:pt>
                <c:pt idx="550">
                  <c:v>0.17373719092642001</c:v>
                </c:pt>
                <c:pt idx="551">
                  <c:v>-0.14011691456408301</c:v>
                </c:pt>
                <c:pt idx="552">
                  <c:v>-7.1773624793460403E-2</c:v>
                </c:pt>
                <c:pt idx="553">
                  <c:v>-6.4910549111693694E-2</c:v>
                </c:pt>
                <c:pt idx="554">
                  <c:v>0.13969983167990099</c:v>
                </c:pt>
                <c:pt idx="555">
                  <c:v>0.13583932646633701</c:v>
                </c:pt>
                <c:pt idx="556">
                  <c:v>-1.14903041889542E-3</c:v>
                </c:pt>
                <c:pt idx="557">
                  <c:v>-0.28068343510213301</c:v>
                </c:pt>
                <c:pt idx="558">
                  <c:v>-0.144794262380292</c:v>
                </c:pt>
                <c:pt idx="559">
                  <c:v>-0.29369681346298998</c:v>
                </c:pt>
                <c:pt idx="560">
                  <c:v>-0.100907295896301</c:v>
                </c:pt>
                <c:pt idx="561">
                  <c:v>-0.31211253353894702</c:v>
                </c:pt>
                <c:pt idx="562">
                  <c:v>-8.9703141408466303E-2</c:v>
                </c:pt>
                <c:pt idx="563">
                  <c:v>0.18976155271050801</c:v>
                </c:pt>
                <c:pt idx="564">
                  <c:v>0.34145815685861203</c:v>
                </c:pt>
                <c:pt idx="565">
                  <c:v>-5.6849902193251103E-2</c:v>
                </c:pt>
                <c:pt idx="566">
                  <c:v>-0.17591307128191</c:v>
                </c:pt>
                <c:pt idx="567">
                  <c:v>-0.20450100801792201</c:v>
                </c:pt>
                <c:pt idx="568">
                  <c:v>9.7210198427797601E-2</c:v>
                </c:pt>
                <c:pt idx="569">
                  <c:v>8.5896858204327309</c:v>
                </c:pt>
                <c:pt idx="570">
                  <c:v>-0.43383230223826202</c:v>
                </c:pt>
                <c:pt idx="571">
                  <c:v>-0.22470132866516601</c:v>
                </c:pt>
                <c:pt idx="572">
                  <c:v>-0.439617979778895</c:v>
                </c:pt>
                <c:pt idx="573">
                  <c:v>-3.4473374916115899E-2</c:v>
                </c:pt>
                <c:pt idx="574">
                  <c:v>-0.34352585708810601</c:v>
                </c:pt>
                <c:pt idx="575">
                  <c:v>-0.25903874283575901</c:v>
                </c:pt>
                <c:pt idx="576">
                  <c:v>-2.0884254503581901E-3</c:v>
                </c:pt>
                <c:pt idx="577">
                  <c:v>5.2659318236038102E-2</c:v>
                </c:pt>
                <c:pt idx="578">
                  <c:v>7.8029240432909194E-2</c:v>
                </c:pt>
                <c:pt idx="579">
                  <c:v>-0.27116299855860598</c:v>
                </c:pt>
                <c:pt idx="580">
                  <c:v>0.123281864415044</c:v>
                </c:pt>
                <c:pt idx="581">
                  <c:v>-0.26287003584810997</c:v>
                </c:pt>
                <c:pt idx="582">
                  <c:v>-0.30569217058307502</c:v>
                </c:pt>
                <c:pt idx="583">
                  <c:v>-0.46447060273181101</c:v>
                </c:pt>
                <c:pt idx="584">
                  <c:v>-0.226834129388884</c:v>
                </c:pt>
                <c:pt idx="585">
                  <c:v>-7.3295959006350095E-2</c:v>
                </c:pt>
                <c:pt idx="586">
                  <c:v>-0.194155568302287</c:v>
                </c:pt>
                <c:pt idx="587">
                  <c:v>1.31091622454089E-2</c:v>
                </c:pt>
                <c:pt idx="588">
                  <c:v>3.5651383654888999E-2</c:v>
                </c:pt>
                <c:pt idx="589">
                  <c:v>0.38643625558969003</c:v>
                </c:pt>
                <c:pt idx="590">
                  <c:v>-4.7836975077513201E-2</c:v>
                </c:pt>
                <c:pt idx="591">
                  <c:v>-2.28699233938328E-2</c:v>
                </c:pt>
                <c:pt idx="592">
                  <c:v>-0.14870721753976601</c:v>
                </c:pt>
                <c:pt idx="593">
                  <c:v>-0.13752981130060801</c:v>
                </c:pt>
                <c:pt idx="594">
                  <c:v>-7.5878864340687496E-2</c:v>
                </c:pt>
                <c:pt idx="595">
                  <c:v>0.125338671387728</c:v>
                </c:pt>
                <c:pt idx="596">
                  <c:v>-0.34792554587070701</c:v>
                </c:pt>
                <c:pt idx="597">
                  <c:v>-0.21845986489646399</c:v>
                </c:pt>
                <c:pt idx="598">
                  <c:v>-0.27126400844651699</c:v>
                </c:pt>
                <c:pt idx="599">
                  <c:v>-0.206667371988214</c:v>
                </c:pt>
                <c:pt idx="600">
                  <c:v>-0.32736855572721202</c:v>
                </c:pt>
                <c:pt idx="601">
                  <c:v>-0.23124513557100801</c:v>
                </c:pt>
                <c:pt idx="602">
                  <c:v>-5.3777839715750002E-2</c:v>
                </c:pt>
                <c:pt idx="603">
                  <c:v>-0.37048216868148198</c:v>
                </c:pt>
                <c:pt idx="604">
                  <c:v>-0.107743457488173</c:v>
                </c:pt>
                <c:pt idx="605">
                  <c:v>-9.1883423472918904E-2</c:v>
                </c:pt>
                <c:pt idx="606">
                  <c:v>-0.186269950009468</c:v>
                </c:pt>
                <c:pt idx="607">
                  <c:v>-0.45706242295802202</c:v>
                </c:pt>
                <c:pt idx="608">
                  <c:v>-0.385242838454877</c:v>
                </c:pt>
                <c:pt idx="609">
                  <c:v>-0.40698370647984899</c:v>
                </c:pt>
                <c:pt idx="610">
                  <c:v>0.53066322353776596</c:v>
                </c:pt>
                <c:pt idx="611">
                  <c:v>3.06848444854316E-2</c:v>
                </c:pt>
                <c:pt idx="612">
                  <c:v>-0.19001405282933301</c:v>
                </c:pt>
                <c:pt idx="613">
                  <c:v>-2.28605035844145E-2</c:v>
                </c:pt>
                <c:pt idx="614">
                  <c:v>5.4886096902570097E-2</c:v>
                </c:pt>
                <c:pt idx="615">
                  <c:v>0.34331633208097401</c:v>
                </c:pt>
                <c:pt idx="616">
                  <c:v>3.9821407598653699E-2</c:v>
                </c:pt>
                <c:pt idx="617">
                  <c:v>-2.1120804325784E-2</c:v>
                </c:pt>
                <c:pt idx="618">
                  <c:v>-0.26418009277125298</c:v>
                </c:pt>
                <c:pt idx="619">
                  <c:v>0.150072206529102</c:v>
                </c:pt>
                <c:pt idx="620">
                  <c:v>0.24653460440642599</c:v>
                </c:pt>
                <c:pt idx="621">
                  <c:v>-0.18667967634771299</c:v>
                </c:pt>
                <c:pt idx="622">
                  <c:v>-0.12387395883171599</c:v>
                </c:pt>
                <c:pt idx="623">
                  <c:v>-0.19035774649395801</c:v>
                </c:pt>
                <c:pt idx="624">
                  <c:v>-0.52749385698041595</c:v>
                </c:pt>
                <c:pt idx="625">
                  <c:v>-2.9835756365547601E-2</c:v>
                </c:pt>
                <c:pt idx="626">
                  <c:v>9.5326106226830506E-2</c:v>
                </c:pt>
                <c:pt idx="627">
                  <c:v>-0.457776027250545</c:v>
                </c:pt>
                <c:pt idx="628">
                  <c:v>-0.135075050444106</c:v>
                </c:pt>
                <c:pt idx="629">
                  <c:v>-0.106677793131085</c:v>
                </c:pt>
                <c:pt idx="630">
                  <c:v>-7.8781295599829104E-2</c:v>
                </c:pt>
                <c:pt idx="631">
                  <c:v>3.2500689389953097E-2</c:v>
                </c:pt>
                <c:pt idx="632">
                  <c:v>-0.35057986899336102</c:v>
                </c:pt>
                <c:pt idx="633">
                  <c:v>1.7662848723440702E-2</c:v>
                </c:pt>
                <c:pt idx="634">
                  <c:v>-0.156450107173429</c:v>
                </c:pt>
                <c:pt idx="635">
                  <c:v>-0.15692997630219399</c:v>
                </c:pt>
                <c:pt idx="636">
                  <c:v>-0.281344926574712</c:v>
                </c:pt>
                <c:pt idx="637">
                  <c:v>-1.86177265233693E-2</c:v>
                </c:pt>
                <c:pt idx="638">
                  <c:v>-0.32493618548669001</c:v>
                </c:pt>
                <c:pt idx="639">
                  <c:v>-0.24023815658296399</c:v>
                </c:pt>
                <c:pt idx="640">
                  <c:v>-0.319275606024221</c:v>
                </c:pt>
                <c:pt idx="641">
                  <c:v>-0.39301713504727798</c:v>
                </c:pt>
                <c:pt idx="642">
                  <c:v>-0.20061739360179201</c:v>
                </c:pt>
                <c:pt idx="643">
                  <c:v>-0.10567087291214999</c:v>
                </c:pt>
                <c:pt idx="644">
                  <c:v>-3.8372948628785798E-2</c:v>
                </c:pt>
                <c:pt idx="645">
                  <c:v>7.9965094161733197E-2</c:v>
                </c:pt>
                <c:pt idx="646">
                  <c:v>-5.7027235410764501E-2</c:v>
                </c:pt>
                <c:pt idx="647">
                  <c:v>-1.7454044783694299E-2</c:v>
                </c:pt>
                <c:pt idx="648">
                  <c:v>6.3337257546524001E-2</c:v>
                </c:pt>
                <c:pt idx="649">
                  <c:v>-0.175441801586563</c:v>
                </c:pt>
                <c:pt idx="650">
                  <c:v>0.23039253134674101</c:v>
                </c:pt>
                <c:pt idx="651">
                  <c:v>9.5591542177928202E-2</c:v>
                </c:pt>
                <c:pt idx="652">
                  <c:v>-0.20363832117641001</c:v>
                </c:pt>
                <c:pt idx="653">
                  <c:v>-0.250244986945166</c:v>
                </c:pt>
                <c:pt idx="654">
                  <c:v>-0.27419233215424799</c:v>
                </c:pt>
                <c:pt idx="655">
                  <c:v>-0.28584261108379</c:v>
                </c:pt>
                <c:pt idx="656">
                  <c:v>-0.30194436109363199</c:v>
                </c:pt>
                <c:pt idx="657">
                  <c:v>-0.118514269653118</c:v>
                </c:pt>
                <c:pt idx="658">
                  <c:v>-0.21261766711631599</c:v>
                </c:pt>
                <c:pt idx="659">
                  <c:v>0.192582210130362</c:v>
                </c:pt>
                <c:pt idx="660">
                  <c:v>-0.25058671659938903</c:v>
                </c:pt>
                <c:pt idx="661">
                  <c:v>-0.35901187253685202</c:v>
                </c:pt>
                <c:pt idx="662">
                  <c:v>-0.49398662641572599</c:v>
                </c:pt>
                <c:pt idx="663">
                  <c:v>-2.9820247322467502E-2</c:v>
                </c:pt>
                <c:pt idx="664">
                  <c:v>-0.32848342500169297</c:v>
                </c:pt>
                <c:pt idx="665">
                  <c:v>-0.49776078900000897</c:v>
                </c:pt>
                <c:pt idx="666">
                  <c:v>-0.49269002674247597</c:v>
                </c:pt>
                <c:pt idx="667">
                  <c:v>-0.50712510003947397</c:v>
                </c:pt>
                <c:pt idx="668">
                  <c:v>-0.40787745900015399</c:v>
                </c:pt>
                <c:pt idx="669">
                  <c:v>-0.43720781103288098</c:v>
                </c:pt>
                <c:pt idx="670">
                  <c:v>-0.33940560537571202</c:v>
                </c:pt>
                <c:pt idx="671">
                  <c:v>4.2007263089873903E-2</c:v>
                </c:pt>
                <c:pt idx="672">
                  <c:v>-0.38754781583659798</c:v>
                </c:pt>
                <c:pt idx="673">
                  <c:v>-0.32420816600070002</c:v>
                </c:pt>
                <c:pt idx="674">
                  <c:v>-0.36716731721075502</c:v>
                </c:pt>
                <c:pt idx="675">
                  <c:v>-0.42210404334859097</c:v>
                </c:pt>
                <c:pt idx="676">
                  <c:v>-0.52936481121037904</c:v>
                </c:pt>
                <c:pt idx="677">
                  <c:v>-0.52303353563550903</c:v>
                </c:pt>
                <c:pt idx="678">
                  <c:v>-0.53171184243076097</c:v>
                </c:pt>
                <c:pt idx="679">
                  <c:v>-0.19163299285656399</c:v>
                </c:pt>
                <c:pt idx="680">
                  <c:v>-0.316320505481898</c:v>
                </c:pt>
                <c:pt idx="681">
                  <c:v>-0.39718322875814199</c:v>
                </c:pt>
                <c:pt idx="682">
                  <c:v>-0.41417075854250301</c:v>
                </c:pt>
                <c:pt idx="683">
                  <c:v>-0.35780524195708602</c:v>
                </c:pt>
                <c:pt idx="684">
                  <c:v>-0.556974991607467</c:v>
                </c:pt>
                <c:pt idx="685">
                  <c:v>-0.33767631518699298</c:v>
                </c:pt>
                <c:pt idx="686">
                  <c:v>-0.33677051428087001</c:v>
                </c:pt>
                <c:pt idx="687">
                  <c:v>-0.40500076994913098</c:v>
                </c:pt>
                <c:pt idx="688">
                  <c:v>-0.22879644627015899</c:v>
                </c:pt>
                <c:pt idx="689">
                  <c:v>-0.45815036063773301</c:v>
                </c:pt>
                <c:pt idx="690">
                  <c:v>-1.8932541195758601E-2</c:v>
                </c:pt>
                <c:pt idx="691">
                  <c:v>-2.1917499351660399E-2</c:v>
                </c:pt>
                <c:pt idx="692">
                  <c:v>-0.12953578077581701</c:v>
                </c:pt>
                <c:pt idx="693">
                  <c:v>-0.28412992102199403</c:v>
                </c:pt>
                <c:pt idx="694">
                  <c:v>-7.26263829793376E-2</c:v>
                </c:pt>
                <c:pt idx="695">
                  <c:v>-0.222932204495428</c:v>
                </c:pt>
                <c:pt idx="696">
                  <c:v>-0.17011892659913999</c:v>
                </c:pt>
                <c:pt idx="697">
                  <c:v>-9.6849709937889494E-2</c:v>
                </c:pt>
                <c:pt idx="698">
                  <c:v>-8.4658813601923802E-2</c:v>
                </c:pt>
                <c:pt idx="699">
                  <c:v>-0.27937476208401602</c:v>
                </c:pt>
                <c:pt idx="700">
                  <c:v>-0.12153970867918901</c:v>
                </c:pt>
                <c:pt idx="701">
                  <c:v>-0.16836610521595799</c:v>
                </c:pt>
                <c:pt idx="702">
                  <c:v>-0.24262770612724399</c:v>
                </c:pt>
                <c:pt idx="703">
                  <c:v>-0.24182306357668501</c:v>
                </c:pt>
                <c:pt idx="704">
                  <c:v>-0.12741818152599399</c:v>
                </c:pt>
                <c:pt idx="705">
                  <c:v>-0.17725775175635999</c:v>
                </c:pt>
                <c:pt idx="706">
                  <c:v>-7.75662491391165E-2</c:v>
                </c:pt>
                <c:pt idx="707">
                  <c:v>-0.283426643355979</c:v>
                </c:pt>
                <c:pt idx="708">
                  <c:v>-0.28577775783073101</c:v>
                </c:pt>
                <c:pt idx="709">
                  <c:v>-0.14686417468715199</c:v>
                </c:pt>
                <c:pt idx="710">
                  <c:v>-1.55512538256149E-2</c:v>
                </c:pt>
                <c:pt idx="711">
                  <c:v>-0.15477151418603599</c:v>
                </c:pt>
                <c:pt idx="712">
                  <c:v>-9.1946646391795006E-2</c:v>
                </c:pt>
                <c:pt idx="713">
                  <c:v>-0.41339859293869202</c:v>
                </c:pt>
                <c:pt idx="714">
                  <c:v>-0.30180950012207303</c:v>
                </c:pt>
                <c:pt idx="715">
                  <c:v>-0.21235580788001501</c:v>
                </c:pt>
                <c:pt idx="716">
                  <c:v>-0.177170181310153</c:v>
                </c:pt>
                <c:pt idx="717">
                  <c:v>-0.122830748649815</c:v>
                </c:pt>
                <c:pt idx="718">
                  <c:v>-0.14983232423554399</c:v>
                </c:pt>
                <c:pt idx="719">
                  <c:v>-0.140289939577835</c:v>
                </c:pt>
                <c:pt idx="720">
                  <c:v>-0.40267521619916902</c:v>
                </c:pt>
                <c:pt idx="721">
                  <c:v>-0.15873490158883199</c:v>
                </c:pt>
                <c:pt idx="722">
                  <c:v>-0.35330755940096298</c:v>
                </c:pt>
                <c:pt idx="723">
                  <c:v>-7.4365533141179094E-2</c:v>
                </c:pt>
                <c:pt idx="724">
                  <c:v>-0.116027311117317</c:v>
                </c:pt>
                <c:pt idx="725">
                  <c:v>-8.8339973574124098E-2</c:v>
                </c:pt>
                <c:pt idx="726">
                  <c:v>-0.27379855574294099</c:v>
                </c:pt>
                <c:pt idx="727">
                  <c:v>-0.223705203261271</c:v>
                </c:pt>
                <c:pt idx="728">
                  <c:v>-0.29262794263120301</c:v>
                </c:pt>
                <c:pt idx="729">
                  <c:v>-0.24965181448655899</c:v>
                </c:pt>
                <c:pt idx="730">
                  <c:v>-0.214282758964533</c:v>
                </c:pt>
                <c:pt idx="731">
                  <c:v>-0.15034406853479801</c:v>
                </c:pt>
                <c:pt idx="732">
                  <c:v>-0.14943388408784</c:v>
                </c:pt>
                <c:pt idx="733">
                  <c:v>-0.15576949882461899</c:v>
                </c:pt>
                <c:pt idx="734">
                  <c:v>-0.36879146956983599</c:v>
                </c:pt>
                <c:pt idx="735">
                  <c:v>-0.36897379433819</c:v>
                </c:pt>
                <c:pt idx="736">
                  <c:v>-0.27708638715066197</c:v>
                </c:pt>
                <c:pt idx="737">
                  <c:v>-0.194033690902254</c:v>
                </c:pt>
                <c:pt idx="738">
                  <c:v>-0.19029207575333501</c:v>
                </c:pt>
                <c:pt idx="739">
                  <c:v>-0.25384401290620601</c:v>
                </c:pt>
                <c:pt idx="740">
                  <c:v>-0.18580020992999099</c:v>
                </c:pt>
                <c:pt idx="741">
                  <c:v>-0.15663879994340199</c:v>
                </c:pt>
                <c:pt idx="742">
                  <c:v>-0.16905025646053701</c:v>
                </c:pt>
                <c:pt idx="743">
                  <c:v>-0.14303805358902399</c:v>
                </c:pt>
                <c:pt idx="744">
                  <c:v>-0.35683082720959702</c:v>
                </c:pt>
                <c:pt idx="745">
                  <c:v>-0.11263083578059201</c:v>
                </c:pt>
                <c:pt idx="746">
                  <c:v>-0.23522160714272999</c:v>
                </c:pt>
                <c:pt idx="747">
                  <c:v>-5.4217487479318399E-2</c:v>
                </c:pt>
                <c:pt idx="748">
                  <c:v>-0.23175879627642201</c:v>
                </c:pt>
                <c:pt idx="749">
                  <c:v>-3.5982532293603299E-2</c:v>
                </c:pt>
                <c:pt idx="750">
                  <c:v>-0.35518166525809097</c:v>
                </c:pt>
                <c:pt idx="751">
                  <c:v>-0.115883242763302</c:v>
                </c:pt>
                <c:pt idx="752">
                  <c:v>-2.4985864751589301E-2</c:v>
                </c:pt>
                <c:pt idx="753">
                  <c:v>-0.27225859103144301</c:v>
                </c:pt>
                <c:pt idx="754">
                  <c:v>-5.06281530126469E-2</c:v>
                </c:pt>
                <c:pt idx="755">
                  <c:v>-0.27113855709682799</c:v>
                </c:pt>
                <c:pt idx="756">
                  <c:v>-2.7248009176536699E-2</c:v>
                </c:pt>
                <c:pt idx="757">
                  <c:v>-5.5397854912520403E-2</c:v>
                </c:pt>
                <c:pt idx="758">
                  <c:v>-0.12682313503369599</c:v>
                </c:pt>
                <c:pt idx="759">
                  <c:v>3.5447791719340198E-2</c:v>
                </c:pt>
                <c:pt idx="760">
                  <c:v>-0.16977937028679699</c:v>
                </c:pt>
                <c:pt idx="761">
                  <c:v>-0.149357922772971</c:v>
                </c:pt>
                <c:pt idx="762">
                  <c:v>2.9134477121611699E-2</c:v>
                </c:pt>
                <c:pt idx="763">
                  <c:v>-0.13091140803561299</c:v>
                </c:pt>
                <c:pt idx="764">
                  <c:v>-8.05325652920479E-2</c:v>
                </c:pt>
                <c:pt idx="765">
                  <c:v>-0.18060947456009499</c:v>
                </c:pt>
                <c:pt idx="766">
                  <c:v>-0.327082063960833</c:v>
                </c:pt>
                <c:pt idx="767">
                  <c:v>-4.2379641977593897E-2</c:v>
                </c:pt>
                <c:pt idx="768">
                  <c:v>-0.11492716081110201</c:v>
                </c:pt>
                <c:pt idx="769">
                  <c:v>-0.140179461697754</c:v>
                </c:pt>
                <c:pt idx="770">
                  <c:v>-0.101726152201483</c:v>
                </c:pt>
                <c:pt idx="771">
                  <c:v>0.35131905688991699</c:v>
                </c:pt>
                <c:pt idx="772">
                  <c:v>-0.23206552009381301</c:v>
                </c:pt>
                <c:pt idx="773">
                  <c:v>-0.131517871015357</c:v>
                </c:pt>
                <c:pt idx="774">
                  <c:v>-0.33294683929996199</c:v>
                </c:pt>
                <c:pt idx="775">
                  <c:v>-0.114867789560634</c:v>
                </c:pt>
                <c:pt idx="776">
                  <c:v>-0.112782145581054</c:v>
                </c:pt>
                <c:pt idx="777">
                  <c:v>-0.15600274648743101</c:v>
                </c:pt>
                <c:pt idx="778">
                  <c:v>-6.5485911997403098E-2</c:v>
                </c:pt>
                <c:pt idx="779">
                  <c:v>1.24254393672117E-2</c:v>
                </c:pt>
                <c:pt idx="780">
                  <c:v>-0.169367745798125</c:v>
                </c:pt>
                <c:pt idx="781">
                  <c:v>-2.3562264892169602E-2</c:v>
                </c:pt>
                <c:pt idx="782">
                  <c:v>-0.2045470369163</c:v>
                </c:pt>
                <c:pt idx="783">
                  <c:v>-0.23510018744019001</c:v>
                </c:pt>
                <c:pt idx="784">
                  <c:v>-0.31239458990884</c:v>
                </c:pt>
                <c:pt idx="785">
                  <c:v>-0.13074235426705</c:v>
                </c:pt>
                <c:pt idx="786">
                  <c:v>-0.311166237434291</c:v>
                </c:pt>
                <c:pt idx="787">
                  <c:v>-0.150539051803109</c:v>
                </c:pt>
                <c:pt idx="788">
                  <c:v>-0.120821280169828</c:v>
                </c:pt>
                <c:pt idx="789">
                  <c:v>-0.1914966073954</c:v>
                </c:pt>
                <c:pt idx="790">
                  <c:v>-0.25725509591984103</c:v>
                </c:pt>
                <c:pt idx="791">
                  <c:v>-6.9953146668673999E-2</c:v>
                </c:pt>
                <c:pt idx="792">
                  <c:v>-0.17549973988784801</c:v>
                </c:pt>
                <c:pt idx="793">
                  <c:v>-0.33122456389156602</c:v>
                </c:pt>
                <c:pt idx="794">
                  <c:v>-0.22709004863483601</c:v>
                </c:pt>
                <c:pt idx="795">
                  <c:v>-0.253865512972205</c:v>
                </c:pt>
                <c:pt idx="796">
                  <c:v>-0.17462695649298501</c:v>
                </c:pt>
                <c:pt idx="797">
                  <c:v>-0.110390476339094</c:v>
                </c:pt>
                <c:pt idx="798">
                  <c:v>-0.23233125896760101</c:v>
                </c:pt>
                <c:pt idx="799">
                  <c:v>-7.6826779209344304E-2</c:v>
                </c:pt>
                <c:pt idx="800">
                  <c:v>-5.4264550364134398E-2</c:v>
                </c:pt>
                <c:pt idx="801">
                  <c:v>-6.7337063270033998E-2</c:v>
                </c:pt>
                <c:pt idx="802">
                  <c:v>-1.43826757169397E-2</c:v>
                </c:pt>
                <c:pt idx="803">
                  <c:v>-5.9466695146839603E-4</c:v>
                </c:pt>
                <c:pt idx="804">
                  <c:v>-0.44016323548375302</c:v>
                </c:pt>
                <c:pt idx="805">
                  <c:v>-0.13116875066884201</c:v>
                </c:pt>
                <c:pt idx="806">
                  <c:v>4.8189191666533598E-2</c:v>
                </c:pt>
                <c:pt idx="807">
                  <c:v>9.2568685180046406E-2</c:v>
                </c:pt>
                <c:pt idx="808">
                  <c:v>-0.203129906938427</c:v>
                </c:pt>
                <c:pt idx="809">
                  <c:v>-0.173712653631931</c:v>
                </c:pt>
                <c:pt idx="810">
                  <c:v>-0.17291641905378</c:v>
                </c:pt>
                <c:pt idx="811">
                  <c:v>-0.19834378806896499</c:v>
                </c:pt>
                <c:pt idx="812">
                  <c:v>-0.15345004010753899</c:v>
                </c:pt>
                <c:pt idx="813">
                  <c:v>-0.26788136164732101</c:v>
                </c:pt>
                <c:pt idx="814">
                  <c:v>-0.23237312229389201</c:v>
                </c:pt>
                <c:pt idx="815">
                  <c:v>-7.3015904462322007E-2</c:v>
                </c:pt>
                <c:pt idx="816">
                  <c:v>-0.13759880034070901</c:v>
                </c:pt>
                <c:pt idx="817">
                  <c:v>-0.44679091948608601</c:v>
                </c:pt>
                <c:pt idx="818">
                  <c:v>-0.16009295969936399</c:v>
                </c:pt>
                <c:pt idx="819">
                  <c:v>-0.26284643037724698</c:v>
                </c:pt>
                <c:pt idx="820">
                  <c:v>-0.30957431444529498</c:v>
                </c:pt>
                <c:pt idx="821">
                  <c:v>-0.17346227030580599</c:v>
                </c:pt>
                <c:pt idx="822">
                  <c:v>-0.32932373721220698</c:v>
                </c:pt>
                <c:pt idx="823">
                  <c:v>-0.31215305851750202</c:v>
                </c:pt>
                <c:pt idx="824">
                  <c:v>-0.33363834021143002</c:v>
                </c:pt>
                <c:pt idx="825">
                  <c:v>-0.19184085389759201</c:v>
                </c:pt>
                <c:pt idx="826">
                  <c:v>-6.8349970939443103E-2</c:v>
                </c:pt>
                <c:pt idx="827">
                  <c:v>-6.26165360238847E-2</c:v>
                </c:pt>
                <c:pt idx="828">
                  <c:v>-0.31392700249689598</c:v>
                </c:pt>
                <c:pt idx="829">
                  <c:v>-0.30508139725698502</c:v>
                </c:pt>
                <c:pt idx="830">
                  <c:v>1.72726113911175E-2</c:v>
                </c:pt>
                <c:pt idx="831">
                  <c:v>4.1227653188714103E-2</c:v>
                </c:pt>
                <c:pt idx="832">
                  <c:v>3.77744277184539E-2</c:v>
                </c:pt>
                <c:pt idx="833">
                  <c:v>-2.97672373387519E-2</c:v>
                </c:pt>
                <c:pt idx="834">
                  <c:v>2.3637026259361101E-2</c:v>
                </c:pt>
                <c:pt idx="835">
                  <c:v>0.12461482587229</c:v>
                </c:pt>
                <c:pt idx="836">
                  <c:v>-0.20269888414557999</c:v>
                </c:pt>
                <c:pt idx="837">
                  <c:v>9.5798926266374096E-2</c:v>
                </c:pt>
                <c:pt idx="838">
                  <c:v>-8.2604224233446502E-2</c:v>
                </c:pt>
                <c:pt idx="839">
                  <c:v>-2.7053045985245699E-2</c:v>
                </c:pt>
                <c:pt idx="840">
                  <c:v>6.0379868558847402E-3</c:v>
                </c:pt>
                <c:pt idx="841">
                  <c:v>0.124336036545105</c:v>
                </c:pt>
                <c:pt idx="842">
                  <c:v>0.17510160418159201</c:v>
                </c:pt>
                <c:pt idx="843">
                  <c:v>8.5139073002791499E-2</c:v>
                </c:pt>
                <c:pt idx="844">
                  <c:v>-0.124578347618698</c:v>
                </c:pt>
                <c:pt idx="845">
                  <c:v>4.2323541176881897E-2</c:v>
                </c:pt>
                <c:pt idx="846">
                  <c:v>8.8853390794994699E-2</c:v>
                </c:pt>
                <c:pt idx="847">
                  <c:v>-1.08501144470055E-2</c:v>
                </c:pt>
                <c:pt idx="848">
                  <c:v>-6.9719234795283996E-2</c:v>
                </c:pt>
                <c:pt idx="849">
                  <c:v>3.5889844616804598E-2</c:v>
                </c:pt>
                <c:pt idx="850">
                  <c:v>0.136659179126908</c:v>
                </c:pt>
                <c:pt idx="851">
                  <c:v>-0.10086928237722</c:v>
                </c:pt>
                <c:pt idx="852">
                  <c:v>7.7363521352284095E-2</c:v>
                </c:pt>
                <c:pt idx="853">
                  <c:v>6.2241006242150801E-2</c:v>
                </c:pt>
                <c:pt idx="854">
                  <c:v>4.84152535341194E-2</c:v>
                </c:pt>
                <c:pt idx="855">
                  <c:v>0.20574285690744201</c:v>
                </c:pt>
                <c:pt idx="856">
                  <c:v>-3.6765527491359098E-2</c:v>
                </c:pt>
                <c:pt idx="857">
                  <c:v>-3.8123646895017203E-2</c:v>
                </c:pt>
                <c:pt idx="858">
                  <c:v>8.4411858679375396E-2</c:v>
                </c:pt>
                <c:pt idx="859">
                  <c:v>1.7547853755020701E-2</c:v>
                </c:pt>
                <c:pt idx="860">
                  <c:v>1.1981024986951899E-3</c:v>
                </c:pt>
                <c:pt idx="861">
                  <c:v>-4.3260696792667697E-2</c:v>
                </c:pt>
                <c:pt idx="862">
                  <c:v>-7.8248684695866703E-4</c:v>
                </c:pt>
                <c:pt idx="863">
                  <c:v>-8.3910709382204907E-2</c:v>
                </c:pt>
                <c:pt idx="864">
                  <c:v>0.18631218470188199</c:v>
                </c:pt>
                <c:pt idx="865">
                  <c:v>-4.9687058772074001E-2</c:v>
                </c:pt>
                <c:pt idx="866">
                  <c:v>-9.9365424616093503E-2</c:v>
                </c:pt>
                <c:pt idx="867">
                  <c:v>7.7142109586900598E-2</c:v>
                </c:pt>
                <c:pt idx="868">
                  <c:v>1.8549283145694099E-2</c:v>
                </c:pt>
                <c:pt idx="869">
                  <c:v>-0.119992198941168</c:v>
                </c:pt>
                <c:pt idx="870">
                  <c:v>-0.211304271297379</c:v>
                </c:pt>
                <c:pt idx="871">
                  <c:v>0.162574086244715</c:v>
                </c:pt>
                <c:pt idx="872">
                  <c:v>-4.01767135366407E-2</c:v>
                </c:pt>
                <c:pt idx="873">
                  <c:v>-0.37248471843564002</c:v>
                </c:pt>
                <c:pt idx="874">
                  <c:v>-0.40430661683754698</c:v>
                </c:pt>
                <c:pt idx="875">
                  <c:v>5.5197765257331499E-2</c:v>
                </c:pt>
                <c:pt idx="876">
                  <c:v>-0.36083297249433999</c:v>
                </c:pt>
                <c:pt idx="877">
                  <c:v>4.6844503839638799E-2</c:v>
                </c:pt>
                <c:pt idx="878">
                  <c:v>-2.6389400252886101E-2</c:v>
                </c:pt>
                <c:pt idx="879">
                  <c:v>-9.8177393795656806E-2</c:v>
                </c:pt>
                <c:pt idx="880">
                  <c:v>2.4710266428292899E-2</c:v>
                </c:pt>
                <c:pt idx="881">
                  <c:v>5.44243589336715E-2</c:v>
                </c:pt>
                <c:pt idx="882">
                  <c:v>-3.5203665383529599E-2</c:v>
                </c:pt>
                <c:pt idx="883">
                  <c:v>0.122246909769382</c:v>
                </c:pt>
                <c:pt idx="884">
                  <c:v>-4.7543299636424799E-2</c:v>
                </c:pt>
                <c:pt idx="885">
                  <c:v>-0.11968491019664999</c:v>
                </c:pt>
                <c:pt idx="886">
                  <c:v>-7.7301881369574305E-2</c:v>
                </c:pt>
                <c:pt idx="887">
                  <c:v>0.23213043450965801</c:v>
                </c:pt>
                <c:pt idx="888">
                  <c:v>-0.23599417531398001</c:v>
                </c:pt>
                <c:pt idx="889">
                  <c:v>-0.24078217720870401</c:v>
                </c:pt>
                <c:pt idx="890">
                  <c:v>2.1443855017411001E-2</c:v>
                </c:pt>
                <c:pt idx="891">
                  <c:v>-0.17843299233616899</c:v>
                </c:pt>
                <c:pt idx="892">
                  <c:v>-5.6079657192098099E-2</c:v>
                </c:pt>
                <c:pt idx="893">
                  <c:v>-0.31644921056930497</c:v>
                </c:pt>
                <c:pt idx="894">
                  <c:v>-0.340344756470154</c:v>
                </c:pt>
                <c:pt idx="895">
                  <c:v>-0.25062436533562199</c:v>
                </c:pt>
                <c:pt idx="896">
                  <c:v>0.366354059519574</c:v>
                </c:pt>
                <c:pt idx="897">
                  <c:v>-8.8893766937645405E-2</c:v>
                </c:pt>
                <c:pt idx="898">
                  <c:v>-0.290331401120694</c:v>
                </c:pt>
                <c:pt idx="899">
                  <c:v>-0.114366005722757</c:v>
                </c:pt>
                <c:pt idx="900">
                  <c:v>-0.39994964193928001</c:v>
                </c:pt>
                <c:pt idx="901">
                  <c:v>-5.1863485655931199E-2</c:v>
                </c:pt>
                <c:pt idx="902">
                  <c:v>6.2894583398349899E-2</c:v>
                </c:pt>
                <c:pt idx="903">
                  <c:v>-5.7927216758442299E-2</c:v>
                </c:pt>
                <c:pt idx="904">
                  <c:v>-0.118369416471047</c:v>
                </c:pt>
                <c:pt idx="905">
                  <c:v>-0.21112633070845399</c:v>
                </c:pt>
                <c:pt idx="906">
                  <c:v>0.25049297555619898</c:v>
                </c:pt>
                <c:pt idx="907">
                  <c:v>-0.10414124962383001</c:v>
                </c:pt>
                <c:pt idx="908">
                  <c:v>-9.8888229351756108E-3</c:v>
                </c:pt>
                <c:pt idx="909">
                  <c:v>1.9347851988812999E-2</c:v>
                </c:pt>
                <c:pt idx="910">
                  <c:v>-2.9989796774825401E-2</c:v>
                </c:pt>
                <c:pt idx="911">
                  <c:v>0.19770782649926499</c:v>
                </c:pt>
                <c:pt idx="912">
                  <c:v>-0.15457851271157899</c:v>
                </c:pt>
                <c:pt idx="913">
                  <c:v>-0.22925431971060201</c:v>
                </c:pt>
                <c:pt idx="914">
                  <c:v>-0.30883791290344198</c:v>
                </c:pt>
                <c:pt idx="915">
                  <c:v>1.51583875144822E-2</c:v>
                </c:pt>
                <c:pt idx="916">
                  <c:v>-0.162197126128861</c:v>
                </c:pt>
                <c:pt idx="917">
                  <c:v>0.19918110390275101</c:v>
                </c:pt>
                <c:pt idx="918">
                  <c:v>-0.151108604661117</c:v>
                </c:pt>
                <c:pt idx="919">
                  <c:v>4.1458018388817403E-3</c:v>
                </c:pt>
                <c:pt idx="920">
                  <c:v>0.104855543613186</c:v>
                </c:pt>
                <c:pt idx="921">
                  <c:v>-0.197453645800654</c:v>
                </c:pt>
                <c:pt idx="922">
                  <c:v>-0.210798661713824</c:v>
                </c:pt>
                <c:pt idx="923">
                  <c:v>-5.9418193497895802E-2</c:v>
                </c:pt>
                <c:pt idx="924">
                  <c:v>-8.1729645487770897E-2</c:v>
                </c:pt>
                <c:pt idx="925">
                  <c:v>-0.144897126340335</c:v>
                </c:pt>
                <c:pt idx="926">
                  <c:v>-0.15019847524431901</c:v>
                </c:pt>
                <c:pt idx="927">
                  <c:v>-0.102029564375234</c:v>
                </c:pt>
                <c:pt idx="928">
                  <c:v>-0.37041865153931602</c:v>
                </c:pt>
                <c:pt idx="929">
                  <c:v>-0.30971942415325299</c:v>
                </c:pt>
                <c:pt idx="930">
                  <c:v>0.14339800237028</c:v>
                </c:pt>
                <c:pt idx="931">
                  <c:v>-3.2544769917333301E-3</c:v>
                </c:pt>
                <c:pt idx="932">
                  <c:v>-0.157492827298015</c:v>
                </c:pt>
                <c:pt idx="933">
                  <c:v>-0.13483589324520801</c:v>
                </c:pt>
                <c:pt idx="934">
                  <c:v>0.31729103684516702</c:v>
                </c:pt>
                <c:pt idx="935">
                  <c:v>-0.228054665995434</c:v>
                </c:pt>
                <c:pt idx="936">
                  <c:v>0.143836127183742</c:v>
                </c:pt>
                <c:pt idx="937">
                  <c:v>7.5664050335135999E-3</c:v>
                </c:pt>
                <c:pt idx="938">
                  <c:v>-0.13248393076687001</c:v>
                </c:pt>
                <c:pt idx="939">
                  <c:v>-0.18124889460764701</c:v>
                </c:pt>
                <c:pt idx="940">
                  <c:v>7.9153360025115499E-2</c:v>
                </c:pt>
                <c:pt idx="941">
                  <c:v>0.14198975386833501</c:v>
                </c:pt>
                <c:pt idx="942">
                  <c:v>-0.719266483976297</c:v>
                </c:pt>
                <c:pt idx="943">
                  <c:v>-7.6529263219797403E-2</c:v>
                </c:pt>
                <c:pt idx="944">
                  <c:v>-0.45831120951973497</c:v>
                </c:pt>
                <c:pt idx="945">
                  <c:v>-0.41105782291876602</c:v>
                </c:pt>
                <c:pt idx="946">
                  <c:v>-0.27672876192717499</c:v>
                </c:pt>
                <c:pt idx="947">
                  <c:v>3.1985070607437098E-2</c:v>
                </c:pt>
                <c:pt idx="948">
                  <c:v>0.39589197727256997</c:v>
                </c:pt>
                <c:pt idx="949">
                  <c:v>-0.26056393347158102</c:v>
                </c:pt>
                <c:pt idx="950">
                  <c:v>-0.28096670536491702</c:v>
                </c:pt>
                <c:pt idx="951">
                  <c:v>7.8295624498885594E-2</c:v>
                </c:pt>
                <c:pt idx="952">
                  <c:v>-0.14178065031419201</c:v>
                </c:pt>
                <c:pt idx="953">
                  <c:v>-0.16558228909859099</c:v>
                </c:pt>
                <c:pt idx="954">
                  <c:v>0.21881182234532501</c:v>
                </c:pt>
                <c:pt idx="955">
                  <c:v>0.19029522087798301</c:v>
                </c:pt>
                <c:pt idx="956">
                  <c:v>0.52363808575176196</c:v>
                </c:pt>
                <c:pt idx="957">
                  <c:v>-0.41491488889837802</c:v>
                </c:pt>
                <c:pt idx="958">
                  <c:v>-0.47145464178213198</c:v>
                </c:pt>
                <c:pt idx="959">
                  <c:v>-0.30576716029103301</c:v>
                </c:pt>
                <c:pt idx="960">
                  <c:v>-0.222478087386556</c:v>
                </c:pt>
                <c:pt idx="961">
                  <c:v>0.13336536429728801</c:v>
                </c:pt>
                <c:pt idx="962">
                  <c:v>-0.150131660495813</c:v>
                </c:pt>
                <c:pt idx="963">
                  <c:v>-9.62863922696785E-2</c:v>
                </c:pt>
                <c:pt idx="964">
                  <c:v>0.10326085359687701</c:v>
                </c:pt>
                <c:pt idx="965">
                  <c:v>7.3780224723637503E-2</c:v>
                </c:pt>
                <c:pt idx="966">
                  <c:v>-8.0322054413098504E-2</c:v>
                </c:pt>
                <c:pt idx="967">
                  <c:v>-0.158920359128771</c:v>
                </c:pt>
                <c:pt idx="968">
                  <c:v>-0.64657137876881099</c:v>
                </c:pt>
                <c:pt idx="969">
                  <c:v>0.43329675125040301</c:v>
                </c:pt>
                <c:pt idx="970">
                  <c:v>-0.48308777121056101</c:v>
                </c:pt>
                <c:pt idx="971">
                  <c:v>-0.11617492385520101</c:v>
                </c:pt>
                <c:pt idx="972">
                  <c:v>-0.31051804078204698</c:v>
                </c:pt>
                <c:pt idx="973">
                  <c:v>-0.107202867606133</c:v>
                </c:pt>
                <c:pt idx="974">
                  <c:v>0.23155655118548299</c:v>
                </c:pt>
                <c:pt idx="975">
                  <c:v>0.106606525413815</c:v>
                </c:pt>
                <c:pt idx="976">
                  <c:v>-0.105382477804114</c:v>
                </c:pt>
                <c:pt idx="977">
                  <c:v>-0.419736122394889</c:v>
                </c:pt>
                <c:pt idx="978">
                  <c:v>0.14280357992718001</c:v>
                </c:pt>
                <c:pt idx="979">
                  <c:v>4.1769309058532399E-2</c:v>
                </c:pt>
                <c:pt idx="980">
                  <c:v>0.46550861856921599</c:v>
                </c:pt>
                <c:pt idx="981">
                  <c:v>-2.6823746872195901E-2</c:v>
                </c:pt>
                <c:pt idx="982">
                  <c:v>1.8929356747304001E-2</c:v>
                </c:pt>
                <c:pt idx="983">
                  <c:v>-0.20023437617505499</c:v>
                </c:pt>
                <c:pt idx="984">
                  <c:v>-0.40639619119093701</c:v>
                </c:pt>
              </c:numCache>
            </c:numRef>
          </c:xVal>
          <c:yVal>
            <c:numRef>
              <c:f>'Normal (2)'!$B$2:$B$986</c:f>
              <c:numCache>
                <c:formatCode>General</c:formatCode>
                <c:ptCount val="985"/>
                <c:pt idx="0">
                  <c:v>0.26572187156392302</c:v>
                </c:pt>
                <c:pt idx="1">
                  <c:v>1.18525750672185</c:v>
                </c:pt>
                <c:pt idx="2">
                  <c:v>1.98476345628291</c:v>
                </c:pt>
                <c:pt idx="3">
                  <c:v>2.3072533470357901</c:v>
                </c:pt>
                <c:pt idx="4">
                  <c:v>1.08105365903356</c:v>
                </c:pt>
                <c:pt idx="5">
                  <c:v>1.4780444456797599</c:v>
                </c:pt>
                <c:pt idx="6">
                  <c:v>1.8088342779300201E-2</c:v>
                </c:pt>
                <c:pt idx="7">
                  <c:v>0.75728710934737797</c:v>
                </c:pt>
                <c:pt idx="8">
                  <c:v>0.98248963116069399</c:v>
                </c:pt>
                <c:pt idx="9">
                  <c:v>0.88182020759226998</c:v>
                </c:pt>
                <c:pt idx="10">
                  <c:v>2.2672427368522499E-2</c:v>
                </c:pt>
                <c:pt idx="11">
                  <c:v>0.62282898352446103</c:v>
                </c:pt>
                <c:pt idx="12">
                  <c:v>0.70813674724570497</c:v>
                </c:pt>
                <c:pt idx="13">
                  <c:v>0.58498429512402506</c:v>
                </c:pt>
                <c:pt idx="14">
                  <c:v>1.16330466455645</c:v>
                </c:pt>
                <c:pt idx="15">
                  <c:v>0.30294262441562497</c:v>
                </c:pt>
                <c:pt idx="16">
                  <c:v>0.407077640602371</c:v>
                </c:pt>
                <c:pt idx="17">
                  <c:v>0.52694339562970405</c:v>
                </c:pt>
                <c:pt idx="18">
                  <c:v>0.63940444823076803</c:v>
                </c:pt>
                <c:pt idx="19">
                  <c:v>0.16781623234026399</c:v>
                </c:pt>
                <c:pt idx="20">
                  <c:v>5.8689332916415898E-2</c:v>
                </c:pt>
                <c:pt idx="21">
                  <c:v>0.216857753357279</c:v>
                </c:pt>
                <c:pt idx="22">
                  <c:v>1.01301262456408</c:v>
                </c:pt>
                <c:pt idx="23">
                  <c:v>0.235444528910735</c:v>
                </c:pt>
                <c:pt idx="24">
                  <c:v>0.66386624267626304</c:v>
                </c:pt>
                <c:pt idx="25">
                  <c:v>0.44821287125027498</c:v>
                </c:pt>
                <c:pt idx="26">
                  <c:v>0.79609407230802198</c:v>
                </c:pt>
                <c:pt idx="27">
                  <c:v>0.85064785542296295</c:v>
                </c:pt>
                <c:pt idx="28">
                  <c:v>2.0279459426863098</c:v>
                </c:pt>
                <c:pt idx="29">
                  <c:v>0.173159216735295</c:v>
                </c:pt>
                <c:pt idx="30">
                  <c:v>0.38832894374525401</c:v>
                </c:pt>
                <c:pt idx="31">
                  <c:v>2.44885506721885</c:v>
                </c:pt>
                <c:pt idx="32">
                  <c:v>0.29854842814072602</c:v>
                </c:pt>
                <c:pt idx="33">
                  <c:v>1.36315840128748</c:v>
                </c:pt>
                <c:pt idx="34">
                  <c:v>1.9391278640502101</c:v>
                </c:pt>
                <c:pt idx="35">
                  <c:v>0.79307754892299898</c:v>
                </c:pt>
                <c:pt idx="36">
                  <c:v>1.95786567866664</c:v>
                </c:pt>
                <c:pt idx="37">
                  <c:v>1.62177201994572</c:v>
                </c:pt>
                <c:pt idx="38">
                  <c:v>1.25159482874179</c:v>
                </c:pt>
                <c:pt idx="39">
                  <c:v>0.93473788802374302</c:v>
                </c:pt>
                <c:pt idx="40">
                  <c:v>0.96161012157637504</c:v>
                </c:pt>
                <c:pt idx="41">
                  <c:v>0.248129221943512</c:v>
                </c:pt>
                <c:pt idx="42">
                  <c:v>0.96161012157637504</c:v>
                </c:pt>
                <c:pt idx="43">
                  <c:v>0.96161012157637504</c:v>
                </c:pt>
                <c:pt idx="44">
                  <c:v>1.2447280671324601</c:v>
                </c:pt>
                <c:pt idx="45">
                  <c:v>1.2447280671324601</c:v>
                </c:pt>
                <c:pt idx="46">
                  <c:v>0.96161012157637504</c:v>
                </c:pt>
                <c:pt idx="47">
                  <c:v>1.6862260105281</c:v>
                </c:pt>
                <c:pt idx="48">
                  <c:v>1.21293888309006E-2</c:v>
                </c:pt>
                <c:pt idx="49">
                  <c:v>0.73624490416210198</c:v>
                </c:pt>
                <c:pt idx="50">
                  <c:v>1.30565688662611</c:v>
                </c:pt>
                <c:pt idx="51">
                  <c:v>0.69014953976281002</c:v>
                </c:pt>
                <c:pt idx="52">
                  <c:v>0.53179854106703195</c:v>
                </c:pt>
                <c:pt idx="53">
                  <c:v>0.88298141504507299</c:v>
                </c:pt>
                <c:pt idx="54">
                  <c:v>9.1120915863752094E-2</c:v>
                </c:pt>
                <c:pt idx="55">
                  <c:v>1.0767343040519399</c:v>
                </c:pt>
                <c:pt idx="56">
                  <c:v>0.45101192712032001</c:v>
                </c:pt>
                <c:pt idx="57">
                  <c:v>1.3752950856825501</c:v>
                </c:pt>
                <c:pt idx="58">
                  <c:v>0.378492117000997</c:v>
                </c:pt>
                <c:pt idx="59">
                  <c:v>0.62686190119860496</c:v>
                </c:pt>
                <c:pt idx="60">
                  <c:v>0.41287576709027102</c:v>
                </c:pt>
                <c:pt idx="61">
                  <c:v>0.82827699981365499</c:v>
                </c:pt>
                <c:pt idx="62">
                  <c:v>0.64180754984225796</c:v>
                </c:pt>
                <c:pt idx="63">
                  <c:v>1.34339079841352</c:v>
                </c:pt>
                <c:pt idx="64">
                  <c:v>0.97290454052462205</c:v>
                </c:pt>
                <c:pt idx="65">
                  <c:v>0.740274442867913</c:v>
                </c:pt>
                <c:pt idx="66">
                  <c:v>0.45101192712032001</c:v>
                </c:pt>
                <c:pt idx="67">
                  <c:v>0.26372681764192701</c:v>
                </c:pt>
                <c:pt idx="68">
                  <c:v>1.02190087511344</c:v>
                </c:pt>
                <c:pt idx="69">
                  <c:v>0.37516580483227702</c:v>
                </c:pt>
                <c:pt idx="70">
                  <c:v>0.55557804835656799</c:v>
                </c:pt>
                <c:pt idx="71">
                  <c:v>1.9995554690499999</c:v>
                </c:pt>
                <c:pt idx="72">
                  <c:v>1.18525750672185</c:v>
                </c:pt>
                <c:pt idx="73">
                  <c:v>1.0349257552744</c:v>
                </c:pt>
                <c:pt idx="74">
                  <c:v>1.3457187646347599</c:v>
                </c:pt>
                <c:pt idx="75">
                  <c:v>1.0499110042431501</c:v>
                </c:pt>
                <c:pt idx="76">
                  <c:v>0.38858198196767801</c:v>
                </c:pt>
                <c:pt idx="77">
                  <c:v>0.33814051262210798</c:v>
                </c:pt>
                <c:pt idx="78">
                  <c:v>0.33661465875753699</c:v>
                </c:pt>
                <c:pt idx="79">
                  <c:v>0.42774232559588499</c:v>
                </c:pt>
                <c:pt idx="80">
                  <c:v>0.15672927224046199</c:v>
                </c:pt>
                <c:pt idx="81">
                  <c:v>2.26780845296665</c:v>
                </c:pt>
                <c:pt idx="82">
                  <c:v>1.2194594931871501</c:v>
                </c:pt>
                <c:pt idx="83">
                  <c:v>1.8009643929993799</c:v>
                </c:pt>
                <c:pt idx="84">
                  <c:v>1.1307175939793399</c:v>
                </c:pt>
                <c:pt idx="85">
                  <c:v>0.19310256501168799</c:v>
                </c:pt>
                <c:pt idx="86">
                  <c:v>3.9195826370565602E-2</c:v>
                </c:pt>
                <c:pt idx="87">
                  <c:v>1.4162125354836299</c:v>
                </c:pt>
                <c:pt idx="88">
                  <c:v>1.50825979963028</c:v>
                </c:pt>
                <c:pt idx="89">
                  <c:v>1.80114254325929</c:v>
                </c:pt>
                <c:pt idx="90">
                  <c:v>0.27501948013024302</c:v>
                </c:pt>
                <c:pt idx="91">
                  <c:v>0.42926297849150102</c:v>
                </c:pt>
                <c:pt idx="92">
                  <c:v>0.77200393348914997</c:v>
                </c:pt>
                <c:pt idx="93">
                  <c:v>1.73780450628921</c:v>
                </c:pt>
                <c:pt idx="94">
                  <c:v>0.224021337117424</c:v>
                </c:pt>
                <c:pt idx="95">
                  <c:v>0.379110542869384</c:v>
                </c:pt>
                <c:pt idx="96">
                  <c:v>0.53001495720254599</c:v>
                </c:pt>
                <c:pt idx="97">
                  <c:v>1.50825979963028</c:v>
                </c:pt>
                <c:pt idx="98">
                  <c:v>0.45101192712032001</c:v>
                </c:pt>
                <c:pt idx="99">
                  <c:v>0.90593176287071997</c:v>
                </c:pt>
                <c:pt idx="100">
                  <c:v>1.17675592412069</c:v>
                </c:pt>
                <c:pt idx="101">
                  <c:v>0.54183026736092199</c:v>
                </c:pt>
                <c:pt idx="102">
                  <c:v>1.39694709665571</c:v>
                </c:pt>
                <c:pt idx="103">
                  <c:v>0.49083939078170602</c:v>
                </c:pt>
                <c:pt idx="104">
                  <c:v>1.72840995094329</c:v>
                </c:pt>
                <c:pt idx="105">
                  <c:v>0.44401778879765502</c:v>
                </c:pt>
                <c:pt idx="106">
                  <c:v>1.37787708005972</c:v>
                </c:pt>
                <c:pt idx="107">
                  <c:v>2.4880613527506599</c:v>
                </c:pt>
                <c:pt idx="108">
                  <c:v>0.60374619299158605</c:v>
                </c:pt>
                <c:pt idx="109">
                  <c:v>2.3157518399205701</c:v>
                </c:pt>
                <c:pt idx="110">
                  <c:v>1.6842343073757899</c:v>
                </c:pt>
                <c:pt idx="111">
                  <c:v>0.89762320310211996</c:v>
                </c:pt>
                <c:pt idx="112">
                  <c:v>5.8689332916415898E-2</c:v>
                </c:pt>
                <c:pt idx="113">
                  <c:v>0.97327084247204898</c:v>
                </c:pt>
                <c:pt idx="114">
                  <c:v>1.2800455359934799</c:v>
                </c:pt>
                <c:pt idx="115">
                  <c:v>5.9034969908997099E-2</c:v>
                </c:pt>
                <c:pt idx="116">
                  <c:v>0.418002641512288</c:v>
                </c:pt>
                <c:pt idx="117">
                  <c:v>1.7843754407150501</c:v>
                </c:pt>
                <c:pt idx="118">
                  <c:v>0.40389663591292202</c:v>
                </c:pt>
                <c:pt idx="119">
                  <c:v>0.62200152574193701</c:v>
                </c:pt>
                <c:pt idx="120">
                  <c:v>0.76556043422584497</c:v>
                </c:pt>
                <c:pt idx="121">
                  <c:v>1.4470613289043699</c:v>
                </c:pt>
                <c:pt idx="122">
                  <c:v>1.0249816317524501</c:v>
                </c:pt>
                <c:pt idx="123">
                  <c:v>0.424635258999354</c:v>
                </c:pt>
                <c:pt idx="124">
                  <c:v>0.30770430491920903</c:v>
                </c:pt>
                <c:pt idx="125">
                  <c:v>0.13478231562586501</c:v>
                </c:pt>
                <c:pt idx="126">
                  <c:v>0.57885594545715702</c:v>
                </c:pt>
                <c:pt idx="127">
                  <c:v>1.3522048071789501</c:v>
                </c:pt>
                <c:pt idx="128">
                  <c:v>0.90988250767058498</c:v>
                </c:pt>
                <c:pt idx="129">
                  <c:v>1.0754511137889899</c:v>
                </c:pt>
                <c:pt idx="130">
                  <c:v>0.14447719500182399</c:v>
                </c:pt>
                <c:pt idx="131">
                  <c:v>0.36261382152338001</c:v>
                </c:pt>
                <c:pt idx="132">
                  <c:v>0.91628158649904001</c:v>
                </c:pt>
                <c:pt idx="133">
                  <c:v>1.1076095178790299</c:v>
                </c:pt>
                <c:pt idx="134">
                  <c:v>0.23066821413896799</c:v>
                </c:pt>
                <c:pt idx="135">
                  <c:v>0.26620702845925898</c:v>
                </c:pt>
                <c:pt idx="136">
                  <c:v>0.95456716452887003</c:v>
                </c:pt>
                <c:pt idx="137">
                  <c:v>2.3296163429557399</c:v>
                </c:pt>
                <c:pt idx="138">
                  <c:v>2.1234407889472098</c:v>
                </c:pt>
                <c:pt idx="139">
                  <c:v>0.76450089705306501</c:v>
                </c:pt>
                <c:pt idx="140">
                  <c:v>0.24458461935093101</c:v>
                </c:pt>
                <c:pt idx="141">
                  <c:v>8.8518483375471496E-2</c:v>
                </c:pt>
                <c:pt idx="142">
                  <c:v>0.18915718332425099</c:v>
                </c:pt>
                <c:pt idx="143">
                  <c:v>1.9103746611226999</c:v>
                </c:pt>
                <c:pt idx="144">
                  <c:v>1.16330466455645</c:v>
                </c:pt>
                <c:pt idx="145">
                  <c:v>0.85634667827434197</c:v>
                </c:pt>
                <c:pt idx="146">
                  <c:v>1.6988724824768699</c:v>
                </c:pt>
                <c:pt idx="147">
                  <c:v>0.62661338288900303</c:v>
                </c:pt>
                <c:pt idx="148">
                  <c:v>0.15425951010063199</c:v>
                </c:pt>
                <c:pt idx="149">
                  <c:v>0.10751997239326</c:v>
                </c:pt>
                <c:pt idx="150">
                  <c:v>4.2168055916841203E-2</c:v>
                </c:pt>
                <c:pt idx="151">
                  <c:v>0.44541533851237602</c:v>
                </c:pt>
                <c:pt idx="152">
                  <c:v>0.44541533851237602</c:v>
                </c:pt>
                <c:pt idx="153">
                  <c:v>0.96452666558752598</c:v>
                </c:pt>
                <c:pt idx="154">
                  <c:v>0.32033748274978102</c:v>
                </c:pt>
                <c:pt idx="155">
                  <c:v>0.32033748274978102</c:v>
                </c:pt>
                <c:pt idx="156">
                  <c:v>0.28816113735375098</c:v>
                </c:pt>
                <c:pt idx="157">
                  <c:v>0.3925035658578</c:v>
                </c:pt>
                <c:pt idx="158">
                  <c:v>0.74028255914145902</c:v>
                </c:pt>
                <c:pt idx="159">
                  <c:v>0.487624221315346</c:v>
                </c:pt>
                <c:pt idx="160">
                  <c:v>0.3925035658578</c:v>
                </c:pt>
                <c:pt idx="161">
                  <c:v>0.36336284260976998</c:v>
                </c:pt>
                <c:pt idx="162">
                  <c:v>0.377914934755615</c:v>
                </c:pt>
                <c:pt idx="163">
                  <c:v>0.780742170070851</c:v>
                </c:pt>
                <c:pt idx="164">
                  <c:v>0.117490271986675</c:v>
                </c:pt>
                <c:pt idx="165">
                  <c:v>0.93473788802374302</c:v>
                </c:pt>
                <c:pt idx="166">
                  <c:v>0.36124656706976299</c:v>
                </c:pt>
                <c:pt idx="167">
                  <c:v>1.6131137338318799</c:v>
                </c:pt>
                <c:pt idx="168">
                  <c:v>3.5391159933811103E-2</c:v>
                </c:pt>
                <c:pt idx="169">
                  <c:v>0.58177148760818098</c:v>
                </c:pt>
                <c:pt idx="170">
                  <c:v>0.29475454244717098</c:v>
                </c:pt>
                <c:pt idx="171">
                  <c:v>0.80866817585966599</c:v>
                </c:pt>
                <c:pt idx="172">
                  <c:v>0.66102314758276004</c:v>
                </c:pt>
                <c:pt idx="173">
                  <c:v>1.07562036194533</c:v>
                </c:pt>
                <c:pt idx="174">
                  <c:v>1.42538655305455</c:v>
                </c:pt>
                <c:pt idx="175">
                  <c:v>4.2168055916841203E-2</c:v>
                </c:pt>
                <c:pt idx="176">
                  <c:v>2.4880613527506599</c:v>
                </c:pt>
                <c:pt idx="177">
                  <c:v>0.54073325787284199</c:v>
                </c:pt>
                <c:pt idx="178">
                  <c:v>7.9773682658733497E-2</c:v>
                </c:pt>
                <c:pt idx="179">
                  <c:v>1.3300347216753201</c:v>
                </c:pt>
                <c:pt idx="180">
                  <c:v>0.80496372133421501</c:v>
                </c:pt>
                <c:pt idx="181">
                  <c:v>0.81658726891741595</c:v>
                </c:pt>
                <c:pt idx="182">
                  <c:v>0.40857595245601203</c:v>
                </c:pt>
                <c:pt idx="183">
                  <c:v>0.23893217791337201</c:v>
                </c:pt>
                <c:pt idx="184">
                  <c:v>0.41320339665954697</c:v>
                </c:pt>
                <c:pt idx="185">
                  <c:v>0.16591115015330499</c:v>
                </c:pt>
                <c:pt idx="186">
                  <c:v>1.73780450628921</c:v>
                </c:pt>
                <c:pt idx="187">
                  <c:v>1.4162125354836299</c:v>
                </c:pt>
                <c:pt idx="188">
                  <c:v>0.17627268428730999</c:v>
                </c:pt>
                <c:pt idx="189">
                  <c:v>1.29266990973009</c:v>
                </c:pt>
                <c:pt idx="190">
                  <c:v>1.5549879716699699</c:v>
                </c:pt>
                <c:pt idx="191">
                  <c:v>0.54452543909431605</c:v>
                </c:pt>
                <c:pt idx="192">
                  <c:v>1.4760519230731901</c:v>
                </c:pt>
                <c:pt idx="193">
                  <c:v>1.4862358735541401</c:v>
                </c:pt>
                <c:pt idx="194">
                  <c:v>0.56407384737089405</c:v>
                </c:pt>
                <c:pt idx="195">
                  <c:v>8.4706147012307401E-2</c:v>
                </c:pt>
                <c:pt idx="196">
                  <c:v>3.26742977933717E-2</c:v>
                </c:pt>
                <c:pt idx="197">
                  <c:v>0.244387048510851</c:v>
                </c:pt>
                <c:pt idx="198">
                  <c:v>1.41722324342342</c:v>
                </c:pt>
                <c:pt idx="199">
                  <c:v>0.54354485962302301</c:v>
                </c:pt>
                <c:pt idx="200">
                  <c:v>0.54354485962302301</c:v>
                </c:pt>
                <c:pt idx="201">
                  <c:v>1.21676274263481</c:v>
                </c:pt>
                <c:pt idx="202">
                  <c:v>1.21676274263481</c:v>
                </c:pt>
                <c:pt idx="203">
                  <c:v>1.21676274263481</c:v>
                </c:pt>
                <c:pt idx="204">
                  <c:v>0.72939944822912695</c:v>
                </c:pt>
                <c:pt idx="205">
                  <c:v>0.72939944822912695</c:v>
                </c:pt>
                <c:pt idx="206">
                  <c:v>1.6878558563308399</c:v>
                </c:pt>
                <c:pt idx="207">
                  <c:v>1.6878558563308399</c:v>
                </c:pt>
                <c:pt idx="208">
                  <c:v>1.0877326952411299</c:v>
                </c:pt>
                <c:pt idx="209">
                  <c:v>1.0877326952411299</c:v>
                </c:pt>
                <c:pt idx="210">
                  <c:v>0.722542871212696</c:v>
                </c:pt>
                <c:pt idx="211">
                  <c:v>1.1502369835417401</c:v>
                </c:pt>
                <c:pt idx="212">
                  <c:v>1.1502369835417401</c:v>
                </c:pt>
                <c:pt idx="213">
                  <c:v>0.15672927224046199</c:v>
                </c:pt>
                <c:pt idx="214">
                  <c:v>0.54210494980227097</c:v>
                </c:pt>
                <c:pt idx="215">
                  <c:v>0.62804197424609398</c:v>
                </c:pt>
                <c:pt idx="216">
                  <c:v>0.669684665658145</c:v>
                </c:pt>
                <c:pt idx="217">
                  <c:v>2.26780845296665</c:v>
                </c:pt>
                <c:pt idx="218">
                  <c:v>0.69196830535362297</c:v>
                </c:pt>
                <c:pt idx="219">
                  <c:v>0.73411235846087697</c:v>
                </c:pt>
                <c:pt idx="220">
                  <c:v>1.9894473442546801</c:v>
                </c:pt>
                <c:pt idx="221">
                  <c:v>5.1513646897299301E-2</c:v>
                </c:pt>
                <c:pt idx="222">
                  <c:v>1.90756315921436</c:v>
                </c:pt>
                <c:pt idx="223">
                  <c:v>0.62565701862280498</c:v>
                </c:pt>
                <c:pt idx="224">
                  <c:v>0.67090323105132899</c:v>
                </c:pt>
                <c:pt idx="225">
                  <c:v>1.19987131560036E-2</c:v>
                </c:pt>
                <c:pt idx="226">
                  <c:v>1.45511697829137</c:v>
                </c:pt>
                <c:pt idx="227">
                  <c:v>1.3404859851768101</c:v>
                </c:pt>
                <c:pt idx="228">
                  <c:v>1.47143316658005</c:v>
                </c:pt>
                <c:pt idx="229">
                  <c:v>0.65329908590268804</c:v>
                </c:pt>
                <c:pt idx="230">
                  <c:v>0.41682713652637399</c:v>
                </c:pt>
                <c:pt idx="231">
                  <c:v>1.0233459229477899</c:v>
                </c:pt>
                <c:pt idx="232">
                  <c:v>0.15671657307793099</c:v>
                </c:pt>
                <c:pt idx="233">
                  <c:v>0.62413354916501496</c:v>
                </c:pt>
                <c:pt idx="234">
                  <c:v>0.98009461881155202</c:v>
                </c:pt>
                <c:pt idx="235">
                  <c:v>0.76135799586117903</c:v>
                </c:pt>
                <c:pt idx="236">
                  <c:v>0.105507078048651</c:v>
                </c:pt>
                <c:pt idx="237">
                  <c:v>0.159538738456343</c:v>
                </c:pt>
                <c:pt idx="238">
                  <c:v>0.44092298767187899</c:v>
                </c:pt>
                <c:pt idx="239">
                  <c:v>0.85363865746071099</c:v>
                </c:pt>
                <c:pt idx="240">
                  <c:v>0.88062969197513496</c:v>
                </c:pt>
                <c:pt idx="241">
                  <c:v>2.26221039921163E-2</c:v>
                </c:pt>
                <c:pt idx="242">
                  <c:v>0.35549035291283498</c:v>
                </c:pt>
                <c:pt idx="243">
                  <c:v>0.167267859812961</c:v>
                </c:pt>
                <c:pt idx="244">
                  <c:v>0.126038790757772</c:v>
                </c:pt>
                <c:pt idx="245">
                  <c:v>0.67209126593606305</c:v>
                </c:pt>
                <c:pt idx="246">
                  <c:v>0.11328832723705599</c:v>
                </c:pt>
                <c:pt idx="247">
                  <c:v>1.14137395023468</c:v>
                </c:pt>
                <c:pt idx="248">
                  <c:v>8.0588957226977904E-3</c:v>
                </c:pt>
                <c:pt idx="249">
                  <c:v>0.212946145781895</c:v>
                </c:pt>
                <c:pt idx="250">
                  <c:v>0.34971641106462198</c:v>
                </c:pt>
                <c:pt idx="251">
                  <c:v>0.98086492018093097</c:v>
                </c:pt>
                <c:pt idx="252">
                  <c:v>0.150538740815331</c:v>
                </c:pt>
                <c:pt idx="253">
                  <c:v>0.301653303937154</c:v>
                </c:pt>
                <c:pt idx="254">
                  <c:v>2.10472907711637</c:v>
                </c:pt>
                <c:pt idx="255">
                  <c:v>0.78192565430434402</c:v>
                </c:pt>
                <c:pt idx="256">
                  <c:v>0.29704223956831399</c:v>
                </c:pt>
                <c:pt idx="257">
                  <c:v>1.2599372649820699</c:v>
                </c:pt>
                <c:pt idx="258">
                  <c:v>0.57034460897785999</c:v>
                </c:pt>
                <c:pt idx="259">
                  <c:v>0.97252330967070699</c:v>
                </c:pt>
                <c:pt idx="260">
                  <c:v>0.54770224897057196</c:v>
                </c:pt>
                <c:pt idx="261">
                  <c:v>1.3363657449894599</c:v>
                </c:pt>
                <c:pt idx="262">
                  <c:v>3.52461238098375E-2</c:v>
                </c:pt>
                <c:pt idx="263">
                  <c:v>0.87824775709599601</c:v>
                </c:pt>
                <c:pt idx="264">
                  <c:v>1.45588331960902</c:v>
                </c:pt>
                <c:pt idx="265">
                  <c:v>0.40523021988376501</c:v>
                </c:pt>
                <c:pt idx="266">
                  <c:v>1.94638515519577</c:v>
                </c:pt>
                <c:pt idx="267">
                  <c:v>0.126038790757772</c:v>
                </c:pt>
                <c:pt idx="268">
                  <c:v>1.4244178491033299</c:v>
                </c:pt>
                <c:pt idx="269">
                  <c:v>0.19310483632047601</c:v>
                </c:pt>
                <c:pt idx="270">
                  <c:v>0.91751805785303797</c:v>
                </c:pt>
                <c:pt idx="271">
                  <c:v>0.52022791891751197</c:v>
                </c:pt>
                <c:pt idx="272">
                  <c:v>1.4308762407434401</c:v>
                </c:pt>
                <c:pt idx="273">
                  <c:v>0.72459641039771805</c:v>
                </c:pt>
                <c:pt idx="274">
                  <c:v>1.2533661633917399</c:v>
                </c:pt>
                <c:pt idx="275">
                  <c:v>0.43123135616417302</c:v>
                </c:pt>
                <c:pt idx="276">
                  <c:v>1.06765714090465</c:v>
                </c:pt>
                <c:pt idx="277">
                  <c:v>0.30627273488297502</c:v>
                </c:pt>
                <c:pt idx="278">
                  <c:v>0.66176984906300096</c:v>
                </c:pt>
                <c:pt idx="279">
                  <c:v>0.25610509277900201</c:v>
                </c:pt>
                <c:pt idx="280">
                  <c:v>0.26756915742385701</c:v>
                </c:pt>
                <c:pt idx="281">
                  <c:v>1.2969385029749001</c:v>
                </c:pt>
                <c:pt idx="282">
                  <c:v>1.8600700132414101</c:v>
                </c:pt>
                <c:pt idx="283">
                  <c:v>0.21075681791542999</c:v>
                </c:pt>
                <c:pt idx="284">
                  <c:v>0.61721553695712295</c:v>
                </c:pt>
                <c:pt idx="285">
                  <c:v>0.65524715196852001</c:v>
                </c:pt>
                <c:pt idx="286">
                  <c:v>1.5312573110850001</c:v>
                </c:pt>
                <c:pt idx="287">
                  <c:v>0.56591855100628596</c:v>
                </c:pt>
                <c:pt idx="288">
                  <c:v>2.0226748060519402</c:v>
                </c:pt>
                <c:pt idx="289">
                  <c:v>0.84590729126069597</c:v>
                </c:pt>
                <c:pt idx="290">
                  <c:v>0.89940235795050305</c:v>
                </c:pt>
                <c:pt idx="291">
                  <c:v>1.87315915000811</c:v>
                </c:pt>
                <c:pt idx="292">
                  <c:v>0.70683943549114203</c:v>
                </c:pt>
                <c:pt idx="293">
                  <c:v>1.8387792905562801</c:v>
                </c:pt>
                <c:pt idx="294">
                  <c:v>0.183091330730908</c:v>
                </c:pt>
                <c:pt idx="295">
                  <c:v>1.0743116446007299</c:v>
                </c:pt>
                <c:pt idx="296">
                  <c:v>2.41502524777012</c:v>
                </c:pt>
                <c:pt idx="297">
                  <c:v>4.5315856917487803E-2</c:v>
                </c:pt>
                <c:pt idx="298">
                  <c:v>1.49903038771695</c:v>
                </c:pt>
                <c:pt idx="299">
                  <c:v>4.2860997829704303E-2</c:v>
                </c:pt>
                <c:pt idx="300">
                  <c:v>1.5940998021508901</c:v>
                </c:pt>
                <c:pt idx="301">
                  <c:v>1.1266579678153901</c:v>
                </c:pt>
                <c:pt idx="302">
                  <c:v>0.132762870691156</c:v>
                </c:pt>
                <c:pt idx="303">
                  <c:v>1.7699781927095399</c:v>
                </c:pt>
                <c:pt idx="304">
                  <c:v>2.00415429356643</c:v>
                </c:pt>
                <c:pt idx="305">
                  <c:v>0.78423475684375299</c:v>
                </c:pt>
                <c:pt idx="306">
                  <c:v>0.56895367382317796</c:v>
                </c:pt>
                <c:pt idx="307">
                  <c:v>1.87754833121592</c:v>
                </c:pt>
                <c:pt idx="308">
                  <c:v>8.9143948836221204E-2</c:v>
                </c:pt>
                <c:pt idx="309">
                  <c:v>1.38047836861049</c:v>
                </c:pt>
                <c:pt idx="310">
                  <c:v>0.89940235795050305</c:v>
                </c:pt>
                <c:pt idx="311">
                  <c:v>1.6413203614623499</c:v>
                </c:pt>
                <c:pt idx="312">
                  <c:v>0.98086492018093097</c:v>
                </c:pt>
                <c:pt idx="313">
                  <c:v>0.82213247110787702</c:v>
                </c:pt>
                <c:pt idx="314">
                  <c:v>0.612468600478143</c:v>
                </c:pt>
                <c:pt idx="315">
                  <c:v>9.6157321663495596E-2</c:v>
                </c:pt>
                <c:pt idx="316">
                  <c:v>1.8555597623090001</c:v>
                </c:pt>
                <c:pt idx="317">
                  <c:v>0.48133744137270701</c:v>
                </c:pt>
                <c:pt idx="318">
                  <c:v>0.404919412631708</c:v>
                </c:pt>
                <c:pt idx="319">
                  <c:v>0.13576389747086101</c:v>
                </c:pt>
                <c:pt idx="320">
                  <c:v>0.29342157621635501</c:v>
                </c:pt>
                <c:pt idx="321">
                  <c:v>4.1511932817210703E-2</c:v>
                </c:pt>
                <c:pt idx="322">
                  <c:v>1.9920936473048001</c:v>
                </c:pt>
                <c:pt idx="323">
                  <c:v>2.0226748060519402</c:v>
                </c:pt>
                <c:pt idx="324">
                  <c:v>0.38464446345126402</c:v>
                </c:pt>
                <c:pt idx="325">
                  <c:v>0.10813726659521899</c:v>
                </c:pt>
                <c:pt idx="326">
                  <c:v>0.23216075036400699</c:v>
                </c:pt>
                <c:pt idx="327">
                  <c:v>1.83096509285034</c:v>
                </c:pt>
                <c:pt idx="328">
                  <c:v>0.366706079463679</c:v>
                </c:pt>
                <c:pt idx="329">
                  <c:v>2.26221039921163E-2</c:v>
                </c:pt>
                <c:pt idx="330">
                  <c:v>1.1018528932504901</c:v>
                </c:pt>
                <c:pt idx="331">
                  <c:v>0.53630644705150099</c:v>
                </c:pt>
                <c:pt idx="332">
                  <c:v>0.99803404369312698</c:v>
                </c:pt>
                <c:pt idx="333">
                  <c:v>1.5663321788940801</c:v>
                </c:pt>
                <c:pt idx="334">
                  <c:v>1.26992755873514</c:v>
                </c:pt>
                <c:pt idx="335">
                  <c:v>1.8510172485231902E-2</c:v>
                </c:pt>
                <c:pt idx="336">
                  <c:v>0.40769607954949599</c:v>
                </c:pt>
                <c:pt idx="337">
                  <c:v>0.88713464962712696</c:v>
                </c:pt>
                <c:pt idx="338">
                  <c:v>0.12828833246935401</c:v>
                </c:pt>
                <c:pt idx="339">
                  <c:v>0.19800879837023899</c:v>
                </c:pt>
                <c:pt idx="340">
                  <c:v>0.48422713027415998</c:v>
                </c:pt>
                <c:pt idx="341">
                  <c:v>8.3190845619363005E-2</c:v>
                </c:pt>
                <c:pt idx="342">
                  <c:v>0.17335234548054401</c:v>
                </c:pt>
                <c:pt idx="343">
                  <c:v>8.8606565778607996E-2</c:v>
                </c:pt>
                <c:pt idx="344">
                  <c:v>0.65567708985420403</c:v>
                </c:pt>
                <c:pt idx="345">
                  <c:v>7.9598500207266304E-2</c:v>
                </c:pt>
                <c:pt idx="346">
                  <c:v>0.28257180340829302</c:v>
                </c:pt>
                <c:pt idx="347">
                  <c:v>0.152681022624019</c:v>
                </c:pt>
                <c:pt idx="348">
                  <c:v>1.5247844157305499</c:v>
                </c:pt>
                <c:pt idx="349">
                  <c:v>0.15893361757475899</c:v>
                </c:pt>
                <c:pt idx="350">
                  <c:v>0.64133402032035103</c:v>
                </c:pt>
                <c:pt idx="351">
                  <c:v>2.3095720402936002</c:v>
                </c:pt>
                <c:pt idx="352">
                  <c:v>0.92667171726507103</c:v>
                </c:pt>
                <c:pt idx="353">
                  <c:v>0.144197040673161</c:v>
                </c:pt>
                <c:pt idx="354">
                  <c:v>2.1285378762885299</c:v>
                </c:pt>
                <c:pt idx="355">
                  <c:v>8.0588957226977904E-3</c:v>
                </c:pt>
                <c:pt idx="356">
                  <c:v>1.41067031452042</c:v>
                </c:pt>
                <c:pt idx="357">
                  <c:v>0.68697365948719802</c:v>
                </c:pt>
                <c:pt idx="358">
                  <c:v>0.89740030359230305</c:v>
                </c:pt>
                <c:pt idx="359">
                  <c:v>0.88062969197513496</c:v>
                </c:pt>
                <c:pt idx="360">
                  <c:v>0.58595250651287401</c:v>
                </c:pt>
                <c:pt idx="361">
                  <c:v>0.13639722711260199</c:v>
                </c:pt>
                <c:pt idx="362">
                  <c:v>0.61831180084351001</c:v>
                </c:pt>
                <c:pt idx="363">
                  <c:v>0.77413302697002495</c:v>
                </c:pt>
                <c:pt idx="364">
                  <c:v>0.43744181087030598</c:v>
                </c:pt>
                <c:pt idx="365">
                  <c:v>1.2577974233637199</c:v>
                </c:pt>
                <c:pt idx="366">
                  <c:v>1.74027696602432</c:v>
                </c:pt>
                <c:pt idx="367">
                  <c:v>1.17269043876812E-3</c:v>
                </c:pt>
                <c:pt idx="368">
                  <c:v>0.70582041733050704</c:v>
                </c:pt>
                <c:pt idx="369">
                  <c:v>4.1356481279443497E-2</c:v>
                </c:pt>
                <c:pt idx="370">
                  <c:v>0.41531815327032801</c:v>
                </c:pt>
                <c:pt idx="371">
                  <c:v>1.45511697829137</c:v>
                </c:pt>
                <c:pt idx="372">
                  <c:v>0.88062969197513496</c:v>
                </c:pt>
                <c:pt idx="373">
                  <c:v>1.3404859851768101</c:v>
                </c:pt>
                <c:pt idx="374">
                  <c:v>0.686210219085433</c:v>
                </c:pt>
                <c:pt idx="375">
                  <c:v>0.16162428750389399</c:v>
                </c:pt>
                <c:pt idx="376">
                  <c:v>1.29101831563106</c:v>
                </c:pt>
                <c:pt idx="377">
                  <c:v>0.75067826552947703</c:v>
                </c:pt>
                <c:pt idx="378">
                  <c:v>0.223521277427775</c:v>
                </c:pt>
                <c:pt idx="379">
                  <c:v>1.2134865384015501</c:v>
                </c:pt>
                <c:pt idx="380">
                  <c:v>0.67253670771115504</c:v>
                </c:pt>
                <c:pt idx="381">
                  <c:v>0.789799432668153</c:v>
                </c:pt>
                <c:pt idx="382">
                  <c:v>1.6448614744071799</c:v>
                </c:pt>
                <c:pt idx="383">
                  <c:v>0.368010765872052</c:v>
                </c:pt>
                <c:pt idx="384">
                  <c:v>1.2305883773086601</c:v>
                </c:pt>
                <c:pt idx="385">
                  <c:v>1.2413346757958199</c:v>
                </c:pt>
                <c:pt idx="386">
                  <c:v>0.223686433986345</c:v>
                </c:pt>
                <c:pt idx="387">
                  <c:v>0.75496148344698499</c:v>
                </c:pt>
                <c:pt idx="388">
                  <c:v>0.75487027905955995</c:v>
                </c:pt>
                <c:pt idx="389">
                  <c:v>2.2452157699220199</c:v>
                </c:pt>
                <c:pt idx="390">
                  <c:v>2.2452157699220199</c:v>
                </c:pt>
                <c:pt idx="391">
                  <c:v>1.9087161696372801</c:v>
                </c:pt>
                <c:pt idx="392">
                  <c:v>1.9087161696372801</c:v>
                </c:pt>
                <c:pt idx="393">
                  <c:v>1.7319011029722</c:v>
                </c:pt>
                <c:pt idx="394">
                  <c:v>1.7319011029722</c:v>
                </c:pt>
                <c:pt idx="395">
                  <c:v>1.8276300664895599</c:v>
                </c:pt>
                <c:pt idx="396">
                  <c:v>1.3336274250976701</c:v>
                </c:pt>
                <c:pt idx="397">
                  <c:v>1.7649154288347699</c:v>
                </c:pt>
                <c:pt idx="398">
                  <c:v>1.7649154288347699</c:v>
                </c:pt>
                <c:pt idx="399">
                  <c:v>1.0091602502299599</c:v>
                </c:pt>
                <c:pt idx="400">
                  <c:v>1.0091602502299599</c:v>
                </c:pt>
                <c:pt idx="401">
                  <c:v>1.2953510531340799</c:v>
                </c:pt>
                <c:pt idx="402">
                  <c:v>1.2953510531340799</c:v>
                </c:pt>
                <c:pt idx="403">
                  <c:v>0.81619758420656996</c:v>
                </c:pt>
                <c:pt idx="404">
                  <c:v>0.84979709468836295</c:v>
                </c:pt>
                <c:pt idx="405">
                  <c:v>2.0524163836589899</c:v>
                </c:pt>
                <c:pt idx="406">
                  <c:v>0.86773690196055997</c:v>
                </c:pt>
                <c:pt idx="407">
                  <c:v>1.5901330347993501</c:v>
                </c:pt>
                <c:pt idx="408">
                  <c:v>0.62700447617508703</c:v>
                </c:pt>
                <c:pt idx="409">
                  <c:v>0.98646833306743198</c:v>
                </c:pt>
                <c:pt idx="410">
                  <c:v>0.63097548255006297</c:v>
                </c:pt>
                <c:pt idx="411">
                  <c:v>2.1988406488141101</c:v>
                </c:pt>
                <c:pt idx="412">
                  <c:v>1.22524112580273</c:v>
                </c:pt>
                <c:pt idx="413">
                  <c:v>0.501696747906487</c:v>
                </c:pt>
                <c:pt idx="414">
                  <c:v>0.69453115250569097</c:v>
                </c:pt>
                <c:pt idx="415">
                  <c:v>0.141720677608803</c:v>
                </c:pt>
                <c:pt idx="416">
                  <c:v>5.7984374131188197E-2</c:v>
                </c:pt>
                <c:pt idx="417">
                  <c:v>0.76300460720465002</c:v>
                </c:pt>
                <c:pt idx="418">
                  <c:v>0.57098904132218098</c:v>
                </c:pt>
                <c:pt idx="419">
                  <c:v>0.27287931972968699</c:v>
                </c:pt>
                <c:pt idx="420">
                  <c:v>3.2594134079037003E-2</c:v>
                </c:pt>
                <c:pt idx="421">
                  <c:v>0.77382408350842102</c:v>
                </c:pt>
                <c:pt idx="422">
                  <c:v>1.4056349664730099</c:v>
                </c:pt>
                <c:pt idx="423">
                  <c:v>0.85995791087155005</c:v>
                </c:pt>
                <c:pt idx="424">
                  <c:v>1.54646870916391</c:v>
                </c:pt>
                <c:pt idx="425">
                  <c:v>0.38071616796208602</c:v>
                </c:pt>
                <c:pt idx="426">
                  <c:v>0.98908072087459198</c:v>
                </c:pt>
                <c:pt idx="427">
                  <c:v>0.88231988111762605</c:v>
                </c:pt>
                <c:pt idx="428">
                  <c:v>0.224584197780544</c:v>
                </c:pt>
                <c:pt idx="429">
                  <c:v>0.37212250376378803</c:v>
                </c:pt>
                <c:pt idx="430">
                  <c:v>0.36948497965176103</c:v>
                </c:pt>
                <c:pt idx="431">
                  <c:v>5.6858456161188002E-2</c:v>
                </c:pt>
                <c:pt idx="432">
                  <c:v>0.96452367091480096</c:v>
                </c:pt>
                <c:pt idx="433">
                  <c:v>0.18789094345572399</c:v>
                </c:pt>
                <c:pt idx="434">
                  <c:v>1.5412277809597901</c:v>
                </c:pt>
                <c:pt idx="435">
                  <c:v>1.5412277809597901</c:v>
                </c:pt>
                <c:pt idx="436">
                  <c:v>7.8665391598293694E-2</c:v>
                </c:pt>
                <c:pt idx="437">
                  <c:v>1.0074544560194101</c:v>
                </c:pt>
                <c:pt idx="438">
                  <c:v>3.4964983726329703E-2</c:v>
                </c:pt>
                <c:pt idx="439">
                  <c:v>0.53338466217845004</c:v>
                </c:pt>
                <c:pt idx="440">
                  <c:v>1.66725166145407</c:v>
                </c:pt>
                <c:pt idx="441">
                  <c:v>0.14489217044621</c:v>
                </c:pt>
                <c:pt idx="442">
                  <c:v>0.40844082612114202</c:v>
                </c:pt>
                <c:pt idx="443">
                  <c:v>1.51408381259641</c:v>
                </c:pt>
                <c:pt idx="444">
                  <c:v>0.217987156999187</c:v>
                </c:pt>
                <c:pt idx="445">
                  <c:v>0.41995485978006603</c:v>
                </c:pt>
                <c:pt idx="446">
                  <c:v>0.75023338421403296</c:v>
                </c:pt>
                <c:pt idx="447">
                  <c:v>1.1342153280237199</c:v>
                </c:pt>
                <c:pt idx="448">
                  <c:v>0.86580246949352002</c:v>
                </c:pt>
                <c:pt idx="449">
                  <c:v>1.22153992668945</c:v>
                </c:pt>
                <c:pt idx="450">
                  <c:v>1.7801336906468599</c:v>
                </c:pt>
                <c:pt idx="451">
                  <c:v>0.29097538094756897</c:v>
                </c:pt>
                <c:pt idx="452">
                  <c:v>1.9314221777392699</c:v>
                </c:pt>
                <c:pt idx="453">
                  <c:v>0.12772232476854001</c:v>
                </c:pt>
                <c:pt idx="454">
                  <c:v>0.98164897053862099</c:v>
                </c:pt>
                <c:pt idx="455">
                  <c:v>0.95677877791153298</c:v>
                </c:pt>
                <c:pt idx="456">
                  <c:v>1.0480732285023899</c:v>
                </c:pt>
                <c:pt idx="457">
                  <c:v>1.20732152579535</c:v>
                </c:pt>
                <c:pt idx="458">
                  <c:v>1.08558309413688</c:v>
                </c:pt>
                <c:pt idx="459">
                  <c:v>1.20937862311702</c:v>
                </c:pt>
                <c:pt idx="460">
                  <c:v>1.5117014579743899</c:v>
                </c:pt>
                <c:pt idx="461">
                  <c:v>0.558914118287683</c:v>
                </c:pt>
                <c:pt idx="462">
                  <c:v>1.57291225754181</c:v>
                </c:pt>
                <c:pt idx="463">
                  <c:v>1.4872081650014</c:v>
                </c:pt>
                <c:pt idx="464">
                  <c:v>0.31845850489466698</c:v>
                </c:pt>
                <c:pt idx="465">
                  <c:v>1.30755514267204</c:v>
                </c:pt>
                <c:pt idx="466">
                  <c:v>0.94309517385598396</c:v>
                </c:pt>
                <c:pt idx="467">
                  <c:v>1.43416732077257</c:v>
                </c:pt>
                <c:pt idx="468">
                  <c:v>0.74398792076563403</c:v>
                </c:pt>
                <c:pt idx="469">
                  <c:v>0.169881682115399</c:v>
                </c:pt>
                <c:pt idx="470">
                  <c:v>1.8602350783343999</c:v>
                </c:pt>
                <c:pt idx="471">
                  <c:v>0.34716883832533701</c:v>
                </c:pt>
                <c:pt idx="472">
                  <c:v>1.43491379834919</c:v>
                </c:pt>
                <c:pt idx="473">
                  <c:v>0.67598296265289304</c:v>
                </c:pt>
                <c:pt idx="474">
                  <c:v>1.04862841061544</c:v>
                </c:pt>
                <c:pt idx="475">
                  <c:v>0.45370203070601101</c:v>
                </c:pt>
                <c:pt idx="476">
                  <c:v>0.53747808735985403</c:v>
                </c:pt>
                <c:pt idx="477">
                  <c:v>1.31275404136225</c:v>
                </c:pt>
                <c:pt idx="478">
                  <c:v>0.86168524964423399</c:v>
                </c:pt>
                <c:pt idx="479">
                  <c:v>1.04041092847893</c:v>
                </c:pt>
                <c:pt idx="480">
                  <c:v>1.0431436554882301</c:v>
                </c:pt>
                <c:pt idx="481">
                  <c:v>0.551110319014259</c:v>
                </c:pt>
                <c:pt idx="482">
                  <c:v>0.54816655728647501</c:v>
                </c:pt>
                <c:pt idx="483">
                  <c:v>0.38780726015380101</c:v>
                </c:pt>
                <c:pt idx="484">
                  <c:v>5.3291050150819003E-2</c:v>
                </c:pt>
                <c:pt idx="485">
                  <c:v>0.97452112312555506</c:v>
                </c:pt>
                <c:pt idx="486">
                  <c:v>0.50688710270288495</c:v>
                </c:pt>
                <c:pt idx="487">
                  <c:v>1.0063453766252299</c:v>
                </c:pt>
                <c:pt idx="488">
                  <c:v>1.3565710833437701E-2</c:v>
                </c:pt>
                <c:pt idx="489">
                  <c:v>0.168934355033384</c:v>
                </c:pt>
                <c:pt idx="490">
                  <c:v>0.302067091018343</c:v>
                </c:pt>
                <c:pt idx="491">
                  <c:v>2.8216864038202699E-2</c:v>
                </c:pt>
                <c:pt idx="492">
                  <c:v>0.69446727998731494</c:v>
                </c:pt>
                <c:pt idx="493">
                  <c:v>0.64353862009940899</c:v>
                </c:pt>
                <c:pt idx="494">
                  <c:v>1.2319325670196599</c:v>
                </c:pt>
                <c:pt idx="495">
                  <c:v>0.16258565481540599</c:v>
                </c:pt>
                <c:pt idx="496">
                  <c:v>0.27725513539884</c:v>
                </c:pt>
                <c:pt idx="497">
                  <c:v>0.88427060374037203</c:v>
                </c:pt>
                <c:pt idx="498">
                  <c:v>0.42749206099971598</c:v>
                </c:pt>
                <c:pt idx="499">
                  <c:v>0.357054553791332</c:v>
                </c:pt>
                <c:pt idx="500">
                  <c:v>0.38630310553535702</c:v>
                </c:pt>
                <c:pt idx="501">
                  <c:v>0.82178892782878399</c:v>
                </c:pt>
                <c:pt idx="502">
                  <c:v>0.79561707239488899</c:v>
                </c:pt>
                <c:pt idx="503">
                  <c:v>0.25249718846043701</c:v>
                </c:pt>
                <c:pt idx="504">
                  <c:v>0.24096250809710901</c:v>
                </c:pt>
                <c:pt idx="505">
                  <c:v>0.531448483880401</c:v>
                </c:pt>
                <c:pt idx="506">
                  <c:v>0.382889625023284</c:v>
                </c:pt>
                <c:pt idx="507">
                  <c:v>1.76032981630647</c:v>
                </c:pt>
                <c:pt idx="508">
                  <c:v>0.63638762775263902</c:v>
                </c:pt>
                <c:pt idx="509">
                  <c:v>0.275042406736413</c:v>
                </c:pt>
                <c:pt idx="510">
                  <c:v>0.48685670476282999</c:v>
                </c:pt>
                <c:pt idx="511">
                  <c:v>0.63206316840321797</c:v>
                </c:pt>
                <c:pt idx="512">
                  <c:v>1.0846982204073801</c:v>
                </c:pt>
                <c:pt idx="513">
                  <c:v>4.4501639258692299E-2</c:v>
                </c:pt>
                <c:pt idx="514">
                  <c:v>0.411626132537598</c:v>
                </c:pt>
                <c:pt idx="515">
                  <c:v>0.51832385525257196</c:v>
                </c:pt>
                <c:pt idx="516">
                  <c:v>0.39622212895791797</c:v>
                </c:pt>
                <c:pt idx="517">
                  <c:v>0.45861510490444501</c:v>
                </c:pt>
                <c:pt idx="518">
                  <c:v>1.00505859865359</c:v>
                </c:pt>
                <c:pt idx="519">
                  <c:v>5.3427821305219803E-3</c:v>
                </c:pt>
                <c:pt idx="520">
                  <c:v>1.38180699551535E-2</c:v>
                </c:pt>
                <c:pt idx="521">
                  <c:v>0.71595352189414696</c:v>
                </c:pt>
                <c:pt idx="522">
                  <c:v>9.0549777310074603E-2</c:v>
                </c:pt>
                <c:pt idx="523">
                  <c:v>0.69690617823203205</c:v>
                </c:pt>
                <c:pt idx="524">
                  <c:v>0.85275591523161298</c:v>
                </c:pt>
                <c:pt idx="525">
                  <c:v>0.40241917504797597</c:v>
                </c:pt>
                <c:pt idx="526">
                  <c:v>0.65829222001052301</c:v>
                </c:pt>
                <c:pt idx="527">
                  <c:v>0.98879429060677404</c:v>
                </c:pt>
                <c:pt idx="528">
                  <c:v>1.14546407562342</c:v>
                </c:pt>
                <c:pt idx="529">
                  <c:v>0.50707931681240803</c:v>
                </c:pt>
                <c:pt idx="530">
                  <c:v>1.0110797821711299</c:v>
                </c:pt>
                <c:pt idx="531">
                  <c:v>0.20959057075544901</c:v>
                </c:pt>
                <c:pt idx="532">
                  <c:v>0.679366443547748</c:v>
                </c:pt>
                <c:pt idx="533">
                  <c:v>0.280151667156809</c:v>
                </c:pt>
                <c:pt idx="534">
                  <c:v>0.83655367660359103</c:v>
                </c:pt>
                <c:pt idx="535">
                  <c:v>0.95331185274481101</c:v>
                </c:pt>
                <c:pt idx="536">
                  <c:v>1.7978862090301799</c:v>
                </c:pt>
                <c:pt idx="537">
                  <c:v>0.44083460196736801</c:v>
                </c:pt>
                <c:pt idx="538">
                  <c:v>0.87865782380589896</c:v>
                </c:pt>
                <c:pt idx="539">
                  <c:v>0.289311175391604</c:v>
                </c:pt>
                <c:pt idx="540">
                  <c:v>0.59208086848203301</c:v>
                </c:pt>
                <c:pt idx="541">
                  <c:v>0.49030179668150697</c:v>
                </c:pt>
                <c:pt idx="542">
                  <c:v>0.30175465501288201</c:v>
                </c:pt>
                <c:pt idx="543">
                  <c:v>2.1891134263438299</c:v>
                </c:pt>
                <c:pt idx="544">
                  <c:v>0.752781641119594</c:v>
                </c:pt>
                <c:pt idx="545">
                  <c:v>0.168724471104753</c:v>
                </c:pt>
                <c:pt idx="546">
                  <c:v>1.1650423092645099</c:v>
                </c:pt>
                <c:pt idx="547">
                  <c:v>0.45044216475313897</c:v>
                </c:pt>
                <c:pt idx="548">
                  <c:v>1.1245954620749401</c:v>
                </c:pt>
                <c:pt idx="549">
                  <c:v>1.24522878065057</c:v>
                </c:pt>
                <c:pt idx="550">
                  <c:v>0.438739277136179</c:v>
                </c:pt>
                <c:pt idx="551">
                  <c:v>0.76390362418817004</c:v>
                </c:pt>
                <c:pt idx="552">
                  <c:v>0.44431958468650001</c:v>
                </c:pt>
                <c:pt idx="553">
                  <c:v>0.20770171914784999</c:v>
                </c:pt>
                <c:pt idx="554">
                  <c:v>0.189341277185129</c:v>
                </c:pt>
                <c:pt idx="555">
                  <c:v>0.74185672891354204</c:v>
                </c:pt>
                <c:pt idx="556">
                  <c:v>0.107990247158254</c:v>
                </c:pt>
                <c:pt idx="557">
                  <c:v>1.92375885649373</c:v>
                </c:pt>
                <c:pt idx="558">
                  <c:v>0.56996673379014995</c:v>
                </c:pt>
                <c:pt idx="559">
                  <c:v>1.76414361687771</c:v>
                </c:pt>
                <c:pt idx="560">
                  <c:v>0.26473467833095399</c:v>
                </c:pt>
                <c:pt idx="561">
                  <c:v>1.92558365718701</c:v>
                </c:pt>
                <c:pt idx="562">
                  <c:v>0.13141580900264399</c:v>
                </c:pt>
                <c:pt idx="563">
                  <c:v>0.10495375418663599</c:v>
                </c:pt>
                <c:pt idx="564">
                  <c:v>0.605582482356264</c:v>
                </c:pt>
                <c:pt idx="565">
                  <c:v>0.71911449825628504</c:v>
                </c:pt>
                <c:pt idx="566">
                  <c:v>1.72531175707395</c:v>
                </c:pt>
                <c:pt idx="567">
                  <c:v>0.38536167552400202</c:v>
                </c:pt>
                <c:pt idx="568">
                  <c:v>0.17626221577532</c:v>
                </c:pt>
                <c:pt idx="569">
                  <c:v>0.93263974721855303</c:v>
                </c:pt>
                <c:pt idx="570">
                  <c:v>2.1304129633347499</c:v>
                </c:pt>
                <c:pt idx="571">
                  <c:v>0.31485112266988102</c:v>
                </c:pt>
                <c:pt idx="572">
                  <c:v>1.1259555088391799</c:v>
                </c:pt>
                <c:pt idx="573">
                  <c:v>0.101472075840741</c:v>
                </c:pt>
                <c:pt idx="574">
                  <c:v>1.5083823561918099</c:v>
                </c:pt>
                <c:pt idx="575">
                  <c:v>2.43456886630231</c:v>
                </c:pt>
                <c:pt idx="576">
                  <c:v>6.7475768618195903E-2</c:v>
                </c:pt>
                <c:pt idx="577">
                  <c:v>0.14581601570702701</c:v>
                </c:pt>
                <c:pt idx="578">
                  <c:v>0.192265246537205</c:v>
                </c:pt>
                <c:pt idx="579">
                  <c:v>0.81940810930532204</c:v>
                </c:pt>
                <c:pt idx="580">
                  <c:v>0.270064104555021</c:v>
                </c:pt>
                <c:pt idx="581">
                  <c:v>0.43853750025562099</c:v>
                </c:pt>
                <c:pt idx="582">
                  <c:v>1.0184411067882799</c:v>
                </c:pt>
                <c:pt idx="583">
                  <c:v>1.2211793433395499</c:v>
                </c:pt>
                <c:pt idx="584">
                  <c:v>0.61386019879874498</c:v>
                </c:pt>
                <c:pt idx="585">
                  <c:v>0.106304737495493</c:v>
                </c:pt>
                <c:pt idx="586">
                  <c:v>1.4148488400449499</c:v>
                </c:pt>
                <c:pt idx="587">
                  <c:v>8.5158883962524495E-2</c:v>
                </c:pt>
                <c:pt idx="588">
                  <c:v>8.9183321171462299E-2</c:v>
                </c:pt>
                <c:pt idx="589">
                  <c:v>0.74604464147724603</c:v>
                </c:pt>
                <c:pt idx="590">
                  <c:v>0.36504266038463101</c:v>
                </c:pt>
                <c:pt idx="591">
                  <c:v>0.44547854172237</c:v>
                </c:pt>
                <c:pt idx="592">
                  <c:v>0.82551038188894199</c:v>
                </c:pt>
                <c:pt idx="593">
                  <c:v>0.99217280464027402</c:v>
                </c:pt>
                <c:pt idx="594">
                  <c:v>0.63926812860043902</c:v>
                </c:pt>
                <c:pt idx="595">
                  <c:v>0.45254975121374602</c:v>
                </c:pt>
                <c:pt idx="596">
                  <c:v>0.807346560463305</c:v>
                </c:pt>
                <c:pt idx="597">
                  <c:v>0.62719519564105097</c:v>
                </c:pt>
                <c:pt idx="598">
                  <c:v>1.2331308642060601</c:v>
                </c:pt>
                <c:pt idx="599">
                  <c:v>1.12444256415218</c:v>
                </c:pt>
                <c:pt idx="600">
                  <c:v>1.5887842966266501</c:v>
                </c:pt>
                <c:pt idx="601">
                  <c:v>0.90578424697139504</c:v>
                </c:pt>
                <c:pt idx="602">
                  <c:v>0.92150801279894001</c:v>
                </c:pt>
                <c:pt idx="603">
                  <c:v>2.0535929394147199</c:v>
                </c:pt>
                <c:pt idx="604">
                  <c:v>0.86316789678745298</c:v>
                </c:pt>
                <c:pt idx="605">
                  <c:v>0.24011641172471501</c:v>
                </c:pt>
                <c:pt idx="606">
                  <c:v>1.63926711040284</c:v>
                </c:pt>
                <c:pt idx="607">
                  <c:v>1.6420610161758999</c:v>
                </c:pt>
                <c:pt idx="608">
                  <c:v>0.60485099204715698</c:v>
                </c:pt>
                <c:pt idx="609">
                  <c:v>0.60304735743566296</c:v>
                </c:pt>
                <c:pt idx="610">
                  <c:v>0.93618886365250797</c:v>
                </c:pt>
                <c:pt idx="611">
                  <c:v>5.5287811604828797E-2</c:v>
                </c:pt>
                <c:pt idx="612">
                  <c:v>1.72694089760917</c:v>
                </c:pt>
                <c:pt idx="613">
                  <c:v>0.46638395449417902</c:v>
                </c:pt>
                <c:pt idx="614">
                  <c:v>0.161409016038776</c:v>
                </c:pt>
                <c:pt idx="615">
                  <c:v>1.7675953780148601</c:v>
                </c:pt>
                <c:pt idx="616">
                  <c:v>1.2406491076122499E-2</c:v>
                </c:pt>
                <c:pt idx="617">
                  <c:v>0.29430944598576603</c:v>
                </c:pt>
                <c:pt idx="618">
                  <c:v>1.65382184185123</c:v>
                </c:pt>
                <c:pt idx="619">
                  <c:v>0.35527292397305998</c:v>
                </c:pt>
                <c:pt idx="620">
                  <c:v>0.84582894357199101</c:v>
                </c:pt>
                <c:pt idx="621">
                  <c:v>0.81422703297079002</c:v>
                </c:pt>
                <c:pt idx="622">
                  <c:v>0.62082251746134298</c:v>
                </c:pt>
                <c:pt idx="623">
                  <c:v>1.4836047919241899</c:v>
                </c:pt>
                <c:pt idx="624">
                  <c:v>1.2745910456207701</c:v>
                </c:pt>
                <c:pt idx="625">
                  <c:v>0.302739895523712</c:v>
                </c:pt>
                <c:pt idx="626">
                  <c:v>4.32292448108735E-2</c:v>
                </c:pt>
                <c:pt idx="627">
                  <c:v>1.7117881696889401</c:v>
                </c:pt>
                <c:pt idx="628">
                  <c:v>0.87695218687277898</c:v>
                </c:pt>
                <c:pt idx="629">
                  <c:v>0.35873935029166998</c:v>
                </c:pt>
                <c:pt idx="630">
                  <c:v>0.60900389386426601</c:v>
                </c:pt>
                <c:pt idx="631">
                  <c:v>0.19316377296971901</c:v>
                </c:pt>
                <c:pt idx="632">
                  <c:v>0.77724813705630402</c:v>
                </c:pt>
                <c:pt idx="633">
                  <c:v>4.6028342651279697E-2</c:v>
                </c:pt>
                <c:pt idx="634">
                  <c:v>0.433918087220106</c:v>
                </c:pt>
                <c:pt idx="635">
                  <c:v>1.01037476822489</c:v>
                </c:pt>
                <c:pt idx="636">
                  <c:v>1.4773865099565999</c:v>
                </c:pt>
                <c:pt idx="637">
                  <c:v>2.7163044180210798E-2</c:v>
                </c:pt>
                <c:pt idx="638">
                  <c:v>1.59408496706293</c:v>
                </c:pt>
                <c:pt idx="639">
                  <c:v>0.82993973850139002</c:v>
                </c:pt>
                <c:pt idx="640">
                  <c:v>1.0917967464424601</c:v>
                </c:pt>
                <c:pt idx="641">
                  <c:v>0.769510885597814</c:v>
                </c:pt>
                <c:pt idx="642">
                  <c:v>0.74254347439342905</c:v>
                </c:pt>
                <c:pt idx="643">
                  <c:v>0.49065830458341603</c:v>
                </c:pt>
                <c:pt idx="644">
                  <c:v>0.45600836616752199</c:v>
                </c:pt>
                <c:pt idx="645">
                  <c:v>0.87337920399092095</c:v>
                </c:pt>
                <c:pt idx="646">
                  <c:v>0.144670105684989</c:v>
                </c:pt>
                <c:pt idx="647">
                  <c:v>0.25381572242038303</c:v>
                </c:pt>
                <c:pt idx="648">
                  <c:v>7.3059375834020404E-2</c:v>
                </c:pt>
                <c:pt idx="649">
                  <c:v>0.85662573358926497</c:v>
                </c:pt>
                <c:pt idx="650">
                  <c:v>0.65408786607745695</c:v>
                </c:pt>
                <c:pt idx="651">
                  <c:v>0.30812659880583998</c:v>
                </c:pt>
                <c:pt idx="652">
                  <c:v>0.76664408639424397</c:v>
                </c:pt>
                <c:pt idx="653">
                  <c:v>0.49120507193066998</c:v>
                </c:pt>
                <c:pt idx="654">
                  <c:v>1.2324850126015101</c:v>
                </c:pt>
                <c:pt idx="655">
                  <c:v>1.21614271686424</c:v>
                </c:pt>
                <c:pt idx="656">
                  <c:v>0.90226217399579101</c:v>
                </c:pt>
                <c:pt idx="657">
                  <c:v>0.25643040751923202</c:v>
                </c:pt>
                <c:pt idx="658">
                  <c:v>1.0426676775519199</c:v>
                </c:pt>
                <c:pt idx="659">
                  <c:v>6.74182755870813E-2</c:v>
                </c:pt>
                <c:pt idx="660">
                  <c:v>1.1633840153700601</c:v>
                </c:pt>
                <c:pt idx="661">
                  <c:v>0.80097584619275797</c:v>
                </c:pt>
                <c:pt idx="662">
                  <c:v>1.1739458167313199</c:v>
                </c:pt>
                <c:pt idx="663">
                  <c:v>0.32277924120663198</c:v>
                </c:pt>
                <c:pt idx="664">
                  <c:v>0.57481730970824196</c:v>
                </c:pt>
                <c:pt idx="665">
                  <c:v>0.758169591911798</c:v>
                </c:pt>
                <c:pt idx="666">
                  <c:v>0.93610542229657401</c:v>
                </c:pt>
                <c:pt idx="667">
                  <c:v>1.0786626717702901</c:v>
                </c:pt>
                <c:pt idx="668">
                  <c:v>0.65829452913946196</c:v>
                </c:pt>
                <c:pt idx="669">
                  <c:v>1.12561113171992</c:v>
                </c:pt>
                <c:pt idx="670">
                  <c:v>0.67300032539880195</c:v>
                </c:pt>
                <c:pt idx="671">
                  <c:v>0.156293231287541</c:v>
                </c:pt>
                <c:pt idx="672">
                  <c:v>0.89125211939332505</c:v>
                </c:pt>
                <c:pt idx="673">
                  <c:v>0.91055651878914101</c:v>
                </c:pt>
                <c:pt idx="674">
                  <c:v>1.07682032335216</c:v>
                </c:pt>
                <c:pt idx="675">
                  <c:v>1.26318314877815</c:v>
                </c:pt>
                <c:pt idx="676">
                  <c:v>1.5088143609757401</c:v>
                </c:pt>
                <c:pt idx="677">
                  <c:v>1.19592116674334</c:v>
                </c:pt>
                <c:pt idx="678">
                  <c:v>0.949046835995773</c:v>
                </c:pt>
                <c:pt idx="679">
                  <c:v>0.43380581883623898</c:v>
                </c:pt>
                <c:pt idx="680">
                  <c:v>1.0914353166289401</c:v>
                </c:pt>
                <c:pt idx="681">
                  <c:v>1.1454584671518799</c:v>
                </c:pt>
                <c:pt idx="682">
                  <c:v>0.94944028542042003</c:v>
                </c:pt>
                <c:pt idx="683">
                  <c:v>0.92697695934385005</c:v>
                </c:pt>
                <c:pt idx="684">
                  <c:v>1.3587343576597699</c:v>
                </c:pt>
                <c:pt idx="685">
                  <c:v>0.66792555590303804</c:v>
                </c:pt>
                <c:pt idx="686">
                  <c:v>1.23846295950809</c:v>
                </c:pt>
                <c:pt idx="687">
                  <c:v>0.96010351517959802</c:v>
                </c:pt>
                <c:pt idx="688">
                  <c:v>0.768703677122484</c:v>
                </c:pt>
                <c:pt idx="689">
                  <c:v>0.89450655676055801</c:v>
                </c:pt>
                <c:pt idx="690">
                  <c:v>0.466182639397343</c:v>
                </c:pt>
                <c:pt idx="691">
                  <c:v>0.510338075162034</c:v>
                </c:pt>
                <c:pt idx="692">
                  <c:v>1.1873812000855399</c:v>
                </c:pt>
                <c:pt idx="693">
                  <c:v>0.76365221383988402</c:v>
                </c:pt>
                <c:pt idx="694">
                  <c:v>9.7605948268256901E-2</c:v>
                </c:pt>
                <c:pt idx="695">
                  <c:v>0.92217618154546699</c:v>
                </c:pt>
                <c:pt idx="696">
                  <c:v>0.42575777851152102</c:v>
                </c:pt>
                <c:pt idx="697">
                  <c:v>0.90187754230877903</c:v>
                </c:pt>
                <c:pt idx="698">
                  <c:v>0.70824180776416301</c:v>
                </c:pt>
                <c:pt idx="699">
                  <c:v>0.612106954630528</c:v>
                </c:pt>
                <c:pt idx="700">
                  <c:v>1.13374799492886</c:v>
                </c:pt>
                <c:pt idx="701">
                  <c:v>0.77217621463915298</c:v>
                </c:pt>
                <c:pt idx="702">
                  <c:v>0.53993032908396899</c:v>
                </c:pt>
                <c:pt idx="703">
                  <c:v>0.697850882128906</c:v>
                </c:pt>
                <c:pt idx="704">
                  <c:v>0.43765580054242298</c:v>
                </c:pt>
                <c:pt idx="705">
                  <c:v>0.99517598072454205</c:v>
                </c:pt>
                <c:pt idx="706">
                  <c:v>0.63754231313031595</c:v>
                </c:pt>
                <c:pt idx="707">
                  <c:v>1.80126704636304</c:v>
                </c:pt>
                <c:pt idx="708">
                  <c:v>0.57701696120923895</c:v>
                </c:pt>
                <c:pt idx="709">
                  <c:v>1.36358773412218</c:v>
                </c:pt>
                <c:pt idx="710">
                  <c:v>0.39193141749715898</c:v>
                </c:pt>
                <c:pt idx="711">
                  <c:v>1.0356879777125401</c:v>
                </c:pt>
                <c:pt idx="712">
                  <c:v>0.43107402098966702</c:v>
                </c:pt>
                <c:pt idx="713">
                  <c:v>0.866440700664174</c:v>
                </c:pt>
                <c:pt idx="714">
                  <c:v>0.88549004572514201</c:v>
                </c:pt>
                <c:pt idx="715">
                  <c:v>0.78379422692085599</c:v>
                </c:pt>
                <c:pt idx="716">
                  <c:v>0.51055486563987795</c:v>
                </c:pt>
                <c:pt idx="717">
                  <c:v>1.11134198374226</c:v>
                </c:pt>
                <c:pt idx="718">
                  <c:v>0.49530097473817503</c:v>
                </c:pt>
                <c:pt idx="719">
                  <c:v>0.85475436335538602</c:v>
                </c:pt>
                <c:pt idx="720">
                  <c:v>1.6093221795453301</c:v>
                </c:pt>
                <c:pt idx="721">
                  <c:v>0.79010774053085597</c:v>
                </c:pt>
                <c:pt idx="722">
                  <c:v>0.96622382690471098</c:v>
                </c:pt>
                <c:pt idx="723">
                  <c:v>0.61306976311801797</c:v>
                </c:pt>
                <c:pt idx="724">
                  <c:v>0.67456135613586798</c:v>
                </c:pt>
                <c:pt idx="725">
                  <c:v>0.46003307221761902</c:v>
                </c:pt>
                <c:pt idx="726">
                  <c:v>0.51701222899018795</c:v>
                </c:pt>
                <c:pt idx="727">
                  <c:v>1.2615703821076101</c:v>
                </c:pt>
                <c:pt idx="728">
                  <c:v>0.92502071764335903</c:v>
                </c:pt>
                <c:pt idx="729">
                  <c:v>1.49074408508587</c:v>
                </c:pt>
                <c:pt idx="730">
                  <c:v>0.945049880528534</c:v>
                </c:pt>
                <c:pt idx="731">
                  <c:v>0.73131464612877495</c:v>
                </c:pt>
                <c:pt idx="732">
                  <c:v>0.51534983858351402</c:v>
                </c:pt>
                <c:pt idx="733">
                  <c:v>0.30891743827916301</c:v>
                </c:pt>
                <c:pt idx="734">
                  <c:v>1.17834577800798</c:v>
                </c:pt>
                <c:pt idx="735">
                  <c:v>1.35240984001139</c:v>
                </c:pt>
                <c:pt idx="736">
                  <c:v>0.54582365397258004</c:v>
                </c:pt>
                <c:pt idx="737">
                  <c:v>0.55984710597388698</c:v>
                </c:pt>
                <c:pt idx="738">
                  <c:v>1.3078932921664801</c:v>
                </c:pt>
                <c:pt idx="739">
                  <c:v>0.50216028746142904</c:v>
                </c:pt>
                <c:pt idx="740">
                  <c:v>0.69413900537261897</c:v>
                </c:pt>
                <c:pt idx="741">
                  <c:v>1.37389672389377</c:v>
                </c:pt>
                <c:pt idx="742">
                  <c:v>0.44181941001548097</c:v>
                </c:pt>
                <c:pt idx="743">
                  <c:v>0.82050750016148799</c:v>
                </c:pt>
                <c:pt idx="744">
                  <c:v>1.6019977638582099</c:v>
                </c:pt>
                <c:pt idx="745">
                  <c:v>0.75750294473685797</c:v>
                </c:pt>
                <c:pt idx="746">
                  <c:v>1.1397579278797301</c:v>
                </c:pt>
                <c:pt idx="747">
                  <c:v>0.18888812581054201</c:v>
                </c:pt>
                <c:pt idx="748">
                  <c:v>0.44951116847223099</c:v>
                </c:pt>
                <c:pt idx="749">
                  <c:v>0.243705398678775</c:v>
                </c:pt>
                <c:pt idx="750">
                  <c:v>2.2276246919932898</c:v>
                </c:pt>
                <c:pt idx="751">
                  <c:v>0.96998985764366896</c:v>
                </c:pt>
                <c:pt idx="752">
                  <c:v>0.349169574153324</c:v>
                </c:pt>
                <c:pt idx="753">
                  <c:v>0.93473212589632004</c:v>
                </c:pt>
                <c:pt idx="754">
                  <c:v>0.49120886332622299</c:v>
                </c:pt>
                <c:pt idx="755">
                  <c:v>0.72575574307536805</c:v>
                </c:pt>
                <c:pt idx="756">
                  <c:v>0.46881603918697001</c:v>
                </c:pt>
                <c:pt idx="757">
                  <c:v>1.0135992032786201</c:v>
                </c:pt>
                <c:pt idx="758">
                  <c:v>0.97448985626234097</c:v>
                </c:pt>
                <c:pt idx="759">
                  <c:v>0.14661252761312099</c:v>
                </c:pt>
                <c:pt idx="760">
                  <c:v>1.24174146442559</c:v>
                </c:pt>
                <c:pt idx="761">
                  <c:v>0.47852094089714597</c:v>
                </c:pt>
                <c:pt idx="762">
                  <c:v>8.0982690536063898E-2</c:v>
                </c:pt>
                <c:pt idx="763">
                  <c:v>0.343349758274619</c:v>
                </c:pt>
                <c:pt idx="764">
                  <c:v>0.285246280647455</c:v>
                </c:pt>
                <c:pt idx="765">
                  <c:v>0.79453489673917099</c:v>
                </c:pt>
                <c:pt idx="766">
                  <c:v>1.1988096613657699</c:v>
                </c:pt>
                <c:pt idx="767">
                  <c:v>0.57837997219718895</c:v>
                </c:pt>
                <c:pt idx="768">
                  <c:v>0.70871703660123497</c:v>
                </c:pt>
                <c:pt idx="769">
                  <c:v>0.88202701640814196</c:v>
                </c:pt>
                <c:pt idx="770">
                  <c:v>0.72773926651715404</c:v>
                </c:pt>
                <c:pt idx="771">
                  <c:v>0.83469252656116899</c:v>
                </c:pt>
                <c:pt idx="772">
                  <c:v>0.68628222194333099</c:v>
                </c:pt>
                <c:pt idx="773">
                  <c:v>0.56492641323301696</c:v>
                </c:pt>
                <c:pt idx="774">
                  <c:v>2.0879724218778999</c:v>
                </c:pt>
                <c:pt idx="775">
                  <c:v>0.94539805424762002</c:v>
                </c:pt>
                <c:pt idx="776">
                  <c:v>0.62375574626536001</c:v>
                </c:pt>
                <c:pt idx="777">
                  <c:v>0.61719812362498405</c:v>
                </c:pt>
                <c:pt idx="778">
                  <c:v>0.308421586614326</c:v>
                </c:pt>
                <c:pt idx="779">
                  <c:v>0.16962658504974301</c:v>
                </c:pt>
                <c:pt idx="780">
                  <c:v>0.71470456488487599</c:v>
                </c:pt>
                <c:pt idx="781">
                  <c:v>0.22424470377132899</c:v>
                </c:pt>
                <c:pt idx="782">
                  <c:v>1.1388864944460799</c:v>
                </c:pt>
                <c:pt idx="783">
                  <c:v>0.81272938945772299</c:v>
                </c:pt>
                <c:pt idx="784">
                  <c:v>0.54928971566987905</c:v>
                </c:pt>
                <c:pt idx="785">
                  <c:v>0.30314792147728098</c:v>
                </c:pt>
                <c:pt idx="786">
                  <c:v>0.451037797029473</c:v>
                </c:pt>
                <c:pt idx="787">
                  <c:v>0.22082828343438701</c:v>
                </c:pt>
                <c:pt idx="788">
                  <c:v>0.13381872318333099</c:v>
                </c:pt>
                <c:pt idx="789">
                  <c:v>0.23291917966181799</c:v>
                </c:pt>
                <c:pt idx="790">
                  <c:v>0.33083656040786402</c:v>
                </c:pt>
                <c:pt idx="791">
                  <c:v>0.76662626981556004</c:v>
                </c:pt>
                <c:pt idx="792">
                  <c:v>1.5328832870104601</c:v>
                </c:pt>
                <c:pt idx="793">
                  <c:v>0.96602503114659199</c:v>
                </c:pt>
                <c:pt idx="794">
                  <c:v>0.44319089022861902</c:v>
                </c:pt>
                <c:pt idx="795">
                  <c:v>0.38161060157772703</c:v>
                </c:pt>
                <c:pt idx="796">
                  <c:v>0.73041667183720904</c:v>
                </c:pt>
                <c:pt idx="797">
                  <c:v>0.56846333366434898</c:v>
                </c:pt>
                <c:pt idx="798">
                  <c:v>0.69386157657780201</c:v>
                </c:pt>
                <c:pt idx="799">
                  <c:v>0.38313517558446097</c:v>
                </c:pt>
                <c:pt idx="800">
                  <c:v>0.34703265432296698</c:v>
                </c:pt>
                <c:pt idx="801">
                  <c:v>0.46909206345260201</c:v>
                </c:pt>
                <c:pt idx="802">
                  <c:v>0.21693633271271101</c:v>
                </c:pt>
                <c:pt idx="803">
                  <c:v>8.8732244479028402E-2</c:v>
                </c:pt>
                <c:pt idx="804">
                  <c:v>0.85123616418409098</c:v>
                </c:pt>
                <c:pt idx="805">
                  <c:v>0.49140869988714397</c:v>
                </c:pt>
                <c:pt idx="806">
                  <c:v>0.11164848204196599</c:v>
                </c:pt>
                <c:pt idx="807">
                  <c:v>4.9518465525104E-2</c:v>
                </c:pt>
                <c:pt idx="808">
                  <c:v>0.36727710434087202</c:v>
                </c:pt>
                <c:pt idx="809">
                  <c:v>1.0673968252002399</c:v>
                </c:pt>
                <c:pt idx="810">
                  <c:v>0.61747342864561405</c:v>
                </c:pt>
                <c:pt idx="811">
                  <c:v>0.60124127386378401</c:v>
                </c:pt>
                <c:pt idx="812">
                  <c:v>0.39284870159523899</c:v>
                </c:pt>
                <c:pt idx="813">
                  <c:v>1.17521814552989</c:v>
                </c:pt>
                <c:pt idx="814">
                  <c:v>0.80703488310265203</c:v>
                </c:pt>
                <c:pt idx="815">
                  <c:v>0.53054017279757404</c:v>
                </c:pt>
                <c:pt idx="816">
                  <c:v>0.527011088939906</c:v>
                </c:pt>
                <c:pt idx="817">
                  <c:v>1.2773096451761901</c:v>
                </c:pt>
                <c:pt idx="818">
                  <c:v>0.47059947668662599</c:v>
                </c:pt>
                <c:pt idx="819">
                  <c:v>0.69385464234576799</c:v>
                </c:pt>
                <c:pt idx="820">
                  <c:v>1.2098245012383</c:v>
                </c:pt>
                <c:pt idx="821">
                  <c:v>0.49009354543963202</c:v>
                </c:pt>
                <c:pt idx="822">
                  <c:v>0.93373824274913497</c:v>
                </c:pt>
                <c:pt idx="823">
                  <c:v>0.84384331073713004</c:v>
                </c:pt>
                <c:pt idx="824">
                  <c:v>1.08510408279842</c:v>
                </c:pt>
                <c:pt idx="825">
                  <c:v>0.57894826043185699</c:v>
                </c:pt>
                <c:pt idx="826">
                  <c:v>0.37880584278093699</c:v>
                </c:pt>
                <c:pt idx="827">
                  <c:v>0.200415437674619</c:v>
                </c:pt>
                <c:pt idx="828">
                  <c:v>0.98273284030207997</c:v>
                </c:pt>
                <c:pt idx="829">
                  <c:v>0.91306463098957902</c:v>
                </c:pt>
                <c:pt idx="830">
                  <c:v>0.13330713458427601</c:v>
                </c:pt>
                <c:pt idx="831">
                  <c:v>4.6010016110961699E-2</c:v>
                </c:pt>
                <c:pt idx="832">
                  <c:v>5.63259824589247E-2</c:v>
                </c:pt>
                <c:pt idx="833">
                  <c:v>0.20938255650147</c:v>
                </c:pt>
                <c:pt idx="834">
                  <c:v>6.3065769511107497E-2</c:v>
                </c:pt>
                <c:pt idx="835">
                  <c:v>0.32664673674776701</c:v>
                </c:pt>
                <c:pt idx="836">
                  <c:v>0.87018194932149795</c:v>
                </c:pt>
                <c:pt idx="837">
                  <c:v>0.73321269054828697</c:v>
                </c:pt>
                <c:pt idx="838">
                  <c:v>0.385619409020584</c:v>
                </c:pt>
                <c:pt idx="839">
                  <c:v>0.19390330230664601</c:v>
                </c:pt>
                <c:pt idx="840">
                  <c:v>0.12613472979795801</c:v>
                </c:pt>
                <c:pt idx="841">
                  <c:v>0.116030147764939</c:v>
                </c:pt>
                <c:pt idx="842">
                  <c:v>0.256124750675988</c:v>
                </c:pt>
                <c:pt idx="843">
                  <c:v>3.2148729933115398E-2</c:v>
                </c:pt>
                <c:pt idx="844">
                  <c:v>0.872705027729621</c:v>
                </c:pt>
                <c:pt idx="845">
                  <c:v>1.5765843988232098E-2</c:v>
                </c:pt>
                <c:pt idx="846">
                  <c:v>0.108477909273144</c:v>
                </c:pt>
                <c:pt idx="847">
                  <c:v>0.20839025032408601</c:v>
                </c:pt>
                <c:pt idx="848">
                  <c:v>0.38338949389829102</c:v>
                </c:pt>
                <c:pt idx="849">
                  <c:v>0.115830204609814</c:v>
                </c:pt>
                <c:pt idx="850">
                  <c:v>0.41288435349599001</c:v>
                </c:pt>
                <c:pt idx="851">
                  <c:v>0.59606164457397304</c:v>
                </c:pt>
                <c:pt idx="852">
                  <c:v>0.235531992936165</c:v>
                </c:pt>
                <c:pt idx="853">
                  <c:v>0.16950733601867801</c:v>
                </c:pt>
                <c:pt idx="854">
                  <c:v>6.7190625027884296E-2</c:v>
                </c:pt>
                <c:pt idx="855">
                  <c:v>0.14541944277445701</c:v>
                </c:pt>
                <c:pt idx="856">
                  <c:v>0.35953726623031501</c:v>
                </c:pt>
                <c:pt idx="857">
                  <c:v>0.29354146887057098</c:v>
                </c:pt>
                <c:pt idx="858">
                  <c:v>1.8765840171756899E-2</c:v>
                </c:pt>
                <c:pt idx="859">
                  <c:v>0.21425383710263701</c:v>
                </c:pt>
                <c:pt idx="860">
                  <c:v>0.13181674524567799</c:v>
                </c:pt>
                <c:pt idx="861">
                  <c:v>0.31744826987100599</c:v>
                </c:pt>
                <c:pt idx="862">
                  <c:v>0.23648387621928901</c:v>
                </c:pt>
                <c:pt idx="863">
                  <c:v>0.45130946461884902</c:v>
                </c:pt>
                <c:pt idx="864">
                  <c:v>0.64817445655192296</c:v>
                </c:pt>
                <c:pt idx="865">
                  <c:v>0.50692040414494899</c:v>
                </c:pt>
                <c:pt idx="866">
                  <c:v>0.38204760740952698</c:v>
                </c:pt>
                <c:pt idx="867">
                  <c:v>0.29119440571817501</c:v>
                </c:pt>
                <c:pt idx="868">
                  <c:v>0.150225822287127</c:v>
                </c:pt>
                <c:pt idx="869">
                  <c:v>0.92883807537378904</c:v>
                </c:pt>
                <c:pt idx="870">
                  <c:v>0.62785441187595104</c:v>
                </c:pt>
                <c:pt idx="871">
                  <c:v>9.3169580181716699E-2</c:v>
                </c:pt>
                <c:pt idx="872">
                  <c:v>4.8212927798764099E-2</c:v>
                </c:pt>
                <c:pt idx="873">
                  <c:v>0.85167127310440405</c:v>
                </c:pt>
                <c:pt idx="874">
                  <c:v>1.7944468027479401</c:v>
                </c:pt>
                <c:pt idx="875">
                  <c:v>1.81856591549025E-2</c:v>
                </c:pt>
                <c:pt idx="876">
                  <c:v>1.1167319264558699</c:v>
                </c:pt>
                <c:pt idx="877">
                  <c:v>5.8546939858822797E-2</c:v>
                </c:pt>
                <c:pt idx="878">
                  <c:v>0.421466874387595</c:v>
                </c:pt>
                <c:pt idx="879">
                  <c:v>0.48702253012815599</c:v>
                </c:pt>
                <c:pt idx="880">
                  <c:v>0.16525673605955901</c:v>
                </c:pt>
                <c:pt idx="881">
                  <c:v>3.88331013789949E-2</c:v>
                </c:pt>
                <c:pt idx="882">
                  <c:v>0.38000712583020402</c:v>
                </c:pt>
                <c:pt idx="883">
                  <c:v>0.50517002620483897</c:v>
                </c:pt>
                <c:pt idx="884">
                  <c:v>0.49119437961765899</c:v>
                </c:pt>
                <c:pt idx="885">
                  <c:v>0.70460246859281594</c:v>
                </c:pt>
                <c:pt idx="886">
                  <c:v>0.57010535044910804</c:v>
                </c:pt>
                <c:pt idx="887">
                  <c:v>1.0178315904531099</c:v>
                </c:pt>
                <c:pt idx="888">
                  <c:v>1.12689808244737</c:v>
                </c:pt>
                <c:pt idx="889">
                  <c:v>0.75331016142311003</c:v>
                </c:pt>
                <c:pt idx="890">
                  <c:v>0.14555471253542801</c:v>
                </c:pt>
                <c:pt idx="891">
                  <c:v>0.55153603073934598</c:v>
                </c:pt>
                <c:pt idx="892">
                  <c:v>0.15773744677371601</c:v>
                </c:pt>
                <c:pt idx="893">
                  <c:v>0.51022389373104005</c:v>
                </c:pt>
                <c:pt idx="894">
                  <c:v>0.47045207019190299</c:v>
                </c:pt>
                <c:pt idx="895">
                  <c:v>0.42900178036132502</c:v>
                </c:pt>
                <c:pt idx="896">
                  <c:v>0.73784549636638996</c:v>
                </c:pt>
                <c:pt idx="897">
                  <c:v>0.46213243703760498</c:v>
                </c:pt>
                <c:pt idx="898">
                  <c:v>0.910988368376205</c:v>
                </c:pt>
                <c:pt idx="899">
                  <c:v>0.90289353526438598</c:v>
                </c:pt>
                <c:pt idx="900">
                  <c:v>1.4292925411441899</c:v>
                </c:pt>
                <c:pt idx="901">
                  <c:v>0.50007347384269096</c:v>
                </c:pt>
                <c:pt idx="902">
                  <c:v>7.3320798054532796E-3</c:v>
                </c:pt>
                <c:pt idx="903">
                  <c:v>0.374797917339598</c:v>
                </c:pt>
                <c:pt idx="904">
                  <c:v>0.68568380394607698</c:v>
                </c:pt>
                <c:pt idx="905">
                  <c:v>0.69377811605829398</c:v>
                </c:pt>
                <c:pt idx="906">
                  <c:v>0.28737492613635801</c:v>
                </c:pt>
                <c:pt idx="907">
                  <c:v>0.188066636632995</c:v>
                </c:pt>
                <c:pt idx="908">
                  <c:v>0.30664945032395702</c:v>
                </c:pt>
                <c:pt idx="909">
                  <c:v>0.14034130290178401</c:v>
                </c:pt>
                <c:pt idx="910">
                  <c:v>0.217231546824939</c:v>
                </c:pt>
                <c:pt idx="911">
                  <c:v>0.93510666239380402</c:v>
                </c:pt>
                <c:pt idx="912">
                  <c:v>0.618603241387778</c:v>
                </c:pt>
                <c:pt idx="913">
                  <c:v>0.38338860419274601</c:v>
                </c:pt>
                <c:pt idx="914">
                  <c:v>0.61875496251783901</c:v>
                </c:pt>
                <c:pt idx="915">
                  <c:v>2.8303865584354401E-3</c:v>
                </c:pt>
                <c:pt idx="916">
                  <c:v>0.45707737195397502</c:v>
                </c:pt>
                <c:pt idx="917">
                  <c:v>0.37843430528067801</c:v>
                </c:pt>
                <c:pt idx="918">
                  <c:v>0.88858235245143102</c:v>
                </c:pt>
                <c:pt idx="919">
                  <c:v>0.25676167296520602</c:v>
                </c:pt>
                <c:pt idx="920">
                  <c:v>6.02941353324438E-2</c:v>
                </c:pt>
                <c:pt idx="921">
                  <c:v>0.59351242299084706</c:v>
                </c:pt>
                <c:pt idx="922">
                  <c:v>0.68637432199774595</c:v>
                </c:pt>
                <c:pt idx="923">
                  <c:v>0.39419131137687102</c:v>
                </c:pt>
                <c:pt idx="924">
                  <c:v>0.40992997670883602</c:v>
                </c:pt>
                <c:pt idx="925">
                  <c:v>0.49415348769669398</c:v>
                </c:pt>
                <c:pt idx="926">
                  <c:v>0.85391518568512303</c:v>
                </c:pt>
                <c:pt idx="927">
                  <c:v>0.242545701870123</c:v>
                </c:pt>
                <c:pt idx="928">
                  <c:v>0.99359162270992596</c:v>
                </c:pt>
                <c:pt idx="929">
                  <c:v>0.91630976348952098</c:v>
                </c:pt>
                <c:pt idx="930">
                  <c:v>0.36130827088457901</c:v>
                </c:pt>
                <c:pt idx="931">
                  <c:v>0.249259198326131</c:v>
                </c:pt>
                <c:pt idx="932">
                  <c:v>0.37924682087920802</c:v>
                </c:pt>
                <c:pt idx="933">
                  <c:v>0.30144498467713499</c:v>
                </c:pt>
                <c:pt idx="934">
                  <c:v>0.98124017777182804</c:v>
                </c:pt>
                <c:pt idx="935">
                  <c:v>1.08574677416226</c:v>
                </c:pt>
                <c:pt idx="936">
                  <c:v>0.35459173442379999</c:v>
                </c:pt>
                <c:pt idx="937">
                  <c:v>0.114769711628026</c:v>
                </c:pt>
                <c:pt idx="938">
                  <c:v>0.35344990440183699</c:v>
                </c:pt>
                <c:pt idx="939">
                  <c:v>0.55430101453373404</c:v>
                </c:pt>
                <c:pt idx="940">
                  <c:v>0.12804476702492201</c:v>
                </c:pt>
                <c:pt idx="941">
                  <c:v>0.27902640190088601</c:v>
                </c:pt>
                <c:pt idx="942">
                  <c:v>0.84371046028823504</c:v>
                </c:pt>
                <c:pt idx="943">
                  <c:v>0.43549840228654402</c:v>
                </c:pt>
                <c:pt idx="944">
                  <c:v>0.65687182421172396</c:v>
                </c:pt>
                <c:pt idx="945">
                  <c:v>0.64971969050796996</c:v>
                </c:pt>
                <c:pt idx="946">
                  <c:v>0.47302587157272902</c:v>
                </c:pt>
                <c:pt idx="947">
                  <c:v>0.123521903110782</c:v>
                </c:pt>
                <c:pt idx="948">
                  <c:v>0.85864602518542299</c:v>
                </c:pt>
                <c:pt idx="949">
                  <c:v>0.42792213068711199</c:v>
                </c:pt>
                <c:pt idx="950">
                  <c:v>0.77564516208756495</c:v>
                </c:pt>
                <c:pt idx="951">
                  <c:v>7.7529309021450193E-2</c:v>
                </c:pt>
                <c:pt idx="952">
                  <c:v>0.271444354130013</c:v>
                </c:pt>
                <c:pt idx="953">
                  <c:v>1.05999612097854</c:v>
                </c:pt>
                <c:pt idx="954">
                  <c:v>0.17206314911026399</c:v>
                </c:pt>
                <c:pt idx="955">
                  <c:v>0.337629995171083</c:v>
                </c:pt>
                <c:pt idx="956">
                  <c:v>0.91933626629793197</c:v>
                </c:pt>
                <c:pt idx="957">
                  <c:v>0.69172045023811601</c:v>
                </c:pt>
                <c:pt idx="958">
                  <c:v>0.73158224539535499</c:v>
                </c:pt>
                <c:pt idx="959">
                  <c:v>1.5291016829120601</c:v>
                </c:pt>
                <c:pt idx="960">
                  <c:v>0.76452548124624198</c:v>
                </c:pt>
                <c:pt idx="961">
                  <c:v>0.302189710678961</c:v>
                </c:pt>
                <c:pt idx="962">
                  <c:v>0.33191250495607999</c:v>
                </c:pt>
                <c:pt idx="963">
                  <c:v>0.46069048573439397</c:v>
                </c:pt>
                <c:pt idx="964">
                  <c:v>0.18975737332588699</c:v>
                </c:pt>
                <c:pt idx="965">
                  <c:v>9.5159703542040106E-2</c:v>
                </c:pt>
                <c:pt idx="966">
                  <c:v>0.57410226175560497</c:v>
                </c:pt>
                <c:pt idx="967">
                  <c:v>0.67715836624755998</c:v>
                </c:pt>
                <c:pt idx="968">
                  <c:v>0.93521734026969305</c:v>
                </c:pt>
                <c:pt idx="969">
                  <c:v>1.83793103739606</c:v>
                </c:pt>
                <c:pt idx="970">
                  <c:v>1.1345239533151099</c:v>
                </c:pt>
                <c:pt idx="971">
                  <c:v>0.31557158011341502</c:v>
                </c:pt>
                <c:pt idx="972">
                  <c:v>0.55568843792523803</c:v>
                </c:pt>
                <c:pt idx="973">
                  <c:v>0.38400385385969898</c:v>
                </c:pt>
                <c:pt idx="974">
                  <c:v>0.25005359003775302</c:v>
                </c:pt>
                <c:pt idx="975">
                  <c:v>0.116933183239529</c:v>
                </c:pt>
                <c:pt idx="976">
                  <c:v>0.41900880107285798</c:v>
                </c:pt>
                <c:pt idx="977">
                  <c:v>1.0486477833196499</c:v>
                </c:pt>
                <c:pt idx="978">
                  <c:v>0.35329478305170098</c:v>
                </c:pt>
                <c:pt idx="979">
                  <c:v>9.5578163003983696E-2</c:v>
                </c:pt>
                <c:pt idx="980">
                  <c:v>0.762708451330811</c:v>
                </c:pt>
                <c:pt idx="981">
                  <c:v>0.104367116490204</c:v>
                </c:pt>
                <c:pt idx="982">
                  <c:v>5.1924727115832802E-3</c:v>
                </c:pt>
                <c:pt idx="983">
                  <c:v>0.47815537050943102</c:v>
                </c:pt>
                <c:pt idx="984">
                  <c:v>1.0972061588664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88C-4A07-8983-2656369A620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Normal (2)'!$D$2:$D$45</c:f>
              <c:numCache>
                <c:formatCode>General</c:formatCode>
                <c:ptCount val="44"/>
                <c:pt idx="0">
                  <c:v>-1.55971245233211</c:v>
                </c:pt>
                <c:pt idx="1">
                  <c:v>-1.72643774511464</c:v>
                </c:pt>
                <c:pt idx="2">
                  <c:v>-0.64315990777877596</c:v>
                </c:pt>
                <c:pt idx="3">
                  <c:v>-0.80605859490254805</c:v>
                </c:pt>
                <c:pt idx="4">
                  <c:v>-0.69627729993603105</c:v>
                </c:pt>
                <c:pt idx="5">
                  <c:v>-1.5967237649520301</c:v>
                </c:pt>
                <c:pt idx="6">
                  <c:v>-1.34485614789671</c:v>
                </c:pt>
                <c:pt idx="7">
                  <c:v>-2.9926311678474602</c:v>
                </c:pt>
                <c:pt idx="8">
                  <c:v>-0.67888070756353702</c:v>
                </c:pt>
                <c:pt idx="9">
                  <c:v>-1.01544964712871</c:v>
                </c:pt>
                <c:pt idx="10">
                  <c:v>-0.75377624007564503</c:v>
                </c:pt>
                <c:pt idx="11">
                  <c:v>-0.60844143916304005</c:v>
                </c:pt>
                <c:pt idx="12">
                  <c:v>-1.0933241088344701</c:v>
                </c:pt>
                <c:pt idx="13">
                  <c:v>-1.1080183001816</c:v>
                </c:pt>
                <c:pt idx="14">
                  <c:v>-1.0933241088344701</c:v>
                </c:pt>
                <c:pt idx="15">
                  <c:v>-1.0933241088344701</c:v>
                </c:pt>
                <c:pt idx="16">
                  <c:v>-0.71658610332345996</c:v>
                </c:pt>
                <c:pt idx="17">
                  <c:v>-1.0205396862237499</c:v>
                </c:pt>
                <c:pt idx="18">
                  <c:v>-0.87237280756423297</c:v>
                </c:pt>
                <c:pt idx="19">
                  <c:v>-0.79748211529304502</c:v>
                </c:pt>
                <c:pt idx="20">
                  <c:v>-0.87362129717304204</c:v>
                </c:pt>
                <c:pt idx="21">
                  <c:v>-1.1595247509292099</c:v>
                </c:pt>
                <c:pt idx="22">
                  <c:v>-0.97036382222209305</c:v>
                </c:pt>
                <c:pt idx="23">
                  <c:v>-1.0611541808210201</c:v>
                </c:pt>
                <c:pt idx="24">
                  <c:v>-1.5193810982800899</c:v>
                </c:pt>
                <c:pt idx="25">
                  <c:v>-0.71500043064060204</c:v>
                </c:pt>
                <c:pt idx="26">
                  <c:v>-0.71500043064060204</c:v>
                </c:pt>
                <c:pt idx="27">
                  <c:v>-0.80333909763522804</c:v>
                </c:pt>
                <c:pt idx="28">
                  <c:v>-0.80849035610405695</c:v>
                </c:pt>
                <c:pt idx="29">
                  <c:v>-0.80849035610405695</c:v>
                </c:pt>
                <c:pt idx="30">
                  <c:v>-0.66094880841864101</c:v>
                </c:pt>
                <c:pt idx="31">
                  <c:v>-1.37110192426307</c:v>
                </c:pt>
                <c:pt idx="32">
                  <c:v>-0.79007519884551602</c:v>
                </c:pt>
                <c:pt idx="33">
                  <c:v>-0.79313201364302599</c:v>
                </c:pt>
                <c:pt idx="34">
                  <c:v>-1.0261240577878099</c:v>
                </c:pt>
                <c:pt idx="35">
                  <c:v>-2.1156471760651598</c:v>
                </c:pt>
                <c:pt idx="36">
                  <c:v>-0.60508208242578299</c:v>
                </c:pt>
                <c:pt idx="37">
                  <c:v>-0.92599289355066705</c:v>
                </c:pt>
                <c:pt idx="38">
                  <c:v>-0.600431507591909</c:v>
                </c:pt>
                <c:pt idx="39">
                  <c:v>-0.61990270368550404</c:v>
                </c:pt>
                <c:pt idx="40">
                  <c:v>-0.67532051089654699</c:v>
                </c:pt>
                <c:pt idx="41">
                  <c:v>-0.720360990447098</c:v>
                </c:pt>
                <c:pt idx="42">
                  <c:v>-0.60852480545022303</c:v>
                </c:pt>
                <c:pt idx="43">
                  <c:v>-0.70984378925049696</c:v>
                </c:pt>
              </c:numCache>
            </c:numRef>
          </c:xVal>
          <c:yVal>
            <c:numRef>
              <c:f>'Normal (2)'!$E$2:$E$45</c:f>
              <c:numCache>
                <c:formatCode>General</c:formatCode>
                <c:ptCount val="44"/>
                <c:pt idx="0">
                  <c:v>1.4240061298023701</c:v>
                </c:pt>
                <c:pt idx="1">
                  <c:v>1.33853975685969</c:v>
                </c:pt>
                <c:pt idx="2">
                  <c:v>1.7166695411925701</c:v>
                </c:pt>
                <c:pt idx="3">
                  <c:v>2.1986544530626202</c:v>
                </c:pt>
                <c:pt idx="4">
                  <c:v>1.1412214156715501</c:v>
                </c:pt>
                <c:pt idx="5">
                  <c:v>1.2919102689080699</c:v>
                </c:pt>
                <c:pt idx="6">
                  <c:v>1.1096740020200599</c:v>
                </c:pt>
                <c:pt idx="7">
                  <c:v>1.2974091545898701</c:v>
                </c:pt>
                <c:pt idx="8">
                  <c:v>1.25984331960066</c:v>
                </c:pt>
                <c:pt idx="9">
                  <c:v>1.46203312360073</c:v>
                </c:pt>
                <c:pt idx="10">
                  <c:v>1.49594994667185</c:v>
                </c:pt>
                <c:pt idx="11">
                  <c:v>1.3412959466396901</c:v>
                </c:pt>
                <c:pt idx="12">
                  <c:v>1.05734696814953</c:v>
                </c:pt>
                <c:pt idx="13">
                  <c:v>1.10393942551482</c:v>
                </c:pt>
                <c:pt idx="14">
                  <c:v>1.05734696814953</c:v>
                </c:pt>
                <c:pt idx="15">
                  <c:v>1.05734696814953</c:v>
                </c:pt>
                <c:pt idx="16">
                  <c:v>1.9567906851149901</c:v>
                </c:pt>
                <c:pt idx="17">
                  <c:v>2.1226345036938099</c:v>
                </c:pt>
                <c:pt idx="18">
                  <c:v>1.4364880479068001</c:v>
                </c:pt>
                <c:pt idx="19">
                  <c:v>1.4585316799094701</c:v>
                </c:pt>
                <c:pt idx="20">
                  <c:v>1.1812708486822401</c:v>
                </c:pt>
                <c:pt idx="21">
                  <c:v>2.1498764406587698</c:v>
                </c:pt>
                <c:pt idx="22">
                  <c:v>1.1543399805702199</c:v>
                </c:pt>
                <c:pt idx="23">
                  <c:v>1.3564319876456701</c:v>
                </c:pt>
                <c:pt idx="24">
                  <c:v>1.2843236483559699</c:v>
                </c:pt>
                <c:pt idx="25">
                  <c:v>1.4367176545832701</c:v>
                </c:pt>
                <c:pt idx="26">
                  <c:v>1.4367176545832701</c:v>
                </c:pt>
                <c:pt idx="27">
                  <c:v>1.50133303164917</c:v>
                </c:pt>
                <c:pt idx="28">
                  <c:v>2.12719874641353</c:v>
                </c:pt>
                <c:pt idx="29">
                  <c:v>2.12719874641353</c:v>
                </c:pt>
                <c:pt idx="30">
                  <c:v>1.7616005973370199</c:v>
                </c:pt>
                <c:pt idx="31">
                  <c:v>1.13730046754137</c:v>
                </c:pt>
                <c:pt idx="32">
                  <c:v>1.9735593806777101</c:v>
                </c:pt>
                <c:pt idx="33">
                  <c:v>1.8661323762144699</c:v>
                </c:pt>
                <c:pt idx="34">
                  <c:v>1.1234694295119401</c:v>
                </c:pt>
                <c:pt idx="35">
                  <c:v>2.0200846399371399</c:v>
                </c:pt>
                <c:pt idx="36">
                  <c:v>1.3519765249000999</c:v>
                </c:pt>
                <c:pt idx="37">
                  <c:v>1.35921203521657</c:v>
                </c:pt>
                <c:pt idx="38">
                  <c:v>1.2968551327145299</c:v>
                </c:pt>
                <c:pt idx="39">
                  <c:v>1.26196475067592</c:v>
                </c:pt>
                <c:pt idx="40">
                  <c:v>1.2291873985430899</c:v>
                </c:pt>
                <c:pt idx="41">
                  <c:v>2.0011034255874902</c:v>
                </c:pt>
                <c:pt idx="42">
                  <c:v>1.4801755346356</c:v>
                </c:pt>
                <c:pt idx="43">
                  <c:v>1.068433292276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88C-4A07-8983-2656369A6209}"/>
            </c:ext>
          </c:extLst>
        </c:ser>
        <c:ser>
          <c:idx val="2"/>
          <c:order val="2"/>
          <c:tx>
            <c:v>up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Normal (2)'!$G$2:$G$49</c:f>
              <c:numCache>
                <c:formatCode>General</c:formatCode>
                <c:ptCount val="48"/>
                <c:pt idx="0">
                  <c:v>2.5104488129173799</c:v>
                </c:pt>
                <c:pt idx="1">
                  <c:v>1.0605222143445301</c:v>
                </c:pt>
                <c:pt idx="2">
                  <c:v>1.77216417442922</c:v>
                </c:pt>
                <c:pt idx="3">
                  <c:v>0.85659313325218001</c:v>
                </c:pt>
                <c:pt idx="4">
                  <c:v>7.95976586269627</c:v>
                </c:pt>
                <c:pt idx="5">
                  <c:v>8.6539861987418405</c:v>
                </c:pt>
                <c:pt idx="6">
                  <c:v>2.3276601742476899</c:v>
                </c:pt>
                <c:pt idx="7">
                  <c:v>1.0139277894333201</c:v>
                </c:pt>
                <c:pt idx="8">
                  <c:v>0.65483303418127903</c:v>
                </c:pt>
                <c:pt idx="9">
                  <c:v>2.0758200032112502</c:v>
                </c:pt>
                <c:pt idx="10">
                  <c:v>1.38758431172914</c:v>
                </c:pt>
                <c:pt idx="11">
                  <c:v>0.65347695027124197</c:v>
                </c:pt>
                <c:pt idx="12">
                  <c:v>0.77249839711694701</c:v>
                </c:pt>
                <c:pt idx="13">
                  <c:v>2.1975624913867602</c:v>
                </c:pt>
                <c:pt idx="14">
                  <c:v>1.0706717979284099</c:v>
                </c:pt>
                <c:pt idx="15">
                  <c:v>0.76635058353159702</c:v>
                </c:pt>
                <c:pt idx="16">
                  <c:v>0.67984275550518503</c:v>
                </c:pt>
                <c:pt idx="17">
                  <c:v>0.62894799549205205</c:v>
                </c:pt>
                <c:pt idx="18">
                  <c:v>10.381022144338599</c:v>
                </c:pt>
                <c:pt idx="19">
                  <c:v>1.9169165729409201</c:v>
                </c:pt>
                <c:pt idx="20">
                  <c:v>1.4240470329253301</c:v>
                </c:pt>
                <c:pt idx="21">
                  <c:v>2.1975624913867602</c:v>
                </c:pt>
                <c:pt idx="22">
                  <c:v>1.75279748461923</c:v>
                </c:pt>
                <c:pt idx="23">
                  <c:v>2.0189137703854798</c:v>
                </c:pt>
                <c:pt idx="24">
                  <c:v>3.41499870429951</c:v>
                </c:pt>
                <c:pt idx="25">
                  <c:v>3.41499870429951</c:v>
                </c:pt>
                <c:pt idx="26">
                  <c:v>3.49659565084804</c:v>
                </c:pt>
                <c:pt idx="27">
                  <c:v>4.3734323481775403</c:v>
                </c:pt>
                <c:pt idx="28">
                  <c:v>1.8912286680035599</c:v>
                </c:pt>
                <c:pt idx="29">
                  <c:v>0.86546891409497695</c:v>
                </c:pt>
                <c:pt idx="30">
                  <c:v>1.4212904703570499</c:v>
                </c:pt>
                <c:pt idx="31">
                  <c:v>0.72877279631097502</c:v>
                </c:pt>
                <c:pt idx="32">
                  <c:v>0.80040452934728101</c:v>
                </c:pt>
                <c:pt idx="33">
                  <c:v>0.94329623189199496</c:v>
                </c:pt>
                <c:pt idx="34">
                  <c:v>0.91190681126573403</c:v>
                </c:pt>
                <c:pt idx="35">
                  <c:v>3.7307297048583301</c:v>
                </c:pt>
                <c:pt idx="36">
                  <c:v>2.26613562557815</c:v>
                </c:pt>
                <c:pt idx="37">
                  <c:v>0.939680899754605</c:v>
                </c:pt>
                <c:pt idx="38">
                  <c:v>2.1190850951862701</c:v>
                </c:pt>
                <c:pt idx="39">
                  <c:v>1.3019436118254899</c:v>
                </c:pt>
                <c:pt idx="40">
                  <c:v>0.64435780247427998</c:v>
                </c:pt>
                <c:pt idx="41">
                  <c:v>0.61941614346100804</c:v>
                </c:pt>
                <c:pt idx="42">
                  <c:v>1.04030798865354</c:v>
                </c:pt>
                <c:pt idx="43">
                  <c:v>8.3809339891917407</c:v>
                </c:pt>
                <c:pt idx="44">
                  <c:v>5.1022226383447897</c:v>
                </c:pt>
                <c:pt idx="45">
                  <c:v>3.7311027677168802</c:v>
                </c:pt>
                <c:pt idx="46">
                  <c:v>0.69361479288327799</c:v>
                </c:pt>
                <c:pt idx="47">
                  <c:v>0.68603974812335899</c:v>
                </c:pt>
              </c:numCache>
            </c:numRef>
          </c:xVal>
          <c:yVal>
            <c:numRef>
              <c:f>'Normal (2)'!$H$2:$H$49</c:f>
              <c:numCache>
                <c:formatCode>General</c:formatCode>
                <c:ptCount val="48"/>
                <c:pt idx="0">
                  <c:v>1.0045324354709</c:v>
                </c:pt>
                <c:pt idx="1">
                  <c:v>1.54349357687471</c:v>
                </c:pt>
                <c:pt idx="2">
                  <c:v>1.10072250466194</c:v>
                </c:pt>
                <c:pt idx="3">
                  <c:v>1.7103194202968599</c:v>
                </c:pt>
                <c:pt idx="4">
                  <c:v>1.65519323072539</c:v>
                </c:pt>
                <c:pt idx="5">
                  <c:v>2.12762131891323</c:v>
                </c:pt>
                <c:pt idx="6">
                  <c:v>2.1738593120707002</c:v>
                </c:pt>
                <c:pt idx="7">
                  <c:v>2.1066152709086601</c:v>
                </c:pt>
                <c:pt idx="8">
                  <c:v>1.70629487244694</c:v>
                </c:pt>
                <c:pt idx="9">
                  <c:v>2.4255439294182599</c:v>
                </c:pt>
                <c:pt idx="10">
                  <c:v>1.23326372313066</c:v>
                </c:pt>
                <c:pt idx="11">
                  <c:v>1.7799009239933301</c:v>
                </c:pt>
                <c:pt idx="12">
                  <c:v>1.94693709103483</c:v>
                </c:pt>
                <c:pt idx="13">
                  <c:v>2.41156653590471</c:v>
                </c:pt>
                <c:pt idx="14">
                  <c:v>1.09083877685592</c:v>
                </c:pt>
                <c:pt idx="15">
                  <c:v>1.03978165780544</c:v>
                </c:pt>
                <c:pt idx="16">
                  <c:v>1.0153424897555301</c:v>
                </c:pt>
                <c:pt idx="17">
                  <c:v>1.16314744113729</c:v>
                </c:pt>
                <c:pt idx="18">
                  <c:v>1.6275655015105599</c:v>
                </c:pt>
                <c:pt idx="19">
                  <c:v>1.9715142630719</c:v>
                </c:pt>
                <c:pt idx="20">
                  <c:v>1.7282339565398701</c:v>
                </c:pt>
                <c:pt idx="21">
                  <c:v>2.41156653590471</c:v>
                </c:pt>
                <c:pt idx="22">
                  <c:v>1.31311389047829</c:v>
                </c:pt>
                <c:pt idx="23">
                  <c:v>1.6329597289839799</c:v>
                </c:pt>
                <c:pt idx="24">
                  <c:v>1.28279125625716</c:v>
                </c:pt>
                <c:pt idx="25">
                  <c:v>1.28279125625716</c:v>
                </c:pt>
                <c:pt idx="26">
                  <c:v>1.2995511682310401</c:v>
                </c:pt>
                <c:pt idx="27">
                  <c:v>1.4628833255</c:v>
                </c:pt>
                <c:pt idx="28">
                  <c:v>2.38302692593623</c:v>
                </c:pt>
                <c:pt idx="29">
                  <c:v>2.05232825655535</c:v>
                </c:pt>
                <c:pt idx="30">
                  <c:v>1.2898073846890801</c:v>
                </c:pt>
                <c:pt idx="31">
                  <c:v>1.7222258220908899</c:v>
                </c:pt>
                <c:pt idx="32">
                  <c:v>1.7948491861903699</c:v>
                </c:pt>
                <c:pt idx="33">
                  <c:v>1.8335775701419501</c:v>
                </c:pt>
                <c:pt idx="34">
                  <c:v>1.44834618752545</c:v>
                </c:pt>
                <c:pt idx="35">
                  <c:v>2.4027935513757002</c:v>
                </c:pt>
                <c:pt idx="36">
                  <c:v>2.0034001446634302</c:v>
                </c:pt>
                <c:pt idx="37">
                  <c:v>1.2061309313608399</c:v>
                </c:pt>
                <c:pt idx="38">
                  <c:v>1.70189969372853</c:v>
                </c:pt>
                <c:pt idx="39">
                  <c:v>1.4866032462530501</c:v>
                </c:pt>
                <c:pt idx="40">
                  <c:v>1.0267970454534101</c:v>
                </c:pt>
                <c:pt idx="41">
                  <c:v>1.35723760717289</c:v>
                </c:pt>
                <c:pt idx="42">
                  <c:v>1.9904332492407799</c:v>
                </c:pt>
                <c:pt idx="43">
                  <c:v>2.60920436139221</c:v>
                </c:pt>
                <c:pt idx="44">
                  <c:v>1.1532683446015</c:v>
                </c:pt>
                <c:pt idx="45">
                  <c:v>1.1532683446015</c:v>
                </c:pt>
                <c:pt idx="46">
                  <c:v>1.1457330728187201</c:v>
                </c:pt>
                <c:pt idx="47">
                  <c:v>1.32846791600331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88C-4A07-8983-2656369A6209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488C-4A07-8983-2656369A6209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0</c:v>
              </c:pt>
              <c:pt idx="1">
                <c:v>20</c:v>
              </c:pt>
            </c:numLit>
          </c:xVal>
          <c:yVal>
            <c:numLit>
              <c:formatCode>General</c:formatCode>
              <c:ptCount val="2"/>
              <c:pt idx="0">
                <c:v>1</c:v>
              </c:pt>
              <c:pt idx="1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488C-4A07-8983-2656369A6209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488C-4A07-8983-2656369A6209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488C-4A07-8983-2656369A62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20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</a:t>
                </a:r>
                <a:r>
                  <a:rPr lang="en-US"/>
                  <a:t>HPVB /</a:t>
                </a:r>
                <a:r>
                  <a:rPr lang="en-US" baseline="0"/>
                  <a:t> PB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5"/>
      </c:valAx>
      <c:valAx>
        <c:axId val="872775711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P (oPLS-DA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0"/>
        <c:crossBetween val="midCat"/>
        <c:majorUnit val="1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07185185185185"/>
          <c:y val="7.7611111111111117E-2"/>
          <c:w val="0.8231640740740741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HFD (2)'!$B$1</c:f>
              <c:strCache>
                <c:ptCount val="1"/>
                <c:pt idx="0">
                  <c:v>HFD.vip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(2)'!$A$2:$A$855</c:f>
              <c:numCache>
                <c:formatCode>General</c:formatCode>
                <c:ptCount val="854"/>
                <c:pt idx="0">
                  <c:v>0.34232214918094001</c:v>
                </c:pt>
                <c:pt idx="1">
                  <c:v>-0.51262135715614598</c:v>
                </c:pt>
                <c:pt idx="2">
                  <c:v>-0.29935451420033299</c:v>
                </c:pt>
                <c:pt idx="3">
                  <c:v>9.1691324018166404E-2</c:v>
                </c:pt>
                <c:pt idx="4">
                  <c:v>2.87860427127485E-2</c:v>
                </c:pt>
                <c:pt idx="5">
                  <c:v>-4.7655040463237897E-3</c:v>
                </c:pt>
                <c:pt idx="6">
                  <c:v>-0.16335004333769701</c:v>
                </c:pt>
                <c:pt idx="7">
                  <c:v>-0.28571809334078102</c:v>
                </c:pt>
                <c:pt idx="8">
                  <c:v>1.3571882506288699</c:v>
                </c:pt>
                <c:pt idx="9">
                  <c:v>-0.47979339038633101</c:v>
                </c:pt>
                <c:pt idx="10">
                  <c:v>1.6706763099152699E-2</c:v>
                </c:pt>
                <c:pt idx="11">
                  <c:v>-0.229819903276373</c:v>
                </c:pt>
                <c:pt idx="12">
                  <c:v>0.35985592741244099</c:v>
                </c:pt>
                <c:pt idx="13">
                  <c:v>-7.1905000964603297E-2</c:v>
                </c:pt>
                <c:pt idx="14">
                  <c:v>1.06880567824779E-2</c:v>
                </c:pt>
                <c:pt idx="15">
                  <c:v>0.46291381035433299</c:v>
                </c:pt>
                <c:pt idx="16">
                  <c:v>0.31341178589761298</c:v>
                </c:pt>
                <c:pt idx="17">
                  <c:v>-0.28597638683488602</c:v>
                </c:pt>
                <c:pt idx="18">
                  <c:v>8.3899751901668193E-2</c:v>
                </c:pt>
                <c:pt idx="19">
                  <c:v>0.13721402456850401</c:v>
                </c:pt>
                <c:pt idx="20">
                  <c:v>0.99853853491766797</c:v>
                </c:pt>
                <c:pt idx="21">
                  <c:v>0.99166963868438096</c:v>
                </c:pt>
                <c:pt idx="22">
                  <c:v>0.84376077033548402</c:v>
                </c:pt>
                <c:pt idx="23">
                  <c:v>2.2925249880137999</c:v>
                </c:pt>
                <c:pt idx="24">
                  <c:v>1.3063812348530399</c:v>
                </c:pt>
                <c:pt idx="25">
                  <c:v>0.44994663667326801</c:v>
                </c:pt>
                <c:pt idx="26">
                  <c:v>-0.264325003536514</c:v>
                </c:pt>
                <c:pt idx="27">
                  <c:v>9.2306669191313001E-2</c:v>
                </c:pt>
                <c:pt idx="28">
                  <c:v>-0.18626468958401099</c:v>
                </c:pt>
                <c:pt idx="29">
                  <c:v>-0.40401255886014498</c:v>
                </c:pt>
                <c:pt idx="30">
                  <c:v>0.15500763725842001</c:v>
                </c:pt>
                <c:pt idx="31">
                  <c:v>-0.10994322201996801</c:v>
                </c:pt>
                <c:pt idx="32">
                  <c:v>0.19737120043130299</c:v>
                </c:pt>
                <c:pt idx="33">
                  <c:v>-7.0921335517301398E-2</c:v>
                </c:pt>
                <c:pt idx="34">
                  <c:v>1.07459072652868E-2</c:v>
                </c:pt>
                <c:pt idx="35">
                  <c:v>-7.0921335517301398E-2</c:v>
                </c:pt>
                <c:pt idx="36">
                  <c:v>-7.0921335517301398E-2</c:v>
                </c:pt>
                <c:pt idx="37">
                  <c:v>0.26499545164768501</c:v>
                </c:pt>
                <c:pt idx="38">
                  <c:v>0.26499545164768501</c:v>
                </c:pt>
                <c:pt idx="39">
                  <c:v>-7.0921335517301398E-2</c:v>
                </c:pt>
                <c:pt idx="40">
                  <c:v>0.95088973261750598</c:v>
                </c:pt>
                <c:pt idx="41">
                  <c:v>0.16895353325082199</c:v>
                </c:pt>
                <c:pt idx="42">
                  <c:v>-6.8422141712614903E-2</c:v>
                </c:pt>
                <c:pt idx="43">
                  <c:v>0.58269815857836904</c:v>
                </c:pt>
                <c:pt idx="44">
                  <c:v>5.6222705298167898E-2</c:v>
                </c:pt>
                <c:pt idx="45">
                  <c:v>-7.1689167443669405E-2</c:v>
                </c:pt>
                <c:pt idx="46">
                  <c:v>-2.7666468999395E-2</c:v>
                </c:pt>
                <c:pt idx="47">
                  <c:v>0.51679377583443598</c:v>
                </c:pt>
                <c:pt idx="48">
                  <c:v>-3.20344403030546E-2</c:v>
                </c:pt>
                <c:pt idx="49">
                  <c:v>0.63049562545559901</c:v>
                </c:pt>
                <c:pt idx="50">
                  <c:v>0.25340262567223099</c:v>
                </c:pt>
                <c:pt idx="51">
                  <c:v>0.30291873473931502</c:v>
                </c:pt>
                <c:pt idx="52">
                  <c:v>-0.21672842005045401</c:v>
                </c:pt>
                <c:pt idx="53">
                  <c:v>0.33528987036775099</c:v>
                </c:pt>
                <c:pt idx="54">
                  <c:v>0.34284004507633797</c:v>
                </c:pt>
                <c:pt idx="55">
                  <c:v>0.26507179268449998</c:v>
                </c:pt>
                <c:pt idx="56">
                  <c:v>-5.4849553754644502E-2</c:v>
                </c:pt>
                <c:pt idx="57">
                  <c:v>0.12716380183638801</c:v>
                </c:pt>
                <c:pt idx="58">
                  <c:v>0.339626363174725</c:v>
                </c:pt>
                <c:pt idx="59">
                  <c:v>-0.51262135715614598</c:v>
                </c:pt>
                <c:pt idx="60">
                  <c:v>0.50287678912605005</c:v>
                </c:pt>
                <c:pt idx="61">
                  <c:v>1.0643155543695</c:v>
                </c:pt>
                <c:pt idx="62">
                  <c:v>-0.10737449029198</c:v>
                </c:pt>
                <c:pt idx="63">
                  <c:v>0.417775066510715</c:v>
                </c:pt>
                <c:pt idx="64">
                  <c:v>0.109678122695421</c:v>
                </c:pt>
                <c:pt idx="65">
                  <c:v>-0.17155059963458799</c:v>
                </c:pt>
                <c:pt idx="66">
                  <c:v>-0.26971679110862701</c:v>
                </c:pt>
                <c:pt idx="67">
                  <c:v>-7.7401736072797503E-2</c:v>
                </c:pt>
                <c:pt idx="68">
                  <c:v>-0.323998863212206</c:v>
                </c:pt>
                <c:pt idx="69">
                  <c:v>-0.49566317550082301</c:v>
                </c:pt>
                <c:pt idx="70">
                  <c:v>-0.381304752554259</c:v>
                </c:pt>
                <c:pt idx="71">
                  <c:v>0.226298477420807</c:v>
                </c:pt>
                <c:pt idx="72">
                  <c:v>0.51212798994829201</c:v>
                </c:pt>
                <c:pt idx="73">
                  <c:v>0.54978133670528595</c:v>
                </c:pt>
                <c:pt idx="74">
                  <c:v>0.42762843170114401</c:v>
                </c:pt>
                <c:pt idx="75">
                  <c:v>-0.32212277547769702</c:v>
                </c:pt>
                <c:pt idx="76">
                  <c:v>-0.25167283420201397</c:v>
                </c:pt>
                <c:pt idx="77">
                  <c:v>-9.2559594132101297E-2</c:v>
                </c:pt>
                <c:pt idx="78">
                  <c:v>-0.195815871161828</c:v>
                </c:pt>
                <c:pt idx="79">
                  <c:v>-0.25303468882730801</c:v>
                </c:pt>
                <c:pt idx="80">
                  <c:v>-0.47807385514966599</c:v>
                </c:pt>
                <c:pt idx="81">
                  <c:v>4.9432285793658201E-2</c:v>
                </c:pt>
                <c:pt idx="82">
                  <c:v>0.57782340888206196</c:v>
                </c:pt>
                <c:pt idx="83">
                  <c:v>0.304712569878759</c:v>
                </c:pt>
                <c:pt idx="84">
                  <c:v>0.26427864484225599</c:v>
                </c:pt>
                <c:pt idx="85">
                  <c:v>-0.15937841207474501</c:v>
                </c:pt>
                <c:pt idx="86">
                  <c:v>-0.28032237407946903</c:v>
                </c:pt>
                <c:pt idx="87">
                  <c:v>0.31670259018500801</c:v>
                </c:pt>
                <c:pt idx="88">
                  <c:v>0.236476122981301</c:v>
                </c:pt>
                <c:pt idx="89">
                  <c:v>0.268508657984323</c:v>
                </c:pt>
                <c:pt idx="90">
                  <c:v>0.55830132155192902</c:v>
                </c:pt>
                <c:pt idx="91">
                  <c:v>6.8291273386947501E-2</c:v>
                </c:pt>
                <c:pt idx="92">
                  <c:v>-0.425012903742438</c:v>
                </c:pt>
                <c:pt idx="93">
                  <c:v>0.13721402456850401</c:v>
                </c:pt>
                <c:pt idx="94">
                  <c:v>0.39397540147281201</c:v>
                </c:pt>
                <c:pt idx="95">
                  <c:v>-0.21530606832955601</c:v>
                </c:pt>
                <c:pt idx="96">
                  <c:v>-0.184659471049433</c:v>
                </c:pt>
                <c:pt idx="97">
                  <c:v>0.14930123809634599</c:v>
                </c:pt>
                <c:pt idx="98">
                  <c:v>0.59476050540762904</c:v>
                </c:pt>
                <c:pt idx="99">
                  <c:v>-0.17287815420618299</c:v>
                </c:pt>
                <c:pt idx="100">
                  <c:v>1.7719819859327099</c:v>
                </c:pt>
                <c:pt idx="101">
                  <c:v>-1.01755712178072</c:v>
                </c:pt>
                <c:pt idx="102">
                  <c:v>0.51269509996556695</c:v>
                </c:pt>
                <c:pt idx="103">
                  <c:v>0.23004361446173399</c:v>
                </c:pt>
                <c:pt idx="104">
                  <c:v>-2.3710517841737899E-2</c:v>
                </c:pt>
                <c:pt idx="105">
                  <c:v>0.78930638437007306</c:v>
                </c:pt>
                <c:pt idx="106">
                  <c:v>-0.40226543088505401</c:v>
                </c:pt>
                <c:pt idx="107">
                  <c:v>0.724551419831858</c:v>
                </c:pt>
                <c:pt idx="108">
                  <c:v>5.26932719534891</c:v>
                </c:pt>
                <c:pt idx="109">
                  <c:v>-1.24558212395669</c:v>
                </c:pt>
                <c:pt idx="110">
                  <c:v>-3.5381700146684798E-2</c:v>
                </c:pt>
                <c:pt idx="111">
                  <c:v>0.42573306801773603</c:v>
                </c:pt>
                <c:pt idx="112">
                  <c:v>0.14304618451866299</c:v>
                </c:pt>
                <c:pt idx="113">
                  <c:v>3.4865840886637002E-2</c:v>
                </c:pt>
                <c:pt idx="114">
                  <c:v>0.26694291386761398</c:v>
                </c:pt>
                <c:pt idx="115">
                  <c:v>0.37024360243601301</c:v>
                </c:pt>
                <c:pt idx="116">
                  <c:v>-6.0932787802288002E-2</c:v>
                </c:pt>
                <c:pt idx="117">
                  <c:v>0.21669375352463599</c:v>
                </c:pt>
                <c:pt idx="118">
                  <c:v>-0.107200590277748</c:v>
                </c:pt>
                <c:pt idx="119">
                  <c:v>-0.80628151049810803</c:v>
                </c:pt>
                <c:pt idx="120">
                  <c:v>0.118755372863409</c:v>
                </c:pt>
                <c:pt idx="121">
                  <c:v>-4.4211703010361598E-2</c:v>
                </c:pt>
                <c:pt idx="122">
                  <c:v>0.17749953895796799</c:v>
                </c:pt>
                <c:pt idx="123">
                  <c:v>0.36170631620986898</c:v>
                </c:pt>
                <c:pt idx="124">
                  <c:v>0.40373612993018898</c:v>
                </c:pt>
                <c:pt idx="125">
                  <c:v>-7.1905000964603297E-2</c:v>
                </c:pt>
                <c:pt idx="126">
                  <c:v>0.15892145339973299</c:v>
                </c:pt>
                <c:pt idx="127">
                  <c:v>-0.12114942464272301</c:v>
                </c:pt>
                <c:pt idx="128">
                  <c:v>0.50144221205626704</c:v>
                </c:pt>
                <c:pt idx="129">
                  <c:v>3.9031722535376297E-2</c:v>
                </c:pt>
                <c:pt idx="130">
                  <c:v>-0.22255389950222501</c:v>
                </c:pt>
                <c:pt idx="131">
                  <c:v>-0.66889743911477195</c:v>
                </c:pt>
                <c:pt idx="132">
                  <c:v>-0.66889743911477195</c:v>
                </c:pt>
                <c:pt idx="133">
                  <c:v>-0.27454566064341901</c:v>
                </c:pt>
                <c:pt idx="134">
                  <c:v>0.22792140253009299</c:v>
                </c:pt>
                <c:pt idx="135">
                  <c:v>-0.27454566064341901</c:v>
                </c:pt>
                <c:pt idx="136">
                  <c:v>0.10986700916728501</c:v>
                </c:pt>
                <c:pt idx="137">
                  <c:v>0.26015611972915997</c:v>
                </c:pt>
                <c:pt idx="138">
                  <c:v>0.19737120043130299</c:v>
                </c:pt>
                <c:pt idx="139">
                  <c:v>0.29434772862754399</c:v>
                </c:pt>
                <c:pt idx="140">
                  <c:v>1.73504368421834E-2</c:v>
                </c:pt>
                <c:pt idx="141">
                  <c:v>0.42765687550916598</c:v>
                </c:pt>
                <c:pt idx="142">
                  <c:v>-0.41008719120278603</c:v>
                </c:pt>
                <c:pt idx="143">
                  <c:v>-1.6241319674531199E-2</c:v>
                </c:pt>
                <c:pt idx="144">
                  <c:v>1.77930550720706</c:v>
                </c:pt>
                <c:pt idx="145">
                  <c:v>-0.54009093271614195</c:v>
                </c:pt>
                <c:pt idx="146">
                  <c:v>-0.14127628094977199</c:v>
                </c:pt>
                <c:pt idx="147">
                  <c:v>0.22813466723136999</c:v>
                </c:pt>
                <c:pt idx="148">
                  <c:v>-0.22255389950222501</c:v>
                </c:pt>
                <c:pt idx="149">
                  <c:v>-2.5992832671092002E-4</c:v>
                </c:pt>
                <c:pt idx="150">
                  <c:v>-0.11839793000198</c:v>
                </c:pt>
                <c:pt idx="151">
                  <c:v>-0.36727651287383101</c:v>
                </c:pt>
                <c:pt idx="152">
                  <c:v>-0.23942368106234599</c:v>
                </c:pt>
                <c:pt idx="153">
                  <c:v>0.42094141574647898</c:v>
                </c:pt>
                <c:pt idx="154">
                  <c:v>0.31384934949295301</c:v>
                </c:pt>
                <c:pt idx="155">
                  <c:v>0.230052863971618</c:v>
                </c:pt>
                <c:pt idx="156">
                  <c:v>0.54978133670528595</c:v>
                </c:pt>
                <c:pt idx="157">
                  <c:v>-3.5828228257242703E-2</c:v>
                </c:pt>
                <c:pt idx="158">
                  <c:v>-8.1410257068271097E-2</c:v>
                </c:pt>
                <c:pt idx="159">
                  <c:v>1.7483643011765</c:v>
                </c:pt>
                <c:pt idx="160">
                  <c:v>0.50123459808105497</c:v>
                </c:pt>
                <c:pt idx="161">
                  <c:v>-2.09842020751588E-2</c:v>
                </c:pt>
                <c:pt idx="162">
                  <c:v>-0.131294327420614</c:v>
                </c:pt>
                <c:pt idx="163">
                  <c:v>-0.23110868375673599</c:v>
                </c:pt>
                <c:pt idx="164">
                  <c:v>2.5827545278370102E-2</c:v>
                </c:pt>
                <c:pt idx="165">
                  <c:v>0.47000520392682699</c:v>
                </c:pt>
                <c:pt idx="166">
                  <c:v>-0.17053101015717101</c:v>
                </c:pt>
                <c:pt idx="167">
                  <c:v>-0.17053101015717101</c:v>
                </c:pt>
                <c:pt idx="168">
                  <c:v>-0.15626995480463399</c:v>
                </c:pt>
                <c:pt idx="169">
                  <c:v>-0.15626995480463399</c:v>
                </c:pt>
                <c:pt idx="170">
                  <c:v>-0.15626995480463399</c:v>
                </c:pt>
                <c:pt idx="171">
                  <c:v>-0.236738274581761</c:v>
                </c:pt>
                <c:pt idx="172">
                  <c:v>-0.236738274581761</c:v>
                </c:pt>
                <c:pt idx="173">
                  <c:v>-0.50971025385218904</c:v>
                </c:pt>
                <c:pt idx="174">
                  <c:v>-0.50971025385218904</c:v>
                </c:pt>
                <c:pt idx="175">
                  <c:v>-0.23392579367640601</c:v>
                </c:pt>
                <c:pt idx="176">
                  <c:v>-0.23392579367640601</c:v>
                </c:pt>
                <c:pt idx="177">
                  <c:v>-0.106141771951605</c:v>
                </c:pt>
                <c:pt idx="178">
                  <c:v>-0.28618490174304501</c:v>
                </c:pt>
                <c:pt idx="179">
                  <c:v>-0.28618490174304501</c:v>
                </c:pt>
                <c:pt idx="180">
                  <c:v>-7.7401736072797503E-2</c:v>
                </c:pt>
                <c:pt idx="181">
                  <c:v>-0.12758026329633099</c:v>
                </c:pt>
                <c:pt idx="182">
                  <c:v>-0.250818291474602</c:v>
                </c:pt>
                <c:pt idx="183">
                  <c:v>-0.39934472760247602</c:v>
                </c:pt>
                <c:pt idx="184">
                  <c:v>-0.323998863212206</c:v>
                </c:pt>
                <c:pt idx="185">
                  <c:v>-0.28249476734031997</c:v>
                </c:pt>
                <c:pt idx="186">
                  <c:v>-0.239358458370103</c:v>
                </c:pt>
                <c:pt idx="187">
                  <c:v>-0.237875137795938</c:v>
                </c:pt>
                <c:pt idx="188">
                  <c:v>-0.26735503000582</c:v>
                </c:pt>
                <c:pt idx="189">
                  <c:v>-3.9414204310343801E-2</c:v>
                </c:pt>
                <c:pt idx="190">
                  <c:v>-0.12019614239939801</c:v>
                </c:pt>
                <c:pt idx="191">
                  <c:v>-0.119817403843109</c:v>
                </c:pt>
                <c:pt idx="192">
                  <c:v>-8.1192705095808303E-3</c:v>
                </c:pt>
                <c:pt idx="193">
                  <c:v>3.9218912085983902E-2</c:v>
                </c:pt>
                <c:pt idx="194">
                  <c:v>-0.25963278077813001</c:v>
                </c:pt>
                <c:pt idx="195">
                  <c:v>-3.6681203335907103E-2</c:v>
                </c:pt>
                <c:pt idx="196">
                  <c:v>-0.12674910817598001</c:v>
                </c:pt>
                <c:pt idx="197">
                  <c:v>-0.28176329060913802</c:v>
                </c:pt>
                <c:pt idx="198">
                  <c:v>-0.14034547579088399</c:v>
                </c:pt>
                <c:pt idx="199">
                  <c:v>0.32611072250058698</c:v>
                </c:pt>
                <c:pt idx="200">
                  <c:v>-0.24599925956622401</c:v>
                </c:pt>
                <c:pt idx="201">
                  <c:v>0.14989412249449</c:v>
                </c:pt>
                <c:pt idx="202">
                  <c:v>0.105916377866314</c:v>
                </c:pt>
                <c:pt idx="203">
                  <c:v>0.63966426187324898</c:v>
                </c:pt>
                <c:pt idx="204">
                  <c:v>0.54579358892387897</c:v>
                </c:pt>
                <c:pt idx="205">
                  <c:v>0.55647308137406204</c:v>
                </c:pt>
                <c:pt idx="206">
                  <c:v>0.32562831090153399</c:v>
                </c:pt>
                <c:pt idx="207">
                  <c:v>3.2347194627194403E-2</c:v>
                </c:pt>
                <c:pt idx="208">
                  <c:v>0.32237717452954301</c:v>
                </c:pt>
                <c:pt idx="209">
                  <c:v>0.33060624548600198</c:v>
                </c:pt>
                <c:pt idx="210">
                  <c:v>0.38730598369214803</c:v>
                </c:pt>
                <c:pt idx="211">
                  <c:v>-6.8209133937004998E-3</c:v>
                </c:pt>
                <c:pt idx="212">
                  <c:v>-2.5922504060560798E-2</c:v>
                </c:pt>
                <c:pt idx="213">
                  <c:v>0.24774186574097001</c:v>
                </c:pt>
                <c:pt idx="214">
                  <c:v>-7.6112011293959503E-2</c:v>
                </c:pt>
                <c:pt idx="215">
                  <c:v>-0.43234713679311898</c:v>
                </c:pt>
                <c:pt idx="216">
                  <c:v>0.18501346307889699</c:v>
                </c:pt>
                <c:pt idx="217">
                  <c:v>0.23090238255012999</c:v>
                </c:pt>
                <c:pt idx="218">
                  <c:v>-9.7160569769812494E-2</c:v>
                </c:pt>
                <c:pt idx="219">
                  <c:v>3.3332243915659401</c:v>
                </c:pt>
                <c:pt idx="220">
                  <c:v>7.0429169645043E-3</c:v>
                </c:pt>
                <c:pt idx="221">
                  <c:v>-9.1033414585015501E-2</c:v>
                </c:pt>
                <c:pt idx="222">
                  <c:v>3.6021814862158701</c:v>
                </c:pt>
                <c:pt idx="223">
                  <c:v>-5.3094909104495297E-2</c:v>
                </c:pt>
                <c:pt idx="224">
                  <c:v>-8.1634924394708597E-2</c:v>
                </c:pt>
                <c:pt idx="225">
                  <c:v>-0.277587071030517</c:v>
                </c:pt>
                <c:pt idx="226">
                  <c:v>-2.7240688080671101E-2</c:v>
                </c:pt>
                <c:pt idx="227">
                  <c:v>0.33060624548600198</c:v>
                </c:pt>
                <c:pt idx="228">
                  <c:v>0.50369832066393705</c:v>
                </c:pt>
                <c:pt idx="229">
                  <c:v>0.10713143188528</c:v>
                </c:pt>
                <c:pt idx="230">
                  <c:v>-3.0159244901669702</c:v>
                </c:pt>
                <c:pt idx="231">
                  <c:v>0.16863852749005601</c:v>
                </c:pt>
                <c:pt idx="232">
                  <c:v>-0.21484475312292201</c:v>
                </c:pt>
                <c:pt idx="233">
                  <c:v>0.73374511731637504</c:v>
                </c:pt>
                <c:pt idx="234">
                  <c:v>0.60356630256360799</c:v>
                </c:pt>
                <c:pt idx="235">
                  <c:v>-0.246691821048726</c:v>
                </c:pt>
                <c:pt idx="236">
                  <c:v>-1.6716788812313799E-2</c:v>
                </c:pt>
                <c:pt idx="237">
                  <c:v>1.01251418345139E-2</c:v>
                </c:pt>
                <c:pt idx="238">
                  <c:v>0.136258036394377</c:v>
                </c:pt>
                <c:pt idx="239">
                  <c:v>-0.199769658148364</c:v>
                </c:pt>
                <c:pt idx="240">
                  <c:v>0.615683474695504</c:v>
                </c:pt>
                <c:pt idx="241">
                  <c:v>-8.7850207552078896E-2</c:v>
                </c:pt>
                <c:pt idx="242">
                  <c:v>-4.7526723647641697E-2</c:v>
                </c:pt>
                <c:pt idx="243">
                  <c:v>-0.49487505026180401</c:v>
                </c:pt>
                <c:pt idx="244">
                  <c:v>-0.36614477469606399</c:v>
                </c:pt>
                <c:pt idx="245">
                  <c:v>-0.19612734961237299</c:v>
                </c:pt>
                <c:pt idx="246">
                  <c:v>-0.41720636021739999</c:v>
                </c:pt>
                <c:pt idx="247">
                  <c:v>-0.31787387271138801</c:v>
                </c:pt>
                <c:pt idx="248">
                  <c:v>-0.16224894878480201</c:v>
                </c:pt>
                <c:pt idx="249">
                  <c:v>-7.4176708571252595E-2</c:v>
                </c:pt>
                <c:pt idx="250">
                  <c:v>-4.04936500052685E-2</c:v>
                </c:pt>
                <c:pt idx="251">
                  <c:v>-0.2927685957542</c:v>
                </c:pt>
                <c:pt idx="252">
                  <c:v>0.274740131652152</c:v>
                </c:pt>
                <c:pt idx="253">
                  <c:v>3.27650737102659E-2</c:v>
                </c:pt>
                <c:pt idx="254">
                  <c:v>-0.36222382901543099</c:v>
                </c:pt>
                <c:pt idx="255">
                  <c:v>-0.58092020320158799</c:v>
                </c:pt>
                <c:pt idx="256">
                  <c:v>-0.101063798901941</c:v>
                </c:pt>
                <c:pt idx="257">
                  <c:v>0.236700700105621</c:v>
                </c:pt>
                <c:pt idx="258">
                  <c:v>3.4715793559318898E-2</c:v>
                </c:pt>
                <c:pt idx="259">
                  <c:v>-0.20647220640332101</c:v>
                </c:pt>
                <c:pt idx="260">
                  <c:v>-6.5966059928173698E-2</c:v>
                </c:pt>
                <c:pt idx="261">
                  <c:v>0.310319449845462</c:v>
                </c:pt>
                <c:pt idx="262">
                  <c:v>-0.269614393499019</c:v>
                </c:pt>
                <c:pt idx="263">
                  <c:v>-0.16039441397434301</c:v>
                </c:pt>
                <c:pt idx="264">
                  <c:v>3.4012781062369803E-2</c:v>
                </c:pt>
                <c:pt idx="265">
                  <c:v>-0.41633994594713197</c:v>
                </c:pt>
                <c:pt idx="266">
                  <c:v>-7.4176708571252595E-2</c:v>
                </c:pt>
                <c:pt idx="267">
                  <c:v>-0.54323990546428003</c:v>
                </c:pt>
                <c:pt idx="268">
                  <c:v>-7.6112011293959503E-2</c:v>
                </c:pt>
                <c:pt idx="269">
                  <c:v>-8.7205589532678193E-2</c:v>
                </c:pt>
                <c:pt idx="270">
                  <c:v>1.46427391574535E-2</c:v>
                </c:pt>
                <c:pt idx="271">
                  <c:v>-0.105578449359291</c:v>
                </c:pt>
                <c:pt idx="272">
                  <c:v>-0.16724537136127901</c:v>
                </c:pt>
                <c:pt idx="273">
                  <c:v>1.2822308175615299E-2</c:v>
                </c:pt>
                <c:pt idx="274">
                  <c:v>0.57207993586747896</c:v>
                </c:pt>
                <c:pt idx="275">
                  <c:v>-0.24071934015305901</c:v>
                </c:pt>
                <c:pt idx="276">
                  <c:v>0.61896630062553304</c:v>
                </c:pt>
                <c:pt idx="277">
                  <c:v>0.330282161986171</c:v>
                </c:pt>
                <c:pt idx="278">
                  <c:v>8.6761508169234003E-2</c:v>
                </c:pt>
                <c:pt idx="279">
                  <c:v>-0.31787387271138801</c:v>
                </c:pt>
                <c:pt idx="280">
                  <c:v>8.4859993392396596E-2</c:v>
                </c:pt>
                <c:pt idx="281">
                  <c:v>0.65713373758550697</c:v>
                </c:pt>
                <c:pt idx="282">
                  <c:v>1.06046950570754</c:v>
                </c:pt>
                <c:pt idx="283">
                  <c:v>0.36816431618512002</c:v>
                </c:pt>
                <c:pt idx="284">
                  <c:v>-0.232963218115459</c:v>
                </c:pt>
                <c:pt idx="285">
                  <c:v>0.98598939871500402</c:v>
                </c:pt>
                <c:pt idx="286">
                  <c:v>0.32562831090153399</c:v>
                </c:pt>
                <c:pt idx="287">
                  <c:v>0.69598968461552402</c:v>
                </c:pt>
                <c:pt idx="288">
                  <c:v>3.24607933017243E-3</c:v>
                </c:pt>
                <c:pt idx="289">
                  <c:v>0.80520879465803497</c:v>
                </c:pt>
                <c:pt idx="290">
                  <c:v>0.47159019723623502</c:v>
                </c:pt>
                <c:pt idx="291">
                  <c:v>7.54695839535688E-2</c:v>
                </c:pt>
                <c:pt idx="292">
                  <c:v>0.50890066511982701</c:v>
                </c:pt>
                <c:pt idx="293">
                  <c:v>-0.33373808954110701</c:v>
                </c:pt>
                <c:pt idx="294">
                  <c:v>-9.1361265866938199E-2</c:v>
                </c:pt>
                <c:pt idx="295">
                  <c:v>0.13461548013695501</c:v>
                </c:pt>
                <c:pt idx="296">
                  <c:v>-0.21014672421130601</c:v>
                </c:pt>
                <c:pt idx="297">
                  <c:v>0.18429452023249199</c:v>
                </c:pt>
                <c:pt idx="298">
                  <c:v>-0.51714214341905795</c:v>
                </c:pt>
                <c:pt idx="299">
                  <c:v>0.116841197904064</c:v>
                </c:pt>
                <c:pt idx="300">
                  <c:v>-0.32235150142533397</c:v>
                </c:pt>
                <c:pt idx="301">
                  <c:v>0.48948190608313302</c:v>
                </c:pt>
                <c:pt idx="302">
                  <c:v>1.00425966634894E-2</c:v>
                </c:pt>
                <c:pt idx="303">
                  <c:v>7.5002780250670503E-2</c:v>
                </c:pt>
                <c:pt idx="304">
                  <c:v>-0.25900157702514698</c:v>
                </c:pt>
                <c:pt idx="305">
                  <c:v>-2.6596832346201801E-2</c:v>
                </c:pt>
                <c:pt idx="306">
                  <c:v>-5.2833538853068303E-2</c:v>
                </c:pt>
                <c:pt idx="307">
                  <c:v>-0.50532059582674704</c:v>
                </c:pt>
                <c:pt idx="308">
                  <c:v>-6.8209133937004998E-3</c:v>
                </c:pt>
                <c:pt idx="309">
                  <c:v>0.36889719109615599</c:v>
                </c:pt>
                <c:pt idx="310">
                  <c:v>0.55647308137406204</c:v>
                </c:pt>
                <c:pt idx="311">
                  <c:v>0.17412603780667599</c:v>
                </c:pt>
                <c:pt idx="312">
                  <c:v>-0.43491121149219297</c:v>
                </c:pt>
                <c:pt idx="313">
                  <c:v>0.47515542258544102</c:v>
                </c:pt>
                <c:pt idx="314">
                  <c:v>-0.18539909233035701</c:v>
                </c:pt>
                <c:pt idx="315">
                  <c:v>-2.3181147177028402E-2</c:v>
                </c:pt>
                <c:pt idx="316">
                  <c:v>-0.42344015079597302</c:v>
                </c:pt>
                <c:pt idx="317">
                  <c:v>-0.14538988984222101</c:v>
                </c:pt>
                <c:pt idx="318">
                  <c:v>-7.0928582122821701E-2</c:v>
                </c:pt>
                <c:pt idx="319">
                  <c:v>0.30911883482290398</c:v>
                </c:pt>
                <c:pt idx="320">
                  <c:v>0.49247449902915003</c:v>
                </c:pt>
                <c:pt idx="321">
                  <c:v>0.55647308137406204</c:v>
                </c:pt>
                <c:pt idx="322">
                  <c:v>-0.539083756090323</c:v>
                </c:pt>
                <c:pt idx="323">
                  <c:v>-8.1192705095808303E-3</c:v>
                </c:pt>
                <c:pt idx="324">
                  <c:v>-5.4625989460681E-2</c:v>
                </c:pt>
                <c:pt idx="325">
                  <c:v>-0.116049290834811</c:v>
                </c:pt>
                <c:pt idx="326">
                  <c:v>0.195117110513708</c:v>
                </c:pt>
                <c:pt idx="327">
                  <c:v>0.299830312533446</c:v>
                </c:pt>
                <c:pt idx="328">
                  <c:v>2.9156643636518799E-2</c:v>
                </c:pt>
                <c:pt idx="329">
                  <c:v>-0.38122437437800499</c:v>
                </c:pt>
                <c:pt idx="330">
                  <c:v>-0.49237005457050298</c:v>
                </c:pt>
                <c:pt idx="331">
                  <c:v>0.63030521489790203</c:v>
                </c:pt>
                <c:pt idx="332">
                  <c:v>0.61357555008463704</c:v>
                </c:pt>
                <c:pt idx="333">
                  <c:v>3.45001066225743E-2</c:v>
                </c:pt>
                <c:pt idx="334">
                  <c:v>-0.21514415789812899</c:v>
                </c:pt>
                <c:pt idx="335">
                  <c:v>-0.59956225717172396</c:v>
                </c:pt>
                <c:pt idx="336">
                  <c:v>-0.59956225717172396</c:v>
                </c:pt>
                <c:pt idx="337">
                  <c:v>-0.50767764437172602</c:v>
                </c:pt>
                <c:pt idx="338">
                  <c:v>-0.50767764437172602</c:v>
                </c:pt>
                <c:pt idx="339">
                  <c:v>-0.49863392446621901</c:v>
                </c:pt>
                <c:pt idx="340">
                  <c:v>-0.25830347298236001</c:v>
                </c:pt>
                <c:pt idx="341">
                  <c:v>-0.34960062055753499</c:v>
                </c:pt>
                <c:pt idx="342">
                  <c:v>-0.34960062055753499</c:v>
                </c:pt>
                <c:pt idx="343">
                  <c:v>-0.19024221107659001</c:v>
                </c:pt>
                <c:pt idx="344">
                  <c:v>-0.19024221107659001</c:v>
                </c:pt>
                <c:pt idx="345">
                  <c:v>-0.23463172268921401</c:v>
                </c:pt>
                <c:pt idx="346">
                  <c:v>-0.28672969615836602</c:v>
                </c:pt>
                <c:pt idx="347">
                  <c:v>-0.34441096457526299</c:v>
                </c:pt>
                <c:pt idx="348">
                  <c:v>-0.27894445854975097</c:v>
                </c:pt>
                <c:pt idx="349">
                  <c:v>0.119935580481646</c:v>
                </c:pt>
                <c:pt idx="350">
                  <c:v>-0.364384964693649</c:v>
                </c:pt>
                <c:pt idx="351">
                  <c:v>-0.214025888344266</c:v>
                </c:pt>
                <c:pt idx="352">
                  <c:v>-0.10005245435063401</c:v>
                </c:pt>
                <c:pt idx="353">
                  <c:v>-0.30660741361250798</c:v>
                </c:pt>
                <c:pt idx="354">
                  <c:v>-0.22412489427239399</c:v>
                </c:pt>
                <c:pt idx="355">
                  <c:v>2.8970066685485799E-3</c:v>
                </c:pt>
                <c:pt idx="356">
                  <c:v>2.0379826158335201</c:v>
                </c:pt>
                <c:pt idx="357">
                  <c:v>-0.199228025207734</c:v>
                </c:pt>
                <c:pt idx="358">
                  <c:v>-0.296066380770798</c:v>
                </c:pt>
                <c:pt idx="359">
                  <c:v>-0.467546172299451</c:v>
                </c:pt>
                <c:pt idx="360">
                  <c:v>-0.44640947726968999</c:v>
                </c:pt>
                <c:pt idx="361">
                  <c:v>-0.25841784744744301</c:v>
                </c:pt>
                <c:pt idx="362">
                  <c:v>-0.43999317934907201</c:v>
                </c:pt>
                <c:pt idx="363">
                  <c:v>0.70494494778769701</c:v>
                </c:pt>
                <c:pt idx="364">
                  <c:v>-0.47279776436546</c:v>
                </c:pt>
                <c:pt idx="365">
                  <c:v>0.396507295813466</c:v>
                </c:pt>
                <c:pt idx="366">
                  <c:v>2.3408301044551501E-2</c:v>
                </c:pt>
                <c:pt idx="367">
                  <c:v>-0.44426797711740301</c:v>
                </c:pt>
                <c:pt idx="368">
                  <c:v>-0.26596326649387803</c:v>
                </c:pt>
                <c:pt idx="369">
                  <c:v>-0.36044231700766</c:v>
                </c:pt>
                <c:pt idx="370">
                  <c:v>-0.44804308568254703</c:v>
                </c:pt>
                <c:pt idx="371">
                  <c:v>0.533621778789791</c:v>
                </c:pt>
                <c:pt idx="372">
                  <c:v>0.36792043951143799</c:v>
                </c:pt>
                <c:pt idx="373">
                  <c:v>0.42752164473237297</c:v>
                </c:pt>
                <c:pt idx="374">
                  <c:v>0.53107387404359196</c:v>
                </c:pt>
                <c:pt idx="375">
                  <c:v>1.04378533405893</c:v>
                </c:pt>
                <c:pt idx="376">
                  <c:v>-0.40417598864132198</c:v>
                </c:pt>
                <c:pt idx="377">
                  <c:v>-0.40417598864132198</c:v>
                </c:pt>
                <c:pt idx="378">
                  <c:v>-0.54751230281693597</c:v>
                </c:pt>
                <c:pt idx="379">
                  <c:v>-0.15414219412293201</c:v>
                </c:pt>
                <c:pt idx="380">
                  <c:v>-0.33247625231623601</c:v>
                </c:pt>
                <c:pt idx="381">
                  <c:v>-0.53983655413514697</c:v>
                </c:pt>
                <c:pt idx="382">
                  <c:v>0.14019391429382499</c:v>
                </c:pt>
                <c:pt idx="383">
                  <c:v>-0.22407450543830101</c:v>
                </c:pt>
                <c:pt idx="384">
                  <c:v>0.274453089908681</c:v>
                </c:pt>
                <c:pt idx="385">
                  <c:v>0.34019304043609999</c:v>
                </c:pt>
                <c:pt idx="386">
                  <c:v>0.41198402817185398</c:v>
                </c:pt>
                <c:pt idx="387">
                  <c:v>0.15001069323527999</c:v>
                </c:pt>
                <c:pt idx="388">
                  <c:v>-0.28495032629268202</c:v>
                </c:pt>
                <c:pt idx="389">
                  <c:v>-0.26754151277390797</c:v>
                </c:pt>
                <c:pt idx="390">
                  <c:v>-2.6411819124632099E-2</c:v>
                </c:pt>
                <c:pt idx="391">
                  <c:v>-0.180200910771074</c:v>
                </c:pt>
                <c:pt idx="392">
                  <c:v>-0.248478501815835</c:v>
                </c:pt>
                <c:pt idx="393">
                  <c:v>-0.36378388518664601</c:v>
                </c:pt>
                <c:pt idx="394">
                  <c:v>-0.210277239183222</c:v>
                </c:pt>
                <c:pt idx="395">
                  <c:v>-0.19651524382646099</c:v>
                </c:pt>
                <c:pt idx="396">
                  <c:v>-0.50540115971440502</c:v>
                </c:pt>
                <c:pt idx="397">
                  <c:v>-0.79712812847376202</c:v>
                </c:pt>
                <c:pt idx="398">
                  <c:v>-0.490171215030414</c:v>
                </c:pt>
                <c:pt idx="399">
                  <c:v>-0.26077744222718802</c:v>
                </c:pt>
                <c:pt idx="400">
                  <c:v>-0.51668057750722496</c:v>
                </c:pt>
                <c:pt idx="401">
                  <c:v>-0.53851347827441998</c:v>
                </c:pt>
                <c:pt idx="402">
                  <c:v>-0.25377618030208698</c:v>
                </c:pt>
                <c:pt idx="403">
                  <c:v>-8.9139498946329901E-2</c:v>
                </c:pt>
                <c:pt idx="404">
                  <c:v>-0.154939678875924</c:v>
                </c:pt>
                <c:pt idx="405">
                  <c:v>-2.7526569071571302E-2</c:v>
                </c:pt>
                <c:pt idx="406">
                  <c:v>-0.40957076686766303</c:v>
                </c:pt>
                <c:pt idx="407">
                  <c:v>-0.13480974184502501</c:v>
                </c:pt>
                <c:pt idx="408">
                  <c:v>-0.29056239146956098</c:v>
                </c:pt>
                <c:pt idx="409">
                  <c:v>-0.32593096496444002</c:v>
                </c:pt>
                <c:pt idx="410">
                  <c:v>8.3910264181272606E-2</c:v>
                </c:pt>
                <c:pt idx="411">
                  <c:v>-0.26466197740781</c:v>
                </c:pt>
                <c:pt idx="412">
                  <c:v>-0.18429039196588801</c:v>
                </c:pt>
                <c:pt idx="413">
                  <c:v>0.45000670802877701</c:v>
                </c:pt>
                <c:pt idx="414">
                  <c:v>0.201808522355514</c:v>
                </c:pt>
                <c:pt idx="415">
                  <c:v>-5.7041695268730798E-2</c:v>
                </c:pt>
                <c:pt idx="416">
                  <c:v>-0.54100832644979202</c:v>
                </c:pt>
                <c:pt idx="417">
                  <c:v>0.25168743485899903</c:v>
                </c:pt>
                <c:pt idx="418">
                  <c:v>-0.34366569995079999</c:v>
                </c:pt>
                <c:pt idx="419">
                  <c:v>-0.32173650593754499</c:v>
                </c:pt>
                <c:pt idx="420">
                  <c:v>-0.34585328489689199</c:v>
                </c:pt>
                <c:pt idx="421">
                  <c:v>-0.151315785831281</c:v>
                </c:pt>
                <c:pt idx="422">
                  <c:v>0.10577891966288901</c:v>
                </c:pt>
                <c:pt idx="423">
                  <c:v>0.17130423746794399</c:v>
                </c:pt>
                <c:pt idx="424">
                  <c:v>-0.31535662302845402</c:v>
                </c:pt>
                <c:pt idx="425">
                  <c:v>-0.56721407393192602</c:v>
                </c:pt>
                <c:pt idx="426">
                  <c:v>-0.402570452422567</c:v>
                </c:pt>
                <c:pt idx="427">
                  <c:v>0.84435855044369001</c:v>
                </c:pt>
                <c:pt idx="428">
                  <c:v>-0.27165928315673399</c:v>
                </c:pt>
                <c:pt idx="429">
                  <c:v>-0.28799118387613698</c:v>
                </c:pt>
                <c:pt idx="430">
                  <c:v>-0.43036590062126501</c:v>
                </c:pt>
                <c:pt idx="431">
                  <c:v>-0.41108823234568198</c:v>
                </c:pt>
                <c:pt idx="432">
                  <c:v>-0.34359537125907202</c:v>
                </c:pt>
                <c:pt idx="433">
                  <c:v>6.5002556880185206E-2</c:v>
                </c:pt>
                <c:pt idx="434">
                  <c:v>-0.20933670092394199</c:v>
                </c:pt>
                <c:pt idx="435">
                  <c:v>0.421529230251319</c:v>
                </c:pt>
                <c:pt idx="436">
                  <c:v>0.224433533140252</c:v>
                </c:pt>
                <c:pt idx="437">
                  <c:v>1.6856481709592499E-2</c:v>
                </c:pt>
                <c:pt idx="438">
                  <c:v>0.41569952146841499</c:v>
                </c:pt>
                <c:pt idx="439">
                  <c:v>-7.3333304576142205E-2</c:v>
                </c:pt>
                <c:pt idx="440">
                  <c:v>-4.0557249572438399E-2</c:v>
                </c:pt>
                <c:pt idx="441">
                  <c:v>0.36385934287400501</c:v>
                </c:pt>
                <c:pt idx="442">
                  <c:v>-2.6266030551304699E-2</c:v>
                </c:pt>
                <c:pt idx="443">
                  <c:v>-0.644991513274904</c:v>
                </c:pt>
                <c:pt idx="444">
                  <c:v>-0.44051341467923699</c:v>
                </c:pt>
                <c:pt idx="445">
                  <c:v>-0.42569560524981898</c:v>
                </c:pt>
                <c:pt idx="446">
                  <c:v>-0.55385522186106195</c:v>
                </c:pt>
                <c:pt idx="447">
                  <c:v>-0.13631252612514999</c:v>
                </c:pt>
                <c:pt idx="448">
                  <c:v>8.91269500633326E-2</c:v>
                </c:pt>
                <c:pt idx="449">
                  <c:v>-0.21234263764445499</c:v>
                </c:pt>
                <c:pt idx="450">
                  <c:v>-0.41178491964617597</c:v>
                </c:pt>
                <c:pt idx="451">
                  <c:v>1.9557036002601402E-2</c:v>
                </c:pt>
                <c:pt idx="452">
                  <c:v>-0.24995099900818499</c:v>
                </c:pt>
                <c:pt idx="453">
                  <c:v>8.7920303965650703E-2</c:v>
                </c:pt>
                <c:pt idx="454">
                  <c:v>-0.19141785440553999</c:v>
                </c:pt>
                <c:pt idx="455">
                  <c:v>-0.19411536582594099</c:v>
                </c:pt>
                <c:pt idx="456">
                  <c:v>-2.73176170535947E-2</c:v>
                </c:pt>
                <c:pt idx="457">
                  <c:v>-0.10486425182185199</c:v>
                </c:pt>
                <c:pt idx="458">
                  <c:v>-0.35887362022874603</c:v>
                </c:pt>
                <c:pt idx="459">
                  <c:v>-0.59586342606500298</c:v>
                </c:pt>
                <c:pt idx="460">
                  <c:v>-0.14527943770940699</c:v>
                </c:pt>
                <c:pt idx="461">
                  <c:v>0.10814220137622001</c:v>
                </c:pt>
                <c:pt idx="462">
                  <c:v>0.3521887757346</c:v>
                </c:pt>
                <c:pt idx="463">
                  <c:v>-0.16302036146387899</c:v>
                </c:pt>
                <c:pt idx="464">
                  <c:v>2.18587910227158E-2</c:v>
                </c:pt>
                <c:pt idx="465">
                  <c:v>-0.40445877375812</c:v>
                </c:pt>
                <c:pt idx="466">
                  <c:v>-0.26109730429071398</c:v>
                </c:pt>
                <c:pt idx="467">
                  <c:v>0.27037926251617</c:v>
                </c:pt>
                <c:pt idx="468">
                  <c:v>0.89450175791061703</c:v>
                </c:pt>
                <c:pt idx="469">
                  <c:v>-5.67316507619735E-2</c:v>
                </c:pt>
                <c:pt idx="470">
                  <c:v>0.85836940907110204</c:v>
                </c:pt>
                <c:pt idx="471">
                  <c:v>2.2721308275192999E-2</c:v>
                </c:pt>
                <c:pt idx="472">
                  <c:v>-0.19053804840134</c:v>
                </c:pt>
                <c:pt idx="473">
                  <c:v>-0.29366719779121703</c:v>
                </c:pt>
                <c:pt idx="474">
                  <c:v>-0.15286452404574699</c:v>
                </c:pt>
                <c:pt idx="475">
                  <c:v>-0.57689219339271502</c:v>
                </c:pt>
                <c:pt idx="476">
                  <c:v>-0.49479853624004899</c:v>
                </c:pt>
                <c:pt idx="477">
                  <c:v>-1.82455647011051E-2</c:v>
                </c:pt>
                <c:pt idx="478">
                  <c:v>-9.9707249980046098E-2</c:v>
                </c:pt>
                <c:pt idx="479">
                  <c:v>-0.33894671841012403</c:v>
                </c:pt>
                <c:pt idx="480">
                  <c:v>-0.52182457919013303</c:v>
                </c:pt>
                <c:pt idx="481">
                  <c:v>-0.59258137097180896</c:v>
                </c:pt>
                <c:pt idx="482">
                  <c:v>-0.45479385914266302</c:v>
                </c:pt>
                <c:pt idx="483">
                  <c:v>-0.18627125172711501</c:v>
                </c:pt>
                <c:pt idx="484">
                  <c:v>-0.21575896324390001</c:v>
                </c:pt>
                <c:pt idx="485">
                  <c:v>6.5634973440913499E-2</c:v>
                </c:pt>
                <c:pt idx="486">
                  <c:v>0.36184712151882598</c:v>
                </c:pt>
                <c:pt idx="487">
                  <c:v>1.9326759043538502E-2</c:v>
                </c:pt>
                <c:pt idx="488">
                  <c:v>-3.6540208595546901E-2</c:v>
                </c:pt>
                <c:pt idx="489">
                  <c:v>-0.194706065653236</c:v>
                </c:pt>
                <c:pt idx="490">
                  <c:v>-0.22483579447705501</c:v>
                </c:pt>
                <c:pt idx="491">
                  <c:v>-0.58799918780261795</c:v>
                </c:pt>
                <c:pt idx="492">
                  <c:v>-0.26979318470182501</c:v>
                </c:pt>
                <c:pt idx="493">
                  <c:v>-0.52539855651852096</c:v>
                </c:pt>
                <c:pt idx="494">
                  <c:v>-0.34186088270965997</c:v>
                </c:pt>
                <c:pt idx="495">
                  <c:v>-0.29079569620897699</c:v>
                </c:pt>
                <c:pt idx="496">
                  <c:v>-0.427640194136716</c:v>
                </c:pt>
                <c:pt idx="497">
                  <c:v>-0.32383238830890498</c:v>
                </c:pt>
                <c:pt idx="498">
                  <c:v>-0.17798488498041101</c:v>
                </c:pt>
                <c:pt idx="499">
                  <c:v>-0.29751160441576002</c:v>
                </c:pt>
                <c:pt idx="500">
                  <c:v>-0.52539235921511496</c:v>
                </c:pt>
                <c:pt idx="501">
                  <c:v>-0.29640093198759399</c:v>
                </c:pt>
                <c:pt idx="502">
                  <c:v>-0.33229544311276799</c:v>
                </c:pt>
                <c:pt idx="503">
                  <c:v>-0.37220633936533298</c:v>
                </c:pt>
                <c:pt idx="504">
                  <c:v>-8.9893696992497496E-2</c:v>
                </c:pt>
                <c:pt idx="505">
                  <c:v>-0.280081900895988</c:v>
                </c:pt>
                <c:pt idx="506">
                  <c:v>-0.44803964216048903</c:v>
                </c:pt>
                <c:pt idx="507">
                  <c:v>-0.290470976093955</c:v>
                </c:pt>
                <c:pt idx="508">
                  <c:v>-0.40736444849139702</c:v>
                </c:pt>
                <c:pt idx="509">
                  <c:v>-0.298628687506653</c:v>
                </c:pt>
                <c:pt idx="510">
                  <c:v>-0.507937412318754</c:v>
                </c:pt>
                <c:pt idx="511">
                  <c:v>-0.59739115054759595</c:v>
                </c:pt>
                <c:pt idx="512">
                  <c:v>0.16217933626682099</c:v>
                </c:pt>
                <c:pt idx="513">
                  <c:v>0.17179429932942</c:v>
                </c:pt>
                <c:pt idx="514">
                  <c:v>0.14908435843767101</c:v>
                </c:pt>
                <c:pt idx="515">
                  <c:v>-7.9414650225325997E-2</c:v>
                </c:pt>
                <c:pt idx="516">
                  <c:v>-0.40791171320692998</c:v>
                </c:pt>
                <c:pt idx="517">
                  <c:v>-0.33835903031293102</c:v>
                </c:pt>
                <c:pt idx="518">
                  <c:v>-0.29695636644088302</c:v>
                </c:pt>
                <c:pt idx="519">
                  <c:v>-0.41517640269165601</c:v>
                </c:pt>
                <c:pt idx="520">
                  <c:v>-0.35513268646896401</c:v>
                </c:pt>
                <c:pt idx="521">
                  <c:v>-0.53571263430757499</c:v>
                </c:pt>
                <c:pt idx="522">
                  <c:v>-0.45660258264623599</c:v>
                </c:pt>
                <c:pt idx="523">
                  <c:v>0.26601021615652098</c:v>
                </c:pt>
                <c:pt idx="524">
                  <c:v>-4.7900247750455503E-2</c:v>
                </c:pt>
                <c:pt idx="525">
                  <c:v>-0.102078015667267</c:v>
                </c:pt>
                <c:pt idx="526">
                  <c:v>-0.15978986753973001</c:v>
                </c:pt>
                <c:pt idx="527">
                  <c:v>-5.0728012147921598E-3</c:v>
                </c:pt>
                <c:pt idx="528">
                  <c:v>-3.2069290430748701E-2</c:v>
                </c:pt>
                <c:pt idx="529">
                  <c:v>8.6486817405200308E-3</c:v>
                </c:pt>
                <c:pt idx="530">
                  <c:v>-0.16076055448149801</c:v>
                </c:pt>
                <c:pt idx="531">
                  <c:v>0.31119215651552401</c:v>
                </c:pt>
                <c:pt idx="532">
                  <c:v>0.12542486003414099</c:v>
                </c:pt>
                <c:pt idx="533">
                  <c:v>4.4988328723562697E-2</c:v>
                </c:pt>
                <c:pt idx="534">
                  <c:v>-0.19716119802227899</c:v>
                </c:pt>
                <c:pt idx="535">
                  <c:v>-0.18514551314300501</c:v>
                </c:pt>
                <c:pt idx="536">
                  <c:v>-8.86563411218068E-2</c:v>
                </c:pt>
                <c:pt idx="537">
                  <c:v>1.7258650517383199E-2</c:v>
                </c:pt>
                <c:pt idx="538">
                  <c:v>-9.2585511763968495E-2</c:v>
                </c:pt>
                <c:pt idx="539">
                  <c:v>-0.39307856177284201</c:v>
                </c:pt>
                <c:pt idx="540">
                  <c:v>-4.2149540162476899E-2</c:v>
                </c:pt>
                <c:pt idx="541">
                  <c:v>1.1684060621967101E-2</c:v>
                </c:pt>
                <c:pt idx="542">
                  <c:v>-7.5190695743261399E-2</c:v>
                </c:pt>
                <c:pt idx="543">
                  <c:v>1.14176176033681E-3</c:v>
                </c:pt>
                <c:pt idx="544">
                  <c:v>-0.42786478987442</c:v>
                </c:pt>
                <c:pt idx="545">
                  <c:v>-2.7066048769909999E-2</c:v>
                </c:pt>
                <c:pt idx="546">
                  <c:v>-0.317789518805219</c:v>
                </c:pt>
                <c:pt idx="547">
                  <c:v>0.15057851124403099</c:v>
                </c:pt>
                <c:pt idx="548">
                  <c:v>-0.34751772921319701</c:v>
                </c:pt>
                <c:pt idx="549">
                  <c:v>-0.132685095910789</c:v>
                </c:pt>
                <c:pt idx="550">
                  <c:v>0.30810230821890899</c:v>
                </c:pt>
                <c:pt idx="551">
                  <c:v>-0.42416213806157799</c:v>
                </c:pt>
                <c:pt idx="552">
                  <c:v>2.13143742124937E-2</c:v>
                </c:pt>
                <c:pt idx="553">
                  <c:v>8.7925438348890605E-2</c:v>
                </c:pt>
                <c:pt idx="554">
                  <c:v>3.22060111903131E-3</c:v>
                </c:pt>
                <c:pt idx="555">
                  <c:v>9.3331070279057099E-2</c:v>
                </c:pt>
                <c:pt idx="556">
                  <c:v>0.19514441256022799</c:v>
                </c:pt>
                <c:pt idx="557">
                  <c:v>6.6943963369169204E-2</c:v>
                </c:pt>
                <c:pt idx="558">
                  <c:v>6.5264964710923801E-3</c:v>
                </c:pt>
                <c:pt idx="559">
                  <c:v>-0.120750510442954</c:v>
                </c:pt>
                <c:pt idx="560">
                  <c:v>-2.72264037611166E-2</c:v>
                </c:pt>
                <c:pt idx="561">
                  <c:v>5.39380768229165E-2</c:v>
                </c:pt>
                <c:pt idx="562">
                  <c:v>-5.1799370927056998E-2</c:v>
                </c:pt>
                <c:pt idx="563">
                  <c:v>-0.20381193179345999</c:v>
                </c:pt>
                <c:pt idx="564">
                  <c:v>-0.62530485071233699</c:v>
                </c:pt>
                <c:pt idx="565">
                  <c:v>0.220965041148592</c:v>
                </c:pt>
                <c:pt idx="566">
                  <c:v>-0.180555594853789</c:v>
                </c:pt>
                <c:pt idx="567">
                  <c:v>-0.83544174136918603</c:v>
                </c:pt>
                <c:pt idx="568">
                  <c:v>-0.39259094282892898</c:v>
                </c:pt>
                <c:pt idx="569">
                  <c:v>-0.90089905871923204</c:v>
                </c:pt>
                <c:pt idx="570">
                  <c:v>-0.53195086860747798</c:v>
                </c:pt>
                <c:pt idx="571">
                  <c:v>-0.52314119504978795</c:v>
                </c:pt>
                <c:pt idx="572">
                  <c:v>-0.44927233884998702</c:v>
                </c:pt>
                <c:pt idx="573">
                  <c:v>-0.36731338554781501</c:v>
                </c:pt>
                <c:pt idx="574">
                  <c:v>-0.50497218350350803</c:v>
                </c:pt>
                <c:pt idx="575">
                  <c:v>-0.60005339081487796</c:v>
                </c:pt>
                <c:pt idx="576">
                  <c:v>-0.30299214729949098</c:v>
                </c:pt>
                <c:pt idx="577">
                  <c:v>-0.56617044871829103</c:v>
                </c:pt>
                <c:pt idx="578">
                  <c:v>-0.435717059343882</c:v>
                </c:pt>
                <c:pt idx="579">
                  <c:v>-1.5212974050410499E-2</c:v>
                </c:pt>
                <c:pt idx="580">
                  <c:v>-0.245076665212762</c:v>
                </c:pt>
                <c:pt idx="581">
                  <c:v>-0.38616444599719801</c:v>
                </c:pt>
                <c:pt idx="582">
                  <c:v>-0.49993479648598899</c:v>
                </c:pt>
                <c:pt idx="583">
                  <c:v>-0.43601257439088897</c:v>
                </c:pt>
                <c:pt idx="584">
                  <c:v>-0.514310891373706</c:v>
                </c:pt>
                <c:pt idx="585">
                  <c:v>-0.40800699602922902</c:v>
                </c:pt>
                <c:pt idx="586">
                  <c:v>-0.37615608925018701</c:v>
                </c:pt>
                <c:pt idx="587">
                  <c:v>-0.31973834091976699</c:v>
                </c:pt>
                <c:pt idx="588">
                  <c:v>-0.52364747414441903</c:v>
                </c:pt>
                <c:pt idx="589">
                  <c:v>-0.57484874538957198</c:v>
                </c:pt>
                <c:pt idx="590">
                  <c:v>-0.47115434998518801</c:v>
                </c:pt>
                <c:pt idx="591">
                  <c:v>-0.58877994832458902</c:v>
                </c:pt>
                <c:pt idx="592">
                  <c:v>-0.11475160977566599</c:v>
                </c:pt>
                <c:pt idx="593">
                  <c:v>-0.37389569706606102</c:v>
                </c:pt>
                <c:pt idx="594">
                  <c:v>-0.26017370455250999</c:v>
                </c:pt>
                <c:pt idx="595">
                  <c:v>-0.23938423043868801</c:v>
                </c:pt>
                <c:pt idx="596">
                  <c:v>-0.32403477492125798</c:v>
                </c:pt>
                <c:pt idx="597">
                  <c:v>-0.272519958679737</c:v>
                </c:pt>
                <c:pt idx="598">
                  <c:v>-0.41908716252890099</c:v>
                </c:pt>
                <c:pt idx="599">
                  <c:v>2.17618502816397E-2</c:v>
                </c:pt>
                <c:pt idx="600">
                  <c:v>-6.7635925326600399E-3</c:v>
                </c:pt>
                <c:pt idx="601">
                  <c:v>-0.29736724935502201</c:v>
                </c:pt>
                <c:pt idx="602">
                  <c:v>-0.78676396249860403</c:v>
                </c:pt>
                <c:pt idx="603">
                  <c:v>-0.54746059251990198</c:v>
                </c:pt>
                <c:pt idx="604">
                  <c:v>-0.43063769401381202</c:v>
                </c:pt>
                <c:pt idx="605">
                  <c:v>-0.38361558852573002</c:v>
                </c:pt>
                <c:pt idx="606">
                  <c:v>-0.76676855369563202</c:v>
                </c:pt>
                <c:pt idx="607">
                  <c:v>-0.25333831951880198</c:v>
                </c:pt>
                <c:pt idx="608">
                  <c:v>-0.24868356195847799</c:v>
                </c:pt>
                <c:pt idx="609">
                  <c:v>-0.60113761515589803</c:v>
                </c:pt>
                <c:pt idx="610">
                  <c:v>-0.28177312719887498</c:v>
                </c:pt>
                <c:pt idx="611">
                  <c:v>-0.57775588838427705</c:v>
                </c:pt>
                <c:pt idx="612">
                  <c:v>-0.35413594714919699</c:v>
                </c:pt>
                <c:pt idx="613">
                  <c:v>-0.34191238918638001</c:v>
                </c:pt>
                <c:pt idx="614">
                  <c:v>-0.32551746100838502</c:v>
                </c:pt>
                <c:pt idx="615">
                  <c:v>-0.44032279568959298</c:v>
                </c:pt>
                <c:pt idx="616">
                  <c:v>-0.52292758881218404</c:v>
                </c:pt>
                <c:pt idx="617">
                  <c:v>-0.331868998164562</c:v>
                </c:pt>
                <c:pt idx="618">
                  <c:v>-0.26826133845258698</c:v>
                </c:pt>
                <c:pt idx="619">
                  <c:v>-0.248483910334132</c:v>
                </c:pt>
                <c:pt idx="620">
                  <c:v>-0.22918275607107499</c:v>
                </c:pt>
                <c:pt idx="621">
                  <c:v>-0.56788744282915904</c:v>
                </c:pt>
                <c:pt idx="622">
                  <c:v>-0.50892023820105903</c:v>
                </c:pt>
                <c:pt idx="623">
                  <c:v>-0.37327763818281201</c:v>
                </c:pt>
                <c:pt idx="624">
                  <c:v>-0.36604584256852901</c:v>
                </c:pt>
                <c:pt idx="625">
                  <c:v>-0.33561124995894198</c:v>
                </c:pt>
                <c:pt idx="626">
                  <c:v>-0.34337799856060303</c:v>
                </c:pt>
                <c:pt idx="627">
                  <c:v>-0.32543938060625799</c:v>
                </c:pt>
                <c:pt idx="628">
                  <c:v>-0.33600596912742298</c:v>
                </c:pt>
                <c:pt idx="629">
                  <c:v>-0.37131634758823001</c:v>
                </c:pt>
                <c:pt idx="630">
                  <c:v>-0.21894439287558301</c:v>
                </c:pt>
                <c:pt idx="631">
                  <c:v>-0.37375556661377302</c:v>
                </c:pt>
                <c:pt idx="632">
                  <c:v>-0.37017307052258203</c:v>
                </c:pt>
                <c:pt idx="633">
                  <c:v>-0.62616942933656705</c:v>
                </c:pt>
                <c:pt idx="634">
                  <c:v>-0.23918269446247101</c:v>
                </c:pt>
                <c:pt idx="635">
                  <c:v>-0.37411847911095703</c:v>
                </c:pt>
                <c:pt idx="636">
                  <c:v>-4.3379613514024397E-2</c:v>
                </c:pt>
                <c:pt idx="637">
                  <c:v>-0.35921542080451901</c:v>
                </c:pt>
                <c:pt idx="638">
                  <c:v>-0.31037655483267401</c:v>
                </c:pt>
                <c:pt idx="639">
                  <c:v>-0.41379388930537198</c:v>
                </c:pt>
                <c:pt idx="640">
                  <c:v>-0.57493189540292899</c:v>
                </c:pt>
                <c:pt idx="641">
                  <c:v>-0.40839195120347199</c:v>
                </c:pt>
                <c:pt idx="642">
                  <c:v>-0.22018401224730999</c:v>
                </c:pt>
                <c:pt idx="643">
                  <c:v>-0.38561981631033998</c:v>
                </c:pt>
                <c:pt idx="644">
                  <c:v>-0.51298785087032595</c:v>
                </c:pt>
                <c:pt idx="645">
                  <c:v>-0.49948238180521298</c:v>
                </c:pt>
                <c:pt idx="646">
                  <c:v>-0.285037400145563</c:v>
                </c:pt>
                <c:pt idx="647">
                  <c:v>-0.48201726565081698</c:v>
                </c:pt>
                <c:pt idx="648">
                  <c:v>-0.41513941756550199</c:v>
                </c:pt>
                <c:pt idx="649">
                  <c:v>-0.39110782877222799</c:v>
                </c:pt>
                <c:pt idx="650">
                  <c:v>-0.37116530296002298</c:v>
                </c:pt>
                <c:pt idx="651">
                  <c:v>-0.40676634247086801</c:v>
                </c:pt>
                <c:pt idx="652">
                  <c:v>-0.408911722777485</c:v>
                </c:pt>
                <c:pt idx="653">
                  <c:v>-0.21052072047037201</c:v>
                </c:pt>
                <c:pt idx="654">
                  <c:v>-0.41882723230812902</c:v>
                </c:pt>
                <c:pt idx="655">
                  <c:v>-0.38998992199631999</c:v>
                </c:pt>
                <c:pt idx="656">
                  <c:v>0.29526233791378198</c:v>
                </c:pt>
                <c:pt idx="657">
                  <c:v>-0.42413892156691302</c:v>
                </c:pt>
                <c:pt idx="658">
                  <c:v>-0.56397716960550903</c:v>
                </c:pt>
                <c:pt idx="659">
                  <c:v>-0.58823674333278997</c:v>
                </c:pt>
                <c:pt idx="660">
                  <c:v>-0.27140010278882398</c:v>
                </c:pt>
                <c:pt idx="661">
                  <c:v>-0.33306741542613699</c:v>
                </c:pt>
                <c:pt idx="662">
                  <c:v>-0.38080538772925099</c:v>
                </c:pt>
                <c:pt idx="663">
                  <c:v>-0.33966379590429202</c:v>
                </c:pt>
                <c:pt idx="664">
                  <c:v>-0.40253813957218199</c:v>
                </c:pt>
                <c:pt idx="665">
                  <c:v>-0.206758610295767</c:v>
                </c:pt>
                <c:pt idx="666">
                  <c:v>-0.36923618735495201</c:v>
                </c:pt>
                <c:pt idx="667">
                  <c:v>-0.40720704791720502</c:v>
                </c:pt>
                <c:pt idx="668">
                  <c:v>-0.28440301973180698</c:v>
                </c:pt>
                <c:pt idx="669">
                  <c:v>-0.55002597730240299</c:v>
                </c:pt>
                <c:pt idx="670">
                  <c:v>6.5280905110473797E-2</c:v>
                </c:pt>
                <c:pt idx="671">
                  <c:v>-0.43444046321954999</c:v>
                </c:pt>
                <c:pt idx="672">
                  <c:v>-0.237791661386513</c:v>
                </c:pt>
                <c:pt idx="673">
                  <c:v>-0.35474414150887601</c:v>
                </c:pt>
                <c:pt idx="674">
                  <c:v>-0.18231578475295801</c:v>
                </c:pt>
                <c:pt idx="675">
                  <c:v>-8.6856164147717602E-2</c:v>
                </c:pt>
                <c:pt idx="676">
                  <c:v>-0.52076004573230095</c:v>
                </c:pt>
                <c:pt idx="677">
                  <c:v>-0.24434975804525499</c:v>
                </c:pt>
                <c:pt idx="678">
                  <c:v>-0.30592931272041002</c:v>
                </c:pt>
                <c:pt idx="679">
                  <c:v>-0.35574975809954601</c:v>
                </c:pt>
                <c:pt idx="680">
                  <c:v>-0.22617449694091901</c:v>
                </c:pt>
                <c:pt idx="681">
                  <c:v>-0.12531703572143299</c:v>
                </c:pt>
                <c:pt idx="682">
                  <c:v>-0.237022485794076</c:v>
                </c:pt>
                <c:pt idx="683">
                  <c:v>-0.337656054615118</c:v>
                </c:pt>
                <c:pt idx="684">
                  <c:v>0.477068386420332</c:v>
                </c:pt>
                <c:pt idx="685">
                  <c:v>-0.34572711381339499</c:v>
                </c:pt>
                <c:pt idx="686">
                  <c:v>-0.24805745117316999</c:v>
                </c:pt>
                <c:pt idx="687">
                  <c:v>-0.53643804294612396</c:v>
                </c:pt>
                <c:pt idx="688">
                  <c:v>-0.432115252808283</c:v>
                </c:pt>
                <c:pt idx="689">
                  <c:v>-0.38360295079221701</c:v>
                </c:pt>
                <c:pt idx="690">
                  <c:v>-0.41664152453945202</c:v>
                </c:pt>
                <c:pt idx="691">
                  <c:v>-0.350909506104918</c:v>
                </c:pt>
                <c:pt idx="692">
                  <c:v>-0.20850259982816099</c:v>
                </c:pt>
                <c:pt idx="693">
                  <c:v>-0.57668730238103505</c:v>
                </c:pt>
                <c:pt idx="694">
                  <c:v>-0.47318804407267701</c:v>
                </c:pt>
                <c:pt idx="695">
                  <c:v>-0.359516583032297</c:v>
                </c:pt>
                <c:pt idx="696">
                  <c:v>-0.47001574270339003</c:v>
                </c:pt>
                <c:pt idx="697">
                  <c:v>-0.45278228105208002</c:v>
                </c:pt>
                <c:pt idx="698">
                  <c:v>-0.36532197191035898</c:v>
                </c:pt>
                <c:pt idx="699">
                  <c:v>-0.42767696095746099</c:v>
                </c:pt>
                <c:pt idx="700">
                  <c:v>-0.51251055719743699</c:v>
                </c:pt>
                <c:pt idx="701">
                  <c:v>-0.39221631655618899</c:v>
                </c:pt>
                <c:pt idx="702">
                  <c:v>5.2356474929117998E-2</c:v>
                </c:pt>
                <c:pt idx="703">
                  <c:v>-0.26327572500174101</c:v>
                </c:pt>
                <c:pt idx="704">
                  <c:v>-0.43076919758800403</c:v>
                </c:pt>
                <c:pt idx="705">
                  <c:v>-0.40610982217432101</c:v>
                </c:pt>
                <c:pt idx="706">
                  <c:v>-0.42195187331096301</c:v>
                </c:pt>
                <c:pt idx="707">
                  <c:v>-0.57271898197707405</c:v>
                </c:pt>
                <c:pt idx="708">
                  <c:v>-7.6123474491949505E-2</c:v>
                </c:pt>
                <c:pt idx="709">
                  <c:v>-0.437383973746512</c:v>
                </c:pt>
                <c:pt idx="710">
                  <c:v>-8.0667055118546299E-2</c:v>
                </c:pt>
                <c:pt idx="711">
                  <c:v>-0.22172061598474299</c:v>
                </c:pt>
                <c:pt idx="712">
                  <c:v>-0.55376296129477098</c:v>
                </c:pt>
                <c:pt idx="713">
                  <c:v>-0.31717951282796097</c:v>
                </c:pt>
                <c:pt idx="714">
                  <c:v>-0.40107006096242298</c:v>
                </c:pt>
                <c:pt idx="715">
                  <c:v>-0.54465687240770499</c:v>
                </c:pt>
                <c:pt idx="716">
                  <c:v>-0.303923039804951</c:v>
                </c:pt>
                <c:pt idx="717">
                  <c:v>-0.46710630997366898</c:v>
                </c:pt>
                <c:pt idx="718">
                  <c:v>-0.34688027802099602</c:v>
                </c:pt>
                <c:pt idx="719">
                  <c:v>-0.38993405974864898</c:v>
                </c:pt>
                <c:pt idx="720">
                  <c:v>-0.34385708948814903</c:v>
                </c:pt>
                <c:pt idx="721">
                  <c:v>-0.45154769482453999</c:v>
                </c:pt>
                <c:pt idx="722">
                  <c:v>-0.362251964608376</c:v>
                </c:pt>
                <c:pt idx="723">
                  <c:v>-0.29217907895553102</c:v>
                </c:pt>
                <c:pt idx="724">
                  <c:v>-0.414017444141557</c:v>
                </c:pt>
                <c:pt idx="725">
                  <c:v>-0.47792297333063699</c:v>
                </c:pt>
                <c:pt idx="726">
                  <c:v>-0.49062661192012003</c:v>
                </c:pt>
                <c:pt idx="727">
                  <c:v>-0.35445801602218102</c:v>
                </c:pt>
                <c:pt idx="728">
                  <c:v>-0.40254373595260701</c:v>
                </c:pt>
                <c:pt idx="729">
                  <c:v>-0.50336799169084701</c:v>
                </c:pt>
                <c:pt idx="730">
                  <c:v>-0.37116805071324299</c:v>
                </c:pt>
                <c:pt idx="731">
                  <c:v>-0.36693320457480499</c:v>
                </c:pt>
                <c:pt idx="732">
                  <c:v>-0.58764604408459598</c:v>
                </c:pt>
                <c:pt idx="733">
                  <c:v>-0.29298526890133297</c:v>
                </c:pt>
                <c:pt idx="734">
                  <c:v>0.218303454216977</c:v>
                </c:pt>
                <c:pt idx="735">
                  <c:v>0.43321399092364998</c:v>
                </c:pt>
                <c:pt idx="736">
                  <c:v>0.169735221305678</c:v>
                </c:pt>
                <c:pt idx="737">
                  <c:v>0.22398651350635601</c:v>
                </c:pt>
                <c:pt idx="738">
                  <c:v>0.223656217454027</c:v>
                </c:pt>
                <c:pt idx="739">
                  <c:v>4.9679198077290498E-3</c:v>
                </c:pt>
                <c:pt idx="740">
                  <c:v>0.13151711382134301</c:v>
                </c:pt>
                <c:pt idx="741">
                  <c:v>9.4350277657561196E-2</c:v>
                </c:pt>
                <c:pt idx="742">
                  <c:v>1.22989975641014E-2</c:v>
                </c:pt>
                <c:pt idx="743">
                  <c:v>0.24426369528592901</c:v>
                </c:pt>
                <c:pt idx="744">
                  <c:v>0.302461108489464</c:v>
                </c:pt>
                <c:pt idx="745">
                  <c:v>0.38471823546488998</c:v>
                </c:pt>
                <c:pt idx="746">
                  <c:v>0.23662902613245099</c:v>
                </c:pt>
                <c:pt idx="747">
                  <c:v>0.332789920129477</c:v>
                </c:pt>
                <c:pt idx="748">
                  <c:v>0.19093818472544399</c:v>
                </c:pt>
                <c:pt idx="749">
                  <c:v>0.38966336047702999</c:v>
                </c:pt>
                <c:pt idx="750">
                  <c:v>5.6719962523990398E-2</c:v>
                </c:pt>
                <c:pt idx="751">
                  <c:v>0.44563690597258299</c:v>
                </c:pt>
                <c:pt idx="752">
                  <c:v>0.29243158465733399</c:v>
                </c:pt>
                <c:pt idx="753">
                  <c:v>0.27553859259748997</c:v>
                </c:pt>
                <c:pt idx="754">
                  <c:v>-0.37223860794644997</c:v>
                </c:pt>
                <c:pt idx="755">
                  <c:v>5.0898960995598298E-2</c:v>
                </c:pt>
                <c:pt idx="756">
                  <c:v>8.3298699444887603E-2</c:v>
                </c:pt>
                <c:pt idx="757">
                  <c:v>-9.2375480435085006E-2</c:v>
                </c:pt>
                <c:pt idx="758">
                  <c:v>0.31528979252539702</c:v>
                </c:pt>
                <c:pt idx="759">
                  <c:v>0.11313043683869101</c:v>
                </c:pt>
                <c:pt idx="760">
                  <c:v>0.63586081554053697</c:v>
                </c:pt>
                <c:pt idx="761">
                  <c:v>0.313166950717152</c:v>
                </c:pt>
                <c:pt idx="762">
                  <c:v>0.43336349358140103</c:v>
                </c:pt>
                <c:pt idx="763">
                  <c:v>0.35235622632452801</c:v>
                </c:pt>
                <c:pt idx="764">
                  <c:v>0.33310749487970298</c:v>
                </c:pt>
                <c:pt idx="765">
                  <c:v>0.31475228994818499</c:v>
                </c:pt>
                <c:pt idx="766">
                  <c:v>0.38905328157762997</c:v>
                </c:pt>
                <c:pt idx="767">
                  <c:v>0.49626173523825101</c:v>
                </c:pt>
                <c:pt idx="768">
                  <c:v>7.5717441880788702E-2</c:v>
                </c:pt>
                <c:pt idx="769">
                  <c:v>0.33089835417473601</c:v>
                </c:pt>
                <c:pt idx="770">
                  <c:v>0.421166006417385</c:v>
                </c:pt>
                <c:pt idx="771">
                  <c:v>0.28529060815526802</c:v>
                </c:pt>
                <c:pt idx="772">
                  <c:v>0.17012044919209299</c:v>
                </c:pt>
                <c:pt idx="773">
                  <c:v>0.32787722825064503</c:v>
                </c:pt>
                <c:pt idx="774">
                  <c:v>0.110157120570086</c:v>
                </c:pt>
                <c:pt idx="775">
                  <c:v>0.63323888694003405</c:v>
                </c:pt>
                <c:pt idx="776">
                  <c:v>0.38798563559215499</c:v>
                </c:pt>
                <c:pt idx="777">
                  <c:v>0.605096081222806</c:v>
                </c:pt>
                <c:pt idx="778">
                  <c:v>-0.13146525707378501</c:v>
                </c:pt>
                <c:pt idx="779">
                  <c:v>0.47370225395131499</c:v>
                </c:pt>
                <c:pt idx="780">
                  <c:v>0.1063617248565</c:v>
                </c:pt>
                <c:pt idx="781">
                  <c:v>5.1248864720976402E-2</c:v>
                </c:pt>
                <c:pt idx="782">
                  <c:v>0.46105770689820602</c:v>
                </c:pt>
                <c:pt idx="783">
                  <c:v>0.54611551545172599</c:v>
                </c:pt>
                <c:pt idx="784">
                  <c:v>0.42663393280366901</c:v>
                </c:pt>
                <c:pt idx="785">
                  <c:v>0.33038045937044902</c:v>
                </c:pt>
                <c:pt idx="786">
                  <c:v>0.48835119750533101</c:v>
                </c:pt>
                <c:pt idx="787">
                  <c:v>0.28530873544859098</c:v>
                </c:pt>
                <c:pt idx="788">
                  <c:v>0.61083429162911096</c:v>
                </c:pt>
                <c:pt idx="789">
                  <c:v>0.21690311610497101</c:v>
                </c:pt>
                <c:pt idx="790">
                  <c:v>0.52296071412926604</c:v>
                </c:pt>
                <c:pt idx="791">
                  <c:v>0.33360837734493598</c:v>
                </c:pt>
                <c:pt idx="792">
                  <c:v>0.20103169262682</c:v>
                </c:pt>
                <c:pt idx="793">
                  <c:v>0.42897714991149699</c:v>
                </c:pt>
                <c:pt idx="794">
                  <c:v>0.48312237199229502</c:v>
                </c:pt>
                <c:pt idx="795">
                  <c:v>-0.412005272829227</c:v>
                </c:pt>
                <c:pt idx="796">
                  <c:v>0.245152623413051</c:v>
                </c:pt>
                <c:pt idx="797">
                  <c:v>0.52220836457055497</c:v>
                </c:pt>
                <c:pt idx="798">
                  <c:v>-0.621807736226619</c:v>
                </c:pt>
                <c:pt idx="799">
                  <c:v>0.28944609955952599</c:v>
                </c:pt>
                <c:pt idx="800">
                  <c:v>-5.1601461224667799E-2</c:v>
                </c:pt>
                <c:pt idx="801">
                  <c:v>0.20726821646875401</c:v>
                </c:pt>
                <c:pt idx="802">
                  <c:v>0.50399423114279096</c:v>
                </c:pt>
                <c:pt idx="803">
                  <c:v>0.33146239499580998</c:v>
                </c:pt>
                <c:pt idx="804">
                  <c:v>0.48776111298326003</c:v>
                </c:pt>
                <c:pt idx="805">
                  <c:v>0.307955473983896</c:v>
                </c:pt>
                <c:pt idx="806">
                  <c:v>0.77983422876949005</c:v>
                </c:pt>
                <c:pt idx="807">
                  <c:v>0.32363042168843198</c:v>
                </c:pt>
                <c:pt idx="808">
                  <c:v>0.75060793573225204</c:v>
                </c:pt>
                <c:pt idx="809">
                  <c:v>0.33948734400494601</c:v>
                </c:pt>
                <c:pt idx="810">
                  <c:v>0.57057473640490697</c:v>
                </c:pt>
                <c:pt idx="811">
                  <c:v>0.435309828648761</c:v>
                </c:pt>
                <c:pt idx="812">
                  <c:v>0.170500445069204</c:v>
                </c:pt>
                <c:pt idx="813">
                  <c:v>4.2266077801134498E-2</c:v>
                </c:pt>
                <c:pt idx="814">
                  <c:v>0.36833893452461403</c:v>
                </c:pt>
                <c:pt idx="815">
                  <c:v>-0.32789611946531</c:v>
                </c:pt>
                <c:pt idx="816">
                  <c:v>0.37880102308261399</c:v>
                </c:pt>
                <c:pt idx="817">
                  <c:v>9.8196351643045604E-2</c:v>
                </c:pt>
                <c:pt idx="818">
                  <c:v>0.45962914475609901</c:v>
                </c:pt>
                <c:pt idx="819">
                  <c:v>0.44984105522031997</c:v>
                </c:pt>
                <c:pt idx="820">
                  <c:v>0.57284833153532799</c:v>
                </c:pt>
                <c:pt idx="821">
                  <c:v>0.39547092579639798</c:v>
                </c:pt>
                <c:pt idx="822">
                  <c:v>-0.119280403579824</c:v>
                </c:pt>
                <c:pt idx="823">
                  <c:v>0.29290088902168399</c:v>
                </c:pt>
                <c:pt idx="824">
                  <c:v>0.34680558051370203</c:v>
                </c:pt>
                <c:pt idx="825">
                  <c:v>6.2997348963202499E-2</c:v>
                </c:pt>
                <c:pt idx="826">
                  <c:v>-0.57175343189269501</c:v>
                </c:pt>
                <c:pt idx="827">
                  <c:v>5.1940813697019902E-2</c:v>
                </c:pt>
                <c:pt idx="828">
                  <c:v>0.44062872785761298</c:v>
                </c:pt>
                <c:pt idx="829">
                  <c:v>1.5052491626802E-2</c:v>
                </c:pt>
                <c:pt idx="830">
                  <c:v>-0.73976447506229703</c:v>
                </c:pt>
                <c:pt idx="831">
                  <c:v>0.65131152848223195</c:v>
                </c:pt>
                <c:pt idx="832">
                  <c:v>1.1105716840417501</c:v>
                </c:pt>
                <c:pt idx="833">
                  <c:v>0.260000123278534</c:v>
                </c:pt>
                <c:pt idx="834">
                  <c:v>9.1015331746078995E-2</c:v>
                </c:pt>
                <c:pt idx="835">
                  <c:v>1.24261002936743</c:v>
                </c:pt>
                <c:pt idx="836">
                  <c:v>0.102177353510438</c:v>
                </c:pt>
                <c:pt idx="837">
                  <c:v>0.37930227043224202</c:v>
                </c:pt>
                <c:pt idx="838">
                  <c:v>0.708495522309044</c:v>
                </c:pt>
                <c:pt idx="839">
                  <c:v>0.96584684387908304</c:v>
                </c:pt>
                <c:pt idx="840">
                  <c:v>1.08757254271226</c:v>
                </c:pt>
                <c:pt idx="841">
                  <c:v>-6.88133750896033E-3</c:v>
                </c:pt>
                <c:pt idx="842">
                  <c:v>1.00671479884528</c:v>
                </c:pt>
                <c:pt idx="843">
                  <c:v>-2.9595762281611499E-2</c:v>
                </c:pt>
                <c:pt idx="844">
                  <c:v>0.69898569187931903</c:v>
                </c:pt>
                <c:pt idx="845">
                  <c:v>1.1170083750101101</c:v>
                </c:pt>
                <c:pt idx="846">
                  <c:v>1.09483758253233</c:v>
                </c:pt>
                <c:pt idx="847">
                  <c:v>0.19904730433941001</c:v>
                </c:pt>
                <c:pt idx="848">
                  <c:v>-5.9282071826211799E-3</c:v>
                </c:pt>
                <c:pt idx="849">
                  <c:v>0.83391302457833005</c:v>
                </c:pt>
                <c:pt idx="850">
                  <c:v>-0.184953570847948</c:v>
                </c:pt>
                <c:pt idx="851">
                  <c:v>3.4619204444073702E-2</c:v>
                </c:pt>
                <c:pt idx="852">
                  <c:v>1.2225906309421599</c:v>
                </c:pt>
                <c:pt idx="853">
                  <c:v>1.77421318646044</c:v>
                </c:pt>
              </c:numCache>
            </c:numRef>
          </c:xVal>
          <c:yVal>
            <c:numRef>
              <c:f>'HFD (2)'!$B$2:$B$855</c:f>
              <c:numCache>
                <c:formatCode>General</c:formatCode>
                <c:ptCount val="854"/>
                <c:pt idx="0">
                  <c:v>1.35274697888357</c:v>
                </c:pt>
                <c:pt idx="1">
                  <c:v>0.96392010938912398</c:v>
                </c:pt>
                <c:pt idx="2">
                  <c:v>0.86491403305204395</c:v>
                </c:pt>
                <c:pt idx="3">
                  <c:v>0.12536628704605701</c:v>
                </c:pt>
                <c:pt idx="4">
                  <c:v>0.113461997301276</c:v>
                </c:pt>
                <c:pt idx="5">
                  <c:v>0.27143565490253302</c:v>
                </c:pt>
                <c:pt idx="6">
                  <c:v>0.71453085455910803</c:v>
                </c:pt>
                <c:pt idx="7">
                  <c:v>1.0148296255647</c:v>
                </c:pt>
                <c:pt idx="8">
                  <c:v>0.84958502570409999</c:v>
                </c:pt>
                <c:pt idx="9">
                  <c:v>0.98608690063734505</c:v>
                </c:pt>
                <c:pt idx="10">
                  <c:v>0.112785428371004</c:v>
                </c:pt>
                <c:pt idx="11">
                  <c:v>0.75781761335671005</c:v>
                </c:pt>
                <c:pt idx="12">
                  <c:v>0.205592525976215</c:v>
                </c:pt>
                <c:pt idx="13">
                  <c:v>0.416814566364966</c:v>
                </c:pt>
                <c:pt idx="14">
                  <c:v>5.2142583945517899E-2</c:v>
                </c:pt>
                <c:pt idx="15">
                  <c:v>0.46501671431517799</c:v>
                </c:pt>
                <c:pt idx="16">
                  <c:v>0.50426930019504501</c:v>
                </c:pt>
                <c:pt idx="17">
                  <c:v>1.57461255378914</c:v>
                </c:pt>
                <c:pt idx="18">
                  <c:v>0.21661836495624701</c:v>
                </c:pt>
                <c:pt idx="19">
                  <c:v>9.7885861198907395E-2</c:v>
                </c:pt>
                <c:pt idx="20">
                  <c:v>0.74382187421392099</c:v>
                </c:pt>
                <c:pt idx="21">
                  <c:v>0.59605830782449398</c:v>
                </c:pt>
                <c:pt idx="22">
                  <c:v>0.68428719172988195</c:v>
                </c:pt>
                <c:pt idx="23">
                  <c:v>0.92443288251946798</c:v>
                </c:pt>
                <c:pt idx="24">
                  <c:v>0.808435600800127</c:v>
                </c:pt>
                <c:pt idx="25">
                  <c:v>1.38738405569459</c:v>
                </c:pt>
                <c:pt idx="26">
                  <c:v>1.4753574907546601</c:v>
                </c:pt>
                <c:pt idx="27">
                  <c:v>0.35532924209352601</c:v>
                </c:pt>
                <c:pt idx="28">
                  <c:v>1.5186338798308301</c:v>
                </c:pt>
                <c:pt idx="29">
                  <c:v>0.49196911597467302</c:v>
                </c:pt>
                <c:pt idx="30">
                  <c:v>0.16303153895932401</c:v>
                </c:pt>
                <c:pt idx="31">
                  <c:v>0.44481547199579302</c:v>
                </c:pt>
                <c:pt idx="32">
                  <c:v>0.54637799015321098</c:v>
                </c:pt>
                <c:pt idx="33">
                  <c:v>0.88968329018372005</c:v>
                </c:pt>
                <c:pt idx="34">
                  <c:v>9.9313224593688496E-3</c:v>
                </c:pt>
                <c:pt idx="35">
                  <c:v>0.88968329018372005</c:v>
                </c:pt>
                <c:pt idx="36">
                  <c:v>0.88968329018372005</c:v>
                </c:pt>
                <c:pt idx="37">
                  <c:v>0.51633816323657999</c:v>
                </c:pt>
                <c:pt idx="38">
                  <c:v>0.51633816323657999</c:v>
                </c:pt>
                <c:pt idx="39">
                  <c:v>0.88968329018372005</c:v>
                </c:pt>
                <c:pt idx="40">
                  <c:v>0.79709285307821898</c:v>
                </c:pt>
                <c:pt idx="41">
                  <c:v>0.31471938310029302</c:v>
                </c:pt>
                <c:pt idx="42">
                  <c:v>6.5686445574583599E-2</c:v>
                </c:pt>
                <c:pt idx="43">
                  <c:v>1.45140077911563</c:v>
                </c:pt>
                <c:pt idx="44">
                  <c:v>2.9387874103577301E-2</c:v>
                </c:pt>
                <c:pt idx="45">
                  <c:v>8.9387155095790094E-2</c:v>
                </c:pt>
                <c:pt idx="46">
                  <c:v>0.28580891211055398</c:v>
                </c:pt>
                <c:pt idx="47">
                  <c:v>0.79053074247739696</c:v>
                </c:pt>
                <c:pt idx="48">
                  <c:v>8.6717786891639698E-2</c:v>
                </c:pt>
                <c:pt idx="49">
                  <c:v>0.72791098218837402</c:v>
                </c:pt>
                <c:pt idx="50">
                  <c:v>1.1689049471973201</c:v>
                </c:pt>
                <c:pt idx="51">
                  <c:v>0.59647189528202205</c:v>
                </c:pt>
                <c:pt idx="52">
                  <c:v>0.68314346858840902</c:v>
                </c:pt>
                <c:pt idx="53">
                  <c:v>0.22350000937247699</c:v>
                </c:pt>
                <c:pt idx="54">
                  <c:v>0.55189569570221697</c:v>
                </c:pt>
                <c:pt idx="55">
                  <c:v>0.150835705842287</c:v>
                </c:pt>
                <c:pt idx="56">
                  <c:v>0.40078162434315101</c:v>
                </c:pt>
                <c:pt idx="57">
                  <c:v>0.31135739137289598</c:v>
                </c:pt>
                <c:pt idx="58">
                  <c:v>1.0166268541569301</c:v>
                </c:pt>
                <c:pt idx="59">
                  <c:v>0.96392010938912398</c:v>
                </c:pt>
                <c:pt idx="60">
                  <c:v>0.765081226472483</c:v>
                </c:pt>
                <c:pt idx="61">
                  <c:v>0.91465263729319002</c:v>
                </c:pt>
                <c:pt idx="62">
                  <c:v>0.64951356012661798</c:v>
                </c:pt>
                <c:pt idx="63">
                  <c:v>1.00261961820719</c:v>
                </c:pt>
                <c:pt idx="64">
                  <c:v>1.06168691703457</c:v>
                </c:pt>
                <c:pt idx="65">
                  <c:v>0.94135640725782999</c:v>
                </c:pt>
                <c:pt idx="66">
                  <c:v>0.765050363328456</c:v>
                </c:pt>
                <c:pt idx="67">
                  <c:v>0.32906023829435899</c:v>
                </c:pt>
                <c:pt idx="68">
                  <c:v>1.44821788620467</c:v>
                </c:pt>
                <c:pt idx="69">
                  <c:v>1.2213814593846499</c:v>
                </c:pt>
                <c:pt idx="70">
                  <c:v>1.4611083496055499</c:v>
                </c:pt>
                <c:pt idx="71">
                  <c:v>0.36104726063797299</c:v>
                </c:pt>
                <c:pt idx="72">
                  <c:v>1.1651858445913601</c:v>
                </c:pt>
                <c:pt idx="73">
                  <c:v>0.89052850420435903</c:v>
                </c:pt>
                <c:pt idx="74">
                  <c:v>1.69963820702529</c:v>
                </c:pt>
                <c:pt idx="75">
                  <c:v>1.2211445380768999</c:v>
                </c:pt>
                <c:pt idx="76">
                  <c:v>1.81863458460726</c:v>
                </c:pt>
                <c:pt idx="77">
                  <c:v>0.263666191830219</c:v>
                </c:pt>
                <c:pt idx="78">
                  <c:v>1.2793343152783401</c:v>
                </c:pt>
                <c:pt idx="79">
                  <c:v>1.29935861123609</c:v>
                </c:pt>
                <c:pt idx="80">
                  <c:v>0.71859093226757798</c:v>
                </c:pt>
                <c:pt idx="81">
                  <c:v>0.59592257251608105</c:v>
                </c:pt>
                <c:pt idx="82">
                  <c:v>0.795186155310739</c:v>
                </c:pt>
                <c:pt idx="83">
                  <c:v>0.58871949619569597</c:v>
                </c:pt>
                <c:pt idx="84">
                  <c:v>1.7555428745702999</c:v>
                </c:pt>
                <c:pt idx="85">
                  <c:v>0.25001165737436998</c:v>
                </c:pt>
                <c:pt idx="86">
                  <c:v>1.5488789711444699E-2</c:v>
                </c:pt>
                <c:pt idx="87">
                  <c:v>0.96505015831420504</c:v>
                </c:pt>
                <c:pt idx="88">
                  <c:v>1.3712460331273499</c:v>
                </c:pt>
                <c:pt idx="89">
                  <c:v>1.1706036067882499</c:v>
                </c:pt>
                <c:pt idx="90">
                  <c:v>0.64317564999835797</c:v>
                </c:pt>
                <c:pt idx="91">
                  <c:v>0.550601072836579</c:v>
                </c:pt>
                <c:pt idx="92">
                  <c:v>0.71072651748419702</c:v>
                </c:pt>
                <c:pt idx="93">
                  <c:v>9.7885861198907395E-2</c:v>
                </c:pt>
                <c:pt idx="94">
                  <c:v>1.33337919087322</c:v>
                </c:pt>
                <c:pt idx="95">
                  <c:v>0.37105000566235902</c:v>
                </c:pt>
                <c:pt idx="96">
                  <c:v>0.84402630966449099</c:v>
                </c:pt>
                <c:pt idx="97">
                  <c:v>0.40603283999907003</c:v>
                </c:pt>
                <c:pt idx="98">
                  <c:v>0.69124415996506805</c:v>
                </c:pt>
                <c:pt idx="99">
                  <c:v>0.537724066048758</c:v>
                </c:pt>
                <c:pt idx="100">
                  <c:v>0.97076402928824501</c:v>
                </c:pt>
                <c:pt idx="101">
                  <c:v>0.89574346297574503</c:v>
                </c:pt>
                <c:pt idx="102">
                  <c:v>0.85319808730191904</c:v>
                </c:pt>
                <c:pt idx="103">
                  <c:v>1.1242083402021401</c:v>
                </c:pt>
                <c:pt idx="104">
                  <c:v>6.6746565510577893E-2</c:v>
                </c:pt>
                <c:pt idx="105">
                  <c:v>0.64336598553081803</c:v>
                </c:pt>
                <c:pt idx="106">
                  <c:v>0.63777315593009298</c:v>
                </c:pt>
                <c:pt idx="107">
                  <c:v>0.82013465168747601</c:v>
                </c:pt>
                <c:pt idx="108">
                  <c:v>0.83625500529382402</c:v>
                </c:pt>
                <c:pt idx="109">
                  <c:v>0.94455837341845394</c:v>
                </c:pt>
                <c:pt idx="110">
                  <c:v>0.25980850675504302</c:v>
                </c:pt>
                <c:pt idx="111">
                  <c:v>0.90012078995897604</c:v>
                </c:pt>
                <c:pt idx="112">
                  <c:v>1.67488358392363</c:v>
                </c:pt>
                <c:pt idx="113">
                  <c:v>0.184196791524633</c:v>
                </c:pt>
                <c:pt idx="114">
                  <c:v>0.16515389678916401</c:v>
                </c:pt>
                <c:pt idx="115">
                  <c:v>0.36100852937275002</c:v>
                </c:pt>
                <c:pt idx="116">
                  <c:v>0.232144936290541</c:v>
                </c:pt>
                <c:pt idx="117">
                  <c:v>0.67745102607763297</c:v>
                </c:pt>
                <c:pt idx="118">
                  <c:v>0.491614656620667</c:v>
                </c:pt>
                <c:pt idx="119">
                  <c:v>0.75242111001174705</c:v>
                </c:pt>
                <c:pt idx="120">
                  <c:v>0.34645297973269001</c:v>
                </c:pt>
                <c:pt idx="121">
                  <c:v>0.234459164509008</c:v>
                </c:pt>
                <c:pt idx="122">
                  <c:v>1.65834629510431</c:v>
                </c:pt>
                <c:pt idx="123">
                  <c:v>0.13737089860677201</c:v>
                </c:pt>
                <c:pt idx="124">
                  <c:v>1.3075661489744901</c:v>
                </c:pt>
                <c:pt idx="125">
                  <c:v>0.416814566364966</c:v>
                </c:pt>
                <c:pt idx="126">
                  <c:v>1.0097742903520199</c:v>
                </c:pt>
                <c:pt idx="127">
                  <c:v>1.8234487736729199</c:v>
                </c:pt>
                <c:pt idx="128">
                  <c:v>1.14388689775459</c:v>
                </c:pt>
                <c:pt idx="129">
                  <c:v>5.1492542078918603E-2</c:v>
                </c:pt>
                <c:pt idx="130">
                  <c:v>0.69714983583202095</c:v>
                </c:pt>
                <c:pt idx="131">
                  <c:v>0.66590887358597495</c:v>
                </c:pt>
                <c:pt idx="132">
                  <c:v>0.66590887358597495</c:v>
                </c:pt>
                <c:pt idx="133">
                  <c:v>0.66816378340659699</c:v>
                </c:pt>
                <c:pt idx="134">
                  <c:v>0.44107226820408402</c:v>
                </c:pt>
                <c:pt idx="135">
                  <c:v>0.66816378340659699</c:v>
                </c:pt>
                <c:pt idx="136">
                  <c:v>0.17839201020473899</c:v>
                </c:pt>
                <c:pt idx="137">
                  <c:v>0.28063419334621298</c:v>
                </c:pt>
                <c:pt idx="138">
                  <c:v>0.54637799015321098</c:v>
                </c:pt>
                <c:pt idx="139">
                  <c:v>0.14725888792240799</c:v>
                </c:pt>
                <c:pt idx="140">
                  <c:v>0.106667591867888</c:v>
                </c:pt>
                <c:pt idx="141">
                  <c:v>0.47531121053754999</c:v>
                </c:pt>
                <c:pt idx="142">
                  <c:v>1.0794661677761901</c:v>
                </c:pt>
                <c:pt idx="143">
                  <c:v>0.12073007131065799</c:v>
                </c:pt>
                <c:pt idx="144">
                  <c:v>0.98889682088520503</c:v>
                </c:pt>
                <c:pt idx="145">
                  <c:v>1.6225008841680799</c:v>
                </c:pt>
                <c:pt idx="146">
                  <c:v>0.54318717795355298</c:v>
                </c:pt>
                <c:pt idx="147">
                  <c:v>1.1439431491907699</c:v>
                </c:pt>
                <c:pt idx="148">
                  <c:v>0.69714983583202095</c:v>
                </c:pt>
                <c:pt idx="149">
                  <c:v>0.27315478686217298</c:v>
                </c:pt>
                <c:pt idx="150">
                  <c:v>0.99299872707848502</c:v>
                </c:pt>
                <c:pt idx="151">
                  <c:v>1.27760786972611</c:v>
                </c:pt>
                <c:pt idx="152">
                  <c:v>0.16053996462943601</c:v>
                </c:pt>
                <c:pt idx="153">
                  <c:v>0.40232269388637498</c:v>
                </c:pt>
                <c:pt idx="154">
                  <c:v>0.34971533728403198</c:v>
                </c:pt>
                <c:pt idx="155">
                  <c:v>0.25156362260919002</c:v>
                </c:pt>
                <c:pt idx="156">
                  <c:v>0.89052850420435903</c:v>
                </c:pt>
                <c:pt idx="157">
                  <c:v>6.9547436857562098E-3</c:v>
                </c:pt>
                <c:pt idx="158">
                  <c:v>1.6544643058366399</c:v>
                </c:pt>
                <c:pt idx="159">
                  <c:v>0.91446940630309603</c:v>
                </c:pt>
                <c:pt idx="160">
                  <c:v>0.39828150114781602</c:v>
                </c:pt>
                <c:pt idx="161">
                  <c:v>7.3002678824469702E-2</c:v>
                </c:pt>
                <c:pt idx="162">
                  <c:v>0.51680085997074698</c:v>
                </c:pt>
                <c:pt idx="163">
                  <c:v>0.46899562667154998</c:v>
                </c:pt>
                <c:pt idx="164">
                  <c:v>5.8617564053111401E-2</c:v>
                </c:pt>
                <c:pt idx="165">
                  <c:v>0.88355681938462405</c:v>
                </c:pt>
                <c:pt idx="166">
                  <c:v>0.30922994666696302</c:v>
                </c:pt>
                <c:pt idx="167">
                  <c:v>0.30922994666696302</c:v>
                </c:pt>
                <c:pt idx="168">
                  <c:v>0.41460219754649102</c:v>
                </c:pt>
                <c:pt idx="169">
                  <c:v>0.41460219754649102</c:v>
                </c:pt>
                <c:pt idx="170">
                  <c:v>0.41460219754649102</c:v>
                </c:pt>
                <c:pt idx="171">
                  <c:v>0.89169224844182104</c:v>
                </c:pt>
                <c:pt idx="172">
                  <c:v>0.89169224844182104</c:v>
                </c:pt>
                <c:pt idx="173">
                  <c:v>1.7326316755922999</c:v>
                </c:pt>
                <c:pt idx="174">
                  <c:v>1.7326316755922999</c:v>
                </c:pt>
                <c:pt idx="175">
                  <c:v>1.14725506077891</c:v>
                </c:pt>
                <c:pt idx="176">
                  <c:v>1.14725506077891</c:v>
                </c:pt>
                <c:pt idx="177">
                  <c:v>0.91720751270021905</c:v>
                </c:pt>
                <c:pt idx="178">
                  <c:v>0.53396854301213603</c:v>
                </c:pt>
                <c:pt idx="179">
                  <c:v>0.53396854301213603</c:v>
                </c:pt>
                <c:pt idx="180">
                  <c:v>0.32906023829435899</c:v>
                </c:pt>
                <c:pt idx="181">
                  <c:v>0.59840248002430596</c:v>
                </c:pt>
                <c:pt idx="182">
                  <c:v>0.53297147836214398</c:v>
                </c:pt>
                <c:pt idx="183">
                  <c:v>0.902388920712203</c:v>
                </c:pt>
                <c:pt idx="184">
                  <c:v>1.44821788620467</c:v>
                </c:pt>
                <c:pt idx="185">
                  <c:v>1.50093241084242</c:v>
                </c:pt>
                <c:pt idx="186">
                  <c:v>1.0730609315284201</c:v>
                </c:pt>
                <c:pt idx="187">
                  <c:v>1.42485997006744</c:v>
                </c:pt>
                <c:pt idx="188">
                  <c:v>0.73437602998222595</c:v>
                </c:pt>
                <c:pt idx="189">
                  <c:v>0.15664051424224301</c:v>
                </c:pt>
                <c:pt idx="190">
                  <c:v>0.37113560260073403</c:v>
                </c:pt>
                <c:pt idx="191">
                  <c:v>0.49226494510171798</c:v>
                </c:pt>
                <c:pt idx="192">
                  <c:v>0.227185065886155</c:v>
                </c:pt>
                <c:pt idx="193">
                  <c:v>0.38899842616303598</c:v>
                </c:pt>
                <c:pt idx="194">
                  <c:v>0.64990394283361996</c:v>
                </c:pt>
                <c:pt idx="195">
                  <c:v>0.35096044878863902</c:v>
                </c:pt>
                <c:pt idx="196">
                  <c:v>0.484545616942127</c:v>
                </c:pt>
                <c:pt idx="197">
                  <c:v>0.75022849482570597</c:v>
                </c:pt>
                <c:pt idx="198">
                  <c:v>0.54122792006860398</c:v>
                </c:pt>
                <c:pt idx="199">
                  <c:v>1.4632457822115299</c:v>
                </c:pt>
                <c:pt idx="200">
                  <c:v>0.75283207074610703</c:v>
                </c:pt>
                <c:pt idx="201">
                  <c:v>1.4025792819025</c:v>
                </c:pt>
                <c:pt idx="202">
                  <c:v>7.6010725626468004E-2</c:v>
                </c:pt>
                <c:pt idx="203">
                  <c:v>0.92301303436280202</c:v>
                </c:pt>
                <c:pt idx="204">
                  <c:v>1.0196113816472001</c:v>
                </c:pt>
                <c:pt idx="205">
                  <c:v>0.81708504908742696</c:v>
                </c:pt>
                <c:pt idx="206">
                  <c:v>0.67420627592479798</c:v>
                </c:pt>
                <c:pt idx="207">
                  <c:v>6.2905690722165801E-3</c:v>
                </c:pt>
                <c:pt idx="208">
                  <c:v>0.219635087855867</c:v>
                </c:pt>
                <c:pt idx="209">
                  <c:v>1.08858565421454</c:v>
                </c:pt>
                <c:pt idx="210">
                  <c:v>1.23595420165582</c:v>
                </c:pt>
                <c:pt idx="211">
                  <c:v>0.10810739664588501</c:v>
                </c:pt>
                <c:pt idx="212">
                  <c:v>0.19740914313003599</c:v>
                </c:pt>
                <c:pt idx="213">
                  <c:v>0.26897857543426701</c:v>
                </c:pt>
                <c:pt idx="214">
                  <c:v>0.24164089903760499</c:v>
                </c:pt>
                <c:pt idx="215">
                  <c:v>0.75707295431080901</c:v>
                </c:pt>
                <c:pt idx="216">
                  <c:v>7.3368856469427396E-2</c:v>
                </c:pt>
                <c:pt idx="217">
                  <c:v>2.0834625550903998</c:v>
                </c:pt>
                <c:pt idx="218">
                  <c:v>3.4088063488180102E-2</c:v>
                </c:pt>
                <c:pt idx="219">
                  <c:v>0.81793331291140903</c:v>
                </c:pt>
                <c:pt idx="220">
                  <c:v>0.14972683461415701</c:v>
                </c:pt>
                <c:pt idx="221">
                  <c:v>0.20740425096406101</c:v>
                </c:pt>
                <c:pt idx="222">
                  <c:v>0.849947645903955</c:v>
                </c:pt>
                <c:pt idx="223">
                  <c:v>0.43513662796150099</c:v>
                </c:pt>
                <c:pt idx="224">
                  <c:v>0.19142000953680699</c:v>
                </c:pt>
                <c:pt idx="225">
                  <c:v>2.0246198799122102</c:v>
                </c:pt>
                <c:pt idx="226">
                  <c:v>5.1267793784123702E-2</c:v>
                </c:pt>
                <c:pt idx="227">
                  <c:v>1.08858565421454</c:v>
                </c:pt>
                <c:pt idx="228">
                  <c:v>0.66350318565456901</c:v>
                </c:pt>
                <c:pt idx="229">
                  <c:v>0.223640539217099</c:v>
                </c:pt>
                <c:pt idx="230">
                  <c:v>0.63459127850420205</c:v>
                </c:pt>
                <c:pt idx="231">
                  <c:v>0.13890208478757601</c:v>
                </c:pt>
                <c:pt idx="232">
                  <c:v>1.04359417186018</c:v>
                </c:pt>
                <c:pt idx="233">
                  <c:v>0.73611853191244903</c:v>
                </c:pt>
                <c:pt idx="234">
                  <c:v>0.66922096804620501</c:v>
                </c:pt>
                <c:pt idx="235">
                  <c:v>0.88876426674130304</c:v>
                </c:pt>
                <c:pt idx="236">
                  <c:v>0.12767565990593499</c:v>
                </c:pt>
                <c:pt idx="237">
                  <c:v>0.25772056372082103</c:v>
                </c:pt>
                <c:pt idx="238">
                  <c:v>0.728355117299614</c:v>
                </c:pt>
                <c:pt idx="239">
                  <c:v>0.25318972880662699</c:v>
                </c:pt>
                <c:pt idx="240">
                  <c:v>0.61028589768849895</c:v>
                </c:pt>
                <c:pt idx="241">
                  <c:v>0.28214450059095098</c:v>
                </c:pt>
                <c:pt idx="242">
                  <c:v>0.105373870054692</c:v>
                </c:pt>
                <c:pt idx="243">
                  <c:v>1.2121592778023</c:v>
                </c:pt>
                <c:pt idx="244">
                  <c:v>0.62414620464762305</c:v>
                </c:pt>
                <c:pt idx="245">
                  <c:v>1.66701418402991</c:v>
                </c:pt>
                <c:pt idx="246">
                  <c:v>1.6987390187882501</c:v>
                </c:pt>
                <c:pt idx="247">
                  <c:v>1.43973958355743</c:v>
                </c:pt>
                <c:pt idx="248">
                  <c:v>0.657692740988569</c:v>
                </c:pt>
                <c:pt idx="249">
                  <c:v>1.04130479062523</c:v>
                </c:pt>
                <c:pt idx="250">
                  <c:v>0.19575551769598201</c:v>
                </c:pt>
                <c:pt idx="251">
                  <c:v>2.0028249929286699</c:v>
                </c:pt>
                <c:pt idx="252">
                  <c:v>0.14459141205641601</c:v>
                </c:pt>
                <c:pt idx="253">
                  <c:v>0.211413748668144</c:v>
                </c:pt>
                <c:pt idx="254">
                  <c:v>2.14287997715949</c:v>
                </c:pt>
                <c:pt idx="255">
                  <c:v>0.91658668338708305</c:v>
                </c:pt>
                <c:pt idx="256">
                  <c:v>0.649877896678138</c:v>
                </c:pt>
                <c:pt idx="257">
                  <c:v>0.38096730355061498</c:v>
                </c:pt>
                <c:pt idx="258">
                  <c:v>0.16132088168168199</c:v>
                </c:pt>
                <c:pt idx="259">
                  <c:v>0.42056190398517401</c:v>
                </c:pt>
                <c:pt idx="260">
                  <c:v>1.3157555744154299</c:v>
                </c:pt>
                <c:pt idx="261">
                  <c:v>0.72855077388930001</c:v>
                </c:pt>
                <c:pt idx="262">
                  <c:v>0.50594289968353301</c:v>
                </c:pt>
                <c:pt idx="263">
                  <c:v>0.93310829139863904</c:v>
                </c:pt>
                <c:pt idx="264">
                  <c:v>0.128858300342376</c:v>
                </c:pt>
                <c:pt idx="265">
                  <c:v>0.73728589547905798</c:v>
                </c:pt>
                <c:pt idx="266">
                  <c:v>1.04130479062523</c:v>
                </c:pt>
                <c:pt idx="267">
                  <c:v>1.7230078710933601</c:v>
                </c:pt>
                <c:pt idx="268">
                  <c:v>0.24164089903760499</c:v>
                </c:pt>
                <c:pt idx="269">
                  <c:v>0.56965322581351596</c:v>
                </c:pt>
                <c:pt idx="270">
                  <c:v>2.73283373452059E-2</c:v>
                </c:pt>
                <c:pt idx="271">
                  <c:v>0.21305147427297599</c:v>
                </c:pt>
                <c:pt idx="272">
                  <c:v>0.66279509173640605</c:v>
                </c:pt>
                <c:pt idx="273">
                  <c:v>1.15847470398388E-2</c:v>
                </c:pt>
                <c:pt idx="274">
                  <c:v>0.93579517307089799</c:v>
                </c:pt>
                <c:pt idx="275">
                  <c:v>1.1629382310069101</c:v>
                </c:pt>
                <c:pt idx="276">
                  <c:v>0.42601324638170701</c:v>
                </c:pt>
                <c:pt idx="277">
                  <c:v>1.1484328336362499</c:v>
                </c:pt>
                <c:pt idx="278">
                  <c:v>1.68021220062915</c:v>
                </c:pt>
                <c:pt idx="279">
                  <c:v>1.43973958355743</c:v>
                </c:pt>
                <c:pt idx="280">
                  <c:v>5.7083598106015598E-2</c:v>
                </c:pt>
                <c:pt idx="281">
                  <c:v>0.66197787232369798</c:v>
                </c:pt>
                <c:pt idx="282">
                  <c:v>0.76319627593797601</c:v>
                </c:pt>
                <c:pt idx="283">
                  <c:v>1.3200942403318701</c:v>
                </c:pt>
                <c:pt idx="284">
                  <c:v>1.3544603092912</c:v>
                </c:pt>
                <c:pt idx="285">
                  <c:v>0.74597728886711001</c:v>
                </c:pt>
                <c:pt idx="286">
                  <c:v>0.67420627592479798</c:v>
                </c:pt>
                <c:pt idx="287">
                  <c:v>0.93105731931692703</c:v>
                </c:pt>
                <c:pt idx="288">
                  <c:v>4.3193300392067001E-2</c:v>
                </c:pt>
                <c:pt idx="289">
                  <c:v>0.71901880958673703</c:v>
                </c:pt>
                <c:pt idx="290">
                  <c:v>0.64954294766618703</c:v>
                </c:pt>
                <c:pt idx="291">
                  <c:v>0.18946946876388099</c:v>
                </c:pt>
                <c:pt idx="292">
                  <c:v>0.96896669327751594</c:v>
                </c:pt>
                <c:pt idx="293">
                  <c:v>0.37082866557413002</c:v>
                </c:pt>
                <c:pt idx="294">
                  <c:v>1.0016098010111001</c:v>
                </c:pt>
                <c:pt idx="295">
                  <c:v>0.382344131185614</c:v>
                </c:pt>
                <c:pt idx="296">
                  <c:v>0.245006683945559</c:v>
                </c:pt>
                <c:pt idx="297">
                  <c:v>0.25673106665053202</c:v>
                </c:pt>
                <c:pt idx="298">
                  <c:v>0.99158328634478599</c:v>
                </c:pt>
                <c:pt idx="299">
                  <c:v>0.24267263816051901</c:v>
                </c:pt>
                <c:pt idx="300">
                  <c:v>1.5829352661782901</c:v>
                </c:pt>
                <c:pt idx="301">
                  <c:v>1.7704143123965801</c:v>
                </c:pt>
                <c:pt idx="302">
                  <c:v>0.12176096307623201</c:v>
                </c:pt>
                <c:pt idx="303">
                  <c:v>0.91562754953824099</c:v>
                </c:pt>
                <c:pt idx="304">
                  <c:v>2.0022354105040399</c:v>
                </c:pt>
                <c:pt idx="305">
                  <c:v>0.17163162213963601</c:v>
                </c:pt>
                <c:pt idx="306">
                  <c:v>0.23216245344671799</c:v>
                </c:pt>
                <c:pt idx="307">
                  <c:v>1.6468762351538599</c:v>
                </c:pt>
                <c:pt idx="308">
                  <c:v>0.10810739664588501</c:v>
                </c:pt>
                <c:pt idx="309">
                  <c:v>1.0918295933470199</c:v>
                </c:pt>
                <c:pt idx="310">
                  <c:v>0.81708504908742696</c:v>
                </c:pt>
                <c:pt idx="311">
                  <c:v>0.10990234118219</c:v>
                </c:pt>
                <c:pt idx="312">
                  <c:v>1.31398426846115</c:v>
                </c:pt>
                <c:pt idx="313">
                  <c:v>0.80577011682996602</c:v>
                </c:pt>
                <c:pt idx="314">
                  <c:v>0.32273693544426701</c:v>
                </c:pt>
                <c:pt idx="315">
                  <c:v>0.76287432780599895</c:v>
                </c:pt>
                <c:pt idx="316">
                  <c:v>0.785098453336464</c:v>
                </c:pt>
                <c:pt idx="317">
                  <c:v>0.71307509299820304</c:v>
                </c:pt>
                <c:pt idx="318">
                  <c:v>1.35534902084924</c:v>
                </c:pt>
                <c:pt idx="319">
                  <c:v>1.11587285236012</c:v>
                </c:pt>
                <c:pt idx="320">
                  <c:v>0.84096797377098498</c:v>
                </c:pt>
                <c:pt idx="321">
                  <c:v>0.81708504908742696</c:v>
                </c:pt>
                <c:pt idx="322">
                  <c:v>0.92159137539982905</c:v>
                </c:pt>
                <c:pt idx="323">
                  <c:v>0.227185065886155</c:v>
                </c:pt>
                <c:pt idx="324">
                  <c:v>0.127108908225843</c:v>
                </c:pt>
                <c:pt idx="325">
                  <c:v>3.5766320043443101E-2</c:v>
                </c:pt>
                <c:pt idx="326">
                  <c:v>0.77487489832804402</c:v>
                </c:pt>
                <c:pt idx="327">
                  <c:v>1.09892643293097</c:v>
                </c:pt>
                <c:pt idx="328">
                  <c:v>0.13707274191018601</c:v>
                </c:pt>
                <c:pt idx="329">
                  <c:v>1.28266154239865</c:v>
                </c:pt>
                <c:pt idx="330">
                  <c:v>1.1722818849480099</c:v>
                </c:pt>
                <c:pt idx="331">
                  <c:v>0.94282790187572096</c:v>
                </c:pt>
                <c:pt idx="332">
                  <c:v>0.74092750545616604</c:v>
                </c:pt>
                <c:pt idx="333">
                  <c:v>0.85168911625711197</c:v>
                </c:pt>
                <c:pt idx="334">
                  <c:v>2.1817671403185499</c:v>
                </c:pt>
                <c:pt idx="335">
                  <c:v>1.4415580953629601</c:v>
                </c:pt>
                <c:pt idx="336">
                  <c:v>1.4415580953629601</c:v>
                </c:pt>
                <c:pt idx="337">
                  <c:v>1.5104547955980101</c:v>
                </c:pt>
                <c:pt idx="338">
                  <c:v>1.5104547955980101</c:v>
                </c:pt>
                <c:pt idx="339">
                  <c:v>1.27634941198486</c:v>
                </c:pt>
                <c:pt idx="340">
                  <c:v>0.85047050758437104</c:v>
                </c:pt>
                <c:pt idx="341">
                  <c:v>1.3282267809506101</c:v>
                </c:pt>
                <c:pt idx="342">
                  <c:v>1.3282267809506101</c:v>
                </c:pt>
                <c:pt idx="343">
                  <c:v>1.32545149413275</c:v>
                </c:pt>
                <c:pt idx="344">
                  <c:v>1.32545149413275</c:v>
                </c:pt>
                <c:pt idx="345">
                  <c:v>0.50199600065676997</c:v>
                </c:pt>
                <c:pt idx="346">
                  <c:v>0.59782710345109402</c:v>
                </c:pt>
                <c:pt idx="347">
                  <c:v>1.4607511888776901</c:v>
                </c:pt>
                <c:pt idx="348">
                  <c:v>1.5745448489499301</c:v>
                </c:pt>
                <c:pt idx="349">
                  <c:v>0.85995506201427796</c:v>
                </c:pt>
                <c:pt idx="350">
                  <c:v>1.0561298409361899</c:v>
                </c:pt>
                <c:pt idx="351">
                  <c:v>2.0639142938599</c:v>
                </c:pt>
                <c:pt idx="352">
                  <c:v>1.2619333932336601</c:v>
                </c:pt>
                <c:pt idx="353">
                  <c:v>0.69488943860319696</c:v>
                </c:pt>
                <c:pt idx="354">
                  <c:v>0.76046935341473398</c:v>
                </c:pt>
                <c:pt idx="355">
                  <c:v>9.5402544971455699E-2</c:v>
                </c:pt>
                <c:pt idx="356">
                  <c:v>0.96345498289305298</c:v>
                </c:pt>
                <c:pt idx="357">
                  <c:v>1.03868094645658</c:v>
                </c:pt>
                <c:pt idx="358">
                  <c:v>1.00687166721159</c:v>
                </c:pt>
                <c:pt idx="359">
                  <c:v>1.02458640513633</c:v>
                </c:pt>
                <c:pt idx="360">
                  <c:v>1.1864393008059899</c:v>
                </c:pt>
                <c:pt idx="361">
                  <c:v>0.83276827831648403</c:v>
                </c:pt>
                <c:pt idx="362">
                  <c:v>1.16630532975093</c:v>
                </c:pt>
                <c:pt idx="363">
                  <c:v>0.46674539363585299</c:v>
                </c:pt>
                <c:pt idx="364">
                  <c:v>1.4155509369839001</c:v>
                </c:pt>
                <c:pt idx="365">
                  <c:v>0.44240830082103599</c:v>
                </c:pt>
                <c:pt idx="366">
                  <c:v>0.150692845423022</c:v>
                </c:pt>
                <c:pt idx="367">
                  <c:v>0.67861417991054496</c:v>
                </c:pt>
                <c:pt idx="368">
                  <c:v>1.80445771751892</c:v>
                </c:pt>
                <c:pt idx="369">
                  <c:v>1.0482836194677001</c:v>
                </c:pt>
                <c:pt idx="370">
                  <c:v>1.33426482961855</c:v>
                </c:pt>
                <c:pt idx="371">
                  <c:v>0.53547523823701104</c:v>
                </c:pt>
                <c:pt idx="372">
                  <c:v>1.13670656138306</c:v>
                </c:pt>
                <c:pt idx="373">
                  <c:v>0.211995270592403</c:v>
                </c:pt>
                <c:pt idx="374">
                  <c:v>0.96324107504340495</c:v>
                </c:pt>
                <c:pt idx="375">
                  <c:v>0.76609792869916904</c:v>
                </c:pt>
                <c:pt idx="376">
                  <c:v>0.49742943788122601</c:v>
                </c:pt>
                <c:pt idx="377">
                  <c:v>0.49742943788122601</c:v>
                </c:pt>
                <c:pt idx="378">
                  <c:v>1.77630815528358</c:v>
                </c:pt>
                <c:pt idx="379">
                  <c:v>0.82966733419810201</c:v>
                </c:pt>
                <c:pt idx="380">
                  <c:v>0.874907410631802</c:v>
                </c:pt>
                <c:pt idx="381">
                  <c:v>1.1656519936771601</c:v>
                </c:pt>
                <c:pt idx="382">
                  <c:v>0.35175693793448798</c:v>
                </c:pt>
                <c:pt idx="383">
                  <c:v>1.31128104791157</c:v>
                </c:pt>
                <c:pt idx="384">
                  <c:v>0.76468491491472601</c:v>
                </c:pt>
                <c:pt idx="385">
                  <c:v>1.9824771030906501</c:v>
                </c:pt>
                <c:pt idx="386">
                  <c:v>1.4918818985066</c:v>
                </c:pt>
                <c:pt idx="387">
                  <c:v>0.74862814257713195</c:v>
                </c:pt>
                <c:pt idx="388">
                  <c:v>1.6836390210418899</c:v>
                </c:pt>
                <c:pt idx="389">
                  <c:v>0.77122606491524004</c:v>
                </c:pt>
                <c:pt idx="390">
                  <c:v>7.6685197258637303E-2</c:v>
                </c:pt>
                <c:pt idx="391">
                  <c:v>0.50664822172600399</c:v>
                </c:pt>
                <c:pt idx="392">
                  <c:v>0.92563210665738505</c:v>
                </c:pt>
                <c:pt idx="393">
                  <c:v>0.62977934664799795</c:v>
                </c:pt>
                <c:pt idx="394">
                  <c:v>0.49197842126122598</c:v>
                </c:pt>
                <c:pt idx="395">
                  <c:v>0.486974302888382</c:v>
                </c:pt>
                <c:pt idx="396">
                  <c:v>1.12440075235937</c:v>
                </c:pt>
                <c:pt idx="397">
                  <c:v>0.88121270251145001</c:v>
                </c:pt>
                <c:pt idx="398">
                  <c:v>1.3569971288182601</c:v>
                </c:pt>
                <c:pt idx="399">
                  <c:v>0.692489900868417</c:v>
                </c:pt>
                <c:pt idx="400">
                  <c:v>0.59100247706734799</c:v>
                </c:pt>
                <c:pt idx="401">
                  <c:v>0.74897253793342999</c:v>
                </c:pt>
                <c:pt idx="402">
                  <c:v>0.24219937232901001</c:v>
                </c:pt>
                <c:pt idx="403">
                  <c:v>1.62356121890673E-2</c:v>
                </c:pt>
                <c:pt idx="404">
                  <c:v>0.26239677633125802</c:v>
                </c:pt>
                <c:pt idx="405">
                  <c:v>1.47405486169809E-2</c:v>
                </c:pt>
                <c:pt idx="406">
                  <c:v>0.96354719862605098</c:v>
                </c:pt>
                <c:pt idx="407">
                  <c:v>0.18896226185211201</c:v>
                </c:pt>
                <c:pt idx="408">
                  <c:v>0.480157574885338</c:v>
                </c:pt>
                <c:pt idx="409">
                  <c:v>1.0925525185773299</c:v>
                </c:pt>
                <c:pt idx="410">
                  <c:v>0.112407288717171</c:v>
                </c:pt>
                <c:pt idx="411">
                  <c:v>0.42432595746831098</c:v>
                </c:pt>
                <c:pt idx="412">
                  <c:v>0.16081534781543</c:v>
                </c:pt>
                <c:pt idx="413">
                  <c:v>0.85230553749679905</c:v>
                </c:pt>
                <c:pt idx="414">
                  <c:v>0.36886025662364103</c:v>
                </c:pt>
                <c:pt idx="415">
                  <c:v>0.221755676194721</c:v>
                </c:pt>
                <c:pt idx="416">
                  <c:v>0.73507221529395805</c:v>
                </c:pt>
                <c:pt idx="417">
                  <c:v>7.7936750115546405E-2</c:v>
                </c:pt>
                <c:pt idx="418">
                  <c:v>0.47514259124953501</c:v>
                </c:pt>
                <c:pt idx="419">
                  <c:v>0.54055476259385804</c:v>
                </c:pt>
                <c:pt idx="420">
                  <c:v>0.20741597453810201</c:v>
                </c:pt>
                <c:pt idx="421">
                  <c:v>0.26464911000882002</c:v>
                </c:pt>
                <c:pt idx="422">
                  <c:v>0.115052101021203</c:v>
                </c:pt>
                <c:pt idx="423">
                  <c:v>0.23112605065809899</c:v>
                </c:pt>
                <c:pt idx="424">
                  <c:v>0.83961340545416496</c:v>
                </c:pt>
                <c:pt idx="425">
                  <c:v>0.73651923137316799</c:v>
                </c:pt>
                <c:pt idx="426">
                  <c:v>0.39998042114751298</c:v>
                </c:pt>
                <c:pt idx="427">
                  <c:v>0.60453154943883403</c:v>
                </c:pt>
                <c:pt idx="428">
                  <c:v>0.76631255930833697</c:v>
                </c:pt>
                <c:pt idx="429">
                  <c:v>0.33767084512163398</c:v>
                </c:pt>
                <c:pt idx="430">
                  <c:v>0.85987471717319197</c:v>
                </c:pt>
                <c:pt idx="431">
                  <c:v>0.501655037626899</c:v>
                </c:pt>
                <c:pt idx="432">
                  <c:v>0.58016802505035603</c:v>
                </c:pt>
                <c:pt idx="433">
                  <c:v>9.0622254165033996E-3</c:v>
                </c:pt>
                <c:pt idx="434">
                  <c:v>0.26485116800421499</c:v>
                </c:pt>
                <c:pt idx="435">
                  <c:v>0.18933853594119601</c:v>
                </c:pt>
                <c:pt idx="436">
                  <c:v>0.41072990184611402</c:v>
                </c:pt>
                <c:pt idx="437">
                  <c:v>7.9135081645121896E-2</c:v>
                </c:pt>
                <c:pt idx="438">
                  <c:v>1.2814519642875899</c:v>
                </c:pt>
                <c:pt idx="439">
                  <c:v>0.26397891156771602</c:v>
                </c:pt>
                <c:pt idx="440">
                  <c:v>4.0333231869491899E-2</c:v>
                </c:pt>
                <c:pt idx="441">
                  <c:v>0.61201261639246995</c:v>
                </c:pt>
                <c:pt idx="442">
                  <c:v>9.3925082368927895E-2</c:v>
                </c:pt>
                <c:pt idx="443">
                  <c:v>0.47895214307961897</c:v>
                </c:pt>
                <c:pt idx="444">
                  <c:v>0.37878411744526203</c:v>
                </c:pt>
                <c:pt idx="445">
                  <c:v>0.50255948669363903</c:v>
                </c:pt>
                <c:pt idx="446">
                  <c:v>0.901785967941097</c:v>
                </c:pt>
                <c:pt idx="447">
                  <c:v>0.53787663743964798</c:v>
                </c:pt>
                <c:pt idx="448">
                  <c:v>1.5358140078388399E-2</c:v>
                </c:pt>
                <c:pt idx="449">
                  <c:v>0.52325146769492603</c:v>
                </c:pt>
                <c:pt idx="450">
                  <c:v>0.516353725493507</c:v>
                </c:pt>
                <c:pt idx="451">
                  <c:v>0.134796372392365</c:v>
                </c:pt>
                <c:pt idx="452">
                  <c:v>0.46588958396204799</c:v>
                </c:pt>
                <c:pt idx="453">
                  <c:v>0.21038412114894101</c:v>
                </c:pt>
                <c:pt idx="454">
                  <c:v>0.32028897648787402</c:v>
                </c:pt>
                <c:pt idx="455">
                  <c:v>1.0209753110605799</c:v>
                </c:pt>
                <c:pt idx="456">
                  <c:v>0.146233118265406</c:v>
                </c:pt>
                <c:pt idx="457">
                  <c:v>0.47449486123168</c:v>
                </c:pt>
                <c:pt idx="458">
                  <c:v>1.17833278905328</c:v>
                </c:pt>
                <c:pt idx="459">
                  <c:v>1.4769858822204101</c:v>
                </c:pt>
                <c:pt idx="460">
                  <c:v>0.71624676974911805</c:v>
                </c:pt>
                <c:pt idx="461">
                  <c:v>0.36145215475853498</c:v>
                </c:pt>
                <c:pt idx="462">
                  <c:v>0.747934580350894</c:v>
                </c:pt>
                <c:pt idx="463">
                  <c:v>0.60462832717589199</c:v>
                </c:pt>
                <c:pt idx="464">
                  <c:v>5.7314659040051098E-2</c:v>
                </c:pt>
                <c:pt idx="465">
                  <c:v>1.6660015228574601</c:v>
                </c:pt>
                <c:pt idx="466">
                  <c:v>1.06083789654008</c:v>
                </c:pt>
                <c:pt idx="467">
                  <c:v>0.219876548168813</c:v>
                </c:pt>
                <c:pt idx="468">
                  <c:v>0.72231161046119496</c:v>
                </c:pt>
                <c:pt idx="469">
                  <c:v>0.48044207842539899</c:v>
                </c:pt>
                <c:pt idx="470">
                  <c:v>0.70063987179495901</c:v>
                </c:pt>
                <c:pt idx="471">
                  <c:v>0.19026204579397599</c:v>
                </c:pt>
                <c:pt idx="472">
                  <c:v>0.36673517840680703</c:v>
                </c:pt>
                <c:pt idx="473">
                  <c:v>1.6791294520550899</c:v>
                </c:pt>
                <c:pt idx="474">
                  <c:v>0.39752583668340602</c:v>
                </c:pt>
                <c:pt idx="475">
                  <c:v>1.1639716756973</c:v>
                </c:pt>
                <c:pt idx="476">
                  <c:v>0.87924315259556396</c:v>
                </c:pt>
                <c:pt idx="477">
                  <c:v>0.105199645624175</c:v>
                </c:pt>
                <c:pt idx="478">
                  <c:v>0.90437339926366</c:v>
                </c:pt>
                <c:pt idx="479">
                  <c:v>0.798407908174943</c:v>
                </c:pt>
                <c:pt idx="480">
                  <c:v>1.0280058856588199</c:v>
                </c:pt>
                <c:pt idx="481">
                  <c:v>1.1171819242884999</c:v>
                </c:pt>
                <c:pt idx="482">
                  <c:v>0.90424416777830996</c:v>
                </c:pt>
                <c:pt idx="483">
                  <c:v>0.474728066276217</c:v>
                </c:pt>
                <c:pt idx="484">
                  <c:v>0.235825302477224</c:v>
                </c:pt>
                <c:pt idx="485">
                  <c:v>0.18586947062252099</c:v>
                </c:pt>
                <c:pt idx="486">
                  <c:v>1.0536033012177499</c:v>
                </c:pt>
                <c:pt idx="487">
                  <c:v>4.77774905850544E-2</c:v>
                </c:pt>
                <c:pt idx="488">
                  <c:v>0.23999549030235101</c:v>
                </c:pt>
                <c:pt idx="489">
                  <c:v>0.69527878802431098</c:v>
                </c:pt>
                <c:pt idx="490">
                  <c:v>0.26775740215655502</c:v>
                </c:pt>
                <c:pt idx="491">
                  <c:v>0.64399585185219699</c:v>
                </c:pt>
                <c:pt idx="492">
                  <c:v>0.50136274269602898</c:v>
                </c:pt>
                <c:pt idx="493">
                  <c:v>0.79188658309819004</c:v>
                </c:pt>
                <c:pt idx="494">
                  <c:v>0.612710891260555</c:v>
                </c:pt>
                <c:pt idx="495">
                  <c:v>0.56818312170252905</c:v>
                </c:pt>
                <c:pt idx="496">
                  <c:v>0.89704671903529098</c:v>
                </c:pt>
                <c:pt idx="497">
                  <c:v>0.43312495905902698</c:v>
                </c:pt>
                <c:pt idx="498">
                  <c:v>0.34086875906696201</c:v>
                </c:pt>
                <c:pt idx="499">
                  <c:v>0.57629479550128904</c:v>
                </c:pt>
                <c:pt idx="500">
                  <c:v>1.90136224290542</c:v>
                </c:pt>
                <c:pt idx="501">
                  <c:v>0.44286379571784801</c:v>
                </c:pt>
                <c:pt idx="502">
                  <c:v>0.451683323822056</c:v>
                </c:pt>
                <c:pt idx="503">
                  <c:v>1.2101088308902599</c:v>
                </c:pt>
                <c:pt idx="504">
                  <c:v>0.343025021001926</c:v>
                </c:pt>
                <c:pt idx="505">
                  <c:v>0.669473786787392</c:v>
                </c:pt>
                <c:pt idx="506">
                  <c:v>0.81281911908168802</c:v>
                </c:pt>
                <c:pt idx="507">
                  <c:v>0.52220265935836396</c:v>
                </c:pt>
                <c:pt idx="508">
                  <c:v>0.64004114858453598</c:v>
                </c:pt>
                <c:pt idx="509">
                  <c:v>0.41394995146709201</c:v>
                </c:pt>
                <c:pt idx="510">
                  <c:v>1.50891672983937</c:v>
                </c:pt>
                <c:pt idx="511">
                  <c:v>1.1929902964366701</c:v>
                </c:pt>
                <c:pt idx="512">
                  <c:v>0.46543334915976797</c:v>
                </c:pt>
                <c:pt idx="513">
                  <c:v>0.36214417143106498</c:v>
                </c:pt>
                <c:pt idx="514">
                  <c:v>0.48921622892404198</c:v>
                </c:pt>
                <c:pt idx="515">
                  <c:v>0.38732849553591497</c:v>
                </c:pt>
                <c:pt idx="516">
                  <c:v>0.90024622092226803</c:v>
                </c:pt>
                <c:pt idx="517">
                  <c:v>0.58093703361643101</c:v>
                </c:pt>
                <c:pt idx="518">
                  <c:v>0.50632088912898998</c:v>
                </c:pt>
                <c:pt idx="519">
                  <c:v>1.0933668253176601</c:v>
                </c:pt>
                <c:pt idx="520">
                  <c:v>0.79299592925035101</c:v>
                </c:pt>
                <c:pt idx="521">
                  <c:v>0.85904952091806197</c:v>
                </c:pt>
                <c:pt idx="522">
                  <c:v>0.71722461115229397</c:v>
                </c:pt>
                <c:pt idx="523">
                  <c:v>0.29261473012269601</c:v>
                </c:pt>
                <c:pt idx="524">
                  <c:v>1.8993775664764598E-2</c:v>
                </c:pt>
                <c:pt idx="525">
                  <c:v>0.49915495755386602</c:v>
                </c:pt>
                <c:pt idx="526">
                  <c:v>0.71616646775253201</c:v>
                </c:pt>
                <c:pt idx="527">
                  <c:v>7.1064918763448795E-2</c:v>
                </c:pt>
                <c:pt idx="528">
                  <c:v>0.15597899472173199</c:v>
                </c:pt>
                <c:pt idx="529">
                  <c:v>0.229892599107234</c:v>
                </c:pt>
                <c:pt idx="530">
                  <c:v>0.99973079826834998</c:v>
                </c:pt>
                <c:pt idx="531">
                  <c:v>0.79341274009722795</c:v>
                </c:pt>
                <c:pt idx="532">
                  <c:v>0.54082322082918999</c:v>
                </c:pt>
                <c:pt idx="533">
                  <c:v>0.42308311610268201</c:v>
                </c:pt>
                <c:pt idx="534">
                  <c:v>0.23582330365220899</c:v>
                </c:pt>
                <c:pt idx="535">
                  <c:v>0.351400800302891</c:v>
                </c:pt>
                <c:pt idx="536">
                  <c:v>9.3305792111057204E-2</c:v>
                </c:pt>
                <c:pt idx="537">
                  <c:v>0.104508156266176</c:v>
                </c:pt>
                <c:pt idx="538">
                  <c:v>1.19128927951153E-2</c:v>
                </c:pt>
                <c:pt idx="539">
                  <c:v>0.47936427522007702</c:v>
                </c:pt>
                <c:pt idx="540">
                  <c:v>0.15193180335334799</c:v>
                </c:pt>
                <c:pt idx="541">
                  <c:v>9.0754980392419096E-2</c:v>
                </c:pt>
                <c:pt idx="542">
                  <c:v>7.7582002808696093E-2</c:v>
                </c:pt>
                <c:pt idx="543">
                  <c:v>0.10061789878487799</c:v>
                </c:pt>
                <c:pt idx="544">
                  <c:v>0.49194528244357999</c:v>
                </c:pt>
                <c:pt idx="545">
                  <c:v>1.3832329729270699E-3</c:v>
                </c:pt>
                <c:pt idx="546">
                  <c:v>0.485596795078445</c:v>
                </c:pt>
                <c:pt idx="547">
                  <c:v>0.44366653671455097</c:v>
                </c:pt>
                <c:pt idx="548">
                  <c:v>0.65854273284735099</c:v>
                </c:pt>
                <c:pt idx="549">
                  <c:v>0.42857487794772098</c:v>
                </c:pt>
                <c:pt idx="550">
                  <c:v>0.60454309847356902</c:v>
                </c:pt>
                <c:pt idx="551">
                  <c:v>1.0106440650633599</c:v>
                </c:pt>
                <c:pt idx="552">
                  <c:v>7.9212575313542102E-2</c:v>
                </c:pt>
                <c:pt idx="553">
                  <c:v>0.17652336557182799</c:v>
                </c:pt>
                <c:pt idx="554">
                  <c:v>0.17781990542950199</c:v>
                </c:pt>
                <c:pt idx="555">
                  <c:v>0.45656965925453302</c:v>
                </c:pt>
                <c:pt idx="556">
                  <c:v>0.298230087121509</c:v>
                </c:pt>
                <c:pt idx="557">
                  <c:v>0.14559241549664201</c:v>
                </c:pt>
                <c:pt idx="558">
                  <c:v>6.3604763490355903E-2</c:v>
                </c:pt>
                <c:pt idx="559">
                  <c:v>0.40476366788600998</c:v>
                </c:pt>
                <c:pt idx="560">
                  <c:v>7.8267009977431301E-2</c:v>
                </c:pt>
                <c:pt idx="561">
                  <c:v>9.0577278590941696E-2</c:v>
                </c:pt>
                <c:pt idx="562">
                  <c:v>7.4800293649267102E-2</c:v>
                </c:pt>
                <c:pt idx="563">
                  <c:v>0.92347534191504199</c:v>
                </c:pt>
                <c:pt idx="564">
                  <c:v>0.899397246552469</c:v>
                </c:pt>
                <c:pt idx="565">
                  <c:v>0.56463104035632095</c:v>
                </c:pt>
                <c:pt idx="566">
                  <c:v>0.28084303344253098</c:v>
                </c:pt>
                <c:pt idx="567">
                  <c:v>0.77273755702869995</c:v>
                </c:pt>
                <c:pt idx="568">
                  <c:v>0.639974542843887</c:v>
                </c:pt>
                <c:pt idx="569">
                  <c:v>0.93148843541005999</c:v>
                </c:pt>
                <c:pt idx="570">
                  <c:v>0.77246842583465203</c:v>
                </c:pt>
                <c:pt idx="571">
                  <c:v>0.996752664098422</c:v>
                </c:pt>
                <c:pt idx="572">
                  <c:v>0.89787599544320496</c:v>
                </c:pt>
                <c:pt idx="573">
                  <c:v>1.15015073227497</c:v>
                </c:pt>
                <c:pt idx="574">
                  <c:v>0.84801058271372198</c:v>
                </c:pt>
                <c:pt idx="575">
                  <c:v>0.83745880324097899</c:v>
                </c:pt>
                <c:pt idx="576">
                  <c:v>0.63339910672727395</c:v>
                </c:pt>
                <c:pt idx="577">
                  <c:v>0.89119222749218396</c:v>
                </c:pt>
                <c:pt idx="578">
                  <c:v>0.67334479275394699</c:v>
                </c:pt>
                <c:pt idx="579">
                  <c:v>7.7292745070443605E-2</c:v>
                </c:pt>
                <c:pt idx="580">
                  <c:v>0.67118063390680005</c:v>
                </c:pt>
                <c:pt idx="581">
                  <c:v>1.39838873289587</c:v>
                </c:pt>
                <c:pt idx="582">
                  <c:v>0.73584806361887201</c:v>
                </c:pt>
                <c:pt idx="583">
                  <c:v>0.65723765845108695</c:v>
                </c:pt>
                <c:pt idx="584">
                  <c:v>0.53530367096811005</c:v>
                </c:pt>
                <c:pt idx="585">
                  <c:v>0.49327767763869002</c:v>
                </c:pt>
                <c:pt idx="586">
                  <c:v>0.77234646330887502</c:v>
                </c:pt>
                <c:pt idx="587">
                  <c:v>0.46529720766678301</c:v>
                </c:pt>
                <c:pt idx="588">
                  <c:v>1.6809278684806901</c:v>
                </c:pt>
                <c:pt idx="589">
                  <c:v>1.30036519865083</c:v>
                </c:pt>
                <c:pt idx="590">
                  <c:v>0.73387548900449295</c:v>
                </c:pt>
                <c:pt idx="591">
                  <c:v>0.76944972045965299</c:v>
                </c:pt>
                <c:pt idx="592">
                  <c:v>0.16755882918875201</c:v>
                </c:pt>
                <c:pt idx="593">
                  <c:v>1.0003646249587701</c:v>
                </c:pt>
                <c:pt idx="594">
                  <c:v>1.86249780057819</c:v>
                </c:pt>
                <c:pt idx="595">
                  <c:v>0.55317467737536896</c:v>
                </c:pt>
                <c:pt idx="596">
                  <c:v>1.1961443019497799</c:v>
                </c:pt>
                <c:pt idx="597">
                  <c:v>0.94241005975269998</c:v>
                </c:pt>
                <c:pt idx="598">
                  <c:v>0.76292979414353301</c:v>
                </c:pt>
                <c:pt idx="599">
                  <c:v>0.42489624477211602</c:v>
                </c:pt>
                <c:pt idx="600">
                  <c:v>7.6303513581072804E-2</c:v>
                </c:pt>
                <c:pt idx="601">
                  <c:v>0.665401232101133</c:v>
                </c:pt>
                <c:pt idx="602">
                  <c:v>0.71860014084592405</c:v>
                </c:pt>
                <c:pt idx="603">
                  <c:v>0.86137840348097305</c:v>
                </c:pt>
                <c:pt idx="604">
                  <c:v>1.21670895273485</c:v>
                </c:pt>
                <c:pt idx="605">
                  <c:v>0.63366976854121504</c:v>
                </c:pt>
                <c:pt idx="606">
                  <c:v>0.69319810041915297</c:v>
                </c:pt>
                <c:pt idx="607">
                  <c:v>0.862678134738323</c:v>
                </c:pt>
                <c:pt idx="608">
                  <c:v>0.86561206091526499</c:v>
                </c:pt>
                <c:pt idx="609">
                  <c:v>0.67776850178582804</c:v>
                </c:pt>
                <c:pt idx="610">
                  <c:v>0.57980405780441602</c:v>
                </c:pt>
                <c:pt idx="611">
                  <c:v>0.61744147892644896</c:v>
                </c:pt>
                <c:pt idx="612">
                  <c:v>0.64426274637327896</c:v>
                </c:pt>
                <c:pt idx="613">
                  <c:v>0.67382778750374095</c:v>
                </c:pt>
                <c:pt idx="614">
                  <c:v>0.48257640981933297</c:v>
                </c:pt>
                <c:pt idx="615">
                  <c:v>0.78003036184415098</c:v>
                </c:pt>
                <c:pt idx="616">
                  <c:v>0.83993968428059995</c:v>
                </c:pt>
                <c:pt idx="617">
                  <c:v>0.39217157565185301</c:v>
                </c:pt>
                <c:pt idx="618">
                  <c:v>0.368560965326097</c:v>
                </c:pt>
                <c:pt idx="619">
                  <c:v>0.85203479137607996</c:v>
                </c:pt>
                <c:pt idx="620">
                  <c:v>0.76123156304836304</c:v>
                </c:pt>
                <c:pt idx="621">
                  <c:v>1.2891352570694401</c:v>
                </c:pt>
                <c:pt idx="622">
                  <c:v>1.0949997655680599</c:v>
                </c:pt>
                <c:pt idx="623">
                  <c:v>0.86645423918726205</c:v>
                </c:pt>
                <c:pt idx="624">
                  <c:v>0.77677184948857603</c:v>
                </c:pt>
                <c:pt idx="625">
                  <c:v>0.58437178217069097</c:v>
                </c:pt>
                <c:pt idx="626">
                  <c:v>0.57040313062804604</c:v>
                </c:pt>
                <c:pt idx="627">
                  <c:v>0.80358334822899002</c:v>
                </c:pt>
                <c:pt idx="628">
                  <c:v>0.75838335222134701</c:v>
                </c:pt>
                <c:pt idx="629">
                  <c:v>0.731453483158372</c:v>
                </c:pt>
                <c:pt idx="630">
                  <c:v>0.218589698272771</c:v>
                </c:pt>
                <c:pt idx="631">
                  <c:v>0.65948884446978095</c:v>
                </c:pt>
                <c:pt idx="632">
                  <c:v>0.81648295067618104</c:v>
                </c:pt>
                <c:pt idx="633">
                  <c:v>0.73790056772145596</c:v>
                </c:pt>
                <c:pt idx="634">
                  <c:v>0.58578313946691296</c:v>
                </c:pt>
                <c:pt idx="635">
                  <c:v>0.85435833926174698</c:v>
                </c:pt>
                <c:pt idx="636">
                  <c:v>0.109187371105949</c:v>
                </c:pt>
                <c:pt idx="637">
                  <c:v>0.94228712444489104</c:v>
                </c:pt>
                <c:pt idx="638">
                  <c:v>0.71202935023556901</c:v>
                </c:pt>
                <c:pt idx="639">
                  <c:v>0.89471580414584595</c:v>
                </c:pt>
                <c:pt idx="640">
                  <c:v>0.65816937375312401</c:v>
                </c:pt>
                <c:pt idx="641">
                  <c:v>0.65412246334598101</c:v>
                </c:pt>
                <c:pt idx="642">
                  <c:v>0.51982783974524305</c:v>
                </c:pt>
                <c:pt idx="643">
                  <c:v>0.51226845277417499</c:v>
                </c:pt>
                <c:pt idx="644">
                  <c:v>0.51867759886750398</c:v>
                </c:pt>
                <c:pt idx="645">
                  <c:v>0.597685368785006</c:v>
                </c:pt>
                <c:pt idx="646">
                  <c:v>0.77256676792660695</c:v>
                </c:pt>
                <c:pt idx="647">
                  <c:v>0.91875517911916404</c:v>
                </c:pt>
                <c:pt idx="648">
                  <c:v>0.93148276973633604</c:v>
                </c:pt>
                <c:pt idx="649">
                  <c:v>0.81450792830525498</c:v>
                </c:pt>
                <c:pt idx="650">
                  <c:v>0.951521430241557</c:v>
                </c:pt>
                <c:pt idx="651">
                  <c:v>0.97252850908022004</c:v>
                </c:pt>
                <c:pt idx="652">
                  <c:v>1.01430223855029</c:v>
                </c:pt>
                <c:pt idx="653">
                  <c:v>1.37770081359467</c:v>
                </c:pt>
                <c:pt idx="654">
                  <c:v>0.84122277572085902</c:v>
                </c:pt>
                <c:pt idx="655">
                  <c:v>1.60831558433797</c:v>
                </c:pt>
                <c:pt idx="656">
                  <c:v>0.97647726969645299</c:v>
                </c:pt>
                <c:pt idx="657">
                  <c:v>0.86801394233229501</c:v>
                </c:pt>
                <c:pt idx="658">
                  <c:v>0.65266482967283002</c:v>
                </c:pt>
                <c:pt idx="659">
                  <c:v>1.29525225563074</c:v>
                </c:pt>
                <c:pt idx="660">
                  <c:v>0.56140540032179598</c:v>
                </c:pt>
                <c:pt idx="661">
                  <c:v>0.46615346623491699</c:v>
                </c:pt>
                <c:pt idx="662">
                  <c:v>0.371368938658934</c:v>
                </c:pt>
                <c:pt idx="663">
                  <c:v>0.51273564787388803</c:v>
                </c:pt>
                <c:pt idx="664">
                  <c:v>0.91296786843372402</c:v>
                </c:pt>
                <c:pt idx="665">
                  <c:v>0.67072132168672405</c:v>
                </c:pt>
                <c:pt idx="666">
                  <c:v>0.70132689251974101</c:v>
                </c:pt>
                <c:pt idx="667">
                  <c:v>0.91203105305508803</c:v>
                </c:pt>
                <c:pt idx="668">
                  <c:v>0.67544136691902001</c:v>
                </c:pt>
                <c:pt idx="669">
                  <c:v>0.88888048150332599</c:v>
                </c:pt>
                <c:pt idx="670">
                  <c:v>0.31445402956156399</c:v>
                </c:pt>
                <c:pt idx="671">
                  <c:v>0.73377433937425696</c:v>
                </c:pt>
                <c:pt idx="672">
                  <c:v>0.89251398521844105</c:v>
                </c:pt>
                <c:pt idx="673">
                  <c:v>1.1644344990311599</c:v>
                </c:pt>
                <c:pt idx="674">
                  <c:v>0.20133351950756201</c:v>
                </c:pt>
                <c:pt idx="675">
                  <c:v>0.26277451654393302</c:v>
                </c:pt>
                <c:pt idx="676">
                  <c:v>1.07997355853157</c:v>
                </c:pt>
                <c:pt idx="677">
                  <c:v>0.70684179908491396</c:v>
                </c:pt>
                <c:pt idx="678">
                  <c:v>0.387948700599208</c:v>
                </c:pt>
                <c:pt idx="679">
                  <c:v>0.49604937768170398</c:v>
                </c:pt>
                <c:pt idx="680">
                  <c:v>0.56993898393051401</c:v>
                </c:pt>
                <c:pt idx="681">
                  <c:v>0.14878171966498799</c:v>
                </c:pt>
                <c:pt idx="682">
                  <c:v>1.06666362065582</c:v>
                </c:pt>
                <c:pt idx="683">
                  <c:v>0.72190638874542801</c:v>
                </c:pt>
                <c:pt idx="684">
                  <c:v>0.75079106016911601</c:v>
                </c:pt>
                <c:pt idx="685">
                  <c:v>0.84898943023136098</c:v>
                </c:pt>
                <c:pt idx="686">
                  <c:v>0.64430280554746999</c:v>
                </c:pt>
                <c:pt idx="687">
                  <c:v>1.1093174496431999</c:v>
                </c:pt>
                <c:pt idx="688">
                  <c:v>0.47772375256256899</c:v>
                </c:pt>
                <c:pt idx="689">
                  <c:v>0.43855201128499399</c:v>
                </c:pt>
                <c:pt idx="690">
                  <c:v>0.57031684419469697</c:v>
                </c:pt>
                <c:pt idx="691">
                  <c:v>0.37202084541062502</c:v>
                </c:pt>
                <c:pt idx="692">
                  <c:v>0.246903031513034</c:v>
                </c:pt>
                <c:pt idx="693">
                  <c:v>0.67664146146371096</c:v>
                </c:pt>
                <c:pt idx="694">
                  <c:v>0.536492339637064</c:v>
                </c:pt>
                <c:pt idx="695">
                  <c:v>0.47145614217916099</c:v>
                </c:pt>
                <c:pt idx="696">
                  <c:v>0.90192416033425205</c:v>
                </c:pt>
                <c:pt idx="697">
                  <c:v>1.33515024107144</c:v>
                </c:pt>
                <c:pt idx="698">
                  <c:v>0.82029475022849296</c:v>
                </c:pt>
                <c:pt idx="699">
                  <c:v>1.15537413146853</c:v>
                </c:pt>
                <c:pt idx="700">
                  <c:v>1.85349415401096</c:v>
                </c:pt>
                <c:pt idx="701">
                  <c:v>0.71342640024753001</c:v>
                </c:pt>
                <c:pt idx="702">
                  <c:v>6.9767147245192399E-3</c:v>
                </c:pt>
                <c:pt idx="703">
                  <c:v>0.55002119649366399</c:v>
                </c:pt>
                <c:pt idx="704">
                  <c:v>0.76793774663946301</c:v>
                </c:pt>
                <c:pt idx="705">
                  <c:v>0.840843095107487</c:v>
                </c:pt>
                <c:pt idx="706">
                  <c:v>0.76238126889790503</c:v>
                </c:pt>
                <c:pt idx="707">
                  <c:v>1.2168025778290701</c:v>
                </c:pt>
                <c:pt idx="708">
                  <c:v>0.36227055484389697</c:v>
                </c:pt>
                <c:pt idx="709">
                  <c:v>1.1843038865551601</c:v>
                </c:pt>
                <c:pt idx="710">
                  <c:v>0.258188912752911</c:v>
                </c:pt>
                <c:pt idx="711">
                  <c:v>0.75345830602314801</c:v>
                </c:pt>
                <c:pt idx="712">
                  <c:v>0.62216217690525899</c:v>
                </c:pt>
                <c:pt idx="713">
                  <c:v>1.0302911975062901</c:v>
                </c:pt>
                <c:pt idx="714">
                  <c:v>1.13684605822968</c:v>
                </c:pt>
                <c:pt idx="715">
                  <c:v>1.07899184398746</c:v>
                </c:pt>
                <c:pt idx="716">
                  <c:v>0.597895712605652</c:v>
                </c:pt>
                <c:pt idx="717">
                  <c:v>0.76118616920150906</c:v>
                </c:pt>
                <c:pt idx="718">
                  <c:v>0.65245287471322999</c:v>
                </c:pt>
                <c:pt idx="719">
                  <c:v>1.1544742844218501</c:v>
                </c:pt>
                <c:pt idx="720">
                  <c:v>1.10290060561857</c:v>
                </c:pt>
                <c:pt idx="721">
                  <c:v>0.910958032322288</c:v>
                </c:pt>
                <c:pt idx="722">
                  <c:v>0.748008286939152</c:v>
                </c:pt>
                <c:pt idx="723">
                  <c:v>0.57949060822950005</c:v>
                </c:pt>
                <c:pt idx="724">
                  <c:v>0.65638203160324804</c:v>
                </c:pt>
                <c:pt idx="725">
                  <c:v>0.84069884333744704</c:v>
                </c:pt>
                <c:pt idx="726">
                  <c:v>0.75066446646562501</c:v>
                </c:pt>
                <c:pt idx="727">
                  <c:v>0.54615013943484203</c:v>
                </c:pt>
                <c:pt idx="728">
                  <c:v>0.97638092325876302</c:v>
                </c:pt>
                <c:pt idx="729">
                  <c:v>0.87264330584725502</c:v>
                </c:pt>
                <c:pt idx="730">
                  <c:v>0.90013610325028903</c:v>
                </c:pt>
                <c:pt idx="731">
                  <c:v>0.76207962524224704</c:v>
                </c:pt>
                <c:pt idx="732">
                  <c:v>0.82520045346274995</c:v>
                </c:pt>
                <c:pt idx="733">
                  <c:v>0.60070004659438003</c:v>
                </c:pt>
                <c:pt idx="734">
                  <c:v>0.34034772049436401</c:v>
                </c:pt>
                <c:pt idx="735">
                  <c:v>0.64326398307846799</c:v>
                </c:pt>
                <c:pt idx="736">
                  <c:v>0.38359999851263499</c:v>
                </c:pt>
                <c:pt idx="737">
                  <c:v>0.580620578460044</c:v>
                </c:pt>
                <c:pt idx="738">
                  <c:v>0.59253604707928598</c:v>
                </c:pt>
                <c:pt idx="739">
                  <c:v>0.210734770392833</c:v>
                </c:pt>
                <c:pt idx="740">
                  <c:v>0.402031843057639</c:v>
                </c:pt>
                <c:pt idx="741">
                  <c:v>0.25701828435968899</c:v>
                </c:pt>
                <c:pt idx="742">
                  <c:v>0.193808896465226</c:v>
                </c:pt>
                <c:pt idx="743">
                  <c:v>0.45237322110886602</c:v>
                </c:pt>
                <c:pt idx="744">
                  <c:v>0.39258221871759602</c:v>
                </c:pt>
                <c:pt idx="745">
                  <c:v>0.60716718999433195</c:v>
                </c:pt>
                <c:pt idx="746">
                  <c:v>0.46286503556102399</c:v>
                </c:pt>
                <c:pt idx="747">
                  <c:v>0.63982218097602095</c:v>
                </c:pt>
                <c:pt idx="748">
                  <c:v>0.52341911117175099</c:v>
                </c:pt>
                <c:pt idx="749">
                  <c:v>0.57091041396273001</c:v>
                </c:pt>
                <c:pt idx="750">
                  <c:v>0.20633056667814201</c:v>
                </c:pt>
                <c:pt idx="751">
                  <c:v>0.68923796865300901</c:v>
                </c:pt>
                <c:pt idx="752">
                  <c:v>0.54032254676938596</c:v>
                </c:pt>
                <c:pt idx="753">
                  <c:v>0.53832417531655397</c:v>
                </c:pt>
                <c:pt idx="754">
                  <c:v>0.28629411408581001</c:v>
                </c:pt>
                <c:pt idx="755">
                  <c:v>0.35058104000767798</c:v>
                </c:pt>
                <c:pt idx="756">
                  <c:v>0.25843329415810501</c:v>
                </c:pt>
                <c:pt idx="757">
                  <c:v>6.2798995279460201E-2</c:v>
                </c:pt>
                <c:pt idx="758">
                  <c:v>0.59404757627839999</c:v>
                </c:pt>
                <c:pt idx="759">
                  <c:v>0.34741329876562199</c:v>
                </c:pt>
                <c:pt idx="760">
                  <c:v>0.65917026503284804</c:v>
                </c:pt>
                <c:pt idx="761">
                  <c:v>0.54923006421000298</c:v>
                </c:pt>
                <c:pt idx="762">
                  <c:v>0.71712956752223</c:v>
                </c:pt>
                <c:pt idx="763">
                  <c:v>0.64831528551960504</c:v>
                </c:pt>
                <c:pt idx="764">
                  <c:v>0.79699573434697701</c:v>
                </c:pt>
                <c:pt idx="765">
                  <c:v>0.73249126483717397</c:v>
                </c:pt>
                <c:pt idx="766">
                  <c:v>0.92507667384697201</c:v>
                </c:pt>
                <c:pt idx="767">
                  <c:v>1.0615546661239399</c:v>
                </c:pt>
                <c:pt idx="768">
                  <c:v>0.79547794443688502</c:v>
                </c:pt>
                <c:pt idx="769">
                  <c:v>0.52554164272445003</c:v>
                </c:pt>
                <c:pt idx="770">
                  <c:v>0.73930552419861195</c:v>
                </c:pt>
                <c:pt idx="771">
                  <c:v>0.55878213989123904</c:v>
                </c:pt>
                <c:pt idx="772">
                  <c:v>0.34746581056023701</c:v>
                </c:pt>
                <c:pt idx="773">
                  <c:v>0.77111416918687803</c:v>
                </c:pt>
                <c:pt idx="774">
                  <c:v>0.37230450733436399</c:v>
                </c:pt>
                <c:pt idx="775">
                  <c:v>0.27654953898531098</c:v>
                </c:pt>
                <c:pt idx="776">
                  <c:v>0.58248548296713598</c:v>
                </c:pt>
                <c:pt idx="777">
                  <c:v>0.65979914605371603</c:v>
                </c:pt>
                <c:pt idx="778">
                  <c:v>4.1678723539229599E-2</c:v>
                </c:pt>
                <c:pt idx="779">
                  <c:v>0.78994838536316603</c:v>
                </c:pt>
                <c:pt idx="780">
                  <c:v>0.29604823831052302</c:v>
                </c:pt>
                <c:pt idx="781">
                  <c:v>0.148924435139869</c:v>
                </c:pt>
                <c:pt idx="782">
                  <c:v>0.44923729981218202</c:v>
                </c:pt>
                <c:pt idx="783">
                  <c:v>1.2442429994253601</c:v>
                </c:pt>
                <c:pt idx="784">
                  <c:v>1.07102648685791</c:v>
                </c:pt>
                <c:pt idx="785">
                  <c:v>0.63193599048129401</c:v>
                </c:pt>
                <c:pt idx="786">
                  <c:v>1.2058672279104199</c:v>
                </c:pt>
                <c:pt idx="787">
                  <c:v>0.88812085590961598</c:v>
                </c:pt>
                <c:pt idx="788">
                  <c:v>0.72517145851430798</c:v>
                </c:pt>
                <c:pt idx="789">
                  <c:v>0.72452748509074605</c:v>
                </c:pt>
                <c:pt idx="790">
                  <c:v>0.947184771998552</c:v>
                </c:pt>
                <c:pt idx="791">
                  <c:v>0.57815664523940202</c:v>
                </c:pt>
                <c:pt idx="792">
                  <c:v>0.26155482856370199</c:v>
                </c:pt>
                <c:pt idx="793">
                  <c:v>0.92864308252400296</c:v>
                </c:pt>
                <c:pt idx="794">
                  <c:v>0.537609200334913</c:v>
                </c:pt>
                <c:pt idx="795">
                  <c:v>0.378026967072353</c:v>
                </c:pt>
                <c:pt idx="796">
                  <c:v>0.68357639217565502</c:v>
                </c:pt>
                <c:pt idx="797">
                  <c:v>1.0297664620145199</c:v>
                </c:pt>
                <c:pt idx="798">
                  <c:v>0.48226342014816298</c:v>
                </c:pt>
                <c:pt idx="799">
                  <c:v>0.517932633937491</c:v>
                </c:pt>
                <c:pt idx="800">
                  <c:v>0.157491519952206</c:v>
                </c:pt>
                <c:pt idx="801">
                  <c:v>0.75236187524647502</c:v>
                </c:pt>
                <c:pt idx="802">
                  <c:v>0.52969441584704702</c:v>
                </c:pt>
                <c:pt idx="803">
                  <c:v>0.55975970046874401</c:v>
                </c:pt>
                <c:pt idx="804">
                  <c:v>1.1864686430629801</c:v>
                </c:pt>
                <c:pt idx="805">
                  <c:v>0.79613482921734702</c:v>
                </c:pt>
                <c:pt idx="806">
                  <c:v>0.64430297105480006</c:v>
                </c:pt>
                <c:pt idx="807">
                  <c:v>0.55226465048637896</c:v>
                </c:pt>
                <c:pt idx="808">
                  <c:v>0.95365827147448901</c:v>
                </c:pt>
                <c:pt idx="809">
                  <c:v>0.63607627779423703</c:v>
                </c:pt>
                <c:pt idx="810">
                  <c:v>1.30013606148692</c:v>
                </c:pt>
                <c:pt idx="811">
                  <c:v>0.93019541300577901</c:v>
                </c:pt>
                <c:pt idx="812">
                  <c:v>0.32882508151790002</c:v>
                </c:pt>
                <c:pt idx="813">
                  <c:v>0.16477504810190299</c:v>
                </c:pt>
                <c:pt idx="814">
                  <c:v>0.52829970852920705</c:v>
                </c:pt>
                <c:pt idx="815">
                  <c:v>0.43025669562434699</c:v>
                </c:pt>
                <c:pt idx="816">
                  <c:v>0.34386487410913502</c:v>
                </c:pt>
                <c:pt idx="817">
                  <c:v>0.51327975861726005</c:v>
                </c:pt>
                <c:pt idx="818">
                  <c:v>1.1614073300490699</c:v>
                </c:pt>
                <c:pt idx="819">
                  <c:v>1.4346891730175499</c:v>
                </c:pt>
                <c:pt idx="820">
                  <c:v>1.11465431522022</c:v>
                </c:pt>
                <c:pt idx="821">
                  <c:v>0.97415527066304897</c:v>
                </c:pt>
                <c:pt idx="822">
                  <c:v>0.20957126199772899</c:v>
                </c:pt>
                <c:pt idx="823">
                  <c:v>0.38246388977692602</c:v>
                </c:pt>
                <c:pt idx="824">
                  <c:v>1.5016890256403499</c:v>
                </c:pt>
                <c:pt idx="825">
                  <c:v>0.138126554546283</c:v>
                </c:pt>
                <c:pt idx="826">
                  <c:v>0.70677152684248001</c:v>
                </c:pt>
                <c:pt idx="827">
                  <c:v>1.5420974698510699E-2</c:v>
                </c:pt>
                <c:pt idx="828">
                  <c:v>1.6090872345840701</c:v>
                </c:pt>
                <c:pt idx="829">
                  <c:v>0.28795194522769701</c:v>
                </c:pt>
                <c:pt idx="830">
                  <c:v>0.86809950299771999</c:v>
                </c:pt>
                <c:pt idx="831">
                  <c:v>0.984684829680192</c:v>
                </c:pt>
                <c:pt idx="832">
                  <c:v>0.83950876251824602</c:v>
                </c:pt>
                <c:pt idx="833">
                  <c:v>0.462910403410839</c:v>
                </c:pt>
                <c:pt idx="834">
                  <c:v>0.100199171893637</c:v>
                </c:pt>
                <c:pt idx="835">
                  <c:v>0.93475978193239095</c:v>
                </c:pt>
                <c:pt idx="836">
                  <c:v>9.3043282631294397E-2</c:v>
                </c:pt>
                <c:pt idx="837">
                  <c:v>0.18235254825036601</c:v>
                </c:pt>
                <c:pt idx="838">
                  <c:v>0.67482214740681201</c:v>
                </c:pt>
                <c:pt idx="839">
                  <c:v>0.78130594360361105</c:v>
                </c:pt>
                <c:pt idx="840">
                  <c:v>0.83421908780447496</c:v>
                </c:pt>
                <c:pt idx="841">
                  <c:v>0.109170239799458</c:v>
                </c:pt>
                <c:pt idx="842">
                  <c:v>0.98477536425466194</c:v>
                </c:pt>
                <c:pt idx="843">
                  <c:v>6.9302046400476196E-3</c:v>
                </c:pt>
                <c:pt idx="844">
                  <c:v>0.58853302114589501</c:v>
                </c:pt>
                <c:pt idx="845">
                  <c:v>0.79925604106567605</c:v>
                </c:pt>
                <c:pt idx="846">
                  <c:v>0.99300974759675198</c:v>
                </c:pt>
                <c:pt idx="847">
                  <c:v>0.26680691438751097</c:v>
                </c:pt>
                <c:pt idx="848">
                  <c:v>0.132440937696536</c:v>
                </c:pt>
                <c:pt idx="849">
                  <c:v>0.62602339400274398</c:v>
                </c:pt>
                <c:pt idx="850">
                  <c:v>3.4083377921852601E-3</c:v>
                </c:pt>
                <c:pt idx="851">
                  <c:v>2.6005954813971902E-2</c:v>
                </c:pt>
                <c:pt idx="852">
                  <c:v>0.853741457301889</c:v>
                </c:pt>
                <c:pt idx="853">
                  <c:v>0.893178478169590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B57-4F98-B479-9C88ADAA6B21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(2)'!$D$2:$D$108</c:f>
              <c:numCache>
                <c:formatCode>General</c:formatCode>
                <c:ptCount val="107"/>
                <c:pt idx="0">
                  <c:v>-2.1831764165363801</c:v>
                </c:pt>
                <c:pt idx="1">
                  <c:v>-1.13853229982501</c:v>
                </c:pt>
                <c:pt idx="2">
                  <c:v>-0.85688727286606903</c:v>
                </c:pt>
                <c:pt idx="3">
                  <c:v>-0.74871250479291396</c:v>
                </c:pt>
                <c:pt idx="4">
                  <c:v>-4.4800103621325302</c:v>
                </c:pt>
                <c:pt idx="5">
                  <c:v>-0.64820098194952103</c:v>
                </c:pt>
                <c:pt idx="6">
                  <c:v>-0.682209487673203</c:v>
                </c:pt>
                <c:pt idx="7">
                  <c:v>-1.19912843993965</c:v>
                </c:pt>
                <c:pt idx="8">
                  <c:v>-1.35246975872228</c:v>
                </c:pt>
                <c:pt idx="9">
                  <c:v>-1.85377543995525</c:v>
                </c:pt>
                <c:pt idx="10">
                  <c:v>-0.75902244817571196</c:v>
                </c:pt>
                <c:pt idx="11">
                  <c:v>-1.19902560783069</c:v>
                </c:pt>
                <c:pt idx="12">
                  <c:v>-1.19912843993965</c:v>
                </c:pt>
                <c:pt idx="13">
                  <c:v>-0.66951897062243404</c:v>
                </c:pt>
                <c:pt idx="14">
                  <c:v>-1.7617829791770201</c:v>
                </c:pt>
                <c:pt idx="15">
                  <c:v>-4.9087445085790398</c:v>
                </c:pt>
                <c:pt idx="16">
                  <c:v>-5.0782577392187296</c:v>
                </c:pt>
                <c:pt idx="17">
                  <c:v>-4.9087445085790398</c:v>
                </c:pt>
                <c:pt idx="18">
                  <c:v>-4.9087445085790398</c:v>
                </c:pt>
                <c:pt idx="19">
                  <c:v>-1.0503800388194799</c:v>
                </c:pt>
                <c:pt idx="20">
                  <c:v>-1.0503800388194799</c:v>
                </c:pt>
                <c:pt idx="21">
                  <c:v>-4.4145070511801796</c:v>
                </c:pt>
                <c:pt idx="22">
                  <c:v>-3.2807245368359101</c:v>
                </c:pt>
                <c:pt idx="23">
                  <c:v>-3.1520001308831902</c:v>
                </c:pt>
                <c:pt idx="24">
                  <c:v>-4.5047047659562498</c:v>
                </c:pt>
                <c:pt idx="25">
                  <c:v>-0.66951897062243404</c:v>
                </c:pt>
                <c:pt idx="26">
                  <c:v>-0.64144096239418802</c:v>
                </c:pt>
                <c:pt idx="27">
                  <c:v>-0.87810176675760898</c:v>
                </c:pt>
                <c:pt idx="28">
                  <c:v>-1.18565882862592</c:v>
                </c:pt>
                <c:pt idx="29">
                  <c:v>-0.75902244817571196</c:v>
                </c:pt>
                <c:pt idx="30">
                  <c:v>-1.6799232875176999</c:v>
                </c:pt>
                <c:pt idx="31">
                  <c:v>-1.40874022626079</c:v>
                </c:pt>
                <c:pt idx="32">
                  <c:v>-0.67106306249756598</c:v>
                </c:pt>
                <c:pt idx="33">
                  <c:v>-0.952100938329841</c:v>
                </c:pt>
                <c:pt idx="34">
                  <c:v>-0.69596815015237801</c:v>
                </c:pt>
                <c:pt idx="35">
                  <c:v>-1.05251647782725</c:v>
                </c:pt>
                <c:pt idx="36">
                  <c:v>-0.87300060621154896</c:v>
                </c:pt>
                <c:pt idx="37">
                  <c:v>-0.73483447543407898</c:v>
                </c:pt>
                <c:pt idx="38">
                  <c:v>-0.62070584395929096</c:v>
                </c:pt>
                <c:pt idx="39">
                  <c:v>-0.99136496274543995</c:v>
                </c:pt>
                <c:pt idx="40">
                  <c:v>-0.76495189504306704</c:v>
                </c:pt>
                <c:pt idx="41">
                  <c:v>-5.4493341684886296</c:v>
                </c:pt>
                <c:pt idx="42">
                  <c:v>-0.86531017269917698</c:v>
                </c:pt>
                <c:pt idx="43">
                  <c:v>-0.63694724238787903</c:v>
                </c:pt>
                <c:pt idx="44">
                  <c:v>-0.86531017269917698</c:v>
                </c:pt>
                <c:pt idx="45">
                  <c:v>-0.92201869378894896</c:v>
                </c:pt>
                <c:pt idx="46">
                  <c:v>-0.92201869378894896</c:v>
                </c:pt>
                <c:pt idx="47">
                  <c:v>-0.91299655397424195</c:v>
                </c:pt>
                <c:pt idx="48">
                  <c:v>-0.69369311706026404</c:v>
                </c:pt>
                <c:pt idx="49">
                  <c:v>-0.69369311706026404</c:v>
                </c:pt>
                <c:pt idx="50">
                  <c:v>-0.71811879009737001</c:v>
                </c:pt>
                <c:pt idx="51">
                  <c:v>-0.66099065726859696</c:v>
                </c:pt>
                <c:pt idx="52">
                  <c:v>-0.71130391818379102</c:v>
                </c:pt>
                <c:pt idx="53">
                  <c:v>-0.71130391818379102</c:v>
                </c:pt>
                <c:pt idx="54">
                  <c:v>-1.7170310368409201</c:v>
                </c:pt>
                <c:pt idx="55">
                  <c:v>-1.44420571398382</c:v>
                </c:pt>
                <c:pt idx="56">
                  <c:v>-1.9016451532182601</c:v>
                </c:pt>
                <c:pt idx="57">
                  <c:v>-4.6968160880383598</c:v>
                </c:pt>
                <c:pt idx="58">
                  <c:v>-4.7292076630918896</c:v>
                </c:pt>
                <c:pt idx="59">
                  <c:v>-4.5162312724974596</c:v>
                </c:pt>
                <c:pt idx="60">
                  <c:v>-0.62795342394601705</c:v>
                </c:pt>
                <c:pt idx="61">
                  <c:v>-2.8659558284608302</c:v>
                </c:pt>
                <c:pt idx="62">
                  <c:v>-0.72855161046111305</c:v>
                </c:pt>
                <c:pt idx="63">
                  <c:v>-0.763060643692553</c:v>
                </c:pt>
                <c:pt idx="64">
                  <c:v>-0.67714043297812399</c:v>
                </c:pt>
                <c:pt idx="65">
                  <c:v>-0.68499535934357203</c:v>
                </c:pt>
                <c:pt idx="66">
                  <c:v>-1.25854329765275</c:v>
                </c:pt>
                <c:pt idx="67">
                  <c:v>-1.31332542101837</c:v>
                </c:pt>
                <c:pt idx="68">
                  <c:v>-0.93738879265401098</c:v>
                </c:pt>
                <c:pt idx="69">
                  <c:v>-1.2783942403822699</c:v>
                </c:pt>
                <c:pt idx="70">
                  <c:v>-0.63894031221754699</c:v>
                </c:pt>
                <c:pt idx="71">
                  <c:v>-1.0801125111754399</c:v>
                </c:pt>
                <c:pt idx="72">
                  <c:v>-1.2436122079541101</c:v>
                </c:pt>
                <c:pt idx="73">
                  <c:v>-0.82351698940386298</c:v>
                </c:pt>
                <c:pt idx="74">
                  <c:v>-1.2282767435711801</c:v>
                </c:pt>
                <c:pt idx="75">
                  <c:v>-1.25013995611107</c:v>
                </c:pt>
                <c:pt idx="76">
                  <c:v>-1.62306396967802</c:v>
                </c:pt>
                <c:pt idx="77">
                  <c:v>-1.1358627949264899</c:v>
                </c:pt>
                <c:pt idx="78">
                  <c:v>-0.64984393291222298</c:v>
                </c:pt>
                <c:pt idx="79">
                  <c:v>-0.62459371143515596</c:v>
                </c:pt>
                <c:pt idx="80">
                  <c:v>-0.68833423344268096</c:v>
                </c:pt>
                <c:pt idx="81">
                  <c:v>-0.80540090169460499</c:v>
                </c:pt>
                <c:pt idx="82">
                  <c:v>-3.5156811876737102</c:v>
                </c:pt>
                <c:pt idx="83">
                  <c:v>-3.8121559083214298</c:v>
                </c:pt>
                <c:pt idx="84">
                  <c:v>-0.69493472640923604</c:v>
                </c:pt>
                <c:pt idx="85">
                  <c:v>-0.75846355837868196</c:v>
                </c:pt>
                <c:pt idx="86">
                  <c:v>-0.91436621226148196</c:v>
                </c:pt>
                <c:pt idx="87">
                  <c:v>-0.92571398271743599</c:v>
                </c:pt>
                <c:pt idx="88">
                  <c:v>-0.62297332214675705</c:v>
                </c:pt>
                <c:pt idx="89">
                  <c:v>-0.62875084305937201</c:v>
                </c:pt>
                <c:pt idx="90">
                  <c:v>-0.60287639300601703</c:v>
                </c:pt>
                <c:pt idx="91">
                  <c:v>-7.7977815953508003</c:v>
                </c:pt>
                <c:pt idx="92">
                  <c:v>-1.61807214694233</c:v>
                </c:pt>
                <c:pt idx="93">
                  <c:v>-0.73672310892441195</c:v>
                </c:pt>
                <c:pt idx="94">
                  <c:v>-0.96785157621666895</c:v>
                </c:pt>
                <c:pt idx="95">
                  <c:v>-0.85678186511212695</c:v>
                </c:pt>
                <c:pt idx="96">
                  <c:v>-8.6411419057050907</c:v>
                </c:pt>
                <c:pt idx="97">
                  <c:v>-0.69295297152295698</c:v>
                </c:pt>
                <c:pt idx="98">
                  <c:v>-4.6409464941988903</c:v>
                </c:pt>
                <c:pt idx="99">
                  <c:v>-0.82173051102727501</c:v>
                </c:pt>
                <c:pt idx="100">
                  <c:v>-0.61670128749582098</c:v>
                </c:pt>
                <c:pt idx="101">
                  <c:v>-0.62763842200398801</c:v>
                </c:pt>
                <c:pt idx="102">
                  <c:v>-4.7392280489486502</c:v>
                </c:pt>
                <c:pt idx="103">
                  <c:v>-6.9872113676148402</c:v>
                </c:pt>
                <c:pt idx="104">
                  <c:v>-1.0212962072113001</c:v>
                </c:pt>
                <c:pt idx="105">
                  <c:v>-1.1103964810743501</c:v>
                </c:pt>
                <c:pt idx="106">
                  <c:v>-1.1902388416458101</c:v>
                </c:pt>
              </c:numCache>
            </c:numRef>
          </c:xVal>
          <c:yVal>
            <c:numRef>
              <c:f>'HFD (2)'!$E$2:$E$108</c:f>
              <c:numCache>
                <c:formatCode>General</c:formatCode>
                <c:ptCount val="107"/>
                <c:pt idx="0">
                  <c:v>1.50680532853759</c:v>
                </c:pt>
                <c:pt idx="1">
                  <c:v>1.25278098687357</c:v>
                </c:pt>
                <c:pt idx="2">
                  <c:v>1.85318806848219</c:v>
                </c:pt>
                <c:pt idx="3">
                  <c:v>1.2781130954531501</c:v>
                </c:pt>
                <c:pt idx="4">
                  <c:v>1.5216059312846</c:v>
                </c:pt>
                <c:pt idx="5">
                  <c:v>1.21141595442063</c:v>
                </c:pt>
                <c:pt idx="6">
                  <c:v>1.3125797666544701</c:v>
                </c:pt>
                <c:pt idx="7">
                  <c:v>1.7208229116860001</c:v>
                </c:pt>
                <c:pt idx="8">
                  <c:v>2.04045682479649</c:v>
                </c:pt>
                <c:pt idx="9">
                  <c:v>1.5045058332093799</c:v>
                </c:pt>
                <c:pt idx="10">
                  <c:v>2.19387911053412</c:v>
                </c:pt>
                <c:pt idx="11">
                  <c:v>1.03708076610626</c:v>
                </c:pt>
                <c:pt idx="12">
                  <c:v>1.7208229116860001</c:v>
                </c:pt>
                <c:pt idx="13">
                  <c:v>1.61621797265821</c:v>
                </c:pt>
                <c:pt idx="14">
                  <c:v>2.13162568166622</c:v>
                </c:pt>
                <c:pt idx="15">
                  <c:v>1.2604832274961399</c:v>
                </c:pt>
                <c:pt idx="16">
                  <c:v>1.3474068269980399</c:v>
                </c:pt>
                <c:pt idx="17">
                  <c:v>1.2604832274961399</c:v>
                </c:pt>
                <c:pt idx="18">
                  <c:v>1.2604832274961399</c:v>
                </c:pt>
                <c:pt idx="19">
                  <c:v>1.3304073308909401</c:v>
                </c:pt>
                <c:pt idx="20">
                  <c:v>1.3304073308909401</c:v>
                </c:pt>
                <c:pt idx="21">
                  <c:v>1.5284112730014201</c:v>
                </c:pt>
                <c:pt idx="22">
                  <c:v>1.19965543239882</c:v>
                </c:pt>
                <c:pt idx="23">
                  <c:v>1.45001167495979</c:v>
                </c:pt>
                <c:pt idx="24">
                  <c:v>1.4835169866924101</c:v>
                </c:pt>
                <c:pt idx="25">
                  <c:v>1.61621797265821</c:v>
                </c:pt>
                <c:pt idx="26">
                  <c:v>1.0863970248836501</c:v>
                </c:pt>
                <c:pt idx="27">
                  <c:v>2.13764756294831</c:v>
                </c:pt>
                <c:pt idx="28">
                  <c:v>1.8602518032328701</c:v>
                </c:pt>
                <c:pt idx="29">
                  <c:v>2.19387911053412</c:v>
                </c:pt>
                <c:pt idx="30">
                  <c:v>1.46649595721278</c:v>
                </c:pt>
                <c:pt idx="31">
                  <c:v>2.14723806393721</c:v>
                </c:pt>
                <c:pt idx="32">
                  <c:v>1.65466503985809</c:v>
                </c:pt>
                <c:pt idx="33">
                  <c:v>1.2295925279784601</c:v>
                </c:pt>
                <c:pt idx="34">
                  <c:v>1.3984436980184201</c:v>
                </c:pt>
                <c:pt idx="35">
                  <c:v>1.9943753258207499</c:v>
                </c:pt>
                <c:pt idx="36">
                  <c:v>1.45865262269342</c:v>
                </c:pt>
                <c:pt idx="37">
                  <c:v>1.08289560149719</c:v>
                </c:pt>
                <c:pt idx="38">
                  <c:v>1.5071223613595399</c:v>
                </c:pt>
                <c:pt idx="39">
                  <c:v>1.4081850435902801</c:v>
                </c:pt>
                <c:pt idx="40">
                  <c:v>1.5313775957629401</c:v>
                </c:pt>
                <c:pt idx="41">
                  <c:v>1.35441476978744</c:v>
                </c:pt>
                <c:pt idx="42">
                  <c:v>1.61145124309814</c:v>
                </c:pt>
                <c:pt idx="43">
                  <c:v>1.4759181150205301</c:v>
                </c:pt>
                <c:pt idx="44">
                  <c:v>1.61145124309814</c:v>
                </c:pt>
                <c:pt idx="45">
                  <c:v>2.1116164996005899</c:v>
                </c:pt>
                <c:pt idx="46">
                  <c:v>2.1116164996005899</c:v>
                </c:pt>
                <c:pt idx="47">
                  <c:v>1.2131632881139101</c:v>
                </c:pt>
                <c:pt idx="48">
                  <c:v>1.24960774848407</c:v>
                </c:pt>
                <c:pt idx="49">
                  <c:v>1.24960774848407</c:v>
                </c:pt>
                <c:pt idx="50">
                  <c:v>1.2157650056232401</c:v>
                </c:pt>
                <c:pt idx="51">
                  <c:v>1.5030192188957601</c:v>
                </c:pt>
                <c:pt idx="52">
                  <c:v>1.2301972238880201</c:v>
                </c:pt>
                <c:pt idx="53">
                  <c:v>1.2301972238880201</c:v>
                </c:pt>
                <c:pt idx="54">
                  <c:v>1.62399024202848</c:v>
                </c:pt>
                <c:pt idx="55">
                  <c:v>1.64041524186081</c:v>
                </c:pt>
                <c:pt idx="56">
                  <c:v>1.50472548739753</c:v>
                </c:pt>
                <c:pt idx="57">
                  <c:v>1.53808281721176</c:v>
                </c:pt>
                <c:pt idx="58">
                  <c:v>1.3778953674608001</c:v>
                </c:pt>
                <c:pt idx="59">
                  <c:v>1.51980209940036</c:v>
                </c:pt>
                <c:pt idx="60">
                  <c:v>1.81668753145552</c:v>
                </c:pt>
                <c:pt idx="61">
                  <c:v>1.46857903483844</c:v>
                </c:pt>
                <c:pt idx="62">
                  <c:v>1.46298300163197</c:v>
                </c:pt>
                <c:pt idx="63">
                  <c:v>1.9124456825606699</c:v>
                </c:pt>
                <c:pt idx="64">
                  <c:v>1.65439634648113</c:v>
                </c:pt>
                <c:pt idx="65">
                  <c:v>1.7939094688417401</c:v>
                </c:pt>
                <c:pt idx="66">
                  <c:v>1.9693298248865101</c:v>
                </c:pt>
                <c:pt idx="67">
                  <c:v>2.0817983396226101</c:v>
                </c:pt>
                <c:pt idx="68">
                  <c:v>2.0629531910315402</c:v>
                </c:pt>
                <c:pt idx="69">
                  <c:v>1.95232448470033</c:v>
                </c:pt>
                <c:pt idx="70">
                  <c:v>1.18231449966265</c:v>
                </c:pt>
                <c:pt idx="71">
                  <c:v>1.99678494425733</c:v>
                </c:pt>
                <c:pt idx="72">
                  <c:v>1.8778450549404999</c:v>
                </c:pt>
                <c:pt idx="73">
                  <c:v>1.70621045364996</c:v>
                </c:pt>
                <c:pt idx="74">
                  <c:v>1.84225790641882</c:v>
                </c:pt>
                <c:pt idx="75">
                  <c:v>2.2161663335366901</c:v>
                </c:pt>
                <c:pt idx="76">
                  <c:v>1.5201637666775101</c:v>
                </c:pt>
                <c:pt idx="77">
                  <c:v>1.9018865473431801</c:v>
                </c:pt>
                <c:pt idx="78">
                  <c:v>1.3668230556313901</c:v>
                </c:pt>
                <c:pt idx="79">
                  <c:v>1.1742190509372601</c:v>
                </c:pt>
                <c:pt idx="80">
                  <c:v>1.9693918728261399</c:v>
                </c:pt>
                <c:pt idx="81">
                  <c:v>1.14115177679873</c:v>
                </c:pt>
                <c:pt idx="82">
                  <c:v>2.1192348506140202</c:v>
                </c:pt>
                <c:pt idx="83">
                  <c:v>1.5911262988103101</c:v>
                </c:pt>
                <c:pt idx="84">
                  <c:v>1.3144715672925</c:v>
                </c:pt>
                <c:pt idx="85">
                  <c:v>1.2285782099574201</c:v>
                </c:pt>
                <c:pt idx="86">
                  <c:v>1.1524119855716299</c:v>
                </c:pt>
                <c:pt idx="87">
                  <c:v>1.19962195848422</c:v>
                </c:pt>
                <c:pt idx="88">
                  <c:v>1.3953465383169701</c:v>
                </c:pt>
                <c:pt idx="89">
                  <c:v>1.56498502557863</c:v>
                </c:pt>
                <c:pt idx="90">
                  <c:v>1.0234208911982201</c:v>
                </c:pt>
                <c:pt idx="91">
                  <c:v>1.36734340792941</c:v>
                </c:pt>
                <c:pt idx="92">
                  <c:v>1.79159300822634</c:v>
                </c:pt>
                <c:pt idx="93">
                  <c:v>1.08082049532497</c:v>
                </c:pt>
                <c:pt idx="94">
                  <c:v>1.2834702097130399</c:v>
                </c:pt>
                <c:pt idx="95">
                  <c:v>1.4357651257633099</c:v>
                </c:pt>
                <c:pt idx="96">
                  <c:v>1.47543565382667</c:v>
                </c:pt>
                <c:pt idx="97">
                  <c:v>1.1223932780138</c:v>
                </c:pt>
                <c:pt idx="98">
                  <c:v>2.04802414903248</c:v>
                </c:pt>
                <c:pt idx="99">
                  <c:v>1.57279924064254</c:v>
                </c:pt>
                <c:pt idx="100">
                  <c:v>1.17931880422164</c:v>
                </c:pt>
                <c:pt idx="101">
                  <c:v>1.1561281260607299</c:v>
                </c:pt>
                <c:pt idx="102">
                  <c:v>1.2165492449750599</c:v>
                </c:pt>
                <c:pt idx="103">
                  <c:v>1.2165492449750599</c:v>
                </c:pt>
                <c:pt idx="104">
                  <c:v>1.9399678178643001</c:v>
                </c:pt>
                <c:pt idx="105">
                  <c:v>1.17076519253193</c:v>
                </c:pt>
                <c:pt idx="106">
                  <c:v>1.213278669847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B57-4F98-B479-9C88ADAA6B21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(2)'!$G$2:$G$117</c:f>
              <c:numCache>
                <c:formatCode>General</c:formatCode>
                <c:ptCount val="116"/>
                <c:pt idx="0">
                  <c:v>0.72185554369681404</c:v>
                </c:pt>
                <c:pt idx="1">
                  <c:v>0.61982318018691696</c:v>
                </c:pt>
                <c:pt idx="2">
                  <c:v>0.89626841703714799</c:v>
                </c:pt>
                <c:pt idx="3">
                  <c:v>3.7909925471272499</c:v>
                </c:pt>
                <c:pt idx="4">
                  <c:v>3.75386422209924</c:v>
                </c:pt>
                <c:pt idx="5">
                  <c:v>1.16551778579406</c:v>
                </c:pt>
                <c:pt idx="6">
                  <c:v>1.9405728521151699</c:v>
                </c:pt>
                <c:pt idx="7">
                  <c:v>1.5241095787894601</c:v>
                </c:pt>
                <c:pt idx="8">
                  <c:v>1.4567485907216</c:v>
                </c:pt>
                <c:pt idx="9">
                  <c:v>9.3395943586866998</c:v>
                </c:pt>
                <c:pt idx="10">
                  <c:v>13.743891599351199</c:v>
                </c:pt>
                <c:pt idx="11">
                  <c:v>1.3705124339961801</c:v>
                </c:pt>
                <c:pt idx="12">
                  <c:v>0.87039625736848603</c:v>
                </c:pt>
                <c:pt idx="13">
                  <c:v>0.69112134071456099</c:v>
                </c:pt>
                <c:pt idx="14">
                  <c:v>0.70502303608635697</c:v>
                </c:pt>
                <c:pt idx="15">
                  <c:v>0.60408234236430303</c:v>
                </c:pt>
                <c:pt idx="16">
                  <c:v>0.82186991795185405</c:v>
                </c:pt>
                <c:pt idx="17">
                  <c:v>4.3504972470841299</c:v>
                </c:pt>
                <c:pt idx="18">
                  <c:v>1.50189725553955</c:v>
                </c:pt>
                <c:pt idx="19">
                  <c:v>1.04125301399998</c:v>
                </c:pt>
                <c:pt idx="20">
                  <c:v>1.50189725553955</c:v>
                </c:pt>
                <c:pt idx="21">
                  <c:v>1.0903325170862299</c:v>
                </c:pt>
                <c:pt idx="22">
                  <c:v>3.00116859257417</c:v>
                </c:pt>
                <c:pt idx="23">
                  <c:v>1.6905347881850401</c:v>
                </c:pt>
                <c:pt idx="24">
                  <c:v>3.55095343878709</c:v>
                </c:pt>
                <c:pt idx="25">
                  <c:v>3.6297241252619799</c:v>
                </c:pt>
                <c:pt idx="26">
                  <c:v>1.50189725553955</c:v>
                </c:pt>
                <c:pt idx="27">
                  <c:v>0.64690635107977401</c:v>
                </c:pt>
                <c:pt idx="28">
                  <c:v>4.5375040412729701</c:v>
                </c:pt>
                <c:pt idx="29">
                  <c:v>0.74554753003732999</c:v>
                </c:pt>
                <c:pt idx="30">
                  <c:v>0.97034708858636398</c:v>
                </c:pt>
                <c:pt idx="31">
                  <c:v>2.6523176023228601</c:v>
                </c:pt>
                <c:pt idx="32">
                  <c:v>2.1780835611330001</c:v>
                </c:pt>
                <c:pt idx="33">
                  <c:v>0.87266541887967597</c:v>
                </c:pt>
                <c:pt idx="34">
                  <c:v>1.5388116479465399</c:v>
                </c:pt>
                <c:pt idx="35">
                  <c:v>10.3467640510897</c:v>
                </c:pt>
                <c:pt idx="36">
                  <c:v>0.97592500217400602</c:v>
                </c:pt>
                <c:pt idx="37">
                  <c:v>1.56385073545826</c:v>
                </c:pt>
                <c:pt idx="38">
                  <c:v>11.564819895519699</c:v>
                </c:pt>
                <c:pt idx="39">
                  <c:v>1.70788735829172</c:v>
                </c:pt>
                <c:pt idx="40">
                  <c:v>3.6297241252619799</c:v>
                </c:pt>
                <c:pt idx="41">
                  <c:v>3.3760936888146502</c:v>
                </c:pt>
                <c:pt idx="42">
                  <c:v>3.2755062354771902</c:v>
                </c:pt>
                <c:pt idx="43">
                  <c:v>3.5438994317218202</c:v>
                </c:pt>
                <c:pt idx="44">
                  <c:v>0.62323431329192103</c:v>
                </c:pt>
                <c:pt idx="45">
                  <c:v>3.5438994317218202</c:v>
                </c:pt>
                <c:pt idx="46">
                  <c:v>3.5262949633619498</c:v>
                </c:pt>
                <c:pt idx="47">
                  <c:v>0.62207198574232203</c:v>
                </c:pt>
                <c:pt idx="48">
                  <c:v>0.75831208990681898</c:v>
                </c:pt>
                <c:pt idx="49">
                  <c:v>0.77011054324594996</c:v>
                </c:pt>
                <c:pt idx="50">
                  <c:v>0.88665296194784204</c:v>
                </c:pt>
                <c:pt idx="51">
                  <c:v>0.85268821006462303</c:v>
                </c:pt>
                <c:pt idx="52">
                  <c:v>1.3698966195373501</c:v>
                </c:pt>
                <c:pt idx="53">
                  <c:v>1.9275911512530901</c:v>
                </c:pt>
                <c:pt idx="54">
                  <c:v>0.93813276870380502</c:v>
                </c:pt>
                <c:pt idx="55">
                  <c:v>4.1640658202203502</c:v>
                </c:pt>
                <c:pt idx="56">
                  <c:v>1.07489415837062</c:v>
                </c:pt>
                <c:pt idx="57">
                  <c:v>2.4614890562545901</c:v>
                </c:pt>
                <c:pt idx="58">
                  <c:v>1.39902451937303</c:v>
                </c:pt>
                <c:pt idx="59">
                  <c:v>1.58204808388799</c:v>
                </c:pt>
                <c:pt idx="60">
                  <c:v>1.60096368574701</c:v>
                </c:pt>
                <c:pt idx="61">
                  <c:v>1.2753414106110501</c:v>
                </c:pt>
                <c:pt idx="62">
                  <c:v>1.18472399805804</c:v>
                </c:pt>
                <c:pt idx="63">
                  <c:v>1.1076307309711</c:v>
                </c:pt>
                <c:pt idx="64">
                  <c:v>1.2527637229225399</c:v>
                </c:pt>
                <c:pt idx="65">
                  <c:v>1.5109430507761199</c:v>
                </c:pt>
                <c:pt idx="66">
                  <c:v>2.10056889253844</c:v>
                </c:pt>
                <c:pt idx="67">
                  <c:v>1.0013833064411</c:v>
                </c:pt>
                <c:pt idx="68">
                  <c:v>1.56398029140367</c:v>
                </c:pt>
                <c:pt idx="69">
                  <c:v>0.75831208990681898</c:v>
                </c:pt>
                <c:pt idx="70">
                  <c:v>1.6658706762664499</c:v>
                </c:pt>
                <c:pt idx="71">
                  <c:v>3.5095918062070899</c:v>
                </c:pt>
                <c:pt idx="72">
                  <c:v>0.98122264723436403</c:v>
                </c:pt>
                <c:pt idx="73">
                  <c:v>1.36423018891685</c:v>
                </c:pt>
                <c:pt idx="74">
                  <c:v>1.9102818952160501</c:v>
                </c:pt>
                <c:pt idx="75">
                  <c:v>2.2682396295996901</c:v>
                </c:pt>
                <c:pt idx="76">
                  <c:v>1.5779792975901801</c:v>
                </c:pt>
                <c:pt idx="77">
                  <c:v>1.27651407652337</c:v>
                </c:pt>
                <c:pt idx="78">
                  <c:v>1.2774728801253801</c:v>
                </c:pt>
                <c:pt idx="79">
                  <c:v>0.94354728181416803</c:v>
                </c:pt>
                <c:pt idx="80">
                  <c:v>1.22562902942006</c:v>
                </c:pt>
                <c:pt idx="81">
                  <c:v>1.24652267204889</c:v>
                </c:pt>
                <c:pt idx="82">
                  <c:v>1.85962025401493</c:v>
                </c:pt>
                <c:pt idx="83">
                  <c:v>0.90511355117812398</c:v>
                </c:pt>
                <c:pt idx="84">
                  <c:v>6.9520271906859303</c:v>
                </c:pt>
                <c:pt idx="85">
                  <c:v>0.86315233723478801</c:v>
                </c:pt>
                <c:pt idx="86">
                  <c:v>0.65429626949264297</c:v>
                </c:pt>
                <c:pt idx="87">
                  <c:v>0.62848984791979201</c:v>
                </c:pt>
                <c:pt idx="88">
                  <c:v>0.66089008781293201</c:v>
                </c:pt>
                <c:pt idx="89">
                  <c:v>0.60067155402602401</c:v>
                </c:pt>
                <c:pt idx="90">
                  <c:v>0.87706992462446198</c:v>
                </c:pt>
                <c:pt idx="91">
                  <c:v>0.76311283230101801</c:v>
                </c:pt>
                <c:pt idx="92">
                  <c:v>0.87155527023234403</c:v>
                </c:pt>
                <c:pt idx="93">
                  <c:v>1.12830042027138</c:v>
                </c:pt>
                <c:pt idx="94">
                  <c:v>0.62655286074196104</c:v>
                </c:pt>
                <c:pt idx="95">
                  <c:v>0.92426210638515405</c:v>
                </c:pt>
                <c:pt idx="96">
                  <c:v>0.946028077148372</c:v>
                </c:pt>
                <c:pt idx="97">
                  <c:v>2.0123420981293401</c:v>
                </c:pt>
                <c:pt idx="98">
                  <c:v>0.69802993863288498</c:v>
                </c:pt>
                <c:pt idx="99">
                  <c:v>0.67980380263721096</c:v>
                </c:pt>
                <c:pt idx="100">
                  <c:v>1.6987393240881601</c:v>
                </c:pt>
                <c:pt idx="101">
                  <c:v>1.21849027729714</c:v>
                </c:pt>
                <c:pt idx="102">
                  <c:v>0.96363938505765401</c:v>
                </c:pt>
                <c:pt idx="103">
                  <c:v>1.0042414728988101</c:v>
                </c:pt>
                <c:pt idx="104">
                  <c:v>1.5970097279580799</c:v>
                </c:pt>
                <c:pt idx="105">
                  <c:v>1.60797700763466</c:v>
                </c:pt>
                <c:pt idx="106">
                  <c:v>1.0522409567640101</c:v>
                </c:pt>
                <c:pt idx="107">
                  <c:v>1.1764063078212199</c:v>
                </c:pt>
                <c:pt idx="108">
                  <c:v>1.6194489458157</c:v>
                </c:pt>
                <c:pt idx="109">
                  <c:v>1.49509655789327</c:v>
                </c:pt>
                <c:pt idx="110">
                  <c:v>1.87887835994977</c:v>
                </c:pt>
                <c:pt idx="111">
                  <c:v>0.72772557160788198</c:v>
                </c:pt>
                <c:pt idx="112">
                  <c:v>1.6353690431472401</c:v>
                </c:pt>
                <c:pt idx="113">
                  <c:v>0.66917703192179601</c:v>
                </c:pt>
                <c:pt idx="114">
                  <c:v>1.8847593481776299</c:v>
                </c:pt>
                <c:pt idx="115">
                  <c:v>2.74465237327269</c:v>
                </c:pt>
              </c:numCache>
            </c:numRef>
          </c:xVal>
          <c:yVal>
            <c:numRef>
              <c:f>'HFD (2)'!$H$2:$H$117</c:f>
              <c:numCache>
                <c:formatCode>General</c:formatCode>
                <c:ptCount val="116"/>
                <c:pt idx="0">
                  <c:v>1.48246055863042</c:v>
                </c:pt>
                <c:pt idx="1">
                  <c:v>1.0456856961727601</c:v>
                </c:pt>
                <c:pt idx="2">
                  <c:v>1.84918400739286</c:v>
                </c:pt>
                <c:pt idx="3">
                  <c:v>1.0780947630198701</c:v>
                </c:pt>
                <c:pt idx="4">
                  <c:v>1.3638779415132301</c:v>
                </c:pt>
                <c:pt idx="5">
                  <c:v>1.2734747168615299</c:v>
                </c:pt>
                <c:pt idx="6">
                  <c:v>1.32390330004303</c:v>
                </c:pt>
                <c:pt idx="7">
                  <c:v>1.4315725838659701</c:v>
                </c:pt>
                <c:pt idx="8">
                  <c:v>1.0633700058992801</c:v>
                </c:pt>
                <c:pt idx="9">
                  <c:v>1.2605538583232201</c:v>
                </c:pt>
                <c:pt idx="10">
                  <c:v>1.5885817193665499</c:v>
                </c:pt>
                <c:pt idx="11">
                  <c:v>1.3573633211474101</c:v>
                </c:pt>
                <c:pt idx="12">
                  <c:v>1.13004687509827</c:v>
                </c:pt>
                <c:pt idx="13">
                  <c:v>1.36868381282703</c:v>
                </c:pt>
                <c:pt idx="14">
                  <c:v>1.4746818705643701</c:v>
                </c:pt>
                <c:pt idx="15">
                  <c:v>1.6525190095151201</c:v>
                </c:pt>
                <c:pt idx="16">
                  <c:v>2.1820419502825201</c:v>
                </c:pt>
                <c:pt idx="17">
                  <c:v>1.0767455716219101</c:v>
                </c:pt>
                <c:pt idx="18">
                  <c:v>1.2973647888829301</c:v>
                </c:pt>
                <c:pt idx="19">
                  <c:v>1.19909697330374</c:v>
                </c:pt>
                <c:pt idx="20">
                  <c:v>1.2973647888829301</c:v>
                </c:pt>
                <c:pt idx="21">
                  <c:v>1.3311112601103201</c:v>
                </c:pt>
                <c:pt idx="22">
                  <c:v>1.4406099620913999</c:v>
                </c:pt>
                <c:pt idx="23">
                  <c:v>1.37312657160704</c:v>
                </c:pt>
                <c:pt idx="24">
                  <c:v>1.0733310540270999</c:v>
                </c:pt>
                <c:pt idx="25">
                  <c:v>1.29325818997223</c:v>
                </c:pt>
                <c:pt idx="26">
                  <c:v>1.2973647888829301</c:v>
                </c:pt>
                <c:pt idx="27">
                  <c:v>1.4090823144993101</c:v>
                </c:pt>
                <c:pt idx="28">
                  <c:v>1.07876778783078</c:v>
                </c:pt>
                <c:pt idx="29">
                  <c:v>1.82024042636363</c:v>
                </c:pt>
                <c:pt idx="30">
                  <c:v>1.85659434543978</c:v>
                </c:pt>
                <c:pt idx="31">
                  <c:v>1.1002753794734399</c:v>
                </c:pt>
                <c:pt idx="32">
                  <c:v>2.19802138991373</c:v>
                </c:pt>
                <c:pt idx="33">
                  <c:v>1.32539998774999</c:v>
                </c:pt>
                <c:pt idx="34">
                  <c:v>2.10953219437588</c:v>
                </c:pt>
                <c:pt idx="35">
                  <c:v>1.6474911282923499</c:v>
                </c:pt>
                <c:pt idx="36">
                  <c:v>2.18783748059725</c:v>
                </c:pt>
                <c:pt idx="37">
                  <c:v>1.2887356712295099</c:v>
                </c:pt>
                <c:pt idx="38">
                  <c:v>2.1875356578137901</c:v>
                </c:pt>
                <c:pt idx="39">
                  <c:v>1.6887175903421501</c:v>
                </c:pt>
                <c:pt idx="40">
                  <c:v>1.29325818997223</c:v>
                </c:pt>
                <c:pt idx="41">
                  <c:v>1.0643691946492999</c:v>
                </c:pt>
                <c:pt idx="42">
                  <c:v>1.5391969725869099</c:v>
                </c:pt>
                <c:pt idx="43">
                  <c:v>1.20767838975321</c:v>
                </c:pt>
                <c:pt idx="44">
                  <c:v>1.6237699090328499</c:v>
                </c:pt>
                <c:pt idx="45">
                  <c:v>1.20767838975321</c:v>
                </c:pt>
                <c:pt idx="46">
                  <c:v>1.2031550520465899</c:v>
                </c:pt>
                <c:pt idx="47">
                  <c:v>1.42746228285904</c:v>
                </c:pt>
                <c:pt idx="48">
                  <c:v>1.3927404133385299</c:v>
                </c:pt>
                <c:pt idx="49">
                  <c:v>1.1151184341709499</c:v>
                </c:pt>
                <c:pt idx="50">
                  <c:v>1.0223833002037901</c:v>
                </c:pt>
                <c:pt idx="51">
                  <c:v>1.07381194787543</c:v>
                </c:pt>
                <c:pt idx="52">
                  <c:v>1.04396694817552</c:v>
                </c:pt>
                <c:pt idx="53">
                  <c:v>1.61171998864633</c:v>
                </c:pt>
                <c:pt idx="54">
                  <c:v>1.0405616623318401</c:v>
                </c:pt>
                <c:pt idx="55">
                  <c:v>1.06705234825533</c:v>
                </c:pt>
                <c:pt idx="56">
                  <c:v>1.5575789465338501</c:v>
                </c:pt>
                <c:pt idx="57">
                  <c:v>1.33475655172686</c:v>
                </c:pt>
                <c:pt idx="58">
                  <c:v>1.3639699567946499</c:v>
                </c:pt>
                <c:pt idx="59">
                  <c:v>1.3265040253039799</c:v>
                </c:pt>
                <c:pt idx="60">
                  <c:v>2.1122788351374702</c:v>
                </c:pt>
                <c:pt idx="61">
                  <c:v>1.07789747315128</c:v>
                </c:pt>
                <c:pt idx="62">
                  <c:v>2.0652885440069002</c:v>
                </c:pt>
                <c:pt idx="63">
                  <c:v>2.0687612206534101</c:v>
                </c:pt>
                <c:pt idx="64">
                  <c:v>2.0748737416246801</c:v>
                </c:pt>
                <c:pt idx="65">
                  <c:v>1.11319217125991</c:v>
                </c:pt>
                <c:pt idx="66">
                  <c:v>1.82785850552095</c:v>
                </c:pt>
                <c:pt idx="67">
                  <c:v>2.0167791885018098</c:v>
                </c:pt>
                <c:pt idx="68">
                  <c:v>1.3804889836960901</c:v>
                </c:pt>
                <c:pt idx="69">
                  <c:v>1.3927404133385299</c:v>
                </c:pt>
                <c:pt idx="70">
                  <c:v>1.2419833874025801</c:v>
                </c:pt>
                <c:pt idx="71">
                  <c:v>1.4950557978691099</c:v>
                </c:pt>
                <c:pt idx="72">
                  <c:v>1.85455394785876</c:v>
                </c:pt>
                <c:pt idx="73">
                  <c:v>1.7204093735639601</c:v>
                </c:pt>
                <c:pt idx="74">
                  <c:v>1.32807483037036</c:v>
                </c:pt>
                <c:pt idx="75">
                  <c:v>1.0133379149005499</c:v>
                </c:pt>
                <c:pt idx="76">
                  <c:v>1.4286499240075701</c:v>
                </c:pt>
                <c:pt idx="77">
                  <c:v>1.3313533096201799</c:v>
                </c:pt>
                <c:pt idx="78">
                  <c:v>1.3045302471765901</c:v>
                </c:pt>
                <c:pt idx="79">
                  <c:v>1.1957651624075301</c:v>
                </c:pt>
                <c:pt idx="80">
                  <c:v>1.8744101214408</c:v>
                </c:pt>
                <c:pt idx="81">
                  <c:v>1.1833542622817801</c:v>
                </c:pt>
                <c:pt idx="82">
                  <c:v>1.43757713440988</c:v>
                </c:pt>
                <c:pt idx="83">
                  <c:v>1.3296720112146501</c:v>
                </c:pt>
                <c:pt idx="84">
                  <c:v>1.58825835179604</c:v>
                </c:pt>
                <c:pt idx="85">
                  <c:v>1.4414786709784999</c:v>
                </c:pt>
                <c:pt idx="86">
                  <c:v>1.4888998881671101</c:v>
                </c:pt>
                <c:pt idx="87">
                  <c:v>1.02627812220319</c:v>
                </c:pt>
                <c:pt idx="88">
                  <c:v>1.3390014302279101</c:v>
                </c:pt>
                <c:pt idx="89">
                  <c:v>1.8748712265426499</c:v>
                </c:pt>
                <c:pt idx="90">
                  <c:v>1.3091933254653501</c:v>
                </c:pt>
                <c:pt idx="91">
                  <c:v>1.2365658870252201</c:v>
                </c:pt>
                <c:pt idx="92">
                  <c:v>1.4226241903757999</c:v>
                </c:pt>
                <c:pt idx="93">
                  <c:v>1.32281506061668</c:v>
                </c:pt>
                <c:pt idx="94">
                  <c:v>1.28818115129599</c:v>
                </c:pt>
                <c:pt idx="95">
                  <c:v>1.56301679148072</c:v>
                </c:pt>
                <c:pt idx="96">
                  <c:v>2.03907631482295</c:v>
                </c:pt>
                <c:pt idx="97">
                  <c:v>1.7486769438472101</c:v>
                </c:pt>
                <c:pt idx="98">
                  <c:v>1.0746770182660701</c:v>
                </c:pt>
                <c:pt idx="99">
                  <c:v>1.11191958704475</c:v>
                </c:pt>
                <c:pt idx="100">
                  <c:v>1.42535218480383</c:v>
                </c:pt>
                <c:pt idx="101">
                  <c:v>1.29354991121166</c:v>
                </c:pt>
                <c:pt idx="102">
                  <c:v>1.5400003059430001</c:v>
                </c:pt>
                <c:pt idx="103">
                  <c:v>1.36203397842999</c:v>
                </c:pt>
                <c:pt idx="104">
                  <c:v>1.0554607133517999</c:v>
                </c:pt>
                <c:pt idx="105">
                  <c:v>1.8797353118173901</c:v>
                </c:pt>
                <c:pt idx="106">
                  <c:v>1.8256374791951699</c:v>
                </c:pt>
                <c:pt idx="107">
                  <c:v>1.6429966253152899</c:v>
                </c:pt>
                <c:pt idx="108">
                  <c:v>1.59803113287711</c:v>
                </c:pt>
                <c:pt idx="109">
                  <c:v>1.0315880411684599</c:v>
                </c:pt>
                <c:pt idx="110">
                  <c:v>1.23936042911641</c:v>
                </c:pt>
                <c:pt idx="111">
                  <c:v>1.06589772944455</c:v>
                </c:pt>
                <c:pt idx="112">
                  <c:v>1.27586857237431</c:v>
                </c:pt>
                <c:pt idx="113">
                  <c:v>1.0756756766337501</c:v>
                </c:pt>
                <c:pt idx="114">
                  <c:v>1.21811947717595</c:v>
                </c:pt>
                <c:pt idx="115">
                  <c:v>1.5679440787386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B57-4F98-B479-9C88ADAA6B21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2B57-4F98-B479-9C88ADAA6B21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0</c:v>
              </c:pt>
              <c:pt idx="1">
                <c:v>20</c:v>
              </c:pt>
            </c:numLit>
          </c:xVal>
          <c:yVal>
            <c:numLit>
              <c:formatCode>General</c:formatCode>
              <c:ptCount val="2"/>
              <c:pt idx="0">
                <c:v>1</c:v>
              </c:pt>
              <c:pt idx="1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2B57-4F98-B479-9C88ADAA6B21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2B57-4F98-B479-9C88ADAA6B21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2B57-4F98-B479-9C88ADAA6B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20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</a:t>
                </a:r>
                <a:r>
                  <a:rPr lang="en-US"/>
                  <a:t>HPVB /</a:t>
                </a:r>
                <a:r>
                  <a:rPr lang="en-US" baseline="0"/>
                  <a:t> PB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5"/>
      </c:valAx>
      <c:valAx>
        <c:axId val="872775711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P (oPLS-DA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0"/>
        <c:crossBetween val="midCat"/>
        <c:majorUnit val="1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07185185185185"/>
          <c:y val="7.7611111111111117E-2"/>
          <c:w val="0.8231640740740741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Diabetes (2)'!$B$1</c:f>
              <c:strCache>
                <c:ptCount val="1"/>
                <c:pt idx="0">
                  <c:v>Diabetes.vip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Diabetes (2)'!$A$2:$A$940</c:f>
              <c:numCache>
                <c:formatCode>General</c:formatCode>
                <c:ptCount val="939"/>
                <c:pt idx="0">
                  <c:v>0.54108237029602202</c:v>
                </c:pt>
                <c:pt idx="1">
                  <c:v>-0.29316246487765801</c:v>
                </c:pt>
                <c:pt idx="2">
                  <c:v>-0.16033622720982299</c:v>
                </c:pt>
                <c:pt idx="3">
                  <c:v>0.592338543912725</c:v>
                </c:pt>
                <c:pt idx="4">
                  <c:v>4.28209817171133E-2</c:v>
                </c:pt>
                <c:pt idx="5">
                  <c:v>-0.20894852963713401</c:v>
                </c:pt>
                <c:pt idx="6">
                  <c:v>-0.35068017849959598</c:v>
                </c:pt>
                <c:pt idx="7">
                  <c:v>-0.52256909617769998</c:v>
                </c:pt>
                <c:pt idx="8">
                  <c:v>5.4355375597406802E-2</c:v>
                </c:pt>
                <c:pt idx="9">
                  <c:v>0.57525117738046205</c:v>
                </c:pt>
                <c:pt idx="10">
                  <c:v>-9.9773560843196399E-2</c:v>
                </c:pt>
                <c:pt idx="11">
                  <c:v>0.26477427063131997</c:v>
                </c:pt>
                <c:pt idx="12">
                  <c:v>6.0681193711874797E-2</c:v>
                </c:pt>
                <c:pt idx="13">
                  <c:v>-0.432305628815434</c:v>
                </c:pt>
                <c:pt idx="14">
                  <c:v>-0.15207166477769299</c:v>
                </c:pt>
                <c:pt idx="15">
                  <c:v>2.5203548587796099E-2</c:v>
                </c:pt>
                <c:pt idx="16">
                  <c:v>0.40076108629999002</c:v>
                </c:pt>
                <c:pt idx="17">
                  <c:v>-0.28822784835948601</c:v>
                </c:pt>
                <c:pt idx="18">
                  <c:v>-0.40593453055165701</c:v>
                </c:pt>
                <c:pt idx="19">
                  <c:v>0.13769147092088899</c:v>
                </c:pt>
                <c:pt idx="20">
                  <c:v>0.51874933190678596</c:v>
                </c:pt>
                <c:pt idx="21">
                  <c:v>0.13102861641013799</c:v>
                </c:pt>
                <c:pt idx="22">
                  <c:v>-0.213520665390739</c:v>
                </c:pt>
                <c:pt idx="23">
                  <c:v>-0.19024670304584601</c:v>
                </c:pt>
                <c:pt idx="24">
                  <c:v>8.7082908366919301E-2</c:v>
                </c:pt>
                <c:pt idx="25">
                  <c:v>4.0002778894447496E-3</c:v>
                </c:pt>
                <c:pt idx="26">
                  <c:v>-0.208975073187921</c:v>
                </c:pt>
                <c:pt idx="27">
                  <c:v>-9.1227334777327501E-2</c:v>
                </c:pt>
                <c:pt idx="28">
                  <c:v>0.286545723306253</c:v>
                </c:pt>
                <c:pt idx="29">
                  <c:v>-4.0508901666485402E-2</c:v>
                </c:pt>
                <c:pt idx="30">
                  <c:v>0.194818075903641</c:v>
                </c:pt>
                <c:pt idx="31">
                  <c:v>0.14611731354506599</c:v>
                </c:pt>
                <c:pt idx="32">
                  <c:v>0.194818075903641</c:v>
                </c:pt>
                <c:pt idx="33">
                  <c:v>0.194818075903641</c:v>
                </c:pt>
                <c:pt idx="34">
                  <c:v>0.38551027503146101</c:v>
                </c:pt>
                <c:pt idx="35">
                  <c:v>0.38551027503146101</c:v>
                </c:pt>
                <c:pt idx="36">
                  <c:v>0.194818075903641</c:v>
                </c:pt>
                <c:pt idx="37">
                  <c:v>0.56755080510834099</c:v>
                </c:pt>
                <c:pt idx="38">
                  <c:v>0.286953621416913</c:v>
                </c:pt>
                <c:pt idx="39">
                  <c:v>0.34600981127994401</c:v>
                </c:pt>
                <c:pt idx="40">
                  <c:v>2.4339759355265E-2</c:v>
                </c:pt>
                <c:pt idx="41">
                  <c:v>0.44029733831929302</c:v>
                </c:pt>
                <c:pt idx="42">
                  <c:v>-0.57981199470537204</c:v>
                </c:pt>
                <c:pt idx="43">
                  <c:v>4.7926911638808398E-2</c:v>
                </c:pt>
                <c:pt idx="44">
                  <c:v>-8.0829055958191703E-2</c:v>
                </c:pt>
                <c:pt idx="45">
                  <c:v>9.7113847288881505E-2</c:v>
                </c:pt>
                <c:pt idx="46">
                  <c:v>0.34852469207694298</c:v>
                </c:pt>
                <c:pt idx="47">
                  <c:v>-0.18138318922533</c:v>
                </c:pt>
                <c:pt idx="48">
                  <c:v>0.54799509215586495</c:v>
                </c:pt>
                <c:pt idx="49">
                  <c:v>4.8622159768008398E-2</c:v>
                </c:pt>
                <c:pt idx="50">
                  <c:v>-0.194049794361873</c:v>
                </c:pt>
                <c:pt idx="51">
                  <c:v>0.39032091775470301</c:v>
                </c:pt>
                <c:pt idx="52">
                  <c:v>0.219482551635757</c:v>
                </c:pt>
                <c:pt idx="53">
                  <c:v>0.37131844358314298</c:v>
                </c:pt>
                <c:pt idx="54">
                  <c:v>0.104209175985001</c:v>
                </c:pt>
                <c:pt idx="55">
                  <c:v>0.20753710183488999</c:v>
                </c:pt>
                <c:pt idx="56">
                  <c:v>0.42494221792869502</c:v>
                </c:pt>
                <c:pt idx="57">
                  <c:v>-0.29316246487765801</c:v>
                </c:pt>
                <c:pt idx="58">
                  <c:v>0.356078228166265</c:v>
                </c:pt>
                <c:pt idx="59">
                  <c:v>-0.107778832066407</c:v>
                </c:pt>
                <c:pt idx="60">
                  <c:v>0.31583522237193001</c:v>
                </c:pt>
                <c:pt idx="61">
                  <c:v>-0.17179839342845199</c:v>
                </c:pt>
                <c:pt idx="62">
                  <c:v>-0.177659254627063</c:v>
                </c:pt>
                <c:pt idx="63">
                  <c:v>-0.32311755737785602</c:v>
                </c:pt>
                <c:pt idx="64">
                  <c:v>-0.18311452133877101</c:v>
                </c:pt>
                <c:pt idx="65">
                  <c:v>-0.26455766245732698</c:v>
                </c:pt>
                <c:pt idx="66">
                  <c:v>-0.41189058272464402</c:v>
                </c:pt>
                <c:pt idx="67">
                  <c:v>-0.16008830431593599</c:v>
                </c:pt>
                <c:pt idx="68">
                  <c:v>-0.23069439843438599</c:v>
                </c:pt>
                <c:pt idx="69">
                  <c:v>0.27655021079963299</c:v>
                </c:pt>
                <c:pt idx="70">
                  <c:v>7.0480370264700595E-2</c:v>
                </c:pt>
                <c:pt idx="71">
                  <c:v>0.56786436689003605</c:v>
                </c:pt>
                <c:pt idx="72">
                  <c:v>-0.41902264452020299</c:v>
                </c:pt>
                <c:pt idx="73">
                  <c:v>-0.32727155551957798</c:v>
                </c:pt>
                <c:pt idx="74">
                  <c:v>0.20286838252030601</c:v>
                </c:pt>
                <c:pt idx="75">
                  <c:v>7.4067388529668104E-3</c:v>
                </c:pt>
                <c:pt idx="76">
                  <c:v>-0.10192265440916499</c:v>
                </c:pt>
                <c:pt idx="77">
                  <c:v>0.27173636506993198</c:v>
                </c:pt>
                <c:pt idx="78">
                  <c:v>-0.39245104483231802</c:v>
                </c:pt>
                <c:pt idx="79">
                  <c:v>-0.182739971855884</c:v>
                </c:pt>
                <c:pt idx="80">
                  <c:v>-0.130053880829476</c:v>
                </c:pt>
                <c:pt idx="81">
                  <c:v>-0.19231687270234901</c:v>
                </c:pt>
                <c:pt idx="82">
                  <c:v>-0.41902264452020299</c:v>
                </c:pt>
                <c:pt idx="83">
                  <c:v>-0.28520716961597198</c:v>
                </c:pt>
                <c:pt idx="84">
                  <c:v>0.54844676910808099</c:v>
                </c:pt>
                <c:pt idx="85">
                  <c:v>-2.5885702109877801E-2</c:v>
                </c:pt>
                <c:pt idx="86">
                  <c:v>9.0283989472268303E-2</c:v>
                </c:pt>
                <c:pt idx="87">
                  <c:v>0.36416607298088499</c:v>
                </c:pt>
                <c:pt idx="88">
                  <c:v>0.20820361365998899</c:v>
                </c:pt>
                <c:pt idx="89">
                  <c:v>0.274092803180359</c:v>
                </c:pt>
                <c:pt idx="90">
                  <c:v>0.12525053873564301</c:v>
                </c:pt>
                <c:pt idx="91">
                  <c:v>0.446215168511986</c:v>
                </c:pt>
                <c:pt idx="92">
                  <c:v>0.20129331283538099</c:v>
                </c:pt>
                <c:pt idx="93">
                  <c:v>0.34812239195175998</c:v>
                </c:pt>
                <c:pt idx="94">
                  <c:v>0.13769147092088899</c:v>
                </c:pt>
                <c:pt idx="95">
                  <c:v>0.18923138517847199</c:v>
                </c:pt>
                <c:pt idx="96">
                  <c:v>-0.51073182458334099</c:v>
                </c:pt>
                <c:pt idx="97">
                  <c:v>0.33896075967077599</c:v>
                </c:pt>
                <c:pt idx="98">
                  <c:v>-0.125085495653943</c:v>
                </c:pt>
                <c:pt idx="99">
                  <c:v>3.8118475385528698E-2</c:v>
                </c:pt>
                <c:pt idx="100">
                  <c:v>0.32297689083673098</c:v>
                </c:pt>
                <c:pt idx="101">
                  <c:v>-0.16272123336036701</c:v>
                </c:pt>
                <c:pt idx="102">
                  <c:v>-0.33645811157123801</c:v>
                </c:pt>
                <c:pt idx="103">
                  <c:v>0.41348783578836601</c:v>
                </c:pt>
                <c:pt idx="104">
                  <c:v>0.11706916237870101</c:v>
                </c:pt>
                <c:pt idx="105">
                  <c:v>0.47447574114107099</c:v>
                </c:pt>
                <c:pt idx="106">
                  <c:v>0.108886161498102</c:v>
                </c:pt>
                <c:pt idx="107">
                  <c:v>-3.6350714586455703E-2</c:v>
                </c:pt>
                <c:pt idx="108">
                  <c:v>0.17659232355190499</c:v>
                </c:pt>
                <c:pt idx="109">
                  <c:v>0.112839419929534</c:v>
                </c:pt>
                <c:pt idx="110">
                  <c:v>0.49950483461333101</c:v>
                </c:pt>
                <c:pt idx="111">
                  <c:v>0.34396604999302</c:v>
                </c:pt>
                <c:pt idx="112">
                  <c:v>2.99473068109119E-2</c:v>
                </c:pt>
                <c:pt idx="113">
                  <c:v>0.29135173926187602</c:v>
                </c:pt>
                <c:pt idx="114">
                  <c:v>-5.9810159441029798E-2</c:v>
                </c:pt>
                <c:pt idx="115">
                  <c:v>4.8060878429632199E-2</c:v>
                </c:pt>
                <c:pt idx="116">
                  <c:v>2.3335016255847101E-2</c:v>
                </c:pt>
                <c:pt idx="117">
                  <c:v>-0.23814881733367499</c:v>
                </c:pt>
                <c:pt idx="118">
                  <c:v>0.18186356803207099</c:v>
                </c:pt>
                <c:pt idx="119">
                  <c:v>-0.32689628272926002</c:v>
                </c:pt>
                <c:pt idx="120">
                  <c:v>0.74367536045897698</c:v>
                </c:pt>
                <c:pt idx="121">
                  <c:v>3.7713125646548898E-2</c:v>
                </c:pt>
                <c:pt idx="122">
                  <c:v>-0.15207166477769299</c:v>
                </c:pt>
                <c:pt idx="123">
                  <c:v>-0.14765273987923999</c:v>
                </c:pt>
                <c:pt idx="124">
                  <c:v>-2.0858821552714998E-2</c:v>
                </c:pt>
                <c:pt idx="125">
                  <c:v>0.57949529579453096</c:v>
                </c:pt>
                <c:pt idx="126">
                  <c:v>0.37588801222443602</c:v>
                </c:pt>
                <c:pt idx="127">
                  <c:v>0.27461753362850699</c:v>
                </c:pt>
                <c:pt idx="128">
                  <c:v>0.29426799128871001</c:v>
                </c:pt>
                <c:pt idx="129">
                  <c:v>-0.14285033312193601</c:v>
                </c:pt>
                <c:pt idx="130">
                  <c:v>-0.14285033312193601</c:v>
                </c:pt>
                <c:pt idx="131">
                  <c:v>-0.56251988756817195</c:v>
                </c:pt>
                <c:pt idx="132">
                  <c:v>-0.46297954942616698</c:v>
                </c:pt>
                <c:pt idx="133">
                  <c:v>-0.44278127526924199</c:v>
                </c:pt>
                <c:pt idx="134">
                  <c:v>-0.46297954942616698</c:v>
                </c:pt>
                <c:pt idx="135">
                  <c:v>-0.46817633213489401</c:v>
                </c:pt>
                <c:pt idx="136">
                  <c:v>-0.66101722970446797</c:v>
                </c:pt>
                <c:pt idx="137">
                  <c:v>-4.0508901666485402E-2</c:v>
                </c:pt>
                <c:pt idx="138">
                  <c:v>0.47493199418544801</c:v>
                </c:pt>
                <c:pt idx="139">
                  <c:v>0.14898843984944099</c:v>
                </c:pt>
                <c:pt idx="140">
                  <c:v>0.80299602092295397</c:v>
                </c:pt>
                <c:pt idx="141">
                  <c:v>-8.96405993066164E-2</c:v>
                </c:pt>
                <c:pt idx="142">
                  <c:v>-0.46480884381052001</c:v>
                </c:pt>
                <c:pt idx="143">
                  <c:v>-0.39996983750443599</c:v>
                </c:pt>
                <c:pt idx="144">
                  <c:v>7.3777823677088794E-2</c:v>
                </c:pt>
                <c:pt idx="145">
                  <c:v>2.95846325962861E-2</c:v>
                </c:pt>
                <c:pt idx="146">
                  <c:v>0.29426799128871001</c:v>
                </c:pt>
                <c:pt idx="147">
                  <c:v>0.12525053873564301</c:v>
                </c:pt>
                <c:pt idx="148">
                  <c:v>2.9118722576103599E-2</c:v>
                </c:pt>
                <c:pt idx="149">
                  <c:v>0.41222308538036301</c:v>
                </c:pt>
                <c:pt idx="150">
                  <c:v>-0.14662501400708</c:v>
                </c:pt>
                <c:pt idx="151">
                  <c:v>-0.45932396375142598</c:v>
                </c:pt>
                <c:pt idx="152">
                  <c:v>-0.45525487850882701</c:v>
                </c:pt>
                <c:pt idx="153">
                  <c:v>0.39368012202361902</c:v>
                </c:pt>
                <c:pt idx="154">
                  <c:v>-0.19585636514743299</c:v>
                </c:pt>
                <c:pt idx="155">
                  <c:v>0.48005740320908802</c:v>
                </c:pt>
                <c:pt idx="156">
                  <c:v>-0.39245104483231802</c:v>
                </c:pt>
                <c:pt idx="157">
                  <c:v>0.56786436689003605</c:v>
                </c:pt>
                <c:pt idx="158">
                  <c:v>-7.8551215279041395E-2</c:v>
                </c:pt>
                <c:pt idx="159">
                  <c:v>6.15989271915246E-2</c:v>
                </c:pt>
                <c:pt idx="160">
                  <c:v>2.03630706833028E-2</c:v>
                </c:pt>
                <c:pt idx="161">
                  <c:v>0.29816248104318199</c:v>
                </c:pt>
                <c:pt idx="162">
                  <c:v>4.3330792879614798E-2</c:v>
                </c:pt>
                <c:pt idx="163">
                  <c:v>0.12885662102531201</c:v>
                </c:pt>
                <c:pt idx="164">
                  <c:v>0.26752834146195098</c:v>
                </c:pt>
                <c:pt idx="165">
                  <c:v>-0.248538921431949</c:v>
                </c:pt>
                <c:pt idx="166">
                  <c:v>-0.30209184456663002</c:v>
                </c:pt>
                <c:pt idx="167">
                  <c:v>-0.30209184456663002</c:v>
                </c:pt>
                <c:pt idx="168">
                  <c:v>-0.187560225548487</c:v>
                </c:pt>
                <c:pt idx="169">
                  <c:v>-0.187560225548487</c:v>
                </c:pt>
                <c:pt idx="170">
                  <c:v>-0.187560225548487</c:v>
                </c:pt>
                <c:pt idx="171">
                  <c:v>-0.137348019228028</c:v>
                </c:pt>
                <c:pt idx="172">
                  <c:v>-0.137348019228028</c:v>
                </c:pt>
                <c:pt idx="173">
                  <c:v>-0.26021873123449901</c:v>
                </c:pt>
                <c:pt idx="174">
                  <c:v>-0.26021873123449901</c:v>
                </c:pt>
                <c:pt idx="175">
                  <c:v>-0.26013862403683102</c:v>
                </c:pt>
                <c:pt idx="176">
                  <c:v>-0.26013862403683102</c:v>
                </c:pt>
                <c:pt idx="177">
                  <c:v>-0.153481757370733</c:v>
                </c:pt>
                <c:pt idx="178">
                  <c:v>-0.249250012492476</c:v>
                </c:pt>
                <c:pt idx="179">
                  <c:v>-0.249250012492476</c:v>
                </c:pt>
                <c:pt idx="180">
                  <c:v>-0.18311452133877101</c:v>
                </c:pt>
                <c:pt idx="181">
                  <c:v>-0.10120679978901501</c:v>
                </c:pt>
                <c:pt idx="182">
                  <c:v>-0.32598152737410602</c:v>
                </c:pt>
                <c:pt idx="183">
                  <c:v>-0.34864785976358398</c:v>
                </c:pt>
                <c:pt idx="184">
                  <c:v>-0.26455766245732698</c:v>
                </c:pt>
                <c:pt idx="185">
                  <c:v>-0.36508038077421701</c:v>
                </c:pt>
                <c:pt idx="186">
                  <c:v>-0.129849624029134</c:v>
                </c:pt>
                <c:pt idx="187">
                  <c:v>8.3857991811213308E-3</c:v>
                </c:pt>
                <c:pt idx="188">
                  <c:v>-0.245941922465616</c:v>
                </c:pt>
                <c:pt idx="189">
                  <c:v>0.149134465775911</c:v>
                </c:pt>
                <c:pt idx="190">
                  <c:v>5.98790229613132E-2</c:v>
                </c:pt>
                <c:pt idx="191">
                  <c:v>-0.38635452862945702</c:v>
                </c:pt>
                <c:pt idx="192">
                  <c:v>0.187560370271043</c:v>
                </c:pt>
                <c:pt idx="193">
                  <c:v>1.17370940753618E-2</c:v>
                </c:pt>
                <c:pt idx="194">
                  <c:v>7.3444610513910005E-2</c:v>
                </c:pt>
                <c:pt idx="195">
                  <c:v>-8.2645795521402096E-2</c:v>
                </c:pt>
                <c:pt idx="196">
                  <c:v>-8.1079606141854194E-2</c:v>
                </c:pt>
                <c:pt idx="197">
                  <c:v>-2.3139468196050499E-2</c:v>
                </c:pt>
                <c:pt idx="198">
                  <c:v>-0.16175630944437799</c:v>
                </c:pt>
                <c:pt idx="199">
                  <c:v>-0.31752069793485199</c:v>
                </c:pt>
                <c:pt idx="200">
                  <c:v>-5.1951052506908998E-2</c:v>
                </c:pt>
                <c:pt idx="201">
                  <c:v>9.3334981539852896E-2</c:v>
                </c:pt>
                <c:pt idx="202">
                  <c:v>-0.40094117303418197</c:v>
                </c:pt>
                <c:pt idx="203">
                  <c:v>0.23660119385803699</c:v>
                </c:pt>
                <c:pt idx="204">
                  <c:v>-0.160384401491423</c:v>
                </c:pt>
                <c:pt idx="205">
                  <c:v>0.235772721631856</c:v>
                </c:pt>
                <c:pt idx="206">
                  <c:v>0.53371465123015105</c:v>
                </c:pt>
                <c:pt idx="207">
                  <c:v>0.37788300909679201</c:v>
                </c:pt>
                <c:pt idx="208">
                  <c:v>0.116324780327381</c:v>
                </c:pt>
                <c:pt idx="209">
                  <c:v>0.20791377662150901</c:v>
                </c:pt>
                <c:pt idx="210">
                  <c:v>0.33342731450660501</c:v>
                </c:pt>
                <c:pt idx="211">
                  <c:v>-0.10447186465600999</c:v>
                </c:pt>
                <c:pt idx="212">
                  <c:v>-0.23838053921698599</c:v>
                </c:pt>
                <c:pt idx="213">
                  <c:v>4.9666842191028002E-2</c:v>
                </c:pt>
                <c:pt idx="214">
                  <c:v>1.6417229618928501E-2</c:v>
                </c:pt>
                <c:pt idx="215">
                  <c:v>6.8461131210087206E-2</c:v>
                </c:pt>
                <c:pt idx="216">
                  <c:v>0.110092233167485</c:v>
                </c:pt>
                <c:pt idx="217">
                  <c:v>6.4800913640573596E-2</c:v>
                </c:pt>
                <c:pt idx="218">
                  <c:v>-0.67036385911002605</c:v>
                </c:pt>
                <c:pt idx="219">
                  <c:v>0.32583981996344402</c:v>
                </c:pt>
                <c:pt idx="220">
                  <c:v>-5.1475546839223903E-2</c:v>
                </c:pt>
                <c:pt idx="221">
                  <c:v>6.3130238990792398E-2</c:v>
                </c:pt>
                <c:pt idx="222">
                  <c:v>1.1811080333532901E-2</c:v>
                </c:pt>
                <c:pt idx="223">
                  <c:v>3.0483194042987601E-2</c:v>
                </c:pt>
                <c:pt idx="224">
                  <c:v>-8.6185295227840505E-2</c:v>
                </c:pt>
                <c:pt idx="225">
                  <c:v>0.41910204502158799</c:v>
                </c:pt>
                <c:pt idx="226">
                  <c:v>-0.243070643669001</c:v>
                </c:pt>
                <c:pt idx="227">
                  <c:v>-0.29264160482037599</c:v>
                </c:pt>
                <c:pt idx="228">
                  <c:v>-0.10447186465600999</c:v>
                </c:pt>
                <c:pt idx="229">
                  <c:v>0.29176188036679601</c:v>
                </c:pt>
                <c:pt idx="230">
                  <c:v>9.8427771543500103E-2</c:v>
                </c:pt>
                <c:pt idx="231">
                  <c:v>0.62932221460528703</c:v>
                </c:pt>
                <c:pt idx="232">
                  <c:v>0.20313472438167199</c:v>
                </c:pt>
                <c:pt idx="233">
                  <c:v>-0.21351982483013399</c:v>
                </c:pt>
                <c:pt idx="234">
                  <c:v>-8.4086491613293998E-2</c:v>
                </c:pt>
                <c:pt idx="235">
                  <c:v>3.7429542510447702E-3</c:v>
                </c:pt>
                <c:pt idx="236">
                  <c:v>-1.42704990871698E-2</c:v>
                </c:pt>
                <c:pt idx="237">
                  <c:v>5.2857789768088401E-2</c:v>
                </c:pt>
                <c:pt idx="238">
                  <c:v>-0.118182584802656</c:v>
                </c:pt>
                <c:pt idx="239">
                  <c:v>-0.25486335284397499</c:v>
                </c:pt>
                <c:pt idx="240">
                  <c:v>-0.15688301379265401</c:v>
                </c:pt>
                <c:pt idx="241">
                  <c:v>-0.50799891054910196</c:v>
                </c:pt>
                <c:pt idx="242">
                  <c:v>-0.41030451334657703</c:v>
                </c:pt>
                <c:pt idx="243">
                  <c:v>-0.11048460771513501</c:v>
                </c:pt>
                <c:pt idx="244">
                  <c:v>-0.43452843359380799</c:v>
                </c:pt>
                <c:pt idx="245">
                  <c:v>-8.9766254983527402E-2</c:v>
                </c:pt>
                <c:pt idx="246">
                  <c:v>-7.49235462572585E-2</c:v>
                </c:pt>
                <c:pt idx="247">
                  <c:v>-6.6519515289156797E-2</c:v>
                </c:pt>
                <c:pt idx="248">
                  <c:v>-0.57014740765119298</c:v>
                </c:pt>
                <c:pt idx="249">
                  <c:v>-0.35889231797593202</c:v>
                </c:pt>
                <c:pt idx="250">
                  <c:v>-0.17499848257209399</c:v>
                </c:pt>
                <c:pt idx="251">
                  <c:v>0.48675764689683898</c:v>
                </c:pt>
                <c:pt idx="252">
                  <c:v>-0.38663118699841098</c:v>
                </c:pt>
                <c:pt idx="253">
                  <c:v>-5.05958863881983E-2</c:v>
                </c:pt>
                <c:pt idx="254">
                  <c:v>-0.21975488646746799</c:v>
                </c:pt>
                <c:pt idx="255">
                  <c:v>-8.1128455846616196E-2</c:v>
                </c:pt>
                <c:pt idx="256">
                  <c:v>0.31199927371996899</c:v>
                </c:pt>
                <c:pt idx="257">
                  <c:v>0.17217173510998601</c:v>
                </c:pt>
                <c:pt idx="258">
                  <c:v>-0.51434494431130995</c:v>
                </c:pt>
                <c:pt idx="259">
                  <c:v>0.25780748301613299</c:v>
                </c:pt>
                <c:pt idx="260">
                  <c:v>-0.442147582385229</c:v>
                </c:pt>
                <c:pt idx="261">
                  <c:v>-1.8242556690246801E-2</c:v>
                </c:pt>
                <c:pt idx="262">
                  <c:v>-0.36182965310577703</c:v>
                </c:pt>
                <c:pt idx="263">
                  <c:v>-0.187232423912707</c:v>
                </c:pt>
                <c:pt idx="264">
                  <c:v>-0.15623806546295099</c:v>
                </c:pt>
                <c:pt idx="265">
                  <c:v>-6.6866089907930701E-3</c:v>
                </c:pt>
                <c:pt idx="266">
                  <c:v>-0.36616704358315599</c:v>
                </c:pt>
                <c:pt idx="267">
                  <c:v>-6.6519515289156797E-2</c:v>
                </c:pt>
                <c:pt idx="268">
                  <c:v>-0.27590964097709803</c:v>
                </c:pt>
                <c:pt idx="269">
                  <c:v>6.4800913640573596E-2</c:v>
                </c:pt>
                <c:pt idx="270">
                  <c:v>-0.46961816035658099</c:v>
                </c:pt>
                <c:pt idx="271">
                  <c:v>9.7207673900880406E-2</c:v>
                </c:pt>
                <c:pt idx="272">
                  <c:v>-5.65019314902378E-2</c:v>
                </c:pt>
                <c:pt idx="273">
                  <c:v>-0.14147481524473701</c:v>
                </c:pt>
                <c:pt idx="274">
                  <c:v>-4.2782039345119198E-2</c:v>
                </c:pt>
                <c:pt idx="275">
                  <c:v>-0.16058188365652301</c:v>
                </c:pt>
                <c:pt idx="276">
                  <c:v>0.166395251685446</c:v>
                </c:pt>
                <c:pt idx="277">
                  <c:v>0.26871849444899698</c:v>
                </c:pt>
                <c:pt idx="278">
                  <c:v>0.18633059400306401</c:v>
                </c:pt>
                <c:pt idx="279">
                  <c:v>3.6299424265723398E-2</c:v>
                </c:pt>
                <c:pt idx="280">
                  <c:v>4.3150626563566398E-3</c:v>
                </c:pt>
                <c:pt idx="281">
                  <c:v>-8.9766254983527402E-2</c:v>
                </c:pt>
                <c:pt idx="282">
                  <c:v>0.31893231199542699</c:v>
                </c:pt>
                <c:pt idx="283">
                  <c:v>4.6546238452522398E-2</c:v>
                </c:pt>
                <c:pt idx="284">
                  <c:v>0.15976873912266101</c:v>
                </c:pt>
                <c:pt idx="285">
                  <c:v>0.116324780327381</c:v>
                </c:pt>
                <c:pt idx="286">
                  <c:v>-8.2494882527270802E-2</c:v>
                </c:pt>
                <c:pt idx="287">
                  <c:v>8.6680878250860793E-2</c:v>
                </c:pt>
                <c:pt idx="288">
                  <c:v>0.31573031540336899</c:v>
                </c:pt>
                <c:pt idx="289">
                  <c:v>0.32756706624667697</c:v>
                </c:pt>
                <c:pt idx="290">
                  <c:v>-0.24071480397147499</c:v>
                </c:pt>
                <c:pt idx="291">
                  <c:v>-0.11753479986757701</c:v>
                </c:pt>
                <c:pt idx="292">
                  <c:v>-0.34405344423816397</c:v>
                </c:pt>
                <c:pt idx="293">
                  <c:v>8.3932502906644904E-2</c:v>
                </c:pt>
                <c:pt idx="294">
                  <c:v>9.1385881909847005E-2</c:v>
                </c:pt>
                <c:pt idx="295">
                  <c:v>0.36195788541135498</c:v>
                </c:pt>
                <c:pt idx="296">
                  <c:v>0.28306327430510297</c:v>
                </c:pt>
                <c:pt idx="297">
                  <c:v>0.35696918968337699</c:v>
                </c:pt>
                <c:pt idx="298">
                  <c:v>0.13789871911634899</c:v>
                </c:pt>
                <c:pt idx="299">
                  <c:v>0.135719885138949</c:v>
                </c:pt>
                <c:pt idx="300">
                  <c:v>-0.16048935032682399</c:v>
                </c:pt>
                <c:pt idx="301">
                  <c:v>0.19986619267240999</c:v>
                </c:pt>
                <c:pt idx="302">
                  <c:v>0.34273189053957298</c:v>
                </c:pt>
                <c:pt idx="303">
                  <c:v>9.5714502581833394E-2</c:v>
                </c:pt>
                <c:pt idx="304">
                  <c:v>-8.7911649548579704E-2</c:v>
                </c:pt>
                <c:pt idx="305">
                  <c:v>6.2037217151993097E-2</c:v>
                </c:pt>
                <c:pt idx="306">
                  <c:v>-1.0649524518379401E-2</c:v>
                </c:pt>
                <c:pt idx="307">
                  <c:v>-6.7243215268468201E-2</c:v>
                </c:pt>
                <c:pt idx="308">
                  <c:v>0.18850935750962799</c:v>
                </c:pt>
                <c:pt idx="309">
                  <c:v>1.6417229618928501E-2</c:v>
                </c:pt>
                <c:pt idx="310">
                  <c:v>0.21188227035035601</c:v>
                </c:pt>
                <c:pt idx="311">
                  <c:v>-0.30297761247947202</c:v>
                </c:pt>
                <c:pt idx="312">
                  <c:v>-0.97772302756635798</c:v>
                </c:pt>
                <c:pt idx="313">
                  <c:v>-0.17149033922836901</c:v>
                </c:pt>
                <c:pt idx="314">
                  <c:v>0.37788300909679201</c:v>
                </c:pt>
                <c:pt idx="315">
                  <c:v>0.100272474859308</c:v>
                </c:pt>
                <c:pt idx="316">
                  <c:v>-2.11719734179504E-2</c:v>
                </c:pt>
                <c:pt idx="317">
                  <c:v>0.54734672429224496</c:v>
                </c:pt>
                <c:pt idx="318">
                  <c:v>0.25081451731364401</c:v>
                </c:pt>
                <c:pt idx="319">
                  <c:v>-3.5266573077229801E-2</c:v>
                </c:pt>
                <c:pt idx="320">
                  <c:v>-0.52968006521996702</c:v>
                </c:pt>
                <c:pt idx="321">
                  <c:v>-0.36220986253701498</c:v>
                </c:pt>
                <c:pt idx="322">
                  <c:v>-8.5852506610125501E-2</c:v>
                </c:pt>
                <c:pt idx="323">
                  <c:v>-0.37291141703151798</c:v>
                </c:pt>
                <c:pt idx="324">
                  <c:v>-0.28553314640982802</c:v>
                </c:pt>
                <c:pt idx="325">
                  <c:v>0.187560370271043</c:v>
                </c:pt>
                <c:pt idx="326">
                  <c:v>0.37788300909679201</c:v>
                </c:pt>
                <c:pt idx="327">
                  <c:v>-0.42087472872069498</c:v>
                </c:pt>
                <c:pt idx="328">
                  <c:v>1.17370940753618E-2</c:v>
                </c:pt>
                <c:pt idx="329">
                  <c:v>0.115438358327205</c:v>
                </c:pt>
                <c:pt idx="330">
                  <c:v>0.25504757237776798</c:v>
                </c:pt>
                <c:pt idx="331">
                  <c:v>-0.50716736980338395</c:v>
                </c:pt>
                <c:pt idx="332">
                  <c:v>2.5979266685229801E-2</c:v>
                </c:pt>
                <c:pt idx="333">
                  <c:v>-0.102870034005489</c:v>
                </c:pt>
                <c:pt idx="334">
                  <c:v>-0.271506640753928</c:v>
                </c:pt>
                <c:pt idx="335">
                  <c:v>-8.0432049494890703E-2</c:v>
                </c:pt>
                <c:pt idx="336">
                  <c:v>-3.91045823205389E-2</c:v>
                </c:pt>
                <c:pt idx="337">
                  <c:v>-0.37142666365388299</c:v>
                </c:pt>
                <c:pt idx="338">
                  <c:v>-4.8318218910213297E-3</c:v>
                </c:pt>
                <c:pt idx="339">
                  <c:v>-0.32627006813236997</c:v>
                </c:pt>
                <c:pt idx="340">
                  <c:v>-7.9874197578909401E-2</c:v>
                </c:pt>
                <c:pt idx="341">
                  <c:v>-0.56977948660218403</c:v>
                </c:pt>
                <c:pt idx="342">
                  <c:v>-0.56977948660218403</c:v>
                </c:pt>
                <c:pt idx="343">
                  <c:v>-0.36541677205749501</c:v>
                </c:pt>
                <c:pt idx="344">
                  <c:v>-0.36541677205749501</c:v>
                </c:pt>
                <c:pt idx="345">
                  <c:v>-0.35484701950637698</c:v>
                </c:pt>
                <c:pt idx="346">
                  <c:v>-0.35484701950637698</c:v>
                </c:pt>
                <c:pt idx="347">
                  <c:v>-0.333178461729284</c:v>
                </c:pt>
                <c:pt idx="348">
                  <c:v>-0.131399401499836</c:v>
                </c:pt>
                <c:pt idx="349">
                  <c:v>-0.62345278964009199</c:v>
                </c:pt>
                <c:pt idx="350">
                  <c:v>-0.38696035088001801</c:v>
                </c:pt>
                <c:pt idx="351">
                  <c:v>-0.38696035088001801</c:v>
                </c:pt>
                <c:pt idx="352">
                  <c:v>-0.164783344379522</c:v>
                </c:pt>
                <c:pt idx="353">
                  <c:v>-0.164783344379522</c:v>
                </c:pt>
                <c:pt idx="354">
                  <c:v>-8.7719045034647503E-2</c:v>
                </c:pt>
                <c:pt idx="355">
                  <c:v>-8.7719045034647503E-2</c:v>
                </c:pt>
                <c:pt idx="356">
                  <c:v>-0.203137100926501</c:v>
                </c:pt>
                <c:pt idx="357">
                  <c:v>-0.19432224256314701</c:v>
                </c:pt>
                <c:pt idx="358">
                  <c:v>-7.9690404012598401E-2</c:v>
                </c:pt>
                <c:pt idx="359">
                  <c:v>-7.2448911928011797E-2</c:v>
                </c:pt>
                <c:pt idx="360">
                  <c:v>6.0805919600636603E-2</c:v>
                </c:pt>
                <c:pt idx="361">
                  <c:v>-0.30969509611988499</c:v>
                </c:pt>
                <c:pt idx="362">
                  <c:v>0.12591761408764801</c:v>
                </c:pt>
                <c:pt idx="363">
                  <c:v>-0.49817868144017102</c:v>
                </c:pt>
                <c:pt idx="364">
                  <c:v>0.37742878574014699</c:v>
                </c:pt>
                <c:pt idx="365">
                  <c:v>-0.42851591257489402</c:v>
                </c:pt>
                <c:pt idx="366">
                  <c:v>-8.6237935231378293E-2</c:v>
                </c:pt>
                <c:pt idx="367">
                  <c:v>8.3188825583643294E-2</c:v>
                </c:pt>
                <c:pt idx="368">
                  <c:v>7.21515508755943E-2</c:v>
                </c:pt>
                <c:pt idx="369">
                  <c:v>0.10948617457275001</c:v>
                </c:pt>
                <c:pt idx="370">
                  <c:v>-0.262893185464109</c:v>
                </c:pt>
                <c:pt idx="371">
                  <c:v>0.15599891464344701</c:v>
                </c:pt>
                <c:pt idx="372">
                  <c:v>9.1554315282268706E-2</c:v>
                </c:pt>
                <c:pt idx="373">
                  <c:v>-9.0056537683018398E-2</c:v>
                </c:pt>
                <c:pt idx="374">
                  <c:v>-0.142766694482093</c:v>
                </c:pt>
                <c:pt idx="375">
                  <c:v>0.63067928884698599</c:v>
                </c:pt>
                <c:pt idx="376">
                  <c:v>-0.39155276653755799</c:v>
                </c:pt>
                <c:pt idx="377">
                  <c:v>-5.2450814339690302E-2</c:v>
                </c:pt>
                <c:pt idx="378">
                  <c:v>0.29253507559388298</c:v>
                </c:pt>
                <c:pt idx="379">
                  <c:v>0.12618100195617499</c:v>
                </c:pt>
                <c:pt idx="380">
                  <c:v>-5.5381819976379601E-2</c:v>
                </c:pt>
                <c:pt idx="381">
                  <c:v>0.58484515843315699</c:v>
                </c:pt>
                <c:pt idx="382">
                  <c:v>0.250041344361284</c:v>
                </c:pt>
                <c:pt idx="383">
                  <c:v>0.22365847328963401</c:v>
                </c:pt>
                <c:pt idx="384">
                  <c:v>0.26497042456952602</c:v>
                </c:pt>
                <c:pt idx="385">
                  <c:v>-0.56492365171179304</c:v>
                </c:pt>
                <c:pt idx="386">
                  <c:v>-0.56492365171179304</c:v>
                </c:pt>
                <c:pt idx="387">
                  <c:v>-5.4455985741183897E-2</c:v>
                </c:pt>
                <c:pt idx="388">
                  <c:v>-5.4455985741183897E-2</c:v>
                </c:pt>
                <c:pt idx="389">
                  <c:v>-0.19410004150563701</c:v>
                </c:pt>
                <c:pt idx="390">
                  <c:v>-0.38950872199033398</c:v>
                </c:pt>
                <c:pt idx="391">
                  <c:v>-0.52115459571947098</c:v>
                </c:pt>
                <c:pt idx="392">
                  <c:v>-4.0886906040839902E-2</c:v>
                </c:pt>
                <c:pt idx="393">
                  <c:v>-0.336186410606168</c:v>
                </c:pt>
                <c:pt idx="394">
                  <c:v>0.548962323310344</c:v>
                </c:pt>
                <c:pt idx="395">
                  <c:v>8.6242366983716595E-2</c:v>
                </c:pt>
                <c:pt idx="396">
                  <c:v>0.368691767471924</c:v>
                </c:pt>
                <c:pt idx="397">
                  <c:v>-0.10397833307767999</c:v>
                </c:pt>
                <c:pt idx="398">
                  <c:v>-0.27920023799238503</c:v>
                </c:pt>
                <c:pt idx="399">
                  <c:v>-0.24631832238867299</c:v>
                </c:pt>
                <c:pt idx="400">
                  <c:v>-0.17691151335550701</c:v>
                </c:pt>
                <c:pt idx="401">
                  <c:v>-0.19432762460070399</c:v>
                </c:pt>
                <c:pt idx="402">
                  <c:v>-0.40518014406108899</c:v>
                </c:pt>
                <c:pt idx="403">
                  <c:v>-0.31786227664834998</c:v>
                </c:pt>
                <c:pt idx="404">
                  <c:v>-0.28308926322585698</c:v>
                </c:pt>
                <c:pt idx="405">
                  <c:v>-0.34900346669427901</c:v>
                </c:pt>
                <c:pt idx="406">
                  <c:v>-0.27549858573750802</c:v>
                </c:pt>
                <c:pt idx="407">
                  <c:v>-0.23125074080513799</c:v>
                </c:pt>
                <c:pt idx="408">
                  <c:v>-0.40047317589100101</c:v>
                </c:pt>
                <c:pt idx="409">
                  <c:v>-0.26395273338344999</c:v>
                </c:pt>
                <c:pt idx="410">
                  <c:v>-0.41684599077206302</c:v>
                </c:pt>
                <c:pt idx="411">
                  <c:v>-0.54065913580915803</c:v>
                </c:pt>
                <c:pt idx="412">
                  <c:v>8.85014943672046E-2</c:v>
                </c:pt>
                <c:pt idx="413">
                  <c:v>-0.59202724685927699</c:v>
                </c:pt>
                <c:pt idx="414">
                  <c:v>-0.40957937936616101</c:v>
                </c:pt>
                <c:pt idx="415">
                  <c:v>0.120571193068316</c:v>
                </c:pt>
                <c:pt idx="416">
                  <c:v>-0.17075098244489301</c:v>
                </c:pt>
                <c:pt idx="417">
                  <c:v>-0.20245319657427299</c:v>
                </c:pt>
                <c:pt idx="418">
                  <c:v>-0.23360238460517899</c:v>
                </c:pt>
                <c:pt idx="419">
                  <c:v>-0.125721171159623</c:v>
                </c:pt>
                <c:pt idx="420">
                  <c:v>-0.128850086322462</c:v>
                </c:pt>
                <c:pt idx="421">
                  <c:v>3.0032561207125202E-2</c:v>
                </c:pt>
                <c:pt idx="422">
                  <c:v>-0.40671554456412601</c:v>
                </c:pt>
                <c:pt idx="423">
                  <c:v>-0.46989801743166598</c:v>
                </c:pt>
                <c:pt idx="424">
                  <c:v>-0.48223430554517699</c:v>
                </c:pt>
                <c:pt idx="425">
                  <c:v>-0.14944403994633801</c:v>
                </c:pt>
                <c:pt idx="426">
                  <c:v>-0.28134262883441402</c:v>
                </c:pt>
                <c:pt idx="427">
                  <c:v>-0.27611799172917501</c:v>
                </c:pt>
                <c:pt idx="428">
                  <c:v>4.68717614075339E-2</c:v>
                </c:pt>
                <c:pt idx="429">
                  <c:v>-1.8656778747265901E-2</c:v>
                </c:pt>
                <c:pt idx="430">
                  <c:v>-0.189440384531817</c:v>
                </c:pt>
                <c:pt idx="431">
                  <c:v>3.6302092839410098E-2</c:v>
                </c:pt>
                <c:pt idx="432">
                  <c:v>-7.8049129499973099E-2</c:v>
                </c:pt>
                <c:pt idx="433">
                  <c:v>-0.12725026215315099</c:v>
                </c:pt>
                <c:pt idx="434">
                  <c:v>-0.25486471111599501</c:v>
                </c:pt>
                <c:pt idx="435">
                  <c:v>-0.13467679838972499</c:v>
                </c:pt>
                <c:pt idx="436">
                  <c:v>-0.13942473999727201</c:v>
                </c:pt>
                <c:pt idx="437">
                  <c:v>4.3301369061533999E-2</c:v>
                </c:pt>
                <c:pt idx="438">
                  <c:v>4.0988197567626797E-2</c:v>
                </c:pt>
                <c:pt idx="439">
                  <c:v>-0.103825664313212</c:v>
                </c:pt>
                <c:pt idx="440">
                  <c:v>-5.2966021353728999E-2</c:v>
                </c:pt>
                <c:pt idx="441">
                  <c:v>-0.41352090708054001</c:v>
                </c:pt>
                <c:pt idx="442">
                  <c:v>0.142742854987366</c:v>
                </c:pt>
                <c:pt idx="443">
                  <c:v>-0.15659319141564501</c:v>
                </c:pt>
                <c:pt idx="444">
                  <c:v>-0.12845426982052599</c:v>
                </c:pt>
                <c:pt idx="445">
                  <c:v>6.1355316224098101E-2</c:v>
                </c:pt>
                <c:pt idx="446">
                  <c:v>-0.113624015217355</c:v>
                </c:pt>
                <c:pt idx="447">
                  <c:v>4.8833001330097102E-3</c:v>
                </c:pt>
                <c:pt idx="448">
                  <c:v>0.72659977186660896</c:v>
                </c:pt>
                <c:pt idx="449">
                  <c:v>-0.17259879973588399</c:v>
                </c:pt>
                <c:pt idx="450">
                  <c:v>-0.28617146650519398</c:v>
                </c:pt>
                <c:pt idx="451">
                  <c:v>-0.94926319795465797</c:v>
                </c:pt>
                <c:pt idx="452">
                  <c:v>7.4633514456888803E-2</c:v>
                </c:pt>
                <c:pt idx="453">
                  <c:v>-6.17336837254195E-2</c:v>
                </c:pt>
                <c:pt idx="454">
                  <c:v>-0.20757569004919399</c:v>
                </c:pt>
                <c:pt idx="455">
                  <c:v>-0.17865551149213599</c:v>
                </c:pt>
                <c:pt idx="456">
                  <c:v>9.8993569441141099E-2</c:v>
                </c:pt>
                <c:pt idx="457">
                  <c:v>-0.28577861198652299</c:v>
                </c:pt>
                <c:pt idx="458">
                  <c:v>-0.27690517708050799</c:v>
                </c:pt>
                <c:pt idx="459">
                  <c:v>-0.20949913022817501</c:v>
                </c:pt>
                <c:pt idx="460">
                  <c:v>-9.3582168010783201E-2</c:v>
                </c:pt>
                <c:pt idx="461">
                  <c:v>-8.78109202187001E-2</c:v>
                </c:pt>
                <c:pt idx="462">
                  <c:v>-0.47327335633036899</c:v>
                </c:pt>
                <c:pt idx="463">
                  <c:v>-0.37017149759044898</c:v>
                </c:pt>
                <c:pt idx="464">
                  <c:v>-0.111353660063117</c:v>
                </c:pt>
                <c:pt idx="465">
                  <c:v>0.11074637018674501</c:v>
                </c:pt>
                <c:pt idx="466">
                  <c:v>0.22037435304560599</c:v>
                </c:pt>
                <c:pt idx="467">
                  <c:v>-6.8026989109816902E-2</c:v>
                </c:pt>
                <c:pt idx="468">
                  <c:v>-9.8391904574529301E-2</c:v>
                </c:pt>
                <c:pt idx="469">
                  <c:v>-0.562371827260987</c:v>
                </c:pt>
                <c:pt idx="470">
                  <c:v>1.7190925947980201E-2</c:v>
                </c:pt>
                <c:pt idx="471">
                  <c:v>2.4660021398309601E-2</c:v>
                </c:pt>
                <c:pt idx="472">
                  <c:v>-0.24005047880417299</c:v>
                </c:pt>
                <c:pt idx="473">
                  <c:v>-0.13946775411950299</c:v>
                </c:pt>
                <c:pt idx="474">
                  <c:v>7.8207993205944001E-2</c:v>
                </c:pt>
                <c:pt idx="475">
                  <c:v>-0.125665609020918</c:v>
                </c:pt>
                <c:pt idx="476">
                  <c:v>-0.66908929569144304</c:v>
                </c:pt>
                <c:pt idx="477">
                  <c:v>-0.73607646692877204</c:v>
                </c:pt>
                <c:pt idx="478">
                  <c:v>0.59756555272028999</c:v>
                </c:pt>
                <c:pt idx="479">
                  <c:v>-4.7294271172882998E-2</c:v>
                </c:pt>
                <c:pt idx="480">
                  <c:v>8.1151233062265196E-2</c:v>
                </c:pt>
                <c:pt idx="481">
                  <c:v>-0.14330747953967601</c:v>
                </c:pt>
                <c:pt idx="482">
                  <c:v>-1.5504335569713601</c:v>
                </c:pt>
                <c:pt idx="483">
                  <c:v>-0.19088912689103199</c:v>
                </c:pt>
                <c:pt idx="484">
                  <c:v>0.39702070272544998</c:v>
                </c:pt>
                <c:pt idx="485">
                  <c:v>-0.17753395185108001</c:v>
                </c:pt>
                <c:pt idx="486">
                  <c:v>-0.17095007818637301</c:v>
                </c:pt>
                <c:pt idx="487">
                  <c:v>-0.23345888400812101</c:v>
                </c:pt>
                <c:pt idx="488">
                  <c:v>-8.5424603014734896E-2</c:v>
                </c:pt>
                <c:pt idx="489">
                  <c:v>-0.52886040708113902</c:v>
                </c:pt>
                <c:pt idx="490">
                  <c:v>-5.2979264789993201E-2</c:v>
                </c:pt>
                <c:pt idx="491">
                  <c:v>5.8976607915085799E-2</c:v>
                </c:pt>
                <c:pt idx="492">
                  <c:v>-9.1584002495639499E-2</c:v>
                </c:pt>
                <c:pt idx="493">
                  <c:v>-0.121660607150415</c:v>
                </c:pt>
                <c:pt idx="494">
                  <c:v>7.3313096396142197E-2</c:v>
                </c:pt>
                <c:pt idx="495">
                  <c:v>-0.17191611887334701</c:v>
                </c:pt>
                <c:pt idx="496">
                  <c:v>0.35495065234163098</c:v>
                </c:pt>
                <c:pt idx="497">
                  <c:v>0.14004877048039799</c:v>
                </c:pt>
                <c:pt idx="498">
                  <c:v>-0.56028958520485805</c:v>
                </c:pt>
                <c:pt idx="499">
                  <c:v>-0.22921144309578401</c:v>
                </c:pt>
                <c:pt idx="500">
                  <c:v>0.42960156170876601</c:v>
                </c:pt>
                <c:pt idx="501">
                  <c:v>0.102042823156676</c:v>
                </c:pt>
                <c:pt idx="502">
                  <c:v>3.26685945447052E-2</c:v>
                </c:pt>
                <c:pt idx="503">
                  <c:v>0.14200208483013399</c:v>
                </c:pt>
                <c:pt idx="504">
                  <c:v>4.0622867724683397E-2</c:v>
                </c:pt>
                <c:pt idx="505">
                  <c:v>0.27504371298156399</c:v>
                </c:pt>
                <c:pt idx="506">
                  <c:v>0.22706537416158401</c:v>
                </c:pt>
                <c:pt idx="507">
                  <c:v>0.246774288614314</c:v>
                </c:pt>
                <c:pt idx="508">
                  <c:v>0.26438451723904699</c:v>
                </c:pt>
                <c:pt idx="509">
                  <c:v>0.103934326862967</c:v>
                </c:pt>
                <c:pt idx="510">
                  <c:v>-0.254182347338755</c:v>
                </c:pt>
                <c:pt idx="511">
                  <c:v>-0.25101504996470098</c:v>
                </c:pt>
                <c:pt idx="512">
                  <c:v>-3.20039552940743E-2</c:v>
                </c:pt>
                <c:pt idx="513">
                  <c:v>-0.27642253045187798</c:v>
                </c:pt>
                <c:pt idx="514">
                  <c:v>-0.118180868822612</c:v>
                </c:pt>
                <c:pt idx="515">
                  <c:v>-7.0316955370651399E-2</c:v>
                </c:pt>
                <c:pt idx="516">
                  <c:v>-9.2725691958720102E-2</c:v>
                </c:pt>
                <c:pt idx="517">
                  <c:v>-0.124662274541496</c:v>
                </c:pt>
                <c:pt idx="518">
                  <c:v>0.118065400997535</c:v>
                </c:pt>
                <c:pt idx="519">
                  <c:v>8.9021197373482505E-2</c:v>
                </c:pt>
                <c:pt idx="520">
                  <c:v>-0.40526245971028602</c:v>
                </c:pt>
                <c:pt idx="521">
                  <c:v>-6.2966720365394404E-3</c:v>
                </c:pt>
                <c:pt idx="522">
                  <c:v>-0.311667912348781</c:v>
                </c:pt>
                <c:pt idx="523">
                  <c:v>-8.0438218104457102E-2</c:v>
                </c:pt>
                <c:pt idx="524">
                  <c:v>-0.15400946361724999</c:v>
                </c:pt>
                <c:pt idx="525">
                  <c:v>-0.14844734695742401</c:v>
                </c:pt>
                <c:pt idx="526">
                  <c:v>-0.104018615795631</c:v>
                </c:pt>
                <c:pt idx="527">
                  <c:v>-0.410480067877177</c:v>
                </c:pt>
                <c:pt idx="528">
                  <c:v>-6.6680009550735803E-2</c:v>
                </c:pt>
                <c:pt idx="529">
                  <c:v>-0.213666919139678</c:v>
                </c:pt>
                <c:pt idx="530">
                  <c:v>-0.27506091249204601</c:v>
                </c:pt>
                <c:pt idx="531">
                  <c:v>6.6477872341701202E-2</c:v>
                </c:pt>
                <c:pt idx="532">
                  <c:v>-0.23239534777545701</c:v>
                </c:pt>
                <c:pt idx="533">
                  <c:v>-0.19058237444156501</c:v>
                </c:pt>
                <c:pt idx="534">
                  <c:v>-0.54071066241560095</c:v>
                </c:pt>
                <c:pt idx="535">
                  <c:v>-0.21981109639455099</c:v>
                </c:pt>
                <c:pt idx="536">
                  <c:v>-4.1919285341518703E-2</c:v>
                </c:pt>
                <c:pt idx="537">
                  <c:v>-0.10916912581004901</c:v>
                </c:pt>
                <c:pt idx="538">
                  <c:v>9.6170815819534503E-3</c:v>
                </c:pt>
                <c:pt idx="539">
                  <c:v>-0.12555761029041099</c:v>
                </c:pt>
                <c:pt idx="540">
                  <c:v>-0.150636069936708</c:v>
                </c:pt>
                <c:pt idx="541">
                  <c:v>-0.22014665607474401</c:v>
                </c:pt>
                <c:pt idx="542">
                  <c:v>-0.10011321360702199</c:v>
                </c:pt>
                <c:pt idx="543">
                  <c:v>-0.209356984477018</c:v>
                </c:pt>
                <c:pt idx="544">
                  <c:v>-0.49725509993629202</c:v>
                </c:pt>
                <c:pt idx="545">
                  <c:v>-0.17425866692160299</c:v>
                </c:pt>
                <c:pt idx="546">
                  <c:v>-0.20670660928128901</c:v>
                </c:pt>
                <c:pt idx="547">
                  <c:v>-6.8815081479880399E-2</c:v>
                </c:pt>
                <c:pt idx="548">
                  <c:v>-0.27659032114525001</c:v>
                </c:pt>
                <c:pt idx="549">
                  <c:v>-4.2450600479133502E-2</c:v>
                </c:pt>
                <c:pt idx="550">
                  <c:v>-0.13725012012784699</c:v>
                </c:pt>
                <c:pt idx="551">
                  <c:v>-9.9006578564523301E-2</c:v>
                </c:pt>
                <c:pt idx="552">
                  <c:v>-0.17742120643711501</c:v>
                </c:pt>
                <c:pt idx="553">
                  <c:v>-0.223006076682777</c:v>
                </c:pt>
                <c:pt idx="554">
                  <c:v>-4.1038741444375498E-2</c:v>
                </c:pt>
                <c:pt idx="555">
                  <c:v>-0.33146279539861401</c:v>
                </c:pt>
                <c:pt idx="556">
                  <c:v>-0.223689841532344</c:v>
                </c:pt>
                <c:pt idx="557">
                  <c:v>0.37515840423559299</c:v>
                </c:pt>
                <c:pt idx="558">
                  <c:v>-0.216746997411701</c:v>
                </c:pt>
                <c:pt idx="559">
                  <c:v>7.2281429934354102E-2</c:v>
                </c:pt>
                <c:pt idx="560">
                  <c:v>2.6084135616703402E-2</c:v>
                </c:pt>
                <c:pt idx="561">
                  <c:v>-5.7222667348697201E-2</c:v>
                </c:pt>
                <c:pt idx="562">
                  <c:v>0.109617395215203</c:v>
                </c:pt>
                <c:pt idx="563">
                  <c:v>-0.18911086812712599</c:v>
                </c:pt>
                <c:pt idx="564">
                  <c:v>4.4062115690783801E-3</c:v>
                </c:pt>
                <c:pt idx="565">
                  <c:v>-4.5094434871496503E-2</c:v>
                </c:pt>
                <c:pt idx="566">
                  <c:v>0.32897087975737899</c:v>
                </c:pt>
                <c:pt idx="567">
                  <c:v>0.38628702425887301</c:v>
                </c:pt>
                <c:pt idx="568">
                  <c:v>-0.35493689185447203</c:v>
                </c:pt>
                <c:pt idx="569">
                  <c:v>-0.32509518096136297</c:v>
                </c:pt>
                <c:pt idx="570">
                  <c:v>-0.31256674515920002</c:v>
                </c:pt>
                <c:pt idx="571">
                  <c:v>-0.43590569684478297</c:v>
                </c:pt>
                <c:pt idx="572">
                  <c:v>-7.2110804744087806E-2</c:v>
                </c:pt>
                <c:pt idx="573">
                  <c:v>-0.16994132279591301</c:v>
                </c:pt>
                <c:pt idx="574">
                  <c:v>-0.24017803464163201</c:v>
                </c:pt>
                <c:pt idx="575">
                  <c:v>-0.25943653467552302</c:v>
                </c:pt>
                <c:pt idx="576">
                  <c:v>-0.27379414526053297</c:v>
                </c:pt>
                <c:pt idx="577">
                  <c:v>-0.12700703990318099</c:v>
                </c:pt>
                <c:pt idx="578">
                  <c:v>-0.1216436585659</c:v>
                </c:pt>
                <c:pt idx="579">
                  <c:v>-0.477260048782923</c:v>
                </c:pt>
                <c:pt idx="580">
                  <c:v>-0.37122250914695498</c:v>
                </c:pt>
                <c:pt idx="581">
                  <c:v>-0.31011654465572303</c:v>
                </c:pt>
                <c:pt idx="582">
                  <c:v>-0.19693889070798101</c:v>
                </c:pt>
                <c:pt idx="583">
                  <c:v>-2.68208500703065E-2</c:v>
                </c:pt>
                <c:pt idx="584">
                  <c:v>-0.23627738580712801</c:v>
                </c:pt>
                <c:pt idx="585">
                  <c:v>-0.43007804936843902</c:v>
                </c:pt>
                <c:pt idx="586">
                  <c:v>-0.28719442293553099</c:v>
                </c:pt>
                <c:pt idx="587">
                  <c:v>-0.36866283488827001</c:v>
                </c:pt>
                <c:pt idx="588">
                  <c:v>-0.248374497447474</c:v>
                </c:pt>
                <c:pt idx="589">
                  <c:v>-4.4052359354271202E-2</c:v>
                </c:pt>
                <c:pt idx="590">
                  <c:v>-0.23535101075702899</c:v>
                </c:pt>
                <c:pt idx="591">
                  <c:v>-0.34309873845348798</c:v>
                </c:pt>
                <c:pt idx="592">
                  <c:v>0.175665756797172</c:v>
                </c:pt>
                <c:pt idx="593">
                  <c:v>-0.13990118703160301</c:v>
                </c:pt>
                <c:pt idx="594">
                  <c:v>-0.17031650620479299</c:v>
                </c:pt>
                <c:pt idx="595">
                  <c:v>-8.7436243696044705E-2</c:v>
                </c:pt>
                <c:pt idx="596">
                  <c:v>-0.120334378833915</c:v>
                </c:pt>
                <c:pt idx="597">
                  <c:v>-0.35502987731736901</c:v>
                </c:pt>
                <c:pt idx="598">
                  <c:v>-0.321143326159121</c:v>
                </c:pt>
                <c:pt idx="599">
                  <c:v>-0.15087801361519801</c:v>
                </c:pt>
                <c:pt idx="600">
                  <c:v>-8.5603597549770497E-2</c:v>
                </c:pt>
                <c:pt idx="601">
                  <c:v>-0.16308356034968199</c:v>
                </c:pt>
                <c:pt idx="602">
                  <c:v>-0.31511380427619901</c:v>
                </c:pt>
                <c:pt idx="603">
                  <c:v>-0.113804753288164</c:v>
                </c:pt>
                <c:pt idx="604">
                  <c:v>0.135623886717541</c:v>
                </c:pt>
                <c:pt idx="605">
                  <c:v>-0.21896177137741499</c:v>
                </c:pt>
                <c:pt idx="606">
                  <c:v>-0.43805080071755997</c:v>
                </c:pt>
                <c:pt idx="607">
                  <c:v>-0.349787508592597</c:v>
                </c:pt>
                <c:pt idx="608">
                  <c:v>-2.4679213228558101E-2</c:v>
                </c:pt>
                <c:pt idx="609">
                  <c:v>-0.46179636247069</c:v>
                </c:pt>
                <c:pt idx="610">
                  <c:v>-0.449764086052861</c:v>
                </c:pt>
                <c:pt idx="611">
                  <c:v>-0.59766079798916105</c:v>
                </c:pt>
                <c:pt idx="612">
                  <c:v>-0.38785865626045801</c:v>
                </c:pt>
                <c:pt idx="613">
                  <c:v>-0.42967665353002599</c:v>
                </c:pt>
                <c:pt idx="614">
                  <c:v>-0.468684354838594</c:v>
                </c:pt>
                <c:pt idx="615">
                  <c:v>-0.43177741291476701</c:v>
                </c:pt>
                <c:pt idx="616">
                  <c:v>-0.53712322691277004</c:v>
                </c:pt>
                <c:pt idx="617">
                  <c:v>-0.36876271806284999</c:v>
                </c:pt>
                <c:pt idx="618">
                  <c:v>-0.106582914905093</c:v>
                </c:pt>
                <c:pt idx="619">
                  <c:v>-0.480486412204991</c:v>
                </c:pt>
                <c:pt idx="620">
                  <c:v>-0.34968438909939198</c:v>
                </c:pt>
                <c:pt idx="621">
                  <c:v>8.4550718212545894E-2</c:v>
                </c:pt>
                <c:pt idx="622">
                  <c:v>-0.25854878910638901</c:v>
                </c:pt>
                <c:pt idx="623">
                  <c:v>-0.26051959278407499</c:v>
                </c:pt>
                <c:pt idx="624">
                  <c:v>-0.43643037483651498</c:v>
                </c:pt>
                <c:pt idx="625">
                  <c:v>-0.37506170116926901</c:v>
                </c:pt>
                <c:pt idx="626">
                  <c:v>-0.42189015000938201</c:v>
                </c:pt>
                <c:pt idx="627">
                  <c:v>-0.35385960566791302</c:v>
                </c:pt>
                <c:pt idx="628">
                  <c:v>-0.41824364720578999</c:v>
                </c:pt>
                <c:pt idx="629">
                  <c:v>-0.412212794535879</c:v>
                </c:pt>
                <c:pt idx="630">
                  <c:v>-0.39611516408347103</c:v>
                </c:pt>
                <c:pt idx="631">
                  <c:v>-0.42365939571811401</c:v>
                </c:pt>
                <c:pt idx="632">
                  <c:v>-0.29580981042875798</c:v>
                </c:pt>
                <c:pt idx="633">
                  <c:v>-0.20725087493123001</c:v>
                </c:pt>
                <c:pt idx="634">
                  <c:v>-0.20018609316432801</c:v>
                </c:pt>
                <c:pt idx="635">
                  <c:v>-0.21019409849339701</c:v>
                </c:pt>
                <c:pt idx="636">
                  <c:v>-0.13320743049964801</c:v>
                </c:pt>
                <c:pt idx="637">
                  <c:v>-0.17204336370574499</c:v>
                </c:pt>
                <c:pt idx="638">
                  <c:v>-9.8921469546274704E-2</c:v>
                </c:pt>
                <c:pt idx="639">
                  <c:v>5.3533107870876603E-2</c:v>
                </c:pt>
                <c:pt idx="640">
                  <c:v>-0.43622492052453299</c:v>
                </c:pt>
                <c:pt idx="641">
                  <c:v>1.9666406444896301E-2</c:v>
                </c:pt>
                <c:pt idx="642">
                  <c:v>1.6743325758611E-2</c:v>
                </c:pt>
                <c:pt idx="643">
                  <c:v>-0.13364531301233201</c:v>
                </c:pt>
                <c:pt idx="644">
                  <c:v>-0.57842193658700303</c:v>
                </c:pt>
                <c:pt idx="645">
                  <c:v>-0.32372916800028101</c:v>
                </c:pt>
                <c:pt idx="646">
                  <c:v>-0.29459844262642099</c:v>
                </c:pt>
                <c:pt idx="647">
                  <c:v>-0.18214976812292499</c:v>
                </c:pt>
                <c:pt idx="648">
                  <c:v>-0.13568055066055201</c:v>
                </c:pt>
                <c:pt idx="649">
                  <c:v>-8.3961747229900005E-2</c:v>
                </c:pt>
                <c:pt idx="650">
                  <c:v>-2.6463739615760599E-2</c:v>
                </c:pt>
                <c:pt idx="651">
                  <c:v>-0.29950655808663001</c:v>
                </c:pt>
                <c:pt idx="652">
                  <c:v>-8.0922220910196602E-2</c:v>
                </c:pt>
                <c:pt idx="653">
                  <c:v>-0.359309816597984</c:v>
                </c:pt>
                <c:pt idx="654">
                  <c:v>-0.31557495975637401</c:v>
                </c:pt>
                <c:pt idx="655">
                  <c:v>-0.20888848288959599</c:v>
                </c:pt>
                <c:pt idx="656">
                  <c:v>-0.11161988455600499</c:v>
                </c:pt>
                <c:pt idx="657">
                  <c:v>-0.231721000042622</c:v>
                </c:pt>
                <c:pt idx="658">
                  <c:v>-0.52923214690317499</c:v>
                </c:pt>
                <c:pt idx="659">
                  <c:v>-0.35465647261211602</c:v>
                </c:pt>
                <c:pt idx="660">
                  <c:v>-0.16314467171706501</c:v>
                </c:pt>
                <c:pt idx="661">
                  <c:v>-0.14861390229392599</c:v>
                </c:pt>
                <c:pt idx="662">
                  <c:v>-0.132053753490502</c:v>
                </c:pt>
                <c:pt idx="663">
                  <c:v>-0.11711634802648201</c:v>
                </c:pt>
                <c:pt idx="664">
                  <c:v>-0.107169199101096</c:v>
                </c:pt>
                <c:pt idx="665">
                  <c:v>-0.17877065924681801</c:v>
                </c:pt>
                <c:pt idx="666">
                  <c:v>-6.6190718706601107E-2</c:v>
                </c:pt>
                <c:pt idx="667">
                  <c:v>-0.12552585876368999</c:v>
                </c:pt>
                <c:pt idx="668">
                  <c:v>-0.24940363334749499</c:v>
                </c:pt>
                <c:pt idx="669">
                  <c:v>2.8833583869591301E-2</c:v>
                </c:pt>
                <c:pt idx="670">
                  <c:v>2.6698976308825499E-2</c:v>
                </c:pt>
                <c:pt idx="671">
                  <c:v>-0.17728476764380499</c:v>
                </c:pt>
                <c:pt idx="672">
                  <c:v>-0.36747974403915301</c:v>
                </c:pt>
                <c:pt idx="673">
                  <c:v>-0.19979080151223599</c:v>
                </c:pt>
                <c:pt idx="674">
                  <c:v>-0.53944320826764802</c:v>
                </c:pt>
                <c:pt idx="675">
                  <c:v>-0.163698607001423</c:v>
                </c:pt>
                <c:pt idx="676">
                  <c:v>-0.11948704331121</c:v>
                </c:pt>
                <c:pt idx="677">
                  <c:v>0.125370932659531</c:v>
                </c:pt>
                <c:pt idx="678">
                  <c:v>-0.234584465375614</c:v>
                </c:pt>
                <c:pt idx="679">
                  <c:v>-0.193920994866466</c:v>
                </c:pt>
                <c:pt idx="680">
                  <c:v>-0.282216912089917</c:v>
                </c:pt>
                <c:pt idx="681">
                  <c:v>-0.16225261417891401</c:v>
                </c:pt>
                <c:pt idx="682">
                  <c:v>-0.25991003336872698</c:v>
                </c:pt>
                <c:pt idx="683">
                  <c:v>-0.19012018340637199</c:v>
                </c:pt>
                <c:pt idx="684">
                  <c:v>-0.347220518021577</c:v>
                </c:pt>
                <c:pt idx="685">
                  <c:v>-0.198708356137307</c:v>
                </c:pt>
                <c:pt idx="686">
                  <c:v>-0.16754810231335299</c:v>
                </c:pt>
                <c:pt idx="687">
                  <c:v>0.21428108760597001</c:v>
                </c:pt>
                <c:pt idx="688">
                  <c:v>-0.18218889908762301</c:v>
                </c:pt>
                <c:pt idx="689">
                  <c:v>-7.1276424466930305E-2</c:v>
                </c:pt>
                <c:pt idx="690">
                  <c:v>-0.229822171276511</c:v>
                </c:pt>
                <c:pt idx="691">
                  <c:v>-0.222764474339776</c:v>
                </c:pt>
                <c:pt idx="692">
                  <c:v>-0.22459267683654399</c:v>
                </c:pt>
                <c:pt idx="693">
                  <c:v>-0.167350781697468</c:v>
                </c:pt>
                <c:pt idx="694">
                  <c:v>-0.13203479639204499</c:v>
                </c:pt>
                <c:pt idx="695">
                  <c:v>-0.23455868459595</c:v>
                </c:pt>
                <c:pt idx="696">
                  <c:v>-0.12852341344728099</c:v>
                </c:pt>
                <c:pt idx="697">
                  <c:v>-8.0901107767718694E-2</c:v>
                </c:pt>
                <c:pt idx="698">
                  <c:v>-0.24691927823555199</c:v>
                </c:pt>
                <c:pt idx="699">
                  <c:v>-0.15651123060230401</c:v>
                </c:pt>
                <c:pt idx="700">
                  <c:v>0.13595602808181301</c:v>
                </c:pt>
                <c:pt idx="701">
                  <c:v>-0.141011078054777</c:v>
                </c:pt>
                <c:pt idx="702">
                  <c:v>-0.22042235031221699</c:v>
                </c:pt>
                <c:pt idx="703">
                  <c:v>-0.203553331650416</c:v>
                </c:pt>
                <c:pt idx="704">
                  <c:v>-0.178744428692064</c:v>
                </c:pt>
                <c:pt idx="705">
                  <c:v>-0.27883314637185402</c:v>
                </c:pt>
                <c:pt idx="706">
                  <c:v>-0.257940455574727</c:v>
                </c:pt>
                <c:pt idx="707">
                  <c:v>-0.28003453490486202</c:v>
                </c:pt>
                <c:pt idx="708">
                  <c:v>-0.17729351644853</c:v>
                </c:pt>
                <c:pt idx="709">
                  <c:v>-4.5035602813510101E-2</c:v>
                </c:pt>
                <c:pt idx="710">
                  <c:v>-0.18092668021558</c:v>
                </c:pt>
                <c:pt idx="711">
                  <c:v>-0.170305741720195</c:v>
                </c:pt>
                <c:pt idx="712">
                  <c:v>-0.210984779981569</c:v>
                </c:pt>
                <c:pt idx="713">
                  <c:v>-0.24265718509468401</c:v>
                </c:pt>
                <c:pt idx="714">
                  <c:v>-0.341613314809043</c:v>
                </c:pt>
                <c:pt idx="715">
                  <c:v>-0.15009997537675501</c:v>
                </c:pt>
                <c:pt idx="716">
                  <c:v>-0.108866948089707</c:v>
                </c:pt>
                <c:pt idx="717">
                  <c:v>-0.252107460217256</c:v>
                </c:pt>
                <c:pt idx="718">
                  <c:v>-0.215109121981607</c:v>
                </c:pt>
                <c:pt idx="719">
                  <c:v>1.7342133399648602E-2</c:v>
                </c:pt>
                <c:pt idx="720">
                  <c:v>-0.287795728746709</c:v>
                </c:pt>
                <c:pt idx="721">
                  <c:v>-9.0135599820255305E-2</c:v>
                </c:pt>
                <c:pt idx="722">
                  <c:v>-0.34627526256735403</c:v>
                </c:pt>
                <c:pt idx="723">
                  <c:v>0.116468868341079</c:v>
                </c:pt>
                <c:pt idx="724">
                  <c:v>-0.21771660193356701</c:v>
                </c:pt>
                <c:pt idx="725">
                  <c:v>-4.4046378488544001E-2</c:v>
                </c:pt>
                <c:pt idx="726">
                  <c:v>-0.38518057818817297</c:v>
                </c:pt>
                <c:pt idx="727">
                  <c:v>-0.22037078327770299</c:v>
                </c:pt>
                <c:pt idx="728">
                  <c:v>-7.8155912697073698E-2</c:v>
                </c:pt>
                <c:pt idx="729">
                  <c:v>-0.139481572725866</c:v>
                </c:pt>
                <c:pt idx="730">
                  <c:v>-0.103008932483402</c:v>
                </c:pt>
                <c:pt idx="731">
                  <c:v>-0.43858643581643503</c:v>
                </c:pt>
                <c:pt idx="732">
                  <c:v>-0.153734334234851</c:v>
                </c:pt>
                <c:pt idx="733">
                  <c:v>-0.26872400979963301</c:v>
                </c:pt>
                <c:pt idx="734">
                  <c:v>-0.234361843457154</c:v>
                </c:pt>
                <c:pt idx="735">
                  <c:v>-0.178238023688466</c:v>
                </c:pt>
                <c:pt idx="736">
                  <c:v>-0.45198604031637701</c:v>
                </c:pt>
                <c:pt idx="737">
                  <c:v>-6.2962271166495998E-2</c:v>
                </c:pt>
                <c:pt idx="738">
                  <c:v>-0.37102675655946898</c:v>
                </c:pt>
                <c:pt idx="739">
                  <c:v>-0.35360641149434702</c:v>
                </c:pt>
                <c:pt idx="740">
                  <c:v>-0.351982754578475</c:v>
                </c:pt>
                <c:pt idx="741">
                  <c:v>-0.12145313479622701</c:v>
                </c:pt>
                <c:pt idx="742">
                  <c:v>-0.27805588072262499</c:v>
                </c:pt>
                <c:pt idx="743">
                  <c:v>-0.20176211399768201</c:v>
                </c:pt>
                <c:pt idx="744">
                  <c:v>-0.302371826004738</c:v>
                </c:pt>
                <c:pt idx="745">
                  <c:v>-0.40236603479752597</c:v>
                </c:pt>
                <c:pt idx="746">
                  <c:v>-0.47475819307690298</c:v>
                </c:pt>
                <c:pt idx="747">
                  <c:v>-0.48300078280294501</c:v>
                </c:pt>
                <c:pt idx="748">
                  <c:v>-0.23650460480177199</c:v>
                </c:pt>
                <c:pt idx="749">
                  <c:v>-0.137587259673493</c:v>
                </c:pt>
                <c:pt idx="750">
                  <c:v>-7.4507659316098998E-2</c:v>
                </c:pt>
                <c:pt idx="751">
                  <c:v>-0.21571420287722501</c:v>
                </c:pt>
                <c:pt idx="752">
                  <c:v>-0.141786997958084</c:v>
                </c:pt>
                <c:pt idx="753">
                  <c:v>-0.14085307869160699</c:v>
                </c:pt>
                <c:pt idx="754">
                  <c:v>-0.16147870233039399</c:v>
                </c:pt>
                <c:pt idx="755">
                  <c:v>-0.13799990992073</c:v>
                </c:pt>
                <c:pt idx="756">
                  <c:v>-0.193778367634553</c:v>
                </c:pt>
                <c:pt idx="757">
                  <c:v>-9.4307528528562695E-2</c:v>
                </c:pt>
                <c:pt idx="758">
                  <c:v>-0.27918651715603199</c:v>
                </c:pt>
                <c:pt idx="759">
                  <c:v>7.2470107295100797E-2</c:v>
                </c:pt>
                <c:pt idx="760">
                  <c:v>-0.26048695142940198</c:v>
                </c:pt>
                <c:pt idx="761">
                  <c:v>-0.17269411729512801</c:v>
                </c:pt>
                <c:pt idx="762">
                  <c:v>-0.21200180805195001</c:v>
                </c:pt>
                <c:pt idx="763">
                  <c:v>-0.19667208865387101</c:v>
                </c:pt>
                <c:pt idx="764">
                  <c:v>-0.30597474992560503</c:v>
                </c:pt>
                <c:pt idx="765">
                  <c:v>-0.24361906852559001</c:v>
                </c:pt>
                <c:pt idx="766">
                  <c:v>-0.17913078928613799</c:v>
                </c:pt>
                <c:pt idx="767">
                  <c:v>-0.18082270785127899</c:v>
                </c:pt>
                <c:pt idx="768">
                  <c:v>-0.1776682832665</c:v>
                </c:pt>
                <c:pt idx="769">
                  <c:v>-0.40101250202198302</c:v>
                </c:pt>
                <c:pt idx="770">
                  <c:v>-0.16078640627645699</c:v>
                </c:pt>
                <c:pt idx="771">
                  <c:v>-0.208366417170264</c:v>
                </c:pt>
                <c:pt idx="772">
                  <c:v>-0.31541363745830198</c:v>
                </c:pt>
                <c:pt idx="773">
                  <c:v>-0.20832543849052401</c:v>
                </c:pt>
                <c:pt idx="774">
                  <c:v>-0.223648478312684</c:v>
                </c:pt>
                <c:pt idx="775">
                  <c:v>-0.45501256322704098</c:v>
                </c:pt>
                <c:pt idx="776">
                  <c:v>-0.360478956342488</c:v>
                </c:pt>
                <c:pt idx="777">
                  <c:v>-0.32939304823294602</c:v>
                </c:pt>
                <c:pt idx="778">
                  <c:v>-0.230683323538249</c:v>
                </c:pt>
                <c:pt idx="779">
                  <c:v>-0.217206562201568</c:v>
                </c:pt>
                <c:pt idx="780">
                  <c:v>-0.33695903912310499</c:v>
                </c:pt>
                <c:pt idx="781">
                  <c:v>-9.0471878249083607E-2</c:v>
                </c:pt>
                <c:pt idx="782">
                  <c:v>0.129662005821434</c:v>
                </c:pt>
                <c:pt idx="783">
                  <c:v>2.59745428042421E-2</c:v>
                </c:pt>
                <c:pt idx="784">
                  <c:v>-8.6693799158979706E-2</c:v>
                </c:pt>
                <c:pt idx="785">
                  <c:v>-3.13239089752901E-3</c:v>
                </c:pt>
                <c:pt idx="786">
                  <c:v>-8.3894113567936808E-3</c:v>
                </c:pt>
                <c:pt idx="787">
                  <c:v>0.160396979179804</c:v>
                </c:pt>
                <c:pt idx="788">
                  <c:v>1.49783738092887E-2</c:v>
                </c:pt>
                <c:pt idx="789">
                  <c:v>0.22836264721497701</c:v>
                </c:pt>
                <c:pt idx="790">
                  <c:v>0.11905729694495901</c:v>
                </c:pt>
                <c:pt idx="791">
                  <c:v>-3.19429521889837E-2</c:v>
                </c:pt>
                <c:pt idx="792">
                  <c:v>-2.25435337388925E-2</c:v>
                </c:pt>
                <c:pt idx="793">
                  <c:v>0.106125809886223</c:v>
                </c:pt>
                <c:pt idx="794">
                  <c:v>-3.7324537000795799E-2</c:v>
                </c:pt>
                <c:pt idx="795">
                  <c:v>6.24226589738733E-2</c:v>
                </c:pt>
                <c:pt idx="796">
                  <c:v>-5.6306475950466298E-2</c:v>
                </c:pt>
                <c:pt idx="797">
                  <c:v>1.26216577024711E-2</c:v>
                </c:pt>
                <c:pt idx="798">
                  <c:v>-5.4492062325492696E-3</c:v>
                </c:pt>
                <c:pt idx="799">
                  <c:v>-0.22854774042569501</c:v>
                </c:pt>
                <c:pt idx="800">
                  <c:v>-0.11830971360642099</c:v>
                </c:pt>
                <c:pt idx="801">
                  <c:v>-0.12568281006821699</c:v>
                </c:pt>
                <c:pt idx="802">
                  <c:v>3.88503274573146E-2</c:v>
                </c:pt>
                <c:pt idx="803">
                  <c:v>-0.18506221674378201</c:v>
                </c:pt>
                <c:pt idx="804">
                  <c:v>-7.7609718351598897E-2</c:v>
                </c:pt>
                <c:pt idx="805">
                  <c:v>0.12230457071611101</c:v>
                </c:pt>
                <c:pt idx="806">
                  <c:v>2.5144968622110998E-2</c:v>
                </c:pt>
                <c:pt idx="807">
                  <c:v>-0.162900522933732</c:v>
                </c:pt>
                <c:pt idx="808">
                  <c:v>-0.275299098243594</c:v>
                </c:pt>
                <c:pt idx="809">
                  <c:v>-0.109592945977204</c:v>
                </c:pt>
                <c:pt idx="810">
                  <c:v>1.56744859725109E-2</c:v>
                </c:pt>
                <c:pt idx="811">
                  <c:v>-6.6570771475109106E-2</c:v>
                </c:pt>
                <c:pt idx="812">
                  <c:v>-2.9423831402036402E-2</c:v>
                </c:pt>
                <c:pt idx="813">
                  <c:v>6.0000324114641297E-2</c:v>
                </c:pt>
                <c:pt idx="814">
                  <c:v>6.12712672290553E-2</c:v>
                </c:pt>
                <c:pt idx="815">
                  <c:v>-0.23378734400439399</c:v>
                </c:pt>
                <c:pt idx="816">
                  <c:v>-0.35368622236400399</c:v>
                </c:pt>
                <c:pt idx="817">
                  <c:v>-9.1545245443444695E-2</c:v>
                </c:pt>
                <c:pt idx="818">
                  <c:v>-0.21707287196713801</c:v>
                </c:pt>
                <c:pt idx="819">
                  <c:v>-6.3006227826152394E-2</c:v>
                </c:pt>
                <c:pt idx="820">
                  <c:v>-0.15185918102353699</c:v>
                </c:pt>
                <c:pt idx="821">
                  <c:v>0.202557946417535</c:v>
                </c:pt>
                <c:pt idx="822">
                  <c:v>-5.32093514716332E-2</c:v>
                </c:pt>
                <c:pt idx="823">
                  <c:v>-7.0062265951303104E-2</c:v>
                </c:pt>
                <c:pt idx="824">
                  <c:v>-0.14629779474681301</c:v>
                </c:pt>
                <c:pt idx="825">
                  <c:v>-0.31280121924589499</c:v>
                </c:pt>
                <c:pt idx="826">
                  <c:v>-3.5043715642748001E-3</c:v>
                </c:pt>
                <c:pt idx="827">
                  <c:v>-0.31960757800942502</c:v>
                </c:pt>
                <c:pt idx="828">
                  <c:v>-4.9098310890160403E-2</c:v>
                </c:pt>
                <c:pt idx="829">
                  <c:v>6.1962072171469701E-3</c:v>
                </c:pt>
                <c:pt idx="830">
                  <c:v>-0.16829363331757699</c:v>
                </c:pt>
                <c:pt idx="831">
                  <c:v>-2.8383875610193701E-2</c:v>
                </c:pt>
                <c:pt idx="832">
                  <c:v>3.5332831924892998E-2</c:v>
                </c:pt>
                <c:pt idx="833">
                  <c:v>-2.4190839610215498E-2</c:v>
                </c:pt>
                <c:pt idx="834">
                  <c:v>-5.1251801999610902E-3</c:v>
                </c:pt>
                <c:pt idx="835">
                  <c:v>-7.7434531335866502E-2</c:v>
                </c:pt>
                <c:pt idx="836">
                  <c:v>-2.2039244307147099E-2</c:v>
                </c:pt>
                <c:pt idx="837">
                  <c:v>0.21718052168392399</c:v>
                </c:pt>
                <c:pt idx="838">
                  <c:v>8.5205136881131793E-2</c:v>
                </c:pt>
                <c:pt idx="839">
                  <c:v>3.2209987614155902E-2</c:v>
                </c:pt>
                <c:pt idx="840">
                  <c:v>2.1515827853229998E-2</c:v>
                </c:pt>
                <c:pt idx="841">
                  <c:v>-0.125384850983425</c:v>
                </c:pt>
                <c:pt idx="842">
                  <c:v>-9.9403708172961392E-3</c:v>
                </c:pt>
                <c:pt idx="843">
                  <c:v>-3.6295410554247197E-2</c:v>
                </c:pt>
                <c:pt idx="844">
                  <c:v>3.2930131683151898E-2</c:v>
                </c:pt>
                <c:pt idx="845">
                  <c:v>-0.124947782277779</c:v>
                </c:pt>
                <c:pt idx="846">
                  <c:v>-0.38381867797949099</c:v>
                </c:pt>
                <c:pt idx="847">
                  <c:v>-0.11826995483979</c:v>
                </c:pt>
                <c:pt idx="848">
                  <c:v>4.9576549083300697E-2</c:v>
                </c:pt>
                <c:pt idx="849">
                  <c:v>6.6710826616897201E-2</c:v>
                </c:pt>
                <c:pt idx="850">
                  <c:v>-2.84902045107058E-3</c:v>
                </c:pt>
                <c:pt idx="851">
                  <c:v>0.101101826915693</c:v>
                </c:pt>
                <c:pt idx="852">
                  <c:v>-6.6180419891145204E-2</c:v>
                </c:pt>
                <c:pt idx="853">
                  <c:v>-9.4603292490662398E-3</c:v>
                </c:pt>
                <c:pt idx="854">
                  <c:v>-2.3399650952108799E-2</c:v>
                </c:pt>
                <c:pt idx="855">
                  <c:v>1.2357557925545E-2</c:v>
                </c:pt>
                <c:pt idx="856">
                  <c:v>2.8120872443721402E-2</c:v>
                </c:pt>
                <c:pt idx="857">
                  <c:v>1.7045326170229198E-2</c:v>
                </c:pt>
                <c:pt idx="858">
                  <c:v>-3.1476172289933001E-3</c:v>
                </c:pt>
                <c:pt idx="859">
                  <c:v>3.8919100153688997E-2</c:v>
                </c:pt>
                <c:pt idx="860">
                  <c:v>-0.12783116939162101</c:v>
                </c:pt>
                <c:pt idx="861">
                  <c:v>9.1976688737193696E-2</c:v>
                </c:pt>
                <c:pt idx="862">
                  <c:v>0.120302342872198</c:v>
                </c:pt>
                <c:pt idx="863">
                  <c:v>-9.2893451887843205E-4</c:v>
                </c:pt>
                <c:pt idx="864">
                  <c:v>4.3660713057182499E-2</c:v>
                </c:pt>
                <c:pt idx="865">
                  <c:v>0.249329678916305</c:v>
                </c:pt>
                <c:pt idx="866">
                  <c:v>-0.108155274524524</c:v>
                </c:pt>
                <c:pt idx="867">
                  <c:v>2.59920176549387E-2</c:v>
                </c:pt>
                <c:pt idx="868">
                  <c:v>-0.36302052558702302</c:v>
                </c:pt>
                <c:pt idx="869">
                  <c:v>-0.38055343436532701</c:v>
                </c:pt>
                <c:pt idx="870">
                  <c:v>-0.21964415977875201</c:v>
                </c:pt>
                <c:pt idx="871">
                  <c:v>-0.175651726490893</c:v>
                </c:pt>
                <c:pt idx="872">
                  <c:v>-9.2751371771475605E-2</c:v>
                </c:pt>
                <c:pt idx="873">
                  <c:v>6.6927230076016999E-3</c:v>
                </c:pt>
                <c:pt idx="874">
                  <c:v>3.21476237108565E-3</c:v>
                </c:pt>
                <c:pt idx="875">
                  <c:v>-9.6906410201358997E-2</c:v>
                </c:pt>
                <c:pt idx="876">
                  <c:v>0.12090996466602801</c:v>
                </c:pt>
                <c:pt idx="877">
                  <c:v>8.2799402532209104E-2</c:v>
                </c:pt>
                <c:pt idx="878">
                  <c:v>0.25173530382227799</c:v>
                </c:pt>
                <c:pt idx="879">
                  <c:v>-6.1669737516986699E-2</c:v>
                </c:pt>
                <c:pt idx="880">
                  <c:v>1.6723510378714401E-2</c:v>
                </c:pt>
                <c:pt idx="881">
                  <c:v>0.23206180992683501</c:v>
                </c:pt>
                <c:pt idx="882">
                  <c:v>0.14209675953623599</c:v>
                </c:pt>
                <c:pt idx="883">
                  <c:v>5.4560913765467303E-2</c:v>
                </c:pt>
                <c:pt idx="884">
                  <c:v>0.207786284826116</c:v>
                </c:pt>
                <c:pt idx="885">
                  <c:v>5.2178198281534902E-2</c:v>
                </c:pt>
                <c:pt idx="886">
                  <c:v>6.7644136537925101E-2</c:v>
                </c:pt>
                <c:pt idx="887">
                  <c:v>-0.17008806389412601</c:v>
                </c:pt>
                <c:pt idx="888">
                  <c:v>-1.10222886244335E-3</c:v>
                </c:pt>
                <c:pt idx="889">
                  <c:v>9.1185207048719102E-2</c:v>
                </c:pt>
                <c:pt idx="890">
                  <c:v>-0.11599340758615399</c:v>
                </c:pt>
                <c:pt idx="891">
                  <c:v>-0.18807371568074299</c:v>
                </c:pt>
                <c:pt idx="892">
                  <c:v>-0.109202003539528</c:v>
                </c:pt>
                <c:pt idx="893">
                  <c:v>-5.8002115891437701E-2</c:v>
                </c:pt>
                <c:pt idx="894">
                  <c:v>-1.25400415993294E-2</c:v>
                </c:pt>
                <c:pt idx="895">
                  <c:v>-3.8627520055753803E-2</c:v>
                </c:pt>
                <c:pt idx="896">
                  <c:v>1.0173272351570099E-3</c:v>
                </c:pt>
                <c:pt idx="897">
                  <c:v>-3.1605121758924597E-2</c:v>
                </c:pt>
                <c:pt idx="898">
                  <c:v>4.5516753223970897E-3</c:v>
                </c:pt>
                <c:pt idx="899">
                  <c:v>-6.8146014536246803E-3</c:v>
                </c:pt>
                <c:pt idx="900">
                  <c:v>2.0328440021380401E-2</c:v>
                </c:pt>
                <c:pt idx="901">
                  <c:v>-1.22488706624246E-2</c:v>
                </c:pt>
                <c:pt idx="902">
                  <c:v>0.158171078157232</c:v>
                </c:pt>
                <c:pt idx="903">
                  <c:v>0.234545030843094</c:v>
                </c:pt>
                <c:pt idx="904">
                  <c:v>3.9804245638909802E-2</c:v>
                </c:pt>
                <c:pt idx="905">
                  <c:v>-0.125604164623699</c:v>
                </c:pt>
                <c:pt idx="906">
                  <c:v>9.8243680208477194E-2</c:v>
                </c:pt>
                <c:pt idx="907">
                  <c:v>-5.2432686438455001E-2</c:v>
                </c:pt>
                <c:pt idx="908">
                  <c:v>8.4163040482285303E-2</c:v>
                </c:pt>
                <c:pt idx="909">
                  <c:v>-0.129692836321286</c:v>
                </c:pt>
                <c:pt idx="910">
                  <c:v>-0.114676469825523</c:v>
                </c:pt>
                <c:pt idx="911">
                  <c:v>-0.10483805229811401</c:v>
                </c:pt>
                <c:pt idx="912">
                  <c:v>-6.8962756511943002E-2</c:v>
                </c:pt>
                <c:pt idx="913">
                  <c:v>-6.8730071318381797E-2</c:v>
                </c:pt>
                <c:pt idx="914">
                  <c:v>8.6244144333457798E-2</c:v>
                </c:pt>
                <c:pt idx="915">
                  <c:v>-7.8048878965919603E-3</c:v>
                </c:pt>
                <c:pt idx="916">
                  <c:v>-0.108736551591239</c:v>
                </c:pt>
                <c:pt idx="917">
                  <c:v>0.12107018858278699</c:v>
                </c:pt>
                <c:pt idx="918">
                  <c:v>-1.4716622057384001E-2</c:v>
                </c:pt>
                <c:pt idx="919">
                  <c:v>2.80886949115731E-3</c:v>
                </c:pt>
                <c:pt idx="920">
                  <c:v>0.22014038656073601</c:v>
                </c:pt>
                <c:pt idx="921">
                  <c:v>5.6523540757823697E-2</c:v>
                </c:pt>
                <c:pt idx="922">
                  <c:v>0.59537109363386898</c:v>
                </c:pt>
                <c:pt idx="923">
                  <c:v>0.14568902753839399</c:v>
                </c:pt>
                <c:pt idx="924">
                  <c:v>0.10460680679511</c:v>
                </c:pt>
                <c:pt idx="925">
                  <c:v>6.1456175570008702E-2</c:v>
                </c:pt>
                <c:pt idx="926">
                  <c:v>3.5678033531914899E-2</c:v>
                </c:pt>
                <c:pt idx="927">
                  <c:v>-6.5570151258772802E-2</c:v>
                </c:pt>
                <c:pt idx="928">
                  <c:v>9.0393034217263496E-2</c:v>
                </c:pt>
                <c:pt idx="929">
                  <c:v>0.21197483064491199</c:v>
                </c:pt>
                <c:pt idx="930">
                  <c:v>8.5598208299406606E-2</c:v>
                </c:pt>
                <c:pt idx="931">
                  <c:v>2.87051534399634E-2</c:v>
                </c:pt>
                <c:pt idx="932">
                  <c:v>-0.13610938568689801</c:v>
                </c:pt>
                <c:pt idx="933">
                  <c:v>-0.248635812689806</c:v>
                </c:pt>
                <c:pt idx="934">
                  <c:v>0.11347805539991999</c:v>
                </c:pt>
                <c:pt idx="935">
                  <c:v>0.23994214362093499</c:v>
                </c:pt>
                <c:pt idx="936">
                  <c:v>5.7567831116654103E-2</c:v>
                </c:pt>
                <c:pt idx="937">
                  <c:v>5.17490595051571E-3</c:v>
                </c:pt>
                <c:pt idx="938">
                  <c:v>7.2101922655478795E-2</c:v>
                </c:pt>
              </c:numCache>
            </c:numRef>
          </c:xVal>
          <c:yVal>
            <c:numRef>
              <c:f>'Diabetes (2)'!$B$2:$B$940</c:f>
              <c:numCache>
                <c:formatCode>General</c:formatCode>
                <c:ptCount val="939"/>
                <c:pt idx="0">
                  <c:v>1.92474304291679</c:v>
                </c:pt>
                <c:pt idx="1">
                  <c:v>1.10817094004242</c:v>
                </c:pt>
                <c:pt idx="2">
                  <c:v>0.60161528487136395</c:v>
                </c:pt>
                <c:pt idx="3">
                  <c:v>1.8766205573205299</c:v>
                </c:pt>
                <c:pt idx="4">
                  <c:v>0.55565550246048001</c:v>
                </c:pt>
                <c:pt idx="5">
                  <c:v>1.2390738308098099</c:v>
                </c:pt>
                <c:pt idx="6">
                  <c:v>1.5269683860543</c:v>
                </c:pt>
                <c:pt idx="7">
                  <c:v>1.2550532327845001</c:v>
                </c:pt>
                <c:pt idx="8">
                  <c:v>0.136931795713987</c:v>
                </c:pt>
                <c:pt idx="9">
                  <c:v>1.0955933282722501</c:v>
                </c:pt>
                <c:pt idx="10">
                  <c:v>0.302570810381732</c:v>
                </c:pt>
                <c:pt idx="11">
                  <c:v>1.0191277895406401</c:v>
                </c:pt>
                <c:pt idx="12">
                  <c:v>0.15561402134001701</c:v>
                </c:pt>
                <c:pt idx="13">
                  <c:v>2.1161136028207101</c:v>
                </c:pt>
                <c:pt idx="14">
                  <c:v>1.0576941329836</c:v>
                </c:pt>
                <c:pt idx="15">
                  <c:v>0.26962982928219797</c:v>
                </c:pt>
                <c:pt idx="16">
                  <c:v>1.8540767446458899</c:v>
                </c:pt>
                <c:pt idx="17">
                  <c:v>1.2313795951140101</c:v>
                </c:pt>
                <c:pt idx="18">
                  <c:v>0.93448774310126204</c:v>
                </c:pt>
                <c:pt idx="19">
                  <c:v>0.340688029288158</c:v>
                </c:pt>
                <c:pt idx="20">
                  <c:v>0.76391101357350299</c:v>
                </c:pt>
                <c:pt idx="21">
                  <c:v>0.56916976520447704</c:v>
                </c:pt>
                <c:pt idx="22">
                  <c:v>1.51777332384685</c:v>
                </c:pt>
                <c:pt idx="23">
                  <c:v>0.63495986249158498</c:v>
                </c:pt>
                <c:pt idx="24">
                  <c:v>0.33407824862917801</c:v>
                </c:pt>
                <c:pt idx="25">
                  <c:v>5.6119556149771899E-3</c:v>
                </c:pt>
                <c:pt idx="26">
                  <c:v>0.30067997942054903</c:v>
                </c:pt>
                <c:pt idx="27">
                  <c:v>0.44900775567470402</c:v>
                </c:pt>
                <c:pt idx="28">
                  <c:v>1.5414265881222999</c:v>
                </c:pt>
                <c:pt idx="29">
                  <c:v>0.333216530642575</c:v>
                </c:pt>
                <c:pt idx="30">
                  <c:v>1.9721576477036</c:v>
                </c:pt>
                <c:pt idx="31">
                  <c:v>2.2715508692845399</c:v>
                </c:pt>
                <c:pt idx="32">
                  <c:v>1.9721576477036</c:v>
                </c:pt>
                <c:pt idx="33">
                  <c:v>1.9721576477036</c:v>
                </c:pt>
                <c:pt idx="34">
                  <c:v>0.89370997227662896</c:v>
                </c:pt>
                <c:pt idx="35">
                  <c:v>0.89370997227662896</c:v>
                </c:pt>
                <c:pt idx="36">
                  <c:v>1.9721576477036</c:v>
                </c:pt>
                <c:pt idx="37">
                  <c:v>2.2048003400997902</c:v>
                </c:pt>
                <c:pt idx="38">
                  <c:v>0.81798585677361602</c:v>
                </c:pt>
                <c:pt idx="39">
                  <c:v>0.79913502090124899</c:v>
                </c:pt>
                <c:pt idx="40">
                  <c:v>0.14394734677190699</c:v>
                </c:pt>
                <c:pt idx="41">
                  <c:v>1.55851677175604</c:v>
                </c:pt>
                <c:pt idx="42">
                  <c:v>1.52060302622314</c:v>
                </c:pt>
                <c:pt idx="43">
                  <c:v>9.6187442099285703E-2</c:v>
                </c:pt>
                <c:pt idx="44">
                  <c:v>8.2569578611334602E-3</c:v>
                </c:pt>
                <c:pt idx="45">
                  <c:v>0.33706528484293202</c:v>
                </c:pt>
                <c:pt idx="46">
                  <c:v>0.72093856325188599</c:v>
                </c:pt>
                <c:pt idx="47">
                  <c:v>8.4630753534098199E-2</c:v>
                </c:pt>
                <c:pt idx="48">
                  <c:v>0.74084347514794002</c:v>
                </c:pt>
                <c:pt idx="49">
                  <c:v>9.7054145230736799E-2</c:v>
                </c:pt>
                <c:pt idx="50">
                  <c:v>1.1705034236035301</c:v>
                </c:pt>
                <c:pt idx="51">
                  <c:v>0.57587644876998501</c:v>
                </c:pt>
                <c:pt idx="52">
                  <c:v>2.31329011228509</c:v>
                </c:pt>
                <c:pt idx="53">
                  <c:v>0.56751259453816405</c:v>
                </c:pt>
                <c:pt idx="54">
                  <c:v>0.27867660510692099</c:v>
                </c:pt>
                <c:pt idx="55">
                  <c:v>0.57528441725339696</c:v>
                </c:pt>
                <c:pt idx="56">
                  <c:v>1.5105594116193299</c:v>
                </c:pt>
                <c:pt idx="57">
                  <c:v>1.10817094004242</c:v>
                </c:pt>
                <c:pt idx="58">
                  <c:v>0.73770156109485596</c:v>
                </c:pt>
                <c:pt idx="59">
                  <c:v>0.84514657527686998</c:v>
                </c:pt>
                <c:pt idx="60">
                  <c:v>0.94342189828939804</c:v>
                </c:pt>
                <c:pt idx="61">
                  <c:v>0.92495275933516197</c:v>
                </c:pt>
                <c:pt idx="62">
                  <c:v>0.45342888496247902</c:v>
                </c:pt>
                <c:pt idx="63">
                  <c:v>0.66730239279126902</c:v>
                </c:pt>
                <c:pt idx="64">
                  <c:v>0.41412668619257798</c:v>
                </c:pt>
                <c:pt idx="65">
                  <c:v>0.62732240583503596</c:v>
                </c:pt>
                <c:pt idx="66">
                  <c:v>0.69402397454825004</c:v>
                </c:pt>
                <c:pt idx="67">
                  <c:v>0.42680109162542101</c:v>
                </c:pt>
                <c:pt idx="68">
                  <c:v>1.29489104832145</c:v>
                </c:pt>
                <c:pt idx="69">
                  <c:v>0.75618876156788795</c:v>
                </c:pt>
                <c:pt idx="70">
                  <c:v>0.36768510121292403</c:v>
                </c:pt>
                <c:pt idx="71">
                  <c:v>1.72956973930786</c:v>
                </c:pt>
                <c:pt idx="72">
                  <c:v>0.80607497379649595</c:v>
                </c:pt>
                <c:pt idx="73">
                  <c:v>0.84900598159107199</c:v>
                </c:pt>
                <c:pt idx="74">
                  <c:v>0.94254429724036304</c:v>
                </c:pt>
                <c:pt idx="75">
                  <c:v>6.08766237147901E-2</c:v>
                </c:pt>
                <c:pt idx="76">
                  <c:v>0.77990788117967103</c:v>
                </c:pt>
                <c:pt idx="77">
                  <c:v>0.73682592772820399</c:v>
                </c:pt>
                <c:pt idx="78">
                  <c:v>0.73546778623614395</c:v>
                </c:pt>
                <c:pt idx="79">
                  <c:v>0.42243591412537401</c:v>
                </c:pt>
                <c:pt idx="80">
                  <c:v>1.9030441331206001</c:v>
                </c:pt>
                <c:pt idx="81">
                  <c:v>0.35810929793820401</c:v>
                </c:pt>
                <c:pt idx="82">
                  <c:v>0.80607497379649595</c:v>
                </c:pt>
                <c:pt idx="83">
                  <c:v>1.11485324988845</c:v>
                </c:pt>
                <c:pt idx="84">
                  <c:v>0.65424130349523202</c:v>
                </c:pt>
                <c:pt idx="85">
                  <c:v>0.32866289548690902</c:v>
                </c:pt>
                <c:pt idx="86">
                  <c:v>1.0649203476395599E-2</c:v>
                </c:pt>
                <c:pt idx="87">
                  <c:v>1.1834128773950401</c:v>
                </c:pt>
                <c:pt idx="88">
                  <c:v>2.3828595135619302</c:v>
                </c:pt>
                <c:pt idx="89">
                  <c:v>2.06701936953817</c:v>
                </c:pt>
                <c:pt idx="90">
                  <c:v>0.26017620157729698</c:v>
                </c:pt>
                <c:pt idx="91">
                  <c:v>0.85344796166764003</c:v>
                </c:pt>
                <c:pt idx="92">
                  <c:v>1.38244505520421</c:v>
                </c:pt>
                <c:pt idx="93">
                  <c:v>1.0709142996357399</c:v>
                </c:pt>
                <c:pt idx="94">
                  <c:v>0.340688029288158</c:v>
                </c:pt>
                <c:pt idx="95">
                  <c:v>0.675907814535749</c:v>
                </c:pt>
                <c:pt idx="96">
                  <c:v>1.25812217202918</c:v>
                </c:pt>
                <c:pt idx="97">
                  <c:v>1.1848678016191101</c:v>
                </c:pt>
                <c:pt idx="98">
                  <c:v>0.71111646235164205</c:v>
                </c:pt>
                <c:pt idx="99">
                  <c:v>0.31362146148554698</c:v>
                </c:pt>
                <c:pt idx="100">
                  <c:v>1.01161407913403</c:v>
                </c:pt>
                <c:pt idx="101">
                  <c:v>1.02594758093732</c:v>
                </c:pt>
                <c:pt idx="102">
                  <c:v>1.0378595339288701</c:v>
                </c:pt>
                <c:pt idx="103">
                  <c:v>1.4357511719781799</c:v>
                </c:pt>
                <c:pt idx="104">
                  <c:v>0.148543781005018</c:v>
                </c:pt>
                <c:pt idx="105">
                  <c:v>1.62387794772482</c:v>
                </c:pt>
                <c:pt idx="106">
                  <c:v>0.38209354954041203</c:v>
                </c:pt>
                <c:pt idx="107">
                  <c:v>8.2509663948778303E-2</c:v>
                </c:pt>
                <c:pt idx="108">
                  <c:v>2.6172524974676099</c:v>
                </c:pt>
                <c:pt idx="109">
                  <c:v>0.45566940230540698</c:v>
                </c:pt>
                <c:pt idx="110">
                  <c:v>0.72859400717009204</c:v>
                </c:pt>
                <c:pt idx="111">
                  <c:v>1.1376491166851299</c:v>
                </c:pt>
                <c:pt idx="112">
                  <c:v>0.101567163818698</c:v>
                </c:pt>
                <c:pt idx="113">
                  <c:v>1.2482005811738099</c:v>
                </c:pt>
                <c:pt idx="114">
                  <c:v>0.265121258567525</c:v>
                </c:pt>
                <c:pt idx="115">
                  <c:v>9.4064388845132609E-3</c:v>
                </c:pt>
                <c:pt idx="116">
                  <c:v>0.130930490178541</c:v>
                </c:pt>
                <c:pt idx="117">
                  <c:v>1.2649392598690801</c:v>
                </c:pt>
                <c:pt idx="118">
                  <c:v>0.43628170464202098</c:v>
                </c:pt>
                <c:pt idx="119">
                  <c:v>1.1615442611284299</c:v>
                </c:pt>
                <c:pt idx="120">
                  <c:v>0.65216460093611905</c:v>
                </c:pt>
                <c:pt idx="121">
                  <c:v>0.34537853494781201</c:v>
                </c:pt>
                <c:pt idx="122">
                  <c:v>1.0576941329836</c:v>
                </c:pt>
                <c:pt idx="123">
                  <c:v>1.05361535671187</c:v>
                </c:pt>
                <c:pt idx="124">
                  <c:v>0.17474261119548901</c:v>
                </c:pt>
                <c:pt idx="125">
                  <c:v>1.2622477408628501</c:v>
                </c:pt>
                <c:pt idx="126">
                  <c:v>1.2818760677569401</c:v>
                </c:pt>
                <c:pt idx="127">
                  <c:v>1.45724991886848</c:v>
                </c:pt>
                <c:pt idx="128">
                  <c:v>1.6596489832111501</c:v>
                </c:pt>
                <c:pt idx="129">
                  <c:v>0.80660200746391297</c:v>
                </c:pt>
                <c:pt idx="130">
                  <c:v>0.80660200746391297</c:v>
                </c:pt>
                <c:pt idx="131">
                  <c:v>1.2236013176367899</c:v>
                </c:pt>
                <c:pt idx="132">
                  <c:v>0.77845811386280495</c:v>
                </c:pt>
                <c:pt idx="133">
                  <c:v>1.6286699644990701</c:v>
                </c:pt>
                <c:pt idx="134">
                  <c:v>0.77845811386280495</c:v>
                </c:pt>
                <c:pt idx="135">
                  <c:v>1.33110678517693</c:v>
                </c:pt>
                <c:pt idx="136">
                  <c:v>0.57876909166572699</c:v>
                </c:pt>
                <c:pt idx="137">
                  <c:v>0.333216530642575</c:v>
                </c:pt>
                <c:pt idx="138">
                  <c:v>0.696556488625651</c:v>
                </c:pt>
                <c:pt idx="139">
                  <c:v>1.6653465192766601</c:v>
                </c:pt>
                <c:pt idx="140">
                  <c:v>0.689229805935069</c:v>
                </c:pt>
                <c:pt idx="141">
                  <c:v>0.32140726902564898</c:v>
                </c:pt>
                <c:pt idx="142">
                  <c:v>0.31242381300895899</c:v>
                </c:pt>
                <c:pt idx="143">
                  <c:v>0.97124081157637898</c:v>
                </c:pt>
                <c:pt idx="144">
                  <c:v>0.89401294658860897</c:v>
                </c:pt>
                <c:pt idx="145">
                  <c:v>0.25083271138468999</c:v>
                </c:pt>
                <c:pt idx="146">
                  <c:v>1.6596489832111501</c:v>
                </c:pt>
                <c:pt idx="147">
                  <c:v>0.26017620157729698</c:v>
                </c:pt>
                <c:pt idx="148">
                  <c:v>0.863441050802637</c:v>
                </c:pt>
                <c:pt idx="149">
                  <c:v>1.1486229729676301</c:v>
                </c:pt>
                <c:pt idx="150">
                  <c:v>1.06244931086716</c:v>
                </c:pt>
                <c:pt idx="151">
                  <c:v>1.6951139445324701</c:v>
                </c:pt>
                <c:pt idx="152">
                  <c:v>2.2366284776424501</c:v>
                </c:pt>
                <c:pt idx="153">
                  <c:v>0.56695007548926601</c:v>
                </c:pt>
                <c:pt idx="154">
                  <c:v>0.53352315508885295</c:v>
                </c:pt>
                <c:pt idx="155">
                  <c:v>0.817336858412824</c:v>
                </c:pt>
                <c:pt idx="156">
                  <c:v>0.73546778623614395</c:v>
                </c:pt>
                <c:pt idx="157">
                  <c:v>1.72956973930786</c:v>
                </c:pt>
                <c:pt idx="158">
                  <c:v>0.48524665513689103</c:v>
                </c:pt>
                <c:pt idx="159">
                  <c:v>0.46669396464014401</c:v>
                </c:pt>
                <c:pt idx="160">
                  <c:v>0.48946531946654998</c:v>
                </c:pt>
                <c:pt idx="161">
                  <c:v>0.39895768800742798</c:v>
                </c:pt>
                <c:pt idx="162">
                  <c:v>0.45495188905403899</c:v>
                </c:pt>
                <c:pt idx="163">
                  <c:v>1.25773254479868</c:v>
                </c:pt>
                <c:pt idx="164">
                  <c:v>0.50728618567427897</c:v>
                </c:pt>
                <c:pt idx="165">
                  <c:v>1.98452890399425</c:v>
                </c:pt>
                <c:pt idx="166">
                  <c:v>0.36759822961212602</c:v>
                </c:pt>
                <c:pt idx="167">
                  <c:v>0.36759822961212602</c:v>
                </c:pt>
                <c:pt idx="168">
                  <c:v>0.31684743454091402</c:v>
                </c:pt>
                <c:pt idx="169">
                  <c:v>0.31684743454091402</c:v>
                </c:pt>
                <c:pt idx="170">
                  <c:v>0.31684743454091402</c:v>
                </c:pt>
                <c:pt idx="171">
                  <c:v>0.78062150116394102</c:v>
                </c:pt>
                <c:pt idx="172">
                  <c:v>0.78062150116394102</c:v>
                </c:pt>
                <c:pt idx="173">
                  <c:v>0.53724495898288005</c:v>
                </c:pt>
                <c:pt idx="174">
                  <c:v>0.53724495898288005</c:v>
                </c:pt>
                <c:pt idx="175">
                  <c:v>0.517122605344287</c:v>
                </c:pt>
                <c:pt idx="176">
                  <c:v>0.517122605344287</c:v>
                </c:pt>
                <c:pt idx="177">
                  <c:v>0.50695900843879904</c:v>
                </c:pt>
                <c:pt idx="178">
                  <c:v>1.5907740440615401</c:v>
                </c:pt>
                <c:pt idx="179">
                  <c:v>1.5907740440615401</c:v>
                </c:pt>
                <c:pt idx="180">
                  <c:v>0.41412668619257798</c:v>
                </c:pt>
                <c:pt idx="181">
                  <c:v>0.39071103009595798</c:v>
                </c:pt>
                <c:pt idx="182">
                  <c:v>1.3297723856050601</c:v>
                </c:pt>
                <c:pt idx="183">
                  <c:v>1.2110579032570199</c:v>
                </c:pt>
                <c:pt idx="184">
                  <c:v>0.62732240583503596</c:v>
                </c:pt>
                <c:pt idx="185">
                  <c:v>0.70091887089707305</c:v>
                </c:pt>
                <c:pt idx="186">
                  <c:v>0.37930864417392501</c:v>
                </c:pt>
                <c:pt idx="187">
                  <c:v>0.112013391463338</c:v>
                </c:pt>
                <c:pt idx="188">
                  <c:v>1.1680364663032401</c:v>
                </c:pt>
                <c:pt idx="189">
                  <c:v>0.89152571198769404</c:v>
                </c:pt>
                <c:pt idx="190">
                  <c:v>0.18090738315869101</c:v>
                </c:pt>
                <c:pt idx="191">
                  <c:v>0.69127340888306399</c:v>
                </c:pt>
                <c:pt idx="192">
                  <c:v>0.84961564577440796</c:v>
                </c:pt>
                <c:pt idx="193">
                  <c:v>8.9882117096809599E-2</c:v>
                </c:pt>
                <c:pt idx="194">
                  <c:v>0.46367090156358998</c:v>
                </c:pt>
                <c:pt idx="195">
                  <c:v>0.49682730115835599</c:v>
                </c:pt>
                <c:pt idx="196">
                  <c:v>0.18312114663415199</c:v>
                </c:pt>
                <c:pt idx="197">
                  <c:v>0.53421763376543596</c:v>
                </c:pt>
                <c:pt idx="198">
                  <c:v>1.19100873858681</c:v>
                </c:pt>
                <c:pt idx="199">
                  <c:v>0.99044327412980404</c:v>
                </c:pt>
                <c:pt idx="200">
                  <c:v>0.67048784013492901</c:v>
                </c:pt>
                <c:pt idx="201">
                  <c:v>0.45815791981063397</c:v>
                </c:pt>
                <c:pt idx="202">
                  <c:v>0.78961454474577397</c:v>
                </c:pt>
                <c:pt idx="203">
                  <c:v>0.69565231400872996</c:v>
                </c:pt>
                <c:pt idx="204">
                  <c:v>0.16375810785653699</c:v>
                </c:pt>
                <c:pt idx="205">
                  <c:v>1.11544878815465</c:v>
                </c:pt>
                <c:pt idx="206">
                  <c:v>1.55487764271405</c:v>
                </c:pt>
                <c:pt idx="207">
                  <c:v>1.6891494261314399</c:v>
                </c:pt>
                <c:pt idx="208">
                  <c:v>0.43434126925522298</c:v>
                </c:pt>
                <c:pt idx="209">
                  <c:v>0.76096242488987698</c:v>
                </c:pt>
                <c:pt idx="210">
                  <c:v>1.0087968849821101</c:v>
                </c:pt>
                <c:pt idx="211">
                  <c:v>0.58230210420859096</c:v>
                </c:pt>
                <c:pt idx="212">
                  <c:v>0.21973969027808299</c:v>
                </c:pt>
                <c:pt idx="213">
                  <c:v>0.29261122540878398</c:v>
                </c:pt>
                <c:pt idx="214">
                  <c:v>2.0386874069154501E-2</c:v>
                </c:pt>
                <c:pt idx="215">
                  <c:v>0.42362136437143499</c:v>
                </c:pt>
                <c:pt idx="216">
                  <c:v>0.68282918343271004</c:v>
                </c:pt>
                <c:pt idx="217">
                  <c:v>0.423576241350275</c:v>
                </c:pt>
                <c:pt idx="218">
                  <c:v>0.64864661528031498</c:v>
                </c:pt>
                <c:pt idx="219">
                  <c:v>0.96690638145532704</c:v>
                </c:pt>
                <c:pt idx="220">
                  <c:v>2.2714512423777599E-2</c:v>
                </c:pt>
                <c:pt idx="221">
                  <c:v>0.48853926604159098</c:v>
                </c:pt>
                <c:pt idx="222">
                  <c:v>0.163410567125991</c:v>
                </c:pt>
                <c:pt idx="223">
                  <c:v>0.102449854310123</c:v>
                </c:pt>
                <c:pt idx="224">
                  <c:v>1.19568118633817</c:v>
                </c:pt>
                <c:pt idx="225">
                  <c:v>1.91282236939633</c:v>
                </c:pt>
                <c:pt idx="226">
                  <c:v>1.89073626058389</c:v>
                </c:pt>
                <c:pt idx="227">
                  <c:v>1.95485418734863</c:v>
                </c:pt>
                <c:pt idx="228">
                  <c:v>0.58230210420859096</c:v>
                </c:pt>
                <c:pt idx="229">
                  <c:v>1.1896338539192099</c:v>
                </c:pt>
                <c:pt idx="230">
                  <c:v>0.94519119970673604</c:v>
                </c:pt>
                <c:pt idx="231">
                  <c:v>0.892333547223089</c:v>
                </c:pt>
                <c:pt idx="232">
                  <c:v>0.57238294953881796</c:v>
                </c:pt>
                <c:pt idx="233">
                  <c:v>1.30832894726351</c:v>
                </c:pt>
                <c:pt idx="234">
                  <c:v>0.297285654339147</c:v>
                </c:pt>
                <c:pt idx="235">
                  <c:v>0.10663045034783</c:v>
                </c:pt>
                <c:pt idx="236">
                  <c:v>0.381886499735551</c:v>
                </c:pt>
                <c:pt idx="237">
                  <c:v>0.27340644319653901</c:v>
                </c:pt>
                <c:pt idx="238">
                  <c:v>0.34718433317009201</c:v>
                </c:pt>
                <c:pt idx="239">
                  <c:v>0.688702899174095</c:v>
                </c:pt>
                <c:pt idx="240">
                  <c:v>0.62672461081108499</c:v>
                </c:pt>
                <c:pt idx="241">
                  <c:v>1.5147605655184999</c:v>
                </c:pt>
                <c:pt idx="242">
                  <c:v>1.07602537281664</c:v>
                </c:pt>
                <c:pt idx="243">
                  <c:v>1.00782866757685</c:v>
                </c:pt>
                <c:pt idx="244">
                  <c:v>0.74060139818395698</c:v>
                </c:pt>
                <c:pt idx="245">
                  <c:v>1.24920639542871</c:v>
                </c:pt>
                <c:pt idx="246">
                  <c:v>0.65155793268317197</c:v>
                </c:pt>
                <c:pt idx="247">
                  <c:v>1.03640278504408</c:v>
                </c:pt>
                <c:pt idx="248">
                  <c:v>0.81491310282222296</c:v>
                </c:pt>
                <c:pt idx="249">
                  <c:v>0.706918426630463</c:v>
                </c:pt>
                <c:pt idx="250">
                  <c:v>2.00410043706743</c:v>
                </c:pt>
                <c:pt idx="251">
                  <c:v>0.69486577133317995</c:v>
                </c:pt>
                <c:pt idx="252">
                  <c:v>1.3375365879692001</c:v>
                </c:pt>
                <c:pt idx="253">
                  <c:v>1.1058818072191099</c:v>
                </c:pt>
                <c:pt idx="254">
                  <c:v>0.42780519451363103</c:v>
                </c:pt>
                <c:pt idx="255">
                  <c:v>1.1172552104445499</c:v>
                </c:pt>
                <c:pt idx="256">
                  <c:v>2.33765953720992</c:v>
                </c:pt>
                <c:pt idx="257">
                  <c:v>0.20648322215874301</c:v>
                </c:pt>
                <c:pt idx="258">
                  <c:v>1.45973368428188</c:v>
                </c:pt>
                <c:pt idx="259">
                  <c:v>0.85587686124895901</c:v>
                </c:pt>
                <c:pt idx="260">
                  <c:v>0.785260540150852</c:v>
                </c:pt>
                <c:pt idx="261">
                  <c:v>1.02859127267572</c:v>
                </c:pt>
                <c:pt idx="262">
                  <c:v>0.99889594608199295</c:v>
                </c:pt>
                <c:pt idx="263">
                  <c:v>1.30213560094919</c:v>
                </c:pt>
                <c:pt idx="264">
                  <c:v>1.0589394610918501</c:v>
                </c:pt>
                <c:pt idx="265">
                  <c:v>9.1448164820785799E-2</c:v>
                </c:pt>
                <c:pt idx="266">
                  <c:v>1.6594173682149</c:v>
                </c:pt>
                <c:pt idx="267">
                  <c:v>1.03640278504408</c:v>
                </c:pt>
                <c:pt idx="268">
                  <c:v>1.1269752487581299</c:v>
                </c:pt>
                <c:pt idx="269">
                  <c:v>0.423576241350275</c:v>
                </c:pt>
                <c:pt idx="270">
                  <c:v>1.2172039408205499</c:v>
                </c:pt>
                <c:pt idx="271">
                  <c:v>0.74469596136439398</c:v>
                </c:pt>
                <c:pt idx="272">
                  <c:v>0.21831298663163201</c:v>
                </c:pt>
                <c:pt idx="273">
                  <c:v>0.20754456974707999</c:v>
                </c:pt>
                <c:pt idx="274">
                  <c:v>0.37140235660369197</c:v>
                </c:pt>
                <c:pt idx="275">
                  <c:v>1.11664179692002</c:v>
                </c:pt>
                <c:pt idx="276">
                  <c:v>1.25798609675226</c:v>
                </c:pt>
                <c:pt idx="277">
                  <c:v>1.29899724817477</c:v>
                </c:pt>
                <c:pt idx="278">
                  <c:v>0.39633042285881598</c:v>
                </c:pt>
                <c:pt idx="279">
                  <c:v>0.141295138672767</c:v>
                </c:pt>
                <c:pt idx="280">
                  <c:v>0.14685751450246801</c:v>
                </c:pt>
                <c:pt idx="281">
                  <c:v>1.24920639542871</c:v>
                </c:pt>
                <c:pt idx="282">
                  <c:v>0.70936749554312195</c:v>
                </c:pt>
                <c:pt idx="283">
                  <c:v>0.20803516081810799</c:v>
                </c:pt>
                <c:pt idx="284">
                  <c:v>1.9162891464440901</c:v>
                </c:pt>
                <c:pt idx="285">
                  <c:v>0.43434126925522298</c:v>
                </c:pt>
                <c:pt idx="286">
                  <c:v>0.98605534558262697</c:v>
                </c:pt>
                <c:pt idx="287">
                  <c:v>0.59708314954833996</c:v>
                </c:pt>
                <c:pt idx="288">
                  <c:v>1.4036491616789899</c:v>
                </c:pt>
                <c:pt idx="289">
                  <c:v>1.1968744525713499</c:v>
                </c:pt>
                <c:pt idx="290">
                  <c:v>1.29356535213372</c:v>
                </c:pt>
                <c:pt idx="291">
                  <c:v>0.23596625937582799</c:v>
                </c:pt>
                <c:pt idx="292">
                  <c:v>0.68649100361057902</c:v>
                </c:pt>
                <c:pt idx="293">
                  <c:v>0.55198618086679296</c:v>
                </c:pt>
                <c:pt idx="294">
                  <c:v>0.48009103241475998</c:v>
                </c:pt>
                <c:pt idx="295">
                  <c:v>0.95267473536724701</c:v>
                </c:pt>
                <c:pt idx="296">
                  <c:v>1.4571827504188199</c:v>
                </c:pt>
                <c:pt idx="297">
                  <c:v>0.49479253280245</c:v>
                </c:pt>
                <c:pt idx="298">
                  <c:v>0.54983901414747305</c:v>
                </c:pt>
                <c:pt idx="299">
                  <c:v>1.04298976577331</c:v>
                </c:pt>
                <c:pt idx="300">
                  <c:v>0.80935809805906</c:v>
                </c:pt>
                <c:pt idx="301">
                  <c:v>0.91620788065799497</c:v>
                </c:pt>
                <c:pt idx="302">
                  <c:v>1.2688610257321999</c:v>
                </c:pt>
                <c:pt idx="303">
                  <c:v>1.34011138846361</c:v>
                </c:pt>
                <c:pt idx="304">
                  <c:v>1.03079285862992</c:v>
                </c:pt>
                <c:pt idx="305">
                  <c:v>0.84821323643544999</c:v>
                </c:pt>
                <c:pt idx="306">
                  <c:v>0.17935397215264401</c:v>
                </c:pt>
                <c:pt idx="307">
                  <c:v>0.67998369083436105</c:v>
                </c:pt>
                <c:pt idx="308">
                  <c:v>0.58016459755369398</c:v>
                </c:pt>
                <c:pt idx="309">
                  <c:v>2.0386874069154501E-2</c:v>
                </c:pt>
                <c:pt idx="310">
                  <c:v>1.0013539419920701</c:v>
                </c:pt>
                <c:pt idx="311">
                  <c:v>0.39427170391681299</c:v>
                </c:pt>
                <c:pt idx="312">
                  <c:v>0.90817608890337498</c:v>
                </c:pt>
                <c:pt idx="313">
                  <c:v>0.44674735383431902</c:v>
                </c:pt>
                <c:pt idx="314">
                  <c:v>1.6891494261314399</c:v>
                </c:pt>
                <c:pt idx="315">
                  <c:v>0.28023869157499998</c:v>
                </c:pt>
                <c:pt idx="316">
                  <c:v>9.7116865584684006E-3</c:v>
                </c:pt>
                <c:pt idx="317">
                  <c:v>1.65714884287007</c:v>
                </c:pt>
                <c:pt idx="318">
                  <c:v>1.3288441783120599</c:v>
                </c:pt>
                <c:pt idx="319">
                  <c:v>2.0804644291534098</c:v>
                </c:pt>
                <c:pt idx="320">
                  <c:v>1.1859442552211701</c:v>
                </c:pt>
                <c:pt idx="321">
                  <c:v>1.6169516452488899</c:v>
                </c:pt>
                <c:pt idx="322">
                  <c:v>1.84421551631277</c:v>
                </c:pt>
                <c:pt idx="323">
                  <c:v>1.6317380973620901</c:v>
                </c:pt>
                <c:pt idx="324">
                  <c:v>1.1293164352585101</c:v>
                </c:pt>
                <c:pt idx="325">
                  <c:v>0.84961564577440796</c:v>
                </c:pt>
                <c:pt idx="326">
                  <c:v>1.6891494261314399</c:v>
                </c:pt>
                <c:pt idx="327">
                  <c:v>1.01652185341589</c:v>
                </c:pt>
                <c:pt idx="328">
                  <c:v>8.9882117096809599E-2</c:v>
                </c:pt>
                <c:pt idx="329">
                  <c:v>0.80970790396694003</c:v>
                </c:pt>
                <c:pt idx="330">
                  <c:v>0.631798902413646</c:v>
                </c:pt>
                <c:pt idx="331">
                  <c:v>0.69844773903195301</c:v>
                </c:pt>
                <c:pt idx="332">
                  <c:v>1.41246056002798E-2</c:v>
                </c:pt>
                <c:pt idx="333">
                  <c:v>2.2388736762137901E-2</c:v>
                </c:pt>
                <c:pt idx="334">
                  <c:v>0.87415373593409595</c:v>
                </c:pt>
                <c:pt idx="335">
                  <c:v>0.22078533260552299</c:v>
                </c:pt>
                <c:pt idx="336">
                  <c:v>0.24421557350409201</c:v>
                </c:pt>
                <c:pt idx="337">
                  <c:v>1.3321141059555299</c:v>
                </c:pt>
                <c:pt idx="338">
                  <c:v>0.19160782527946299</c:v>
                </c:pt>
                <c:pt idx="339">
                  <c:v>0.77354296433729297</c:v>
                </c:pt>
                <c:pt idx="340">
                  <c:v>0.78878414628254601</c:v>
                </c:pt>
                <c:pt idx="341">
                  <c:v>2.2655342103701299</c:v>
                </c:pt>
                <c:pt idx="342">
                  <c:v>2.2655342103701299</c:v>
                </c:pt>
                <c:pt idx="343">
                  <c:v>0.47266821656313801</c:v>
                </c:pt>
                <c:pt idx="344">
                  <c:v>0.47266821656313801</c:v>
                </c:pt>
                <c:pt idx="345">
                  <c:v>0.53244382003621304</c:v>
                </c:pt>
                <c:pt idx="346">
                  <c:v>0.53244382003621304</c:v>
                </c:pt>
                <c:pt idx="347">
                  <c:v>0.502651901098219</c:v>
                </c:pt>
                <c:pt idx="348">
                  <c:v>0.89939453334767405</c:v>
                </c:pt>
                <c:pt idx="349">
                  <c:v>0.90420389807260104</c:v>
                </c:pt>
                <c:pt idx="350">
                  <c:v>0.733146116043493</c:v>
                </c:pt>
                <c:pt idx="351">
                  <c:v>0.733146116043493</c:v>
                </c:pt>
                <c:pt idx="352">
                  <c:v>0.57953038614179198</c:v>
                </c:pt>
                <c:pt idx="353">
                  <c:v>0.57953038614179198</c:v>
                </c:pt>
                <c:pt idx="354">
                  <c:v>0.60042711192259901</c:v>
                </c:pt>
                <c:pt idx="355">
                  <c:v>0.60042711192259901</c:v>
                </c:pt>
                <c:pt idx="356">
                  <c:v>1.6694754090705199</c:v>
                </c:pt>
                <c:pt idx="357">
                  <c:v>1.5569276395831899</c:v>
                </c:pt>
                <c:pt idx="358">
                  <c:v>1.7265164384885301</c:v>
                </c:pt>
                <c:pt idx="359">
                  <c:v>0.78675159992790999</c:v>
                </c:pt>
                <c:pt idx="360">
                  <c:v>0.84419152272542597</c:v>
                </c:pt>
                <c:pt idx="361">
                  <c:v>0.81101150554304102</c:v>
                </c:pt>
                <c:pt idx="362">
                  <c:v>0.90006958603482001</c:v>
                </c:pt>
                <c:pt idx="363">
                  <c:v>0.69387605530009699</c:v>
                </c:pt>
                <c:pt idx="364">
                  <c:v>2.6770466776972102</c:v>
                </c:pt>
                <c:pt idx="365">
                  <c:v>0.83619265309469004</c:v>
                </c:pt>
                <c:pt idx="366">
                  <c:v>0.31137902056615802</c:v>
                </c:pt>
                <c:pt idx="367">
                  <c:v>0.22683534346157999</c:v>
                </c:pt>
                <c:pt idx="368">
                  <c:v>0.27136724520948702</c:v>
                </c:pt>
                <c:pt idx="369">
                  <c:v>0.246986124069077</c:v>
                </c:pt>
                <c:pt idx="370">
                  <c:v>0.406778999044345</c:v>
                </c:pt>
                <c:pt idx="371">
                  <c:v>0.14294121210591401</c:v>
                </c:pt>
                <c:pt idx="372">
                  <c:v>9.2098897940317906E-2</c:v>
                </c:pt>
                <c:pt idx="373">
                  <c:v>0.13413986468827299</c:v>
                </c:pt>
                <c:pt idx="374">
                  <c:v>0.242133992341279</c:v>
                </c:pt>
                <c:pt idx="375">
                  <c:v>0.62092700000340295</c:v>
                </c:pt>
                <c:pt idx="376">
                  <c:v>0.69137081390335597</c:v>
                </c:pt>
                <c:pt idx="377">
                  <c:v>0.16458841677484301</c:v>
                </c:pt>
                <c:pt idx="378">
                  <c:v>2.3068799078262199</c:v>
                </c:pt>
                <c:pt idx="379">
                  <c:v>0.28545409751209799</c:v>
                </c:pt>
                <c:pt idx="380">
                  <c:v>0.124803914324068</c:v>
                </c:pt>
                <c:pt idx="381">
                  <c:v>1.8573037398227099</c:v>
                </c:pt>
                <c:pt idx="382">
                  <c:v>0.52127385975742002</c:v>
                </c:pt>
                <c:pt idx="383">
                  <c:v>0.410837589394148</c:v>
                </c:pt>
                <c:pt idx="384">
                  <c:v>0.89973969539152399</c:v>
                </c:pt>
                <c:pt idx="385">
                  <c:v>0.71790247096374404</c:v>
                </c:pt>
                <c:pt idx="386">
                  <c:v>0.71790247096374404</c:v>
                </c:pt>
                <c:pt idx="387">
                  <c:v>0.18364742366079401</c:v>
                </c:pt>
                <c:pt idx="388">
                  <c:v>0.18364742366079401</c:v>
                </c:pt>
                <c:pt idx="389">
                  <c:v>0.79098881325731696</c:v>
                </c:pt>
                <c:pt idx="390">
                  <c:v>2.1101134773601999</c:v>
                </c:pt>
                <c:pt idx="391">
                  <c:v>0.88921910651878799</c:v>
                </c:pt>
                <c:pt idx="392">
                  <c:v>0.21478834229032201</c:v>
                </c:pt>
                <c:pt idx="393">
                  <c:v>2.4785353827336598</c:v>
                </c:pt>
                <c:pt idx="394">
                  <c:v>1.4904048212340799</c:v>
                </c:pt>
                <c:pt idx="395">
                  <c:v>0.94273544099652495</c:v>
                </c:pt>
                <c:pt idx="396">
                  <c:v>2.3549211150443101</c:v>
                </c:pt>
                <c:pt idx="397">
                  <c:v>0.46686547164218101</c:v>
                </c:pt>
                <c:pt idx="398">
                  <c:v>2.0870625487115002</c:v>
                </c:pt>
                <c:pt idx="399">
                  <c:v>1.6701680204878699</c:v>
                </c:pt>
                <c:pt idx="400">
                  <c:v>0.59743566747036303</c:v>
                </c:pt>
                <c:pt idx="401">
                  <c:v>0.68565200682229799</c:v>
                </c:pt>
                <c:pt idx="402">
                  <c:v>1.0332964237074</c:v>
                </c:pt>
                <c:pt idx="403">
                  <c:v>1.1731606716941201</c:v>
                </c:pt>
                <c:pt idx="404">
                  <c:v>0.70884478739127399</c:v>
                </c:pt>
                <c:pt idx="405">
                  <c:v>0.88510987802864904</c:v>
                </c:pt>
                <c:pt idx="406">
                  <c:v>0.85155175530005001</c:v>
                </c:pt>
                <c:pt idx="407">
                  <c:v>0.58405860686601396</c:v>
                </c:pt>
                <c:pt idx="408">
                  <c:v>0.90329824997137997</c:v>
                </c:pt>
                <c:pt idx="409">
                  <c:v>0.68238558221382695</c:v>
                </c:pt>
                <c:pt idx="410">
                  <c:v>0.92513159963630998</c:v>
                </c:pt>
                <c:pt idx="411">
                  <c:v>0.91110749248683398</c:v>
                </c:pt>
                <c:pt idx="412">
                  <c:v>1.0791167982076999</c:v>
                </c:pt>
                <c:pt idx="413">
                  <c:v>1.19046409309038</c:v>
                </c:pt>
                <c:pt idx="414">
                  <c:v>1.4399928332366501</c:v>
                </c:pt>
                <c:pt idx="415">
                  <c:v>0.68107102750133897</c:v>
                </c:pt>
                <c:pt idx="416">
                  <c:v>0.53373549373376405</c:v>
                </c:pt>
                <c:pt idx="417">
                  <c:v>0.79556515156722896</c:v>
                </c:pt>
                <c:pt idx="418">
                  <c:v>0.53315856971998599</c:v>
                </c:pt>
                <c:pt idx="419">
                  <c:v>0.301716405070028</c:v>
                </c:pt>
                <c:pt idx="420">
                  <c:v>0.64161107830526598</c:v>
                </c:pt>
                <c:pt idx="421">
                  <c:v>0.23880060232716399</c:v>
                </c:pt>
                <c:pt idx="422">
                  <c:v>0.721740026558779</c:v>
                </c:pt>
                <c:pt idx="423">
                  <c:v>0.85169469979398604</c:v>
                </c:pt>
                <c:pt idx="424">
                  <c:v>1.0484981592540701</c:v>
                </c:pt>
                <c:pt idx="425">
                  <c:v>0.215979390662728</c:v>
                </c:pt>
                <c:pt idx="426">
                  <c:v>0.693073277464202</c:v>
                </c:pt>
                <c:pt idx="427">
                  <c:v>0.323677704956088</c:v>
                </c:pt>
                <c:pt idx="428">
                  <c:v>0.205860756584924</c:v>
                </c:pt>
                <c:pt idx="429">
                  <c:v>8.7068865818062099E-2</c:v>
                </c:pt>
                <c:pt idx="430">
                  <c:v>0.57536924125563405</c:v>
                </c:pt>
                <c:pt idx="431">
                  <c:v>6.1601090127009199E-2</c:v>
                </c:pt>
                <c:pt idx="432">
                  <c:v>0.19139654518297999</c:v>
                </c:pt>
                <c:pt idx="433">
                  <c:v>0.25740030287201099</c:v>
                </c:pt>
                <c:pt idx="434">
                  <c:v>0.54214896606014396</c:v>
                </c:pt>
                <c:pt idx="435">
                  <c:v>0.308182629754296</c:v>
                </c:pt>
                <c:pt idx="436">
                  <c:v>0.31012466228379798</c:v>
                </c:pt>
                <c:pt idx="437">
                  <c:v>6.2435943298097998E-2</c:v>
                </c:pt>
                <c:pt idx="438">
                  <c:v>0.12800349685058199</c:v>
                </c:pt>
                <c:pt idx="439">
                  <c:v>0.25380601259607</c:v>
                </c:pt>
                <c:pt idx="440">
                  <c:v>4.9771814887441902E-2</c:v>
                </c:pt>
                <c:pt idx="441">
                  <c:v>0.61857522107445595</c:v>
                </c:pt>
                <c:pt idx="442">
                  <c:v>0.60409412635132997</c:v>
                </c:pt>
                <c:pt idx="443">
                  <c:v>0.52941028427385395</c:v>
                </c:pt>
                <c:pt idx="444">
                  <c:v>0.23880179909754001</c:v>
                </c:pt>
                <c:pt idx="445">
                  <c:v>0.31330408902453399</c:v>
                </c:pt>
                <c:pt idx="446">
                  <c:v>0.124771009258538</c:v>
                </c:pt>
                <c:pt idx="447">
                  <c:v>2.76823066713324E-2</c:v>
                </c:pt>
                <c:pt idx="448">
                  <c:v>0.77946350098010397</c:v>
                </c:pt>
                <c:pt idx="449">
                  <c:v>0.27858528808636801</c:v>
                </c:pt>
                <c:pt idx="450">
                  <c:v>0.30752455763660802</c:v>
                </c:pt>
                <c:pt idx="451">
                  <c:v>0.87509530014208003</c:v>
                </c:pt>
                <c:pt idx="452">
                  <c:v>0.10774164273907701</c:v>
                </c:pt>
                <c:pt idx="453">
                  <c:v>0.121253335788945</c:v>
                </c:pt>
                <c:pt idx="454">
                  <c:v>0.41463377526247902</c:v>
                </c:pt>
                <c:pt idx="455">
                  <c:v>0.248778718404077</c:v>
                </c:pt>
                <c:pt idx="456">
                  <c:v>0.167020400493781</c:v>
                </c:pt>
                <c:pt idx="457">
                  <c:v>0.38477852533229401</c:v>
                </c:pt>
                <c:pt idx="458">
                  <c:v>0.405429152602925</c:v>
                </c:pt>
                <c:pt idx="459">
                  <c:v>0.44132955639167798</c:v>
                </c:pt>
                <c:pt idx="460">
                  <c:v>5.3714595567494097E-2</c:v>
                </c:pt>
                <c:pt idx="461">
                  <c:v>0.28920557372188699</c:v>
                </c:pt>
                <c:pt idx="462">
                  <c:v>0.72640078695624499</c:v>
                </c:pt>
                <c:pt idx="463">
                  <c:v>0.32916270886259302</c:v>
                </c:pt>
                <c:pt idx="464">
                  <c:v>0.36162448952543802</c:v>
                </c:pt>
                <c:pt idx="465">
                  <c:v>0.49389875339285699</c:v>
                </c:pt>
                <c:pt idx="466">
                  <c:v>0.52266824848097004</c:v>
                </c:pt>
                <c:pt idx="467">
                  <c:v>0.23514211496047599</c:v>
                </c:pt>
                <c:pt idx="468">
                  <c:v>0.16071577483091601</c:v>
                </c:pt>
                <c:pt idx="469">
                  <c:v>0.87259533445442805</c:v>
                </c:pt>
                <c:pt idx="470">
                  <c:v>4.0973926890212897E-2</c:v>
                </c:pt>
                <c:pt idx="471">
                  <c:v>3.4649285843061699E-2</c:v>
                </c:pt>
                <c:pt idx="472">
                  <c:v>0.31105052016923301</c:v>
                </c:pt>
                <c:pt idx="473">
                  <c:v>0.47890326271977202</c:v>
                </c:pt>
                <c:pt idx="474">
                  <c:v>0.19688610991694899</c:v>
                </c:pt>
                <c:pt idx="475">
                  <c:v>0.177590079774952</c:v>
                </c:pt>
                <c:pt idx="476">
                  <c:v>0.61998068697175501</c:v>
                </c:pt>
                <c:pt idx="477">
                  <c:v>0.79121880684741996</c:v>
                </c:pt>
                <c:pt idx="478">
                  <c:v>0.99878744322145596</c:v>
                </c:pt>
                <c:pt idx="479">
                  <c:v>0.13021201367944901</c:v>
                </c:pt>
                <c:pt idx="480">
                  <c:v>0.100911222526449</c:v>
                </c:pt>
                <c:pt idx="481">
                  <c:v>0.19896261755948999</c:v>
                </c:pt>
                <c:pt idx="482">
                  <c:v>0.83331154556504905</c:v>
                </c:pt>
                <c:pt idx="483">
                  <c:v>0.40936639931304197</c:v>
                </c:pt>
                <c:pt idx="484">
                  <c:v>0.36260400263617099</c:v>
                </c:pt>
                <c:pt idx="485">
                  <c:v>0.34905305162239703</c:v>
                </c:pt>
                <c:pt idx="486">
                  <c:v>0.341132956418641</c:v>
                </c:pt>
                <c:pt idx="487">
                  <c:v>0.44453843449852398</c:v>
                </c:pt>
                <c:pt idx="488">
                  <c:v>1.8790091411943299</c:v>
                </c:pt>
                <c:pt idx="489">
                  <c:v>0.739295522652897</c:v>
                </c:pt>
                <c:pt idx="490">
                  <c:v>0.197565581097918</c:v>
                </c:pt>
                <c:pt idx="491">
                  <c:v>0.23035889249143199</c:v>
                </c:pt>
                <c:pt idx="492">
                  <c:v>0.20699468546376401</c:v>
                </c:pt>
                <c:pt idx="493">
                  <c:v>0.38704523911481897</c:v>
                </c:pt>
                <c:pt idx="494">
                  <c:v>0.264619390832118</c:v>
                </c:pt>
                <c:pt idx="495">
                  <c:v>1.3960795556082199</c:v>
                </c:pt>
                <c:pt idx="496">
                  <c:v>2.16202405227896</c:v>
                </c:pt>
                <c:pt idx="497">
                  <c:v>0.82578825360314501</c:v>
                </c:pt>
                <c:pt idx="498">
                  <c:v>1.1187139526943199</c:v>
                </c:pt>
                <c:pt idx="499">
                  <c:v>0.92944614276377302</c:v>
                </c:pt>
                <c:pt idx="500">
                  <c:v>1.0109482495748101</c:v>
                </c:pt>
                <c:pt idx="501">
                  <c:v>1.90151504144858</c:v>
                </c:pt>
                <c:pt idx="502">
                  <c:v>0.25323876117023802</c:v>
                </c:pt>
                <c:pt idx="503">
                  <c:v>0.26846350468195801</c:v>
                </c:pt>
                <c:pt idx="504">
                  <c:v>1.1593251145219099</c:v>
                </c:pt>
                <c:pt idx="505">
                  <c:v>0.45017912854146203</c:v>
                </c:pt>
                <c:pt idx="506">
                  <c:v>0.38777162718661801</c:v>
                </c:pt>
                <c:pt idx="507">
                  <c:v>0.69307247941684402</c:v>
                </c:pt>
                <c:pt idx="508">
                  <c:v>2.3021140202936099</c:v>
                </c:pt>
                <c:pt idx="509">
                  <c:v>1.5769404408590399</c:v>
                </c:pt>
                <c:pt idx="510">
                  <c:v>0.59913570702363905</c:v>
                </c:pt>
                <c:pt idx="511">
                  <c:v>0.44695745048301699</c:v>
                </c:pt>
                <c:pt idx="512">
                  <c:v>7.5875345029812996E-2</c:v>
                </c:pt>
                <c:pt idx="513">
                  <c:v>0.52587854866170702</c:v>
                </c:pt>
                <c:pt idx="514">
                  <c:v>0.41923843562569701</c:v>
                </c:pt>
                <c:pt idx="515">
                  <c:v>0.17036625216034301</c:v>
                </c:pt>
                <c:pt idx="516">
                  <c:v>0.42933105919652698</c:v>
                </c:pt>
                <c:pt idx="517">
                  <c:v>0.261544420475044</c:v>
                </c:pt>
                <c:pt idx="518">
                  <c:v>0.171063413994062</c:v>
                </c:pt>
                <c:pt idx="519">
                  <c:v>0.13594101800708699</c:v>
                </c:pt>
                <c:pt idx="520">
                  <c:v>0.66711093652735498</c:v>
                </c:pt>
                <c:pt idx="521">
                  <c:v>4.5824082155337703E-2</c:v>
                </c:pt>
                <c:pt idx="522">
                  <c:v>0.49176611281805299</c:v>
                </c:pt>
                <c:pt idx="523">
                  <c:v>0.147859718871932</c:v>
                </c:pt>
                <c:pt idx="524">
                  <c:v>0.16721439272316099</c:v>
                </c:pt>
                <c:pt idx="525">
                  <c:v>0.45410218795281299</c:v>
                </c:pt>
                <c:pt idx="526">
                  <c:v>0.18508530815230001</c:v>
                </c:pt>
                <c:pt idx="527">
                  <c:v>0.93830026384323595</c:v>
                </c:pt>
                <c:pt idx="528">
                  <c:v>0.11576178512204199</c:v>
                </c:pt>
                <c:pt idx="529">
                  <c:v>0.35554372809359402</c:v>
                </c:pt>
                <c:pt idx="530">
                  <c:v>0.33975102770877003</c:v>
                </c:pt>
                <c:pt idx="531">
                  <c:v>0.26315233401731503</c:v>
                </c:pt>
                <c:pt idx="532">
                  <c:v>0.368014725685401</c:v>
                </c:pt>
                <c:pt idx="533">
                  <c:v>0.31070286699890398</c:v>
                </c:pt>
                <c:pt idx="534">
                  <c:v>1.13509925416975</c:v>
                </c:pt>
                <c:pt idx="535">
                  <c:v>0.44949369323752802</c:v>
                </c:pt>
                <c:pt idx="536">
                  <c:v>0.14069631517478201</c:v>
                </c:pt>
                <c:pt idx="537">
                  <c:v>0.33066513762094102</c:v>
                </c:pt>
                <c:pt idx="538">
                  <c:v>5.6864753879432697E-2</c:v>
                </c:pt>
                <c:pt idx="539">
                  <c:v>0.59452697523935805</c:v>
                </c:pt>
                <c:pt idx="540">
                  <c:v>0.63278654581392701</c:v>
                </c:pt>
                <c:pt idx="541">
                  <c:v>0.65908877639069796</c:v>
                </c:pt>
                <c:pt idx="542">
                  <c:v>0.22580993837251301</c:v>
                </c:pt>
                <c:pt idx="543">
                  <c:v>0.79492971238240395</c:v>
                </c:pt>
                <c:pt idx="544">
                  <c:v>0.66781701775407798</c:v>
                </c:pt>
                <c:pt idx="545">
                  <c:v>0.64208332612051</c:v>
                </c:pt>
                <c:pt idx="546">
                  <c:v>0.77642240632093296</c:v>
                </c:pt>
                <c:pt idx="547">
                  <c:v>0.117683081223458</c:v>
                </c:pt>
                <c:pt idx="548">
                  <c:v>0.776240092387943</c:v>
                </c:pt>
                <c:pt idx="549">
                  <c:v>0.32658991486373501</c:v>
                </c:pt>
                <c:pt idx="550">
                  <c:v>0.54560226070206996</c:v>
                </c:pt>
                <c:pt idx="551">
                  <c:v>0.44735105457921898</c:v>
                </c:pt>
                <c:pt idx="552">
                  <c:v>1.1740724516996399</c:v>
                </c:pt>
                <c:pt idx="553">
                  <c:v>0.803095282231158</c:v>
                </c:pt>
                <c:pt idx="554">
                  <c:v>0.263455093787267</c:v>
                </c:pt>
                <c:pt idx="555">
                  <c:v>0.61740193785548603</c:v>
                </c:pt>
                <c:pt idx="556">
                  <c:v>0.62836357939367904</c:v>
                </c:pt>
                <c:pt idx="557">
                  <c:v>0.93458875280610199</c:v>
                </c:pt>
                <c:pt idx="558">
                  <c:v>0.502339399191847</c:v>
                </c:pt>
                <c:pt idx="559">
                  <c:v>0.78756090775399001</c:v>
                </c:pt>
                <c:pt idx="560">
                  <c:v>0.57516170656504895</c:v>
                </c:pt>
                <c:pt idx="561">
                  <c:v>5.6513145002222202E-2</c:v>
                </c:pt>
                <c:pt idx="562">
                  <c:v>1.00558367847841</c:v>
                </c:pt>
                <c:pt idx="563">
                  <c:v>1.52391341368516</c:v>
                </c:pt>
                <c:pt idx="564">
                  <c:v>0.168867903706654</c:v>
                </c:pt>
                <c:pt idx="565">
                  <c:v>0.28686763723646103</c:v>
                </c:pt>
                <c:pt idx="566">
                  <c:v>2.50665448568461</c:v>
                </c:pt>
                <c:pt idx="567">
                  <c:v>2.4340035076947002</c:v>
                </c:pt>
                <c:pt idx="568">
                  <c:v>0.68593333616700602</c:v>
                </c:pt>
                <c:pt idx="569">
                  <c:v>1.3986647924126401</c:v>
                </c:pt>
                <c:pt idx="570">
                  <c:v>1.5049354517207401</c:v>
                </c:pt>
                <c:pt idx="571">
                  <c:v>1.47991329107072</c:v>
                </c:pt>
                <c:pt idx="572">
                  <c:v>9.3343360658047797E-2</c:v>
                </c:pt>
                <c:pt idx="573">
                  <c:v>0.23781374718494999</c:v>
                </c:pt>
                <c:pt idx="574">
                  <c:v>0.53029825705655098</c:v>
                </c:pt>
                <c:pt idx="575">
                  <c:v>1.9259668625219699</c:v>
                </c:pt>
                <c:pt idx="576">
                  <c:v>0.80251344952782799</c:v>
                </c:pt>
                <c:pt idx="577">
                  <c:v>0.31959600584824599</c:v>
                </c:pt>
                <c:pt idx="578">
                  <c:v>0.84925387583295298</c:v>
                </c:pt>
                <c:pt idx="579">
                  <c:v>1.08942210053921</c:v>
                </c:pt>
                <c:pt idx="580">
                  <c:v>0.93001245657113796</c:v>
                </c:pt>
                <c:pt idx="581">
                  <c:v>0.46910901869144001</c:v>
                </c:pt>
                <c:pt idx="582">
                  <c:v>0.14887573230512899</c:v>
                </c:pt>
                <c:pt idx="583">
                  <c:v>6.6847700935668802E-2</c:v>
                </c:pt>
                <c:pt idx="584">
                  <c:v>0.50937506144125499</c:v>
                </c:pt>
                <c:pt idx="585">
                  <c:v>2.3112755327530699</c:v>
                </c:pt>
                <c:pt idx="586">
                  <c:v>1.83048170982628</c:v>
                </c:pt>
                <c:pt idx="587">
                  <c:v>2.05639299626039</c:v>
                </c:pt>
                <c:pt idx="588">
                  <c:v>1.4991365573779201</c:v>
                </c:pt>
                <c:pt idx="589">
                  <c:v>0.2574640905367</c:v>
                </c:pt>
                <c:pt idx="590">
                  <c:v>0.65493595188240405</c:v>
                </c:pt>
                <c:pt idx="591">
                  <c:v>1.09201484802083</c:v>
                </c:pt>
                <c:pt idx="592">
                  <c:v>0.97885510212484095</c:v>
                </c:pt>
                <c:pt idx="593">
                  <c:v>0.61605160790353597</c:v>
                </c:pt>
                <c:pt idx="594">
                  <c:v>0.55894912543025499</c:v>
                </c:pt>
                <c:pt idx="595">
                  <c:v>0.34231683509946997</c:v>
                </c:pt>
                <c:pt idx="596">
                  <c:v>0.57284272639238298</c:v>
                </c:pt>
                <c:pt idx="597">
                  <c:v>1.6273888188546899</c:v>
                </c:pt>
                <c:pt idx="598">
                  <c:v>1.0045843865261901</c:v>
                </c:pt>
                <c:pt idx="599">
                  <c:v>0.39183406741855498</c:v>
                </c:pt>
                <c:pt idx="600">
                  <c:v>0.25815836846161899</c:v>
                </c:pt>
                <c:pt idx="601">
                  <c:v>0.69806092985844603</c:v>
                </c:pt>
                <c:pt idx="602">
                  <c:v>1.62917483038057</c:v>
                </c:pt>
                <c:pt idx="603">
                  <c:v>0.41836125046615502</c:v>
                </c:pt>
                <c:pt idx="604">
                  <c:v>0.27948327877885998</c:v>
                </c:pt>
                <c:pt idx="605">
                  <c:v>0.42151907819714901</c:v>
                </c:pt>
                <c:pt idx="606">
                  <c:v>2.4108597587721099</c:v>
                </c:pt>
                <c:pt idx="607">
                  <c:v>1.03518499981135</c:v>
                </c:pt>
                <c:pt idx="608">
                  <c:v>3.7306073571970799E-2</c:v>
                </c:pt>
                <c:pt idx="609">
                  <c:v>1.1894398123863299</c:v>
                </c:pt>
                <c:pt idx="610">
                  <c:v>1.4774280569178599</c:v>
                </c:pt>
                <c:pt idx="611">
                  <c:v>1.36025375501746</c:v>
                </c:pt>
                <c:pt idx="612">
                  <c:v>0.75018844216203295</c:v>
                </c:pt>
                <c:pt idx="613">
                  <c:v>0.66958781956017299</c:v>
                </c:pt>
                <c:pt idx="614">
                  <c:v>0.85695059354023695</c:v>
                </c:pt>
                <c:pt idx="615">
                  <c:v>0.80406654146789303</c:v>
                </c:pt>
                <c:pt idx="616">
                  <c:v>0.94706756104291001</c:v>
                </c:pt>
                <c:pt idx="617">
                  <c:v>0.98816204025079402</c:v>
                </c:pt>
                <c:pt idx="618">
                  <c:v>0.16674403890839601</c:v>
                </c:pt>
                <c:pt idx="619">
                  <c:v>0.99085509525187199</c:v>
                </c:pt>
                <c:pt idx="620">
                  <c:v>1.01458950533835</c:v>
                </c:pt>
                <c:pt idx="621">
                  <c:v>0.12519655192899301</c:v>
                </c:pt>
                <c:pt idx="622">
                  <c:v>1.8237994803258299</c:v>
                </c:pt>
                <c:pt idx="623">
                  <c:v>0.83386363871467695</c:v>
                </c:pt>
                <c:pt idx="624">
                  <c:v>1.6077690912839999</c:v>
                </c:pt>
                <c:pt idx="625">
                  <c:v>0.65680551884815097</c:v>
                </c:pt>
                <c:pt idx="626">
                  <c:v>0.97840246102240802</c:v>
                </c:pt>
                <c:pt idx="627">
                  <c:v>1.2199520054124899</c:v>
                </c:pt>
                <c:pt idx="628">
                  <c:v>0.71096337267841103</c:v>
                </c:pt>
                <c:pt idx="629">
                  <c:v>0.92101086121165399</c:v>
                </c:pt>
                <c:pt idx="630">
                  <c:v>0.62349992463095205</c:v>
                </c:pt>
                <c:pt idx="631">
                  <c:v>0.61384634513273895</c:v>
                </c:pt>
                <c:pt idx="632">
                  <c:v>0.53358907918904697</c:v>
                </c:pt>
                <c:pt idx="633">
                  <c:v>0.58088596581986496</c:v>
                </c:pt>
                <c:pt idx="634">
                  <c:v>0.48508634595120798</c:v>
                </c:pt>
                <c:pt idx="635">
                  <c:v>0.48836728448704603</c:v>
                </c:pt>
                <c:pt idx="636">
                  <c:v>0.47043357736409802</c:v>
                </c:pt>
                <c:pt idx="637">
                  <c:v>0.72948788197543402</c:v>
                </c:pt>
                <c:pt idx="638">
                  <c:v>0.47018245530809899</c:v>
                </c:pt>
                <c:pt idx="639">
                  <c:v>4.68540524075024E-2</c:v>
                </c:pt>
                <c:pt idx="640">
                  <c:v>0.943743712414159</c:v>
                </c:pt>
                <c:pt idx="641">
                  <c:v>0.63466064413308598</c:v>
                </c:pt>
                <c:pt idx="642">
                  <c:v>0.55813295851218103</c:v>
                </c:pt>
                <c:pt idx="643">
                  <c:v>0.28793980781363898</c:v>
                </c:pt>
                <c:pt idx="644">
                  <c:v>0.56924113896984097</c:v>
                </c:pt>
                <c:pt idx="645">
                  <c:v>0.48234807583717998</c:v>
                </c:pt>
                <c:pt idx="646">
                  <c:v>0.42607553787367503</c:v>
                </c:pt>
                <c:pt idx="647">
                  <c:v>0.395325648230477</c:v>
                </c:pt>
                <c:pt idx="648">
                  <c:v>0.16534090901593301</c:v>
                </c:pt>
                <c:pt idx="649">
                  <c:v>0.55863045548704104</c:v>
                </c:pt>
                <c:pt idx="650">
                  <c:v>0.237106878863729</c:v>
                </c:pt>
                <c:pt idx="651">
                  <c:v>0.54823253155051199</c:v>
                </c:pt>
                <c:pt idx="652">
                  <c:v>0.36440808128582203</c:v>
                </c:pt>
                <c:pt idx="653">
                  <c:v>0.50271173100400501</c:v>
                </c:pt>
                <c:pt idx="654">
                  <c:v>0.46837610362398502</c:v>
                </c:pt>
                <c:pt idx="655">
                  <c:v>0.38598932017078003</c:v>
                </c:pt>
                <c:pt idx="656">
                  <c:v>0.45288048956240201</c:v>
                </c:pt>
                <c:pt idx="657">
                  <c:v>0.47254630782319801</c:v>
                </c:pt>
                <c:pt idx="658">
                  <c:v>0.81441476181155803</c:v>
                </c:pt>
                <c:pt idx="659">
                  <c:v>0.41363636483722199</c:v>
                </c:pt>
                <c:pt idx="660">
                  <c:v>0.35256095124980802</c:v>
                </c:pt>
                <c:pt idx="661">
                  <c:v>0.46339928704750999</c:v>
                </c:pt>
                <c:pt idx="662">
                  <c:v>0.39320968673883899</c:v>
                </c:pt>
                <c:pt idx="663">
                  <c:v>0.39642834620795703</c:v>
                </c:pt>
                <c:pt idx="664">
                  <c:v>0.40675618769102501</c:v>
                </c:pt>
                <c:pt idx="665">
                  <c:v>0.57232553087685301</c:v>
                </c:pt>
                <c:pt idx="666">
                  <c:v>7.7973325028767498E-2</c:v>
                </c:pt>
                <c:pt idx="667">
                  <c:v>0.52604181525284299</c:v>
                </c:pt>
                <c:pt idx="668">
                  <c:v>0.67641543890531697</c:v>
                </c:pt>
                <c:pt idx="669">
                  <c:v>2.9532510786860099E-2</c:v>
                </c:pt>
                <c:pt idx="670">
                  <c:v>2.83358316030233E-2</c:v>
                </c:pt>
                <c:pt idx="671">
                  <c:v>0.32694745125387598</c:v>
                </c:pt>
                <c:pt idx="672">
                  <c:v>0.34642652752034803</c:v>
                </c:pt>
                <c:pt idx="673">
                  <c:v>0.39551167614048799</c:v>
                </c:pt>
                <c:pt idx="674">
                  <c:v>1.3740955402080901</c:v>
                </c:pt>
                <c:pt idx="675">
                  <c:v>0.65340208069712702</c:v>
                </c:pt>
                <c:pt idx="676">
                  <c:v>0.48489107781880397</c:v>
                </c:pt>
                <c:pt idx="677">
                  <c:v>0.39839768332631997</c:v>
                </c:pt>
                <c:pt idx="678">
                  <c:v>0.39377426411308702</c:v>
                </c:pt>
                <c:pt idx="679">
                  <c:v>0.58207911007519697</c:v>
                </c:pt>
                <c:pt idx="680">
                  <c:v>0.518859595702721</c:v>
                </c:pt>
                <c:pt idx="681">
                  <c:v>0.99478486107519504</c:v>
                </c:pt>
                <c:pt idx="682">
                  <c:v>1.0400862681001399</c:v>
                </c:pt>
                <c:pt idx="683">
                  <c:v>0.36425523450672798</c:v>
                </c:pt>
                <c:pt idx="684">
                  <c:v>0.60714717672771101</c:v>
                </c:pt>
                <c:pt idx="685">
                  <c:v>0.708145591350965</c:v>
                </c:pt>
                <c:pt idx="686">
                  <c:v>0.52719175586124201</c:v>
                </c:pt>
                <c:pt idx="687">
                  <c:v>0.60409655136582197</c:v>
                </c:pt>
                <c:pt idx="688">
                  <c:v>0.41466184196815398</c:v>
                </c:pt>
                <c:pt idx="689">
                  <c:v>0.31233856911083402</c:v>
                </c:pt>
                <c:pt idx="690">
                  <c:v>0.48865477806345903</c:v>
                </c:pt>
                <c:pt idx="691">
                  <c:v>0.59773598739873801</c:v>
                </c:pt>
                <c:pt idx="692">
                  <c:v>0.42886368646186501</c:v>
                </c:pt>
                <c:pt idx="693">
                  <c:v>0.404731664988356</c:v>
                </c:pt>
                <c:pt idx="694">
                  <c:v>0.41793878644858301</c:v>
                </c:pt>
                <c:pt idx="695">
                  <c:v>0.63370896506626195</c:v>
                </c:pt>
                <c:pt idx="696">
                  <c:v>0.425860071549717</c:v>
                </c:pt>
                <c:pt idx="697">
                  <c:v>0.372248860618485</c:v>
                </c:pt>
                <c:pt idx="698">
                  <c:v>0.96935447730229696</c:v>
                </c:pt>
                <c:pt idx="699">
                  <c:v>0.50095407723162499</c:v>
                </c:pt>
                <c:pt idx="700">
                  <c:v>0.30275233416289499</c:v>
                </c:pt>
                <c:pt idx="701">
                  <c:v>0.27106317809763603</c:v>
                </c:pt>
                <c:pt idx="702">
                  <c:v>0.34549981862250001</c:v>
                </c:pt>
                <c:pt idx="703">
                  <c:v>0.31909265119063401</c:v>
                </c:pt>
                <c:pt idx="704">
                  <c:v>0.41446587235658999</c:v>
                </c:pt>
                <c:pt idx="705">
                  <c:v>0.45922797320827002</c:v>
                </c:pt>
                <c:pt idx="706">
                  <c:v>0.41510594075906299</c:v>
                </c:pt>
                <c:pt idx="707">
                  <c:v>0.38272459352184801</c:v>
                </c:pt>
                <c:pt idx="708">
                  <c:v>0.81463315006507298</c:v>
                </c:pt>
                <c:pt idx="709">
                  <c:v>0.122795016736685</c:v>
                </c:pt>
                <c:pt idx="710">
                  <c:v>0.45480694494470397</c:v>
                </c:pt>
                <c:pt idx="711">
                  <c:v>0.42839760973400598</c:v>
                </c:pt>
                <c:pt idx="712">
                  <c:v>0.60179709298043205</c:v>
                </c:pt>
                <c:pt idx="713">
                  <c:v>0.37983853313083898</c:v>
                </c:pt>
                <c:pt idx="714">
                  <c:v>0.40266802142014102</c:v>
                </c:pt>
                <c:pt idx="715">
                  <c:v>0.207657918788451</c:v>
                </c:pt>
                <c:pt idx="716">
                  <c:v>0.44762988919471203</c:v>
                </c:pt>
                <c:pt idx="717">
                  <c:v>0.45404785315143198</c:v>
                </c:pt>
                <c:pt idx="718">
                  <c:v>0.35435567625122399</c:v>
                </c:pt>
                <c:pt idx="719">
                  <c:v>0.43182228704481701</c:v>
                </c:pt>
                <c:pt idx="720">
                  <c:v>1.57501860773123</c:v>
                </c:pt>
                <c:pt idx="721">
                  <c:v>0.393313201092239</c:v>
                </c:pt>
                <c:pt idx="722">
                  <c:v>0.37979158213014602</c:v>
                </c:pt>
                <c:pt idx="723">
                  <c:v>0.219734503319024</c:v>
                </c:pt>
                <c:pt idx="724">
                  <c:v>0.44926666531818199</c:v>
                </c:pt>
                <c:pt idx="725">
                  <c:v>0.12586904915928501</c:v>
                </c:pt>
                <c:pt idx="726">
                  <c:v>0.39238633071864898</c:v>
                </c:pt>
                <c:pt idx="727">
                  <c:v>0.34288213588184002</c:v>
                </c:pt>
                <c:pt idx="728">
                  <c:v>0.55778598723794903</c:v>
                </c:pt>
                <c:pt idx="729">
                  <c:v>0.41948343160283003</c:v>
                </c:pt>
                <c:pt idx="730">
                  <c:v>0.496666060280894</c:v>
                </c:pt>
                <c:pt idx="731">
                  <c:v>0.87224506140967195</c:v>
                </c:pt>
                <c:pt idx="732">
                  <c:v>0.592144553099061</c:v>
                </c:pt>
                <c:pt idx="733">
                  <c:v>0.71169967698948</c:v>
                </c:pt>
                <c:pt idx="734">
                  <c:v>0.52033332437128499</c:v>
                </c:pt>
                <c:pt idx="735">
                  <c:v>0.68739345678836095</c:v>
                </c:pt>
                <c:pt idx="736">
                  <c:v>0.46675960065782601</c:v>
                </c:pt>
                <c:pt idx="737">
                  <c:v>0.35514473151973602</c:v>
                </c:pt>
                <c:pt idx="738">
                  <c:v>0.43831040843623598</c:v>
                </c:pt>
                <c:pt idx="739">
                  <c:v>0.44636165096444602</c:v>
                </c:pt>
                <c:pt idx="740">
                  <c:v>0.59494801749755799</c:v>
                </c:pt>
                <c:pt idx="741">
                  <c:v>0.30359364565097002</c:v>
                </c:pt>
                <c:pt idx="742">
                  <c:v>0.425376182071945</c:v>
                </c:pt>
                <c:pt idx="743">
                  <c:v>1.48887613168485</c:v>
                </c:pt>
                <c:pt idx="744">
                  <c:v>0.83988230623603499</c:v>
                </c:pt>
                <c:pt idx="745">
                  <c:v>0.95254808603468999</c:v>
                </c:pt>
                <c:pt idx="746">
                  <c:v>0.72537034618349805</c:v>
                </c:pt>
                <c:pt idx="747">
                  <c:v>0.653935180648749</c:v>
                </c:pt>
                <c:pt idx="748">
                  <c:v>0.69329489480005901</c:v>
                </c:pt>
                <c:pt idx="749">
                  <c:v>0.45403569567042601</c:v>
                </c:pt>
                <c:pt idx="750">
                  <c:v>0.23460651168709201</c:v>
                </c:pt>
                <c:pt idx="751">
                  <c:v>0.61776498695506699</c:v>
                </c:pt>
                <c:pt idx="752">
                  <c:v>0.44411310732532999</c:v>
                </c:pt>
                <c:pt idx="753">
                  <c:v>0.46686557867428202</c:v>
                </c:pt>
                <c:pt idx="754">
                  <c:v>0.53446160355741201</c:v>
                </c:pt>
                <c:pt idx="755">
                  <c:v>0.55216939659880104</c:v>
                </c:pt>
                <c:pt idx="756">
                  <c:v>0.48522904910278902</c:v>
                </c:pt>
                <c:pt idx="757">
                  <c:v>0.25471061417408197</c:v>
                </c:pt>
                <c:pt idx="758">
                  <c:v>0.96601132308730098</c:v>
                </c:pt>
                <c:pt idx="759">
                  <c:v>2.3914408319832499E-2</c:v>
                </c:pt>
                <c:pt idx="760">
                  <c:v>0.41451121324770601</c:v>
                </c:pt>
                <c:pt idx="761">
                  <c:v>0.39530456133695002</c:v>
                </c:pt>
                <c:pt idx="762">
                  <c:v>0.395630260522574</c:v>
                </c:pt>
                <c:pt idx="763">
                  <c:v>0.31898373834342703</c:v>
                </c:pt>
                <c:pt idx="764">
                  <c:v>0.50174042890512205</c:v>
                </c:pt>
                <c:pt idx="765">
                  <c:v>0.61849515140448197</c:v>
                </c:pt>
                <c:pt idx="766">
                  <c:v>0.27834639713685699</c:v>
                </c:pt>
                <c:pt idx="767">
                  <c:v>0.39249990009230401</c:v>
                </c:pt>
                <c:pt idx="768">
                  <c:v>0.34143191230347297</c:v>
                </c:pt>
                <c:pt idx="769">
                  <c:v>0.58568070551641505</c:v>
                </c:pt>
                <c:pt idx="770">
                  <c:v>0.31834790747132802</c:v>
                </c:pt>
                <c:pt idx="771">
                  <c:v>0.63331003471119796</c:v>
                </c:pt>
                <c:pt idx="772">
                  <c:v>0.40658032376390202</c:v>
                </c:pt>
                <c:pt idx="773">
                  <c:v>0.40653903829879201</c:v>
                </c:pt>
                <c:pt idx="774">
                  <c:v>0.486448961159482</c:v>
                </c:pt>
                <c:pt idx="775">
                  <c:v>0.64318345485538198</c:v>
                </c:pt>
                <c:pt idx="776">
                  <c:v>0.563675265485993</c:v>
                </c:pt>
                <c:pt idx="777">
                  <c:v>0.50265455420258898</c:v>
                </c:pt>
                <c:pt idx="778">
                  <c:v>0.62625824166096</c:v>
                </c:pt>
                <c:pt idx="779">
                  <c:v>0.47191436646064899</c:v>
                </c:pt>
                <c:pt idx="780">
                  <c:v>0.50657742297130004</c:v>
                </c:pt>
                <c:pt idx="781">
                  <c:v>0.16700970799332501</c:v>
                </c:pt>
                <c:pt idx="782">
                  <c:v>0.51415621969738901</c:v>
                </c:pt>
                <c:pt idx="783">
                  <c:v>0.224005102340018</c:v>
                </c:pt>
                <c:pt idx="784">
                  <c:v>0.52435413075468895</c:v>
                </c:pt>
                <c:pt idx="785">
                  <c:v>0.144601626685289</c:v>
                </c:pt>
                <c:pt idx="786">
                  <c:v>0.12877322695704899</c:v>
                </c:pt>
                <c:pt idx="787">
                  <c:v>0.74103566897218398</c:v>
                </c:pt>
                <c:pt idx="788">
                  <c:v>0.190792331619834</c:v>
                </c:pt>
                <c:pt idx="789">
                  <c:v>0.88400260045647605</c:v>
                </c:pt>
                <c:pt idx="790">
                  <c:v>0.397476063078534</c:v>
                </c:pt>
                <c:pt idx="791">
                  <c:v>8.4568508477333201E-2</c:v>
                </c:pt>
                <c:pt idx="792">
                  <c:v>9.1265525051181004E-2</c:v>
                </c:pt>
                <c:pt idx="793">
                  <c:v>0.395918684025791</c:v>
                </c:pt>
                <c:pt idx="794">
                  <c:v>7.76987270684876E-2</c:v>
                </c:pt>
                <c:pt idx="795">
                  <c:v>0.39623266326541601</c:v>
                </c:pt>
                <c:pt idx="796">
                  <c:v>0.30333615159827898</c:v>
                </c:pt>
                <c:pt idx="797">
                  <c:v>0.19410022668228599</c:v>
                </c:pt>
                <c:pt idx="798">
                  <c:v>0.158862206507357</c:v>
                </c:pt>
                <c:pt idx="799">
                  <c:v>0.59265750726891997</c:v>
                </c:pt>
                <c:pt idx="800">
                  <c:v>0.217067872711528</c:v>
                </c:pt>
                <c:pt idx="801">
                  <c:v>0.22488276222476999</c:v>
                </c:pt>
                <c:pt idx="802">
                  <c:v>0.213520952241079</c:v>
                </c:pt>
                <c:pt idx="803">
                  <c:v>0.23102359407887399</c:v>
                </c:pt>
                <c:pt idx="804">
                  <c:v>1.8729717032377802E-2</c:v>
                </c:pt>
                <c:pt idx="805">
                  <c:v>0.26691370067584202</c:v>
                </c:pt>
                <c:pt idx="806">
                  <c:v>0.192853556810996</c:v>
                </c:pt>
                <c:pt idx="807">
                  <c:v>0.157886079384842</c:v>
                </c:pt>
                <c:pt idx="808">
                  <c:v>0.70621734007220205</c:v>
                </c:pt>
                <c:pt idx="809">
                  <c:v>0.120034763454951</c:v>
                </c:pt>
                <c:pt idx="810">
                  <c:v>0.21752841791001201</c:v>
                </c:pt>
                <c:pt idx="811">
                  <c:v>3.7770879835166402E-2</c:v>
                </c:pt>
                <c:pt idx="812">
                  <c:v>1.2790201285515E-2</c:v>
                </c:pt>
                <c:pt idx="813">
                  <c:v>0.19968016390944399</c:v>
                </c:pt>
                <c:pt idx="814">
                  <c:v>0.62453835564437998</c:v>
                </c:pt>
                <c:pt idx="815">
                  <c:v>0.63173957303449502</c:v>
                </c:pt>
                <c:pt idx="816">
                  <c:v>0.79001635635081902</c:v>
                </c:pt>
                <c:pt idx="817">
                  <c:v>0.10975465910529</c:v>
                </c:pt>
                <c:pt idx="818">
                  <c:v>0.39270941921503499</c:v>
                </c:pt>
                <c:pt idx="819">
                  <c:v>6.7711789993608995E-2</c:v>
                </c:pt>
                <c:pt idx="820">
                  <c:v>0.27210192065768202</c:v>
                </c:pt>
                <c:pt idx="821">
                  <c:v>0.62177811510938996</c:v>
                </c:pt>
                <c:pt idx="822">
                  <c:v>4.1070436649519697E-2</c:v>
                </c:pt>
                <c:pt idx="823">
                  <c:v>2.6879753604841499E-2</c:v>
                </c:pt>
                <c:pt idx="824">
                  <c:v>0.14016254359236399</c:v>
                </c:pt>
                <c:pt idx="825">
                  <c:v>0.46617021715010998</c:v>
                </c:pt>
                <c:pt idx="826">
                  <c:v>0.11655778869747099</c:v>
                </c:pt>
                <c:pt idx="827">
                  <c:v>0.73609363886138202</c:v>
                </c:pt>
                <c:pt idx="828">
                  <c:v>6.9421569911962203E-2</c:v>
                </c:pt>
                <c:pt idx="829">
                  <c:v>0.17607226453139699</c:v>
                </c:pt>
                <c:pt idx="830">
                  <c:v>0.24561752466310899</c:v>
                </c:pt>
                <c:pt idx="831">
                  <c:v>6.5235793563271804E-2</c:v>
                </c:pt>
                <c:pt idx="832">
                  <c:v>0.20937667373911401</c:v>
                </c:pt>
                <c:pt idx="833">
                  <c:v>7.3418711979653994E-2</c:v>
                </c:pt>
                <c:pt idx="834">
                  <c:v>0.12724575680268399</c:v>
                </c:pt>
                <c:pt idx="835">
                  <c:v>0.45442057192636798</c:v>
                </c:pt>
                <c:pt idx="836">
                  <c:v>8.7291516362115296E-2</c:v>
                </c:pt>
                <c:pt idx="837">
                  <c:v>1.14229920471367</c:v>
                </c:pt>
                <c:pt idx="838">
                  <c:v>0.73512698523029596</c:v>
                </c:pt>
                <c:pt idx="839">
                  <c:v>0.27783765174324199</c:v>
                </c:pt>
                <c:pt idx="840">
                  <c:v>0.21348042310085999</c:v>
                </c:pt>
                <c:pt idx="841">
                  <c:v>0.31262158230817999</c:v>
                </c:pt>
                <c:pt idx="842">
                  <c:v>0.120277199067819</c:v>
                </c:pt>
                <c:pt idx="843">
                  <c:v>1.8268618720596298E-2</c:v>
                </c:pt>
                <c:pt idx="844">
                  <c:v>0.242569515416589</c:v>
                </c:pt>
                <c:pt idx="845">
                  <c:v>0.139176386375611</c:v>
                </c:pt>
                <c:pt idx="846">
                  <c:v>0.58726417157649902</c:v>
                </c:pt>
                <c:pt idx="847">
                  <c:v>8.0273791523694293E-2</c:v>
                </c:pt>
                <c:pt idx="848">
                  <c:v>0.24995461681079501</c:v>
                </c:pt>
                <c:pt idx="849">
                  <c:v>0.298739963991901</c:v>
                </c:pt>
                <c:pt idx="850">
                  <c:v>0.155465000882892</c:v>
                </c:pt>
                <c:pt idx="851">
                  <c:v>0.41971250295016399</c:v>
                </c:pt>
                <c:pt idx="852">
                  <c:v>0.13642112810118501</c:v>
                </c:pt>
                <c:pt idx="853">
                  <c:v>7.3122517950266405E-2</c:v>
                </c:pt>
                <c:pt idx="854">
                  <c:v>9.6859399517623901E-2</c:v>
                </c:pt>
                <c:pt idx="855">
                  <c:v>5.5831564348948502E-2</c:v>
                </c:pt>
                <c:pt idx="856">
                  <c:v>0.24024472527238699</c:v>
                </c:pt>
                <c:pt idx="857">
                  <c:v>0.40566435426803299</c:v>
                </c:pt>
                <c:pt idx="858">
                  <c:v>0.101653307892018</c:v>
                </c:pt>
                <c:pt idx="859">
                  <c:v>0.174265689379175</c:v>
                </c:pt>
                <c:pt idx="860">
                  <c:v>0.40527443534916202</c:v>
                </c:pt>
                <c:pt idx="861">
                  <c:v>0.57424947911712998</c:v>
                </c:pt>
                <c:pt idx="862">
                  <c:v>0.63443227995767904</c:v>
                </c:pt>
                <c:pt idx="863">
                  <c:v>0.14777745380798399</c:v>
                </c:pt>
                <c:pt idx="864">
                  <c:v>8.6182802499351105E-2</c:v>
                </c:pt>
                <c:pt idx="865">
                  <c:v>0.98112111722442397</c:v>
                </c:pt>
                <c:pt idx="866">
                  <c:v>0.13422276539366801</c:v>
                </c:pt>
                <c:pt idx="867">
                  <c:v>0.22802080187827301</c:v>
                </c:pt>
                <c:pt idx="868">
                  <c:v>0.69950885388954998</c:v>
                </c:pt>
                <c:pt idx="869">
                  <c:v>0.63464311947765395</c:v>
                </c:pt>
                <c:pt idx="870">
                  <c:v>0.21028700946792001</c:v>
                </c:pt>
                <c:pt idx="871">
                  <c:v>0.81402328696542403</c:v>
                </c:pt>
                <c:pt idx="872">
                  <c:v>7.9217177430360008E-3</c:v>
                </c:pt>
                <c:pt idx="873">
                  <c:v>0.15335717104458199</c:v>
                </c:pt>
                <c:pt idx="874">
                  <c:v>0.15422389141948101</c:v>
                </c:pt>
                <c:pt idx="875">
                  <c:v>0.35298397795585001</c:v>
                </c:pt>
                <c:pt idx="876">
                  <c:v>0.56525697994572399</c:v>
                </c:pt>
                <c:pt idx="877">
                  <c:v>0.54625125591736101</c:v>
                </c:pt>
                <c:pt idx="878">
                  <c:v>0.94845007701362904</c:v>
                </c:pt>
                <c:pt idx="879">
                  <c:v>0.20313208258434301</c:v>
                </c:pt>
                <c:pt idx="880">
                  <c:v>0.37503016502375702</c:v>
                </c:pt>
                <c:pt idx="881">
                  <c:v>1.0197239723145901</c:v>
                </c:pt>
                <c:pt idx="882">
                  <c:v>0.53298288338056099</c:v>
                </c:pt>
                <c:pt idx="883">
                  <c:v>0.361997855416541</c:v>
                </c:pt>
                <c:pt idx="884">
                  <c:v>1.1438446810633101</c:v>
                </c:pt>
                <c:pt idx="885">
                  <c:v>0.37118565851190599</c:v>
                </c:pt>
                <c:pt idx="886">
                  <c:v>0.396441685102154</c:v>
                </c:pt>
                <c:pt idx="887">
                  <c:v>0.34699136098411598</c:v>
                </c:pt>
                <c:pt idx="888">
                  <c:v>8.3803680527350502E-2</c:v>
                </c:pt>
                <c:pt idx="889">
                  <c:v>0.25444436348685701</c:v>
                </c:pt>
                <c:pt idx="890">
                  <c:v>0.451172723008754</c:v>
                </c:pt>
                <c:pt idx="891">
                  <c:v>0.66167794486676001</c:v>
                </c:pt>
                <c:pt idx="892">
                  <c:v>0.219591963126305</c:v>
                </c:pt>
                <c:pt idx="893">
                  <c:v>4.9088273739905E-2</c:v>
                </c:pt>
                <c:pt idx="894">
                  <c:v>0.105146858225698</c:v>
                </c:pt>
                <c:pt idx="895">
                  <c:v>9.1663775092210801E-3</c:v>
                </c:pt>
                <c:pt idx="896">
                  <c:v>8.5710338284431295E-2</c:v>
                </c:pt>
                <c:pt idx="897">
                  <c:v>5.15575860204779E-2</c:v>
                </c:pt>
                <c:pt idx="898">
                  <c:v>0.20633259921826699</c:v>
                </c:pt>
                <c:pt idx="899">
                  <c:v>0.145995311746899</c:v>
                </c:pt>
                <c:pt idx="900">
                  <c:v>5.1241448503366697E-2</c:v>
                </c:pt>
                <c:pt idx="901">
                  <c:v>8.2492015991956505E-2</c:v>
                </c:pt>
                <c:pt idx="902">
                  <c:v>0.952629192746967</c:v>
                </c:pt>
                <c:pt idx="903">
                  <c:v>1.0158947478689999</c:v>
                </c:pt>
                <c:pt idx="904">
                  <c:v>0.16445049874656201</c:v>
                </c:pt>
                <c:pt idx="905">
                  <c:v>0.67459875119561097</c:v>
                </c:pt>
                <c:pt idx="906">
                  <c:v>0.33264288306171202</c:v>
                </c:pt>
                <c:pt idx="907">
                  <c:v>0.17534832715287199</c:v>
                </c:pt>
                <c:pt idx="908">
                  <c:v>0.436885842251789</c:v>
                </c:pt>
                <c:pt idx="909">
                  <c:v>0.89234115263578095</c:v>
                </c:pt>
                <c:pt idx="910">
                  <c:v>1.3810096563943699</c:v>
                </c:pt>
                <c:pt idx="911">
                  <c:v>0.54842239461652398</c:v>
                </c:pt>
                <c:pt idx="912">
                  <c:v>3.7663119840627202E-2</c:v>
                </c:pt>
                <c:pt idx="913">
                  <c:v>5.46698731560471E-2</c:v>
                </c:pt>
                <c:pt idx="914">
                  <c:v>0.51719153517118399</c:v>
                </c:pt>
                <c:pt idx="915">
                  <c:v>0.103972163394685</c:v>
                </c:pt>
                <c:pt idx="916">
                  <c:v>0.375957163735472</c:v>
                </c:pt>
                <c:pt idx="917">
                  <c:v>0.71936589921203598</c:v>
                </c:pt>
                <c:pt idx="918">
                  <c:v>0.13244880364532199</c:v>
                </c:pt>
                <c:pt idx="919">
                  <c:v>7.8638937410337506E-2</c:v>
                </c:pt>
                <c:pt idx="920">
                  <c:v>1.1637358661152699</c:v>
                </c:pt>
                <c:pt idx="921">
                  <c:v>0.34645914562672597</c:v>
                </c:pt>
                <c:pt idx="922">
                  <c:v>1.30050253938706</c:v>
                </c:pt>
                <c:pt idx="923">
                  <c:v>0.49648946359572399</c:v>
                </c:pt>
                <c:pt idx="924">
                  <c:v>0.33566701035994001</c:v>
                </c:pt>
                <c:pt idx="925">
                  <c:v>0.27468876074730098</c:v>
                </c:pt>
                <c:pt idx="926">
                  <c:v>0.155802370055935</c:v>
                </c:pt>
                <c:pt idx="927">
                  <c:v>0.543007773414526</c:v>
                </c:pt>
                <c:pt idx="928">
                  <c:v>0.13257298865870101</c:v>
                </c:pt>
                <c:pt idx="929">
                  <c:v>0.60990248467947605</c:v>
                </c:pt>
                <c:pt idx="930">
                  <c:v>0.17631037044554199</c:v>
                </c:pt>
                <c:pt idx="931">
                  <c:v>0.150587671118139</c:v>
                </c:pt>
                <c:pt idx="932">
                  <c:v>0.45918755594979499</c:v>
                </c:pt>
                <c:pt idx="933">
                  <c:v>0.94941554482373802</c:v>
                </c:pt>
                <c:pt idx="934">
                  <c:v>0.58988655393992595</c:v>
                </c:pt>
                <c:pt idx="935">
                  <c:v>0.91845636420263899</c:v>
                </c:pt>
                <c:pt idx="936">
                  <c:v>0.24801819790438001</c:v>
                </c:pt>
                <c:pt idx="937">
                  <c:v>8.0036383281663799E-3</c:v>
                </c:pt>
                <c:pt idx="938">
                  <c:v>0.193904782448848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26-46AD-AA78-8C0263ABFF3A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Diabetes (2)'!$D$2:$D$38</c:f>
              <c:numCache>
                <c:formatCode>General</c:formatCode>
                <c:ptCount val="37"/>
                <c:pt idx="0">
                  <c:v>-1.8914775131837001</c:v>
                </c:pt>
                <c:pt idx="1">
                  <c:v>-0.85904291125906096</c:v>
                </c:pt>
                <c:pt idx="2">
                  <c:v>-0.81640781265898299</c:v>
                </c:pt>
                <c:pt idx="3">
                  <c:v>-2.5737655443811902</c:v>
                </c:pt>
                <c:pt idx="4">
                  <c:v>-0.81618998279785304</c:v>
                </c:pt>
                <c:pt idx="5">
                  <c:v>-2.9546066686074401</c:v>
                </c:pt>
                <c:pt idx="6">
                  <c:v>-2.9631893320024298</c:v>
                </c:pt>
                <c:pt idx="7">
                  <c:v>-2.9546066686074401</c:v>
                </c:pt>
                <c:pt idx="8">
                  <c:v>-2.9546066686074401</c:v>
                </c:pt>
                <c:pt idx="9">
                  <c:v>-0.90482141885128398</c:v>
                </c:pt>
                <c:pt idx="10">
                  <c:v>-0.90482141885128398</c:v>
                </c:pt>
                <c:pt idx="11">
                  <c:v>-2.8233467202984901</c:v>
                </c:pt>
                <c:pt idx="12">
                  <c:v>-2.0326023216045601</c:v>
                </c:pt>
                <c:pt idx="13">
                  <c:v>-2.1711890046643698</c:v>
                </c:pt>
                <c:pt idx="14">
                  <c:v>-2.5974714746569898</c:v>
                </c:pt>
                <c:pt idx="15">
                  <c:v>-0.76398552525719499</c:v>
                </c:pt>
                <c:pt idx="16">
                  <c:v>-0.92214288372637498</c:v>
                </c:pt>
                <c:pt idx="17">
                  <c:v>-0.72812288210918996</c:v>
                </c:pt>
                <c:pt idx="18">
                  <c:v>-0.84115249699615802</c:v>
                </c:pt>
                <c:pt idx="19">
                  <c:v>-0.794559803567227</c:v>
                </c:pt>
                <c:pt idx="20">
                  <c:v>-3.2499098155249899</c:v>
                </c:pt>
                <c:pt idx="21">
                  <c:v>-0.61924505778945904</c:v>
                </c:pt>
                <c:pt idx="22">
                  <c:v>-0.61924505778945904</c:v>
                </c:pt>
                <c:pt idx="23">
                  <c:v>-0.63594300869334697</c:v>
                </c:pt>
                <c:pt idx="24">
                  <c:v>-0.82174123743555805</c:v>
                </c:pt>
                <c:pt idx="25">
                  <c:v>-1.1289134436813899</c:v>
                </c:pt>
                <c:pt idx="26">
                  <c:v>-2.87468914039655</c:v>
                </c:pt>
                <c:pt idx="27">
                  <c:v>-2.9129485003603599</c:v>
                </c:pt>
                <c:pt idx="28">
                  <c:v>-3.1705786561747198</c:v>
                </c:pt>
                <c:pt idx="29">
                  <c:v>-0.97196903436577098</c:v>
                </c:pt>
                <c:pt idx="30">
                  <c:v>-1.61216553677737</c:v>
                </c:pt>
                <c:pt idx="31">
                  <c:v>-0.61769736407777298</c:v>
                </c:pt>
                <c:pt idx="32">
                  <c:v>-0.62452815608629497</c:v>
                </c:pt>
                <c:pt idx="33">
                  <c:v>-0.66444382416271397</c:v>
                </c:pt>
                <c:pt idx="34">
                  <c:v>-0.65722295482784399</c:v>
                </c:pt>
                <c:pt idx="35">
                  <c:v>-0.76675818204822599</c:v>
                </c:pt>
                <c:pt idx="36">
                  <c:v>-0.92943986633917297</c:v>
                </c:pt>
              </c:numCache>
            </c:numRef>
          </c:xVal>
          <c:yVal>
            <c:numRef>
              <c:f>'Diabetes (2)'!$E$2:$E$38</c:f>
              <c:numCache>
                <c:formatCode>General</c:formatCode>
                <c:ptCount val="37"/>
                <c:pt idx="0">
                  <c:v>2.10066706832185</c:v>
                </c:pt>
                <c:pt idx="1">
                  <c:v>1.88257438044437</c:v>
                </c:pt>
                <c:pt idx="2">
                  <c:v>1.3836682190826399</c:v>
                </c:pt>
                <c:pt idx="3">
                  <c:v>1.9838112584163901</c:v>
                </c:pt>
                <c:pt idx="4">
                  <c:v>1.66783035684543</c:v>
                </c:pt>
                <c:pt idx="5">
                  <c:v>1.24290570671004</c:v>
                </c:pt>
                <c:pt idx="6">
                  <c:v>1.2388019762490801</c:v>
                </c:pt>
                <c:pt idx="7">
                  <c:v>1.24290570671004</c:v>
                </c:pt>
                <c:pt idx="8">
                  <c:v>1.24290570671004</c:v>
                </c:pt>
                <c:pt idx="9">
                  <c:v>2.6092747687004998</c:v>
                </c:pt>
                <c:pt idx="10">
                  <c:v>2.6092747687004998</c:v>
                </c:pt>
                <c:pt idx="11">
                  <c:v>2.02679982091442</c:v>
                </c:pt>
                <c:pt idx="12">
                  <c:v>1.3829563148622599</c:v>
                </c:pt>
                <c:pt idx="13">
                  <c:v>1.9059293015230201</c:v>
                </c:pt>
                <c:pt idx="14">
                  <c:v>1.9536625349143499</c:v>
                </c:pt>
                <c:pt idx="15">
                  <c:v>1.3861091759652</c:v>
                </c:pt>
                <c:pt idx="16">
                  <c:v>2.4681523571150099</c:v>
                </c:pt>
                <c:pt idx="17">
                  <c:v>1.33733859726309</c:v>
                </c:pt>
                <c:pt idx="18">
                  <c:v>1.9067925906302501</c:v>
                </c:pt>
                <c:pt idx="19">
                  <c:v>2.2679001707508899</c:v>
                </c:pt>
                <c:pt idx="20">
                  <c:v>1.2412290244923101</c:v>
                </c:pt>
                <c:pt idx="21">
                  <c:v>1.05370600384602</c:v>
                </c:pt>
                <c:pt idx="22">
                  <c:v>1.05370600384602</c:v>
                </c:pt>
                <c:pt idx="23">
                  <c:v>1.3709213189787499</c:v>
                </c:pt>
                <c:pt idx="24">
                  <c:v>1.7879566512766001</c:v>
                </c:pt>
                <c:pt idx="25">
                  <c:v>2.4980897376960201</c:v>
                </c:pt>
                <c:pt idx="26">
                  <c:v>2.1255224851099199</c:v>
                </c:pt>
                <c:pt idx="27">
                  <c:v>1.2089968160776901</c:v>
                </c:pt>
                <c:pt idx="28">
                  <c:v>2.06601349850121</c:v>
                </c:pt>
                <c:pt idx="29">
                  <c:v>1.62697792554684</c:v>
                </c:pt>
                <c:pt idx="30">
                  <c:v>1.73746646531087</c:v>
                </c:pt>
                <c:pt idx="31">
                  <c:v>1.23164525063023</c:v>
                </c:pt>
                <c:pt idx="32">
                  <c:v>1.2120659177202899</c:v>
                </c:pt>
                <c:pt idx="33">
                  <c:v>1.56435331081228</c:v>
                </c:pt>
                <c:pt idx="34">
                  <c:v>1.01770508672855</c:v>
                </c:pt>
                <c:pt idx="35">
                  <c:v>2.3760675506791999</c:v>
                </c:pt>
                <c:pt idx="36">
                  <c:v>2.31196671441407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B26-46AD-AA78-8C0263ABFF3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Diabetes (2)'!$G$2:$G$103</c:f>
              <c:numCache>
                <c:formatCode>General</c:formatCode>
                <c:ptCount val="102"/>
                <c:pt idx="0">
                  <c:v>1.9357307041952501</c:v>
                </c:pt>
                <c:pt idx="1">
                  <c:v>0.90618872498368597</c:v>
                </c:pt>
                <c:pt idx="2">
                  <c:v>2.6928971493481599</c:v>
                </c:pt>
                <c:pt idx="3">
                  <c:v>2.3846665297198499</c:v>
                </c:pt>
                <c:pt idx="4">
                  <c:v>0.66877863918904201</c:v>
                </c:pt>
                <c:pt idx="5">
                  <c:v>1.18939430108511</c:v>
                </c:pt>
                <c:pt idx="6">
                  <c:v>0.82463984719370798</c:v>
                </c:pt>
                <c:pt idx="7">
                  <c:v>1.2380450246814301</c:v>
                </c:pt>
                <c:pt idx="8">
                  <c:v>2.2200389181486702</c:v>
                </c:pt>
                <c:pt idx="9">
                  <c:v>4.3345061200228603</c:v>
                </c:pt>
                <c:pt idx="10">
                  <c:v>3.7695953390478798</c:v>
                </c:pt>
                <c:pt idx="11">
                  <c:v>3.2300131031332802</c:v>
                </c:pt>
                <c:pt idx="12">
                  <c:v>1.0413508036575401</c:v>
                </c:pt>
                <c:pt idx="13">
                  <c:v>0.76927152078382199</c:v>
                </c:pt>
                <c:pt idx="14">
                  <c:v>4.1672288310182299</c:v>
                </c:pt>
                <c:pt idx="15">
                  <c:v>3.4183802189934598</c:v>
                </c:pt>
                <c:pt idx="16">
                  <c:v>0.92966070592674399</c:v>
                </c:pt>
                <c:pt idx="17">
                  <c:v>1.06167971741037</c:v>
                </c:pt>
                <c:pt idx="18">
                  <c:v>0.87037750631572497</c:v>
                </c:pt>
                <c:pt idx="19">
                  <c:v>1.5861258669790499</c:v>
                </c:pt>
                <c:pt idx="20">
                  <c:v>0.81714965685589303</c:v>
                </c:pt>
                <c:pt idx="21">
                  <c:v>1.9506628941656201</c:v>
                </c:pt>
                <c:pt idx="22">
                  <c:v>1.5861258669790499</c:v>
                </c:pt>
                <c:pt idx="23">
                  <c:v>0.617843356808501</c:v>
                </c:pt>
                <c:pt idx="24">
                  <c:v>3.3864049535633902</c:v>
                </c:pt>
                <c:pt idx="25">
                  <c:v>2.2186077568998801</c:v>
                </c:pt>
                <c:pt idx="26">
                  <c:v>0.92092422601410695</c:v>
                </c:pt>
                <c:pt idx="27">
                  <c:v>2.7972050068946599</c:v>
                </c:pt>
                <c:pt idx="28">
                  <c:v>1.38987495952408</c:v>
                </c:pt>
                <c:pt idx="29">
                  <c:v>0.656404025324689</c:v>
                </c:pt>
                <c:pt idx="30">
                  <c:v>1.9162975696386999</c:v>
                </c:pt>
                <c:pt idx="31">
                  <c:v>1.5861258669790499</c:v>
                </c:pt>
                <c:pt idx="32">
                  <c:v>0.62649004345207404</c:v>
                </c:pt>
                <c:pt idx="33">
                  <c:v>1.0000539937995701</c:v>
                </c:pt>
                <c:pt idx="34">
                  <c:v>0.97657806915700895</c:v>
                </c:pt>
                <c:pt idx="35">
                  <c:v>4.03650514914957</c:v>
                </c:pt>
                <c:pt idx="36">
                  <c:v>0.85733721448548605</c:v>
                </c:pt>
                <c:pt idx="37">
                  <c:v>1.1541707162802299</c:v>
                </c:pt>
                <c:pt idx="38">
                  <c:v>2.3710650004012401</c:v>
                </c:pt>
                <c:pt idx="39">
                  <c:v>1.2426899449358699</c:v>
                </c:pt>
                <c:pt idx="40">
                  <c:v>0.880803035444511</c:v>
                </c:pt>
                <c:pt idx="41">
                  <c:v>0.60268460069313701</c:v>
                </c:pt>
                <c:pt idx="42">
                  <c:v>0.94321552884627802</c:v>
                </c:pt>
                <c:pt idx="43">
                  <c:v>1.21823040143511</c:v>
                </c:pt>
                <c:pt idx="44">
                  <c:v>1.12644522845996</c:v>
                </c:pt>
                <c:pt idx="45">
                  <c:v>1.00793911440532</c:v>
                </c:pt>
                <c:pt idx="46">
                  <c:v>14.1460588848163</c:v>
                </c:pt>
                <c:pt idx="47">
                  <c:v>0.616989545706357</c:v>
                </c:pt>
                <c:pt idx="48">
                  <c:v>2.8237267898648999</c:v>
                </c:pt>
                <c:pt idx="49">
                  <c:v>0.79993669970518599</c:v>
                </c:pt>
                <c:pt idx="50">
                  <c:v>3.9359319699767101</c:v>
                </c:pt>
                <c:pt idx="51">
                  <c:v>1.9162975696386999</c:v>
                </c:pt>
                <c:pt idx="52">
                  <c:v>17.215415379668201</c:v>
                </c:pt>
                <c:pt idx="53">
                  <c:v>4.1971632297210402</c:v>
                </c:pt>
                <c:pt idx="54">
                  <c:v>1.11310405606012</c:v>
                </c:pt>
                <c:pt idx="55">
                  <c:v>5.4248651517244104</c:v>
                </c:pt>
                <c:pt idx="56">
                  <c:v>5.4248651517244104</c:v>
                </c:pt>
                <c:pt idx="57">
                  <c:v>1.5385089471281199</c:v>
                </c:pt>
                <c:pt idx="58">
                  <c:v>5.50525650166158</c:v>
                </c:pt>
                <c:pt idx="59">
                  <c:v>0.91392056818767797</c:v>
                </c:pt>
                <c:pt idx="60">
                  <c:v>0.70494254182379101</c:v>
                </c:pt>
                <c:pt idx="61">
                  <c:v>0.79807330972169299</c:v>
                </c:pt>
                <c:pt idx="62">
                  <c:v>1.3412255938000099</c:v>
                </c:pt>
                <c:pt idx="63">
                  <c:v>3.36999197840094</c:v>
                </c:pt>
                <c:pt idx="64">
                  <c:v>4.2114917229389297</c:v>
                </c:pt>
                <c:pt idx="65">
                  <c:v>1.89623669385323</c:v>
                </c:pt>
                <c:pt idx="66">
                  <c:v>1.1494962113943601</c:v>
                </c:pt>
                <c:pt idx="67">
                  <c:v>3.70179119042951</c:v>
                </c:pt>
                <c:pt idx="68">
                  <c:v>0.93318026377723495</c:v>
                </c:pt>
                <c:pt idx="69">
                  <c:v>2.4552353784949101</c:v>
                </c:pt>
                <c:pt idx="70">
                  <c:v>0.75096378719985701</c:v>
                </c:pt>
                <c:pt idx="71">
                  <c:v>0.61724254009865298</c:v>
                </c:pt>
                <c:pt idx="72">
                  <c:v>1.36157746542876</c:v>
                </c:pt>
                <c:pt idx="73">
                  <c:v>1.16505209035961</c:v>
                </c:pt>
                <c:pt idx="74">
                  <c:v>1.4315885912942401</c:v>
                </c:pt>
                <c:pt idx="75">
                  <c:v>0.89346374561101605</c:v>
                </c:pt>
                <c:pt idx="76">
                  <c:v>1.1235259991120901</c:v>
                </c:pt>
                <c:pt idx="77">
                  <c:v>0.76781658952888598</c:v>
                </c:pt>
                <c:pt idx="78">
                  <c:v>2.6212645495942</c:v>
                </c:pt>
                <c:pt idx="79">
                  <c:v>0.71295461678608796</c:v>
                </c:pt>
                <c:pt idx="80">
                  <c:v>0.743598700663609</c:v>
                </c:pt>
                <c:pt idx="81">
                  <c:v>0.65457606338445495</c:v>
                </c:pt>
                <c:pt idx="82">
                  <c:v>1.1305051125021801</c:v>
                </c:pt>
                <c:pt idx="83">
                  <c:v>3.7699239487314098</c:v>
                </c:pt>
                <c:pt idx="84">
                  <c:v>1.1912954526763699</c:v>
                </c:pt>
                <c:pt idx="85">
                  <c:v>2.0439093803703701</c:v>
                </c:pt>
                <c:pt idx="86">
                  <c:v>5.7679921971502397</c:v>
                </c:pt>
                <c:pt idx="87">
                  <c:v>1.03153020924892</c:v>
                </c:pt>
                <c:pt idx="88">
                  <c:v>0.787506176679583</c:v>
                </c:pt>
                <c:pt idx="89">
                  <c:v>2.4086631765217299</c:v>
                </c:pt>
                <c:pt idx="90">
                  <c:v>2.4008304378800398</c:v>
                </c:pt>
                <c:pt idx="91">
                  <c:v>0.74360854798244302</c:v>
                </c:pt>
                <c:pt idx="92">
                  <c:v>1.4443014048898499</c:v>
                </c:pt>
                <c:pt idx="93">
                  <c:v>3.5491385099736399</c:v>
                </c:pt>
                <c:pt idx="94">
                  <c:v>0.67911023690869998</c:v>
                </c:pt>
                <c:pt idx="95">
                  <c:v>0.68657023305242404</c:v>
                </c:pt>
                <c:pt idx="96">
                  <c:v>2.1916327205653001</c:v>
                </c:pt>
                <c:pt idx="97">
                  <c:v>0.98577353426973102</c:v>
                </c:pt>
                <c:pt idx="98">
                  <c:v>1.4641073086674301</c:v>
                </c:pt>
                <c:pt idx="99">
                  <c:v>1.16485657406145</c:v>
                </c:pt>
                <c:pt idx="100">
                  <c:v>0.90458807622898496</c:v>
                </c:pt>
                <c:pt idx="101">
                  <c:v>1.0384280154872501</c:v>
                </c:pt>
              </c:numCache>
            </c:numRef>
          </c:xVal>
          <c:yVal>
            <c:numRef>
              <c:f>'Diabetes (2)'!$H$2:$H$103</c:f>
              <c:numCache>
                <c:formatCode>General</c:formatCode>
                <c:ptCount val="102"/>
                <c:pt idx="0">
                  <c:v>1.5242124877935399</c:v>
                </c:pt>
                <c:pt idx="1">
                  <c:v>1.77880260382502</c:v>
                </c:pt>
                <c:pt idx="2">
                  <c:v>1.69342597950635</c:v>
                </c:pt>
                <c:pt idx="3">
                  <c:v>1.8023519855436601</c:v>
                </c:pt>
                <c:pt idx="4">
                  <c:v>1.4006934213104201</c:v>
                </c:pt>
                <c:pt idx="5">
                  <c:v>2.3899401813535999</c:v>
                </c:pt>
                <c:pt idx="6">
                  <c:v>1.1487236930526601</c:v>
                </c:pt>
                <c:pt idx="7">
                  <c:v>1.63056361537282</c:v>
                </c:pt>
                <c:pt idx="8">
                  <c:v>1.6827223394656801</c:v>
                </c:pt>
                <c:pt idx="9">
                  <c:v>1.51897869696401</c:v>
                </c:pt>
                <c:pt idx="10">
                  <c:v>1.65733081872299</c:v>
                </c:pt>
                <c:pt idx="11">
                  <c:v>2.1164414538435898</c:v>
                </c:pt>
                <c:pt idx="12">
                  <c:v>1.1369684738494299</c:v>
                </c:pt>
                <c:pt idx="13">
                  <c:v>1.947136317337</c:v>
                </c:pt>
                <c:pt idx="14">
                  <c:v>1.49587982509564</c:v>
                </c:pt>
                <c:pt idx="15">
                  <c:v>2.0045793961483902</c:v>
                </c:pt>
                <c:pt idx="16">
                  <c:v>1.32864306365687</c:v>
                </c:pt>
                <c:pt idx="17">
                  <c:v>2.2931429271327</c:v>
                </c:pt>
                <c:pt idx="18">
                  <c:v>2.02253266545216</c:v>
                </c:pt>
                <c:pt idx="19">
                  <c:v>1.25271230112709</c:v>
                </c:pt>
                <c:pt idx="20">
                  <c:v>2.1446595736994598</c:v>
                </c:pt>
                <c:pt idx="21">
                  <c:v>2.36433842677364</c:v>
                </c:pt>
                <c:pt idx="22">
                  <c:v>1.25271230112709</c:v>
                </c:pt>
                <c:pt idx="23">
                  <c:v>1.1054005066958399</c:v>
                </c:pt>
                <c:pt idx="24">
                  <c:v>2.5613591658703099</c:v>
                </c:pt>
                <c:pt idx="25">
                  <c:v>1.7932140778644201</c:v>
                </c:pt>
                <c:pt idx="26">
                  <c:v>1.28835374698462</c:v>
                </c:pt>
                <c:pt idx="27">
                  <c:v>1.5867344711065501</c:v>
                </c:pt>
                <c:pt idx="28">
                  <c:v>1.0274487872320599</c:v>
                </c:pt>
                <c:pt idx="29">
                  <c:v>1.9939933605446201</c:v>
                </c:pt>
                <c:pt idx="30">
                  <c:v>1.1444808701213101</c:v>
                </c:pt>
                <c:pt idx="31">
                  <c:v>1.25271230112709</c:v>
                </c:pt>
                <c:pt idx="32">
                  <c:v>1.40218608061182</c:v>
                </c:pt>
                <c:pt idx="33">
                  <c:v>1.88940105837502</c:v>
                </c:pt>
                <c:pt idx="34">
                  <c:v>2.0865488086933102</c:v>
                </c:pt>
                <c:pt idx="35">
                  <c:v>1.5570762907162701</c:v>
                </c:pt>
                <c:pt idx="36">
                  <c:v>1.79460242000076</c:v>
                </c:pt>
                <c:pt idx="37">
                  <c:v>1.2774681873546201</c:v>
                </c:pt>
                <c:pt idx="38">
                  <c:v>2.0433747110178699</c:v>
                </c:pt>
                <c:pt idx="39">
                  <c:v>1.6750239243259299</c:v>
                </c:pt>
                <c:pt idx="40">
                  <c:v>1.7795902182811301</c:v>
                </c:pt>
                <c:pt idx="41">
                  <c:v>1.03429207155713</c:v>
                </c:pt>
                <c:pt idx="42">
                  <c:v>1.90488197381008</c:v>
                </c:pt>
                <c:pt idx="43">
                  <c:v>1.38728726436725</c:v>
                </c:pt>
                <c:pt idx="44">
                  <c:v>1.2088290513581299</c:v>
                </c:pt>
                <c:pt idx="45">
                  <c:v>1.18447949709986</c:v>
                </c:pt>
                <c:pt idx="46">
                  <c:v>1.2503096143666199</c:v>
                </c:pt>
                <c:pt idx="47">
                  <c:v>1.38488446706946</c:v>
                </c:pt>
                <c:pt idx="48">
                  <c:v>1.7156709641282999</c:v>
                </c:pt>
                <c:pt idx="49">
                  <c:v>2.2683517972611602</c:v>
                </c:pt>
                <c:pt idx="50">
                  <c:v>2.7237681762528099</c:v>
                </c:pt>
                <c:pt idx="51">
                  <c:v>1.1444808701213101</c:v>
                </c:pt>
                <c:pt idx="52">
                  <c:v>1.2854735341843899</c:v>
                </c:pt>
                <c:pt idx="53">
                  <c:v>1.66386029982918</c:v>
                </c:pt>
                <c:pt idx="54">
                  <c:v>1.0650361619484201</c:v>
                </c:pt>
                <c:pt idx="55">
                  <c:v>1.7308822755958899</c:v>
                </c:pt>
                <c:pt idx="56">
                  <c:v>1.7308822755958899</c:v>
                </c:pt>
                <c:pt idx="57">
                  <c:v>1.9617217683244399</c:v>
                </c:pt>
                <c:pt idx="58">
                  <c:v>1.73948929645828</c:v>
                </c:pt>
                <c:pt idx="59">
                  <c:v>1.77757065972456</c:v>
                </c:pt>
                <c:pt idx="60">
                  <c:v>1.7358254031643201</c:v>
                </c:pt>
                <c:pt idx="61">
                  <c:v>1.9445942192652801</c:v>
                </c:pt>
                <c:pt idx="62">
                  <c:v>1.9108372075428399</c:v>
                </c:pt>
                <c:pt idx="63">
                  <c:v>1.1913743204426499</c:v>
                </c:pt>
                <c:pt idx="64">
                  <c:v>1.30194551025765</c:v>
                </c:pt>
                <c:pt idx="65">
                  <c:v>2.3886341580869401</c:v>
                </c:pt>
                <c:pt idx="66">
                  <c:v>1.4014063429721999</c:v>
                </c:pt>
                <c:pt idx="67">
                  <c:v>1.5572328307801899</c:v>
                </c:pt>
                <c:pt idx="68">
                  <c:v>1.8156201037448001</c:v>
                </c:pt>
                <c:pt idx="69">
                  <c:v>1.4720842495228901</c:v>
                </c:pt>
                <c:pt idx="70">
                  <c:v>1.1138772227154301</c:v>
                </c:pt>
                <c:pt idx="71">
                  <c:v>1.13301849523558</c:v>
                </c:pt>
                <c:pt idx="72">
                  <c:v>2.16669745062618</c:v>
                </c:pt>
                <c:pt idx="73">
                  <c:v>2.6488049613592102</c:v>
                </c:pt>
                <c:pt idx="74">
                  <c:v>1.5611762432944101</c:v>
                </c:pt>
                <c:pt idx="75">
                  <c:v>2.15001766608375</c:v>
                </c:pt>
                <c:pt idx="76">
                  <c:v>2.1592932094765098</c:v>
                </c:pt>
                <c:pt idx="77">
                  <c:v>1.5000177982815801</c:v>
                </c:pt>
                <c:pt idx="78">
                  <c:v>2.03382764750405</c:v>
                </c:pt>
                <c:pt idx="79">
                  <c:v>1.3400904597391601</c:v>
                </c:pt>
                <c:pt idx="80">
                  <c:v>1.4374099833147</c:v>
                </c:pt>
                <c:pt idx="81">
                  <c:v>1.7891290364047501</c:v>
                </c:pt>
                <c:pt idx="82">
                  <c:v>1.5135351138893101</c:v>
                </c:pt>
                <c:pt idx="83">
                  <c:v>2.2935689842476399</c:v>
                </c:pt>
                <c:pt idx="84">
                  <c:v>1.5225443772232501</c:v>
                </c:pt>
                <c:pt idx="85">
                  <c:v>2.3598140008539299</c:v>
                </c:pt>
                <c:pt idx="86">
                  <c:v>1.79123542663572</c:v>
                </c:pt>
                <c:pt idx="87">
                  <c:v>1.8131488520897501</c:v>
                </c:pt>
                <c:pt idx="88">
                  <c:v>1.2573671544377201</c:v>
                </c:pt>
                <c:pt idx="89">
                  <c:v>2.1432324436736301</c:v>
                </c:pt>
                <c:pt idx="90">
                  <c:v>1.4784924348355399</c:v>
                </c:pt>
                <c:pt idx="91">
                  <c:v>1.04735487670256</c:v>
                </c:pt>
                <c:pt idx="92">
                  <c:v>1.55569927350237</c:v>
                </c:pt>
                <c:pt idx="93">
                  <c:v>1.43980331384322</c:v>
                </c:pt>
                <c:pt idx="94">
                  <c:v>1.31198547970819</c:v>
                </c:pt>
                <c:pt idx="95">
                  <c:v>1.3663280762655501</c:v>
                </c:pt>
                <c:pt idx="96">
                  <c:v>1.48943261600633</c:v>
                </c:pt>
                <c:pt idx="97">
                  <c:v>2.30504901770224</c:v>
                </c:pt>
                <c:pt idx="98">
                  <c:v>1.8050766500478901</c:v>
                </c:pt>
                <c:pt idx="99">
                  <c:v>1.2444292105461701</c:v>
                </c:pt>
                <c:pt idx="100">
                  <c:v>1.3586743301708</c:v>
                </c:pt>
                <c:pt idx="101">
                  <c:v>1.60229821227705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B26-46AD-AA78-8C0263ABFF3A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1B26-46AD-AA78-8C0263ABFF3A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0</c:v>
              </c:pt>
              <c:pt idx="1">
                <c:v>20</c:v>
              </c:pt>
            </c:numLit>
          </c:xVal>
          <c:yVal>
            <c:numLit>
              <c:formatCode>General</c:formatCode>
              <c:ptCount val="2"/>
              <c:pt idx="0">
                <c:v>1</c:v>
              </c:pt>
              <c:pt idx="1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1B26-46AD-AA78-8C0263ABFF3A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1B26-46AD-AA78-8C0263ABFF3A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1B26-46AD-AA78-8C0263ABFF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20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</a:t>
                </a:r>
                <a:r>
                  <a:rPr lang="en-US"/>
                  <a:t>HPVB /</a:t>
                </a:r>
                <a:r>
                  <a:rPr lang="en-US" baseline="0"/>
                  <a:t> PB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5"/>
      </c:valAx>
      <c:valAx>
        <c:axId val="872775711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P (oPLS-DA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0"/>
        <c:crossBetween val="midCat"/>
        <c:majorUnit val="1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49578643136832"/>
          <c:y val="7.7611111111111117E-2"/>
          <c:w val="0.7997399373267402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HFD - NC Prot'!$B$1</c:f>
              <c:strCache>
                <c:ptCount val="1"/>
                <c:pt idx="0">
                  <c:v>-log10q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- NC Prot'!$A$2:$A$3441</c:f>
              <c:numCache>
                <c:formatCode>General</c:formatCode>
                <c:ptCount val="3440"/>
                <c:pt idx="0">
                  <c:v>-0.17886126250929635</c:v>
                </c:pt>
                <c:pt idx="1">
                  <c:v>0.39110779997457817</c:v>
                </c:pt>
                <c:pt idx="2">
                  <c:v>0.15419432499278973</c:v>
                </c:pt>
                <c:pt idx="3">
                  <c:v>-0.54224813127260663</c:v>
                </c:pt>
                <c:pt idx="4">
                  <c:v>0.44084591823726571</c:v>
                </c:pt>
                <c:pt idx="5">
                  <c:v>-1.3751972347470529</c:v>
                </c:pt>
                <c:pt idx="6">
                  <c:v>9.4905029474524356E-3</c:v>
                </c:pt>
                <c:pt idx="7">
                  <c:v>0.10124665668343902</c:v>
                </c:pt>
                <c:pt idx="8">
                  <c:v>0.15730246631897368</c:v>
                </c:pt>
                <c:pt idx="9">
                  <c:v>1.5616438487872883</c:v>
                </c:pt>
                <c:pt idx="10">
                  <c:v>0.21138606167942936</c:v>
                </c:pt>
                <c:pt idx="11">
                  <c:v>-0.20856097412755825</c:v>
                </c:pt>
                <c:pt idx="12">
                  <c:v>0.52957110757389492</c:v>
                </c:pt>
                <c:pt idx="13">
                  <c:v>0.1056780778945372</c:v>
                </c:pt>
                <c:pt idx="14">
                  <c:v>-1.4427671804501932E-4</c:v>
                </c:pt>
                <c:pt idx="15">
                  <c:v>0.12776532814854508</c:v>
                </c:pt>
                <c:pt idx="16">
                  <c:v>-0.29000363108859872</c:v>
                </c:pt>
                <c:pt idx="17">
                  <c:v>-0.24639546372000481</c:v>
                </c:pt>
                <c:pt idx="18">
                  <c:v>6.0600829554117094E-2</c:v>
                </c:pt>
                <c:pt idx="19">
                  <c:v>-0.11091590140185059</c:v>
                </c:pt>
                <c:pt idx="20">
                  <c:v>-1.5665855159511612E-2</c:v>
                </c:pt>
                <c:pt idx="21">
                  <c:v>0.83713591392318309</c:v>
                </c:pt>
                <c:pt idx="22">
                  <c:v>6.1015774681628034E-2</c:v>
                </c:pt>
                <c:pt idx="23">
                  <c:v>-2.6058163871946174E-2</c:v>
                </c:pt>
                <c:pt idx="24">
                  <c:v>-0.39687813016000373</c:v>
                </c:pt>
                <c:pt idx="25">
                  <c:v>-0.89405378809467551</c:v>
                </c:pt>
                <c:pt idx="26">
                  <c:v>-0.38326591504372898</c:v>
                </c:pt>
                <c:pt idx="27">
                  <c:v>0.16130726372093501</c:v>
                </c:pt>
                <c:pt idx="28">
                  <c:v>0.20551763289270666</c:v>
                </c:pt>
                <c:pt idx="29">
                  <c:v>0.90303827011291216</c:v>
                </c:pt>
                <c:pt idx="30">
                  <c:v>0.26915286721717357</c:v>
                </c:pt>
                <c:pt idx="31">
                  <c:v>0.2542312073752227</c:v>
                </c:pt>
                <c:pt idx="32">
                  <c:v>-0.23090534396884144</c:v>
                </c:pt>
                <c:pt idx="33">
                  <c:v>0.26627682332247754</c:v>
                </c:pt>
                <c:pt idx="34">
                  <c:v>9.2883965678484434E-2</c:v>
                </c:pt>
                <c:pt idx="35">
                  <c:v>0.4849114869108278</c:v>
                </c:pt>
                <c:pt idx="36">
                  <c:v>6.621180122379962E-3</c:v>
                </c:pt>
                <c:pt idx="37">
                  <c:v>-0.17853467619417457</c:v>
                </c:pt>
                <c:pt idx="38">
                  <c:v>0.2002532315936873</c:v>
                </c:pt>
                <c:pt idx="39">
                  <c:v>7.9130816432649298E-3</c:v>
                </c:pt>
                <c:pt idx="40">
                  <c:v>0.20876694742141266</c:v>
                </c:pt>
                <c:pt idx="41">
                  <c:v>-0.38986692354393793</c:v>
                </c:pt>
                <c:pt idx="42">
                  <c:v>-0.61374085886665386</c:v>
                </c:pt>
                <c:pt idx="43">
                  <c:v>0.24366908096686266</c:v>
                </c:pt>
                <c:pt idx="44">
                  <c:v>0.23707417130215752</c:v>
                </c:pt>
                <c:pt idx="45">
                  <c:v>-0.20323614209555665</c:v>
                </c:pt>
                <c:pt idx="46">
                  <c:v>0.62583155823354941</c:v>
                </c:pt>
                <c:pt idx="47">
                  <c:v>-0.1157537604723288</c:v>
                </c:pt>
                <c:pt idx="48">
                  <c:v>-0.27753397552890902</c:v>
                </c:pt>
                <c:pt idx="49">
                  <c:v>0.1373723636933977</c:v>
                </c:pt>
                <c:pt idx="50">
                  <c:v>1.7415317039794205</c:v>
                </c:pt>
                <c:pt idx="51">
                  <c:v>0.11076412189980746</c:v>
                </c:pt>
                <c:pt idx="52">
                  <c:v>-7.0865820402710765E-3</c:v>
                </c:pt>
                <c:pt idx="53">
                  <c:v>0.32849183030484769</c:v>
                </c:pt>
                <c:pt idx="54">
                  <c:v>0.49692246600807122</c:v>
                </c:pt>
                <c:pt idx="55">
                  <c:v>-1.2897465098613576E-2</c:v>
                </c:pt>
                <c:pt idx="56">
                  <c:v>0.37617923151752053</c:v>
                </c:pt>
                <c:pt idx="57">
                  <c:v>0.15081959821213325</c:v>
                </c:pt>
                <c:pt idx="58">
                  <c:v>0.27357556561537982</c:v>
                </c:pt>
                <c:pt idx="59">
                  <c:v>0.26843439357638349</c:v>
                </c:pt>
                <c:pt idx="60">
                  <c:v>0.62919339686218323</c:v>
                </c:pt>
                <c:pt idx="61">
                  <c:v>0.28688114778816154</c:v>
                </c:pt>
                <c:pt idx="62">
                  <c:v>-7.2315692310758635E-3</c:v>
                </c:pt>
                <c:pt idx="63">
                  <c:v>0.18865411783672911</c:v>
                </c:pt>
                <c:pt idx="64">
                  <c:v>6.3226801996981316E-2</c:v>
                </c:pt>
                <c:pt idx="65">
                  <c:v>0.31521841136578999</c:v>
                </c:pt>
                <c:pt idx="66">
                  <c:v>0.23927582588255761</c:v>
                </c:pt>
                <c:pt idx="67">
                  <c:v>-0.33061033798716322</c:v>
                </c:pt>
                <c:pt idx="68">
                  <c:v>0.32492578405532102</c:v>
                </c:pt>
                <c:pt idx="69">
                  <c:v>-1.3481331652347563</c:v>
                </c:pt>
                <c:pt idx="70">
                  <c:v>0.21797514092288733</c:v>
                </c:pt>
                <c:pt idx="71">
                  <c:v>-0.41696237620333604</c:v>
                </c:pt>
                <c:pt idx="72">
                  <c:v>-0.11076011121316849</c:v>
                </c:pt>
                <c:pt idx="73">
                  <c:v>0.40414016626392429</c:v>
                </c:pt>
                <c:pt idx="74">
                  <c:v>-0.17006927816035736</c:v>
                </c:pt>
                <c:pt idx="75">
                  <c:v>0.44413695658759167</c:v>
                </c:pt>
                <c:pt idx="76">
                  <c:v>-2.1365037713555978E-2</c:v>
                </c:pt>
                <c:pt idx="77">
                  <c:v>-4.8561405768748102E-2</c:v>
                </c:pt>
                <c:pt idx="78">
                  <c:v>0.10299399332332565</c:v>
                </c:pt>
                <c:pt idx="79">
                  <c:v>-0.35254732994575438</c:v>
                </c:pt>
                <c:pt idx="80">
                  <c:v>-0.11935365232556311</c:v>
                </c:pt>
                <c:pt idx="81">
                  <c:v>0.17248751551013405</c:v>
                </c:pt>
                <c:pt idx="82">
                  <c:v>0.52034681151940132</c:v>
                </c:pt>
                <c:pt idx="83">
                  <c:v>0.23401073310840068</c:v>
                </c:pt>
                <c:pt idx="84">
                  <c:v>-0.16585513393679513</c:v>
                </c:pt>
                <c:pt idx="85">
                  <c:v>0.26627682332247754</c:v>
                </c:pt>
                <c:pt idx="86">
                  <c:v>-0.18213119827201343</c:v>
                </c:pt>
                <c:pt idx="87">
                  <c:v>0.21225804420273489</c:v>
                </c:pt>
                <c:pt idx="88">
                  <c:v>0.13369503251307499</c:v>
                </c:pt>
                <c:pt idx="89">
                  <c:v>0.31452252179161477</c:v>
                </c:pt>
                <c:pt idx="90">
                  <c:v>0.16517231793716666</c:v>
                </c:pt>
                <c:pt idx="91">
                  <c:v>-3.6112535523788363E-3</c:v>
                </c:pt>
                <c:pt idx="92">
                  <c:v>-0.30543177499116642</c:v>
                </c:pt>
                <c:pt idx="93">
                  <c:v>-0.26326525550880248</c:v>
                </c:pt>
                <c:pt idx="94">
                  <c:v>-1.6103455397704806E-2</c:v>
                </c:pt>
                <c:pt idx="95">
                  <c:v>4.3484497603579468E-2</c:v>
                </c:pt>
                <c:pt idx="96">
                  <c:v>0.22366967138824589</c:v>
                </c:pt>
                <c:pt idx="97">
                  <c:v>-0.31616882559867737</c:v>
                </c:pt>
                <c:pt idx="98">
                  <c:v>0.2709474874770586</c:v>
                </c:pt>
                <c:pt idx="99">
                  <c:v>1.8634174139050975E-2</c:v>
                </c:pt>
                <c:pt idx="100">
                  <c:v>-0.34208565731962409</c:v>
                </c:pt>
                <c:pt idx="101">
                  <c:v>-0.28138630102451551</c:v>
                </c:pt>
                <c:pt idx="102">
                  <c:v>-0.14337278830160996</c:v>
                </c:pt>
                <c:pt idx="103">
                  <c:v>-0.68223286148778028</c:v>
                </c:pt>
                <c:pt idx="104">
                  <c:v>-8.2682824543577699E-2</c:v>
                </c:pt>
                <c:pt idx="105">
                  <c:v>-0.44379132826041501</c:v>
                </c:pt>
                <c:pt idx="106">
                  <c:v>1.8349309878891815E-2</c:v>
                </c:pt>
                <c:pt idx="107">
                  <c:v>2.6304324351908496E-2</c:v>
                </c:pt>
                <c:pt idx="108">
                  <c:v>4.1803687657085198E-2</c:v>
                </c:pt>
                <c:pt idx="109">
                  <c:v>0.11169907219742027</c:v>
                </c:pt>
                <c:pt idx="110">
                  <c:v>1.7209290032223101E-2</c:v>
                </c:pt>
                <c:pt idx="111">
                  <c:v>6.6950243924627034E-2</c:v>
                </c:pt>
                <c:pt idx="112">
                  <c:v>-0.52159762196272674</c:v>
                </c:pt>
                <c:pt idx="113">
                  <c:v>0.88885038176729736</c:v>
                </c:pt>
                <c:pt idx="114">
                  <c:v>0.4362684647193904</c:v>
                </c:pt>
                <c:pt idx="115">
                  <c:v>0.83017418043241098</c:v>
                </c:pt>
                <c:pt idx="116">
                  <c:v>0.43498843946050963</c:v>
                </c:pt>
                <c:pt idx="117">
                  <c:v>0.33113192221720217</c:v>
                </c:pt>
                <c:pt idx="118">
                  <c:v>-8.0392953091645014E-2</c:v>
                </c:pt>
                <c:pt idx="119">
                  <c:v>-6.9906105987850617E-2</c:v>
                </c:pt>
                <c:pt idx="120">
                  <c:v>0.2649567179648224</c:v>
                </c:pt>
                <c:pt idx="121">
                  <c:v>1.5786006361527425</c:v>
                </c:pt>
                <c:pt idx="122">
                  <c:v>-6.3107698010950411E-2</c:v>
                </c:pt>
                <c:pt idx="123">
                  <c:v>0.27154519848568659</c:v>
                </c:pt>
                <c:pt idx="124">
                  <c:v>-0.29565918669681096</c:v>
                </c:pt>
                <c:pt idx="125">
                  <c:v>-0.19710370520817377</c:v>
                </c:pt>
                <c:pt idx="126">
                  <c:v>0.45101324294397299</c:v>
                </c:pt>
                <c:pt idx="127">
                  <c:v>0.23130951607250091</c:v>
                </c:pt>
                <c:pt idx="128">
                  <c:v>0.12895322038600612</c:v>
                </c:pt>
                <c:pt idx="129">
                  <c:v>-2.9735320985471221E-2</c:v>
                </c:pt>
                <c:pt idx="130">
                  <c:v>-7.2786191607014744E-2</c:v>
                </c:pt>
                <c:pt idx="131">
                  <c:v>-0.32535857091417558</c:v>
                </c:pt>
                <c:pt idx="132">
                  <c:v>0.10017031975697704</c:v>
                </c:pt>
                <c:pt idx="133">
                  <c:v>0.12617994882319306</c:v>
                </c:pt>
                <c:pt idx="134">
                  <c:v>-0.62148837674627011</c:v>
                </c:pt>
                <c:pt idx="135">
                  <c:v>-0.15440959115214525</c:v>
                </c:pt>
                <c:pt idx="136">
                  <c:v>0.63264047586563177</c:v>
                </c:pt>
                <c:pt idx="137">
                  <c:v>0.60255189747165994</c:v>
                </c:pt>
                <c:pt idx="138">
                  <c:v>0.13711000780235091</c:v>
                </c:pt>
                <c:pt idx="139">
                  <c:v>-0.28191241603948319</c:v>
                </c:pt>
                <c:pt idx="140">
                  <c:v>0.11129845340254099</c:v>
                </c:pt>
                <c:pt idx="141">
                  <c:v>4.1777607891099701E-3</c:v>
                </c:pt>
                <c:pt idx="142">
                  <c:v>0.32849183030484769</c:v>
                </c:pt>
                <c:pt idx="143">
                  <c:v>0.57318060278937322</c:v>
                </c:pt>
                <c:pt idx="144">
                  <c:v>0.32446500633154179</c:v>
                </c:pt>
                <c:pt idx="145">
                  <c:v>-0.20839427529544829</c:v>
                </c:pt>
                <c:pt idx="146">
                  <c:v>0.2566483898806774</c:v>
                </c:pt>
                <c:pt idx="147">
                  <c:v>3.125402547050081E-2</c:v>
                </c:pt>
                <c:pt idx="148">
                  <c:v>-0.10562845003872474</c:v>
                </c:pt>
                <c:pt idx="149">
                  <c:v>-5.9946037903044792E-2</c:v>
                </c:pt>
                <c:pt idx="150">
                  <c:v>6.2812492405021181E-2</c:v>
                </c:pt>
                <c:pt idx="151">
                  <c:v>-4.0971781056306174E-2</c:v>
                </c:pt>
                <c:pt idx="152">
                  <c:v>0.36994102225426628</c:v>
                </c:pt>
                <c:pt idx="153">
                  <c:v>-0.14273555549933767</c:v>
                </c:pt>
                <c:pt idx="154">
                  <c:v>-0.22735419690730771</c:v>
                </c:pt>
                <c:pt idx="155">
                  <c:v>6.1015774681628034E-2</c:v>
                </c:pt>
                <c:pt idx="156">
                  <c:v>0.23315180343929373</c:v>
                </c:pt>
                <c:pt idx="157">
                  <c:v>-1.4353850282750529E-2</c:v>
                </c:pt>
                <c:pt idx="158">
                  <c:v>0.19547359238726494</c:v>
                </c:pt>
                <c:pt idx="159">
                  <c:v>-0.34464817138744597</c:v>
                </c:pt>
                <c:pt idx="160">
                  <c:v>-9.2186374903252696E-2</c:v>
                </c:pt>
                <c:pt idx="161">
                  <c:v>-7.4608159907542701E-2</c:v>
                </c:pt>
                <c:pt idx="162">
                  <c:v>-7.8868388814834711E-2</c:v>
                </c:pt>
                <c:pt idx="163">
                  <c:v>1.166522644328112</c:v>
                </c:pt>
                <c:pt idx="164">
                  <c:v>3.8900274333718426E-3</c:v>
                </c:pt>
                <c:pt idx="165">
                  <c:v>0.16401388852505705</c:v>
                </c:pt>
                <c:pt idx="166">
                  <c:v>-0.20822759572263408</c:v>
                </c:pt>
                <c:pt idx="167">
                  <c:v>-0.42468766931256319</c:v>
                </c:pt>
                <c:pt idx="168">
                  <c:v>-0.29371258775692632</c:v>
                </c:pt>
                <c:pt idx="169">
                  <c:v>-0.26986004764348781</c:v>
                </c:pt>
                <c:pt idx="170">
                  <c:v>-0.17869796011047026</c:v>
                </c:pt>
                <c:pt idx="171">
                  <c:v>0.15341624225524791</c:v>
                </c:pt>
                <c:pt idx="172">
                  <c:v>0.10902617649836698</c:v>
                </c:pt>
                <c:pt idx="173">
                  <c:v>1.9630756335508422E-2</c:v>
                </c:pt>
                <c:pt idx="174">
                  <c:v>0.19698466352921809</c:v>
                </c:pt>
                <c:pt idx="175">
                  <c:v>-9.8505544952425056E-2</c:v>
                </c:pt>
                <c:pt idx="176">
                  <c:v>-0.61772009993305166</c:v>
                </c:pt>
                <c:pt idx="177">
                  <c:v>-8.6660565246178073E-2</c:v>
                </c:pt>
                <c:pt idx="178">
                  <c:v>0.58890048769913272</c:v>
                </c:pt>
                <c:pt idx="179">
                  <c:v>-0.35383734284210644</c:v>
                </c:pt>
                <c:pt idx="180">
                  <c:v>-2.7969115858667879E-2</c:v>
                </c:pt>
                <c:pt idx="181">
                  <c:v>0.24135208577065867</c:v>
                </c:pt>
                <c:pt idx="182">
                  <c:v>-0.69829530378083982</c:v>
                </c:pt>
                <c:pt idx="183">
                  <c:v>6.3364878758429374E-2</c:v>
                </c:pt>
                <c:pt idx="184">
                  <c:v>0.28593480794387272</c:v>
                </c:pt>
                <c:pt idx="185">
                  <c:v>-0.51663563928665079</c:v>
                </c:pt>
                <c:pt idx="186">
                  <c:v>-4.8710621783866787E-2</c:v>
                </c:pt>
                <c:pt idx="187">
                  <c:v>0.15081959821213325</c:v>
                </c:pt>
                <c:pt idx="188">
                  <c:v>1.8491749039879199E-2</c:v>
                </c:pt>
                <c:pt idx="189">
                  <c:v>0.1126334169852453</c:v>
                </c:pt>
                <c:pt idx="190">
                  <c:v>-7.1269640388957348E-2</c:v>
                </c:pt>
                <c:pt idx="191">
                  <c:v>5.9908989018685112E-2</c:v>
                </c:pt>
                <c:pt idx="192">
                  <c:v>0.27393356926688534</c:v>
                </c:pt>
                <c:pt idx="193">
                  <c:v>4.9630767724600428E-2</c:v>
                </c:pt>
                <c:pt idx="194">
                  <c:v>0.5059925243950385</c:v>
                </c:pt>
                <c:pt idx="195">
                  <c:v>0.12657645701337311</c:v>
                </c:pt>
                <c:pt idx="196">
                  <c:v>-7.7041035763828009E-2</c:v>
                </c:pt>
                <c:pt idx="197">
                  <c:v>-0.41004480548156808</c:v>
                </c:pt>
                <c:pt idx="198">
                  <c:v>-6.5067789415843525E-3</c:v>
                </c:pt>
                <c:pt idx="199">
                  <c:v>4.2504263128963445E-2</c:v>
                </c:pt>
                <c:pt idx="200">
                  <c:v>0.42502954752628558</c:v>
                </c:pt>
                <c:pt idx="201">
                  <c:v>-7.5672038310899623E-2</c:v>
                </c:pt>
                <c:pt idx="202">
                  <c:v>6.6950243924627034E-2</c:v>
                </c:pt>
                <c:pt idx="203">
                  <c:v>0.40304952889652451</c:v>
                </c:pt>
                <c:pt idx="204">
                  <c:v>-0.25808005150531182</c:v>
                </c:pt>
                <c:pt idx="205">
                  <c:v>-0.29442013806090195</c:v>
                </c:pt>
                <c:pt idx="206">
                  <c:v>-1.0709665213541435</c:v>
                </c:pt>
                <c:pt idx="207">
                  <c:v>-0.25963365684456191</c:v>
                </c:pt>
                <c:pt idx="208">
                  <c:v>0.17772648293206822</c:v>
                </c:pt>
                <c:pt idx="209">
                  <c:v>4.1943829970167254E-2</c:v>
                </c:pt>
                <c:pt idx="210">
                  <c:v>-0.43070335443835533</c:v>
                </c:pt>
                <c:pt idx="211">
                  <c:v>4.5442970761167115E-2</c:v>
                </c:pt>
                <c:pt idx="212">
                  <c:v>-0.33042892396103429</c:v>
                </c:pt>
                <c:pt idx="213">
                  <c:v>0.50375578744949878</c:v>
                </c:pt>
                <c:pt idx="214">
                  <c:v>0.1682569232085816</c:v>
                </c:pt>
                <c:pt idx="215">
                  <c:v>0.13592881552640673</c:v>
                </c:pt>
                <c:pt idx="216">
                  <c:v>0.13527217947625234</c:v>
                </c:pt>
                <c:pt idx="217">
                  <c:v>-0.72499295250013029</c:v>
                </c:pt>
                <c:pt idx="218">
                  <c:v>-5.4092702789747427E-2</c:v>
                </c:pt>
                <c:pt idx="219">
                  <c:v>9.4776556895597316E-2</c:v>
                </c:pt>
                <c:pt idx="220">
                  <c:v>0.10406822646371666</c:v>
                </c:pt>
                <c:pt idx="221">
                  <c:v>-0.40793770221252285</c:v>
                </c:pt>
                <c:pt idx="222">
                  <c:v>0.20075543159558679</c:v>
                </c:pt>
                <c:pt idx="223">
                  <c:v>4.6002046544520461E-2</c:v>
                </c:pt>
                <c:pt idx="224">
                  <c:v>0.25749344787615602</c:v>
                </c:pt>
                <c:pt idx="225">
                  <c:v>-6.1601281417060512E-2</c:v>
                </c:pt>
                <c:pt idx="226">
                  <c:v>1.4926544238102822E-2</c:v>
                </c:pt>
                <c:pt idx="227">
                  <c:v>0.48109223690635056</c:v>
                </c:pt>
                <c:pt idx="228">
                  <c:v>0.26074832839644746</c:v>
                </c:pt>
                <c:pt idx="229">
                  <c:v>-2.8410464469938029E-2</c:v>
                </c:pt>
                <c:pt idx="230">
                  <c:v>4.9212534632560277E-2</c:v>
                </c:pt>
                <c:pt idx="231">
                  <c:v>0.28297348862158911</c:v>
                </c:pt>
                <c:pt idx="232">
                  <c:v>-7.8716020959078287E-2</c:v>
                </c:pt>
                <c:pt idx="233">
                  <c:v>0.53455968460831615</c:v>
                </c:pt>
                <c:pt idx="234">
                  <c:v>-0.13701309080490964</c:v>
                </c:pt>
                <c:pt idx="235">
                  <c:v>2.8852005847493426E-2</c:v>
                </c:pt>
                <c:pt idx="236">
                  <c:v>0.42621107202740416</c:v>
                </c:pt>
                <c:pt idx="237">
                  <c:v>0.13697881196350373</c:v>
                </c:pt>
                <c:pt idx="238">
                  <c:v>0.23106369991227274</c:v>
                </c:pt>
                <c:pt idx="239">
                  <c:v>-0.13431868566083344</c:v>
                </c:pt>
                <c:pt idx="240">
                  <c:v>-0.14416972531623412</c:v>
                </c:pt>
                <c:pt idx="241">
                  <c:v>6.4469017368442544E-2</c:v>
                </c:pt>
                <c:pt idx="242">
                  <c:v>-0.14353214049052646</c:v>
                </c:pt>
                <c:pt idx="243">
                  <c:v>9.7880434051913115E-2</c:v>
                </c:pt>
                <c:pt idx="244">
                  <c:v>0.30614555930877391</c:v>
                </c:pt>
                <c:pt idx="245">
                  <c:v>-0.14800116288755377</c:v>
                </c:pt>
                <c:pt idx="246">
                  <c:v>0.74183368096448687</c:v>
                </c:pt>
                <c:pt idx="247">
                  <c:v>0.16877038350082046</c:v>
                </c:pt>
                <c:pt idx="248">
                  <c:v>5.783147456057329E-2</c:v>
                </c:pt>
                <c:pt idx="249">
                  <c:v>0.16915535883089369</c:v>
                </c:pt>
                <c:pt idx="250">
                  <c:v>-4.0452120579487346E-3</c:v>
                </c:pt>
                <c:pt idx="251">
                  <c:v>-0.1679606673480262</c:v>
                </c:pt>
                <c:pt idx="252">
                  <c:v>9.3830571635135501E-2</c:v>
                </c:pt>
                <c:pt idx="253">
                  <c:v>-0.14018943519870503</c:v>
                </c:pt>
                <c:pt idx="254">
                  <c:v>0.24439999124554931</c:v>
                </c:pt>
                <c:pt idx="255">
                  <c:v>-0.18164023517696062</c:v>
                </c:pt>
                <c:pt idx="256">
                  <c:v>-0.27998426491719525</c:v>
                </c:pt>
                <c:pt idx="257">
                  <c:v>-1.3778192957794075</c:v>
                </c:pt>
                <c:pt idx="258">
                  <c:v>0.11343380260404853</c:v>
                </c:pt>
                <c:pt idx="259">
                  <c:v>7.3957299943324409E-2</c:v>
                </c:pt>
                <c:pt idx="260">
                  <c:v>-8.1003230190799691E-2</c:v>
                </c:pt>
                <c:pt idx="261">
                  <c:v>0.34721208558564493</c:v>
                </c:pt>
                <c:pt idx="262">
                  <c:v>0.26855416403354321</c:v>
                </c:pt>
                <c:pt idx="263">
                  <c:v>-3.0029898840683307E-2</c:v>
                </c:pt>
                <c:pt idx="264">
                  <c:v>-2.2075610699353621</c:v>
                </c:pt>
                <c:pt idx="265">
                  <c:v>0.44646798609732558</c:v>
                </c:pt>
                <c:pt idx="266">
                  <c:v>5.783147456057329E-2</c:v>
                </c:pt>
                <c:pt idx="267">
                  <c:v>-0.65812807935559947</c:v>
                </c:pt>
                <c:pt idx="268">
                  <c:v>-5.3793170962472027E-2</c:v>
                </c:pt>
                <c:pt idx="269">
                  <c:v>0.56169272139830895</c:v>
                </c:pt>
                <c:pt idx="270">
                  <c:v>0.67120277654190019</c:v>
                </c:pt>
                <c:pt idx="271">
                  <c:v>-0.99223040585408229</c:v>
                </c:pt>
                <c:pt idx="272">
                  <c:v>-9.9432627585305883E-2</c:v>
                </c:pt>
                <c:pt idx="273">
                  <c:v>-0.23497452999962937</c:v>
                </c:pt>
                <c:pt idx="274">
                  <c:v>-3.1774255410241372E-3</c:v>
                </c:pt>
                <c:pt idx="275">
                  <c:v>0.16594408777059766</c:v>
                </c:pt>
                <c:pt idx="276">
                  <c:v>0.69323045558009877</c:v>
                </c:pt>
                <c:pt idx="277">
                  <c:v>0.19244669373504691</c:v>
                </c:pt>
                <c:pt idx="278">
                  <c:v>-0.46952967460080958</c:v>
                </c:pt>
                <c:pt idx="279">
                  <c:v>0.44105846999321385</c:v>
                </c:pt>
                <c:pt idx="280">
                  <c:v>-0.11763084416884118</c:v>
                </c:pt>
                <c:pt idx="281">
                  <c:v>0.1159654315868071</c:v>
                </c:pt>
                <c:pt idx="282">
                  <c:v>-9.9741787565250095E-2</c:v>
                </c:pt>
                <c:pt idx="283">
                  <c:v>0.534659280413878</c:v>
                </c:pt>
                <c:pt idx="284">
                  <c:v>-0.3125809226281096</c:v>
                </c:pt>
                <c:pt idx="285">
                  <c:v>0.15769051358205341</c:v>
                </c:pt>
                <c:pt idx="286">
                  <c:v>0.21412480535284734</c:v>
                </c:pt>
                <c:pt idx="287">
                  <c:v>0.33913738491958534</c:v>
                </c:pt>
                <c:pt idx="288">
                  <c:v>2.9841557136715127E-2</c:v>
                </c:pt>
                <c:pt idx="289">
                  <c:v>0.2507190834005546</c:v>
                </c:pt>
                <c:pt idx="290">
                  <c:v>7.6011738569641274E-2</c:v>
                </c:pt>
                <c:pt idx="291">
                  <c:v>0.32803219030386255</c:v>
                </c:pt>
                <c:pt idx="292">
                  <c:v>5.172011644732763E-2</c:v>
                </c:pt>
                <c:pt idx="293">
                  <c:v>0.11396714643300218</c:v>
                </c:pt>
                <c:pt idx="294">
                  <c:v>0.51974317341817278</c:v>
                </c:pt>
                <c:pt idx="295">
                  <c:v>-0.16536967769053793</c:v>
                </c:pt>
                <c:pt idx="296">
                  <c:v>0.36681177312712715</c:v>
                </c:pt>
                <c:pt idx="297">
                  <c:v>1.0063683344697479E-2</c:v>
                </c:pt>
                <c:pt idx="298">
                  <c:v>-0.22600367488882686</c:v>
                </c:pt>
                <c:pt idx="299">
                  <c:v>1.1146335490689394</c:v>
                </c:pt>
                <c:pt idx="300">
                  <c:v>0.87609451272990913</c:v>
                </c:pt>
                <c:pt idx="301">
                  <c:v>0.40642782452698145</c:v>
                </c:pt>
                <c:pt idx="302">
                  <c:v>0.19685880136635622</c:v>
                </c:pt>
                <c:pt idx="303">
                  <c:v>4.3274360397113599E-4</c:v>
                </c:pt>
                <c:pt idx="304">
                  <c:v>0.19118360922003899</c:v>
                </c:pt>
                <c:pt idx="305">
                  <c:v>7.5737982394078154E-2</c:v>
                </c:pt>
                <c:pt idx="306">
                  <c:v>6.1430600497748115E-2</c:v>
                </c:pt>
                <c:pt idx="307">
                  <c:v>-0.21357091679694382</c:v>
                </c:pt>
                <c:pt idx="308">
                  <c:v>0.6857159359906515</c:v>
                </c:pt>
                <c:pt idx="309">
                  <c:v>-0.54140801184814435</c:v>
                </c:pt>
                <c:pt idx="310">
                  <c:v>0.31231665440199746</c:v>
                </c:pt>
                <c:pt idx="311">
                  <c:v>8.2975027257768202E-2</c:v>
                </c:pt>
                <c:pt idx="312">
                  <c:v>-0.12139235428247001</c:v>
                </c:pt>
                <c:pt idx="313">
                  <c:v>-0.6117553466077007</c:v>
                </c:pt>
                <c:pt idx="314">
                  <c:v>-0.16634075359048736</c:v>
                </c:pt>
                <c:pt idx="315">
                  <c:v>0.15691431465323905</c:v>
                </c:pt>
                <c:pt idx="316">
                  <c:v>9.1259766192678296E-2</c:v>
                </c:pt>
                <c:pt idx="317">
                  <c:v>-0.48822837392943463</c:v>
                </c:pt>
                <c:pt idx="318">
                  <c:v>-0.11778737810713708</c:v>
                </c:pt>
                <c:pt idx="319">
                  <c:v>0.15172895534333664</c:v>
                </c:pt>
                <c:pt idx="320">
                  <c:v>-0.70228032795648698</c:v>
                </c:pt>
                <c:pt idx="321">
                  <c:v>-0.10982572320065556</c:v>
                </c:pt>
                <c:pt idx="322">
                  <c:v>-3.7558918843352052E-3</c:v>
                </c:pt>
                <c:pt idx="323">
                  <c:v>0.51258087867396862</c:v>
                </c:pt>
                <c:pt idx="324">
                  <c:v>-0.44654119030090655</c:v>
                </c:pt>
                <c:pt idx="325">
                  <c:v>-2.1804370318348448E-2</c:v>
                </c:pt>
                <c:pt idx="326">
                  <c:v>1.735184178777496E-2</c:v>
                </c:pt>
                <c:pt idx="327">
                  <c:v>0.31741984983470184</c:v>
                </c:pt>
                <c:pt idx="328">
                  <c:v>0.20213558088984851</c:v>
                </c:pt>
                <c:pt idx="329">
                  <c:v>0.59645813955898563</c:v>
                </c:pt>
                <c:pt idx="330">
                  <c:v>-5.5741240386646497E-2</c:v>
                </c:pt>
                <c:pt idx="331">
                  <c:v>-7.0814985716076778E-2</c:v>
                </c:pt>
                <c:pt idx="332">
                  <c:v>0.35411359249237673</c:v>
                </c:pt>
                <c:pt idx="333">
                  <c:v>0.19572554751205637</c:v>
                </c:pt>
                <c:pt idx="334">
                  <c:v>-1.7125039101938438E-2</c:v>
                </c:pt>
                <c:pt idx="335">
                  <c:v>0.1682569232085816</c:v>
                </c:pt>
                <c:pt idx="336">
                  <c:v>-0.46076672913396444</c:v>
                </c:pt>
                <c:pt idx="337">
                  <c:v>-0.50963525001409116</c:v>
                </c:pt>
                <c:pt idx="338">
                  <c:v>-6.0848662567038407E-2</c:v>
                </c:pt>
                <c:pt idx="339">
                  <c:v>0.25507768200545078</c:v>
                </c:pt>
                <c:pt idx="340">
                  <c:v>8.351974882017292E-2</c:v>
                </c:pt>
                <c:pt idx="341">
                  <c:v>4.670058674162228E-2</c:v>
                </c:pt>
                <c:pt idx="342">
                  <c:v>-0.15521264992094008</c:v>
                </c:pt>
                <c:pt idx="343">
                  <c:v>0.23988680079572053</c:v>
                </c:pt>
                <c:pt idx="344">
                  <c:v>0.26171132887668525</c:v>
                </c:pt>
                <c:pt idx="345">
                  <c:v>0.15975833805629808</c:v>
                </c:pt>
                <c:pt idx="346">
                  <c:v>1.4498126999352837E-2</c:v>
                </c:pt>
                <c:pt idx="347">
                  <c:v>-0.12658049656514306</c:v>
                </c:pt>
                <c:pt idx="348">
                  <c:v>0.39319651187040622</c:v>
                </c:pt>
                <c:pt idx="349">
                  <c:v>0.29513524900081806</c:v>
                </c:pt>
                <c:pt idx="350">
                  <c:v>0.19711051471269642</c:v>
                </c:pt>
                <c:pt idx="351">
                  <c:v>0.24549566281992086</c:v>
                </c:pt>
                <c:pt idx="352">
                  <c:v>-5.6941361109602261E-2</c:v>
                </c:pt>
                <c:pt idx="353">
                  <c:v>0.32538641465977336</c:v>
                </c:pt>
                <c:pt idx="354">
                  <c:v>0.30999103926006899</c:v>
                </c:pt>
                <c:pt idx="355">
                  <c:v>0.45227913513477624</c:v>
                </c:pt>
                <c:pt idx="356">
                  <c:v>0.10956115195305141</c:v>
                </c:pt>
                <c:pt idx="357">
                  <c:v>0.22391675051899007</c:v>
                </c:pt>
                <c:pt idx="358">
                  <c:v>0.12617994882319306</c:v>
                </c:pt>
                <c:pt idx="359">
                  <c:v>-8.537110053967626E-3</c:v>
                </c:pt>
                <c:pt idx="360">
                  <c:v>-0.33061033798716322</c:v>
                </c:pt>
                <c:pt idx="361">
                  <c:v>0.51480398557177365</c:v>
                </c:pt>
                <c:pt idx="362">
                  <c:v>5.6999630385563736E-2</c:v>
                </c:pt>
                <c:pt idx="363">
                  <c:v>0.27953072572998972</c:v>
                </c:pt>
                <c:pt idx="364">
                  <c:v>6.9702166630067411E-2</c:v>
                </c:pt>
                <c:pt idx="365">
                  <c:v>0.10151561549124424</c:v>
                </c:pt>
                <c:pt idx="366">
                  <c:v>0.15250794836490289</c:v>
                </c:pt>
                <c:pt idx="367">
                  <c:v>-2.9279628192271199</c:v>
                </c:pt>
                <c:pt idx="368">
                  <c:v>0.11649784050174836</c:v>
                </c:pt>
                <c:pt idx="369">
                  <c:v>0.292781749227846</c:v>
                </c:pt>
                <c:pt idx="370">
                  <c:v>0.21549222999098053</c:v>
                </c:pt>
                <c:pt idx="371">
                  <c:v>-7.0865820402710765E-3</c:v>
                </c:pt>
                <c:pt idx="372">
                  <c:v>8.2000138321361282E-3</c:v>
                </c:pt>
                <c:pt idx="373">
                  <c:v>0.62283666638227642</c:v>
                </c:pt>
                <c:pt idx="374">
                  <c:v>-0.11857030266148418</c:v>
                </c:pt>
                <c:pt idx="375">
                  <c:v>0.11796095273241665</c:v>
                </c:pt>
                <c:pt idx="376">
                  <c:v>-0.22145497419719512</c:v>
                </c:pt>
                <c:pt idx="377">
                  <c:v>0.10057404021319742</c:v>
                </c:pt>
                <c:pt idx="378">
                  <c:v>-0.50573801216011105</c:v>
                </c:pt>
                <c:pt idx="379">
                  <c:v>0.25507768200545078</c:v>
                </c:pt>
                <c:pt idx="380">
                  <c:v>0.23008001621890775</c:v>
                </c:pt>
                <c:pt idx="381">
                  <c:v>-0.49410907027004275</c:v>
                </c:pt>
                <c:pt idx="382">
                  <c:v>6.1568849268002809E-2</c:v>
                </c:pt>
                <c:pt idx="383">
                  <c:v>0.31533436033437867</c:v>
                </c:pt>
                <c:pt idx="384">
                  <c:v>0.1584662951247956</c:v>
                </c:pt>
                <c:pt idx="385">
                  <c:v>0.37261784412629206</c:v>
                </c:pt>
                <c:pt idx="386">
                  <c:v>-1.0819191301522921</c:v>
                </c:pt>
                <c:pt idx="387">
                  <c:v>-0.81730770248380979</c:v>
                </c:pt>
                <c:pt idx="388">
                  <c:v>-5.3478713255848444E-3</c:v>
                </c:pt>
                <c:pt idx="389">
                  <c:v>-0.85543148233528843</c:v>
                </c:pt>
                <c:pt idx="390">
                  <c:v>0.26435627052581034</c:v>
                </c:pt>
                <c:pt idx="391">
                  <c:v>0.33193447043881358</c:v>
                </c:pt>
                <c:pt idx="392">
                  <c:v>0.16388511670894185</c:v>
                </c:pt>
                <c:pt idx="393">
                  <c:v>-0.24195271816676633</c:v>
                </c:pt>
                <c:pt idx="394">
                  <c:v>5.088474002509346E-2</c:v>
                </c:pt>
                <c:pt idx="395">
                  <c:v>9.9631850014460371E-2</c:v>
                </c:pt>
                <c:pt idx="396">
                  <c:v>0.18535913475800209</c:v>
                </c:pt>
                <c:pt idx="397">
                  <c:v>-0.14448862342559837</c:v>
                </c:pt>
                <c:pt idx="398">
                  <c:v>-0.81324591541681746</c:v>
                </c:pt>
                <c:pt idx="399">
                  <c:v>-0.26968611370622381</c:v>
                </c:pt>
                <c:pt idx="400">
                  <c:v>0.12974460550781922</c:v>
                </c:pt>
                <c:pt idx="401">
                  <c:v>0.29266397339685779</c:v>
                </c:pt>
                <c:pt idx="402">
                  <c:v>5.3945424962785253E-2</c:v>
                </c:pt>
                <c:pt idx="403">
                  <c:v>0.1554901977475622</c:v>
                </c:pt>
                <c:pt idx="404">
                  <c:v>-0.35181069728186254</c:v>
                </c:pt>
                <c:pt idx="405">
                  <c:v>0.15081959821213325</c:v>
                </c:pt>
                <c:pt idx="406">
                  <c:v>0.23106369991227274</c:v>
                </c:pt>
                <c:pt idx="407">
                  <c:v>-0.10516283924207756</c:v>
                </c:pt>
                <c:pt idx="408">
                  <c:v>-7.263446472662155E-2</c:v>
                </c:pt>
                <c:pt idx="409">
                  <c:v>4.2083958671252489E-2</c:v>
                </c:pt>
                <c:pt idx="410">
                  <c:v>-0.45977429940446057</c:v>
                </c:pt>
                <c:pt idx="411">
                  <c:v>0.29124991296422992</c:v>
                </c:pt>
                <c:pt idx="412">
                  <c:v>-0.50532838835245042</c:v>
                </c:pt>
                <c:pt idx="413">
                  <c:v>0.20050435344652129</c:v>
                </c:pt>
                <c:pt idx="414">
                  <c:v>0.47248777146274357</c:v>
                </c:pt>
                <c:pt idx="415">
                  <c:v>-0.45699912259757436</c:v>
                </c:pt>
                <c:pt idx="416">
                  <c:v>-7.3848726800103348E-2</c:v>
                </c:pt>
                <c:pt idx="417">
                  <c:v>-0.25068027542591964</c:v>
                </c:pt>
                <c:pt idx="418">
                  <c:v>0.52656966049778331</c:v>
                </c:pt>
                <c:pt idx="419">
                  <c:v>-0.61705613043100949</c:v>
                </c:pt>
                <c:pt idx="420">
                  <c:v>5.8939854556232962E-2</c:v>
                </c:pt>
                <c:pt idx="421">
                  <c:v>0.31022376954624697</c:v>
                </c:pt>
                <c:pt idx="422">
                  <c:v>-0.36419918324104023</c:v>
                </c:pt>
                <c:pt idx="423">
                  <c:v>0.44583262420762798</c:v>
                </c:pt>
                <c:pt idx="424">
                  <c:v>-0.35531305711565686</c:v>
                </c:pt>
                <c:pt idx="425">
                  <c:v>-0.24725140859286618</c:v>
                </c:pt>
                <c:pt idx="426">
                  <c:v>0.20989000723403936</c:v>
                </c:pt>
                <c:pt idx="427">
                  <c:v>3.506079690511428E-2</c:v>
                </c:pt>
                <c:pt idx="428">
                  <c:v>0.16375633339790888</c:v>
                </c:pt>
                <c:pt idx="429">
                  <c:v>0.75017770559305719</c:v>
                </c:pt>
                <c:pt idx="430">
                  <c:v>2.8144767713378684E-2</c:v>
                </c:pt>
                <c:pt idx="431">
                  <c:v>1.4069582501655862E-2</c:v>
                </c:pt>
                <c:pt idx="432">
                  <c:v>0.37828965309545082</c:v>
                </c:pt>
                <c:pt idx="433">
                  <c:v>0.18256518222108284</c:v>
                </c:pt>
                <c:pt idx="434">
                  <c:v>0.12789736448606356</c:v>
                </c:pt>
                <c:pt idx="435">
                  <c:v>-0.24502700733009838</c:v>
                </c:pt>
                <c:pt idx="436">
                  <c:v>0.69072996215655957</c:v>
                </c:pt>
                <c:pt idx="437">
                  <c:v>-0.47092870017088889</c:v>
                </c:pt>
                <c:pt idx="438">
                  <c:v>-0.33606339364482973</c:v>
                </c:pt>
                <c:pt idx="439">
                  <c:v>0.18903382439001684</c:v>
                </c:pt>
                <c:pt idx="440">
                  <c:v>2.2900402110078832E-2</c:v>
                </c:pt>
                <c:pt idx="441">
                  <c:v>0.86251090312833978</c:v>
                </c:pt>
                <c:pt idx="442">
                  <c:v>-3.106139526236049E-2</c:v>
                </c:pt>
                <c:pt idx="443">
                  <c:v>-4.2405884674354235</c:v>
                </c:pt>
                <c:pt idx="444">
                  <c:v>0.4696776298171893</c:v>
                </c:pt>
                <c:pt idx="445">
                  <c:v>-0.1073369764212953</c:v>
                </c:pt>
                <c:pt idx="446">
                  <c:v>-0.29442013806090195</c:v>
                </c:pt>
                <c:pt idx="447">
                  <c:v>-0.31922557450753902</c:v>
                </c:pt>
                <c:pt idx="448">
                  <c:v>0.42502954752628558</c:v>
                </c:pt>
                <c:pt idx="449">
                  <c:v>0.48005826922725514</c:v>
                </c:pt>
                <c:pt idx="450">
                  <c:v>0.11809388938681974</c:v>
                </c:pt>
                <c:pt idx="451">
                  <c:v>0.15484240686923265</c:v>
                </c:pt>
                <c:pt idx="452">
                  <c:v>-0.21893410156403686</c:v>
                </c:pt>
                <c:pt idx="453">
                  <c:v>0.26699637198621584</c:v>
                </c:pt>
                <c:pt idx="454">
                  <c:v>-0.27142639744063524</c:v>
                </c:pt>
                <c:pt idx="455">
                  <c:v>-9.1571349831212748E-2</c:v>
                </c:pt>
                <c:pt idx="456">
                  <c:v>-0.64363078628377501</c:v>
                </c:pt>
                <c:pt idx="457">
                  <c:v>-8.1017984969644994E-3</c:v>
                </c:pt>
                <c:pt idx="458">
                  <c:v>0.21847121074326151</c:v>
                </c:pt>
                <c:pt idx="459">
                  <c:v>0.4996800871870592</c:v>
                </c:pt>
                <c:pt idx="460">
                  <c:v>-1.9901561182208771E-2</c:v>
                </c:pt>
                <c:pt idx="461">
                  <c:v>0.25023398082675447</c:v>
                </c:pt>
                <c:pt idx="462">
                  <c:v>0.37851162325372983</c:v>
                </c:pt>
                <c:pt idx="463">
                  <c:v>0.12366619645381971</c:v>
                </c:pt>
                <c:pt idx="464">
                  <c:v>-0.15024087619748916</c:v>
                </c:pt>
                <c:pt idx="465">
                  <c:v>6.6674762724460157E-2</c:v>
                </c:pt>
                <c:pt idx="466">
                  <c:v>0.26483664846777927</c:v>
                </c:pt>
                <c:pt idx="467">
                  <c:v>0.36490855508871478</c:v>
                </c:pt>
                <c:pt idx="468">
                  <c:v>-1.5475099907815497</c:v>
                </c:pt>
                <c:pt idx="469">
                  <c:v>-0.77151990167008255</c:v>
                </c:pt>
                <c:pt idx="470">
                  <c:v>4.7119548568550634E-2</c:v>
                </c:pt>
                <c:pt idx="471">
                  <c:v>0.15820774762573614</c:v>
                </c:pt>
                <c:pt idx="472">
                  <c:v>0.66220549965361664</c:v>
                </c:pt>
                <c:pt idx="473">
                  <c:v>0.42470714556415079</c:v>
                </c:pt>
                <c:pt idx="474">
                  <c:v>0.26507677746981317</c:v>
                </c:pt>
                <c:pt idx="475">
                  <c:v>-0.2864801343050864</c:v>
                </c:pt>
                <c:pt idx="476">
                  <c:v>0.2202061130801844</c:v>
                </c:pt>
                <c:pt idx="477">
                  <c:v>0.29313501904332107</c:v>
                </c:pt>
                <c:pt idx="478">
                  <c:v>0.62358597239971192</c:v>
                </c:pt>
                <c:pt idx="479">
                  <c:v>-0.11091590140185059</c:v>
                </c:pt>
                <c:pt idx="480">
                  <c:v>0.34426039498541872</c:v>
                </c:pt>
                <c:pt idx="481">
                  <c:v>-1.7125039101938438E-2</c:v>
                </c:pt>
                <c:pt idx="482">
                  <c:v>0.15250794836490289</c:v>
                </c:pt>
                <c:pt idx="483">
                  <c:v>-2.0194137747983117E-2</c:v>
                </c:pt>
                <c:pt idx="484">
                  <c:v>1.5354834293464041E-2</c:v>
                </c:pt>
                <c:pt idx="485">
                  <c:v>0.10138114235502452</c:v>
                </c:pt>
                <c:pt idx="486">
                  <c:v>-0.15810736839694411</c:v>
                </c:pt>
                <c:pt idx="487">
                  <c:v>0.27178421356921684</c:v>
                </c:pt>
                <c:pt idx="488">
                  <c:v>3.463831799900894E-2</c:v>
                </c:pt>
                <c:pt idx="489">
                  <c:v>8.800587129002016E-2</c:v>
                </c:pt>
                <c:pt idx="490">
                  <c:v>0.10084312443311183</c:v>
                </c:pt>
                <c:pt idx="491">
                  <c:v>0.42050935048890331</c:v>
                </c:pt>
                <c:pt idx="492">
                  <c:v>0.3256166748216045</c:v>
                </c:pt>
                <c:pt idx="493">
                  <c:v>9.3560176162337833E-2</c:v>
                </c:pt>
                <c:pt idx="494">
                  <c:v>-2.7822029653627511E-2</c:v>
                </c:pt>
                <c:pt idx="495">
                  <c:v>-1.7221342427651205</c:v>
                </c:pt>
                <c:pt idx="496">
                  <c:v>-0.15810736839694411</c:v>
                </c:pt>
                <c:pt idx="497">
                  <c:v>0.41186007373781969</c:v>
                </c:pt>
                <c:pt idx="498">
                  <c:v>0.15419432499278973</c:v>
                </c:pt>
                <c:pt idx="499">
                  <c:v>-0.41311518714781531</c:v>
                </c:pt>
                <c:pt idx="500">
                  <c:v>-0.38364230300330965</c:v>
                </c:pt>
                <c:pt idx="501">
                  <c:v>0.43786690087015107</c:v>
                </c:pt>
                <c:pt idx="502">
                  <c:v>0.91532967601300941</c:v>
                </c:pt>
                <c:pt idx="503">
                  <c:v>0.37851162325372983</c:v>
                </c:pt>
                <c:pt idx="504">
                  <c:v>0.47227980043155038</c:v>
                </c:pt>
                <c:pt idx="505">
                  <c:v>0.32584689823881513</c:v>
                </c:pt>
                <c:pt idx="506">
                  <c:v>3.506079690511428E-2</c:v>
                </c:pt>
                <c:pt idx="507">
                  <c:v>-8.0392953091645014E-2</c:v>
                </c:pt>
                <c:pt idx="508">
                  <c:v>0.30264075142856844</c:v>
                </c:pt>
                <c:pt idx="509">
                  <c:v>-0.42449403196700858</c:v>
                </c:pt>
                <c:pt idx="510">
                  <c:v>-0.28419446744084736</c:v>
                </c:pt>
                <c:pt idx="511">
                  <c:v>-0.14018943519870503</c:v>
                </c:pt>
                <c:pt idx="512">
                  <c:v>0.19937396072182095</c:v>
                </c:pt>
                <c:pt idx="513">
                  <c:v>0.30812784417874139</c:v>
                </c:pt>
                <c:pt idx="514">
                  <c:v>-0.17153089311826675</c:v>
                </c:pt>
                <c:pt idx="515">
                  <c:v>0.19773960600635557</c:v>
                </c:pt>
                <c:pt idx="516">
                  <c:v>-0.33715648250193742</c:v>
                </c:pt>
                <c:pt idx="517">
                  <c:v>0.16246786761530391</c:v>
                </c:pt>
                <c:pt idx="518">
                  <c:v>-1.5228387614574906E-2</c:v>
                </c:pt>
                <c:pt idx="519">
                  <c:v>-0.93870766152170593</c:v>
                </c:pt>
                <c:pt idx="520">
                  <c:v>-0.28472160770889682</c:v>
                </c:pt>
                <c:pt idx="521">
                  <c:v>7.9019633034838013E-2</c:v>
                </c:pt>
                <c:pt idx="522">
                  <c:v>0.18027518961187949</c:v>
                </c:pt>
                <c:pt idx="523">
                  <c:v>-0.37388798914138671</c:v>
                </c:pt>
                <c:pt idx="524">
                  <c:v>0.43786690087015107</c:v>
                </c:pt>
                <c:pt idx="525">
                  <c:v>-1.4208145587288721E-2</c:v>
                </c:pt>
                <c:pt idx="526">
                  <c:v>6.0466301184147796E-3</c:v>
                </c:pt>
                <c:pt idx="527">
                  <c:v>0.31417445108964359</c:v>
                </c:pt>
                <c:pt idx="528">
                  <c:v>4.8794180260804912E-2</c:v>
                </c:pt>
                <c:pt idx="529">
                  <c:v>-0.51271947061627399</c:v>
                </c:pt>
                <c:pt idx="530">
                  <c:v>0.22441078187075333</c:v>
                </c:pt>
                <c:pt idx="531">
                  <c:v>0.31753562201635438</c:v>
                </c:pt>
                <c:pt idx="532">
                  <c:v>0.69224863567337858</c:v>
                </c:pt>
                <c:pt idx="533">
                  <c:v>0.16851367619749361</c:v>
                </c:pt>
                <c:pt idx="534">
                  <c:v>8.8413009726725E-2</c:v>
                </c:pt>
                <c:pt idx="535">
                  <c:v>0.37662378742301456</c:v>
                </c:pt>
                <c:pt idx="536">
                  <c:v>-0.12973392960401731</c:v>
                </c:pt>
                <c:pt idx="537">
                  <c:v>0.43733428557230525</c:v>
                </c:pt>
                <c:pt idx="538">
                  <c:v>-0.28612825746410064</c:v>
                </c:pt>
                <c:pt idx="539">
                  <c:v>-0.39649827364362034</c:v>
                </c:pt>
                <c:pt idx="540">
                  <c:v>9.5316841534769714E-2</c:v>
                </c:pt>
                <c:pt idx="541">
                  <c:v>0.1947174628935997</c:v>
                </c:pt>
                <c:pt idx="542">
                  <c:v>-0.19958668736124272</c:v>
                </c:pt>
                <c:pt idx="543">
                  <c:v>2.6587622348084181E-2</c:v>
                </c:pt>
                <c:pt idx="544">
                  <c:v>-0.49268739558806196</c:v>
                </c:pt>
                <c:pt idx="545">
                  <c:v>-0.45422927388986406</c:v>
                </c:pt>
                <c:pt idx="546">
                  <c:v>-0.20506433719646369</c:v>
                </c:pt>
                <c:pt idx="547">
                  <c:v>0.67056844561957241</c:v>
                </c:pt>
                <c:pt idx="548">
                  <c:v>7.9702371697378191E-2</c:v>
                </c:pt>
                <c:pt idx="549">
                  <c:v>4.9630767724600428E-2</c:v>
                </c:pt>
                <c:pt idx="550">
                  <c:v>-0.38345409674893161</c:v>
                </c:pt>
                <c:pt idx="551">
                  <c:v>-8.6967000047858789E-2</c:v>
                </c:pt>
                <c:pt idx="552">
                  <c:v>0.14469902515413874</c:v>
                </c:pt>
                <c:pt idx="553">
                  <c:v>1.2068023309090343E-2</c:v>
                </c:pt>
                <c:pt idx="554">
                  <c:v>-0.22549755489034062</c:v>
                </c:pt>
                <c:pt idx="555">
                  <c:v>-0.49817873457908973</c:v>
                </c:pt>
                <c:pt idx="556">
                  <c:v>0.41586681052321495</c:v>
                </c:pt>
                <c:pt idx="557">
                  <c:v>-1.1661788622094178</c:v>
                </c:pt>
                <c:pt idx="558">
                  <c:v>4.6092532525896721E-3</c:v>
                </c:pt>
                <c:pt idx="559">
                  <c:v>-0.23786383009888792</c:v>
                </c:pt>
                <c:pt idx="560">
                  <c:v>-9.7424700969059461E-2</c:v>
                </c:pt>
                <c:pt idx="561">
                  <c:v>-0.4003013469962648</c:v>
                </c:pt>
                <c:pt idx="562">
                  <c:v>0.36725922448866971</c:v>
                </c:pt>
                <c:pt idx="563">
                  <c:v>0.16620125266270289</c:v>
                </c:pt>
                <c:pt idx="564">
                  <c:v>-0.31922557450753902</c:v>
                </c:pt>
                <c:pt idx="565">
                  <c:v>-0.29265191251673023</c:v>
                </c:pt>
                <c:pt idx="566">
                  <c:v>0.38515489688434379</c:v>
                </c:pt>
                <c:pt idx="567">
                  <c:v>-0.104387155024838</c:v>
                </c:pt>
                <c:pt idx="568">
                  <c:v>0.36692364897851804</c:v>
                </c:pt>
                <c:pt idx="569">
                  <c:v>-0.46534071958612205</c:v>
                </c:pt>
                <c:pt idx="570">
                  <c:v>6.04624879861069E-2</c:v>
                </c:pt>
                <c:pt idx="571">
                  <c:v>0.10715219863491048</c:v>
                </c:pt>
                <c:pt idx="572">
                  <c:v>-6.4163126315974664E-2</c:v>
                </c:pt>
                <c:pt idx="573">
                  <c:v>-0.41966152580429128</c:v>
                </c:pt>
                <c:pt idx="574">
                  <c:v>0.47227980043155038</c:v>
                </c:pt>
                <c:pt idx="575">
                  <c:v>9.0988888414772345E-2</c:v>
                </c:pt>
                <c:pt idx="576">
                  <c:v>-4.6240265254475013E-3</c:v>
                </c:pt>
                <c:pt idx="577">
                  <c:v>-0.33206247202107553</c:v>
                </c:pt>
                <c:pt idx="578">
                  <c:v>0.5723076236140493</c:v>
                </c:pt>
                <c:pt idx="579">
                  <c:v>-0.25497785096273551</c:v>
                </c:pt>
                <c:pt idx="580">
                  <c:v>0.10030490579568548</c:v>
                </c:pt>
                <c:pt idx="581">
                  <c:v>0.3298698723176593</c:v>
                </c:pt>
                <c:pt idx="582">
                  <c:v>-0.54582410681419791</c:v>
                </c:pt>
                <c:pt idx="583">
                  <c:v>2.6304324351908496E-2</c:v>
                </c:pt>
                <c:pt idx="584">
                  <c:v>-0.30739426159190475</c:v>
                </c:pt>
                <c:pt idx="585">
                  <c:v>-1.7322736212371211E-3</c:v>
                </c:pt>
                <c:pt idx="586">
                  <c:v>0.10554399219892611</c:v>
                </c:pt>
                <c:pt idx="587">
                  <c:v>0.3059121701566207</c:v>
                </c:pt>
                <c:pt idx="588">
                  <c:v>0.12048465689545584</c:v>
                </c:pt>
                <c:pt idx="589">
                  <c:v>-8.0240424144958675E-2</c:v>
                </c:pt>
                <c:pt idx="590">
                  <c:v>-0.18114943910456646</c:v>
                </c:pt>
                <c:pt idx="591">
                  <c:v>-2.1657911251080002E-2</c:v>
                </c:pt>
                <c:pt idx="592">
                  <c:v>0.41673167082091089</c:v>
                </c:pt>
                <c:pt idx="593">
                  <c:v>0.10514166032342348</c:v>
                </c:pt>
                <c:pt idx="594">
                  <c:v>-0.38326591504372898</c:v>
                </c:pt>
                <c:pt idx="595">
                  <c:v>9.8419557765544521E-2</c:v>
                </c:pt>
                <c:pt idx="596">
                  <c:v>0.4963089448247282</c:v>
                </c:pt>
                <c:pt idx="597">
                  <c:v>3.8857550020362112E-2</c:v>
                </c:pt>
                <c:pt idx="598">
                  <c:v>8.4336445723323716E-2</c:v>
                </c:pt>
                <c:pt idx="599">
                  <c:v>-0.16100790670625933</c:v>
                </c:pt>
                <c:pt idx="600">
                  <c:v>-2.4003042383556775E-2</c:v>
                </c:pt>
                <c:pt idx="601">
                  <c:v>0.75026347563802087</c:v>
                </c:pt>
                <c:pt idx="602">
                  <c:v>0.80817908377147074</c:v>
                </c:pt>
                <c:pt idx="603">
                  <c:v>-0.21943792382894028</c:v>
                </c:pt>
                <c:pt idx="604">
                  <c:v>0.15302704346482343</c:v>
                </c:pt>
                <c:pt idx="605">
                  <c:v>-0.12894492491337062</c:v>
                </c:pt>
                <c:pt idx="606">
                  <c:v>-0.10252721272912138</c:v>
                </c:pt>
                <c:pt idx="607">
                  <c:v>-0.85673720696138012</c:v>
                </c:pt>
                <c:pt idx="608">
                  <c:v>2.2190239634065988E-2</c:v>
                </c:pt>
                <c:pt idx="609">
                  <c:v>0.20414071678022522</c:v>
                </c:pt>
                <c:pt idx="610">
                  <c:v>8.6240275820744103E-2</c:v>
                </c:pt>
                <c:pt idx="611">
                  <c:v>-0.63845620203213505</c:v>
                </c:pt>
                <c:pt idx="612">
                  <c:v>-0.42275246440684927</c:v>
                </c:pt>
                <c:pt idx="613">
                  <c:v>0.11875838897983476</c:v>
                </c:pt>
                <c:pt idx="614">
                  <c:v>1.3957757425511714</c:v>
                </c:pt>
                <c:pt idx="615">
                  <c:v>-3.3569532693701831E-2</c:v>
                </c:pt>
                <c:pt idx="616">
                  <c:v>0.38449194441458373</c:v>
                </c:pt>
                <c:pt idx="617">
                  <c:v>-6.2956985548981131E-2</c:v>
                </c:pt>
                <c:pt idx="618">
                  <c:v>-0.1231196628370833</c:v>
                </c:pt>
                <c:pt idx="619">
                  <c:v>1.7209290032223101E-2</c:v>
                </c:pt>
                <c:pt idx="620">
                  <c:v>4.0962547778497838E-2</c:v>
                </c:pt>
                <c:pt idx="621">
                  <c:v>0.36434830692009251</c:v>
                </c:pt>
                <c:pt idx="622">
                  <c:v>0.57162827441806985</c:v>
                </c:pt>
                <c:pt idx="623">
                  <c:v>0.37873355926538038</c:v>
                </c:pt>
                <c:pt idx="624">
                  <c:v>0.21275608340363808</c:v>
                </c:pt>
                <c:pt idx="625">
                  <c:v>0.24902051028596492</c:v>
                </c:pt>
                <c:pt idx="626">
                  <c:v>-0.74154137728209935</c:v>
                </c:pt>
                <c:pt idx="627">
                  <c:v>2.7437182706851134E-2</c:v>
                </c:pt>
                <c:pt idx="628">
                  <c:v>1.2640180778770334E-2</c:v>
                </c:pt>
                <c:pt idx="629">
                  <c:v>-6.8392577690317161E-2</c:v>
                </c:pt>
                <c:pt idx="630">
                  <c:v>-0.14432916555962885</c:v>
                </c:pt>
                <c:pt idx="631">
                  <c:v>0.14756720709463242</c:v>
                </c:pt>
                <c:pt idx="632">
                  <c:v>0.23229236208914866</c:v>
                </c:pt>
                <c:pt idx="633">
                  <c:v>-4.3348544428939068E-2</c:v>
                </c:pt>
                <c:pt idx="634">
                  <c:v>-0.19809638532134477</c:v>
                </c:pt>
                <c:pt idx="635">
                  <c:v>0.15367564979723761</c:v>
                </c:pt>
                <c:pt idx="636">
                  <c:v>0.25447310795273254</c:v>
                </c:pt>
                <c:pt idx="637">
                  <c:v>-6.1751852313287614E-2</c:v>
                </c:pt>
                <c:pt idx="638">
                  <c:v>0.3339961181964527</c:v>
                </c:pt>
                <c:pt idx="639">
                  <c:v>-0.48640819350042674</c:v>
                </c:pt>
                <c:pt idx="640">
                  <c:v>0.75983759648807969</c:v>
                </c:pt>
                <c:pt idx="641">
                  <c:v>-0.47192883542126463</c:v>
                </c:pt>
                <c:pt idx="642">
                  <c:v>0.43669488755287661</c:v>
                </c:pt>
                <c:pt idx="643">
                  <c:v>-0.13590302036968363</c:v>
                </c:pt>
                <c:pt idx="644">
                  <c:v>4.3064478664937421E-2</c:v>
                </c:pt>
                <c:pt idx="645">
                  <c:v>-3.3220203836296473E-3</c:v>
                </c:pt>
                <c:pt idx="646">
                  <c:v>0.18764107818068257</c:v>
                </c:pt>
                <c:pt idx="647">
                  <c:v>7.6969476315110794E-2</c:v>
                </c:pt>
                <c:pt idx="648">
                  <c:v>0.14404636961670686</c:v>
                </c:pt>
                <c:pt idx="649">
                  <c:v>-9.2955525127201538E-2</c:v>
                </c:pt>
                <c:pt idx="650">
                  <c:v>4.8654701840346405E-2</c:v>
                </c:pt>
                <c:pt idx="651">
                  <c:v>0.10097764772482092</c:v>
                </c:pt>
                <c:pt idx="652">
                  <c:v>0.20476675065461339</c:v>
                </c:pt>
                <c:pt idx="653">
                  <c:v>-0.35974927854598193</c:v>
                </c:pt>
                <c:pt idx="654">
                  <c:v>8.9769308633508405E-2</c:v>
                </c:pt>
                <c:pt idx="655">
                  <c:v>0.18840092460321003</c:v>
                </c:pt>
                <c:pt idx="656">
                  <c:v>-0.58100053456873424</c:v>
                </c:pt>
                <c:pt idx="657">
                  <c:v>0.77820857639808771</c:v>
                </c:pt>
                <c:pt idx="658">
                  <c:v>3.7311930641966591E-2</c:v>
                </c:pt>
                <c:pt idx="659">
                  <c:v>0.32653734813995189</c:v>
                </c:pt>
                <c:pt idx="660">
                  <c:v>-0.41138729348621372</c:v>
                </c:pt>
                <c:pt idx="661">
                  <c:v>-5.8442917282712031E-2</c:v>
                </c:pt>
                <c:pt idx="662">
                  <c:v>-0.19942102220163152</c:v>
                </c:pt>
                <c:pt idx="663">
                  <c:v>-0.1592346626761259</c:v>
                </c:pt>
                <c:pt idx="664">
                  <c:v>-0.3282537331367773</c:v>
                </c:pt>
                <c:pt idx="665">
                  <c:v>9.3695380233557043E-2</c:v>
                </c:pt>
                <c:pt idx="666">
                  <c:v>0.34959174255675179</c:v>
                </c:pt>
                <c:pt idx="667">
                  <c:v>0.17810907609432516</c:v>
                </c:pt>
                <c:pt idx="668">
                  <c:v>0.15432396466047718</c:v>
                </c:pt>
                <c:pt idx="669">
                  <c:v>0.5352567109038382</c:v>
                </c:pt>
                <c:pt idx="670">
                  <c:v>0.42427716417630545</c:v>
                </c:pt>
                <c:pt idx="671">
                  <c:v>2.2758397578157615E-2</c:v>
                </c:pt>
                <c:pt idx="672">
                  <c:v>0.20939097746742774</c:v>
                </c:pt>
                <c:pt idx="673">
                  <c:v>-9.5265439226189422E-2</c:v>
                </c:pt>
                <c:pt idx="674">
                  <c:v>6.2674362763392485E-2</c:v>
                </c:pt>
                <c:pt idx="675">
                  <c:v>-0.71193679967468382</c:v>
                </c:pt>
                <c:pt idx="676">
                  <c:v>-0.47393118833241243</c:v>
                </c:pt>
                <c:pt idx="677">
                  <c:v>-0.22769202504159672</c:v>
                </c:pt>
                <c:pt idx="678">
                  <c:v>-0.11450372678347603</c:v>
                </c:pt>
                <c:pt idx="679">
                  <c:v>0.1315894843281353</c:v>
                </c:pt>
                <c:pt idx="680">
                  <c:v>-0.2703819753094357</c:v>
                </c:pt>
                <c:pt idx="681">
                  <c:v>0.14090950654166201</c:v>
                </c:pt>
                <c:pt idx="682">
                  <c:v>0.30777822705819147</c:v>
                </c:pt>
                <c:pt idx="683">
                  <c:v>0.52225666762670075</c:v>
                </c:pt>
                <c:pt idx="684">
                  <c:v>0.36109457017632046</c:v>
                </c:pt>
                <c:pt idx="685">
                  <c:v>0.13316893348604381</c:v>
                </c:pt>
                <c:pt idx="686">
                  <c:v>-0.23667341743204048</c:v>
                </c:pt>
                <c:pt idx="687">
                  <c:v>5.1024003024466885E-2</c:v>
                </c:pt>
                <c:pt idx="688">
                  <c:v>0.60055521900626996</c:v>
                </c:pt>
                <c:pt idx="689">
                  <c:v>-0.30275995181708248</c:v>
                </c:pt>
                <c:pt idx="690">
                  <c:v>0.11209957977623511</c:v>
                </c:pt>
                <c:pt idx="691">
                  <c:v>-0.12752580294878771</c:v>
                </c:pt>
                <c:pt idx="692">
                  <c:v>-9.3417212167534708E-2</c:v>
                </c:pt>
                <c:pt idx="693">
                  <c:v>-7.7954422968056242E-2</c:v>
                </c:pt>
                <c:pt idx="694">
                  <c:v>0.7015046997649127</c:v>
                </c:pt>
                <c:pt idx="695">
                  <c:v>0.27738969881086384</c:v>
                </c:pt>
                <c:pt idx="696">
                  <c:v>-0.14432916555962885</c:v>
                </c:pt>
                <c:pt idx="697">
                  <c:v>-4.8412205185245895E-2</c:v>
                </c:pt>
                <c:pt idx="698">
                  <c:v>-0.5557570057775153</c:v>
                </c:pt>
                <c:pt idx="699">
                  <c:v>0.23915359984436965</c:v>
                </c:pt>
                <c:pt idx="700">
                  <c:v>-0.19445989268794478</c:v>
                </c:pt>
                <c:pt idx="701">
                  <c:v>-0.23837430779751656</c:v>
                </c:pt>
                <c:pt idx="702">
                  <c:v>9.2613392714283843E-2</c:v>
                </c:pt>
                <c:pt idx="703">
                  <c:v>-0.14992070419420242</c:v>
                </c:pt>
                <c:pt idx="704">
                  <c:v>1.8491749039879199E-2</c:v>
                </c:pt>
                <c:pt idx="705">
                  <c:v>6.5020769948411342E-2</c:v>
                </c:pt>
                <c:pt idx="706">
                  <c:v>-0.13352717028415231</c:v>
                </c:pt>
                <c:pt idx="707">
                  <c:v>0.34902551348205962</c:v>
                </c:pt>
                <c:pt idx="708">
                  <c:v>0.41424379871868749</c:v>
                </c:pt>
                <c:pt idx="709">
                  <c:v>0.26038703742893748</c:v>
                </c:pt>
                <c:pt idx="710">
                  <c:v>8.3928155062359275E-2</c:v>
                </c:pt>
                <c:pt idx="711">
                  <c:v>-0.13131323467786499</c:v>
                </c:pt>
                <c:pt idx="712">
                  <c:v>-5.0950715977864845E-2</c:v>
                </c:pt>
                <c:pt idx="713">
                  <c:v>7.0251921820444208E-2</c:v>
                </c:pt>
                <c:pt idx="714">
                  <c:v>-0.66978582275069831</c:v>
                </c:pt>
                <c:pt idx="715">
                  <c:v>-0.11107170841543583</c:v>
                </c:pt>
                <c:pt idx="716">
                  <c:v>-7.9567238283430389E-3</c:v>
                </c:pt>
                <c:pt idx="717">
                  <c:v>-1.1890222828758559</c:v>
                </c:pt>
                <c:pt idx="718">
                  <c:v>-0.4213993638472574</c:v>
                </c:pt>
                <c:pt idx="719">
                  <c:v>0.37584572466782368</c:v>
                </c:pt>
                <c:pt idx="720">
                  <c:v>1.2661568636466183</c:v>
                </c:pt>
                <c:pt idx="721">
                  <c:v>-0.14912058491192856</c:v>
                </c:pt>
                <c:pt idx="722">
                  <c:v>-0.61727741964701033</c:v>
                </c:pt>
                <c:pt idx="723">
                  <c:v>0.10554399219892611</c:v>
                </c:pt>
                <c:pt idx="724">
                  <c:v>-6.4766575050440145E-2</c:v>
                </c:pt>
                <c:pt idx="725">
                  <c:v>-0.17250612639620203</c:v>
                </c:pt>
                <c:pt idx="726">
                  <c:v>-0.33442531167132961</c:v>
                </c:pt>
                <c:pt idx="727">
                  <c:v>6.04624879861069E-2</c:v>
                </c:pt>
                <c:pt idx="728">
                  <c:v>0.55561985666812796</c:v>
                </c:pt>
                <c:pt idx="729">
                  <c:v>-0.14672288610361572</c:v>
                </c:pt>
                <c:pt idx="730">
                  <c:v>-0.1695824020521686</c:v>
                </c:pt>
                <c:pt idx="731">
                  <c:v>3.6749476427868279E-2</c:v>
                </c:pt>
                <c:pt idx="732">
                  <c:v>0.74794589274462164</c:v>
                </c:pt>
                <c:pt idx="733">
                  <c:v>-0.10889193997006984</c:v>
                </c:pt>
                <c:pt idx="734">
                  <c:v>1.1627256528462031</c:v>
                </c:pt>
                <c:pt idx="735">
                  <c:v>-7.6280321250611363E-2</c:v>
                </c:pt>
                <c:pt idx="736">
                  <c:v>2.5170575734906053E-2</c:v>
                </c:pt>
                <c:pt idx="737">
                  <c:v>-0.10967005068462765</c:v>
                </c:pt>
                <c:pt idx="738">
                  <c:v>0.56306048276387322</c:v>
                </c:pt>
                <c:pt idx="739">
                  <c:v>-0.37613313814730182</c:v>
                </c:pt>
                <c:pt idx="740">
                  <c:v>0.15250794836490289</c:v>
                </c:pt>
                <c:pt idx="741">
                  <c:v>0.27703255187479342</c:v>
                </c:pt>
                <c:pt idx="742">
                  <c:v>0.34687181394424943</c:v>
                </c:pt>
                <c:pt idx="743">
                  <c:v>-0.47312991364317331</c:v>
                </c:pt>
                <c:pt idx="744">
                  <c:v>0.78634543658521039</c:v>
                </c:pt>
                <c:pt idx="745">
                  <c:v>-2.6939827195915918E-2</c:v>
                </c:pt>
                <c:pt idx="746">
                  <c:v>-0.22145497419719512</c:v>
                </c:pt>
                <c:pt idx="747">
                  <c:v>0.16259676598848671</c:v>
                </c:pt>
                <c:pt idx="748">
                  <c:v>0.15717309403346449</c:v>
                </c:pt>
                <c:pt idx="749">
                  <c:v>7.8883046521989117E-2</c:v>
                </c:pt>
                <c:pt idx="750">
                  <c:v>1.6815841954078865</c:v>
                </c:pt>
                <c:pt idx="751">
                  <c:v>0.22354611595281831</c:v>
                </c:pt>
                <c:pt idx="752">
                  <c:v>4.3484497603579468E-2</c:v>
                </c:pt>
                <c:pt idx="753">
                  <c:v>0.34913877707708452</c:v>
                </c:pt>
                <c:pt idx="754">
                  <c:v>0.33605482401083503</c:v>
                </c:pt>
                <c:pt idx="755">
                  <c:v>-0.32264962280482185</c:v>
                </c:pt>
                <c:pt idx="756">
                  <c:v>0.32768736417604716</c:v>
                </c:pt>
                <c:pt idx="757">
                  <c:v>0.48892626752413432</c:v>
                </c:pt>
                <c:pt idx="758">
                  <c:v>2.5879273023258959E-2</c:v>
                </c:pt>
                <c:pt idx="759">
                  <c:v>-0.52824025834661592</c:v>
                </c:pt>
                <c:pt idx="760">
                  <c:v>0.24403458239369338</c:v>
                </c:pt>
                <c:pt idx="761">
                  <c:v>-0.38533726506342392</c:v>
                </c:pt>
                <c:pt idx="762">
                  <c:v>2.2332300098056389E-2</c:v>
                </c:pt>
                <c:pt idx="763">
                  <c:v>-2.6498928183401077E-2</c:v>
                </c:pt>
                <c:pt idx="764">
                  <c:v>0.56149722101981503</c:v>
                </c:pt>
                <c:pt idx="765">
                  <c:v>0.19017234480229803</c:v>
                </c:pt>
                <c:pt idx="766">
                  <c:v>0.10017031975697704</c:v>
                </c:pt>
                <c:pt idx="767">
                  <c:v>0.12750121921583699</c:v>
                </c:pt>
                <c:pt idx="768">
                  <c:v>0.10232219119668604</c:v>
                </c:pt>
                <c:pt idx="769">
                  <c:v>-0.24144097295032563</c:v>
                </c:pt>
                <c:pt idx="770">
                  <c:v>0.16748638996564932</c:v>
                </c:pt>
                <c:pt idx="771">
                  <c:v>-7.3545065455919836E-2</c:v>
                </c:pt>
                <c:pt idx="772">
                  <c:v>0.91096286083022449</c:v>
                </c:pt>
                <c:pt idx="773">
                  <c:v>-0.1124747292584125</c:v>
                </c:pt>
                <c:pt idx="774">
                  <c:v>0.52326084045271481</c:v>
                </c:pt>
                <c:pt idx="775">
                  <c:v>-0.94647155901070079</c:v>
                </c:pt>
                <c:pt idx="776">
                  <c:v>0.17171923908784797</c:v>
                </c:pt>
                <c:pt idx="777">
                  <c:v>-0.13748909687166025</c:v>
                </c:pt>
                <c:pt idx="778">
                  <c:v>1.3355058669067579E-2</c:v>
                </c:pt>
                <c:pt idx="779">
                  <c:v>0.18231091802569632</c:v>
                </c:pt>
                <c:pt idx="780">
                  <c:v>6.9977070411556347E-2</c:v>
                </c:pt>
                <c:pt idx="781">
                  <c:v>-0.15312562618508427</c:v>
                </c:pt>
                <c:pt idx="782">
                  <c:v>0.22230997926431559</c:v>
                </c:pt>
                <c:pt idx="783">
                  <c:v>5.4779031519619492E-2</c:v>
                </c:pt>
                <c:pt idx="784">
                  <c:v>0.24780601821921888</c:v>
                </c:pt>
                <c:pt idx="785">
                  <c:v>-8.4211427188055091E-2</c:v>
                </c:pt>
                <c:pt idx="786">
                  <c:v>0.17056605679206857</c:v>
                </c:pt>
                <c:pt idx="787">
                  <c:v>0.3060288694522062</c:v>
                </c:pt>
                <c:pt idx="788">
                  <c:v>3.8717107572853585E-2</c:v>
                </c:pt>
                <c:pt idx="789">
                  <c:v>-3.0177210327092033E-2</c:v>
                </c:pt>
                <c:pt idx="790">
                  <c:v>-9.1417634521186258E-2</c:v>
                </c:pt>
                <c:pt idx="791">
                  <c:v>-0.59968067713551498</c:v>
                </c:pt>
                <c:pt idx="792">
                  <c:v>-0.38967790355796311</c:v>
                </c:pt>
                <c:pt idx="793">
                  <c:v>0.17708860210596758</c:v>
                </c:pt>
                <c:pt idx="794">
                  <c:v>-0.40068220630177387</c:v>
                </c:pt>
                <c:pt idx="795">
                  <c:v>-5.7691943843815319E-2</c:v>
                </c:pt>
                <c:pt idx="796">
                  <c:v>-0.22212795148794712</c:v>
                </c:pt>
                <c:pt idx="797">
                  <c:v>0.27011027582361774</c:v>
                </c:pt>
                <c:pt idx="798">
                  <c:v>-0.15810736839694411</c:v>
                </c:pt>
                <c:pt idx="799">
                  <c:v>0.37094541257663599</c:v>
                </c:pt>
                <c:pt idx="800">
                  <c:v>0.10070858859668395</c:v>
                </c:pt>
                <c:pt idx="801">
                  <c:v>0.20576784014981819</c:v>
                </c:pt>
                <c:pt idx="802">
                  <c:v>0.21871918170311724</c:v>
                </c:pt>
                <c:pt idx="803">
                  <c:v>0.12921706366415348</c:v>
                </c:pt>
                <c:pt idx="804">
                  <c:v>5.4501216182560569E-2</c:v>
                </c:pt>
                <c:pt idx="805">
                  <c:v>0.13697881196350373</c:v>
                </c:pt>
                <c:pt idx="806">
                  <c:v>4.4464066513246032E-2</c:v>
                </c:pt>
                <c:pt idx="807">
                  <c:v>0.12750121921583699</c:v>
                </c:pt>
                <c:pt idx="808">
                  <c:v>0.43712118438419428</c:v>
                </c:pt>
                <c:pt idx="809">
                  <c:v>-0.20439927089869361</c:v>
                </c:pt>
                <c:pt idx="810">
                  <c:v>0.1495195214900292</c:v>
                </c:pt>
                <c:pt idx="811">
                  <c:v>0.24914190328034752</c:v>
                </c:pt>
                <c:pt idx="812">
                  <c:v>0.31869283314833541</c:v>
                </c:pt>
                <c:pt idx="813">
                  <c:v>0.35693256841934529</c:v>
                </c:pt>
                <c:pt idx="814">
                  <c:v>0.17785402525994945</c:v>
                </c:pt>
                <c:pt idx="815">
                  <c:v>1.4355292977070055E-2</c:v>
                </c:pt>
                <c:pt idx="816">
                  <c:v>0.1631122443471244</c:v>
                </c:pt>
                <c:pt idx="817">
                  <c:v>-0.81883382573002306</c:v>
                </c:pt>
                <c:pt idx="818">
                  <c:v>-7.187606958699487E-2</c:v>
                </c:pt>
                <c:pt idx="819">
                  <c:v>0.24829193773910013</c:v>
                </c:pt>
                <c:pt idx="820">
                  <c:v>0.31103803002230457</c:v>
                </c:pt>
                <c:pt idx="821">
                  <c:v>0.88213434855421757</c:v>
                </c:pt>
                <c:pt idx="822">
                  <c:v>-0.27473873117490921</c:v>
                </c:pt>
                <c:pt idx="823">
                  <c:v>0.1151664496349353</c:v>
                </c:pt>
                <c:pt idx="824">
                  <c:v>-1.3226496228048219</c:v>
                </c:pt>
                <c:pt idx="825">
                  <c:v>-4.1565604913584353E-2</c:v>
                </c:pt>
                <c:pt idx="826">
                  <c:v>0.30474465771863113</c:v>
                </c:pt>
                <c:pt idx="827">
                  <c:v>0.43871867656479113</c:v>
                </c:pt>
                <c:pt idx="828">
                  <c:v>0.25930262134514132</c:v>
                </c:pt>
                <c:pt idx="829">
                  <c:v>-0.33952768671884448</c:v>
                </c:pt>
                <c:pt idx="830">
                  <c:v>5.8939854556232962E-2</c:v>
                </c:pt>
                <c:pt idx="831">
                  <c:v>-0.10624949827943407</c:v>
                </c:pt>
                <c:pt idx="832">
                  <c:v>0.20276248527588681</c:v>
                </c:pt>
                <c:pt idx="833">
                  <c:v>-0.28384314757039358</c:v>
                </c:pt>
                <c:pt idx="834">
                  <c:v>-0.25085193287640339</c:v>
                </c:pt>
                <c:pt idx="835">
                  <c:v>-8.4058494019852437E-2</c:v>
                </c:pt>
                <c:pt idx="836">
                  <c:v>-0.25652811740860676</c:v>
                </c:pt>
                <c:pt idx="837">
                  <c:v>0.12220886170022928</c:v>
                </c:pt>
                <c:pt idx="838">
                  <c:v>0.14587306160104482</c:v>
                </c:pt>
                <c:pt idx="839">
                  <c:v>-0.19942102220163152</c:v>
                </c:pt>
                <c:pt idx="840">
                  <c:v>0.10043947928031166</c:v>
                </c:pt>
                <c:pt idx="841">
                  <c:v>0.39495308469636126</c:v>
                </c:pt>
                <c:pt idx="842">
                  <c:v>0.19333019538430424</c:v>
                </c:pt>
                <c:pt idx="843">
                  <c:v>0.33388165946809018</c:v>
                </c:pt>
                <c:pt idx="844">
                  <c:v>-2.3416402123002746E-2</c:v>
                </c:pt>
                <c:pt idx="845">
                  <c:v>4.5023521698497729E-2</c:v>
                </c:pt>
                <c:pt idx="846">
                  <c:v>7.6559095131604402E-2</c:v>
                </c:pt>
                <c:pt idx="847">
                  <c:v>3.3229160785110998E-2</c:v>
                </c:pt>
                <c:pt idx="848">
                  <c:v>1.2202680353087014</c:v>
                </c:pt>
                <c:pt idx="849">
                  <c:v>0.55679724659274321</c:v>
                </c:pt>
                <c:pt idx="850">
                  <c:v>-2.8557610682609706E-2</c:v>
                </c:pt>
                <c:pt idx="851">
                  <c:v>0.82048534298637898</c:v>
                </c:pt>
                <c:pt idx="852">
                  <c:v>-2.6351991783529823E-2</c:v>
                </c:pt>
                <c:pt idx="853">
                  <c:v>0.19232043503449905</c:v>
                </c:pt>
                <c:pt idx="854">
                  <c:v>0.25302109571151316</c:v>
                </c:pt>
                <c:pt idx="855">
                  <c:v>0.89909827210408289</c:v>
                </c:pt>
                <c:pt idx="856">
                  <c:v>-3.6229968929237404E-2</c:v>
                </c:pt>
                <c:pt idx="857">
                  <c:v>9.2613392714283843E-2</c:v>
                </c:pt>
                <c:pt idx="858">
                  <c:v>-4.3497222229955772E-2</c:v>
                </c:pt>
                <c:pt idx="859">
                  <c:v>-0.67300253543424127</c:v>
                </c:pt>
                <c:pt idx="860">
                  <c:v>0.44985186519090581</c:v>
                </c:pt>
                <c:pt idx="861">
                  <c:v>-1.9708651959469772</c:v>
                </c:pt>
                <c:pt idx="862">
                  <c:v>0.84943888072885654</c:v>
                </c:pt>
                <c:pt idx="863">
                  <c:v>0.18726100484169694</c:v>
                </c:pt>
                <c:pt idx="864">
                  <c:v>-0.2889456781879336</c:v>
                </c:pt>
                <c:pt idx="865">
                  <c:v>0.92956378375783344</c:v>
                </c:pt>
                <c:pt idx="866">
                  <c:v>0.37350901551800741</c:v>
                </c:pt>
                <c:pt idx="867">
                  <c:v>-0.28243872298551187</c:v>
                </c:pt>
                <c:pt idx="868">
                  <c:v>-0.16925790923908474</c:v>
                </c:pt>
                <c:pt idx="869">
                  <c:v>5.1441711382610174E-2</c:v>
                </c:pt>
                <c:pt idx="870">
                  <c:v>0.21238257012235723</c:v>
                </c:pt>
                <c:pt idx="871">
                  <c:v>-0.37594590888989948</c:v>
                </c:pt>
                <c:pt idx="872">
                  <c:v>-7.2152791745935796E-4</c:v>
                </c:pt>
                <c:pt idx="873">
                  <c:v>-0.43070335443835533</c:v>
                </c:pt>
                <c:pt idx="874">
                  <c:v>4.5582760019634981E-2</c:v>
                </c:pt>
                <c:pt idx="875">
                  <c:v>-7.597614772199382E-2</c:v>
                </c:pt>
                <c:pt idx="876">
                  <c:v>-0.17722906973322358</c:v>
                </c:pt>
                <c:pt idx="877">
                  <c:v>-1.6103455397704806E-2</c:v>
                </c:pt>
                <c:pt idx="878">
                  <c:v>3.7593075540233077E-2</c:v>
                </c:pt>
                <c:pt idx="879">
                  <c:v>-0.11904026141721905</c:v>
                </c:pt>
                <c:pt idx="880">
                  <c:v>-0.17902458339483771</c:v>
                </c:pt>
                <c:pt idx="881">
                  <c:v>-2.4736678321506448E-2</c:v>
                </c:pt>
                <c:pt idx="882">
                  <c:v>0.17670573818911434</c:v>
                </c:pt>
                <c:pt idx="883">
                  <c:v>-0.48580197665241931</c:v>
                </c:pt>
                <c:pt idx="884">
                  <c:v>-0.51045706435752647</c:v>
                </c:pt>
                <c:pt idx="885">
                  <c:v>1.0211243400356065</c:v>
                </c:pt>
                <c:pt idx="886">
                  <c:v>9.4641454115062321E-2</c:v>
                </c:pt>
                <c:pt idx="887">
                  <c:v>-0.79360683148839617</c:v>
                </c:pt>
                <c:pt idx="888">
                  <c:v>-0.13115522634947868</c:v>
                </c:pt>
                <c:pt idx="889">
                  <c:v>0.44243929362386342</c:v>
                </c:pt>
                <c:pt idx="890">
                  <c:v>0.17120682741814242</c:v>
                </c:pt>
                <c:pt idx="891">
                  <c:v>-0.15392797036954209</c:v>
                </c:pt>
                <c:pt idx="892">
                  <c:v>0.18662732668292162</c:v>
                </c:pt>
                <c:pt idx="893">
                  <c:v>-0.15537331533019225</c:v>
                </c:pt>
                <c:pt idx="894">
                  <c:v>-0.16052407850624451</c:v>
                </c:pt>
                <c:pt idx="895">
                  <c:v>0.32699746456575879</c:v>
                </c:pt>
                <c:pt idx="896">
                  <c:v>0.41629930547987942</c:v>
                </c:pt>
                <c:pt idx="897">
                  <c:v>0.10138114235502452</c:v>
                </c:pt>
                <c:pt idx="898">
                  <c:v>0.2672361418124099</c:v>
                </c:pt>
                <c:pt idx="899">
                  <c:v>0.3313612672682994</c:v>
                </c:pt>
                <c:pt idx="900">
                  <c:v>-0.36141638476833787</c:v>
                </c:pt>
                <c:pt idx="901">
                  <c:v>0.15042969819420526</c:v>
                </c:pt>
                <c:pt idx="902">
                  <c:v>0.22478119439558927</c:v>
                </c:pt>
                <c:pt idx="903">
                  <c:v>-0.21541226362111154</c:v>
                </c:pt>
                <c:pt idx="904">
                  <c:v>0.1392075202712541</c:v>
                </c:pt>
                <c:pt idx="905">
                  <c:v>0.32354300914988898</c:v>
                </c:pt>
                <c:pt idx="906">
                  <c:v>-0.33916263230371629</c:v>
                </c:pt>
                <c:pt idx="907">
                  <c:v>-0.22650997250444205</c:v>
                </c:pt>
                <c:pt idx="908">
                  <c:v>-0.15537331533019225</c:v>
                </c:pt>
                <c:pt idx="909">
                  <c:v>-0.80364475711725158</c:v>
                </c:pt>
                <c:pt idx="910">
                  <c:v>-0.26205370660595007</c:v>
                </c:pt>
                <c:pt idx="911">
                  <c:v>0.52967104834778322</c:v>
                </c:pt>
                <c:pt idx="912">
                  <c:v>1.5925689990254212E-2</c:v>
                </c:pt>
                <c:pt idx="913">
                  <c:v>1.3737317223787289</c:v>
                </c:pt>
                <c:pt idx="914">
                  <c:v>4.739878887541106E-2</c:v>
                </c:pt>
                <c:pt idx="915">
                  <c:v>-0.13653724174087753</c:v>
                </c:pt>
                <c:pt idx="916">
                  <c:v>4.1102771819128116E-2</c:v>
                </c:pt>
                <c:pt idx="917">
                  <c:v>0.1947174628935997</c:v>
                </c:pt>
                <c:pt idx="918">
                  <c:v>-0.34245145221024748</c:v>
                </c:pt>
                <c:pt idx="919">
                  <c:v>3.0830430153274507E-2</c:v>
                </c:pt>
                <c:pt idx="920">
                  <c:v>-0.13210353600734515</c:v>
                </c:pt>
                <c:pt idx="921">
                  <c:v>7.5874866975127644E-2</c:v>
                </c:pt>
                <c:pt idx="922">
                  <c:v>-4.6027091947825026E-2</c:v>
                </c:pt>
                <c:pt idx="923">
                  <c:v>-0.87805626648959878</c:v>
                </c:pt>
                <c:pt idx="924">
                  <c:v>0.2660368939953171</c:v>
                </c:pt>
                <c:pt idx="925">
                  <c:v>-8.682243099800882E-3</c:v>
                </c:pt>
                <c:pt idx="926">
                  <c:v>0.34675837222680245</c:v>
                </c:pt>
                <c:pt idx="927">
                  <c:v>-0.45225406131285639</c:v>
                </c:pt>
                <c:pt idx="928">
                  <c:v>2.5595835882683472E-2</c:v>
                </c:pt>
                <c:pt idx="929">
                  <c:v>-0.45878255189796296</c:v>
                </c:pt>
                <c:pt idx="930">
                  <c:v>-0.12736820886474998</c:v>
                </c:pt>
                <c:pt idx="931">
                  <c:v>-7.3393258748683562E-2</c:v>
                </c:pt>
                <c:pt idx="932">
                  <c:v>0.30882682434788383</c:v>
                </c:pt>
                <c:pt idx="933">
                  <c:v>0.28948038613759469</c:v>
                </c:pt>
                <c:pt idx="934">
                  <c:v>-0.23497452999962937</c:v>
                </c:pt>
                <c:pt idx="935">
                  <c:v>-7.1421223792394808E-2</c:v>
                </c:pt>
                <c:pt idx="936">
                  <c:v>8.0930487672983928E-2</c:v>
                </c:pt>
                <c:pt idx="937">
                  <c:v>6.2812492405021181E-2</c:v>
                </c:pt>
                <c:pt idx="938">
                  <c:v>0.13553486976118947</c:v>
                </c:pt>
                <c:pt idx="939">
                  <c:v>0.37651266128847938</c:v>
                </c:pt>
                <c:pt idx="940">
                  <c:v>-0.22465441592596019</c:v>
                </c:pt>
                <c:pt idx="941">
                  <c:v>-0.64611216371509261</c:v>
                </c:pt>
                <c:pt idx="942">
                  <c:v>5.0745463581398975E-2</c:v>
                </c:pt>
                <c:pt idx="943">
                  <c:v>0.2714256760929345</c:v>
                </c:pt>
                <c:pt idx="944">
                  <c:v>-0.13606154957602837</c:v>
                </c:pt>
                <c:pt idx="945">
                  <c:v>-9.68074392029252E-2</c:v>
                </c:pt>
                <c:pt idx="946">
                  <c:v>0.17759892932773344</c:v>
                </c:pt>
                <c:pt idx="947">
                  <c:v>0.3740657182225377</c:v>
                </c:pt>
                <c:pt idx="948">
                  <c:v>0.73699444777848888</c:v>
                </c:pt>
                <c:pt idx="949">
                  <c:v>0.15536066283920233</c:v>
                </c:pt>
                <c:pt idx="950">
                  <c:v>-0.29778574898955923</c:v>
                </c:pt>
                <c:pt idx="951">
                  <c:v>0.292781749227846</c:v>
                </c:pt>
                <c:pt idx="952">
                  <c:v>-1.2297206567902736</c:v>
                </c:pt>
                <c:pt idx="953">
                  <c:v>-0.11200690402352172</c:v>
                </c:pt>
                <c:pt idx="954">
                  <c:v>0.29760229865200793</c:v>
                </c:pt>
                <c:pt idx="955">
                  <c:v>-0.93373855773127867</c:v>
                </c:pt>
                <c:pt idx="956">
                  <c:v>3.9840264531791104E-2</c:v>
                </c:pt>
                <c:pt idx="957">
                  <c:v>-0.92823733069990888</c:v>
                </c:pt>
                <c:pt idx="958">
                  <c:v>0.4188915560074607</c:v>
                </c:pt>
                <c:pt idx="959">
                  <c:v>-8.1461107488762799E-2</c:v>
                </c:pt>
                <c:pt idx="960">
                  <c:v>0.21946283895715482</c:v>
                </c:pt>
                <c:pt idx="961">
                  <c:v>0.22490464410609018</c:v>
                </c:pt>
                <c:pt idx="962">
                  <c:v>0.27130614379733703</c:v>
                </c:pt>
                <c:pt idx="963">
                  <c:v>0.17478989304781481</c:v>
                </c:pt>
                <c:pt idx="964">
                  <c:v>-3.4899137556436519E-2</c:v>
                </c:pt>
                <c:pt idx="965">
                  <c:v>-0.13400202739773406</c:v>
                </c:pt>
                <c:pt idx="966">
                  <c:v>0.2911320120087531</c:v>
                </c:pt>
                <c:pt idx="967">
                  <c:v>0.75745001623129016</c:v>
                </c:pt>
                <c:pt idx="968">
                  <c:v>-0.12752580294878771</c:v>
                </c:pt>
                <c:pt idx="969">
                  <c:v>-0.27316878296750702</c:v>
                </c:pt>
                <c:pt idx="970">
                  <c:v>0.36030808479519605</c:v>
                </c:pt>
                <c:pt idx="971">
                  <c:v>0.10393399105623309</c:v>
                </c:pt>
                <c:pt idx="972">
                  <c:v>-0.11465992177533421</c:v>
                </c:pt>
                <c:pt idx="973">
                  <c:v>3.7874165661120111E-2</c:v>
                </c:pt>
                <c:pt idx="974">
                  <c:v>-0.22179142360191229</c:v>
                </c:pt>
                <c:pt idx="975">
                  <c:v>-7.3241468013534983E-2</c:v>
                </c:pt>
                <c:pt idx="976">
                  <c:v>3.9699917720951411E-2</c:v>
                </c:pt>
                <c:pt idx="977">
                  <c:v>0.36221737748716937</c:v>
                </c:pt>
                <c:pt idx="978">
                  <c:v>-4.751732556952442E-2</c:v>
                </c:pt>
                <c:pt idx="979">
                  <c:v>-0.45284634118743111</c:v>
                </c:pt>
                <c:pt idx="980">
                  <c:v>-1.013916780335185</c:v>
                </c:pt>
                <c:pt idx="981">
                  <c:v>0.18764107818068257</c:v>
                </c:pt>
                <c:pt idx="982">
                  <c:v>-8.1017984969644994E-3</c:v>
                </c:pt>
                <c:pt idx="983">
                  <c:v>0.67879307235629172</c:v>
                </c:pt>
                <c:pt idx="984">
                  <c:v>0.79435347818858404</c:v>
                </c:pt>
                <c:pt idx="985">
                  <c:v>0.66630212817309487</c:v>
                </c:pt>
                <c:pt idx="986">
                  <c:v>-1.2095615718147992</c:v>
                </c:pt>
                <c:pt idx="987">
                  <c:v>-0.14656318111193345</c:v>
                </c:pt>
                <c:pt idx="988">
                  <c:v>-6.1450726233945659E-2</c:v>
                </c:pt>
                <c:pt idx="989">
                  <c:v>-0.15746359549876116</c:v>
                </c:pt>
                <c:pt idx="990">
                  <c:v>0.13053555675618825</c:v>
                </c:pt>
                <c:pt idx="991">
                  <c:v>3.1677496450760248E-2</c:v>
                </c:pt>
                <c:pt idx="992">
                  <c:v>0.24719838857586485</c:v>
                </c:pt>
                <c:pt idx="993">
                  <c:v>0.79318840368061594</c:v>
                </c:pt>
                <c:pt idx="994">
                  <c:v>0.10178452416693216</c:v>
                </c:pt>
                <c:pt idx="995">
                  <c:v>-0.17478423769433896</c:v>
                </c:pt>
                <c:pt idx="996">
                  <c:v>-0.13955360661155597</c:v>
                </c:pt>
                <c:pt idx="997">
                  <c:v>9.3471722592525994E-3</c:v>
                </c:pt>
                <c:pt idx="998">
                  <c:v>0.30451104180995309</c:v>
                </c:pt>
                <c:pt idx="999">
                  <c:v>-7.4760094512589539E-2</c:v>
                </c:pt>
                <c:pt idx="1000">
                  <c:v>3.8155201025968831E-2</c:v>
                </c:pt>
                <c:pt idx="1001">
                  <c:v>9.5586907997723985E-2</c:v>
                </c:pt>
                <c:pt idx="1002">
                  <c:v>0.63338470855734297</c:v>
                </c:pt>
                <c:pt idx="1003">
                  <c:v>-4.1862608525727242E-2</c:v>
                </c:pt>
                <c:pt idx="1004">
                  <c:v>-0.90158044223445544</c:v>
                </c:pt>
                <c:pt idx="1005">
                  <c:v>-2.1218623237265453E-2</c:v>
                </c:pt>
                <c:pt idx="1006">
                  <c:v>0.49988414589190988</c:v>
                </c:pt>
                <c:pt idx="1007">
                  <c:v>0.77112495312836671</c:v>
                </c:pt>
                <c:pt idx="1008">
                  <c:v>-6.1149662993936413E-2</c:v>
                </c:pt>
                <c:pt idx="1009">
                  <c:v>-1.0279670959395051E-2</c:v>
                </c:pt>
                <c:pt idx="1010">
                  <c:v>-0.53595912811011326</c:v>
                </c:pt>
                <c:pt idx="1011">
                  <c:v>0.13842131042024966</c:v>
                </c:pt>
                <c:pt idx="1012">
                  <c:v>-0.18033181650354449</c:v>
                </c:pt>
                <c:pt idx="1013">
                  <c:v>9.9497201170189897E-2</c:v>
                </c:pt>
                <c:pt idx="1014">
                  <c:v>-0.16116921883712443</c:v>
                </c:pt>
                <c:pt idx="1015">
                  <c:v>0.26615686364661811</c:v>
                </c:pt>
                <c:pt idx="1016">
                  <c:v>-4.8859853233794395E-2</c:v>
                </c:pt>
                <c:pt idx="1017">
                  <c:v>-0.10036030634895302</c:v>
                </c:pt>
                <c:pt idx="1018">
                  <c:v>-5.9645288466706789E-2</c:v>
                </c:pt>
                <c:pt idx="1019">
                  <c:v>-0.16262184024619339</c:v>
                </c:pt>
                <c:pt idx="1020">
                  <c:v>-4.7964695992527992E-2</c:v>
                </c:pt>
                <c:pt idx="1021">
                  <c:v>-1.2751907408847889E-2</c:v>
                </c:pt>
                <c:pt idx="1022">
                  <c:v>1.6068368627653675E-2</c:v>
                </c:pt>
                <c:pt idx="1023">
                  <c:v>0.15003969277415322</c:v>
                </c:pt>
                <c:pt idx="1024">
                  <c:v>-2.6792845886544348E-2</c:v>
                </c:pt>
                <c:pt idx="1025">
                  <c:v>-0.32210844303946773</c:v>
                </c:pt>
                <c:pt idx="1026">
                  <c:v>5.3667449038825303E-2</c:v>
                </c:pt>
                <c:pt idx="1027">
                  <c:v>0.53296521593360235</c:v>
                </c:pt>
                <c:pt idx="1028">
                  <c:v>-7.2315692310758635E-3</c:v>
                </c:pt>
                <c:pt idx="1029">
                  <c:v>0.80636530612245516</c:v>
                </c:pt>
                <c:pt idx="1030">
                  <c:v>-0.55152187858852286</c:v>
                </c:pt>
                <c:pt idx="1031">
                  <c:v>-0.29956028185890782</c:v>
                </c:pt>
                <c:pt idx="1032">
                  <c:v>0.21797514092288733</c:v>
                </c:pt>
                <c:pt idx="1033">
                  <c:v>-4.6474000426040364E-2</c:v>
                </c:pt>
                <c:pt idx="1034">
                  <c:v>-0.23633347986192646</c:v>
                </c:pt>
                <c:pt idx="1035">
                  <c:v>0.41608307420835816</c:v>
                </c:pt>
                <c:pt idx="1036">
                  <c:v>5.8939854556232962E-2</c:v>
                </c:pt>
                <c:pt idx="1037">
                  <c:v>2.1624211506207254E-3</c:v>
                </c:pt>
                <c:pt idx="1038">
                  <c:v>0.88315157086247809</c:v>
                </c:pt>
                <c:pt idx="1039">
                  <c:v>0.3352545652410609</c:v>
                </c:pt>
                <c:pt idx="1040">
                  <c:v>8.1884966729227376E-2</c:v>
                </c:pt>
                <c:pt idx="1041">
                  <c:v>4.4324168812201428E-2</c:v>
                </c:pt>
                <c:pt idx="1042">
                  <c:v>0.17082239919517525</c:v>
                </c:pt>
                <c:pt idx="1043">
                  <c:v>-0.76023537348905335</c:v>
                </c:pt>
                <c:pt idx="1044">
                  <c:v>0.11822681379294767</c:v>
                </c:pt>
                <c:pt idx="1045">
                  <c:v>0.39889757120247327</c:v>
                </c:pt>
                <c:pt idx="1046">
                  <c:v>0.25362627842137686</c:v>
                </c:pt>
                <c:pt idx="1047">
                  <c:v>-0.18573670860021829</c:v>
                </c:pt>
                <c:pt idx="1048">
                  <c:v>0.20075543159558679</c:v>
                </c:pt>
                <c:pt idx="1049">
                  <c:v>0.20801775489589241</c:v>
                </c:pt>
                <c:pt idx="1050">
                  <c:v>-2.9588054610526951E-2</c:v>
                </c:pt>
                <c:pt idx="1051">
                  <c:v>-2.1218623237265453E-2</c:v>
                </c:pt>
                <c:pt idx="1052">
                  <c:v>7.2448850069692441E-2</c:v>
                </c:pt>
                <c:pt idx="1053">
                  <c:v>0.36154379796786501</c:v>
                </c:pt>
                <c:pt idx="1054">
                  <c:v>0.13907651504611174</c:v>
                </c:pt>
                <c:pt idx="1055">
                  <c:v>0.32665239100440335</c:v>
                </c:pt>
                <c:pt idx="1056">
                  <c:v>8.8548697010238028E-2</c:v>
                </c:pt>
                <c:pt idx="1057">
                  <c:v>0.15094954147192738</c:v>
                </c:pt>
                <c:pt idx="1058">
                  <c:v>0.22305178836844153</c:v>
                </c:pt>
                <c:pt idx="1059">
                  <c:v>8.8820033298585108E-2</c:v>
                </c:pt>
                <c:pt idx="1060">
                  <c:v>-0.34245145221024748</c:v>
                </c:pt>
                <c:pt idx="1061">
                  <c:v>-0.14960060322974547</c:v>
                </c:pt>
                <c:pt idx="1062">
                  <c:v>0.25676914276134122</c:v>
                </c:pt>
                <c:pt idx="1063">
                  <c:v>0.27453004467162329</c:v>
                </c:pt>
                <c:pt idx="1064">
                  <c:v>0.41370238878217669</c:v>
                </c:pt>
                <c:pt idx="1065">
                  <c:v>-0.10066966520955489</c:v>
                </c:pt>
                <c:pt idx="1066">
                  <c:v>0.28948038613759469</c:v>
                </c:pt>
                <c:pt idx="1067">
                  <c:v>0.39000726209155923</c:v>
                </c:pt>
                <c:pt idx="1068">
                  <c:v>0.57811753162393764</c:v>
                </c:pt>
                <c:pt idx="1069">
                  <c:v>0.30509501066669742</c:v>
                </c:pt>
                <c:pt idx="1070">
                  <c:v>0.10915993896111069</c:v>
                </c:pt>
                <c:pt idx="1071">
                  <c:v>-1.0860992631766838E-2</c:v>
                </c:pt>
                <c:pt idx="1072">
                  <c:v>0.20351441113075852</c:v>
                </c:pt>
                <c:pt idx="1073">
                  <c:v>-0.19776541605150852</c:v>
                </c:pt>
                <c:pt idx="1074">
                  <c:v>0.23793076959580084</c:v>
                </c:pt>
                <c:pt idx="1075">
                  <c:v>0.26147063901278217</c:v>
                </c:pt>
                <c:pt idx="1076">
                  <c:v>-8.3141235300245864E-2</c:v>
                </c:pt>
                <c:pt idx="1077">
                  <c:v>-3.2831392467372364E-2</c:v>
                </c:pt>
                <c:pt idx="1078">
                  <c:v>0.44020807501374981</c:v>
                </c:pt>
                <c:pt idx="1079">
                  <c:v>0.40119355106326404</c:v>
                </c:pt>
                <c:pt idx="1080">
                  <c:v>0.40860317934337126</c:v>
                </c:pt>
                <c:pt idx="1081">
                  <c:v>0.15962918582122781</c:v>
                </c:pt>
                <c:pt idx="1082">
                  <c:v>8.3383587710082821E-2</c:v>
                </c:pt>
                <c:pt idx="1083">
                  <c:v>-0.21809478858388701</c:v>
                </c:pt>
                <c:pt idx="1084">
                  <c:v>0.2409859040247386</c:v>
                </c:pt>
                <c:pt idx="1085">
                  <c:v>3.9559557255705827E-2</c:v>
                </c:pt>
                <c:pt idx="1086">
                  <c:v>-0.26153478266022367</c:v>
                </c:pt>
                <c:pt idx="1087">
                  <c:v>-0.28401879681160275</c:v>
                </c:pt>
                <c:pt idx="1088">
                  <c:v>1.3355058669067579E-2</c:v>
                </c:pt>
                <c:pt idx="1089">
                  <c:v>1.6353683577834812E-2</c:v>
                </c:pt>
                <c:pt idx="1090">
                  <c:v>-0.24622433566798174</c:v>
                </c:pt>
                <c:pt idx="1091">
                  <c:v>-0.36419918324104023</c:v>
                </c:pt>
                <c:pt idx="1092">
                  <c:v>-6.9754681685335454E-2</c:v>
                </c:pt>
                <c:pt idx="1093">
                  <c:v>0.2810750492774744</c:v>
                </c:pt>
                <c:pt idx="1094">
                  <c:v>0.32262042236168464</c:v>
                </c:pt>
                <c:pt idx="1095">
                  <c:v>-1.9316585992890892E-2</c:v>
                </c:pt>
                <c:pt idx="1096">
                  <c:v>-0.15136203809529375</c:v>
                </c:pt>
                <c:pt idx="1097">
                  <c:v>0.43509515162009738</c:v>
                </c:pt>
                <c:pt idx="1098">
                  <c:v>4.2364175248007729E-2</c:v>
                </c:pt>
                <c:pt idx="1099">
                  <c:v>0.2215677885384093</c:v>
                </c:pt>
                <c:pt idx="1100">
                  <c:v>0.19861987321921495</c:v>
                </c:pt>
                <c:pt idx="1101">
                  <c:v>0.57424686046882689</c:v>
                </c:pt>
                <c:pt idx="1102">
                  <c:v>4.5303167956572146E-2</c:v>
                </c:pt>
                <c:pt idx="1103">
                  <c:v>0.41175162896452183</c:v>
                </c:pt>
                <c:pt idx="1104">
                  <c:v>6.5985829498585336E-2</c:v>
                </c:pt>
                <c:pt idx="1105">
                  <c:v>0.32204350587425556</c:v>
                </c:pt>
                <c:pt idx="1106">
                  <c:v>-4.8859853233794395E-2</c:v>
                </c:pt>
                <c:pt idx="1107">
                  <c:v>9.4371210592517171E-2</c:v>
                </c:pt>
                <c:pt idx="1108">
                  <c:v>-0.27316878296750702</c:v>
                </c:pt>
                <c:pt idx="1109">
                  <c:v>0.13684760419288092</c:v>
                </c:pt>
                <c:pt idx="1110">
                  <c:v>-0.17739220593975111</c:v>
                </c:pt>
                <c:pt idx="1111">
                  <c:v>0.86076420262882791</c:v>
                </c:pt>
                <c:pt idx="1112">
                  <c:v>-0.84502801168361608</c:v>
                </c:pt>
                <c:pt idx="1113">
                  <c:v>-0.30275995181708248</c:v>
                </c:pt>
                <c:pt idx="1114">
                  <c:v>0.29889288105416106</c:v>
                </c:pt>
                <c:pt idx="1115">
                  <c:v>1.7494379459272503E-2</c:v>
                </c:pt>
                <c:pt idx="1116">
                  <c:v>-0.31616882559867737</c:v>
                </c:pt>
                <c:pt idx="1117">
                  <c:v>2.4319679195412894E-2</c:v>
                </c:pt>
                <c:pt idx="1118">
                  <c:v>-0.64227910438518976</c:v>
                </c:pt>
                <c:pt idx="1119">
                  <c:v>0.18383583144967966</c:v>
                </c:pt>
                <c:pt idx="1120">
                  <c:v>-0.60559561459937494</c:v>
                </c:pt>
                <c:pt idx="1121">
                  <c:v>0.31961793420016132</c:v>
                </c:pt>
                <c:pt idx="1122">
                  <c:v>-4.1565604913584353E-2</c:v>
                </c:pt>
                <c:pt idx="1123">
                  <c:v>-0.26015189730067256</c:v>
                </c:pt>
                <c:pt idx="1124">
                  <c:v>0.11915694187363209</c:v>
                </c:pt>
                <c:pt idx="1125">
                  <c:v>-0.1195103733121806</c:v>
                </c:pt>
                <c:pt idx="1126">
                  <c:v>-0.41119543298444972</c:v>
                </c:pt>
                <c:pt idx="1127">
                  <c:v>-0.21424022557298891</c:v>
                </c:pt>
                <c:pt idx="1128">
                  <c:v>0.2542312073752227</c:v>
                </c:pt>
                <c:pt idx="1129">
                  <c:v>-3.3126603240018884E-2</c:v>
                </c:pt>
                <c:pt idx="1130">
                  <c:v>-9.6653165017793016E-2</c:v>
                </c:pt>
                <c:pt idx="1131">
                  <c:v>-6.8392577690317161E-2</c:v>
                </c:pt>
                <c:pt idx="1132">
                  <c:v>0.53266605677423307</c:v>
                </c:pt>
                <c:pt idx="1133">
                  <c:v>0.11316705673273479</c:v>
                </c:pt>
                <c:pt idx="1134">
                  <c:v>0.34164424053016035</c:v>
                </c:pt>
                <c:pt idx="1135">
                  <c:v>0.46498186227495181</c:v>
                </c:pt>
                <c:pt idx="1136">
                  <c:v>0.15911246123085834</c:v>
                </c:pt>
                <c:pt idx="1137">
                  <c:v>-0.31293931166010763</c:v>
                </c:pt>
                <c:pt idx="1138">
                  <c:v>-0.29176861178449726</c:v>
                </c:pt>
                <c:pt idx="1139">
                  <c:v>-5.5441366130549251E-2</c:v>
                </c:pt>
                <c:pt idx="1140">
                  <c:v>-0.19462498910523182</c:v>
                </c:pt>
                <c:pt idx="1141">
                  <c:v>-0.13162930326076783</c:v>
                </c:pt>
                <c:pt idx="1142">
                  <c:v>0.58217059059184273</c:v>
                </c:pt>
                <c:pt idx="1143">
                  <c:v>-0.1679606673480262</c:v>
                </c:pt>
                <c:pt idx="1144">
                  <c:v>0.45943161863729726</c:v>
                </c:pt>
                <c:pt idx="1145">
                  <c:v>-0.20856097412755825</c:v>
                </c:pt>
                <c:pt idx="1146">
                  <c:v>2.019992294349774E-2</c:v>
                </c:pt>
                <c:pt idx="1147">
                  <c:v>-4.915836245085127E-2</c:v>
                </c:pt>
                <c:pt idx="1148">
                  <c:v>-0.54645608245731359</c:v>
                </c:pt>
                <c:pt idx="1149">
                  <c:v>0.15406467367471652</c:v>
                </c:pt>
                <c:pt idx="1150">
                  <c:v>0.51601514700366469</c:v>
                </c:pt>
                <c:pt idx="1151">
                  <c:v>0.23829772751228739</c:v>
                </c:pt>
                <c:pt idx="1152">
                  <c:v>2.7295624050907501E-2</c:v>
                </c:pt>
                <c:pt idx="1153">
                  <c:v>0.13514081639481501</c:v>
                </c:pt>
                <c:pt idx="1154">
                  <c:v>-0.6829275224630289</c:v>
                </c:pt>
                <c:pt idx="1155">
                  <c:v>3.6327491817765054E-2</c:v>
                </c:pt>
                <c:pt idx="1156">
                  <c:v>-0.23090534396884144</c:v>
                </c:pt>
                <c:pt idx="1157">
                  <c:v>-0.30525349942209329</c:v>
                </c:pt>
                <c:pt idx="1158">
                  <c:v>-0.20141026076689628</c:v>
                </c:pt>
                <c:pt idx="1159">
                  <c:v>-6.6427361738976065E-2</c:v>
                </c:pt>
                <c:pt idx="1160">
                  <c:v>-0.38477205642117435</c:v>
                </c:pt>
                <c:pt idx="1161">
                  <c:v>2.1906076733622219E-2</c:v>
                </c:pt>
                <c:pt idx="1162">
                  <c:v>0.279768421593595</c:v>
                </c:pt>
                <c:pt idx="1163">
                  <c:v>0.1443074672630423</c:v>
                </c:pt>
                <c:pt idx="1164">
                  <c:v>0.39176771995599674</c:v>
                </c:pt>
                <c:pt idx="1165">
                  <c:v>-0.1512018187558111</c:v>
                </c:pt>
                <c:pt idx="1166">
                  <c:v>0.22206262477748781</c:v>
                </c:pt>
                <c:pt idx="1167">
                  <c:v>-8.3919916068414136E-3</c:v>
                </c:pt>
                <c:pt idx="1168">
                  <c:v>3.0547964162966627E-2</c:v>
                </c:pt>
                <c:pt idx="1169">
                  <c:v>-0.93787828809220253</c:v>
                </c:pt>
                <c:pt idx="1170">
                  <c:v>-6.5672221684630466E-2</c:v>
                </c:pt>
                <c:pt idx="1171">
                  <c:v>0.21350281998391649</c:v>
                </c:pt>
                <c:pt idx="1172">
                  <c:v>0.57995246883129503</c:v>
                </c:pt>
                <c:pt idx="1173">
                  <c:v>-3.5490466611088241E-2</c:v>
                </c:pt>
                <c:pt idx="1174">
                  <c:v>0.19105723992631402</c:v>
                </c:pt>
                <c:pt idx="1175">
                  <c:v>8.6303051434400563E-3</c:v>
                </c:pt>
                <c:pt idx="1176">
                  <c:v>-7.8868388814834711E-2</c:v>
                </c:pt>
                <c:pt idx="1177">
                  <c:v>0.2938412992667393</c:v>
                </c:pt>
                <c:pt idx="1178">
                  <c:v>-0.13194544110379658</c:v>
                </c:pt>
                <c:pt idx="1179">
                  <c:v>0.33742566428268811</c:v>
                </c:pt>
                <c:pt idx="1180">
                  <c:v>-0.49228146000831885</c:v>
                </c:pt>
                <c:pt idx="1181">
                  <c:v>0.33147592612318899</c:v>
                </c:pt>
                <c:pt idx="1182">
                  <c:v>-2.8116217061027168E-2</c:v>
                </c:pt>
                <c:pt idx="1183">
                  <c:v>2.4603367140657029E-2</c:v>
                </c:pt>
                <c:pt idx="1184">
                  <c:v>-0.11747432721280061</c:v>
                </c:pt>
                <c:pt idx="1185">
                  <c:v>-0.19710370520817377</c:v>
                </c:pt>
                <c:pt idx="1186">
                  <c:v>-0.26986004764348781</c:v>
                </c:pt>
                <c:pt idx="1187">
                  <c:v>0.26795521229127123</c:v>
                </c:pt>
                <c:pt idx="1188">
                  <c:v>0.17593970540604287</c:v>
                </c:pt>
                <c:pt idx="1189">
                  <c:v>-0.13431868566083344</c:v>
                </c:pt>
                <c:pt idx="1190">
                  <c:v>-4.7687664343613618E-3</c:v>
                </c:pt>
                <c:pt idx="1191">
                  <c:v>3.1959741397544997E-2</c:v>
                </c:pt>
                <c:pt idx="1192">
                  <c:v>4.1242982231881345E-2</c:v>
                </c:pt>
                <c:pt idx="1193">
                  <c:v>-0.23548398620204741</c:v>
                </c:pt>
                <c:pt idx="1194">
                  <c:v>-0.31473259348315835</c:v>
                </c:pt>
                <c:pt idx="1195">
                  <c:v>5.8108649401173953E-2</c:v>
                </c:pt>
                <c:pt idx="1196">
                  <c:v>-0.27456420809468807</c:v>
                </c:pt>
                <c:pt idx="1197">
                  <c:v>0.11769504266975458</c:v>
                </c:pt>
                <c:pt idx="1198">
                  <c:v>0.10822334117387104</c:v>
                </c:pt>
                <c:pt idx="1199">
                  <c:v>2.2190239634065988E-2</c:v>
                </c:pt>
                <c:pt idx="1200">
                  <c:v>0.28782686728508117</c:v>
                </c:pt>
                <c:pt idx="1201">
                  <c:v>0.31417445108964359</c:v>
                </c:pt>
                <c:pt idx="1202">
                  <c:v>-0.27073003201580148</c:v>
                </c:pt>
                <c:pt idx="1203">
                  <c:v>-7.3848726800103348E-2</c:v>
                </c:pt>
                <c:pt idx="1204">
                  <c:v>8.5560624872625515E-2</c:v>
                </c:pt>
                <c:pt idx="1205">
                  <c:v>-0.18229488977282882</c:v>
                </c:pt>
                <c:pt idx="1206">
                  <c:v>0.24792751344358552</c:v>
                </c:pt>
                <c:pt idx="1207">
                  <c:v>0.28012489197572954</c:v>
                </c:pt>
                <c:pt idx="1208">
                  <c:v>0.52546756346514134</c:v>
                </c:pt>
                <c:pt idx="1209">
                  <c:v>0.36098224136862644</c:v>
                </c:pt>
                <c:pt idx="1210">
                  <c:v>0.26747587179649235</c:v>
                </c:pt>
                <c:pt idx="1211">
                  <c:v>-0.63935479753978386</c:v>
                </c:pt>
                <c:pt idx="1212">
                  <c:v>0.19244669373504691</c:v>
                </c:pt>
                <c:pt idx="1213">
                  <c:v>3.1677496450760248E-2</c:v>
                </c:pt>
                <c:pt idx="1214">
                  <c:v>0.27441076931783798</c:v>
                </c:pt>
                <c:pt idx="1215">
                  <c:v>0.19522159325284455</c:v>
                </c:pt>
                <c:pt idx="1216">
                  <c:v>0.54240664589506549</c:v>
                </c:pt>
                <c:pt idx="1217">
                  <c:v>-0.29388944280353324</c:v>
                </c:pt>
                <c:pt idx="1218">
                  <c:v>0.21747890047053098</c:v>
                </c:pt>
                <c:pt idx="1219">
                  <c:v>-8.4823322029542222E-2</c:v>
                </c:pt>
                <c:pt idx="1220">
                  <c:v>-7.9478021209660937E-2</c:v>
                </c:pt>
                <c:pt idx="1221">
                  <c:v>-0.46394709975979032</c:v>
                </c:pt>
                <c:pt idx="1222">
                  <c:v>1.5354834293464041E-2</c:v>
                </c:pt>
                <c:pt idx="1223">
                  <c:v>8.5152680563138308E-2</c:v>
                </c:pt>
                <c:pt idx="1224">
                  <c:v>-0.93926084214232153</c:v>
                </c:pt>
                <c:pt idx="1225">
                  <c:v>0.41207693883268709</c:v>
                </c:pt>
                <c:pt idx="1226">
                  <c:v>-0.69385444069122615</c:v>
                </c:pt>
                <c:pt idx="1227">
                  <c:v>8.787013294105718E-2</c:v>
                </c:pt>
                <c:pt idx="1228">
                  <c:v>0.71387174253589936</c:v>
                </c:pt>
                <c:pt idx="1229">
                  <c:v>0.36692364897851804</c:v>
                </c:pt>
                <c:pt idx="1230">
                  <c:v>1.0923027184791876E-2</c:v>
                </c:pt>
                <c:pt idx="1231">
                  <c:v>0.1694119519913547</c:v>
                </c:pt>
                <c:pt idx="1232">
                  <c:v>-0.4819685073978307</c:v>
                </c:pt>
                <c:pt idx="1233">
                  <c:v>0.10393399105623309</c:v>
                </c:pt>
                <c:pt idx="1234">
                  <c:v>0.28344770837797978</c:v>
                </c:pt>
                <c:pt idx="1235">
                  <c:v>0.49855724809901664</c:v>
                </c:pt>
                <c:pt idx="1236">
                  <c:v>9.6531742693628672E-2</c:v>
                </c:pt>
                <c:pt idx="1237">
                  <c:v>-0.19479010441767403</c:v>
                </c:pt>
                <c:pt idx="1238">
                  <c:v>3.3370138460592183E-2</c:v>
                </c:pt>
                <c:pt idx="1239">
                  <c:v>0.16414264884830632</c:v>
                </c:pt>
                <c:pt idx="1240">
                  <c:v>0.56900492681818005</c:v>
                </c:pt>
                <c:pt idx="1241">
                  <c:v>-0.4467378097275671</c:v>
                </c:pt>
                <c:pt idx="1242">
                  <c:v>-0.3621579396758951</c:v>
                </c:pt>
                <c:pt idx="1243">
                  <c:v>-0.56639953737413751</c:v>
                </c:pt>
                <c:pt idx="1244">
                  <c:v>-0.33879767023729013</c:v>
                </c:pt>
                <c:pt idx="1245">
                  <c:v>0.46131900249075414</c:v>
                </c:pt>
                <c:pt idx="1246">
                  <c:v>-6.3107698010950411E-2</c:v>
                </c:pt>
                <c:pt idx="1247">
                  <c:v>-0.11060433784575602</c:v>
                </c:pt>
                <c:pt idx="1248">
                  <c:v>1.8113477179915423</c:v>
                </c:pt>
                <c:pt idx="1249">
                  <c:v>-5.8743416146720677E-2</c:v>
                </c:pt>
                <c:pt idx="1250">
                  <c:v>-9.3725085630267088E-2</c:v>
                </c:pt>
                <c:pt idx="1251">
                  <c:v>0.16362753858990578</c:v>
                </c:pt>
                <c:pt idx="1252">
                  <c:v>-0.23310806158877709</c:v>
                </c:pt>
                <c:pt idx="1253">
                  <c:v>7.769594145917668E-3</c:v>
                </c:pt>
                <c:pt idx="1254">
                  <c:v>0.39088775955000937</c:v>
                </c:pt>
                <c:pt idx="1255">
                  <c:v>-1.9316585992890892E-2</c:v>
                </c:pt>
                <c:pt idx="1256">
                  <c:v>0.52837127796071892</c:v>
                </c:pt>
                <c:pt idx="1257">
                  <c:v>-0.35070645303286002</c:v>
                </c:pt>
                <c:pt idx="1258">
                  <c:v>1.5185854939512395</c:v>
                </c:pt>
                <c:pt idx="1259">
                  <c:v>0.63542937107181785</c:v>
                </c:pt>
                <c:pt idx="1260">
                  <c:v>0.12207630369573588</c:v>
                </c:pt>
                <c:pt idx="1261">
                  <c:v>-1.7764538840471817</c:v>
                </c:pt>
                <c:pt idx="1262">
                  <c:v>0.39385547733902904</c:v>
                </c:pt>
                <c:pt idx="1263">
                  <c:v>-4.1268662432163747E-2</c:v>
                </c:pt>
                <c:pt idx="1264">
                  <c:v>9.1801369217674345E-2</c:v>
                </c:pt>
                <c:pt idx="1265">
                  <c:v>0.17082239919517525</c:v>
                </c:pt>
                <c:pt idx="1266">
                  <c:v>0.44190836400358918</c:v>
                </c:pt>
                <c:pt idx="1267">
                  <c:v>-0.57089291821950039</c:v>
                </c:pt>
                <c:pt idx="1268">
                  <c:v>-1.0664273617389761</c:v>
                </c:pt>
                <c:pt idx="1269">
                  <c:v>0.70274618552426105</c:v>
                </c:pt>
                <c:pt idx="1270">
                  <c:v>0.10111215847415045</c:v>
                </c:pt>
                <c:pt idx="1271">
                  <c:v>0.43722773891290978</c:v>
                </c:pt>
                <c:pt idx="1272">
                  <c:v>7.3408955185340033E-2</c:v>
                </c:pt>
                <c:pt idx="1273">
                  <c:v>0.44562077471519318</c:v>
                </c:pt>
                <c:pt idx="1274">
                  <c:v>-4.8263020030168663E-2</c:v>
                </c:pt>
                <c:pt idx="1275">
                  <c:v>0.1300083041086062</c:v>
                </c:pt>
                <c:pt idx="1276">
                  <c:v>-0.36940814584951631</c:v>
                </c:pt>
                <c:pt idx="1277">
                  <c:v>5.7696263152051458E-4</c:v>
                </c:pt>
                <c:pt idx="1278">
                  <c:v>0.24889910707632634</c:v>
                </c:pt>
                <c:pt idx="1279">
                  <c:v>0.34266851820249955</c:v>
                </c:pt>
                <c:pt idx="1280">
                  <c:v>0.13435238662336282</c:v>
                </c:pt>
                <c:pt idx="1281">
                  <c:v>0.16710096896307505</c:v>
                </c:pt>
                <c:pt idx="1282">
                  <c:v>-0.87197061125935893</c:v>
                </c:pt>
                <c:pt idx="1283">
                  <c:v>0.21896711004895661</c:v>
                </c:pt>
                <c:pt idx="1284">
                  <c:v>0.18726100484169694</c:v>
                </c:pt>
                <c:pt idx="1285">
                  <c:v>0.18281940161220564</c:v>
                </c:pt>
                <c:pt idx="1286">
                  <c:v>0.57366536306438498</c:v>
                </c:pt>
                <c:pt idx="1287">
                  <c:v>-0.45403163089470749</c:v>
                </c:pt>
                <c:pt idx="1288">
                  <c:v>-0.4206267329326126</c:v>
                </c:pt>
                <c:pt idx="1289">
                  <c:v>7.8336571121179033E-2</c:v>
                </c:pt>
                <c:pt idx="1290">
                  <c:v>-0.36104575020216612</c:v>
                </c:pt>
                <c:pt idx="1291">
                  <c:v>0.40326772233930108</c:v>
                </c:pt>
                <c:pt idx="1292">
                  <c:v>-0.84528718621784205</c:v>
                </c:pt>
                <c:pt idx="1293">
                  <c:v>-0.20406685268503655</c:v>
                </c:pt>
                <c:pt idx="1294">
                  <c:v>0.41164317603901396</c:v>
                </c:pt>
                <c:pt idx="1295">
                  <c:v>0.19773960600635557</c:v>
                </c:pt>
                <c:pt idx="1296">
                  <c:v>0.14626419486652553</c:v>
                </c:pt>
                <c:pt idx="1297">
                  <c:v>0.2077679375721706</c:v>
                </c:pt>
                <c:pt idx="1298">
                  <c:v>1.0481664211497808</c:v>
                </c:pt>
                <c:pt idx="1299">
                  <c:v>7.8609834696366468E-2</c:v>
                </c:pt>
                <c:pt idx="1300">
                  <c:v>-0.37482304331948774</c:v>
                </c:pt>
                <c:pt idx="1301">
                  <c:v>5.85243118408003E-2</c:v>
                </c:pt>
                <c:pt idx="1302">
                  <c:v>0.67716993881824494</c:v>
                </c:pt>
                <c:pt idx="1303">
                  <c:v>2.7012465062581668E-2</c:v>
                </c:pt>
                <c:pt idx="1304">
                  <c:v>0.20238637533478931</c:v>
                </c:pt>
                <c:pt idx="1305">
                  <c:v>-0.5769059458500978</c:v>
                </c:pt>
                <c:pt idx="1306">
                  <c:v>0.10487337672601831</c:v>
                </c:pt>
                <c:pt idx="1307">
                  <c:v>0.55030967875509607</c:v>
                </c:pt>
                <c:pt idx="1308">
                  <c:v>-0.33042892396103429</c:v>
                </c:pt>
                <c:pt idx="1309">
                  <c:v>0.27548389266728768</c:v>
                </c:pt>
                <c:pt idx="1310">
                  <c:v>1.5925689990254212E-2</c:v>
                </c:pt>
                <c:pt idx="1311">
                  <c:v>-2.7233834745514982E-2</c:v>
                </c:pt>
                <c:pt idx="1312">
                  <c:v>-0.27508784068438985</c:v>
                </c:pt>
                <c:pt idx="1313">
                  <c:v>-3.7413961643116916E-2</c:v>
                </c:pt>
                <c:pt idx="1314">
                  <c:v>-3.2831392467372364E-2</c:v>
                </c:pt>
                <c:pt idx="1315">
                  <c:v>-0.19182091622852934</c:v>
                </c:pt>
                <c:pt idx="1316">
                  <c:v>0.11249997620071796</c:v>
                </c:pt>
                <c:pt idx="1317">
                  <c:v>0.17171923908784797</c:v>
                </c:pt>
                <c:pt idx="1318">
                  <c:v>-8.7733371933550366E-2</c:v>
                </c:pt>
                <c:pt idx="1319">
                  <c:v>0.19597745864258795</c:v>
                </c:pt>
                <c:pt idx="1320">
                  <c:v>0.49671798793517713</c:v>
                </c:pt>
                <c:pt idx="1321">
                  <c:v>6.9702166630067411E-2</c:v>
                </c:pt>
                <c:pt idx="1322">
                  <c:v>6.3226801996981316E-2</c:v>
                </c:pt>
                <c:pt idx="1323">
                  <c:v>-0.17510997602060169</c:v>
                </c:pt>
                <c:pt idx="1324">
                  <c:v>8.9091318564689173E-2</c:v>
                </c:pt>
                <c:pt idx="1325">
                  <c:v>0.21375164631100604</c:v>
                </c:pt>
                <c:pt idx="1326">
                  <c:v>7.8883046521989117E-2</c:v>
                </c:pt>
                <c:pt idx="1327">
                  <c:v>0.20701822594562194</c:v>
                </c:pt>
                <c:pt idx="1328">
                  <c:v>6.2812492405021181E-2</c:v>
                </c:pt>
                <c:pt idx="1329">
                  <c:v>0.40762467556660881</c:v>
                </c:pt>
                <c:pt idx="1330">
                  <c:v>0.13435238662336282</c:v>
                </c:pt>
                <c:pt idx="1331">
                  <c:v>0.59855577332351084</c:v>
                </c:pt>
                <c:pt idx="1332">
                  <c:v>0.36938272533894062</c:v>
                </c:pt>
                <c:pt idx="1333">
                  <c:v>0.41932314528325104</c:v>
                </c:pt>
                <c:pt idx="1334">
                  <c:v>0.17568427073099724</c:v>
                </c:pt>
                <c:pt idx="1335">
                  <c:v>0.25302109571151316</c:v>
                </c:pt>
                <c:pt idx="1336">
                  <c:v>-7.9478021209660937E-2</c:v>
                </c:pt>
                <c:pt idx="1337">
                  <c:v>1.0234682805039055</c:v>
                </c:pt>
                <c:pt idx="1338">
                  <c:v>-0.15633768370894113</c:v>
                </c:pt>
                <c:pt idx="1339">
                  <c:v>0.14352403252161328</c:v>
                </c:pt>
                <c:pt idx="1340">
                  <c:v>-0.79110822497384681</c:v>
                </c:pt>
                <c:pt idx="1341">
                  <c:v>0.63450033823599872</c:v>
                </c:pt>
                <c:pt idx="1342">
                  <c:v>-0.60691334497646887</c:v>
                </c:pt>
                <c:pt idx="1343">
                  <c:v>0.45206823022381099</c:v>
                </c:pt>
                <c:pt idx="1344">
                  <c:v>0.20689323612177143</c:v>
                </c:pt>
                <c:pt idx="1345">
                  <c:v>5.3111336459562536E-2</c:v>
                </c:pt>
                <c:pt idx="1346">
                  <c:v>0.5650121808982248</c:v>
                </c:pt>
                <c:pt idx="1347">
                  <c:v>0.55493260188047289</c:v>
                </c:pt>
                <c:pt idx="1348">
                  <c:v>-7.1572823124314774E-2</c:v>
                </c:pt>
                <c:pt idx="1349">
                  <c:v>-0.36086046861957166</c:v>
                </c:pt>
                <c:pt idx="1350">
                  <c:v>0.47539622238261831</c:v>
                </c:pt>
                <c:pt idx="1351">
                  <c:v>0.19899696624010865</c:v>
                </c:pt>
                <c:pt idx="1352">
                  <c:v>0.13527217947625234</c:v>
                </c:pt>
                <c:pt idx="1353">
                  <c:v>-0.34135434566240397</c:v>
                </c:pt>
                <c:pt idx="1354">
                  <c:v>-2.0047842048330423E-2</c:v>
                </c:pt>
                <c:pt idx="1355">
                  <c:v>1.2354130407874092E-2</c:v>
                </c:pt>
                <c:pt idx="1356">
                  <c:v>-0.3982084161379737</c:v>
                </c:pt>
                <c:pt idx="1357">
                  <c:v>1.6781550233402012E-2</c:v>
                </c:pt>
                <c:pt idx="1358">
                  <c:v>0.44339447483858407</c:v>
                </c:pt>
                <c:pt idx="1359">
                  <c:v>0.45364926604329114</c:v>
                </c:pt>
                <c:pt idx="1360">
                  <c:v>-0.3802583412308248</c:v>
                </c:pt>
                <c:pt idx="1361">
                  <c:v>-0.19248020793011561</c:v>
                </c:pt>
                <c:pt idx="1362">
                  <c:v>9.1395186011700019E-2</c:v>
                </c:pt>
                <c:pt idx="1363">
                  <c:v>0.40968962795325908</c:v>
                </c:pt>
                <c:pt idx="1364">
                  <c:v>0.31150311546826975</c:v>
                </c:pt>
                <c:pt idx="1365">
                  <c:v>-0.24708017898719503</c:v>
                </c:pt>
                <c:pt idx="1366">
                  <c:v>8.4064264788474549E-2</c:v>
                </c:pt>
                <c:pt idx="1367">
                  <c:v>5.3111336459562536E-2</c:v>
                </c:pt>
                <c:pt idx="1368">
                  <c:v>-0.24656661207311956</c:v>
                </c:pt>
                <c:pt idx="1369">
                  <c:v>-0.29707654654642718</c:v>
                </c:pt>
                <c:pt idx="1370">
                  <c:v>-4.5580321867076112E-2</c:v>
                </c:pt>
                <c:pt idx="1371">
                  <c:v>0.14156358237500305</c:v>
                </c:pt>
                <c:pt idx="1372">
                  <c:v>1.3530409357376116</c:v>
                </c:pt>
                <c:pt idx="1373">
                  <c:v>0.18383583144967966</c:v>
                </c:pt>
                <c:pt idx="1374">
                  <c:v>0.54002726925750733</c:v>
                </c:pt>
                <c:pt idx="1375">
                  <c:v>2.2616379067348556E-2</c:v>
                </c:pt>
                <c:pt idx="1376">
                  <c:v>0.33445386232368096</c:v>
                </c:pt>
                <c:pt idx="1377">
                  <c:v>0.21871918170311724</c:v>
                </c:pt>
                <c:pt idx="1378">
                  <c:v>-0.51107373247586563</c:v>
                </c:pt>
                <c:pt idx="1379">
                  <c:v>0.11503324294624007</c:v>
                </c:pt>
                <c:pt idx="1380">
                  <c:v>0.42899992576300405</c:v>
                </c:pt>
                <c:pt idx="1381">
                  <c:v>0.40577457794987587</c:v>
                </c:pt>
                <c:pt idx="1382">
                  <c:v>0.21412480535284734</c:v>
                </c:pt>
                <c:pt idx="1383">
                  <c:v>0.21524370371286569</c:v>
                </c:pt>
                <c:pt idx="1384">
                  <c:v>-7.3241468013534983E-2</c:v>
                </c:pt>
                <c:pt idx="1385">
                  <c:v>4.3064478664937421E-2</c:v>
                </c:pt>
                <c:pt idx="1386">
                  <c:v>-0.74831120052133693</c:v>
                </c:pt>
                <c:pt idx="1387">
                  <c:v>0.24049751707326048</c:v>
                </c:pt>
                <c:pt idx="1388">
                  <c:v>-2.1218623237265453E-2</c:v>
                </c:pt>
                <c:pt idx="1389">
                  <c:v>0.71413559385633285</c:v>
                </c:pt>
                <c:pt idx="1390">
                  <c:v>0.14847861593196762</c:v>
                </c:pt>
                <c:pt idx="1391">
                  <c:v>-1.173341457382676E-2</c:v>
                </c:pt>
                <c:pt idx="1392">
                  <c:v>1.1781859459914711E-2</c:v>
                </c:pt>
                <c:pt idx="1393">
                  <c:v>0.22663183180789062</c:v>
                </c:pt>
                <c:pt idx="1394">
                  <c:v>0.9268344213655566</c:v>
                </c:pt>
                <c:pt idx="1395">
                  <c:v>0.1373723636933977</c:v>
                </c:pt>
                <c:pt idx="1396">
                  <c:v>0.10487337672601831</c:v>
                </c:pt>
                <c:pt idx="1397">
                  <c:v>-0.41100359799435399</c:v>
                </c:pt>
                <c:pt idx="1398">
                  <c:v>-0.17185589763437173</c:v>
                </c:pt>
                <c:pt idx="1399">
                  <c:v>0.52496633181611219</c:v>
                </c:pt>
                <c:pt idx="1400">
                  <c:v>-5.7842107262206295E-2</c:v>
                </c:pt>
                <c:pt idx="1401">
                  <c:v>4.4184257544003833E-2</c:v>
                </c:pt>
                <c:pt idx="1402">
                  <c:v>9.1530593120616247E-2</c:v>
                </c:pt>
                <c:pt idx="1403">
                  <c:v>-0.14066649060373157</c:v>
                </c:pt>
                <c:pt idx="1404">
                  <c:v>0.11223305759849703</c:v>
                </c:pt>
                <c:pt idx="1405">
                  <c:v>-0.11419138752248348</c:v>
                </c:pt>
                <c:pt idx="1406">
                  <c:v>0.1790013990992444</c:v>
                </c:pt>
                <c:pt idx="1407">
                  <c:v>6.6674762724460157E-2</c:v>
                </c:pt>
                <c:pt idx="1408">
                  <c:v>3.3933911441931759E-2</c:v>
                </c:pt>
                <c:pt idx="1409">
                  <c:v>-3.7858209542205166E-2</c:v>
                </c:pt>
                <c:pt idx="1410">
                  <c:v>9.9204095930638808E-3</c:v>
                </c:pt>
                <c:pt idx="1411">
                  <c:v>5.6444801019668117E-2</c:v>
                </c:pt>
                <c:pt idx="1412">
                  <c:v>7.0664100778789651E-2</c:v>
                </c:pt>
                <c:pt idx="1413">
                  <c:v>0.24000896473507025</c:v>
                </c:pt>
                <c:pt idx="1414">
                  <c:v>0.38780366453332893</c:v>
                </c:pt>
                <c:pt idx="1415">
                  <c:v>0.1920678844796504</c:v>
                </c:pt>
                <c:pt idx="1416">
                  <c:v>-0.62682510924688362</c:v>
                </c:pt>
                <c:pt idx="1417">
                  <c:v>0.14795788138710142</c:v>
                </c:pt>
                <c:pt idx="1418">
                  <c:v>0.17338332121472341</c:v>
                </c:pt>
                <c:pt idx="1419">
                  <c:v>0.13461524442510855</c:v>
                </c:pt>
                <c:pt idx="1420">
                  <c:v>-5.6375109653629104E-3</c:v>
                </c:pt>
                <c:pt idx="1421">
                  <c:v>-4.4793011362616996E-3</c:v>
                </c:pt>
                <c:pt idx="1422">
                  <c:v>1.5860923540263689E-3</c:v>
                </c:pt>
                <c:pt idx="1423">
                  <c:v>-3.7858209542205166E-2</c:v>
                </c:pt>
                <c:pt idx="1424">
                  <c:v>-0.16165326347876927</c:v>
                </c:pt>
                <c:pt idx="1425">
                  <c:v>0.22144405295439859</c:v>
                </c:pt>
                <c:pt idx="1426">
                  <c:v>0.26819482282842538</c:v>
                </c:pt>
                <c:pt idx="1427">
                  <c:v>0.2237932162430325</c:v>
                </c:pt>
                <c:pt idx="1428">
                  <c:v>0.28214322878149845</c:v>
                </c:pt>
                <c:pt idx="1429">
                  <c:v>0.13395801010054917</c:v>
                </c:pt>
                <c:pt idx="1430">
                  <c:v>-0.13844158042797131</c:v>
                </c:pt>
                <c:pt idx="1431">
                  <c:v>-0.31634845518751536</c:v>
                </c:pt>
                <c:pt idx="1432">
                  <c:v>-0.25894295902603642</c:v>
                </c:pt>
                <c:pt idx="1433">
                  <c:v>-0.17788172527065546</c:v>
                </c:pt>
                <c:pt idx="1434">
                  <c:v>0.36457243229585612</c:v>
                </c:pt>
                <c:pt idx="1435">
                  <c:v>-7.0360474279115293E-2</c:v>
                </c:pt>
                <c:pt idx="1436">
                  <c:v>-0.28718414556262822</c:v>
                </c:pt>
                <c:pt idx="1437">
                  <c:v>0.24281588402684193</c:v>
                </c:pt>
                <c:pt idx="1438">
                  <c:v>-0.30098148137380276</c:v>
                </c:pt>
                <c:pt idx="1439">
                  <c:v>7.6559095131604402E-2</c:v>
                </c:pt>
                <c:pt idx="1440">
                  <c:v>0.44063333516152725</c:v>
                </c:pt>
                <c:pt idx="1441">
                  <c:v>0.73439530876016679</c:v>
                </c:pt>
                <c:pt idx="1442">
                  <c:v>-0.16165326347876927</c:v>
                </c:pt>
                <c:pt idx="1443">
                  <c:v>-6.8846469479774089E-2</c:v>
                </c:pt>
                <c:pt idx="1444">
                  <c:v>-0.48944310459975832</c:v>
                </c:pt>
                <c:pt idx="1445">
                  <c:v>0.25241565903265056</c:v>
                </c:pt>
                <c:pt idx="1446">
                  <c:v>0.32296646154964515</c:v>
                </c:pt>
                <c:pt idx="1447">
                  <c:v>0.60046007011648195</c:v>
                </c:pt>
                <c:pt idx="1448">
                  <c:v>0.18447073664009189</c:v>
                </c:pt>
                <c:pt idx="1449">
                  <c:v>-9.2493985787336988E-2</c:v>
                </c:pt>
                <c:pt idx="1450">
                  <c:v>7.7379740797013583E-2</c:v>
                </c:pt>
                <c:pt idx="1451">
                  <c:v>0.2623128779163344</c:v>
                </c:pt>
                <c:pt idx="1452">
                  <c:v>-0.11309873231350795</c:v>
                </c:pt>
                <c:pt idx="1453">
                  <c:v>-0.25188230671443235</c:v>
                </c:pt>
                <c:pt idx="1454">
                  <c:v>-7.4000581443776928E-2</c:v>
                </c:pt>
                <c:pt idx="1455">
                  <c:v>0.32941067121856837</c:v>
                </c:pt>
                <c:pt idx="1456">
                  <c:v>9.4371210592517171E-2</c:v>
                </c:pt>
                <c:pt idx="1457">
                  <c:v>0.27607972757473248</c:v>
                </c:pt>
                <c:pt idx="1458">
                  <c:v>-1.1878869535979393E-2</c:v>
                </c:pt>
                <c:pt idx="1459">
                  <c:v>0.13815914522947029</c:v>
                </c:pt>
                <c:pt idx="1460">
                  <c:v>0.8665519573747672</c:v>
                </c:pt>
                <c:pt idx="1461">
                  <c:v>-0.13194544110379658</c:v>
                </c:pt>
                <c:pt idx="1462">
                  <c:v>0.23756371831767567</c:v>
                </c:pt>
                <c:pt idx="1463">
                  <c:v>4.0401515284206602E-2</c:v>
                </c:pt>
                <c:pt idx="1464">
                  <c:v>0.13579751222339106</c:v>
                </c:pt>
                <c:pt idx="1465">
                  <c:v>-0.32553934843974119</c:v>
                </c:pt>
                <c:pt idx="1466">
                  <c:v>7.2586047068596546E-2</c:v>
                </c:pt>
                <c:pt idx="1467">
                  <c:v>-0.10066966520955489</c:v>
                </c:pt>
                <c:pt idx="1468">
                  <c:v>-0.11559744701631276</c:v>
                </c:pt>
                <c:pt idx="1469">
                  <c:v>-0.24588214044795012</c:v>
                </c:pt>
                <c:pt idx="1470">
                  <c:v>6.0600829554117094E-2</c:v>
                </c:pt>
                <c:pt idx="1471">
                  <c:v>-0.57561532846190344</c:v>
                </c:pt>
                <c:pt idx="1472">
                  <c:v>0.49446681428175904</c:v>
                </c:pt>
                <c:pt idx="1473">
                  <c:v>0.48346755409280667</c:v>
                </c:pt>
                <c:pt idx="1474">
                  <c:v>-1.7125039101938438E-2</c:v>
                </c:pt>
                <c:pt idx="1475">
                  <c:v>-0.11512860824030058</c:v>
                </c:pt>
                <c:pt idx="1476">
                  <c:v>-7.0814985716076778E-2</c:v>
                </c:pt>
                <c:pt idx="1477">
                  <c:v>-0.93098532208481954</c:v>
                </c:pt>
                <c:pt idx="1478">
                  <c:v>0.16259676598848671</c:v>
                </c:pt>
                <c:pt idx="1479">
                  <c:v>6.0739157857678541E-2</c:v>
                </c:pt>
                <c:pt idx="1480">
                  <c:v>0.25676914276134122</c:v>
                </c:pt>
                <c:pt idx="1481">
                  <c:v>0.31521841136578999</c:v>
                </c:pt>
                <c:pt idx="1482">
                  <c:v>2.2616379067348556E-2</c:v>
                </c:pt>
                <c:pt idx="1483">
                  <c:v>0.48346755409280667</c:v>
                </c:pt>
                <c:pt idx="1484">
                  <c:v>-0.27893363126894993</c:v>
                </c:pt>
                <c:pt idx="1485">
                  <c:v>-7.7193226812113963E-2</c:v>
                </c:pt>
                <c:pt idx="1486">
                  <c:v>-0.30454061736144167</c:v>
                </c:pt>
                <c:pt idx="1487">
                  <c:v>-6.9451880752145215E-2</c:v>
                </c:pt>
                <c:pt idx="1488">
                  <c:v>-1.0860992631766838E-2</c:v>
                </c:pt>
                <c:pt idx="1489">
                  <c:v>-0.33188087531356802</c:v>
                </c:pt>
                <c:pt idx="1490">
                  <c:v>0.15367564979723761</c:v>
                </c:pt>
                <c:pt idx="1491">
                  <c:v>0.12406339602707796</c:v>
                </c:pt>
                <c:pt idx="1492">
                  <c:v>-0.26551797778881464</c:v>
                </c:pt>
                <c:pt idx="1493">
                  <c:v>0.69126614713828471</c:v>
                </c:pt>
                <c:pt idx="1494">
                  <c:v>-0.10547322974260549</c:v>
                </c:pt>
                <c:pt idx="1495">
                  <c:v>0.55493260188047289</c:v>
                </c:pt>
                <c:pt idx="1496">
                  <c:v>0.37228351288052824</c:v>
                </c:pt>
                <c:pt idx="1497">
                  <c:v>-0.17039395353944559</c:v>
                </c:pt>
                <c:pt idx="1498">
                  <c:v>-8.0545498166160787E-2</c:v>
                </c:pt>
                <c:pt idx="1499">
                  <c:v>-5.0651835711436693E-2</c:v>
                </c:pt>
                <c:pt idx="1500">
                  <c:v>-2.7086823481222041E-2</c:v>
                </c:pt>
                <c:pt idx="1501">
                  <c:v>-0.13083926159988268</c:v>
                </c:pt>
                <c:pt idx="1502">
                  <c:v>-1.0424567992428948</c:v>
                </c:pt>
                <c:pt idx="1503">
                  <c:v>-0.49025349363434523</c:v>
                </c:pt>
                <c:pt idx="1504">
                  <c:v>-1.1199806384462045</c:v>
                </c:pt>
                <c:pt idx="1505">
                  <c:v>0.22737142258325888</c:v>
                </c:pt>
                <c:pt idx="1506">
                  <c:v>0.30917618747851466</c:v>
                </c:pt>
                <c:pt idx="1507">
                  <c:v>0.23327453899093431</c:v>
                </c:pt>
                <c:pt idx="1508">
                  <c:v>-0.2870081105382028</c:v>
                </c:pt>
                <c:pt idx="1509">
                  <c:v>9.0582476362442335E-2</c:v>
                </c:pt>
                <c:pt idx="1510">
                  <c:v>0.7662135019816555</c:v>
                </c:pt>
                <c:pt idx="1511">
                  <c:v>0.25954367314869103</c:v>
                </c:pt>
                <c:pt idx="1512">
                  <c:v>0.76000798683206994</c:v>
                </c:pt>
                <c:pt idx="1513">
                  <c:v>-0.14800116288755377</c:v>
                </c:pt>
                <c:pt idx="1514">
                  <c:v>0.25362627842137686</c:v>
                </c:pt>
                <c:pt idx="1515">
                  <c:v>0.78927018643170954</c:v>
                </c:pt>
                <c:pt idx="1516">
                  <c:v>3.7311930641966591E-2</c:v>
                </c:pt>
                <c:pt idx="1517">
                  <c:v>-0.24024760623102903</c:v>
                </c:pt>
                <c:pt idx="1518">
                  <c:v>-0.22482300430370261</c:v>
                </c:pt>
                <c:pt idx="1519">
                  <c:v>0.43274565884384791</c:v>
                </c:pt>
                <c:pt idx="1520">
                  <c:v>-0.22802993230181082</c:v>
                </c:pt>
                <c:pt idx="1521">
                  <c:v>0.10594621190532462</c:v>
                </c:pt>
                <c:pt idx="1522">
                  <c:v>-0.85178172784585493</c:v>
                </c:pt>
                <c:pt idx="1523">
                  <c:v>6.4606975297391928E-2</c:v>
                </c:pt>
                <c:pt idx="1524">
                  <c:v>0.42406212541589983</c:v>
                </c:pt>
                <c:pt idx="1525">
                  <c:v>-4.1565604913584353E-2</c:v>
                </c:pt>
                <c:pt idx="1526">
                  <c:v>-0.12831403169641201</c:v>
                </c:pt>
                <c:pt idx="1527">
                  <c:v>-1.0679388286565756</c:v>
                </c:pt>
                <c:pt idx="1528">
                  <c:v>-0.94009101098131487</c:v>
                </c:pt>
                <c:pt idx="1529">
                  <c:v>-1.4645303827355665E-2</c:v>
                </c:pt>
                <c:pt idx="1530">
                  <c:v>5.6860943046750968E-2</c:v>
                </c:pt>
                <c:pt idx="1531">
                  <c:v>-0.64611216371509261</c:v>
                </c:pt>
                <c:pt idx="1532">
                  <c:v>-4.7070093830198501E-2</c:v>
                </c:pt>
                <c:pt idx="1533">
                  <c:v>-7.9020772764370514E-2</c:v>
                </c:pt>
                <c:pt idx="1534">
                  <c:v>0.38039699198844928</c:v>
                </c:pt>
                <c:pt idx="1535">
                  <c:v>0.65076455911690234</c:v>
                </c:pt>
                <c:pt idx="1536">
                  <c:v>4.6979908144409395E-2</c:v>
                </c:pt>
                <c:pt idx="1537">
                  <c:v>0.10875861436093671</c:v>
                </c:pt>
                <c:pt idx="1538">
                  <c:v>-0.11403524324602944</c:v>
                </c:pt>
                <c:pt idx="1539">
                  <c:v>0.69305199256145344</c:v>
                </c:pt>
                <c:pt idx="1540">
                  <c:v>0.80347504291765548</c:v>
                </c:pt>
                <c:pt idx="1541">
                  <c:v>0.54883115400482185</c:v>
                </c:pt>
                <c:pt idx="1542">
                  <c:v>0.59024270806259049</c:v>
                </c:pt>
                <c:pt idx="1543">
                  <c:v>-0.47834617173337196</c:v>
                </c:pt>
                <c:pt idx="1544">
                  <c:v>0.51136682947955703</c:v>
                </c:pt>
                <c:pt idx="1545">
                  <c:v>0.53585389409589967</c:v>
                </c:pt>
                <c:pt idx="1546">
                  <c:v>6.5985829498585336E-2</c:v>
                </c:pt>
                <c:pt idx="1547">
                  <c:v>0.22478119439558927</c:v>
                </c:pt>
                <c:pt idx="1548">
                  <c:v>8.343458529334968E-3</c:v>
                </c:pt>
                <c:pt idx="1549">
                  <c:v>-7.3393258748683562E-2</c:v>
                </c:pt>
                <c:pt idx="1550">
                  <c:v>5.8662839378559886E-2</c:v>
                </c:pt>
                <c:pt idx="1551">
                  <c:v>0.24000896473507025</c:v>
                </c:pt>
                <c:pt idx="1552">
                  <c:v>-0.34044072708910089</c:v>
                </c:pt>
                <c:pt idx="1553">
                  <c:v>-0.19859298163428171</c:v>
                </c:pt>
                <c:pt idx="1554">
                  <c:v>0.3520805137298626</c:v>
                </c:pt>
                <c:pt idx="1555">
                  <c:v>0.17171923908784797</c:v>
                </c:pt>
                <c:pt idx="1556">
                  <c:v>-4.364591535463163E-2</c:v>
                </c:pt>
                <c:pt idx="1557">
                  <c:v>1.1347466553684877</c:v>
                </c:pt>
                <c:pt idx="1558">
                  <c:v>0.13251103979919548</c:v>
                </c:pt>
                <c:pt idx="1559">
                  <c:v>2.019992294349774E-2</c:v>
                </c:pt>
                <c:pt idx="1560">
                  <c:v>5.2555009434105286E-2</c:v>
                </c:pt>
                <c:pt idx="1561">
                  <c:v>0.70248024278347498</c:v>
                </c:pt>
                <c:pt idx="1562">
                  <c:v>0.37651266128847938</c:v>
                </c:pt>
                <c:pt idx="1563">
                  <c:v>0.10996225339881809</c:v>
                </c:pt>
                <c:pt idx="1564">
                  <c:v>-0.32337151175703105</c:v>
                </c:pt>
                <c:pt idx="1565">
                  <c:v>-4.4538396076498447E-2</c:v>
                </c:pt>
                <c:pt idx="1566">
                  <c:v>-0.55894153000678615</c:v>
                </c:pt>
                <c:pt idx="1567">
                  <c:v>-0.20656185827758058</c:v>
                </c:pt>
                <c:pt idx="1568">
                  <c:v>-2.8410464469938029E-2</c:v>
                </c:pt>
                <c:pt idx="1569">
                  <c:v>-0.44654119030090655</c:v>
                </c:pt>
                <c:pt idx="1570">
                  <c:v>0.1094274266861541</c:v>
                </c:pt>
                <c:pt idx="1571">
                  <c:v>9.7206245974365807E-2</c:v>
                </c:pt>
                <c:pt idx="1572">
                  <c:v>0.39143779769800013</c:v>
                </c:pt>
                <c:pt idx="1573">
                  <c:v>-0.44379132826041501</c:v>
                </c:pt>
                <c:pt idx="1574">
                  <c:v>0.2458607018403533</c:v>
                </c:pt>
                <c:pt idx="1575">
                  <c:v>0.12234140752611965</c:v>
                </c:pt>
                <c:pt idx="1576">
                  <c:v>0.14064779315484202</c:v>
                </c:pt>
                <c:pt idx="1577">
                  <c:v>0.13027195451885909</c:v>
                </c:pt>
                <c:pt idx="1578">
                  <c:v>-0.31994575175493578</c:v>
                </c:pt>
                <c:pt idx="1579">
                  <c:v>0.39363585562435793</c:v>
                </c:pt>
                <c:pt idx="1580">
                  <c:v>0.28486943309603219</c:v>
                </c:pt>
                <c:pt idx="1581">
                  <c:v>-0.11966711132535979</c:v>
                </c:pt>
                <c:pt idx="1582">
                  <c:v>-7.6280321250611363E-2</c:v>
                </c:pt>
                <c:pt idx="1583">
                  <c:v>5.9632159882099592E-2</c:v>
                </c:pt>
                <c:pt idx="1584">
                  <c:v>-0.59662319331291813</c:v>
                </c:pt>
                <c:pt idx="1585">
                  <c:v>0.29337048420475265</c:v>
                </c:pt>
                <c:pt idx="1586">
                  <c:v>0.32665239100440335</c:v>
                </c:pt>
                <c:pt idx="1587">
                  <c:v>9.0717959767799825E-2</c:v>
                </c:pt>
                <c:pt idx="1588">
                  <c:v>-0.3606752108291546</c:v>
                </c:pt>
                <c:pt idx="1589">
                  <c:v>0.55375368860474738</c:v>
                </c:pt>
                <c:pt idx="1590">
                  <c:v>0.17427857103612218</c:v>
                </c:pt>
                <c:pt idx="1591">
                  <c:v>-0.28947455766140301</c:v>
                </c:pt>
                <c:pt idx="1592">
                  <c:v>-0.24999384979579936</c:v>
                </c:pt>
                <c:pt idx="1593">
                  <c:v>0.31185183118705778</c:v>
                </c:pt>
                <c:pt idx="1594">
                  <c:v>4.0541793862846835E-2</c:v>
                </c:pt>
                <c:pt idx="1595">
                  <c:v>-0.17039395353944559</c:v>
                </c:pt>
                <c:pt idx="1596">
                  <c:v>-1.1526444337716328</c:v>
                </c:pt>
                <c:pt idx="1597">
                  <c:v>-0.17153089311826675</c:v>
                </c:pt>
                <c:pt idx="1598">
                  <c:v>-2.6339716008428806</c:v>
                </c:pt>
                <c:pt idx="1599">
                  <c:v>0.12075005333492556</c:v>
                </c:pt>
                <c:pt idx="1600">
                  <c:v>0.67671874411843336</c:v>
                </c:pt>
                <c:pt idx="1601">
                  <c:v>-0.50348651912319764</c:v>
                </c:pt>
                <c:pt idx="1602">
                  <c:v>0.31138685816203882</c:v>
                </c:pt>
                <c:pt idx="1603">
                  <c:v>-0.13558601420692962</c:v>
                </c:pt>
                <c:pt idx="1604">
                  <c:v>-1.6103455397704806E-2</c:v>
                </c:pt>
                <c:pt idx="1605">
                  <c:v>0.22515151184127313</c:v>
                </c:pt>
                <c:pt idx="1606">
                  <c:v>9.777121611529915E-3</c:v>
                </c:pt>
                <c:pt idx="1607">
                  <c:v>-0.87832144341174756</c:v>
                </c:pt>
                <c:pt idx="1608">
                  <c:v>0.39966330388801757</c:v>
                </c:pt>
                <c:pt idx="1609">
                  <c:v>-9.5265439226189422E-2</c:v>
                </c:pt>
                <c:pt idx="1610">
                  <c:v>0.32204350587425556</c:v>
                </c:pt>
                <c:pt idx="1611">
                  <c:v>-0.76121314041288357</c:v>
                </c:pt>
                <c:pt idx="1612">
                  <c:v>2.0484422065084031E-2</c:v>
                </c:pt>
                <c:pt idx="1613">
                  <c:v>0.73170460339473453</c:v>
                </c:pt>
                <c:pt idx="1614">
                  <c:v>0.32238968345021501</c:v>
                </c:pt>
                <c:pt idx="1615">
                  <c:v>0.49774008860909319</c:v>
                </c:pt>
                <c:pt idx="1616">
                  <c:v>-0.10144335270645244</c:v>
                </c:pt>
                <c:pt idx="1617">
                  <c:v>4.1523362184350425E-2</c:v>
                </c:pt>
                <c:pt idx="1618">
                  <c:v>-0.17902458339483771</c:v>
                </c:pt>
                <c:pt idx="1619">
                  <c:v>8.0521231831492415E-2</c:v>
                </c:pt>
                <c:pt idx="1620">
                  <c:v>-0.40354186044101442</c:v>
                </c:pt>
                <c:pt idx="1621">
                  <c:v>-0.26257281727094117</c:v>
                </c:pt>
                <c:pt idx="1622">
                  <c:v>-0.1837689496578922</c:v>
                </c:pt>
                <c:pt idx="1623">
                  <c:v>-0.21006213101980523</c:v>
                </c:pt>
                <c:pt idx="1624">
                  <c:v>0.19232043503449905</c:v>
                </c:pt>
                <c:pt idx="1625">
                  <c:v>-0.19000941602479479</c:v>
                </c:pt>
                <c:pt idx="1626">
                  <c:v>-1.9640946162578721</c:v>
                </c:pt>
                <c:pt idx="1627">
                  <c:v>0.16774328010893649</c:v>
                </c:pt>
                <c:pt idx="1628">
                  <c:v>0.53674920564802608</c:v>
                </c:pt>
                <c:pt idx="1629">
                  <c:v>1.2926174444270048E-2</c:v>
                </c:pt>
                <c:pt idx="1630">
                  <c:v>-3.7265909404197023E-2</c:v>
                </c:pt>
                <c:pt idx="1631">
                  <c:v>-0.24502700733009838</c:v>
                </c:pt>
                <c:pt idx="1632">
                  <c:v>0.26567692517216907</c:v>
                </c:pt>
                <c:pt idx="1633">
                  <c:v>-0.33061033798716322</c:v>
                </c:pt>
                <c:pt idx="1634">
                  <c:v>-0.45047867921036217</c:v>
                </c:pt>
                <c:pt idx="1635">
                  <c:v>-0.51374901111589155</c:v>
                </c:pt>
                <c:pt idx="1636">
                  <c:v>0.65992455840237829</c:v>
                </c:pt>
                <c:pt idx="1637">
                  <c:v>0.65773145682846212</c:v>
                </c:pt>
                <c:pt idx="1638">
                  <c:v>0.74974877886449587</c:v>
                </c:pt>
                <c:pt idx="1639">
                  <c:v>0.84855784556200131</c:v>
                </c:pt>
                <c:pt idx="1640">
                  <c:v>6.0047383669938899E-2</c:v>
                </c:pt>
                <c:pt idx="1641">
                  <c:v>-0.35162659786977213</c:v>
                </c:pt>
                <c:pt idx="1642">
                  <c:v>5.1859298835249854E-2</c:v>
                </c:pt>
                <c:pt idx="1643">
                  <c:v>0.45048545986111993</c:v>
                </c:pt>
                <c:pt idx="1644">
                  <c:v>-0.64408162848772166</c:v>
                </c:pt>
                <c:pt idx="1645">
                  <c:v>-0.73480317301558562</c:v>
                </c:pt>
                <c:pt idx="1646">
                  <c:v>4.3204498565167566E-2</c:v>
                </c:pt>
                <c:pt idx="1647">
                  <c:v>-0.59902495632691344</c:v>
                </c:pt>
                <c:pt idx="1648">
                  <c:v>0.18852752677440171</c:v>
                </c:pt>
                <c:pt idx="1649">
                  <c:v>-0.73120632487752113</c:v>
                </c:pt>
                <c:pt idx="1650">
                  <c:v>0.18688083134723416</c:v>
                </c:pt>
                <c:pt idx="1651">
                  <c:v>-0.58510677743920136</c:v>
                </c:pt>
                <c:pt idx="1652">
                  <c:v>-0.10640480212165201</c:v>
                </c:pt>
                <c:pt idx="1653">
                  <c:v>0.43733428557230525</c:v>
                </c:pt>
                <c:pt idx="1654">
                  <c:v>-0.26777422312465438</c:v>
                </c:pt>
                <c:pt idx="1655">
                  <c:v>-8.8346762691467781E-2</c:v>
                </c:pt>
                <c:pt idx="1656">
                  <c:v>0.17976580835814965</c:v>
                </c:pt>
                <c:pt idx="1657">
                  <c:v>-0.56298537801500426</c:v>
                </c:pt>
                <c:pt idx="1658">
                  <c:v>1.6781550233402012E-2</c:v>
                </c:pt>
                <c:pt idx="1659">
                  <c:v>0.20125745684324109</c:v>
                </c:pt>
                <c:pt idx="1660">
                  <c:v>0.37617923151752053</c:v>
                </c:pt>
                <c:pt idx="1661">
                  <c:v>6.4469017368442544E-2</c:v>
                </c:pt>
                <c:pt idx="1662">
                  <c:v>0.29089618118830335</c:v>
                </c:pt>
                <c:pt idx="1663">
                  <c:v>6.1707084791597165E-2</c:v>
                </c:pt>
                <c:pt idx="1664">
                  <c:v>-0.33588129266120026</c:v>
                </c:pt>
                <c:pt idx="1665">
                  <c:v>0.37428833916903131</c:v>
                </c:pt>
                <c:pt idx="1666">
                  <c:v>1.0923027184791876E-2</c:v>
                </c:pt>
                <c:pt idx="1667">
                  <c:v>-0.21357091679694382</c:v>
                </c:pt>
                <c:pt idx="1668">
                  <c:v>1.273336847150222</c:v>
                </c:pt>
                <c:pt idx="1669">
                  <c:v>0.14117117246074129</c:v>
                </c:pt>
                <c:pt idx="1670">
                  <c:v>0.63375668098196125</c:v>
                </c:pt>
                <c:pt idx="1671">
                  <c:v>0.17951105027151046</c:v>
                </c:pt>
                <c:pt idx="1672">
                  <c:v>-0.55004251637199653</c:v>
                </c:pt>
                <c:pt idx="1673">
                  <c:v>0.38084025031926966</c:v>
                </c:pt>
                <c:pt idx="1674">
                  <c:v>-0.19363469387754481</c:v>
                </c:pt>
                <c:pt idx="1675">
                  <c:v>0.22416378734166367</c:v>
                </c:pt>
                <c:pt idx="1676">
                  <c:v>-5.4242492027372392E-2</c:v>
                </c:pt>
                <c:pt idx="1677">
                  <c:v>0.28368475981474189</c:v>
                </c:pt>
                <c:pt idx="1678">
                  <c:v>-1.6979054276021938E-2</c:v>
                </c:pt>
                <c:pt idx="1679">
                  <c:v>-4.9904905826313933E-2</c:v>
                </c:pt>
                <c:pt idx="1680">
                  <c:v>0.20839239979067614</c:v>
                </c:pt>
                <c:pt idx="1681">
                  <c:v>0.12538660536581386</c:v>
                </c:pt>
                <c:pt idx="1682">
                  <c:v>0.12498976997866353</c:v>
                </c:pt>
                <c:pt idx="1683">
                  <c:v>0.28000607830130464</c:v>
                </c:pt>
                <c:pt idx="1684">
                  <c:v>0.12379860846262165</c:v>
                </c:pt>
                <c:pt idx="1685">
                  <c:v>0.14639454906050522</c:v>
                </c:pt>
                <c:pt idx="1686">
                  <c:v>-0.53053074673273437</c:v>
                </c:pt>
                <c:pt idx="1687">
                  <c:v>-0.56000460207676417</c:v>
                </c:pt>
                <c:pt idx="1688">
                  <c:v>0.12816140091448883</c:v>
                </c:pt>
                <c:pt idx="1689">
                  <c:v>-0.53679607957137532</c:v>
                </c:pt>
                <c:pt idx="1690">
                  <c:v>-0.87170659899018255</c:v>
                </c:pt>
                <c:pt idx="1691">
                  <c:v>0.2373189655745509</c:v>
                </c:pt>
                <c:pt idx="1692">
                  <c:v>-0.89942595978680262</c:v>
                </c:pt>
                <c:pt idx="1693">
                  <c:v>-0.64724147495936335</c:v>
                </c:pt>
                <c:pt idx="1694">
                  <c:v>0.22663183180789062</c:v>
                </c:pt>
                <c:pt idx="1695">
                  <c:v>0.34687181394424943</c:v>
                </c:pt>
                <c:pt idx="1696">
                  <c:v>-0.19165614036850323</c:v>
                </c:pt>
                <c:pt idx="1697">
                  <c:v>0.18472462050188018</c:v>
                </c:pt>
                <c:pt idx="1698">
                  <c:v>0.50477291597505369</c:v>
                </c:pt>
                <c:pt idx="1699">
                  <c:v>-0.22465441592596019</c:v>
                </c:pt>
                <c:pt idx="1700">
                  <c:v>-8.6660565246178073E-2</c:v>
                </c:pt>
                <c:pt idx="1701">
                  <c:v>3.8576651452323155E-2</c:v>
                </c:pt>
                <c:pt idx="1702">
                  <c:v>-9.4081274124168356E-3</c:v>
                </c:pt>
                <c:pt idx="1703">
                  <c:v>0.5152078190358208</c:v>
                </c:pt>
                <c:pt idx="1704">
                  <c:v>0.37451092576839107</c:v>
                </c:pt>
                <c:pt idx="1705">
                  <c:v>9.9766486292929807E-2</c:v>
                </c:pt>
                <c:pt idx="1706">
                  <c:v>-6.235429309493612E-2</c:v>
                </c:pt>
                <c:pt idx="1707">
                  <c:v>8.1066880491888524E-2</c:v>
                </c:pt>
                <c:pt idx="1708">
                  <c:v>-7.6736701823053935E-2</c:v>
                </c:pt>
                <c:pt idx="1709">
                  <c:v>-0.51849438342294452</c:v>
                </c:pt>
                <c:pt idx="1710">
                  <c:v>0.29912740841237706</c:v>
                </c:pt>
                <c:pt idx="1711">
                  <c:v>0.24061962931175979</c:v>
                </c:pt>
                <c:pt idx="1712">
                  <c:v>-7.8106710405880533E-2</c:v>
                </c:pt>
                <c:pt idx="1713">
                  <c:v>0.18650055764449477</c:v>
                </c:pt>
                <c:pt idx="1714">
                  <c:v>4.0401515284206602E-2</c:v>
                </c:pt>
                <c:pt idx="1715">
                  <c:v>0.23339726410188313</c:v>
                </c:pt>
                <c:pt idx="1716">
                  <c:v>-0.54772086486522376</c:v>
                </c:pt>
                <c:pt idx="1717">
                  <c:v>-0.26777422312465438</c:v>
                </c:pt>
                <c:pt idx="1718">
                  <c:v>0.14639454906050522</c:v>
                </c:pt>
                <c:pt idx="1719">
                  <c:v>0.75454548946918887</c:v>
                </c:pt>
                <c:pt idx="1720">
                  <c:v>-0.23276896297612443</c:v>
                </c:pt>
                <c:pt idx="1721">
                  <c:v>0.66575658267939852</c:v>
                </c:pt>
                <c:pt idx="1722">
                  <c:v>0.14899916258776436</c:v>
                </c:pt>
                <c:pt idx="1723">
                  <c:v>-0.24776521938035551</c:v>
                </c:pt>
                <c:pt idx="1724">
                  <c:v>9.5451881085660537E-2</c:v>
                </c:pt>
                <c:pt idx="1725">
                  <c:v>0.26110952890930156</c:v>
                </c:pt>
                <c:pt idx="1726">
                  <c:v>-0.35956416338041219</c:v>
                </c:pt>
                <c:pt idx="1727">
                  <c:v>0.39407506562573752</c:v>
                </c:pt>
                <c:pt idx="1728">
                  <c:v>3.3511102361323694E-2</c:v>
                </c:pt>
                <c:pt idx="1729">
                  <c:v>0.24744147114440773</c:v>
                </c:pt>
                <c:pt idx="1730">
                  <c:v>0.32262042236168464</c:v>
                </c:pt>
                <c:pt idx="1731">
                  <c:v>-0.61197582418754271</c:v>
                </c:pt>
                <c:pt idx="1732">
                  <c:v>6.7087964801146954E-2</c:v>
                </c:pt>
                <c:pt idx="1733">
                  <c:v>-0.13147126031369732</c:v>
                </c:pt>
                <c:pt idx="1734">
                  <c:v>0.22848009832991745</c:v>
                </c:pt>
                <c:pt idx="1735">
                  <c:v>-0.19859298163428171</c:v>
                </c:pt>
                <c:pt idx="1736">
                  <c:v>-1.0037558918843352</c:v>
                </c:pt>
                <c:pt idx="1737">
                  <c:v>0.13382652729882785</c:v>
                </c:pt>
                <c:pt idx="1738">
                  <c:v>0.20951575109266374</c:v>
                </c:pt>
                <c:pt idx="1739">
                  <c:v>-0.58445764580130311</c:v>
                </c:pt>
                <c:pt idx="1740">
                  <c:v>0.20238637533478931</c:v>
                </c:pt>
                <c:pt idx="1741">
                  <c:v>-5.4991671584577052E-2</c:v>
                </c:pt>
                <c:pt idx="1742">
                  <c:v>-0.53366001202052515</c:v>
                </c:pt>
                <c:pt idx="1743">
                  <c:v>0.15133930104228091</c:v>
                </c:pt>
                <c:pt idx="1744">
                  <c:v>-0.84762185459896067</c:v>
                </c:pt>
                <c:pt idx="1745">
                  <c:v>-6.9754681685335454E-2</c:v>
                </c:pt>
                <c:pt idx="1746">
                  <c:v>6.9427210456014174E-2</c:v>
                </c:pt>
                <c:pt idx="1747">
                  <c:v>-0.41215499074572254</c:v>
                </c:pt>
                <c:pt idx="1748">
                  <c:v>0.37939916252557832</c:v>
                </c:pt>
                <c:pt idx="1749">
                  <c:v>0.27524548978466823</c:v>
                </c:pt>
                <c:pt idx="1750">
                  <c:v>0.69839630332520464</c:v>
                </c:pt>
                <c:pt idx="1751">
                  <c:v>3.5905383742127948E-2</c:v>
                </c:pt>
                <c:pt idx="1752">
                  <c:v>-1.0901885012916617</c:v>
                </c:pt>
                <c:pt idx="1753">
                  <c:v>0.47591497217817863</c:v>
                </c:pt>
                <c:pt idx="1754">
                  <c:v>-0.5395195299599892</c:v>
                </c:pt>
                <c:pt idx="1755">
                  <c:v>0.19874558184482397</c:v>
                </c:pt>
                <c:pt idx="1756">
                  <c:v>-0.13241977779749542</c:v>
                </c:pt>
                <c:pt idx="1757">
                  <c:v>-0.48217001519072605</c:v>
                </c:pt>
                <c:pt idx="1758">
                  <c:v>-0.47012909087183358</c:v>
                </c:pt>
                <c:pt idx="1759">
                  <c:v>-9.0034933242031531E-2</c:v>
                </c:pt>
                <c:pt idx="1760">
                  <c:v>0.36669988859949043</c:v>
                </c:pt>
                <c:pt idx="1761">
                  <c:v>-0.16149189721934384</c:v>
                </c:pt>
                <c:pt idx="1762">
                  <c:v>-0.28208783035557128</c:v>
                </c:pt>
                <c:pt idx="1763">
                  <c:v>0.12895322038600612</c:v>
                </c:pt>
                <c:pt idx="1764">
                  <c:v>2.8825085331213654E-3</c:v>
                </c:pt>
                <c:pt idx="1765">
                  <c:v>0.18218376912146836</c:v>
                </c:pt>
                <c:pt idx="1766">
                  <c:v>-0.46553991807327183</c:v>
                </c:pt>
                <c:pt idx="1767">
                  <c:v>-0.28173702304906734</c:v>
                </c:pt>
                <c:pt idx="1768">
                  <c:v>2.2900402110078832E-2</c:v>
                </c:pt>
                <c:pt idx="1769">
                  <c:v>-0.30525349942209329</c:v>
                </c:pt>
                <c:pt idx="1770">
                  <c:v>0.94005396209695524</c:v>
                </c:pt>
                <c:pt idx="1771">
                  <c:v>0.23241517077540189</c:v>
                </c:pt>
                <c:pt idx="1772">
                  <c:v>-2.1950844255312567E-2</c:v>
                </c:pt>
                <c:pt idx="1773">
                  <c:v>-0.31365635692381932</c:v>
                </c:pt>
                <c:pt idx="1774">
                  <c:v>0.10728613495222238</c:v>
                </c:pt>
                <c:pt idx="1775">
                  <c:v>0.50558610280184746</c:v>
                </c:pt>
                <c:pt idx="1776">
                  <c:v>-0.38873317492693521</c:v>
                </c:pt>
                <c:pt idx="1777">
                  <c:v>0.18180225515894124</c:v>
                </c:pt>
                <c:pt idx="1778">
                  <c:v>1.3926706042921726E-2</c:v>
                </c:pt>
                <c:pt idx="1779">
                  <c:v>-1.4212061673232474</c:v>
                </c:pt>
                <c:pt idx="1780">
                  <c:v>-0.38364230300330965</c:v>
                </c:pt>
                <c:pt idx="1781">
                  <c:v>0.10393399105623309</c:v>
                </c:pt>
                <c:pt idx="1782">
                  <c:v>0.56218135647186707</c:v>
                </c:pt>
                <c:pt idx="1783">
                  <c:v>-0.20439927089869361</c:v>
                </c:pt>
                <c:pt idx="1784">
                  <c:v>0.40206724982782521</c:v>
                </c:pt>
                <c:pt idx="1785">
                  <c:v>0.3251561177415912</c:v>
                </c:pt>
                <c:pt idx="1786">
                  <c:v>-1.2606364403338443E-2</c:v>
                </c:pt>
                <c:pt idx="1787">
                  <c:v>0.17210342844013979</c:v>
                </c:pt>
                <c:pt idx="1788">
                  <c:v>0.5638414788803281</c:v>
                </c:pt>
                <c:pt idx="1789">
                  <c:v>0.13014013533644853</c:v>
                </c:pt>
                <c:pt idx="1790">
                  <c:v>7.1955014042037668E-3</c:v>
                </c:pt>
                <c:pt idx="1791">
                  <c:v>0.30882682434788383</c:v>
                </c:pt>
                <c:pt idx="1792">
                  <c:v>0.16504364948304445</c:v>
                </c:pt>
                <c:pt idx="1793">
                  <c:v>0.18789440479079594</c:v>
                </c:pt>
                <c:pt idx="1794">
                  <c:v>1.1495638837829439E-2</c:v>
                </c:pt>
                <c:pt idx="1795">
                  <c:v>-0.14896061429127466</c:v>
                </c:pt>
                <c:pt idx="1796">
                  <c:v>0.42974985080021605</c:v>
                </c:pt>
                <c:pt idx="1797">
                  <c:v>-2.3563039826121193E-2</c:v>
                </c:pt>
                <c:pt idx="1798">
                  <c:v>0.15185881672700494</c:v>
                </c:pt>
                <c:pt idx="1799">
                  <c:v>0.35524184393088254</c:v>
                </c:pt>
                <c:pt idx="1800">
                  <c:v>0.17645043911909955</c:v>
                </c:pt>
                <c:pt idx="1801">
                  <c:v>3.125402547050081E-2</c:v>
                </c:pt>
                <c:pt idx="1802">
                  <c:v>-9.2493985787336988E-2</c:v>
                </c:pt>
                <c:pt idx="1803">
                  <c:v>7.382023329167138E-2</c:v>
                </c:pt>
                <c:pt idx="1804">
                  <c:v>-0.57992188402062606</c:v>
                </c:pt>
                <c:pt idx="1805">
                  <c:v>0.11928976837475146</c:v>
                </c:pt>
                <c:pt idx="1806">
                  <c:v>7.3390460081619964E-3</c:v>
                </c:pt>
                <c:pt idx="1807">
                  <c:v>-0.41850412899862327</c:v>
                </c:pt>
                <c:pt idx="1808">
                  <c:v>0.29337048420475265</c:v>
                </c:pt>
                <c:pt idx="1809">
                  <c:v>1.4783752627070351E-2</c:v>
                </c:pt>
                <c:pt idx="1810">
                  <c:v>-0.37257993059879913</c:v>
                </c:pt>
                <c:pt idx="1811">
                  <c:v>0.36042046610320916</c:v>
                </c:pt>
                <c:pt idx="1812">
                  <c:v>-0.49675304585062618</c:v>
                </c:pt>
                <c:pt idx="1813">
                  <c:v>0.27166471097723399</c:v>
                </c:pt>
                <c:pt idx="1814">
                  <c:v>2.4319679195412894E-2</c:v>
                </c:pt>
                <c:pt idx="1815">
                  <c:v>0.69260573840809525</c:v>
                </c:pt>
                <c:pt idx="1816">
                  <c:v>-1.5092245183270783</c:v>
                </c:pt>
                <c:pt idx="1817">
                  <c:v>-0.25446146545072984</c:v>
                </c:pt>
                <c:pt idx="1818">
                  <c:v>-5.5141554192460952E-2</c:v>
                </c:pt>
                <c:pt idx="1819">
                  <c:v>-0.37950742642355889</c:v>
                </c:pt>
                <c:pt idx="1820">
                  <c:v>0.43402767466359748</c:v>
                </c:pt>
                <c:pt idx="1821">
                  <c:v>0.15885402951661801</c:v>
                </c:pt>
                <c:pt idx="1822">
                  <c:v>0.34709867062226835</c:v>
                </c:pt>
                <c:pt idx="1823">
                  <c:v>-0.3722064173175183</c:v>
                </c:pt>
                <c:pt idx="1824">
                  <c:v>-0.22718531250080656</c:v>
                </c:pt>
                <c:pt idx="1825">
                  <c:v>-2.9293566950617151E-2</c:v>
                </c:pt>
                <c:pt idx="1826">
                  <c:v>0.23044897620750635</c:v>
                </c:pt>
                <c:pt idx="1827">
                  <c:v>0.28865386360516937</c:v>
                </c:pt>
                <c:pt idx="1828">
                  <c:v>0.36086990381428591</c:v>
                </c:pt>
                <c:pt idx="1829">
                  <c:v>0.69456822500883364</c:v>
                </c:pt>
                <c:pt idx="1830">
                  <c:v>0.13066733981550699</c:v>
                </c:pt>
                <c:pt idx="1831">
                  <c:v>0.1333004762297765</c:v>
                </c:pt>
                <c:pt idx="1832">
                  <c:v>-0.26170773657050578</c:v>
                </c:pt>
                <c:pt idx="1833">
                  <c:v>-0.17315664835103578</c:v>
                </c:pt>
                <c:pt idx="1834">
                  <c:v>0.52727055687734092</c:v>
                </c:pt>
                <c:pt idx="1835">
                  <c:v>-0.6362121588967109</c:v>
                </c:pt>
                <c:pt idx="1836">
                  <c:v>0.48800077083406829</c:v>
                </c:pt>
                <c:pt idx="1837">
                  <c:v>-0.1637526689571587</c:v>
                </c:pt>
                <c:pt idx="1838">
                  <c:v>-0.27980910616740334</c:v>
                </c:pt>
                <c:pt idx="1839">
                  <c:v>0.52707033551266058</c:v>
                </c:pt>
                <c:pt idx="1840">
                  <c:v>-0.32427438120316371</c:v>
                </c:pt>
                <c:pt idx="1841">
                  <c:v>6.9152201869422988E-2</c:v>
                </c:pt>
                <c:pt idx="1842">
                  <c:v>-0.29212186718314975</c:v>
                </c:pt>
                <c:pt idx="1843">
                  <c:v>5.1441711382610174E-2</c:v>
                </c:pt>
                <c:pt idx="1844">
                  <c:v>6.3779029770571261E-2</c:v>
                </c:pt>
                <c:pt idx="1845">
                  <c:v>0.24184018356467063</c:v>
                </c:pt>
                <c:pt idx="1846">
                  <c:v>0.11169907219742027</c:v>
                </c:pt>
                <c:pt idx="1847">
                  <c:v>-0.28121097198001599</c:v>
                </c:pt>
                <c:pt idx="1848">
                  <c:v>0.13763467188337281</c:v>
                </c:pt>
                <c:pt idx="1849">
                  <c:v>0.31950232900430725</c:v>
                </c:pt>
                <c:pt idx="1850">
                  <c:v>0.11370049916472832</c:v>
                </c:pt>
                <c:pt idx="1851">
                  <c:v>0.13776580809587857</c:v>
                </c:pt>
                <c:pt idx="1852">
                  <c:v>5.4362288449689107E-2</c:v>
                </c:pt>
                <c:pt idx="1853">
                  <c:v>-8.2468877554856181E-3</c:v>
                </c:pt>
                <c:pt idx="1854">
                  <c:v>0.11729608565724151</c:v>
                </c:pt>
                <c:pt idx="1855">
                  <c:v>-2.5700359564830535</c:v>
                </c:pt>
                <c:pt idx="1856">
                  <c:v>0.18561286234235091</c:v>
                </c:pt>
                <c:pt idx="1857">
                  <c:v>0.32975508574474682</c:v>
                </c:pt>
                <c:pt idx="1858">
                  <c:v>-0.11309873231350795</c:v>
                </c:pt>
                <c:pt idx="1859">
                  <c:v>0.51075942155216958</c:v>
                </c:pt>
                <c:pt idx="1860">
                  <c:v>-0.25274151407762163</c:v>
                </c:pt>
                <c:pt idx="1861">
                  <c:v>0.4469972406763888</c:v>
                </c:pt>
                <c:pt idx="1862">
                  <c:v>-5.9645288466706789E-2</c:v>
                </c:pt>
                <c:pt idx="1863">
                  <c:v>-5.3343989793084919E-2</c:v>
                </c:pt>
                <c:pt idx="1864">
                  <c:v>9.3695380233557043E-2</c:v>
                </c:pt>
                <c:pt idx="1865">
                  <c:v>-0.38007057588392235</c:v>
                </c:pt>
                <c:pt idx="1866">
                  <c:v>0.1397314222437436</c:v>
                </c:pt>
                <c:pt idx="1867">
                  <c:v>0.16877038350082046</c:v>
                </c:pt>
                <c:pt idx="1868">
                  <c:v>0.32492578405532102</c:v>
                </c:pt>
                <c:pt idx="1869">
                  <c:v>-2.1365037713555978E-2</c:v>
                </c:pt>
                <c:pt idx="1870">
                  <c:v>1.5354834293464041E-2</c:v>
                </c:pt>
                <c:pt idx="1871">
                  <c:v>-0.14034843614016634</c:v>
                </c:pt>
                <c:pt idx="1872">
                  <c:v>-1.213570916796944</c:v>
                </c:pt>
                <c:pt idx="1873">
                  <c:v>-0.14066649060373157</c:v>
                </c:pt>
                <c:pt idx="1874">
                  <c:v>-0.41426826703407293</c:v>
                </c:pt>
                <c:pt idx="1875">
                  <c:v>-0.41407602304139879</c:v>
                </c:pt>
                <c:pt idx="1876">
                  <c:v>-3.3569532693701831E-2</c:v>
                </c:pt>
                <c:pt idx="1877">
                  <c:v>-0.18049530395806687</c:v>
                </c:pt>
                <c:pt idx="1878">
                  <c:v>0.5056877189343697</c:v>
                </c:pt>
                <c:pt idx="1879">
                  <c:v>0.11703005301018697</c:v>
                </c:pt>
                <c:pt idx="1880">
                  <c:v>0.21747890047053098</c:v>
                </c:pt>
                <c:pt idx="1881">
                  <c:v>-0.16682653676165965</c:v>
                </c:pt>
                <c:pt idx="1882">
                  <c:v>-0.18688580865371102</c:v>
                </c:pt>
                <c:pt idx="1883">
                  <c:v>0.16246786761530391</c:v>
                </c:pt>
                <c:pt idx="1884">
                  <c:v>-0.42449403196700858</c:v>
                </c:pt>
                <c:pt idx="1885">
                  <c:v>0.57724753559315078</c:v>
                </c:pt>
                <c:pt idx="1886">
                  <c:v>-8.1155839810753583E-2</c:v>
                </c:pt>
                <c:pt idx="1887">
                  <c:v>1.231002239327311</c:v>
                </c:pt>
                <c:pt idx="1888">
                  <c:v>0.25386828044171933</c:v>
                </c:pt>
                <c:pt idx="1889">
                  <c:v>-0.10051497748722915</c:v>
                </c:pt>
                <c:pt idx="1890">
                  <c:v>-0.67415310176118493</c:v>
                </c:pt>
                <c:pt idx="1891">
                  <c:v>0.23339726410188313</c:v>
                </c:pt>
                <c:pt idx="1892">
                  <c:v>9.0853430451113479E-2</c:v>
                </c:pt>
                <c:pt idx="1893">
                  <c:v>-2.7360041179287609</c:v>
                </c:pt>
                <c:pt idx="1894">
                  <c:v>0.4026130429871701</c:v>
                </c:pt>
                <c:pt idx="1895">
                  <c:v>0.36982938015392897</c:v>
                </c:pt>
                <c:pt idx="1896">
                  <c:v>-0.2155797753822157</c:v>
                </c:pt>
                <c:pt idx="1897">
                  <c:v>0.17095055331836756</c:v>
                </c:pt>
                <c:pt idx="1898">
                  <c:v>-0.32879722345809981</c:v>
                </c:pt>
                <c:pt idx="1899">
                  <c:v>0.22737142258325888</c:v>
                </c:pt>
                <c:pt idx="1900">
                  <c:v>7.9702371697378191E-2</c:v>
                </c:pt>
                <c:pt idx="1901">
                  <c:v>-1.2646511298141148</c:v>
                </c:pt>
                <c:pt idx="1902">
                  <c:v>0.31649333777531463</c:v>
                </c:pt>
                <c:pt idx="1903">
                  <c:v>0.17938365435629777</c:v>
                </c:pt>
                <c:pt idx="1904">
                  <c:v>-0.16181464778912144</c:v>
                </c:pt>
                <c:pt idx="1905">
                  <c:v>-0.49349960956638378</c:v>
                </c:pt>
                <c:pt idx="1906">
                  <c:v>0.14613382889337501</c:v>
                </c:pt>
                <c:pt idx="1907">
                  <c:v>0.10634831950514673</c:v>
                </c:pt>
                <c:pt idx="1908">
                  <c:v>0.13040376165803888</c:v>
                </c:pt>
                <c:pt idx="1909">
                  <c:v>0.28048127430062353</c:v>
                </c:pt>
                <c:pt idx="1910">
                  <c:v>-0.15939577664590515</c:v>
                </c:pt>
                <c:pt idx="1911">
                  <c:v>0.39659793157489975</c:v>
                </c:pt>
                <c:pt idx="1912">
                  <c:v>8.0521231831492415E-2</c:v>
                </c:pt>
                <c:pt idx="1913">
                  <c:v>-0.14114370380866342</c:v>
                </c:pt>
                <c:pt idx="1914">
                  <c:v>9.4776556895597316E-2</c:v>
                </c:pt>
                <c:pt idx="1915">
                  <c:v>-0.39554906968748377</c:v>
                </c:pt>
                <c:pt idx="1916">
                  <c:v>0.17478989304781481</c:v>
                </c:pt>
                <c:pt idx="1917">
                  <c:v>0.11716307546575941</c:v>
                </c:pt>
                <c:pt idx="1918">
                  <c:v>0.13789693238961928</c:v>
                </c:pt>
                <c:pt idx="1919">
                  <c:v>0.3033423944873308</c:v>
                </c:pt>
                <c:pt idx="1920">
                  <c:v>-0.2073944865923113</c:v>
                </c:pt>
                <c:pt idx="1921">
                  <c:v>-0.91267294820252465</c:v>
                </c:pt>
                <c:pt idx="1922">
                  <c:v>-0.2397364653786003</c:v>
                </c:pt>
                <c:pt idx="1923">
                  <c:v>0.43178339880387578</c:v>
                </c:pt>
                <c:pt idx="1924">
                  <c:v>7.7653185650161383E-2</c:v>
                </c:pt>
                <c:pt idx="1925">
                  <c:v>9.7745621638518854E-2</c:v>
                </c:pt>
                <c:pt idx="1926">
                  <c:v>-0.18180387097829168</c:v>
                </c:pt>
                <c:pt idx="1927">
                  <c:v>-0.23599362237133509</c:v>
                </c:pt>
                <c:pt idx="1928">
                  <c:v>0.5951216919961716</c:v>
                </c:pt>
                <c:pt idx="1929">
                  <c:v>-0.18836456914625643</c:v>
                </c:pt>
                <c:pt idx="1930">
                  <c:v>0.35681991507599453</c:v>
                </c:pt>
                <c:pt idx="1931">
                  <c:v>-0.21072981356829051</c:v>
                </c:pt>
                <c:pt idx="1932">
                  <c:v>0.36848900064510354</c:v>
                </c:pt>
                <c:pt idx="1933">
                  <c:v>-0.28138630102451551</c:v>
                </c:pt>
                <c:pt idx="1934">
                  <c:v>0.15600822110712773</c:v>
                </c:pt>
                <c:pt idx="1935">
                  <c:v>8.8820033298585108E-2</c:v>
                </c:pt>
                <c:pt idx="1936">
                  <c:v>-0.78338993125755829</c:v>
                </c:pt>
                <c:pt idx="1937">
                  <c:v>1.6353683577834812E-2</c:v>
                </c:pt>
                <c:pt idx="1938">
                  <c:v>0.18650055764449477</c:v>
                </c:pt>
                <c:pt idx="1939">
                  <c:v>-0.16763653905169792</c:v>
                </c:pt>
                <c:pt idx="1940">
                  <c:v>0.13946949503879594</c:v>
                </c:pt>
                <c:pt idx="1941">
                  <c:v>-0.19017400390254907</c:v>
                </c:pt>
                <c:pt idx="1942">
                  <c:v>0.48129894154756508</c:v>
                </c:pt>
                <c:pt idx="1943">
                  <c:v>0.11556599592160316</c:v>
                </c:pt>
                <c:pt idx="1944">
                  <c:v>-0.31634845518751536</c:v>
                </c:pt>
                <c:pt idx="1945">
                  <c:v>-0.93815469292893061</c:v>
                </c:pt>
                <c:pt idx="1946">
                  <c:v>0.39352603222835553</c:v>
                </c:pt>
                <c:pt idx="1947">
                  <c:v>3.421571533791299E-2</c:v>
                </c:pt>
                <c:pt idx="1948">
                  <c:v>0.27262045466299184</c:v>
                </c:pt>
                <c:pt idx="1949">
                  <c:v>-2.8704771904840675E-2</c:v>
                </c:pt>
                <c:pt idx="1950">
                  <c:v>-0.13875921474032632</c:v>
                </c:pt>
                <c:pt idx="1951">
                  <c:v>-1.2233064176584072</c:v>
                </c:pt>
                <c:pt idx="1952">
                  <c:v>-8.8346762691467781E-2</c:v>
                </c:pt>
                <c:pt idx="1953">
                  <c:v>2.2190239634065988E-2</c:v>
                </c:pt>
                <c:pt idx="1954">
                  <c:v>0.53555533339930994</c:v>
                </c:pt>
                <c:pt idx="1955">
                  <c:v>-0.35199482018950684</c:v>
                </c:pt>
                <c:pt idx="1956">
                  <c:v>-1.5228387614574906E-2</c:v>
                </c:pt>
                <c:pt idx="1957">
                  <c:v>-0.27090409186289555</c:v>
                </c:pt>
                <c:pt idx="1958">
                  <c:v>0.23609457863787781</c:v>
                </c:pt>
                <c:pt idx="1959">
                  <c:v>0.51561153949204119</c:v>
                </c:pt>
                <c:pt idx="1960">
                  <c:v>-0.15859038666189532</c:v>
                </c:pt>
                <c:pt idx="1961">
                  <c:v>-5.2030733086129094E-3</c:v>
                </c:pt>
                <c:pt idx="1962">
                  <c:v>-0.10206260157995356</c:v>
                </c:pt>
                <c:pt idx="1963">
                  <c:v>0.14156358237500305</c:v>
                </c:pt>
                <c:pt idx="1964">
                  <c:v>0.13868342797927169</c:v>
                </c:pt>
                <c:pt idx="1965">
                  <c:v>-0.21256753548313209</c:v>
                </c:pt>
                <c:pt idx="1966">
                  <c:v>-1.2108967824986185</c:v>
                </c:pt>
                <c:pt idx="1967">
                  <c:v>0.40979822782841963</c:v>
                </c:pt>
                <c:pt idx="1968">
                  <c:v>-0.62727072934027639</c:v>
                </c:pt>
                <c:pt idx="1969">
                  <c:v>0.2925461879503386</c:v>
                </c:pt>
                <c:pt idx="1970">
                  <c:v>0.16001660784590455</c:v>
                </c:pt>
                <c:pt idx="1971">
                  <c:v>8.3928155062359275E-2</c:v>
                </c:pt>
                <c:pt idx="1972">
                  <c:v>8.9633736106895567E-2</c:v>
                </c:pt>
                <c:pt idx="1973">
                  <c:v>-0.15714181674402258</c:v>
                </c:pt>
                <c:pt idx="1974">
                  <c:v>1.6496319896195974E-2</c:v>
                </c:pt>
                <c:pt idx="1975">
                  <c:v>0.41510963222757952</c:v>
                </c:pt>
                <c:pt idx="1976">
                  <c:v>-0.28630418515664108</c:v>
                </c:pt>
                <c:pt idx="1977">
                  <c:v>-0.2149098450052418</c:v>
                </c:pt>
                <c:pt idx="1978">
                  <c:v>0.22675512326982</c:v>
                </c:pt>
                <c:pt idx="1979">
                  <c:v>-0.5038956202292677</c:v>
                </c:pt>
                <c:pt idx="1980">
                  <c:v>-0.40889509493522119</c:v>
                </c:pt>
                <c:pt idx="1981">
                  <c:v>0.2077679375721706</c:v>
                </c:pt>
                <c:pt idx="1982">
                  <c:v>9.3019233133544738E-2</c:v>
                </c:pt>
                <c:pt idx="1983">
                  <c:v>-8.8273907472786965E-3</c:v>
                </c:pt>
                <c:pt idx="1984">
                  <c:v>-7.917317281108581E-2</c:v>
                </c:pt>
                <c:pt idx="1985">
                  <c:v>-0.10951439496446924</c:v>
                </c:pt>
                <c:pt idx="1986">
                  <c:v>0.49497875319664042</c:v>
                </c:pt>
                <c:pt idx="1987">
                  <c:v>0.13514081639481501</c:v>
                </c:pt>
                <c:pt idx="1988">
                  <c:v>0.1495195214900292</c:v>
                </c:pt>
                <c:pt idx="1989">
                  <c:v>-2.4296451992233268E-2</c:v>
                </c:pt>
                <c:pt idx="1990">
                  <c:v>4.9351959135291522E-2</c:v>
                </c:pt>
                <c:pt idx="1991">
                  <c:v>-0.25016542558727101</c:v>
                </c:pt>
                <c:pt idx="1992">
                  <c:v>-2.6939827195915918E-2</c:v>
                </c:pt>
                <c:pt idx="1993">
                  <c:v>-7.8716020959078287E-2</c:v>
                </c:pt>
                <c:pt idx="1994">
                  <c:v>-9.6344666130508488E-2</c:v>
                </c:pt>
                <c:pt idx="1995">
                  <c:v>-5.4691953074952525E-2</c:v>
                </c:pt>
                <c:pt idx="1996">
                  <c:v>-0.18721429113256383</c:v>
                </c:pt>
                <c:pt idx="1997">
                  <c:v>0.6769894778709975</c:v>
                </c:pt>
                <c:pt idx="1998">
                  <c:v>-1.2315322433239111E-2</c:v>
                </c:pt>
                <c:pt idx="1999">
                  <c:v>-0.12045105691922373</c:v>
                </c:pt>
                <c:pt idx="2000">
                  <c:v>0.24257202076715229</c:v>
                </c:pt>
                <c:pt idx="2001">
                  <c:v>-5.8142480996559893E-2</c:v>
                </c:pt>
                <c:pt idx="2002">
                  <c:v>0.66566563837067938</c:v>
                </c:pt>
                <c:pt idx="2003">
                  <c:v>0.2573727556068014</c:v>
                </c:pt>
                <c:pt idx="2004">
                  <c:v>-0.117161344232749</c:v>
                </c:pt>
                <c:pt idx="2005">
                  <c:v>-0.38948890833389133</c:v>
                </c:pt>
                <c:pt idx="2006">
                  <c:v>0.11303366529989149</c:v>
                </c:pt>
                <c:pt idx="2007">
                  <c:v>0.17082239919517525</c:v>
                </c:pt>
                <c:pt idx="2008">
                  <c:v>-0.14289483731466815</c:v>
                </c:pt>
                <c:pt idx="2009">
                  <c:v>0.7116711029181243</c:v>
                </c:pt>
                <c:pt idx="2010">
                  <c:v>8.2702589330249349E-2</c:v>
                </c:pt>
                <c:pt idx="2011">
                  <c:v>0.34437403328573257</c:v>
                </c:pt>
                <c:pt idx="2012">
                  <c:v>-0.21056286395971574</c:v>
                </c:pt>
                <c:pt idx="2013">
                  <c:v>0.23927582588255761</c:v>
                </c:pt>
                <c:pt idx="2014">
                  <c:v>0.40544784370753517</c:v>
                </c:pt>
                <c:pt idx="2015">
                  <c:v>0.10326262660608464</c:v>
                </c:pt>
                <c:pt idx="2016">
                  <c:v>0.32596199617185229</c:v>
                </c:pt>
                <c:pt idx="2017">
                  <c:v>-6.0848662567038407E-2</c:v>
                </c:pt>
                <c:pt idx="2018">
                  <c:v>-0.12799868851682014</c:v>
                </c:pt>
                <c:pt idx="2019">
                  <c:v>7.3390460081619964E-3</c:v>
                </c:pt>
                <c:pt idx="2020">
                  <c:v>1.4498126999352837E-2</c:v>
                </c:pt>
                <c:pt idx="2021">
                  <c:v>0.63598650374562304</c:v>
                </c:pt>
                <c:pt idx="2022">
                  <c:v>-0.30436245187299188</c:v>
                </c:pt>
                <c:pt idx="2023">
                  <c:v>-0.16391428829759438</c:v>
                </c:pt>
                <c:pt idx="2024">
                  <c:v>0.22428728989200139</c:v>
                </c:pt>
                <c:pt idx="2025">
                  <c:v>2.1624211506207254E-3</c:v>
                </c:pt>
                <c:pt idx="2026">
                  <c:v>0.81229284487327114</c:v>
                </c:pt>
                <c:pt idx="2027">
                  <c:v>0.11330043583336066</c:v>
                </c:pt>
                <c:pt idx="2028">
                  <c:v>-0.34098882880185011</c:v>
                </c:pt>
                <c:pt idx="2029">
                  <c:v>0.40479415314769318</c:v>
                </c:pt>
                <c:pt idx="2030">
                  <c:v>0.6958156916156446</c:v>
                </c:pt>
                <c:pt idx="2031">
                  <c:v>5.8662839378559886E-2</c:v>
                </c:pt>
                <c:pt idx="2032">
                  <c:v>4.8968432148474624E-3</c:v>
                </c:pt>
                <c:pt idx="2033">
                  <c:v>0.14899916258776436</c:v>
                </c:pt>
                <c:pt idx="2034">
                  <c:v>1.4419741739063218E-3</c:v>
                </c:pt>
                <c:pt idx="2035">
                  <c:v>0.63180275492412874</c:v>
                </c:pt>
                <c:pt idx="2036">
                  <c:v>0.21921499579542364</c:v>
                </c:pt>
                <c:pt idx="2037">
                  <c:v>-7.6736701823053935E-2</c:v>
                </c:pt>
                <c:pt idx="2038">
                  <c:v>0.83293051029927978</c:v>
                </c:pt>
                <c:pt idx="2039">
                  <c:v>-4.9456933445478336E-2</c:v>
                </c:pt>
                <c:pt idx="2040">
                  <c:v>0.37128005402265407</c:v>
                </c:pt>
                <c:pt idx="2041">
                  <c:v>0.85614910231840902</c:v>
                </c:pt>
                <c:pt idx="2042">
                  <c:v>0.14600345113892463</c:v>
                </c:pt>
                <c:pt idx="2043">
                  <c:v>0.70937887125385168</c:v>
                </c:pt>
                <c:pt idx="2044">
                  <c:v>0.66648393083742574</c:v>
                </c:pt>
                <c:pt idx="2045">
                  <c:v>-0.53366001202052515</c:v>
                </c:pt>
                <c:pt idx="2046">
                  <c:v>5.3806443695793821E-2</c:v>
                </c:pt>
                <c:pt idx="2047">
                  <c:v>-0.5576668766702485</c:v>
                </c:pt>
                <c:pt idx="2048">
                  <c:v>-0.5061477523051231</c:v>
                </c:pt>
                <c:pt idx="2049">
                  <c:v>-0.2560111768091472</c:v>
                </c:pt>
                <c:pt idx="2050">
                  <c:v>0.51035434081361353</c:v>
                </c:pt>
                <c:pt idx="2051">
                  <c:v>9.1124333661164736E-2</c:v>
                </c:pt>
                <c:pt idx="2052">
                  <c:v>0.16285452819051041</c:v>
                </c:pt>
                <c:pt idx="2053">
                  <c:v>-0.10206260157995356</c:v>
                </c:pt>
                <c:pt idx="2054">
                  <c:v>0.18865411783672911</c:v>
                </c:pt>
                <c:pt idx="2055">
                  <c:v>0.11955538469528244</c:v>
                </c:pt>
                <c:pt idx="2056">
                  <c:v>-0.13273608892371075</c:v>
                </c:pt>
                <c:pt idx="2057">
                  <c:v>8.4744620868467985E-2</c:v>
                </c:pt>
                <c:pt idx="2058">
                  <c:v>-0.12421993693151197</c:v>
                </c:pt>
                <c:pt idx="2059">
                  <c:v>0.10191895971107164</c:v>
                </c:pt>
                <c:pt idx="2060">
                  <c:v>0.23315180343929373</c:v>
                </c:pt>
                <c:pt idx="2061">
                  <c:v>-0.51560403749733374</c:v>
                </c:pt>
                <c:pt idx="2062">
                  <c:v>0.12855736497375747</c:v>
                </c:pt>
                <c:pt idx="2063">
                  <c:v>-0.10842527490344586</c:v>
                </c:pt>
                <c:pt idx="2064">
                  <c:v>0.1333004762297765</c:v>
                </c:pt>
                <c:pt idx="2065">
                  <c:v>0.36748289813886792</c:v>
                </c:pt>
                <c:pt idx="2066">
                  <c:v>0.10742005883636484</c:v>
                </c:pt>
                <c:pt idx="2067">
                  <c:v>-0.18935125221735402</c:v>
                </c:pt>
                <c:pt idx="2068">
                  <c:v>0.16722945407166856</c:v>
                </c:pt>
                <c:pt idx="2069">
                  <c:v>-0.10330189729957423</c:v>
                </c:pt>
                <c:pt idx="2070">
                  <c:v>0.30684550031428276</c:v>
                </c:pt>
                <c:pt idx="2071">
                  <c:v>-0.11450372678347603</c:v>
                </c:pt>
                <c:pt idx="2072">
                  <c:v>0.14860877020522015</c:v>
                </c:pt>
                <c:pt idx="2073">
                  <c:v>4.0962547778497838E-2</c:v>
                </c:pt>
                <c:pt idx="2074">
                  <c:v>-0.19248020793011561</c:v>
                </c:pt>
                <c:pt idx="2075">
                  <c:v>0.28024369586601683</c:v>
                </c:pt>
                <c:pt idx="2076">
                  <c:v>8.1612322857889844E-2</c:v>
                </c:pt>
                <c:pt idx="2077">
                  <c:v>-4.9456933445478336E-2</c:v>
                </c:pt>
                <c:pt idx="2078">
                  <c:v>-0.24690896970189485</c:v>
                </c:pt>
                <c:pt idx="2079">
                  <c:v>0.53535625860378377</c:v>
                </c:pt>
                <c:pt idx="2080">
                  <c:v>-2.3856359953366994E-2</c:v>
                </c:pt>
                <c:pt idx="2081">
                  <c:v>0.13093086982644869</c:v>
                </c:pt>
                <c:pt idx="2082">
                  <c:v>-6.5974230277085405E-2</c:v>
                </c:pt>
                <c:pt idx="2083">
                  <c:v>0.77820857639808771</c:v>
                </c:pt>
                <c:pt idx="2084">
                  <c:v>-4.8859853233794395E-2</c:v>
                </c:pt>
                <c:pt idx="2085">
                  <c:v>0.17708860210596758</c:v>
                </c:pt>
                <c:pt idx="2086">
                  <c:v>-1.4791052682446421E-2</c:v>
                </c:pt>
                <c:pt idx="2087">
                  <c:v>0.19861987321921495</c:v>
                </c:pt>
                <c:pt idx="2088">
                  <c:v>-0.23141336499911191</c:v>
                </c:pt>
                <c:pt idx="2089">
                  <c:v>0.77281468749919358</c:v>
                </c:pt>
                <c:pt idx="2090">
                  <c:v>-9.8814506307260339E-2</c:v>
                </c:pt>
                <c:pt idx="2091">
                  <c:v>-0.23582372364407178</c:v>
                </c:pt>
                <c:pt idx="2092">
                  <c:v>0.203890227146661</c:v>
                </c:pt>
                <c:pt idx="2093">
                  <c:v>-0.38514883757789642</c:v>
                </c:pt>
                <c:pt idx="2094">
                  <c:v>8.6535744325324474E-4</c:v>
                </c:pt>
                <c:pt idx="2095">
                  <c:v>0.87750868867149467</c:v>
                </c:pt>
                <c:pt idx="2096">
                  <c:v>6.9152201869422988E-2</c:v>
                </c:pt>
                <c:pt idx="2097">
                  <c:v>0.15730246631897368</c:v>
                </c:pt>
                <c:pt idx="2098">
                  <c:v>0.14143279092929553</c:v>
                </c:pt>
                <c:pt idx="2099">
                  <c:v>0.46529538939579645</c:v>
                </c:pt>
                <c:pt idx="2100">
                  <c:v>-4.3497222229955772E-2</c:v>
                </c:pt>
                <c:pt idx="2101">
                  <c:v>7.5737982394078154E-2</c:v>
                </c:pt>
                <c:pt idx="2102">
                  <c:v>0.4811955929289537</c:v>
                </c:pt>
                <c:pt idx="2103">
                  <c:v>0.53893540877333124</c:v>
                </c:pt>
                <c:pt idx="2104">
                  <c:v>-7.445624130150659E-2</c:v>
                </c:pt>
                <c:pt idx="2105">
                  <c:v>-0.69245489810041372</c:v>
                </c:pt>
                <c:pt idx="2106">
                  <c:v>0.36781834360619331</c:v>
                </c:pt>
                <c:pt idx="2107">
                  <c:v>-0.69362108928903699</c:v>
                </c:pt>
                <c:pt idx="2108">
                  <c:v>-0.21792698456614754</c:v>
                </c:pt>
                <c:pt idx="2109">
                  <c:v>0.2311866132278648</c:v>
                </c:pt>
                <c:pt idx="2110">
                  <c:v>-0.26603833669107946</c:v>
                </c:pt>
                <c:pt idx="2111">
                  <c:v>8.1066880491888524E-2</c:v>
                </c:pt>
                <c:pt idx="2112">
                  <c:v>0.38338634619901596</c:v>
                </c:pt>
                <c:pt idx="2113">
                  <c:v>0.86457246275713251</c:v>
                </c:pt>
                <c:pt idx="2114">
                  <c:v>-0.23446525363702297</c:v>
                </c:pt>
                <c:pt idx="2115">
                  <c:v>-0.14003045177897405</c:v>
                </c:pt>
                <c:pt idx="2116">
                  <c:v>0.3409609845188627</c:v>
                </c:pt>
                <c:pt idx="2117">
                  <c:v>0.72691838630480077</c:v>
                </c:pt>
                <c:pt idx="2118">
                  <c:v>0.4789200482286573</c:v>
                </c:pt>
                <c:pt idx="2119">
                  <c:v>9.4236069845765533E-2</c:v>
                </c:pt>
                <c:pt idx="2120">
                  <c:v>-0.13875921474032632</c:v>
                </c:pt>
                <c:pt idx="2121">
                  <c:v>-9.7116037073810862E-2</c:v>
                </c:pt>
                <c:pt idx="2122">
                  <c:v>-1.1462438241563651</c:v>
                </c:pt>
                <c:pt idx="2123">
                  <c:v>0.32169724521235366</c:v>
                </c:pt>
                <c:pt idx="2124">
                  <c:v>-0.14736188292101099</c:v>
                </c:pt>
                <c:pt idx="2125">
                  <c:v>-0.30115922979279047</c:v>
                </c:pt>
                <c:pt idx="2126">
                  <c:v>-9.9123533842101319E-2</c:v>
                </c:pt>
                <c:pt idx="2127">
                  <c:v>0.14077865578279594</c:v>
                </c:pt>
                <c:pt idx="2128">
                  <c:v>0.10835717809041853</c:v>
                </c:pt>
                <c:pt idx="2129">
                  <c:v>-0.82367722735953708</c:v>
                </c:pt>
                <c:pt idx="2130">
                  <c:v>0.1950955771772184</c:v>
                </c:pt>
                <c:pt idx="2131">
                  <c:v>6.4331046245983931E-2</c:v>
                </c:pt>
                <c:pt idx="2132">
                  <c:v>0.49538817357282244</c:v>
                </c:pt>
                <c:pt idx="2133">
                  <c:v>-0.49268739558806196</c:v>
                </c:pt>
                <c:pt idx="2134">
                  <c:v>0.33742566428268811</c:v>
                </c:pt>
                <c:pt idx="2135">
                  <c:v>-0.3817613444045454</c:v>
                </c:pt>
                <c:pt idx="2136">
                  <c:v>0.11849262586940462</c:v>
                </c:pt>
                <c:pt idx="2137">
                  <c:v>0.17849156782231052</c:v>
                </c:pt>
                <c:pt idx="2138">
                  <c:v>0.33571191032046199</c:v>
                </c:pt>
                <c:pt idx="2139">
                  <c:v>0.50161748054298283</c:v>
                </c:pt>
                <c:pt idx="2140">
                  <c:v>-0.20473176572406224</c:v>
                </c:pt>
                <c:pt idx="2141">
                  <c:v>-3.4308050775295314E-2</c:v>
                </c:pt>
                <c:pt idx="2142">
                  <c:v>3.491998434915955E-2</c:v>
                </c:pt>
                <c:pt idx="2143">
                  <c:v>-0.39725808671760915</c:v>
                </c:pt>
                <c:pt idx="2144">
                  <c:v>0.62928666953335766</c:v>
                </c:pt>
                <c:pt idx="2145">
                  <c:v>7.0114502661328182E-2</c:v>
                </c:pt>
                <c:pt idx="2146">
                  <c:v>0.19547359238726494</c:v>
                </c:pt>
                <c:pt idx="2147">
                  <c:v>0.78366618090782858</c:v>
                </c:pt>
                <c:pt idx="2148">
                  <c:v>-0.11138337293185398</c:v>
                </c:pt>
                <c:pt idx="2149">
                  <c:v>0.18814768692643399</c:v>
                </c:pt>
                <c:pt idx="2150">
                  <c:v>0.19736218414916346</c:v>
                </c:pt>
                <c:pt idx="2151">
                  <c:v>0.6141915585252915</c:v>
                </c:pt>
                <c:pt idx="2152">
                  <c:v>3.7461392328946375E-3</c:v>
                </c:pt>
                <c:pt idx="2153">
                  <c:v>-0.43109232587260399</c:v>
                </c:pt>
                <c:pt idx="2154">
                  <c:v>-0.12831403169641201</c:v>
                </c:pt>
                <c:pt idx="2155">
                  <c:v>-0.10687081398278779</c:v>
                </c:pt>
                <c:pt idx="2156">
                  <c:v>0.26050747780475469</c:v>
                </c:pt>
                <c:pt idx="2157">
                  <c:v>-0.17266872938773947</c:v>
                </c:pt>
                <c:pt idx="2158">
                  <c:v>1.4069582501655862E-2</c:v>
                </c:pt>
                <c:pt idx="2159">
                  <c:v>5.5612156686692518E-2</c:v>
                </c:pt>
                <c:pt idx="2160">
                  <c:v>0.2046415656104211</c:v>
                </c:pt>
                <c:pt idx="2161">
                  <c:v>1.1307991108381943</c:v>
                </c:pt>
                <c:pt idx="2162">
                  <c:v>0.10070858859668395</c:v>
                </c:pt>
                <c:pt idx="2163">
                  <c:v>-1.0291463456595165</c:v>
                </c:pt>
                <c:pt idx="2164">
                  <c:v>0.46978180680686438</c:v>
                </c:pt>
                <c:pt idx="2165">
                  <c:v>0.36982938015392897</c:v>
                </c:pt>
                <c:pt idx="2166">
                  <c:v>-2.7086823481222041E-2</c:v>
                </c:pt>
                <c:pt idx="2167">
                  <c:v>-0.63084065393546851</c:v>
                </c:pt>
                <c:pt idx="2168">
                  <c:v>0.23474655174432221</c:v>
                </c:pt>
                <c:pt idx="2169">
                  <c:v>-0.97341237765191591</c:v>
                </c:pt>
                <c:pt idx="2170">
                  <c:v>-0.11216282891325889</c:v>
                </c:pt>
                <c:pt idx="2171">
                  <c:v>0.6528765148096225</c:v>
                </c:pt>
                <c:pt idx="2172">
                  <c:v>-6.1450726233945659E-2</c:v>
                </c:pt>
                <c:pt idx="2173">
                  <c:v>0.2199583975849177</c:v>
                </c:pt>
                <c:pt idx="2174">
                  <c:v>0.27453004467162329</c:v>
                </c:pt>
                <c:pt idx="2175">
                  <c:v>3.9419183133397186E-2</c:v>
                </c:pt>
                <c:pt idx="2176">
                  <c:v>0.28534303015925572</c:v>
                </c:pt>
                <c:pt idx="2177">
                  <c:v>1.5354834293464041E-2</c:v>
                </c:pt>
                <c:pt idx="2178">
                  <c:v>0.43306626961761574</c:v>
                </c:pt>
                <c:pt idx="2179">
                  <c:v>-1.0715640252329111E-2</c:v>
                </c:pt>
                <c:pt idx="2180">
                  <c:v>0.28806320032531629</c:v>
                </c:pt>
                <c:pt idx="2181">
                  <c:v>0.11076412189980746</c:v>
                </c:pt>
                <c:pt idx="2182">
                  <c:v>7.0526720876682436E-2</c:v>
                </c:pt>
                <c:pt idx="2183">
                  <c:v>0.16414264884830632</c:v>
                </c:pt>
                <c:pt idx="2184">
                  <c:v>-1.88780102056894E-2</c:v>
                </c:pt>
                <c:pt idx="2185">
                  <c:v>-0.28788850053372333</c:v>
                </c:pt>
                <c:pt idx="2186">
                  <c:v>-0.73937209187330155</c:v>
                </c:pt>
                <c:pt idx="2187">
                  <c:v>-0.16456094677587454</c:v>
                </c:pt>
                <c:pt idx="2188">
                  <c:v>8.0111859861598189E-2</c:v>
                </c:pt>
                <c:pt idx="2189">
                  <c:v>1.3069150019521305E-2</c:v>
                </c:pt>
                <c:pt idx="2190">
                  <c:v>-0.38364230300330965</c:v>
                </c:pt>
                <c:pt idx="2191">
                  <c:v>0.89328454003027236</c:v>
                </c:pt>
                <c:pt idx="2192">
                  <c:v>0.26291417623741697</c:v>
                </c:pt>
                <c:pt idx="2193">
                  <c:v>-0.56853749722137059</c:v>
                </c:pt>
                <c:pt idx="2194">
                  <c:v>0.13592881552640673</c:v>
                </c:pt>
                <c:pt idx="2195">
                  <c:v>0.41218535915670679</c:v>
                </c:pt>
                <c:pt idx="2196">
                  <c:v>4.8794180260804912E-2</c:v>
                </c:pt>
                <c:pt idx="2197">
                  <c:v>1.1638756246893662E-2</c:v>
                </c:pt>
                <c:pt idx="2198">
                  <c:v>-0.12595063624477434</c:v>
                </c:pt>
                <c:pt idx="2199">
                  <c:v>0.12459282540582266</c:v>
                </c:pt>
                <c:pt idx="2200">
                  <c:v>0.20238637533478931</c:v>
                </c:pt>
                <c:pt idx="2201">
                  <c:v>-0.27945885245340113</c:v>
                </c:pt>
                <c:pt idx="2202">
                  <c:v>0.20113196690788698</c:v>
                </c:pt>
                <c:pt idx="2203">
                  <c:v>0.32481060342048368</c:v>
                </c:pt>
                <c:pt idx="2204">
                  <c:v>6.0047383669938899E-2</c:v>
                </c:pt>
                <c:pt idx="2205">
                  <c:v>-2.0047842048330423E-2</c:v>
                </c:pt>
                <c:pt idx="2206">
                  <c:v>5.1163252582114578E-2</c:v>
                </c:pt>
                <c:pt idx="2207">
                  <c:v>-0.35291578737104634</c:v>
                </c:pt>
                <c:pt idx="2208">
                  <c:v>0.39396527566024264</c:v>
                </c:pt>
                <c:pt idx="2209">
                  <c:v>-8.5894762881528142E-2</c:v>
                </c:pt>
                <c:pt idx="2210">
                  <c:v>-0.12689552987590236</c:v>
                </c:pt>
                <c:pt idx="2211">
                  <c:v>0.10688428869154284</c:v>
                </c:pt>
                <c:pt idx="2212">
                  <c:v>-0.25136702780870268</c:v>
                </c:pt>
                <c:pt idx="2213">
                  <c:v>-5.5741240386646497E-2</c:v>
                </c:pt>
                <c:pt idx="2214">
                  <c:v>0.1552311162992788</c:v>
                </c:pt>
                <c:pt idx="2215">
                  <c:v>0.33113192221720217</c:v>
                </c:pt>
                <c:pt idx="2216">
                  <c:v>-0.43381806630183517</c:v>
                </c:pt>
                <c:pt idx="2217">
                  <c:v>-1.2606364403338443E-2</c:v>
                </c:pt>
                <c:pt idx="2218">
                  <c:v>-0.18573670860021829</c:v>
                </c:pt>
                <c:pt idx="2219">
                  <c:v>-0.14353214049052646</c:v>
                </c:pt>
                <c:pt idx="2220">
                  <c:v>-1.0688464694797741</c:v>
                </c:pt>
                <c:pt idx="2221">
                  <c:v>-0.25016542558727101</c:v>
                </c:pt>
                <c:pt idx="2222">
                  <c:v>-0.14305413671756714</c:v>
                </c:pt>
                <c:pt idx="2223">
                  <c:v>0.30847737659496088</c:v>
                </c:pt>
                <c:pt idx="2224">
                  <c:v>0.27762774765900544</c:v>
                </c:pt>
                <c:pt idx="2225">
                  <c:v>0.14012422390907067</c:v>
                </c:pt>
                <c:pt idx="2226">
                  <c:v>-0.16844699637366267</c:v>
                </c:pt>
                <c:pt idx="2227">
                  <c:v>0.46016589467643088</c:v>
                </c:pt>
                <c:pt idx="2228">
                  <c:v>6.2674362763392485E-2</c:v>
                </c:pt>
                <c:pt idx="2229">
                  <c:v>0.32481060342048368</c:v>
                </c:pt>
                <c:pt idx="2230">
                  <c:v>-9.7733430916929001E-2</c:v>
                </c:pt>
                <c:pt idx="2231">
                  <c:v>0.33685463912546515</c:v>
                </c:pt>
                <c:pt idx="2232">
                  <c:v>9.2883965678484434E-2</c:v>
                </c:pt>
                <c:pt idx="2233">
                  <c:v>0.55591429424339844</c:v>
                </c:pt>
                <c:pt idx="2234">
                  <c:v>0.26086873861567933</c:v>
                </c:pt>
                <c:pt idx="2235">
                  <c:v>0.24598236099132045</c:v>
                </c:pt>
                <c:pt idx="2236">
                  <c:v>-0.54140801184814435</c:v>
                </c:pt>
                <c:pt idx="2237">
                  <c:v>1.3133619593922186</c:v>
                </c:pt>
                <c:pt idx="2238">
                  <c:v>0.31231665440199746</c:v>
                </c:pt>
                <c:pt idx="2239">
                  <c:v>-0.20024953829911005</c:v>
                </c:pt>
                <c:pt idx="2240">
                  <c:v>0.55944286597807813</c:v>
                </c:pt>
                <c:pt idx="2241">
                  <c:v>0.53426085593167449</c:v>
                </c:pt>
                <c:pt idx="2242">
                  <c:v>0.10312831621722547</c:v>
                </c:pt>
                <c:pt idx="2243">
                  <c:v>0.81155323303354143</c:v>
                </c:pt>
                <c:pt idx="2244">
                  <c:v>-0.81451399587192197</c:v>
                </c:pt>
                <c:pt idx="2245">
                  <c:v>7.2860401931244947E-2</c:v>
                </c:pt>
                <c:pt idx="2246">
                  <c:v>-3.1208812116408833E-2</c:v>
                </c:pt>
                <c:pt idx="2247">
                  <c:v>0.65104020699359144</c:v>
                </c:pt>
                <c:pt idx="2248">
                  <c:v>-4.9456933445478336E-2</c:v>
                </c:pt>
                <c:pt idx="2249">
                  <c:v>0.2458607018403533</c:v>
                </c:pt>
                <c:pt idx="2250">
                  <c:v>0.13986236801564098</c:v>
                </c:pt>
                <c:pt idx="2251">
                  <c:v>-0.44339891834615297</c:v>
                </c:pt>
                <c:pt idx="2252">
                  <c:v>-0.18688580865371102</c:v>
                </c:pt>
                <c:pt idx="2253">
                  <c:v>-1.2880646430210785</c:v>
                </c:pt>
                <c:pt idx="2254">
                  <c:v>-0.24212334025210375</c:v>
                </c:pt>
                <c:pt idx="2255">
                  <c:v>0.14613382889337501</c:v>
                </c:pt>
                <c:pt idx="2256">
                  <c:v>-0.27875860002325281</c:v>
                </c:pt>
                <c:pt idx="2257">
                  <c:v>1.8349309878891815E-2</c:v>
                </c:pt>
                <c:pt idx="2258">
                  <c:v>0.37995359742763618</c:v>
                </c:pt>
                <c:pt idx="2259">
                  <c:v>0.92523990548741053</c:v>
                </c:pt>
                <c:pt idx="2260">
                  <c:v>0.51581335736197775</c:v>
                </c:pt>
                <c:pt idx="2261">
                  <c:v>0.23167816179851056</c:v>
                </c:pt>
                <c:pt idx="2262">
                  <c:v>0.57966289701600737</c:v>
                </c:pt>
                <c:pt idx="2263">
                  <c:v>0.26411602155924535</c:v>
                </c:pt>
                <c:pt idx="2264">
                  <c:v>0.10889240163240912</c:v>
                </c:pt>
                <c:pt idx="2265">
                  <c:v>7.9838880666670442E-2</c:v>
                </c:pt>
                <c:pt idx="2266">
                  <c:v>0.18307357621485193</c:v>
                </c:pt>
                <c:pt idx="2267">
                  <c:v>-0.84970029189831797</c:v>
                </c:pt>
                <c:pt idx="2268">
                  <c:v>0.30626223972785072</c:v>
                </c:pt>
                <c:pt idx="2269">
                  <c:v>0.19761380969107431</c:v>
                </c:pt>
                <c:pt idx="2270">
                  <c:v>0.23976462651094677</c:v>
                </c:pt>
                <c:pt idx="2271">
                  <c:v>-1.2990276927772837</c:v>
                </c:pt>
                <c:pt idx="2272">
                  <c:v>0.10151561549124424</c:v>
                </c:pt>
                <c:pt idx="2273">
                  <c:v>-0.3808217839409308</c:v>
                </c:pt>
                <c:pt idx="2274">
                  <c:v>8.5016673488713876E-2</c:v>
                </c:pt>
                <c:pt idx="2275">
                  <c:v>-0.57540033776917432</c:v>
                </c:pt>
                <c:pt idx="2276">
                  <c:v>9.9901110007942689E-2</c:v>
                </c:pt>
                <c:pt idx="2277">
                  <c:v>0.28593480794387272</c:v>
                </c:pt>
                <c:pt idx="2278">
                  <c:v>0.86844972037690937</c:v>
                </c:pt>
                <c:pt idx="2279">
                  <c:v>9.777121611529915E-3</c:v>
                </c:pt>
                <c:pt idx="2280">
                  <c:v>0.92478400564449859</c:v>
                </c:pt>
                <c:pt idx="2281">
                  <c:v>0.87954894308077625</c:v>
                </c:pt>
                <c:pt idx="2282">
                  <c:v>0.11756206925697886</c:v>
                </c:pt>
                <c:pt idx="2283">
                  <c:v>4.2224073762984898E-2</c:v>
                </c:pt>
                <c:pt idx="2284">
                  <c:v>8.1748651234167885E-2</c:v>
                </c:pt>
                <c:pt idx="2285">
                  <c:v>2.0342179517185827E-2</c:v>
                </c:pt>
                <c:pt idx="2286">
                  <c:v>-0.27491327536977322</c:v>
                </c:pt>
                <c:pt idx="2287">
                  <c:v>0.45775186872739343</c:v>
                </c:pt>
                <c:pt idx="2288">
                  <c:v>-6.0397279643956275E-2</c:v>
                </c:pt>
                <c:pt idx="2289">
                  <c:v>0.35366204474506335</c:v>
                </c:pt>
                <c:pt idx="2290">
                  <c:v>0.27488781157758291</c:v>
                </c:pt>
                <c:pt idx="2291">
                  <c:v>-0.16504613092064882</c:v>
                </c:pt>
                <c:pt idx="2292">
                  <c:v>0.30742852519224734</c:v>
                </c:pt>
                <c:pt idx="2293">
                  <c:v>2.8286243079109982E-2</c:v>
                </c:pt>
                <c:pt idx="2294">
                  <c:v>-6.5672221684630466E-2</c:v>
                </c:pt>
                <c:pt idx="2295">
                  <c:v>0.26927257804501381</c:v>
                </c:pt>
                <c:pt idx="2296">
                  <c:v>0.12802938874064107</c:v>
                </c:pt>
                <c:pt idx="2297">
                  <c:v>-9.1417634521186258E-2</c:v>
                </c:pt>
                <c:pt idx="2298">
                  <c:v>-0.16359106772026177</c:v>
                </c:pt>
                <c:pt idx="2299">
                  <c:v>0.22650852980867975</c:v>
                </c:pt>
                <c:pt idx="2300">
                  <c:v>-0.31473259348315835</c:v>
                </c:pt>
                <c:pt idx="2301">
                  <c:v>6.7225672531971578E-2</c:v>
                </c:pt>
                <c:pt idx="2302">
                  <c:v>0.53396196534515139</c:v>
                </c:pt>
                <c:pt idx="2303">
                  <c:v>0.12194373351040128</c:v>
                </c:pt>
                <c:pt idx="2304">
                  <c:v>-0.44969032124490399</c:v>
                </c:pt>
                <c:pt idx="2305">
                  <c:v>3.8576651452323155E-2</c:v>
                </c:pt>
                <c:pt idx="2306">
                  <c:v>0.15211850443194314</c:v>
                </c:pt>
                <c:pt idx="2307">
                  <c:v>0.37061069349059284</c:v>
                </c:pt>
                <c:pt idx="2308">
                  <c:v>0.23278353412245326</c:v>
                </c:pt>
                <c:pt idx="2309">
                  <c:v>0.35749570322523405</c:v>
                </c:pt>
                <c:pt idx="2310">
                  <c:v>-0.52056246726459654</c:v>
                </c:pt>
                <c:pt idx="2311">
                  <c:v>1.2107628941863102</c:v>
                </c:pt>
                <c:pt idx="2312">
                  <c:v>-0.31904558635424107</c:v>
                </c:pt>
                <c:pt idx="2313">
                  <c:v>-0.45997273074249273</c:v>
                </c:pt>
                <c:pt idx="2314">
                  <c:v>0.46100460993347425</c:v>
                </c:pt>
                <c:pt idx="2315">
                  <c:v>0.14548182226552472</c:v>
                </c:pt>
                <c:pt idx="2316">
                  <c:v>-0.10252721272912138</c:v>
                </c:pt>
                <c:pt idx="2317">
                  <c:v>1.3075451018995865</c:v>
                </c:pt>
                <c:pt idx="2318">
                  <c:v>-0.65539871696332286</c:v>
                </c:pt>
                <c:pt idx="2319">
                  <c:v>1.8491749039879199E-2</c:v>
                </c:pt>
                <c:pt idx="2320">
                  <c:v>-0.20423305221760774</c:v>
                </c:pt>
                <c:pt idx="2321">
                  <c:v>-0.11747432721280061</c:v>
                </c:pt>
                <c:pt idx="2322">
                  <c:v>0.11902410314227461</c:v>
                </c:pt>
                <c:pt idx="2323">
                  <c:v>9.6936482502957083E-2</c:v>
                </c:pt>
                <c:pt idx="2324">
                  <c:v>0.11663091203630645</c:v>
                </c:pt>
                <c:pt idx="2325">
                  <c:v>0.45280626256250056</c:v>
                </c:pt>
                <c:pt idx="2326">
                  <c:v>-0.75999103526492973</c:v>
                </c:pt>
                <c:pt idx="2327">
                  <c:v>-2.3709692435232362E-2</c:v>
                </c:pt>
                <c:pt idx="2328">
                  <c:v>-0.13352717028415231</c:v>
                </c:pt>
                <c:pt idx="2329">
                  <c:v>5.9770581090254599E-2</c:v>
                </c:pt>
                <c:pt idx="2330">
                  <c:v>-0.20889442958747079</c:v>
                </c:pt>
                <c:pt idx="2331">
                  <c:v>0.23229236208914866</c:v>
                </c:pt>
                <c:pt idx="2332">
                  <c:v>-0.45166202449137977</c:v>
                </c:pt>
                <c:pt idx="2333">
                  <c:v>0.43573525887346848</c:v>
                </c:pt>
                <c:pt idx="2334">
                  <c:v>0.32077347694587044</c:v>
                </c:pt>
                <c:pt idx="2335">
                  <c:v>-0.10842527490344586</c:v>
                </c:pt>
                <c:pt idx="2336">
                  <c:v>0.16208110338237527</c:v>
                </c:pt>
                <c:pt idx="2337">
                  <c:v>-0.13844158042797131</c:v>
                </c:pt>
                <c:pt idx="2338">
                  <c:v>0.18142064028014168</c:v>
                </c:pt>
                <c:pt idx="2339">
                  <c:v>0.11196608960349229</c:v>
                </c:pt>
                <c:pt idx="2340">
                  <c:v>0.15042969819420526</c:v>
                </c:pt>
                <c:pt idx="2341">
                  <c:v>0.21387604338294247</c:v>
                </c:pt>
                <c:pt idx="2342">
                  <c:v>0.10715219863491048</c:v>
                </c:pt>
                <c:pt idx="2343">
                  <c:v>0.74794589274462164</c:v>
                </c:pt>
                <c:pt idx="2344">
                  <c:v>0.28344770837797978</c:v>
                </c:pt>
                <c:pt idx="2345">
                  <c:v>-0.23395615698730485</c:v>
                </c:pt>
                <c:pt idx="2346">
                  <c:v>-0.24536899975575791</c:v>
                </c:pt>
                <c:pt idx="2347">
                  <c:v>0.71184727766994771</c:v>
                </c:pt>
                <c:pt idx="2348">
                  <c:v>5.3806443695793821E-2</c:v>
                </c:pt>
                <c:pt idx="2349">
                  <c:v>0.73048779926377627</c:v>
                </c:pt>
                <c:pt idx="2350">
                  <c:v>-5.2446046792589351E-2</c:v>
                </c:pt>
                <c:pt idx="2351">
                  <c:v>-0.13495221077404998</c:v>
                </c:pt>
                <c:pt idx="2352">
                  <c:v>0.29865831556451516</c:v>
                </c:pt>
                <c:pt idx="2353">
                  <c:v>0.30684550031428276</c:v>
                </c:pt>
                <c:pt idx="2354">
                  <c:v>7.6011738569641274E-2</c:v>
                </c:pt>
                <c:pt idx="2355">
                  <c:v>-0.3159892183726889</c:v>
                </c:pt>
                <c:pt idx="2356">
                  <c:v>-0.22280124285048297</c:v>
                </c:pt>
                <c:pt idx="2357">
                  <c:v>-0.54940896807481132</c:v>
                </c:pt>
                <c:pt idx="2358">
                  <c:v>-0.77472507013043068</c:v>
                </c:pt>
                <c:pt idx="2359">
                  <c:v>-0.35715982521331457</c:v>
                </c:pt>
                <c:pt idx="2360">
                  <c:v>-0.12610807554660453</c:v>
                </c:pt>
                <c:pt idx="2361">
                  <c:v>4.5862297908687961E-2</c:v>
                </c:pt>
                <c:pt idx="2362">
                  <c:v>0.17670573818911434</c:v>
                </c:pt>
                <c:pt idx="2363">
                  <c:v>-3.5638336753265436E-2</c:v>
                </c:pt>
                <c:pt idx="2364">
                  <c:v>0.26663664251398955</c:v>
                </c:pt>
                <c:pt idx="2365">
                  <c:v>9.6801581849168691E-2</c:v>
                </c:pt>
                <c:pt idx="2366">
                  <c:v>0.12750121921583699</c:v>
                </c:pt>
                <c:pt idx="2367">
                  <c:v>0.10017031975697704</c:v>
                </c:pt>
                <c:pt idx="2368">
                  <c:v>0.16104922490055676</c:v>
                </c:pt>
                <c:pt idx="2369">
                  <c:v>0.55709144399869526</c:v>
                </c:pt>
                <c:pt idx="2370">
                  <c:v>5.0406167005301369E-3</c:v>
                </c:pt>
                <c:pt idx="2371">
                  <c:v>0.19987646683658047</c:v>
                </c:pt>
                <c:pt idx="2372">
                  <c:v>0.49610437977073235</c:v>
                </c:pt>
                <c:pt idx="2373">
                  <c:v>-0.282263266002518</c:v>
                </c:pt>
                <c:pt idx="2374">
                  <c:v>0.23707417130215752</c:v>
                </c:pt>
                <c:pt idx="2375">
                  <c:v>0.19433924948446313</c:v>
                </c:pt>
                <c:pt idx="2376">
                  <c:v>-6.3710705351344391E-2</c:v>
                </c:pt>
                <c:pt idx="2377">
                  <c:v>-0.40870356555679338</c:v>
                </c:pt>
                <c:pt idx="2378">
                  <c:v>0.52336121930409563</c:v>
                </c:pt>
                <c:pt idx="2379">
                  <c:v>-0.43772093637013354</c:v>
                </c:pt>
                <c:pt idx="2380">
                  <c:v>0.1575611760911883</c:v>
                </c:pt>
                <c:pt idx="2381">
                  <c:v>-6.930050411480064E-2</c:v>
                </c:pt>
                <c:pt idx="2382">
                  <c:v>-0.24075892824272166</c:v>
                </c:pt>
                <c:pt idx="2383">
                  <c:v>-0.25256963166353985</c:v>
                </c:pt>
                <c:pt idx="2384">
                  <c:v>0.77997406106575684</c:v>
                </c:pt>
                <c:pt idx="2385">
                  <c:v>0.25290002870008066</c:v>
                </c:pt>
                <c:pt idx="2386">
                  <c:v>-0.25670047211174335</c:v>
                </c:pt>
                <c:pt idx="2387">
                  <c:v>0.23057194190465208</c:v>
                </c:pt>
                <c:pt idx="2388">
                  <c:v>-0.17935128064281186</c:v>
                </c:pt>
                <c:pt idx="2389">
                  <c:v>-0.15072126746921974</c:v>
                </c:pt>
                <c:pt idx="2390">
                  <c:v>0.24452177363205552</c:v>
                </c:pt>
                <c:pt idx="2391">
                  <c:v>-0.61440330398775445</c:v>
                </c:pt>
                <c:pt idx="2392">
                  <c:v>7.769594145917668E-3</c:v>
                </c:pt>
                <c:pt idx="2393">
                  <c:v>-0.18393282709782408</c:v>
                </c:pt>
                <c:pt idx="2394">
                  <c:v>0.44498503952237534</c:v>
                </c:pt>
                <c:pt idx="2395">
                  <c:v>0.47103134427152771</c:v>
                </c:pt>
                <c:pt idx="2396">
                  <c:v>0.39736488547837867</c:v>
                </c:pt>
                <c:pt idx="2397">
                  <c:v>0.19861987321921495</c:v>
                </c:pt>
                <c:pt idx="2398">
                  <c:v>0.30940904924011919</c:v>
                </c:pt>
                <c:pt idx="2399">
                  <c:v>0.26183165875213665</c:v>
                </c:pt>
                <c:pt idx="2400">
                  <c:v>-1.0191703792493263</c:v>
                </c:pt>
                <c:pt idx="2401">
                  <c:v>0.30076803328030882</c:v>
                </c:pt>
                <c:pt idx="2402">
                  <c:v>0.55944286597807813</c:v>
                </c:pt>
                <c:pt idx="2403">
                  <c:v>0.4014120253638086</c:v>
                </c:pt>
                <c:pt idx="2404">
                  <c:v>-0.4060248206794444</c:v>
                </c:pt>
                <c:pt idx="2405">
                  <c:v>-0.17023160671646545</c:v>
                </c:pt>
                <c:pt idx="2406">
                  <c:v>3.9699917720951411E-2</c:v>
                </c:pt>
                <c:pt idx="2407">
                  <c:v>-1.0917250815209409</c:v>
                </c:pt>
                <c:pt idx="2408">
                  <c:v>-1.045133690098103</c:v>
                </c:pt>
                <c:pt idx="2409">
                  <c:v>0.66657482357904596</c:v>
                </c:pt>
                <c:pt idx="2410">
                  <c:v>-0.5636249177554612</c:v>
                </c:pt>
                <c:pt idx="2411">
                  <c:v>-1.6249351645074812E-2</c:v>
                </c:pt>
                <c:pt idx="2412">
                  <c:v>-0.36810414094619553</c:v>
                </c:pt>
                <c:pt idx="2413">
                  <c:v>-0.54035855007138833</c:v>
                </c:pt>
                <c:pt idx="2414">
                  <c:v>-0.37594590888989948</c:v>
                </c:pt>
                <c:pt idx="2415">
                  <c:v>0.28238049463860565</c:v>
                </c:pt>
                <c:pt idx="2416">
                  <c:v>0.52596862103308861</c:v>
                </c:pt>
                <c:pt idx="2417">
                  <c:v>0.20564274194545723</c:v>
                </c:pt>
                <c:pt idx="2418">
                  <c:v>-0.3159892183726889</c:v>
                </c:pt>
                <c:pt idx="2419">
                  <c:v>-0.13416034784133754</c:v>
                </c:pt>
                <c:pt idx="2420">
                  <c:v>0.82415684372882914</c:v>
                </c:pt>
                <c:pt idx="2421">
                  <c:v>-2.1656672181143929E-3</c:v>
                </c:pt>
                <c:pt idx="2422">
                  <c:v>-0.15762451179371229</c:v>
                </c:pt>
                <c:pt idx="2423">
                  <c:v>0.10205338272918787</c:v>
                </c:pt>
                <c:pt idx="2424">
                  <c:v>-0.24896482333213796</c:v>
                </c:pt>
                <c:pt idx="2425">
                  <c:v>-8.6201035049303931E-2</c:v>
                </c:pt>
                <c:pt idx="2426">
                  <c:v>0.39714579739278089</c:v>
                </c:pt>
                <c:pt idx="2427">
                  <c:v>0.40446719676308956</c:v>
                </c:pt>
                <c:pt idx="2428">
                  <c:v>0.32941067121856837</c:v>
                </c:pt>
                <c:pt idx="2429">
                  <c:v>-0.1073369764212953</c:v>
                </c:pt>
                <c:pt idx="2430">
                  <c:v>-4.1898939054238315E-3</c:v>
                </c:pt>
                <c:pt idx="2431">
                  <c:v>0.58274867062130375</c:v>
                </c:pt>
                <c:pt idx="2432">
                  <c:v>0.50345050900556887</c:v>
                </c:pt>
                <c:pt idx="2433">
                  <c:v>0.77441810410581269</c:v>
                </c:pt>
                <c:pt idx="2434">
                  <c:v>0.19648114898230806</c:v>
                </c:pt>
                <c:pt idx="2435">
                  <c:v>-1.1006359657018591E-2</c:v>
                </c:pt>
                <c:pt idx="2436">
                  <c:v>1.7779412561234692E-2</c:v>
                </c:pt>
                <c:pt idx="2437">
                  <c:v>0.41413553298445122</c:v>
                </c:pt>
                <c:pt idx="2438">
                  <c:v>-0.23005903958551285</c:v>
                </c:pt>
                <c:pt idx="2439">
                  <c:v>0.26399588207123914</c:v>
                </c:pt>
                <c:pt idx="2440">
                  <c:v>0.35839626195665403</c:v>
                </c:pt>
                <c:pt idx="2441">
                  <c:v>0.34993137336011471</c:v>
                </c:pt>
                <c:pt idx="2442">
                  <c:v>-7.8116637466875902E-3</c:v>
                </c:pt>
                <c:pt idx="2443">
                  <c:v>0.68320237296636765</c:v>
                </c:pt>
                <c:pt idx="2444">
                  <c:v>0.15769051358205341</c:v>
                </c:pt>
                <c:pt idx="2445">
                  <c:v>0.23388806017427727</c:v>
                </c:pt>
                <c:pt idx="2446">
                  <c:v>-0.17641366529118754</c:v>
                </c:pt>
                <c:pt idx="2447">
                  <c:v>-2.4589921285533417E-2</c:v>
                </c:pt>
                <c:pt idx="2448">
                  <c:v>-0.21223323006143255</c:v>
                </c:pt>
                <c:pt idx="2449">
                  <c:v>-0.17641366529118754</c:v>
                </c:pt>
                <c:pt idx="2450">
                  <c:v>3.8717107572853585E-2</c:v>
                </c:pt>
                <c:pt idx="2451">
                  <c:v>0.19685880136635622</c:v>
                </c:pt>
                <c:pt idx="2452">
                  <c:v>0.45659590512621256</c:v>
                </c:pt>
                <c:pt idx="2453">
                  <c:v>-0.45719717257261111</c:v>
                </c:pt>
                <c:pt idx="2454">
                  <c:v>-2.0633113878218808E-2</c:v>
                </c:pt>
                <c:pt idx="2455">
                  <c:v>0.1552311162992788</c:v>
                </c:pt>
                <c:pt idx="2456">
                  <c:v>-0.73552361999229965</c:v>
                </c:pt>
                <c:pt idx="2457">
                  <c:v>-5.9043977614659619E-2</c:v>
                </c:pt>
                <c:pt idx="2458">
                  <c:v>-0.75462603738183764</c:v>
                </c:pt>
                <c:pt idx="2459">
                  <c:v>0.16040392586001362</c:v>
                </c:pt>
                <c:pt idx="2460">
                  <c:v>-0.39592867633113921</c:v>
                </c:pt>
                <c:pt idx="2461">
                  <c:v>-3.5342611623422178E-2</c:v>
                </c:pt>
                <c:pt idx="2462">
                  <c:v>0.41218535915670679</c:v>
                </c:pt>
                <c:pt idx="2463">
                  <c:v>0.37350901551800741</c:v>
                </c:pt>
                <c:pt idx="2464">
                  <c:v>7.0526720876682436E-2</c:v>
                </c:pt>
                <c:pt idx="2465">
                  <c:v>0.4640408718898868</c:v>
                </c:pt>
                <c:pt idx="2466">
                  <c:v>-3.5490466611088241E-2</c:v>
                </c:pt>
                <c:pt idx="2467">
                  <c:v>-0.23327764078860663</c:v>
                </c:pt>
                <c:pt idx="2468">
                  <c:v>0.3307878362655241</c:v>
                </c:pt>
                <c:pt idx="2469">
                  <c:v>0.37973184903480972</c:v>
                </c:pt>
                <c:pt idx="2470">
                  <c:v>-0.15585541894065663</c:v>
                </c:pt>
                <c:pt idx="2471">
                  <c:v>0.38868550749531394</c:v>
                </c:pt>
                <c:pt idx="2472">
                  <c:v>-0.2404180267664453</c:v>
                </c:pt>
                <c:pt idx="2473">
                  <c:v>0.17261552181347775</c:v>
                </c:pt>
                <c:pt idx="2474">
                  <c:v>-0.87276293807518557</c:v>
                </c:pt>
                <c:pt idx="2475">
                  <c:v>1.9488429591360157E-2</c:v>
                </c:pt>
                <c:pt idx="2476">
                  <c:v>-0.65676275271657947</c:v>
                </c:pt>
                <c:pt idx="2477">
                  <c:v>-1.6687128932879054E-2</c:v>
                </c:pt>
                <c:pt idx="2478">
                  <c:v>1.1495638837829439E-2</c:v>
                </c:pt>
                <c:pt idx="2479">
                  <c:v>-8.5282413534096893E-2</c:v>
                </c:pt>
                <c:pt idx="2480">
                  <c:v>-0.11372300538291501</c:v>
                </c:pt>
                <c:pt idx="2481">
                  <c:v>0.26363540356832926</c:v>
                </c:pt>
                <c:pt idx="2482">
                  <c:v>0.44710306829726071</c:v>
                </c:pt>
                <c:pt idx="2483">
                  <c:v>0.44328837481714339</c:v>
                </c:pt>
                <c:pt idx="2484">
                  <c:v>-0.2150772984371388</c:v>
                </c:pt>
                <c:pt idx="2485">
                  <c:v>0.11689701828826239</c:v>
                </c:pt>
                <c:pt idx="2486">
                  <c:v>2.1337582965694914E-2</c:v>
                </c:pt>
                <c:pt idx="2487">
                  <c:v>0.46946925326726557</c:v>
                </c:pt>
                <c:pt idx="2488">
                  <c:v>-0.10376690779220243</c:v>
                </c:pt>
                <c:pt idx="2489">
                  <c:v>-0.36922178725713822</c:v>
                </c:pt>
                <c:pt idx="2490">
                  <c:v>0.14077865578279594</c:v>
                </c:pt>
                <c:pt idx="2491">
                  <c:v>0.24439999124554931</c:v>
                </c:pt>
                <c:pt idx="2492">
                  <c:v>-7.3089693247113494E-2</c:v>
                </c:pt>
                <c:pt idx="2493">
                  <c:v>0.18370881687541188</c:v>
                </c:pt>
                <c:pt idx="2494">
                  <c:v>-9.6985834312939643E-3</c:v>
                </c:pt>
                <c:pt idx="2495">
                  <c:v>0.11156554495951765</c:v>
                </c:pt>
                <c:pt idx="2496">
                  <c:v>0.38371811463577504</c:v>
                </c:pt>
                <c:pt idx="2497">
                  <c:v>0.25978468468297838</c:v>
                </c:pt>
                <c:pt idx="2498">
                  <c:v>0.39856927559498334</c:v>
                </c:pt>
                <c:pt idx="2499">
                  <c:v>-0.34062340452408874</c:v>
                </c:pt>
                <c:pt idx="2500">
                  <c:v>0.25217341320202702</c:v>
                </c:pt>
                <c:pt idx="2501">
                  <c:v>-0.18508049069448126</c:v>
                </c:pt>
                <c:pt idx="2502">
                  <c:v>-0.14752167635761326</c:v>
                </c:pt>
                <c:pt idx="2503">
                  <c:v>4.8375704538976265E-2</c:v>
                </c:pt>
                <c:pt idx="2504">
                  <c:v>0.50355227566458116</c:v>
                </c:pt>
                <c:pt idx="2505">
                  <c:v>-0.248793390257147</c:v>
                </c:pt>
                <c:pt idx="2506">
                  <c:v>0.27964957855708572</c:v>
                </c:pt>
                <c:pt idx="2507">
                  <c:v>4.3484497603579468E-2</c:v>
                </c:pt>
                <c:pt idx="2508">
                  <c:v>5.9493725391671554E-2</c:v>
                </c:pt>
                <c:pt idx="2509">
                  <c:v>3.3370138460592183E-2</c:v>
                </c:pt>
                <c:pt idx="2510">
                  <c:v>-0.19875855173154142</c:v>
                </c:pt>
                <c:pt idx="2511">
                  <c:v>0.3520805137298626</c:v>
                </c:pt>
                <c:pt idx="2512">
                  <c:v>-0.19396471676378066</c:v>
                </c:pt>
                <c:pt idx="2513">
                  <c:v>-2.5769059458500982</c:v>
                </c:pt>
                <c:pt idx="2514">
                  <c:v>0.11169907219742027</c:v>
                </c:pt>
                <c:pt idx="2515">
                  <c:v>-0.1648843847417823</c:v>
                </c:pt>
                <c:pt idx="2516">
                  <c:v>0.25144643155858187</c:v>
                </c:pt>
                <c:pt idx="2517">
                  <c:v>-7.4152452072991204E-2</c:v>
                </c:pt>
                <c:pt idx="2518">
                  <c:v>-0.17120596180137768</c:v>
                </c:pt>
                <c:pt idx="2519">
                  <c:v>6.5296567127780952E-2</c:v>
                </c:pt>
                <c:pt idx="2520">
                  <c:v>2.0183605343056252E-3</c:v>
                </c:pt>
                <c:pt idx="2521">
                  <c:v>-0.40506933018760816</c:v>
                </c:pt>
                <c:pt idx="2522">
                  <c:v>0.30544527855355263</c:v>
                </c:pt>
                <c:pt idx="2523">
                  <c:v>-8.1613765553652129E-2</c:v>
                </c:pt>
                <c:pt idx="2524">
                  <c:v>-0.1548913727698765</c:v>
                </c:pt>
                <c:pt idx="2525">
                  <c:v>-0.22600367488882686</c:v>
                </c:pt>
                <c:pt idx="2526">
                  <c:v>0.11129845340254099</c:v>
                </c:pt>
                <c:pt idx="2527">
                  <c:v>-0.4943122810656303</c:v>
                </c:pt>
                <c:pt idx="2528">
                  <c:v>0.11769504266975458</c:v>
                </c:pt>
                <c:pt idx="2529">
                  <c:v>0.14391580307144478</c:v>
                </c:pt>
                <c:pt idx="2530">
                  <c:v>3.8900274333718426E-3</c:v>
                </c:pt>
                <c:pt idx="2531">
                  <c:v>-0.71430187404187495</c:v>
                </c:pt>
                <c:pt idx="2532">
                  <c:v>4.4603950649767972E-2</c:v>
                </c:pt>
                <c:pt idx="2533">
                  <c:v>-0.11653558189767754</c:v>
                </c:pt>
                <c:pt idx="2534">
                  <c:v>0.25652762689220954</c:v>
                </c:pt>
                <c:pt idx="2535">
                  <c:v>-0.16052407850624451</c:v>
                </c:pt>
                <c:pt idx="2536">
                  <c:v>-0.19958668736124272</c:v>
                </c:pt>
                <c:pt idx="2537">
                  <c:v>-1.4499569695115091E-2</c:v>
                </c:pt>
                <c:pt idx="2538">
                  <c:v>0.22070141650652012</c:v>
                </c:pt>
                <c:pt idx="2539">
                  <c:v>-0.46096529702924571</c:v>
                </c:pt>
                <c:pt idx="2540">
                  <c:v>-5.1698187649364617E-2</c:v>
                </c:pt>
                <c:pt idx="2541">
                  <c:v>0.28095631383105635</c:v>
                </c:pt>
                <c:pt idx="2542">
                  <c:v>0.47103134427152771</c:v>
                </c:pt>
                <c:pt idx="2543">
                  <c:v>0.14925936549962288</c:v>
                </c:pt>
                <c:pt idx="2544">
                  <c:v>9.4776556895597316E-2</c:v>
                </c:pt>
                <c:pt idx="2545">
                  <c:v>5.9493725391671554E-2</c:v>
                </c:pt>
                <c:pt idx="2546">
                  <c:v>-0.12092162883126943</c:v>
                </c:pt>
                <c:pt idx="2547">
                  <c:v>0.52707033551266058</c:v>
                </c:pt>
                <c:pt idx="2548">
                  <c:v>-0.23192156498354455</c:v>
                </c:pt>
                <c:pt idx="2549">
                  <c:v>3.8576651452323155E-2</c:v>
                </c:pt>
                <c:pt idx="2550">
                  <c:v>0.84671394067147665</c:v>
                </c:pt>
                <c:pt idx="2551">
                  <c:v>-0.28542476114837428</c:v>
                </c:pt>
                <c:pt idx="2552">
                  <c:v>0.15704371014558005</c:v>
                </c:pt>
                <c:pt idx="2553">
                  <c:v>0.50548447951149522</c:v>
                </c:pt>
                <c:pt idx="2554">
                  <c:v>-0.24485604151359347</c:v>
                </c:pt>
                <c:pt idx="2555">
                  <c:v>6.3339337220504853E-3</c:v>
                </c:pt>
                <c:pt idx="2556">
                  <c:v>0.75154941479160597</c:v>
                </c:pt>
                <c:pt idx="2557">
                  <c:v>-0.11747432721280061</c:v>
                </c:pt>
                <c:pt idx="2558">
                  <c:v>-0.1548913727698765</c:v>
                </c:pt>
                <c:pt idx="2559">
                  <c:v>-0.15601615595167342</c:v>
                </c:pt>
                <c:pt idx="2560">
                  <c:v>-0.45146473286154909</c:v>
                </c:pt>
                <c:pt idx="2561">
                  <c:v>-0.21173191713316272</c:v>
                </c:pt>
                <c:pt idx="2562">
                  <c:v>-0.26222672274106046</c:v>
                </c:pt>
                <c:pt idx="2563">
                  <c:v>-0.43498781910177525</c:v>
                </c:pt>
                <c:pt idx="2564">
                  <c:v>-3.8747115941792303E-2</c:v>
                </c:pt>
                <c:pt idx="2565">
                  <c:v>2.8144767713378684E-2</c:v>
                </c:pt>
                <c:pt idx="2566">
                  <c:v>3.2100843167024079E-2</c:v>
                </c:pt>
                <c:pt idx="2567">
                  <c:v>0.71475105934308569</c:v>
                </c:pt>
                <c:pt idx="2568">
                  <c:v>0.32596199617185229</c:v>
                </c:pt>
                <c:pt idx="2569">
                  <c:v>9.3695380233557043E-2</c:v>
                </c:pt>
                <c:pt idx="2570">
                  <c:v>1.8123750005659496</c:v>
                </c:pt>
                <c:pt idx="2571">
                  <c:v>1.6496319896195974E-2</c:v>
                </c:pt>
                <c:pt idx="2572">
                  <c:v>0.36647609351009564</c:v>
                </c:pt>
                <c:pt idx="2573">
                  <c:v>-4.2753986398315645E-2</c:v>
                </c:pt>
                <c:pt idx="2574">
                  <c:v>0.36333931162947919</c:v>
                </c:pt>
                <c:pt idx="2575">
                  <c:v>0.10969486482592983</c:v>
                </c:pt>
                <c:pt idx="2576">
                  <c:v>-0.23514432874529573</c:v>
                </c:pt>
                <c:pt idx="2577">
                  <c:v>-9.4649100419041649E-2</c:v>
                </c:pt>
                <c:pt idx="2578">
                  <c:v>0.57918014812715013</c:v>
                </c:pt>
                <c:pt idx="2579">
                  <c:v>0.1738949605643148</c:v>
                </c:pt>
                <c:pt idx="2580">
                  <c:v>8.5968453862165048E-2</c:v>
                </c:pt>
                <c:pt idx="2581">
                  <c:v>-0.51086814714728279</c:v>
                </c:pt>
                <c:pt idx="2582">
                  <c:v>0.24561735275638444</c:v>
                </c:pt>
                <c:pt idx="2583">
                  <c:v>-2.4443179176787795E-2</c:v>
                </c:pt>
                <c:pt idx="2584">
                  <c:v>0.23670690199535252</c:v>
                </c:pt>
                <c:pt idx="2585">
                  <c:v>6.3364878758429374E-2</c:v>
                </c:pt>
                <c:pt idx="2586">
                  <c:v>0.30532853203996363</c:v>
                </c:pt>
                <c:pt idx="2587">
                  <c:v>-0.22398025935252983</c:v>
                </c:pt>
                <c:pt idx="2588">
                  <c:v>-0.2735175127349504</c:v>
                </c:pt>
                <c:pt idx="2589">
                  <c:v>0.12498976997866353</c:v>
                </c:pt>
                <c:pt idx="2590">
                  <c:v>-0.24502700733009838</c:v>
                </c:pt>
                <c:pt idx="2591">
                  <c:v>-0.36512797683578568</c:v>
                </c:pt>
                <c:pt idx="2592">
                  <c:v>0.4680097740928324</c:v>
                </c:pt>
                <c:pt idx="2593">
                  <c:v>-0.26760054046136283</c:v>
                </c:pt>
                <c:pt idx="2594">
                  <c:v>-1.2467377807321431</c:v>
                </c:pt>
                <c:pt idx="2595">
                  <c:v>0.35366204474506335</c:v>
                </c:pt>
                <c:pt idx="2596">
                  <c:v>-0.49817873457908973</c:v>
                </c:pt>
                <c:pt idx="2597">
                  <c:v>0.35027092422840367</c:v>
                </c:pt>
                <c:pt idx="2598">
                  <c:v>0.3373114773309574</c:v>
                </c:pt>
                <c:pt idx="2599">
                  <c:v>0.30193876696533578</c:v>
                </c:pt>
                <c:pt idx="2600">
                  <c:v>6.3339337220504853E-3</c:v>
                </c:pt>
                <c:pt idx="2601">
                  <c:v>-0.14448862342559837</c:v>
                </c:pt>
                <c:pt idx="2602">
                  <c:v>7.1076162010958899E-2</c:v>
                </c:pt>
                <c:pt idx="2603">
                  <c:v>8.9904868421335535E-2</c:v>
                </c:pt>
                <c:pt idx="2604">
                  <c:v>-2.8557610682609706E-2</c:v>
                </c:pt>
                <c:pt idx="2605">
                  <c:v>0.35963361304804037</c:v>
                </c:pt>
                <c:pt idx="2606">
                  <c:v>-0.39573886052389368</c:v>
                </c:pt>
                <c:pt idx="2607">
                  <c:v>3.6022366801955253E-3</c:v>
                </c:pt>
                <c:pt idx="2608">
                  <c:v>-1.0613001867606637</c:v>
                </c:pt>
                <c:pt idx="2609">
                  <c:v>0.28770868624541718</c:v>
                </c:pt>
                <c:pt idx="2610">
                  <c:v>0.55247544449103292</c:v>
                </c:pt>
                <c:pt idx="2611">
                  <c:v>-3.4308050775295314E-2</c:v>
                </c:pt>
                <c:pt idx="2612">
                  <c:v>0.86108194187488474</c:v>
                </c:pt>
                <c:pt idx="2613">
                  <c:v>0.55109760615911008</c:v>
                </c:pt>
                <c:pt idx="2614">
                  <c:v>4.9909522443057998E-2</c:v>
                </c:pt>
                <c:pt idx="2615">
                  <c:v>-1.2477652193803557</c:v>
                </c:pt>
                <c:pt idx="2616">
                  <c:v>0.41986245037752395</c:v>
                </c:pt>
                <c:pt idx="2617">
                  <c:v>0.21859520155085696</c:v>
                </c:pt>
                <c:pt idx="2618">
                  <c:v>7.4779426496613344E-2</c:v>
                </c:pt>
                <c:pt idx="2619">
                  <c:v>0.25616527726305621</c:v>
                </c:pt>
                <c:pt idx="2620">
                  <c:v>-0.11450372678347603</c:v>
                </c:pt>
                <c:pt idx="2621">
                  <c:v>0.26038703742893748</c:v>
                </c:pt>
                <c:pt idx="2622">
                  <c:v>0.97283967275919558</c:v>
                </c:pt>
                <c:pt idx="2623">
                  <c:v>1.3069150019521305E-2</c:v>
                </c:pt>
                <c:pt idx="2624">
                  <c:v>0.81876877314400776</c:v>
                </c:pt>
                <c:pt idx="2625">
                  <c:v>0.15704371014558005</c:v>
                </c:pt>
                <c:pt idx="2626">
                  <c:v>-9.8196649749256168E-2</c:v>
                </c:pt>
                <c:pt idx="2627">
                  <c:v>3.0689204071140411E-2</c:v>
                </c:pt>
                <c:pt idx="2628">
                  <c:v>0.4156505144147305</c:v>
                </c:pt>
                <c:pt idx="2629">
                  <c:v>0.41186007373781969</c:v>
                </c:pt>
                <c:pt idx="2630">
                  <c:v>-2.2976578419310063E-2</c:v>
                </c:pt>
                <c:pt idx="2631">
                  <c:v>0.31080543106317299</c:v>
                </c:pt>
                <c:pt idx="2632">
                  <c:v>8.7055434543375734E-2</c:v>
                </c:pt>
                <c:pt idx="2633">
                  <c:v>-0.30293791950260873</c:v>
                </c:pt>
                <c:pt idx="2634">
                  <c:v>0.41705585981314924</c:v>
                </c:pt>
                <c:pt idx="2635">
                  <c:v>-0.2735175127349504</c:v>
                </c:pt>
                <c:pt idx="2636">
                  <c:v>-0.30062605022125632</c:v>
                </c:pt>
                <c:pt idx="2637">
                  <c:v>-0.80440042455009653</c:v>
                </c:pt>
                <c:pt idx="2638">
                  <c:v>0.15510155812570256</c:v>
                </c:pt>
                <c:pt idx="2639">
                  <c:v>-3.4012598175268485E-2</c:v>
                </c:pt>
                <c:pt idx="2640">
                  <c:v>0.37873355926538038</c:v>
                </c:pt>
                <c:pt idx="2641">
                  <c:v>-7.8106710405880533E-2</c:v>
                </c:pt>
                <c:pt idx="2642">
                  <c:v>-0.13463541344276173</c:v>
                </c:pt>
                <c:pt idx="2643">
                  <c:v>3.1112840850249287E-2</c:v>
                </c:pt>
                <c:pt idx="2644">
                  <c:v>-0.46017118937694679</c:v>
                </c:pt>
                <c:pt idx="2645">
                  <c:v>0.46142378478668494</c:v>
                </c:pt>
                <c:pt idx="2646">
                  <c:v>0.35907131228834427</c:v>
                </c:pt>
                <c:pt idx="2647">
                  <c:v>0.19396093689782179</c:v>
                </c:pt>
                <c:pt idx="2648">
                  <c:v>5.7554246458089021E-2</c:v>
                </c:pt>
                <c:pt idx="2649">
                  <c:v>0.55198351041838067</c:v>
                </c:pt>
                <c:pt idx="2650">
                  <c:v>-0.25859773408040998</c:v>
                </c:pt>
                <c:pt idx="2651">
                  <c:v>-1.4645303827355665E-2</c:v>
                </c:pt>
                <c:pt idx="2652">
                  <c:v>1.8918982163051733E-2</c:v>
                </c:pt>
                <c:pt idx="2653">
                  <c:v>0.11196608960349229</c:v>
                </c:pt>
                <c:pt idx="2654">
                  <c:v>0.46351783412869663</c:v>
                </c:pt>
                <c:pt idx="2655">
                  <c:v>0.44477306552245122</c:v>
                </c:pt>
                <c:pt idx="2656">
                  <c:v>0.14417692434652662</c:v>
                </c:pt>
                <c:pt idx="2657">
                  <c:v>0.19080446812700094</c:v>
                </c:pt>
                <c:pt idx="2658">
                  <c:v>0.90988828477647721</c:v>
                </c:pt>
                <c:pt idx="2659">
                  <c:v>0.31857715379607932</c:v>
                </c:pt>
                <c:pt idx="2660">
                  <c:v>0.69403326608512561</c:v>
                </c:pt>
                <c:pt idx="2661">
                  <c:v>0.36759472196102905</c:v>
                </c:pt>
                <c:pt idx="2662">
                  <c:v>0.22490464410609018</c:v>
                </c:pt>
                <c:pt idx="2663">
                  <c:v>2.8710585954140094E-2</c:v>
                </c:pt>
                <c:pt idx="2664">
                  <c:v>0.22687840419626878</c:v>
                </c:pt>
                <c:pt idx="2665">
                  <c:v>-0.23565384492254604</c:v>
                </c:pt>
                <c:pt idx="2666">
                  <c:v>-1.3947901559188582</c:v>
                </c:pt>
                <c:pt idx="2667">
                  <c:v>0.67011518128429448</c:v>
                </c:pt>
                <c:pt idx="2668">
                  <c:v>-0.12626553203144172</c:v>
                </c:pt>
                <c:pt idx="2669">
                  <c:v>1.106620140620535E-2</c:v>
                </c:pt>
                <c:pt idx="2670">
                  <c:v>3.0830430153274507E-2</c:v>
                </c:pt>
                <c:pt idx="2671">
                  <c:v>-0.35549762758106423</c:v>
                </c:pt>
                <c:pt idx="2672">
                  <c:v>0.76799371761187507</c:v>
                </c:pt>
                <c:pt idx="2673">
                  <c:v>0.31312973483785173</c:v>
                </c:pt>
                <c:pt idx="2674">
                  <c:v>0.51187280747404262</c:v>
                </c:pt>
                <c:pt idx="2675">
                  <c:v>-0.10423206821567078</c:v>
                </c:pt>
                <c:pt idx="2676">
                  <c:v>0.30812784417874139</c:v>
                </c:pt>
                <c:pt idx="2677">
                  <c:v>0.14938944935894988</c:v>
                </c:pt>
                <c:pt idx="2678">
                  <c:v>-0.22819891561572453</c:v>
                </c:pt>
                <c:pt idx="2679">
                  <c:v>0.33330922957489645</c:v>
                </c:pt>
                <c:pt idx="2680">
                  <c:v>7.5053364604507275E-2</c:v>
                </c:pt>
                <c:pt idx="2681">
                  <c:v>0.3386811246245463</c:v>
                </c:pt>
                <c:pt idx="2682">
                  <c:v>-0.25756255462373434</c:v>
                </c:pt>
                <c:pt idx="2683">
                  <c:v>-1.5872726614083572</c:v>
                </c:pt>
                <c:pt idx="2684">
                  <c:v>-6.7938828656575564E-2</c:v>
                </c:pt>
                <c:pt idx="2685">
                  <c:v>0.68140428581282975</c:v>
                </c:pt>
                <c:pt idx="2686">
                  <c:v>-0.1964422977279868</c:v>
                </c:pt>
                <c:pt idx="2687">
                  <c:v>0.20614306969137305</c:v>
                </c:pt>
                <c:pt idx="2688">
                  <c:v>0.34562346417512851</c:v>
                </c:pt>
                <c:pt idx="2689">
                  <c:v>0.68176408257032506</c:v>
                </c:pt>
                <c:pt idx="2690">
                  <c:v>1.1890338243900169</c:v>
                </c:pt>
                <c:pt idx="2691">
                  <c:v>0.14574266027760549</c:v>
                </c:pt>
                <c:pt idx="2692">
                  <c:v>9.9766486292929807E-2</c:v>
                </c:pt>
                <c:pt idx="2693">
                  <c:v>0.56071495447447905</c:v>
                </c:pt>
                <c:pt idx="2694">
                  <c:v>7.7242998932460352E-2</c:v>
                </c:pt>
                <c:pt idx="2695">
                  <c:v>5.3281206952817016E-3</c:v>
                </c:pt>
                <c:pt idx="2696">
                  <c:v>-0.25670047211174335</c:v>
                </c:pt>
                <c:pt idx="2697">
                  <c:v>-9.6190441421302994E-2</c:v>
                </c:pt>
                <c:pt idx="2698">
                  <c:v>4.6979908144409395E-2</c:v>
                </c:pt>
                <c:pt idx="2699">
                  <c:v>-2.8557610682609706E-2</c:v>
                </c:pt>
                <c:pt idx="2700">
                  <c:v>0.26939227894040618</c:v>
                </c:pt>
                <c:pt idx="2701">
                  <c:v>-0.31706719728278437</c:v>
                </c:pt>
                <c:pt idx="2702">
                  <c:v>0.15717309403346449</c:v>
                </c:pt>
                <c:pt idx="2703">
                  <c:v>0.26279393662065453</c:v>
                </c:pt>
                <c:pt idx="2704">
                  <c:v>0.22786427254650743</c:v>
                </c:pt>
                <c:pt idx="2705">
                  <c:v>1.4426229109453829E-4</c:v>
                </c:pt>
                <c:pt idx="2706">
                  <c:v>8.5560624872625515E-2</c:v>
                </c:pt>
                <c:pt idx="2707">
                  <c:v>0.31938671454410283</c:v>
                </c:pt>
                <c:pt idx="2708">
                  <c:v>0.13474665536848754</c:v>
                </c:pt>
                <c:pt idx="2709">
                  <c:v>0.315798063043357</c:v>
                </c:pt>
                <c:pt idx="2710">
                  <c:v>0.57879383267675266</c:v>
                </c:pt>
                <c:pt idx="2711">
                  <c:v>-0.33006616433103936</c:v>
                </c:pt>
                <c:pt idx="2712">
                  <c:v>0.41878363851173855</c:v>
                </c:pt>
                <c:pt idx="2713">
                  <c:v>-5.4092702789747427E-2</c:v>
                </c:pt>
                <c:pt idx="2714">
                  <c:v>0.13711000780235091</c:v>
                </c:pt>
                <c:pt idx="2715">
                  <c:v>0.1738949605643148</c:v>
                </c:pt>
                <c:pt idx="2716">
                  <c:v>0.35264554528092595</c:v>
                </c:pt>
                <c:pt idx="2717">
                  <c:v>0.15691431465323905</c:v>
                </c:pt>
                <c:pt idx="2718">
                  <c:v>0.3330801940067239</c:v>
                </c:pt>
                <c:pt idx="2719">
                  <c:v>6.3502942306157953E-2</c:v>
                </c:pt>
                <c:pt idx="2720">
                  <c:v>6.7087964801146954E-2</c:v>
                </c:pt>
                <c:pt idx="2721">
                  <c:v>0.23927582588255761</c:v>
                </c:pt>
                <c:pt idx="2722">
                  <c:v>0.25411024187472092</c:v>
                </c:pt>
                <c:pt idx="2723">
                  <c:v>0.36714737465794428</c:v>
                </c:pt>
                <c:pt idx="2724">
                  <c:v>-0.84840091773060344</c:v>
                </c:pt>
                <c:pt idx="2725">
                  <c:v>4.670058674162228E-2</c:v>
                </c:pt>
                <c:pt idx="2726">
                  <c:v>0.14613382889337501</c:v>
                </c:pt>
                <c:pt idx="2727">
                  <c:v>3.7461392328946375E-3</c:v>
                </c:pt>
                <c:pt idx="2728">
                  <c:v>0.10996225339881809</c:v>
                </c:pt>
                <c:pt idx="2729">
                  <c:v>0.38261192301518759</c:v>
                </c:pt>
                <c:pt idx="2730">
                  <c:v>-0.43070335443835533</c:v>
                </c:pt>
                <c:pt idx="2731">
                  <c:v>-0.24297675349254044</c:v>
                </c:pt>
                <c:pt idx="2732">
                  <c:v>-0.28982725172033835</c:v>
                </c:pt>
                <c:pt idx="2733">
                  <c:v>0.53276578338685276</c:v>
                </c:pt>
                <c:pt idx="2734">
                  <c:v>-0.13257792469169477</c:v>
                </c:pt>
                <c:pt idx="2735">
                  <c:v>0.23646200383810367</c:v>
                </c:pt>
                <c:pt idx="2736">
                  <c:v>-0.15024087619748916</c:v>
                </c:pt>
                <c:pt idx="2737">
                  <c:v>0.20163386116965043</c:v>
                </c:pt>
                <c:pt idx="2738">
                  <c:v>-3.4160316911985761E-2</c:v>
                </c:pt>
                <c:pt idx="2739">
                  <c:v>0.19307782154636707</c:v>
                </c:pt>
                <c:pt idx="2740">
                  <c:v>0.23670690199535252</c:v>
                </c:pt>
                <c:pt idx="2741">
                  <c:v>-0.11528487090396689</c:v>
                </c:pt>
                <c:pt idx="2742">
                  <c:v>-0.15344651031471868</c:v>
                </c:pt>
                <c:pt idx="2743">
                  <c:v>0.17210342844013979</c:v>
                </c:pt>
                <c:pt idx="2744">
                  <c:v>-0.13463541344276173</c:v>
                </c:pt>
                <c:pt idx="2745">
                  <c:v>0.28534303015925572</c:v>
                </c:pt>
                <c:pt idx="2746">
                  <c:v>2.9134804053022847E-2</c:v>
                </c:pt>
                <c:pt idx="2747">
                  <c:v>0.34244096377917466</c:v>
                </c:pt>
                <c:pt idx="2748">
                  <c:v>3.421571533791299E-2</c:v>
                </c:pt>
                <c:pt idx="2749">
                  <c:v>-0.76243628168232436</c:v>
                </c:pt>
                <c:pt idx="2750">
                  <c:v>0.37806764878003413</c:v>
                </c:pt>
                <c:pt idx="2751">
                  <c:v>0.17338332121472341</c:v>
                </c:pt>
                <c:pt idx="2752">
                  <c:v>0.5951216919961716</c:v>
                </c:pt>
                <c:pt idx="2753">
                  <c:v>-0.36178711457659374</c:v>
                </c:pt>
                <c:pt idx="2754">
                  <c:v>-0.17023160671646545</c:v>
                </c:pt>
                <c:pt idx="2755">
                  <c:v>-0.29141544286207516</c:v>
                </c:pt>
                <c:pt idx="2756">
                  <c:v>-0.10392194460293558</c:v>
                </c:pt>
                <c:pt idx="2757">
                  <c:v>3.2100843167024079E-2</c:v>
                </c:pt>
                <c:pt idx="2758">
                  <c:v>-4.6656605600930732</c:v>
                </c:pt>
                <c:pt idx="2759">
                  <c:v>0.23462394136385586</c:v>
                </c:pt>
                <c:pt idx="2760">
                  <c:v>-0.16893348939492731</c:v>
                </c:pt>
                <c:pt idx="2761">
                  <c:v>0.21113682698227515</c:v>
                </c:pt>
                <c:pt idx="2762">
                  <c:v>-0.29300538429134881</c:v>
                </c:pt>
                <c:pt idx="2763">
                  <c:v>-0.27718427366296466</c:v>
                </c:pt>
                <c:pt idx="2764">
                  <c:v>0.15367564979723761</c:v>
                </c:pt>
                <c:pt idx="2765">
                  <c:v>-0.39422123246453605</c:v>
                </c:pt>
                <c:pt idx="2766">
                  <c:v>-0.1101371186348213</c:v>
                </c:pt>
                <c:pt idx="2767">
                  <c:v>-2.7822029653627511E-2</c:v>
                </c:pt>
                <c:pt idx="2768">
                  <c:v>7.0519425164900255E-3</c:v>
                </c:pt>
                <c:pt idx="2769">
                  <c:v>3.6327491817765054E-2</c:v>
                </c:pt>
                <c:pt idx="2770">
                  <c:v>0.10527578341568687</c:v>
                </c:pt>
                <c:pt idx="2771">
                  <c:v>0.48212546407999074</c:v>
                </c:pt>
                <c:pt idx="2772">
                  <c:v>0.11450029316519267</c:v>
                </c:pt>
                <c:pt idx="2773">
                  <c:v>0.25084033356164537</c:v>
                </c:pt>
                <c:pt idx="2774">
                  <c:v>0.44742050459049681</c:v>
                </c:pt>
                <c:pt idx="2775">
                  <c:v>0.24768451276238293</c:v>
                </c:pt>
                <c:pt idx="2776">
                  <c:v>0.20000206602186754</c:v>
                </c:pt>
                <c:pt idx="2777">
                  <c:v>-0.27893363126894993</c:v>
                </c:pt>
                <c:pt idx="2778">
                  <c:v>-6.5672221684630466E-2</c:v>
                </c:pt>
                <c:pt idx="2779">
                  <c:v>3.8155201025968831E-2</c:v>
                </c:pt>
                <c:pt idx="2780">
                  <c:v>0.2841587458694001</c:v>
                </c:pt>
                <c:pt idx="2781">
                  <c:v>0.32146635859252998</c:v>
                </c:pt>
                <c:pt idx="2782">
                  <c:v>-0.14768148749495644</c:v>
                </c:pt>
                <c:pt idx="2783">
                  <c:v>0.41131776833697148</c:v>
                </c:pt>
                <c:pt idx="2784">
                  <c:v>-0.75633091903313743</c:v>
                </c:pt>
                <c:pt idx="2785">
                  <c:v>-0.41369161189047277</c:v>
                </c:pt>
                <c:pt idx="2786">
                  <c:v>0.3126651735583944</c:v>
                </c:pt>
                <c:pt idx="2787">
                  <c:v>5.0745463581398975E-2</c:v>
                </c:pt>
                <c:pt idx="2788">
                  <c:v>-0.39175848673728125</c:v>
                </c:pt>
                <c:pt idx="2789">
                  <c:v>3.5905383742127948E-2</c:v>
                </c:pt>
                <c:pt idx="2790">
                  <c:v>-0.48297632793541928</c:v>
                </c:pt>
                <c:pt idx="2791">
                  <c:v>-0.46534071958612205</c:v>
                </c:pt>
                <c:pt idx="2792">
                  <c:v>-0.25618346976222583</c:v>
                </c:pt>
                <c:pt idx="2793">
                  <c:v>1.4212444812104711E-2</c:v>
                </c:pt>
                <c:pt idx="2794">
                  <c:v>0.73734064612219563</c:v>
                </c:pt>
                <c:pt idx="2795">
                  <c:v>0.18192943769006684</c:v>
                </c:pt>
                <c:pt idx="2796">
                  <c:v>0.30754510189958634</c:v>
                </c:pt>
                <c:pt idx="2797">
                  <c:v>0.2945472338955149</c:v>
                </c:pt>
                <c:pt idx="2798">
                  <c:v>-7.0966521354143594E-2</c:v>
                </c:pt>
                <c:pt idx="2799">
                  <c:v>3.4583197724110796E-3</c:v>
                </c:pt>
                <c:pt idx="2800">
                  <c:v>0.12234140752611965</c:v>
                </c:pt>
                <c:pt idx="2801">
                  <c:v>0.17912882877215228</c:v>
                </c:pt>
                <c:pt idx="2802">
                  <c:v>-1.8074270586130774</c:v>
                </c:pt>
                <c:pt idx="2803">
                  <c:v>-0.65290132937773171</c:v>
                </c:pt>
                <c:pt idx="2804">
                  <c:v>0.82146532380582549</c:v>
                </c:pt>
                <c:pt idx="2805">
                  <c:v>0.1437852247086015</c:v>
                </c:pt>
                <c:pt idx="2806">
                  <c:v>-5.2595665153199515E-2</c:v>
                </c:pt>
                <c:pt idx="2807">
                  <c:v>0.13040376165803888</c:v>
                </c:pt>
                <c:pt idx="2808">
                  <c:v>-7.0511962181904642E-2</c:v>
                </c:pt>
                <c:pt idx="2809">
                  <c:v>-1.3902450378275566</c:v>
                </c:pt>
                <c:pt idx="2810">
                  <c:v>1.2068023309090343E-2</c:v>
                </c:pt>
                <c:pt idx="2811">
                  <c:v>-0.18524451719012613</c:v>
                </c:pt>
                <c:pt idx="2812">
                  <c:v>0.1086248146816487</c:v>
                </c:pt>
                <c:pt idx="2813">
                  <c:v>-0.46813200439444519</c:v>
                </c:pt>
                <c:pt idx="2814">
                  <c:v>-0.15633768370894113</c:v>
                </c:pt>
                <c:pt idx="2815">
                  <c:v>-0.54687755340418753</c:v>
                </c:pt>
                <c:pt idx="2816">
                  <c:v>0.2076430126865326</c:v>
                </c:pt>
                <c:pt idx="2817">
                  <c:v>0.37928824997192856</c:v>
                </c:pt>
                <c:pt idx="2818">
                  <c:v>6.1568849268002809E-2</c:v>
                </c:pt>
                <c:pt idx="2819">
                  <c:v>-0.21893410156403686</c:v>
                </c:pt>
                <c:pt idx="2820">
                  <c:v>7.4779426496613344E-2</c:v>
                </c:pt>
                <c:pt idx="2821">
                  <c:v>9.2207438097088895E-2</c:v>
                </c:pt>
                <c:pt idx="2822">
                  <c:v>-0.54414019061381502</c:v>
                </c:pt>
                <c:pt idx="2823">
                  <c:v>-0.63039392996816213</c:v>
                </c:pt>
                <c:pt idx="2824">
                  <c:v>-0.15762451179371229</c:v>
                </c:pt>
                <c:pt idx="2825">
                  <c:v>1.9773069040027156E-2</c:v>
                </c:pt>
                <c:pt idx="2826">
                  <c:v>2.0057652341253479E-2</c:v>
                </c:pt>
                <c:pt idx="2827">
                  <c:v>0.13606010688026618</c:v>
                </c:pt>
                <c:pt idx="2828">
                  <c:v>0.16208110338237527</c:v>
                </c:pt>
                <c:pt idx="2829">
                  <c:v>0.13251103979919548</c:v>
                </c:pt>
                <c:pt idx="2830">
                  <c:v>0.30147058748990185</c:v>
                </c:pt>
                <c:pt idx="2831">
                  <c:v>0.78014208983847044</c:v>
                </c:pt>
                <c:pt idx="2832">
                  <c:v>-0.28050986879970646</c:v>
                </c:pt>
                <c:pt idx="2833">
                  <c:v>0.10272531001108826</c:v>
                </c:pt>
                <c:pt idx="2834">
                  <c:v>0.10339692449223131</c:v>
                </c:pt>
                <c:pt idx="2835">
                  <c:v>0.31695666818183055</c:v>
                </c:pt>
                <c:pt idx="2836">
                  <c:v>-0.1124747292584125</c:v>
                </c:pt>
                <c:pt idx="2837">
                  <c:v>-0.1101371186348213</c:v>
                </c:pt>
                <c:pt idx="2838">
                  <c:v>-0.1694201465224594</c:v>
                </c:pt>
                <c:pt idx="2839">
                  <c:v>-0.13971253748925902</c:v>
                </c:pt>
                <c:pt idx="2840">
                  <c:v>0.21636173497112735</c:v>
                </c:pt>
                <c:pt idx="2841">
                  <c:v>0.1738949605643148</c:v>
                </c:pt>
                <c:pt idx="2842">
                  <c:v>0.30451104180995309</c:v>
                </c:pt>
                <c:pt idx="2843">
                  <c:v>0.28344770837797978</c:v>
                </c:pt>
                <c:pt idx="2844">
                  <c:v>0.47394272984657354</c:v>
                </c:pt>
                <c:pt idx="2845">
                  <c:v>0.32941067121856837</c:v>
                </c:pt>
                <c:pt idx="2846">
                  <c:v>-0.15473076102009872</c:v>
                </c:pt>
                <c:pt idx="2847">
                  <c:v>0.15652605852865611</c:v>
                </c:pt>
                <c:pt idx="2848">
                  <c:v>0.2349917412488024</c:v>
                </c:pt>
                <c:pt idx="2849">
                  <c:v>0.46330856591816305</c:v>
                </c:pt>
                <c:pt idx="2850">
                  <c:v>0.52245755811520866</c:v>
                </c:pt>
                <c:pt idx="2851">
                  <c:v>7.6559095131604402E-2</c:v>
                </c:pt>
                <c:pt idx="2852">
                  <c:v>0.14326279303861991</c:v>
                </c:pt>
                <c:pt idx="2853">
                  <c:v>-0.2523977697250569</c:v>
                </c:pt>
                <c:pt idx="2854">
                  <c:v>0.35603109527222071</c:v>
                </c:pt>
                <c:pt idx="2855">
                  <c:v>0.15872479629747943</c:v>
                </c:pt>
                <c:pt idx="2856">
                  <c:v>0.26879367512247893</c:v>
                </c:pt>
                <c:pt idx="2857">
                  <c:v>8.0248330092120304E-2</c:v>
                </c:pt>
                <c:pt idx="2858">
                  <c:v>-0.15280481341060489</c:v>
                </c:pt>
                <c:pt idx="2859">
                  <c:v>0.20576784014981819</c:v>
                </c:pt>
                <c:pt idx="2860">
                  <c:v>0.41705585981314924</c:v>
                </c:pt>
                <c:pt idx="2861">
                  <c:v>7.5190314155219248E-2</c:v>
                </c:pt>
                <c:pt idx="2862">
                  <c:v>-0.29760841569194935</c:v>
                </c:pt>
                <c:pt idx="2863">
                  <c:v>0.24987004682249817</c:v>
                </c:pt>
                <c:pt idx="2864">
                  <c:v>0.22564512061895256</c:v>
                </c:pt>
                <c:pt idx="2865">
                  <c:v>1.3212111426851169E-2</c:v>
                </c:pt>
                <c:pt idx="2866">
                  <c:v>-0.30721574336599006</c:v>
                </c:pt>
                <c:pt idx="2867">
                  <c:v>0.70345512659056098</c:v>
                </c:pt>
                <c:pt idx="2868">
                  <c:v>-9.5882041454141254E-2</c:v>
                </c:pt>
                <c:pt idx="2869">
                  <c:v>-0.22650997250444205</c:v>
                </c:pt>
                <c:pt idx="2870">
                  <c:v>-2.8410464469938029E-2</c:v>
                </c:pt>
                <c:pt idx="2871">
                  <c:v>-2.9735320985471221E-2</c:v>
                </c:pt>
                <c:pt idx="2872">
                  <c:v>0.56296282851529023</c:v>
                </c:pt>
                <c:pt idx="2873">
                  <c:v>0.44424299422248481</c:v>
                </c:pt>
                <c:pt idx="2874">
                  <c:v>0.23560453276329896</c:v>
                </c:pt>
                <c:pt idx="2875">
                  <c:v>-0.2164176260596288</c:v>
                </c:pt>
                <c:pt idx="2876">
                  <c:v>-0.39744810252834001</c:v>
                </c:pt>
                <c:pt idx="2877">
                  <c:v>0.32262042236168464</c:v>
                </c:pt>
                <c:pt idx="2878">
                  <c:v>-3.5490466611088241E-2</c:v>
                </c:pt>
                <c:pt idx="2879">
                  <c:v>7.1213489605264552E-2</c:v>
                </c:pt>
                <c:pt idx="2880">
                  <c:v>-3.7413961643116916E-2</c:v>
                </c:pt>
                <c:pt idx="2881">
                  <c:v>0.60615792523564604</c:v>
                </c:pt>
                <c:pt idx="2882">
                  <c:v>0.34664492158852678</c:v>
                </c:pt>
                <c:pt idx="2883">
                  <c:v>0.26207228839841024</c:v>
                </c:pt>
                <c:pt idx="2884">
                  <c:v>0.11503324294624007</c:v>
                </c:pt>
                <c:pt idx="2885">
                  <c:v>-0.20489804187717534</c:v>
                </c:pt>
                <c:pt idx="2886">
                  <c:v>0.29030643542491436</c:v>
                </c:pt>
                <c:pt idx="2887">
                  <c:v>-0.36866285587251868</c:v>
                </c:pt>
                <c:pt idx="2888">
                  <c:v>2.2616379067348556E-2</c:v>
                </c:pt>
                <c:pt idx="2889">
                  <c:v>0.15885402951661801</c:v>
                </c:pt>
                <c:pt idx="2890">
                  <c:v>-0.55427329665001579</c:v>
                </c:pt>
                <c:pt idx="2891">
                  <c:v>0.26062790812669856</c:v>
                </c:pt>
                <c:pt idx="2892">
                  <c:v>1.9773069040027156E-2</c:v>
                </c:pt>
                <c:pt idx="2893">
                  <c:v>-0.24690896970189485</c:v>
                </c:pt>
                <c:pt idx="2894">
                  <c:v>-3.6969850498809846E-2</c:v>
                </c:pt>
                <c:pt idx="2895">
                  <c:v>0.18561286234235091</c:v>
                </c:pt>
                <c:pt idx="2896">
                  <c:v>-3.4899137556436519E-2</c:v>
                </c:pt>
                <c:pt idx="2897">
                  <c:v>-0.20174206735549979</c:v>
                </c:pt>
                <c:pt idx="2898">
                  <c:v>-0.30418430838435545</c:v>
                </c:pt>
                <c:pt idx="2899">
                  <c:v>0.15003969277415322</c:v>
                </c:pt>
                <c:pt idx="2900">
                  <c:v>0.1437852247086015</c:v>
                </c:pt>
                <c:pt idx="2901">
                  <c:v>-0.16262184024619339</c:v>
                </c:pt>
                <c:pt idx="2902">
                  <c:v>-0.16569329703709221</c:v>
                </c:pt>
                <c:pt idx="2903">
                  <c:v>0.48604499259034967</c:v>
                </c:pt>
                <c:pt idx="2904">
                  <c:v>4.1242982231881345E-2</c:v>
                </c:pt>
                <c:pt idx="2905">
                  <c:v>0.47466965916094334</c:v>
                </c:pt>
                <c:pt idx="2906">
                  <c:v>-5.1100179333698127E-2</c:v>
                </c:pt>
                <c:pt idx="2907">
                  <c:v>-0.22229624487290192</c:v>
                </c:pt>
                <c:pt idx="2908">
                  <c:v>0.86401771720462339</c:v>
                </c:pt>
                <c:pt idx="2909">
                  <c:v>-9.2493985787336988E-2</c:v>
                </c:pt>
                <c:pt idx="2910">
                  <c:v>0.36042046610320916</c:v>
                </c:pt>
                <c:pt idx="2911">
                  <c:v>1.0359053837421279</c:v>
                </c:pt>
                <c:pt idx="2912">
                  <c:v>0.3389092728089213</c:v>
                </c:pt>
                <c:pt idx="2913">
                  <c:v>0.26447638000770035</c:v>
                </c:pt>
                <c:pt idx="2914">
                  <c:v>0.14130198762525845</c:v>
                </c:pt>
                <c:pt idx="2915">
                  <c:v>0.28534303015925572</c:v>
                </c:pt>
                <c:pt idx="2916">
                  <c:v>0.41023254559820493</c:v>
                </c:pt>
                <c:pt idx="2917">
                  <c:v>0.55914914773725732</c:v>
                </c:pt>
                <c:pt idx="2918">
                  <c:v>2.5312343046069E-2</c:v>
                </c:pt>
                <c:pt idx="2919">
                  <c:v>-5.6375109653629104E-3</c:v>
                </c:pt>
                <c:pt idx="2920">
                  <c:v>-0.17088110365073941</c:v>
                </c:pt>
                <c:pt idx="2921">
                  <c:v>0.33947948547232215</c:v>
                </c:pt>
                <c:pt idx="2922">
                  <c:v>-0.96240692445976694</c:v>
                </c:pt>
                <c:pt idx="2923">
                  <c:v>9.1395186011700019E-2</c:v>
                </c:pt>
                <c:pt idx="2924">
                  <c:v>-0.22684760298594764</c:v>
                </c:pt>
                <c:pt idx="2925">
                  <c:v>-6.8846469479774089E-2</c:v>
                </c:pt>
                <c:pt idx="2926">
                  <c:v>-6.3258426218880476E-2</c:v>
                </c:pt>
                <c:pt idx="2927">
                  <c:v>-9.0188501291661727E-2</c:v>
                </c:pt>
                <c:pt idx="2928">
                  <c:v>3.2100843167024079E-2</c:v>
                </c:pt>
                <c:pt idx="2929">
                  <c:v>0.37751248848500502</c:v>
                </c:pt>
                <c:pt idx="2930">
                  <c:v>0.3595211704275954</c:v>
                </c:pt>
                <c:pt idx="2931">
                  <c:v>0.31996469421646567</c:v>
                </c:pt>
                <c:pt idx="2932">
                  <c:v>0.17810907609432516</c:v>
                </c:pt>
                <c:pt idx="2933">
                  <c:v>0.12855736497375747</c:v>
                </c:pt>
                <c:pt idx="2934">
                  <c:v>-6.9451880752145215E-2</c:v>
                </c:pt>
                <c:pt idx="2935">
                  <c:v>-3.3274231282193117E-2</c:v>
                </c:pt>
                <c:pt idx="2936">
                  <c:v>-6.3861496576032364E-2</c:v>
                </c:pt>
                <c:pt idx="2937">
                  <c:v>0.43360046262586249</c:v>
                </c:pt>
                <c:pt idx="2938">
                  <c:v>0.12829340100981756</c:v>
                </c:pt>
                <c:pt idx="2939">
                  <c:v>2.4504992348224897E-3</c:v>
                </c:pt>
                <c:pt idx="2940">
                  <c:v>-0.27316878296750702</c:v>
                </c:pt>
                <c:pt idx="2941">
                  <c:v>-0.12579321412220137</c:v>
                </c:pt>
                <c:pt idx="2942">
                  <c:v>-0.20706137759963106</c:v>
                </c:pt>
                <c:pt idx="2943">
                  <c:v>-0.10345688414410087</c:v>
                </c:pt>
                <c:pt idx="2944">
                  <c:v>-6.4313964837821397E-2</c:v>
                </c:pt>
                <c:pt idx="2945">
                  <c:v>-2.2683437091289494E-2</c:v>
                </c:pt>
                <c:pt idx="2946">
                  <c:v>5.9078342201253034E-2</c:v>
                </c:pt>
                <c:pt idx="2947">
                  <c:v>0.13553486976118947</c:v>
                </c:pt>
                <c:pt idx="2948">
                  <c:v>0.98979297778251374</c:v>
                </c:pt>
                <c:pt idx="2949">
                  <c:v>0.25180996817153983</c:v>
                </c:pt>
                <c:pt idx="2950">
                  <c:v>1.1243281350022019</c:v>
                </c:pt>
                <c:pt idx="2951">
                  <c:v>0.2856981259581251</c:v>
                </c:pt>
                <c:pt idx="2952">
                  <c:v>-0.3213871856611713</c:v>
                </c:pt>
                <c:pt idx="2953">
                  <c:v>0.28048127430062353</c:v>
                </c:pt>
                <c:pt idx="2954">
                  <c:v>0.13251103979919548</c:v>
                </c:pt>
                <c:pt idx="2955">
                  <c:v>0.14925936549962288</c:v>
                </c:pt>
                <c:pt idx="2956">
                  <c:v>0.13435238662336282</c:v>
                </c:pt>
                <c:pt idx="2957">
                  <c:v>0.26267368698183613</c:v>
                </c:pt>
                <c:pt idx="2958">
                  <c:v>0.15833702716710066</c:v>
                </c:pt>
                <c:pt idx="2959">
                  <c:v>-0.88790042022376492</c:v>
                </c:pt>
                <c:pt idx="2960">
                  <c:v>-3.5786222053060632E-2</c:v>
                </c:pt>
                <c:pt idx="2961">
                  <c:v>-8.4364376569686692E-2</c:v>
                </c:pt>
                <c:pt idx="2962">
                  <c:v>0.42212533285652015</c:v>
                </c:pt>
                <c:pt idx="2963">
                  <c:v>-0.45087301980073291</c:v>
                </c:pt>
                <c:pt idx="2964">
                  <c:v>-0.35107444054687881</c:v>
                </c:pt>
                <c:pt idx="2965">
                  <c:v>6.6674762724460157E-2</c:v>
                </c:pt>
                <c:pt idx="2966">
                  <c:v>-0.53303361572692065</c:v>
                </c:pt>
                <c:pt idx="2967">
                  <c:v>-6.1902438925906862E-2</c:v>
                </c:pt>
                <c:pt idx="2968">
                  <c:v>0.32803219030386255</c:v>
                </c:pt>
                <c:pt idx="2969">
                  <c:v>0.11196608960349229</c:v>
                </c:pt>
                <c:pt idx="2970">
                  <c:v>-0.16553147828969708</c:v>
                </c:pt>
                <c:pt idx="2971">
                  <c:v>-1.3479842759519691E-2</c:v>
                </c:pt>
                <c:pt idx="2972">
                  <c:v>7.6832695557398592E-2</c:v>
                </c:pt>
                <c:pt idx="2973">
                  <c:v>2.375213589899498E-2</c:v>
                </c:pt>
                <c:pt idx="2974">
                  <c:v>-0.16068533654485095</c:v>
                </c:pt>
                <c:pt idx="2975">
                  <c:v>6.6950243924627034E-2</c:v>
                </c:pt>
                <c:pt idx="2976">
                  <c:v>0.42158687316270571</c:v>
                </c:pt>
                <c:pt idx="2977">
                  <c:v>-1.7322736212371211E-3</c:v>
                </c:pt>
                <c:pt idx="2978">
                  <c:v>0.18078439107869881</c:v>
                </c:pt>
                <c:pt idx="2979">
                  <c:v>-0.23395615698730485</c:v>
                </c:pt>
                <c:pt idx="2980">
                  <c:v>-5.4691953074952525E-2</c:v>
                </c:pt>
                <c:pt idx="2981">
                  <c:v>-0.766602735898117</c:v>
                </c:pt>
                <c:pt idx="2982">
                  <c:v>-0.14800116288755377</c:v>
                </c:pt>
                <c:pt idx="2983">
                  <c:v>-6.6427361738976065E-2</c:v>
                </c:pt>
                <c:pt idx="2984">
                  <c:v>-0.48843075802752745</c:v>
                </c:pt>
                <c:pt idx="2985">
                  <c:v>0.15341624225524791</c:v>
                </c:pt>
                <c:pt idx="2986">
                  <c:v>-5.0801268104846878E-2</c:v>
                </c:pt>
                <c:pt idx="2987">
                  <c:v>0.50883427425123384</c:v>
                </c:pt>
                <c:pt idx="2988">
                  <c:v>0.29736752321765925</c:v>
                </c:pt>
                <c:pt idx="2989">
                  <c:v>8.2702589330249349E-2</c:v>
                </c:pt>
                <c:pt idx="2990">
                  <c:v>0.63710012405633143</c:v>
                </c:pt>
                <c:pt idx="2991">
                  <c:v>1.8918982163051733E-2</c:v>
                </c:pt>
                <c:pt idx="2992">
                  <c:v>-0.25171052662958465</c:v>
                </c:pt>
                <c:pt idx="2993">
                  <c:v>0.51045562166176417</c:v>
                </c:pt>
                <c:pt idx="2994">
                  <c:v>-1.6610907271910789</c:v>
                </c:pt>
                <c:pt idx="2995">
                  <c:v>-0.21407286926621943</c:v>
                </c:pt>
                <c:pt idx="2996">
                  <c:v>-3.3717206069222426E-2</c:v>
                </c:pt>
                <c:pt idx="2997">
                  <c:v>-0.38967790355796311</c:v>
                </c:pt>
                <c:pt idx="2998">
                  <c:v>-0.3536529846486553</c:v>
                </c:pt>
                <c:pt idx="2999">
                  <c:v>0.3710569683501993</c:v>
                </c:pt>
                <c:pt idx="3000">
                  <c:v>-0.33024753274423801</c:v>
                </c:pt>
                <c:pt idx="3001">
                  <c:v>-0.88923587810019256</c:v>
                </c:pt>
                <c:pt idx="3002">
                  <c:v>0.43988904761977915</c:v>
                </c:pt>
                <c:pt idx="3003">
                  <c:v>0.22823379956006803</c:v>
                </c:pt>
                <c:pt idx="3004">
                  <c:v>-0.17299399036102314</c:v>
                </c:pt>
                <c:pt idx="3005">
                  <c:v>0.24184018356467063</c:v>
                </c:pt>
                <c:pt idx="3006">
                  <c:v>0.71826297695093266</c:v>
                </c:pt>
                <c:pt idx="3007">
                  <c:v>0.50528121145326699</c:v>
                </c:pt>
                <c:pt idx="3008">
                  <c:v>0.20689323612177143</c:v>
                </c:pt>
                <c:pt idx="3009">
                  <c:v>0.2649567179648224</c:v>
                </c:pt>
                <c:pt idx="3010">
                  <c:v>0.38736254083599553</c:v>
                </c:pt>
                <c:pt idx="3011">
                  <c:v>-5.4242492027372392E-2</c:v>
                </c:pt>
                <c:pt idx="3012">
                  <c:v>5.2415894151138537E-2</c:v>
                </c:pt>
                <c:pt idx="3013">
                  <c:v>0.39506279951757767</c:v>
                </c:pt>
                <c:pt idx="3014">
                  <c:v>-0.19000941602479479</c:v>
                </c:pt>
                <c:pt idx="3015">
                  <c:v>0.37451092576839107</c:v>
                </c:pt>
                <c:pt idx="3016">
                  <c:v>0.23939804156655567</c:v>
                </c:pt>
                <c:pt idx="3017">
                  <c:v>-3.519477178716135E-2</c:v>
                </c:pt>
                <c:pt idx="3018">
                  <c:v>-2.3510744405468786</c:v>
                </c:pt>
                <c:pt idx="3019">
                  <c:v>0.58496250072115619</c:v>
                </c:pt>
                <c:pt idx="3020">
                  <c:v>0.40708077545050081</c:v>
                </c:pt>
                <c:pt idx="3021">
                  <c:v>8.9904868421335535E-2</c:v>
                </c:pt>
                <c:pt idx="3022">
                  <c:v>0.2409859040247386</c:v>
                </c:pt>
                <c:pt idx="3023">
                  <c:v>-0.26153478266022367</c:v>
                </c:pt>
                <c:pt idx="3024">
                  <c:v>0.27178421356921684</c:v>
                </c:pt>
                <c:pt idx="3025">
                  <c:v>-0.42217240876375189</c:v>
                </c:pt>
                <c:pt idx="3026">
                  <c:v>-8.0545498166160787E-2</c:v>
                </c:pt>
                <c:pt idx="3027">
                  <c:v>-0.50185127378984884</c:v>
                </c:pt>
                <c:pt idx="3028">
                  <c:v>0.19118360922003899</c:v>
                </c:pt>
                <c:pt idx="3029">
                  <c:v>0.75454548946918887</c:v>
                </c:pt>
                <c:pt idx="3030">
                  <c:v>0.36176835941915331</c:v>
                </c:pt>
                <c:pt idx="3031">
                  <c:v>0.15950002202321961</c:v>
                </c:pt>
                <c:pt idx="3032">
                  <c:v>1.5283212633989662</c:v>
                </c:pt>
                <c:pt idx="3033">
                  <c:v>-3.1774255410241372E-3</c:v>
                </c:pt>
                <c:pt idx="3034">
                  <c:v>0.10929368902294002</c:v>
                </c:pt>
                <c:pt idx="3035">
                  <c:v>0.11556599592160316</c:v>
                </c:pt>
                <c:pt idx="3036">
                  <c:v>-0.30151479234317652</c:v>
                </c:pt>
                <c:pt idx="3037">
                  <c:v>0.25845862271790077</c:v>
                </c:pt>
                <c:pt idx="3038">
                  <c:v>-0.11341083508181846</c:v>
                </c:pt>
                <c:pt idx="3039">
                  <c:v>-0.19958668736124272</c:v>
                </c:pt>
                <c:pt idx="3040">
                  <c:v>-3.8302594280321775E-2</c:v>
                </c:pt>
                <c:pt idx="3041">
                  <c:v>0.35027092422840367</c:v>
                </c:pt>
                <c:pt idx="3042">
                  <c:v>4.3904394295621103E-2</c:v>
                </c:pt>
                <c:pt idx="3043">
                  <c:v>-0.2515387669959645</c:v>
                </c:pt>
                <c:pt idx="3044">
                  <c:v>0.39374567066082494</c:v>
                </c:pt>
                <c:pt idx="3045">
                  <c:v>0.45037988007104107</c:v>
                </c:pt>
                <c:pt idx="3046">
                  <c:v>-0.10252721272912138</c:v>
                </c:pt>
                <c:pt idx="3047">
                  <c:v>-0.71406519205612728</c:v>
                </c:pt>
                <c:pt idx="3048">
                  <c:v>-9.7733430916929001E-2</c:v>
                </c:pt>
                <c:pt idx="3049">
                  <c:v>6.0324133151103833E-2</c:v>
                </c:pt>
                <c:pt idx="3050">
                  <c:v>-0.55596908884160745</c:v>
                </c:pt>
                <c:pt idx="3051">
                  <c:v>0.10151561549124424</c:v>
                </c:pt>
                <c:pt idx="3052">
                  <c:v>0.58245965956076218</c:v>
                </c:pt>
                <c:pt idx="3053">
                  <c:v>-6.0246850047772985E-2</c:v>
                </c:pt>
                <c:pt idx="3054">
                  <c:v>-1.4353850282750529E-2</c:v>
                </c:pt>
                <c:pt idx="3055">
                  <c:v>-0.67714887562440906</c:v>
                </c:pt>
                <c:pt idx="3056">
                  <c:v>-0.42623770442367687</c:v>
                </c:pt>
                <c:pt idx="3057">
                  <c:v>0.25761413004954092</c:v>
                </c:pt>
                <c:pt idx="3058">
                  <c:v>-0.31043245604953296</c:v>
                </c:pt>
                <c:pt idx="3059">
                  <c:v>-0.11872693857075141</c:v>
                </c:pt>
                <c:pt idx="3060">
                  <c:v>0.9505430665545217</c:v>
                </c:pt>
                <c:pt idx="3061">
                  <c:v>0.36625226369956387</c:v>
                </c:pt>
                <c:pt idx="3062">
                  <c:v>0.32895132391200888</c:v>
                </c:pt>
                <c:pt idx="3063">
                  <c:v>0.54922557545239892</c:v>
                </c:pt>
                <c:pt idx="3064">
                  <c:v>-0.16634075359048736</c:v>
                </c:pt>
                <c:pt idx="3065">
                  <c:v>0.56071495447447905</c:v>
                </c:pt>
                <c:pt idx="3066">
                  <c:v>-1.6103455397704806E-2</c:v>
                </c:pt>
                <c:pt idx="3067">
                  <c:v>-2.092583885454798E-2</c:v>
                </c:pt>
                <c:pt idx="3068">
                  <c:v>0.23106369991227274</c:v>
                </c:pt>
                <c:pt idx="3069">
                  <c:v>0.2649567179648224</c:v>
                </c:pt>
                <c:pt idx="3070">
                  <c:v>-0.6999348632212391</c:v>
                </c:pt>
                <c:pt idx="3071">
                  <c:v>0.22786427254650743</c:v>
                </c:pt>
                <c:pt idx="3072">
                  <c:v>0.2709474874770586</c:v>
                </c:pt>
                <c:pt idx="3073">
                  <c:v>-1.0673340518542214</c:v>
                </c:pt>
                <c:pt idx="3074">
                  <c:v>0.271186601597253</c:v>
                </c:pt>
                <c:pt idx="3075">
                  <c:v>0.33204908374897429</c:v>
                </c:pt>
                <c:pt idx="3076">
                  <c:v>0.12061736121794181</c:v>
                </c:pt>
                <c:pt idx="3077">
                  <c:v>6.8051642997789777E-2</c:v>
                </c:pt>
                <c:pt idx="3078">
                  <c:v>-0.43850277898018503</c:v>
                </c:pt>
                <c:pt idx="3079">
                  <c:v>5.85243118408003E-2</c:v>
                </c:pt>
                <c:pt idx="3080">
                  <c:v>0.44911231954941605</c:v>
                </c:pt>
                <c:pt idx="3081">
                  <c:v>-7.4000581443776928E-2</c:v>
                </c:pt>
                <c:pt idx="3082">
                  <c:v>-6.220365931344831E-2</c:v>
                </c:pt>
                <c:pt idx="3083">
                  <c:v>-0.35808409652488726</c:v>
                </c:pt>
                <c:pt idx="3084">
                  <c:v>0.10326262660608464</c:v>
                </c:pt>
                <c:pt idx="3085">
                  <c:v>0.30404369647354051</c:v>
                </c:pt>
                <c:pt idx="3086">
                  <c:v>8.3247413747936122E-2</c:v>
                </c:pt>
                <c:pt idx="3087">
                  <c:v>-3.3717206069222426E-2</c:v>
                </c:pt>
                <c:pt idx="3088">
                  <c:v>0.47632983775713772</c:v>
                </c:pt>
                <c:pt idx="3089">
                  <c:v>-1.0637107053513444</c:v>
                </c:pt>
                <c:pt idx="3090">
                  <c:v>0.15172895534333664</c:v>
                </c:pt>
                <c:pt idx="3091">
                  <c:v>0.11676397129772324</c:v>
                </c:pt>
                <c:pt idx="3092">
                  <c:v>0.28510625106125354</c:v>
                </c:pt>
                <c:pt idx="3093">
                  <c:v>8.732705179747538E-2</c:v>
                </c:pt>
                <c:pt idx="3094">
                  <c:v>-0.16020161649308068</c:v>
                </c:pt>
                <c:pt idx="3095">
                  <c:v>0.16066208011334429</c:v>
                </c:pt>
                <c:pt idx="3096">
                  <c:v>2.2048165180173156E-2</c:v>
                </c:pt>
                <c:pt idx="3097">
                  <c:v>-0.41253899262206173</c:v>
                </c:pt>
                <c:pt idx="3098">
                  <c:v>-0.11403524324602944</c:v>
                </c:pt>
                <c:pt idx="3099">
                  <c:v>0.375512140703744</c:v>
                </c:pt>
                <c:pt idx="3100">
                  <c:v>-1.5022599113909068</c:v>
                </c:pt>
                <c:pt idx="3101">
                  <c:v>0.3918776772778661</c:v>
                </c:pt>
                <c:pt idx="3102">
                  <c:v>8.8413009726725E-2</c:v>
                </c:pt>
                <c:pt idx="3103">
                  <c:v>7.6832695557398592E-2</c:v>
                </c:pt>
                <c:pt idx="3104">
                  <c:v>0.292781749227846</c:v>
                </c:pt>
                <c:pt idx="3105">
                  <c:v>-3.9784866105863903E-2</c:v>
                </c:pt>
                <c:pt idx="3106">
                  <c:v>0.1653009749168648</c:v>
                </c:pt>
                <c:pt idx="3107">
                  <c:v>-0.34245145221024748</c:v>
                </c:pt>
                <c:pt idx="3108">
                  <c:v>-0.13305246941640167</c:v>
                </c:pt>
                <c:pt idx="3109">
                  <c:v>-6.2169647499932743E-3</c:v>
                </c:pt>
                <c:pt idx="3110">
                  <c:v>-0.4979749784823046</c:v>
                </c:pt>
                <c:pt idx="3111">
                  <c:v>0.17453425469490197</c:v>
                </c:pt>
                <c:pt idx="3112">
                  <c:v>-0.12107852025014938</c:v>
                </c:pt>
                <c:pt idx="3113">
                  <c:v>-0.14289483731466815</c:v>
                </c:pt>
                <c:pt idx="3114">
                  <c:v>0.13697881196350373</c:v>
                </c:pt>
                <c:pt idx="3115">
                  <c:v>0.24914190328034752</c:v>
                </c:pt>
                <c:pt idx="3116">
                  <c:v>-0.38741159330128244</c:v>
                </c:pt>
                <c:pt idx="3117">
                  <c:v>8.2000138321361282E-3</c:v>
                </c:pt>
                <c:pt idx="3118">
                  <c:v>-2.2351443287452959</c:v>
                </c:pt>
                <c:pt idx="3119">
                  <c:v>-7.0360474279115293E-2</c:v>
                </c:pt>
                <c:pt idx="3120">
                  <c:v>1.7779412561234692E-2</c:v>
                </c:pt>
                <c:pt idx="3121">
                  <c:v>0.30135351887776402</c:v>
                </c:pt>
                <c:pt idx="3122">
                  <c:v>0.82334176176314344</c:v>
                </c:pt>
                <c:pt idx="3123">
                  <c:v>-0.23395615698730485</c:v>
                </c:pt>
                <c:pt idx="3124">
                  <c:v>-0.23124400477811693</c:v>
                </c:pt>
                <c:pt idx="3125">
                  <c:v>0.36848900064510354</c:v>
                </c:pt>
                <c:pt idx="3126">
                  <c:v>0.30964187342216065</c:v>
                </c:pt>
                <c:pt idx="3127">
                  <c:v>0.23890911669840434</c:v>
                </c:pt>
                <c:pt idx="3128">
                  <c:v>-8.8806976967544984E-2</c:v>
                </c:pt>
                <c:pt idx="3129">
                  <c:v>0.51530875974188883</c:v>
                </c:pt>
                <c:pt idx="3130">
                  <c:v>0.40544784370753517</c:v>
                </c:pt>
                <c:pt idx="3131">
                  <c:v>0.18002052146631287</c:v>
                </c:pt>
                <c:pt idx="3132">
                  <c:v>0.4365882936601177</c:v>
                </c:pt>
                <c:pt idx="3133">
                  <c:v>3.449746419944489E-2</c:v>
                </c:pt>
                <c:pt idx="3134">
                  <c:v>0.2197106395487792</c:v>
                </c:pt>
                <c:pt idx="3135">
                  <c:v>6.5158675128546825E-2</c:v>
                </c:pt>
                <c:pt idx="3136">
                  <c:v>0.3529844580206441</c:v>
                </c:pt>
                <c:pt idx="3137">
                  <c:v>5.9078342201253034E-2</c:v>
                </c:pt>
                <c:pt idx="3138">
                  <c:v>0.43274565884384791</c:v>
                </c:pt>
                <c:pt idx="3139">
                  <c:v>9.9766486292929807E-2</c:v>
                </c:pt>
                <c:pt idx="3140">
                  <c:v>0.71439939693040266</c:v>
                </c:pt>
                <c:pt idx="3141">
                  <c:v>0.17069423368708325</c:v>
                </c:pt>
                <c:pt idx="3142">
                  <c:v>0.32837693403266582</c:v>
                </c:pt>
                <c:pt idx="3143">
                  <c:v>-0.35808409652488726</c:v>
                </c:pt>
                <c:pt idx="3144">
                  <c:v>-1.9839316313723465</c:v>
                </c:pt>
                <c:pt idx="3145">
                  <c:v>0.63236128959656712</c:v>
                </c:pt>
                <c:pt idx="3146">
                  <c:v>-2.3856359953366994E-2</c:v>
                </c:pt>
                <c:pt idx="3147">
                  <c:v>-0.26447782270346254</c:v>
                </c:pt>
                <c:pt idx="3148">
                  <c:v>-0.10097909042058312</c:v>
                </c:pt>
                <c:pt idx="3149">
                  <c:v>-0.74903842646678132</c:v>
                </c:pt>
                <c:pt idx="3150">
                  <c:v>0.29195711642980726</c:v>
                </c:pt>
                <c:pt idx="3151">
                  <c:v>-0.68872940851335873</c:v>
                </c:pt>
                <c:pt idx="3152">
                  <c:v>0.27393356926688534</c:v>
                </c:pt>
                <c:pt idx="3153">
                  <c:v>1.6010308693488096</c:v>
                </c:pt>
                <c:pt idx="3154">
                  <c:v>-0.45660310419242817</c:v>
                </c:pt>
                <c:pt idx="3155">
                  <c:v>-1.4104282460262543</c:v>
                </c:pt>
                <c:pt idx="3156">
                  <c:v>-0.26968611370622381</c:v>
                </c:pt>
                <c:pt idx="3157">
                  <c:v>1.225706809843125</c:v>
                </c:pt>
                <c:pt idx="3158">
                  <c:v>0.72866066662148288</c:v>
                </c:pt>
                <c:pt idx="3159">
                  <c:v>0.64136105632736407</c:v>
                </c:pt>
                <c:pt idx="3160">
                  <c:v>0.13540353059765128</c:v>
                </c:pt>
                <c:pt idx="3161">
                  <c:v>0.1086248146816487</c:v>
                </c:pt>
                <c:pt idx="3162">
                  <c:v>0.29360591094171251</c:v>
                </c:pt>
                <c:pt idx="3163">
                  <c:v>-0.91729741066975079</c:v>
                </c:pt>
                <c:pt idx="3164">
                  <c:v>6.7087964801146954E-2</c:v>
                </c:pt>
                <c:pt idx="3165">
                  <c:v>0.11036324336041808</c:v>
                </c:pt>
                <c:pt idx="3166">
                  <c:v>-0.69245489810041372</c:v>
                </c:pt>
                <c:pt idx="3167">
                  <c:v>0.48460219437220325</c:v>
                </c:pt>
                <c:pt idx="3168">
                  <c:v>5.9632159882099592E-2</c:v>
                </c:pt>
                <c:pt idx="3169">
                  <c:v>-2.3710864573382135</c:v>
                </c:pt>
                <c:pt idx="3170">
                  <c:v>5.2555009434105286E-2</c:v>
                </c:pt>
                <c:pt idx="3171">
                  <c:v>4.4044332706021212E-2</c:v>
                </c:pt>
                <c:pt idx="3172">
                  <c:v>-1.1025272127291215</c:v>
                </c:pt>
                <c:pt idx="3173">
                  <c:v>5.2415894151138537E-2</c:v>
                </c:pt>
                <c:pt idx="3174">
                  <c:v>0.53645083019470852</c:v>
                </c:pt>
                <c:pt idx="3175">
                  <c:v>0.13789693238961928</c:v>
                </c:pt>
                <c:pt idx="3176">
                  <c:v>0.29466485609124171</c:v>
                </c:pt>
                <c:pt idx="3177">
                  <c:v>0.49128873189744249</c:v>
                </c:pt>
                <c:pt idx="3178">
                  <c:v>0.45554422477574164</c:v>
                </c:pt>
                <c:pt idx="3179">
                  <c:v>-0.79085860216140835</c:v>
                </c:pt>
                <c:pt idx="3180">
                  <c:v>0.33913738491958534</c:v>
                </c:pt>
                <c:pt idx="3181">
                  <c:v>-0.55745454389469573</c:v>
                </c:pt>
                <c:pt idx="3182">
                  <c:v>7.6969476315110794E-2</c:v>
                </c:pt>
                <c:pt idx="3183">
                  <c:v>-0.15136203809529375</c:v>
                </c:pt>
                <c:pt idx="3184">
                  <c:v>0.12287146908839318</c:v>
                </c:pt>
                <c:pt idx="3185">
                  <c:v>-0.30632348343224342</c:v>
                </c:pt>
                <c:pt idx="3186">
                  <c:v>0.11276684542842838</c:v>
                </c:pt>
                <c:pt idx="3187">
                  <c:v>-0.31383567393864076</c:v>
                </c:pt>
                <c:pt idx="3188">
                  <c:v>0.24476530756931322</c:v>
                </c:pt>
                <c:pt idx="3189">
                  <c:v>0.80182086049611678</c:v>
                </c:pt>
                <c:pt idx="3190">
                  <c:v>-1.9788045754855101</c:v>
                </c:pt>
                <c:pt idx="3191">
                  <c:v>-0.43948067845563149</c:v>
                </c:pt>
                <c:pt idx="3192">
                  <c:v>0.17836408184680327</c:v>
                </c:pt>
                <c:pt idx="3193">
                  <c:v>2.9417546835091738E-2</c:v>
                </c:pt>
                <c:pt idx="3194">
                  <c:v>9.0717959767799825E-2</c:v>
                </c:pt>
                <c:pt idx="3195">
                  <c:v>0.31138685816203882</c:v>
                </c:pt>
                <c:pt idx="3196">
                  <c:v>0.36725922448866971</c:v>
                </c:pt>
                <c:pt idx="3197">
                  <c:v>-8.0240424144958675E-2</c:v>
                </c:pt>
                <c:pt idx="3198">
                  <c:v>0.18814768692643399</c:v>
                </c:pt>
                <c:pt idx="3199">
                  <c:v>0.26267368698183613</c:v>
                </c:pt>
                <c:pt idx="3200">
                  <c:v>-0.61418245514830461</c:v>
                </c:pt>
                <c:pt idx="3201">
                  <c:v>0.21698248926876829</c:v>
                </c:pt>
                <c:pt idx="3202">
                  <c:v>0.17734378828172601</c:v>
                </c:pt>
                <c:pt idx="3203">
                  <c:v>5.5334501751099399E-2</c:v>
                </c:pt>
                <c:pt idx="3204">
                  <c:v>4.670058674162228E-2</c:v>
                </c:pt>
                <c:pt idx="3205">
                  <c:v>0.1300083041086062</c:v>
                </c:pt>
                <c:pt idx="3206">
                  <c:v>-0.21039593366842291</c:v>
                </c:pt>
                <c:pt idx="3207">
                  <c:v>0.20701822594562194</c:v>
                </c:pt>
                <c:pt idx="3208">
                  <c:v>0.4185677792997119</c:v>
                </c:pt>
                <c:pt idx="3209">
                  <c:v>-2.1365037713555978E-2</c:v>
                </c:pt>
                <c:pt idx="3210">
                  <c:v>0.24184018356467063</c:v>
                </c:pt>
                <c:pt idx="3211">
                  <c:v>-0.29973785525329644</c:v>
                </c:pt>
                <c:pt idx="3212">
                  <c:v>0.32964029003823003</c:v>
                </c:pt>
                <c:pt idx="3213">
                  <c:v>0.34891224099419954</c:v>
                </c:pt>
                <c:pt idx="3214">
                  <c:v>0.67446065156025881</c:v>
                </c:pt>
                <c:pt idx="3215">
                  <c:v>9.4100916438866505E-2</c:v>
                </c:pt>
                <c:pt idx="3216">
                  <c:v>-2.8116217061027168E-2</c:v>
                </c:pt>
                <c:pt idx="3217">
                  <c:v>1.7779982556686695</c:v>
                </c:pt>
                <c:pt idx="3218">
                  <c:v>0.26447638000770035</c:v>
                </c:pt>
                <c:pt idx="3219">
                  <c:v>-0.23650343863468462</c:v>
                </c:pt>
                <c:pt idx="3220">
                  <c:v>-0.23344723992368574</c:v>
                </c:pt>
                <c:pt idx="3221">
                  <c:v>0.39933518250207145</c:v>
                </c:pt>
                <c:pt idx="3222">
                  <c:v>0.24366908096686266</c:v>
                </c:pt>
                <c:pt idx="3223">
                  <c:v>0.34925203178067049</c:v>
                </c:pt>
                <c:pt idx="3224">
                  <c:v>-0.20141026076689628</c:v>
                </c:pt>
                <c:pt idx="3225">
                  <c:v>-0.19578119333292007</c:v>
                </c:pt>
                <c:pt idx="3226">
                  <c:v>0.12008647067252551</c:v>
                </c:pt>
                <c:pt idx="3227">
                  <c:v>0.15574923267794485</c:v>
                </c:pt>
                <c:pt idx="3228">
                  <c:v>0.74140226591959002</c:v>
                </c:pt>
                <c:pt idx="3229">
                  <c:v>-0.19429481516148869</c:v>
                </c:pt>
                <c:pt idx="3230">
                  <c:v>0.60511500168943755</c:v>
                </c:pt>
                <c:pt idx="3231">
                  <c:v>0.1950955771772184</c:v>
                </c:pt>
                <c:pt idx="3232">
                  <c:v>9.1665987521812903E-2</c:v>
                </c:pt>
                <c:pt idx="3233">
                  <c:v>3.125402547050081E-2</c:v>
                </c:pt>
                <c:pt idx="3234">
                  <c:v>0.23535944739094555</c:v>
                </c:pt>
                <c:pt idx="3235">
                  <c:v>0.29760229865200793</c:v>
                </c:pt>
                <c:pt idx="3236">
                  <c:v>-4.5431429247006001E-2</c:v>
                </c:pt>
                <c:pt idx="3237">
                  <c:v>-0.12705307233206642</c:v>
                </c:pt>
                <c:pt idx="3238">
                  <c:v>-0.2942432179502027</c:v>
                </c:pt>
                <c:pt idx="3239">
                  <c:v>6.7087964801146954E-2</c:v>
                </c:pt>
                <c:pt idx="3240">
                  <c:v>8.0521231831492415E-2</c:v>
                </c:pt>
                <c:pt idx="3241">
                  <c:v>-0.49370273452847768</c:v>
                </c:pt>
                <c:pt idx="3242">
                  <c:v>1.9061365093430198E-2</c:v>
                </c:pt>
                <c:pt idx="3243">
                  <c:v>0.48851500895781214</c:v>
                </c:pt>
                <c:pt idx="3244">
                  <c:v>0.42502954752628558</c:v>
                </c:pt>
                <c:pt idx="3245">
                  <c:v>-0.94869751129936897</c:v>
                </c:pt>
                <c:pt idx="3246">
                  <c:v>-0.18803582468980631</c:v>
                </c:pt>
                <c:pt idx="3247">
                  <c:v>9.3965750369447459E-2</c:v>
                </c:pt>
                <c:pt idx="3248">
                  <c:v>0.21375164631100604</c:v>
                </c:pt>
                <c:pt idx="3249">
                  <c:v>-7.917317281108581E-2</c:v>
                </c:pt>
                <c:pt idx="3250">
                  <c:v>8.569658067924632E-2</c:v>
                </c:pt>
                <c:pt idx="3251">
                  <c:v>0.24086382278574986</c:v>
                </c:pt>
                <c:pt idx="3252">
                  <c:v>-0.4831779765542239</c:v>
                </c:pt>
                <c:pt idx="3253">
                  <c:v>0.14339341869318775</c:v>
                </c:pt>
                <c:pt idx="3254">
                  <c:v>-0.21440760129576947</c:v>
                </c:pt>
                <c:pt idx="3255">
                  <c:v>7.6832695557398592E-2</c:v>
                </c:pt>
                <c:pt idx="3256">
                  <c:v>-9.3109404391481479E-2</c:v>
                </c:pt>
                <c:pt idx="3257">
                  <c:v>0.18256518222108284</c:v>
                </c:pt>
                <c:pt idx="3258">
                  <c:v>0.56208364269615918</c:v>
                </c:pt>
                <c:pt idx="3259">
                  <c:v>0.17056605679206857</c:v>
                </c:pt>
                <c:pt idx="3260">
                  <c:v>2.786177535450958E-2</c:v>
                </c:pt>
                <c:pt idx="3261">
                  <c:v>5.269411130384509E-2</c:v>
                </c:pt>
                <c:pt idx="3262">
                  <c:v>-0.59444323665624321</c:v>
                </c:pt>
                <c:pt idx="3263">
                  <c:v>0.60065036162119478</c:v>
                </c:pt>
                <c:pt idx="3264">
                  <c:v>0.16671544496642232</c:v>
                </c:pt>
                <c:pt idx="3265">
                  <c:v>0.48933740888938171</c:v>
                </c:pt>
                <c:pt idx="3266">
                  <c:v>0.75804728183323367</c:v>
                </c:pt>
                <c:pt idx="3267">
                  <c:v>0.14274017211608214</c:v>
                </c:pt>
                <c:pt idx="3268">
                  <c:v>-0.40526037766731376</c:v>
                </c:pt>
                <c:pt idx="3269">
                  <c:v>0.28475100953422644</c:v>
                </c:pt>
                <c:pt idx="3270">
                  <c:v>-0.14464809891803829</c:v>
                </c:pt>
                <c:pt idx="3271">
                  <c:v>0.20701822594562194</c:v>
                </c:pt>
                <c:pt idx="3272">
                  <c:v>0.25362627842137686</c:v>
                </c:pt>
                <c:pt idx="3273">
                  <c:v>-0.26638534692507693</c:v>
                </c:pt>
                <c:pt idx="3274">
                  <c:v>-2.4546686295154373E-3</c:v>
                </c:pt>
                <c:pt idx="3275">
                  <c:v>-7.4152452072991204E-2</c:v>
                </c:pt>
                <c:pt idx="3276">
                  <c:v>0.14130198762525845</c:v>
                </c:pt>
                <c:pt idx="3277">
                  <c:v>-0.12658049656514306</c:v>
                </c:pt>
                <c:pt idx="3278">
                  <c:v>8.800587129002016E-2</c:v>
                </c:pt>
                <c:pt idx="3279">
                  <c:v>-0.51560403749733374</c:v>
                </c:pt>
                <c:pt idx="3280">
                  <c:v>-0.31670778147602041</c:v>
                </c:pt>
                <c:pt idx="3281">
                  <c:v>0.27262045466299184</c:v>
                </c:pt>
                <c:pt idx="3282">
                  <c:v>-0.44595149274890361</c:v>
                </c:pt>
                <c:pt idx="3283">
                  <c:v>-0.15939577664590515</c:v>
                </c:pt>
                <c:pt idx="3284">
                  <c:v>0.75445997362547879</c:v>
                </c:pt>
                <c:pt idx="3285">
                  <c:v>-0.37332724739400663</c:v>
                </c:pt>
                <c:pt idx="3286">
                  <c:v>2.0626650589957819E-2</c:v>
                </c:pt>
                <c:pt idx="3287">
                  <c:v>6.7776372048492753E-2</c:v>
                </c:pt>
                <c:pt idx="3288">
                  <c:v>0.12260646265104097</c:v>
                </c:pt>
                <c:pt idx="3289">
                  <c:v>0.24622564851987147</c:v>
                </c:pt>
                <c:pt idx="3290">
                  <c:v>0.51237860807554536</c:v>
                </c:pt>
                <c:pt idx="3291">
                  <c:v>-0.4773415793657213</c:v>
                </c:pt>
                <c:pt idx="3292">
                  <c:v>-0.16181464778912144</c:v>
                </c:pt>
                <c:pt idx="3293">
                  <c:v>-0.29159201651640371</c:v>
                </c:pt>
                <c:pt idx="3294">
                  <c:v>0.54517763461529234</c:v>
                </c:pt>
                <c:pt idx="3295">
                  <c:v>-3.5490466611088241E-2</c:v>
                </c:pt>
                <c:pt idx="3296">
                  <c:v>0.32146635859252998</c:v>
                </c:pt>
                <c:pt idx="3297">
                  <c:v>0.18966644665005042</c:v>
                </c:pt>
                <c:pt idx="3298">
                  <c:v>0.17043786850810766</c:v>
                </c:pt>
                <c:pt idx="3299">
                  <c:v>0.12485746725576016</c:v>
                </c:pt>
                <c:pt idx="3300">
                  <c:v>-0.50799302440604521</c:v>
                </c:pt>
                <c:pt idx="3301">
                  <c:v>-0.30489701435952116</c:v>
                </c:pt>
                <c:pt idx="3302">
                  <c:v>-0.34354939369466136</c:v>
                </c:pt>
                <c:pt idx="3303">
                  <c:v>7.3957299943324409E-2</c:v>
                </c:pt>
                <c:pt idx="3304">
                  <c:v>0.60511500168943755</c:v>
                </c:pt>
                <c:pt idx="3305">
                  <c:v>-0.27840860122461997</c:v>
                </c:pt>
                <c:pt idx="3306">
                  <c:v>-9.8351089083652837E-2</c:v>
                </c:pt>
                <c:pt idx="3307">
                  <c:v>0.25531944070578838</c:v>
                </c:pt>
                <c:pt idx="3308">
                  <c:v>-0.41657719530640408</c:v>
                </c:pt>
                <c:pt idx="3309">
                  <c:v>-0.912401382076379</c:v>
                </c:pt>
                <c:pt idx="3310">
                  <c:v>-1.8411459704833821</c:v>
                </c:pt>
                <c:pt idx="3311">
                  <c:v>0.14535138557262012</c:v>
                </c:pt>
                <c:pt idx="3312">
                  <c:v>0.27345621132030545</c:v>
                </c:pt>
                <c:pt idx="3313">
                  <c:v>-0.21859831777551078</c:v>
                </c:pt>
                <c:pt idx="3314">
                  <c:v>0.21636173497112735</c:v>
                </c:pt>
                <c:pt idx="3315">
                  <c:v>-1.3625473915035144E-2</c:v>
                </c:pt>
                <c:pt idx="3316">
                  <c:v>0.98804839748319351</c:v>
                </c:pt>
                <c:pt idx="3317">
                  <c:v>0.29771967204351296</c:v>
                </c:pt>
                <c:pt idx="3318">
                  <c:v>0.14821827215414507</c:v>
                </c:pt>
                <c:pt idx="3319">
                  <c:v>-0.19842743053640191</c:v>
                </c:pt>
                <c:pt idx="3320">
                  <c:v>-2.3101606872011158E-3</c:v>
                </c:pt>
                <c:pt idx="3321">
                  <c:v>0.27417218902278639</c:v>
                </c:pt>
                <c:pt idx="3322">
                  <c:v>8.7191249562623016E-2</c:v>
                </c:pt>
                <c:pt idx="3323">
                  <c:v>0.41824392991209242</c:v>
                </c:pt>
                <c:pt idx="3324">
                  <c:v>0.18154785645595639</c:v>
                </c:pt>
                <c:pt idx="3325">
                  <c:v>0.16272565284620308</c:v>
                </c:pt>
                <c:pt idx="3326">
                  <c:v>6.5434445948633138E-2</c:v>
                </c:pt>
                <c:pt idx="3327">
                  <c:v>-1.2937125877569264</c:v>
                </c:pt>
                <c:pt idx="3328">
                  <c:v>-2.8116217061027168E-2</c:v>
                </c:pt>
                <c:pt idx="3329">
                  <c:v>0.17363916357057899</c:v>
                </c:pt>
                <c:pt idx="3330">
                  <c:v>0.59798399378994593</c:v>
                </c:pt>
                <c:pt idx="3331">
                  <c:v>7.7653185650161383E-2</c:v>
                </c:pt>
                <c:pt idx="3332">
                  <c:v>0.17849156782231052</c:v>
                </c:pt>
                <c:pt idx="3333">
                  <c:v>-0.48539797355795911</c:v>
                </c:pt>
                <c:pt idx="3334">
                  <c:v>0.15950002202321961</c:v>
                </c:pt>
                <c:pt idx="3335">
                  <c:v>0.17555653643184002</c:v>
                </c:pt>
                <c:pt idx="3336">
                  <c:v>0.19673292822219471</c:v>
                </c:pt>
                <c:pt idx="3337">
                  <c:v>-0.15891248870406582</c:v>
                </c:pt>
                <c:pt idx="3338">
                  <c:v>7.2448850069692441E-2</c:v>
                </c:pt>
                <c:pt idx="3339">
                  <c:v>0.53515715633450711</c:v>
                </c:pt>
                <c:pt idx="3340">
                  <c:v>-5.3793170962472027E-2</c:v>
                </c:pt>
                <c:pt idx="3341">
                  <c:v>-0.11778737810713708</c:v>
                </c:pt>
                <c:pt idx="3342">
                  <c:v>0.28012489197572954</c:v>
                </c:pt>
                <c:pt idx="3343">
                  <c:v>0.30731193906418769</c:v>
                </c:pt>
                <c:pt idx="3344">
                  <c:v>0.31034012061215049</c:v>
                </c:pt>
                <c:pt idx="3345">
                  <c:v>-2.5030237187284567E-2</c:v>
                </c:pt>
                <c:pt idx="3346">
                  <c:v>8.0657663345225186E-2</c:v>
                </c:pt>
                <c:pt idx="3347">
                  <c:v>0.37951006655306796</c:v>
                </c:pt>
                <c:pt idx="3348">
                  <c:v>1.1384868442748062</c:v>
                </c:pt>
                <c:pt idx="3349">
                  <c:v>-0.19000941602479479</c:v>
                </c:pt>
                <c:pt idx="3350">
                  <c:v>0.16169423543613154</c:v>
                </c:pt>
                <c:pt idx="3351">
                  <c:v>5.7592692886849527E-3</c:v>
                </c:pt>
                <c:pt idx="3352">
                  <c:v>2.9841557136715127E-2</c:v>
                </c:pt>
                <c:pt idx="3353">
                  <c:v>5.1024003024466885E-2</c:v>
                </c:pt>
                <c:pt idx="3354">
                  <c:v>-1.6483716708972176</c:v>
                </c:pt>
                <c:pt idx="3355">
                  <c:v>0.18726100484169694</c:v>
                </c:pt>
                <c:pt idx="3356">
                  <c:v>-7.3393258748683562E-2</c:v>
                </c:pt>
                <c:pt idx="3357">
                  <c:v>0.17887395816979515</c:v>
                </c:pt>
                <c:pt idx="3358">
                  <c:v>0.50334873516750422</c:v>
                </c:pt>
                <c:pt idx="3359">
                  <c:v>-0.50266866476972527</c:v>
                </c:pt>
                <c:pt idx="3360">
                  <c:v>1.310979883798131</c:v>
                </c:pt>
                <c:pt idx="3361">
                  <c:v>5.1843758597232576E-3</c:v>
                </c:pt>
                <c:pt idx="3362">
                  <c:v>-0.19396471676378066</c:v>
                </c:pt>
                <c:pt idx="3363">
                  <c:v>-0.56597232533640263</c:v>
                </c:pt>
                <c:pt idx="3364">
                  <c:v>0.75634015225185269</c:v>
                </c:pt>
                <c:pt idx="3365">
                  <c:v>0.29548794305975318</c:v>
                </c:pt>
                <c:pt idx="3366">
                  <c:v>0.1397314222437436</c:v>
                </c:pt>
                <c:pt idx="3367">
                  <c:v>-5.1249658175554769E-2</c:v>
                </c:pt>
                <c:pt idx="3368">
                  <c:v>-3.9043539826313409E-2</c:v>
                </c:pt>
                <c:pt idx="3369">
                  <c:v>0.30170469621916018</c:v>
                </c:pt>
                <c:pt idx="3370">
                  <c:v>-0.2735175127349504</c:v>
                </c:pt>
                <c:pt idx="3371">
                  <c:v>0.38967693695196187</c:v>
                </c:pt>
                <c:pt idx="3372">
                  <c:v>0.33055840003080245</c:v>
                </c:pt>
                <c:pt idx="3373">
                  <c:v>-0.35549762758106423</c:v>
                </c:pt>
                <c:pt idx="3374">
                  <c:v>0.2311866132278648</c:v>
                </c:pt>
                <c:pt idx="3375">
                  <c:v>0.35625651637281824</c:v>
                </c:pt>
                <c:pt idx="3376">
                  <c:v>-3.2241152082382186E-2</c:v>
                </c:pt>
                <c:pt idx="3377">
                  <c:v>0.25023398082675447</c:v>
                </c:pt>
                <c:pt idx="3378">
                  <c:v>0.13119435170845012</c:v>
                </c:pt>
                <c:pt idx="3379">
                  <c:v>0.57811753162393764</c:v>
                </c:pt>
                <c:pt idx="3380">
                  <c:v>0.18726100484169694</c:v>
                </c:pt>
                <c:pt idx="3381">
                  <c:v>0.62199323166612308</c:v>
                </c:pt>
                <c:pt idx="3382">
                  <c:v>0.1779815563133707</c:v>
                </c:pt>
                <c:pt idx="3383">
                  <c:v>0.22070141650652012</c:v>
                </c:pt>
                <c:pt idx="3384">
                  <c:v>0.43189034828618045</c:v>
                </c:pt>
                <c:pt idx="3385">
                  <c:v>0.13369503251307499</c:v>
                </c:pt>
                <c:pt idx="3386">
                  <c:v>4.6979908144409395E-2</c:v>
                </c:pt>
                <c:pt idx="3387">
                  <c:v>0.2900704696015407</c:v>
                </c:pt>
                <c:pt idx="3388">
                  <c:v>6.5296567127780952E-2</c:v>
                </c:pt>
                <c:pt idx="3389">
                  <c:v>0.235972082773581</c:v>
                </c:pt>
                <c:pt idx="3390">
                  <c:v>0.15055967657538141</c:v>
                </c:pt>
                <c:pt idx="3391">
                  <c:v>6.9977070411556347E-2</c:v>
                </c:pt>
                <c:pt idx="3392">
                  <c:v>7.2174416924316628E-2</c:v>
                </c:pt>
                <c:pt idx="3393">
                  <c:v>0.32342771806093251</c:v>
                </c:pt>
                <c:pt idx="3394">
                  <c:v>0.4723837896946429</c:v>
                </c:pt>
                <c:pt idx="3395">
                  <c:v>0.14886904353100072</c:v>
                </c:pt>
                <c:pt idx="3396">
                  <c:v>-0.1295760941418076</c:v>
                </c:pt>
                <c:pt idx="3397">
                  <c:v>0.24938465863022038</c:v>
                </c:pt>
                <c:pt idx="3398">
                  <c:v>-7.521587332542789E-3</c:v>
                </c:pt>
                <c:pt idx="3399">
                  <c:v>-5.0502418794427899E-2</c:v>
                </c:pt>
                <c:pt idx="3400">
                  <c:v>-0.41119543298444972</c:v>
                </c:pt>
                <c:pt idx="3401">
                  <c:v>1.2561048768091785</c:v>
                </c:pt>
                <c:pt idx="3402">
                  <c:v>0.14274017211608214</c:v>
                </c:pt>
                <c:pt idx="3403">
                  <c:v>2.0768865094571851E-2</c:v>
                </c:pt>
                <c:pt idx="3404">
                  <c:v>-0.79010999276596061</c:v>
                </c:pt>
                <c:pt idx="3405">
                  <c:v>0.12578333162732361</c:v>
                </c:pt>
                <c:pt idx="3406">
                  <c:v>0.72159139877538003</c:v>
                </c:pt>
                <c:pt idx="3407">
                  <c:v>0.79809200072863606</c:v>
                </c:pt>
                <c:pt idx="3408">
                  <c:v>0.58563560136230075</c:v>
                </c:pt>
                <c:pt idx="3409">
                  <c:v>0.65754854778975258</c:v>
                </c:pt>
                <c:pt idx="3410">
                  <c:v>4.2504263128963445E-2</c:v>
                </c:pt>
                <c:pt idx="3411">
                  <c:v>0.18052981281072061</c:v>
                </c:pt>
                <c:pt idx="3412">
                  <c:v>0.35354913572204438</c:v>
                </c:pt>
                <c:pt idx="3413">
                  <c:v>0.35884633060509863</c:v>
                </c:pt>
                <c:pt idx="3414">
                  <c:v>-1.1546179414920685E-3</c:v>
                </c:pt>
                <c:pt idx="3415">
                  <c:v>-6.6427361738976065E-2</c:v>
                </c:pt>
                <c:pt idx="3416">
                  <c:v>0.1290851480566105</c:v>
                </c:pt>
                <c:pt idx="3417">
                  <c:v>-0.36382783316411504</c:v>
                </c:pt>
                <c:pt idx="3418">
                  <c:v>-0.29070936427664218</c:v>
                </c:pt>
                <c:pt idx="3419">
                  <c:v>0.70902589674823413</c:v>
                </c:pt>
                <c:pt idx="3420">
                  <c:v>-0.26274589567567025</c:v>
                </c:pt>
                <c:pt idx="3421">
                  <c:v>0.50741409901544032</c:v>
                </c:pt>
                <c:pt idx="3422">
                  <c:v>0.31034012061215049</c:v>
                </c:pt>
                <c:pt idx="3423">
                  <c:v>0.26399588207123914</c:v>
                </c:pt>
                <c:pt idx="3424">
                  <c:v>-2.4296451992233268E-2</c:v>
                </c:pt>
                <c:pt idx="3425">
                  <c:v>0.18370881687541188</c:v>
                </c:pt>
                <c:pt idx="3426">
                  <c:v>0.20062989798307435</c:v>
                </c:pt>
                <c:pt idx="3427">
                  <c:v>-6.7031758497245478E-2</c:v>
                </c:pt>
                <c:pt idx="3428">
                  <c:v>4.7957107396655034E-2</c:v>
                </c:pt>
                <c:pt idx="3429">
                  <c:v>0.40130279234911409</c:v>
                </c:pt>
                <c:pt idx="3430">
                  <c:v>0.53873679987421674</c:v>
                </c:pt>
                <c:pt idx="3431">
                  <c:v>-0.5280322123384843</c:v>
                </c:pt>
                <c:pt idx="3432">
                  <c:v>0.4331731240442756</c:v>
                </c:pt>
                <c:pt idx="3433">
                  <c:v>-1.3375210295767486</c:v>
                </c:pt>
                <c:pt idx="3434">
                  <c:v>0.28427721805512784</c:v>
                </c:pt>
                <c:pt idx="3435">
                  <c:v>0.28368475981474189</c:v>
                </c:pt>
                <c:pt idx="3436">
                  <c:v>0.49282738792251163</c:v>
                </c:pt>
                <c:pt idx="3437">
                  <c:v>2.4319679195412894E-2</c:v>
                </c:pt>
                <c:pt idx="3438">
                  <c:v>-0.37913211553671566</c:v>
                </c:pt>
                <c:pt idx="3439">
                  <c:v>-1.0406749607608679</c:v>
                </c:pt>
              </c:numCache>
            </c:numRef>
          </c:xVal>
          <c:yVal>
            <c:numRef>
              <c:f>'HFD - NC Prot'!$B$2:$B$3441</c:f>
              <c:numCache>
                <c:formatCode>General</c:formatCode>
                <c:ptCount val="3440"/>
                <c:pt idx="0">
                  <c:v>0.46537898959268753</c:v>
                </c:pt>
                <c:pt idx="1">
                  <c:v>0.84348722693289435</c:v>
                </c:pt>
                <c:pt idx="2">
                  <c:v>0.11951001287468058</c:v>
                </c:pt>
                <c:pt idx="3">
                  <c:v>8.9109671736133045E-2</c:v>
                </c:pt>
                <c:pt idx="4">
                  <c:v>0.6546646880647301</c:v>
                </c:pt>
                <c:pt idx="5">
                  <c:v>0.75301725150567722</c:v>
                </c:pt>
                <c:pt idx="6">
                  <c:v>7.4858210863648382E-3</c:v>
                </c:pt>
                <c:pt idx="7">
                  <c:v>0.17474134787098736</c:v>
                </c:pt>
                <c:pt idx="8">
                  <c:v>0.6507546071819188</c:v>
                </c:pt>
                <c:pt idx="9">
                  <c:v>0.40556154191952376</c:v>
                </c:pt>
                <c:pt idx="10">
                  <c:v>0.90389195688532442</c:v>
                </c:pt>
                <c:pt idx="11">
                  <c:v>0.39363089796144202</c:v>
                </c:pt>
                <c:pt idx="12">
                  <c:v>0.86428185870243579</c:v>
                </c:pt>
                <c:pt idx="13">
                  <c:v>0.19435428588814702</c:v>
                </c:pt>
                <c:pt idx="14">
                  <c:v>1.5477697015542944E-2</c:v>
                </c:pt>
                <c:pt idx="15">
                  <c:v>8.4265658661346818E-2</c:v>
                </c:pt>
                <c:pt idx="16">
                  <c:v>0.28953501514317387</c:v>
                </c:pt>
                <c:pt idx="17">
                  <c:v>0.38027738450283693</c:v>
                </c:pt>
                <c:pt idx="18">
                  <c:v>0.1145811237789352</c:v>
                </c:pt>
                <c:pt idx="19">
                  <c:v>0.36247514542994519</c:v>
                </c:pt>
                <c:pt idx="20">
                  <c:v>5.5380590415563924E-2</c:v>
                </c:pt>
                <c:pt idx="21">
                  <c:v>0.90454838470218579</c:v>
                </c:pt>
                <c:pt idx="22">
                  <c:v>8.7957509178696866E-2</c:v>
                </c:pt>
                <c:pt idx="23">
                  <c:v>9.152979958944242E-2</c:v>
                </c:pt>
                <c:pt idx="24">
                  <c:v>2.4669793925594221</c:v>
                </c:pt>
                <c:pt idx="25">
                  <c:v>0.49112559374905118</c:v>
                </c:pt>
                <c:pt idx="26">
                  <c:v>0.44650006160154243</c:v>
                </c:pt>
                <c:pt idx="27">
                  <c:v>0.7405948422684564</c:v>
                </c:pt>
                <c:pt idx="28">
                  <c:v>0.27356008721823299</c:v>
                </c:pt>
                <c:pt idx="29">
                  <c:v>1.0083737823981509</c:v>
                </c:pt>
                <c:pt idx="30">
                  <c:v>0.87511707831874441</c:v>
                </c:pt>
                <c:pt idx="31">
                  <c:v>1.4346596565497993</c:v>
                </c:pt>
                <c:pt idx="32">
                  <c:v>8.2004051108344966E-2</c:v>
                </c:pt>
                <c:pt idx="33">
                  <c:v>1.3824264784261704</c:v>
                </c:pt>
                <c:pt idx="34">
                  <c:v>0.18387176309451994</c:v>
                </c:pt>
                <c:pt idx="35">
                  <c:v>0.76015831951678547</c:v>
                </c:pt>
                <c:pt idx="36">
                  <c:v>1.6256475687625616E-2</c:v>
                </c:pt>
                <c:pt idx="37">
                  <c:v>0.43181329180560779</c:v>
                </c:pt>
                <c:pt idx="38">
                  <c:v>0.57315590765437463</c:v>
                </c:pt>
                <c:pt idx="39">
                  <c:v>1.6097233630405664E-2</c:v>
                </c:pt>
                <c:pt idx="40">
                  <c:v>0.45261830351453874</c:v>
                </c:pt>
                <c:pt idx="41">
                  <c:v>0.7363906175415158</c:v>
                </c:pt>
                <c:pt idx="42">
                  <c:v>0.32780156646966507</c:v>
                </c:pt>
                <c:pt idx="43">
                  <c:v>0.72758792917724036</c:v>
                </c:pt>
                <c:pt idx="44">
                  <c:v>0.65141261170069309</c:v>
                </c:pt>
                <c:pt idx="45">
                  <c:v>0.5861106711578068</c:v>
                </c:pt>
                <c:pt idx="46">
                  <c:v>0.47978671400651907</c:v>
                </c:pt>
                <c:pt idx="47">
                  <c:v>0.15768909905046144</c:v>
                </c:pt>
                <c:pt idx="48">
                  <c:v>0.28868144093398462</c:v>
                </c:pt>
                <c:pt idx="49">
                  <c:v>4.3404114952840772E-2</c:v>
                </c:pt>
                <c:pt idx="50">
                  <c:v>0.63864357076928846</c:v>
                </c:pt>
                <c:pt idx="51">
                  <c:v>2.5298054352553799E-2</c:v>
                </c:pt>
                <c:pt idx="52">
                  <c:v>1.919789862196938E-2</c:v>
                </c:pt>
                <c:pt idx="53">
                  <c:v>0.30580175960469774</c:v>
                </c:pt>
                <c:pt idx="54">
                  <c:v>1.296198487407106</c:v>
                </c:pt>
                <c:pt idx="55">
                  <c:v>3.9057611921238307E-2</c:v>
                </c:pt>
                <c:pt idx="56">
                  <c:v>0.47595321348773845</c:v>
                </c:pt>
                <c:pt idx="57">
                  <c:v>0.5057310851775958</c:v>
                </c:pt>
                <c:pt idx="58">
                  <c:v>1.3905892173694006</c:v>
                </c:pt>
                <c:pt idx="59">
                  <c:v>2.1890377153432956</c:v>
                </c:pt>
                <c:pt idx="60">
                  <c:v>0.52339674308382511</c:v>
                </c:pt>
                <c:pt idx="61">
                  <c:v>0.59389186902547209</c:v>
                </c:pt>
                <c:pt idx="62">
                  <c:v>1.9561282597426732E-2</c:v>
                </c:pt>
                <c:pt idx="63">
                  <c:v>0.44938623224794405</c:v>
                </c:pt>
                <c:pt idx="64">
                  <c:v>0.11859676511718625</c:v>
                </c:pt>
                <c:pt idx="65">
                  <c:v>0.44411522240240781</c:v>
                </c:pt>
                <c:pt idx="66">
                  <c:v>0.62750437566503525</c:v>
                </c:pt>
                <c:pt idx="67">
                  <c:v>0.39491108848422379</c:v>
                </c:pt>
                <c:pt idx="68">
                  <c:v>1.044279226633259</c:v>
                </c:pt>
                <c:pt idx="69">
                  <c:v>0.84227870135232386</c:v>
                </c:pt>
                <c:pt idx="70">
                  <c:v>0.38835314922721531</c:v>
                </c:pt>
                <c:pt idx="71">
                  <c:v>0.84186859253605539</c:v>
                </c:pt>
                <c:pt idx="72">
                  <c:v>0.16720770471588448</c:v>
                </c:pt>
                <c:pt idx="73">
                  <c:v>0.79180042101859738</c:v>
                </c:pt>
                <c:pt idx="74">
                  <c:v>0.58622174588078091</c:v>
                </c:pt>
                <c:pt idx="75">
                  <c:v>1.1423742046586938</c:v>
                </c:pt>
                <c:pt idx="76">
                  <c:v>3.8706430755614189E-2</c:v>
                </c:pt>
                <c:pt idx="77">
                  <c:v>9.0814108921249276E-2</c:v>
                </c:pt>
                <c:pt idx="78">
                  <c:v>0.20686625273241116</c:v>
                </c:pt>
                <c:pt idx="79">
                  <c:v>0.79105158076976334</c:v>
                </c:pt>
                <c:pt idx="80">
                  <c:v>0.28013360443931451</c:v>
                </c:pt>
                <c:pt idx="81">
                  <c:v>0.52854710644179381</c:v>
                </c:pt>
                <c:pt idx="82">
                  <c:v>2.0746980580866943</c:v>
                </c:pt>
                <c:pt idx="83">
                  <c:v>0.21923487646522183</c:v>
                </c:pt>
                <c:pt idx="84">
                  <c:v>0.18941335555293651</c:v>
                </c:pt>
                <c:pt idx="85">
                  <c:v>0.38610003045896968</c:v>
                </c:pt>
                <c:pt idx="86">
                  <c:v>0.53831007569010492</c:v>
                </c:pt>
                <c:pt idx="87">
                  <c:v>0.74958372580482913</c:v>
                </c:pt>
                <c:pt idx="88">
                  <c:v>0.56023504248965261</c:v>
                </c:pt>
                <c:pt idx="89">
                  <c:v>1.0578374831883719</c:v>
                </c:pt>
                <c:pt idx="90">
                  <c:v>0.34021276784065918</c:v>
                </c:pt>
                <c:pt idx="91">
                  <c:v>2.0903906262999948E-2</c:v>
                </c:pt>
                <c:pt idx="92">
                  <c:v>0.35662506024847268</c:v>
                </c:pt>
                <c:pt idx="93">
                  <c:v>0.55115945102225761</c:v>
                </c:pt>
                <c:pt idx="94">
                  <c:v>4.2592975659058001E-3</c:v>
                </c:pt>
                <c:pt idx="95">
                  <c:v>0.16018694997179769</c:v>
                </c:pt>
                <c:pt idx="96">
                  <c:v>0.31810680328100699</c:v>
                </c:pt>
                <c:pt idx="97">
                  <c:v>1.2607485428609713</c:v>
                </c:pt>
                <c:pt idx="98">
                  <c:v>0.68610194247983514</c:v>
                </c:pt>
                <c:pt idx="99">
                  <c:v>1.6295571022767463E-2</c:v>
                </c:pt>
                <c:pt idx="100">
                  <c:v>0.52423412592101293</c:v>
                </c:pt>
                <c:pt idx="101">
                  <c:v>0.12180897008648658</c:v>
                </c:pt>
                <c:pt idx="102">
                  <c:v>0.27191888331356878</c:v>
                </c:pt>
                <c:pt idx="103">
                  <c:v>0.27198228545286857</c:v>
                </c:pt>
                <c:pt idx="104">
                  <c:v>0.18109944980991546</c:v>
                </c:pt>
                <c:pt idx="105">
                  <c:v>0.41233741690115749</c:v>
                </c:pt>
                <c:pt idx="106">
                  <c:v>3.8109840231672083E-2</c:v>
                </c:pt>
                <c:pt idx="107">
                  <c:v>0.11889016018151911</c:v>
                </c:pt>
                <c:pt idx="108">
                  <c:v>1.1966189790590484E-3</c:v>
                </c:pt>
                <c:pt idx="109">
                  <c:v>5.1891397754540693E-2</c:v>
                </c:pt>
                <c:pt idx="110">
                  <c:v>0.118168733719407</c:v>
                </c:pt>
                <c:pt idx="111">
                  <c:v>0.22993365565850185</c:v>
                </c:pt>
                <c:pt idx="112">
                  <c:v>0.65921901088200807</c:v>
                </c:pt>
                <c:pt idx="113">
                  <c:v>0.96533705173647233</c:v>
                </c:pt>
                <c:pt idx="114">
                  <c:v>1.1558383655609614</c:v>
                </c:pt>
                <c:pt idx="115">
                  <c:v>1.2060699251770033</c:v>
                </c:pt>
                <c:pt idx="116">
                  <c:v>0.70959869789909902</c:v>
                </c:pt>
                <c:pt idx="117">
                  <c:v>0.77526991955834934</c:v>
                </c:pt>
                <c:pt idx="118">
                  <c:v>0.19532394942564013</c:v>
                </c:pt>
                <c:pt idx="119">
                  <c:v>0.11169310741182802</c:v>
                </c:pt>
                <c:pt idx="120">
                  <c:v>0.93749893984633847</c:v>
                </c:pt>
                <c:pt idx="121">
                  <c:v>1.1844902365885857</c:v>
                </c:pt>
                <c:pt idx="122">
                  <c:v>0.10700231725685004</c:v>
                </c:pt>
                <c:pt idx="123">
                  <c:v>0.61861268031823657</c:v>
                </c:pt>
                <c:pt idx="124">
                  <c:v>0.2591761101686173</c:v>
                </c:pt>
                <c:pt idx="125">
                  <c:v>0.24474474414098865</c:v>
                </c:pt>
                <c:pt idx="126">
                  <c:v>0.84095370917435452</c:v>
                </c:pt>
                <c:pt idx="127">
                  <c:v>0.40777324062767711</c:v>
                </c:pt>
                <c:pt idx="128">
                  <c:v>0.25605570717952492</c:v>
                </c:pt>
                <c:pt idx="129">
                  <c:v>8.0900216665959798E-2</c:v>
                </c:pt>
                <c:pt idx="130">
                  <c:v>0.12566389341734965</c:v>
                </c:pt>
                <c:pt idx="131">
                  <c:v>0.64937718584124648</c:v>
                </c:pt>
                <c:pt idx="132">
                  <c:v>0.15555077283806243</c:v>
                </c:pt>
                <c:pt idx="133">
                  <c:v>0.24393951628523494</c:v>
                </c:pt>
                <c:pt idx="134">
                  <c:v>1.0796614118111068</c:v>
                </c:pt>
                <c:pt idx="135">
                  <c:v>0.1742423948257048</c:v>
                </c:pt>
                <c:pt idx="136">
                  <c:v>0.39529967667950139</c:v>
                </c:pt>
                <c:pt idx="137">
                  <c:v>1.1079240933894836</c:v>
                </c:pt>
                <c:pt idx="138">
                  <c:v>0.24957661724586122</c:v>
                </c:pt>
                <c:pt idx="139">
                  <c:v>2.2298997670357461</c:v>
                </c:pt>
                <c:pt idx="140">
                  <c:v>0.55257024700147539</c:v>
                </c:pt>
                <c:pt idx="141">
                  <c:v>2.2892485278625394E-2</c:v>
                </c:pt>
                <c:pt idx="142">
                  <c:v>0.55581377218973116</c:v>
                </c:pt>
                <c:pt idx="143">
                  <c:v>0.93275882599014337</c:v>
                </c:pt>
                <c:pt idx="144">
                  <c:v>0.33224178621915651</c:v>
                </c:pt>
                <c:pt idx="145">
                  <c:v>0.27971451804823716</c:v>
                </c:pt>
                <c:pt idx="146">
                  <c:v>0.80565406705044584</c:v>
                </c:pt>
                <c:pt idx="147">
                  <c:v>9.8301014731428077E-2</c:v>
                </c:pt>
                <c:pt idx="148">
                  <c:v>0.25722885944293405</c:v>
                </c:pt>
                <c:pt idx="149">
                  <c:v>1.2108866122012686E-3</c:v>
                </c:pt>
                <c:pt idx="150">
                  <c:v>0.29967479900885913</c:v>
                </c:pt>
                <c:pt idx="151">
                  <c:v>0.12488755657118687</c:v>
                </c:pt>
                <c:pt idx="152">
                  <c:v>0.43289694355168001</c:v>
                </c:pt>
                <c:pt idx="153">
                  <c:v>0.30167479783932272</c:v>
                </c:pt>
                <c:pt idx="154">
                  <c:v>0.5787410180075705</c:v>
                </c:pt>
                <c:pt idx="155">
                  <c:v>0.10515048283687863</c:v>
                </c:pt>
                <c:pt idx="156">
                  <c:v>1.3129405602922963</c:v>
                </c:pt>
                <c:pt idx="157">
                  <c:v>3.1431629705419503E-3</c:v>
                </c:pt>
                <c:pt idx="158">
                  <c:v>0.45598522499750405</c:v>
                </c:pt>
                <c:pt idx="159">
                  <c:v>0.24601834316882942</c:v>
                </c:pt>
                <c:pt idx="160">
                  <c:v>9.3785803123713637E-2</c:v>
                </c:pt>
                <c:pt idx="161">
                  <c:v>0.13040433590330094</c:v>
                </c:pt>
                <c:pt idx="162">
                  <c:v>0.25533262219077124</c:v>
                </c:pt>
                <c:pt idx="163">
                  <c:v>0.18305296650574984</c:v>
                </c:pt>
                <c:pt idx="164">
                  <c:v>3.4644394572731309E-2</c:v>
                </c:pt>
                <c:pt idx="165">
                  <c:v>0.19447859824803956</c:v>
                </c:pt>
                <c:pt idx="166">
                  <c:v>0.55351409120897921</c:v>
                </c:pt>
                <c:pt idx="167">
                  <c:v>0.44325700643765853</c:v>
                </c:pt>
                <c:pt idx="168">
                  <c:v>0.5928926905557379</c:v>
                </c:pt>
                <c:pt idx="169">
                  <c:v>0.50056758515976474</c:v>
                </c:pt>
                <c:pt idx="170">
                  <c:v>0.33954852231293847</c:v>
                </c:pt>
                <c:pt idx="171">
                  <c:v>0.33190070777740083</c:v>
                </c:pt>
                <c:pt idx="172">
                  <c:v>0.40345797291827512</c:v>
                </c:pt>
                <c:pt idx="173">
                  <c:v>7.1627738860192025E-2</c:v>
                </c:pt>
                <c:pt idx="174">
                  <c:v>0.31255100268233632</c:v>
                </c:pt>
                <c:pt idx="175">
                  <c:v>0.13213869254039223</c:v>
                </c:pt>
                <c:pt idx="176">
                  <c:v>0.86185083587359357</c:v>
                </c:pt>
                <c:pt idx="177">
                  <c:v>0.1286189592764499</c:v>
                </c:pt>
                <c:pt idx="178">
                  <c:v>1.222996434152682</c:v>
                </c:pt>
                <c:pt idx="179">
                  <c:v>0.37729585071468691</c:v>
                </c:pt>
                <c:pt idx="180">
                  <c:v>4.9898138820653214E-2</c:v>
                </c:pt>
                <c:pt idx="181">
                  <c:v>0.47387422243252841</c:v>
                </c:pt>
                <c:pt idx="182">
                  <c:v>0.40106862167747293</c:v>
                </c:pt>
                <c:pt idx="183">
                  <c:v>0.11067052067710409</c:v>
                </c:pt>
                <c:pt idx="184">
                  <c:v>0.28592529111069509</c:v>
                </c:pt>
                <c:pt idx="185">
                  <c:v>1.6826361803283933</c:v>
                </c:pt>
                <c:pt idx="186">
                  <c:v>9.8135923694822949E-2</c:v>
                </c:pt>
                <c:pt idx="187">
                  <c:v>0.65537107071687373</c:v>
                </c:pt>
                <c:pt idx="188">
                  <c:v>6.0967627390725518E-2</c:v>
                </c:pt>
                <c:pt idx="189">
                  <c:v>0.24286121445167333</c:v>
                </c:pt>
                <c:pt idx="190">
                  <c:v>0.20919214985620463</c:v>
                </c:pt>
                <c:pt idx="191">
                  <c:v>0.30611161654934627</c:v>
                </c:pt>
                <c:pt idx="192">
                  <c:v>0.85980600991953893</c:v>
                </c:pt>
                <c:pt idx="193">
                  <c:v>7.4174714885660423E-2</c:v>
                </c:pt>
                <c:pt idx="194">
                  <c:v>0.37805631832642989</c:v>
                </c:pt>
                <c:pt idx="195">
                  <c:v>0.13025448142561671</c:v>
                </c:pt>
                <c:pt idx="196">
                  <c:v>0.30181069892510959</c:v>
                </c:pt>
                <c:pt idx="197">
                  <c:v>0.33526994600654098</c:v>
                </c:pt>
                <c:pt idx="198">
                  <c:v>8.5936860321254652E-3</c:v>
                </c:pt>
                <c:pt idx="199">
                  <c:v>0.20759682462812371</c:v>
                </c:pt>
                <c:pt idx="200">
                  <c:v>0.66134143336628481</c:v>
                </c:pt>
                <c:pt idx="201">
                  <c:v>7.1331334409082264E-2</c:v>
                </c:pt>
                <c:pt idx="202">
                  <c:v>0.12018415935907478</c:v>
                </c:pt>
                <c:pt idx="203">
                  <c:v>1.4890096626159197</c:v>
                </c:pt>
                <c:pt idx="204">
                  <c:v>0.15834743842100799</c:v>
                </c:pt>
                <c:pt idx="205">
                  <c:v>0.86447251761037025</c:v>
                </c:pt>
                <c:pt idx="206">
                  <c:v>0.79566198778047459</c:v>
                </c:pt>
                <c:pt idx="207">
                  <c:v>0.57478300887954392</c:v>
                </c:pt>
                <c:pt idx="208">
                  <c:v>0.4334350153017576</c:v>
                </c:pt>
                <c:pt idx="209">
                  <c:v>8.114599376185045E-3</c:v>
                </c:pt>
                <c:pt idx="210">
                  <c:v>1.0877899810993821</c:v>
                </c:pt>
                <c:pt idx="211">
                  <c:v>0.1439376932148938</c:v>
                </c:pt>
                <c:pt idx="212">
                  <c:v>0.39342963810076137</c:v>
                </c:pt>
                <c:pt idx="213">
                  <c:v>1.9709028064949441</c:v>
                </c:pt>
                <c:pt idx="214">
                  <c:v>0.39516749828170877</c:v>
                </c:pt>
                <c:pt idx="215">
                  <c:v>0.4861609189708116</c:v>
                </c:pt>
                <c:pt idx="216">
                  <c:v>0.51494342469187393</c:v>
                </c:pt>
                <c:pt idx="217">
                  <c:v>0.25062611280627922</c:v>
                </c:pt>
                <c:pt idx="218">
                  <c:v>0.2446607572328964</c:v>
                </c:pt>
                <c:pt idx="219">
                  <c:v>9.351155726603054E-2</c:v>
                </c:pt>
                <c:pt idx="220">
                  <c:v>0.65951745980365628</c:v>
                </c:pt>
                <c:pt idx="221">
                  <c:v>0.89230088690140286</c:v>
                </c:pt>
                <c:pt idx="222">
                  <c:v>0.51602683688655826</c:v>
                </c:pt>
                <c:pt idx="223">
                  <c:v>7.4587688367814931E-2</c:v>
                </c:pt>
                <c:pt idx="224">
                  <c:v>0.26906081850936764</c:v>
                </c:pt>
                <c:pt idx="225">
                  <c:v>9.3504016162659548E-2</c:v>
                </c:pt>
                <c:pt idx="226">
                  <c:v>4.4179789672885522E-2</c:v>
                </c:pt>
                <c:pt idx="227">
                  <c:v>1.568174585403727</c:v>
                </c:pt>
                <c:pt idx="228">
                  <c:v>0.32043239462182838</c:v>
                </c:pt>
                <c:pt idx="229">
                  <c:v>8.2029665496665655E-2</c:v>
                </c:pt>
                <c:pt idx="230">
                  <c:v>5.398157432773943E-2</c:v>
                </c:pt>
                <c:pt idx="231">
                  <c:v>0.13201387985073659</c:v>
                </c:pt>
                <c:pt idx="232">
                  <c:v>0.11015080421756955</c:v>
                </c:pt>
                <c:pt idx="233">
                  <c:v>0.44774689596144618</c:v>
                </c:pt>
                <c:pt idx="234">
                  <c:v>0.25222456931754639</c:v>
                </c:pt>
                <c:pt idx="235">
                  <c:v>7.0139478257151611E-2</c:v>
                </c:pt>
                <c:pt idx="236">
                  <c:v>0.87386302645987635</c:v>
                </c:pt>
                <c:pt idx="237">
                  <c:v>9.8985773061298687E-2</c:v>
                </c:pt>
                <c:pt idx="238">
                  <c:v>0.35104578371182632</c:v>
                </c:pt>
                <c:pt idx="239">
                  <c:v>7.4256612367938138E-2</c:v>
                </c:pt>
                <c:pt idx="240">
                  <c:v>0.42557845474816147</c:v>
                </c:pt>
                <c:pt idx="241">
                  <c:v>0.14631481275592728</c:v>
                </c:pt>
                <c:pt idx="242">
                  <c:v>6.4750801105599581E-2</c:v>
                </c:pt>
                <c:pt idx="243">
                  <c:v>0.11954608565753522</c:v>
                </c:pt>
                <c:pt idx="244">
                  <c:v>0.45085264018562532</c:v>
                </c:pt>
                <c:pt idx="245">
                  <c:v>2.133969941778531E-2</c:v>
                </c:pt>
                <c:pt idx="246">
                  <c:v>0.36694586915753313</c:v>
                </c:pt>
                <c:pt idx="247">
                  <c:v>0.19458079321946692</c:v>
                </c:pt>
                <c:pt idx="248">
                  <c:v>6.2288966534543785E-2</c:v>
                </c:pt>
                <c:pt idx="249">
                  <c:v>0.9695926048770982</c:v>
                </c:pt>
                <c:pt idx="250">
                  <c:v>3.959321661593794E-2</c:v>
                </c:pt>
                <c:pt idx="251">
                  <c:v>0.35346350774232493</c:v>
                </c:pt>
                <c:pt idx="252">
                  <c:v>0.18284458236471524</c:v>
                </c:pt>
                <c:pt idx="253">
                  <c:v>0.26419495591273645</c:v>
                </c:pt>
                <c:pt idx="254">
                  <c:v>0.59506780376187662</c:v>
                </c:pt>
                <c:pt idx="255">
                  <c:v>0.36248916045140328</c:v>
                </c:pt>
                <c:pt idx="256">
                  <c:v>0.76781959560489255</c:v>
                </c:pt>
                <c:pt idx="257">
                  <c:v>0.28692449846055129</c:v>
                </c:pt>
                <c:pt idx="258">
                  <c:v>0.18195415638767995</c:v>
                </c:pt>
                <c:pt idx="259">
                  <c:v>0.7327658435307125</c:v>
                </c:pt>
                <c:pt idx="260">
                  <c:v>0.19505226720949706</c:v>
                </c:pt>
                <c:pt idx="261">
                  <c:v>0.72383005863511041</c:v>
                </c:pt>
                <c:pt idx="262">
                  <c:v>0.10474117485074112</c:v>
                </c:pt>
                <c:pt idx="263">
                  <c:v>7.1316523499224155E-2</c:v>
                </c:pt>
                <c:pt idx="264">
                  <c:v>0.45143935161776794</c:v>
                </c:pt>
                <c:pt idx="265">
                  <c:v>0.83594600946162401</c:v>
                </c:pt>
                <c:pt idx="266">
                  <c:v>0.24406759297469655</c:v>
                </c:pt>
                <c:pt idx="267">
                  <c:v>0.82984400470052555</c:v>
                </c:pt>
                <c:pt idx="268">
                  <c:v>2.9595510464946555E-2</c:v>
                </c:pt>
                <c:pt idx="269">
                  <c:v>0.469306766932024</c:v>
                </c:pt>
                <c:pt idx="270">
                  <c:v>0.92723484137177214</c:v>
                </c:pt>
                <c:pt idx="271">
                  <c:v>1.1253839380780104</c:v>
                </c:pt>
                <c:pt idx="272">
                  <c:v>0.20135981284832277</c:v>
                </c:pt>
                <c:pt idx="273">
                  <c:v>0.48179347126168121</c:v>
                </c:pt>
                <c:pt idx="274">
                  <c:v>2.9792776933012738E-3</c:v>
                </c:pt>
                <c:pt idx="275">
                  <c:v>0.40798576669414327</c:v>
                </c:pt>
                <c:pt idx="276">
                  <c:v>1.2727337435703496</c:v>
                </c:pt>
                <c:pt idx="277">
                  <c:v>0.54155546707169522</c:v>
                </c:pt>
                <c:pt idx="278">
                  <c:v>0.54301778713253579</c:v>
                </c:pt>
                <c:pt idx="279">
                  <c:v>0.42268476175164305</c:v>
                </c:pt>
                <c:pt idx="280">
                  <c:v>0.21463855459083342</c:v>
                </c:pt>
                <c:pt idx="281">
                  <c:v>0.17075253083117994</c:v>
                </c:pt>
                <c:pt idx="282">
                  <c:v>0.40916770999801499</c:v>
                </c:pt>
                <c:pt idx="283">
                  <c:v>0.10752175200310715</c:v>
                </c:pt>
                <c:pt idx="284">
                  <c:v>0.22139073214542407</c:v>
                </c:pt>
                <c:pt idx="285">
                  <c:v>0.57630782770924893</c:v>
                </c:pt>
                <c:pt idx="286">
                  <c:v>0.22741388921631797</c:v>
                </c:pt>
                <c:pt idx="287">
                  <c:v>0.2122680916241981</c:v>
                </c:pt>
                <c:pt idx="288">
                  <c:v>7.8765029037964229E-2</c:v>
                </c:pt>
                <c:pt idx="289">
                  <c:v>0.64507822637830448</c:v>
                </c:pt>
                <c:pt idx="290">
                  <c:v>8.9300172870052819E-2</c:v>
                </c:pt>
                <c:pt idx="291">
                  <c:v>0.69414735863223942</c:v>
                </c:pt>
                <c:pt idx="292">
                  <c:v>1.805696712517451E-2</c:v>
                </c:pt>
                <c:pt idx="293">
                  <c:v>0.13395707750658775</c:v>
                </c:pt>
                <c:pt idx="294">
                  <c:v>0.54231163164409713</c:v>
                </c:pt>
                <c:pt idx="295">
                  <c:v>0.494763704141371</c:v>
                </c:pt>
                <c:pt idx="296">
                  <c:v>0.85089570004840498</c:v>
                </c:pt>
                <c:pt idx="297">
                  <c:v>4.5251017333066752E-2</c:v>
                </c:pt>
                <c:pt idx="298">
                  <c:v>0.27952762387794922</c:v>
                </c:pt>
                <c:pt idx="299">
                  <c:v>0.38007334982594942</c:v>
                </c:pt>
                <c:pt idx="300">
                  <c:v>0.70501938200662662</c:v>
                </c:pt>
                <c:pt idx="301">
                  <c:v>0.85045033619383448</c:v>
                </c:pt>
                <c:pt idx="302">
                  <c:v>0.6621799795936486</c:v>
                </c:pt>
                <c:pt idx="303">
                  <c:v>3.9546549089767971E-2</c:v>
                </c:pt>
                <c:pt idx="304">
                  <c:v>0.48915288489725944</c:v>
                </c:pt>
                <c:pt idx="305">
                  <c:v>2.6055684684237388E-2</c:v>
                </c:pt>
                <c:pt idx="306">
                  <c:v>0.17026974276945225</c:v>
                </c:pt>
                <c:pt idx="307">
                  <c:v>0.2257971439847887</c:v>
                </c:pt>
                <c:pt idx="308">
                  <c:v>0.5587875609558095</c:v>
                </c:pt>
                <c:pt idx="309">
                  <c:v>0.51306586470113213</c:v>
                </c:pt>
                <c:pt idx="310">
                  <c:v>0.7069034710263612</c:v>
                </c:pt>
                <c:pt idx="311">
                  <c:v>0.16001032414049424</c:v>
                </c:pt>
                <c:pt idx="312">
                  <c:v>0.28295398181881104</c:v>
                </c:pt>
                <c:pt idx="313">
                  <c:v>0.97080960838081487</c:v>
                </c:pt>
                <c:pt idx="314">
                  <c:v>2.1485923362094362E-2</c:v>
                </c:pt>
                <c:pt idx="315">
                  <c:v>0.75195279033582207</c:v>
                </c:pt>
                <c:pt idx="316">
                  <c:v>0.11269833381888307</c:v>
                </c:pt>
                <c:pt idx="317">
                  <c:v>0.64282809195193269</c:v>
                </c:pt>
                <c:pt idx="318">
                  <c:v>0.19457384209565021</c:v>
                </c:pt>
                <c:pt idx="319">
                  <c:v>6.920071525217536E-2</c:v>
                </c:pt>
                <c:pt idx="320">
                  <c:v>0.3227164065506945</c:v>
                </c:pt>
                <c:pt idx="321">
                  <c:v>0.24603676165673882</c:v>
                </c:pt>
                <c:pt idx="322">
                  <c:v>4.3459778305514778E-2</c:v>
                </c:pt>
                <c:pt idx="323">
                  <c:v>1.9746360310503654</c:v>
                </c:pt>
                <c:pt idx="324">
                  <c:v>0.1463542694501074</c:v>
                </c:pt>
                <c:pt idx="325">
                  <c:v>6.836432802788768E-2</c:v>
                </c:pt>
                <c:pt idx="326">
                  <c:v>8.7756090848626258E-3</c:v>
                </c:pt>
                <c:pt idx="327">
                  <c:v>0.99973079547817167</c:v>
                </c:pt>
                <c:pt idx="328">
                  <c:v>1.1134375915655348</c:v>
                </c:pt>
                <c:pt idx="329">
                  <c:v>1.1980369145326315</c:v>
                </c:pt>
                <c:pt idx="330">
                  <c:v>0.11397094859300905</c:v>
                </c:pt>
                <c:pt idx="331">
                  <c:v>0.23293024376718394</c:v>
                </c:pt>
                <c:pt idx="332">
                  <c:v>0.28869749590248583</c:v>
                </c:pt>
                <c:pt idx="333">
                  <c:v>0.36024243659494509</c:v>
                </c:pt>
                <c:pt idx="334">
                  <c:v>7.9084734515386029E-2</c:v>
                </c:pt>
                <c:pt idx="335">
                  <c:v>0.27870844879189177</c:v>
                </c:pt>
                <c:pt idx="336">
                  <c:v>0.29358855922780752</c:v>
                </c:pt>
                <c:pt idx="337">
                  <c:v>0.18596407320160055</c:v>
                </c:pt>
                <c:pt idx="338">
                  <c:v>2.6229082728075555E-2</c:v>
                </c:pt>
                <c:pt idx="339">
                  <c:v>0.5146808202749481</c:v>
                </c:pt>
                <c:pt idx="340">
                  <c:v>0.24899235001211403</c:v>
                </c:pt>
                <c:pt idx="341">
                  <c:v>5.5724738842803573E-2</c:v>
                </c:pt>
                <c:pt idx="342">
                  <c:v>0.27654871726537722</c:v>
                </c:pt>
                <c:pt idx="343">
                  <c:v>0.66085204004622089</c:v>
                </c:pt>
                <c:pt idx="344">
                  <c:v>8.5489429331625649E-2</c:v>
                </c:pt>
                <c:pt idx="345">
                  <c:v>0.5231747590640925</c:v>
                </c:pt>
                <c:pt idx="346">
                  <c:v>2.4139724276457174E-2</c:v>
                </c:pt>
                <c:pt idx="347">
                  <c:v>0.12208859705586297</c:v>
                </c:pt>
                <c:pt idx="348">
                  <c:v>1.2766072912544888</c:v>
                </c:pt>
                <c:pt idx="349">
                  <c:v>0.63568051807788728</c:v>
                </c:pt>
                <c:pt idx="350">
                  <c:v>0.81104121821344455</c:v>
                </c:pt>
                <c:pt idx="351">
                  <c:v>0.1416567128801067</c:v>
                </c:pt>
                <c:pt idx="352">
                  <c:v>9.9829986243382879E-2</c:v>
                </c:pt>
                <c:pt idx="353">
                  <c:v>0.79901286734371801</c:v>
                </c:pt>
                <c:pt idx="354">
                  <c:v>1.3003981752005422</c:v>
                </c:pt>
                <c:pt idx="355">
                  <c:v>1.2447760377027255</c:v>
                </c:pt>
                <c:pt idx="356">
                  <c:v>0.56399290696627558</c:v>
                </c:pt>
                <c:pt idx="357">
                  <c:v>0.72521727044801521</c:v>
                </c:pt>
                <c:pt idx="358">
                  <c:v>0.17142566474088294</c:v>
                </c:pt>
                <c:pt idx="359">
                  <c:v>2.1397263337299174E-2</c:v>
                </c:pt>
                <c:pt idx="360">
                  <c:v>0.32881676265634158</c:v>
                </c:pt>
                <c:pt idx="361">
                  <c:v>0.62205689284135757</c:v>
                </c:pt>
                <c:pt idx="362">
                  <c:v>0.13731208875990619</c:v>
                </c:pt>
                <c:pt idx="363">
                  <c:v>2.9661035599178875</c:v>
                </c:pt>
                <c:pt idx="364">
                  <c:v>1.3000425350762705E-2</c:v>
                </c:pt>
                <c:pt idx="365">
                  <c:v>0.12051391282711266</c:v>
                </c:pt>
                <c:pt idx="366">
                  <c:v>0.2809146736393574</c:v>
                </c:pt>
                <c:pt idx="367">
                  <c:v>1.1462442381495863</c:v>
                </c:pt>
                <c:pt idx="368">
                  <c:v>0.30761447840331907</c:v>
                </c:pt>
                <c:pt idx="369">
                  <c:v>0.59614591065012079</c:v>
                </c:pt>
                <c:pt idx="370">
                  <c:v>0.32195067159733737</c:v>
                </c:pt>
                <c:pt idx="371">
                  <c:v>2.0098981578355588E-2</c:v>
                </c:pt>
                <c:pt idx="372">
                  <c:v>1.336804853450094E-2</c:v>
                </c:pt>
                <c:pt idx="373">
                  <c:v>0.22811629338385384</c:v>
                </c:pt>
                <c:pt idx="374">
                  <c:v>0.411566854714842</c:v>
                </c:pt>
                <c:pt idx="375">
                  <c:v>0.33930780309946823</c:v>
                </c:pt>
                <c:pt idx="376">
                  <c:v>0.46529669088687692</c:v>
                </c:pt>
                <c:pt idx="377">
                  <c:v>6.1610606469252052E-2</c:v>
                </c:pt>
                <c:pt idx="378">
                  <c:v>0.74685941717159787</c:v>
                </c:pt>
                <c:pt idx="379">
                  <c:v>0.25391572693294662</c:v>
                </c:pt>
                <c:pt idx="380">
                  <c:v>0.70736934782975236</c:v>
                </c:pt>
                <c:pt idx="381">
                  <c:v>0.58364818748999581</c:v>
                </c:pt>
                <c:pt idx="382">
                  <c:v>0.17661054756265696</c:v>
                </c:pt>
                <c:pt idx="383">
                  <c:v>0.57763636880431146</c:v>
                </c:pt>
                <c:pt idx="384">
                  <c:v>0.32470098157517252</c:v>
                </c:pt>
                <c:pt idx="385">
                  <c:v>1.5571374033634857</c:v>
                </c:pt>
                <c:pt idx="386">
                  <c:v>1.1685255459342434</c:v>
                </c:pt>
                <c:pt idx="387">
                  <c:v>1.0842350878669711</c:v>
                </c:pt>
                <c:pt idx="388">
                  <c:v>9.1214358713231497E-3</c:v>
                </c:pt>
                <c:pt idx="389">
                  <c:v>0.48948789849131713</c:v>
                </c:pt>
                <c:pt idx="390">
                  <c:v>0.22553243280956872</c:v>
                </c:pt>
                <c:pt idx="391">
                  <c:v>0.28184983296233923</c:v>
                </c:pt>
                <c:pt idx="392">
                  <c:v>0.36835794036128255</c:v>
                </c:pt>
                <c:pt idx="393">
                  <c:v>0.74973560161067065</c:v>
                </c:pt>
                <c:pt idx="394">
                  <c:v>0.12299211626818787</c:v>
                </c:pt>
                <c:pt idx="395">
                  <c:v>0.32182231260574673</c:v>
                </c:pt>
                <c:pt idx="396">
                  <c:v>0.65569965115404927</c:v>
                </c:pt>
                <c:pt idx="397">
                  <c:v>0.21452576356942249</c:v>
                </c:pt>
                <c:pt idx="398">
                  <c:v>0.91274775037018019</c:v>
                </c:pt>
                <c:pt idx="399">
                  <c:v>0.88269442768114448</c:v>
                </c:pt>
                <c:pt idx="400">
                  <c:v>0.44143764888907416</c:v>
                </c:pt>
                <c:pt idx="401">
                  <c:v>0.51479649577524811</c:v>
                </c:pt>
                <c:pt idx="402">
                  <c:v>0.1661842774844714</c:v>
                </c:pt>
                <c:pt idx="403">
                  <c:v>0.15955632616911974</c:v>
                </c:pt>
                <c:pt idx="404">
                  <c:v>0.44791406437136888</c:v>
                </c:pt>
                <c:pt idx="405">
                  <c:v>0.25723385293207746</c:v>
                </c:pt>
                <c:pt idx="406">
                  <c:v>0.36503039506930102</c:v>
                </c:pt>
                <c:pt idx="407">
                  <c:v>0.12350939034982794</c:v>
                </c:pt>
                <c:pt idx="408">
                  <c:v>0.14496867827590243</c:v>
                </c:pt>
                <c:pt idx="409">
                  <c:v>2.0343343482001879E-2</c:v>
                </c:pt>
                <c:pt idx="410">
                  <c:v>0.49710908662337</c:v>
                </c:pt>
                <c:pt idx="411">
                  <c:v>0.41890500994729524</c:v>
                </c:pt>
                <c:pt idx="412">
                  <c:v>1.1472237735019326</c:v>
                </c:pt>
                <c:pt idx="413">
                  <c:v>0.21217066214741948</c:v>
                </c:pt>
                <c:pt idx="414">
                  <c:v>0.79689240368204328</c:v>
                </c:pt>
                <c:pt idx="415">
                  <c:v>0.28738671510771141</c:v>
                </c:pt>
                <c:pt idx="416">
                  <c:v>7.9010378340219692E-2</c:v>
                </c:pt>
                <c:pt idx="417">
                  <c:v>0.4739915799045748</c:v>
                </c:pt>
                <c:pt idx="418">
                  <c:v>0.96289269983014147</c:v>
                </c:pt>
                <c:pt idx="419">
                  <c:v>1.0107515108509935</c:v>
                </c:pt>
                <c:pt idx="420">
                  <c:v>8.9488205083831554E-2</c:v>
                </c:pt>
                <c:pt idx="421">
                  <c:v>0.9847618532060719</c:v>
                </c:pt>
                <c:pt idx="422">
                  <c:v>0.52186577328753547</c:v>
                </c:pt>
                <c:pt idx="423">
                  <c:v>0.34512970035620821</c:v>
                </c:pt>
                <c:pt idx="424">
                  <c:v>0.47905165373578962</c:v>
                </c:pt>
                <c:pt idx="425">
                  <c:v>0.29283041958285838</c:v>
                </c:pt>
                <c:pt idx="426">
                  <c:v>0.39775756409500568</c:v>
                </c:pt>
                <c:pt idx="427">
                  <c:v>1.8121312176526353E-2</c:v>
                </c:pt>
                <c:pt idx="428">
                  <c:v>0.1294873354141392</c:v>
                </c:pt>
                <c:pt idx="429">
                  <c:v>0.75285531974015907</c:v>
                </c:pt>
                <c:pt idx="430">
                  <c:v>9.5425502808722234E-3</c:v>
                </c:pt>
                <c:pt idx="431">
                  <c:v>9.309648136064037E-3</c:v>
                </c:pt>
                <c:pt idx="432">
                  <c:v>0.64453326358857899</c:v>
                </c:pt>
                <c:pt idx="433">
                  <c:v>5.2291413782726982E-2</c:v>
                </c:pt>
                <c:pt idx="434">
                  <c:v>0.28413583227567907</c:v>
                </c:pt>
                <c:pt idx="435">
                  <c:v>0.56138419491243075</c:v>
                </c:pt>
                <c:pt idx="436">
                  <c:v>1.2882699099972983</c:v>
                </c:pt>
                <c:pt idx="437">
                  <c:v>1.0590759196507369</c:v>
                </c:pt>
                <c:pt idx="438">
                  <c:v>2.4670383251008259</c:v>
                </c:pt>
                <c:pt idx="439">
                  <c:v>0.50558260965876878</c:v>
                </c:pt>
                <c:pt idx="440">
                  <c:v>1.5197143413254869E-2</c:v>
                </c:pt>
                <c:pt idx="441">
                  <c:v>1.1786496851641499</c:v>
                </c:pt>
                <c:pt idx="442">
                  <c:v>6.8355868706121758E-2</c:v>
                </c:pt>
                <c:pt idx="443">
                  <c:v>0.87036134793317887</c:v>
                </c:pt>
                <c:pt idx="444">
                  <c:v>1.0589235703665538</c:v>
                </c:pt>
                <c:pt idx="445">
                  <c:v>8.2561315591196255E-2</c:v>
                </c:pt>
                <c:pt idx="446">
                  <c:v>0.37420738063057424</c:v>
                </c:pt>
                <c:pt idx="447">
                  <c:v>5.8890787083930047E-3</c:v>
                </c:pt>
                <c:pt idx="448">
                  <c:v>0.88285642828635502</c:v>
                </c:pt>
                <c:pt idx="449">
                  <c:v>0.55976641067465094</c:v>
                </c:pt>
                <c:pt idx="450">
                  <c:v>8.4767073441638682E-2</c:v>
                </c:pt>
                <c:pt idx="451">
                  <c:v>0.23262725878835691</c:v>
                </c:pt>
                <c:pt idx="452">
                  <c:v>0.76609212055958864</c:v>
                </c:pt>
                <c:pt idx="453">
                  <c:v>0.20440931561322193</c:v>
                </c:pt>
                <c:pt idx="454">
                  <c:v>0.30173403468763121</c:v>
                </c:pt>
                <c:pt idx="455">
                  <c:v>0.20806912556268167</c:v>
                </c:pt>
                <c:pt idx="456">
                  <c:v>0.43065161186772943</c:v>
                </c:pt>
                <c:pt idx="457">
                  <c:v>4.9976040556171004E-2</c:v>
                </c:pt>
                <c:pt idx="458">
                  <c:v>0.49822269657525831</c:v>
                </c:pt>
                <c:pt idx="459">
                  <c:v>0.88446167479545601</c:v>
                </c:pt>
                <c:pt idx="460">
                  <c:v>1.3579187934549233E-2</c:v>
                </c:pt>
                <c:pt idx="461">
                  <c:v>0.63905058595180231</c:v>
                </c:pt>
                <c:pt idx="462">
                  <c:v>0.69797991465095943</c:v>
                </c:pt>
                <c:pt idx="463">
                  <c:v>0.20294772106918404</c:v>
                </c:pt>
                <c:pt idx="464">
                  <c:v>9.339379678605049E-2</c:v>
                </c:pt>
                <c:pt idx="465">
                  <c:v>0.20280343669636255</c:v>
                </c:pt>
                <c:pt idx="466">
                  <c:v>0.75336375872251726</c:v>
                </c:pt>
                <c:pt idx="467">
                  <c:v>0.56222918632474139</c:v>
                </c:pt>
                <c:pt idx="468">
                  <c:v>0.75508318028288934</c:v>
                </c:pt>
                <c:pt idx="469">
                  <c:v>0.39591893771740738</c:v>
                </c:pt>
                <c:pt idx="470">
                  <c:v>0.13636393608019345</c:v>
                </c:pt>
                <c:pt idx="471">
                  <c:v>0.35578353537403706</c:v>
                </c:pt>
                <c:pt idx="472">
                  <c:v>0.46163507033689671</c:v>
                </c:pt>
                <c:pt idx="473">
                  <c:v>0.39953589354036195</c:v>
                </c:pt>
                <c:pt idx="474">
                  <c:v>1.1140966929910563</c:v>
                </c:pt>
                <c:pt idx="475">
                  <c:v>1.6423730601105473</c:v>
                </c:pt>
                <c:pt idx="476">
                  <c:v>7.058715440055062E-2</c:v>
                </c:pt>
                <c:pt idx="477">
                  <c:v>1.5416145064933422</c:v>
                </c:pt>
                <c:pt idx="478">
                  <c:v>0.56767929734873135</c:v>
                </c:pt>
                <c:pt idx="479">
                  <c:v>0.20523952630758596</c:v>
                </c:pt>
                <c:pt idx="480">
                  <c:v>0.54928517817894817</c:v>
                </c:pt>
                <c:pt idx="481">
                  <c:v>5.0014500295914179E-2</c:v>
                </c:pt>
                <c:pt idx="482">
                  <c:v>0.1788095151512111</c:v>
                </c:pt>
                <c:pt idx="483">
                  <c:v>0.1298213884616897</c:v>
                </c:pt>
                <c:pt idx="484">
                  <c:v>1.6756438655125088E-2</c:v>
                </c:pt>
                <c:pt idx="485">
                  <c:v>0.13557216537145278</c:v>
                </c:pt>
                <c:pt idx="486">
                  <c:v>0.25397230658895242</c:v>
                </c:pt>
                <c:pt idx="487">
                  <c:v>1.0919266399350167</c:v>
                </c:pt>
                <c:pt idx="488">
                  <c:v>5.9871162981693503E-2</c:v>
                </c:pt>
                <c:pt idx="489">
                  <c:v>0.3118623730386425</c:v>
                </c:pt>
                <c:pt idx="490">
                  <c:v>0.10718475957537511</c:v>
                </c:pt>
                <c:pt idx="491">
                  <c:v>0.40427558125124102</c:v>
                </c:pt>
                <c:pt idx="492">
                  <c:v>1.3340634458724607</c:v>
                </c:pt>
                <c:pt idx="493">
                  <c:v>0.18269511897796581</c:v>
                </c:pt>
                <c:pt idx="494">
                  <c:v>3.4595258698181586E-2</c:v>
                </c:pt>
                <c:pt idx="495">
                  <c:v>0.60094389992635566</c:v>
                </c:pt>
                <c:pt idx="496">
                  <c:v>0.59534638942640306</c:v>
                </c:pt>
                <c:pt idx="497">
                  <c:v>0.62755387820691932</c:v>
                </c:pt>
                <c:pt idx="498">
                  <c:v>0.44717930746028967</c:v>
                </c:pt>
                <c:pt idx="499">
                  <c:v>0.85486381406920453</c:v>
                </c:pt>
                <c:pt idx="500">
                  <c:v>0.53081609113694583</c:v>
                </c:pt>
                <c:pt idx="501">
                  <c:v>0.75173519232006547</c:v>
                </c:pt>
                <c:pt idx="502">
                  <c:v>0.93030870271006705</c:v>
                </c:pt>
                <c:pt idx="503">
                  <c:v>0.16991791942748982</c:v>
                </c:pt>
                <c:pt idx="504">
                  <c:v>2.4987679022848082</c:v>
                </c:pt>
                <c:pt idx="505">
                  <c:v>0.74968668313711817</c:v>
                </c:pt>
                <c:pt idx="506">
                  <c:v>0.11376128299659052</c:v>
                </c:pt>
                <c:pt idx="507">
                  <c:v>0.17067180301151985</c:v>
                </c:pt>
                <c:pt idx="508">
                  <c:v>0.52484788842499508</c:v>
                </c:pt>
                <c:pt idx="509">
                  <c:v>0.69983257795905451</c:v>
                </c:pt>
                <c:pt idx="510">
                  <c:v>0.34008371451156583</c:v>
                </c:pt>
                <c:pt idx="511">
                  <c:v>0.26117414087369767</c:v>
                </c:pt>
                <c:pt idx="512">
                  <c:v>0.11952637055372123</c:v>
                </c:pt>
                <c:pt idx="513">
                  <c:v>0.81924406043423925</c:v>
                </c:pt>
                <c:pt idx="514">
                  <c:v>3.4213468037999462E-2</c:v>
                </c:pt>
                <c:pt idx="515">
                  <c:v>8.2364615660825563E-2</c:v>
                </c:pt>
                <c:pt idx="516">
                  <c:v>0.17132357066447529</c:v>
                </c:pt>
                <c:pt idx="517">
                  <c:v>0.33982465107303528</c:v>
                </c:pt>
                <c:pt idx="518">
                  <c:v>4.6585576535862309E-2</c:v>
                </c:pt>
                <c:pt idx="519">
                  <c:v>0.18045865447926215</c:v>
                </c:pt>
                <c:pt idx="520">
                  <c:v>0.2419505023901781</c:v>
                </c:pt>
                <c:pt idx="521">
                  <c:v>0.26860429374740241</c:v>
                </c:pt>
                <c:pt idx="522">
                  <c:v>0.19660392531614826</c:v>
                </c:pt>
                <c:pt idx="523">
                  <c:v>0.87058759796263152</c:v>
                </c:pt>
                <c:pt idx="524">
                  <c:v>0.29394574089233316</c:v>
                </c:pt>
                <c:pt idx="525">
                  <c:v>9.9101444415941962E-3</c:v>
                </c:pt>
                <c:pt idx="526">
                  <c:v>6.1467874735631374E-3</c:v>
                </c:pt>
                <c:pt idx="527">
                  <c:v>0.45923059744571698</c:v>
                </c:pt>
                <c:pt idx="528">
                  <c:v>7.9267229326945701E-2</c:v>
                </c:pt>
                <c:pt idx="529">
                  <c:v>0.43082666437820244</c:v>
                </c:pt>
                <c:pt idx="530">
                  <c:v>0.51602745182403642</c:v>
                </c:pt>
                <c:pt idx="531">
                  <c:v>0.59474014227820959</c:v>
                </c:pt>
                <c:pt idx="532">
                  <c:v>1.299320504678372</c:v>
                </c:pt>
                <c:pt idx="533">
                  <c:v>0.32314936162671731</c:v>
                </c:pt>
                <c:pt idx="534">
                  <c:v>9.8102590702110512E-2</c:v>
                </c:pt>
                <c:pt idx="535">
                  <c:v>1.2699212620455982</c:v>
                </c:pt>
                <c:pt idx="536">
                  <c:v>2.0117129737275675E-2</c:v>
                </c:pt>
                <c:pt idx="537">
                  <c:v>0.94280482289273737</c:v>
                </c:pt>
                <c:pt idx="538">
                  <c:v>0.11610267466615769</c:v>
                </c:pt>
                <c:pt idx="539">
                  <c:v>0.51103884324570947</c:v>
                </c:pt>
                <c:pt idx="540">
                  <c:v>0.20289535668178604</c:v>
                </c:pt>
                <c:pt idx="541">
                  <c:v>1.4241332688999495</c:v>
                </c:pt>
                <c:pt idx="542">
                  <c:v>0.2855481589604138</c:v>
                </c:pt>
                <c:pt idx="543">
                  <c:v>7.0449696628434005E-2</c:v>
                </c:pt>
                <c:pt idx="544">
                  <c:v>0.22456510640274457</c:v>
                </c:pt>
                <c:pt idx="545">
                  <c:v>1.067603005321726</c:v>
                </c:pt>
                <c:pt idx="546">
                  <c:v>0.22805669980270829</c:v>
                </c:pt>
                <c:pt idx="547">
                  <c:v>0.84242501007604498</c:v>
                </c:pt>
                <c:pt idx="548">
                  <c:v>0.1568772013624001</c:v>
                </c:pt>
                <c:pt idx="549">
                  <c:v>8.4986564224413669E-2</c:v>
                </c:pt>
                <c:pt idx="550">
                  <c:v>0.59177859785069342</c:v>
                </c:pt>
                <c:pt idx="551">
                  <c:v>0.20131519033727735</c:v>
                </c:pt>
                <c:pt idx="552">
                  <c:v>0.19141152286824614</c:v>
                </c:pt>
                <c:pt idx="553">
                  <c:v>1.9689648998105637E-2</c:v>
                </c:pt>
                <c:pt idx="554">
                  <c:v>0.55064124189450914</c:v>
                </c:pt>
                <c:pt idx="555">
                  <c:v>0.43137945944157935</c:v>
                </c:pt>
                <c:pt idx="556">
                  <c:v>2.8738926949414973</c:v>
                </c:pt>
                <c:pt idx="557">
                  <c:v>0.42946521324258036</c:v>
                </c:pt>
                <c:pt idx="558">
                  <c:v>2.7020090033628111E-2</c:v>
                </c:pt>
                <c:pt idx="559">
                  <c:v>0.44663855323987423</c:v>
                </c:pt>
                <c:pt idx="560">
                  <c:v>4.0559755757764999E-2</c:v>
                </c:pt>
                <c:pt idx="561">
                  <c:v>0.35293076137331614</c:v>
                </c:pt>
                <c:pt idx="562">
                  <c:v>0.97567026051913319</c:v>
                </c:pt>
                <c:pt idx="563">
                  <c:v>0.43965693079233426</c:v>
                </c:pt>
                <c:pt idx="564">
                  <c:v>0.7641371211454977</c:v>
                </c:pt>
                <c:pt idx="565">
                  <c:v>0.5328789102927467</c:v>
                </c:pt>
                <c:pt idx="566">
                  <c:v>0.48888986222115965</c:v>
                </c:pt>
                <c:pt idx="567">
                  <c:v>0.16322106375758494</c:v>
                </c:pt>
                <c:pt idx="568">
                  <c:v>2.0913634653944656E-2</c:v>
                </c:pt>
                <c:pt idx="569">
                  <c:v>0.33437284410881507</c:v>
                </c:pt>
                <c:pt idx="570">
                  <c:v>0.17856012157489651</c:v>
                </c:pt>
                <c:pt idx="571">
                  <c:v>0.15816387425505943</c:v>
                </c:pt>
                <c:pt idx="572">
                  <c:v>0.12183923208427658</c:v>
                </c:pt>
                <c:pt idx="573">
                  <c:v>0.8213937523948075</c:v>
                </c:pt>
                <c:pt idx="574">
                  <c:v>0.60832218027600315</c:v>
                </c:pt>
                <c:pt idx="575">
                  <c:v>9.7466427654469556E-2</c:v>
                </c:pt>
                <c:pt idx="576">
                  <c:v>2.7801641457475268E-2</c:v>
                </c:pt>
                <c:pt idx="577">
                  <c:v>0.18609170802664138</c:v>
                </c:pt>
                <c:pt idx="578">
                  <c:v>0.80593141997163764</c:v>
                </c:pt>
                <c:pt idx="579">
                  <c:v>0.12941451811130655</c:v>
                </c:pt>
                <c:pt idx="580">
                  <c:v>0.24577281623419692</c:v>
                </c:pt>
                <c:pt idx="581">
                  <c:v>0.76383634280587853</c:v>
                </c:pt>
                <c:pt idx="582">
                  <c:v>0.79665295312342577</c:v>
                </c:pt>
                <c:pt idx="583">
                  <c:v>1.0560893169502322E-2</c:v>
                </c:pt>
                <c:pt idx="584">
                  <c:v>0.14483871059841316</c:v>
                </c:pt>
                <c:pt idx="585">
                  <c:v>1.0500909925479685E-2</c:v>
                </c:pt>
                <c:pt idx="586">
                  <c:v>0.12605309858863337</c:v>
                </c:pt>
                <c:pt idx="587">
                  <c:v>0.3954472152150792</c:v>
                </c:pt>
                <c:pt idx="588">
                  <c:v>0.5327000061131999</c:v>
                </c:pt>
                <c:pt idx="589">
                  <c:v>0.26404964059524522</c:v>
                </c:pt>
                <c:pt idx="590">
                  <c:v>0.19861966936913136</c:v>
                </c:pt>
                <c:pt idx="591">
                  <c:v>4.2009044707256867E-2</c:v>
                </c:pt>
                <c:pt idx="592">
                  <c:v>0.43408156506075124</c:v>
                </c:pt>
                <c:pt idx="593">
                  <c:v>3.4321713544680992E-2</c:v>
                </c:pt>
                <c:pt idx="594">
                  <c:v>0.3978656176556874</c:v>
                </c:pt>
                <c:pt idx="595">
                  <c:v>0.68209882543013611</c:v>
                </c:pt>
                <c:pt idx="596">
                  <c:v>1.7370939144372965</c:v>
                </c:pt>
                <c:pt idx="597">
                  <c:v>5.9035496399261353E-2</c:v>
                </c:pt>
                <c:pt idx="598">
                  <c:v>0.18070347004514239</c:v>
                </c:pt>
                <c:pt idx="599">
                  <c:v>0.28230485749220036</c:v>
                </c:pt>
                <c:pt idx="600">
                  <c:v>8.6150348126324133E-2</c:v>
                </c:pt>
                <c:pt idx="601">
                  <c:v>1.0367687553983893</c:v>
                </c:pt>
                <c:pt idx="602">
                  <c:v>0.91671519944072555</c:v>
                </c:pt>
                <c:pt idx="603">
                  <c:v>7.128070722197833E-3</c:v>
                </c:pt>
                <c:pt idx="604">
                  <c:v>1.1540859838179118</c:v>
                </c:pt>
                <c:pt idx="605">
                  <c:v>0.17184031685702603</c:v>
                </c:pt>
                <c:pt idx="606">
                  <c:v>0.13276047704594796</c:v>
                </c:pt>
                <c:pt idx="607">
                  <c:v>1.1588619201177504</c:v>
                </c:pt>
                <c:pt idx="608">
                  <c:v>1.6471775880889137E-2</c:v>
                </c:pt>
                <c:pt idx="609">
                  <c:v>0.30136805321156318</c:v>
                </c:pt>
                <c:pt idx="610">
                  <c:v>6.8672715073729101E-2</c:v>
                </c:pt>
                <c:pt idx="611">
                  <c:v>0.5641829908484417</c:v>
                </c:pt>
                <c:pt idx="612">
                  <c:v>3.4430853995069497</c:v>
                </c:pt>
                <c:pt idx="613">
                  <c:v>8.2821124698845894E-2</c:v>
                </c:pt>
                <c:pt idx="614">
                  <c:v>0.89787068366503542</c:v>
                </c:pt>
                <c:pt idx="615">
                  <c:v>3.8422133672662832E-2</c:v>
                </c:pt>
                <c:pt idx="616">
                  <c:v>0.15750836297609561</c:v>
                </c:pt>
                <c:pt idx="617">
                  <c:v>3.7473637092428062E-2</c:v>
                </c:pt>
                <c:pt idx="618">
                  <c:v>0.73432127915506862</c:v>
                </c:pt>
                <c:pt idx="619">
                  <c:v>4.4115409632539557E-2</c:v>
                </c:pt>
                <c:pt idx="620">
                  <c:v>8.0792819498705676E-2</c:v>
                </c:pt>
                <c:pt idx="621">
                  <c:v>0.60843617457297583</c:v>
                </c:pt>
                <c:pt idx="622">
                  <c:v>2.2744355154395621</c:v>
                </c:pt>
                <c:pt idx="623">
                  <c:v>0.14407744020273081</c:v>
                </c:pt>
                <c:pt idx="624">
                  <c:v>0.78536152047325791</c:v>
                </c:pt>
                <c:pt idx="625">
                  <c:v>0.25221856181975805</c:v>
                </c:pt>
                <c:pt idx="626">
                  <c:v>0.57851679731632455</c:v>
                </c:pt>
                <c:pt idx="627">
                  <c:v>2.5687333206199415E-2</c:v>
                </c:pt>
                <c:pt idx="628">
                  <c:v>1.160105049311661E-2</c:v>
                </c:pt>
                <c:pt idx="629">
                  <c:v>0.17242196027149811</c:v>
                </c:pt>
                <c:pt idx="630">
                  <c:v>0.12414420019660713</c:v>
                </c:pt>
                <c:pt idx="631">
                  <c:v>1.0683370335218174</c:v>
                </c:pt>
                <c:pt idx="632">
                  <c:v>0.41404093201205167</c:v>
                </c:pt>
                <c:pt idx="633">
                  <c:v>9.0455335402926301E-2</c:v>
                </c:pt>
                <c:pt idx="634">
                  <c:v>0.23210021215499274</c:v>
                </c:pt>
                <c:pt idx="635">
                  <c:v>0.23326721635540892</c:v>
                </c:pt>
                <c:pt idx="636">
                  <c:v>1.0992704176992119</c:v>
                </c:pt>
                <c:pt idx="637">
                  <c:v>0.23962704268934013</c:v>
                </c:pt>
                <c:pt idx="638">
                  <c:v>0.79944548693968809</c:v>
                </c:pt>
                <c:pt idx="639">
                  <c:v>1.7987005696003258</c:v>
                </c:pt>
                <c:pt idx="640">
                  <c:v>0.39569873778209025</c:v>
                </c:pt>
                <c:pt idx="641">
                  <c:v>1.4251276343080901</c:v>
                </c:pt>
                <c:pt idx="642">
                  <c:v>8.584997639501607E-2</c:v>
                </c:pt>
                <c:pt idx="643">
                  <c:v>0.18140418503688521</c:v>
                </c:pt>
                <c:pt idx="644">
                  <c:v>2.9277133422365854E-2</c:v>
                </c:pt>
                <c:pt idx="645">
                  <c:v>1.0215413127850967E-2</c:v>
                </c:pt>
                <c:pt idx="646">
                  <c:v>0.99368817298396384</c:v>
                </c:pt>
                <c:pt idx="647">
                  <c:v>0.10086178107459633</c:v>
                </c:pt>
                <c:pt idx="648">
                  <c:v>0.21964527411672427</c:v>
                </c:pt>
                <c:pt idx="649">
                  <c:v>0.18691704661298195</c:v>
                </c:pt>
                <c:pt idx="650">
                  <c:v>9.7338612453462786E-2</c:v>
                </c:pt>
                <c:pt idx="651">
                  <c:v>0.3890990344318882</c:v>
                </c:pt>
                <c:pt idx="652">
                  <c:v>0.41122073802216963</c:v>
                </c:pt>
                <c:pt idx="653">
                  <c:v>3.1388376916163648E-2</c:v>
                </c:pt>
                <c:pt idx="654">
                  <c:v>0.19735891129915767</c:v>
                </c:pt>
                <c:pt idx="655">
                  <c:v>0.35893481388624526</c:v>
                </c:pt>
                <c:pt idx="656">
                  <c:v>0.47204547428956878</c:v>
                </c:pt>
                <c:pt idx="657">
                  <c:v>0.61449015289229048</c:v>
                </c:pt>
                <c:pt idx="658">
                  <c:v>0.1121891865863404</c:v>
                </c:pt>
                <c:pt idx="659">
                  <c:v>1.0301127246316049</c:v>
                </c:pt>
                <c:pt idx="660">
                  <c:v>1.1188443844830218</c:v>
                </c:pt>
                <c:pt idx="661">
                  <c:v>2.4130018053497269E-2</c:v>
                </c:pt>
                <c:pt idx="662">
                  <c:v>9.2201064050619813E-2</c:v>
                </c:pt>
                <c:pt idx="663">
                  <c:v>0.19520811612280703</c:v>
                </c:pt>
                <c:pt idx="664">
                  <c:v>0.46662988017183543</c:v>
                </c:pt>
                <c:pt idx="665">
                  <c:v>6.4354221808211071E-2</c:v>
                </c:pt>
                <c:pt idx="666">
                  <c:v>0.80123619432619375</c:v>
                </c:pt>
                <c:pt idx="667">
                  <c:v>0.39783184013658507</c:v>
                </c:pt>
                <c:pt idx="668">
                  <c:v>0.11879049383180372</c:v>
                </c:pt>
                <c:pt idx="669">
                  <c:v>1.0969489090522115</c:v>
                </c:pt>
                <c:pt idx="670">
                  <c:v>0.98161925837822728</c:v>
                </c:pt>
                <c:pt idx="671">
                  <c:v>5.7043826888317356E-2</c:v>
                </c:pt>
                <c:pt idx="672">
                  <c:v>0.21052079355225126</c:v>
                </c:pt>
                <c:pt idx="673">
                  <c:v>0.2338637877246843</c:v>
                </c:pt>
                <c:pt idx="674">
                  <c:v>0.32145827119076487</c:v>
                </c:pt>
                <c:pt idx="675">
                  <c:v>0.66062665470744342</c:v>
                </c:pt>
                <c:pt idx="676">
                  <c:v>0.26162199537579295</c:v>
                </c:pt>
                <c:pt idx="677">
                  <c:v>0.349874887443615</c:v>
                </c:pt>
                <c:pt idx="678">
                  <c:v>0.29316282008827144</c:v>
                </c:pt>
                <c:pt idx="679">
                  <c:v>0.15195269967963501</c:v>
                </c:pt>
                <c:pt idx="680">
                  <c:v>0.45072085621424257</c:v>
                </c:pt>
                <c:pt idx="681">
                  <c:v>0.13034024146565973</c:v>
                </c:pt>
                <c:pt idx="682">
                  <c:v>1.35317360834375</c:v>
                </c:pt>
                <c:pt idx="683">
                  <c:v>1.4423571637753139</c:v>
                </c:pt>
                <c:pt idx="684">
                  <c:v>0.73295352991460605</c:v>
                </c:pt>
                <c:pt idx="685">
                  <c:v>0.17041194848437063</c:v>
                </c:pt>
                <c:pt idx="686">
                  <c:v>0.37927520123823016</c:v>
                </c:pt>
                <c:pt idx="687">
                  <c:v>0.23916586021539696</c:v>
                </c:pt>
                <c:pt idx="688">
                  <c:v>1.1635053261108823</c:v>
                </c:pt>
                <c:pt idx="689">
                  <c:v>0.81993391416133843</c:v>
                </c:pt>
                <c:pt idx="690">
                  <c:v>8.6992685976337733E-2</c:v>
                </c:pt>
                <c:pt idx="691">
                  <c:v>0.41508437094013428</c:v>
                </c:pt>
                <c:pt idx="692">
                  <c:v>0.18871166953527294</c:v>
                </c:pt>
                <c:pt idx="693">
                  <c:v>0.27492772831777373</c:v>
                </c:pt>
                <c:pt idx="694">
                  <c:v>0.78083511656455351</c:v>
                </c:pt>
                <c:pt idx="695">
                  <c:v>0.70121713425377008</c:v>
                </c:pt>
                <c:pt idx="696">
                  <c:v>0.14245069226724047</c:v>
                </c:pt>
                <c:pt idx="697">
                  <c:v>5.2918734778358907E-2</c:v>
                </c:pt>
                <c:pt idx="698">
                  <c:v>0.27083484311581862</c:v>
                </c:pt>
                <c:pt idx="699">
                  <c:v>0.71505691334294741</c:v>
                </c:pt>
                <c:pt idx="700">
                  <c:v>0.30618702074486576</c:v>
                </c:pt>
                <c:pt idx="701">
                  <c:v>1.0825923933537975</c:v>
                </c:pt>
                <c:pt idx="702">
                  <c:v>0.14509730952807207</c:v>
                </c:pt>
                <c:pt idx="703">
                  <c:v>0.93220953962138786</c:v>
                </c:pt>
                <c:pt idx="704">
                  <c:v>5.7530748479590429E-2</c:v>
                </c:pt>
                <c:pt idx="705">
                  <c:v>0.2279714284956833</c:v>
                </c:pt>
                <c:pt idx="706">
                  <c:v>3.8879991566768052E-2</c:v>
                </c:pt>
                <c:pt idx="707">
                  <c:v>0.4020736842077966</c:v>
                </c:pt>
                <c:pt idx="708">
                  <c:v>0.30846560927023747</c:v>
                </c:pt>
                <c:pt idx="709">
                  <c:v>9.2449058356353156E-2</c:v>
                </c:pt>
                <c:pt idx="710">
                  <c:v>1.3899506182204875E-2</c:v>
                </c:pt>
                <c:pt idx="711">
                  <c:v>0.15090462907260635</c:v>
                </c:pt>
                <c:pt idx="712">
                  <c:v>7.4419039127021372E-2</c:v>
                </c:pt>
                <c:pt idx="713">
                  <c:v>5.9437439992592205E-2</c:v>
                </c:pt>
                <c:pt idx="714">
                  <c:v>0.50321558142869649</c:v>
                </c:pt>
                <c:pt idx="715">
                  <c:v>0.23316718365545339</c:v>
                </c:pt>
                <c:pt idx="716">
                  <c:v>1.6987729740204537E-2</c:v>
                </c:pt>
                <c:pt idx="717">
                  <c:v>1.0564506278456598E-2</c:v>
                </c:pt>
                <c:pt idx="718">
                  <c:v>1.1117176325839868</c:v>
                </c:pt>
                <c:pt idx="719">
                  <c:v>0.65620805152282824</c:v>
                </c:pt>
                <c:pt idx="720">
                  <c:v>0.92447405724813181</c:v>
                </c:pt>
                <c:pt idx="721">
                  <c:v>2.0972608936764666E-2</c:v>
                </c:pt>
                <c:pt idx="722">
                  <c:v>0.59005773703940634</c:v>
                </c:pt>
                <c:pt idx="723">
                  <c:v>0.12237485982812464</c:v>
                </c:pt>
                <c:pt idx="724">
                  <c:v>0.12481906742585876</c:v>
                </c:pt>
                <c:pt idx="725">
                  <c:v>0.43056999377339844</c:v>
                </c:pt>
                <c:pt idx="726">
                  <c:v>0.21138898957997729</c:v>
                </c:pt>
                <c:pt idx="727">
                  <c:v>9.2194932566943999E-2</c:v>
                </c:pt>
                <c:pt idx="728">
                  <c:v>0.55748250053726833</c:v>
                </c:pt>
                <c:pt idx="729">
                  <c:v>0.40098728603455092</c:v>
                </c:pt>
                <c:pt idx="730">
                  <c:v>0.43563936721603203</c:v>
                </c:pt>
                <c:pt idx="731">
                  <c:v>9.5984142409193229E-2</c:v>
                </c:pt>
                <c:pt idx="732">
                  <c:v>0.82357009047455032</c:v>
                </c:pt>
                <c:pt idx="733">
                  <c:v>0.36828358961834656</c:v>
                </c:pt>
                <c:pt idx="734">
                  <c:v>0.97582031560231308</c:v>
                </c:pt>
                <c:pt idx="735">
                  <c:v>2.7485189679456044E-2</c:v>
                </c:pt>
                <c:pt idx="736">
                  <c:v>1.3924567182863327E-2</c:v>
                </c:pt>
                <c:pt idx="737">
                  <c:v>0.30536260005043325</c:v>
                </c:pt>
                <c:pt idx="738">
                  <c:v>0.96874014567170286</c:v>
                </c:pt>
                <c:pt idx="739">
                  <c:v>0.32485184489096164</c:v>
                </c:pt>
                <c:pt idx="740">
                  <c:v>5.7199152577428088E-2</c:v>
                </c:pt>
                <c:pt idx="741">
                  <c:v>0.62878455615823725</c:v>
                </c:pt>
                <c:pt idx="742">
                  <c:v>0.51756935858702657</c:v>
                </c:pt>
                <c:pt idx="743">
                  <c:v>0.5161618077492991</c:v>
                </c:pt>
                <c:pt idx="744">
                  <c:v>1.2530372313895082</c:v>
                </c:pt>
                <c:pt idx="745">
                  <c:v>4.3147870072399112E-2</c:v>
                </c:pt>
                <c:pt idx="746">
                  <c:v>0.98276742032182063</c:v>
                </c:pt>
                <c:pt idx="747">
                  <c:v>1.2952476564488964</c:v>
                </c:pt>
                <c:pt idx="748">
                  <c:v>1.1690225254147451</c:v>
                </c:pt>
                <c:pt idx="749">
                  <c:v>0.32154196200783353</c:v>
                </c:pt>
                <c:pt idx="750">
                  <c:v>1.0079422937460734</c:v>
                </c:pt>
                <c:pt idx="751">
                  <c:v>0.34656123202824946</c:v>
                </c:pt>
                <c:pt idx="752">
                  <c:v>0.62115891154130864</c:v>
                </c:pt>
                <c:pt idx="753">
                  <c:v>0.62357970053304068</c:v>
                </c:pt>
                <c:pt idx="754">
                  <c:v>0.61813551778351972</c:v>
                </c:pt>
                <c:pt idx="755">
                  <c:v>0.41923455123256226</c:v>
                </c:pt>
                <c:pt idx="756">
                  <c:v>0.1578754517816191</c:v>
                </c:pt>
                <c:pt idx="757">
                  <c:v>1.0615895313999908</c:v>
                </c:pt>
                <c:pt idx="758">
                  <c:v>6.6409482639010461E-2</c:v>
                </c:pt>
                <c:pt idx="759">
                  <c:v>1.0743885721836492</c:v>
                </c:pt>
                <c:pt idx="760">
                  <c:v>0.56048911016045577</c:v>
                </c:pt>
                <c:pt idx="761">
                  <c:v>0.9506318476722293</c:v>
                </c:pt>
                <c:pt idx="762">
                  <c:v>5.7046050594012923E-2</c:v>
                </c:pt>
                <c:pt idx="763">
                  <c:v>4.2659908236284003E-2</c:v>
                </c:pt>
                <c:pt idx="764">
                  <c:v>1.7666519856339393</c:v>
                </c:pt>
                <c:pt idx="765">
                  <c:v>0.20201400774927347</c:v>
                </c:pt>
                <c:pt idx="766">
                  <c:v>8.390029947133287E-3</c:v>
                </c:pt>
                <c:pt idx="767">
                  <c:v>0.31341435624904024</c:v>
                </c:pt>
                <c:pt idx="768">
                  <c:v>2.603138512421586E-2</c:v>
                </c:pt>
                <c:pt idx="769">
                  <c:v>1.1874380481660025</c:v>
                </c:pt>
                <c:pt idx="770">
                  <c:v>0.34702975576364248</c:v>
                </c:pt>
                <c:pt idx="771">
                  <c:v>0.26325117937954834</c:v>
                </c:pt>
                <c:pt idx="772">
                  <c:v>0.56823187012269338</c:v>
                </c:pt>
                <c:pt idx="773">
                  <c:v>0.21960535644956053</c:v>
                </c:pt>
                <c:pt idx="774">
                  <c:v>1.2989715716037402</c:v>
                </c:pt>
                <c:pt idx="775">
                  <c:v>0.48659035609110118</c:v>
                </c:pt>
                <c:pt idx="776">
                  <c:v>0.55723958873211521</c:v>
                </c:pt>
                <c:pt idx="777">
                  <c:v>0.19616943290332559</c:v>
                </c:pt>
                <c:pt idx="778">
                  <c:v>4.1298513032491053E-2</c:v>
                </c:pt>
                <c:pt idx="779">
                  <c:v>1.1778021765503011</c:v>
                </c:pt>
                <c:pt idx="780">
                  <c:v>0.40750132829254648</c:v>
                </c:pt>
                <c:pt idx="781">
                  <c:v>0.23085867735280163</c:v>
                </c:pt>
                <c:pt idx="782">
                  <c:v>0.22968009165797276</c:v>
                </c:pt>
                <c:pt idx="783">
                  <c:v>0.20244866154012284</c:v>
                </c:pt>
                <c:pt idx="784">
                  <c:v>0.25976145168331027</c:v>
                </c:pt>
                <c:pt idx="785">
                  <c:v>0.11354704941772879</c:v>
                </c:pt>
                <c:pt idx="786">
                  <c:v>0.23108028020344965</c:v>
                </c:pt>
                <c:pt idx="787">
                  <c:v>0.66781389477771258</c:v>
                </c:pt>
                <c:pt idx="788">
                  <c:v>6.6890141706021491E-2</c:v>
                </c:pt>
                <c:pt idx="789">
                  <c:v>7.4401985947558674E-2</c:v>
                </c:pt>
                <c:pt idx="790">
                  <c:v>0.48480670174242352</c:v>
                </c:pt>
                <c:pt idx="791">
                  <c:v>0.96119676959982203</c:v>
                </c:pt>
                <c:pt idx="792">
                  <c:v>1.8004713093713207</c:v>
                </c:pt>
                <c:pt idx="793">
                  <c:v>0.30617564943156544</c:v>
                </c:pt>
                <c:pt idx="794">
                  <c:v>0.59065335638729954</c:v>
                </c:pt>
                <c:pt idx="795">
                  <c:v>7.6238526659902439E-2</c:v>
                </c:pt>
                <c:pt idx="796">
                  <c:v>0.18755655885590045</c:v>
                </c:pt>
                <c:pt idx="797">
                  <c:v>0.17903340348490732</c:v>
                </c:pt>
                <c:pt idx="798">
                  <c:v>0.1557600036040496</c:v>
                </c:pt>
                <c:pt idx="799">
                  <c:v>0.68457490639147067</c:v>
                </c:pt>
                <c:pt idx="800">
                  <c:v>0.1840269924297247</c:v>
                </c:pt>
                <c:pt idx="801">
                  <c:v>0.64867698684476771</c:v>
                </c:pt>
                <c:pt idx="802">
                  <c:v>0.28195073661433573</c:v>
                </c:pt>
                <c:pt idx="803">
                  <c:v>0.37071049231749059</c:v>
                </c:pt>
                <c:pt idx="804">
                  <c:v>0.13128500571497448</c:v>
                </c:pt>
                <c:pt idx="805">
                  <c:v>0.12857209565079056</c:v>
                </c:pt>
                <c:pt idx="806">
                  <c:v>0.13713677033034055</c:v>
                </c:pt>
                <c:pt idx="807">
                  <c:v>0.4629576414050382</c:v>
                </c:pt>
                <c:pt idx="808">
                  <c:v>2.1164604480267712</c:v>
                </c:pt>
                <c:pt idx="809">
                  <c:v>0.69024793089974323</c:v>
                </c:pt>
                <c:pt idx="810">
                  <c:v>1.4135229856535507</c:v>
                </c:pt>
                <c:pt idx="811">
                  <c:v>1.3811406257808467</c:v>
                </c:pt>
                <c:pt idx="812">
                  <c:v>0.36385496659063926</c:v>
                </c:pt>
                <c:pt idx="813">
                  <c:v>0.67136626280129885</c:v>
                </c:pt>
                <c:pt idx="814">
                  <c:v>0.45849425121230714</c:v>
                </c:pt>
                <c:pt idx="815">
                  <c:v>2.217023260367958E-2</c:v>
                </c:pt>
                <c:pt idx="816">
                  <c:v>0.46576223371140291</c:v>
                </c:pt>
                <c:pt idx="817">
                  <c:v>1.1434156536483628</c:v>
                </c:pt>
                <c:pt idx="818">
                  <c:v>0.16216709839514146</c:v>
                </c:pt>
                <c:pt idx="819">
                  <c:v>0.74888506108041319</c:v>
                </c:pt>
                <c:pt idx="820">
                  <c:v>0.22728490532517773</c:v>
                </c:pt>
                <c:pt idx="821">
                  <c:v>0.77590503720323578</c:v>
                </c:pt>
                <c:pt idx="822">
                  <c:v>0.27236123127121248</c:v>
                </c:pt>
                <c:pt idx="823">
                  <c:v>0.72390481218275093</c:v>
                </c:pt>
                <c:pt idx="824">
                  <c:v>0.44257917258087259</c:v>
                </c:pt>
                <c:pt idx="825">
                  <c:v>1.1401104958852456E-2</c:v>
                </c:pt>
                <c:pt idx="826">
                  <c:v>0.31392722899440817</c:v>
                </c:pt>
                <c:pt idx="827">
                  <c:v>0.35597376934005814</c:v>
                </c:pt>
                <c:pt idx="828">
                  <c:v>0.3039370589582846</c:v>
                </c:pt>
                <c:pt idx="829">
                  <c:v>0.21735431196636681</c:v>
                </c:pt>
                <c:pt idx="830">
                  <c:v>0.11493712498779832</c:v>
                </c:pt>
                <c:pt idx="831">
                  <c:v>1.6188025413961828E-2</c:v>
                </c:pt>
                <c:pt idx="832">
                  <c:v>0.19540073246562684</c:v>
                </c:pt>
                <c:pt idx="833">
                  <c:v>0.41679571586418068</c:v>
                </c:pt>
                <c:pt idx="834">
                  <c:v>0.18537335129185423</c:v>
                </c:pt>
                <c:pt idx="835">
                  <c:v>4.6049417740101758E-3</c:v>
                </c:pt>
                <c:pt idx="836">
                  <c:v>0.45107930482130298</c:v>
                </c:pt>
                <c:pt idx="837">
                  <c:v>0.17683645087193692</c:v>
                </c:pt>
                <c:pt idx="838">
                  <c:v>0.23728050325009095</c:v>
                </c:pt>
                <c:pt idx="839">
                  <c:v>0.29021281746041444</c:v>
                </c:pt>
                <c:pt idx="840">
                  <c:v>0.38352786466531436</c:v>
                </c:pt>
                <c:pt idx="841">
                  <c:v>0.44244699387494457</c:v>
                </c:pt>
                <c:pt idx="842">
                  <c:v>0.56337344431297798</c:v>
                </c:pt>
                <c:pt idx="843">
                  <c:v>0.57343736847728133</c:v>
                </c:pt>
                <c:pt idx="844">
                  <c:v>4.8600617828127586E-2</c:v>
                </c:pt>
                <c:pt idx="845">
                  <c:v>3.2933514750332696E-2</c:v>
                </c:pt>
                <c:pt idx="846">
                  <c:v>0.17618289533975343</c:v>
                </c:pt>
                <c:pt idx="847">
                  <c:v>6.0915132986696152E-2</c:v>
                </c:pt>
                <c:pt idx="848">
                  <c:v>1.223763357288757</c:v>
                </c:pt>
                <c:pt idx="849">
                  <c:v>0.72406343257570094</c:v>
                </c:pt>
                <c:pt idx="850">
                  <c:v>2.2173582195842478E-2</c:v>
                </c:pt>
                <c:pt idx="851">
                  <c:v>0.76878280980254365</c:v>
                </c:pt>
                <c:pt idx="852">
                  <c:v>4.2212448118928277E-2</c:v>
                </c:pt>
                <c:pt idx="853">
                  <c:v>0.25297866363087412</c:v>
                </c:pt>
                <c:pt idx="854">
                  <c:v>0.41388474138098075</c:v>
                </c:pt>
                <c:pt idx="855">
                  <c:v>0.72115969124375345</c:v>
                </c:pt>
                <c:pt idx="856">
                  <c:v>6.5220609059675291E-2</c:v>
                </c:pt>
                <c:pt idx="857">
                  <c:v>0.20957448240864895</c:v>
                </c:pt>
                <c:pt idx="858">
                  <c:v>9.9732836035175632E-2</c:v>
                </c:pt>
                <c:pt idx="859">
                  <c:v>0.60548547044165146</c:v>
                </c:pt>
                <c:pt idx="860">
                  <c:v>0.87848032261864661</c:v>
                </c:pt>
                <c:pt idx="861">
                  <c:v>1.2933776700875919</c:v>
                </c:pt>
                <c:pt idx="862">
                  <c:v>0.88698683810967971</c:v>
                </c:pt>
                <c:pt idx="863">
                  <c:v>0.26012695661715113</c:v>
                </c:pt>
                <c:pt idx="864">
                  <c:v>0.55446840159522004</c:v>
                </c:pt>
                <c:pt idx="865">
                  <c:v>1.0915768366590293</c:v>
                </c:pt>
                <c:pt idx="866">
                  <c:v>2.6884322688517255</c:v>
                </c:pt>
                <c:pt idx="867">
                  <c:v>0.30199127858988001</c:v>
                </c:pt>
                <c:pt idx="868">
                  <c:v>0.39237595039251877</c:v>
                </c:pt>
                <c:pt idx="869">
                  <c:v>7.1290543054696343E-2</c:v>
                </c:pt>
                <c:pt idx="870">
                  <c:v>0.25706122503520934</c:v>
                </c:pt>
                <c:pt idx="871">
                  <c:v>0.70070606540377911</c:v>
                </c:pt>
                <c:pt idx="872">
                  <c:v>2.3754319354338159E-2</c:v>
                </c:pt>
                <c:pt idx="873">
                  <c:v>0.63932580143934958</c:v>
                </c:pt>
                <c:pt idx="874">
                  <c:v>0.13520331103530259</c:v>
                </c:pt>
                <c:pt idx="875">
                  <c:v>0.17308806592969078</c:v>
                </c:pt>
                <c:pt idx="876">
                  <c:v>0.26090212590825823</c:v>
                </c:pt>
                <c:pt idx="877">
                  <c:v>6.8359611818050212E-2</c:v>
                </c:pt>
                <c:pt idx="878">
                  <c:v>8.9259204796792987E-2</c:v>
                </c:pt>
                <c:pt idx="879">
                  <c:v>1.2013554117945201E-2</c:v>
                </c:pt>
                <c:pt idx="880">
                  <c:v>0.20847381189177466</c:v>
                </c:pt>
                <c:pt idx="881">
                  <c:v>1.6960130811365507E-3</c:v>
                </c:pt>
                <c:pt idx="882">
                  <c:v>0.23295977221588982</c:v>
                </c:pt>
                <c:pt idx="883">
                  <c:v>6.1420500818824199E-2</c:v>
                </c:pt>
                <c:pt idx="884">
                  <c:v>0.61278188592466831</c:v>
                </c:pt>
                <c:pt idx="885">
                  <c:v>1.2019067485558141</c:v>
                </c:pt>
                <c:pt idx="886">
                  <c:v>9.91709849367957E-2</c:v>
                </c:pt>
                <c:pt idx="887">
                  <c:v>0.31764491249393267</c:v>
                </c:pt>
                <c:pt idx="888">
                  <c:v>0.23194448132638304</c:v>
                </c:pt>
                <c:pt idx="889">
                  <c:v>1.0032173684354382</c:v>
                </c:pt>
                <c:pt idx="890">
                  <c:v>0.23376136148236204</c:v>
                </c:pt>
                <c:pt idx="891">
                  <c:v>0.25572810258989315</c:v>
                </c:pt>
                <c:pt idx="892">
                  <c:v>0.32336130183349349</c:v>
                </c:pt>
                <c:pt idx="893">
                  <c:v>0.36444186490021435</c:v>
                </c:pt>
                <c:pt idx="894">
                  <c:v>0.15214247764408542</c:v>
                </c:pt>
                <c:pt idx="895">
                  <c:v>0.38134295805099505</c:v>
                </c:pt>
                <c:pt idx="896">
                  <c:v>0.98738176095187724</c:v>
                </c:pt>
                <c:pt idx="897">
                  <c:v>5.742790261847721E-2</c:v>
                </c:pt>
                <c:pt idx="898">
                  <c:v>1.0669777896726176</c:v>
                </c:pt>
                <c:pt idx="899">
                  <c:v>0.47580290396696956</c:v>
                </c:pt>
                <c:pt idx="900">
                  <c:v>0.6945767747409709</c:v>
                </c:pt>
                <c:pt idx="901">
                  <c:v>0.41385100489787674</c:v>
                </c:pt>
                <c:pt idx="902">
                  <c:v>0.34281224825235979</c:v>
                </c:pt>
                <c:pt idx="903">
                  <c:v>1.0830238749057215</c:v>
                </c:pt>
                <c:pt idx="904">
                  <c:v>0.74009611115388307</c:v>
                </c:pt>
                <c:pt idx="905">
                  <c:v>0.19628016807132304</c:v>
                </c:pt>
                <c:pt idx="906">
                  <c:v>0.33836043915595637</c:v>
                </c:pt>
                <c:pt idx="907">
                  <c:v>0.41645269192915763</c:v>
                </c:pt>
                <c:pt idx="908">
                  <c:v>0.25303542208612811</c:v>
                </c:pt>
                <c:pt idx="909">
                  <c:v>0.81647705387367175</c:v>
                </c:pt>
                <c:pt idx="910">
                  <c:v>8.6682066250904272E-2</c:v>
                </c:pt>
                <c:pt idx="911">
                  <c:v>1.5234806088038366</c:v>
                </c:pt>
                <c:pt idx="912">
                  <c:v>5.0699166364857259E-3</c:v>
                </c:pt>
                <c:pt idx="913">
                  <c:v>1.2690523885407643</c:v>
                </c:pt>
                <c:pt idx="914">
                  <c:v>0.13219297650104492</c:v>
                </c:pt>
                <c:pt idx="915">
                  <c:v>0.24238999999053087</c:v>
                </c:pt>
                <c:pt idx="916">
                  <c:v>1.8411843300931995E-2</c:v>
                </c:pt>
                <c:pt idx="917">
                  <c:v>0.69641454910785128</c:v>
                </c:pt>
                <c:pt idx="918">
                  <c:v>0.38427454796442478</c:v>
                </c:pt>
                <c:pt idx="919">
                  <c:v>2.5642490033298389E-2</c:v>
                </c:pt>
                <c:pt idx="920">
                  <c:v>0.26159499760488919</c:v>
                </c:pt>
                <c:pt idx="921">
                  <c:v>0.13792912080505598</c:v>
                </c:pt>
                <c:pt idx="922">
                  <c:v>0.10711147129580972</c:v>
                </c:pt>
                <c:pt idx="923">
                  <c:v>0.63540494622348642</c:v>
                </c:pt>
                <c:pt idx="924">
                  <c:v>0.61280283177770112</c:v>
                </c:pt>
                <c:pt idx="925">
                  <c:v>5.8574318700109922E-2</c:v>
                </c:pt>
                <c:pt idx="926">
                  <c:v>0.25287213121946528</c:v>
                </c:pt>
                <c:pt idx="927">
                  <c:v>0.6526457338197208</c:v>
                </c:pt>
                <c:pt idx="928">
                  <c:v>5.9824645328209199E-2</c:v>
                </c:pt>
                <c:pt idx="929">
                  <c:v>0.74414705816067606</c:v>
                </c:pt>
                <c:pt idx="930">
                  <c:v>0.11360897219674226</c:v>
                </c:pt>
                <c:pt idx="931">
                  <c:v>0.11980704539110457</c:v>
                </c:pt>
                <c:pt idx="932">
                  <c:v>0.35880230661442702</c:v>
                </c:pt>
                <c:pt idx="933">
                  <c:v>0.63236033264980074</c:v>
                </c:pt>
                <c:pt idx="934">
                  <c:v>0.91128111560323244</c:v>
                </c:pt>
                <c:pt idx="935">
                  <c:v>0.17168419393153925</c:v>
                </c:pt>
                <c:pt idx="936">
                  <c:v>5.0112349645058146E-2</c:v>
                </c:pt>
                <c:pt idx="937">
                  <c:v>0.18098739956018206</c:v>
                </c:pt>
                <c:pt idx="938">
                  <c:v>0.18448448975175144</c:v>
                </c:pt>
                <c:pt idx="939">
                  <c:v>0.4382567802468787</c:v>
                </c:pt>
                <c:pt idx="940">
                  <c:v>0.27920883502359339</c:v>
                </c:pt>
                <c:pt idx="941">
                  <c:v>0.47105586205032407</c:v>
                </c:pt>
                <c:pt idx="942">
                  <c:v>0.13374721107607995</c:v>
                </c:pt>
                <c:pt idx="943">
                  <c:v>0.44911007376832757</c:v>
                </c:pt>
                <c:pt idx="944">
                  <c:v>0.21683007752780925</c:v>
                </c:pt>
                <c:pt idx="945">
                  <c:v>0.18286460707227203</c:v>
                </c:pt>
                <c:pt idx="946">
                  <c:v>0.66993902122493676</c:v>
                </c:pt>
                <c:pt idx="947">
                  <c:v>0.8054126789436451</c:v>
                </c:pt>
                <c:pt idx="948">
                  <c:v>0.18378754692189392</c:v>
                </c:pt>
                <c:pt idx="949">
                  <c:v>0.25090367594906726</c:v>
                </c:pt>
                <c:pt idx="950">
                  <c:v>0.57692758818323997</c:v>
                </c:pt>
                <c:pt idx="951">
                  <c:v>0.40750967510532088</c:v>
                </c:pt>
                <c:pt idx="952">
                  <c:v>1.1342542123539099</c:v>
                </c:pt>
                <c:pt idx="953">
                  <c:v>0.18936412725945215</c:v>
                </c:pt>
                <c:pt idx="954">
                  <c:v>0.31291148717893119</c:v>
                </c:pt>
                <c:pt idx="955">
                  <c:v>0.76080511643059101</c:v>
                </c:pt>
                <c:pt idx="956">
                  <c:v>0.11970677654157467</c:v>
                </c:pt>
                <c:pt idx="957">
                  <c:v>0.20853416555260737</c:v>
                </c:pt>
                <c:pt idx="958">
                  <c:v>0.56740467954737328</c:v>
                </c:pt>
                <c:pt idx="959">
                  <c:v>0.11450508732331661</c:v>
                </c:pt>
                <c:pt idx="960">
                  <c:v>0.33744858651325266</c:v>
                </c:pt>
                <c:pt idx="961">
                  <c:v>0.18590328988489022</c:v>
                </c:pt>
                <c:pt idx="962">
                  <c:v>0.81129698610406265</c:v>
                </c:pt>
                <c:pt idx="963">
                  <c:v>0.13979090836029842</c:v>
                </c:pt>
                <c:pt idx="964">
                  <c:v>4.9850964742938972E-3</c:v>
                </c:pt>
                <c:pt idx="965">
                  <c:v>9.4595763005792421E-2</c:v>
                </c:pt>
                <c:pt idx="966">
                  <c:v>0.22894852493155743</c:v>
                </c:pt>
                <c:pt idx="967">
                  <c:v>0.30549179520024405</c:v>
                </c:pt>
                <c:pt idx="968">
                  <c:v>0.19665512540727767</c:v>
                </c:pt>
                <c:pt idx="969">
                  <c:v>0.37418064531548245</c:v>
                </c:pt>
                <c:pt idx="970">
                  <c:v>0.56110131334377189</c:v>
                </c:pt>
                <c:pt idx="971">
                  <c:v>0.22068204694540813</c:v>
                </c:pt>
                <c:pt idx="972">
                  <c:v>0.23090508333692622</c:v>
                </c:pt>
                <c:pt idx="973">
                  <c:v>1.6714872129459088E-2</c:v>
                </c:pt>
                <c:pt idx="974">
                  <c:v>0.29390545713107891</c:v>
                </c:pt>
                <c:pt idx="975">
                  <c:v>0.1691668594549566</c:v>
                </c:pt>
                <c:pt idx="976">
                  <c:v>9.8927965833022519E-2</c:v>
                </c:pt>
                <c:pt idx="977">
                  <c:v>1.0066670182443811</c:v>
                </c:pt>
                <c:pt idx="978">
                  <c:v>0.13253923607673862</c:v>
                </c:pt>
                <c:pt idx="979">
                  <c:v>0.56100584105693052</c:v>
                </c:pt>
                <c:pt idx="980">
                  <c:v>1.0122796069739333</c:v>
                </c:pt>
                <c:pt idx="981">
                  <c:v>0.43067689085266142</c:v>
                </c:pt>
                <c:pt idx="982">
                  <c:v>9.4445416162277397E-3</c:v>
                </c:pt>
                <c:pt idx="983">
                  <c:v>0.78043072334197261</c:v>
                </c:pt>
                <c:pt idx="984">
                  <c:v>0.74709837645865151</c:v>
                </c:pt>
                <c:pt idx="985">
                  <c:v>1.0908326688651426</c:v>
                </c:pt>
                <c:pt idx="986">
                  <c:v>0.78357405714168638</c:v>
                </c:pt>
                <c:pt idx="987">
                  <c:v>0.5654326206837591</c:v>
                </c:pt>
                <c:pt idx="988">
                  <c:v>9.1927582402160618E-2</c:v>
                </c:pt>
                <c:pt idx="989">
                  <c:v>0.7779051582440718</c:v>
                </c:pt>
                <c:pt idx="990">
                  <c:v>0.11129509105302586</c:v>
                </c:pt>
                <c:pt idx="991">
                  <c:v>9.9074490218471048E-2</c:v>
                </c:pt>
                <c:pt idx="992">
                  <c:v>0.52625071971969484</c:v>
                </c:pt>
                <c:pt idx="993">
                  <c:v>0.8912049715648136</c:v>
                </c:pt>
                <c:pt idx="994">
                  <c:v>0.12250346964185664</c:v>
                </c:pt>
                <c:pt idx="995">
                  <c:v>0.1524897762953219</c:v>
                </c:pt>
                <c:pt idx="996">
                  <c:v>0.1664648975018227</c:v>
                </c:pt>
                <c:pt idx="997">
                  <c:v>6.5859841185800974E-2</c:v>
                </c:pt>
                <c:pt idx="998">
                  <c:v>1.2322473748018061</c:v>
                </c:pt>
                <c:pt idx="999">
                  <c:v>0.14143756722077713</c:v>
                </c:pt>
                <c:pt idx="1000">
                  <c:v>9.0904776366993262E-2</c:v>
                </c:pt>
                <c:pt idx="1001">
                  <c:v>0.1855975771490006</c:v>
                </c:pt>
                <c:pt idx="1002">
                  <c:v>1.2556735253886413</c:v>
                </c:pt>
                <c:pt idx="1003">
                  <c:v>5.333019005454661E-2</c:v>
                </c:pt>
                <c:pt idx="1004">
                  <c:v>1.1356783173432639</c:v>
                </c:pt>
                <c:pt idx="1005">
                  <c:v>7.7082292694726051E-2</c:v>
                </c:pt>
                <c:pt idx="1006">
                  <c:v>0.89191541513512729</c:v>
                </c:pt>
                <c:pt idx="1007">
                  <c:v>1.1321178189955994</c:v>
                </c:pt>
                <c:pt idx="1008">
                  <c:v>0.21290017027444808</c:v>
                </c:pt>
                <c:pt idx="1009">
                  <c:v>3.4356454217409599E-2</c:v>
                </c:pt>
                <c:pt idx="1010">
                  <c:v>1.688473313450803</c:v>
                </c:pt>
                <c:pt idx="1011">
                  <c:v>0.20670897165363705</c:v>
                </c:pt>
                <c:pt idx="1012">
                  <c:v>0.30369473971137634</c:v>
                </c:pt>
                <c:pt idx="1013">
                  <c:v>0.19324744587093867</c:v>
                </c:pt>
                <c:pt idx="1014">
                  <c:v>0.33174663103098229</c:v>
                </c:pt>
                <c:pt idx="1015">
                  <c:v>2.2553106141384798</c:v>
                </c:pt>
                <c:pt idx="1016">
                  <c:v>9.2055748863231701E-2</c:v>
                </c:pt>
                <c:pt idx="1017">
                  <c:v>0.22554508416402694</c:v>
                </c:pt>
                <c:pt idx="1018">
                  <c:v>2.7290530440645614E-2</c:v>
                </c:pt>
                <c:pt idx="1019">
                  <c:v>0.7491473797970305</c:v>
                </c:pt>
                <c:pt idx="1020">
                  <c:v>0.10046506849536158</c:v>
                </c:pt>
                <c:pt idx="1021">
                  <c:v>2.14366539809147E-2</c:v>
                </c:pt>
                <c:pt idx="1022">
                  <c:v>1.5583772980033517E-2</c:v>
                </c:pt>
                <c:pt idx="1023">
                  <c:v>0.56563096802208146</c:v>
                </c:pt>
                <c:pt idx="1024">
                  <c:v>0.51846771691328875</c:v>
                </c:pt>
                <c:pt idx="1025">
                  <c:v>0.17769429333537989</c:v>
                </c:pt>
                <c:pt idx="1026">
                  <c:v>8.8914528128652581E-2</c:v>
                </c:pt>
                <c:pt idx="1027">
                  <c:v>0.64990709930443813</c:v>
                </c:pt>
                <c:pt idx="1028">
                  <c:v>1.1950512532024742E-2</c:v>
                </c:pt>
                <c:pt idx="1029">
                  <c:v>0.56641134939146243</c:v>
                </c:pt>
                <c:pt idx="1030">
                  <c:v>0.73173622926903437</c:v>
                </c:pt>
                <c:pt idx="1031">
                  <c:v>0.47734783270186554</c:v>
                </c:pt>
                <c:pt idx="1032">
                  <c:v>1.4613754484393928</c:v>
                </c:pt>
                <c:pt idx="1033">
                  <c:v>8.6225285775359164E-2</c:v>
                </c:pt>
                <c:pt idx="1034">
                  <c:v>0.27974586081745911</c:v>
                </c:pt>
                <c:pt idx="1035">
                  <c:v>0.78024092255344168</c:v>
                </c:pt>
                <c:pt idx="1036">
                  <c:v>0.12575882204104383</c:v>
                </c:pt>
                <c:pt idx="1037">
                  <c:v>1.5021419516757506E-2</c:v>
                </c:pt>
                <c:pt idx="1038">
                  <c:v>0.42503138040214739</c:v>
                </c:pt>
                <c:pt idx="1039">
                  <c:v>0.49146294894110254</c:v>
                </c:pt>
                <c:pt idx="1040">
                  <c:v>0.23419134363138847</c:v>
                </c:pt>
                <c:pt idx="1041">
                  <c:v>9.2767060855081449E-2</c:v>
                </c:pt>
                <c:pt idx="1042">
                  <c:v>0.43831539383608698</c:v>
                </c:pt>
                <c:pt idx="1043">
                  <c:v>1.0562171598601551</c:v>
                </c:pt>
                <c:pt idx="1044">
                  <c:v>0.4432283494400498</c:v>
                </c:pt>
                <c:pt idx="1045">
                  <c:v>0.24474226800539983</c:v>
                </c:pt>
                <c:pt idx="1046">
                  <c:v>0.27163616337400648</c:v>
                </c:pt>
                <c:pt idx="1047">
                  <c:v>0.55209586887268924</c:v>
                </c:pt>
                <c:pt idx="1048">
                  <c:v>0.21555986970235957</c:v>
                </c:pt>
                <c:pt idx="1049">
                  <c:v>2.5103807176272867E-2</c:v>
                </c:pt>
                <c:pt idx="1050">
                  <c:v>3.920755056712151E-2</c:v>
                </c:pt>
                <c:pt idx="1051">
                  <c:v>0.10165076934999195</c:v>
                </c:pt>
                <c:pt idx="1052">
                  <c:v>6.6524845870758617E-2</c:v>
                </c:pt>
                <c:pt idx="1053">
                  <c:v>0.83836778390725097</c:v>
                </c:pt>
                <c:pt idx="1054">
                  <c:v>0.41363910316055263</c:v>
                </c:pt>
                <c:pt idx="1055">
                  <c:v>6.6445715026403687E-2</c:v>
                </c:pt>
                <c:pt idx="1056">
                  <c:v>0.29541922602828102</c:v>
                </c:pt>
                <c:pt idx="1057">
                  <c:v>7.0735999536032268E-2</c:v>
                </c:pt>
                <c:pt idx="1058">
                  <c:v>0.37165087058256019</c:v>
                </c:pt>
                <c:pt idx="1059">
                  <c:v>7.7041955383685967E-2</c:v>
                </c:pt>
                <c:pt idx="1060">
                  <c:v>0.36076505817708587</c:v>
                </c:pt>
                <c:pt idx="1061">
                  <c:v>0.1614283886243226</c:v>
                </c:pt>
                <c:pt idx="1062">
                  <c:v>0.82472325397790525</c:v>
                </c:pt>
                <c:pt idx="1063">
                  <c:v>0.3507750709818151</c:v>
                </c:pt>
                <c:pt idx="1064">
                  <c:v>0.90845358181986824</c:v>
                </c:pt>
                <c:pt idx="1065">
                  <c:v>0.13518933293819971</c:v>
                </c:pt>
                <c:pt idx="1066">
                  <c:v>1.6966857295691553</c:v>
                </c:pt>
                <c:pt idx="1067">
                  <c:v>0.78722120424006392</c:v>
                </c:pt>
                <c:pt idx="1068">
                  <c:v>0.9364669339714573</c:v>
                </c:pt>
                <c:pt idx="1069">
                  <c:v>0.33546598248032972</c:v>
                </c:pt>
                <c:pt idx="1070">
                  <c:v>0.25062365856549401</c:v>
                </c:pt>
                <c:pt idx="1071">
                  <c:v>5.9675034731235428E-3</c:v>
                </c:pt>
                <c:pt idx="1072">
                  <c:v>0.25850391457484007</c:v>
                </c:pt>
                <c:pt idx="1073">
                  <c:v>0.36559777640489843</c:v>
                </c:pt>
                <c:pt idx="1074">
                  <c:v>0.65252212264778231</c:v>
                </c:pt>
                <c:pt idx="1075">
                  <c:v>0.49577807249827693</c:v>
                </c:pt>
                <c:pt idx="1076">
                  <c:v>0.36795383088212202</c:v>
                </c:pt>
                <c:pt idx="1077">
                  <c:v>4.4535676787757925E-2</c:v>
                </c:pt>
                <c:pt idx="1078">
                  <c:v>0.99045509454326019</c:v>
                </c:pt>
                <c:pt idx="1079">
                  <c:v>0.80656870702937766</c:v>
                </c:pt>
                <c:pt idx="1080">
                  <c:v>0.4620013863156931</c:v>
                </c:pt>
                <c:pt idx="1081">
                  <c:v>0.48516751273701519</c:v>
                </c:pt>
                <c:pt idx="1082">
                  <c:v>0.26859498777231294</c:v>
                </c:pt>
                <c:pt idx="1083">
                  <c:v>0.21840332480190655</c:v>
                </c:pt>
                <c:pt idx="1084">
                  <c:v>0.20614579145058387</c:v>
                </c:pt>
                <c:pt idx="1085">
                  <c:v>9.2725938584813011E-2</c:v>
                </c:pt>
                <c:pt idx="1086">
                  <c:v>0.6660110269938242</c:v>
                </c:pt>
                <c:pt idx="1087">
                  <c:v>0.3432008550697711</c:v>
                </c:pt>
                <c:pt idx="1088">
                  <c:v>5.7054397368411711E-2</c:v>
                </c:pt>
                <c:pt idx="1089">
                  <c:v>2.0450382455573683E-2</c:v>
                </c:pt>
                <c:pt idx="1090">
                  <c:v>0.99130155978713241</c:v>
                </c:pt>
                <c:pt idx="1091">
                  <c:v>0.29911540413969212</c:v>
                </c:pt>
                <c:pt idx="1092">
                  <c:v>3.4316274925967144E-2</c:v>
                </c:pt>
                <c:pt idx="1093">
                  <c:v>0.65888288566942088</c:v>
                </c:pt>
                <c:pt idx="1094">
                  <c:v>1.3078549040924721</c:v>
                </c:pt>
                <c:pt idx="1095">
                  <c:v>8.0477010422808637E-2</c:v>
                </c:pt>
                <c:pt idx="1096">
                  <c:v>0.43186350724743922</c:v>
                </c:pt>
                <c:pt idx="1097">
                  <c:v>0.96656136571393614</c:v>
                </c:pt>
                <c:pt idx="1098">
                  <c:v>0.14938232972769935</c:v>
                </c:pt>
                <c:pt idx="1099">
                  <c:v>0.59230427120197637</c:v>
                </c:pt>
                <c:pt idx="1100">
                  <c:v>0.84456800695793277</c:v>
                </c:pt>
                <c:pt idx="1101">
                  <c:v>1.1206385768227027</c:v>
                </c:pt>
                <c:pt idx="1102">
                  <c:v>0.12777952539752985</c:v>
                </c:pt>
                <c:pt idx="1103">
                  <c:v>1.9352960455321637</c:v>
                </c:pt>
                <c:pt idx="1104">
                  <c:v>0.28735546833114989</c:v>
                </c:pt>
                <c:pt idx="1105">
                  <c:v>0.24326743339965645</c:v>
                </c:pt>
                <c:pt idx="1106">
                  <c:v>3.6347858601607566E-2</c:v>
                </c:pt>
                <c:pt idx="1107">
                  <c:v>0.80317200441779191</c:v>
                </c:pt>
                <c:pt idx="1108">
                  <c:v>0.39841959134818844</c:v>
                </c:pt>
                <c:pt idx="1109">
                  <c:v>0.20872077313002441</c:v>
                </c:pt>
                <c:pt idx="1110">
                  <c:v>0.45262872875926768</c:v>
                </c:pt>
                <c:pt idx="1111">
                  <c:v>0.64907678473745312</c:v>
                </c:pt>
                <c:pt idx="1112">
                  <c:v>0.5791983992528893</c:v>
                </c:pt>
                <c:pt idx="1113">
                  <c:v>0.58261016778100372</c:v>
                </c:pt>
                <c:pt idx="1114">
                  <c:v>0.93246960894119946</c:v>
                </c:pt>
                <c:pt idx="1115">
                  <c:v>3.4100505268013531E-2</c:v>
                </c:pt>
                <c:pt idx="1116">
                  <c:v>0.32063524485764727</c:v>
                </c:pt>
                <c:pt idx="1117">
                  <c:v>2.4011083418002094E-2</c:v>
                </c:pt>
                <c:pt idx="1118">
                  <c:v>0.93894373326449354</c:v>
                </c:pt>
                <c:pt idx="1119">
                  <c:v>0.1417138959459959</c:v>
                </c:pt>
                <c:pt idx="1120">
                  <c:v>0.94381066308012529</c:v>
                </c:pt>
                <c:pt idx="1121">
                  <c:v>0.21696153575274024</c:v>
                </c:pt>
                <c:pt idx="1122">
                  <c:v>2.7407354942932092E-2</c:v>
                </c:pt>
                <c:pt idx="1123">
                  <c:v>0.71163985689943898</c:v>
                </c:pt>
                <c:pt idx="1124">
                  <c:v>0.43899715582365922</c:v>
                </c:pt>
                <c:pt idx="1125">
                  <c:v>0.19321527847624512</c:v>
                </c:pt>
                <c:pt idx="1126">
                  <c:v>0.62525996046195209</c:v>
                </c:pt>
                <c:pt idx="1127">
                  <c:v>0.75209212772743428</c:v>
                </c:pt>
                <c:pt idx="1128">
                  <c:v>0.22562055647315246</c:v>
                </c:pt>
                <c:pt idx="1129">
                  <c:v>3.301900553388732E-2</c:v>
                </c:pt>
                <c:pt idx="1130">
                  <c:v>0.34136505643407428</c:v>
                </c:pt>
                <c:pt idx="1131">
                  <c:v>0.13298944968911217</c:v>
                </c:pt>
                <c:pt idx="1132">
                  <c:v>0.95818076739366764</c:v>
                </c:pt>
                <c:pt idx="1133">
                  <c:v>4.9458093723645527E-2</c:v>
                </c:pt>
                <c:pt idx="1134">
                  <c:v>3.3493040556653129</c:v>
                </c:pt>
                <c:pt idx="1135">
                  <c:v>0.18495042929219735</c:v>
                </c:pt>
                <c:pt idx="1136">
                  <c:v>0.42822856595220504</c:v>
                </c:pt>
                <c:pt idx="1137">
                  <c:v>0.42654272769845325</c:v>
                </c:pt>
                <c:pt idx="1138">
                  <c:v>0.79415204144991192</c:v>
                </c:pt>
                <c:pt idx="1139">
                  <c:v>4.2052506731293619E-2</c:v>
                </c:pt>
                <c:pt idx="1140">
                  <c:v>0.37067323844400724</c:v>
                </c:pt>
                <c:pt idx="1141">
                  <c:v>0.25928371379433229</c:v>
                </c:pt>
                <c:pt idx="1142">
                  <c:v>1.086957546530237</c:v>
                </c:pt>
                <c:pt idx="1143">
                  <c:v>0.43425579638688172</c:v>
                </c:pt>
                <c:pt idx="1144">
                  <c:v>1.2285863585758285</c:v>
                </c:pt>
                <c:pt idx="1145">
                  <c:v>0.57758178215394351</c:v>
                </c:pt>
                <c:pt idx="1146">
                  <c:v>7.7710952883005474E-2</c:v>
                </c:pt>
                <c:pt idx="1147">
                  <c:v>5.0106907833686862E-2</c:v>
                </c:pt>
                <c:pt idx="1148">
                  <c:v>0.70858619335440087</c:v>
                </c:pt>
                <c:pt idx="1149">
                  <c:v>0.27625343524908924</c:v>
                </c:pt>
                <c:pt idx="1150">
                  <c:v>1.0448353907859462</c:v>
                </c:pt>
                <c:pt idx="1151">
                  <c:v>0.61198208259912246</c:v>
                </c:pt>
                <c:pt idx="1152">
                  <c:v>8.0551788589388204E-2</c:v>
                </c:pt>
                <c:pt idx="1153">
                  <c:v>0.1628001703658539</c:v>
                </c:pt>
                <c:pt idx="1154">
                  <c:v>0.16189108066007987</c:v>
                </c:pt>
                <c:pt idx="1155">
                  <c:v>0.15659608987504822</c:v>
                </c:pt>
                <c:pt idx="1156">
                  <c:v>0.38768205038430997</c:v>
                </c:pt>
                <c:pt idx="1157">
                  <c:v>0.19223271549011181</c:v>
                </c:pt>
                <c:pt idx="1158">
                  <c:v>0.22789775177893359</c:v>
                </c:pt>
                <c:pt idx="1159">
                  <c:v>0.13513535453758047</c:v>
                </c:pt>
                <c:pt idx="1160">
                  <c:v>0.92605103026306879</c:v>
                </c:pt>
                <c:pt idx="1161">
                  <c:v>2.7421346225334955E-2</c:v>
                </c:pt>
                <c:pt idx="1162">
                  <c:v>0.36645550279772132</c:v>
                </c:pt>
                <c:pt idx="1163">
                  <c:v>6.9169702583781592E-2</c:v>
                </c:pt>
                <c:pt idx="1164">
                  <c:v>0.89609171016471723</c:v>
                </c:pt>
                <c:pt idx="1165">
                  <c:v>9.374713297917367E-2</c:v>
                </c:pt>
                <c:pt idx="1166">
                  <c:v>0.24085273219498457</c:v>
                </c:pt>
                <c:pt idx="1167">
                  <c:v>2.665551935852703E-2</c:v>
                </c:pt>
                <c:pt idx="1168">
                  <c:v>6.9565237034491349E-3</c:v>
                </c:pt>
                <c:pt idx="1169">
                  <c:v>0.77095422829478966</c:v>
                </c:pt>
                <c:pt idx="1170">
                  <c:v>5.115931947448827E-2</c:v>
                </c:pt>
                <c:pt idx="1171">
                  <c:v>0.41406578942706274</c:v>
                </c:pt>
                <c:pt idx="1172">
                  <c:v>0.40727672296162643</c:v>
                </c:pt>
                <c:pt idx="1173">
                  <c:v>8.8402405389632441E-2</c:v>
                </c:pt>
                <c:pt idx="1174">
                  <c:v>0.76506217172248714</c:v>
                </c:pt>
                <c:pt idx="1175">
                  <c:v>4.3258650326625681E-2</c:v>
                </c:pt>
                <c:pt idx="1176">
                  <c:v>9.3636173742804862E-2</c:v>
                </c:pt>
                <c:pt idx="1177">
                  <c:v>0.54897253200722285</c:v>
                </c:pt>
                <c:pt idx="1178">
                  <c:v>8.8156380239851423E-2</c:v>
                </c:pt>
                <c:pt idx="1179">
                  <c:v>0.64288947329256185</c:v>
                </c:pt>
                <c:pt idx="1180">
                  <c:v>0.3737372569528804</c:v>
                </c:pt>
                <c:pt idx="1181">
                  <c:v>0.60363808035774991</c:v>
                </c:pt>
                <c:pt idx="1182">
                  <c:v>3.2216657777191099E-3</c:v>
                </c:pt>
                <c:pt idx="1183">
                  <c:v>5.5397696627493449E-2</c:v>
                </c:pt>
                <c:pt idx="1184">
                  <c:v>0.13815241048804633</c:v>
                </c:pt>
                <c:pt idx="1185">
                  <c:v>0.82480418330380556</c:v>
                </c:pt>
                <c:pt idx="1186">
                  <c:v>0.11759498809976618</c:v>
                </c:pt>
                <c:pt idx="1187">
                  <c:v>0.22296527836701568</c:v>
                </c:pt>
                <c:pt idx="1188">
                  <c:v>7.2107996560145812E-2</c:v>
                </c:pt>
                <c:pt idx="1189">
                  <c:v>0.33024282107952169</c:v>
                </c:pt>
                <c:pt idx="1190">
                  <c:v>4.5518175909878784E-2</c:v>
                </c:pt>
                <c:pt idx="1191">
                  <c:v>6.1280336748510793E-2</c:v>
                </c:pt>
                <c:pt idx="1192">
                  <c:v>9.9253751968547809E-3</c:v>
                </c:pt>
                <c:pt idx="1193">
                  <c:v>0.32384479295623014</c:v>
                </c:pt>
                <c:pt idx="1194">
                  <c:v>0.97549258665969818</c:v>
                </c:pt>
                <c:pt idx="1195">
                  <c:v>0.20633661236943565</c:v>
                </c:pt>
                <c:pt idx="1196">
                  <c:v>0.57674714413831429</c:v>
                </c:pt>
                <c:pt idx="1197">
                  <c:v>0.22319322589558899</c:v>
                </c:pt>
                <c:pt idx="1198">
                  <c:v>6.6291537618992369E-2</c:v>
                </c:pt>
                <c:pt idx="1199">
                  <c:v>8.6645303050753505E-2</c:v>
                </c:pt>
                <c:pt idx="1200">
                  <c:v>0.35845350585475488</c:v>
                </c:pt>
                <c:pt idx="1201">
                  <c:v>0.68959508043968754</c:v>
                </c:pt>
                <c:pt idx="1202">
                  <c:v>0.3908847739813272</c:v>
                </c:pt>
                <c:pt idx="1203">
                  <c:v>0.15135842633599292</c:v>
                </c:pt>
                <c:pt idx="1204">
                  <c:v>3.8008101846828748E-2</c:v>
                </c:pt>
                <c:pt idx="1205">
                  <c:v>0.15057788679191417</c:v>
                </c:pt>
                <c:pt idx="1206">
                  <c:v>0.90577002994430567</c:v>
                </c:pt>
                <c:pt idx="1207">
                  <c:v>0.22481774754249689</c:v>
                </c:pt>
                <c:pt idx="1208">
                  <c:v>1.2607402925812068</c:v>
                </c:pt>
                <c:pt idx="1209">
                  <c:v>0.81969983259887202</c:v>
                </c:pt>
                <c:pt idx="1210">
                  <c:v>0.77486430201073131</c:v>
                </c:pt>
                <c:pt idx="1211">
                  <c:v>0.62158734918721692</c:v>
                </c:pt>
                <c:pt idx="1212">
                  <c:v>0.4295541404407302</c:v>
                </c:pt>
                <c:pt idx="1213">
                  <c:v>9.1483611291749672E-2</c:v>
                </c:pt>
                <c:pt idx="1214">
                  <c:v>0.48088077382975369</c:v>
                </c:pt>
                <c:pt idx="1215">
                  <c:v>0.58521965812910504</c:v>
                </c:pt>
                <c:pt idx="1216">
                  <c:v>1.3833772465737015</c:v>
                </c:pt>
                <c:pt idx="1217">
                  <c:v>1.3198324169461684</c:v>
                </c:pt>
                <c:pt idx="1218">
                  <c:v>0.56558959407003806</c:v>
                </c:pt>
                <c:pt idx="1219">
                  <c:v>0.2237285486621001</c:v>
                </c:pt>
                <c:pt idx="1220">
                  <c:v>8.0396461647140566E-2</c:v>
                </c:pt>
                <c:pt idx="1221">
                  <c:v>0.42241562800501492</c:v>
                </c:pt>
                <c:pt idx="1222">
                  <c:v>3.7960970182555014E-4</c:v>
                </c:pt>
                <c:pt idx="1223">
                  <c:v>0.16573990988918705</c:v>
                </c:pt>
                <c:pt idx="1224">
                  <c:v>0.60639558744951272</c:v>
                </c:pt>
                <c:pt idx="1225">
                  <c:v>0.53758530295889528</c:v>
                </c:pt>
                <c:pt idx="1226">
                  <c:v>0.68518323291441818</c:v>
                </c:pt>
                <c:pt idx="1227">
                  <c:v>9.91183730942896E-2</c:v>
                </c:pt>
                <c:pt idx="1228">
                  <c:v>0.8539598256127231</c:v>
                </c:pt>
                <c:pt idx="1229">
                  <c:v>0.29917686145055089</c:v>
                </c:pt>
                <c:pt idx="1230">
                  <c:v>4.8359714454583556E-3</c:v>
                </c:pt>
                <c:pt idx="1231">
                  <c:v>0.45803648995481117</c:v>
                </c:pt>
                <c:pt idx="1232">
                  <c:v>1.8603550631512686</c:v>
                </c:pt>
                <c:pt idx="1233">
                  <c:v>0.14001546850628571</c:v>
                </c:pt>
                <c:pt idx="1234">
                  <c:v>0.57142395259802947</c:v>
                </c:pt>
                <c:pt idx="1235">
                  <c:v>0.26981311163094046</c:v>
                </c:pt>
                <c:pt idx="1236">
                  <c:v>0.12633813394980781</c:v>
                </c:pt>
                <c:pt idx="1237">
                  <c:v>0.13627757336573201</c:v>
                </c:pt>
                <c:pt idx="1238">
                  <c:v>9.6904172237088568E-2</c:v>
                </c:pt>
                <c:pt idx="1239">
                  <c:v>0.42815372535090329</c:v>
                </c:pt>
                <c:pt idx="1240">
                  <c:v>0.60259779627392718</c:v>
                </c:pt>
                <c:pt idx="1241">
                  <c:v>8.9281773979475426E-2</c:v>
                </c:pt>
                <c:pt idx="1242">
                  <c:v>1.533593483570896</c:v>
                </c:pt>
                <c:pt idx="1243">
                  <c:v>2.0295897305990298</c:v>
                </c:pt>
                <c:pt idx="1244">
                  <c:v>0.3796598315909937</c:v>
                </c:pt>
                <c:pt idx="1245">
                  <c:v>0.55223887722042719</c:v>
                </c:pt>
                <c:pt idx="1246">
                  <c:v>2.8938825307498212E-2</c:v>
                </c:pt>
                <c:pt idx="1247">
                  <c:v>0.21461106908387761</c:v>
                </c:pt>
                <c:pt idx="1248">
                  <c:v>0.26037891407074798</c:v>
                </c:pt>
                <c:pt idx="1249">
                  <c:v>0.10159977828535989</c:v>
                </c:pt>
                <c:pt idx="1250">
                  <c:v>0.16101873717044216</c:v>
                </c:pt>
                <c:pt idx="1251">
                  <c:v>0.2575351810504713</c:v>
                </c:pt>
                <c:pt idx="1252">
                  <c:v>0.43991003671543005</c:v>
                </c:pt>
                <c:pt idx="1253">
                  <c:v>1.0687074774694279E-2</c:v>
                </c:pt>
                <c:pt idx="1254">
                  <c:v>0.82962852640186613</c:v>
                </c:pt>
                <c:pt idx="1255">
                  <c:v>8.7498233813472187E-2</c:v>
                </c:pt>
                <c:pt idx="1256">
                  <c:v>0.88681015258395357</c:v>
                </c:pt>
                <c:pt idx="1257">
                  <c:v>0.81409855100404938</c:v>
                </c:pt>
                <c:pt idx="1258">
                  <c:v>1.1722324430078421</c:v>
                </c:pt>
                <c:pt idx="1259">
                  <c:v>1.0709910333355384</c:v>
                </c:pt>
                <c:pt idx="1260">
                  <c:v>0.2736557533816989</c:v>
                </c:pt>
                <c:pt idx="1261">
                  <c:v>1.0353030077690655</c:v>
                </c:pt>
                <c:pt idx="1262">
                  <c:v>0.57336655798919034</c:v>
                </c:pt>
                <c:pt idx="1263">
                  <c:v>8.950852319655131E-3</c:v>
                </c:pt>
                <c:pt idx="1264">
                  <c:v>0.16583512015916183</c:v>
                </c:pt>
                <c:pt idx="1265">
                  <c:v>0.36807663989929262</c:v>
                </c:pt>
                <c:pt idx="1266">
                  <c:v>0.84845415350123587</c:v>
                </c:pt>
                <c:pt idx="1267">
                  <c:v>1.1962667362798496</c:v>
                </c:pt>
                <c:pt idx="1268">
                  <c:v>0.69674094844355294</c:v>
                </c:pt>
                <c:pt idx="1269">
                  <c:v>0.88074053156018139</c:v>
                </c:pt>
                <c:pt idx="1270">
                  <c:v>0.4896086215607533</c:v>
                </c:pt>
                <c:pt idx="1271">
                  <c:v>0.71393753988552855</c:v>
                </c:pt>
                <c:pt idx="1272">
                  <c:v>0.15909369190767811</c:v>
                </c:pt>
                <c:pt idx="1273">
                  <c:v>0.49663575673369798</c:v>
                </c:pt>
                <c:pt idx="1274">
                  <c:v>0.11940040791985619</c:v>
                </c:pt>
                <c:pt idx="1275">
                  <c:v>0.18274040527474616</c:v>
                </c:pt>
                <c:pt idx="1276">
                  <c:v>0.34460463557821869</c:v>
                </c:pt>
                <c:pt idx="1277">
                  <c:v>3.5863954862218508E-2</c:v>
                </c:pt>
                <c:pt idx="1278">
                  <c:v>0.22915270708872557</c:v>
                </c:pt>
                <c:pt idx="1279">
                  <c:v>1.6678678703211278</c:v>
                </c:pt>
                <c:pt idx="1280">
                  <c:v>0.21161455239277169</c:v>
                </c:pt>
                <c:pt idx="1281">
                  <c:v>4.5664627408696229E-2</c:v>
                </c:pt>
                <c:pt idx="1282">
                  <c:v>0.68714550931050655</c:v>
                </c:pt>
                <c:pt idx="1283">
                  <c:v>0.21854886258264666</c:v>
                </c:pt>
                <c:pt idx="1284">
                  <c:v>0.2823865512695935</c:v>
                </c:pt>
                <c:pt idx="1285">
                  <c:v>0.94118422489047449</c:v>
                </c:pt>
                <c:pt idx="1286">
                  <c:v>1.890611289677427</c:v>
                </c:pt>
                <c:pt idx="1287">
                  <c:v>0.41438751695727422</c:v>
                </c:pt>
                <c:pt idx="1288">
                  <c:v>0.44538762964344303</c:v>
                </c:pt>
                <c:pt idx="1289">
                  <c:v>0.36111306363253404</c:v>
                </c:pt>
                <c:pt idx="1290">
                  <c:v>0.30879792627883246</c:v>
                </c:pt>
                <c:pt idx="1291">
                  <c:v>0.71907840043644822</c:v>
                </c:pt>
                <c:pt idx="1292">
                  <c:v>0.5989992501355762</c:v>
                </c:pt>
                <c:pt idx="1293">
                  <c:v>0.24641241348135937</c:v>
                </c:pt>
                <c:pt idx="1294">
                  <c:v>0.65021838180829661</c:v>
                </c:pt>
                <c:pt idx="1295">
                  <c:v>0.62020333393752058</c:v>
                </c:pt>
                <c:pt idx="1296">
                  <c:v>0.30291722812400124</c:v>
                </c:pt>
                <c:pt idx="1297">
                  <c:v>0.42316780635755774</c:v>
                </c:pt>
                <c:pt idx="1298">
                  <c:v>1.2192497462598877</c:v>
                </c:pt>
                <c:pt idx="1299">
                  <c:v>0.13993512674964173</c:v>
                </c:pt>
                <c:pt idx="1300">
                  <c:v>0.53199296794736217</c:v>
                </c:pt>
                <c:pt idx="1301">
                  <c:v>0.16621587554457712</c:v>
                </c:pt>
                <c:pt idx="1302">
                  <c:v>0.14552996873310237</c:v>
                </c:pt>
                <c:pt idx="1303">
                  <c:v>0.10433644613029332</c:v>
                </c:pt>
                <c:pt idx="1304">
                  <c:v>0.81182309029721655</c:v>
                </c:pt>
                <c:pt idx="1305">
                  <c:v>0.56047307095243659</c:v>
                </c:pt>
                <c:pt idx="1306">
                  <c:v>8.2736183498707816E-2</c:v>
                </c:pt>
                <c:pt idx="1307">
                  <c:v>0.66009156061138241</c:v>
                </c:pt>
                <c:pt idx="1308">
                  <c:v>1.2053387543004657</c:v>
                </c:pt>
                <c:pt idx="1309">
                  <c:v>0.4513012836001592</c:v>
                </c:pt>
                <c:pt idx="1310">
                  <c:v>6.4631759006206235E-4</c:v>
                </c:pt>
                <c:pt idx="1311">
                  <c:v>1.6260960407728463E-2</c:v>
                </c:pt>
                <c:pt idx="1312">
                  <c:v>6.4849449574220494E-2</c:v>
                </c:pt>
                <c:pt idx="1313">
                  <c:v>0.22373420087582799</c:v>
                </c:pt>
                <c:pt idx="1314">
                  <c:v>9.6058294297042629E-2</c:v>
                </c:pt>
                <c:pt idx="1315">
                  <c:v>0.42095650281796926</c:v>
                </c:pt>
                <c:pt idx="1316">
                  <c:v>0.22950735668491676</c:v>
                </c:pt>
                <c:pt idx="1317">
                  <c:v>0.32198057987993944</c:v>
                </c:pt>
                <c:pt idx="1318">
                  <c:v>5.5171200320484247E-2</c:v>
                </c:pt>
                <c:pt idx="1319">
                  <c:v>0.25560117721060172</c:v>
                </c:pt>
                <c:pt idx="1320">
                  <c:v>1.1289086564527981</c:v>
                </c:pt>
                <c:pt idx="1321">
                  <c:v>0.1506684838434067</c:v>
                </c:pt>
                <c:pt idx="1322">
                  <c:v>0.14576276050220904</c:v>
                </c:pt>
                <c:pt idx="1323">
                  <c:v>0.21039859585152337</c:v>
                </c:pt>
                <c:pt idx="1324">
                  <c:v>0.17752572266538424</c:v>
                </c:pt>
                <c:pt idx="1325">
                  <c:v>0.40210636229899588</c:v>
                </c:pt>
                <c:pt idx="1326">
                  <c:v>0.53897247864963638</c:v>
                </c:pt>
                <c:pt idx="1327">
                  <c:v>0.18915843110281186</c:v>
                </c:pt>
                <c:pt idx="1328">
                  <c:v>8.6424256776212821E-2</c:v>
                </c:pt>
                <c:pt idx="1329">
                  <c:v>0.64549935954970672</c:v>
                </c:pt>
                <c:pt idx="1330">
                  <c:v>0.16798540960015115</c:v>
                </c:pt>
                <c:pt idx="1331">
                  <c:v>0.46539848057252536</c:v>
                </c:pt>
                <c:pt idx="1332">
                  <c:v>0.31613097745125046</c:v>
                </c:pt>
                <c:pt idx="1333">
                  <c:v>0.79248189289875848</c:v>
                </c:pt>
                <c:pt idx="1334">
                  <c:v>0.76288493408654157</c:v>
                </c:pt>
                <c:pt idx="1335">
                  <c:v>0.5781574703695993</c:v>
                </c:pt>
                <c:pt idx="1336">
                  <c:v>0.13860490961448524</c:v>
                </c:pt>
                <c:pt idx="1337">
                  <c:v>1.1360271772293842</c:v>
                </c:pt>
                <c:pt idx="1338">
                  <c:v>1.2839817464325267</c:v>
                </c:pt>
                <c:pt idx="1339">
                  <c:v>0.32236066371329575</c:v>
                </c:pt>
                <c:pt idx="1340">
                  <c:v>9.3185036515301037E-2</c:v>
                </c:pt>
                <c:pt idx="1341">
                  <c:v>0.19732582388473208</c:v>
                </c:pt>
                <c:pt idx="1342">
                  <c:v>1.0669147825768248</c:v>
                </c:pt>
                <c:pt idx="1343">
                  <c:v>0.79769650318239305</c:v>
                </c:pt>
                <c:pt idx="1344">
                  <c:v>0.21388394809104275</c:v>
                </c:pt>
                <c:pt idx="1345">
                  <c:v>0.12896949886475964</c:v>
                </c:pt>
                <c:pt idx="1346">
                  <c:v>1.438845341078423</c:v>
                </c:pt>
                <c:pt idx="1347">
                  <c:v>1.2718938410370786</c:v>
                </c:pt>
                <c:pt idx="1348">
                  <c:v>0.12953576144738427</c:v>
                </c:pt>
                <c:pt idx="1349">
                  <c:v>5.793109363697882E-2</c:v>
                </c:pt>
                <c:pt idx="1350">
                  <c:v>0.80286874998652658</c:v>
                </c:pt>
                <c:pt idx="1351">
                  <c:v>0.32628141172130015</c:v>
                </c:pt>
                <c:pt idx="1352">
                  <c:v>0.29651936269461998</c:v>
                </c:pt>
                <c:pt idx="1353">
                  <c:v>0.10424966649590231</c:v>
                </c:pt>
                <c:pt idx="1354">
                  <c:v>3.7623092609815376E-2</c:v>
                </c:pt>
                <c:pt idx="1355">
                  <c:v>6.6098807024348658E-2</c:v>
                </c:pt>
                <c:pt idx="1356">
                  <c:v>0.92621348304909179</c:v>
                </c:pt>
                <c:pt idx="1357">
                  <c:v>2.035359342734186E-2</c:v>
                </c:pt>
                <c:pt idx="1358">
                  <c:v>1.0335526272042015</c:v>
                </c:pt>
                <c:pt idx="1359">
                  <c:v>0.58095722824089724</c:v>
                </c:pt>
                <c:pt idx="1360">
                  <c:v>0.4877261181422754</c:v>
                </c:pt>
                <c:pt idx="1361">
                  <c:v>5.0787335954502584E-2</c:v>
                </c:pt>
                <c:pt idx="1362">
                  <c:v>0.41424618198765317</c:v>
                </c:pt>
                <c:pt idx="1363">
                  <c:v>0.51192188286795959</c:v>
                </c:pt>
                <c:pt idx="1364">
                  <c:v>0.67106162970305328</c:v>
                </c:pt>
                <c:pt idx="1365">
                  <c:v>0.27421117332677714</c:v>
                </c:pt>
                <c:pt idx="1366">
                  <c:v>0.14763367885232492</c:v>
                </c:pt>
                <c:pt idx="1367">
                  <c:v>0.1387788317346425</c:v>
                </c:pt>
                <c:pt idx="1368">
                  <c:v>0.39081448332155994</c:v>
                </c:pt>
                <c:pt idx="1369">
                  <c:v>0.40844284978951867</c:v>
                </c:pt>
                <c:pt idx="1370">
                  <c:v>0.36102719536793348</c:v>
                </c:pt>
                <c:pt idx="1371">
                  <c:v>0.15163093931919192</c:v>
                </c:pt>
                <c:pt idx="1372">
                  <c:v>0.83424487749825782</c:v>
                </c:pt>
                <c:pt idx="1373">
                  <c:v>0.34702486169951413</c:v>
                </c:pt>
                <c:pt idx="1374">
                  <c:v>1.4189651178287186</c:v>
                </c:pt>
                <c:pt idx="1375">
                  <c:v>7.4135863468683366E-2</c:v>
                </c:pt>
                <c:pt idx="1376">
                  <c:v>0.38103079119595629</c:v>
                </c:pt>
                <c:pt idx="1377">
                  <c:v>0.14470110445503084</c:v>
                </c:pt>
                <c:pt idx="1378">
                  <c:v>0.35770789051313767</c:v>
                </c:pt>
                <c:pt idx="1379">
                  <c:v>0.25769880175001086</c:v>
                </c:pt>
                <c:pt idx="1380">
                  <c:v>1.4176152833790419</c:v>
                </c:pt>
                <c:pt idx="1381">
                  <c:v>1.1039817792987261</c:v>
                </c:pt>
                <c:pt idx="1382">
                  <c:v>0.5592857859922139</c:v>
                </c:pt>
                <c:pt idx="1383">
                  <c:v>0.33372528350061903</c:v>
                </c:pt>
                <c:pt idx="1384">
                  <c:v>0.14912990603814436</c:v>
                </c:pt>
                <c:pt idx="1385">
                  <c:v>7.7950392964369938E-2</c:v>
                </c:pt>
                <c:pt idx="1386">
                  <c:v>0.64525129724044727</c:v>
                </c:pt>
                <c:pt idx="1387">
                  <c:v>0.67971240415257861</c:v>
                </c:pt>
                <c:pt idx="1388">
                  <c:v>2.8439914256387124E-2</c:v>
                </c:pt>
                <c:pt idx="1389">
                  <c:v>1.1159216937042458</c:v>
                </c:pt>
                <c:pt idx="1390">
                  <c:v>0.45169758761761519</c:v>
                </c:pt>
                <c:pt idx="1391">
                  <c:v>3.6679608808847061E-2</c:v>
                </c:pt>
                <c:pt idx="1392">
                  <c:v>6.1789820818169763E-2</c:v>
                </c:pt>
                <c:pt idx="1393">
                  <c:v>0.1063611036933811</c:v>
                </c:pt>
                <c:pt idx="1394">
                  <c:v>0.51657618006372852</c:v>
                </c:pt>
                <c:pt idx="1395">
                  <c:v>0.15198698036341282</c:v>
                </c:pt>
                <c:pt idx="1396">
                  <c:v>0.49525596138759043</c:v>
                </c:pt>
                <c:pt idx="1397">
                  <c:v>0.67266636780795075</c:v>
                </c:pt>
                <c:pt idx="1398">
                  <c:v>0.24064608775903576</c:v>
                </c:pt>
                <c:pt idx="1399">
                  <c:v>0.76336419525062416</c:v>
                </c:pt>
                <c:pt idx="1400">
                  <c:v>7.1165322260955247E-2</c:v>
                </c:pt>
                <c:pt idx="1401">
                  <c:v>3.9438926687126999E-3</c:v>
                </c:pt>
                <c:pt idx="1402">
                  <c:v>0.19269000194829969</c:v>
                </c:pt>
                <c:pt idx="1403">
                  <c:v>0.23995631213968852</c:v>
                </c:pt>
                <c:pt idx="1404">
                  <c:v>0.21527039792736688</c:v>
                </c:pt>
                <c:pt idx="1405">
                  <c:v>6.342598553003103E-3</c:v>
                </c:pt>
                <c:pt idx="1406">
                  <c:v>2.126352490934504</c:v>
                </c:pt>
                <c:pt idx="1407">
                  <c:v>8.7123655168781844E-2</c:v>
                </c:pt>
                <c:pt idx="1408">
                  <c:v>1.5005489840069655E-2</c:v>
                </c:pt>
                <c:pt idx="1409">
                  <c:v>0.1725136455587942</c:v>
                </c:pt>
                <c:pt idx="1410">
                  <c:v>3.8521646576928921E-2</c:v>
                </c:pt>
                <c:pt idx="1411">
                  <c:v>9.3589136365506573E-2</c:v>
                </c:pt>
                <c:pt idx="1412">
                  <c:v>0.14879657730965981</c:v>
                </c:pt>
                <c:pt idx="1413">
                  <c:v>0.58204234477055738</c:v>
                </c:pt>
                <c:pt idx="1414">
                  <c:v>0.54773000459259147</c:v>
                </c:pt>
                <c:pt idx="1415">
                  <c:v>0.30527232224082146</c:v>
                </c:pt>
                <c:pt idx="1416">
                  <c:v>1.0685612454355871</c:v>
                </c:pt>
                <c:pt idx="1417">
                  <c:v>0.22317985280863201</c:v>
                </c:pt>
                <c:pt idx="1418">
                  <c:v>0.22548660386981498</c:v>
                </c:pt>
                <c:pt idx="1419">
                  <c:v>0.34132483614792952</c:v>
                </c:pt>
                <c:pt idx="1420">
                  <c:v>1.9549901559153406E-2</c:v>
                </c:pt>
                <c:pt idx="1421">
                  <c:v>4.1491319857785314E-2</c:v>
                </c:pt>
                <c:pt idx="1422">
                  <c:v>1.0655778976275409E-2</c:v>
                </c:pt>
                <c:pt idx="1423">
                  <c:v>0.13184169289995473</c:v>
                </c:pt>
                <c:pt idx="1424">
                  <c:v>0.49338397257772937</c:v>
                </c:pt>
                <c:pt idx="1425">
                  <c:v>0.13924882110471809</c:v>
                </c:pt>
                <c:pt idx="1426">
                  <c:v>0.40456962417169912</c:v>
                </c:pt>
                <c:pt idx="1427">
                  <c:v>0.72202218169711818</c:v>
                </c:pt>
                <c:pt idx="1428">
                  <c:v>0.83076560916080255</c:v>
                </c:pt>
                <c:pt idx="1429">
                  <c:v>0.26431419052616167</c:v>
                </c:pt>
                <c:pt idx="1430">
                  <c:v>0.48449018181911352</c:v>
                </c:pt>
                <c:pt idx="1431">
                  <c:v>0.4516801920998606</c:v>
                </c:pt>
                <c:pt idx="1432">
                  <c:v>0.58952352127049612</c:v>
                </c:pt>
                <c:pt idx="1433">
                  <c:v>0.26658424902791122</c:v>
                </c:pt>
                <c:pt idx="1434">
                  <c:v>0.74260055438157591</c:v>
                </c:pt>
                <c:pt idx="1435">
                  <c:v>0.11631328379648215</c:v>
                </c:pt>
                <c:pt idx="1436">
                  <c:v>0.21177009691936699</c:v>
                </c:pt>
                <c:pt idx="1437">
                  <c:v>1.0071344021037321</c:v>
                </c:pt>
                <c:pt idx="1438">
                  <c:v>0.68589085089195156</c:v>
                </c:pt>
                <c:pt idx="1439">
                  <c:v>7.8438840271219348E-2</c:v>
                </c:pt>
                <c:pt idx="1440">
                  <c:v>1.8949421674833853</c:v>
                </c:pt>
                <c:pt idx="1441">
                  <c:v>0.89735731614626824</c:v>
                </c:pt>
                <c:pt idx="1442">
                  <c:v>0.17920638207677553</c:v>
                </c:pt>
                <c:pt idx="1443">
                  <c:v>0.40820144955488036</c:v>
                </c:pt>
                <c:pt idx="1444">
                  <c:v>0.41944615932858764</c:v>
                </c:pt>
                <c:pt idx="1445">
                  <c:v>0.94159626897689142</c:v>
                </c:pt>
                <c:pt idx="1446">
                  <c:v>0.30560984594814555</c:v>
                </c:pt>
                <c:pt idx="1447">
                  <c:v>0.47162086912513967</c:v>
                </c:pt>
                <c:pt idx="1448">
                  <c:v>0.35396898463088083</c:v>
                </c:pt>
                <c:pt idx="1449">
                  <c:v>0.30121524009330047</c:v>
                </c:pt>
                <c:pt idx="1450">
                  <c:v>1.2072650793947823</c:v>
                </c:pt>
                <c:pt idx="1451">
                  <c:v>0.31804136346882905</c:v>
                </c:pt>
                <c:pt idx="1452">
                  <c:v>0.1376125516035217</c:v>
                </c:pt>
                <c:pt idx="1453">
                  <c:v>0.76887186081884573</c:v>
                </c:pt>
                <c:pt idx="1454">
                  <c:v>0.24582893740863185</c:v>
                </c:pt>
                <c:pt idx="1455">
                  <c:v>0.65709438592918101</c:v>
                </c:pt>
                <c:pt idx="1456">
                  <c:v>0.15027182368892544</c:v>
                </c:pt>
                <c:pt idx="1457">
                  <c:v>7.6196347215757082E-3</c:v>
                </c:pt>
                <c:pt idx="1458">
                  <c:v>4.5559988326374007E-2</c:v>
                </c:pt>
                <c:pt idx="1459">
                  <c:v>0.30013083079473668</c:v>
                </c:pt>
                <c:pt idx="1460">
                  <c:v>1.1057107664829846</c:v>
                </c:pt>
                <c:pt idx="1461">
                  <c:v>0.1353523906283845</c:v>
                </c:pt>
                <c:pt idx="1462">
                  <c:v>1.2474953921602689</c:v>
                </c:pt>
                <c:pt idx="1463">
                  <c:v>6.5732000344699684E-2</c:v>
                </c:pt>
                <c:pt idx="1464">
                  <c:v>0.19361517943141032</c:v>
                </c:pt>
                <c:pt idx="1465">
                  <c:v>0.7615689401452046</c:v>
                </c:pt>
                <c:pt idx="1466">
                  <c:v>7.7456157461079029E-3</c:v>
                </c:pt>
                <c:pt idx="1467">
                  <c:v>0.13998480971424759</c:v>
                </c:pt>
                <c:pt idx="1468">
                  <c:v>0.19304376959534694</c:v>
                </c:pt>
                <c:pt idx="1469">
                  <c:v>0.16470888096396324</c:v>
                </c:pt>
                <c:pt idx="1470">
                  <c:v>0.16864694579616182</c:v>
                </c:pt>
                <c:pt idx="1471">
                  <c:v>0.90709315835627224</c:v>
                </c:pt>
                <c:pt idx="1472">
                  <c:v>1.2193607257674572</c:v>
                </c:pt>
                <c:pt idx="1473">
                  <c:v>0.90381144504087541</c:v>
                </c:pt>
                <c:pt idx="1474">
                  <c:v>9.5402017184738674E-2</c:v>
                </c:pt>
                <c:pt idx="1475">
                  <c:v>0.13398601160890733</c:v>
                </c:pt>
                <c:pt idx="1476">
                  <c:v>0.12418580258556364</c:v>
                </c:pt>
                <c:pt idx="1477">
                  <c:v>0.31814426822900282</c:v>
                </c:pt>
                <c:pt idx="1478">
                  <c:v>0.31997643858943831</c:v>
                </c:pt>
                <c:pt idx="1479">
                  <c:v>6.6547652352388298E-2</c:v>
                </c:pt>
                <c:pt idx="1480">
                  <c:v>0.33255546545425341</c:v>
                </c:pt>
                <c:pt idx="1481">
                  <c:v>0.91699943205848533</c:v>
                </c:pt>
                <c:pt idx="1482">
                  <c:v>3.4548908238223361E-2</c:v>
                </c:pt>
                <c:pt idx="1483">
                  <c:v>1.4055960797103748</c:v>
                </c:pt>
                <c:pt idx="1484">
                  <c:v>5.9829787954920957E-2</c:v>
                </c:pt>
                <c:pt idx="1485">
                  <c:v>6.7571157244589536E-2</c:v>
                </c:pt>
                <c:pt idx="1486">
                  <c:v>0.37764977911293357</c:v>
                </c:pt>
                <c:pt idx="1487">
                  <c:v>5.0136100873362607E-2</c:v>
                </c:pt>
                <c:pt idx="1488">
                  <c:v>4.6343918242853006E-2</c:v>
                </c:pt>
                <c:pt idx="1489">
                  <c:v>0.41187928332387469</c:v>
                </c:pt>
                <c:pt idx="1490">
                  <c:v>0.40047012752956163</c:v>
                </c:pt>
                <c:pt idx="1491">
                  <c:v>0.9855257363284311</c:v>
                </c:pt>
                <c:pt idx="1492">
                  <c:v>0.22608392934519106</c:v>
                </c:pt>
                <c:pt idx="1493">
                  <c:v>1.038553494440229</c:v>
                </c:pt>
                <c:pt idx="1494">
                  <c:v>0.14522017950784077</c:v>
                </c:pt>
                <c:pt idx="1495">
                  <c:v>0.80101095143856516</c:v>
                </c:pt>
                <c:pt idx="1496">
                  <c:v>0.353737630345131</c:v>
                </c:pt>
                <c:pt idx="1497">
                  <c:v>0.83205662833492389</c:v>
                </c:pt>
                <c:pt idx="1498">
                  <c:v>0.28993849854939302</c:v>
                </c:pt>
                <c:pt idx="1499">
                  <c:v>8.963179510762391E-2</c:v>
                </c:pt>
                <c:pt idx="1500">
                  <c:v>6.5568424479601012E-2</c:v>
                </c:pt>
                <c:pt idx="1501">
                  <c:v>0.310021616147583</c:v>
                </c:pt>
                <c:pt idx="1502">
                  <c:v>1.1041144476617004</c:v>
                </c:pt>
                <c:pt idx="1503">
                  <c:v>0.62565203087746801</c:v>
                </c:pt>
                <c:pt idx="1504">
                  <c:v>0.58433927970867894</c:v>
                </c:pt>
                <c:pt idx="1505">
                  <c:v>0.29099056675703761</c:v>
                </c:pt>
                <c:pt idx="1506">
                  <c:v>0.71816233883485647</c:v>
                </c:pt>
                <c:pt idx="1507">
                  <c:v>0.4323965767555602</c:v>
                </c:pt>
                <c:pt idx="1508">
                  <c:v>0.81455884548357393</c:v>
                </c:pt>
                <c:pt idx="1509">
                  <c:v>0.10143257266975703</c:v>
                </c:pt>
                <c:pt idx="1510">
                  <c:v>0.37982230865691358</c:v>
                </c:pt>
                <c:pt idx="1511">
                  <c:v>0.53785457581058904</c:v>
                </c:pt>
                <c:pt idx="1512">
                  <c:v>1.0099450464034483</c:v>
                </c:pt>
                <c:pt idx="1513">
                  <c:v>0.21791777876157259</c:v>
                </c:pt>
                <c:pt idx="1514">
                  <c:v>0.55695933413217236</c:v>
                </c:pt>
                <c:pt idx="1515">
                  <c:v>9.3423570086058449E-2</c:v>
                </c:pt>
                <c:pt idx="1516">
                  <c:v>4.2207700116012534E-3</c:v>
                </c:pt>
                <c:pt idx="1517">
                  <c:v>0.53421028990287811</c:v>
                </c:pt>
                <c:pt idx="1518">
                  <c:v>1.3167055067137059</c:v>
                </c:pt>
                <c:pt idx="1519">
                  <c:v>0.73793262442718321</c:v>
                </c:pt>
                <c:pt idx="1520">
                  <c:v>0.58798168181081023</c:v>
                </c:pt>
                <c:pt idx="1521">
                  <c:v>0.18686780410956799</c:v>
                </c:pt>
                <c:pt idx="1522">
                  <c:v>1.2792014168371484</c:v>
                </c:pt>
                <c:pt idx="1523">
                  <c:v>3.7260851997293246E-2</c:v>
                </c:pt>
                <c:pt idx="1524">
                  <c:v>0.29750014242459216</c:v>
                </c:pt>
                <c:pt idx="1525">
                  <c:v>0.17255759437647397</c:v>
                </c:pt>
                <c:pt idx="1526">
                  <c:v>2.7908705507511955E-2</c:v>
                </c:pt>
                <c:pt idx="1527">
                  <c:v>1.1670163878644979</c:v>
                </c:pt>
                <c:pt idx="1528">
                  <c:v>0.8863101369684242</c:v>
                </c:pt>
                <c:pt idx="1529">
                  <c:v>5.1460650590166345E-3</c:v>
                </c:pt>
                <c:pt idx="1530">
                  <c:v>3.9022470677459481E-2</c:v>
                </c:pt>
                <c:pt idx="1531">
                  <c:v>4.9819756762942086E-3</c:v>
                </c:pt>
                <c:pt idx="1532">
                  <c:v>6.6620097345981691E-2</c:v>
                </c:pt>
                <c:pt idx="1533">
                  <c:v>0.19798925253677094</c:v>
                </c:pt>
                <c:pt idx="1534">
                  <c:v>1.8549859702875653</c:v>
                </c:pt>
                <c:pt idx="1535">
                  <c:v>1.04338659703362</c:v>
                </c:pt>
                <c:pt idx="1536">
                  <c:v>0.12446398819845257</c:v>
                </c:pt>
                <c:pt idx="1537">
                  <c:v>0.5501746883525952</c:v>
                </c:pt>
                <c:pt idx="1538">
                  <c:v>0.24175530639265311</c:v>
                </c:pt>
                <c:pt idx="1539">
                  <c:v>0.92386966061076814</c:v>
                </c:pt>
                <c:pt idx="1540">
                  <c:v>0.85980150465794491</c:v>
                </c:pt>
                <c:pt idx="1541">
                  <c:v>0.56280983783334237</c:v>
                </c:pt>
                <c:pt idx="1542">
                  <c:v>0.30033803521567487</c:v>
                </c:pt>
                <c:pt idx="1543">
                  <c:v>0.49546451286203258</c:v>
                </c:pt>
                <c:pt idx="1544">
                  <c:v>0.93241301694859791</c:v>
                </c:pt>
                <c:pt idx="1545">
                  <c:v>0.60897254842497783</c:v>
                </c:pt>
                <c:pt idx="1546">
                  <c:v>7.3583008535856365E-2</c:v>
                </c:pt>
                <c:pt idx="1547">
                  <c:v>0.41321657327950018</c:v>
                </c:pt>
                <c:pt idx="1548">
                  <c:v>1.1584489041567754E-2</c:v>
                </c:pt>
                <c:pt idx="1549">
                  <c:v>5.8230316900833384E-2</c:v>
                </c:pt>
                <c:pt idx="1550">
                  <c:v>0.10286555575925999</c:v>
                </c:pt>
                <c:pt idx="1551">
                  <c:v>0.15621980593021392</c:v>
                </c:pt>
                <c:pt idx="1552">
                  <c:v>0.36433816109956529</c:v>
                </c:pt>
                <c:pt idx="1553">
                  <c:v>0.31121949249460307</c:v>
                </c:pt>
                <c:pt idx="1554">
                  <c:v>0.90743126848225797</c:v>
                </c:pt>
                <c:pt idx="1555">
                  <c:v>0.21223137532472336</c:v>
                </c:pt>
                <c:pt idx="1556">
                  <c:v>9.2594312545681401E-2</c:v>
                </c:pt>
                <c:pt idx="1557">
                  <c:v>0.41137843195022444</c:v>
                </c:pt>
                <c:pt idx="1558">
                  <c:v>0.36446171352390111</c:v>
                </c:pt>
                <c:pt idx="1559">
                  <c:v>6.2265500093704684E-2</c:v>
                </c:pt>
                <c:pt idx="1560">
                  <c:v>3.4159804198820996E-2</c:v>
                </c:pt>
                <c:pt idx="1561">
                  <c:v>0.67719724913580259</c:v>
                </c:pt>
                <c:pt idx="1562">
                  <c:v>1.504163608511818</c:v>
                </c:pt>
                <c:pt idx="1563">
                  <c:v>0.13212617957049638</c:v>
                </c:pt>
                <c:pt idx="1564">
                  <c:v>1.0495829918884154</c:v>
                </c:pt>
                <c:pt idx="1565">
                  <c:v>6.1844782636935026E-2</c:v>
                </c:pt>
                <c:pt idx="1566">
                  <c:v>0.50612949047279931</c:v>
                </c:pt>
                <c:pt idx="1567">
                  <c:v>0.24423416657098518</c:v>
                </c:pt>
                <c:pt idx="1568">
                  <c:v>9.4353939659779174E-2</c:v>
                </c:pt>
                <c:pt idx="1569">
                  <c:v>0.62044186164012172</c:v>
                </c:pt>
                <c:pt idx="1570">
                  <c:v>0.30617268280091753</c:v>
                </c:pt>
                <c:pt idx="1571">
                  <c:v>0.45574033500600131</c:v>
                </c:pt>
                <c:pt idx="1572">
                  <c:v>0.30764525583372071</c:v>
                </c:pt>
                <c:pt idx="1573">
                  <c:v>0.15116991873065536</c:v>
                </c:pt>
                <c:pt idx="1574">
                  <c:v>0.69208449096028857</c:v>
                </c:pt>
                <c:pt idx="1575">
                  <c:v>0.17341247715491043</c:v>
                </c:pt>
                <c:pt idx="1576">
                  <c:v>0.25523454061455586</c:v>
                </c:pt>
                <c:pt idx="1577">
                  <c:v>0.23254015538784042</c:v>
                </c:pt>
                <c:pt idx="1578">
                  <c:v>0.58877748070335423</c:v>
                </c:pt>
                <c:pt idx="1579">
                  <c:v>0.36941914340157261</c:v>
                </c:pt>
                <c:pt idx="1580">
                  <c:v>1.1331868170231088</c:v>
                </c:pt>
                <c:pt idx="1581">
                  <c:v>0.14843202019183399</c:v>
                </c:pt>
                <c:pt idx="1582">
                  <c:v>0.10807321409517646</c:v>
                </c:pt>
                <c:pt idx="1583">
                  <c:v>7.8407716780572609E-2</c:v>
                </c:pt>
                <c:pt idx="1584">
                  <c:v>1.8291468085472218</c:v>
                </c:pt>
                <c:pt idx="1585">
                  <c:v>0.74310635640234235</c:v>
                </c:pt>
                <c:pt idx="1586">
                  <c:v>1.8587508239903026</c:v>
                </c:pt>
                <c:pt idx="1587">
                  <c:v>0.33577776918269481</c:v>
                </c:pt>
                <c:pt idx="1588">
                  <c:v>1.4445954148804936</c:v>
                </c:pt>
                <c:pt idx="1589">
                  <c:v>0.30768360541061029</c:v>
                </c:pt>
                <c:pt idx="1590">
                  <c:v>0.2908578108427316</c:v>
                </c:pt>
                <c:pt idx="1591">
                  <c:v>0.79534573646144457</c:v>
                </c:pt>
                <c:pt idx="1592">
                  <c:v>0.29285666325940307</c:v>
                </c:pt>
                <c:pt idx="1593">
                  <c:v>0.23822417117441763</c:v>
                </c:pt>
                <c:pt idx="1594">
                  <c:v>0.1960724310967418</c:v>
                </c:pt>
                <c:pt idx="1595">
                  <c:v>0.29395099450452211</c:v>
                </c:pt>
                <c:pt idx="1596">
                  <c:v>0.86553229618977601</c:v>
                </c:pt>
                <c:pt idx="1597">
                  <c:v>0.57094017113296658</c:v>
                </c:pt>
                <c:pt idx="1598">
                  <c:v>0.90200428990734205</c:v>
                </c:pt>
                <c:pt idx="1599">
                  <c:v>2.7878683772725038E-2</c:v>
                </c:pt>
                <c:pt idx="1600">
                  <c:v>0.6076757438041217</c:v>
                </c:pt>
                <c:pt idx="1601">
                  <c:v>0.56846014583201676</c:v>
                </c:pt>
                <c:pt idx="1602">
                  <c:v>0.7073588082983866</c:v>
                </c:pt>
                <c:pt idx="1603">
                  <c:v>1.8026817344952513E-3</c:v>
                </c:pt>
                <c:pt idx="1604">
                  <c:v>7.2903827231186921E-2</c:v>
                </c:pt>
                <c:pt idx="1605">
                  <c:v>0.18696539291041389</c:v>
                </c:pt>
                <c:pt idx="1606">
                  <c:v>9.268011516177517E-3</c:v>
                </c:pt>
                <c:pt idx="1607">
                  <c:v>0.35626531946460005</c:v>
                </c:pt>
                <c:pt idx="1608">
                  <c:v>0.7200789657747918</c:v>
                </c:pt>
                <c:pt idx="1609">
                  <c:v>0.13124970296200592</c:v>
                </c:pt>
                <c:pt idx="1610">
                  <c:v>1.1883848496484433</c:v>
                </c:pt>
                <c:pt idx="1611">
                  <c:v>0.69634315992303342</c:v>
                </c:pt>
                <c:pt idx="1612">
                  <c:v>2.3920518466652899E-2</c:v>
                </c:pt>
                <c:pt idx="1613">
                  <c:v>0.29516905653559455</c:v>
                </c:pt>
                <c:pt idx="1614">
                  <c:v>0.64168067455058475</c:v>
                </c:pt>
                <c:pt idx="1615">
                  <c:v>2.5903990265829129</c:v>
                </c:pt>
                <c:pt idx="1616">
                  <c:v>0.15929755625479489</c:v>
                </c:pt>
                <c:pt idx="1617">
                  <c:v>0.21561736444813381</c:v>
                </c:pt>
                <c:pt idx="1618">
                  <c:v>0.60742191093429998</c:v>
                </c:pt>
                <c:pt idx="1619">
                  <c:v>3.9059554508615063E-2</c:v>
                </c:pt>
                <c:pt idx="1620">
                  <c:v>0.8192261368839554</c:v>
                </c:pt>
                <c:pt idx="1621">
                  <c:v>0.37982717881119088</c:v>
                </c:pt>
                <c:pt idx="1622">
                  <c:v>0.25639283395220802</c:v>
                </c:pt>
                <c:pt idx="1623">
                  <c:v>0.27450936077388716</c:v>
                </c:pt>
                <c:pt idx="1624">
                  <c:v>0.74742079108216886</c:v>
                </c:pt>
                <c:pt idx="1625">
                  <c:v>0.12700163634205708</c:v>
                </c:pt>
                <c:pt idx="1626">
                  <c:v>0.29763769365583453</c:v>
                </c:pt>
                <c:pt idx="1627">
                  <c:v>0.41909401114302525</c:v>
                </c:pt>
                <c:pt idx="1628">
                  <c:v>1.3964452244943624</c:v>
                </c:pt>
                <c:pt idx="1629">
                  <c:v>2.6473009862543948E-2</c:v>
                </c:pt>
                <c:pt idx="1630">
                  <c:v>9.1709074427302598E-2</c:v>
                </c:pt>
                <c:pt idx="1631">
                  <c:v>0.40021008226792654</c:v>
                </c:pt>
                <c:pt idx="1632">
                  <c:v>0.29058781166288217</c:v>
                </c:pt>
                <c:pt idx="1633">
                  <c:v>0.57206923089074035</c:v>
                </c:pt>
                <c:pt idx="1634">
                  <c:v>1.0189139002816077</c:v>
                </c:pt>
                <c:pt idx="1635">
                  <c:v>0.93434097475340627</c:v>
                </c:pt>
                <c:pt idx="1636">
                  <c:v>9.0672012944497699E-2</c:v>
                </c:pt>
                <c:pt idx="1637">
                  <c:v>0.60109956996739156</c:v>
                </c:pt>
                <c:pt idx="1638">
                  <c:v>0.73358464057729811</c:v>
                </c:pt>
                <c:pt idx="1639">
                  <c:v>1.0814180440741283</c:v>
                </c:pt>
                <c:pt idx="1640">
                  <c:v>1.4431477760297172E-2</c:v>
                </c:pt>
                <c:pt idx="1641">
                  <c:v>1.1866606575518335</c:v>
                </c:pt>
                <c:pt idx="1642">
                  <c:v>8.1773455946788046E-2</c:v>
                </c:pt>
                <c:pt idx="1643">
                  <c:v>1.1245101654461125</c:v>
                </c:pt>
                <c:pt idx="1644">
                  <c:v>0.70369265466824804</c:v>
                </c:pt>
                <c:pt idx="1645">
                  <c:v>1.2624447990321663</c:v>
                </c:pt>
                <c:pt idx="1646">
                  <c:v>0.11886640376826366</c:v>
                </c:pt>
                <c:pt idx="1647">
                  <c:v>0.99361021879013811</c:v>
                </c:pt>
                <c:pt idx="1648">
                  <c:v>0.85078790555476891</c:v>
                </c:pt>
                <c:pt idx="1649">
                  <c:v>0.90512052576705959</c:v>
                </c:pt>
                <c:pt idx="1650">
                  <c:v>0.6977588308769348</c:v>
                </c:pt>
                <c:pt idx="1651">
                  <c:v>0.3290034518412337</c:v>
                </c:pt>
                <c:pt idx="1652">
                  <c:v>0.11715281741971593</c:v>
                </c:pt>
                <c:pt idx="1653">
                  <c:v>0.49439569618983781</c:v>
                </c:pt>
                <c:pt idx="1654">
                  <c:v>0.19272484409891016</c:v>
                </c:pt>
                <c:pt idx="1655">
                  <c:v>0.20685447598851936</c:v>
                </c:pt>
                <c:pt idx="1656">
                  <c:v>0.27523545363944363</c:v>
                </c:pt>
                <c:pt idx="1657">
                  <c:v>0.90116212772006266</c:v>
                </c:pt>
                <c:pt idx="1658">
                  <c:v>5.8812211691924673E-2</c:v>
                </c:pt>
                <c:pt idx="1659">
                  <c:v>0.18811525759557921</c:v>
                </c:pt>
                <c:pt idx="1660">
                  <c:v>0.40332131546087141</c:v>
                </c:pt>
                <c:pt idx="1661">
                  <c:v>0.21994581183856288</c:v>
                </c:pt>
                <c:pt idx="1662">
                  <c:v>1.5171775005388348</c:v>
                </c:pt>
                <c:pt idx="1663">
                  <c:v>5.2540581773170718E-2</c:v>
                </c:pt>
                <c:pt idx="1664">
                  <c:v>0.34400632204077436</c:v>
                </c:pt>
                <c:pt idx="1665">
                  <c:v>0.93485002231191394</c:v>
                </c:pt>
                <c:pt idx="1666">
                  <c:v>2.7242911564045378E-2</c:v>
                </c:pt>
                <c:pt idx="1667">
                  <c:v>0.57988041088382414</c:v>
                </c:pt>
                <c:pt idx="1668">
                  <c:v>0.36710880129354112</c:v>
                </c:pt>
                <c:pt idx="1669">
                  <c:v>0.16965924538426447</c:v>
                </c:pt>
                <c:pt idx="1670">
                  <c:v>1.2093459542056137</c:v>
                </c:pt>
                <c:pt idx="1671">
                  <c:v>0.66506401127162829</c:v>
                </c:pt>
                <c:pt idx="1672">
                  <c:v>1.6786033949226342</c:v>
                </c:pt>
                <c:pt idx="1673">
                  <c:v>1.671914148151926</c:v>
                </c:pt>
                <c:pt idx="1674">
                  <c:v>0.47821677332348406</c:v>
                </c:pt>
                <c:pt idx="1675">
                  <c:v>0.1997906934782423</c:v>
                </c:pt>
                <c:pt idx="1676">
                  <c:v>4.7326968582777032E-2</c:v>
                </c:pt>
                <c:pt idx="1677">
                  <c:v>1.0587335721098248</c:v>
                </c:pt>
                <c:pt idx="1678">
                  <c:v>2.5031195437315169E-2</c:v>
                </c:pt>
                <c:pt idx="1679">
                  <c:v>0.10841897381326983</c:v>
                </c:pt>
                <c:pt idx="1680">
                  <c:v>0.39183507688706237</c:v>
                </c:pt>
                <c:pt idx="1681">
                  <c:v>0.19200020085368491</c:v>
                </c:pt>
                <c:pt idx="1682">
                  <c:v>0.24397227015954009</c:v>
                </c:pt>
                <c:pt idx="1683">
                  <c:v>1.002648335884663</c:v>
                </c:pt>
                <c:pt idx="1684">
                  <c:v>0.26395162308909487</c:v>
                </c:pt>
                <c:pt idx="1685">
                  <c:v>0.54562299421399807</c:v>
                </c:pt>
                <c:pt idx="1686">
                  <c:v>1.0044611361982168</c:v>
                </c:pt>
                <c:pt idx="1687">
                  <c:v>0.81214298038955968</c:v>
                </c:pt>
                <c:pt idx="1688">
                  <c:v>0.23045153155219411</c:v>
                </c:pt>
                <c:pt idx="1689">
                  <c:v>0.69865643623683693</c:v>
                </c:pt>
                <c:pt idx="1690">
                  <c:v>0.80377207379838933</c:v>
                </c:pt>
                <c:pt idx="1691">
                  <c:v>0.40742563485608901</c:v>
                </c:pt>
                <c:pt idx="1692">
                  <c:v>0.528940078952994</c:v>
                </c:pt>
                <c:pt idx="1693">
                  <c:v>0.72881407837475864</c:v>
                </c:pt>
                <c:pt idx="1694">
                  <c:v>8.4195413301187932E-2</c:v>
                </c:pt>
                <c:pt idx="1695">
                  <c:v>0.90927305144939174</c:v>
                </c:pt>
                <c:pt idx="1696">
                  <c:v>0.27071893986110129</c:v>
                </c:pt>
                <c:pt idx="1697">
                  <c:v>0.36477530490135929</c:v>
                </c:pt>
                <c:pt idx="1698">
                  <c:v>0.62673231626317516</c:v>
                </c:pt>
                <c:pt idx="1699">
                  <c:v>1.0635657992564338</c:v>
                </c:pt>
                <c:pt idx="1700">
                  <c:v>0.15152607446287886</c:v>
                </c:pt>
                <c:pt idx="1701">
                  <c:v>9.1333957912834857E-3</c:v>
                </c:pt>
                <c:pt idx="1702">
                  <c:v>4.3342012026544322E-2</c:v>
                </c:pt>
                <c:pt idx="1703">
                  <c:v>0.23710607704698794</c:v>
                </c:pt>
                <c:pt idx="1704">
                  <c:v>0.82622703098879746</c:v>
                </c:pt>
                <c:pt idx="1705">
                  <c:v>0.19386464525551642</c:v>
                </c:pt>
                <c:pt idx="1706">
                  <c:v>0.17055286073656603</c:v>
                </c:pt>
                <c:pt idx="1707">
                  <c:v>0.10987910353143615</c:v>
                </c:pt>
                <c:pt idx="1708">
                  <c:v>0.33042545813459862</c:v>
                </c:pt>
                <c:pt idx="1709">
                  <c:v>0.42824528535907819</c:v>
                </c:pt>
                <c:pt idx="1710">
                  <c:v>9.2388717646167171E-2</c:v>
                </c:pt>
                <c:pt idx="1711">
                  <c:v>0.25492653976569341</c:v>
                </c:pt>
                <c:pt idx="1712">
                  <c:v>6.7657880294618817E-3</c:v>
                </c:pt>
                <c:pt idx="1713">
                  <c:v>0.33796631232600532</c:v>
                </c:pt>
                <c:pt idx="1714">
                  <c:v>4.2114766321821151E-2</c:v>
                </c:pt>
                <c:pt idx="1715">
                  <c:v>0.50688524167555304</c:v>
                </c:pt>
                <c:pt idx="1716">
                  <c:v>1.0552898000598199</c:v>
                </c:pt>
                <c:pt idx="1717">
                  <c:v>0.35400586383845539</c:v>
                </c:pt>
                <c:pt idx="1718">
                  <c:v>0.51097135308114727</c:v>
                </c:pt>
                <c:pt idx="1719">
                  <c:v>0.86821085878693371</c:v>
                </c:pt>
                <c:pt idx="1720">
                  <c:v>0.39629114987513014</c:v>
                </c:pt>
                <c:pt idx="1721">
                  <c:v>0.31899439026777088</c:v>
                </c:pt>
                <c:pt idx="1722">
                  <c:v>0.39806529072602082</c:v>
                </c:pt>
                <c:pt idx="1723">
                  <c:v>0.20965852040979197</c:v>
                </c:pt>
                <c:pt idx="1724">
                  <c:v>0.20836399719933948</c:v>
                </c:pt>
                <c:pt idx="1725">
                  <c:v>1.1911506985324587</c:v>
                </c:pt>
                <c:pt idx="1726">
                  <c:v>0.47577741108270538</c:v>
                </c:pt>
                <c:pt idx="1727">
                  <c:v>0.42824706468652224</c:v>
                </c:pt>
                <c:pt idx="1728">
                  <c:v>5.2925323734444009E-2</c:v>
                </c:pt>
                <c:pt idx="1729">
                  <c:v>1.113701877773474</c:v>
                </c:pt>
                <c:pt idx="1730">
                  <c:v>0.34882857913429333</c:v>
                </c:pt>
                <c:pt idx="1731">
                  <c:v>1.2539737427329061</c:v>
                </c:pt>
                <c:pt idx="1732">
                  <c:v>0.15848048486003166</c:v>
                </c:pt>
                <c:pt idx="1733">
                  <c:v>0.12223640897509463</c:v>
                </c:pt>
                <c:pt idx="1734">
                  <c:v>0.98713610841647981</c:v>
                </c:pt>
                <c:pt idx="1735">
                  <c:v>0.53329040428940633</c:v>
                </c:pt>
                <c:pt idx="1736">
                  <c:v>1.1998198870448973</c:v>
                </c:pt>
                <c:pt idx="1737">
                  <c:v>0.26328161137238809</c:v>
                </c:pt>
                <c:pt idx="1738">
                  <c:v>0.41215959818616416</c:v>
                </c:pt>
                <c:pt idx="1739">
                  <c:v>1.1751510379976222</c:v>
                </c:pt>
                <c:pt idx="1740">
                  <c:v>0.4408566328940729</c:v>
                </c:pt>
                <c:pt idx="1741">
                  <c:v>0.18602142375004377</c:v>
                </c:pt>
                <c:pt idx="1742">
                  <c:v>0.75551512343692118</c:v>
                </c:pt>
                <c:pt idx="1743">
                  <c:v>0.17157294756654989</c:v>
                </c:pt>
                <c:pt idx="1744">
                  <c:v>0.99899281500502368</c:v>
                </c:pt>
                <c:pt idx="1745">
                  <c:v>0.19098448344136362</c:v>
                </c:pt>
                <c:pt idx="1746">
                  <c:v>0.22818181103395668</c:v>
                </c:pt>
                <c:pt idx="1747">
                  <c:v>0.99137883554580419</c:v>
                </c:pt>
                <c:pt idx="1748">
                  <c:v>0.19380924739974509</c:v>
                </c:pt>
                <c:pt idx="1749">
                  <c:v>1.229728391324338</c:v>
                </c:pt>
                <c:pt idx="1750">
                  <c:v>1.1498139017371556</c:v>
                </c:pt>
                <c:pt idx="1751">
                  <c:v>5.8764445448264577E-2</c:v>
                </c:pt>
                <c:pt idx="1752">
                  <c:v>0.61228539740013488</c:v>
                </c:pt>
                <c:pt idx="1753">
                  <c:v>0.75513216331007815</c:v>
                </c:pt>
                <c:pt idx="1754">
                  <c:v>0.76643361563581658</c:v>
                </c:pt>
                <c:pt idx="1755">
                  <c:v>1.4854751633849956</c:v>
                </c:pt>
                <c:pt idx="1756">
                  <c:v>0.36405556887412893</c:v>
                </c:pt>
                <c:pt idx="1757">
                  <c:v>0.60348180128441231</c:v>
                </c:pt>
                <c:pt idx="1758">
                  <c:v>0.67074382158767054</c:v>
                </c:pt>
                <c:pt idx="1759">
                  <c:v>0.53982092378566937</c:v>
                </c:pt>
                <c:pt idx="1760">
                  <c:v>0.40228412151660181</c:v>
                </c:pt>
                <c:pt idx="1761">
                  <c:v>0.60031521244128949</c:v>
                </c:pt>
                <c:pt idx="1762">
                  <c:v>1.5890617324597553</c:v>
                </c:pt>
                <c:pt idx="1763">
                  <c:v>9.0235251519305351E-2</c:v>
                </c:pt>
                <c:pt idx="1764">
                  <c:v>1.1972531736466908E-2</c:v>
                </c:pt>
                <c:pt idx="1765">
                  <c:v>0.35590829695388332</c:v>
                </c:pt>
                <c:pt idx="1766">
                  <c:v>0.5185868582558375</c:v>
                </c:pt>
                <c:pt idx="1767">
                  <c:v>0.48693013517256095</c:v>
                </c:pt>
                <c:pt idx="1768">
                  <c:v>5.772767985428108E-2</c:v>
                </c:pt>
                <c:pt idx="1769">
                  <c:v>0.49813422893459552</c:v>
                </c:pt>
                <c:pt idx="1770">
                  <c:v>0.79966625417091286</c:v>
                </c:pt>
                <c:pt idx="1771">
                  <c:v>0.79948417425443152</c:v>
                </c:pt>
                <c:pt idx="1772">
                  <c:v>8.9687901362043326E-2</c:v>
                </c:pt>
                <c:pt idx="1773">
                  <c:v>0.1205062475912448</c:v>
                </c:pt>
                <c:pt idx="1774">
                  <c:v>0.18110547508697286</c:v>
                </c:pt>
                <c:pt idx="1775">
                  <c:v>1.0979484426667148</c:v>
                </c:pt>
                <c:pt idx="1776">
                  <c:v>0.43455319633857825</c:v>
                </c:pt>
                <c:pt idx="1777">
                  <c:v>0.14860669722785544</c:v>
                </c:pt>
                <c:pt idx="1778">
                  <c:v>2.1612486789586365E-2</c:v>
                </c:pt>
                <c:pt idx="1779">
                  <c:v>1.0901773912393984</c:v>
                </c:pt>
                <c:pt idx="1780">
                  <c:v>0.76074359802714442</c:v>
                </c:pt>
                <c:pt idx="1781">
                  <c:v>0.51022532877774018</c:v>
                </c:pt>
                <c:pt idx="1782">
                  <c:v>0.66975459837965223</c:v>
                </c:pt>
                <c:pt idx="1783">
                  <c:v>4.9979930193018744E-3</c:v>
                </c:pt>
                <c:pt idx="1784">
                  <c:v>0.7834230064734824</c:v>
                </c:pt>
                <c:pt idx="1785">
                  <c:v>0.81451822372389815</c:v>
                </c:pt>
                <c:pt idx="1786">
                  <c:v>4.9410992234446255E-2</c:v>
                </c:pt>
                <c:pt idx="1787">
                  <c:v>0.31493257641952643</c:v>
                </c:pt>
                <c:pt idx="1788">
                  <c:v>0.63931993396318121</c:v>
                </c:pt>
                <c:pt idx="1789">
                  <c:v>0.21553910988716801</c:v>
                </c:pt>
                <c:pt idx="1790">
                  <c:v>1.3052241630429976E-2</c:v>
                </c:pt>
                <c:pt idx="1791">
                  <c:v>1.0257318524488517</c:v>
                </c:pt>
                <c:pt idx="1792">
                  <c:v>0.25094669994528213</c:v>
                </c:pt>
                <c:pt idx="1793">
                  <c:v>0.19595318311962678</c:v>
                </c:pt>
                <c:pt idx="1794">
                  <c:v>3.8023988987890875E-2</c:v>
                </c:pt>
                <c:pt idx="1795">
                  <c:v>0.49745335200716756</c:v>
                </c:pt>
                <c:pt idx="1796">
                  <c:v>0.98924137361620479</c:v>
                </c:pt>
                <c:pt idx="1797">
                  <c:v>6.7964897166790009E-2</c:v>
                </c:pt>
                <c:pt idx="1798">
                  <c:v>0.30012614447894509</c:v>
                </c:pt>
                <c:pt idx="1799">
                  <c:v>0.24179833465404324</c:v>
                </c:pt>
                <c:pt idx="1800">
                  <c:v>0.95286247804454205</c:v>
                </c:pt>
                <c:pt idx="1801">
                  <c:v>0.11699151694945317</c:v>
                </c:pt>
                <c:pt idx="1802">
                  <c:v>0.19604149988381192</c:v>
                </c:pt>
                <c:pt idx="1803">
                  <c:v>0.1468213414296827</c:v>
                </c:pt>
                <c:pt idx="1804">
                  <c:v>0.24436349804912808</c:v>
                </c:pt>
                <c:pt idx="1805">
                  <c:v>0.25447194763307168</c:v>
                </c:pt>
                <c:pt idx="1806">
                  <c:v>6.1164979398641468E-2</c:v>
                </c:pt>
                <c:pt idx="1807">
                  <c:v>0.88853762433997052</c:v>
                </c:pt>
                <c:pt idx="1808">
                  <c:v>1.544749532728146</c:v>
                </c:pt>
                <c:pt idx="1809">
                  <c:v>4.3416307818783167E-2</c:v>
                </c:pt>
                <c:pt idx="1810">
                  <c:v>0.2917776524112291</c:v>
                </c:pt>
                <c:pt idx="1811">
                  <c:v>1.0741889454610216</c:v>
                </c:pt>
                <c:pt idx="1812">
                  <c:v>1.0494241593238889</c:v>
                </c:pt>
                <c:pt idx="1813">
                  <c:v>0.70164065592802016</c:v>
                </c:pt>
                <c:pt idx="1814">
                  <c:v>2.2967123968683362E-3</c:v>
                </c:pt>
                <c:pt idx="1815">
                  <c:v>0.85894639602234502</c:v>
                </c:pt>
                <c:pt idx="1816">
                  <c:v>0.64212793814460045</c:v>
                </c:pt>
                <c:pt idx="1817">
                  <c:v>0.68607628031261825</c:v>
                </c:pt>
                <c:pt idx="1818">
                  <c:v>0.11922637762913921</c:v>
                </c:pt>
                <c:pt idx="1819">
                  <c:v>0.51367896804397273</c:v>
                </c:pt>
                <c:pt idx="1820">
                  <c:v>0.68838375318774592</c:v>
                </c:pt>
                <c:pt idx="1821">
                  <c:v>0.54876429715678732</c:v>
                </c:pt>
                <c:pt idx="1822">
                  <c:v>0.55330425588089738</c:v>
                </c:pt>
                <c:pt idx="1823">
                  <c:v>0.62565343152991537</c:v>
                </c:pt>
                <c:pt idx="1824">
                  <c:v>0.5475442818655879</c:v>
                </c:pt>
                <c:pt idx="1825">
                  <c:v>8.6494310415875977E-2</c:v>
                </c:pt>
                <c:pt idx="1826">
                  <c:v>0.75961430453786261</c:v>
                </c:pt>
                <c:pt idx="1827">
                  <c:v>0.48949970674595039</c:v>
                </c:pt>
                <c:pt idx="1828">
                  <c:v>0.19720990159730736</c:v>
                </c:pt>
                <c:pt idx="1829">
                  <c:v>0.91199025987520599</c:v>
                </c:pt>
                <c:pt idx="1830">
                  <c:v>0.16597930396473795</c:v>
                </c:pt>
                <c:pt idx="1831">
                  <c:v>0.44724516292785249</c:v>
                </c:pt>
                <c:pt idx="1832">
                  <c:v>0.23443778157964973</c:v>
                </c:pt>
                <c:pt idx="1833">
                  <c:v>0.26117230832680693</c:v>
                </c:pt>
                <c:pt idx="1834">
                  <c:v>1.5066628981506431</c:v>
                </c:pt>
                <c:pt idx="1835">
                  <c:v>1.1530247691230249</c:v>
                </c:pt>
                <c:pt idx="1836">
                  <c:v>0.76822454102149595</c:v>
                </c:pt>
                <c:pt idx="1837">
                  <c:v>0.73109776516104574</c:v>
                </c:pt>
                <c:pt idx="1838">
                  <c:v>0.29391570472480849</c:v>
                </c:pt>
                <c:pt idx="1839">
                  <c:v>0.836822322470821</c:v>
                </c:pt>
                <c:pt idx="1840">
                  <c:v>0.46592908603119731</c:v>
                </c:pt>
                <c:pt idx="1841">
                  <c:v>4.6487844107257668E-2</c:v>
                </c:pt>
                <c:pt idx="1842">
                  <c:v>0.87454472658488391</c:v>
                </c:pt>
                <c:pt idx="1843">
                  <c:v>1.5899286624920884E-2</c:v>
                </c:pt>
                <c:pt idx="1844">
                  <c:v>0.11403366467912235</c:v>
                </c:pt>
                <c:pt idx="1845">
                  <c:v>0.90369155514036381</c:v>
                </c:pt>
                <c:pt idx="1846">
                  <c:v>1.9081359911236783E-2</c:v>
                </c:pt>
                <c:pt idx="1847">
                  <c:v>0.12185356485332773</c:v>
                </c:pt>
                <c:pt idx="1848">
                  <c:v>0.57086142579249166</c:v>
                </c:pt>
                <c:pt idx="1849">
                  <c:v>0.71972598181590708</c:v>
                </c:pt>
                <c:pt idx="1850">
                  <c:v>0.23038804901488477</c:v>
                </c:pt>
                <c:pt idx="1851">
                  <c:v>0.20260675611658704</c:v>
                </c:pt>
                <c:pt idx="1852">
                  <c:v>2.4197414464207305E-2</c:v>
                </c:pt>
                <c:pt idx="1853">
                  <c:v>2.9560514615161317E-2</c:v>
                </c:pt>
                <c:pt idx="1854">
                  <c:v>0.21306762095712473</c:v>
                </c:pt>
                <c:pt idx="1855">
                  <c:v>1.0108357870515194</c:v>
                </c:pt>
                <c:pt idx="1856">
                  <c:v>0.28168798088484209</c:v>
                </c:pt>
                <c:pt idx="1857">
                  <c:v>1.2850742524921097</c:v>
                </c:pt>
                <c:pt idx="1858">
                  <c:v>0.24146447807756516</c:v>
                </c:pt>
                <c:pt idx="1859">
                  <c:v>0.46231510801348336</c:v>
                </c:pt>
                <c:pt idx="1860">
                  <c:v>0.16706685168251748</c:v>
                </c:pt>
                <c:pt idx="1861">
                  <c:v>0.35157570014913248</c:v>
                </c:pt>
                <c:pt idx="1862">
                  <c:v>0.27691327915669411</c:v>
                </c:pt>
                <c:pt idx="1863">
                  <c:v>0.14487831441578403</c:v>
                </c:pt>
                <c:pt idx="1864">
                  <c:v>0.12509094214411079</c:v>
                </c:pt>
                <c:pt idx="1865">
                  <c:v>0.45889566527688697</c:v>
                </c:pt>
                <c:pt idx="1866">
                  <c:v>0.31112162047254849</c:v>
                </c:pt>
                <c:pt idx="1867">
                  <c:v>0.27717142715094739</c:v>
                </c:pt>
                <c:pt idx="1868">
                  <c:v>0.45967439540413468</c:v>
                </c:pt>
                <c:pt idx="1869">
                  <c:v>8.182289502536505E-2</c:v>
                </c:pt>
                <c:pt idx="1870">
                  <c:v>5.9140787644543634E-2</c:v>
                </c:pt>
                <c:pt idx="1871">
                  <c:v>0.11485107398956196</c:v>
                </c:pt>
                <c:pt idx="1872">
                  <c:v>0.38963983943064084</c:v>
                </c:pt>
                <c:pt idx="1873">
                  <c:v>0.16777323723941745</c:v>
                </c:pt>
                <c:pt idx="1874">
                  <c:v>0.41862146777292231</c:v>
                </c:pt>
                <c:pt idx="1875">
                  <c:v>0.40964011154626606</c:v>
                </c:pt>
                <c:pt idx="1876">
                  <c:v>5.5260009493439934E-2</c:v>
                </c:pt>
                <c:pt idx="1877">
                  <c:v>2.2287837255020315E-3</c:v>
                </c:pt>
                <c:pt idx="1878">
                  <c:v>1.1302173419339441</c:v>
                </c:pt>
                <c:pt idx="1879">
                  <c:v>0.32773266916925803</c:v>
                </c:pt>
                <c:pt idx="1880">
                  <c:v>0.6164181176423974</c:v>
                </c:pt>
                <c:pt idx="1881">
                  <c:v>0.29312029887464286</c:v>
                </c:pt>
                <c:pt idx="1882">
                  <c:v>0.33943357849408112</c:v>
                </c:pt>
                <c:pt idx="1883">
                  <c:v>0.49833568846970527</c:v>
                </c:pt>
                <c:pt idx="1884">
                  <c:v>0.84953654382388111</c:v>
                </c:pt>
                <c:pt idx="1885">
                  <c:v>0.35163668931683345</c:v>
                </c:pt>
                <c:pt idx="1886">
                  <c:v>0.64133629902151335</c:v>
                </c:pt>
                <c:pt idx="1887">
                  <c:v>0.51096244069560515</c:v>
                </c:pt>
                <c:pt idx="1888">
                  <c:v>0.54668809272737562</c:v>
                </c:pt>
                <c:pt idx="1889">
                  <c:v>0.20405490640943075</c:v>
                </c:pt>
                <c:pt idx="1890">
                  <c:v>0.90745432002670567</c:v>
                </c:pt>
                <c:pt idx="1891">
                  <c:v>0.41490571543486771</c:v>
                </c:pt>
                <c:pt idx="1892">
                  <c:v>0.6251992907117605</c:v>
                </c:pt>
                <c:pt idx="1893">
                  <c:v>1.0016578917203227</c:v>
                </c:pt>
                <c:pt idx="1894">
                  <c:v>1.9860940592328666</c:v>
                </c:pt>
                <c:pt idx="1895">
                  <c:v>0.11333432497433982</c:v>
                </c:pt>
                <c:pt idx="1896">
                  <c:v>0.31783062076905916</c:v>
                </c:pt>
                <c:pt idx="1897">
                  <c:v>0.72674189489159535</c:v>
                </c:pt>
                <c:pt idx="1898">
                  <c:v>0.38887785839265127</c:v>
                </c:pt>
                <c:pt idx="1899">
                  <c:v>0.27216402641144571</c:v>
                </c:pt>
                <c:pt idx="1900">
                  <c:v>0.27290786819098295</c:v>
                </c:pt>
                <c:pt idx="1901">
                  <c:v>0.68752181932783119</c:v>
                </c:pt>
                <c:pt idx="1902">
                  <c:v>0.8297478710040106</c:v>
                </c:pt>
                <c:pt idx="1903">
                  <c:v>0.11530080138317346</c:v>
                </c:pt>
                <c:pt idx="1904">
                  <c:v>0.11996852484591625</c:v>
                </c:pt>
                <c:pt idx="1905">
                  <c:v>0.38180814069848779</c:v>
                </c:pt>
                <c:pt idx="1906">
                  <c:v>0.27730314911709553</c:v>
                </c:pt>
                <c:pt idx="1907">
                  <c:v>0.468538118130847</c:v>
                </c:pt>
                <c:pt idx="1908">
                  <c:v>0.82523272676519688</c:v>
                </c:pt>
                <c:pt idx="1909">
                  <c:v>0.53831492036680884</c:v>
                </c:pt>
                <c:pt idx="1910">
                  <c:v>0.29590902256418811</c:v>
                </c:pt>
                <c:pt idx="1911">
                  <c:v>0.38440071808040677</c:v>
                </c:pt>
                <c:pt idx="1912">
                  <c:v>7.8062466648066944E-2</c:v>
                </c:pt>
                <c:pt idx="1913">
                  <c:v>0.14223372514594698</c:v>
                </c:pt>
                <c:pt idx="1914">
                  <c:v>0.28541528697845003</c:v>
                </c:pt>
                <c:pt idx="1915">
                  <c:v>1.0138718077966855</c:v>
                </c:pt>
                <c:pt idx="1916">
                  <c:v>0.85753824640890541</c:v>
                </c:pt>
                <c:pt idx="1917">
                  <c:v>0.10333576333063417</c:v>
                </c:pt>
                <c:pt idx="1918">
                  <c:v>0.58744898950242941</c:v>
                </c:pt>
                <c:pt idx="1919">
                  <c:v>0.51331450152307467</c:v>
                </c:pt>
                <c:pt idx="1920">
                  <c:v>0.19599663314586685</c:v>
                </c:pt>
                <c:pt idx="1921">
                  <c:v>1.1832698752621702</c:v>
                </c:pt>
                <c:pt idx="1922">
                  <c:v>0.83494759472676816</c:v>
                </c:pt>
                <c:pt idx="1923">
                  <c:v>0.40376433626708808</c:v>
                </c:pt>
                <c:pt idx="1924">
                  <c:v>0.16138958976672302</c:v>
                </c:pt>
                <c:pt idx="1925">
                  <c:v>9.3856022259169752E-2</c:v>
                </c:pt>
                <c:pt idx="1926">
                  <c:v>2.2073531317599081E-3</c:v>
                </c:pt>
                <c:pt idx="1927">
                  <c:v>0.72201088962396376</c:v>
                </c:pt>
                <c:pt idx="1928">
                  <c:v>0.84716978811215926</c:v>
                </c:pt>
                <c:pt idx="1929">
                  <c:v>0.39610944159748956</c:v>
                </c:pt>
                <c:pt idx="1930">
                  <c:v>0.56947588976932451</c:v>
                </c:pt>
                <c:pt idx="1931">
                  <c:v>0.54152161712297253</c:v>
                </c:pt>
                <c:pt idx="1932">
                  <c:v>0.69013515721830498</c:v>
                </c:pt>
                <c:pt idx="1933">
                  <c:v>0.24063346261321256</c:v>
                </c:pt>
                <c:pt idx="1934">
                  <c:v>0.31873950841654897</c:v>
                </c:pt>
                <c:pt idx="1935">
                  <c:v>2.341560438726897E-2</c:v>
                </c:pt>
                <c:pt idx="1936">
                  <c:v>0.50421368558975954</c:v>
                </c:pt>
                <c:pt idx="1937">
                  <c:v>0.31678288381971315</c:v>
                </c:pt>
                <c:pt idx="1938">
                  <c:v>0.50443579428423624</c:v>
                </c:pt>
                <c:pt idx="1939">
                  <c:v>0.60068660705563104</c:v>
                </c:pt>
                <c:pt idx="1940">
                  <c:v>0.46030923514556338</c:v>
                </c:pt>
                <c:pt idx="1941">
                  <c:v>0.37921502549180053</c:v>
                </c:pt>
                <c:pt idx="1942">
                  <c:v>2.7198231273819409</c:v>
                </c:pt>
                <c:pt idx="1943">
                  <c:v>0.32910378097001886</c:v>
                </c:pt>
                <c:pt idx="1944">
                  <c:v>0.55568904789602591</c:v>
                </c:pt>
                <c:pt idx="1945">
                  <c:v>1.0638156926194176</c:v>
                </c:pt>
                <c:pt idx="1946">
                  <c:v>0.61969594965293284</c:v>
                </c:pt>
                <c:pt idx="1947">
                  <c:v>2.9971449731416949E-2</c:v>
                </c:pt>
                <c:pt idx="1948">
                  <c:v>1.2837781781867801</c:v>
                </c:pt>
                <c:pt idx="1949">
                  <c:v>9.0806508242477615E-2</c:v>
                </c:pt>
                <c:pt idx="1950">
                  <c:v>0.15921829278373062</c:v>
                </c:pt>
                <c:pt idx="1951">
                  <c:v>0.96386675059857874</c:v>
                </c:pt>
                <c:pt idx="1952">
                  <c:v>0.15862310655128947</c:v>
                </c:pt>
                <c:pt idx="1953">
                  <c:v>7.321497248230413E-2</c:v>
                </c:pt>
                <c:pt idx="1954">
                  <c:v>1.4168910258493173</c:v>
                </c:pt>
                <c:pt idx="1955">
                  <c:v>0.56175779320136376</c:v>
                </c:pt>
                <c:pt idx="1956">
                  <c:v>1.2551802051007553E-2</c:v>
                </c:pt>
                <c:pt idx="1957">
                  <c:v>0.61412004110642071</c:v>
                </c:pt>
                <c:pt idx="1958">
                  <c:v>0.29177506445451351</c:v>
                </c:pt>
                <c:pt idx="1959">
                  <c:v>0.85375526828547432</c:v>
                </c:pt>
                <c:pt idx="1960">
                  <c:v>0.31640985440915653</c:v>
                </c:pt>
                <c:pt idx="1961">
                  <c:v>1.0231997727608622E-2</c:v>
                </c:pt>
                <c:pt idx="1962">
                  <c:v>0.11951482190515875</c:v>
                </c:pt>
                <c:pt idx="1963">
                  <c:v>0.20578016627348561</c:v>
                </c:pt>
                <c:pt idx="1964">
                  <c:v>0.64318591348210041</c:v>
                </c:pt>
                <c:pt idx="1965">
                  <c:v>0.13375471914657736</c:v>
                </c:pt>
                <c:pt idx="1966">
                  <c:v>0.56496510415010714</c:v>
                </c:pt>
                <c:pt idx="1967">
                  <c:v>1.1637890381886493</c:v>
                </c:pt>
                <c:pt idx="1968">
                  <c:v>1.0523894752822949</c:v>
                </c:pt>
                <c:pt idx="1969">
                  <c:v>0.29060015372365838</c:v>
                </c:pt>
                <c:pt idx="1970">
                  <c:v>0.28027342741310002</c:v>
                </c:pt>
                <c:pt idx="1971">
                  <c:v>0.11865173781374158</c:v>
                </c:pt>
                <c:pt idx="1972">
                  <c:v>0.21713759545112646</c:v>
                </c:pt>
                <c:pt idx="1973">
                  <c:v>0.15250366282597913</c:v>
                </c:pt>
                <c:pt idx="1974">
                  <c:v>1.2528972523773472E-2</c:v>
                </c:pt>
                <c:pt idx="1975">
                  <c:v>0.49047315811744729</c:v>
                </c:pt>
                <c:pt idx="1976">
                  <c:v>0.86294563949048697</c:v>
                </c:pt>
                <c:pt idx="1977">
                  <c:v>0.31842783488896304</c:v>
                </c:pt>
                <c:pt idx="1978">
                  <c:v>0.39008834830587258</c:v>
                </c:pt>
                <c:pt idx="1979">
                  <c:v>0.78406712868889872</c:v>
                </c:pt>
                <c:pt idx="1980">
                  <c:v>0.31272995278741328</c:v>
                </c:pt>
                <c:pt idx="1981">
                  <c:v>9.5376298009926835E-2</c:v>
                </c:pt>
                <c:pt idx="1982">
                  <c:v>0.10389943194088892</c:v>
                </c:pt>
                <c:pt idx="1983">
                  <c:v>4.5195790220571071E-3</c:v>
                </c:pt>
                <c:pt idx="1984">
                  <c:v>0.29104499923271998</c:v>
                </c:pt>
                <c:pt idx="1985">
                  <c:v>5.4445325523734579E-2</c:v>
                </c:pt>
                <c:pt idx="1986">
                  <c:v>1.9738865034461082</c:v>
                </c:pt>
                <c:pt idx="1987">
                  <c:v>0.49020564737887912</c:v>
                </c:pt>
                <c:pt idx="1988">
                  <c:v>3.6379647437834658E-2</c:v>
                </c:pt>
                <c:pt idx="1989">
                  <c:v>6.882689890791562E-3</c:v>
                </c:pt>
                <c:pt idx="1990">
                  <c:v>5.9417475724140526E-3</c:v>
                </c:pt>
                <c:pt idx="1991">
                  <c:v>0.70088532894254507</c:v>
                </c:pt>
                <c:pt idx="1992">
                  <c:v>8.6078365559618591E-2</c:v>
                </c:pt>
                <c:pt idx="1993">
                  <c:v>0.18720626704003451</c:v>
                </c:pt>
                <c:pt idx="1994">
                  <c:v>0.29574381513988235</c:v>
                </c:pt>
                <c:pt idx="1995">
                  <c:v>4.8476403873931255E-2</c:v>
                </c:pt>
                <c:pt idx="1996">
                  <c:v>0.15106332275466294</c:v>
                </c:pt>
                <c:pt idx="1997">
                  <c:v>1.1472396052128746</c:v>
                </c:pt>
                <c:pt idx="1998">
                  <c:v>2.4637889658456542E-2</c:v>
                </c:pt>
                <c:pt idx="1999">
                  <c:v>0.21523193948855177</c:v>
                </c:pt>
                <c:pt idx="2000">
                  <c:v>1.0505218321659742</c:v>
                </c:pt>
                <c:pt idx="2001">
                  <c:v>0.12011492226794045</c:v>
                </c:pt>
                <c:pt idx="2002">
                  <c:v>1.2376555138978502</c:v>
                </c:pt>
                <c:pt idx="2003">
                  <c:v>0.52624505066186933</c:v>
                </c:pt>
                <c:pt idx="2004">
                  <c:v>0.23912868871620277</c:v>
                </c:pt>
                <c:pt idx="2005">
                  <c:v>0.36439629651672484</c:v>
                </c:pt>
                <c:pt idx="2006">
                  <c:v>0.46072682216370903</c:v>
                </c:pt>
                <c:pt idx="2007">
                  <c:v>0.34708118280709249</c:v>
                </c:pt>
                <c:pt idx="2008">
                  <c:v>0.22746882261475532</c:v>
                </c:pt>
                <c:pt idx="2009">
                  <c:v>0.70441884855750259</c:v>
                </c:pt>
                <c:pt idx="2010">
                  <c:v>0.12317840156096183</c:v>
                </c:pt>
                <c:pt idx="2011">
                  <c:v>0.41856542895544319</c:v>
                </c:pt>
                <c:pt idx="2012">
                  <c:v>0.19971332610489789</c:v>
                </c:pt>
                <c:pt idx="2013">
                  <c:v>6.0379865417975229E-2</c:v>
                </c:pt>
                <c:pt idx="2014">
                  <c:v>1.2877431171546239</c:v>
                </c:pt>
                <c:pt idx="2015">
                  <c:v>0.32800399680715181</c:v>
                </c:pt>
                <c:pt idx="2016">
                  <c:v>0.87026347490114953</c:v>
                </c:pt>
                <c:pt idx="2017">
                  <c:v>0.20625833165831822</c:v>
                </c:pt>
                <c:pt idx="2018">
                  <c:v>0.15484920537592226</c:v>
                </c:pt>
                <c:pt idx="2019">
                  <c:v>1.782470518948101E-2</c:v>
                </c:pt>
                <c:pt idx="2020">
                  <c:v>5.6073638088891776E-3</c:v>
                </c:pt>
                <c:pt idx="2021">
                  <c:v>0.44613899915992655</c:v>
                </c:pt>
                <c:pt idx="2022">
                  <c:v>0.34350307711730593</c:v>
                </c:pt>
                <c:pt idx="2023">
                  <c:v>0.42148032621549991</c:v>
                </c:pt>
                <c:pt idx="2024">
                  <c:v>0.34805511699653502</c:v>
                </c:pt>
                <c:pt idx="2025">
                  <c:v>0.12119577481450602</c:v>
                </c:pt>
                <c:pt idx="2026">
                  <c:v>1.0890219031446096</c:v>
                </c:pt>
                <c:pt idx="2027">
                  <c:v>0.14545797029083207</c:v>
                </c:pt>
                <c:pt idx="2028">
                  <c:v>0.42730431181960266</c:v>
                </c:pt>
                <c:pt idx="2029">
                  <c:v>1.9223009410068406</c:v>
                </c:pt>
                <c:pt idx="2030">
                  <c:v>0.3394103145714184</c:v>
                </c:pt>
                <c:pt idx="2031">
                  <c:v>0.13688665307579162</c:v>
                </c:pt>
                <c:pt idx="2032">
                  <c:v>0.13586577356559576</c:v>
                </c:pt>
                <c:pt idx="2033">
                  <c:v>0.59752832697518332</c:v>
                </c:pt>
                <c:pt idx="2034">
                  <c:v>4.1886298768274779E-3</c:v>
                </c:pt>
                <c:pt idx="2035">
                  <c:v>1.2923066010399937</c:v>
                </c:pt>
                <c:pt idx="2036">
                  <c:v>0.35967472718737387</c:v>
                </c:pt>
                <c:pt idx="2037">
                  <c:v>0.20196389844739074</c:v>
                </c:pt>
                <c:pt idx="2038">
                  <c:v>0.80998729510810807</c:v>
                </c:pt>
                <c:pt idx="2039">
                  <c:v>9.5066442266854706E-2</c:v>
                </c:pt>
                <c:pt idx="2040">
                  <c:v>0.99154209360258849</c:v>
                </c:pt>
                <c:pt idx="2041">
                  <c:v>0.96443001928974137</c:v>
                </c:pt>
                <c:pt idx="2042">
                  <c:v>3.9100347279498293E-2</c:v>
                </c:pt>
                <c:pt idx="2043">
                  <c:v>0.50689021524046174</c:v>
                </c:pt>
                <c:pt idx="2044">
                  <c:v>1.2189324934810353</c:v>
                </c:pt>
                <c:pt idx="2045">
                  <c:v>0.27162176945517369</c:v>
                </c:pt>
                <c:pt idx="2046">
                  <c:v>9.8809078740821704E-2</c:v>
                </c:pt>
                <c:pt idx="2047">
                  <c:v>1.9012987845143106</c:v>
                </c:pt>
                <c:pt idx="2048">
                  <c:v>0.6969757514113033</c:v>
                </c:pt>
                <c:pt idx="2049">
                  <c:v>0.25605229263858531</c:v>
                </c:pt>
                <c:pt idx="2050">
                  <c:v>1.4816382325456257</c:v>
                </c:pt>
                <c:pt idx="2051">
                  <c:v>0.14865480952258373</c:v>
                </c:pt>
                <c:pt idx="2052">
                  <c:v>0.69526497181312308</c:v>
                </c:pt>
                <c:pt idx="2053">
                  <c:v>0.45488332729882569</c:v>
                </c:pt>
                <c:pt idx="2054">
                  <c:v>0.19416986290422883</c:v>
                </c:pt>
                <c:pt idx="2055">
                  <c:v>0.30195205407098197</c:v>
                </c:pt>
                <c:pt idx="2056">
                  <c:v>0.48806703266459706</c:v>
                </c:pt>
                <c:pt idx="2057">
                  <c:v>7.8794382279808825E-2</c:v>
                </c:pt>
                <c:pt idx="2058">
                  <c:v>0.10723732389710397</c:v>
                </c:pt>
                <c:pt idx="2059">
                  <c:v>0.15617427462767677</c:v>
                </c:pt>
                <c:pt idx="2060">
                  <c:v>0.69846833720249668</c:v>
                </c:pt>
                <c:pt idx="2061">
                  <c:v>1.0327974424850654</c:v>
                </c:pt>
                <c:pt idx="2062">
                  <c:v>0.20913782776870826</c:v>
                </c:pt>
                <c:pt idx="2063">
                  <c:v>0.44402890898748515</c:v>
                </c:pt>
                <c:pt idx="2064">
                  <c:v>0.18912833983339122</c:v>
                </c:pt>
                <c:pt idx="2065">
                  <c:v>1.4479878821046677</c:v>
                </c:pt>
                <c:pt idx="2066">
                  <c:v>0.16464754993104508</c:v>
                </c:pt>
                <c:pt idx="2067">
                  <c:v>1.6756077208263106E-2</c:v>
                </c:pt>
                <c:pt idx="2068">
                  <c:v>0.6295367645811667</c:v>
                </c:pt>
                <c:pt idx="2069">
                  <c:v>0.27341106419953876</c:v>
                </c:pt>
                <c:pt idx="2070">
                  <c:v>0.90943921880802681</c:v>
                </c:pt>
                <c:pt idx="2071">
                  <c:v>0.10735767495560289</c:v>
                </c:pt>
                <c:pt idx="2072">
                  <c:v>0.87516788901703146</c:v>
                </c:pt>
                <c:pt idx="2073">
                  <c:v>0.14311917146217998</c:v>
                </c:pt>
                <c:pt idx="2074">
                  <c:v>0.59520387022063403</c:v>
                </c:pt>
                <c:pt idx="2075">
                  <c:v>0.3828230663538213</c:v>
                </c:pt>
                <c:pt idx="2076">
                  <c:v>4.3777168206206273E-2</c:v>
                </c:pt>
                <c:pt idx="2077">
                  <c:v>0.14240312661099755</c:v>
                </c:pt>
                <c:pt idx="2078">
                  <c:v>0.62776297947772086</c:v>
                </c:pt>
                <c:pt idx="2079">
                  <c:v>0.72298023040650528</c:v>
                </c:pt>
                <c:pt idx="2080">
                  <c:v>4.7403684550293215E-2</c:v>
                </c:pt>
                <c:pt idx="2081">
                  <c:v>0.32772781614724111</c:v>
                </c:pt>
                <c:pt idx="2082">
                  <c:v>0.16361234839627806</c:v>
                </c:pt>
                <c:pt idx="2083">
                  <c:v>1.165068906492432</c:v>
                </c:pt>
                <c:pt idx="2084">
                  <c:v>5.9150644785017865E-2</c:v>
                </c:pt>
                <c:pt idx="2085">
                  <c:v>0.13028576878559869</c:v>
                </c:pt>
                <c:pt idx="2086">
                  <c:v>3.5251868126069539E-4</c:v>
                </c:pt>
                <c:pt idx="2087">
                  <c:v>0.21164588730110781</c:v>
                </c:pt>
                <c:pt idx="2088">
                  <c:v>0.72212288979972117</c:v>
                </c:pt>
                <c:pt idx="2089">
                  <c:v>0.83714111146606407</c:v>
                </c:pt>
                <c:pt idx="2090">
                  <c:v>0.17316960827150485</c:v>
                </c:pt>
                <c:pt idx="2091">
                  <c:v>1.1083602745504111</c:v>
                </c:pt>
                <c:pt idx="2092">
                  <c:v>0.34760208329919667</c:v>
                </c:pt>
                <c:pt idx="2093">
                  <c:v>0.68909887510787193</c:v>
                </c:pt>
                <c:pt idx="2094">
                  <c:v>2.1279697905334186E-2</c:v>
                </c:pt>
                <c:pt idx="2095">
                  <c:v>0.39596830576585085</c:v>
                </c:pt>
                <c:pt idx="2096">
                  <c:v>0.19871809888663339</c:v>
                </c:pt>
                <c:pt idx="2097">
                  <c:v>0.13751843159204383</c:v>
                </c:pt>
                <c:pt idx="2098">
                  <c:v>0.14167841636137818</c:v>
                </c:pt>
                <c:pt idx="2099">
                  <c:v>0.21623613890325183</c:v>
                </c:pt>
                <c:pt idx="2100">
                  <c:v>4.2069114575033782E-2</c:v>
                </c:pt>
                <c:pt idx="2101">
                  <c:v>5.6547945919816885E-2</c:v>
                </c:pt>
                <c:pt idx="2102">
                  <c:v>0.47221403360004321</c:v>
                </c:pt>
                <c:pt idx="2103">
                  <c:v>0.97696188999396438</c:v>
                </c:pt>
                <c:pt idx="2104">
                  <c:v>0.14274547534861678</c:v>
                </c:pt>
                <c:pt idx="2105">
                  <c:v>0.61597631648075479</c:v>
                </c:pt>
                <c:pt idx="2106">
                  <c:v>0.17464564755085163</c:v>
                </c:pt>
                <c:pt idx="2107">
                  <c:v>0.60499137921554869</c:v>
                </c:pt>
                <c:pt idx="2108">
                  <c:v>0.5730534407724347</c:v>
                </c:pt>
                <c:pt idx="2109">
                  <c:v>0.99951937228411636</c:v>
                </c:pt>
                <c:pt idx="2110">
                  <c:v>0.29953801753962767</c:v>
                </c:pt>
                <c:pt idx="2111">
                  <c:v>0.20505676120356897</c:v>
                </c:pt>
                <c:pt idx="2112">
                  <c:v>0.87979222022596937</c:v>
                </c:pt>
                <c:pt idx="2113">
                  <c:v>0.6949399426179097</c:v>
                </c:pt>
                <c:pt idx="2114">
                  <c:v>0.65971271371155304</c:v>
                </c:pt>
                <c:pt idx="2115">
                  <c:v>0.22132990181114737</c:v>
                </c:pt>
                <c:pt idx="2116">
                  <c:v>0.71321660197628878</c:v>
                </c:pt>
                <c:pt idx="2117">
                  <c:v>0.72613296281854078</c:v>
                </c:pt>
                <c:pt idx="2118">
                  <c:v>0.93724539998133527</c:v>
                </c:pt>
                <c:pt idx="2119">
                  <c:v>9.4547355274417988E-2</c:v>
                </c:pt>
                <c:pt idx="2120">
                  <c:v>0.50893136873714628</c:v>
                </c:pt>
                <c:pt idx="2121">
                  <c:v>0.20516974405459157</c:v>
                </c:pt>
                <c:pt idx="2122">
                  <c:v>0.31025135430228501</c:v>
                </c:pt>
                <c:pt idx="2123">
                  <c:v>0.24792910812049984</c:v>
                </c:pt>
                <c:pt idx="2124">
                  <c:v>3.4230751540849272E-2</c:v>
                </c:pt>
                <c:pt idx="2125">
                  <c:v>0.71139372259249078</c:v>
                </c:pt>
                <c:pt idx="2126">
                  <c:v>0.22669932477082133</c:v>
                </c:pt>
                <c:pt idx="2127">
                  <c:v>0.3666878667070772</c:v>
                </c:pt>
                <c:pt idx="2128">
                  <c:v>0.32328757934182395</c:v>
                </c:pt>
                <c:pt idx="2129">
                  <c:v>1.1193372100809096</c:v>
                </c:pt>
                <c:pt idx="2130">
                  <c:v>0.46966123987781333</c:v>
                </c:pt>
                <c:pt idx="2131">
                  <c:v>7.7582482844618883E-2</c:v>
                </c:pt>
                <c:pt idx="2132">
                  <c:v>0.32918064170401379</c:v>
                </c:pt>
                <c:pt idx="2133">
                  <c:v>0.82966054669761202</c:v>
                </c:pt>
                <c:pt idx="2134">
                  <c:v>0.72946122643067901</c:v>
                </c:pt>
                <c:pt idx="2135">
                  <c:v>0.31648450792961341</c:v>
                </c:pt>
                <c:pt idx="2136">
                  <c:v>0.15664512232954186</c:v>
                </c:pt>
                <c:pt idx="2137">
                  <c:v>0.27535892912141474</c:v>
                </c:pt>
                <c:pt idx="2138">
                  <c:v>0.93205261984405285</c:v>
                </c:pt>
                <c:pt idx="2139">
                  <c:v>0.37587546513944375</c:v>
                </c:pt>
                <c:pt idx="2140">
                  <c:v>0.20760373153789671</c:v>
                </c:pt>
                <c:pt idx="2141">
                  <c:v>4.55689293456953E-2</c:v>
                </c:pt>
                <c:pt idx="2142">
                  <c:v>0.21227831780799761</c:v>
                </c:pt>
                <c:pt idx="2143">
                  <c:v>0.71250013940501811</c:v>
                </c:pt>
                <c:pt idx="2144">
                  <c:v>0.7307970641380408</c:v>
                </c:pt>
                <c:pt idx="2145">
                  <c:v>0.15898669304567212</c:v>
                </c:pt>
                <c:pt idx="2146">
                  <c:v>0.54102874553376534</c:v>
                </c:pt>
                <c:pt idx="2147">
                  <c:v>0.62871081932555062</c:v>
                </c:pt>
                <c:pt idx="2148">
                  <c:v>0.23347662047681111</c:v>
                </c:pt>
                <c:pt idx="2149">
                  <c:v>0.98269435154596985</c:v>
                </c:pt>
                <c:pt idx="2150">
                  <c:v>0.81848001285014138</c:v>
                </c:pt>
                <c:pt idx="2151">
                  <c:v>0.81374323805445359</c:v>
                </c:pt>
                <c:pt idx="2152">
                  <c:v>5.8266236095771834E-2</c:v>
                </c:pt>
                <c:pt idx="2153">
                  <c:v>1.9297376881351715</c:v>
                </c:pt>
                <c:pt idx="2154">
                  <c:v>0.14110292412762587</c:v>
                </c:pt>
                <c:pt idx="2155">
                  <c:v>0.20905041273179192</c:v>
                </c:pt>
                <c:pt idx="2156">
                  <c:v>0.33357376600216909</c:v>
                </c:pt>
                <c:pt idx="2157">
                  <c:v>0.78940155088630792</c:v>
                </c:pt>
                <c:pt idx="2158">
                  <c:v>2.1087672405671574E-2</c:v>
                </c:pt>
                <c:pt idx="2159">
                  <c:v>1.759077684724639E-2</c:v>
                </c:pt>
                <c:pt idx="2160">
                  <c:v>0.69134827655812192</c:v>
                </c:pt>
                <c:pt idx="2161">
                  <c:v>0.88411674527708117</c:v>
                </c:pt>
                <c:pt idx="2162">
                  <c:v>0.14106620062412673</c:v>
                </c:pt>
                <c:pt idx="2163">
                  <c:v>0.77854088628078533</c:v>
                </c:pt>
                <c:pt idx="2164">
                  <c:v>0.29674258159109007</c:v>
                </c:pt>
                <c:pt idx="2165">
                  <c:v>0.48119369239699367</c:v>
                </c:pt>
                <c:pt idx="2166">
                  <c:v>5.0341092360186752E-2</c:v>
                </c:pt>
                <c:pt idx="2167">
                  <c:v>0.59163138334271947</c:v>
                </c:pt>
                <c:pt idx="2168">
                  <c:v>0.24754208938962252</c:v>
                </c:pt>
                <c:pt idx="2169">
                  <c:v>0.65991617450902151</c:v>
                </c:pt>
                <c:pt idx="2170">
                  <c:v>0.39035258811991946</c:v>
                </c:pt>
                <c:pt idx="2171">
                  <c:v>1.2336605864376149</c:v>
                </c:pt>
                <c:pt idx="2172">
                  <c:v>4.9359894212562615E-2</c:v>
                </c:pt>
                <c:pt idx="2173">
                  <c:v>0.34653692588112561</c:v>
                </c:pt>
                <c:pt idx="2174">
                  <c:v>0.44631068251543238</c:v>
                </c:pt>
                <c:pt idx="2175">
                  <c:v>4.8401204532025274E-2</c:v>
                </c:pt>
                <c:pt idx="2176">
                  <c:v>0.43439789448376404</c:v>
                </c:pt>
                <c:pt idx="2177">
                  <c:v>5.9328647243629594E-2</c:v>
                </c:pt>
                <c:pt idx="2178">
                  <c:v>0.39068839722329202</c:v>
                </c:pt>
                <c:pt idx="2179">
                  <c:v>2.3313780328772529E-2</c:v>
                </c:pt>
                <c:pt idx="2180">
                  <c:v>0.44412369475630714</c:v>
                </c:pt>
                <c:pt idx="2181">
                  <c:v>0.14544076010205959</c:v>
                </c:pt>
                <c:pt idx="2182">
                  <c:v>2.5567551032338622E-2</c:v>
                </c:pt>
                <c:pt idx="2183">
                  <c:v>0.51066873023231407</c:v>
                </c:pt>
                <c:pt idx="2184">
                  <c:v>4.6528327703813765E-2</c:v>
                </c:pt>
                <c:pt idx="2185">
                  <c:v>0.50906609006668468</c:v>
                </c:pt>
                <c:pt idx="2186">
                  <c:v>0.67400155232024095</c:v>
                </c:pt>
                <c:pt idx="2187">
                  <c:v>9.6447502144369951E-2</c:v>
                </c:pt>
                <c:pt idx="2188">
                  <c:v>4.5494484002728736E-2</c:v>
                </c:pt>
                <c:pt idx="2189">
                  <c:v>2.0086225148686639E-2</c:v>
                </c:pt>
                <c:pt idx="2190">
                  <c:v>1.3702506389566707</c:v>
                </c:pt>
                <c:pt idx="2191">
                  <c:v>0.31424931795359934</c:v>
                </c:pt>
                <c:pt idx="2192">
                  <c:v>0.28549413539677332</c:v>
                </c:pt>
                <c:pt idx="2193">
                  <c:v>0.59695492999761468</c:v>
                </c:pt>
                <c:pt idx="2194">
                  <c:v>0.14170682297186979</c:v>
                </c:pt>
                <c:pt idx="2195">
                  <c:v>0.32865512960487214</c:v>
                </c:pt>
                <c:pt idx="2196">
                  <c:v>0.12629806532327689</c:v>
                </c:pt>
                <c:pt idx="2197">
                  <c:v>4.6936585357140806E-2</c:v>
                </c:pt>
                <c:pt idx="2198">
                  <c:v>0.50418501134480176</c:v>
                </c:pt>
                <c:pt idx="2199">
                  <c:v>0.30329626868714843</c:v>
                </c:pt>
                <c:pt idx="2200">
                  <c:v>0.19001687720404645</c:v>
                </c:pt>
                <c:pt idx="2201">
                  <c:v>0.67776520747300106</c:v>
                </c:pt>
                <c:pt idx="2202">
                  <c:v>0.47690802369035096</c:v>
                </c:pt>
                <c:pt idx="2203">
                  <c:v>0.29073881197456153</c:v>
                </c:pt>
                <c:pt idx="2204">
                  <c:v>3.1651301419371301E-2</c:v>
                </c:pt>
                <c:pt idx="2205">
                  <c:v>4.0090348798663654E-2</c:v>
                </c:pt>
                <c:pt idx="2206">
                  <c:v>0.14592721573377984</c:v>
                </c:pt>
                <c:pt idx="2207">
                  <c:v>0.34338112824584477</c:v>
                </c:pt>
                <c:pt idx="2208">
                  <c:v>0.63080268948684082</c:v>
                </c:pt>
                <c:pt idx="2209">
                  <c:v>0.12460201877349694</c:v>
                </c:pt>
                <c:pt idx="2210">
                  <c:v>0.56475192567622334</c:v>
                </c:pt>
                <c:pt idx="2211">
                  <c:v>0.29915338639264044</c:v>
                </c:pt>
                <c:pt idx="2212">
                  <c:v>0.59545697639835138</c:v>
                </c:pt>
                <c:pt idx="2213">
                  <c:v>0.25911721104745217</c:v>
                </c:pt>
                <c:pt idx="2214">
                  <c:v>0.79302366985109918</c:v>
                </c:pt>
                <c:pt idx="2215">
                  <c:v>0.57822848141552052</c:v>
                </c:pt>
                <c:pt idx="2216">
                  <c:v>0.75392435504832256</c:v>
                </c:pt>
                <c:pt idx="2217">
                  <c:v>5.1805542567357664E-2</c:v>
                </c:pt>
                <c:pt idx="2218">
                  <c:v>8.4742191816480752E-2</c:v>
                </c:pt>
                <c:pt idx="2219">
                  <c:v>9.146036755274238E-2</c:v>
                </c:pt>
                <c:pt idx="2220">
                  <c:v>0.62733446690749184</c:v>
                </c:pt>
                <c:pt idx="2221">
                  <c:v>0.5625253057212185</c:v>
                </c:pt>
                <c:pt idx="2222">
                  <c:v>0.25501829779233448</c:v>
                </c:pt>
                <c:pt idx="2223">
                  <c:v>0.32287199423965118</c:v>
                </c:pt>
                <c:pt idx="2224">
                  <c:v>0.79281628917589342</c:v>
                </c:pt>
                <c:pt idx="2225">
                  <c:v>0.17760133841654774</c:v>
                </c:pt>
                <c:pt idx="2226">
                  <c:v>0.70303525328827066</c:v>
                </c:pt>
                <c:pt idx="2227">
                  <c:v>0.66159676793992406</c:v>
                </c:pt>
                <c:pt idx="2228">
                  <c:v>9.1118093274933698E-2</c:v>
                </c:pt>
                <c:pt idx="2229">
                  <c:v>0.37006501059994862</c:v>
                </c:pt>
                <c:pt idx="2230">
                  <c:v>0.30842794851438382</c:v>
                </c:pt>
                <c:pt idx="2231">
                  <c:v>1.1173040071029143</c:v>
                </c:pt>
                <c:pt idx="2232">
                  <c:v>0.21347374202061054</c:v>
                </c:pt>
                <c:pt idx="2233">
                  <c:v>1.2644290776112559</c:v>
                </c:pt>
                <c:pt idx="2234">
                  <c:v>0.53191700363236594</c:v>
                </c:pt>
                <c:pt idx="2235">
                  <c:v>1.4853014731304752</c:v>
                </c:pt>
                <c:pt idx="2236">
                  <c:v>0.63556264081802138</c:v>
                </c:pt>
                <c:pt idx="2237">
                  <c:v>0.71142850089210652</c:v>
                </c:pt>
                <c:pt idx="2238">
                  <c:v>0.64691366147146978</c:v>
                </c:pt>
                <c:pt idx="2239">
                  <c:v>1.1412233817572176E-2</c:v>
                </c:pt>
                <c:pt idx="2240">
                  <c:v>0.34830255795213422</c:v>
                </c:pt>
                <c:pt idx="2241">
                  <c:v>1.306417054386507</c:v>
                </c:pt>
                <c:pt idx="2242">
                  <c:v>0.15824535541174992</c:v>
                </c:pt>
                <c:pt idx="2243">
                  <c:v>1.2130477188014581</c:v>
                </c:pt>
                <c:pt idx="2244">
                  <c:v>0.20142877220331087</c:v>
                </c:pt>
                <c:pt idx="2245">
                  <c:v>0.34452307061202381</c:v>
                </c:pt>
                <c:pt idx="2246">
                  <c:v>0.15622413152393885</c:v>
                </c:pt>
                <c:pt idx="2247">
                  <c:v>0.20847732239462155</c:v>
                </c:pt>
                <c:pt idx="2248">
                  <c:v>0.3030372656306215</c:v>
                </c:pt>
                <c:pt idx="2249">
                  <c:v>0.36925425610926377</c:v>
                </c:pt>
                <c:pt idx="2250">
                  <c:v>0.27351247208043944</c:v>
                </c:pt>
                <c:pt idx="2251">
                  <c:v>0.4068382612737006</c:v>
                </c:pt>
                <c:pt idx="2252">
                  <c:v>0.36481810778437607</c:v>
                </c:pt>
                <c:pt idx="2253">
                  <c:v>0.96684284187559222</c:v>
                </c:pt>
                <c:pt idx="2254">
                  <c:v>0.2948401333893671</c:v>
                </c:pt>
                <c:pt idx="2255">
                  <c:v>0.19859564524379281</c:v>
                </c:pt>
                <c:pt idx="2256">
                  <c:v>0.36261696925635256</c:v>
                </c:pt>
                <c:pt idx="2257">
                  <c:v>2.8979581353313803E-2</c:v>
                </c:pt>
                <c:pt idx="2258">
                  <c:v>1.3252337769937736</c:v>
                </c:pt>
                <c:pt idx="2259">
                  <c:v>1.1151815062020283</c:v>
                </c:pt>
                <c:pt idx="2260">
                  <c:v>0.62394980479548112</c:v>
                </c:pt>
                <c:pt idx="2261">
                  <c:v>0.3069807040534081</c:v>
                </c:pt>
                <c:pt idx="2262">
                  <c:v>0.48076191300441562</c:v>
                </c:pt>
                <c:pt idx="2263">
                  <c:v>0.91745562959525606</c:v>
                </c:pt>
                <c:pt idx="2264">
                  <c:v>0.27381822110101911</c:v>
                </c:pt>
                <c:pt idx="2265">
                  <c:v>1.7752104075592749E-3</c:v>
                </c:pt>
                <c:pt idx="2266">
                  <c:v>0.66960915730975534</c:v>
                </c:pt>
                <c:pt idx="2267">
                  <c:v>0.92147827017360706</c:v>
                </c:pt>
                <c:pt idx="2268">
                  <c:v>0.90498172575825198</c:v>
                </c:pt>
                <c:pt idx="2269">
                  <c:v>0.58761665120573037</c:v>
                </c:pt>
                <c:pt idx="2270">
                  <c:v>0.23464969572825822</c:v>
                </c:pt>
                <c:pt idx="2271">
                  <c:v>0.61485009271862323</c:v>
                </c:pt>
                <c:pt idx="2272">
                  <c:v>0.19356104101978072</c:v>
                </c:pt>
                <c:pt idx="2273">
                  <c:v>0.85897059824416744</c:v>
                </c:pt>
                <c:pt idx="2274">
                  <c:v>0.12647389298093129</c:v>
                </c:pt>
                <c:pt idx="2275">
                  <c:v>0.67051146136789808</c:v>
                </c:pt>
                <c:pt idx="2276">
                  <c:v>0.38898783980096413</c:v>
                </c:pt>
                <c:pt idx="2277">
                  <c:v>1.1891522992671764</c:v>
                </c:pt>
                <c:pt idx="2278">
                  <c:v>0.94331681672129264</c:v>
                </c:pt>
                <c:pt idx="2279">
                  <c:v>2.0399112846890985E-2</c:v>
                </c:pt>
                <c:pt idx="2280">
                  <c:v>0.54584404203381642</c:v>
                </c:pt>
                <c:pt idx="2281">
                  <c:v>0.33968091295959507</c:v>
                </c:pt>
                <c:pt idx="2282">
                  <c:v>0.26377529567029023</c:v>
                </c:pt>
                <c:pt idx="2283">
                  <c:v>3.3633814567829308E-3</c:v>
                </c:pt>
                <c:pt idx="2284">
                  <c:v>0.16269270722400883</c:v>
                </c:pt>
                <c:pt idx="2285">
                  <c:v>7.522043160509943E-3</c:v>
                </c:pt>
                <c:pt idx="2286">
                  <c:v>0.40741875754415141</c:v>
                </c:pt>
                <c:pt idx="2287">
                  <c:v>0.28772645529678381</c:v>
                </c:pt>
                <c:pt idx="2288">
                  <c:v>0.10519875036717041</c:v>
                </c:pt>
                <c:pt idx="2289">
                  <c:v>0.43852784443824983</c:v>
                </c:pt>
                <c:pt idx="2290">
                  <c:v>0.66023782922712559</c:v>
                </c:pt>
                <c:pt idx="2291">
                  <c:v>0.40516861990735814</c:v>
                </c:pt>
                <c:pt idx="2292">
                  <c:v>0.4930920377910874</c:v>
                </c:pt>
                <c:pt idx="2293">
                  <c:v>5.4955476471353501E-2</c:v>
                </c:pt>
                <c:pt idx="2294">
                  <c:v>0.11883011241942346</c:v>
                </c:pt>
                <c:pt idx="2295">
                  <c:v>0.56890881385899938</c:v>
                </c:pt>
                <c:pt idx="2296">
                  <c:v>0.24030737911241853</c:v>
                </c:pt>
                <c:pt idx="2297">
                  <c:v>1.3639636801172945E-3</c:v>
                </c:pt>
                <c:pt idx="2298">
                  <c:v>5.2487439274735287E-2</c:v>
                </c:pt>
                <c:pt idx="2299">
                  <c:v>1.2964139034593263</c:v>
                </c:pt>
                <c:pt idx="2300">
                  <c:v>0.17866607677091192</c:v>
                </c:pt>
                <c:pt idx="2301">
                  <c:v>0.20195526231368072</c:v>
                </c:pt>
                <c:pt idx="2302">
                  <c:v>0.83902997796564593</c:v>
                </c:pt>
                <c:pt idx="2303">
                  <c:v>0.3363595935450498</c:v>
                </c:pt>
                <c:pt idx="2304">
                  <c:v>2.4520389338835092E-2</c:v>
                </c:pt>
                <c:pt idx="2305">
                  <c:v>8.4005155762626821E-2</c:v>
                </c:pt>
                <c:pt idx="2306">
                  <c:v>0.14422276212035348</c:v>
                </c:pt>
                <c:pt idx="2307">
                  <c:v>0.43913302838361162</c:v>
                </c:pt>
                <c:pt idx="2308">
                  <c:v>0.6416970095694966</c:v>
                </c:pt>
                <c:pt idx="2309">
                  <c:v>0.76301213265565038</c:v>
                </c:pt>
                <c:pt idx="2310">
                  <c:v>0.68539404515192393</c:v>
                </c:pt>
                <c:pt idx="2311">
                  <c:v>0.73994631642295439</c:v>
                </c:pt>
                <c:pt idx="2312">
                  <c:v>0.37553751709376365</c:v>
                </c:pt>
                <c:pt idx="2313">
                  <c:v>0.33261114058463886</c:v>
                </c:pt>
                <c:pt idx="2314">
                  <c:v>1.7672836981769133</c:v>
                </c:pt>
                <c:pt idx="2315">
                  <c:v>0.29873245473755106</c:v>
                </c:pt>
                <c:pt idx="2316">
                  <c:v>0.23667348494959498</c:v>
                </c:pt>
                <c:pt idx="2317">
                  <c:v>0.52391760937567788</c:v>
                </c:pt>
                <c:pt idx="2318">
                  <c:v>1.0562969725957236</c:v>
                </c:pt>
                <c:pt idx="2319">
                  <c:v>2.6873394440439992E-2</c:v>
                </c:pt>
                <c:pt idx="2320">
                  <c:v>0.43314138419472142</c:v>
                </c:pt>
                <c:pt idx="2321">
                  <c:v>0.33738436315890624</c:v>
                </c:pt>
                <c:pt idx="2322">
                  <c:v>2.1358594260586356E-2</c:v>
                </c:pt>
                <c:pt idx="2323">
                  <c:v>0.3467882402881402</c:v>
                </c:pt>
                <c:pt idx="2324">
                  <c:v>0.2103541697361998</c:v>
                </c:pt>
                <c:pt idx="2325">
                  <c:v>1.0253606332441172</c:v>
                </c:pt>
                <c:pt idx="2326">
                  <c:v>0.17699240173731309</c:v>
                </c:pt>
                <c:pt idx="2327">
                  <c:v>5.5478075766082144E-2</c:v>
                </c:pt>
                <c:pt idx="2328">
                  <c:v>6.856586706399416E-2</c:v>
                </c:pt>
                <c:pt idx="2329">
                  <c:v>8.5300780945687261E-3</c:v>
                </c:pt>
                <c:pt idx="2330">
                  <c:v>0.32031085508604551</c:v>
                </c:pt>
                <c:pt idx="2331">
                  <c:v>7.5176330894882126E-2</c:v>
                </c:pt>
                <c:pt idx="2332">
                  <c:v>0.63520543401526952</c:v>
                </c:pt>
                <c:pt idx="2333">
                  <c:v>1.8715557966176124</c:v>
                </c:pt>
                <c:pt idx="2334">
                  <c:v>0.49233801174520214</c:v>
                </c:pt>
                <c:pt idx="2335">
                  <c:v>0.27801028513456516</c:v>
                </c:pt>
                <c:pt idx="2336">
                  <c:v>0.36184624208364852</c:v>
                </c:pt>
                <c:pt idx="2337">
                  <c:v>0.18413634719973793</c:v>
                </c:pt>
                <c:pt idx="2338">
                  <c:v>0.1439501406528215</c:v>
                </c:pt>
                <c:pt idx="2339">
                  <c:v>4.6010574745377217E-2</c:v>
                </c:pt>
                <c:pt idx="2340">
                  <c:v>0.4906921041504187</c:v>
                </c:pt>
                <c:pt idx="2341">
                  <c:v>0.73315828713304032</c:v>
                </c:pt>
                <c:pt idx="2342">
                  <c:v>2.2632932923986011E-2</c:v>
                </c:pt>
                <c:pt idx="2343">
                  <c:v>0.65824233992006431</c:v>
                </c:pt>
                <c:pt idx="2344">
                  <c:v>0.46115496347800955</c:v>
                </c:pt>
                <c:pt idx="2345">
                  <c:v>7.2723785012993439E-2</c:v>
                </c:pt>
                <c:pt idx="2346">
                  <c:v>0.90523138905935063</c:v>
                </c:pt>
                <c:pt idx="2347">
                  <c:v>0.97938958973740209</c:v>
                </c:pt>
                <c:pt idx="2348">
                  <c:v>7.6037788240547452E-2</c:v>
                </c:pt>
                <c:pt idx="2349">
                  <c:v>0.48640986260152286</c:v>
                </c:pt>
                <c:pt idx="2350">
                  <c:v>0.14664965579541789</c:v>
                </c:pt>
                <c:pt idx="2351">
                  <c:v>0.38343230868930817</c:v>
                </c:pt>
                <c:pt idx="2352">
                  <c:v>0.61624481289659661</c:v>
                </c:pt>
                <c:pt idx="2353">
                  <c:v>0.57682921798631781</c:v>
                </c:pt>
                <c:pt idx="2354">
                  <c:v>8.2512703454879766E-2</c:v>
                </c:pt>
                <c:pt idx="2355">
                  <c:v>0.19092349245453569</c:v>
                </c:pt>
                <c:pt idx="2356">
                  <c:v>0.43207876139420998</c:v>
                </c:pt>
                <c:pt idx="2357">
                  <c:v>0.61507545868274816</c:v>
                </c:pt>
                <c:pt idx="2358">
                  <c:v>1.1438578477332122</c:v>
                </c:pt>
                <c:pt idx="2359">
                  <c:v>0.38392767773406383</c:v>
                </c:pt>
                <c:pt idx="2360">
                  <c:v>0.13746839897743174</c:v>
                </c:pt>
                <c:pt idx="2361">
                  <c:v>0.12525290149827278</c:v>
                </c:pt>
                <c:pt idx="2362">
                  <c:v>0.44608873222066608</c:v>
                </c:pt>
                <c:pt idx="2363">
                  <c:v>0.12278900796318142</c:v>
                </c:pt>
                <c:pt idx="2364">
                  <c:v>1.0368269197798061</c:v>
                </c:pt>
                <c:pt idx="2365">
                  <c:v>0.38060117693501161</c:v>
                </c:pt>
                <c:pt idx="2366">
                  <c:v>0.40883970553374804</c:v>
                </c:pt>
                <c:pt idx="2367">
                  <c:v>0.29399585035930742</c:v>
                </c:pt>
                <c:pt idx="2368">
                  <c:v>0.24741367751948667</c:v>
                </c:pt>
                <c:pt idx="2369">
                  <c:v>1.2729999460577597</c:v>
                </c:pt>
                <c:pt idx="2370">
                  <c:v>3.5955066260898796E-2</c:v>
                </c:pt>
                <c:pt idx="2371">
                  <c:v>0.34950215282310509</c:v>
                </c:pt>
                <c:pt idx="2372">
                  <c:v>0.56868632173735978</c:v>
                </c:pt>
                <c:pt idx="2373">
                  <c:v>0.48816433686572086</c:v>
                </c:pt>
                <c:pt idx="2374">
                  <c:v>0.71812442405615673</c:v>
                </c:pt>
                <c:pt idx="2375">
                  <c:v>0.80450146000020806</c:v>
                </c:pt>
                <c:pt idx="2376">
                  <c:v>0.18010712730013667</c:v>
                </c:pt>
                <c:pt idx="2377">
                  <c:v>0.32590922896819735</c:v>
                </c:pt>
                <c:pt idx="2378">
                  <c:v>1.2972335986168395</c:v>
                </c:pt>
                <c:pt idx="2379">
                  <c:v>0.28143970677393776</c:v>
                </c:pt>
                <c:pt idx="2380">
                  <c:v>0.35026514962149663</c:v>
                </c:pt>
                <c:pt idx="2381">
                  <c:v>3.011909855724219E-2</c:v>
                </c:pt>
                <c:pt idx="2382">
                  <c:v>0.52388120259534054</c:v>
                </c:pt>
                <c:pt idx="2383">
                  <c:v>0.55407365934595587</c:v>
                </c:pt>
                <c:pt idx="2384">
                  <c:v>0.7335318688081901</c:v>
                </c:pt>
                <c:pt idx="2385">
                  <c:v>0.59815023631310626</c:v>
                </c:pt>
                <c:pt idx="2386">
                  <c:v>1.1052595416125823</c:v>
                </c:pt>
                <c:pt idx="2387">
                  <c:v>0.30167189225064917</c:v>
                </c:pt>
                <c:pt idx="2388">
                  <c:v>0.2960017082076522</c:v>
                </c:pt>
                <c:pt idx="2389">
                  <c:v>8.4359940628141949E-2</c:v>
                </c:pt>
                <c:pt idx="2390">
                  <c:v>0.45193101692721838</c:v>
                </c:pt>
                <c:pt idx="2391">
                  <c:v>0.13477735115092304</c:v>
                </c:pt>
                <c:pt idx="2392">
                  <c:v>6.2417637498192935E-3</c:v>
                </c:pt>
                <c:pt idx="2393">
                  <c:v>0.24977288961285268</c:v>
                </c:pt>
                <c:pt idx="2394">
                  <c:v>0.20736017302269794</c:v>
                </c:pt>
                <c:pt idx="2395">
                  <c:v>1.4288450276422877</c:v>
                </c:pt>
                <c:pt idx="2396">
                  <c:v>0.53026302902972466</c:v>
                </c:pt>
                <c:pt idx="2397">
                  <c:v>0.55067822542738853</c:v>
                </c:pt>
                <c:pt idx="2398">
                  <c:v>1.1912872128012468</c:v>
                </c:pt>
                <c:pt idx="2399">
                  <c:v>0.86794579871374566</c:v>
                </c:pt>
                <c:pt idx="2400">
                  <c:v>1.1930559996433978</c:v>
                </c:pt>
                <c:pt idx="2401">
                  <c:v>0.9431941624384963</c:v>
                </c:pt>
                <c:pt idx="2402">
                  <c:v>0.98741512127344477</c:v>
                </c:pt>
                <c:pt idx="2403">
                  <c:v>0.38905902096186001</c:v>
                </c:pt>
                <c:pt idx="2404">
                  <c:v>0.80648918653611656</c:v>
                </c:pt>
                <c:pt idx="2405">
                  <c:v>0.36097129629852998</c:v>
                </c:pt>
                <c:pt idx="2406">
                  <c:v>0.10525479846925953</c:v>
                </c:pt>
                <c:pt idx="2407">
                  <c:v>0.47273129837652345</c:v>
                </c:pt>
                <c:pt idx="2408">
                  <c:v>0.34951489139943748</c:v>
                </c:pt>
                <c:pt idx="2409">
                  <c:v>0.40582539349843161</c:v>
                </c:pt>
                <c:pt idx="2410">
                  <c:v>1.1511754710290423</c:v>
                </c:pt>
                <c:pt idx="2411">
                  <c:v>0.1005933447772949</c:v>
                </c:pt>
                <c:pt idx="2412">
                  <c:v>0.49063559689022068</c:v>
                </c:pt>
                <c:pt idx="2413">
                  <c:v>0.81348594557890896</c:v>
                </c:pt>
                <c:pt idx="2414">
                  <c:v>0.46883467961500969</c:v>
                </c:pt>
                <c:pt idx="2415">
                  <c:v>1.5694186079385066</c:v>
                </c:pt>
                <c:pt idx="2416">
                  <c:v>1.2479782087873579</c:v>
                </c:pt>
                <c:pt idx="2417">
                  <c:v>0.73281176882558963</c:v>
                </c:pt>
                <c:pt idx="2418">
                  <c:v>0.61045976372127597</c:v>
                </c:pt>
                <c:pt idx="2419">
                  <c:v>0.23570120744167705</c:v>
                </c:pt>
                <c:pt idx="2420">
                  <c:v>0.41383725898146001</c:v>
                </c:pt>
                <c:pt idx="2421">
                  <c:v>1.939589016437961E-3</c:v>
                </c:pt>
                <c:pt idx="2422">
                  <c:v>0.36949807175777516</c:v>
                </c:pt>
                <c:pt idx="2423">
                  <c:v>0.19029968825804661</c:v>
                </c:pt>
                <c:pt idx="2424">
                  <c:v>0.20230925048763834</c:v>
                </c:pt>
                <c:pt idx="2425">
                  <c:v>0.14054324555243181</c:v>
                </c:pt>
                <c:pt idx="2426">
                  <c:v>0.60946017675770081</c:v>
                </c:pt>
                <c:pt idx="2427">
                  <c:v>1.2068732002830269</c:v>
                </c:pt>
                <c:pt idx="2428">
                  <c:v>0.56079541289186063</c:v>
                </c:pt>
                <c:pt idx="2429">
                  <c:v>0.10061934920969327</c:v>
                </c:pt>
                <c:pt idx="2430">
                  <c:v>8.9756078031914491E-3</c:v>
                </c:pt>
                <c:pt idx="2431">
                  <c:v>1.4300702580799722</c:v>
                </c:pt>
                <c:pt idx="2432">
                  <c:v>0.68993200920446784</c:v>
                </c:pt>
                <c:pt idx="2433">
                  <c:v>0.74516126018527362</c:v>
                </c:pt>
                <c:pt idx="2434">
                  <c:v>0.2022620270788803</c:v>
                </c:pt>
                <c:pt idx="2435">
                  <c:v>2.6022654323063506E-2</c:v>
                </c:pt>
                <c:pt idx="2436">
                  <c:v>2.9539204737194107E-2</c:v>
                </c:pt>
                <c:pt idx="2437">
                  <c:v>0.52280321774033744</c:v>
                </c:pt>
                <c:pt idx="2438">
                  <c:v>0.4335217365751623</c:v>
                </c:pt>
                <c:pt idx="2439">
                  <c:v>0.67210277270487617</c:v>
                </c:pt>
                <c:pt idx="2440">
                  <c:v>0.59482532998627802</c:v>
                </c:pt>
                <c:pt idx="2441">
                  <c:v>0.61089467650925944</c:v>
                </c:pt>
                <c:pt idx="2442">
                  <c:v>2.6038306099429042E-2</c:v>
                </c:pt>
                <c:pt idx="2443">
                  <c:v>0.72741342804855624</c:v>
                </c:pt>
                <c:pt idx="2444">
                  <c:v>0.36909707799465746</c:v>
                </c:pt>
                <c:pt idx="2445">
                  <c:v>0.20071527396245478</c:v>
                </c:pt>
                <c:pt idx="2446">
                  <c:v>1.4515834474628383E-2</c:v>
                </c:pt>
                <c:pt idx="2447">
                  <c:v>8.7903984773934726E-2</c:v>
                </c:pt>
                <c:pt idx="2448">
                  <c:v>0.69784430188916757</c:v>
                </c:pt>
                <c:pt idx="2449">
                  <c:v>0.17878384932914124</c:v>
                </c:pt>
                <c:pt idx="2450">
                  <c:v>2.7905592907670314E-2</c:v>
                </c:pt>
                <c:pt idx="2451">
                  <c:v>0.49188725647896914</c:v>
                </c:pt>
                <c:pt idx="2452">
                  <c:v>1.8640680117605199</c:v>
                </c:pt>
                <c:pt idx="2453">
                  <c:v>0.28787108850280513</c:v>
                </c:pt>
                <c:pt idx="2454">
                  <c:v>6.6462598146405621E-2</c:v>
                </c:pt>
                <c:pt idx="2455">
                  <c:v>0.24448493465627943</c:v>
                </c:pt>
                <c:pt idx="2456">
                  <c:v>0.65694067049303428</c:v>
                </c:pt>
                <c:pt idx="2457">
                  <c:v>0.17320251569115844</c:v>
                </c:pt>
                <c:pt idx="2458">
                  <c:v>0.89915356198369611</c:v>
                </c:pt>
                <c:pt idx="2459">
                  <c:v>0.35018259351761849</c:v>
                </c:pt>
                <c:pt idx="2460">
                  <c:v>1.0740038320484533E-2</c:v>
                </c:pt>
                <c:pt idx="2461">
                  <c:v>6.0901987902766061E-2</c:v>
                </c:pt>
                <c:pt idx="2462">
                  <c:v>0.57181229819190427</c:v>
                </c:pt>
                <c:pt idx="2463">
                  <c:v>0.59394889122457695</c:v>
                </c:pt>
                <c:pt idx="2464">
                  <c:v>9.860785362577773E-2</c:v>
                </c:pt>
                <c:pt idx="2465">
                  <c:v>0.58585349125575592</c:v>
                </c:pt>
                <c:pt idx="2466">
                  <c:v>2.1555615459480418E-3</c:v>
                </c:pt>
                <c:pt idx="2467">
                  <c:v>0.42542089005831429</c:v>
                </c:pt>
                <c:pt idx="2468">
                  <c:v>0.11450088095294408</c:v>
                </c:pt>
                <c:pt idx="2469">
                  <c:v>0.2323834902243978</c:v>
                </c:pt>
                <c:pt idx="2470">
                  <c:v>0.27711480363964935</c:v>
                </c:pt>
                <c:pt idx="2471">
                  <c:v>0.43582257797151841</c:v>
                </c:pt>
                <c:pt idx="2472">
                  <c:v>0.66920040055914864</c:v>
                </c:pt>
                <c:pt idx="2473">
                  <c:v>0.46271957694843829</c:v>
                </c:pt>
                <c:pt idx="2474">
                  <c:v>0.77511184780377951</c:v>
                </c:pt>
                <c:pt idx="2475">
                  <c:v>9.4513936213060212E-3</c:v>
                </c:pt>
                <c:pt idx="2476">
                  <c:v>0.85412172567973121</c:v>
                </c:pt>
                <c:pt idx="2477">
                  <c:v>4.0635180678758653E-2</c:v>
                </c:pt>
                <c:pt idx="2478">
                  <c:v>1.5433502246491254E-2</c:v>
                </c:pt>
                <c:pt idx="2479">
                  <c:v>6.7984842393509451E-2</c:v>
                </c:pt>
                <c:pt idx="2480">
                  <c:v>0.52440366821714335</c:v>
                </c:pt>
                <c:pt idx="2481">
                  <c:v>0.54858811607606273</c:v>
                </c:pt>
                <c:pt idx="2482">
                  <c:v>2.0709070948257269</c:v>
                </c:pt>
                <c:pt idx="2483">
                  <c:v>0.61028976456139017</c:v>
                </c:pt>
                <c:pt idx="2484">
                  <c:v>0.23250286402073098</c:v>
                </c:pt>
                <c:pt idx="2485">
                  <c:v>0.21299383716239509</c:v>
                </c:pt>
                <c:pt idx="2486">
                  <c:v>4.6663761793099758E-2</c:v>
                </c:pt>
                <c:pt idx="2487">
                  <c:v>0.31832209576681247</c:v>
                </c:pt>
                <c:pt idx="2488">
                  <c:v>0.2009653090531334</c:v>
                </c:pt>
                <c:pt idx="2489">
                  <c:v>1.1134905857473625</c:v>
                </c:pt>
                <c:pt idx="2490">
                  <c:v>0.41839590287866846</c:v>
                </c:pt>
                <c:pt idx="2491">
                  <c:v>1.0675987693028608</c:v>
                </c:pt>
                <c:pt idx="2492">
                  <c:v>3.725539088546421E-3</c:v>
                </c:pt>
                <c:pt idx="2493">
                  <c:v>0.44854349266671273</c:v>
                </c:pt>
                <c:pt idx="2494">
                  <c:v>9.7895451656548321E-3</c:v>
                </c:pt>
                <c:pt idx="2495">
                  <c:v>0.19817811757509476</c:v>
                </c:pt>
                <c:pt idx="2496">
                  <c:v>0.83546837219814507</c:v>
                </c:pt>
                <c:pt idx="2497">
                  <c:v>0.63905618296770939</c:v>
                </c:pt>
                <c:pt idx="2498">
                  <c:v>0.59482602477629043</c:v>
                </c:pt>
                <c:pt idx="2499">
                  <c:v>0.42185419040983912</c:v>
                </c:pt>
                <c:pt idx="2500">
                  <c:v>3.7329114940952111E-2</c:v>
                </c:pt>
                <c:pt idx="2501">
                  <c:v>0.57265248375394517</c:v>
                </c:pt>
                <c:pt idx="2502">
                  <c:v>0.7034845416787594</c:v>
                </c:pt>
                <c:pt idx="2503">
                  <c:v>0.1450209108964477</c:v>
                </c:pt>
                <c:pt idx="2504">
                  <c:v>0.55023996264183306</c:v>
                </c:pt>
                <c:pt idx="2505">
                  <c:v>0.44558398088399875</c:v>
                </c:pt>
                <c:pt idx="2506">
                  <c:v>1.0562089746107028</c:v>
                </c:pt>
                <c:pt idx="2507">
                  <c:v>9.9361262059113539E-2</c:v>
                </c:pt>
                <c:pt idx="2508">
                  <c:v>0.13555626397929738</c:v>
                </c:pt>
                <c:pt idx="2509">
                  <c:v>3.6846340184707423E-3</c:v>
                </c:pt>
                <c:pt idx="2510">
                  <c:v>0.31129361908575637</c:v>
                </c:pt>
                <c:pt idx="2511">
                  <c:v>0.82442896449252079</c:v>
                </c:pt>
                <c:pt idx="2512">
                  <c:v>0.24731219422971989</c:v>
                </c:pt>
                <c:pt idx="2513">
                  <c:v>0.36201219282512809</c:v>
                </c:pt>
                <c:pt idx="2514">
                  <c:v>0.34411257646802185</c:v>
                </c:pt>
                <c:pt idx="2515">
                  <c:v>0.25019786915018505</c:v>
                </c:pt>
                <c:pt idx="2516">
                  <c:v>0.23855504228963414</c:v>
                </c:pt>
                <c:pt idx="2517">
                  <c:v>0.2022036640387046</c:v>
                </c:pt>
                <c:pt idx="2518">
                  <c:v>0.22125397212077116</c:v>
                </c:pt>
                <c:pt idx="2519">
                  <c:v>0.21069762474552775</c:v>
                </c:pt>
                <c:pt idx="2520">
                  <c:v>6.3494740777397807E-2</c:v>
                </c:pt>
                <c:pt idx="2521">
                  <c:v>1.2527937041075614</c:v>
                </c:pt>
                <c:pt idx="2522">
                  <c:v>0.28410362741742001</c:v>
                </c:pt>
                <c:pt idx="2523">
                  <c:v>9.7366538637520969E-2</c:v>
                </c:pt>
                <c:pt idx="2524">
                  <c:v>2.7595396614596059E-2</c:v>
                </c:pt>
                <c:pt idx="2525">
                  <c:v>0.25996864823554727</c:v>
                </c:pt>
                <c:pt idx="2526">
                  <c:v>0.38946094523527652</c:v>
                </c:pt>
                <c:pt idx="2527">
                  <c:v>1.2371581492679689</c:v>
                </c:pt>
                <c:pt idx="2528">
                  <c:v>4.4763590406125799E-2</c:v>
                </c:pt>
                <c:pt idx="2529">
                  <c:v>1.4994294638060486</c:v>
                </c:pt>
                <c:pt idx="2530">
                  <c:v>3.7455241163473416E-2</c:v>
                </c:pt>
                <c:pt idx="2531">
                  <c:v>0.8448877851887342</c:v>
                </c:pt>
                <c:pt idx="2532">
                  <c:v>1.0545410755732792E-2</c:v>
                </c:pt>
                <c:pt idx="2533">
                  <c:v>0.20066760075479925</c:v>
                </c:pt>
                <c:pt idx="2534">
                  <c:v>1.2267921324794957</c:v>
                </c:pt>
                <c:pt idx="2535">
                  <c:v>0.23463177408291644</c:v>
                </c:pt>
                <c:pt idx="2536">
                  <c:v>0.39562000177717616</c:v>
                </c:pt>
                <c:pt idx="2537">
                  <c:v>1.1626041725957974E-2</c:v>
                </c:pt>
                <c:pt idx="2538">
                  <c:v>0.64687927813843482</c:v>
                </c:pt>
                <c:pt idx="2539">
                  <c:v>0.14003934488683686</c:v>
                </c:pt>
                <c:pt idx="2540">
                  <c:v>9.1693675663477067E-2</c:v>
                </c:pt>
                <c:pt idx="2541">
                  <c:v>0.21817509900029083</c:v>
                </c:pt>
                <c:pt idx="2542">
                  <c:v>0.70217189744741471</c:v>
                </c:pt>
                <c:pt idx="2543">
                  <c:v>0.17952156503498079</c:v>
                </c:pt>
                <c:pt idx="2544">
                  <c:v>0.18521282394170566</c:v>
                </c:pt>
                <c:pt idx="2545">
                  <c:v>0.16863771882854547</c:v>
                </c:pt>
                <c:pt idx="2546">
                  <c:v>0.14529412230458855</c:v>
                </c:pt>
                <c:pt idx="2547">
                  <c:v>1.2506516972773736</c:v>
                </c:pt>
                <c:pt idx="2548">
                  <c:v>0.21635136725354828</c:v>
                </c:pt>
                <c:pt idx="2549">
                  <c:v>5.6882238637777763E-2</c:v>
                </c:pt>
                <c:pt idx="2550">
                  <c:v>0.22486209397689677</c:v>
                </c:pt>
                <c:pt idx="2551">
                  <c:v>0.33358927140484712</c:v>
                </c:pt>
                <c:pt idx="2552">
                  <c:v>0.13077591597747998</c:v>
                </c:pt>
                <c:pt idx="2553">
                  <c:v>1.5155868361537621</c:v>
                </c:pt>
                <c:pt idx="2554">
                  <c:v>0.1467858853264386</c:v>
                </c:pt>
                <c:pt idx="2555">
                  <c:v>3.1311745009108202E-2</c:v>
                </c:pt>
                <c:pt idx="2556">
                  <c:v>1.1329099038330108</c:v>
                </c:pt>
                <c:pt idx="2557">
                  <c:v>0.24320993927783677</c:v>
                </c:pt>
                <c:pt idx="2558">
                  <c:v>0.54843982571697703</c:v>
                </c:pt>
                <c:pt idx="2559">
                  <c:v>0.23958411855784564</c:v>
                </c:pt>
                <c:pt idx="2560">
                  <c:v>0.69237182625625715</c:v>
                </c:pt>
                <c:pt idx="2561">
                  <c:v>0.11152368132153594</c:v>
                </c:pt>
                <c:pt idx="2562">
                  <c:v>1.1939559796242689</c:v>
                </c:pt>
                <c:pt idx="2563">
                  <c:v>0.28082297900706465</c:v>
                </c:pt>
                <c:pt idx="2564">
                  <c:v>0.11659773727692038</c:v>
                </c:pt>
                <c:pt idx="2565">
                  <c:v>6.3244269460382169E-2</c:v>
                </c:pt>
                <c:pt idx="2566">
                  <c:v>3.8333124088261242E-2</c:v>
                </c:pt>
                <c:pt idx="2567">
                  <c:v>0.87468249488690009</c:v>
                </c:pt>
                <c:pt idx="2568">
                  <c:v>0.65231861157744497</c:v>
                </c:pt>
                <c:pt idx="2569">
                  <c:v>0.23539086980586121</c:v>
                </c:pt>
                <c:pt idx="2570">
                  <c:v>0.20543816696835096</c:v>
                </c:pt>
                <c:pt idx="2571">
                  <c:v>3.8658150385730346E-2</c:v>
                </c:pt>
                <c:pt idx="2572">
                  <c:v>0.63564701935837775</c:v>
                </c:pt>
                <c:pt idx="2573">
                  <c:v>0.14273926406823703</c:v>
                </c:pt>
                <c:pt idx="2574">
                  <c:v>0.83792605928032127</c:v>
                </c:pt>
                <c:pt idx="2575">
                  <c:v>0.23540084547169826</c:v>
                </c:pt>
                <c:pt idx="2576">
                  <c:v>0.12103021511098508</c:v>
                </c:pt>
                <c:pt idx="2577">
                  <c:v>0.29709736764291733</c:v>
                </c:pt>
                <c:pt idx="2578">
                  <c:v>0.85485517809618916</c:v>
                </c:pt>
                <c:pt idx="2579">
                  <c:v>0.25840220790419072</c:v>
                </c:pt>
                <c:pt idx="2580">
                  <c:v>0.10390418213349265</c:v>
                </c:pt>
                <c:pt idx="2581">
                  <c:v>0.8516719156637611</c:v>
                </c:pt>
                <c:pt idx="2582">
                  <c:v>1.3884556044863896</c:v>
                </c:pt>
                <c:pt idx="2583">
                  <c:v>2.9333516190993197E-2</c:v>
                </c:pt>
                <c:pt idx="2584">
                  <c:v>0.60332263978510958</c:v>
                </c:pt>
                <c:pt idx="2585">
                  <c:v>0.13020273636200136</c:v>
                </c:pt>
                <c:pt idx="2586">
                  <c:v>0.28580789880232865</c:v>
                </c:pt>
                <c:pt idx="2587">
                  <c:v>0.48228071185656424</c:v>
                </c:pt>
                <c:pt idx="2588">
                  <c:v>0.18619334391081024</c:v>
                </c:pt>
                <c:pt idx="2589">
                  <c:v>0.26145950143037799</c:v>
                </c:pt>
                <c:pt idx="2590">
                  <c:v>0.31443682116450888</c:v>
                </c:pt>
                <c:pt idx="2591">
                  <c:v>0.74079498579588443</c:v>
                </c:pt>
                <c:pt idx="2592">
                  <c:v>0.34129646951012932</c:v>
                </c:pt>
                <c:pt idx="2593">
                  <c:v>1.931592633784829</c:v>
                </c:pt>
                <c:pt idx="2594">
                  <c:v>0.62497899000321044</c:v>
                </c:pt>
                <c:pt idx="2595">
                  <c:v>1.248642872654411</c:v>
                </c:pt>
                <c:pt idx="2596">
                  <c:v>0.38554250948666574</c:v>
                </c:pt>
                <c:pt idx="2597">
                  <c:v>0.11598018183965475</c:v>
                </c:pt>
                <c:pt idx="2598">
                  <c:v>0.89252459122783567</c:v>
                </c:pt>
                <c:pt idx="2599">
                  <c:v>0.70293491106422012</c:v>
                </c:pt>
                <c:pt idx="2600">
                  <c:v>8.9976074818456583E-3</c:v>
                </c:pt>
                <c:pt idx="2601">
                  <c:v>0.18126743483734425</c:v>
                </c:pt>
                <c:pt idx="2602">
                  <c:v>0.19929795185271504</c:v>
                </c:pt>
                <c:pt idx="2603">
                  <c:v>0.18109636544054089</c:v>
                </c:pt>
                <c:pt idx="2604">
                  <c:v>4.638969026706221E-2</c:v>
                </c:pt>
                <c:pt idx="2605">
                  <c:v>0.77648956578770589</c:v>
                </c:pt>
                <c:pt idx="2606">
                  <c:v>0.88181256648843909</c:v>
                </c:pt>
                <c:pt idx="2607">
                  <c:v>8.0575155059497104E-3</c:v>
                </c:pt>
                <c:pt idx="2608">
                  <c:v>1.1887351942225499</c:v>
                </c:pt>
                <c:pt idx="2609">
                  <c:v>0.86348847116471317</c:v>
                </c:pt>
                <c:pt idx="2610">
                  <c:v>0.99526357461527992</c:v>
                </c:pt>
                <c:pt idx="2611">
                  <c:v>0.1125144400826787</c:v>
                </c:pt>
                <c:pt idx="2612">
                  <c:v>1.1140834039762471</c:v>
                </c:pt>
                <c:pt idx="2613">
                  <c:v>2.7663250831918909</c:v>
                </c:pt>
                <c:pt idx="2614">
                  <c:v>0.1503812030486178</c:v>
                </c:pt>
                <c:pt idx="2615">
                  <c:v>0.64504796005639531</c:v>
                </c:pt>
                <c:pt idx="2616">
                  <c:v>1.082195910615271</c:v>
                </c:pt>
                <c:pt idx="2617">
                  <c:v>1.5714967523379291</c:v>
                </c:pt>
                <c:pt idx="2618">
                  <c:v>0.10285215263415742</c:v>
                </c:pt>
                <c:pt idx="2619">
                  <c:v>0.39107860215344209</c:v>
                </c:pt>
                <c:pt idx="2620">
                  <c:v>0.13224129313852959</c:v>
                </c:pt>
                <c:pt idx="2621">
                  <c:v>0.69928932497045893</c:v>
                </c:pt>
                <c:pt idx="2622">
                  <c:v>0.72230023394247267</c:v>
                </c:pt>
                <c:pt idx="2623">
                  <c:v>6.5430652166566433E-2</c:v>
                </c:pt>
                <c:pt idx="2624">
                  <c:v>1.2046388801622303</c:v>
                </c:pt>
                <c:pt idx="2625">
                  <c:v>0.26322285667332901</c:v>
                </c:pt>
                <c:pt idx="2626">
                  <c:v>0.25687863015130447</c:v>
                </c:pt>
                <c:pt idx="2627">
                  <c:v>9.527986546533021E-2</c:v>
                </c:pt>
                <c:pt idx="2628">
                  <c:v>0.29981699679079454</c:v>
                </c:pt>
                <c:pt idx="2629">
                  <c:v>1.0033594129847543</c:v>
                </c:pt>
                <c:pt idx="2630">
                  <c:v>7.109348330821956E-2</c:v>
                </c:pt>
                <c:pt idx="2631">
                  <c:v>0.7858740684046579</c:v>
                </c:pt>
                <c:pt idx="2632">
                  <c:v>0.29499086024192295</c:v>
                </c:pt>
                <c:pt idx="2633">
                  <c:v>0.4121227328207393</c:v>
                </c:pt>
                <c:pt idx="2634">
                  <c:v>0.31351755207777615</c:v>
                </c:pt>
                <c:pt idx="2635">
                  <c:v>0.53272818442939029</c:v>
                </c:pt>
                <c:pt idx="2636">
                  <c:v>0.35637144724307668</c:v>
                </c:pt>
                <c:pt idx="2637">
                  <c:v>0.53085832034229852</c:v>
                </c:pt>
                <c:pt idx="2638">
                  <c:v>0.54354143630272189</c:v>
                </c:pt>
                <c:pt idx="2639">
                  <c:v>2.3112788015743211E-2</c:v>
                </c:pt>
                <c:pt idx="2640">
                  <c:v>0.61328372940465914</c:v>
                </c:pt>
                <c:pt idx="2641">
                  <c:v>0.15703847461765838</c:v>
                </c:pt>
                <c:pt idx="2642">
                  <c:v>0.38328884059902324</c:v>
                </c:pt>
                <c:pt idx="2643">
                  <c:v>7.5154414688304236E-2</c:v>
                </c:pt>
                <c:pt idx="2644">
                  <c:v>1.086437715808581</c:v>
                </c:pt>
                <c:pt idx="2645">
                  <c:v>0.45817749518559431</c:v>
                </c:pt>
                <c:pt idx="2646">
                  <c:v>0.60944558898414503</c:v>
                </c:pt>
                <c:pt idx="2647">
                  <c:v>0.26428660001657056</c:v>
                </c:pt>
                <c:pt idx="2648">
                  <c:v>0.12863862274821847</c:v>
                </c:pt>
                <c:pt idx="2649">
                  <c:v>0.73742728493041421</c:v>
                </c:pt>
                <c:pt idx="2650">
                  <c:v>0.22170157911594257</c:v>
                </c:pt>
                <c:pt idx="2651">
                  <c:v>6.5873585374862667E-2</c:v>
                </c:pt>
                <c:pt idx="2652">
                  <c:v>1.2322801698588036E-2</c:v>
                </c:pt>
                <c:pt idx="2653">
                  <c:v>0.22327198521737493</c:v>
                </c:pt>
                <c:pt idx="2654">
                  <c:v>0.45184923606002553</c:v>
                </c:pt>
                <c:pt idx="2655">
                  <c:v>0.58188355626934818</c:v>
                </c:pt>
                <c:pt idx="2656">
                  <c:v>0.23778062057874041</c:v>
                </c:pt>
                <c:pt idx="2657">
                  <c:v>0.12959424259908567</c:v>
                </c:pt>
                <c:pt idx="2658">
                  <c:v>0.84760627469662686</c:v>
                </c:pt>
                <c:pt idx="2659">
                  <c:v>0.35370551796953137</c:v>
                </c:pt>
                <c:pt idx="2660">
                  <c:v>0.92018715948922192</c:v>
                </c:pt>
                <c:pt idx="2661">
                  <c:v>1.8202293727595642</c:v>
                </c:pt>
                <c:pt idx="2662">
                  <c:v>0.45236308563865202</c:v>
                </c:pt>
                <c:pt idx="2663">
                  <c:v>4.9958333724716773E-2</c:v>
                </c:pt>
                <c:pt idx="2664">
                  <c:v>0.18808170429105542</c:v>
                </c:pt>
                <c:pt idx="2665">
                  <c:v>0.25749644623027806</c:v>
                </c:pt>
                <c:pt idx="2666">
                  <c:v>0.8472423059209534</c:v>
                </c:pt>
                <c:pt idx="2667">
                  <c:v>0.74395024277906274</c:v>
                </c:pt>
                <c:pt idx="2668">
                  <c:v>0.11816553821717601</c:v>
                </c:pt>
                <c:pt idx="2669">
                  <c:v>0.10610444514055573</c:v>
                </c:pt>
                <c:pt idx="2670">
                  <c:v>0.11396454314992667</c:v>
                </c:pt>
                <c:pt idx="2671">
                  <c:v>0.38574380422911264</c:v>
                </c:pt>
                <c:pt idx="2672">
                  <c:v>0.53211129151638237</c:v>
                </c:pt>
                <c:pt idx="2673">
                  <c:v>6.1505230524932168E-2</c:v>
                </c:pt>
                <c:pt idx="2674">
                  <c:v>9.7870567945407133E-2</c:v>
                </c:pt>
                <c:pt idx="2675">
                  <c:v>6.2546498174596565E-2</c:v>
                </c:pt>
                <c:pt idx="2676">
                  <c:v>0.64892319732003167</c:v>
                </c:pt>
                <c:pt idx="2677">
                  <c:v>0.38077951316016023</c:v>
                </c:pt>
                <c:pt idx="2678">
                  <c:v>0.57718978023556</c:v>
                </c:pt>
                <c:pt idx="2679">
                  <c:v>0.18820803501458214</c:v>
                </c:pt>
                <c:pt idx="2680">
                  <c:v>0.12987640418250571</c:v>
                </c:pt>
                <c:pt idx="2681">
                  <c:v>0.9619058317043836</c:v>
                </c:pt>
                <c:pt idx="2682">
                  <c:v>0.43532535160609537</c:v>
                </c:pt>
                <c:pt idx="2683">
                  <c:v>1.0533758990514723</c:v>
                </c:pt>
                <c:pt idx="2684">
                  <c:v>5.2174742340404791E-2</c:v>
                </c:pt>
                <c:pt idx="2685">
                  <c:v>0.70566689686688178</c:v>
                </c:pt>
                <c:pt idx="2686">
                  <c:v>0.20556106387899781</c:v>
                </c:pt>
                <c:pt idx="2687">
                  <c:v>0.49964085661262697</c:v>
                </c:pt>
                <c:pt idx="2688">
                  <c:v>0.84366617589438075</c:v>
                </c:pt>
                <c:pt idx="2689">
                  <c:v>1.1277727533709681</c:v>
                </c:pt>
                <c:pt idx="2690">
                  <c:v>0.90637975057872389</c:v>
                </c:pt>
                <c:pt idx="2691">
                  <c:v>0.73199652797903003</c:v>
                </c:pt>
                <c:pt idx="2692">
                  <c:v>6.6909926231994987E-2</c:v>
                </c:pt>
                <c:pt idx="2693">
                  <c:v>1.1777496612887188</c:v>
                </c:pt>
                <c:pt idx="2694">
                  <c:v>5.2658390473565304E-2</c:v>
                </c:pt>
                <c:pt idx="2695">
                  <c:v>3.1134601637969068E-3</c:v>
                </c:pt>
                <c:pt idx="2696">
                  <c:v>0.30748495766128159</c:v>
                </c:pt>
                <c:pt idx="2697">
                  <c:v>0.22657389281761517</c:v>
                </c:pt>
                <c:pt idx="2698">
                  <c:v>4.2252462137061499E-2</c:v>
                </c:pt>
                <c:pt idx="2699">
                  <c:v>6.2520047623528585E-2</c:v>
                </c:pt>
                <c:pt idx="2700">
                  <c:v>0.58118056077073399</c:v>
                </c:pt>
                <c:pt idx="2701">
                  <c:v>0.33466734986515306</c:v>
                </c:pt>
                <c:pt idx="2702">
                  <c:v>0.12539312364805663</c:v>
                </c:pt>
                <c:pt idx="2703">
                  <c:v>0.59858925884045566</c:v>
                </c:pt>
                <c:pt idx="2704">
                  <c:v>0.75005208260477307</c:v>
                </c:pt>
                <c:pt idx="2705">
                  <c:v>3.5940572762639206E-2</c:v>
                </c:pt>
                <c:pt idx="2706">
                  <c:v>0.28665266972140463</c:v>
                </c:pt>
                <c:pt idx="2707">
                  <c:v>0.56708361559556997</c:v>
                </c:pt>
                <c:pt idx="2708">
                  <c:v>0.61461540397892722</c:v>
                </c:pt>
                <c:pt idx="2709">
                  <c:v>0.91216744060044919</c:v>
                </c:pt>
                <c:pt idx="2710">
                  <c:v>1.1552604111475464</c:v>
                </c:pt>
                <c:pt idx="2711">
                  <c:v>0.58376029808859298</c:v>
                </c:pt>
                <c:pt idx="2712">
                  <c:v>0.76568935323989928</c:v>
                </c:pt>
                <c:pt idx="2713">
                  <c:v>9.0768536374077724E-2</c:v>
                </c:pt>
                <c:pt idx="2714">
                  <c:v>0.30639397115601447</c:v>
                </c:pt>
                <c:pt idx="2715">
                  <c:v>0.26651316415083298</c:v>
                </c:pt>
                <c:pt idx="2716">
                  <c:v>0.37796129770534997</c:v>
                </c:pt>
                <c:pt idx="2717">
                  <c:v>0.22981111036137492</c:v>
                </c:pt>
                <c:pt idx="2718">
                  <c:v>0.41450855722280078</c:v>
                </c:pt>
                <c:pt idx="2719">
                  <c:v>3.5626162889617612E-2</c:v>
                </c:pt>
                <c:pt idx="2720">
                  <c:v>0.10968583066070861</c:v>
                </c:pt>
                <c:pt idx="2721">
                  <c:v>0.22558293311735567</c:v>
                </c:pt>
                <c:pt idx="2722">
                  <c:v>1.4247282970559583</c:v>
                </c:pt>
                <c:pt idx="2723">
                  <c:v>0.731611000125172</c:v>
                </c:pt>
                <c:pt idx="2724">
                  <c:v>0.37261138167891</c:v>
                </c:pt>
                <c:pt idx="2725">
                  <c:v>0.13143844536900565</c:v>
                </c:pt>
                <c:pt idx="2726">
                  <c:v>0.25829116776966782</c:v>
                </c:pt>
                <c:pt idx="2727">
                  <c:v>3.452226991860529E-2</c:v>
                </c:pt>
                <c:pt idx="2728">
                  <c:v>0.3372326650052036</c:v>
                </c:pt>
                <c:pt idx="2729">
                  <c:v>0.25750857209319916</c:v>
                </c:pt>
                <c:pt idx="2730">
                  <c:v>0.85206091184592236</c:v>
                </c:pt>
                <c:pt idx="2731">
                  <c:v>0.40422896334991965</c:v>
                </c:pt>
                <c:pt idx="2732">
                  <c:v>0.76177873316432354</c:v>
                </c:pt>
                <c:pt idx="2733">
                  <c:v>1.0639270901183269</c:v>
                </c:pt>
                <c:pt idx="2734">
                  <c:v>0.19721475080024156</c:v>
                </c:pt>
                <c:pt idx="2735">
                  <c:v>0.30655758467526917</c:v>
                </c:pt>
                <c:pt idx="2736">
                  <c:v>0.12345806769176414</c:v>
                </c:pt>
                <c:pt idx="2737">
                  <c:v>0.76652881344884105</c:v>
                </c:pt>
                <c:pt idx="2738">
                  <c:v>2.2022080365388979E-2</c:v>
                </c:pt>
                <c:pt idx="2739">
                  <c:v>0.44140195796368059</c:v>
                </c:pt>
                <c:pt idx="2740">
                  <c:v>0.9477842384052414</c:v>
                </c:pt>
                <c:pt idx="2741">
                  <c:v>0.37772641817100666</c:v>
                </c:pt>
                <c:pt idx="2742">
                  <c:v>0.76214031353819767</c:v>
                </c:pt>
                <c:pt idx="2743">
                  <c:v>0.60878969375850212</c:v>
                </c:pt>
                <c:pt idx="2744">
                  <c:v>9.4344001924672752E-2</c:v>
                </c:pt>
                <c:pt idx="2745">
                  <c:v>0.17602773707066371</c:v>
                </c:pt>
                <c:pt idx="2746">
                  <c:v>6.3265318588490604E-2</c:v>
                </c:pt>
                <c:pt idx="2747">
                  <c:v>0.16330018147067635</c:v>
                </c:pt>
                <c:pt idx="2748">
                  <c:v>4.4557531526230772E-2</c:v>
                </c:pt>
                <c:pt idx="2749">
                  <c:v>0.50256749069660878</c:v>
                </c:pt>
                <c:pt idx="2750">
                  <c:v>0.72923209298820146</c:v>
                </c:pt>
                <c:pt idx="2751">
                  <c:v>0.57720130389669755</c:v>
                </c:pt>
                <c:pt idx="2752">
                  <c:v>1.7180385380236778</c:v>
                </c:pt>
                <c:pt idx="2753">
                  <c:v>1.1462432133979181</c:v>
                </c:pt>
                <c:pt idx="2754">
                  <c:v>0.21865360789201863</c:v>
                </c:pt>
                <c:pt idx="2755">
                  <c:v>0.19539854048335392</c:v>
                </c:pt>
                <c:pt idx="2756">
                  <c:v>4.2705013399092294E-2</c:v>
                </c:pt>
                <c:pt idx="2757">
                  <c:v>0.13244080593865523</c:v>
                </c:pt>
                <c:pt idx="2758">
                  <c:v>0.8771100520894004</c:v>
                </c:pt>
                <c:pt idx="2759">
                  <c:v>0.32973113690792821</c:v>
                </c:pt>
                <c:pt idx="2760">
                  <c:v>0.62984855548438945</c:v>
                </c:pt>
                <c:pt idx="2761">
                  <c:v>0.40203549909763669</c:v>
                </c:pt>
                <c:pt idx="2762">
                  <c:v>0.56454035292524363</c:v>
                </c:pt>
                <c:pt idx="2763">
                  <c:v>0.25333902986264722</c:v>
                </c:pt>
                <c:pt idx="2764">
                  <c:v>0.19213694010471974</c:v>
                </c:pt>
                <c:pt idx="2765">
                  <c:v>0.29074650820741621</c:v>
                </c:pt>
                <c:pt idx="2766">
                  <c:v>0.17677439322526112</c:v>
                </c:pt>
                <c:pt idx="2767">
                  <c:v>6.8417191273847475E-2</c:v>
                </c:pt>
                <c:pt idx="2768">
                  <c:v>8.2464658421088188E-2</c:v>
                </c:pt>
                <c:pt idx="2769">
                  <c:v>1.7728816942957137E-2</c:v>
                </c:pt>
                <c:pt idx="2770">
                  <c:v>0.20098894675082143</c:v>
                </c:pt>
                <c:pt idx="2771">
                  <c:v>1.0405909692960378</c:v>
                </c:pt>
                <c:pt idx="2772">
                  <c:v>0.13592497977076592</c:v>
                </c:pt>
                <c:pt idx="2773">
                  <c:v>0.54741982670099176</c:v>
                </c:pt>
                <c:pt idx="2774">
                  <c:v>0.42693005023413733</c:v>
                </c:pt>
                <c:pt idx="2775">
                  <c:v>0.49925477795940776</c:v>
                </c:pt>
                <c:pt idx="2776">
                  <c:v>0.85835393101524249</c:v>
                </c:pt>
                <c:pt idx="2777">
                  <c:v>0.95694745816609161</c:v>
                </c:pt>
                <c:pt idx="2778">
                  <c:v>6.5248460225566532E-2</c:v>
                </c:pt>
                <c:pt idx="2779">
                  <c:v>9.5000811172136573E-2</c:v>
                </c:pt>
                <c:pt idx="2780">
                  <c:v>1.312137215014092</c:v>
                </c:pt>
                <c:pt idx="2781">
                  <c:v>0.62270142872093004</c:v>
                </c:pt>
                <c:pt idx="2782">
                  <c:v>0.74626066070563968</c:v>
                </c:pt>
                <c:pt idx="2783">
                  <c:v>0.62505869235080769</c:v>
                </c:pt>
                <c:pt idx="2784">
                  <c:v>1.0692279647862097</c:v>
                </c:pt>
                <c:pt idx="2785">
                  <c:v>0.50992949922137432</c:v>
                </c:pt>
                <c:pt idx="2786">
                  <c:v>0.11072564374797962</c:v>
                </c:pt>
                <c:pt idx="2787">
                  <c:v>9.2618280892323102E-2</c:v>
                </c:pt>
                <c:pt idx="2788">
                  <c:v>0.87503548497543204</c:v>
                </c:pt>
                <c:pt idx="2789">
                  <c:v>2.7290355276582821E-2</c:v>
                </c:pt>
                <c:pt idx="2790">
                  <c:v>0.24620344547261755</c:v>
                </c:pt>
                <c:pt idx="2791">
                  <c:v>0.33615930021982127</c:v>
                </c:pt>
                <c:pt idx="2792">
                  <c:v>0.59922188447845881</c:v>
                </c:pt>
                <c:pt idx="2793">
                  <c:v>4.1401333311992484E-3</c:v>
                </c:pt>
                <c:pt idx="2794">
                  <c:v>1.0338738973646997</c:v>
                </c:pt>
                <c:pt idx="2795">
                  <c:v>0.23869563565143845</c:v>
                </c:pt>
                <c:pt idx="2796">
                  <c:v>1.0219522816412991</c:v>
                </c:pt>
                <c:pt idx="2797">
                  <c:v>0.51413756554690604</c:v>
                </c:pt>
                <c:pt idx="2798">
                  <c:v>0.18136129454229277</c:v>
                </c:pt>
                <c:pt idx="2799">
                  <c:v>2.374434229208849E-2</c:v>
                </c:pt>
                <c:pt idx="2800">
                  <c:v>0.26227536841932941</c:v>
                </c:pt>
                <c:pt idx="2801">
                  <c:v>0.18044654022526682</c:v>
                </c:pt>
                <c:pt idx="2802">
                  <c:v>1.1274917357237653</c:v>
                </c:pt>
                <c:pt idx="2803">
                  <c:v>1.2286078883385776</c:v>
                </c:pt>
                <c:pt idx="2804">
                  <c:v>1.0626123031944956</c:v>
                </c:pt>
                <c:pt idx="2805">
                  <c:v>0.36979718748909668</c:v>
                </c:pt>
                <c:pt idx="2806">
                  <c:v>0.22521594458173252</c:v>
                </c:pt>
                <c:pt idx="2807">
                  <c:v>4.4665033804654065E-2</c:v>
                </c:pt>
                <c:pt idx="2808">
                  <c:v>0.15636674443364043</c:v>
                </c:pt>
                <c:pt idx="2809">
                  <c:v>0.79960948987758396</c:v>
                </c:pt>
                <c:pt idx="2810">
                  <c:v>6.3726537224194788E-2</c:v>
                </c:pt>
                <c:pt idx="2811">
                  <c:v>0.2525575821344524</c:v>
                </c:pt>
                <c:pt idx="2812">
                  <c:v>7.0482041752179467E-2</c:v>
                </c:pt>
                <c:pt idx="2813">
                  <c:v>0.34147040832832826</c:v>
                </c:pt>
                <c:pt idx="2814">
                  <c:v>7.266123433445601E-2</c:v>
                </c:pt>
                <c:pt idx="2815">
                  <c:v>0.54548231877692022</c:v>
                </c:pt>
                <c:pt idx="2816">
                  <c:v>1.0969287652345343</c:v>
                </c:pt>
                <c:pt idx="2817">
                  <c:v>0.96581544190241697</c:v>
                </c:pt>
                <c:pt idx="2818">
                  <c:v>0.10620472614267178</c:v>
                </c:pt>
                <c:pt idx="2819">
                  <c:v>0.31534589047420025</c:v>
                </c:pt>
                <c:pt idx="2820">
                  <c:v>0.10551408214804511</c:v>
                </c:pt>
                <c:pt idx="2821">
                  <c:v>9.0981132827628944E-2</c:v>
                </c:pt>
                <c:pt idx="2822">
                  <c:v>0.16376483397594557</c:v>
                </c:pt>
                <c:pt idx="2823">
                  <c:v>0.57936597591269079</c:v>
                </c:pt>
                <c:pt idx="2824">
                  <c:v>6.1193421702966141E-2</c:v>
                </c:pt>
                <c:pt idx="2825">
                  <c:v>3.4686689120849969E-2</c:v>
                </c:pt>
                <c:pt idx="2826">
                  <c:v>6.9001366137614664E-2</c:v>
                </c:pt>
                <c:pt idx="2827">
                  <c:v>0.27637716606799517</c:v>
                </c:pt>
                <c:pt idx="2828">
                  <c:v>0.22363731713546295</c:v>
                </c:pt>
                <c:pt idx="2829">
                  <c:v>8.1628580750231772E-2</c:v>
                </c:pt>
                <c:pt idx="2830">
                  <c:v>0.91929021730679061</c:v>
                </c:pt>
                <c:pt idx="2831">
                  <c:v>0.79599642251517666</c:v>
                </c:pt>
                <c:pt idx="2832">
                  <c:v>0.15020532204668535</c:v>
                </c:pt>
                <c:pt idx="2833">
                  <c:v>0.21571856414842039</c:v>
                </c:pt>
                <c:pt idx="2834">
                  <c:v>0.16229305413360451</c:v>
                </c:pt>
                <c:pt idx="2835">
                  <c:v>1.2591440186171876</c:v>
                </c:pt>
                <c:pt idx="2836">
                  <c:v>0.12260658708255413</c:v>
                </c:pt>
                <c:pt idx="2837">
                  <c:v>0.24744897012298872</c:v>
                </c:pt>
                <c:pt idx="2838">
                  <c:v>0.75717869339802424</c:v>
                </c:pt>
                <c:pt idx="2839">
                  <c:v>0.2010194368038716</c:v>
                </c:pt>
                <c:pt idx="2840">
                  <c:v>0.43923717729105388</c:v>
                </c:pt>
                <c:pt idx="2841">
                  <c:v>0.77051779758512884</c:v>
                </c:pt>
                <c:pt idx="2842">
                  <c:v>0.43474822391982382</c:v>
                </c:pt>
                <c:pt idx="2843">
                  <c:v>0.73180705445321614</c:v>
                </c:pt>
                <c:pt idx="2844">
                  <c:v>1.4515360521187597</c:v>
                </c:pt>
                <c:pt idx="2845">
                  <c:v>0.51042582649492396</c:v>
                </c:pt>
                <c:pt idx="2846">
                  <c:v>0.54055609061636767</c:v>
                </c:pt>
                <c:pt idx="2847">
                  <c:v>0.59865516335290569</c:v>
                </c:pt>
                <c:pt idx="2848">
                  <c:v>0.31597693852682751</c:v>
                </c:pt>
                <c:pt idx="2849">
                  <c:v>0.92506083647542603</c:v>
                </c:pt>
                <c:pt idx="2850">
                  <c:v>1.1029952161273668</c:v>
                </c:pt>
                <c:pt idx="2851">
                  <c:v>0.20126552527708141</c:v>
                </c:pt>
                <c:pt idx="2852">
                  <c:v>0.40437434181231996</c:v>
                </c:pt>
                <c:pt idx="2853">
                  <c:v>0.314497365228259</c:v>
                </c:pt>
                <c:pt idx="2854">
                  <c:v>0.50854263231379448</c:v>
                </c:pt>
                <c:pt idx="2855">
                  <c:v>0.39457753307802157</c:v>
                </c:pt>
                <c:pt idx="2856">
                  <c:v>1.1389467607061123</c:v>
                </c:pt>
                <c:pt idx="2857">
                  <c:v>0.12320926581997863</c:v>
                </c:pt>
                <c:pt idx="2858">
                  <c:v>0.15091559921749212</c:v>
                </c:pt>
                <c:pt idx="2859">
                  <c:v>0.52958454834097612</c:v>
                </c:pt>
                <c:pt idx="2860">
                  <c:v>0.52891596442960387</c:v>
                </c:pt>
                <c:pt idx="2861">
                  <c:v>0.17030167746551944</c:v>
                </c:pt>
                <c:pt idx="2862">
                  <c:v>1.3744022726455991</c:v>
                </c:pt>
                <c:pt idx="2863">
                  <c:v>1.5185162587947927</c:v>
                </c:pt>
                <c:pt idx="2864">
                  <c:v>0.33319873116823212</c:v>
                </c:pt>
                <c:pt idx="2865">
                  <c:v>6.4221387163772028E-2</c:v>
                </c:pt>
                <c:pt idx="2866">
                  <c:v>0.20767243978740083</c:v>
                </c:pt>
                <c:pt idx="2867">
                  <c:v>0.54409626496868002</c:v>
                </c:pt>
                <c:pt idx="2868">
                  <c:v>0.1264038662135098</c:v>
                </c:pt>
                <c:pt idx="2869">
                  <c:v>0.69859604642712336</c:v>
                </c:pt>
                <c:pt idx="2870">
                  <c:v>0.11563874272660118</c:v>
                </c:pt>
                <c:pt idx="2871">
                  <c:v>1.2158564827223004E-2</c:v>
                </c:pt>
                <c:pt idx="2872">
                  <c:v>0.36877323251559863</c:v>
                </c:pt>
                <c:pt idx="2873">
                  <c:v>1.829000525789011</c:v>
                </c:pt>
                <c:pt idx="2874">
                  <c:v>0.49478518116611719</c:v>
                </c:pt>
                <c:pt idx="2875">
                  <c:v>1.0594412466231143E-2</c:v>
                </c:pt>
                <c:pt idx="2876">
                  <c:v>2.8741266531601739</c:v>
                </c:pt>
                <c:pt idx="2877">
                  <c:v>0.56668165205815535</c:v>
                </c:pt>
                <c:pt idx="2878">
                  <c:v>0.14439144864517761</c:v>
                </c:pt>
                <c:pt idx="2879">
                  <c:v>0.13963422492683664</c:v>
                </c:pt>
                <c:pt idx="2880">
                  <c:v>9.0503564503290598E-2</c:v>
                </c:pt>
                <c:pt idx="2881">
                  <c:v>0.46794461528886161</c:v>
                </c:pt>
                <c:pt idx="2882">
                  <c:v>0.20408675083176042</c:v>
                </c:pt>
                <c:pt idx="2883">
                  <c:v>0.28221163940249266</c:v>
                </c:pt>
                <c:pt idx="2884">
                  <c:v>0.37507642087793114</c:v>
                </c:pt>
                <c:pt idx="2885">
                  <c:v>0.10631021388125382</c:v>
                </c:pt>
                <c:pt idx="2886">
                  <c:v>0.35366914147630957</c:v>
                </c:pt>
                <c:pt idx="2887">
                  <c:v>0.73083119129539464</c:v>
                </c:pt>
                <c:pt idx="2888">
                  <c:v>6.2696658757481039E-2</c:v>
                </c:pt>
                <c:pt idx="2889">
                  <c:v>0.27551355958498985</c:v>
                </c:pt>
                <c:pt idx="2890">
                  <c:v>0.21000760930456633</c:v>
                </c:pt>
                <c:pt idx="2891">
                  <c:v>0.63537074267645877</c:v>
                </c:pt>
                <c:pt idx="2892">
                  <c:v>6.1990402630715265E-2</c:v>
                </c:pt>
                <c:pt idx="2893">
                  <c:v>0.56799768472807288</c:v>
                </c:pt>
                <c:pt idx="2894">
                  <c:v>0.23035269851802986</c:v>
                </c:pt>
                <c:pt idx="2895">
                  <c:v>0.81191712028800478</c:v>
                </c:pt>
                <c:pt idx="2896">
                  <c:v>4.7958207831889053E-2</c:v>
                </c:pt>
                <c:pt idx="2897">
                  <c:v>0.69302592620601888</c:v>
                </c:pt>
                <c:pt idx="2898">
                  <c:v>0.3818130905785953</c:v>
                </c:pt>
                <c:pt idx="2899">
                  <c:v>0.35361169873676701</c:v>
                </c:pt>
                <c:pt idx="2900">
                  <c:v>0.17978156296937239</c:v>
                </c:pt>
                <c:pt idx="2901">
                  <c:v>0.40174492268519973</c:v>
                </c:pt>
                <c:pt idx="2902">
                  <c:v>0.24814054531656252</c:v>
                </c:pt>
                <c:pt idx="2903">
                  <c:v>1.4906321283718966</c:v>
                </c:pt>
                <c:pt idx="2904">
                  <c:v>0.11215760313226973</c:v>
                </c:pt>
                <c:pt idx="2905">
                  <c:v>1.4899152114526073</c:v>
                </c:pt>
                <c:pt idx="2906">
                  <c:v>8.5219218090075183E-2</c:v>
                </c:pt>
                <c:pt idx="2907">
                  <c:v>0.25692350404518544</c:v>
                </c:pt>
                <c:pt idx="2908">
                  <c:v>1.1609865541754201</c:v>
                </c:pt>
                <c:pt idx="2909">
                  <c:v>0.15839044823266207</c:v>
                </c:pt>
                <c:pt idx="2910">
                  <c:v>1.1281479224329223</c:v>
                </c:pt>
                <c:pt idx="2911">
                  <c:v>1.2369166131496154</c:v>
                </c:pt>
                <c:pt idx="2912">
                  <c:v>0.28516941924766065</c:v>
                </c:pt>
                <c:pt idx="2913">
                  <c:v>1.0838734814117736</c:v>
                </c:pt>
                <c:pt idx="2914">
                  <c:v>0.80997024814963914</c:v>
                </c:pt>
                <c:pt idx="2915">
                  <c:v>0.16791435158465834</c:v>
                </c:pt>
                <c:pt idx="2916">
                  <c:v>0.19677710340608254</c:v>
                </c:pt>
                <c:pt idx="2917">
                  <c:v>1.0746305497358974</c:v>
                </c:pt>
                <c:pt idx="2918">
                  <c:v>4.6604013935514284E-2</c:v>
                </c:pt>
                <c:pt idx="2919">
                  <c:v>6.4618533808199749E-2</c:v>
                </c:pt>
                <c:pt idx="2920">
                  <c:v>0.15825516479373974</c:v>
                </c:pt>
                <c:pt idx="2921">
                  <c:v>0.62714595897033898</c:v>
                </c:pt>
                <c:pt idx="2922">
                  <c:v>0.81910097448624841</c:v>
                </c:pt>
                <c:pt idx="2923">
                  <c:v>0.33504214429331208</c:v>
                </c:pt>
                <c:pt idx="2924">
                  <c:v>0.68170208463984805</c:v>
                </c:pt>
                <c:pt idx="2925">
                  <c:v>6.1638012103395886E-3</c:v>
                </c:pt>
                <c:pt idx="2926">
                  <c:v>0.10750747658007588</c:v>
                </c:pt>
                <c:pt idx="2927">
                  <c:v>0.20287698603277643</c:v>
                </c:pt>
                <c:pt idx="2928">
                  <c:v>0.23483956152133542</c:v>
                </c:pt>
                <c:pt idx="2929">
                  <c:v>1.473538007733574</c:v>
                </c:pt>
                <c:pt idx="2930">
                  <c:v>0.90356313556692469</c:v>
                </c:pt>
                <c:pt idx="2931">
                  <c:v>0.52217472052834202</c:v>
                </c:pt>
                <c:pt idx="2932">
                  <c:v>0.50123412344181495</c:v>
                </c:pt>
                <c:pt idx="2933">
                  <c:v>0.18200473210541576</c:v>
                </c:pt>
                <c:pt idx="2934">
                  <c:v>0.11998475648742864</c:v>
                </c:pt>
                <c:pt idx="2935">
                  <c:v>8.836730594049455E-2</c:v>
                </c:pt>
                <c:pt idx="2936">
                  <c:v>0.16873472528941288</c:v>
                </c:pt>
                <c:pt idx="2937">
                  <c:v>0.50706377896933885</c:v>
                </c:pt>
                <c:pt idx="2938">
                  <c:v>0.37308664902656402</c:v>
                </c:pt>
                <c:pt idx="2939">
                  <c:v>3.0815633659244748E-2</c:v>
                </c:pt>
                <c:pt idx="2940">
                  <c:v>0.67694417210843849</c:v>
                </c:pt>
                <c:pt idx="2941">
                  <c:v>0.13483574718185082</c:v>
                </c:pt>
                <c:pt idx="2942">
                  <c:v>0.38034726791500212</c:v>
                </c:pt>
                <c:pt idx="2943">
                  <c:v>0.25607629639976659</c:v>
                </c:pt>
                <c:pt idx="2944">
                  <c:v>0.14673527317802365</c:v>
                </c:pt>
                <c:pt idx="2945">
                  <c:v>2.0083555526966643E-2</c:v>
                </c:pt>
                <c:pt idx="2946">
                  <c:v>0.15072535188608452</c:v>
                </c:pt>
                <c:pt idx="2947">
                  <c:v>0.48057703199112428</c:v>
                </c:pt>
                <c:pt idx="2948">
                  <c:v>0.67799912075938873</c:v>
                </c:pt>
                <c:pt idx="2949">
                  <c:v>0.24563051918749343</c:v>
                </c:pt>
                <c:pt idx="2950">
                  <c:v>0.94880829576970682</c:v>
                </c:pt>
                <c:pt idx="2951">
                  <c:v>0.99560212233734291</c:v>
                </c:pt>
                <c:pt idx="2952">
                  <c:v>0.35356659296094523</c:v>
                </c:pt>
                <c:pt idx="2953">
                  <c:v>0.5962893519108764</c:v>
                </c:pt>
                <c:pt idx="2954">
                  <c:v>0.30666416978280708</c:v>
                </c:pt>
                <c:pt idx="2955">
                  <c:v>3.9302509124409531E-2</c:v>
                </c:pt>
                <c:pt idx="2956">
                  <c:v>0.312699951782413</c:v>
                </c:pt>
                <c:pt idx="2957">
                  <c:v>1.0445631253927099</c:v>
                </c:pt>
                <c:pt idx="2958">
                  <c:v>0.2566463135437545</c:v>
                </c:pt>
                <c:pt idx="2959">
                  <c:v>0.8342140298277112</c:v>
                </c:pt>
                <c:pt idx="2960">
                  <c:v>5.2389651901700252E-2</c:v>
                </c:pt>
                <c:pt idx="2961">
                  <c:v>0.16104153030560767</c:v>
                </c:pt>
                <c:pt idx="2962">
                  <c:v>0.69618808372110874</c:v>
                </c:pt>
                <c:pt idx="2963">
                  <c:v>0.77436583472379861</c:v>
                </c:pt>
                <c:pt idx="2964">
                  <c:v>0.1863505138553975</c:v>
                </c:pt>
                <c:pt idx="2965">
                  <c:v>1.1018404230107787E-3</c:v>
                </c:pt>
                <c:pt idx="2966">
                  <c:v>0.40923481348169477</c:v>
                </c:pt>
                <c:pt idx="2967">
                  <c:v>0.18669412798173984</c:v>
                </c:pt>
                <c:pt idx="2968">
                  <c:v>0.89839685003700209</c:v>
                </c:pt>
                <c:pt idx="2969">
                  <c:v>8.7500311155208066E-3</c:v>
                </c:pt>
                <c:pt idx="2970">
                  <c:v>0.34043690192802273</c:v>
                </c:pt>
                <c:pt idx="2971">
                  <c:v>4.2602566558097674E-2</c:v>
                </c:pt>
                <c:pt idx="2972">
                  <c:v>0.32227516031965731</c:v>
                </c:pt>
                <c:pt idx="2973">
                  <c:v>7.3948913761330171E-2</c:v>
                </c:pt>
                <c:pt idx="2974">
                  <c:v>0.222372311463365</c:v>
                </c:pt>
                <c:pt idx="2975">
                  <c:v>0.16430261937468646</c:v>
                </c:pt>
                <c:pt idx="2976">
                  <c:v>0.79677657399045909</c:v>
                </c:pt>
                <c:pt idx="2977">
                  <c:v>8.1309462472146238E-3</c:v>
                </c:pt>
                <c:pt idx="2978">
                  <c:v>0.33001774350274443</c:v>
                </c:pt>
                <c:pt idx="2979">
                  <c:v>0.69262305359371146</c:v>
                </c:pt>
                <c:pt idx="2980">
                  <c:v>0.19074438253465179</c:v>
                </c:pt>
                <c:pt idx="2981">
                  <c:v>0.77318628784361876</c:v>
                </c:pt>
                <c:pt idx="2982">
                  <c:v>0.1370131110520508</c:v>
                </c:pt>
                <c:pt idx="2983">
                  <c:v>0.10837364345346172</c:v>
                </c:pt>
                <c:pt idx="2984">
                  <c:v>0.62993649502948235</c:v>
                </c:pt>
                <c:pt idx="2985">
                  <c:v>0.30491543325609793</c:v>
                </c:pt>
                <c:pt idx="2986">
                  <c:v>4.4968418341962621E-2</c:v>
                </c:pt>
                <c:pt idx="2987">
                  <c:v>0.46285756114557519</c:v>
                </c:pt>
                <c:pt idx="2988">
                  <c:v>1.471316853797511</c:v>
                </c:pt>
                <c:pt idx="2989">
                  <c:v>0.42028632811091249</c:v>
                </c:pt>
                <c:pt idx="2990">
                  <c:v>0.5525714479440611</c:v>
                </c:pt>
                <c:pt idx="2991">
                  <c:v>2.628860801951929E-2</c:v>
                </c:pt>
                <c:pt idx="2992">
                  <c:v>0.589650732544445</c:v>
                </c:pt>
                <c:pt idx="2993">
                  <c:v>0.74787942037722499</c:v>
                </c:pt>
                <c:pt idx="2994">
                  <c:v>0.83624132575659571</c:v>
                </c:pt>
                <c:pt idx="2995">
                  <c:v>0.16977897653524029</c:v>
                </c:pt>
                <c:pt idx="2996">
                  <c:v>8.1374760529512064E-2</c:v>
                </c:pt>
                <c:pt idx="2997">
                  <c:v>0.61312285799872002</c:v>
                </c:pt>
                <c:pt idx="2998">
                  <c:v>0.45110994531732612</c:v>
                </c:pt>
                <c:pt idx="2999">
                  <c:v>0.88975165276195101</c:v>
                </c:pt>
                <c:pt idx="3000">
                  <c:v>1.9842782969868262</c:v>
                </c:pt>
                <c:pt idx="3001">
                  <c:v>0.91996706409771345</c:v>
                </c:pt>
                <c:pt idx="3002">
                  <c:v>1.0570981329286262</c:v>
                </c:pt>
                <c:pt idx="3003">
                  <c:v>0.35511565667443978</c:v>
                </c:pt>
                <c:pt idx="3004">
                  <c:v>0.51451491600135246</c:v>
                </c:pt>
                <c:pt idx="3005">
                  <c:v>0.36164520817472334</c:v>
                </c:pt>
                <c:pt idx="3006">
                  <c:v>0.81416913818962666</c:v>
                </c:pt>
                <c:pt idx="3007">
                  <c:v>0.49317847415447502</c:v>
                </c:pt>
                <c:pt idx="3008">
                  <c:v>0.21313605379808587</c:v>
                </c:pt>
                <c:pt idx="3009">
                  <c:v>0.62947792212974463</c:v>
                </c:pt>
                <c:pt idx="3010">
                  <c:v>1.3162575112599808</c:v>
                </c:pt>
                <c:pt idx="3011">
                  <c:v>0.16509908763871209</c:v>
                </c:pt>
                <c:pt idx="3012">
                  <c:v>9.8072717642372936E-2</c:v>
                </c:pt>
                <c:pt idx="3013">
                  <c:v>1.6678198253175998</c:v>
                </c:pt>
                <c:pt idx="3014">
                  <c:v>0.52692954210688803</c:v>
                </c:pt>
                <c:pt idx="3015">
                  <c:v>2.2517231598433135E-2</c:v>
                </c:pt>
                <c:pt idx="3016">
                  <c:v>0.6302099210624087</c:v>
                </c:pt>
                <c:pt idx="3017">
                  <c:v>7.5019217401960853E-2</c:v>
                </c:pt>
                <c:pt idx="3018">
                  <c:v>0.93405268683681164</c:v>
                </c:pt>
                <c:pt idx="3019">
                  <c:v>1.3166072068683616</c:v>
                </c:pt>
                <c:pt idx="3020">
                  <c:v>0.47042220801658796</c:v>
                </c:pt>
                <c:pt idx="3021">
                  <c:v>0.14709913250514242</c:v>
                </c:pt>
                <c:pt idx="3022">
                  <c:v>1.0617876121597829</c:v>
                </c:pt>
                <c:pt idx="3023">
                  <c:v>0.53302740178286134</c:v>
                </c:pt>
                <c:pt idx="3024">
                  <c:v>0.48552957326802565</c:v>
                </c:pt>
                <c:pt idx="3025">
                  <c:v>0.48195787914588772</c:v>
                </c:pt>
                <c:pt idx="3026">
                  <c:v>0.20784115854220128</c:v>
                </c:pt>
                <c:pt idx="3027">
                  <c:v>0.91785696882092727</c:v>
                </c:pt>
                <c:pt idx="3028">
                  <c:v>0.88647251237115443</c:v>
                </c:pt>
                <c:pt idx="3029">
                  <c:v>0.76437197714030325</c:v>
                </c:pt>
                <c:pt idx="3030">
                  <c:v>0.82549101302203365</c:v>
                </c:pt>
                <c:pt idx="3031">
                  <c:v>0.26653375392768253</c:v>
                </c:pt>
                <c:pt idx="3032">
                  <c:v>1.2945103740636759</c:v>
                </c:pt>
                <c:pt idx="3033">
                  <c:v>1.5484900351246764E-2</c:v>
                </c:pt>
                <c:pt idx="3034">
                  <c:v>0.12791750513346659</c:v>
                </c:pt>
                <c:pt idx="3035">
                  <c:v>0.16816943138060442</c:v>
                </c:pt>
                <c:pt idx="3036">
                  <c:v>0.46765194760034301</c:v>
                </c:pt>
                <c:pt idx="3037">
                  <c:v>0.85665610385657287</c:v>
                </c:pt>
                <c:pt idx="3038">
                  <c:v>0.39303589810318001</c:v>
                </c:pt>
                <c:pt idx="3039">
                  <c:v>1.1431845953964259</c:v>
                </c:pt>
                <c:pt idx="3040">
                  <c:v>1.9861972383676818E-2</c:v>
                </c:pt>
                <c:pt idx="3041">
                  <c:v>0.51834176372101071</c:v>
                </c:pt>
                <c:pt idx="3042">
                  <c:v>5.1425216985457656E-2</c:v>
                </c:pt>
                <c:pt idx="3043">
                  <c:v>0.26721164620707849</c:v>
                </c:pt>
                <c:pt idx="3044">
                  <c:v>1.2064293760133378</c:v>
                </c:pt>
                <c:pt idx="3045">
                  <c:v>1.5567383360519738</c:v>
                </c:pt>
                <c:pt idx="3046">
                  <c:v>0.24337766355782278</c:v>
                </c:pt>
                <c:pt idx="3047">
                  <c:v>0.41685955684592874</c:v>
                </c:pt>
                <c:pt idx="3048">
                  <c:v>8.7036553743967099E-2</c:v>
                </c:pt>
                <c:pt idx="3049">
                  <c:v>7.0503649289810177E-2</c:v>
                </c:pt>
                <c:pt idx="3050">
                  <c:v>0.67863529685037749</c:v>
                </c:pt>
                <c:pt idx="3051">
                  <c:v>2.6881593314564266E-2</c:v>
                </c:pt>
                <c:pt idx="3052">
                  <c:v>1.2646917200758108</c:v>
                </c:pt>
                <c:pt idx="3053">
                  <c:v>0.16484512407747279</c:v>
                </c:pt>
                <c:pt idx="3054">
                  <c:v>1.1667209856508235E-3</c:v>
                </c:pt>
                <c:pt idx="3055">
                  <c:v>0.16242179246326274</c:v>
                </c:pt>
                <c:pt idx="3056">
                  <c:v>0.75373264033759479</c:v>
                </c:pt>
                <c:pt idx="3057">
                  <c:v>0.89035863011273775</c:v>
                </c:pt>
                <c:pt idx="3058">
                  <c:v>0.53242145274448394</c:v>
                </c:pt>
                <c:pt idx="3059">
                  <c:v>0.27920329858654952</c:v>
                </c:pt>
                <c:pt idx="3060">
                  <c:v>1.1646911341372905</c:v>
                </c:pt>
                <c:pt idx="3061">
                  <c:v>0.80891754013007799</c:v>
                </c:pt>
                <c:pt idx="3062">
                  <c:v>0.82851675851518847</c:v>
                </c:pt>
                <c:pt idx="3063">
                  <c:v>0.77268235070966484</c:v>
                </c:pt>
                <c:pt idx="3064">
                  <c:v>0.2848998355399841</c:v>
                </c:pt>
                <c:pt idx="3065">
                  <c:v>1.0751003964720822</c:v>
                </c:pt>
                <c:pt idx="3066">
                  <c:v>6.0166605411533049E-2</c:v>
                </c:pt>
                <c:pt idx="3067">
                  <c:v>4.584788506015415E-2</c:v>
                </c:pt>
                <c:pt idx="3068">
                  <c:v>0.29815693710505231</c:v>
                </c:pt>
                <c:pt idx="3069">
                  <c:v>1.1871819273803521</c:v>
                </c:pt>
                <c:pt idx="3070">
                  <c:v>0.48002802601682731</c:v>
                </c:pt>
                <c:pt idx="3071">
                  <c:v>0.29223213951256671</c:v>
                </c:pt>
                <c:pt idx="3072">
                  <c:v>1.096628136068901</c:v>
                </c:pt>
                <c:pt idx="3073">
                  <c:v>0.48520376154698963</c:v>
                </c:pt>
                <c:pt idx="3074">
                  <c:v>0.56177325075274276</c:v>
                </c:pt>
                <c:pt idx="3075">
                  <c:v>0.8868902141452214</c:v>
                </c:pt>
                <c:pt idx="3076">
                  <c:v>0.14059719513556715</c:v>
                </c:pt>
                <c:pt idx="3077">
                  <c:v>0.12331570672627094</c:v>
                </c:pt>
                <c:pt idx="3078">
                  <c:v>0.12736686990978777</c:v>
                </c:pt>
                <c:pt idx="3079">
                  <c:v>6.0199287142795176E-2</c:v>
                </c:pt>
                <c:pt idx="3080">
                  <c:v>0.53011214798735684</c:v>
                </c:pt>
                <c:pt idx="3081">
                  <c:v>0.16796173054687275</c:v>
                </c:pt>
                <c:pt idx="3082">
                  <c:v>0.1613195420587144</c:v>
                </c:pt>
                <c:pt idx="3083">
                  <c:v>1.1051678568804677</c:v>
                </c:pt>
                <c:pt idx="3084">
                  <c:v>0.10454142116798605</c:v>
                </c:pt>
                <c:pt idx="3085">
                  <c:v>1.1542433565285597</c:v>
                </c:pt>
                <c:pt idx="3086">
                  <c:v>0.14635678306450164</c:v>
                </c:pt>
                <c:pt idx="3087">
                  <c:v>6.0857472982397444E-2</c:v>
                </c:pt>
                <c:pt idx="3088">
                  <c:v>0.69209911868999219</c:v>
                </c:pt>
                <c:pt idx="3089">
                  <c:v>0.14978976729658611</c:v>
                </c:pt>
                <c:pt idx="3090">
                  <c:v>0.15736376736572749</c:v>
                </c:pt>
                <c:pt idx="3091">
                  <c:v>0.33469623468590387</c:v>
                </c:pt>
                <c:pt idx="3092">
                  <c:v>0.498531723080476</c:v>
                </c:pt>
                <c:pt idx="3093">
                  <c:v>0.15833982873089258</c:v>
                </c:pt>
                <c:pt idx="3094">
                  <c:v>0.22600030472943275</c:v>
                </c:pt>
                <c:pt idx="3095">
                  <c:v>0.10103803833642185</c:v>
                </c:pt>
                <c:pt idx="3096">
                  <c:v>2.0159373978384191E-2</c:v>
                </c:pt>
                <c:pt idx="3097">
                  <c:v>0.8392995516399403</c:v>
                </c:pt>
                <c:pt idx="3098">
                  <c:v>0.23422544374509213</c:v>
                </c:pt>
                <c:pt idx="3099">
                  <c:v>0.56376249384860166</c:v>
                </c:pt>
                <c:pt idx="3100">
                  <c:v>0.58042136141900735</c:v>
                </c:pt>
                <c:pt idx="3101">
                  <c:v>0.22352600722043581</c:v>
                </c:pt>
                <c:pt idx="3102">
                  <c:v>0.12995077657498685</c:v>
                </c:pt>
                <c:pt idx="3103">
                  <c:v>0.16435500281090423</c:v>
                </c:pt>
                <c:pt idx="3104">
                  <c:v>1.2043994716429838</c:v>
                </c:pt>
                <c:pt idx="3105">
                  <c:v>8.0083029376237388E-2</c:v>
                </c:pt>
                <c:pt idx="3106">
                  <c:v>0.50798038904865062</c:v>
                </c:pt>
                <c:pt idx="3107">
                  <c:v>1.264915610929213</c:v>
                </c:pt>
                <c:pt idx="3108">
                  <c:v>0.36706551310864277</c:v>
                </c:pt>
                <c:pt idx="3109">
                  <c:v>2.4587816940751201E-2</c:v>
                </c:pt>
                <c:pt idx="3110">
                  <c:v>0.85706282150494073</c:v>
                </c:pt>
                <c:pt idx="3111">
                  <c:v>0.2328400155924179</c:v>
                </c:pt>
                <c:pt idx="3112">
                  <c:v>0.29351401637288704</c:v>
                </c:pt>
                <c:pt idx="3113">
                  <c:v>0.78692352681496069</c:v>
                </c:pt>
                <c:pt idx="3114">
                  <c:v>0.22771227939801605</c:v>
                </c:pt>
                <c:pt idx="3115">
                  <c:v>1.2297027569567602</c:v>
                </c:pt>
                <c:pt idx="3116">
                  <c:v>0.53302052335965555</c:v>
                </c:pt>
                <c:pt idx="3117">
                  <c:v>8.1368464799994045E-2</c:v>
                </c:pt>
                <c:pt idx="3118">
                  <c:v>0.76786175142838342</c:v>
                </c:pt>
                <c:pt idx="3119">
                  <c:v>0.16946687309599778</c:v>
                </c:pt>
                <c:pt idx="3120">
                  <c:v>6.4243628722491647E-3</c:v>
                </c:pt>
                <c:pt idx="3121">
                  <c:v>0.29186460402641462</c:v>
                </c:pt>
                <c:pt idx="3122">
                  <c:v>1.2615779333542168</c:v>
                </c:pt>
                <c:pt idx="3123">
                  <c:v>0.11067679855416461</c:v>
                </c:pt>
                <c:pt idx="3124">
                  <c:v>0.31671959473742595</c:v>
                </c:pt>
                <c:pt idx="3125">
                  <c:v>0.49173802275270506</c:v>
                </c:pt>
                <c:pt idx="3126">
                  <c:v>2.3655748480389494</c:v>
                </c:pt>
                <c:pt idx="3127">
                  <c:v>0.26988383533413607</c:v>
                </c:pt>
                <c:pt idx="3128">
                  <c:v>7.3649467874878513E-2</c:v>
                </c:pt>
                <c:pt idx="3129">
                  <c:v>0.43740147064987717</c:v>
                </c:pt>
                <c:pt idx="3130">
                  <c:v>0.52935293637739711</c:v>
                </c:pt>
                <c:pt idx="3131">
                  <c:v>0.3199625858211449</c:v>
                </c:pt>
                <c:pt idx="3132">
                  <c:v>1.48320335886995</c:v>
                </c:pt>
                <c:pt idx="3133">
                  <c:v>0.26868820894206225</c:v>
                </c:pt>
                <c:pt idx="3134">
                  <c:v>0.33454501594697877</c:v>
                </c:pt>
                <c:pt idx="3135">
                  <c:v>0.3160943018513277</c:v>
                </c:pt>
                <c:pt idx="3136">
                  <c:v>0.68225175497727442</c:v>
                </c:pt>
                <c:pt idx="3137">
                  <c:v>7.2068906056855855E-2</c:v>
                </c:pt>
                <c:pt idx="3138">
                  <c:v>0.88437005832862781</c:v>
                </c:pt>
                <c:pt idx="3139">
                  <c:v>0.15968584563934943</c:v>
                </c:pt>
                <c:pt idx="3140">
                  <c:v>0.38176142644984523</c:v>
                </c:pt>
                <c:pt idx="3141">
                  <c:v>0.3023225140406211</c:v>
                </c:pt>
                <c:pt idx="3142">
                  <c:v>0.7535595865470277</c:v>
                </c:pt>
                <c:pt idx="3143">
                  <c:v>1.0024659758646524</c:v>
                </c:pt>
                <c:pt idx="3144">
                  <c:v>0.45474791857394015</c:v>
                </c:pt>
                <c:pt idx="3145">
                  <c:v>0.49730334136475135</c:v>
                </c:pt>
                <c:pt idx="3146">
                  <c:v>3.8017918731895167E-2</c:v>
                </c:pt>
                <c:pt idx="3147">
                  <c:v>0.223214360892866</c:v>
                </c:pt>
                <c:pt idx="3148">
                  <c:v>0.26203841993436577</c:v>
                </c:pt>
                <c:pt idx="3149">
                  <c:v>0.88161300020808453</c:v>
                </c:pt>
                <c:pt idx="3150">
                  <c:v>0.83800331479748813</c:v>
                </c:pt>
                <c:pt idx="3151">
                  <c:v>0.86710072941944127</c:v>
                </c:pt>
                <c:pt idx="3152">
                  <c:v>0.46570914781283168</c:v>
                </c:pt>
                <c:pt idx="3153">
                  <c:v>0.7782202389328865</c:v>
                </c:pt>
                <c:pt idx="3154">
                  <c:v>0.5832557895090309</c:v>
                </c:pt>
                <c:pt idx="3155">
                  <c:v>0.75995828181246006</c:v>
                </c:pt>
                <c:pt idx="3156">
                  <c:v>0.56393484376461589</c:v>
                </c:pt>
                <c:pt idx="3157">
                  <c:v>1.1831505385011996</c:v>
                </c:pt>
                <c:pt idx="3158">
                  <c:v>1.1986698442208394</c:v>
                </c:pt>
                <c:pt idx="3159">
                  <c:v>0.64454060503383181</c:v>
                </c:pt>
                <c:pt idx="3160">
                  <c:v>0.28697203212978395</c:v>
                </c:pt>
                <c:pt idx="3161">
                  <c:v>0.30913013368844661</c:v>
                </c:pt>
                <c:pt idx="3162">
                  <c:v>0.36030287811819073</c:v>
                </c:pt>
                <c:pt idx="3163">
                  <c:v>1.0996214047229429</c:v>
                </c:pt>
                <c:pt idx="3164">
                  <c:v>0.25054856022174754</c:v>
                </c:pt>
                <c:pt idx="3165">
                  <c:v>0.11155709996568224</c:v>
                </c:pt>
                <c:pt idx="3166">
                  <c:v>1.1326081260222702</c:v>
                </c:pt>
                <c:pt idx="3167">
                  <c:v>1.1208914228495437</c:v>
                </c:pt>
                <c:pt idx="3168">
                  <c:v>0.1525091713168471</c:v>
                </c:pt>
                <c:pt idx="3169">
                  <c:v>0.87823519076128131</c:v>
                </c:pt>
                <c:pt idx="3170">
                  <c:v>9.8900699082577884E-2</c:v>
                </c:pt>
                <c:pt idx="3171">
                  <c:v>0.11188442689448083</c:v>
                </c:pt>
                <c:pt idx="3172">
                  <c:v>1.0381432193621727</c:v>
                </c:pt>
                <c:pt idx="3173">
                  <c:v>8.976506673008465E-2</c:v>
                </c:pt>
                <c:pt idx="3174">
                  <c:v>1.3811256131375298</c:v>
                </c:pt>
                <c:pt idx="3175">
                  <c:v>0.34940940234887774</c:v>
                </c:pt>
                <c:pt idx="3176">
                  <c:v>1.02798232926628</c:v>
                </c:pt>
                <c:pt idx="3177">
                  <c:v>0.89327106958128522</c:v>
                </c:pt>
                <c:pt idx="3178">
                  <c:v>0.80837715211743755</c:v>
                </c:pt>
                <c:pt idx="3179">
                  <c:v>7.7589175063177029E-2</c:v>
                </c:pt>
                <c:pt idx="3180">
                  <c:v>0.84458270563828453</c:v>
                </c:pt>
                <c:pt idx="3181">
                  <c:v>0.78572544320786741</c:v>
                </c:pt>
                <c:pt idx="3182">
                  <c:v>0.50511492656419632</c:v>
                </c:pt>
                <c:pt idx="3183">
                  <c:v>0.10387163800671399</c:v>
                </c:pt>
                <c:pt idx="3184">
                  <c:v>0.1450531825301748</c:v>
                </c:pt>
                <c:pt idx="3185">
                  <c:v>0.42871461342474415</c:v>
                </c:pt>
                <c:pt idx="3186">
                  <c:v>0.41554967699415973</c:v>
                </c:pt>
                <c:pt idx="3187">
                  <c:v>1.7956289273408399</c:v>
                </c:pt>
                <c:pt idx="3188">
                  <c:v>0.97064979401076856</c:v>
                </c:pt>
                <c:pt idx="3189">
                  <c:v>1.1518364893487669</c:v>
                </c:pt>
                <c:pt idx="3190">
                  <c:v>1.0887363602103697</c:v>
                </c:pt>
                <c:pt idx="3191">
                  <c:v>0.72010354418408007</c:v>
                </c:pt>
                <c:pt idx="3192">
                  <c:v>0.23891014176590636</c:v>
                </c:pt>
                <c:pt idx="3193">
                  <c:v>2.9784047802356352E-3</c:v>
                </c:pt>
                <c:pt idx="3194">
                  <c:v>0.17576062405044041</c:v>
                </c:pt>
                <c:pt idx="3195">
                  <c:v>0.24870994790057319</c:v>
                </c:pt>
                <c:pt idx="3196">
                  <c:v>0.64908962202726572</c:v>
                </c:pt>
                <c:pt idx="3197">
                  <c:v>3.1030550740059212E-2</c:v>
                </c:pt>
                <c:pt idx="3198">
                  <c:v>0.42259246449710686</c:v>
                </c:pt>
                <c:pt idx="3199">
                  <c:v>0.56248783120143586</c:v>
                </c:pt>
                <c:pt idx="3200">
                  <c:v>0.35834475427757417</c:v>
                </c:pt>
                <c:pt idx="3201">
                  <c:v>0.66566150493425158</c:v>
                </c:pt>
                <c:pt idx="3202">
                  <c:v>0.29347699462639371</c:v>
                </c:pt>
                <c:pt idx="3203">
                  <c:v>0.16952850402705261</c:v>
                </c:pt>
                <c:pt idx="3204">
                  <c:v>0.13585337398677896</c:v>
                </c:pt>
                <c:pt idx="3205">
                  <c:v>0.61271761142064518</c:v>
                </c:pt>
                <c:pt idx="3206">
                  <c:v>1.1503010472532516</c:v>
                </c:pt>
                <c:pt idx="3207">
                  <c:v>0.71964608994953394</c:v>
                </c:pt>
                <c:pt idx="3208">
                  <c:v>0.18819140039844648</c:v>
                </c:pt>
                <c:pt idx="3209">
                  <c:v>1.8673680497788184E-2</c:v>
                </c:pt>
                <c:pt idx="3210">
                  <c:v>0.61378384874349934</c:v>
                </c:pt>
                <c:pt idx="3211">
                  <c:v>0.33024006093858532</c:v>
                </c:pt>
                <c:pt idx="3212">
                  <c:v>0.42828663196743949</c:v>
                </c:pt>
                <c:pt idx="3213">
                  <c:v>0.17764945206062061</c:v>
                </c:pt>
                <c:pt idx="3214">
                  <c:v>1.2905590117068784</c:v>
                </c:pt>
                <c:pt idx="3215">
                  <c:v>0.21057183461152632</c:v>
                </c:pt>
                <c:pt idx="3216">
                  <c:v>7.7585619315421475E-2</c:v>
                </c:pt>
                <c:pt idx="3217">
                  <c:v>1.1340742809046234</c:v>
                </c:pt>
                <c:pt idx="3218">
                  <c:v>0.35984117357231288</c:v>
                </c:pt>
                <c:pt idx="3219">
                  <c:v>0.26929497016430781</c:v>
                </c:pt>
                <c:pt idx="3220">
                  <c:v>0.33136177006325701</c:v>
                </c:pt>
                <c:pt idx="3221">
                  <c:v>0.35857846203708676</c:v>
                </c:pt>
                <c:pt idx="3222">
                  <c:v>0.55925013265954793</c:v>
                </c:pt>
                <c:pt idx="3223">
                  <c:v>0.27767331301698217</c:v>
                </c:pt>
                <c:pt idx="3224">
                  <c:v>0.72193631049662987</c:v>
                </c:pt>
                <c:pt idx="3225">
                  <c:v>7.433657887219185E-3</c:v>
                </c:pt>
                <c:pt idx="3226">
                  <c:v>0.13308645854187523</c:v>
                </c:pt>
                <c:pt idx="3227">
                  <c:v>0.19167429586689028</c:v>
                </c:pt>
                <c:pt idx="3228">
                  <c:v>0.6794493326182921</c:v>
                </c:pt>
                <c:pt idx="3229">
                  <c:v>0.20486323673311768</c:v>
                </c:pt>
                <c:pt idx="3230">
                  <c:v>0.39726070971183097</c:v>
                </c:pt>
                <c:pt idx="3231">
                  <c:v>0.93495543610435838</c:v>
                </c:pt>
                <c:pt idx="3232">
                  <c:v>0.17775406645236297</c:v>
                </c:pt>
                <c:pt idx="3233">
                  <c:v>0.13025498054070009</c:v>
                </c:pt>
                <c:pt idx="3234">
                  <c:v>0.18142830775526028</c:v>
                </c:pt>
                <c:pt idx="3235">
                  <c:v>0.74094387471202872</c:v>
                </c:pt>
                <c:pt idx="3236">
                  <c:v>4.5224942125126838E-3</c:v>
                </c:pt>
                <c:pt idx="3237">
                  <c:v>0.15944996088856125</c:v>
                </c:pt>
                <c:pt idx="3238">
                  <c:v>0.45210342085669369</c:v>
                </c:pt>
                <c:pt idx="3239">
                  <c:v>0.31090619892815302</c:v>
                </c:pt>
                <c:pt idx="3240">
                  <c:v>0.17030379086044853</c:v>
                </c:pt>
                <c:pt idx="3241">
                  <c:v>1.0334842787108844</c:v>
                </c:pt>
                <c:pt idx="3242">
                  <c:v>5.0157928553016137E-2</c:v>
                </c:pt>
                <c:pt idx="3243">
                  <c:v>0.78368602832502599</c:v>
                </c:pt>
                <c:pt idx="3244">
                  <c:v>2.1882400780648563</c:v>
                </c:pt>
                <c:pt idx="3245">
                  <c:v>0.85982794904485349</c:v>
                </c:pt>
                <c:pt idx="3246">
                  <c:v>0.33407879638492544</c:v>
                </c:pt>
                <c:pt idx="3247">
                  <c:v>0.21536765504732081</c:v>
                </c:pt>
                <c:pt idx="3248">
                  <c:v>4.9594891867002985E-2</c:v>
                </c:pt>
                <c:pt idx="3249">
                  <c:v>0.51828466697475239</c:v>
                </c:pt>
                <c:pt idx="3250">
                  <c:v>0.17816030659146911</c:v>
                </c:pt>
                <c:pt idx="3251">
                  <c:v>1.1838695123540657</c:v>
                </c:pt>
                <c:pt idx="3252">
                  <c:v>0.53439494320617764</c:v>
                </c:pt>
                <c:pt idx="3253">
                  <c:v>3.9929903087103785E-2</c:v>
                </c:pt>
                <c:pt idx="3254">
                  <c:v>0.30873311700083045</c:v>
                </c:pt>
                <c:pt idx="3255">
                  <c:v>0.10239715916645249</c:v>
                </c:pt>
                <c:pt idx="3256">
                  <c:v>0.24082422228101691</c:v>
                </c:pt>
                <c:pt idx="3257">
                  <c:v>3.6312485421641873E-2</c:v>
                </c:pt>
                <c:pt idx="3258">
                  <c:v>1.88135235946966</c:v>
                </c:pt>
                <c:pt idx="3259">
                  <c:v>0.63955521882338251</c:v>
                </c:pt>
                <c:pt idx="3260">
                  <c:v>3.1513352838489647E-2</c:v>
                </c:pt>
                <c:pt idx="3261">
                  <c:v>0.17543302103288211</c:v>
                </c:pt>
                <c:pt idx="3262">
                  <c:v>0.8008697847314773</c:v>
                </c:pt>
                <c:pt idx="3263">
                  <c:v>0.2276308696358586</c:v>
                </c:pt>
                <c:pt idx="3264">
                  <c:v>0.41233171987553263</c:v>
                </c:pt>
                <c:pt idx="3265">
                  <c:v>0.58733062202458097</c:v>
                </c:pt>
                <c:pt idx="3266">
                  <c:v>0.60161639613756934</c:v>
                </c:pt>
                <c:pt idx="3267">
                  <c:v>0.68012916482808938</c:v>
                </c:pt>
                <c:pt idx="3268">
                  <c:v>0.55459552197411066</c:v>
                </c:pt>
                <c:pt idx="3269">
                  <c:v>0.98504670366506097</c:v>
                </c:pt>
                <c:pt idx="3270">
                  <c:v>8.5078255809118222E-2</c:v>
                </c:pt>
                <c:pt idx="3271">
                  <c:v>0.69773171780919019</c:v>
                </c:pt>
                <c:pt idx="3272">
                  <c:v>0.37561344055817492</c:v>
                </c:pt>
                <c:pt idx="3273">
                  <c:v>0.43130574421543194</c:v>
                </c:pt>
                <c:pt idx="3274">
                  <c:v>6.5176645700742745E-3</c:v>
                </c:pt>
                <c:pt idx="3275">
                  <c:v>7.7339461402423329E-2</c:v>
                </c:pt>
                <c:pt idx="3276">
                  <c:v>0.55291095093185438</c:v>
                </c:pt>
                <c:pt idx="3277">
                  <c:v>0.37562798078966231</c:v>
                </c:pt>
                <c:pt idx="3278">
                  <c:v>0.26303556208523043</c:v>
                </c:pt>
                <c:pt idx="3279">
                  <c:v>0.53387162848027936</c:v>
                </c:pt>
                <c:pt idx="3280">
                  <c:v>0.43384288515974534</c:v>
                </c:pt>
                <c:pt idx="3281">
                  <c:v>0.38102125313403423</c:v>
                </c:pt>
                <c:pt idx="3282">
                  <c:v>0.24676867165675739</c:v>
                </c:pt>
                <c:pt idx="3283">
                  <c:v>9.0435687257053837E-2</c:v>
                </c:pt>
                <c:pt idx="3284">
                  <c:v>1.2052896743650754</c:v>
                </c:pt>
                <c:pt idx="3285">
                  <c:v>5.3805124667727487E-2</c:v>
                </c:pt>
                <c:pt idx="3286">
                  <c:v>8.5812507746210478E-2</c:v>
                </c:pt>
                <c:pt idx="3287">
                  <c:v>1.0372942715975587E-2</c:v>
                </c:pt>
                <c:pt idx="3288">
                  <c:v>0.3028184053403275</c:v>
                </c:pt>
                <c:pt idx="3289">
                  <c:v>0.99727275919580638</c:v>
                </c:pt>
                <c:pt idx="3290">
                  <c:v>0.54012229330602102</c:v>
                </c:pt>
                <c:pt idx="3291">
                  <c:v>0.88065006067497198</c:v>
                </c:pt>
                <c:pt idx="3292">
                  <c:v>0.29538768899678597</c:v>
                </c:pt>
                <c:pt idx="3293">
                  <c:v>0.32868590024766231</c:v>
                </c:pt>
                <c:pt idx="3294">
                  <c:v>0.79663779370573029</c:v>
                </c:pt>
                <c:pt idx="3295">
                  <c:v>7.4747995713590504E-2</c:v>
                </c:pt>
                <c:pt idx="3296">
                  <c:v>0.1302343943664073</c:v>
                </c:pt>
                <c:pt idx="3297">
                  <c:v>0.55569084202885477</c:v>
                </c:pt>
                <c:pt idx="3298">
                  <c:v>0.55135075898056984</c:v>
                </c:pt>
                <c:pt idx="3299">
                  <c:v>0.65406166713175795</c:v>
                </c:pt>
                <c:pt idx="3300">
                  <c:v>0.5658776053507083</c:v>
                </c:pt>
                <c:pt idx="3301">
                  <c:v>0.31849013748414912</c:v>
                </c:pt>
                <c:pt idx="3302">
                  <c:v>0.79029914049393479</c:v>
                </c:pt>
                <c:pt idx="3303">
                  <c:v>0.11039662340008902</c:v>
                </c:pt>
                <c:pt idx="3304">
                  <c:v>0.91767390744686428</c:v>
                </c:pt>
                <c:pt idx="3305">
                  <c:v>0.61986040593342984</c:v>
                </c:pt>
                <c:pt idx="3306">
                  <c:v>0.45134670481443417</c:v>
                </c:pt>
                <c:pt idx="3307">
                  <c:v>0.87010484421013234</c:v>
                </c:pt>
                <c:pt idx="3308">
                  <c:v>0.65294106740435554</c:v>
                </c:pt>
                <c:pt idx="3309">
                  <c:v>1.0846509482819509</c:v>
                </c:pt>
                <c:pt idx="3310">
                  <c:v>0.64286225944322384</c:v>
                </c:pt>
                <c:pt idx="3311">
                  <c:v>1.1537819048392086</c:v>
                </c:pt>
                <c:pt idx="3312">
                  <c:v>1.9670205046076316E-2</c:v>
                </c:pt>
                <c:pt idx="3313">
                  <c:v>0.31939639722125318</c:v>
                </c:pt>
                <c:pt idx="3314">
                  <c:v>0.37629951561358788</c:v>
                </c:pt>
                <c:pt idx="3315">
                  <c:v>1.3083081637394483E-2</c:v>
                </c:pt>
                <c:pt idx="3316">
                  <c:v>0.74019507893575709</c:v>
                </c:pt>
                <c:pt idx="3317">
                  <c:v>1.3982029856365452</c:v>
                </c:pt>
                <c:pt idx="3318">
                  <c:v>0.19922678814201081</c:v>
                </c:pt>
                <c:pt idx="3319">
                  <c:v>0.5169547461068732</c:v>
                </c:pt>
                <c:pt idx="3320">
                  <c:v>1.0981793398105153E-2</c:v>
                </c:pt>
                <c:pt idx="3321">
                  <c:v>1.5857681769476957</c:v>
                </c:pt>
                <c:pt idx="3322">
                  <c:v>0.14678716325052274</c:v>
                </c:pt>
                <c:pt idx="3323">
                  <c:v>3.127214610357782</c:v>
                </c:pt>
                <c:pt idx="3324">
                  <c:v>0.1488737617991335</c:v>
                </c:pt>
                <c:pt idx="3325">
                  <c:v>0.30761555385888673</c:v>
                </c:pt>
                <c:pt idx="3326">
                  <c:v>0.20171655955857301</c:v>
                </c:pt>
                <c:pt idx="3327">
                  <c:v>0.88055773945187277</c:v>
                </c:pt>
                <c:pt idx="3328">
                  <c:v>6.0111824317716764E-2</c:v>
                </c:pt>
                <c:pt idx="3329">
                  <c:v>0.97235321432778432</c:v>
                </c:pt>
                <c:pt idx="3330">
                  <c:v>1.6417332334579873</c:v>
                </c:pt>
                <c:pt idx="3331">
                  <c:v>0.23476284804159225</c:v>
                </c:pt>
                <c:pt idx="3332">
                  <c:v>0.92968406972815998</c:v>
                </c:pt>
                <c:pt idx="3333">
                  <c:v>0.9676424817012611</c:v>
                </c:pt>
                <c:pt idx="3334">
                  <c:v>0.81898611821162626</c:v>
                </c:pt>
                <c:pt idx="3335">
                  <c:v>0.27822893068716986</c:v>
                </c:pt>
                <c:pt idx="3336">
                  <c:v>0.39077205758044847</c:v>
                </c:pt>
                <c:pt idx="3337">
                  <c:v>0.71492155157786963</c:v>
                </c:pt>
                <c:pt idx="3338">
                  <c:v>0.20593829604226374</c:v>
                </c:pt>
                <c:pt idx="3339">
                  <c:v>1.0892749517568538</c:v>
                </c:pt>
                <c:pt idx="3340">
                  <c:v>0.247819088268427</c:v>
                </c:pt>
                <c:pt idx="3341">
                  <c:v>0.27647838096454896</c:v>
                </c:pt>
                <c:pt idx="3342">
                  <c:v>0.73743669032455128</c:v>
                </c:pt>
                <c:pt idx="3343">
                  <c:v>0.72715403322318273</c:v>
                </c:pt>
                <c:pt idx="3344">
                  <c:v>0.40476449115089796</c:v>
                </c:pt>
                <c:pt idx="3345">
                  <c:v>4.5633256490545733E-2</c:v>
                </c:pt>
                <c:pt idx="3346">
                  <c:v>0.23852273322509715</c:v>
                </c:pt>
                <c:pt idx="3347">
                  <c:v>0.73270083062681768</c:v>
                </c:pt>
                <c:pt idx="3348">
                  <c:v>0.97069674018888141</c:v>
                </c:pt>
                <c:pt idx="3349">
                  <c:v>0.61271528128012209</c:v>
                </c:pt>
                <c:pt idx="3350">
                  <c:v>0.16330752636051829</c:v>
                </c:pt>
                <c:pt idx="3351">
                  <c:v>3.1593701850179325E-2</c:v>
                </c:pt>
                <c:pt idx="3352">
                  <c:v>2.7627218539382863E-2</c:v>
                </c:pt>
                <c:pt idx="3353">
                  <c:v>7.8163282699769288E-3</c:v>
                </c:pt>
                <c:pt idx="3354">
                  <c:v>0.78153317199850547</c:v>
                </c:pt>
                <c:pt idx="3355">
                  <c:v>0.79132075567304039</c:v>
                </c:pt>
                <c:pt idx="3356">
                  <c:v>0.12788148858915205</c:v>
                </c:pt>
                <c:pt idx="3357">
                  <c:v>0.68836279825344471</c:v>
                </c:pt>
                <c:pt idx="3358">
                  <c:v>1.1308342789261141</c:v>
                </c:pt>
                <c:pt idx="3359">
                  <c:v>0.14981001353706996</c:v>
                </c:pt>
                <c:pt idx="3360">
                  <c:v>0.73643549104673589</c:v>
                </c:pt>
                <c:pt idx="3361">
                  <c:v>2.4399770607393165E-2</c:v>
                </c:pt>
                <c:pt idx="3362">
                  <c:v>0.41714022563503522</c:v>
                </c:pt>
                <c:pt idx="3363">
                  <c:v>0.82230501990409977</c:v>
                </c:pt>
                <c:pt idx="3364">
                  <c:v>0.85696075077355005</c:v>
                </c:pt>
                <c:pt idx="3365">
                  <c:v>0.33782518382454052</c:v>
                </c:pt>
                <c:pt idx="3366">
                  <c:v>0.35944801709404017</c:v>
                </c:pt>
                <c:pt idx="3367">
                  <c:v>0.11216942176264218</c:v>
                </c:pt>
                <c:pt idx="3368">
                  <c:v>0.19861868090241291</c:v>
                </c:pt>
                <c:pt idx="3369">
                  <c:v>0.68058703144199528</c:v>
                </c:pt>
                <c:pt idx="3370">
                  <c:v>0.35107105816462642</c:v>
                </c:pt>
                <c:pt idx="3371">
                  <c:v>0.75254418007389079</c:v>
                </c:pt>
                <c:pt idx="3372">
                  <c:v>1.1303778572048795</c:v>
                </c:pt>
                <c:pt idx="3373">
                  <c:v>0.38875845178542284</c:v>
                </c:pt>
                <c:pt idx="3374">
                  <c:v>0.3732598848633506</c:v>
                </c:pt>
                <c:pt idx="3375">
                  <c:v>1.1878349113841886</c:v>
                </c:pt>
                <c:pt idx="3376">
                  <c:v>1.4101400502665373E-2</c:v>
                </c:pt>
                <c:pt idx="3377">
                  <c:v>0.79590585490984311</c:v>
                </c:pt>
                <c:pt idx="3378">
                  <c:v>0.15686025534328796</c:v>
                </c:pt>
                <c:pt idx="3379">
                  <c:v>1.7739933965025898</c:v>
                </c:pt>
                <c:pt idx="3380">
                  <c:v>0.37696998912464347</c:v>
                </c:pt>
                <c:pt idx="3381">
                  <c:v>1.1512202722634621</c:v>
                </c:pt>
                <c:pt idx="3382">
                  <c:v>1.1917525721368629</c:v>
                </c:pt>
                <c:pt idx="3383">
                  <c:v>0.60626033552006797</c:v>
                </c:pt>
                <c:pt idx="3384">
                  <c:v>0.42520689120281485</c:v>
                </c:pt>
                <c:pt idx="3385">
                  <c:v>0.34342057447194119</c:v>
                </c:pt>
                <c:pt idx="3386">
                  <c:v>0.27638069423141248</c:v>
                </c:pt>
                <c:pt idx="3387">
                  <c:v>0.92640793623278506</c:v>
                </c:pt>
                <c:pt idx="3388">
                  <c:v>0.57073869309287484</c:v>
                </c:pt>
                <c:pt idx="3389">
                  <c:v>1.3532383586244832</c:v>
                </c:pt>
                <c:pt idx="3390">
                  <c:v>0.51032957274219271</c:v>
                </c:pt>
                <c:pt idx="3391">
                  <c:v>0.33064844618317496</c:v>
                </c:pt>
                <c:pt idx="3392">
                  <c:v>0.20069559063486003</c:v>
                </c:pt>
                <c:pt idx="3393">
                  <c:v>0.41623048587344902</c:v>
                </c:pt>
                <c:pt idx="3394">
                  <c:v>0.35068304989543253</c:v>
                </c:pt>
                <c:pt idx="3395">
                  <c:v>0.25359310201908253</c:v>
                </c:pt>
                <c:pt idx="3396">
                  <c:v>0.27445750363068599</c:v>
                </c:pt>
                <c:pt idx="3397">
                  <c:v>0.68607205026286555</c:v>
                </c:pt>
                <c:pt idx="3398">
                  <c:v>1.8889202097466112E-2</c:v>
                </c:pt>
                <c:pt idx="3399">
                  <c:v>0.16703582545555484</c:v>
                </c:pt>
                <c:pt idx="3400">
                  <c:v>0.87399405763755023</c:v>
                </c:pt>
                <c:pt idx="3401">
                  <c:v>0.38939459503712642</c:v>
                </c:pt>
                <c:pt idx="3402">
                  <c:v>0.36047882548067867</c:v>
                </c:pt>
                <c:pt idx="3403">
                  <c:v>4.5352309530961093E-3</c:v>
                </c:pt>
                <c:pt idx="3404">
                  <c:v>0.76405724341799508</c:v>
                </c:pt>
                <c:pt idx="3405">
                  <c:v>0.14973907506250034</c:v>
                </c:pt>
                <c:pt idx="3406">
                  <c:v>1.2438772750281422</c:v>
                </c:pt>
                <c:pt idx="3407">
                  <c:v>0.61571226613459351</c:v>
                </c:pt>
                <c:pt idx="3408">
                  <c:v>0.90703902163646888</c:v>
                </c:pt>
                <c:pt idx="3409">
                  <c:v>1.0576856363516094</c:v>
                </c:pt>
                <c:pt idx="3410">
                  <c:v>7.3568603802635107E-2</c:v>
                </c:pt>
                <c:pt idx="3411">
                  <c:v>0.67742981917541578</c:v>
                </c:pt>
                <c:pt idx="3412">
                  <c:v>0.44458163814388896</c:v>
                </c:pt>
                <c:pt idx="3413">
                  <c:v>1.5659529424809804</c:v>
                </c:pt>
                <c:pt idx="3414">
                  <c:v>7.5244022542905811E-2</c:v>
                </c:pt>
                <c:pt idx="3415">
                  <c:v>8.393981534383782E-2</c:v>
                </c:pt>
                <c:pt idx="3416">
                  <c:v>0.16615740512896501</c:v>
                </c:pt>
                <c:pt idx="3417">
                  <c:v>0.34664219419160597</c:v>
                </c:pt>
                <c:pt idx="3418">
                  <c:v>0.46113448119590372</c:v>
                </c:pt>
                <c:pt idx="3419">
                  <c:v>0.7387153398986821</c:v>
                </c:pt>
                <c:pt idx="3420">
                  <c:v>0.28836879194062826</c:v>
                </c:pt>
                <c:pt idx="3421">
                  <c:v>1.2590261464179766</c:v>
                </c:pt>
                <c:pt idx="3422">
                  <c:v>1.1942564573190497</c:v>
                </c:pt>
                <c:pt idx="3423">
                  <c:v>0.50035378007216202</c:v>
                </c:pt>
                <c:pt idx="3424">
                  <c:v>8.507469958911823E-2</c:v>
                </c:pt>
                <c:pt idx="3425">
                  <c:v>0.22287351419848589</c:v>
                </c:pt>
                <c:pt idx="3426">
                  <c:v>0.10942488436768644</c:v>
                </c:pt>
                <c:pt idx="3427">
                  <c:v>0.19945242711539934</c:v>
                </c:pt>
                <c:pt idx="3428">
                  <c:v>0.11193417067813947</c:v>
                </c:pt>
                <c:pt idx="3429">
                  <c:v>0.75884622147260861</c:v>
                </c:pt>
                <c:pt idx="3430">
                  <c:v>0.6658525456256198</c:v>
                </c:pt>
                <c:pt idx="3431">
                  <c:v>0.59219344100914806</c:v>
                </c:pt>
                <c:pt idx="3432">
                  <c:v>0.95340475262564095</c:v>
                </c:pt>
                <c:pt idx="3433">
                  <c:v>1.0684773216442918</c:v>
                </c:pt>
                <c:pt idx="3434">
                  <c:v>0.59200566514921582</c:v>
                </c:pt>
                <c:pt idx="3435">
                  <c:v>0.96908902920275586</c:v>
                </c:pt>
                <c:pt idx="3436">
                  <c:v>0.50065771830276484</c:v>
                </c:pt>
                <c:pt idx="3437">
                  <c:v>1.3943937039092923E-2</c:v>
                </c:pt>
                <c:pt idx="3438">
                  <c:v>0.59625820845372646</c:v>
                </c:pt>
                <c:pt idx="3439">
                  <c:v>0.662068690894929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750-49E9-BA33-867EEA30340D}"/>
            </c:ext>
          </c:extLst>
        </c:ser>
        <c:ser>
          <c:idx val="1"/>
          <c:order val="1"/>
          <c:tx>
            <c:v>dow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- NC Prot'!$E$2:$E$72</c:f>
              <c:numCache>
                <c:formatCode>General</c:formatCode>
                <c:ptCount val="71"/>
                <c:pt idx="0">
                  <c:v>-0.78115684879812641</c:v>
                </c:pt>
                <c:pt idx="1">
                  <c:v>-1.6330763510214819</c:v>
                </c:pt>
                <c:pt idx="2">
                  <c:v>-0.86197195523323877</c:v>
                </c:pt>
                <c:pt idx="3">
                  <c:v>-1.3309732344903693</c:v>
                </c:pt>
                <c:pt idx="4">
                  <c:v>-0.82418800627826927</c:v>
                </c:pt>
                <c:pt idx="5">
                  <c:v>-0.96550253580055512</c:v>
                </c:pt>
                <c:pt idx="6">
                  <c:v>-0.64453261162390074</c:v>
                </c:pt>
                <c:pt idx="7">
                  <c:v>-0.72977009276200233</c:v>
                </c:pt>
                <c:pt idx="8">
                  <c:v>-0.62171034690454918</c:v>
                </c:pt>
                <c:pt idx="9">
                  <c:v>-0.96804025860245513</c:v>
                </c:pt>
                <c:pt idx="10">
                  <c:v>-1.1814766179337017</c:v>
                </c:pt>
                <c:pt idx="11">
                  <c:v>-0.84166297283289937</c:v>
                </c:pt>
                <c:pt idx="12">
                  <c:v>-0.70228032795648698</c:v>
                </c:pt>
                <c:pt idx="13">
                  <c:v>-1.3673595241343683</c:v>
                </c:pt>
                <c:pt idx="14">
                  <c:v>-1.1162228024837937</c:v>
                </c:pt>
                <c:pt idx="15">
                  <c:v>-0.75049397901085313</c:v>
                </c:pt>
                <c:pt idx="16">
                  <c:v>-0.73240427814812081</c:v>
                </c:pt>
                <c:pt idx="17">
                  <c:v>-2.2062289414557759</c:v>
                </c:pt>
                <c:pt idx="18">
                  <c:v>-0.75025128491643112</c:v>
                </c:pt>
                <c:pt idx="19">
                  <c:v>-0.63643640620281083</c:v>
                </c:pt>
                <c:pt idx="20">
                  <c:v>-1.1999180747615488</c:v>
                </c:pt>
                <c:pt idx="21">
                  <c:v>-0.82700052740823782</c:v>
                </c:pt>
                <c:pt idx="22">
                  <c:v>-0.7280962937367248</c:v>
                </c:pt>
                <c:pt idx="23">
                  <c:v>-1.4461480318188744</c:v>
                </c:pt>
                <c:pt idx="24">
                  <c:v>-0.63173451706250738</c:v>
                </c:pt>
                <c:pt idx="25">
                  <c:v>-1.0267928458865443</c:v>
                </c:pt>
                <c:pt idx="26">
                  <c:v>-1.5994620704162712</c:v>
                </c:pt>
                <c:pt idx="27">
                  <c:v>-1.0706634659931111</c:v>
                </c:pt>
                <c:pt idx="28">
                  <c:v>-0.88816741292201729</c:v>
                </c:pt>
                <c:pt idx="29">
                  <c:v>-0.64769344709366428</c:v>
                </c:pt>
                <c:pt idx="30">
                  <c:v>-1.0014434168696689</c:v>
                </c:pt>
                <c:pt idx="31">
                  <c:v>-0.69478822392181161</c:v>
                </c:pt>
                <c:pt idx="32">
                  <c:v>-2.0110063596570185</c:v>
                </c:pt>
                <c:pt idx="33">
                  <c:v>-0.97284594849627337</c:v>
                </c:pt>
                <c:pt idx="34">
                  <c:v>-1.7504939790108531</c:v>
                </c:pt>
                <c:pt idx="35">
                  <c:v>-3.5311560570253624</c:v>
                </c:pt>
                <c:pt idx="36">
                  <c:v>-4.061300186760664</c:v>
                </c:pt>
                <c:pt idx="37">
                  <c:v>-1.1632679195408642</c:v>
                </c:pt>
                <c:pt idx="38">
                  <c:v>-1.3061450976464348</c:v>
                </c:pt>
                <c:pt idx="39">
                  <c:v>-0.80540859722626634</c:v>
                </c:pt>
                <c:pt idx="40">
                  <c:v>-0.96888715914975065</c:v>
                </c:pt>
                <c:pt idx="41">
                  <c:v>-0.93649705769384195</c:v>
                </c:pt>
                <c:pt idx="42">
                  <c:v>-3.4787482046301883</c:v>
                </c:pt>
                <c:pt idx="43">
                  <c:v>-1.0819191301522921</c:v>
                </c:pt>
                <c:pt idx="44">
                  <c:v>-6.0685438590872876</c:v>
                </c:pt>
                <c:pt idx="45">
                  <c:v>-1.1328942704973453</c:v>
                </c:pt>
                <c:pt idx="46">
                  <c:v>-2.3496030533302106</c:v>
                </c:pt>
                <c:pt idx="47">
                  <c:v>-0.83058804800864539</c:v>
                </c:pt>
                <c:pt idx="48">
                  <c:v>-0.67185288596636872</c:v>
                </c:pt>
                <c:pt idx="49">
                  <c:v>-0.94730588869615495</c:v>
                </c:pt>
                <c:pt idx="50">
                  <c:v>-0.61949218066055423</c:v>
                </c:pt>
                <c:pt idx="51">
                  <c:v>-1.0484122051852458</c:v>
                </c:pt>
                <c:pt idx="52">
                  <c:v>-1.5610684580654552</c:v>
                </c:pt>
                <c:pt idx="53">
                  <c:v>-0.9919434451289415</c:v>
                </c:pt>
                <c:pt idx="54">
                  <c:v>-0.71501215306215726</c:v>
                </c:pt>
                <c:pt idx="55">
                  <c:v>-3.2243172982609405</c:v>
                </c:pt>
                <c:pt idx="56">
                  <c:v>-4.3868455715687009</c:v>
                </c:pt>
                <c:pt idx="57">
                  <c:v>-3.954557029238833</c:v>
                </c:pt>
                <c:pt idx="58">
                  <c:v>-1.9467496152977499</c:v>
                </c:pt>
                <c:pt idx="59">
                  <c:v>-0.67070415189748489</c:v>
                </c:pt>
                <c:pt idx="60">
                  <c:v>-2.9224835302979049</c:v>
                </c:pt>
                <c:pt idx="61">
                  <c:v>-0.92961067210860204</c:v>
                </c:pt>
                <c:pt idx="62">
                  <c:v>-1.3397102485717789</c:v>
                </c:pt>
                <c:pt idx="63">
                  <c:v>-2.2317521450971554</c:v>
                </c:pt>
                <c:pt idx="64">
                  <c:v>-0.70981154266247926</c:v>
                </c:pt>
                <c:pt idx="65">
                  <c:v>-0.83830576456386852</c:v>
                </c:pt>
                <c:pt idx="66">
                  <c:v>-1.9050883529745331</c:v>
                </c:pt>
                <c:pt idx="67">
                  <c:v>-3.3658714424749592</c:v>
                </c:pt>
                <c:pt idx="68">
                  <c:v>-4.1923153567568932</c:v>
                </c:pt>
                <c:pt idx="69">
                  <c:v>-1.1507212674692198</c:v>
                </c:pt>
                <c:pt idx="70">
                  <c:v>-2.1850804906944812</c:v>
                </c:pt>
              </c:numCache>
            </c:numRef>
          </c:xVal>
          <c:yVal>
            <c:numRef>
              <c:f>'HFD - NC Prot'!$F$2:$F$72</c:f>
              <c:numCache>
                <c:formatCode>General</c:formatCode>
                <c:ptCount val="71"/>
                <c:pt idx="0">
                  <c:v>1.5929384573700258</c:v>
                </c:pt>
                <c:pt idx="1">
                  <c:v>2.1779390279877573</c:v>
                </c:pt>
                <c:pt idx="2">
                  <c:v>1.6150379219192814</c:v>
                </c:pt>
                <c:pt idx="3">
                  <c:v>2.0061638727749989</c:v>
                </c:pt>
                <c:pt idx="4">
                  <c:v>1.5108955096087542</c:v>
                </c:pt>
                <c:pt idx="5">
                  <c:v>1.4648575714736312</c:v>
                </c:pt>
                <c:pt idx="6">
                  <c:v>1.8139568418670391</c:v>
                </c:pt>
                <c:pt idx="7">
                  <c:v>1.9773739152062195</c:v>
                </c:pt>
                <c:pt idx="8">
                  <c:v>1.5219831712366392</c:v>
                </c:pt>
                <c:pt idx="9">
                  <c:v>1.5364883406024101</c:v>
                </c:pt>
                <c:pt idx="10">
                  <c:v>1.7839989716709339</c:v>
                </c:pt>
                <c:pt idx="11">
                  <c:v>1.6900438212618445</c:v>
                </c:pt>
                <c:pt idx="12">
                  <c:v>2.5981725927565282</c:v>
                </c:pt>
                <c:pt idx="13">
                  <c:v>1.6757179691922097</c:v>
                </c:pt>
                <c:pt idx="14">
                  <c:v>1.6482390780295044</c:v>
                </c:pt>
                <c:pt idx="15">
                  <c:v>1.7592195665774146</c:v>
                </c:pt>
                <c:pt idx="16">
                  <c:v>1.4865985253748468</c:v>
                </c:pt>
                <c:pt idx="17">
                  <c:v>1.349651992607134</c:v>
                </c:pt>
                <c:pt idx="18">
                  <c:v>1.4741084053760445</c:v>
                </c:pt>
                <c:pt idx="19">
                  <c:v>2.0717013648393969</c:v>
                </c:pt>
                <c:pt idx="20">
                  <c:v>1.7277898438363251</c:v>
                </c:pt>
                <c:pt idx="21">
                  <c:v>1.5153638386614889</c:v>
                </c:pt>
                <c:pt idx="22">
                  <c:v>1.6035453714583405</c:v>
                </c:pt>
                <c:pt idx="23">
                  <c:v>1.9404524569347124</c:v>
                </c:pt>
                <c:pt idx="24">
                  <c:v>1.625367417537531</c:v>
                </c:pt>
                <c:pt idx="25">
                  <c:v>1.5016563356689203</c:v>
                </c:pt>
                <c:pt idx="26">
                  <c:v>3.3468198037659636</c:v>
                </c:pt>
                <c:pt idx="27">
                  <c:v>1.7562841796812694</c:v>
                </c:pt>
                <c:pt idx="28">
                  <c:v>1.4053138000902428</c:v>
                </c:pt>
                <c:pt idx="29">
                  <c:v>1.3512242226232352</c:v>
                </c:pt>
                <c:pt idx="30">
                  <c:v>1.4443055598787178</c:v>
                </c:pt>
                <c:pt idx="31">
                  <c:v>1.5094088969765953</c:v>
                </c:pt>
                <c:pt idx="32">
                  <c:v>2.5740201665739084</c:v>
                </c:pt>
                <c:pt idx="33">
                  <c:v>2.2825594363679418</c:v>
                </c:pt>
                <c:pt idx="34">
                  <c:v>1.3505729186949642</c:v>
                </c:pt>
                <c:pt idx="35">
                  <c:v>3.0932262156759598</c:v>
                </c:pt>
                <c:pt idx="36">
                  <c:v>2.0776593054109145</c:v>
                </c:pt>
                <c:pt idx="37">
                  <c:v>1.7770150155218278</c:v>
                </c:pt>
                <c:pt idx="38">
                  <c:v>2.6668253132866919</c:v>
                </c:pt>
                <c:pt idx="39">
                  <c:v>1.3908782285807828</c:v>
                </c:pt>
                <c:pt idx="40">
                  <c:v>2.0586548573394876</c:v>
                </c:pt>
                <c:pt idx="41">
                  <c:v>1.5117050654509199</c:v>
                </c:pt>
                <c:pt idx="42">
                  <c:v>1.9330218197607649</c:v>
                </c:pt>
                <c:pt idx="43">
                  <c:v>1.301210930273673</c:v>
                </c:pt>
                <c:pt idx="44">
                  <c:v>2.5313780271162569</c:v>
                </c:pt>
                <c:pt idx="45">
                  <c:v>2.4646160916051278</c:v>
                </c:pt>
                <c:pt idx="46">
                  <c:v>2.0769394427206369</c:v>
                </c:pt>
                <c:pt idx="47">
                  <c:v>1.9236931014786296</c:v>
                </c:pt>
                <c:pt idx="48">
                  <c:v>1.3343152345090663</c:v>
                </c:pt>
                <c:pt idx="49">
                  <c:v>1.4628818450754271</c:v>
                </c:pt>
                <c:pt idx="50">
                  <c:v>1.8527007151263439</c:v>
                </c:pt>
                <c:pt idx="51">
                  <c:v>3.0912612930037571</c:v>
                </c:pt>
                <c:pt idx="52">
                  <c:v>2.1709296902597535</c:v>
                </c:pt>
                <c:pt idx="53">
                  <c:v>2.5854394575298927</c:v>
                </c:pt>
                <c:pt idx="54">
                  <c:v>1.8915193435307049</c:v>
                </c:pt>
                <c:pt idx="55">
                  <c:v>3.2023578712535934</c:v>
                </c:pt>
                <c:pt idx="56">
                  <c:v>2.9603459213733623</c:v>
                </c:pt>
                <c:pt idx="57">
                  <c:v>1.6619581737386686</c:v>
                </c:pt>
                <c:pt idx="58">
                  <c:v>2.6686554212468847</c:v>
                </c:pt>
                <c:pt idx="59">
                  <c:v>1.323319265774596</c:v>
                </c:pt>
                <c:pt idx="60">
                  <c:v>2.1958699957452379</c:v>
                </c:pt>
                <c:pt idx="61">
                  <c:v>1.802966074681704</c:v>
                </c:pt>
                <c:pt idx="62">
                  <c:v>2.5607167980221752</c:v>
                </c:pt>
                <c:pt idx="63">
                  <c:v>2.7252158451440613</c:v>
                </c:pt>
                <c:pt idx="64">
                  <c:v>3.1667424949572505</c:v>
                </c:pt>
                <c:pt idx="65">
                  <c:v>1.7490142377689506</c:v>
                </c:pt>
                <c:pt idx="66">
                  <c:v>3.1615594639151414</c:v>
                </c:pt>
                <c:pt idx="67">
                  <c:v>2.9508435242691711</c:v>
                </c:pt>
                <c:pt idx="68">
                  <c:v>3.7529104724137565</c:v>
                </c:pt>
                <c:pt idx="69">
                  <c:v>1.484489493054165</c:v>
                </c:pt>
                <c:pt idx="70">
                  <c:v>2.34088659212915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750-49E9-BA33-867EEA30340D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HFD - NC Prot'!$I$2:$I$122</c:f>
              <c:numCache>
                <c:formatCode>General</c:formatCode>
                <c:ptCount val="121"/>
                <c:pt idx="0">
                  <c:v>0.90681364982109858</c:v>
                </c:pt>
                <c:pt idx="1">
                  <c:v>1.1847880844869729</c:v>
                </c:pt>
                <c:pt idx="2">
                  <c:v>1.1475672070946326</c:v>
                </c:pt>
                <c:pt idx="3">
                  <c:v>1.4902106954511503</c:v>
                </c:pt>
                <c:pt idx="4">
                  <c:v>0.76400637762866497</c:v>
                </c:pt>
                <c:pt idx="5">
                  <c:v>0.90727526299938266</c:v>
                </c:pt>
                <c:pt idx="6">
                  <c:v>1.4442960101174247</c:v>
                </c:pt>
                <c:pt idx="7">
                  <c:v>1.4290535047666271</c:v>
                </c:pt>
                <c:pt idx="8">
                  <c:v>0.63189585905380441</c:v>
                </c:pt>
                <c:pt idx="9">
                  <c:v>0.68562624125091121</c:v>
                </c:pt>
                <c:pt idx="10">
                  <c:v>1.0714881055841825</c:v>
                </c:pt>
                <c:pt idx="11">
                  <c:v>1.8800585561702829</c:v>
                </c:pt>
                <c:pt idx="12">
                  <c:v>0.86916073840011732</c:v>
                </c:pt>
                <c:pt idx="13">
                  <c:v>0.63087138301257606</c:v>
                </c:pt>
                <c:pt idx="14">
                  <c:v>0.92615127319989665</c:v>
                </c:pt>
                <c:pt idx="15">
                  <c:v>2.0449885621046051</c:v>
                </c:pt>
                <c:pt idx="16">
                  <c:v>0.92804810883680111</c:v>
                </c:pt>
                <c:pt idx="17">
                  <c:v>1.0890913185646893</c:v>
                </c:pt>
                <c:pt idx="18">
                  <c:v>0.62695304177066524</c:v>
                </c:pt>
                <c:pt idx="19">
                  <c:v>1.1788102334832464</c:v>
                </c:pt>
                <c:pt idx="20">
                  <c:v>0.60445093031251629</c:v>
                </c:pt>
                <c:pt idx="21">
                  <c:v>0.75505847811068083</c:v>
                </c:pt>
                <c:pt idx="22">
                  <c:v>0.70778980545031278</c:v>
                </c:pt>
                <c:pt idx="23">
                  <c:v>2.8957291616449643</c:v>
                </c:pt>
                <c:pt idx="24">
                  <c:v>0.85606940201504989</c:v>
                </c:pt>
                <c:pt idx="25">
                  <c:v>0.71826297695093266</c:v>
                </c:pt>
                <c:pt idx="26">
                  <c:v>0.67870294616286009</c:v>
                </c:pt>
                <c:pt idx="27">
                  <c:v>1.6045458163687107</c:v>
                </c:pt>
                <c:pt idx="28">
                  <c:v>0.74751630186484652</c:v>
                </c:pt>
                <c:pt idx="29">
                  <c:v>1.197865391353738</c:v>
                </c:pt>
                <c:pt idx="30">
                  <c:v>0.95991849668924845</c:v>
                </c:pt>
                <c:pt idx="31">
                  <c:v>0.69501387263258196</c:v>
                </c:pt>
                <c:pt idx="32">
                  <c:v>0.68284293477306923</c:v>
                </c:pt>
                <c:pt idx="33">
                  <c:v>0.64330208848476567</c:v>
                </c:pt>
                <c:pt idx="34">
                  <c:v>0.864334740782428</c:v>
                </c:pt>
                <c:pt idx="35">
                  <c:v>0.91968331339746368</c:v>
                </c:pt>
                <c:pt idx="36">
                  <c:v>1.4137023887821767</c:v>
                </c:pt>
                <c:pt idx="37">
                  <c:v>1.1005067613155757</c:v>
                </c:pt>
                <c:pt idx="38">
                  <c:v>1.5509006646475234</c:v>
                </c:pt>
                <c:pt idx="39">
                  <c:v>1.1040682264637167</c:v>
                </c:pt>
                <c:pt idx="40">
                  <c:v>1.1154994125575262</c:v>
                </c:pt>
                <c:pt idx="41">
                  <c:v>2.226446874857031</c:v>
                </c:pt>
                <c:pt idx="42">
                  <c:v>0.98702975054898157</c:v>
                </c:pt>
                <c:pt idx="43">
                  <c:v>0.78559239870423048</c:v>
                </c:pt>
                <c:pt idx="44">
                  <c:v>1.8110188330179837</c:v>
                </c:pt>
                <c:pt idx="45">
                  <c:v>0.83745889932574979</c:v>
                </c:pt>
                <c:pt idx="46">
                  <c:v>0.71992814773245228</c:v>
                </c:pt>
                <c:pt idx="47">
                  <c:v>0.77963794479866722</c:v>
                </c:pt>
                <c:pt idx="48">
                  <c:v>0.79975046170089004</c:v>
                </c:pt>
                <c:pt idx="49">
                  <c:v>0.61485116242210358</c:v>
                </c:pt>
                <c:pt idx="50">
                  <c:v>0.70283482221159199</c:v>
                </c:pt>
                <c:pt idx="51">
                  <c:v>0.77213903122135341</c:v>
                </c:pt>
                <c:pt idx="52">
                  <c:v>0.89600053074346087</c:v>
                </c:pt>
                <c:pt idx="53">
                  <c:v>0.8204036478624358</c:v>
                </c:pt>
                <c:pt idx="54">
                  <c:v>1.0037461392328946</c:v>
                </c:pt>
                <c:pt idx="55">
                  <c:v>0.70088355602826879</c:v>
                </c:pt>
                <c:pt idx="56">
                  <c:v>0.82056703348445525</c:v>
                </c:pt>
                <c:pt idx="57">
                  <c:v>1.3467016480228557</c:v>
                </c:pt>
                <c:pt idx="58">
                  <c:v>0.61107792883176204</c:v>
                </c:pt>
                <c:pt idx="59">
                  <c:v>1.9136075118230995</c:v>
                </c:pt>
                <c:pt idx="60">
                  <c:v>1.111765831182226</c:v>
                </c:pt>
                <c:pt idx="61">
                  <c:v>0.9074291012423189</c:v>
                </c:pt>
                <c:pt idx="62">
                  <c:v>0.70043971814109218</c:v>
                </c:pt>
                <c:pt idx="63">
                  <c:v>0.86155841957202883</c:v>
                </c:pt>
                <c:pt idx="64">
                  <c:v>0.69010416104457972</c:v>
                </c:pt>
                <c:pt idx="65">
                  <c:v>0.61786266001321466</c:v>
                </c:pt>
                <c:pt idx="66">
                  <c:v>0.78140168222448936</c:v>
                </c:pt>
                <c:pt idx="67">
                  <c:v>0.7057567820497973</c:v>
                </c:pt>
                <c:pt idx="68">
                  <c:v>1.9229209179792073</c:v>
                </c:pt>
                <c:pt idx="69">
                  <c:v>0.86401771720462339</c:v>
                </c:pt>
                <c:pt idx="70">
                  <c:v>0.82113873749070365</c:v>
                </c:pt>
                <c:pt idx="71">
                  <c:v>0.97276616525448512</c:v>
                </c:pt>
                <c:pt idx="72">
                  <c:v>0.75094945249059508</c:v>
                </c:pt>
                <c:pt idx="73">
                  <c:v>1.0540843928423793</c:v>
                </c:pt>
                <c:pt idx="74">
                  <c:v>1.2102018132048846</c:v>
                </c:pt>
                <c:pt idx="75">
                  <c:v>0.72909590813710445</c:v>
                </c:pt>
                <c:pt idx="76">
                  <c:v>0.70026214474670367</c:v>
                </c:pt>
                <c:pt idx="77">
                  <c:v>0.94904928402213518</c:v>
                </c:pt>
                <c:pt idx="78">
                  <c:v>0.7568525032631761</c:v>
                </c:pt>
                <c:pt idx="79">
                  <c:v>0.67978408906555587</c:v>
                </c:pt>
                <c:pt idx="80">
                  <c:v>0.95315347005994999</c:v>
                </c:pt>
                <c:pt idx="81">
                  <c:v>0.74743036833646026</c:v>
                </c:pt>
                <c:pt idx="82">
                  <c:v>1.7199281477324522</c:v>
                </c:pt>
                <c:pt idx="83">
                  <c:v>1.4789718050329426</c:v>
                </c:pt>
                <c:pt idx="84">
                  <c:v>0.7965146949480848</c:v>
                </c:pt>
                <c:pt idx="85">
                  <c:v>0.80842624050466061</c:v>
                </c:pt>
                <c:pt idx="86">
                  <c:v>1.0500488796072227</c:v>
                </c:pt>
                <c:pt idx="87">
                  <c:v>1.5586105089376265</c:v>
                </c:pt>
                <c:pt idx="88">
                  <c:v>1.6876430253149193</c:v>
                </c:pt>
                <c:pt idx="89">
                  <c:v>2.752256193056339</c:v>
                </c:pt>
                <c:pt idx="90">
                  <c:v>0.74467778931707407</c:v>
                </c:pt>
                <c:pt idx="91">
                  <c:v>0.62396047951866596</c:v>
                </c:pt>
                <c:pt idx="92">
                  <c:v>0.80041331263875726</c:v>
                </c:pt>
                <c:pt idx="93">
                  <c:v>1.3328511220721542</c:v>
                </c:pt>
                <c:pt idx="94">
                  <c:v>0.79085542822882693</c:v>
                </c:pt>
                <c:pt idx="95">
                  <c:v>0.64182344376790712</c:v>
                </c:pt>
                <c:pt idx="96">
                  <c:v>1.1191569418736322</c:v>
                </c:pt>
                <c:pt idx="97">
                  <c:v>1.040541793862847</c:v>
                </c:pt>
                <c:pt idx="98">
                  <c:v>3.4466929430175113</c:v>
                </c:pt>
                <c:pt idx="99">
                  <c:v>0.76706149768048892</c:v>
                </c:pt>
                <c:pt idx="100">
                  <c:v>0.87868611062609026</c:v>
                </c:pt>
                <c:pt idx="101">
                  <c:v>0.77256135347514898</c:v>
                </c:pt>
                <c:pt idx="102">
                  <c:v>1.3933063603526528</c:v>
                </c:pt>
                <c:pt idx="103">
                  <c:v>0.70628741224307368</c:v>
                </c:pt>
                <c:pt idx="104">
                  <c:v>1.1849150040824525</c:v>
                </c:pt>
                <c:pt idx="105">
                  <c:v>0.74734442968917403</c:v>
                </c:pt>
                <c:pt idx="106">
                  <c:v>1.2589409681055064</c:v>
                </c:pt>
                <c:pt idx="107">
                  <c:v>1.9941452211382065</c:v>
                </c:pt>
                <c:pt idx="108">
                  <c:v>1.1302060464331951</c:v>
                </c:pt>
                <c:pt idx="109">
                  <c:v>1.1276993054479916</c:v>
                </c:pt>
                <c:pt idx="110">
                  <c:v>1.830458163541077</c:v>
                </c:pt>
                <c:pt idx="111">
                  <c:v>0.96952812156712687</c:v>
                </c:pt>
                <c:pt idx="112">
                  <c:v>1.1115655449595176</c:v>
                </c:pt>
                <c:pt idx="113">
                  <c:v>1.0984195577655445</c:v>
                </c:pt>
                <c:pt idx="114">
                  <c:v>1.1543887801260806</c:v>
                </c:pt>
                <c:pt idx="115">
                  <c:v>0.97372147080481453</c:v>
                </c:pt>
                <c:pt idx="116">
                  <c:v>0.81270357656028425</c:v>
                </c:pt>
                <c:pt idx="117">
                  <c:v>1.3684331244646561</c:v>
                </c:pt>
                <c:pt idx="118">
                  <c:v>0.75351896464137536</c:v>
                </c:pt>
                <c:pt idx="119">
                  <c:v>0.90504276309091714</c:v>
                </c:pt>
                <c:pt idx="120">
                  <c:v>0.83527734330512093</c:v>
                </c:pt>
              </c:numCache>
            </c:numRef>
          </c:xVal>
          <c:yVal>
            <c:numRef>
              <c:f>'HFD - NC Prot'!$J$2:$J$122</c:f>
              <c:numCache>
                <c:formatCode>General</c:formatCode>
                <c:ptCount val="121"/>
                <c:pt idx="0">
                  <c:v>2.4130922197663978</c:v>
                </c:pt>
                <c:pt idx="1">
                  <c:v>1.7045043652734631</c:v>
                </c:pt>
                <c:pt idx="2">
                  <c:v>1.5645208907256958</c:v>
                </c:pt>
                <c:pt idx="3">
                  <c:v>1.3351521369364172</c:v>
                </c:pt>
                <c:pt idx="4">
                  <c:v>2.2893255299538806</c:v>
                </c:pt>
                <c:pt idx="5">
                  <c:v>1.8340068524344859</c:v>
                </c:pt>
                <c:pt idx="6">
                  <c:v>1.6966492175951915</c:v>
                </c:pt>
                <c:pt idx="7">
                  <c:v>2.6731920505488396</c:v>
                </c:pt>
                <c:pt idx="8">
                  <c:v>1.8506185997818263</c:v>
                </c:pt>
                <c:pt idx="9">
                  <c:v>1.3105240253080268</c:v>
                </c:pt>
                <c:pt idx="10">
                  <c:v>2.3399878594584469</c:v>
                </c:pt>
                <c:pt idx="11">
                  <c:v>2.188009264948354</c:v>
                </c:pt>
                <c:pt idx="12">
                  <c:v>1.384880688933833</c:v>
                </c:pt>
                <c:pt idx="13">
                  <c:v>2.9859578485247016</c:v>
                </c:pt>
                <c:pt idx="14">
                  <c:v>3.0352779619448</c:v>
                </c:pt>
                <c:pt idx="15">
                  <c:v>1.5477563801555914</c:v>
                </c:pt>
                <c:pt idx="16">
                  <c:v>1.6480175374367623</c:v>
                </c:pt>
                <c:pt idx="17">
                  <c:v>1.747555637263877</c:v>
                </c:pt>
                <c:pt idx="18">
                  <c:v>2.0841689871896762</c:v>
                </c:pt>
                <c:pt idx="19">
                  <c:v>1.6964403526533396</c:v>
                </c:pt>
                <c:pt idx="20">
                  <c:v>1.4459549267586049</c:v>
                </c:pt>
                <c:pt idx="21">
                  <c:v>2.4425107364248322</c:v>
                </c:pt>
                <c:pt idx="22">
                  <c:v>3.0845891587751249</c:v>
                </c:pt>
                <c:pt idx="23">
                  <c:v>2.218294192759303</c:v>
                </c:pt>
                <c:pt idx="24">
                  <c:v>1.8252959425737283</c:v>
                </c:pt>
                <c:pt idx="25">
                  <c:v>1.4989463554999549</c:v>
                </c:pt>
                <c:pt idx="26">
                  <c:v>1.5999794918007031</c:v>
                </c:pt>
                <c:pt idx="27">
                  <c:v>1.6086447145542653</c:v>
                </c:pt>
                <c:pt idx="28">
                  <c:v>1.6803171623907052</c:v>
                </c:pt>
                <c:pt idx="29">
                  <c:v>2.5268400387869456</c:v>
                </c:pt>
                <c:pt idx="30">
                  <c:v>1.8934107372538993</c:v>
                </c:pt>
                <c:pt idx="31">
                  <c:v>1.7046147928362576</c:v>
                </c:pt>
                <c:pt idx="32">
                  <c:v>1.4519529941611264</c:v>
                </c:pt>
                <c:pt idx="33">
                  <c:v>1.8654572826671858</c:v>
                </c:pt>
                <c:pt idx="34">
                  <c:v>1.6401089590792994</c:v>
                </c:pt>
                <c:pt idx="35">
                  <c:v>1.8877941750471787</c:v>
                </c:pt>
                <c:pt idx="36">
                  <c:v>2.1854635690570907</c:v>
                </c:pt>
                <c:pt idx="37">
                  <c:v>1.8675177613123075</c:v>
                </c:pt>
                <c:pt idx="38">
                  <c:v>2.2706839671595991</c:v>
                </c:pt>
                <c:pt idx="39">
                  <c:v>1.9438424297623149</c:v>
                </c:pt>
                <c:pt idx="40">
                  <c:v>2.0370193216985886</c:v>
                </c:pt>
                <c:pt idx="41">
                  <c:v>1.4776272069938856</c:v>
                </c:pt>
                <c:pt idx="42">
                  <c:v>2.7635233410929554</c:v>
                </c:pt>
                <c:pt idx="43">
                  <c:v>1.7339440694419737</c:v>
                </c:pt>
                <c:pt idx="44">
                  <c:v>1.8447694230688678</c:v>
                </c:pt>
                <c:pt idx="45">
                  <c:v>1.7982922613728476</c:v>
                </c:pt>
                <c:pt idx="46">
                  <c:v>4.0095342121087247</c:v>
                </c:pt>
                <c:pt idx="47">
                  <c:v>2.3780393465830807</c:v>
                </c:pt>
                <c:pt idx="48">
                  <c:v>2.2400981116848788</c:v>
                </c:pt>
                <c:pt idx="49">
                  <c:v>1.4208348243004421</c:v>
                </c:pt>
                <c:pt idx="50">
                  <c:v>2.7184334459393198</c:v>
                </c:pt>
                <c:pt idx="51">
                  <c:v>1.3639977414368236</c:v>
                </c:pt>
                <c:pt idx="52">
                  <c:v>1.4570022767303665</c:v>
                </c:pt>
                <c:pt idx="53">
                  <c:v>1.6573204633319212</c:v>
                </c:pt>
                <c:pt idx="54">
                  <c:v>1.5172126363538867</c:v>
                </c:pt>
                <c:pt idx="55">
                  <c:v>1.4545615773262175</c:v>
                </c:pt>
                <c:pt idx="56">
                  <c:v>1.6651446320232197</c:v>
                </c:pt>
                <c:pt idx="57">
                  <c:v>1.4446383013366784</c:v>
                </c:pt>
                <c:pt idx="58">
                  <c:v>1.4461732829568443</c:v>
                </c:pt>
                <c:pt idx="59">
                  <c:v>3.2767266939900823</c:v>
                </c:pt>
                <c:pt idx="60">
                  <c:v>2.1613365290966393</c:v>
                </c:pt>
                <c:pt idx="61">
                  <c:v>2.1150370345541689</c:v>
                </c:pt>
                <c:pt idx="62">
                  <c:v>3.3717422835521043</c:v>
                </c:pt>
                <c:pt idx="63">
                  <c:v>2.2013824001951292</c:v>
                </c:pt>
                <c:pt idx="64">
                  <c:v>1.7285372600875046</c:v>
                </c:pt>
                <c:pt idx="65">
                  <c:v>1.431699924864702</c:v>
                </c:pt>
                <c:pt idx="66">
                  <c:v>1.319864658243717</c:v>
                </c:pt>
                <c:pt idx="67">
                  <c:v>2.2883185431301691</c:v>
                </c:pt>
                <c:pt idx="68">
                  <c:v>2.7029654474441029</c:v>
                </c:pt>
                <c:pt idx="69">
                  <c:v>1.6742754514951905</c:v>
                </c:pt>
                <c:pt idx="70">
                  <c:v>2.1838526928834194</c:v>
                </c:pt>
                <c:pt idx="71">
                  <c:v>1.4159321064677599</c:v>
                </c:pt>
                <c:pt idx="72">
                  <c:v>1.6879093501708482</c:v>
                </c:pt>
                <c:pt idx="73">
                  <c:v>1.3306058231050018</c:v>
                </c:pt>
                <c:pt idx="74">
                  <c:v>1.3157765278688256</c:v>
                </c:pt>
                <c:pt idx="75">
                  <c:v>2.0046522096733361</c:v>
                </c:pt>
                <c:pt idx="76">
                  <c:v>2.0211152048525425</c:v>
                </c:pt>
                <c:pt idx="77">
                  <c:v>1.9074482592562179</c:v>
                </c:pt>
                <c:pt idx="78">
                  <c:v>1.4279382524727799</c:v>
                </c:pt>
                <c:pt idx="79">
                  <c:v>1.8065736590133417</c:v>
                </c:pt>
                <c:pt idx="80">
                  <c:v>1.7024064850013103</c:v>
                </c:pt>
                <c:pt idx="81">
                  <c:v>1.391142529251677</c:v>
                </c:pt>
                <c:pt idx="82">
                  <c:v>2.7822180851681173</c:v>
                </c:pt>
                <c:pt idx="83">
                  <c:v>2.0391200026135965</c:v>
                </c:pt>
                <c:pt idx="84">
                  <c:v>2.1451834176149314</c:v>
                </c:pt>
                <c:pt idx="85">
                  <c:v>2.10086621718541</c:v>
                </c:pt>
                <c:pt idx="86">
                  <c:v>2.0614377719158599</c:v>
                </c:pt>
                <c:pt idx="87">
                  <c:v>2.062222191087729</c:v>
                </c:pt>
                <c:pt idx="88">
                  <c:v>2.1275555111797622</c:v>
                </c:pt>
                <c:pt idx="89">
                  <c:v>1.3276585381922323</c:v>
                </c:pt>
                <c:pt idx="90">
                  <c:v>3.4315803055441245</c:v>
                </c:pt>
                <c:pt idx="91">
                  <c:v>1.6225588765843642</c:v>
                </c:pt>
                <c:pt idx="92">
                  <c:v>1.3365206404511625</c:v>
                </c:pt>
                <c:pt idx="93">
                  <c:v>1.9460474891293345</c:v>
                </c:pt>
                <c:pt idx="94">
                  <c:v>2.2948485400426386</c:v>
                </c:pt>
                <c:pt idx="95">
                  <c:v>1.3787558053769751</c:v>
                </c:pt>
                <c:pt idx="96">
                  <c:v>1.5719344984747072</c:v>
                </c:pt>
                <c:pt idx="97">
                  <c:v>2.0078632895065445</c:v>
                </c:pt>
                <c:pt idx="98">
                  <c:v>3.5342545529536968</c:v>
                </c:pt>
                <c:pt idx="99">
                  <c:v>1.5619617434435003</c:v>
                </c:pt>
                <c:pt idx="100">
                  <c:v>1.7864120969792454</c:v>
                </c:pt>
                <c:pt idx="101">
                  <c:v>1.3419873789242844</c:v>
                </c:pt>
                <c:pt idx="102">
                  <c:v>3.194319874512257</c:v>
                </c:pt>
                <c:pt idx="103">
                  <c:v>1.6098753228113791</c:v>
                </c:pt>
                <c:pt idx="104">
                  <c:v>1.7453058113470683</c:v>
                </c:pt>
                <c:pt idx="105">
                  <c:v>1.3092923511827259</c:v>
                </c:pt>
                <c:pt idx="106">
                  <c:v>2.5774728095948682</c:v>
                </c:pt>
                <c:pt idx="107">
                  <c:v>1.5506949571140334</c:v>
                </c:pt>
                <c:pt idx="108">
                  <c:v>1.362576066329144</c:v>
                </c:pt>
                <c:pt idx="109">
                  <c:v>2.3056018489719006</c:v>
                </c:pt>
                <c:pt idx="110">
                  <c:v>2.219086988532379</c:v>
                </c:pt>
                <c:pt idx="111">
                  <c:v>1.7817749043466371</c:v>
                </c:pt>
                <c:pt idx="112">
                  <c:v>1.830983310264849</c:v>
                </c:pt>
                <c:pt idx="113">
                  <c:v>1.5111436869026291</c:v>
                </c:pt>
                <c:pt idx="114">
                  <c:v>2.2895699450781439</c:v>
                </c:pt>
                <c:pt idx="115">
                  <c:v>1.6837435282261533</c:v>
                </c:pt>
                <c:pt idx="116">
                  <c:v>2.0837858198666637</c:v>
                </c:pt>
                <c:pt idx="117">
                  <c:v>1.8049005527695274</c:v>
                </c:pt>
                <c:pt idx="118">
                  <c:v>1.8424229793685756</c:v>
                </c:pt>
                <c:pt idx="119">
                  <c:v>1.9049191141644204</c:v>
                </c:pt>
                <c:pt idx="120">
                  <c:v>1.65200613910102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750-49E9-BA33-867EEA30340D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7750-49E9-BA33-867EEA30340D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5</c:v>
              </c:pt>
              <c:pt idx="1">
                <c:v>15</c:v>
              </c:pt>
            </c:numLit>
          </c:xVal>
          <c:yVal>
            <c:numLit>
              <c:formatCode>General</c:formatCode>
              <c:ptCount val="2"/>
              <c:pt idx="0">
                <c:v>1.3</c:v>
              </c:pt>
              <c:pt idx="1">
                <c:v>1.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7750-49E9-BA33-867EEA30340D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7750-49E9-BA33-867EEA30340D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7750-49E9-BA33-867EEA303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8"/>
          <c:min val="-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HFHS</a:t>
                </a:r>
                <a:r>
                  <a:rPr lang="en-US"/>
                  <a:t> /</a:t>
                </a:r>
                <a:r>
                  <a:rPr lang="en-US" baseline="0"/>
                  <a:t> NC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4"/>
      </c:valAx>
      <c:valAx>
        <c:axId val="872775711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</a:t>
                </a:r>
                <a:r>
                  <a:rPr lang="en-US" baseline="-25000"/>
                  <a:t>10</a:t>
                </a:r>
                <a:r>
                  <a:rPr lang="en-US"/>
                  <a:t> 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5"/>
        <c:crossBetween val="midCat"/>
        <c:majorUnit val="2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49578643136832"/>
          <c:y val="7.7611111111111117E-2"/>
          <c:w val="0.7997399373267402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sDM - NC Prot'!$B$1</c:f>
              <c:strCache>
                <c:ptCount val="1"/>
                <c:pt idx="0">
                  <c:v>-log10q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NC Prot'!$A$2:$A$3493</c:f>
              <c:numCache>
                <c:formatCode>General</c:formatCode>
                <c:ptCount val="3492"/>
                <c:pt idx="0">
                  <c:v>-1.814734671025936E-2</c:v>
                </c:pt>
                <c:pt idx="1">
                  <c:v>-0.37145968073723962</c:v>
                </c:pt>
                <c:pt idx="2">
                  <c:v>0.30287467036558496</c:v>
                </c:pt>
                <c:pt idx="3">
                  <c:v>-0.88950311808259797</c:v>
                </c:pt>
                <c:pt idx="4">
                  <c:v>3.9278795351367586E-2</c:v>
                </c:pt>
                <c:pt idx="5">
                  <c:v>-1.4560092803351499</c:v>
                </c:pt>
                <c:pt idx="6">
                  <c:v>-0.42371974237864457</c:v>
                </c:pt>
                <c:pt idx="7">
                  <c:v>0.1779815563133707</c:v>
                </c:pt>
                <c:pt idx="8">
                  <c:v>3.2383005311652981E-2</c:v>
                </c:pt>
                <c:pt idx="9">
                  <c:v>-0.13844158042797131</c:v>
                </c:pt>
                <c:pt idx="10">
                  <c:v>0.41910736678436111</c:v>
                </c:pt>
                <c:pt idx="11">
                  <c:v>0.15807845649862637</c:v>
                </c:pt>
                <c:pt idx="12">
                  <c:v>-0.22330641765840703</c:v>
                </c:pt>
                <c:pt idx="13">
                  <c:v>-0.10889193997006984</c:v>
                </c:pt>
                <c:pt idx="14">
                  <c:v>0.19333019538430424</c:v>
                </c:pt>
                <c:pt idx="15">
                  <c:v>-0.81527537949811979</c:v>
                </c:pt>
                <c:pt idx="16">
                  <c:v>0.20551763289270666</c:v>
                </c:pt>
                <c:pt idx="17">
                  <c:v>-0.38138544678884673</c:v>
                </c:pt>
                <c:pt idx="18">
                  <c:v>-0.14768148749495644</c:v>
                </c:pt>
                <c:pt idx="19">
                  <c:v>0.14886904353100072</c:v>
                </c:pt>
                <c:pt idx="20">
                  <c:v>-8.0850636712325549E-2</c:v>
                </c:pt>
                <c:pt idx="21">
                  <c:v>-0.47072875629406841</c:v>
                </c:pt>
                <c:pt idx="22">
                  <c:v>-6.9906105987850617E-2</c:v>
                </c:pt>
                <c:pt idx="23">
                  <c:v>0.19635524288274839</c:v>
                </c:pt>
                <c:pt idx="24">
                  <c:v>7.9130816432649298E-3</c:v>
                </c:pt>
                <c:pt idx="25">
                  <c:v>-0.38948890833389133</c:v>
                </c:pt>
                <c:pt idx="26">
                  <c:v>-0.12658049656514306</c:v>
                </c:pt>
                <c:pt idx="27">
                  <c:v>-3.4455799768295443E-2</c:v>
                </c:pt>
                <c:pt idx="28">
                  <c:v>8.9633736106895567E-2</c:v>
                </c:pt>
                <c:pt idx="29">
                  <c:v>2.019992294349774E-2</c:v>
                </c:pt>
                <c:pt idx="30">
                  <c:v>2.9134804053022847E-2</c:v>
                </c:pt>
                <c:pt idx="31">
                  <c:v>-0.50225991139090687</c:v>
                </c:pt>
                <c:pt idx="32">
                  <c:v>-0.38854430341512675</c:v>
                </c:pt>
                <c:pt idx="33">
                  <c:v>5.8662839378559886E-2</c:v>
                </c:pt>
                <c:pt idx="34">
                  <c:v>0.39813143187663363</c:v>
                </c:pt>
                <c:pt idx="35">
                  <c:v>0.53645083019470852</c:v>
                </c:pt>
                <c:pt idx="36">
                  <c:v>0.16092018818110321</c:v>
                </c:pt>
                <c:pt idx="37">
                  <c:v>-2.9146345659516508E-2</c:v>
                </c:pt>
                <c:pt idx="38">
                  <c:v>0.22995700858436255</c:v>
                </c:pt>
                <c:pt idx="39">
                  <c:v>-2.7674958442848348E-2</c:v>
                </c:pt>
                <c:pt idx="40">
                  <c:v>-5.8893689053568565E-2</c:v>
                </c:pt>
                <c:pt idx="41">
                  <c:v>-0.3606752108291546</c:v>
                </c:pt>
                <c:pt idx="42">
                  <c:v>-0.50901919632560888</c:v>
                </c:pt>
                <c:pt idx="43">
                  <c:v>-7.217937980379352E-2</c:v>
                </c:pt>
                <c:pt idx="44">
                  <c:v>-0.24212334025210375</c:v>
                </c:pt>
                <c:pt idx="45">
                  <c:v>0.15172895534333664</c:v>
                </c:pt>
                <c:pt idx="46">
                  <c:v>-0.66611834053190988</c:v>
                </c:pt>
                <c:pt idx="47">
                  <c:v>-0.46374812106271068</c:v>
                </c:pt>
                <c:pt idx="48">
                  <c:v>-0.28314076438179314</c:v>
                </c:pt>
                <c:pt idx="49">
                  <c:v>-0.2889456781879336</c:v>
                </c:pt>
                <c:pt idx="50">
                  <c:v>-0.34794953447769711</c:v>
                </c:pt>
                <c:pt idx="51">
                  <c:v>0.50294156800445755</c:v>
                </c:pt>
                <c:pt idx="52">
                  <c:v>6.7363367119610232E-2</c:v>
                </c:pt>
                <c:pt idx="53">
                  <c:v>-6.6880635568192126E-2</c:v>
                </c:pt>
                <c:pt idx="54">
                  <c:v>5.4917919128957937E-2</c:v>
                </c:pt>
                <c:pt idx="55">
                  <c:v>-0.11700487820137295</c:v>
                </c:pt>
                <c:pt idx="56">
                  <c:v>-1.1006359657018591E-2</c:v>
                </c:pt>
                <c:pt idx="57">
                  <c:v>0.52737065714040898</c:v>
                </c:pt>
                <c:pt idx="58">
                  <c:v>-0.50717261207748843</c:v>
                </c:pt>
                <c:pt idx="59">
                  <c:v>0.35614381022527536</c:v>
                </c:pt>
                <c:pt idx="60">
                  <c:v>-3.3274231282193117E-2</c:v>
                </c:pt>
                <c:pt idx="61">
                  <c:v>4.9351959135291522E-2</c:v>
                </c:pt>
                <c:pt idx="62">
                  <c:v>6.8189258778968073E-2</c:v>
                </c:pt>
                <c:pt idx="63">
                  <c:v>-0.57540033776917432</c:v>
                </c:pt>
                <c:pt idx="64">
                  <c:v>-0.23735353296184938</c:v>
                </c:pt>
                <c:pt idx="65">
                  <c:v>-0.30578839223210941</c:v>
                </c:pt>
                <c:pt idx="66">
                  <c:v>0.54961988909773396</c:v>
                </c:pt>
                <c:pt idx="67">
                  <c:v>0.4859419834124194</c:v>
                </c:pt>
                <c:pt idx="68">
                  <c:v>0.34289603673961971</c:v>
                </c:pt>
                <c:pt idx="69">
                  <c:v>-9.68074392029252E-2</c:v>
                </c:pt>
                <c:pt idx="70">
                  <c:v>-0.97001713378428578</c:v>
                </c:pt>
                <c:pt idx="71">
                  <c:v>0.1392075202712541</c:v>
                </c:pt>
                <c:pt idx="72">
                  <c:v>-2.5030237187284567E-2</c:v>
                </c:pt>
                <c:pt idx="73">
                  <c:v>-0.26395802625003234</c:v>
                </c:pt>
                <c:pt idx="74">
                  <c:v>-0.58597274087509821</c:v>
                </c:pt>
                <c:pt idx="75">
                  <c:v>9.4641454115062321E-2</c:v>
                </c:pt>
                <c:pt idx="76">
                  <c:v>-0.16181464778912144</c:v>
                </c:pt>
                <c:pt idx="77">
                  <c:v>0.47404659931930554</c:v>
                </c:pt>
                <c:pt idx="78">
                  <c:v>0.12948085869887829</c:v>
                </c:pt>
                <c:pt idx="79">
                  <c:v>-0.13447704086003628</c:v>
                </c:pt>
                <c:pt idx="80">
                  <c:v>2.1479727410451396E-2</c:v>
                </c:pt>
                <c:pt idx="81">
                  <c:v>-0.67484388225840886</c:v>
                </c:pt>
                <c:pt idx="82">
                  <c:v>-0.58337640836713001</c:v>
                </c:pt>
                <c:pt idx="83">
                  <c:v>-3.8006322579744921E-2</c:v>
                </c:pt>
                <c:pt idx="84">
                  <c:v>1.0923027184791876E-2</c:v>
                </c:pt>
                <c:pt idx="85">
                  <c:v>-4.2308228619120168E-2</c:v>
                </c:pt>
                <c:pt idx="86">
                  <c:v>7.8609834696366468E-2</c:v>
                </c:pt>
                <c:pt idx="87">
                  <c:v>-8.1461107488762799E-2</c:v>
                </c:pt>
                <c:pt idx="88">
                  <c:v>-0.23718347401889431</c:v>
                </c:pt>
                <c:pt idx="89">
                  <c:v>-0.49309344541930672</c:v>
                </c:pt>
                <c:pt idx="90">
                  <c:v>-6.7636408565144385E-2</c:v>
                </c:pt>
                <c:pt idx="91">
                  <c:v>7.5053364604507275E-2</c:v>
                </c:pt>
                <c:pt idx="92">
                  <c:v>0.16298339202346543</c:v>
                </c:pt>
                <c:pt idx="93">
                  <c:v>-0.6097725631593085</c:v>
                </c:pt>
                <c:pt idx="94">
                  <c:v>0.3595211704275954</c:v>
                </c:pt>
                <c:pt idx="95">
                  <c:v>-0.19379969588388798</c:v>
                </c:pt>
                <c:pt idx="96">
                  <c:v>0.12181115114198661</c:v>
                </c:pt>
                <c:pt idx="97">
                  <c:v>-0.14928057327260158</c:v>
                </c:pt>
                <c:pt idx="98">
                  <c:v>-1.4353850282750529E-2</c:v>
                </c:pt>
                <c:pt idx="99">
                  <c:v>-0.43752554190367526</c:v>
                </c:pt>
                <c:pt idx="100">
                  <c:v>-0.16342948458284823</c:v>
                </c:pt>
                <c:pt idx="101">
                  <c:v>0.38305450144979236</c:v>
                </c:pt>
                <c:pt idx="102">
                  <c:v>-0.5651182805928654</c:v>
                </c:pt>
                <c:pt idx="103">
                  <c:v>0.37417703298983873</c:v>
                </c:pt>
                <c:pt idx="104">
                  <c:v>-8.4517342168185378E-2</c:v>
                </c:pt>
                <c:pt idx="105">
                  <c:v>-0.58770622866658329</c:v>
                </c:pt>
                <c:pt idx="106">
                  <c:v>-0.20656185827758058</c:v>
                </c:pt>
                <c:pt idx="107">
                  <c:v>-0.26846916294584156</c:v>
                </c:pt>
                <c:pt idx="108">
                  <c:v>-2.1309972353247475</c:v>
                </c:pt>
                <c:pt idx="109">
                  <c:v>1.5925689990254212E-2</c:v>
                </c:pt>
                <c:pt idx="110">
                  <c:v>0.5349580265838958</c:v>
                </c:pt>
                <c:pt idx="111">
                  <c:v>0.23878685958711648</c:v>
                </c:pt>
                <c:pt idx="112">
                  <c:v>6.9702166630067411E-2</c:v>
                </c:pt>
                <c:pt idx="113">
                  <c:v>-0.8772610280454548</c:v>
                </c:pt>
                <c:pt idx="114">
                  <c:v>5.4640130538345412E-2</c:v>
                </c:pt>
                <c:pt idx="115">
                  <c:v>-0.28736020206914831</c:v>
                </c:pt>
                <c:pt idx="116">
                  <c:v>-9.511132983749522E-2</c:v>
                </c:pt>
                <c:pt idx="117">
                  <c:v>-0.65835575946983971</c:v>
                </c:pt>
                <c:pt idx="118">
                  <c:v>0.2439127588731744</c:v>
                </c:pt>
                <c:pt idx="119">
                  <c:v>8.5288674816987306E-2</c:v>
                </c:pt>
                <c:pt idx="120">
                  <c:v>0.30111935315076249</c:v>
                </c:pt>
                <c:pt idx="121">
                  <c:v>-4.3287344653065887E-4</c:v>
                </c:pt>
                <c:pt idx="122">
                  <c:v>0.11036324336041808</c:v>
                </c:pt>
                <c:pt idx="123">
                  <c:v>0.10178452416693216</c:v>
                </c:pt>
                <c:pt idx="124">
                  <c:v>0.25338423580007446</c:v>
                </c:pt>
                <c:pt idx="125">
                  <c:v>0.14717642698094646</c:v>
                </c:pt>
                <c:pt idx="126">
                  <c:v>0.36915934606453149</c:v>
                </c:pt>
                <c:pt idx="127">
                  <c:v>-5.4392296818627783E-2</c:v>
                </c:pt>
                <c:pt idx="128">
                  <c:v>0.64145354567194091</c:v>
                </c:pt>
                <c:pt idx="129">
                  <c:v>0.28463257625082955</c:v>
                </c:pt>
                <c:pt idx="130">
                  <c:v>0.46915663199964297</c:v>
                </c:pt>
                <c:pt idx="131">
                  <c:v>-0.21139780526485866</c:v>
                </c:pt>
                <c:pt idx="132">
                  <c:v>-0.38873317492693521</c:v>
                </c:pt>
                <c:pt idx="133">
                  <c:v>1.4926544238102822E-2</c:v>
                </c:pt>
                <c:pt idx="134">
                  <c:v>4.4654367703005314E-3</c:v>
                </c:pt>
                <c:pt idx="135">
                  <c:v>-7.3089693247113494E-2</c:v>
                </c:pt>
                <c:pt idx="136">
                  <c:v>-1.9755295146610233E-2</c:v>
                </c:pt>
                <c:pt idx="137">
                  <c:v>-0.41638464341544235</c:v>
                </c:pt>
                <c:pt idx="138">
                  <c:v>0.21586493915323998</c:v>
                </c:pt>
                <c:pt idx="139">
                  <c:v>-0.28859319955415269</c:v>
                </c:pt>
                <c:pt idx="140">
                  <c:v>-0.14480759204084612</c:v>
                </c:pt>
                <c:pt idx="141">
                  <c:v>-0.31061137277834022</c:v>
                </c:pt>
                <c:pt idx="142">
                  <c:v>5.9908989018685112E-2</c:v>
                </c:pt>
                <c:pt idx="143">
                  <c:v>-0.65108775900580051</c:v>
                </c:pt>
                <c:pt idx="144">
                  <c:v>-0.33952768671884448</c:v>
                </c:pt>
                <c:pt idx="145">
                  <c:v>-0.13511063553025032</c:v>
                </c:pt>
                <c:pt idx="146">
                  <c:v>-7.0966521354143594E-2</c:v>
                </c:pt>
                <c:pt idx="147">
                  <c:v>0.1230039540548198</c:v>
                </c:pt>
                <c:pt idx="148">
                  <c:v>-0.19445989268794478</c:v>
                </c:pt>
                <c:pt idx="149">
                  <c:v>0.1333004762297765</c:v>
                </c:pt>
                <c:pt idx="150">
                  <c:v>0.33044366822900922</c:v>
                </c:pt>
                <c:pt idx="151">
                  <c:v>-0.20157615452214014</c:v>
                </c:pt>
                <c:pt idx="152">
                  <c:v>0.29431196073111726</c:v>
                </c:pt>
                <c:pt idx="153">
                  <c:v>0.15263773965111241</c:v>
                </c:pt>
                <c:pt idx="154">
                  <c:v>-0.19297487450135609</c:v>
                </c:pt>
                <c:pt idx="155">
                  <c:v>-0.10113382791640249</c:v>
                </c:pt>
                <c:pt idx="156">
                  <c:v>-1.0828356119454561</c:v>
                </c:pt>
                <c:pt idx="157">
                  <c:v>3.5342380792197078E-2</c:v>
                </c:pt>
                <c:pt idx="158">
                  <c:v>-0.27003400255307203</c:v>
                </c:pt>
                <c:pt idx="159">
                  <c:v>-0.18131301924430618</c:v>
                </c:pt>
                <c:pt idx="160">
                  <c:v>-0.26760054046136283</c:v>
                </c:pt>
                <c:pt idx="161">
                  <c:v>-0.18311362598508041</c:v>
                </c:pt>
                <c:pt idx="162">
                  <c:v>9.0604681563835974E-3</c:v>
                </c:pt>
                <c:pt idx="163">
                  <c:v>-0.38364230300330965</c:v>
                </c:pt>
                <c:pt idx="164">
                  <c:v>4.9212534632560277E-2</c:v>
                </c:pt>
                <c:pt idx="165">
                  <c:v>0.22835695420104843</c:v>
                </c:pt>
                <c:pt idx="166">
                  <c:v>0.25084033356164537</c:v>
                </c:pt>
                <c:pt idx="167">
                  <c:v>0.89538018349783122</c:v>
                </c:pt>
                <c:pt idx="168">
                  <c:v>-1.0436459153546316</c:v>
                </c:pt>
                <c:pt idx="169">
                  <c:v>-0.15136203809529375</c:v>
                </c:pt>
                <c:pt idx="170">
                  <c:v>-0.33515311849261153</c:v>
                </c:pt>
                <c:pt idx="171">
                  <c:v>0.20451636970277204</c:v>
                </c:pt>
                <c:pt idx="172">
                  <c:v>1.3745109257683912</c:v>
                </c:pt>
                <c:pt idx="173">
                  <c:v>4.1242982231881345E-2</c:v>
                </c:pt>
                <c:pt idx="174">
                  <c:v>0.11009592910342045</c:v>
                </c:pt>
                <c:pt idx="175">
                  <c:v>1.4084944894694442</c:v>
                </c:pt>
                <c:pt idx="176">
                  <c:v>7.8063255776819121E-2</c:v>
                </c:pt>
                <c:pt idx="177">
                  <c:v>0.7110543218120664</c:v>
                </c:pt>
                <c:pt idx="178">
                  <c:v>0.51045562166176417</c:v>
                </c:pt>
                <c:pt idx="179">
                  <c:v>0.10929368902294002</c:v>
                </c:pt>
                <c:pt idx="180">
                  <c:v>0.57094860517332746</c:v>
                </c:pt>
                <c:pt idx="181">
                  <c:v>-3.8450752949606162E-2</c:v>
                </c:pt>
                <c:pt idx="182">
                  <c:v>0.15133930104228091</c:v>
                </c:pt>
                <c:pt idx="183">
                  <c:v>0.32308178950373262</c:v>
                </c:pt>
                <c:pt idx="184">
                  <c:v>8.0248330092120304E-2</c:v>
                </c:pt>
                <c:pt idx="185">
                  <c:v>-0.49187563861580075</c:v>
                </c:pt>
                <c:pt idx="186">
                  <c:v>0.4439248579337417</c:v>
                </c:pt>
                <c:pt idx="187">
                  <c:v>0.55581615506163962</c:v>
                </c:pt>
                <c:pt idx="188">
                  <c:v>-0.19842743053640191</c:v>
                </c:pt>
                <c:pt idx="189">
                  <c:v>4.5862297908687961E-2</c:v>
                </c:pt>
                <c:pt idx="190">
                  <c:v>-2.4736678321506448E-2</c:v>
                </c:pt>
                <c:pt idx="191">
                  <c:v>-0.51498543030959998</c:v>
                </c:pt>
                <c:pt idx="192">
                  <c:v>-2.2536888760533304E-2</c:v>
                </c:pt>
                <c:pt idx="193">
                  <c:v>-0.33169930146135063</c:v>
                </c:pt>
                <c:pt idx="194">
                  <c:v>4.6092532525896721E-3</c:v>
                </c:pt>
                <c:pt idx="195">
                  <c:v>0.32469541358922055</c:v>
                </c:pt>
                <c:pt idx="196">
                  <c:v>0.12432813500220179</c:v>
                </c:pt>
                <c:pt idx="197">
                  <c:v>0.26363540356832926</c:v>
                </c:pt>
                <c:pt idx="198">
                  <c:v>3.506079690511428E-2</c:v>
                </c:pt>
                <c:pt idx="199">
                  <c:v>-1.88780102056894E-2</c:v>
                </c:pt>
                <c:pt idx="200">
                  <c:v>0.2746493101650892</c:v>
                </c:pt>
                <c:pt idx="201">
                  <c:v>-0.12862944381854494</c:v>
                </c:pt>
                <c:pt idx="202">
                  <c:v>-0.11263070472111794</c:v>
                </c:pt>
                <c:pt idx="203">
                  <c:v>0.20726817311202828</c:v>
                </c:pt>
                <c:pt idx="204">
                  <c:v>2.1624211506207254E-3</c:v>
                </c:pt>
                <c:pt idx="205">
                  <c:v>0.107553970289646</c:v>
                </c:pt>
                <c:pt idx="206">
                  <c:v>-4.0674960760867886E-2</c:v>
                </c:pt>
                <c:pt idx="207">
                  <c:v>-0.23735353296184938</c:v>
                </c:pt>
                <c:pt idx="208">
                  <c:v>-0.45977429940446057</c:v>
                </c:pt>
                <c:pt idx="209">
                  <c:v>3.9980597690881255E-2</c:v>
                </c:pt>
                <c:pt idx="210">
                  <c:v>0.38835487954820652</c:v>
                </c:pt>
                <c:pt idx="211">
                  <c:v>-0.92166342887882102</c:v>
                </c:pt>
                <c:pt idx="212">
                  <c:v>-0.4979749784823046</c:v>
                </c:pt>
                <c:pt idx="213">
                  <c:v>-4.5729229855120658E-2</c:v>
                </c:pt>
                <c:pt idx="214">
                  <c:v>0.11902410314227461</c:v>
                </c:pt>
                <c:pt idx="215">
                  <c:v>-0.1166919970375162</c:v>
                </c:pt>
                <c:pt idx="216">
                  <c:v>0.10097764772482092</c:v>
                </c:pt>
                <c:pt idx="217">
                  <c:v>-0.61949218066055423</c:v>
                </c:pt>
                <c:pt idx="218">
                  <c:v>0.24537396261816252</c:v>
                </c:pt>
                <c:pt idx="219">
                  <c:v>0.13619138628714406</c:v>
                </c:pt>
                <c:pt idx="220">
                  <c:v>-0.16213747057876307</c:v>
                </c:pt>
                <c:pt idx="221">
                  <c:v>0.14587306160104482</c:v>
                </c:pt>
                <c:pt idx="222">
                  <c:v>-0.68710252710274311</c:v>
                </c:pt>
                <c:pt idx="223">
                  <c:v>-0.23820412849435385</c:v>
                </c:pt>
                <c:pt idx="224">
                  <c:v>-0.32789151996869614</c:v>
                </c:pt>
                <c:pt idx="225">
                  <c:v>-0.15200309344504997</c:v>
                </c:pt>
                <c:pt idx="226">
                  <c:v>-0.24314749673682384</c:v>
                </c:pt>
                <c:pt idx="227">
                  <c:v>7.5464174262512521E-2</c:v>
                </c:pt>
                <c:pt idx="228">
                  <c:v>9.3154487907082958E-2</c:v>
                </c:pt>
                <c:pt idx="229">
                  <c:v>-0.23412583591027478</c:v>
                </c:pt>
                <c:pt idx="230">
                  <c:v>-0.16456094677587454</c:v>
                </c:pt>
                <c:pt idx="231">
                  <c:v>-0.44163439337685084</c:v>
                </c:pt>
                <c:pt idx="232">
                  <c:v>-1.8001258406667484E-2</c:v>
                </c:pt>
                <c:pt idx="233">
                  <c:v>0.11209957977623511</c:v>
                </c:pt>
                <c:pt idx="234">
                  <c:v>0.15975833805629808</c:v>
                </c:pt>
                <c:pt idx="235">
                  <c:v>2.9134804053022847E-2</c:v>
                </c:pt>
                <c:pt idx="236">
                  <c:v>-0.65380897020093021</c:v>
                </c:pt>
                <c:pt idx="237">
                  <c:v>-8.0392953091645014E-2</c:v>
                </c:pt>
                <c:pt idx="238">
                  <c:v>-7.521587332542789E-3</c:v>
                </c:pt>
                <c:pt idx="239">
                  <c:v>4.5163351603224475E-2</c:v>
                </c:pt>
                <c:pt idx="240">
                  <c:v>-1.1546179414920685E-3</c:v>
                </c:pt>
                <c:pt idx="241">
                  <c:v>-0.66726342753613888</c:v>
                </c:pt>
                <c:pt idx="242">
                  <c:v>0.82089374922856539</c:v>
                </c:pt>
                <c:pt idx="243">
                  <c:v>0.33856703700115137</c:v>
                </c:pt>
                <c:pt idx="244">
                  <c:v>-0.72857432390706556</c:v>
                </c:pt>
                <c:pt idx="245">
                  <c:v>1.9346088804811971E-2</c:v>
                </c:pt>
                <c:pt idx="246">
                  <c:v>-0.39327352498718732</c:v>
                </c:pt>
                <c:pt idx="247">
                  <c:v>-1.8084373492992443</c:v>
                </c:pt>
                <c:pt idx="248">
                  <c:v>0.23474655174432221</c:v>
                </c:pt>
                <c:pt idx="249">
                  <c:v>0.36535659703048007</c:v>
                </c:pt>
                <c:pt idx="250">
                  <c:v>-1.5955328032369107</c:v>
                </c:pt>
                <c:pt idx="251">
                  <c:v>8.8141596869017569E-2</c:v>
                </c:pt>
                <c:pt idx="252">
                  <c:v>0.12697285625776553</c:v>
                </c:pt>
                <c:pt idx="253">
                  <c:v>-0.31742670265242157</c:v>
                </c:pt>
                <c:pt idx="254">
                  <c:v>5.1441711382610174E-2</c:v>
                </c:pt>
                <c:pt idx="255">
                  <c:v>3.2947164099129018E-2</c:v>
                </c:pt>
                <c:pt idx="256">
                  <c:v>-0.88843445504048235</c:v>
                </c:pt>
                <c:pt idx="257">
                  <c:v>-0.45858428418090685</c:v>
                </c:pt>
                <c:pt idx="258">
                  <c:v>-0.12202022722933546</c:v>
                </c:pt>
                <c:pt idx="259">
                  <c:v>-0.12374828813717702</c:v>
                </c:pt>
                <c:pt idx="260">
                  <c:v>-9.2955525127201538E-2</c:v>
                </c:pt>
                <c:pt idx="261">
                  <c:v>4.2364175248007729E-2</c:v>
                </c:pt>
                <c:pt idx="262">
                  <c:v>-0.34226854317153799</c:v>
                </c:pt>
                <c:pt idx="263">
                  <c:v>-4.8710621783866787E-2</c:v>
                </c:pt>
                <c:pt idx="264">
                  <c:v>3.0547964162966627E-2</c:v>
                </c:pt>
                <c:pt idx="265">
                  <c:v>0.10205338272918787</c:v>
                </c:pt>
                <c:pt idx="266">
                  <c:v>1.8634174139050975E-2</c:v>
                </c:pt>
                <c:pt idx="267">
                  <c:v>0.24683368791054239</c:v>
                </c:pt>
                <c:pt idx="268">
                  <c:v>0.82472712723210284</c:v>
                </c:pt>
                <c:pt idx="269">
                  <c:v>-1.4481148965282753</c:v>
                </c:pt>
                <c:pt idx="270">
                  <c:v>-7.3545065455919836E-2</c:v>
                </c:pt>
                <c:pt idx="271">
                  <c:v>-0.12139235428247001</c:v>
                </c:pt>
                <c:pt idx="272">
                  <c:v>-0.23005903958551285</c:v>
                </c:pt>
                <c:pt idx="273">
                  <c:v>-0.36475638764097196</c:v>
                </c:pt>
                <c:pt idx="274">
                  <c:v>-2.8557610682609706E-2</c:v>
                </c:pt>
                <c:pt idx="275">
                  <c:v>-2.6064739677716444</c:v>
                </c:pt>
                <c:pt idx="276">
                  <c:v>0.3764015265935981</c:v>
                </c:pt>
                <c:pt idx="277">
                  <c:v>0.34414674773333043</c:v>
                </c:pt>
                <c:pt idx="278">
                  <c:v>0.30964187342216065</c:v>
                </c:pt>
                <c:pt idx="279">
                  <c:v>0.63217513539748449</c:v>
                </c:pt>
                <c:pt idx="280">
                  <c:v>-0.46972945235379643</c:v>
                </c:pt>
                <c:pt idx="281">
                  <c:v>-0.14369151028255694</c:v>
                </c:pt>
                <c:pt idx="282">
                  <c:v>1.2783184698289594E-2</c:v>
                </c:pt>
                <c:pt idx="283">
                  <c:v>0.22169151351090388</c:v>
                </c:pt>
                <c:pt idx="284">
                  <c:v>-6.9906105987850617E-2</c:v>
                </c:pt>
                <c:pt idx="285">
                  <c:v>-9.1177298589224832E-3</c:v>
                </c:pt>
                <c:pt idx="286">
                  <c:v>0.25592366027356356</c:v>
                </c:pt>
                <c:pt idx="287">
                  <c:v>-0.60186856812336642</c:v>
                </c:pt>
                <c:pt idx="288">
                  <c:v>0.34323724728342053</c:v>
                </c:pt>
                <c:pt idx="289">
                  <c:v>0.52927124370593159</c:v>
                </c:pt>
                <c:pt idx="290">
                  <c:v>-3.0177210327092033E-2</c:v>
                </c:pt>
                <c:pt idx="291">
                  <c:v>-0.10998141251617803</c:v>
                </c:pt>
                <c:pt idx="292">
                  <c:v>-0.1073369764212953</c:v>
                </c:pt>
                <c:pt idx="293">
                  <c:v>-9.6190441421302994E-2</c:v>
                </c:pt>
                <c:pt idx="294">
                  <c:v>-0.10516283924207756</c:v>
                </c:pt>
                <c:pt idx="295">
                  <c:v>1.2798278394408837</c:v>
                </c:pt>
                <c:pt idx="296">
                  <c:v>-0.21524477130759082</c:v>
                </c:pt>
                <c:pt idx="297">
                  <c:v>-0.20008379701098586</c:v>
                </c:pt>
                <c:pt idx="298">
                  <c:v>0.19522159325284455</c:v>
                </c:pt>
                <c:pt idx="299">
                  <c:v>-0.66337383423646445</c:v>
                </c:pt>
                <c:pt idx="300">
                  <c:v>0.2409859040247386</c:v>
                </c:pt>
                <c:pt idx="301">
                  <c:v>9.9901110007942689E-2</c:v>
                </c:pt>
                <c:pt idx="302">
                  <c:v>-0.15264443377163267</c:v>
                </c:pt>
                <c:pt idx="303">
                  <c:v>-0.47112867176187906</c:v>
                </c:pt>
                <c:pt idx="304">
                  <c:v>-0.29814048099058144</c:v>
                </c:pt>
                <c:pt idx="305">
                  <c:v>0.874128076963685</c:v>
                </c:pt>
                <c:pt idx="306">
                  <c:v>-3.3717206069222426E-2</c:v>
                </c:pt>
                <c:pt idx="307">
                  <c:v>-3.1818038709782916</c:v>
                </c:pt>
                <c:pt idx="308">
                  <c:v>0.11316705673273479</c:v>
                </c:pt>
                <c:pt idx="309">
                  <c:v>8.9362552827734545E-2</c:v>
                </c:pt>
                <c:pt idx="310">
                  <c:v>9.0311471376036581E-2</c:v>
                </c:pt>
                <c:pt idx="311">
                  <c:v>-0.12296254930130168</c:v>
                </c:pt>
                <c:pt idx="312">
                  <c:v>0.37984272749168235</c:v>
                </c:pt>
                <c:pt idx="313">
                  <c:v>0.71580553255915269</c:v>
                </c:pt>
                <c:pt idx="314">
                  <c:v>-0.39119075732447617</c:v>
                </c:pt>
                <c:pt idx="315">
                  <c:v>-0.13115522634947868</c:v>
                </c:pt>
                <c:pt idx="316">
                  <c:v>0.11143200536198733</c:v>
                </c:pt>
                <c:pt idx="317">
                  <c:v>-8.375267630998684E-2</c:v>
                </c:pt>
                <c:pt idx="318">
                  <c:v>0.25011267969237527</c:v>
                </c:pt>
                <c:pt idx="319">
                  <c:v>0.2680750225343238</c:v>
                </c:pt>
                <c:pt idx="320">
                  <c:v>-0.39289461624150579</c:v>
                </c:pt>
                <c:pt idx="321">
                  <c:v>0.1474369588174809</c:v>
                </c:pt>
                <c:pt idx="322">
                  <c:v>0.13053555675618825</c:v>
                </c:pt>
                <c:pt idx="323">
                  <c:v>-0.72261030118913616</c:v>
                </c:pt>
                <c:pt idx="324">
                  <c:v>0.71131868886058225</c:v>
                </c:pt>
                <c:pt idx="325">
                  <c:v>0.12340133597191391</c:v>
                </c:pt>
                <c:pt idx="326">
                  <c:v>-0.92659104481466004</c:v>
                </c:pt>
                <c:pt idx="327">
                  <c:v>-0.25618346976222583</c:v>
                </c:pt>
                <c:pt idx="328">
                  <c:v>-0.858305638035469</c:v>
                </c:pt>
                <c:pt idx="329">
                  <c:v>0.65269298917130247</c:v>
                </c:pt>
                <c:pt idx="330">
                  <c:v>-0.16877130682594205</c:v>
                </c:pt>
                <c:pt idx="331">
                  <c:v>0.1644001350244117</c:v>
                </c:pt>
                <c:pt idx="332">
                  <c:v>-0.45521789521333694</c:v>
                </c:pt>
                <c:pt idx="333">
                  <c:v>-6.3710705351344391E-2</c:v>
                </c:pt>
                <c:pt idx="334">
                  <c:v>-2.0194137747983117E-2</c:v>
                </c:pt>
                <c:pt idx="335">
                  <c:v>-5.4991671584577052E-2</c:v>
                </c:pt>
                <c:pt idx="336">
                  <c:v>0.15406467367471652</c:v>
                </c:pt>
                <c:pt idx="337">
                  <c:v>0.91218996848244227</c:v>
                </c:pt>
                <c:pt idx="338">
                  <c:v>-2.092583885454798E-2</c:v>
                </c:pt>
                <c:pt idx="339">
                  <c:v>-0.39611851711579221</c:v>
                </c:pt>
                <c:pt idx="340">
                  <c:v>0.23682933548639973</c:v>
                </c:pt>
                <c:pt idx="341">
                  <c:v>-0.25652811740860676</c:v>
                </c:pt>
                <c:pt idx="342">
                  <c:v>-0.1294182759454145</c:v>
                </c:pt>
                <c:pt idx="343">
                  <c:v>7.5737982394078154E-2</c:v>
                </c:pt>
                <c:pt idx="344">
                  <c:v>-0.73216460790238502</c:v>
                </c:pt>
                <c:pt idx="345">
                  <c:v>-0.64769344709366428</c:v>
                </c:pt>
                <c:pt idx="346">
                  <c:v>0.21661006874244171</c:v>
                </c:pt>
                <c:pt idx="347">
                  <c:v>-0.34611451128335413</c:v>
                </c:pt>
                <c:pt idx="348">
                  <c:v>0.22008226064924694</c:v>
                </c:pt>
                <c:pt idx="349">
                  <c:v>-0.11044858129598112</c:v>
                </c:pt>
                <c:pt idx="350">
                  <c:v>0.10272531001108826</c:v>
                </c:pt>
                <c:pt idx="351">
                  <c:v>0.11609855223657987</c:v>
                </c:pt>
                <c:pt idx="352">
                  <c:v>0.52897131749836745</c:v>
                </c:pt>
                <c:pt idx="353">
                  <c:v>8.1612322857889844E-2</c:v>
                </c:pt>
                <c:pt idx="354">
                  <c:v>-0.2397364653786003</c:v>
                </c:pt>
                <c:pt idx="355">
                  <c:v>0.59579007053066013</c:v>
                </c:pt>
                <c:pt idx="356">
                  <c:v>0.29054236266025435</c:v>
                </c:pt>
                <c:pt idx="357">
                  <c:v>2.5312343046069E-2</c:v>
                </c:pt>
                <c:pt idx="358">
                  <c:v>2.1624211506207254E-3</c:v>
                </c:pt>
                <c:pt idx="359">
                  <c:v>0.76171078436334383</c:v>
                </c:pt>
                <c:pt idx="360">
                  <c:v>-0.10640480212165201</c:v>
                </c:pt>
                <c:pt idx="361">
                  <c:v>0.12736914661622181</c:v>
                </c:pt>
                <c:pt idx="362">
                  <c:v>-6.0720794834001196E-3</c:v>
                </c:pt>
                <c:pt idx="363">
                  <c:v>0.41348576790475933</c:v>
                </c:pt>
                <c:pt idx="364">
                  <c:v>8.8141596869017569E-2</c:v>
                </c:pt>
                <c:pt idx="365">
                  <c:v>-0.17055631863340895</c:v>
                </c:pt>
                <c:pt idx="366">
                  <c:v>-9.0342085689623222E-2</c:v>
                </c:pt>
                <c:pt idx="367">
                  <c:v>0.42147915710330686</c:v>
                </c:pt>
                <c:pt idx="368">
                  <c:v>-0.51251365065146393</c:v>
                </c:pt>
                <c:pt idx="369">
                  <c:v>0.30801131455217762</c:v>
                </c:pt>
                <c:pt idx="370">
                  <c:v>-2.3709692435232362E-2</c:v>
                </c:pt>
                <c:pt idx="371">
                  <c:v>-1.0570302515754394E-2</c:v>
                </c:pt>
                <c:pt idx="372">
                  <c:v>-0.17918792277128037</c:v>
                </c:pt>
                <c:pt idx="373">
                  <c:v>-0.5388905849347454</c:v>
                </c:pt>
                <c:pt idx="374">
                  <c:v>-1.2944201380609019</c:v>
                </c:pt>
                <c:pt idx="375">
                  <c:v>0.18154785645595639</c:v>
                </c:pt>
                <c:pt idx="376">
                  <c:v>1.4498126999352837E-2</c:v>
                </c:pt>
                <c:pt idx="377">
                  <c:v>0.20964051392760022</c:v>
                </c:pt>
                <c:pt idx="378">
                  <c:v>0.18827431132120426</c:v>
                </c:pt>
                <c:pt idx="379">
                  <c:v>7.5190314155219248E-2</c:v>
                </c:pt>
                <c:pt idx="380">
                  <c:v>-0.45521789521333694</c:v>
                </c:pt>
                <c:pt idx="381">
                  <c:v>-0.11904026141721905</c:v>
                </c:pt>
                <c:pt idx="382">
                  <c:v>-7.3089693247113494E-2</c:v>
                </c:pt>
                <c:pt idx="383">
                  <c:v>8.5832523674954794E-2</c:v>
                </c:pt>
                <c:pt idx="384">
                  <c:v>0.44116473412915036</c:v>
                </c:pt>
                <c:pt idx="385">
                  <c:v>-0.15360697914763968</c:v>
                </c:pt>
                <c:pt idx="386">
                  <c:v>-0.402206649757195</c:v>
                </c:pt>
                <c:pt idx="387">
                  <c:v>-6.235429309493612E-2</c:v>
                </c:pt>
                <c:pt idx="388">
                  <c:v>-4.9606242117372572E-2</c:v>
                </c:pt>
                <c:pt idx="389">
                  <c:v>0.18637377746594411</c:v>
                </c:pt>
                <c:pt idx="390">
                  <c:v>0.25035527176304762</c:v>
                </c:pt>
                <c:pt idx="391">
                  <c:v>-0.33369787182690513</c:v>
                </c:pt>
                <c:pt idx="392">
                  <c:v>0.13960046458551464</c:v>
                </c:pt>
                <c:pt idx="393">
                  <c:v>-0.5838088061047858</c:v>
                </c:pt>
                <c:pt idx="394">
                  <c:v>0.45901186447638193</c:v>
                </c:pt>
                <c:pt idx="395">
                  <c:v>0.13658515284762579</c:v>
                </c:pt>
                <c:pt idx="396">
                  <c:v>-1.1068708139827879</c:v>
                </c:pt>
                <c:pt idx="397">
                  <c:v>0.28699939663383972</c:v>
                </c:pt>
                <c:pt idx="398">
                  <c:v>0.42126370085426706</c:v>
                </c:pt>
                <c:pt idx="399">
                  <c:v>7.7242998932460352E-2</c:v>
                </c:pt>
                <c:pt idx="400">
                  <c:v>-0.22010996065995284</c:v>
                </c:pt>
                <c:pt idx="401">
                  <c:v>0.43253187873811627</c:v>
                </c:pt>
                <c:pt idx="402">
                  <c:v>0.24744147114440773</c:v>
                </c:pt>
                <c:pt idx="403">
                  <c:v>0.23437868933761452</c:v>
                </c:pt>
                <c:pt idx="404">
                  <c:v>0.19168897573396876</c:v>
                </c:pt>
                <c:pt idx="405">
                  <c:v>-2.6351991783529823E-2</c:v>
                </c:pt>
                <c:pt idx="406">
                  <c:v>0.19962523565773244</c:v>
                </c:pt>
                <c:pt idx="407">
                  <c:v>-0.14880066140670606</c:v>
                </c:pt>
                <c:pt idx="408">
                  <c:v>-0.19809638532134477</c:v>
                </c:pt>
                <c:pt idx="409">
                  <c:v>-0.52865644038927961</c:v>
                </c:pt>
                <c:pt idx="410">
                  <c:v>0.40697197081672326</c:v>
                </c:pt>
                <c:pt idx="411">
                  <c:v>-1.8585700400031553E-2</c:v>
                </c:pt>
                <c:pt idx="412">
                  <c:v>0.2120089601135649</c:v>
                </c:pt>
                <c:pt idx="413">
                  <c:v>0.1469158480872752</c:v>
                </c:pt>
                <c:pt idx="414">
                  <c:v>0.1467855409887005</c:v>
                </c:pt>
                <c:pt idx="415">
                  <c:v>-0.43498781910177525</c:v>
                </c:pt>
                <c:pt idx="416">
                  <c:v>0.17683337078449007</c:v>
                </c:pt>
                <c:pt idx="417">
                  <c:v>-5.7391663888336684E-2</c:v>
                </c:pt>
                <c:pt idx="418">
                  <c:v>-0.38383053381326926</c:v>
                </c:pt>
                <c:pt idx="419">
                  <c:v>0.12631213032870389</c:v>
                </c:pt>
                <c:pt idx="420">
                  <c:v>1.3497991748977313E-2</c:v>
                </c:pt>
                <c:pt idx="421">
                  <c:v>-0.35715982521331457</c:v>
                </c:pt>
                <c:pt idx="422">
                  <c:v>0.10889240163240912</c:v>
                </c:pt>
                <c:pt idx="423">
                  <c:v>0.59148793839794311</c:v>
                </c:pt>
                <c:pt idx="424">
                  <c:v>-0.52014861326265105</c:v>
                </c:pt>
                <c:pt idx="425">
                  <c:v>-0.27998426491719525</c:v>
                </c:pt>
                <c:pt idx="426">
                  <c:v>0.4014120253638086</c:v>
                </c:pt>
                <c:pt idx="427">
                  <c:v>-0.60559561459937494</c:v>
                </c:pt>
                <c:pt idx="428">
                  <c:v>0.57676397767312548</c:v>
                </c:pt>
                <c:pt idx="429">
                  <c:v>4.2364175248007729E-2</c:v>
                </c:pt>
                <c:pt idx="430">
                  <c:v>0.57821416547245441</c:v>
                </c:pt>
                <c:pt idx="431">
                  <c:v>0.13815914522947029</c:v>
                </c:pt>
                <c:pt idx="432">
                  <c:v>0.43178339880387578</c:v>
                </c:pt>
                <c:pt idx="433">
                  <c:v>0.78718168460357507</c:v>
                </c:pt>
                <c:pt idx="434">
                  <c:v>0.2680750225343238</c:v>
                </c:pt>
                <c:pt idx="435">
                  <c:v>0.31591396543674244</c:v>
                </c:pt>
                <c:pt idx="436">
                  <c:v>3.2241931137493844E-2</c:v>
                </c:pt>
                <c:pt idx="437">
                  <c:v>6.3502942306157953E-2</c:v>
                </c:pt>
                <c:pt idx="438">
                  <c:v>0.4770555655785727</c:v>
                </c:pt>
                <c:pt idx="439">
                  <c:v>-0.3823253745313186</c:v>
                </c:pt>
                <c:pt idx="440">
                  <c:v>5.9029568582364064E-3</c:v>
                </c:pt>
                <c:pt idx="441">
                  <c:v>0.38261192301518759</c:v>
                </c:pt>
                <c:pt idx="442">
                  <c:v>-0.23209100476774178</c:v>
                </c:pt>
                <c:pt idx="443">
                  <c:v>0.12181115114198661</c:v>
                </c:pt>
                <c:pt idx="444">
                  <c:v>0.2911320120087531</c:v>
                </c:pt>
                <c:pt idx="445">
                  <c:v>-0.40449633949725805</c:v>
                </c:pt>
                <c:pt idx="446">
                  <c:v>-2.649276465558978</c:v>
                </c:pt>
                <c:pt idx="447">
                  <c:v>-5.3942929102523324E-2</c:v>
                </c:pt>
                <c:pt idx="448">
                  <c:v>-0.12989178233582188</c:v>
                </c:pt>
                <c:pt idx="449">
                  <c:v>-5.8142480996559893E-2</c:v>
                </c:pt>
                <c:pt idx="450">
                  <c:v>-0.22870598434833792</c:v>
                </c:pt>
                <c:pt idx="451">
                  <c:v>0.45985125070566846</c:v>
                </c:pt>
                <c:pt idx="452">
                  <c:v>-0.15056111927114346</c:v>
                </c:pt>
                <c:pt idx="453">
                  <c:v>-0.25016542558727101</c:v>
                </c:pt>
                <c:pt idx="454">
                  <c:v>-0.17266872938773947</c:v>
                </c:pt>
                <c:pt idx="455">
                  <c:v>0.22958792274065198</c:v>
                </c:pt>
                <c:pt idx="456">
                  <c:v>-0.26343841700944731</c:v>
                </c:pt>
                <c:pt idx="457">
                  <c:v>-0.24058846743542356</c:v>
                </c:pt>
                <c:pt idx="458">
                  <c:v>-0.3230105221290025</c:v>
                </c:pt>
                <c:pt idx="459">
                  <c:v>0.99189820150303554</c:v>
                </c:pt>
                <c:pt idx="460">
                  <c:v>0.26735601178388751</c:v>
                </c:pt>
                <c:pt idx="461">
                  <c:v>0.31984911680475642</c:v>
                </c:pt>
                <c:pt idx="462">
                  <c:v>-0.18311362598508041</c:v>
                </c:pt>
                <c:pt idx="463">
                  <c:v>-1.8767236880300184E-3</c:v>
                </c:pt>
                <c:pt idx="464">
                  <c:v>-1.0279670959395051E-2</c:v>
                </c:pt>
                <c:pt idx="465">
                  <c:v>-9.6985834312939643E-3</c:v>
                </c:pt>
                <c:pt idx="466">
                  <c:v>-1.1946249891052318</c:v>
                </c:pt>
                <c:pt idx="467">
                  <c:v>-7.7954422968056242E-2</c:v>
                </c:pt>
                <c:pt idx="468">
                  <c:v>0.25217341320202702</c:v>
                </c:pt>
                <c:pt idx="469">
                  <c:v>0.39988201002667473</c:v>
                </c:pt>
                <c:pt idx="470">
                  <c:v>0.25144643155858187</c:v>
                </c:pt>
                <c:pt idx="471">
                  <c:v>-0.93760193620152155</c:v>
                </c:pt>
                <c:pt idx="472">
                  <c:v>-1.1081142486996134</c:v>
                </c:pt>
                <c:pt idx="473">
                  <c:v>4.7677975144475609E-2</c:v>
                </c:pt>
                <c:pt idx="474">
                  <c:v>0.1585955515008968</c:v>
                </c:pt>
                <c:pt idx="475">
                  <c:v>0.55355710936464364</c:v>
                </c:pt>
                <c:pt idx="476">
                  <c:v>0.2624331576313475</c:v>
                </c:pt>
                <c:pt idx="477">
                  <c:v>-0.86617347270117218</c:v>
                </c:pt>
                <c:pt idx="478">
                  <c:v>-0.17136841831198107</c:v>
                </c:pt>
                <c:pt idx="479">
                  <c:v>0.30742852519224734</c:v>
                </c:pt>
                <c:pt idx="480">
                  <c:v>0.33262201375963707</c:v>
                </c:pt>
                <c:pt idx="481">
                  <c:v>-4.6027091947825026E-2</c:v>
                </c:pt>
                <c:pt idx="482">
                  <c:v>-0.35623614566265771</c:v>
                </c:pt>
                <c:pt idx="483">
                  <c:v>2.786177535450958E-2</c:v>
                </c:pt>
                <c:pt idx="484">
                  <c:v>0.29736752321765925</c:v>
                </c:pt>
                <c:pt idx="485">
                  <c:v>0.18332770604480075</c:v>
                </c:pt>
                <c:pt idx="486">
                  <c:v>-0.95987908279912248</c:v>
                </c:pt>
                <c:pt idx="487">
                  <c:v>-7.8716020959078287E-2</c:v>
                </c:pt>
                <c:pt idx="488">
                  <c:v>0.52135231409766225</c:v>
                </c:pt>
                <c:pt idx="489">
                  <c:v>1.9773069040027156E-2</c:v>
                </c:pt>
                <c:pt idx="490">
                  <c:v>-0.16698850084163766</c:v>
                </c:pt>
                <c:pt idx="491">
                  <c:v>0.24196218221519267</c:v>
                </c:pt>
                <c:pt idx="492">
                  <c:v>1.8776585179183278E-2</c:v>
                </c:pt>
                <c:pt idx="493">
                  <c:v>-5.3493701310978706E-2</c:v>
                </c:pt>
                <c:pt idx="494">
                  <c:v>-0.78711943365561521</c:v>
                </c:pt>
                <c:pt idx="495">
                  <c:v>-0.55109904885487226</c:v>
                </c:pt>
                <c:pt idx="496">
                  <c:v>4.1943829970167254E-2</c:v>
                </c:pt>
                <c:pt idx="497">
                  <c:v>-0.27020797844003464</c:v>
                </c:pt>
                <c:pt idx="498">
                  <c:v>0.19219416528334513</c:v>
                </c:pt>
                <c:pt idx="499">
                  <c:v>-0.20972840558669811</c:v>
                </c:pt>
                <c:pt idx="500">
                  <c:v>-6.1149662993936413E-2</c:v>
                </c:pt>
                <c:pt idx="501">
                  <c:v>0.22329897333278972</c:v>
                </c:pt>
                <c:pt idx="502">
                  <c:v>-0.33934514796477178</c:v>
                </c:pt>
                <c:pt idx="503">
                  <c:v>-0.1073369764212953</c:v>
                </c:pt>
                <c:pt idx="504">
                  <c:v>0.46842691882347864</c:v>
                </c:pt>
                <c:pt idx="505">
                  <c:v>-9.7424700969059461E-2</c:v>
                </c:pt>
                <c:pt idx="506">
                  <c:v>-6.5823218078183851E-2</c:v>
                </c:pt>
                <c:pt idx="507">
                  <c:v>0.54032490603074368</c:v>
                </c:pt>
                <c:pt idx="508">
                  <c:v>-0.41927562369128046</c:v>
                </c:pt>
                <c:pt idx="509">
                  <c:v>0.43605520602855291</c:v>
                </c:pt>
                <c:pt idx="510">
                  <c:v>-6.3258426218880476E-2</c:v>
                </c:pt>
                <c:pt idx="511">
                  <c:v>-2.5617534179269933E-2</c:v>
                </c:pt>
                <c:pt idx="512">
                  <c:v>0.18953994438850338</c:v>
                </c:pt>
                <c:pt idx="513">
                  <c:v>-9.6344666130508488E-2</c:v>
                </c:pt>
                <c:pt idx="514">
                  <c:v>-4.5133690098103037E-2</c:v>
                </c:pt>
                <c:pt idx="515">
                  <c:v>0.18014786115842862</c:v>
                </c:pt>
                <c:pt idx="516">
                  <c:v>1.2926174444270048E-2</c:v>
                </c:pt>
                <c:pt idx="517">
                  <c:v>6.1902890720698343E-3</c:v>
                </c:pt>
                <c:pt idx="518">
                  <c:v>6.7363367119610232E-2</c:v>
                </c:pt>
                <c:pt idx="519">
                  <c:v>-0.62082267110919243</c:v>
                </c:pt>
                <c:pt idx="520">
                  <c:v>-0.30757280191029224</c:v>
                </c:pt>
                <c:pt idx="521">
                  <c:v>1.6211033155917154E-2</c:v>
                </c:pt>
                <c:pt idx="522">
                  <c:v>-0.87144263502624253</c:v>
                </c:pt>
                <c:pt idx="523">
                  <c:v>-0.65721771804387219</c:v>
                </c:pt>
                <c:pt idx="524">
                  <c:v>-6.6517078724300681E-3</c:v>
                </c:pt>
                <c:pt idx="525">
                  <c:v>-1.782397023413212</c:v>
                </c:pt>
                <c:pt idx="526">
                  <c:v>-7.1118072910655541E-2</c:v>
                </c:pt>
                <c:pt idx="527">
                  <c:v>-0.54877569787331004</c:v>
                </c:pt>
                <c:pt idx="528">
                  <c:v>-0.19396471676378066</c:v>
                </c:pt>
                <c:pt idx="529">
                  <c:v>0.10138114235502452</c:v>
                </c:pt>
                <c:pt idx="530">
                  <c:v>0.16517231793716666</c:v>
                </c:pt>
                <c:pt idx="531">
                  <c:v>-0.10144335270645244</c:v>
                </c:pt>
                <c:pt idx="532">
                  <c:v>-0.69572261193432483</c:v>
                </c:pt>
                <c:pt idx="533">
                  <c:v>0.1335635257411058</c:v>
                </c:pt>
                <c:pt idx="534">
                  <c:v>0.55630678422497692</c:v>
                </c:pt>
                <c:pt idx="535">
                  <c:v>0.38338634619901596</c:v>
                </c:pt>
                <c:pt idx="536">
                  <c:v>-4.1268662432163747E-2</c:v>
                </c:pt>
                <c:pt idx="537">
                  <c:v>0.4849114869108278</c:v>
                </c:pt>
                <c:pt idx="538">
                  <c:v>0.14600345113892463</c:v>
                </c:pt>
                <c:pt idx="539">
                  <c:v>-0.31455316495971475</c:v>
                </c:pt>
                <c:pt idx="540">
                  <c:v>0.16401388852505705</c:v>
                </c:pt>
                <c:pt idx="541">
                  <c:v>0.69081934015992674</c:v>
                </c:pt>
                <c:pt idx="542">
                  <c:v>-0.32897843240651226</c:v>
                </c:pt>
                <c:pt idx="543">
                  <c:v>-0.22414876896445868</c:v>
                </c:pt>
                <c:pt idx="544">
                  <c:v>-0.16990696786701084</c:v>
                </c:pt>
                <c:pt idx="545">
                  <c:v>2.8286243079109982E-2</c:v>
                </c:pt>
                <c:pt idx="546">
                  <c:v>0.2031384971908485</c:v>
                </c:pt>
                <c:pt idx="547">
                  <c:v>0.13500944135116105</c:v>
                </c:pt>
                <c:pt idx="548">
                  <c:v>-0.80540859722626634</c:v>
                </c:pt>
                <c:pt idx="549">
                  <c:v>2.9134804053022847E-2</c:v>
                </c:pt>
                <c:pt idx="550">
                  <c:v>-0.53199022590716771</c:v>
                </c:pt>
                <c:pt idx="551">
                  <c:v>0.51450103627428501</c:v>
                </c:pt>
                <c:pt idx="552">
                  <c:v>-0.35660554652010767</c:v>
                </c:pt>
                <c:pt idx="553">
                  <c:v>0.1655582544611737</c:v>
                </c:pt>
                <c:pt idx="554">
                  <c:v>0.49661573802968845</c:v>
                </c:pt>
                <c:pt idx="555">
                  <c:v>0.35377494493222345</c:v>
                </c:pt>
                <c:pt idx="556">
                  <c:v>-0.17837141075622645</c:v>
                </c:pt>
                <c:pt idx="557">
                  <c:v>-0.33133622229977933</c:v>
                </c:pt>
                <c:pt idx="558">
                  <c:v>-0.39270519918078745</c:v>
                </c:pt>
                <c:pt idx="559">
                  <c:v>9.4371210592517171E-2</c:v>
                </c:pt>
                <c:pt idx="560">
                  <c:v>-0.43987202391873631</c:v>
                </c:pt>
                <c:pt idx="561">
                  <c:v>-0.56682687595572434</c:v>
                </c:pt>
                <c:pt idx="562">
                  <c:v>-0.50225991139090687</c:v>
                </c:pt>
                <c:pt idx="563">
                  <c:v>-0.24827921322495461</c:v>
                </c:pt>
                <c:pt idx="564">
                  <c:v>-0.1373304107316016</c:v>
                </c:pt>
                <c:pt idx="565">
                  <c:v>-0.20058107800892003</c:v>
                </c:pt>
                <c:pt idx="566">
                  <c:v>-0.2409294091930991</c:v>
                </c:pt>
                <c:pt idx="567">
                  <c:v>0.16195215892674233</c:v>
                </c:pt>
                <c:pt idx="568">
                  <c:v>-0.45403163089470749</c:v>
                </c:pt>
                <c:pt idx="569">
                  <c:v>0.11703005301018697</c:v>
                </c:pt>
                <c:pt idx="570">
                  <c:v>0.17466207953358825</c:v>
                </c:pt>
                <c:pt idx="571">
                  <c:v>0.26002565596145555</c:v>
                </c:pt>
                <c:pt idx="572">
                  <c:v>7.1899931565633082E-2</c:v>
                </c:pt>
                <c:pt idx="573">
                  <c:v>1.2439736719193062</c:v>
                </c:pt>
                <c:pt idx="574">
                  <c:v>0.20201016731643198</c:v>
                </c:pt>
                <c:pt idx="575">
                  <c:v>-8.2835611945456133E-2</c:v>
                </c:pt>
                <c:pt idx="576">
                  <c:v>9.6936482502957083E-2</c:v>
                </c:pt>
                <c:pt idx="577">
                  <c:v>7.9975376720595889E-2</c:v>
                </c:pt>
                <c:pt idx="578">
                  <c:v>-0.12296254930130168</c:v>
                </c:pt>
                <c:pt idx="579">
                  <c:v>-0.38007057588392235</c:v>
                </c:pt>
                <c:pt idx="580">
                  <c:v>0.48150561657705548</c:v>
                </c:pt>
                <c:pt idx="581">
                  <c:v>0.10982856530708653</c:v>
                </c:pt>
                <c:pt idx="582">
                  <c:v>1.1267086021969683</c:v>
                </c:pt>
                <c:pt idx="583">
                  <c:v>-7.6432432067441491E-2</c:v>
                </c:pt>
                <c:pt idx="584">
                  <c:v>-0.32807261518526343</c:v>
                </c:pt>
                <c:pt idx="585">
                  <c:v>0.32077347694587044</c:v>
                </c:pt>
                <c:pt idx="586">
                  <c:v>0.27607972757473248</c:v>
                </c:pt>
                <c:pt idx="587">
                  <c:v>0.54873253179191894</c:v>
                </c:pt>
                <c:pt idx="588">
                  <c:v>-0.56853749722137059</c:v>
                </c:pt>
                <c:pt idx="589">
                  <c:v>-0.49309344541930672</c:v>
                </c:pt>
                <c:pt idx="590">
                  <c:v>0.40588347292225563</c:v>
                </c:pt>
                <c:pt idx="591">
                  <c:v>-0.24178211625787144</c:v>
                </c:pt>
                <c:pt idx="592">
                  <c:v>3.2012731423176928</c:v>
                </c:pt>
                <c:pt idx="593">
                  <c:v>0.24537396261816252</c:v>
                </c:pt>
                <c:pt idx="594">
                  <c:v>-0.2137382148826987</c:v>
                </c:pt>
                <c:pt idx="595">
                  <c:v>0.31034012061215049</c:v>
                </c:pt>
                <c:pt idx="596">
                  <c:v>0.16915535883089369</c:v>
                </c:pt>
                <c:pt idx="597">
                  <c:v>1.9488429591360157E-2</c:v>
                </c:pt>
                <c:pt idx="598">
                  <c:v>-0.10624949827943407</c:v>
                </c:pt>
                <c:pt idx="599">
                  <c:v>-1.038598926835721</c:v>
                </c:pt>
                <c:pt idx="600">
                  <c:v>-2.0779468942091602E-2</c:v>
                </c:pt>
                <c:pt idx="601">
                  <c:v>0.3430097825543898</c:v>
                </c:pt>
                <c:pt idx="602">
                  <c:v>0.59865104788460788</c:v>
                </c:pt>
                <c:pt idx="603">
                  <c:v>-0.56832355860736716</c:v>
                </c:pt>
                <c:pt idx="604">
                  <c:v>-6.2655607849767592E-2</c:v>
                </c:pt>
                <c:pt idx="605">
                  <c:v>0.23253796900851761</c:v>
                </c:pt>
                <c:pt idx="606">
                  <c:v>-0.25411731109774072</c:v>
                </c:pt>
                <c:pt idx="607">
                  <c:v>-0.13860038884256159</c:v>
                </c:pt>
                <c:pt idx="608">
                  <c:v>-0.5106625911106184</c:v>
                </c:pt>
                <c:pt idx="609">
                  <c:v>0.44932365699077959</c:v>
                </c:pt>
                <c:pt idx="610">
                  <c:v>0.25084033356164537</c:v>
                </c:pt>
                <c:pt idx="611">
                  <c:v>0.67536431274914566</c:v>
                </c:pt>
                <c:pt idx="612">
                  <c:v>0.31996469421646567</c:v>
                </c:pt>
                <c:pt idx="613">
                  <c:v>-8.7886695175194096E-2</c:v>
                </c:pt>
                <c:pt idx="614">
                  <c:v>0.54161395629221709</c:v>
                </c:pt>
                <c:pt idx="615">
                  <c:v>-0.36382783316411504</c:v>
                </c:pt>
                <c:pt idx="616">
                  <c:v>0.16838530541475208</c:v>
                </c:pt>
                <c:pt idx="617">
                  <c:v>2.8569152196770919E-2</c:v>
                </c:pt>
                <c:pt idx="618">
                  <c:v>0.3520805137298626</c:v>
                </c:pt>
                <c:pt idx="619">
                  <c:v>-1.1184136837566039</c:v>
                </c:pt>
                <c:pt idx="620">
                  <c:v>-0.11403524324602944</c:v>
                </c:pt>
                <c:pt idx="621">
                  <c:v>2.0911065581689963E-2</c:v>
                </c:pt>
                <c:pt idx="622">
                  <c:v>0.71905198164157935</c:v>
                </c:pt>
                <c:pt idx="623">
                  <c:v>-0.28454587288428235</c:v>
                </c:pt>
                <c:pt idx="624">
                  <c:v>-0.50307753399192878</c:v>
                </c:pt>
                <c:pt idx="625">
                  <c:v>0.18865411783672911</c:v>
                </c:pt>
                <c:pt idx="626">
                  <c:v>-0.54435057268358478</c:v>
                </c:pt>
                <c:pt idx="627">
                  <c:v>0.10366548276569647</c:v>
                </c:pt>
                <c:pt idx="628">
                  <c:v>-0.11200690402352172</c:v>
                </c:pt>
                <c:pt idx="629">
                  <c:v>5.199846779700238E-2</c:v>
                </c:pt>
                <c:pt idx="630">
                  <c:v>2.3894042655701022E-2</c:v>
                </c:pt>
                <c:pt idx="631">
                  <c:v>0.10996225339881809</c:v>
                </c:pt>
                <c:pt idx="632">
                  <c:v>-3.0324536856797681E-2</c:v>
                </c:pt>
                <c:pt idx="633">
                  <c:v>-0.31545053081615754</c:v>
                </c:pt>
                <c:pt idx="634">
                  <c:v>-0.62393192886631443</c:v>
                </c:pt>
                <c:pt idx="635">
                  <c:v>3.9278795351367586E-2</c:v>
                </c:pt>
                <c:pt idx="636">
                  <c:v>5.0466870350661899E-2</c:v>
                </c:pt>
                <c:pt idx="637">
                  <c:v>3.2524065692199365E-2</c:v>
                </c:pt>
                <c:pt idx="638">
                  <c:v>-0.2942432179502027</c:v>
                </c:pt>
                <c:pt idx="639">
                  <c:v>0.37072227514816719</c:v>
                </c:pt>
                <c:pt idx="640">
                  <c:v>0.24330348691813794</c:v>
                </c:pt>
                <c:pt idx="641">
                  <c:v>-0.12673800462151313</c:v>
                </c:pt>
                <c:pt idx="642">
                  <c:v>-3.1798630211659788E-2</c:v>
                </c:pt>
                <c:pt idx="643">
                  <c:v>-0.25515002054834335</c:v>
                </c:pt>
                <c:pt idx="644">
                  <c:v>0.10259094958809113</c:v>
                </c:pt>
                <c:pt idx="645">
                  <c:v>-0.27264584631915878</c:v>
                </c:pt>
                <c:pt idx="646">
                  <c:v>0.78517387442265874</c:v>
                </c:pt>
                <c:pt idx="647">
                  <c:v>-1.2169823462727122E-2</c:v>
                </c:pt>
                <c:pt idx="648">
                  <c:v>1.8365705154171519</c:v>
                </c:pt>
                <c:pt idx="649">
                  <c:v>-5.2296443946923198E-2</c:v>
                </c:pt>
                <c:pt idx="650">
                  <c:v>0.36714737465794428</c:v>
                </c:pt>
                <c:pt idx="651">
                  <c:v>5.9078342201253034E-2</c:v>
                </c:pt>
                <c:pt idx="652">
                  <c:v>-0.54687755340418753</c:v>
                </c:pt>
                <c:pt idx="653">
                  <c:v>-0.3248163742121889</c:v>
                </c:pt>
                <c:pt idx="654">
                  <c:v>5.3945424962785253E-2</c:v>
                </c:pt>
                <c:pt idx="655">
                  <c:v>-0.2150772984371388</c:v>
                </c:pt>
                <c:pt idx="656">
                  <c:v>0.42996404351694661</c:v>
                </c:pt>
                <c:pt idx="657">
                  <c:v>-0.31204350595551827</c:v>
                </c:pt>
                <c:pt idx="658">
                  <c:v>0.1247251523988885</c:v>
                </c:pt>
                <c:pt idx="659">
                  <c:v>-3.475134315576546E-2</c:v>
                </c:pt>
                <c:pt idx="660">
                  <c:v>-0.22684760298594764</c:v>
                </c:pt>
                <c:pt idx="661">
                  <c:v>0.39319651187040622</c:v>
                </c:pt>
                <c:pt idx="662">
                  <c:v>-0.42468766931256319</c:v>
                </c:pt>
                <c:pt idx="663">
                  <c:v>0.70318931451410405</c:v>
                </c:pt>
                <c:pt idx="664">
                  <c:v>-1.5665855159511612E-2</c:v>
                </c:pt>
                <c:pt idx="665">
                  <c:v>-0.21256753548313209</c:v>
                </c:pt>
                <c:pt idx="666">
                  <c:v>0.39033751161592428</c:v>
                </c:pt>
                <c:pt idx="667">
                  <c:v>-0.19859298163428171</c:v>
                </c:pt>
                <c:pt idx="668">
                  <c:v>-1.5864059175908247</c:v>
                </c:pt>
                <c:pt idx="669">
                  <c:v>-9.2032594053468059E-2</c:v>
                </c:pt>
                <c:pt idx="670">
                  <c:v>6.5985829498585336E-2</c:v>
                </c:pt>
                <c:pt idx="671">
                  <c:v>-6.3559929885785321E-2</c:v>
                </c:pt>
                <c:pt idx="672">
                  <c:v>0.19937396072182095</c:v>
                </c:pt>
                <c:pt idx="673">
                  <c:v>-7.7041035763828009E-2</c:v>
                </c:pt>
                <c:pt idx="674">
                  <c:v>9.5856923914830514E-2</c:v>
                </c:pt>
                <c:pt idx="675">
                  <c:v>0.22230997926431559</c:v>
                </c:pt>
                <c:pt idx="676">
                  <c:v>0.63329170046390337</c:v>
                </c:pt>
                <c:pt idx="677">
                  <c:v>-3.3421874432389906E-2</c:v>
                </c:pt>
                <c:pt idx="678">
                  <c:v>-0.38345409674893161</c:v>
                </c:pt>
                <c:pt idx="679">
                  <c:v>7.7379740797013583E-2</c:v>
                </c:pt>
                <c:pt idx="680">
                  <c:v>-7.7041035763828009E-2</c:v>
                </c:pt>
                <c:pt idx="681">
                  <c:v>-3.3717206069222426E-2</c:v>
                </c:pt>
                <c:pt idx="682">
                  <c:v>-0.88310298171173773</c:v>
                </c:pt>
                <c:pt idx="683">
                  <c:v>-0.37538436686235355</c:v>
                </c:pt>
                <c:pt idx="684">
                  <c:v>0.47622613254623242</c:v>
                </c:pt>
                <c:pt idx="685">
                  <c:v>-2.8410464469938029E-2</c:v>
                </c:pt>
                <c:pt idx="686">
                  <c:v>-0.49349960956638378</c:v>
                </c:pt>
                <c:pt idx="687">
                  <c:v>-0.51189636687642337</c:v>
                </c:pt>
                <c:pt idx="688">
                  <c:v>-0.77373810580879232</c:v>
                </c:pt>
                <c:pt idx="689">
                  <c:v>0.27703255187479342</c:v>
                </c:pt>
                <c:pt idx="690">
                  <c:v>0.19748800240598138</c:v>
                </c:pt>
                <c:pt idx="691">
                  <c:v>0.39583056973269676</c:v>
                </c:pt>
                <c:pt idx="692">
                  <c:v>-4.7964695992527992E-2</c:v>
                </c:pt>
                <c:pt idx="693">
                  <c:v>6.6123642465293633E-2</c:v>
                </c:pt>
                <c:pt idx="694">
                  <c:v>-0.10904752854297758</c:v>
                </c:pt>
                <c:pt idx="695">
                  <c:v>-0.3823253745313186</c:v>
                </c:pt>
                <c:pt idx="696">
                  <c:v>0.13894549792384134</c:v>
                </c:pt>
                <c:pt idx="697">
                  <c:v>0.29242839288671801</c:v>
                </c:pt>
                <c:pt idx="698">
                  <c:v>-0.13083926159988268</c:v>
                </c:pt>
                <c:pt idx="699">
                  <c:v>-0.13875921474032632</c:v>
                </c:pt>
                <c:pt idx="700">
                  <c:v>-0.23446525363702297</c:v>
                </c:pt>
                <c:pt idx="701">
                  <c:v>-0.15264443377163267</c:v>
                </c:pt>
                <c:pt idx="702">
                  <c:v>0.43221114917121922</c:v>
                </c:pt>
                <c:pt idx="703">
                  <c:v>-9.2629213289679192E-3</c:v>
                </c:pt>
                <c:pt idx="704">
                  <c:v>-0.45977429940446057</c:v>
                </c:pt>
                <c:pt idx="705">
                  <c:v>-0.21290191838899539</c:v>
                </c:pt>
                <c:pt idx="706">
                  <c:v>-1.7271038701404111E-2</c:v>
                </c:pt>
                <c:pt idx="707">
                  <c:v>-0.11982386636880067</c:v>
                </c:pt>
                <c:pt idx="708">
                  <c:v>4.6092532525896721E-3</c:v>
                </c:pt>
                <c:pt idx="709">
                  <c:v>8.1339627451938776E-2</c:v>
                </c:pt>
                <c:pt idx="710">
                  <c:v>-0.11231877065700785</c:v>
                </c:pt>
                <c:pt idx="711">
                  <c:v>0.39802195018119962</c:v>
                </c:pt>
                <c:pt idx="712">
                  <c:v>-0.27177470624022387</c:v>
                </c:pt>
                <c:pt idx="713">
                  <c:v>-0.35125846950827233</c:v>
                </c:pt>
                <c:pt idx="714">
                  <c:v>-0.55109904885487226</c:v>
                </c:pt>
                <c:pt idx="715">
                  <c:v>0.75060650483559255</c:v>
                </c:pt>
                <c:pt idx="716">
                  <c:v>-0.30828718421797618</c:v>
                </c:pt>
                <c:pt idx="717">
                  <c:v>0.34834574511348082</c:v>
                </c:pt>
                <c:pt idx="718">
                  <c:v>-0.65517150300255889</c:v>
                </c:pt>
                <c:pt idx="719">
                  <c:v>0.21213350753375612</c:v>
                </c:pt>
                <c:pt idx="720">
                  <c:v>0.32469541358922055</c:v>
                </c:pt>
                <c:pt idx="721">
                  <c:v>-0.88683294326726525</c:v>
                </c:pt>
                <c:pt idx="722">
                  <c:v>-0.45482236538470772</c:v>
                </c:pt>
                <c:pt idx="723">
                  <c:v>-0.41580714189026247</c:v>
                </c:pt>
                <c:pt idx="724">
                  <c:v>-1.3259009714622862</c:v>
                </c:pt>
                <c:pt idx="725">
                  <c:v>-7.597614772199382E-2</c:v>
                </c:pt>
                <c:pt idx="726">
                  <c:v>-0.3808217839409308</c:v>
                </c:pt>
                <c:pt idx="727">
                  <c:v>1.231493850710315</c:v>
                </c:pt>
                <c:pt idx="728">
                  <c:v>-1.6734626518600482</c:v>
                </c:pt>
                <c:pt idx="729">
                  <c:v>1.8349309878891815E-2</c:v>
                </c:pt>
                <c:pt idx="730">
                  <c:v>-0.1102928415602128</c:v>
                </c:pt>
                <c:pt idx="731">
                  <c:v>-1.0391917746110202</c:v>
                </c:pt>
                <c:pt idx="732">
                  <c:v>9.8823768379691534E-2</c:v>
                </c:pt>
                <c:pt idx="733">
                  <c:v>0.56071495447447905</c:v>
                </c:pt>
                <c:pt idx="734">
                  <c:v>0.59263642860657728</c:v>
                </c:pt>
                <c:pt idx="735">
                  <c:v>-0.36940814584951631</c:v>
                </c:pt>
                <c:pt idx="736">
                  <c:v>0.43060643092981143</c:v>
                </c:pt>
                <c:pt idx="737">
                  <c:v>0.54468320538364989</c:v>
                </c:pt>
                <c:pt idx="738">
                  <c:v>0.50761706680430763</c:v>
                </c:pt>
                <c:pt idx="739">
                  <c:v>-0.15457016714884828</c:v>
                </c:pt>
                <c:pt idx="740">
                  <c:v>-7.0057546185427227E-2</c:v>
                </c:pt>
                <c:pt idx="741">
                  <c:v>2.4745190197137796E-2</c:v>
                </c:pt>
                <c:pt idx="742">
                  <c:v>-0.21173191713316272</c:v>
                </c:pt>
                <c:pt idx="743">
                  <c:v>1.0907179597677998</c:v>
                </c:pt>
                <c:pt idx="744">
                  <c:v>1.866235420696214</c:v>
                </c:pt>
                <c:pt idx="745">
                  <c:v>0.47622613254623242</c:v>
                </c:pt>
                <c:pt idx="746">
                  <c:v>0.21536797220347947</c:v>
                </c:pt>
                <c:pt idx="747">
                  <c:v>0.22391675051899007</c:v>
                </c:pt>
                <c:pt idx="748">
                  <c:v>-0.29053289861182807</c:v>
                </c:pt>
                <c:pt idx="749">
                  <c:v>0.10581215112923141</c:v>
                </c:pt>
                <c:pt idx="750">
                  <c:v>0.23756371831767567</c:v>
                </c:pt>
                <c:pt idx="751">
                  <c:v>-0.46853120058982251</c:v>
                </c:pt>
                <c:pt idx="752">
                  <c:v>0.49906773783962793</c:v>
                </c:pt>
                <c:pt idx="753">
                  <c:v>-0.37838178654261423</c:v>
                </c:pt>
                <c:pt idx="754">
                  <c:v>0.5164186416338683</c:v>
                </c:pt>
                <c:pt idx="755">
                  <c:v>-0.34941923539775971</c:v>
                </c:pt>
                <c:pt idx="756">
                  <c:v>3.1395196275534318E-2</c:v>
                </c:pt>
                <c:pt idx="757">
                  <c:v>9.1259766192678296E-2</c:v>
                </c:pt>
                <c:pt idx="758">
                  <c:v>-5.2446046792589351E-2</c:v>
                </c:pt>
                <c:pt idx="759">
                  <c:v>-6.3618645684135602E-3</c:v>
                </c:pt>
                <c:pt idx="760">
                  <c:v>0.58188146369133464</c:v>
                </c:pt>
                <c:pt idx="761">
                  <c:v>0.93900084506951331</c:v>
                </c:pt>
                <c:pt idx="762">
                  <c:v>0.12776532814854508</c:v>
                </c:pt>
                <c:pt idx="763">
                  <c:v>4.9909522443057998E-2</c:v>
                </c:pt>
                <c:pt idx="764">
                  <c:v>4.7677975144475609E-2</c:v>
                </c:pt>
                <c:pt idx="765">
                  <c:v>0.54468320538364989</c:v>
                </c:pt>
                <c:pt idx="766">
                  <c:v>-0.29018003202308379</c:v>
                </c:pt>
                <c:pt idx="767">
                  <c:v>-6.5370276300336816E-2</c:v>
                </c:pt>
                <c:pt idx="768">
                  <c:v>0.48212546407999074</c:v>
                </c:pt>
                <c:pt idx="769">
                  <c:v>-0.27980910616740334</c:v>
                </c:pt>
                <c:pt idx="770">
                  <c:v>0.15691431465323905</c:v>
                </c:pt>
                <c:pt idx="771">
                  <c:v>7.2586047068596546E-2</c:v>
                </c:pt>
                <c:pt idx="772">
                  <c:v>0.42717705468210015</c:v>
                </c:pt>
                <c:pt idx="773">
                  <c:v>0.26555691560250466</c:v>
                </c:pt>
                <c:pt idx="774">
                  <c:v>-0.18557262613875183</c:v>
                </c:pt>
                <c:pt idx="775">
                  <c:v>-0.30703724722708142</c:v>
                </c:pt>
                <c:pt idx="776">
                  <c:v>1.4426229109453829E-4</c:v>
                </c:pt>
                <c:pt idx="777">
                  <c:v>0.29854101851653081</c:v>
                </c:pt>
                <c:pt idx="778">
                  <c:v>0.29947912798038351</c:v>
                </c:pt>
                <c:pt idx="779">
                  <c:v>0.27417218902278639</c:v>
                </c:pt>
                <c:pt idx="780">
                  <c:v>0.33376719165822422</c:v>
                </c:pt>
                <c:pt idx="781">
                  <c:v>0.16427139768074095</c:v>
                </c:pt>
                <c:pt idx="782">
                  <c:v>0.30322547767208885</c:v>
                </c:pt>
                <c:pt idx="783">
                  <c:v>-0.3402580727822303</c:v>
                </c:pt>
                <c:pt idx="784">
                  <c:v>-0.84037081417877213</c:v>
                </c:pt>
                <c:pt idx="785">
                  <c:v>-0.36086046861957166</c:v>
                </c:pt>
                <c:pt idx="786">
                  <c:v>1.7779412561234692E-2</c:v>
                </c:pt>
                <c:pt idx="787">
                  <c:v>-0.86906913017355136</c:v>
                </c:pt>
                <c:pt idx="788">
                  <c:v>-5.5891200892045148E-2</c:v>
                </c:pt>
                <c:pt idx="789">
                  <c:v>-8.359979176145306E-2</c:v>
                </c:pt>
                <c:pt idx="790">
                  <c:v>-0.15344651031471868</c:v>
                </c:pt>
                <c:pt idx="791">
                  <c:v>8.1475981597958602E-2</c:v>
                </c:pt>
                <c:pt idx="792">
                  <c:v>6.1983516108957325E-2</c:v>
                </c:pt>
                <c:pt idx="793">
                  <c:v>-0.17706595197162872</c:v>
                </c:pt>
                <c:pt idx="794">
                  <c:v>-0.61484510311565621</c:v>
                </c:pt>
                <c:pt idx="795">
                  <c:v>-0.22431729826094016</c:v>
                </c:pt>
                <c:pt idx="796">
                  <c:v>0.23450132056221062</c:v>
                </c:pt>
                <c:pt idx="797">
                  <c:v>0.14964958189497543</c:v>
                </c:pt>
                <c:pt idx="798">
                  <c:v>-6.7636408565144385E-2</c:v>
                </c:pt>
                <c:pt idx="799">
                  <c:v>0.2237932162430325</c:v>
                </c:pt>
                <c:pt idx="800">
                  <c:v>-0.44536203613564135</c:v>
                </c:pt>
                <c:pt idx="801">
                  <c:v>-0.72690191082150868</c:v>
                </c:pt>
                <c:pt idx="802">
                  <c:v>-0.14416972531623412</c:v>
                </c:pt>
                <c:pt idx="803">
                  <c:v>-4.0526573510452642E-2</c:v>
                </c:pt>
                <c:pt idx="804">
                  <c:v>-0.40908664974409176</c:v>
                </c:pt>
                <c:pt idx="805">
                  <c:v>-0.38986692354393793</c:v>
                </c:pt>
                <c:pt idx="806">
                  <c:v>0.11076412189980746</c:v>
                </c:pt>
                <c:pt idx="807">
                  <c:v>-0.26361159929653949</c:v>
                </c:pt>
                <c:pt idx="808">
                  <c:v>-0.19231535675689287</c:v>
                </c:pt>
                <c:pt idx="809">
                  <c:v>0.43231806694952352</c:v>
                </c:pt>
                <c:pt idx="810">
                  <c:v>0.56890767412739596</c:v>
                </c:pt>
                <c:pt idx="811">
                  <c:v>-0.52907274252487346</c:v>
                </c:pt>
                <c:pt idx="812">
                  <c:v>-0.37725702423962809</c:v>
                </c:pt>
                <c:pt idx="813">
                  <c:v>0.30217279974075217</c:v>
                </c:pt>
                <c:pt idx="814">
                  <c:v>0.28782686728508117</c:v>
                </c:pt>
                <c:pt idx="815">
                  <c:v>0.16838530541475208</c:v>
                </c:pt>
                <c:pt idx="816">
                  <c:v>8.8141596869017569E-2</c:v>
                </c:pt>
                <c:pt idx="817">
                  <c:v>-0.23837430779751656</c:v>
                </c:pt>
                <c:pt idx="818">
                  <c:v>3.5201595718566084E-2</c:v>
                </c:pt>
                <c:pt idx="819">
                  <c:v>0.16104922490055676</c:v>
                </c:pt>
                <c:pt idx="820">
                  <c:v>0.19219416528334513</c:v>
                </c:pt>
                <c:pt idx="821">
                  <c:v>0.27441076931783798</c:v>
                </c:pt>
                <c:pt idx="822">
                  <c:v>0.40152125010860007</c:v>
                </c:pt>
                <c:pt idx="823">
                  <c:v>0.17376706773670639</c:v>
                </c:pt>
                <c:pt idx="824">
                  <c:v>-0.12170625659895835</c:v>
                </c:pt>
                <c:pt idx="825">
                  <c:v>1.9203733973092663E-2</c:v>
                </c:pt>
                <c:pt idx="826">
                  <c:v>0.44784364436208551</c:v>
                </c:pt>
                <c:pt idx="827">
                  <c:v>0.1949695500934179</c:v>
                </c:pt>
                <c:pt idx="828">
                  <c:v>0.20451636970277204</c:v>
                </c:pt>
                <c:pt idx="829">
                  <c:v>0.55591429424339844</c:v>
                </c:pt>
                <c:pt idx="830">
                  <c:v>4.8236185652847631E-2</c:v>
                </c:pt>
                <c:pt idx="831">
                  <c:v>-0.25085193287640339</c:v>
                </c:pt>
                <c:pt idx="832">
                  <c:v>-5.5891200892045148E-2</c:v>
                </c:pt>
                <c:pt idx="833">
                  <c:v>0.16427139768074095</c:v>
                </c:pt>
                <c:pt idx="834">
                  <c:v>-0.14209860403606026</c:v>
                </c:pt>
                <c:pt idx="835">
                  <c:v>-0.90131095590867172</c:v>
                </c:pt>
                <c:pt idx="836">
                  <c:v>-1.6687128932879054E-2</c:v>
                </c:pt>
                <c:pt idx="837">
                  <c:v>-1.6524477230099359</c:v>
                </c:pt>
                <c:pt idx="838">
                  <c:v>-5.6191168673745184E-2</c:v>
                </c:pt>
                <c:pt idx="839">
                  <c:v>-0.51581029885173313</c:v>
                </c:pt>
                <c:pt idx="840">
                  <c:v>-0.35512851026015863</c:v>
                </c:pt>
                <c:pt idx="841">
                  <c:v>6.8464450966905732E-2</c:v>
                </c:pt>
                <c:pt idx="842">
                  <c:v>-3.1208812116408833E-2</c:v>
                </c:pt>
                <c:pt idx="843">
                  <c:v>-0.43908943912011134</c:v>
                </c:pt>
                <c:pt idx="844">
                  <c:v>4.8096653272944018E-2</c:v>
                </c:pt>
                <c:pt idx="845">
                  <c:v>1.2827956160179461</c:v>
                </c:pt>
                <c:pt idx="846">
                  <c:v>-0.46136251482935686</c:v>
                </c:pt>
                <c:pt idx="847">
                  <c:v>-0.20889442958747079</c:v>
                </c:pt>
                <c:pt idx="848">
                  <c:v>-9.8969011800408166E-2</c:v>
                </c:pt>
                <c:pt idx="849">
                  <c:v>0.20050435344652129</c:v>
                </c:pt>
                <c:pt idx="850">
                  <c:v>4.6141781644720638E-2</c:v>
                </c:pt>
                <c:pt idx="851">
                  <c:v>0.41629930547987942</c:v>
                </c:pt>
                <c:pt idx="852">
                  <c:v>-0.18672159545668776</c:v>
                </c:pt>
                <c:pt idx="853">
                  <c:v>0.25785546411515703</c:v>
                </c:pt>
                <c:pt idx="854">
                  <c:v>0.33032892730232616</c:v>
                </c:pt>
                <c:pt idx="855">
                  <c:v>-0.36327098721025225</c:v>
                </c:pt>
                <c:pt idx="856">
                  <c:v>2.5737561413608275E-2</c:v>
                </c:pt>
                <c:pt idx="857">
                  <c:v>0.4052299797625592</c:v>
                </c:pt>
                <c:pt idx="858">
                  <c:v>-0.13574450858125972</c:v>
                </c:pt>
                <c:pt idx="859">
                  <c:v>0.13907651504611174</c:v>
                </c:pt>
                <c:pt idx="860">
                  <c:v>-1.7417053077409407E-2</c:v>
                </c:pt>
                <c:pt idx="861">
                  <c:v>0.37183761733042053</c:v>
                </c:pt>
                <c:pt idx="862">
                  <c:v>-0.33278908751912922</c:v>
                </c:pt>
                <c:pt idx="863">
                  <c:v>-9.68074392029252E-2</c:v>
                </c:pt>
                <c:pt idx="864">
                  <c:v>0.25507768200545078</c:v>
                </c:pt>
                <c:pt idx="865">
                  <c:v>7.4231394185792027E-2</c:v>
                </c:pt>
                <c:pt idx="866">
                  <c:v>-9.2340172146710586E-2</c:v>
                </c:pt>
                <c:pt idx="867">
                  <c:v>-3.1774255410241372E-3</c:v>
                </c:pt>
                <c:pt idx="868">
                  <c:v>-0.66223182907836953</c:v>
                </c:pt>
                <c:pt idx="869">
                  <c:v>6.0047383669938899E-2</c:v>
                </c:pt>
                <c:pt idx="870">
                  <c:v>-1.4699292577749161</c:v>
                </c:pt>
                <c:pt idx="871">
                  <c:v>-9.6190441421302994E-2</c:v>
                </c:pt>
                <c:pt idx="872">
                  <c:v>-8.9420824457239506E-2</c:v>
                </c:pt>
                <c:pt idx="873">
                  <c:v>-0.46454420056470835</c:v>
                </c:pt>
                <c:pt idx="874">
                  <c:v>0.23388806017427727</c:v>
                </c:pt>
                <c:pt idx="875">
                  <c:v>0.3558056389440718</c:v>
                </c:pt>
                <c:pt idx="876">
                  <c:v>0.43242497680476449</c:v>
                </c:pt>
                <c:pt idx="877">
                  <c:v>-0.15971805857305543</c:v>
                </c:pt>
                <c:pt idx="878">
                  <c:v>0.26531686651028885</c:v>
                </c:pt>
                <c:pt idx="879">
                  <c:v>-0.20406685268503655</c:v>
                </c:pt>
                <c:pt idx="880">
                  <c:v>0.16671544496642232</c:v>
                </c:pt>
                <c:pt idx="881">
                  <c:v>-0.30080375485175614</c:v>
                </c:pt>
                <c:pt idx="882">
                  <c:v>0.10688428869154284</c:v>
                </c:pt>
                <c:pt idx="883">
                  <c:v>-0.19000941602479479</c:v>
                </c:pt>
                <c:pt idx="884">
                  <c:v>0.21001473770927276</c:v>
                </c:pt>
                <c:pt idx="885">
                  <c:v>-4.364591535463163E-2</c:v>
                </c:pt>
                <c:pt idx="886">
                  <c:v>-0.13479380341282682</c:v>
                </c:pt>
                <c:pt idx="887">
                  <c:v>-0.21440760129576947</c:v>
                </c:pt>
                <c:pt idx="888">
                  <c:v>-0.79987234572639809</c:v>
                </c:pt>
                <c:pt idx="889">
                  <c:v>0.32964029003823003</c:v>
                </c:pt>
                <c:pt idx="890">
                  <c:v>-5.5591295467227582E-2</c:v>
                </c:pt>
                <c:pt idx="891">
                  <c:v>0.63115085772514512</c:v>
                </c:pt>
                <c:pt idx="892">
                  <c:v>-0.77497191674595101</c:v>
                </c:pt>
                <c:pt idx="893">
                  <c:v>-0.27508784068438985</c:v>
                </c:pt>
                <c:pt idx="894">
                  <c:v>-0.37781929577940754</c:v>
                </c:pt>
                <c:pt idx="895">
                  <c:v>-1.0988145063072605</c:v>
                </c:pt>
                <c:pt idx="896">
                  <c:v>-2.0047842048330423E-2</c:v>
                </c:pt>
                <c:pt idx="897">
                  <c:v>0.56881041488032458</c:v>
                </c:pt>
                <c:pt idx="898">
                  <c:v>-0.78687049999252012</c:v>
                </c:pt>
                <c:pt idx="899">
                  <c:v>-6.8695156349330821E-2</c:v>
                </c:pt>
                <c:pt idx="900">
                  <c:v>7.0114502661328182E-2</c:v>
                </c:pt>
                <c:pt idx="901">
                  <c:v>0.34255474547732023</c:v>
                </c:pt>
                <c:pt idx="902">
                  <c:v>0.14169436196453092</c:v>
                </c:pt>
                <c:pt idx="903">
                  <c:v>0.44572670334998421</c:v>
                </c:pt>
                <c:pt idx="904">
                  <c:v>-3.0029898840683307E-2</c:v>
                </c:pt>
                <c:pt idx="905">
                  <c:v>-0.27055599316633672</c:v>
                </c:pt>
                <c:pt idx="906">
                  <c:v>0.10151561549124424</c:v>
                </c:pt>
                <c:pt idx="907">
                  <c:v>-0.36810414094619553</c:v>
                </c:pt>
                <c:pt idx="908">
                  <c:v>-8.727349995147364E-2</c:v>
                </c:pt>
                <c:pt idx="909">
                  <c:v>-5.6191168673745184E-2</c:v>
                </c:pt>
                <c:pt idx="910">
                  <c:v>-0.34593113727091912</c:v>
                </c:pt>
                <c:pt idx="911">
                  <c:v>0.42621107202740416</c:v>
                </c:pt>
                <c:pt idx="912">
                  <c:v>-6.3861496576032364E-2</c:v>
                </c:pt>
                <c:pt idx="913">
                  <c:v>-1.1587974275211846E-2</c:v>
                </c:pt>
                <c:pt idx="914">
                  <c:v>-0.36810414094619553</c:v>
                </c:pt>
                <c:pt idx="915">
                  <c:v>0.41705585981314924</c:v>
                </c:pt>
                <c:pt idx="916">
                  <c:v>-0.29353575438771695</c:v>
                </c:pt>
                <c:pt idx="917">
                  <c:v>0.83139085751311381</c:v>
                </c:pt>
                <c:pt idx="918">
                  <c:v>2.8427704572667339E-2</c:v>
                </c:pt>
                <c:pt idx="919">
                  <c:v>-0.6576728268933526</c:v>
                </c:pt>
                <c:pt idx="920">
                  <c:v>5.1024003024466885E-2</c:v>
                </c:pt>
                <c:pt idx="921">
                  <c:v>-0.1832774289986982</c:v>
                </c:pt>
                <c:pt idx="922">
                  <c:v>-0.23463499245019467</c:v>
                </c:pt>
                <c:pt idx="923">
                  <c:v>-0.28472160770889682</c:v>
                </c:pt>
                <c:pt idx="924">
                  <c:v>4.0822310107341116E-2</c:v>
                </c:pt>
                <c:pt idx="925">
                  <c:v>2.9841557136715127E-2</c:v>
                </c:pt>
                <c:pt idx="926">
                  <c:v>6.8602027378671535E-2</c:v>
                </c:pt>
                <c:pt idx="927">
                  <c:v>-0.42004753116870497</c:v>
                </c:pt>
                <c:pt idx="928">
                  <c:v>7.5190314155219248E-2</c:v>
                </c:pt>
                <c:pt idx="929">
                  <c:v>-0.24485604151359347</c:v>
                </c:pt>
                <c:pt idx="930">
                  <c:v>-0.3455644591546006</c:v>
                </c:pt>
                <c:pt idx="931">
                  <c:v>0.57531233068743692</c:v>
                </c:pt>
                <c:pt idx="932">
                  <c:v>4.6840254202972352E-2</c:v>
                </c:pt>
                <c:pt idx="933">
                  <c:v>-1.3022261804448141</c:v>
                </c:pt>
                <c:pt idx="934">
                  <c:v>0.24013111833074791</c:v>
                </c:pt>
                <c:pt idx="935">
                  <c:v>6.983962506863442E-2</c:v>
                </c:pt>
                <c:pt idx="936">
                  <c:v>0.597793350242805</c:v>
                </c:pt>
                <c:pt idx="937">
                  <c:v>3.1959741397544997E-2</c:v>
                </c:pt>
                <c:pt idx="938">
                  <c:v>-1.2460836079122765E-2</c:v>
                </c:pt>
                <c:pt idx="939">
                  <c:v>-0.46215727867861967</c:v>
                </c:pt>
                <c:pt idx="940">
                  <c:v>2.5737561413608275E-2</c:v>
                </c:pt>
                <c:pt idx="941">
                  <c:v>0.18421680809224128</c:v>
                </c:pt>
                <c:pt idx="942">
                  <c:v>0.17645043911909955</c:v>
                </c:pt>
                <c:pt idx="943">
                  <c:v>-0.40277873159968802</c:v>
                </c:pt>
                <c:pt idx="944">
                  <c:v>-6.0547724927046763E-2</c:v>
                </c:pt>
                <c:pt idx="945">
                  <c:v>-7.6432432067441491E-2</c:v>
                </c:pt>
                <c:pt idx="946">
                  <c:v>-0.33752102957674851</c:v>
                </c:pt>
                <c:pt idx="947">
                  <c:v>-0.15392797036954209</c:v>
                </c:pt>
                <c:pt idx="948">
                  <c:v>0.58832486791191596</c:v>
                </c:pt>
                <c:pt idx="949">
                  <c:v>8.2975027257768202E-2</c:v>
                </c:pt>
                <c:pt idx="950">
                  <c:v>-0.98879063857969662</c:v>
                </c:pt>
                <c:pt idx="951">
                  <c:v>-5.3643428366365951E-2</c:v>
                </c:pt>
                <c:pt idx="952">
                  <c:v>6.6261442268721271E-2</c:v>
                </c:pt>
                <c:pt idx="953">
                  <c:v>-1.4434168696687186E-3</c:v>
                </c:pt>
                <c:pt idx="954">
                  <c:v>-3.0471878432873134E-2</c:v>
                </c:pt>
                <c:pt idx="955">
                  <c:v>0.21797514092288733</c:v>
                </c:pt>
                <c:pt idx="956">
                  <c:v>-0.5106625911106184</c:v>
                </c:pt>
                <c:pt idx="957">
                  <c:v>-0.12626553203144172</c:v>
                </c:pt>
                <c:pt idx="958">
                  <c:v>-8.6967000047858789E-2</c:v>
                </c:pt>
                <c:pt idx="959">
                  <c:v>-0.23786383009888792</c:v>
                </c:pt>
                <c:pt idx="960">
                  <c:v>-0.14034843614016634</c:v>
                </c:pt>
                <c:pt idx="961">
                  <c:v>0.58217059059184273</c:v>
                </c:pt>
                <c:pt idx="962">
                  <c:v>-0.9632505235721317</c:v>
                </c:pt>
                <c:pt idx="963">
                  <c:v>-0.21407286926621943</c:v>
                </c:pt>
                <c:pt idx="964">
                  <c:v>0.64607046922592271</c:v>
                </c:pt>
                <c:pt idx="965">
                  <c:v>-1.0528949484321255</c:v>
                </c:pt>
                <c:pt idx="966">
                  <c:v>-0.3090019204430921</c:v>
                </c:pt>
                <c:pt idx="967">
                  <c:v>-0.54140801184814435</c:v>
                </c:pt>
                <c:pt idx="968">
                  <c:v>4.7817548021369539E-2</c:v>
                </c:pt>
                <c:pt idx="969">
                  <c:v>0.1247251523988885</c:v>
                </c:pt>
                <c:pt idx="970">
                  <c:v>0.22687840419626878</c:v>
                </c:pt>
                <c:pt idx="971">
                  <c:v>0.10406822646371666</c:v>
                </c:pt>
                <c:pt idx="972">
                  <c:v>-0.15264443377163267</c:v>
                </c:pt>
                <c:pt idx="973">
                  <c:v>-0.76635731699119036</c:v>
                </c:pt>
                <c:pt idx="974">
                  <c:v>0.15613769788898613</c:v>
                </c:pt>
                <c:pt idx="975">
                  <c:v>-0.60669363964734724</c:v>
                </c:pt>
                <c:pt idx="976">
                  <c:v>0.20050435344652129</c:v>
                </c:pt>
                <c:pt idx="977">
                  <c:v>0.57937326706738745</c:v>
                </c:pt>
                <c:pt idx="978">
                  <c:v>0.21013945740166848</c:v>
                </c:pt>
                <c:pt idx="979">
                  <c:v>-0.14944057937722838</c:v>
                </c:pt>
                <c:pt idx="980">
                  <c:v>0.30801131455217762</c:v>
                </c:pt>
                <c:pt idx="981">
                  <c:v>-0.41792577860367019</c:v>
                </c:pt>
                <c:pt idx="982">
                  <c:v>2.6304324351908496E-2</c:v>
                </c:pt>
                <c:pt idx="983">
                  <c:v>0.12855736497375747</c:v>
                </c:pt>
                <c:pt idx="984">
                  <c:v>-0.56533174438564793</c:v>
                </c:pt>
                <c:pt idx="985">
                  <c:v>-0.60055543541054246</c:v>
                </c:pt>
                <c:pt idx="986">
                  <c:v>0.27810372755144197</c:v>
                </c:pt>
                <c:pt idx="987">
                  <c:v>0.2938412992667393</c:v>
                </c:pt>
                <c:pt idx="988">
                  <c:v>1.9346088804811971E-2</c:v>
                </c:pt>
                <c:pt idx="989">
                  <c:v>-0.40411447209405199</c:v>
                </c:pt>
                <c:pt idx="990">
                  <c:v>-0.68942720540284574</c:v>
                </c:pt>
                <c:pt idx="991">
                  <c:v>-0.47333019059787668</c:v>
                </c:pt>
                <c:pt idx="992">
                  <c:v>0.49292990666768804</c:v>
                </c:pt>
                <c:pt idx="993">
                  <c:v>1.2926174444270048E-2</c:v>
                </c:pt>
                <c:pt idx="994">
                  <c:v>0.14274017211608214</c:v>
                </c:pt>
                <c:pt idx="995">
                  <c:v>-0.18393282709782408</c:v>
                </c:pt>
                <c:pt idx="996">
                  <c:v>0.47767732756530717</c:v>
                </c:pt>
                <c:pt idx="997">
                  <c:v>0.51359180649957337</c:v>
                </c:pt>
                <c:pt idx="998">
                  <c:v>0.22292818000261269</c:v>
                </c:pt>
                <c:pt idx="999">
                  <c:v>0.34118877247874047</c:v>
                </c:pt>
                <c:pt idx="1000">
                  <c:v>-5.66412373221898E-2</c:v>
                </c:pt>
                <c:pt idx="1001">
                  <c:v>-8.0392953091645014E-2</c:v>
                </c:pt>
                <c:pt idx="1002">
                  <c:v>-0.49005085369568935</c:v>
                </c:pt>
                <c:pt idx="1003">
                  <c:v>0.33044366822900922</c:v>
                </c:pt>
                <c:pt idx="1004">
                  <c:v>0.35715784871975448</c:v>
                </c:pt>
                <c:pt idx="1005">
                  <c:v>1.9630756335508422E-2</c:v>
                </c:pt>
                <c:pt idx="1006">
                  <c:v>-0.14178023372893378</c:v>
                </c:pt>
                <c:pt idx="1007">
                  <c:v>-0.21859831777551078</c:v>
                </c:pt>
                <c:pt idx="1008">
                  <c:v>0.2519311266885868</c:v>
                </c:pt>
                <c:pt idx="1009">
                  <c:v>-0.16650266314016504</c:v>
                </c:pt>
                <c:pt idx="1010">
                  <c:v>0.26747587179649235</c:v>
                </c:pt>
                <c:pt idx="1011">
                  <c:v>0.1230039540548198</c:v>
                </c:pt>
                <c:pt idx="1012">
                  <c:v>-0.104387155024838</c:v>
                </c:pt>
                <c:pt idx="1013">
                  <c:v>-0.32879722345809981</c:v>
                </c:pt>
                <c:pt idx="1014">
                  <c:v>-0.60867219315638843</c:v>
                </c:pt>
                <c:pt idx="1015">
                  <c:v>-1.4434168696687186E-3</c:v>
                </c:pt>
                <c:pt idx="1016">
                  <c:v>0.41943102243145908</c:v>
                </c:pt>
                <c:pt idx="1017">
                  <c:v>0.46351783412869663</c:v>
                </c:pt>
                <c:pt idx="1018">
                  <c:v>-6.4917476681338543E-2</c:v>
                </c:pt>
                <c:pt idx="1019">
                  <c:v>0.12008647067252551</c:v>
                </c:pt>
                <c:pt idx="1020">
                  <c:v>-0.11419138752248348</c:v>
                </c:pt>
                <c:pt idx="1021">
                  <c:v>5.4640130538345412E-2</c:v>
                </c:pt>
                <c:pt idx="1022">
                  <c:v>-1.5374195390826201E-2</c:v>
                </c:pt>
                <c:pt idx="1023">
                  <c:v>0.34698524674227055</c:v>
                </c:pt>
                <c:pt idx="1024">
                  <c:v>0.23351997877391634</c:v>
                </c:pt>
                <c:pt idx="1025">
                  <c:v>4.2224073762984898E-2</c:v>
                </c:pt>
                <c:pt idx="1026">
                  <c:v>7.0664100778789651E-2</c:v>
                </c:pt>
                <c:pt idx="1027">
                  <c:v>-0.480558740371961</c:v>
                </c:pt>
                <c:pt idx="1028">
                  <c:v>7.6148597180082933E-2</c:v>
                </c:pt>
                <c:pt idx="1029">
                  <c:v>-3.8221459747400508</c:v>
                </c:pt>
                <c:pt idx="1030">
                  <c:v>-0.57626049283468372</c:v>
                </c:pt>
                <c:pt idx="1031">
                  <c:v>-0.36289987594366852</c:v>
                </c:pt>
                <c:pt idx="1032">
                  <c:v>-4.9606242117372572E-2</c:v>
                </c:pt>
                <c:pt idx="1033">
                  <c:v>0.23854231427915087</c:v>
                </c:pt>
                <c:pt idx="1034">
                  <c:v>-0.42914851657708047</c:v>
                </c:pt>
                <c:pt idx="1035">
                  <c:v>-0.12437718746748855</c:v>
                </c:pt>
                <c:pt idx="1036">
                  <c:v>4.97701518163845E-2</c:v>
                </c:pt>
                <c:pt idx="1037">
                  <c:v>-0.36661529144265709</c:v>
                </c:pt>
                <c:pt idx="1038">
                  <c:v>3.7593075540233077E-2</c:v>
                </c:pt>
                <c:pt idx="1039">
                  <c:v>-0.18475249363932542</c:v>
                </c:pt>
                <c:pt idx="1040">
                  <c:v>-7.0865820402710765E-3</c:v>
                </c:pt>
                <c:pt idx="1041">
                  <c:v>0.19861987321921495</c:v>
                </c:pt>
                <c:pt idx="1042">
                  <c:v>-1.7271038701404111E-2</c:v>
                </c:pt>
                <c:pt idx="1043">
                  <c:v>0.13619138628714406</c:v>
                </c:pt>
                <c:pt idx="1044">
                  <c:v>-8.2468877554856181E-3</c:v>
                </c:pt>
                <c:pt idx="1045">
                  <c:v>-0.21390553237095686</c:v>
                </c:pt>
                <c:pt idx="1046">
                  <c:v>-0.10951439496446924</c:v>
                </c:pt>
                <c:pt idx="1047">
                  <c:v>8.5016673488713876E-2</c:v>
                </c:pt>
                <c:pt idx="1048">
                  <c:v>1.874285531350833E-3</c:v>
                </c:pt>
                <c:pt idx="1049">
                  <c:v>-4.0823363275105495E-2</c:v>
                </c:pt>
                <c:pt idx="1050">
                  <c:v>0.35467782850445312</c:v>
                </c:pt>
                <c:pt idx="1051">
                  <c:v>-0.71311885221183846</c:v>
                </c:pt>
                <c:pt idx="1052">
                  <c:v>0.22255729134872837</c:v>
                </c:pt>
                <c:pt idx="1053">
                  <c:v>-2.6058163871946174E-2</c:v>
                </c:pt>
                <c:pt idx="1054">
                  <c:v>5.0745463581398975E-2</c:v>
                </c:pt>
                <c:pt idx="1055">
                  <c:v>1.2497162682902151E-2</c:v>
                </c:pt>
                <c:pt idx="1056">
                  <c:v>-0.34923544088309766</c:v>
                </c:pt>
                <c:pt idx="1057">
                  <c:v>4.7259175478012817E-2</c:v>
                </c:pt>
                <c:pt idx="1058">
                  <c:v>0.11356715704707816</c:v>
                </c:pt>
                <c:pt idx="1059">
                  <c:v>4.9630767724600428E-2</c:v>
                </c:pt>
                <c:pt idx="1060">
                  <c:v>0.36871248372833082</c:v>
                </c:pt>
                <c:pt idx="1061">
                  <c:v>-0.19759995988516069</c:v>
                </c:pt>
                <c:pt idx="1062">
                  <c:v>-6.0246850047772985E-2</c:v>
                </c:pt>
                <c:pt idx="1063">
                  <c:v>-0.20174206735549979</c:v>
                </c:pt>
                <c:pt idx="1064">
                  <c:v>-0.60099301352760304</c:v>
                </c:pt>
                <c:pt idx="1065">
                  <c:v>0.22292818000261269</c:v>
                </c:pt>
                <c:pt idx="1066">
                  <c:v>0.18510536254259161</c:v>
                </c:pt>
                <c:pt idx="1067">
                  <c:v>0.30065090764266472</c:v>
                </c:pt>
                <c:pt idx="1068">
                  <c:v>0.13316893348604381</c:v>
                </c:pt>
                <c:pt idx="1069">
                  <c:v>8.6376167596937337E-2</c:v>
                </c:pt>
                <c:pt idx="1070">
                  <c:v>-0.52782419632761446</c:v>
                </c:pt>
                <c:pt idx="1071">
                  <c:v>0.11330043583336066</c:v>
                </c:pt>
                <c:pt idx="1072">
                  <c:v>-0.36605736876439621</c:v>
                </c:pt>
                <c:pt idx="1073">
                  <c:v>-3.5490466611088241E-2</c:v>
                </c:pt>
                <c:pt idx="1074">
                  <c:v>-2.8704771904840675E-2</c:v>
                </c:pt>
                <c:pt idx="1075">
                  <c:v>3.7311930641966591E-2</c:v>
                </c:pt>
                <c:pt idx="1076">
                  <c:v>-9.1417634521186258E-2</c:v>
                </c:pt>
                <c:pt idx="1077">
                  <c:v>0.24683368791054239</c:v>
                </c:pt>
                <c:pt idx="1078">
                  <c:v>-0.27177470624022387</c:v>
                </c:pt>
                <c:pt idx="1079">
                  <c:v>0.57347147850007096</c:v>
                </c:pt>
                <c:pt idx="1080">
                  <c:v>3.6749476427868279E-2</c:v>
                </c:pt>
                <c:pt idx="1081">
                  <c:v>0.14169436196453092</c:v>
                </c:pt>
                <c:pt idx="1082">
                  <c:v>-0.47553507403500217</c:v>
                </c:pt>
                <c:pt idx="1083">
                  <c:v>6.2950608822807855E-2</c:v>
                </c:pt>
                <c:pt idx="1084">
                  <c:v>8.9904868421335535E-2</c:v>
                </c:pt>
                <c:pt idx="1085">
                  <c:v>-8.2530053320806804E-2</c:v>
                </c:pt>
                <c:pt idx="1086">
                  <c:v>-0.17169338622435606</c:v>
                </c:pt>
                <c:pt idx="1087">
                  <c:v>-7.4152452072991204E-2</c:v>
                </c:pt>
                <c:pt idx="1088">
                  <c:v>0.23253796900851761</c:v>
                </c:pt>
                <c:pt idx="1089">
                  <c:v>-0.14544574091374737</c:v>
                </c:pt>
                <c:pt idx="1090">
                  <c:v>0.13842131042024966</c:v>
                </c:pt>
                <c:pt idx="1091">
                  <c:v>0.23032600002869186</c:v>
                </c:pt>
                <c:pt idx="1092">
                  <c:v>0.26267368698183613</c:v>
                </c:pt>
                <c:pt idx="1093">
                  <c:v>0.21474652268239544</c:v>
                </c:pt>
                <c:pt idx="1094">
                  <c:v>-0.28665610491467075</c:v>
                </c:pt>
                <c:pt idx="1095">
                  <c:v>0.17248751551013405</c:v>
                </c:pt>
                <c:pt idx="1096">
                  <c:v>-0.36048997682480577</c:v>
                </c:pt>
                <c:pt idx="1097">
                  <c:v>-0.41157917950643264</c:v>
                </c:pt>
                <c:pt idx="1098">
                  <c:v>-5.3942929102523324E-2</c:v>
                </c:pt>
                <c:pt idx="1099">
                  <c:v>0.1497796305759026</c:v>
                </c:pt>
                <c:pt idx="1100">
                  <c:v>0.20414071678022522</c:v>
                </c:pt>
                <c:pt idx="1101">
                  <c:v>-0.51230786004546791</c:v>
                </c:pt>
                <c:pt idx="1102">
                  <c:v>-0.25377323882306224</c:v>
                </c:pt>
                <c:pt idx="1103">
                  <c:v>0.27369491003707908</c:v>
                </c:pt>
                <c:pt idx="1104">
                  <c:v>-0.12989178233582188</c:v>
                </c:pt>
                <c:pt idx="1105">
                  <c:v>-0.21809478858388701</c:v>
                </c:pt>
                <c:pt idx="1106">
                  <c:v>0.4037040102509617</c:v>
                </c:pt>
                <c:pt idx="1107">
                  <c:v>0.22218630732211234</c:v>
                </c:pt>
                <c:pt idx="1108">
                  <c:v>0.21723071622066917</c:v>
                </c:pt>
                <c:pt idx="1109">
                  <c:v>-0.15585541894065663</c:v>
                </c:pt>
                <c:pt idx="1110">
                  <c:v>-1.2460836079122765E-2</c:v>
                </c:pt>
                <c:pt idx="1111">
                  <c:v>0.13606010688026618</c:v>
                </c:pt>
                <c:pt idx="1112">
                  <c:v>2.488699931317951E-2</c:v>
                </c:pt>
                <c:pt idx="1113">
                  <c:v>0.13264264253961866</c:v>
                </c:pt>
                <c:pt idx="1114">
                  <c:v>0.39011735366633044</c:v>
                </c:pt>
                <c:pt idx="1115">
                  <c:v>-0.14337278830160996</c:v>
                </c:pt>
                <c:pt idx="1116">
                  <c:v>0.22329897333278972</c:v>
                </c:pt>
                <c:pt idx="1117">
                  <c:v>-0.472128945698427</c:v>
                </c:pt>
                <c:pt idx="1118">
                  <c:v>0.5730836311851768</c:v>
                </c:pt>
                <c:pt idx="1119">
                  <c:v>-0.2610160452994883</c:v>
                </c:pt>
                <c:pt idx="1120">
                  <c:v>0.21263158972095403</c:v>
                </c:pt>
                <c:pt idx="1121">
                  <c:v>0.15042969819420526</c:v>
                </c:pt>
                <c:pt idx="1122">
                  <c:v>0.1028596579220564</c:v>
                </c:pt>
                <c:pt idx="1123">
                  <c:v>1.0806576633452252</c:v>
                </c:pt>
                <c:pt idx="1124">
                  <c:v>-0.9037381469415966</c:v>
                </c:pt>
                <c:pt idx="1125">
                  <c:v>-0.42643157596074061</c:v>
                </c:pt>
                <c:pt idx="1126">
                  <c:v>-4.528255199173857E-2</c:v>
                </c:pt>
                <c:pt idx="1127">
                  <c:v>-0.16828486848217453</c:v>
                </c:pt>
                <c:pt idx="1128">
                  <c:v>-0.52056246726459654</c:v>
                </c:pt>
                <c:pt idx="1129">
                  <c:v>4.4184257544003833E-2</c:v>
                </c:pt>
                <c:pt idx="1130">
                  <c:v>5.0606173690787397E-2</c:v>
                </c:pt>
                <c:pt idx="1131">
                  <c:v>-0.23905522582355559</c:v>
                </c:pt>
                <c:pt idx="1132">
                  <c:v>-0.31832585820716669</c:v>
                </c:pt>
                <c:pt idx="1133">
                  <c:v>0.48604499259034967</c:v>
                </c:pt>
                <c:pt idx="1134">
                  <c:v>-0.46414610590410044</c:v>
                </c:pt>
                <c:pt idx="1135">
                  <c:v>-0.2889456781879336</c:v>
                </c:pt>
                <c:pt idx="1136">
                  <c:v>-6.2053041258199659E-2</c:v>
                </c:pt>
                <c:pt idx="1137">
                  <c:v>0.44742050459049681</c:v>
                </c:pt>
                <c:pt idx="1138">
                  <c:v>-0.54203805554731532</c:v>
                </c:pt>
                <c:pt idx="1139">
                  <c:v>-1.2024339164626849E-2</c:v>
                </c:pt>
                <c:pt idx="1140">
                  <c:v>-0.24383067186070126</c:v>
                </c:pt>
                <c:pt idx="1141">
                  <c:v>0.30649557225963686</c:v>
                </c:pt>
                <c:pt idx="1142">
                  <c:v>-0.37819426525283456</c:v>
                </c:pt>
                <c:pt idx="1143">
                  <c:v>0.34619102979906985</c:v>
                </c:pt>
                <c:pt idx="1144">
                  <c:v>-4.7964695992527992E-2</c:v>
                </c:pt>
                <c:pt idx="1145">
                  <c:v>0.42739162968671807</c:v>
                </c:pt>
                <c:pt idx="1146">
                  <c:v>-0.52263351993276519</c:v>
                </c:pt>
                <c:pt idx="1147">
                  <c:v>0.40686315797653982</c:v>
                </c:pt>
                <c:pt idx="1148">
                  <c:v>-0.11778737810713708</c:v>
                </c:pt>
                <c:pt idx="1149">
                  <c:v>-0.35420612992000639</c:v>
                </c:pt>
                <c:pt idx="1150">
                  <c:v>-0.36698735979826891</c:v>
                </c:pt>
                <c:pt idx="1151">
                  <c:v>-3.9191774611020275E-2</c:v>
                </c:pt>
                <c:pt idx="1152">
                  <c:v>-0.11091590140185059</c:v>
                </c:pt>
                <c:pt idx="1153">
                  <c:v>0.22280456104526111</c:v>
                </c:pt>
                <c:pt idx="1154">
                  <c:v>5.8108649401173953E-2</c:v>
                </c:pt>
                <c:pt idx="1155">
                  <c:v>6.8877140850307828E-2</c:v>
                </c:pt>
                <c:pt idx="1156">
                  <c:v>0.10527578341568687</c:v>
                </c:pt>
                <c:pt idx="1157">
                  <c:v>-0.6438561897747247</c:v>
                </c:pt>
                <c:pt idx="1158">
                  <c:v>-0.47132867107472293</c:v>
                </c:pt>
                <c:pt idx="1159">
                  <c:v>0.17210342844013979</c:v>
                </c:pt>
                <c:pt idx="1160">
                  <c:v>0.32964029003823003</c:v>
                </c:pt>
                <c:pt idx="1161">
                  <c:v>-0.23022826075055217</c:v>
                </c:pt>
                <c:pt idx="1162">
                  <c:v>0.11742908358689449</c:v>
                </c:pt>
                <c:pt idx="1163">
                  <c:v>-2.5991910479572374E-3</c:v>
                </c:pt>
                <c:pt idx="1164">
                  <c:v>9.1936738210585178E-2</c:v>
                </c:pt>
                <c:pt idx="1165">
                  <c:v>-5.2595665153199515E-2</c:v>
                </c:pt>
                <c:pt idx="1166">
                  <c:v>-0.32174776927736698</c:v>
                </c:pt>
                <c:pt idx="1167">
                  <c:v>-0.17348201935847915</c:v>
                </c:pt>
                <c:pt idx="1168">
                  <c:v>0.30053377249536789</c:v>
                </c:pt>
                <c:pt idx="1169">
                  <c:v>0.42449217088920543</c:v>
                </c:pt>
                <c:pt idx="1170">
                  <c:v>-0.22381176942055567</c:v>
                </c:pt>
                <c:pt idx="1171">
                  <c:v>0.19093085956261455</c:v>
                </c:pt>
                <c:pt idx="1172">
                  <c:v>0.27917410848904678</c:v>
                </c:pt>
                <c:pt idx="1173">
                  <c:v>0.36781834360619331</c:v>
                </c:pt>
                <c:pt idx="1174">
                  <c:v>-0.14273555549933767</c:v>
                </c:pt>
                <c:pt idx="1175">
                  <c:v>-0.24810786159569104</c:v>
                </c:pt>
                <c:pt idx="1176">
                  <c:v>0.52105073690096315</c:v>
                </c:pt>
                <c:pt idx="1177">
                  <c:v>-0.42159258624637952</c:v>
                </c:pt>
                <c:pt idx="1178">
                  <c:v>5.0048879607222582E-2</c:v>
                </c:pt>
                <c:pt idx="1179">
                  <c:v>-0.68733482644160571</c:v>
                </c:pt>
                <c:pt idx="1180">
                  <c:v>-2.9988463053836298</c:v>
                </c:pt>
                <c:pt idx="1181">
                  <c:v>-0.25773503295987005</c:v>
                </c:pt>
                <c:pt idx="1182">
                  <c:v>0.41164317603901396</c:v>
                </c:pt>
                <c:pt idx="1183">
                  <c:v>-1.2024339164626849E-2</c:v>
                </c:pt>
                <c:pt idx="1184">
                  <c:v>-6.0547724927046763E-2</c:v>
                </c:pt>
                <c:pt idx="1185">
                  <c:v>-0.27770885825424452</c:v>
                </c:pt>
                <c:pt idx="1186">
                  <c:v>8.9226942070395526E-2</c:v>
                </c:pt>
                <c:pt idx="1187">
                  <c:v>2.786177535450958E-2</c:v>
                </c:pt>
                <c:pt idx="1188">
                  <c:v>9.4911647025466978E-2</c:v>
                </c:pt>
                <c:pt idx="1189">
                  <c:v>-0.81527537949811979</c:v>
                </c:pt>
                <c:pt idx="1190">
                  <c:v>-9.9890979390998176E-3</c:v>
                </c:pt>
                <c:pt idx="1191">
                  <c:v>-0.49268739558806196</c:v>
                </c:pt>
                <c:pt idx="1192">
                  <c:v>0.12974460550781922</c:v>
                </c:pt>
                <c:pt idx="1193">
                  <c:v>-0.41580714189026247</c:v>
                </c:pt>
                <c:pt idx="1194">
                  <c:v>-0.32789151996869614</c:v>
                </c:pt>
                <c:pt idx="1195">
                  <c:v>-0.24605322791223488</c:v>
                </c:pt>
                <c:pt idx="1196">
                  <c:v>-3.6377914890592389E-2</c:v>
                </c:pt>
                <c:pt idx="1197">
                  <c:v>-1.0209258388545479</c:v>
                </c:pt>
                <c:pt idx="1198">
                  <c:v>0.66893602711902955</c:v>
                </c:pt>
                <c:pt idx="1199">
                  <c:v>-0.63643640620281083</c:v>
                </c:pt>
                <c:pt idx="1200">
                  <c:v>-5.6941361109602261E-2</c:v>
                </c:pt>
                <c:pt idx="1201">
                  <c:v>-1.6541188409676479E-2</c:v>
                </c:pt>
                <c:pt idx="1202">
                  <c:v>0.2911320120087531</c:v>
                </c:pt>
                <c:pt idx="1203">
                  <c:v>0.12697285625776553</c:v>
                </c:pt>
                <c:pt idx="1204">
                  <c:v>0.31811434360977353</c:v>
                </c:pt>
                <c:pt idx="1205">
                  <c:v>-1.9316585992890892E-2</c:v>
                </c:pt>
                <c:pt idx="1206">
                  <c:v>0.52676995135481608</c:v>
                </c:pt>
                <c:pt idx="1207">
                  <c:v>0.41899946543126571</c:v>
                </c:pt>
                <c:pt idx="1208">
                  <c:v>-0.28208783035557128</c:v>
                </c:pt>
                <c:pt idx="1209">
                  <c:v>0.17082239919517525</c:v>
                </c:pt>
                <c:pt idx="1210">
                  <c:v>0.1506896432473209</c:v>
                </c:pt>
                <c:pt idx="1211">
                  <c:v>-0.11591009086646677</c:v>
                </c:pt>
                <c:pt idx="1212">
                  <c:v>-0.38646834708207289</c:v>
                </c:pt>
                <c:pt idx="1213">
                  <c:v>0.38890588403906923</c:v>
                </c:pt>
                <c:pt idx="1214">
                  <c:v>-0.47693993820475056</c:v>
                </c:pt>
                <c:pt idx="1215">
                  <c:v>-0.32861603726748317</c:v>
                </c:pt>
                <c:pt idx="1216">
                  <c:v>0.26735601178388751</c:v>
                </c:pt>
                <c:pt idx="1217">
                  <c:v>0.34471489449012716</c:v>
                </c:pt>
                <c:pt idx="1218">
                  <c:v>-0.50512362005448563</c:v>
                </c:pt>
                <c:pt idx="1219">
                  <c:v>-7.3241468013534983E-2</c:v>
                </c:pt>
                <c:pt idx="1220">
                  <c:v>-0.22111860323719876</c:v>
                </c:pt>
                <c:pt idx="1221">
                  <c:v>-5.9494937256014839E-2</c:v>
                </c:pt>
                <c:pt idx="1222">
                  <c:v>0.15613769788898613</c:v>
                </c:pt>
                <c:pt idx="1223">
                  <c:v>9.518178934268523E-2</c:v>
                </c:pt>
                <c:pt idx="1224">
                  <c:v>-5.035301735061512E-2</c:v>
                </c:pt>
                <c:pt idx="1225">
                  <c:v>0.25435216273399303</c:v>
                </c:pt>
                <c:pt idx="1226">
                  <c:v>-0.45047867921036217</c:v>
                </c:pt>
                <c:pt idx="1227">
                  <c:v>-4.8113850300325924E-2</c:v>
                </c:pt>
                <c:pt idx="1228">
                  <c:v>-0.23565384492254604</c:v>
                </c:pt>
                <c:pt idx="1229">
                  <c:v>0.44148347958264489</c:v>
                </c:pt>
                <c:pt idx="1230">
                  <c:v>0.81245715158045739</c:v>
                </c:pt>
                <c:pt idx="1231">
                  <c:v>1.2497162682902151E-2</c:v>
                </c:pt>
                <c:pt idx="1232">
                  <c:v>-2.2830000309873453E-2</c:v>
                </c:pt>
                <c:pt idx="1233">
                  <c:v>3.4779158048019003E-2</c:v>
                </c:pt>
                <c:pt idx="1234">
                  <c:v>-0.26655888334687616</c:v>
                </c:pt>
                <c:pt idx="1235">
                  <c:v>-8.1766439773688651E-2</c:v>
                </c:pt>
                <c:pt idx="1236">
                  <c:v>0.1631122443471244</c:v>
                </c:pt>
                <c:pt idx="1237">
                  <c:v>-0.57153597374202081</c:v>
                </c:pt>
                <c:pt idx="1238">
                  <c:v>3.8014690186715924E-2</c:v>
                </c:pt>
                <c:pt idx="1239">
                  <c:v>-0.11622280248379357</c:v>
                </c:pt>
                <c:pt idx="1240">
                  <c:v>-0.13068130517109525</c:v>
                </c:pt>
                <c:pt idx="1241">
                  <c:v>0.52757083683281958</c:v>
                </c:pt>
                <c:pt idx="1242">
                  <c:v>-0.32517781603817786</c:v>
                </c:pt>
                <c:pt idx="1243">
                  <c:v>0.13671638448831197</c:v>
                </c:pt>
                <c:pt idx="1244">
                  <c:v>-0.16407592574562507</c:v>
                </c:pt>
                <c:pt idx="1245">
                  <c:v>0.21797514092288733</c:v>
                </c:pt>
                <c:pt idx="1246">
                  <c:v>0.61202216280806176</c:v>
                </c:pt>
                <c:pt idx="1247">
                  <c:v>0.32975508574474682</c:v>
                </c:pt>
                <c:pt idx="1248">
                  <c:v>0.12512206056982392</c:v>
                </c:pt>
                <c:pt idx="1249">
                  <c:v>-1.085282413534097</c:v>
                </c:pt>
                <c:pt idx="1250">
                  <c:v>-0.17869796011047026</c:v>
                </c:pt>
                <c:pt idx="1251">
                  <c:v>-5.9946037903044792E-2</c:v>
                </c:pt>
                <c:pt idx="1252">
                  <c:v>0.29136780428530784</c:v>
                </c:pt>
                <c:pt idx="1253">
                  <c:v>-0.69852941251009826</c:v>
                </c:pt>
                <c:pt idx="1254">
                  <c:v>-1.8390798118188969</c:v>
                </c:pt>
                <c:pt idx="1255">
                  <c:v>-0.1512018187558111</c:v>
                </c:pt>
                <c:pt idx="1256">
                  <c:v>-0.28086037780067463</c:v>
                </c:pt>
                <c:pt idx="1257">
                  <c:v>1.0350188169567268E-2</c:v>
                </c:pt>
                <c:pt idx="1258">
                  <c:v>-1.5195280547725232</c:v>
                </c:pt>
                <c:pt idx="1259">
                  <c:v>-0.13004965234100108</c:v>
                </c:pt>
                <c:pt idx="1260">
                  <c:v>-9.8814506307260339E-2</c:v>
                </c:pt>
                <c:pt idx="1261">
                  <c:v>-0.15987922653846787</c:v>
                </c:pt>
                <c:pt idx="1262">
                  <c:v>-2.5030237187284567E-2</c:v>
                </c:pt>
                <c:pt idx="1263">
                  <c:v>0.22515151184127313</c:v>
                </c:pt>
                <c:pt idx="1264">
                  <c:v>-9.4957236909082907E-2</c:v>
                </c:pt>
                <c:pt idx="1265">
                  <c:v>-0.52450001273504909</c:v>
                </c:pt>
                <c:pt idx="1266">
                  <c:v>5.5334501751099399E-2</c:v>
                </c:pt>
                <c:pt idx="1267">
                  <c:v>-0.17315664835103578</c:v>
                </c:pt>
                <c:pt idx="1268">
                  <c:v>-5.5291452373372858E-2</c:v>
                </c:pt>
                <c:pt idx="1269">
                  <c:v>-4.915836245085127E-2</c:v>
                </c:pt>
                <c:pt idx="1270">
                  <c:v>-0.43070335443835533</c:v>
                </c:pt>
                <c:pt idx="1271">
                  <c:v>-1.3681041409461956</c:v>
                </c:pt>
                <c:pt idx="1272">
                  <c:v>0.26447638000770035</c:v>
                </c:pt>
                <c:pt idx="1273">
                  <c:v>-0.39934963837880527</c:v>
                </c:pt>
                <c:pt idx="1274">
                  <c:v>-0.24161153452064771</c:v>
                </c:pt>
                <c:pt idx="1275">
                  <c:v>2.7295624050907501E-2</c:v>
                </c:pt>
                <c:pt idx="1276">
                  <c:v>-0.29973785525329644</c:v>
                </c:pt>
                <c:pt idx="1277">
                  <c:v>0.11143200536198733</c:v>
                </c:pt>
                <c:pt idx="1278">
                  <c:v>-0.35549762758106423</c:v>
                </c:pt>
                <c:pt idx="1279">
                  <c:v>-1.9024187321259902E-2</c:v>
                </c:pt>
                <c:pt idx="1280">
                  <c:v>0.33090254070135383</c:v>
                </c:pt>
                <c:pt idx="1281">
                  <c:v>0.18091166336856906</c:v>
                </c:pt>
                <c:pt idx="1282">
                  <c:v>0.30041662783687401</c:v>
                </c:pt>
                <c:pt idx="1283">
                  <c:v>0.29148568597356145</c:v>
                </c:pt>
                <c:pt idx="1284">
                  <c:v>-5.7719346274552337E-4</c:v>
                </c:pt>
                <c:pt idx="1285">
                  <c:v>-0.20307005736148862</c:v>
                </c:pt>
                <c:pt idx="1286">
                  <c:v>-1.3625473915035144E-2</c:v>
                </c:pt>
                <c:pt idx="1287">
                  <c:v>-0.41811853630866547</c:v>
                </c:pt>
                <c:pt idx="1288">
                  <c:v>-5.1698187649364617E-2</c:v>
                </c:pt>
                <c:pt idx="1289">
                  <c:v>7.7379740797013583E-2</c:v>
                </c:pt>
                <c:pt idx="1290">
                  <c:v>-0.26205370660595007</c:v>
                </c:pt>
                <c:pt idx="1291">
                  <c:v>-0.49106433813560463</c:v>
                </c:pt>
                <c:pt idx="1292">
                  <c:v>-0.56021731052401846</c:v>
                </c:pt>
                <c:pt idx="1293">
                  <c:v>-0.14640349379748749</c:v>
                </c:pt>
                <c:pt idx="1294">
                  <c:v>-0.36549966176400123</c:v>
                </c:pt>
                <c:pt idx="1295">
                  <c:v>-0.44006773646612846</c:v>
                </c:pt>
                <c:pt idx="1296">
                  <c:v>0.19572554751205637</c:v>
                </c:pt>
                <c:pt idx="1297">
                  <c:v>0.21797514092288733</c:v>
                </c:pt>
                <c:pt idx="1298">
                  <c:v>-0.5172549546174271</c:v>
                </c:pt>
                <c:pt idx="1299">
                  <c:v>-0.15826835651750271</c:v>
                </c:pt>
                <c:pt idx="1300">
                  <c:v>0.50660194219101495</c:v>
                </c:pt>
                <c:pt idx="1301">
                  <c:v>0.46539988329660548</c:v>
                </c:pt>
                <c:pt idx="1302">
                  <c:v>-0.61816291609395257</c:v>
                </c:pt>
                <c:pt idx="1303">
                  <c:v>0.28178725681582628</c:v>
                </c:pt>
                <c:pt idx="1304">
                  <c:v>0.20376496601865624</c:v>
                </c:pt>
                <c:pt idx="1305">
                  <c:v>-3.1208812116408833E-2</c:v>
                </c:pt>
                <c:pt idx="1306">
                  <c:v>-6.1902438925906862E-2</c:v>
                </c:pt>
                <c:pt idx="1307">
                  <c:v>6.8877140850307828E-2</c:v>
                </c:pt>
                <c:pt idx="1308">
                  <c:v>-0.1648843847417823</c:v>
                </c:pt>
                <c:pt idx="1309">
                  <c:v>0.12551885957509099</c:v>
                </c:pt>
                <c:pt idx="1310">
                  <c:v>-3.3274231282193117E-2</c:v>
                </c:pt>
                <c:pt idx="1311">
                  <c:v>0.18789440479079594</c:v>
                </c:pt>
                <c:pt idx="1312">
                  <c:v>-8.8653555896428024E-2</c:v>
                </c:pt>
                <c:pt idx="1313">
                  <c:v>0.14574266027760549</c:v>
                </c:pt>
                <c:pt idx="1314">
                  <c:v>-0.53324238427382864</c:v>
                </c:pt>
                <c:pt idx="1315">
                  <c:v>-0.24348904385984163</c:v>
                </c:pt>
                <c:pt idx="1316">
                  <c:v>0.1126334169852453</c:v>
                </c:pt>
                <c:pt idx="1317">
                  <c:v>-0.48721687908263733</c:v>
                </c:pt>
                <c:pt idx="1318">
                  <c:v>-0.40545145044964581</c:v>
                </c:pt>
                <c:pt idx="1319">
                  <c:v>2.2900402110078832E-2</c:v>
                </c:pt>
                <c:pt idx="1320">
                  <c:v>-0.11825708185241866</c:v>
                </c:pt>
                <c:pt idx="1321">
                  <c:v>-0.91185840313098243</c:v>
                </c:pt>
                <c:pt idx="1322">
                  <c:v>-0.1956159645586584</c:v>
                </c:pt>
                <c:pt idx="1323">
                  <c:v>0.18890726664258814</c:v>
                </c:pt>
                <c:pt idx="1324">
                  <c:v>-0.21273471724829843</c:v>
                </c:pt>
                <c:pt idx="1325">
                  <c:v>-0.50471417062903579</c:v>
                </c:pt>
                <c:pt idx="1326">
                  <c:v>-0.11841368375660379</c:v>
                </c:pt>
                <c:pt idx="1327">
                  <c:v>-0.45502011674419607</c:v>
                </c:pt>
                <c:pt idx="1328">
                  <c:v>-0.34666477320886879</c:v>
                </c:pt>
                <c:pt idx="1329">
                  <c:v>0.24634727690091462</c:v>
                </c:pt>
                <c:pt idx="1330">
                  <c:v>-6.796651363875519E-3</c:v>
                </c:pt>
                <c:pt idx="1331">
                  <c:v>0.12670860219696831</c:v>
                </c:pt>
                <c:pt idx="1332">
                  <c:v>-0.22330641765840703</c:v>
                </c:pt>
                <c:pt idx="1333">
                  <c:v>0.36053283865776131</c:v>
                </c:pt>
                <c:pt idx="1334">
                  <c:v>0.19899696624010865</c:v>
                </c:pt>
                <c:pt idx="1335">
                  <c:v>0.20826752896869236</c:v>
                </c:pt>
                <c:pt idx="1336">
                  <c:v>0.12538660536581386</c:v>
                </c:pt>
                <c:pt idx="1337">
                  <c:v>-0.40049176408106429</c:v>
                </c:pt>
                <c:pt idx="1338">
                  <c:v>-9.8196649749256168E-2</c:v>
                </c:pt>
                <c:pt idx="1339">
                  <c:v>0.68239351106273127</c:v>
                </c:pt>
                <c:pt idx="1340">
                  <c:v>0.57879383267675266</c:v>
                </c:pt>
                <c:pt idx="1341">
                  <c:v>0.78651272497140079</c:v>
                </c:pt>
                <c:pt idx="1342">
                  <c:v>-0.43167597973029381</c:v>
                </c:pt>
                <c:pt idx="1343">
                  <c:v>-7.9630469568326465E-2</c:v>
                </c:pt>
                <c:pt idx="1344">
                  <c:v>-4.5431429247006001E-2</c:v>
                </c:pt>
                <c:pt idx="1345">
                  <c:v>-0.12186323337305249</c:v>
                </c:pt>
                <c:pt idx="1346">
                  <c:v>0.49426198783988889</c:v>
                </c:pt>
                <c:pt idx="1347">
                  <c:v>-0.36475638764097196</c:v>
                </c:pt>
                <c:pt idx="1348">
                  <c:v>-0.22263289054958724</c:v>
                </c:pt>
                <c:pt idx="1349">
                  <c:v>-0.94535986946165462</c:v>
                </c:pt>
                <c:pt idx="1350">
                  <c:v>-0.57970625065337777</c:v>
                </c:pt>
                <c:pt idx="1351">
                  <c:v>-5.1997284787553923E-2</c:v>
                </c:pt>
                <c:pt idx="1352">
                  <c:v>0.10969486482592983</c:v>
                </c:pt>
                <c:pt idx="1353">
                  <c:v>0.66739260066710537</c:v>
                </c:pt>
                <c:pt idx="1354">
                  <c:v>0.14873891273752515</c:v>
                </c:pt>
                <c:pt idx="1355">
                  <c:v>-0.39270519918078745</c:v>
                </c:pt>
                <c:pt idx="1356">
                  <c:v>0.32722746776128597</c:v>
                </c:pt>
                <c:pt idx="1357">
                  <c:v>0.4459385372892663</c:v>
                </c:pt>
                <c:pt idx="1358">
                  <c:v>2.5028794491522448E-2</c:v>
                </c:pt>
                <c:pt idx="1359">
                  <c:v>-0.51127934710471634</c:v>
                </c:pt>
                <c:pt idx="1360">
                  <c:v>-9.0802937008312615E-2</c:v>
                </c:pt>
                <c:pt idx="1361">
                  <c:v>9.6801581849168691E-2</c:v>
                </c:pt>
                <c:pt idx="1362">
                  <c:v>0.14730669878029351</c:v>
                </c:pt>
                <c:pt idx="1363">
                  <c:v>-0.24400151620229335</c:v>
                </c:pt>
                <c:pt idx="1364">
                  <c:v>-0.13083926159988268</c:v>
                </c:pt>
                <c:pt idx="1365">
                  <c:v>-0.16828486848217453</c:v>
                </c:pt>
                <c:pt idx="1366">
                  <c:v>9.3424959419102921E-2</c:v>
                </c:pt>
                <c:pt idx="1367">
                  <c:v>-0.73696559416620622</c:v>
                </c:pt>
                <c:pt idx="1368">
                  <c:v>0.34732549163380216</c:v>
                </c:pt>
                <c:pt idx="1369">
                  <c:v>-0.17837141075622645</c:v>
                </c:pt>
                <c:pt idx="1370">
                  <c:v>5.6860943046750968E-2</c:v>
                </c:pt>
                <c:pt idx="1371">
                  <c:v>-0.17283135070796901</c:v>
                </c:pt>
                <c:pt idx="1372">
                  <c:v>0.12008647067252551</c:v>
                </c:pt>
                <c:pt idx="1373">
                  <c:v>-0.45502011674419607</c:v>
                </c:pt>
                <c:pt idx="1374">
                  <c:v>2.1053252054075176E-2</c:v>
                </c:pt>
                <c:pt idx="1375">
                  <c:v>-0.45442694396496797</c:v>
                </c:pt>
                <c:pt idx="1376">
                  <c:v>0.2719037062632752</c:v>
                </c:pt>
                <c:pt idx="1377">
                  <c:v>4.3764442310170244E-2</c:v>
                </c:pt>
                <c:pt idx="1378">
                  <c:v>-0.12469173996865587</c:v>
                </c:pt>
                <c:pt idx="1379">
                  <c:v>0.19912264201360066</c:v>
                </c:pt>
                <c:pt idx="1380">
                  <c:v>-5.1249658175554769E-2</c:v>
                </c:pt>
                <c:pt idx="1381">
                  <c:v>0.12684073527769343</c:v>
                </c:pt>
                <c:pt idx="1382">
                  <c:v>0.28036248997377788</c:v>
                </c:pt>
                <c:pt idx="1383">
                  <c:v>-1.9132162338579333</c:v>
                </c:pt>
                <c:pt idx="1384">
                  <c:v>-0.12437718746748855</c:v>
                </c:pt>
                <c:pt idx="1385">
                  <c:v>-0.37034030007260832</c:v>
                </c:pt>
                <c:pt idx="1386">
                  <c:v>0.15341624225524791</c:v>
                </c:pt>
                <c:pt idx="1387">
                  <c:v>-0.19412975652154102</c:v>
                </c:pt>
                <c:pt idx="1388">
                  <c:v>0.15639661659766543</c:v>
                </c:pt>
                <c:pt idx="1389">
                  <c:v>-0.73816834124786346</c:v>
                </c:pt>
                <c:pt idx="1390">
                  <c:v>-8.9727846173845924E-2</c:v>
                </c:pt>
                <c:pt idx="1391">
                  <c:v>-5.2296443946923198E-2</c:v>
                </c:pt>
                <c:pt idx="1392">
                  <c:v>0.1554901977475622</c:v>
                </c:pt>
                <c:pt idx="1393">
                  <c:v>-0.15248407195955288</c:v>
                </c:pt>
                <c:pt idx="1394">
                  <c:v>0.29595806772082212</c:v>
                </c:pt>
                <c:pt idx="1395">
                  <c:v>6.4331046245983931E-2</c:v>
                </c:pt>
                <c:pt idx="1396">
                  <c:v>0.46811407158363427</c:v>
                </c:pt>
                <c:pt idx="1397">
                  <c:v>-0.20473176572406224</c:v>
                </c:pt>
                <c:pt idx="1398">
                  <c:v>-0.36866285587251868</c:v>
                </c:pt>
                <c:pt idx="1399">
                  <c:v>0.12670860219696831</c:v>
                </c:pt>
                <c:pt idx="1400">
                  <c:v>-3.0029898840683307E-2</c:v>
                </c:pt>
                <c:pt idx="1401">
                  <c:v>-7.9935414621435788E-2</c:v>
                </c:pt>
                <c:pt idx="1402">
                  <c:v>-0.42681939721062684</c:v>
                </c:pt>
                <c:pt idx="1403">
                  <c:v>-0.67922652305412956</c:v>
                </c:pt>
                <c:pt idx="1404">
                  <c:v>0.4343480006925689</c:v>
                </c:pt>
                <c:pt idx="1405">
                  <c:v>-0.26812165119156856</c:v>
                </c:pt>
                <c:pt idx="1406">
                  <c:v>-0.16682653676165965</c:v>
                </c:pt>
                <c:pt idx="1407">
                  <c:v>4.1383179019406156E-2</c:v>
                </c:pt>
                <c:pt idx="1408">
                  <c:v>-0.23633347986192646</c:v>
                </c:pt>
                <c:pt idx="1409">
                  <c:v>-0.11935365232556311</c:v>
                </c:pt>
                <c:pt idx="1410">
                  <c:v>0.30509501066669742</c:v>
                </c:pt>
                <c:pt idx="1411">
                  <c:v>-0.15008078131402144</c:v>
                </c:pt>
                <c:pt idx="1412">
                  <c:v>4.0339012844897151E-3</c:v>
                </c:pt>
                <c:pt idx="1413">
                  <c:v>0.40577457794987587</c:v>
                </c:pt>
                <c:pt idx="1414">
                  <c:v>0.80215184874899137</c:v>
                </c:pt>
                <c:pt idx="1415">
                  <c:v>0.59731663112903033</c:v>
                </c:pt>
                <c:pt idx="1416">
                  <c:v>0.87829374340104172</c:v>
                </c:pt>
                <c:pt idx="1417">
                  <c:v>0.10043947928031166</c:v>
                </c:pt>
                <c:pt idx="1418">
                  <c:v>-0.2931821526602385</c:v>
                </c:pt>
                <c:pt idx="1419">
                  <c:v>0.18218376912146836</c:v>
                </c:pt>
                <c:pt idx="1420">
                  <c:v>-0.30365000986301266</c:v>
                </c:pt>
                <c:pt idx="1421">
                  <c:v>-0.39327352498718732</c:v>
                </c:pt>
                <c:pt idx="1422">
                  <c:v>-9.0188501291661727E-2</c:v>
                </c:pt>
                <c:pt idx="1423">
                  <c:v>-0.41638464341544235</c:v>
                </c:pt>
                <c:pt idx="1424">
                  <c:v>0.11196608960349229</c:v>
                </c:pt>
                <c:pt idx="1425">
                  <c:v>-0.37482304331948774</c:v>
                </c:pt>
                <c:pt idx="1426">
                  <c:v>-0.45699912259757436</c:v>
                </c:pt>
                <c:pt idx="1427">
                  <c:v>-0.23259944355393436</c:v>
                </c:pt>
                <c:pt idx="1428">
                  <c:v>-0.40640719413540388</c:v>
                </c:pt>
                <c:pt idx="1429">
                  <c:v>0.23988680079572053</c:v>
                </c:pt>
                <c:pt idx="1430">
                  <c:v>0</c:v>
                </c:pt>
                <c:pt idx="1431">
                  <c:v>9.7745621638518854E-2</c:v>
                </c:pt>
                <c:pt idx="1432">
                  <c:v>0.21449786790051678</c:v>
                </c:pt>
                <c:pt idx="1433">
                  <c:v>7.8199919921371541E-2</c:v>
                </c:pt>
                <c:pt idx="1434">
                  <c:v>-0.46653632327959588</c:v>
                </c:pt>
                <c:pt idx="1435">
                  <c:v>0.17785402525994945</c:v>
                </c:pt>
                <c:pt idx="1436">
                  <c:v>0.48088550264492513</c:v>
                </c:pt>
                <c:pt idx="1437">
                  <c:v>-8.4211427188055091E-2</c:v>
                </c:pt>
                <c:pt idx="1438">
                  <c:v>-0.10982572320065556</c:v>
                </c:pt>
                <c:pt idx="1439">
                  <c:v>0.10245657665073429</c:v>
                </c:pt>
                <c:pt idx="1440">
                  <c:v>0.13907651504611174</c:v>
                </c:pt>
                <c:pt idx="1441">
                  <c:v>2.1624211506207254E-3</c:v>
                </c:pt>
                <c:pt idx="1442">
                  <c:v>-0.3904341321381869</c:v>
                </c:pt>
                <c:pt idx="1443">
                  <c:v>-0.28595235122223311</c:v>
                </c:pt>
                <c:pt idx="1444">
                  <c:v>0.50436615061227197</c:v>
                </c:pt>
                <c:pt idx="1445">
                  <c:v>0.23180102277715744</c:v>
                </c:pt>
                <c:pt idx="1446">
                  <c:v>-0.15505200240216277</c:v>
                </c:pt>
                <c:pt idx="1447">
                  <c:v>-0.29689930039584012</c:v>
                </c:pt>
                <c:pt idx="1448">
                  <c:v>0.14821827215414507</c:v>
                </c:pt>
                <c:pt idx="1449">
                  <c:v>0.40031932286448507</c:v>
                </c:pt>
                <c:pt idx="1450">
                  <c:v>0.32319710823932757</c:v>
                </c:pt>
                <c:pt idx="1451">
                  <c:v>-0.15649847446317711</c:v>
                </c:pt>
                <c:pt idx="1452">
                  <c:v>0.35479064923107084</c:v>
                </c:pt>
                <c:pt idx="1453">
                  <c:v>-0.11044858129598112</c:v>
                </c:pt>
                <c:pt idx="1454">
                  <c:v>0.60331181060004824</c:v>
                </c:pt>
                <c:pt idx="1455">
                  <c:v>0.1056780778945372</c:v>
                </c:pt>
                <c:pt idx="1456">
                  <c:v>0.7565109561401584</c:v>
                </c:pt>
                <c:pt idx="1457">
                  <c:v>0.15237814540103931</c:v>
                </c:pt>
                <c:pt idx="1458">
                  <c:v>0.36434830692009251</c:v>
                </c:pt>
                <c:pt idx="1459">
                  <c:v>0.20351441113075852</c:v>
                </c:pt>
                <c:pt idx="1460">
                  <c:v>8.4064264788474549E-2</c:v>
                </c:pt>
                <c:pt idx="1461">
                  <c:v>-0.24365984774814731</c:v>
                </c:pt>
                <c:pt idx="1462">
                  <c:v>-0.5557570057775153</c:v>
                </c:pt>
                <c:pt idx="1463">
                  <c:v>0.12273897195454528</c:v>
                </c:pt>
                <c:pt idx="1464">
                  <c:v>-0.1002056517911709</c:v>
                </c:pt>
                <c:pt idx="1465">
                  <c:v>9.5991912924602796E-2</c:v>
                </c:pt>
                <c:pt idx="1466">
                  <c:v>1.1209361420303354E-2</c:v>
                </c:pt>
                <c:pt idx="1467">
                  <c:v>0.15185881672700494</c:v>
                </c:pt>
                <c:pt idx="1468">
                  <c:v>-0.13210353600734515</c:v>
                </c:pt>
                <c:pt idx="1469">
                  <c:v>6.1568849268002809E-2</c:v>
                </c:pt>
                <c:pt idx="1470">
                  <c:v>-0.863808613712856</c:v>
                </c:pt>
                <c:pt idx="1471">
                  <c:v>0.42190997309482892</c:v>
                </c:pt>
                <c:pt idx="1472">
                  <c:v>-6.4464819131981835E-2</c:v>
                </c:pt>
                <c:pt idx="1473">
                  <c:v>-1.0715640252329111E-2</c:v>
                </c:pt>
                <c:pt idx="1474">
                  <c:v>-0.52928093864918146</c:v>
                </c:pt>
                <c:pt idx="1475">
                  <c:v>-0.10283703664116549</c:v>
                </c:pt>
                <c:pt idx="1476">
                  <c:v>7.0114502661328182E-2</c:v>
                </c:pt>
                <c:pt idx="1477">
                  <c:v>0.47363107655120013</c:v>
                </c:pt>
                <c:pt idx="1478">
                  <c:v>-0.5568177330077777</c:v>
                </c:pt>
                <c:pt idx="1479">
                  <c:v>-3.0177210327092033E-2</c:v>
                </c:pt>
                <c:pt idx="1480">
                  <c:v>-0.49025349363434523</c:v>
                </c:pt>
                <c:pt idx="1481">
                  <c:v>8.6240275820744103E-2</c:v>
                </c:pt>
                <c:pt idx="1482">
                  <c:v>-0.13796526004476725</c:v>
                </c:pt>
                <c:pt idx="1483">
                  <c:v>4.3204498565167566E-2</c:v>
                </c:pt>
                <c:pt idx="1484">
                  <c:v>-1.4735304953591692</c:v>
                </c:pt>
                <c:pt idx="1485">
                  <c:v>-0.30632348343224342</c:v>
                </c:pt>
                <c:pt idx="1486">
                  <c:v>-8.5435476506060412E-2</c:v>
                </c:pt>
                <c:pt idx="1487">
                  <c:v>-1.1389180581251155</c:v>
                </c:pt>
                <c:pt idx="1488">
                  <c:v>-0.14082554413356455</c:v>
                </c:pt>
                <c:pt idx="1489">
                  <c:v>-0.22972065679027356</c:v>
                </c:pt>
                <c:pt idx="1490">
                  <c:v>0.36658799539426185</c:v>
                </c:pt>
                <c:pt idx="1491">
                  <c:v>3.7452509939606575E-2</c:v>
                </c:pt>
                <c:pt idx="1492">
                  <c:v>0.1649149695524513</c:v>
                </c:pt>
                <c:pt idx="1493">
                  <c:v>-0.18360509083087875</c:v>
                </c:pt>
                <c:pt idx="1494">
                  <c:v>0.4830547362801641</c:v>
                </c:pt>
                <c:pt idx="1495">
                  <c:v>0.34959174255675179</c:v>
                </c:pt>
                <c:pt idx="1496">
                  <c:v>0.10675031506086766</c:v>
                </c:pt>
                <c:pt idx="1497">
                  <c:v>1.9213601569346952</c:v>
                </c:pt>
                <c:pt idx="1498">
                  <c:v>-0.11982386636880067</c:v>
                </c:pt>
                <c:pt idx="1499">
                  <c:v>0.2077679375721706</c:v>
                </c:pt>
                <c:pt idx="1500">
                  <c:v>0.58178507518013201</c:v>
                </c:pt>
                <c:pt idx="1501">
                  <c:v>0.27022990723799772</c:v>
                </c:pt>
                <c:pt idx="1502">
                  <c:v>0.15962918582122781</c:v>
                </c:pt>
                <c:pt idx="1503">
                  <c:v>-0.2249916123844051</c:v>
                </c:pt>
                <c:pt idx="1504">
                  <c:v>4.4654367703005314E-3</c:v>
                </c:pt>
                <c:pt idx="1505">
                  <c:v>0.31138685816203882</c:v>
                </c:pt>
                <c:pt idx="1506">
                  <c:v>-7.1724438388065137E-2</c:v>
                </c:pt>
                <c:pt idx="1507">
                  <c:v>-0.30507524588002566</c:v>
                </c:pt>
                <c:pt idx="1508">
                  <c:v>0.11928976837475146</c:v>
                </c:pt>
                <c:pt idx="1509">
                  <c:v>0.37250640898616877</c:v>
                </c:pt>
                <c:pt idx="1510">
                  <c:v>0.26183165875213665</c:v>
                </c:pt>
                <c:pt idx="1511">
                  <c:v>1.0157829972409276</c:v>
                </c:pt>
                <c:pt idx="1512">
                  <c:v>9.9901110007942689E-2</c:v>
                </c:pt>
                <c:pt idx="1513">
                  <c:v>0.2830920581750474</c:v>
                </c:pt>
                <c:pt idx="1514">
                  <c:v>5.172011644732763E-2</c:v>
                </c:pt>
                <c:pt idx="1515">
                  <c:v>-0.29938273031836143</c:v>
                </c:pt>
                <c:pt idx="1516">
                  <c:v>-0.5929192245494993</c:v>
                </c:pt>
                <c:pt idx="1517">
                  <c:v>-0.38665694699617753</c:v>
                </c:pt>
                <c:pt idx="1518">
                  <c:v>4.3624476747034631E-2</c:v>
                </c:pt>
                <c:pt idx="1519">
                  <c:v>-0.25842515258120435</c:v>
                </c:pt>
                <c:pt idx="1520">
                  <c:v>0.11463354906893945</c:v>
                </c:pt>
                <c:pt idx="1521">
                  <c:v>0.56257214540657585</c:v>
                </c:pt>
                <c:pt idx="1522">
                  <c:v>0.42717705468210015</c:v>
                </c:pt>
                <c:pt idx="1523">
                  <c:v>9.747595901326854E-2</c:v>
                </c:pt>
                <c:pt idx="1524">
                  <c:v>0.25059782304823369</c:v>
                </c:pt>
                <c:pt idx="1525">
                  <c:v>-0.44634459766710932</c:v>
                </c:pt>
                <c:pt idx="1526">
                  <c:v>0.19534759832221926</c:v>
                </c:pt>
                <c:pt idx="1527">
                  <c:v>0.16014572540457925</c:v>
                </c:pt>
                <c:pt idx="1528">
                  <c:v>0.2470768319308177</c:v>
                </c:pt>
                <c:pt idx="1529">
                  <c:v>-0.41177109105189535</c:v>
                </c:pt>
                <c:pt idx="1530">
                  <c:v>7.0664100778789651E-2</c:v>
                </c:pt>
                <c:pt idx="1531">
                  <c:v>-0.56000460207676417</c:v>
                </c:pt>
                <c:pt idx="1532">
                  <c:v>3.6046100156859551E-2</c:v>
                </c:pt>
                <c:pt idx="1533">
                  <c:v>-0.4347927944254541</c:v>
                </c:pt>
                <c:pt idx="1534">
                  <c:v>7.382023329167138E-2</c:v>
                </c:pt>
                <c:pt idx="1535">
                  <c:v>-0.5838088061047858</c:v>
                </c:pt>
                <c:pt idx="1536">
                  <c:v>-0.53324238427382864</c:v>
                </c:pt>
                <c:pt idx="1537">
                  <c:v>0.58496250072115619</c:v>
                </c:pt>
                <c:pt idx="1538">
                  <c:v>-0.31724693876945409</c:v>
                </c:pt>
                <c:pt idx="1539">
                  <c:v>-0.71928118638198957</c:v>
                </c:pt>
                <c:pt idx="1540">
                  <c:v>9.2072094502929053E-2</c:v>
                </c:pt>
                <c:pt idx="1541">
                  <c:v>0.35670725293538136</c:v>
                </c:pt>
                <c:pt idx="1542">
                  <c:v>-5.9645288466706789E-2</c:v>
                </c:pt>
                <c:pt idx="1543">
                  <c:v>0.21063822838015023</c:v>
                </c:pt>
                <c:pt idx="1544">
                  <c:v>-0.46952967460080958</c:v>
                </c:pt>
                <c:pt idx="1545">
                  <c:v>-3.9976935326168315</c:v>
                </c:pt>
                <c:pt idx="1546">
                  <c:v>0.98009843881779135</c:v>
                </c:pt>
                <c:pt idx="1547">
                  <c:v>6.9702166630067411E-2</c:v>
                </c:pt>
                <c:pt idx="1548">
                  <c:v>0.11356715704707816</c:v>
                </c:pt>
                <c:pt idx="1549">
                  <c:v>0.19143631460532146</c:v>
                </c:pt>
                <c:pt idx="1550">
                  <c:v>-8.1308465575602493E-2</c:v>
                </c:pt>
                <c:pt idx="1551">
                  <c:v>-5.6941361109602261E-2</c:v>
                </c:pt>
                <c:pt idx="1552">
                  <c:v>-0.31455316495971475</c:v>
                </c:pt>
                <c:pt idx="1553">
                  <c:v>0.25168879947866313</c:v>
                </c:pt>
                <c:pt idx="1554">
                  <c:v>0.2526578641941174</c:v>
                </c:pt>
                <c:pt idx="1555">
                  <c:v>-0.45502011674419607</c:v>
                </c:pt>
                <c:pt idx="1556">
                  <c:v>0.7468286902744028</c:v>
                </c:pt>
                <c:pt idx="1557">
                  <c:v>9.3830571635135501E-2</c:v>
                </c:pt>
                <c:pt idx="1558">
                  <c:v>1.2351756060347376</c:v>
                </c:pt>
                <c:pt idx="1559">
                  <c:v>-0.35125846950827233</c:v>
                </c:pt>
                <c:pt idx="1560">
                  <c:v>0.46173808602046618</c:v>
                </c:pt>
                <c:pt idx="1561">
                  <c:v>-0.13622009620412232</c:v>
                </c:pt>
                <c:pt idx="1562">
                  <c:v>-0.45442694396496797</c:v>
                </c:pt>
                <c:pt idx="1563">
                  <c:v>6.1707084791597165E-2</c:v>
                </c:pt>
                <c:pt idx="1564">
                  <c:v>-9.7733430916929001E-2</c:v>
                </c:pt>
                <c:pt idx="1565">
                  <c:v>-0.80163157689748077</c:v>
                </c:pt>
                <c:pt idx="1566">
                  <c:v>-0.2703819753094357</c:v>
                </c:pt>
                <c:pt idx="1567">
                  <c:v>-0.35826902186525311</c:v>
                </c:pt>
                <c:pt idx="1568">
                  <c:v>-0.30525349942209329</c:v>
                </c:pt>
                <c:pt idx="1569">
                  <c:v>0.3743996367614405</c:v>
                </c:pt>
                <c:pt idx="1570">
                  <c:v>-0.26846916294584156</c:v>
                </c:pt>
                <c:pt idx="1571">
                  <c:v>1.3212111426851169E-2</c:v>
                </c:pt>
                <c:pt idx="1572">
                  <c:v>0.53843883525075775</c:v>
                </c:pt>
                <c:pt idx="1573">
                  <c:v>0.47632983775713772</c:v>
                </c:pt>
                <c:pt idx="1574">
                  <c:v>-8.359979176145306E-2</c:v>
                </c:pt>
                <c:pt idx="1575">
                  <c:v>-0.24109991029131669</c:v>
                </c:pt>
                <c:pt idx="1576">
                  <c:v>-0.44320275340725684</c:v>
                </c:pt>
                <c:pt idx="1577">
                  <c:v>0.19811692915245538</c:v>
                </c:pt>
                <c:pt idx="1578">
                  <c:v>0.14964958189497543</c:v>
                </c:pt>
                <c:pt idx="1579">
                  <c:v>-5.3793170962472027E-2</c:v>
                </c:pt>
                <c:pt idx="1580">
                  <c:v>-0.28876942810636458</c:v>
                </c:pt>
                <c:pt idx="1581">
                  <c:v>-0.25790753191875182</c:v>
                </c:pt>
                <c:pt idx="1582">
                  <c:v>-9.4957236909082907E-2</c:v>
                </c:pt>
                <c:pt idx="1583">
                  <c:v>-0.46036967531533357</c:v>
                </c:pt>
                <c:pt idx="1584">
                  <c:v>0.1644001350244117</c:v>
                </c:pt>
                <c:pt idx="1585">
                  <c:v>-4.4836012383049274E-2</c:v>
                </c:pt>
                <c:pt idx="1586">
                  <c:v>-6.2169647499932743E-3</c:v>
                </c:pt>
                <c:pt idx="1587">
                  <c:v>6.3339337220504853E-3</c:v>
                </c:pt>
                <c:pt idx="1588">
                  <c:v>0.15471281378215795</c:v>
                </c:pt>
                <c:pt idx="1589">
                  <c:v>7.1955014042037668E-3</c:v>
                </c:pt>
                <c:pt idx="1590">
                  <c:v>-0.11091590140185059</c:v>
                </c:pt>
                <c:pt idx="1591">
                  <c:v>-3.3421874432389906E-2</c:v>
                </c:pt>
                <c:pt idx="1592">
                  <c:v>-0.25428937801199908</c:v>
                </c:pt>
                <c:pt idx="1593">
                  <c:v>-1.4353850282750529E-2</c:v>
                </c:pt>
                <c:pt idx="1594">
                  <c:v>-0.29849530023508736</c:v>
                </c:pt>
                <c:pt idx="1595">
                  <c:v>-0.14576492123383</c:v>
                </c:pt>
                <c:pt idx="1596">
                  <c:v>8.2000138321361282E-3</c:v>
                </c:pt>
                <c:pt idx="1597">
                  <c:v>0.22921874244924689</c:v>
                </c:pt>
                <c:pt idx="1598">
                  <c:v>0.31521841136578999</c:v>
                </c:pt>
                <c:pt idx="1599">
                  <c:v>0.34426039498541872</c:v>
                </c:pt>
                <c:pt idx="1600">
                  <c:v>0.64145354567194091</c:v>
                </c:pt>
                <c:pt idx="1601">
                  <c:v>0.38681094647221681</c:v>
                </c:pt>
                <c:pt idx="1602">
                  <c:v>-8.6047890838036475E-2</c:v>
                </c:pt>
                <c:pt idx="1603">
                  <c:v>-3.9191774611020275E-2</c:v>
                </c:pt>
                <c:pt idx="1604">
                  <c:v>-0.17088110365073941</c:v>
                </c:pt>
                <c:pt idx="1605">
                  <c:v>-5.6341175956530584E-2</c:v>
                </c:pt>
                <c:pt idx="1606">
                  <c:v>0.18256518222108284</c:v>
                </c:pt>
                <c:pt idx="1607">
                  <c:v>0.26759572185187913</c:v>
                </c:pt>
                <c:pt idx="1608">
                  <c:v>0.10728613495222238</c:v>
                </c:pt>
                <c:pt idx="1609">
                  <c:v>-0.176087632512198</c:v>
                </c:pt>
                <c:pt idx="1610">
                  <c:v>-0.14114370380866342</c:v>
                </c:pt>
                <c:pt idx="1611">
                  <c:v>6.1707084791597165E-2</c:v>
                </c:pt>
                <c:pt idx="1612">
                  <c:v>-0.26881675842780001</c:v>
                </c:pt>
                <c:pt idx="1613">
                  <c:v>-1.9640946162578721</c:v>
                </c:pt>
                <c:pt idx="1614">
                  <c:v>0.25302109571151316</c:v>
                </c:pt>
                <c:pt idx="1615">
                  <c:v>-1.5606428215257431</c:v>
                </c:pt>
                <c:pt idx="1616">
                  <c:v>0.17836408184680327</c:v>
                </c:pt>
                <c:pt idx="1617">
                  <c:v>0.39966330388801757</c:v>
                </c:pt>
                <c:pt idx="1618">
                  <c:v>0.26363540356832926</c:v>
                </c:pt>
                <c:pt idx="1619">
                  <c:v>0.2414741257014415</c:v>
                </c:pt>
                <c:pt idx="1620">
                  <c:v>0.42050935048890331</c:v>
                </c:pt>
                <c:pt idx="1621">
                  <c:v>-0.67415310176118493</c:v>
                </c:pt>
                <c:pt idx="1622">
                  <c:v>-1.4707287562940683</c:v>
                </c:pt>
                <c:pt idx="1623">
                  <c:v>-0.10051497748722915</c:v>
                </c:pt>
                <c:pt idx="1624">
                  <c:v>0.18510536254259161</c:v>
                </c:pt>
                <c:pt idx="1625">
                  <c:v>-1.0043345902638912</c:v>
                </c:pt>
                <c:pt idx="1626">
                  <c:v>-0.37034030007260832</c:v>
                </c:pt>
                <c:pt idx="1627">
                  <c:v>-0.22162318909167694</c:v>
                </c:pt>
                <c:pt idx="1628">
                  <c:v>7.0389327891398012E-2</c:v>
                </c:pt>
                <c:pt idx="1629">
                  <c:v>5.2972274813988696E-2</c:v>
                </c:pt>
                <c:pt idx="1630">
                  <c:v>-0.22010996065995284</c:v>
                </c:pt>
                <c:pt idx="1631">
                  <c:v>-1.59466108415245</c:v>
                </c:pt>
                <c:pt idx="1632">
                  <c:v>0.11703005301018697</c:v>
                </c:pt>
                <c:pt idx="1633">
                  <c:v>0.30310855138107468</c:v>
                </c:pt>
                <c:pt idx="1634">
                  <c:v>0.2031384971908485</c:v>
                </c:pt>
                <c:pt idx="1635">
                  <c:v>1.0206942869257081E-2</c:v>
                </c:pt>
                <c:pt idx="1636">
                  <c:v>-0.17397021350026112</c:v>
                </c:pt>
                <c:pt idx="1637">
                  <c:v>3.449746419944489E-2</c:v>
                </c:pt>
                <c:pt idx="1638">
                  <c:v>-0.37108645733821372</c:v>
                </c:pt>
                <c:pt idx="1639">
                  <c:v>-0.18065880994122924</c:v>
                </c:pt>
                <c:pt idx="1640">
                  <c:v>3.2947164099129018E-2</c:v>
                </c:pt>
                <c:pt idx="1641">
                  <c:v>-0.13748909687166025</c:v>
                </c:pt>
                <c:pt idx="1642">
                  <c:v>-0.64859781637003566</c:v>
                </c:pt>
                <c:pt idx="1643">
                  <c:v>0.21449786790051678</c:v>
                </c:pt>
                <c:pt idx="1644">
                  <c:v>0.81475548280987387</c:v>
                </c:pt>
                <c:pt idx="1645">
                  <c:v>-1.2511953090629322</c:v>
                </c:pt>
                <c:pt idx="1646">
                  <c:v>-0.24383067186070126</c:v>
                </c:pt>
                <c:pt idx="1647">
                  <c:v>0.43498843946050963</c:v>
                </c:pt>
                <c:pt idx="1648">
                  <c:v>0.19585150857564437</c:v>
                </c:pt>
                <c:pt idx="1649">
                  <c:v>-0.22904412920887801</c:v>
                </c:pt>
                <c:pt idx="1650">
                  <c:v>2.4504992348224897E-3</c:v>
                </c:pt>
                <c:pt idx="1651">
                  <c:v>0.41272733859164273</c:v>
                </c:pt>
                <c:pt idx="1652">
                  <c:v>-0.5267845659296031</c:v>
                </c:pt>
                <c:pt idx="1653">
                  <c:v>-0.35826902186525311</c:v>
                </c:pt>
                <c:pt idx="1654">
                  <c:v>5.9770581090254599E-2</c:v>
                </c:pt>
                <c:pt idx="1655">
                  <c:v>-9.9278072435885073E-2</c:v>
                </c:pt>
                <c:pt idx="1656">
                  <c:v>0.12432813500220179</c:v>
                </c:pt>
                <c:pt idx="1657">
                  <c:v>1.0239649908000459</c:v>
                </c:pt>
                <c:pt idx="1658">
                  <c:v>-0.1569809542762316</c:v>
                </c:pt>
                <c:pt idx="1659">
                  <c:v>-0.34171995515267511</c:v>
                </c:pt>
                <c:pt idx="1660">
                  <c:v>-3.8006322579744921E-2</c:v>
                </c:pt>
                <c:pt idx="1661">
                  <c:v>0.25338423580007446</c:v>
                </c:pt>
                <c:pt idx="1662">
                  <c:v>-0.85178172784585493</c:v>
                </c:pt>
                <c:pt idx="1663">
                  <c:v>-0.28015944493573225</c:v>
                </c:pt>
                <c:pt idx="1664">
                  <c:v>-0.13241977779749542</c:v>
                </c:pt>
                <c:pt idx="1665">
                  <c:v>-2.1072223618601206E-2</c:v>
                </c:pt>
                <c:pt idx="1666">
                  <c:v>-2.2243836750407486E-2</c:v>
                </c:pt>
                <c:pt idx="1667">
                  <c:v>-0.61927055149645149</c:v>
                </c:pt>
                <c:pt idx="1668">
                  <c:v>5.8662839378559886E-2</c:v>
                </c:pt>
                <c:pt idx="1669">
                  <c:v>0.80074462393677759</c:v>
                </c:pt>
                <c:pt idx="1670">
                  <c:v>-0.26760054046136283</c:v>
                </c:pt>
                <c:pt idx="1671">
                  <c:v>-3.5934122513581662E-2</c:v>
                </c:pt>
                <c:pt idx="1672">
                  <c:v>0.32296646154964515</c:v>
                </c:pt>
                <c:pt idx="1673">
                  <c:v>0.58053143815518704</c:v>
                </c:pt>
                <c:pt idx="1674">
                  <c:v>0.10661632898778425</c:v>
                </c:pt>
                <c:pt idx="1675">
                  <c:v>0.12419577158719183</c:v>
                </c:pt>
                <c:pt idx="1676">
                  <c:v>0.68436992901300675</c:v>
                </c:pt>
                <c:pt idx="1677">
                  <c:v>0.59731663112903033</c:v>
                </c:pt>
                <c:pt idx="1678">
                  <c:v>7.8336571121179033E-2</c:v>
                </c:pt>
                <c:pt idx="1679">
                  <c:v>0.39385547733902904</c:v>
                </c:pt>
                <c:pt idx="1680">
                  <c:v>-4.4538396076498447E-2</c:v>
                </c:pt>
                <c:pt idx="1681">
                  <c:v>0.14169436196453092</c:v>
                </c:pt>
                <c:pt idx="1682">
                  <c:v>0.13802804476676125</c:v>
                </c:pt>
                <c:pt idx="1683">
                  <c:v>-0.39649827364362034</c:v>
                </c:pt>
                <c:pt idx="1684">
                  <c:v>-0.26067032398441692</c:v>
                </c:pt>
                <c:pt idx="1685">
                  <c:v>-6.5974230277085405E-2</c:v>
                </c:pt>
                <c:pt idx="1686">
                  <c:v>3.6046100156859551E-2</c:v>
                </c:pt>
                <c:pt idx="1687">
                  <c:v>-0.50164699838548799</c:v>
                </c:pt>
                <c:pt idx="1688">
                  <c:v>-0.75608724112682557</c:v>
                </c:pt>
                <c:pt idx="1689">
                  <c:v>-0.17364473238418468</c:v>
                </c:pt>
                <c:pt idx="1690">
                  <c:v>-1.3625473915035144E-2</c:v>
                </c:pt>
                <c:pt idx="1691">
                  <c:v>0.43584191580922754</c:v>
                </c:pt>
                <c:pt idx="1692">
                  <c:v>-0.26655888334687616</c:v>
                </c:pt>
                <c:pt idx="1693">
                  <c:v>-0.31437375874908885</c:v>
                </c:pt>
                <c:pt idx="1694">
                  <c:v>-3.0913993470059714E-2</c:v>
                </c:pt>
                <c:pt idx="1695">
                  <c:v>1.8776585179183278E-2</c:v>
                </c:pt>
                <c:pt idx="1696">
                  <c:v>-0.23735353296184938</c:v>
                </c:pt>
                <c:pt idx="1697">
                  <c:v>-8.8346762691467781E-2</c:v>
                </c:pt>
                <c:pt idx="1698">
                  <c:v>0.39506279951757767</c:v>
                </c:pt>
                <c:pt idx="1699">
                  <c:v>3.6046100156859551E-2</c:v>
                </c:pt>
                <c:pt idx="1700">
                  <c:v>0.70194821018707465</c:v>
                </c:pt>
                <c:pt idx="1701">
                  <c:v>-0.24862197755084561</c:v>
                </c:pt>
                <c:pt idx="1702">
                  <c:v>-0.1295760941418076</c:v>
                </c:pt>
                <c:pt idx="1703">
                  <c:v>0.58101373516796573</c:v>
                </c:pt>
                <c:pt idx="1704">
                  <c:v>-0.16133054900680766</c:v>
                </c:pt>
                <c:pt idx="1705">
                  <c:v>0.46790546906145347</c:v>
                </c:pt>
                <c:pt idx="1706">
                  <c:v>-0.1002056517911709</c:v>
                </c:pt>
                <c:pt idx="1707">
                  <c:v>-0.39422123246453605</c:v>
                </c:pt>
                <c:pt idx="1708">
                  <c:v>0.23560453276329896</c:v>
                </c:pt>
                <c:pt idx="1709">
                  <c:v>-0.18180387097829168</c:v>
                </c:pt>
                <c:pt idx="1710">
                  <c:v>-0.43225986980540271</c:v>
                </c:pt>
                <c:pt idx="1711">
                  <c:v>-0.18885782633069192</c:v>
                </c:pt>
                <c:pt idx="1712">
                  <c:v>-1.8001258406667484E-2</c:v>
                </c:pt>
                <c:pt idx="1713">
                  <c:v>-0.24947924481767011</c:v>
                </c:pt>
                <c:pt idx="1714">
                  <c:v>0.16427139768074095</c:v>
                </c:pt>
                <c:pt idx="1715">
                  <c:v>1.106620140620535E-2</c:v>
                </c:pt>
                <c:pt idx="1716">
                  <c:v>0.39999135066418123</c:v>
                </c:pt>
                <c:pt idx="1717">
                  <c:v>-4.3348544428939068E-2</c:v>
                </c:pt>
                <c:pt idx="1718">
                  <c:v>-0.15714181674402258</c:v>
                </c:pt>
                <c:pt idx="1719">
                  <c:v>0.19723635491870653</c:v>
                </c:pt>
                <c:pt idx="1720">
                  <c:v>-0.16036283849033051</c:v>
                </c:pt>
                <c:pt idx="1721">
                  <c:v>-0.33278908751912922</c:v>
                </c:pt>
                <c:pt idx="1722">
                  <c:v>0.25845862271790077</c:v>
                </c:pt>
                <c:pt idx="1723">
                  <c:v>-5.4392296818627783E-2</c:v>
                </c:pt>
                <c:pt idx="1724">
                  <c:v>8.3247413747936122E-2</c:v>
                </c:pt>
                <c:pt idx="1725">
                  <c:v>-0.33588129266120026</c:v>
                </c:pt>
                <c:pt idx="1726">
                  <c:v>0.48202217465514696</c:v>
                </c:pt>
                <c:pt idx="1727">
                  <c:v>0.52927124370593159</c:v>
                </c:pt>
                <c:pt idx="1728">
                  <c:v>-0.47955260668107469</c:v>
                </c:pt>
                <c:pt idx="1729">
                  <c:v>-0.41330730313996134</c:v>
                </c:pt>
                <c:pt idx="1730">
                  <c:v>-9.4187019048234358E-2</c:v>
                </c:pt>
                <c:pt idx="1731">
                  <c:v>0.2073931304583356</c:v>
                </c:pt>
                <c:pt idx="1732">
                  <c:v>-0.23514432874529573</c:v>
                </c:pt>
                <c:pt idx="1733">
                  <c:v>0.28865386360516937</c:v>
                </c:pt>
                <c:pt idx="1734">
                  <c:v>2.0342179517185827E-2</c:v>
                </c:pt>
                <c:pt idx="1735">
                  <c:v>0.10487337672601831</c:v>
                </c:pt>
                <c:pt idx="1736">
                  <c:v>0.34357837714689493</c:v>
                </c:pt>
                <c:pt idx="1737">
                  <c:v>0.33388165946809018</c:v>
                </c:pt>
                <c:pt idx="1738">
                  <c:v>-0.56982179556216894</c:v>
                </c:pt>
                <c:pt idx="1739">
                  <c:v>0.5512945207899882</c:v>
                </c:pt>
                <c:pt idx="1740">
                  <c:v>-3.9488289880975545E-2</c:v>
                </c:pt>
                <c:pt idx="1741">
                  <c:v>-0.33006616433103936</c:v>
                </c:pt>
                <c:pt idx="1742">
                  <c:v>-5.7842107262206295E-2</c:v>
                </c:pt>
                <c:pt idx="1743">
                  <c:v>-0.30614509764643483</c:v>
                </c:pt>
                <c:pt idx="1744">
                  <c:v>0.13855237515264857</c:v>
                </c:pt>
                <c:pt idx="1745">
                  <c:v>-0.24434326559176059</c:v>
                </c:pt>
                <c:pt idx="1746">
                  <c:v>-0.41696237620333604</c:v>
                </c:pt>
                <c:pt idx="1747">
                  <c:v>-0.19875855173154142</c:v>
                </c:pt>
                <c:pt idx="1748">
                  <c:v>-0.21910202277017288</c:v>
                </c:pt>
                <c:pt idx="1749">
                  <c:v>-0.17478423769433896</c:v>
                </c:pt>
                <c:pt idx="1750">
                  <c:v>-0.35919400429155951</c:v>
                </c:pt>
                <c:pt idx="1751">
                  <c:v>1.735184178777496E-2</c:v>
                </c:pt>
                <c:pt idx="1752">
                  <c:v>-0.46414610590410044</c:v>
                </c:pt>
                <c:pt idx="1753">
                  <c:v>0.34811908446244288</c:v>
                </c:pt>
                <c:pt idx="1754">
                  <c:v>9.2883965678484434E-2</c:v>
                </c:pt>
                <c:pt idx="1755">
                  <c:v>-1.1265804965651431</c:v>
                </c:pt>
                <c:pt idx="1756">
                  <c:v>-0.25342924858755345</c:v>
                </c:pt>
                <c:pt idx="1757">
                  <c:v>3.1959741397544997E-2</c:v>
                </c:pt>
                <c:pt idx="1758">
                  <c:v>6.1292338478294087E-2</c:v>
                </c:pt>
                <c:pt idx="1759">
                  <c:v>-0.40296947596975347</c:v>
                </c:pt>
                <c:pt idx="1760">
                  <c:v>3.1536353268053249E-2</c:v>
                </c:pt>
                <c:pt idx="1761">
                  <c:v>-0.4490993353524767</c:v>
                </c:pt>
                <c:pt idx="1762">
                  <c:v>0.19433924948446313</c:v>
                </c:pt>
                <c:pt idx="1763">
                  <c:v>-0.46534071958612205</c:v>
                </c:pt>
                <c:pt idx="1764">
                  <c:v>0.26903314645523702</c:v>
                </c:pt>
                <c:pt idx="1765">
                  <c:v>-3.3220203836296473E-3</c:v>
                </c:pt>
                <c:pt idx="1766">
                  <c:v>0.30871035116807738</c:v>
                </c:pt>
                <c:pt idx="1767">
                  <c:v>-0.107181572204967</c:v>
                </c:pt>
                <c:pt idx="1768">
                  <c:v>0.16375633339790888</c:v>
                </c:pt>
                <c:pt idx="1769">
                  <c:v>0.64671566107735456</c:v>
                </c:pt>
                <c:pt idx="1770">
                  <c:v>-7.5064011733197086E-2</c:v>
                </c:pt>
                <c:pt idx="1771">
                  <c:v>0.55316387050949656</c:v>
                </c:pt>
                <c:pt idx="1772">
                  <c:v>-0.34794953447769711</c:v>
                </c:pt>
                <c:pt idx="1773">
                  <c:v>-0.3621579396758951</c:v>
                </c:pt>
                <c:pt idx="1774">
                  <c:v>-0.20572971022377226</c:v>
                </c:pt>
                <c:pt idx="1775">
                  <c:v>2.8993411879548688E-2</c:v>
                </c:pt>
                <c:pt idx="1776">
                  <c:v>-9.0956586834421829E-2</c:v>
                </c:pt>
                <c:pt idx="1777">
                  <c:v>0.14548182226552472</c:v>
                </c:pt>
                <c:pt idx="1778">
                  <c:v>-0.14976064483409052</c:v>
                </c:pt>
                <c:pt idx="1779">
                  <c:v>-0.25411731109774072</c:v>
                </c:pt>
                <c:pt idx="1780">
                  <c:v>0.12393100831963091</c:v>
                </c:pt>
                <c:pt idx="1781">
                  <c:v>-6.3861496576032364E-2</c:v>
                </c:pt>
                <c:pt idx="1782">
                  <c:v>0.11583229865256488</c:v>
                </c:pt>
                <c:pt idx="1783">
                  <c:v>0.26915286721717357</c:v>
                </c:pt>
                <c:pt idx="1784">
                  <c:v>-0.1956159645586584</c:v>
                </c:pt>
                <c:pt idx="1785">
                  <c:v>0.45037988007104107</c:v>
                </c:pt>
                <c:pt idx="1786">
                  <c:v>1.3913828033190165</c:v>
                </c:pt>
                <c:pt idx="1787">
                  <c:v>5.8662839378559886E-2</c:v>
                </c:pt>
                <c:pt idx="1788">
                  <c:v>0.23511432037635724</c:v>
                </c:pt>
                <c:pt idx="1789">
                  <c:v>0.1230039540548198</c:v>
                </c:pt>
                <c:pt idx="1790">
                  <c:v>-0.18147661793370173</c:v>
                </c:pt>
                <c:pt idx="1791">
                  <c:v>0.1584662951247956</c:v>
                </c:pt>
                <c:pt idx="1792">
                  <c:v>-0.20706137759963106</c:v>
                </c:pt>
                <c:pt idx="1793">
                  <c:v>-6.4313964837821397E-2</c:v>
                </c:pt>
                <c:pt idx="1794">
                  <c:v>0.19685880136635622</c:v>
                </c:pt>
                <c:pt idx="1795">
                  <c:v>-0.45205668870964977</c:v>
                </c:pt>
                <c:pt idx="1796">
                  <c:v>-0.59335449232799764</c:v>
                </c:pt>
                <c:pt idx="1797">
                  <c:v>-0.35383734284210644</c:v>
                </c:pt>
                <c:pt idx="1798">
                  <c:v>0.14899916258776436</c:v>
                </c:pt>
                <c:pt idx="1799">
                  <c:v>0.1056780778945372</c:v>
                </c:pt>
                <c:pt idx="1800">
                  <c:v>-0.26447782270346254</c:v>
                </c:pt>
                <c:pt idx="1801">
                  <c:v>-0.31994575175493578</c:v>
                </c:pt>
                <c:pt idx="1802">
                  <c:v>-5.6191168673745184E-2</c:v>
                </c:pt>
                <c:pt idx="1803">
                  <c:v>-0.45403163089470749</c:v>
                </c:pt>
                <c:pt idx="1804">
                  <c:v>-0.49451552048850483</c:v>
                </c:pt>
                <c:pt idx="1805">
                  <c:v>-0.23650343863468462</c:v>
                </c:pt>
                <c:pt idx="1806">
                  <c:v>4.3064478664937421E-2</c:v>
                </c:pt>
                <c:pt idx="1807">
                  <c:v>-1.3411715756563463</c:v>
                </c:pt>
                <c:pt idx="1808">
                  <c:v>0.14077865578279594</c:v>
                </c:pt>
                <c:pt idx="1809">
                  <c:v>-0.107181572204967</c:v>
                </c:pt>
                <c:pt idx="1810">
                  <c:v>0.14287084509664236</c:v>
                </c:pt>
                <c:pt idx="1811">
                  <c:v>0.3918776772778661</c:v>
                </c:pt>
                <c:pt idx="1812">
                  <c:v>0.22909566135537973</c:v>
                </c:pt>
                <c:pt idx="1813">
                  <c:v>-0.15473076102009872</c:v>
                </c:pt>
                <c:pt idx="1814">
                  <c:v>0.42867840994823009</c:v>
                </c:pt>
                <c:pt idx="1815">
                  <c:v>-7.8563669193702126E-2</c:v>
                </c:pt>
                <c:pt idx="1816">
                  <c:v>0.14352403252161328</c:v>
                </c:pt>
                <c:pt idx="1817">
                  <c:v>-8.8040034713085039E-2</c:v>
                </c:pt>
                <c:pt idx="1818">
                  <c:v>0.20639316851160391</c:v>
                </c:pt>
                <c:pt idx="1819">
                  <c:v>-3.5046947099200802E-2</c:v>
                </c:pt>
                <c:pt idx="1820">
                  <c:v>0.19156265070075562</c:v>
                </c:pt>
                <c:pt idx="1821">
                  <c:v>5.0406167005301369E-3</c:v>
                </c:pt>
                <c:pt idx="1822">
                  <c:v>0.12855736497375747</c:v>
                </c:pt>
                <c:pt idx="1823">
                  <c:v>0.20062989798307435</c:v>
                </c:pt>
                <c:pt idx="1824">
                  <c:v>-0.27107817271268608</c:v>
                </c:pt>
                <c:pt idx="1825">
                  <c:v>-0.38929993786523565</c:v>
                </c:pt>
                <c:pt idx="1826">
                  <c:v>0.12763327972587371</c:v>
                </c:pt>
                <c:pt idx="1827">
                  <c:v>0.55257381117984394</c:v>
                </c:pt>
                <c:pt idx="1828">
                  <c:v>-3.0177210327092033E-2</c:v>
                </c:pt>
                <c:pt idx="1829">
                  <c:v>0.41975460548561111</c:v>
                </c:pt>
                <c:pt idx="1830">
                  <c:v>-0.16229890906613462</c:v>
                </c:pt>
                <c:pt idx="1831">
                  <c:v>-0.28595235122223311</c:v>
                </c:pt>
                <c:pt idx="1832">
                  <c:v>0.27238157809304653</c:v>
                </c:pt>
                <c:pt idx="1833">
                  <c:v>-0.20989525865354564</c:v>
                </c:pt>
                <c:pt idx="1834">
                  <c:v>-0.35217896659870301</c:v>
                </c:pt>
                <c:pt idx="1835">
                  <c:v>-1.2618807112174235</c:v>
                </c:pt>
                <c:pt idx="1836">
                  <c:v>0.1575611760911883</c:v>
                </c:pt>
                <c:pt idx="1837">
                  <c:v>0.41921526006795384</c:v>
                </c:pt>
                <c:pt idx="1838">
                  <c:v>7.1955014042037668E-3</c:v>
                </c:pt>
                <c:pt idx="1839">
                  <c:v>0.28083756861177128</c:v>
                </c:pt>
                <c:pt idx="1840">
                  <c:v>2.6870864724745192E-2</c:v>
                </c:pt>
                <c:pt idx="1841">
                  <c:v>-0.24297675349254044</c:v>
                </c:pt>
                <c:pt idx="1842">
                  <c:v>-0.248793390257147</c:v>
                </c:pt>
                <c:pt idx="1843">
                  <c:v>0.24537396261816252</c:v>
                </c:pt>
                <c:pt idx="1844">
                  <c:v>-0.30080375485175614</c:v>
                </c:pt>
                <c:pt idx="1845">
                  <c:v>-0.48297632793541928</c:v>
                </c:pt>
                <c:pt idx="1846">
                  <c:v>-0.1566592831398067</c:v>
                </c:pt>
                <c:pt idx="1847">
                  <c:v>0.18535913475800209</c:v>
                </c:pt>
                <c:pt idx="1848">
                  <c:v>0.36401205355861466</c:v>
                </c:pt>
                <c:pt idx="1849">
                  <c:v>-0.21876619990066562</c:v>
                </c:pt>
                <c:pt idx="1850">
                  <c:v>-0.23429553479194887</c:v>
                </c:pt>
                <c:pt idx="1851">
                  <c:v>-0.11512860824030058</c:v>
                </c:pt>
                <c:pt idx="1852">
                  <c:v>-0.28068511265548085</c:v>
                </c:pt>
                <c:pt idx="1853">
                  <c:v>0.58217059059184273</c:v>
                </c:pt>
                <c:pt idx="1854">
                  <c:v>0.21760297658678796</c:v>
                </c:pt>
                <c:pt idx="1855">
                  <c:v>-0.12123542873264555</c:v>
                </c:pt>
                <c:pt idx="1856">
                  <c:v>0.15962918582122781</c:v>
                </c:pt>
                <c:pt idx="1857">
                  <c:v>-9.357114068631385E-2</c:v>
                </c:pt>
                <c:pt idx="1858">
                  <c:v>0.56335340585531068</c:v>
                </c:pt>
                <c:pt idx="1859">
                  <c:v>-0.38627977181994066</c:v>
                </c:pt>
                <c:pt idx="1860">
                  <c:v>0.27441076931783798</c:v>
                </c:pt>
                <c:pt idx="1861">
                  <c:v>-0.24810786159569104</c:v>
                </c:pt>
                <c:pt idx="1862">
                  <c:v>0.28226186658764962</c:v>
                </c:pt>
                <c:pt idx="1863">
                  <c:v>0.22663183180789062</c:v>
                </c:pt>
                <c:pt idx="1864">
                  <c:v>2.9276182370632071E-2</c:v>
                </c:pt>
                <c:pt idx="1865">
                  <c:v>4.9212534632560277E-2</c:v>
                </c:pt>
                <c:pt idx="1866">
                  <c:v>-0.20756106993536216</c:v>
                </c:pt>
                <c:pt idx="1867">
                  <c:v>0.34323724728342053</c:v>
                </c:pt>
                <c:pt idx="1868">
                  <c:v>5.199846779700238E-2</c:v>
                </c:pt>
                <c:pt idx="1869">
                  <c:v>0.21362723851194748</c:v>
                </c:pt>
                <c:pt idx="1870">
                  <c:v>-0.3134770621940926</c:v>
                </c:pt>
                <c:pt idx="1871">
                  <c:v>-2.6792845886544348E-2</c:v>
                </c:pt>
                <c:pt idx="1872">
                  <c:v>0.58062791045726514</c:v>
                </c:pt>
                <c:pt idx="1873">
                  <c:v>0.34437403328573257</c:v>
                </c:pt>
                <c:pt idx="1874">
                  <c:v>-0.12107852025014938</c:v>
                </c:pt>
                <c:pt idx="1875">
                  <c:v>-1.2782336336613846</c:v>
                </c:pt>
                <c:pt idx="1876">
                  <c:v>-0.11076011121316849</c:v>
                </c:pt>
                <c:pt idx="1877">
                  <c:v>-8.5741651176328579E-2</c:v>
                </c:pt>
                <c:pt idx="1878">
                  <c:v>-0.2703819753094357</c:v>
                </c:pt>
                <c:pt idx="1879">
                  <c:v>0.13093086982644869</c:v>
                </c:pt>
                <c:pt idx="1880">
                  <c:v>0.4584869999743259</c:v>
                </c:pt>
                <c:pt idx="1881">
                  <c:v>-0.31365635692381932</c:v>
                </c:pt>
                <c:pt idx="1882">
                  <c:v>-0.36829035521439718</c:v>
                </c:pt>
                <c:pt idx="1883">
                  <c:v>0.12921706366415348</c:v>
                </c:pt>
                <c:pt idx="1884">
                  <c:v>-0.12202022722933546</c:v>
                </c:pt>
                <c:pt idx="1885">
                  <c:v>0.42599632135107901</c:v>
                </c:pt>
                <c:pt idx="1886">
                  <c:v>0.71448732057006115</c:v>
                </c:pt>
                <c:pt idx="1887">
                  <c:v>0.4104496554618034</c:v>
                </c:pt>
                <c:pt idx="1888">
                  <c:v>0.12644429972469104</c:v>
                </c:pt>
                <c:pt idx="1889">
                  <c:v>-0.11091590140185059</c:v>
                </c:pt>
                <c:pt idx="1890">
                  <c:v>0.25217341320202702</c:v>
                </c:pt>
                <c:pt idx="1891">
                  <c:v>-0.21574730659542016</c:v>
                </c:pt>
                <c:pt idx="1892">
                  <c:v>0.13829023377991154</c:v>
                </c:pt>
                <c:pt idx="1893">
                  <c:v>-1.5071726120774886</c:v>
                </c:pt>
                <c:pt idx="1894">
                  <c:v>0.47019843955566681</c:v>
                </c:pt>
                <c:pt idx="1895">
                  <c:v>-0.77299832541096247</c:v>
                </c:pt>
                <c:pt idx="1896">
                  <c:v>-0.28683209699063023</c:v>
                </c:pt>
                <c:pt idx="1897">
                  <c:v>0.37851162325372983</c:v>
                </c:pt>
                <c:pt idx="1898">
                  <c:v>-1.0309139934700597</c:v>
                </c:pt>
                <c:pt idx="1899">
                  <c:v>0.14182512970002847</c:v>
                </c:pt>
                <c:pt idx="1900">
                  <c:v>-0.320846479161911</c:v>
                </c:pt>
                <c:pt idx="1901">
                  <c:v>-0.2864801343050864</c:v>
                </c:pt>
                <c:pt idx="1902">
                  <c:v>-0.35420612992000639</c:v>
                </c:pt>
                <c:pt idx="1903">
                  <c:v>-0.14034843614016634</c:v>
                </c:pt>
                <c:pt idx="1904">
                  <c:v>-2.5911272354139817E-2</c:v>
                </c:pt>
                <c:pt idx="1905">
                  <c:v>6.5434445948633138E-2</c:v>
                </c:pt>
                <c:pt idx="1906">
                  <c:v>-7.0663465993111213E-2</c:v>
                </c:pt>
                <c:pt idx="1907">
                  <c:v>-1.0895743271483338</c:v>
                </c:pt>
                <c:pt idx="1908">
                  <c:v>0.84591150723353148</c:v>
                </c:pt>
                <c:pt idx="1909">
                  <c:v>0.30952546602782721</c:v>
                </c:pt>
                <c:pt idx="1910">
                  <c:v>-3.682184382610873E-2</c:v>
                </c:pt>
                <c:pt idx="1911">
                  <c:v>-1.4707287562940683</c:v>
                </c:pt>
                <c:pt idx="1912">
                  <c:v>0.18154785645595639</c:v>
                </c:pt>
                <c:pt idx="1913">
                  <c:v>-6.235429309493612E-2</c:v>
                </c:pt>
                <c:pt idx="1914">
                  <c:v>-1.4851960144282266</c:v>
                </c:pt>
                <c:pt idx="1915">
                  <c:v>0.48542682717024171</c:v>
                </c:pt>
                <c:pt idx="1916">
                  <c:v>0.1230039540548198</c:v>
                </c:pt>
                <c:pt idx="1917">
                  <c:v>-0.39081239512957489</c:v>
                </c:pt>
                <c:pt idx="1918">
                  <c:v>0.47207179941606769</c:v>
                </c:pt>
                <c:pt idx="1919">
                  <c:v>0.17005323530230423</c:v>
                </c:pt>
                <c:pt idx="1920">
                  <c:v>0.15263773965111241</c:v>
                </c:pt>
                <c:pt idx="1921">
                  <c:v>-0.34117157565634604</c:v>
                </c:pt>
                <c:pt idx="1922">
                  <c:v>0.15237814540103931</c:v>
                </c:pt>
                <c:pt idx="1923">
                  <c:v>0.45037988007104107</c:v>
                </c:pt>
                <c:pt idx="1924">
                  <c:v>0.10661632898778425</c:v>
                </c:pt>
                <c:pt idx="1925">
                  <c:v>0.68095441364575904</c:v>
                </c:pt>
                <c:pt idx="1926">
                  <c:v>0.47144761637739163</c:v>
                </c:pt>
                <c:pt idx="1927">
                  <c:v>-0.24930775060755553</c:v>
                </c:pt>
                <c:pt idx="1928">
                  <c:v>7.6260923761779474E-3</c:v>
                </c:pt>
                <c:pt idx="1929">
                  <c:v>0.30053377249536789</c:v>
                </c:pt>
                <c:pt idx="1930">
                  <c:v>0.43199728984072255</c:v>
                </c:pt>
                <c:pt idx="1931">
                  <c:v>0.19622932579422084</c:v>
                </c:pt>
                <c:pt idx="1932">
                  <c:v>8.4880653591296484E-2</c:v>
                </c:pt>
                <c:pt idx="1933">
                  <c:v>-0.45363642611456495</c:v>
                </c:pt>
                <c:pt idx="1934">
                  <c:v>0.42545930476535532</c:v>
                </c:pt>
                <c:pt idx="1935">
                  <c:v>-0.13321068568468425</c:v>
                </c:pt>
                <c:pt idx="1936">
                  <c:v>0.22823379956006803</c:v>
                </c:pt>
                <c:pt idx="1937">
                  <c:v>-8.1308465575602493E-2</c:v>
                </c:pt>
                <c:pt idx="1938">
                  <c:v>2.7012465062581668E-2</c:v>
                </c:pt>
                <c:pt idx="1939">
                  <c:v>-0.29707654654642718</c:v>
                </c:pt>
                <c:pt idx="1940">
                  <c:v>-2.3269779322847191E-2</c:v>
                </c:pt>
                <c:pt idx="1941">
                  <c:v>4.8968432148474624E-3</c:v>
                </c:pt>
                <c:pt idx="1942">
                  <c:v>-9.8969011800408166E-2</c:v>
                </c:pt>
                <c:pt idx="1943">
                  <c:v>9.5586907997723985E-2</c:v>
                </c:pt>
                <c:pt idx="1944">
                  <c:v>-0.19396471676378066</c:v>
                </c:pt>
                <c:pt idx="1945">
                  <c:v>-0.35217896659870301</c:v>
                </c:pt>
                <c:pt idx="1946">
                  <c:v>0.19333019538430424</c:v>
                </c:pt>
                <c:pt idx="1947">
                  <c:v>0.1554901977475622</c:v>
                </c:pt>
                <c:pt idx="1948">
                  <c:v>0.19924830684020234</c:v>
                </c:pt>
                <c:pt idx="1949">
                  <c:v>0.44307615136267298</c:v>
                </c:pt>
                <c:pt idx="1950">
                  <c:v>-0.32120692764370823</c:v>
                </c:pt>
                <c:pt idx="1951">
                  <c:v>-0.17413298159891508</c:v>
                </c:pt>
                <c:pt idx="1952">
                  <c:v>-0.14018943519870503</c:v>
                </c:pt>
                <c:pt idx="1953">
                  <c:v>-0.22229624487290192</c:v>
                </c:pt>
                <c:pt idx="1954">
                  <c:v>-1.2315322433239111E-2</c:v>
                </c:pt>
                <c:pt idx="1955">
                  <c:v>-2.8263333263764023E-2</c:v>
                </c:pt>
                <c:pt idx="1956">
                  <c:v>-0.75486946858816706</c:v>
                </c:pt>
                <c:pt idx="1957">
                  <c:v>0.20414071678022522</c:v>
                </c:pt>
                <c:pt idx="1958">
                  <c:v>-0.29814048099058144</c:v>
                </c:pt>
                <c:pt idx="1959">
                  <c:v>-0.14512663119316105</c:v>
                </c:pt>
                <c:pt idx="1960">
                  <c:v>0.2507190834005546</c:v>
                </c:pt>
                <c:pt idx="1961">
                  <c:v>0.14496000472085782</c:v>
                </c:pt>
                <c:pt idx="1962">
                  <c:v>7.2997559799950124E-2</c:v>
                </c:pt>
                <c:pt idx="1963">
                  <c:v>0.11995371750556837</c:v>
                </c:pt>
                <c:pt idx="1964">
                  <c:v>0.27022990723799772</c:v>
                </c:pt>
                <c:pt idx="1965">
                  <c:v>0.1271049651394007</c:v>
                </c:pt>
                <c:pt idx="1966">
                  <c:v>0.3022898018932747</c:v>
                </c:pt>
                <c:pt idx="1967">
                  <c:v>-0.19363469387754481</c:v>
                </c:pt>
                <c:pt idx="1968">
                  <c:v>-6.220365931344831E-2</c:v>
                </c:pt>
                <c:pt idx="1969">
                  <c:v>-0.4817670277465167</c:v>
                </c:pt>
                <c:pt idx="1970">
                  <c:v>-0.12784104277105995</c:v>
                </c:pt>
                <c:pt idx="1971">
                  <c:v>-7.1118072910655541E-2</c:v>
                </c:pt>
                <c:pt idx="1972">
                  <c:v>-0.62927772485183275</c:v>
                </c:pt>
                <c:pt idx="1973">
                  <c:v>-0.43654896632933221</c:v>
                </c:pt>
                <c:pt idx="1974">
                  <c:v>-0.15859038666189532</c:v>
                </c:pt>
                <c:pt idx="1975">
                  <c:v>-1.2587703362270404</c:v>
                </c:pt>
                <c:pt idx="1976">
                  <c:v>0.30521177607818833</c:v>
                </c:pt>
                <c:pt idx="1977">
                  <c:v>7.0938821343437514E-2</c:v>
                </c:pt>
                <c:pt idx="1978">
                  <c:v>-1.2751907408847889E-2</c:v>
                </c:pt>
                <c:pt idx="1979">
                  <c:v>-0.21675290262188346</c:v>
                </c:pt>
                <c:pt idx="1980">
                  <c:v>0.23364268300880972</c:v>
                </c:pt>
                <c:pt idx="1981">
                  <c:v>-1.8731847899613435E-2</c:v>
                </c:pt>
                <c:pt idx="1982">
                  <c:v>0.51692285127828663</c:v>
                </c:pt>
                <c:pt idx="1983">
                  <c:v>0.35049724708413316</c:v>
                </c:pt>
                <c:pt idx="1984">
                  <c:v>-0.11138337293185398</c:v>
                </c:pt>
                <c:pt idx="1985">
                  <c:v>-0.58597274087509821</c:v>
                </c:pt>
                <c:pt idx="1986">
                  <c:v>-0.37407495150034598</c:v>
                </c:pt>
                <c:pt idx="1987">
                  <c:v>0.21536797220347947</c:v>
                </c:pt>
                <c:pt idx="1988">
                  <c:v>6.1015774681628034E-2</c:v>
                </c:pt>
                <c:pt idx="1989">
                  <c:v>-0.6966576055126692</c:v>
                </c:pt>
                <c:pt idx="1990">
                  <c:v>-0.74564783726600703</c:v>
                </c:pt>
                <c:pt idx="1991">
                  <c:v>0.19446533163799662</c:v>
                </c:pt>
                <c:pt idx="1992">
                  <c:v>0.47446200244365228</c:v>
                </c:pt>
                <c:pt idx="1993">
                  <c:v>0.16517231793716666</c:v>
                </c:pt>
                <c:pt idx="1994">
                  <c:v>0.52225666762670075</c:v>
                </c:pt>
                <c:pt idx="1995">
                  <c:v>0.14886904353100072</c:v>
                </c:pt>
                <c:pt idx="1996">
                  <c:v>-8.9881381537252572E-2</c:v>
                </c:pt>
                <c:pt idx="1997">
                  <c:v>0.64634701535134476</c:v>
                </c:pt>
                <c:pt idx="1998">
                  <c:v>0.54369383828899243</c:v>
                </c:pt>
                <c:pt idx="1999">
                  <c:v>0.21598915414672054</c:v>
                </c:pt>
                <c:pt idx="2000">
                  <c:v>-2.2683437091289494E-2</c:v>
                </c:pt>
                <c:pt idx="2001">
                  <c:v>5.0048879607222582E-2</c:v>
                </c:pt>
                <c:pt idx="2002">
                  <c:v>2.0342179517185827E-2</c:v>
                </c:pt>
                <c:pt idx="2003">
                  <c:v>-0.11138337293185398</c:v>
                </c:pt>
                <c:pt idx="2004">
                  <c:v>-0.2102290226899422</c:v>
                </c:pt>
                <c:pt idx="2005">
                  <c:v>8.5560624872625515E-2</c:v>
                </c:pt>
                <c:pt idx="2006">
                  <c:v>-0.43012009385192357</c:v>
                </c:pt>
                <c:pt idx="2007">
                  <c:v>0.77061764665620303</c:v>
                </c:pt>
                <c:pt idx="2008">
                  <c:v>0.74648476154260213</c:v>
                </c:pt>
                <c:pt idx="2009">
                  <c:v>-1.3625473915035144E-2</c:v>
                </c:pt>
                <c:pt idx="2010">
                  <c:v>0.78190521141611302</c:v>
                </c:pt>
                <c:pt idx="2011">
                  <c:v>0.21126144971296112</c:v>
                </c:pt>
                <c:pt idx="2012">
                  <c:v>-0.72094478351653291</c:v>
                </c:pt>
                <c:pt idx="2013">
                  <c:v>-0.19445989268794478</c:v>
                </c:pt>
                <c:pt idx="2014">
                  <c:v>3.3370138460592183E-2</c:v>
                </c:pt>
                <c:pt idx="2015">
                  <c:v>-0.27735911400019497</c:v>
                </c:pt>
                <c:pt idx="2016">
                  <c:v>-0.49919794694284236</c:v>
                </c:pt>
                <c:pt idx="2017">
                  <c:v>0.23682933548639973</c:v>
                </c:pt>
                <c:pt idx="2018">
                  <c:v>0.20351441113075852</c:v>
                </c:pt>
                <c:pt idx="2019">
                  <c:v>-0.16229890906613462</c:v>
                </c:pt>
                <c:pt idx="2020">
                  <c:v>9.7206245974365807E-2</c:v>
                </c:pt>
                <c:pt idx="2021">
                  <c:v>0.34687181394424943</c:v>
                </c:pt>
                <c:pt idx="2022">
                  <c:v>0.10070858859668395</c:v>
                </c:pt>
                <c:pt idx="2023">
                  <c:v>-0.27020797844003464</c:v>
                </c:pt>
                <c:pt idx="2024">
                  <c:v>0.50039416641579526</c:v>
                </c:pt>
                <c:pt idx="2025">
                  <c:v>0.11156554495951765</c:v>
                </c:pt>
                <c:pt idx="2026">
                  <c:v>-0.21139780526485866</c:v>
                </c:pt>
                <c:pt idx="2027">
                  <c:v>-0.15168253016389796</c:v>
                </c:pt>
                <c:pt idx="2028">
                  <c:v>-0.35052249446826406</c:v>
                </c:pt>
                <c:pt idx="2029">
                  <c:v>0.2709474874770586</c:v>
                </c:pt>
                <c:pt idx="2030">
                  <c:v>0.59100913083957096</c:v>
                </c:pt>
                <c:pt idx="2031">
                  <c:v>-0.11888359148809831</c:v>
                </c:pt>
                <c:pt idx="2032">
                  <c:v>-0.55957927924323292</c:v>
                </c:pt>
                <c:pt idx="2033">
                  <c:v>-0.13257792469169477</c:v>
                </c:pt>
                <c:pt idx="2034">
                  <c:v>9.6396804187157126E-2</c:v>
                </c:pt>
                <c:pt idx="2035">
                  <c:v>0.51227746214071312</c:v>
                </c:pt>
                <c:pt idx="2036">
                  <c:v>-0.15008078131402144</c:v>
                </c:pt>
                <c:pt idx="2037">
                  <c:v>0.83398301100712124</c:v>
                </c:pt>
                <c:pt idx="2038">
                  <c:v>0.54121744810203698</c:v>
                </c:pt>
                <c:pt idx="2039">
                  <c:v>-0.15008078131402144</c:v>
                </c:pt>
                <c:pt idx="2040">
                  <c:v>-0.51395500740965039</c:v>
                </c:pt>
                <c:pt idx="2041">
                  <c:v>-8.0850636712325549E-2</c:v>
                </c:pt>
                <c:pt idx="2042">
                  <c:v>1.4640946881753174E-2</c:v>
                </c:pt>
                <c:pt idx="2043">
                  <c:v>8.8277309680451901E-2</c:v>
                </c:pt>
                <c:pt idx="2044">
                  <c:v>-0.13479380341282682</c:v>
                </c:pt>
                <c:pt idx="2045">
                  <c:v>-0.20223992036816657</c:v>
                </c:pt>
                <c:pt idx="2046">
                  <c:v>-0.38684557156870081</c:v>
                </c:pt>
                <c:pt idx="2047">
                  <c:v>0.31823006007591847</c:v>
                </c:pt>
                <c:pt idx="2048">
                  <c:v>0.42696244775855241</c:v>
                </c:pt>
                <c:pt idx="2049">
                  <c:v>-0.17788172527065546</c:v>
                </c:pt>
                <c:pt idx="2050">
                  <c:v>-1.0102401539421205E-3</c:v>
                </c:pt>
                <c:pt idx="2051">
                  <c:v>8.4336445723323716E-2</c:v>
                </c:pt>
                <c:pt idx="2052">
                  <c:v>-0.25188230671443235</c:v>
                </c:pt>
                <c:pt idx="2053">
                  <c:v>-1.537424111957796</c:v>
                </c:pt>
                <c:pt idx="2054">
                  <c:v>-0.25308534035210162</c:v>
                </c:pt>
                <c:pt idx="2055">
                  <c:v>-5.6941361109602261E-2</c:v>
                </c:pt>
                <c:pt idx="2056">
                  <c:v>-0.29583628054603456</c:v>
                </c:pt>
                <c:pt idx="2057">
                  <c:v>-0.15955690861020833</c:v>
                </c:pt>
                <c:pt idx="2058">
                  <c:v>-0.18869338853021883</c:v>
                </c:pt>
                <c:pt idx="2059">
                  <c:v>1.3133619593922186</c:v>
                </c:pt>
                <c:pt idx="2060">
                  <c:v>7.5601084824028206E-2</c:v>
                </c:pt>
                <c:pt idx="2061">
                  <c:v>-0.43050890804128378</c:v>
                </c:pt>
                <c:pt idx="2062">
                  <c:v>0.26567692517216907</c:v>
                </c:pt>
                <c:pt idx="2063">
                  <c:v>-0.21290191838899539</c:v>
                </c:pt>
                <c:pt idx="2064">
                  <c:v>-0.19545075470552753</c:v>
                </c:pt>
                <c:pt idx="2065">
                  <c:v>3.3088169332187757E-2</c:v>
                </c:pt>
                <c:pt idx="2066">
                  <c:v>-0.26170773657050578</c:v>
                </c:pt>
                <c:pt idx="2067">
                  <c:v>1.2349304477791854</c:v>
                </c:pt>
                <c:pt idx="2068">
                  <c:v>6.419306192749237E-2</c:v>
                </c:pt>
                <c:pt idx="2069">
                  <c:v>0.25616527726305621</c:v>
                </c:pt>
                <c:pt idx="2070">
                  <c:v>-1.5228387614574906E-2</c:v>
                </c:pt>
                <c:pt idx="2071">
                  <c:v>-7.8106710405880533E-2</c:v>
                </c:pt>
                <c:pt idx="2072">
                  <c:v>1.6973735095414264</c:v>
                </c:pt>
                <c:pt idx="2073">
                  <c:v>-0.13875921474032632</c:v>
                </c:pt>
                <c:pt idx="2074">
                  <c:v>0.64034328200586643</c:v>
                </c:pt>
                <c:pt idx="2075">
                  <c:v>0.18662732668292162</c:v>
                </c:pt>
                <c:pt idx="2076">
                  <c:v>-0.13860038884256159</c:v>
                </c:pt>
                <c:pt idx="2077">
                  <c:v>-0.14560532224689929</c:v>
                </c:pt>
                <c:pt idx="2078">
                  <c:v>0.68275306123054591</c:v>
                </c:pt>
                <c:pt idx="2079">
                  <c:v>-0.28788850053372333</c:v>
                </c:pt>
                <c:pt idx="2080">
                  <c:v>-0.10206260157995356</c:v>
                </c:pt>
                <c:pt idx="2081">
                  <c:v>-0.19743452269205597</c:v>
                </c:pt>
                <c:pt idx="2082">
                  <c:v>-0.13987148587711204</c:v>
                </c:pt>
                <c:pt idx="2083">
                  <c:v>0.27178421356921684</c:v>
                </c:pt>
                <c:pt idx="2084">
                  <c:v>-3.6525876025114042E-2</c:v>
                </c:pt>
                <c:pt idx="2085">
                  <c:v>0.19433924948446313</c:v>
                </c:pt>
                <c:pt idx="2086">
                  <c:v>-0.17315664835103578</c:v>
                </c:pt>
                <c:pt idx="2087">
                  <c:v>-0.95735566259150628</c:v>
                </c:pt>
                <c:pt idx="2088">
                  <c:v>-0.21106377075517266</c:v>
                </c:pt>
                <c:pt idx="2089">
                  <c:v>2.1195424514489698E-2</c:v>
                </c:pt>
                <c:pt idx="2090">
                  <c:v>0.16401388852505705</c:v>
                </c:pt>
                <c:pt idx="2091">
                  <c:v>-2.7437279454271078E-3</c:v>
                </c:pt>
                <c:pt idx="2092">
                  <c:v>0.15081959821213325</c:v>
                </c:pt>
                <c:pt idx="2093">
                  <c:v>0.32227430015420527</c:v>
                </c:pt>
                <c:pt idx="2094">
                  <c:v>-0.23226046445442164</c:v>
                </c:pt>
                <c:pt idx="2095">
                  <c:v>-0.65086122292291559</c:v>
                </c:pt>
                <c:pt idx="2096">
                  <c:v>0.39867871576502545</c:v>
                </c:pt>
                <c:pt idx="2097">
                  <c:v>-5.2745299031971712E-2</c:v>
                </c:pt>
                <c:pt idx="2098">
                  <c:v>-3.2536242089729016E-2</c:v>
                </c:pt>
                <c:pt idx="2099">
                  <c:v>0.34494209056002806</c:v>
                </c:pt>
                <c:pt idx="2100">
                  <c:v>0.3764015265935981</c:v>
                </c:pt>
                <c:pt idx="2101">
                  <c:v>-0.30507524588002566</c:v>
                </c:pt>
                <c:pt idx="2102">
                  <c:v>-8.537110053967626E-3</c:v>
                </c:pt>
                <c:pt idx="2103">
                  <c:v>2.4177814301165262E-2</c:v>
                </c:pt>
                <c:pt idx="2104">
                  <c:v>0.54191126593590477</c:v>
                </c:pt>
                <c:pt idx="2105">
                  <c:v>0.81426329139978171</c:v>
                </c:pt>
                <c:pt idx="2106">
                  <c:v>-2.7674958442848348E-2</c:v>
                </c:pt>
                <c:pt idx="2107">
                  <c:v>1.1638756246893662E-2</c:v>
                </c:pt>
                <c:pt idx="2108">
                  <c:v>-0.20174206735549979</c:v>
                </c:pt>
                <c:pt idx="2109">
                  <c:v>0.41131776833697148</c:v>
                </c:pt>
                <c:pt idx="2110">
                  <c:v>-0.54098813552361813</c:v>
                </c:pt>
                <c:pt idx="2111">
                  <c:v>-0.24212334025210375</c:v>
                </c:pt>
                <c:pt idx="2112">
                  <c:v>8.1884966729227376E-2</c:v>
                </c:pt>
                <c:pt idx="2113">
                  <c:v>0.26195197859215374</c:v>
                </c:pt>
                <c:pt idx="2114">
                  <c:v>-0.45383401497207965</c:v>
                </c:pt>
                <c:pt idx="2115">
                  <c:v>0.73915682571394592</c:v>
                </c:pt>
                <c:pt idx="2116">
                  <c:v>-1.2606364403338443E-2</c:v>
                </c:pt>
                <c:pt idx="2117">
                  <c:v>0.24379092506481009</c:v>
                </c:pt>
                <c:pt idx="2118">
                  <c:v>-0.13210353600734515</c:v>
                </c:pt>
                <c:pt idx="2119">
                  <c:v>-4.9307640224370425E-2</c:v>
                </c:pt>
                <c:pt idx="2120">
                  <c:v>0.36019569473235818</c:v>
                </c:pt>
                <c:pt idx="2121">
                  <c:v>-0.11278669704877065</c:v>
                </c:pt>
                <c:pt idx="2122">
                  <c:v>0.16787170802916096</c:v>
                </c:pt>
                <c:pt idx="2123">
                  <c:v>0.37506724206761044</c:v>
                </c:pt>
                <c:pt idx="2124">
                  <c:v>-0.44261441857647488</c:v>
                </c:pt>
                <c:pt idx="2125">
                  <c:v>-1.2024339164626849E-2</c:v>
                </c:pt>
                <c:pt idx="2126">
                  <c:v>-0.17869796011047026</c:v>
                </c:pt>
                <c:pt idx="2127">
                  <c:v>0.13303737874734975</c:v>
                </c:pt>
                <c:pt idx="2128">
                  <c:v>-2.3101606872011158E-3</c:v>
                </c:pt>
                <c:pt idx="2129">
                  <c:v>-0.3159892183726889</c:v>
                </c:pt>
                <c:pt idx="2130">
                  <c:v>-5.7842107262206295E-2</c:v>
                </c:pt>
                <c:pt idx="2131">
                  <c:v>0.7923556311794917</c:v>
                </c:pt>
                <c:pt idx="2132">
                  <c:v>-1.1713684183119812</c:v>
                </c:pt>
                <c:pt idx="2133">
                  <c:v>7.0526720876682436E-2</c:v>
                </c:pt>
                <c:pt idx="2134">
                  <c:v>-0.16165326347876927</c:v>
                </c:pt>
                <c:pt idx="2135">
                  <c:v>-0.23905522582355559</c:v>
                </c:pt>
                <c:pt idx="2136">
                  <c:v>-0.33971024857177884</c:v>
                </c:pt>
                <c:pt idx="2137">
                  <c:v>0.35264554528092595</c:v>
                </c:pt>
                <c:pt idx="2138">
                  <c:v>4.2644337408493722E-2</c:v>
                </c:pt>
                <c:pt idx="2139">
                  <c:v>-0.71288236421181894</c:v>
                </c:pt>
                <c:pt idx="2140">
                  <c:v>-1.5228387614574906E-2</c:v>
                </c:pt>
                <c:pt idx="2141">
                  <c:v>-0.14193941010035235</c:v>
                </c:pt>
                <c:pt idx="2142">
                  <c:v>0.12868932884678694</c:v>
                </c:pt>
                <c:pt idx="2143">
                  <c:v>0.45270085248384417</c:v>
                </c:pt>
                <c:pt idx="2144">
                  <c:v>0.32169724521235366</c:v>
                </c:pt>
                <c:pt idx="2145">
                  <c:v>9.6261853058403485E-2</c:v>
                </c:pt>
                <c:pt idx="2146">
                  <c:v>0.68912021051818673</c:v>
                </c:pt>
                <c:pt idx="2147">
                  <c:v>-0.52014861326265105</c:v>
                </c:pt>
                <c:pt idx="2148">
                  <c:v>0.34004947285316645</c:v>
                </c:pt>
                <c:pt idx="2149">
                  <c:v>-9.1263935587371392E-2</c:v>
                </c:pt>
                <c:pt idx="2150">
                  <c:v>-0.37988283497131581</c:v>
                </c:pt>
                <c:pt idx="2151">
                  <c:v>-0.95343909424225881</c:v>
                </c:pt>
                <c:pt idx="2152">
                  <c:v>4.8236185652847631E-2</c:v>
                </c:pt>
                <c:pt idx="2153">
                  <c:v>-0.23939580539097524</c:v>
                </c:pt>
                <c:pt idx="2154">
                  <c:v>8.2000138321361282E-3</c:v>
                </c:pt>
                <c:pt idx="2155">
                  <c:v>-6.9416094188468891E-3</c:v>
                </c:pt>
                <c:pt idx="2156">
                  <c:v>0.18040250682864914</c:v>
                </c:pt>
                <c:pt idx="2157">
                  <c:v>0.27703255187479342</c:v>
                </c:pt>
                <c:pt idx="2158">
                  <c:v>-1.0649174766813385</c:v>
                </c:pt>
                <c:pt idx="2159">
                  <c:v>3.0971642412075527E-2</c:v>
                </c:pt>
                <c:pt idx="2160">
                  <c:v>-0.63890542982367959</c:v>
                </c:pt>
                <c:pt idx="2161">
                  <c:v>-0.46076672913396444</c:v>
                </c:pt>
                <c:pt idx="2162">
                  <c:v>-0.16359106772026177</c:v>
                </c:pt>
                <c:pt idx="2163">
                  <c:v>0.15211850443194314</c:v>
                </c:pt>
                <c:pt idx="2164">
                  <c:v>-0.26951220073622373</c:v>
                </c:pt>
                <c:pt idx="2165">
                  <c:v>0.10191895971107164</c:v>
                </c:pt>
                <c:pt idx="2166">
                  <c:v>-0.6515409379135283</c:v>
                </c:pt>
                <c:pt idx="2167">
                  <c:v>-0.53073915338400168</c:v>
                </c:pt>
                <c:pt idx="2168">
                  <c:v>-0.28068511265548085</c:v>
                </c:pt>
                <c:pt idx="2169">
                  <c:v>-0.38364230300330965</c:v>
                </c:pt>
                <c:pt idx="2170">
                  <c:v>-8.344692341260658E-2</c:v>
                </c:pt>
                <c:pt idx="2171">
                  <c:v>0.35241955921516172</c:v>
                </c:pt>
                <c:pt idx="2172">
                  <c:v>0.11649784050174836</c:v>
                </c:pt>
                <c:pt idx="2173">
                  <c:v>0.25592366027356356</c:v>
                </c:pt>
                <c:pt idx="2174">
                  <c:v>-0.1002056517911709</c:v>
                </c:pt>
                <c:pt idx="2175">
                  <c:v>-0.30578839223210941</c:v>
                </c:pt>
                <c:pt idx="2176">
                  <c:v>0.23278353412245326</c:v>
                </c:pt>
                <c:pt idx="2177">
                  <c:v>0.24719838857586485</c:v>
                </c:pt>
                <c:pt idx="2178">
                  <c:v>0.29654550819511738</c:v>
                </c:pt>
                <c:pt idx="2179">
                  <c:v>0.89809223555900797</c:v>
                </c:pt>
                <c:pt idx="2180">
                  <c:v>-0.53178163846505078</c:v>
                </c:pt>
                <c:pt idx="2181">
                  <c:v>-2.8116217061027168E-2</c:v>
                </c:pt>
                <c:pt idx="2182">
                  <c:v>-0.26118893702968365</c:v>
                </c:pt>
                <c:pt idx="2183">
                  <c:v>-1.5665855159511612E-2</c:v>
                </c:pt>
                <c:pt idx="2184">
                  <c:v>0.12167855658825247</c:v>
                </c:pt>
                <c:pt idx="2185">
                  <c:v>-0.24331826019099598</c:v>
                </c:pt>
                <c:pt idx="2186">
                  <c:v>0.24110797493405448</c:v>
                </c:pt>
                <c:pt idx="2187">
                  <c:v>-1.0755200076409777</c:v>
                </c:pt>
                <c:pt idx="2188">
                  <c:v>-4.0229844788532719E-2</c:v>
                </c:pt>
                <c:pt idx="2189">
                  <c:v>0.39143779769800013</c:v>
                </c:pt>
                <c:pt idx="2190">
                  <c:v>-0.45699912259757436</c:v>
                </c:pt>
                <c:pt idx="2191">
                  <c:v>-0.94369393966812354</c:v>
                </c:pt>
                <c:pt idx="2192">
                  <c:v>-0.65653532384547109</c:v>
                </c:pt>
                <c:pt idx="2193">
                  <c:v>-0.37145968073723962</c:v>
                </c:pt>
                <c:pt idx="2194">
                  <c:v>0.30894328812521354</c:v>
                </c:pt>
                <c:pt idx="2195">
                  <c:v>-0.18164023517696062</c:v>
                </c:pt>
                <c:pt idx="2196">
                  <c:v>0.40849448946944417</c:v>
                </c:pt>
                <c:pt idx="2197">
                  <c:v>-0.25549442137138945</c:v>
                </c:pt>
                <c:pt idx="2198">
                  <c:v>0.11103131238874395</c:v>
                </c:pt>
                <c:pt idx="2199">
                  <c:v>-7.9782934037782902E-2</c:v>
                </c:pt>
                <c:pt idx="2200">
                  <c:v>-0.14209860403606026</c:v>
                </c:pt>
                <c:pt idx="2201">
                  <c:v>0.18573970940278248</c:v>
                </c:pt>
                <c:pt idx="2202">
                  <c:v>0.62685961809953739</c:v>
                </c:pt>
                <c:pt idx="2203">
                  <c:v>-0.35052249446826406</c:v>
                </c:pt>
                <c:pt idx="2204">
                  <c:v>-0.26916443767779907</c:v>
                </c:pt>
                <c:pt idx="2205">
                  <c:v>0.10030490579568548</c:v>
                </c:pt>
                <c:pt idx="2206">
                  <c:v>0.12657645701337311</c:v>
                </c:pt>
                <c:pt idx="2207">
                  <c:v>8.0930487672983928E-2</c:v>
                </c:pt>
                <c:pt idx="2208">
                  <c:v>-3.9191774611020275E-2</c:v>
                </c:pt>
                <c:pt idx="2209">
                  <c:v>-8.9420824457239506E-2</c:v>
                </c:pt>
                <c:pt idx="2210">
                  <c:v>0.49794442187774279</c:v>
                </c:pt>
                <c:pt idx="2211">
                  <c:v>-0.17869796011047026</c:v>
                </c:pt>
                <c:pt idx="2212">
                  <c:v>-0.30578839223210941</c:v>
                </c:pt>
                <c:pt idx="2213">
                  <c:v>-0.49370273452847768</c:v>
                </c:pt>
                <c:pt idx="2214">
                  <c:v>-0.39024503782755654</c:v>
                </c:pt>
                <c:pt idx="2215">
                  <c:v>0.45206823022381099</c:v>
                </c:pt>
                <c:pt idx="2216">
                  <c:v>-0.32970349589250586</c:v>
                </c:pt>
                <c:pt idx="2217">
                  <c:v>0.30357619969664068</c:v>
                </c:pt>
                <c:pt idx="2218">
                  <c:v>-0.16731248356046824</c:v>
                </c:pt>
                <c:pt idx="2219">
                  <c:v>0.22958792274065198</c:v>
                </c:pt>
                <c:pt idx="2220">
                  <c:v>-0.86013763198435911</c:v>
                </c:pt>
                <c:pt idx="2221">
                  <c:v>0.16542962042418519</c:v>
                </c:pt>
                <c:pt idx="2222">
                  <c:v>-0.1195103733121806</c:v>
                </c:pt>
                <c:pt idx="2223">
                  <c:v>0.47269571251829079</c:v>
                </c:pt>
                <c:pt idx="2224">
                  <c:v>-0.62727072934027639</c:v>
                </c:pt>
                <c:pt idx="2225">
                  <c:v>-0.2155797753822157</c:v>
                </c:pt>
                <c:pt idx="2226">
                  <c:v>-1.1379652600447674</c:v>
                </c:pt>
                <c:pt idx="2227">
                  <c:v>-0.12076475447229479</c:v>
                </c:pt>
                <c:pt idx="2228">
                  <c:v>-0.28859319955415269</c:v>
                </c:pt>
                <c:pt idx="2229">
                  <c:v>0.16658691407044984</c:v>
                </c:pt>
                <c:pt idx="2230">
                  <c:v>0.12114805647531052</c:v>
                </c:pt>
                <c:pt idx="2231">
                  <c:v>0.25180996817153983</c:v>
                </c:pt>
                <c:pt idx="2232">
                  <c:v>-1.6687128932879054E-2</c:v>
                </c:pt>
                <c:pt idx="2233">
                  <c:v>-0.11153923044195951</c:v>
                </c:pt>
                <c:pt idx="2234">
                  <c:v>0.37717928973663867</c:v>
                </c:pt>
                <c:pt idx="2235">
                  <c:v>0.22823379956006803</c:v>
                </c:pt>
                <c:pt idx="2236">
                  <c:v>-0.22887504687163332</c:v>
                </c:pt>
                <c:pt idx="2237">
                  <c:v>-5.0582898230289624E-3</c:v>
                </c:pt>
                <c:pt idx="2238">
                  <c:v>-4.319988194842328E-2</c:v>
                </c:pt>
                <c:pt idx="2239">
                  <c:v>0.10084312443311183</c:v>
                </c:pt>
                <c:pt idx="2240">
                  <c:v>7.1762669300091272E-2</c:v>
                </c:pt>
                <c:pt idx="2241">
                  <c:v>0.31208426151475388</c:v>
                </c:pt>
                <c:pt idx="2242">
                  <c:v>-3.0029898840683307E-2</c:v>
                </c:pt>
                <c:pt idx="2243">
                  <c:v>-0.18705004054425081</c:v>
                </c:pt>
                <c:pt idx="2244">
                  <c:v>7.9565849810274772E-2</c:v>
                </c:pt>
                <c:pt idx="2245">
                  <c:v>0.10889240163240912</c:v>
                </c:pt>
                <c:pt idx="2246">
                  <c:v>-0.45225406131285639</c:v>
                </c:pt>
                <c:pt idx="2247">
                  <c:v>0.20288783347014344</c:v>
                </c:pt>
                <c:pt idx="2248">
                  <c:v>0.34209956483278436</c:v>
                </c:pt>
                <c:pt idx="2249">
                  <c:v>-0.10299197355168209</c:v>
                </c:pt>
                <c:pt idx="2250">
                  <c:v>-0.69478822392181161</c:v>
                </c:pt>
                <c:pt idx="2251">
                  <c:v>-0.30792994884636288</c:v>
                </c:pt>
                <c:pt idx="2252">
                  <c:v>0.16915535883089369</c:v>
                </c:pt>
                <c:pt idx="2253">
                  <c:v>-0.18885782633069192</c:v>
                </c:pt>
                <c:pt idx="2254">
                  <c:v>-0.18540856233680228</c:v>
                </c:pt>
                <c:pt idx="2255">
                  <c:v>0.82968722215566049</c:v>
                </c:pt>
                <c:pt idx="2256">
                  <c:v>-5.7823525940061109E-3</c:v>
                </c:pt>
                <c:pt idx="2257">
                  <c:v>0.36893593219790022</c:v>
                </c:pt>
                <c:pt idx="2258">
                  <c:v>-0.176087632512198</c:v>
                </c:pt>
                <c:pt idx="2259">
                  <c:v>-0.18918675816998476</c:v>
                </c:pt>
                <c:pt idx="2260">
                  <c:v>-2.4546686295154373E-3</c:v>
                </c:pt>
                <c:pt idx="2261">
                  <c:v>-9.7424700969059461E-2</c:v>
                </c:pt>
                <c:pt idx="2262">
                  <c:v>-0.20008379701098586</c:v>
                </c:pt>
                <c:pt idx="2263">
                  <c:v>-3.3864894562046173E-2</c:v>
                </c:pt>
                <c:pt idx="2264">
                  <c:v>8.800587129002016E-2</c:v>
                </c:pt>
                <c:pt idx="2265">
                  <c:v>0.16992500144231237</c:v>
                </c:pt>
                <c:pt idx="2266">
                  <c:v>0.22724818378073325</c:v>
                </c:pt>
                <c:pt idx="2267">
                  <c:v>-1.066729528467673</c:v>
                </c:pt>
                <c:pt idx="2268">
                  <c:v>-0.28138630102451551</c:v>
                </c:pt>
                <c:pt idx="2269">
                  <c:v>-0.17201842735243814</c:v>
                </c:pt>
                <c:pt idx="2270">
                  <c:v>0.33170521649889234</c:v>
                </c:pt>
                <c:pt idx="2271">
                  <c:v>0.18243805572490959</c:v>
                </c:pt>
                <c:pt idx="2272">
                  <c:v>-1.1306813051710953</c:v>
                </c:pt>
                <c:pt idx="2273">
                  <c:v>0.53555533339930994</c:v>
                </c:pt>
                <c:pt idx="2274">
                  <c:v>0.24318160164447203</c:v>
                </c:pt>
                <c:pt idx="2275">
                  <c:v>-9.9890979390998176E-3</c:v>
                </c:pt>
                <c:pt idx="2276">
                  <c:v>-0.94730588869615495</c:v>
                </c:pt>
                <c:pt idx="2277">
                  <c:v>0.18192943769006684</c:v>
                </c:pt>
                <c:pt idx="2278">
                  <c:v>9.1665987521812903E-2</c:v>
                </c:pt>
                <c:pt idx="2279">
                  <c:v>-0.34281733987157681</c:v>
                </c:pt>
                <c:pt idx="2280">
                  <c:v>0.27178421356921684</c:v>
                </c:pt>
                <c:pt idx="2281">
                  <c:v>0.21387604338294247</c:v>
                </c:pt>
                <c:pt idx="2282">
                  <c:v>0.35704521296680752</c:v>
                </c:pt>
                <c:pt idx="2283">
                  <c:v>0.37984272749168235</c:v>
                </c:pt>
                <c:pt idx="2284">
                  <c:v>0.47092725747512665</c:v>
                </c:pt>
                <c:pt idx="2285">
                  <c:v>-0.96353183293070843</c:v>
                </c:pt>
                <c:pt idx="2286">
                  <c:v>-1.1539279703695422</c:v>
                </c:pt>
                <c:pt idx="2287">
                  <c:v>0.20376496601865624</c:v>
                </c:pt>
                <c:pt idx="2288">
                  <c:v>0.32227430015420527</c:v>
                </c:pt>
                <c:pt idx="2289">
                  <c:v>-1.173341457382676E-2</c:v>
                </c:pt>
                <c:pt idx="2290">
                  <c:v>0.53136898309983993</c:v>
                </c:pt>
                <c:pt idx="2291">
                  <c:v>0.64800517981049321</c:v>
                </c:pt>
                <c:pt idx="2292">
                  <c:v>-0.30329392074831124</c:v>
                </c:pt>
                <c:pt idx="2293">
                  <c:v>-2.3123171422625623E-2</c:v>
                </c:pt>
                <c:pt idx="2294">
                  <c:v>-0.50123853432814769</c:v>
                </c:pt>
                <c:pt idx="2295">
                  <c:v>6.2674362763392485E-2</c:v>
                </c:pt>
                <c:pt idx="2296">
                  <c:v>-0.14592453787844586</c:v>
                </c:pt>
                <c:pt idx="2297">
                  <c:v>2.9417546835091738E-2</c:v>
                </c:pt>
                <c:pt idx="2298">
                  <c:v>-5.005426086976103E-2</c:v>
                </c:pt>
                <c:pt idx="2299">
                  <c:v>0.39791246017690557</c:v>
                </c:pt>
                <c:pt idx="2300">
                  <c:v>5.5056793368935104E-2</c:v>
                </c:pt>
                <c:pt idx="2301">
                  <c:v>0.3925372452751309</c:v>
                </c:pt>
                <c:pt idx="2302">
                  <c:v>0.19559957544990356</c:v>
                </c:pt>
                <c:pt idx="2303">
                  <c:v>-1.0782590139204995</c:v>
                </c:pt>
                <c:pt idx="2304">
                  <c:v>-7.597614772199382E-2</c:v>
                </c:pt>
                <c:pt idx="2305">
                  <c:v>-0.19809638532134477</c:v>
                </c:pt>
                <c:pt idx="2306">
                  <c:v>0.11583229865256488</c:v>
                </c:pt>
                <c:pt idx="2307">
                  <c:v>-5.2745299031971712E-2</c:v>
                </c:pt>
                <c:pt idx="2308">
                  <c:v>0.20213558088984851</c:v>
                </c:pt>
                <c:pt idx="2309">
                  <c:v>0.20864210901516606</c:v>
                </c:pt>
                <c:pt idx="2310">
                  <c:v>0.63394263123560379</c:v>
                </c:pt>
                <c:pt idx="2311">
                  <c:v>-0.33351606916257426</c:v>
                </c:pt>
                <c:pt idx="2312">
                  <c:v>0.17287150035227722</c:v>
                </c:pt>
                <c:pt idx="2313">
                  <c:v>0.33365271476541358</c:v>
                </c:pt>
                <c:pt idx="2314">
                  <c:v>-2.1804370318348448E-2</c:v>
                </c:pt>
                <c:pt idx="2315">
                  <c:v>-2.8116217061027168E-2</c:v>
                </c:pt>
                <c:pt idx="2316">
                  <c:v>0.24086382278574986</c:v>
                </c:pt>
                <c:pt idx="2317">
                  <c:v>-0.10935875603655623</c:v>
                </c:pt>
                <c:pt idx="2318">
                  <c:v>-0.863808613712856</c:v>
                </c:pt>
                <c:pt idx="2319">
                  <c:v>0.10138114235502452</c:v>
                </c:pt>
                <c:pt idx="2320">
                  <c:v>-2.3123171422625623E-2</c:v>
                </c:pt>
                <c:pt idx="2321">
                  <c:v>7.9702371697378191E-2</c:v>
                </c:pt>
                <c:pt idx="2322">
                  <c:v>-8.6660565246178073E-2</c:v>
                </c:pt>
                <c:pt idx="2323">
                  <c:v>7.0389327891398012E-2</c:v>
                </c:pt>
                <c:pt idx="2324">
                  <c:v>0.29124991296422992</c:v>
                </c:pt>
                <c:pt idx="2325">
                  <c:v>-0.22465441592596019</c:v>
                </c:pt>
                <c:pt idx="2326">
                  <c:v>-0.42565624607998709</c:v>
                </c:pt>
                <c:pt idx="2327">
                  <c:v>-0.14241704461585192</c:v>
                </c:pt>
                <c:pt idx="2328">
                  <c:v>-0.29018003202308379</c:v>
                </c:pt>
                <c:pt idx="2329">
                  <c:v>-0.11591009086646677</c:v>
                </c:pt>
                <c:pt idx="2330">
                  <c:v>-0.51560403749733374</c:v>
                </c:pt>
                <c:pt idx="2331">
                  <c:v>0.72106636873105012</c:v>
                </c:pt>
                <c:pt idx="2332">
                  <c:v>2.7012465062581668E-2</c:v>
                </c:pt>
                <c:pt idx="2333">
                  <c:v>-0.20856097412755825</c:v>
                </c:pt>
                <c:pt idx="2334">
                  <c:v>-2.5911272354139817E-2</c:v>
                </c:pt>
                <c:pt idx="2335">
                  <c:v>0.36625226369956387</c:v>
                </c:pt>
                <c:pt idx="2336">
                  <c:v>9.8554307220729456E-2</c:v>
                </c:pt>
                <c:pt idx="2337">
                  <c:v>-1.250165425587271</c:v>
                </c:pt>
                <c:pt idx="2338">
                  <c:v>0.3167250215787496</c:v>
                </c:pt>
                <c:pt idx="2339">
                  <c:v>0.1905516520322702</c:v>
                </c:pt>
                <c:pt idx="2340">
                  <c:v>-2.4149739728834305E-2</c:v>
                </c:pt>
                <c:pt idx="2341">
                  <c:v>-0.11528487090396689</c:v>
                </c:pt>
                <c:pt idx="2342">
                  <c:v>0.1392075202712541</c:v>
                </c:pt>
                <c:pt idx="2343">
                  <c:v>-0.6438561897747247</c:v>
                </c:pt>
                <c:pt idx="2344">
                  <c:v>0.48635397600203695</c:v>
                </c:pt>
                <c:pt idx="2345">
                  <c:v>-0.63710935733413976</c:v>
                </c:pt>
                <c:pt idx="2346">
                  <c:v>-0.28595235122223311</c:v>
                </c:pt>
                <c:pt idx="2347">
                  <c:v>0.16992500144231237</c:v>
                </c:pt>
                <c:pt idx="2348">
                  <c:v>5.8801353616186228E-2</c:v>
                </c:pt>
                <c:pt idx="2349">
                  <c:v>0.51883724243651186</c:v>
                </c:pt>
                <c:pt idx="2350">
                  <c:v>7.3408955185340033E-2</c:v>
                </c:pt>
                <c:pt idx="2351">
                  <c:v>-0.20058107800892003</c:v>
                </c:pt>
                <c:pt idx="2352">
                  <c:v>-0.63913009618571404</c:v>
                </c:pt>
                <c:pt idx="2353">
                  <c:v>0.34266851820249955</c:v>
                </c:pt>
                <c:pt idx="2354">
                  <c:v>0.3386811246245463</c:v>
                </c:pt>
                <c:pt idx="2355">
                  <c:v>-1.3479842759519691E-2</c:v>
                </c:pt>
                <c:pt idx="2356">
                  <c:v>-0.15344651031471868</c:v>
                </c:pt>
                <c:pt idx="2357">
                  <c:v>0.23609457863787781</c:v>
                </c:pt>
                <c:pt idx="2358">
                  <c:v>0.18878069779214166</c:v>
                </c:pt>
                <c:pt idx="2359">
                  <c:v>1.3497991748977313E-2</c:v>
                </c:pt>
                <c:pt idx="2360">
                  <c:v>0.19257294138692257</c:v>
                </c:pt>
                <c:pt idx="2361">
                  <c:v>-0.95959848471579345</c:v>
                </c:pt>
                <c:pt idx="2362">
                  <c:v>-0.18147661793370173</c:v>
                </c:pt>
                <c:pt idx="2363">
                  <c:v>0.23155529035604061</c:v>
                </c:pt>
                <c:pt idx="2364">
                  <c:v>-0.29938273031836143</c:v>
                </c:pt>
                <c:pt idx="2365">
                  <c:v>0.52717044966841287</c:v>
                </c:pt>
                <c:pt idx="2366">
                  <c:v>-0.36123105558305013</c:v>
                </c:pt>
                <c:pt idx="2367">
                  <c:v>0.50842865253185743</c:v>
                </c:pt>
                <c:pt idx="2368">
                  <c:v>-0.6479194862701374</c:v>
                </c:pt>
                <c:pt idx="2369">
                  <c:v>-1.173341457382676E-2</c:v>
                </c:pt>
                <c:pt idx="2370">
                  <c:v>0.21884315120187356</c:v>
                </c:pt>
                <c:pt idx="2371">
                  <c:v>-0.21742368958776961</c:v>
                </c:pt>
                <c:pt idx="2372">
                  <c:v>0.12895322038600612</c:v>
                </c:pt>
                <c:pt idx="2373">
                  <c:v>0.44995748362800358</c:v>
                </c:pt>
                <c:pt idx="2374">
                  <c:v>0.13894549792384134</c:v>
                </c:pt>
                <c:pt idx="2375">
                  <c:v>-0.28630418515664108</c:v>
                </c:pt>
                <c:pt idx="2376">
                  <c:v>1.2926174444270048E-2</c:v>
                </c:pt>
                <c:pt idx="2377">
                  <c:v>0.13172117115592868</c:v>
                </c:pt>
                <c:pt idx="2378">
                  <c:v>0.32400408139442982</c:v>
                </c:pt>
                <c:pt idx="2379">
                  <c:v>-0.13305246941640167</c:v>
                </c:pt>
                <c:pt idx="2380">
                  <c:v>-0.36531380733013541</c:v>
                </c:pt>
                <c:pt idx="2381">
                  <c:v>0.24950602098914695</c:v>
                </c:pt>
                <c:pt idx="2382">
                  <c:v>0.10138114235502452</c:v>
                </c:pt>
                <c:pt idx="2383">
                  <c:v>0.23780842954562034</c:v>
                </c:pt>
                <c:pt idx="2384">
                  <c:v>-5.8593158890854979E-2</c:v>
                </c:pt>
                <c:pt idx="2385">
                  <c:v>0.4490066392182045</c:v>
                </c:pt>
                <c:pt idx="2386">
                  <c:v>0.11782800382748095</c:v>
                </c:pt>
                <c:pt idx="2387">
                  <c:v>0.58890048769913272</c:v>
                </c:pt>
                <c:pt idx="2388">
                  <c:v>-0.23514432874529573</c:v>
                </c:pt>
                <c:pt idx="2389">
                  <c:v>-0.18049530395806687</c:v>
                </c:pt>
                <c:pt idx="2390">
                  <c:v>0.62105550329973946</c:v>
                </c:pt>
                <c:pt idx="2391">
                  <c:v>-0.32283006118175506</c:v>
                </c:pt>
                <c:pt idx="2392">
                  <c:v>-0.52969742105417805</c:v>
                </c:pt>
                <c:pt idx="2393">
                  <c:v>-2.7086823481222041E-2</c:v>
                </c:pt>
                <c:pt idx="2394">
                  <c:v>0.4923146848925275</c:v>
                </c:pt>
                <c:pt idx="2395">
                  <c:v>-7.3545065455919836E-2</c:v>
                </c:pt>
                <c:pt idx="2396">
                  <c:v>-0.44006773646612846</c:v>
                </c:pt>
                <c:pt idx="2397">
                  <c:v>7.5737982394078154E-2</c:v>
                </c:pt>
                <c:pt idx="2398">
                  <c:v>6.0600829554117094E-2</c:v>
                </c:pt>
                <c:pt idx="2399">
                  <c:v>1.8064389360361564E-2</c:v>
                </c:pt>
                <c:pt idx="2400">
                  <c:v>-0.31186441154266475</c:v>
                </c:pt>
                <c:pt idx="2401">
                  <c:v>-6.7485222288779803E-2</c:v>
                </c:pt>
                <c:pt idx="2402">
                  <c:v>0.12181115114198661</c:v>
                </c:pt>
                <c:pt idx="2403">
                  <c:v>-3.3126603240018884E-2</c:v>
                </c:pt>
                <c:pt idx="2404">
                  <c:v>-0.12076475447229479</c:v>
                </c:pt>
                <c:pt idx="2405">
                  <c:v>0.18523225423016085</c:v>
                </c:pt>
                <c:pt idx="2406">
                  <c:v>9.4911647025466978E-2</c:v>
                </c:pt>
                <c:pt idx="2407">
                  <c:v>-1.9024187321259902E-2</c:v>
                </c:pt>
                <c:pt idx="2408">
                  <c:v>0.43124853243476091</c:v>
                </c:pt>
                <c:pt idx="2409">
                  <c:v>0.11423374442708778</c:v>
                </c:pt>
                <c:pt idx="2410">
                  <c:v>-0.25171052662958465</c:v>
                </c:pt>
                <c:pt idx="2411">
                  <c:v>-0.27229732716276189</c:v>
                </c:pt>
                <c:pt idx="2412">
                  <c:v>-0.16925790923908474</c:v>
                </c:pt>
                <c:pt idx="2413">
                  <c:v>1.0533894195446349</c:v>
                </c:pt>
                <c:pt idx="2414">
                  <c:v>-0.12595063624477434</c:v>
                </c:pt>
                <c:pt idx="2415">
                  <c:v>0.37928824997192856</c:v>
                </c:pt>
                <c:pt idx="2416">
                  <c:v>-6.4163126315974664E-2</c:v>
                </c:pt>
                <c:pt idx="2417">
                  <c:v>0.24561735275638444</c:v>
                </c:pt>
                <c:pt idx="2418">
                  <c:v>-0.43948067845563149</c:v>
                </c:pt>
                <c:pt idx="2419">
                  <c:v>9.1665987521812903E-2</c:v>
                </c:pt>
                <c:pt idx="2420">
                  <c:v>0.39659793157489975</c:v>
                </c:pt>
                <c:pt idx="2421">
                  <c:v>-0.36829035521439718</c:v>
                </c:pt>
                <c:pt idx="2422">
                  <c:v>-0.14018943519870503</c:v>
                </c:pt>
                <c:pt idx="2423">
                  <c:v>-0.47012909087183358</c:v>
                </c:pt>
                <c:pt idx="2424">
                  <c:v>-1.3334226303086319E-2</c:v>
                </c:pt>
                <c:pt idx="2425">
                  <c:v>-5.8593158890854979E-2</c:v>
                </c:pt>
                <c:pt idx="2426">
                  <c:v>-0.95343909424225881</c:v>
                </c:pt>
                <c:pt idx="2427">
                  <c:v>-0.1253210507925446</c:v>
                </c:pt>
                <c:pt idx="2428">
                  <c:v>0.45491284838015522</c:v>
                </c:pt>
                <c:pt idx="2429">
                  <c:v>-0.38778906453339101</c:v>
                </c:pt>
                <c:pt idx="2430">
                  <c:v>0.4037040102509617</c:v>
                </c:pt>
                <c:pt idx="2431">
                  <c:v>2.4035935455509409E-2</c:v>
                </c:pt>
                <c:pt idx="2432">
                  <c:v>0.34709867062226835</c:v>
                </c:pt>
                <c:pt idx="2433">
                  <c:v>9.9227865774861049E-2</c:v>
                </c:pt>
                <c:pt idx="2434">
                  <c:v>0.3056787432422875</c:v>
                </c:pt>
                <c:pt idx="2435">
                  <c:v>-2.1218623237265453E-2</c:v>
                </c:pt>
                <c:pt idx="2436">
                  <c:v>0.50192314706643759</c:v>
                </c:pt>
                <c:pt idx="2437">
                  <c:v>0.15574923267794485</c:v>
                </c:pt>
                <c:pt idx="2438">
                  <c:v>-0.16133054900680766</c:v>
                </c:pt>
                <c:pt idx="2439">
                  <c:v>3.2241931137493844E-2</c:v>
                </c:pt>
                <c:pt idx="2440">
                  <c:v>-0.95735566259150628</c:v>
                </c:pt>
                <c:pt idx="2441">
                  <c:v>-0.34044072708910089</c:v>
                </c:pt>
                <c:pt idx="2442">
                  <c:v>-0.14800116288755377</c:v>
                </c:pt>
                <c:pt idx="2443">
                  <c:v>-3.0324536856797681E-2</c:v>
                </c:pt>
                <c:pt idx="2444">
                  <c:v>-0.20822759572263408</c:v>
                </c:pt>
                <c:pt idx="2445">
                  <c:v>-0.186064929518683</c:v>
                </c:pt>
                <c:pt idx="2446">
                  <c:v>-0.13748909687166025</c:v>
                </c:pt>
                <c:pt idx="2447">
                  <c:v>1.5212085068503288E-2</c:v>
                </c:pt>
                <c:pt idx="2448">
                  <c:v>0.42782068397713346</c:v>
                </c:pt>
                <c:pt idx="2449">
                  <c:v>0.25930262134514132</c:v>
                </c:pt>
                <c:pt idx="2450">
                  <c:v>0.2450088004037965</c:v>
                </c:pt>
                <c:pt idx="2451">
                  <c:v>-6.3559929885785321E-2</c:v>
                </c:pt>
                <c:pt idx="2452">
                  <c:v>0.7238643236267277</c:v>
                </c:pt>
                <c:pt idx="2453">
                  <c:v>0.10272531001108826</c:v>
                </c:pt>
                <c:pt idx="2454">
                  <c:v>0.15471281378215795</c:v>
                </c:pt>
                <c:pt idx="2455">
                  <c:v>0.17261552181347775</c:v>
                </c:pt>
                <c:pt idx="2456">
                  <c:v>-0.16068533654485095</c:v>
                </c:pt>
                <c:pt idx="2457">
                  <c:v>0.30929262305752048</c:v>
                </c:pt>
                <c:pt idx="2458">
                  <c:v>1.457226545544628</c:v>
                </c:pt>
                <c:pt idx="2459">
                  <c:v>0.27750872814477806</c:v>
                </c:pt>
                <c:pt idx="2460">
                  <c:v>0.39835037034596477</c:v>
                </c:pt>
                <c:pt idx="2461">
                  <c:v>-0.22600367488882686</c:v>
                </c:pt>
                <c:pt idx="2462">
                  <c:v>0.22280456104526111</c:v>
                </c:pt>
                <c:pt idx="2463">
                  <c:v>-1.2082275957226341</c:v>
                </c:pt>
                <c:pt idx="2464">
                  <c:v>8.8141596869017569E-2</c:v>
                </c:pt>
                <c:pt idx="2465">
                  <c:v>-0.10624949827943407</c:v>
                </c:pt>
                <c:pt idx="2466">
                  <c:v>0.30952546602782721</c:v>
                </c:pt>
                <c:pt idx="2467">
                  <c:v>0.16542962042418519</c:v>
                </c:pt>
                <c:pt idx="2468">
                  <c:v>0.1159654315868071</c:v>
                </c:pt>
                <c:pt idx="2469">
                  <c:v>-0.10252721272912138</c:v>
                </c:pt>
                <c:pt idx="2470">
                  <c:v>0.23253796900851761</c:v>
                </c:pt>
                <c:pt idx="2471">
                  <c:v>-5.0651835711436693E-2</c:v>
                </c:pt>
                <c:pt idx="2472">
                  <c:v>0.66411870733879974</c:v>
                </c:pt>
                <c:pt idx="2473">
                  <c:v>3.3143885066770121E-3</c:v>
                </c:pt>
                <c:pt idx="2474">
                  <c:v>0.2763179926522169</c:v>
                </c:pt>
                <c:pt idx="2475">
                  <c:v>-0.11888359148809831</c:v>
                </c:pt>
                <c:pt idx="2476">
                  <c:v>-0.54350922841662053</c:v>
                </c:pt>
                <c:pt idx="2477">
                  <c:v>-3.9191774611020275E-2</c:v>
                </c:pt>
                <c:pt idx="2478">
                  <c:v>-0.80087735798639936</c:v>
                </c:pt>
                <c:pt idx="2479">
                  <c:v>0.11942258264788451</c:v>
                </c:pt>
                <c:pt idx="2480">
                  <c:v>0.23707417130215752</c:v>
                </c:pt>
                <c:pt idx="2481">
                  <c:v>0.12340133597191391</c:v>
                </c:pt>
                <c:pt idx="2482">
                  <c:v>0.19269917799205966</c:v>
                </c:pt>
                <c:pt idx="2483">
                  <c:v>-9.2801662274084026E-2</c:v>
                </c:pt>
                <c:pt idx="2484">
                  <c:v>7.1955014042037668E-3</c:v>
                </c:pt>
                <c:pt idx="2485">
                  <c:v>-0.16084661261017891</c:v>
                </c:pt>
                <c:pt idx="2486">
                  <c:v>-0.24673778073214328</c:v>
                </c:pt>
                <c:pt idx="2487">
                  <c:v>0.14509047680241982</c:v>
                </c:pt>
                <c:pt idx="2488">
                  <c:v>-0.60077420787906211</c:v>
                </c:pt>
                <c:pt idx="2489">
                  <c:v>-0.37276672350912526</c:v>
                </c:pt>
                <c:pt idx="2490">
                  <c:v>0.12048465689545584</c:v>
                </c:pt>
                <c:pt idx="2491">
                  <c:v>-0.63576376882600327</c:v>
                </c:pt>
                <c:pt idx="2492">
                  <c:v>-0.17234354172922556</c:v>
                </c:pt>
                <c:pt idx="2493">
                  <c:v>6.5710164065265711E-2</c:v>
                </c:pt>
                <c:pt idx="2494">
                  <c:v>-0.12989178233582188</c:v>
                </c:pt>
                <c:pt idx="2495">
                  <c:v>1.268075022534324</c:v>
                </c:pt>
                <c:pt idx="2496">
                  <c:v>-0.41042824602625433</c:v>
                </c:pt>
                <c:pt idx="2497">
                  <c:v>0.32088898033177649</c:v>
                </c:pt>
                <c:pt idx="2498">
                  <c:v>0.58918821149085698</c:v>
                </c:pt>
                <c:pt idx="2499">
                  <c:v>9.6801581849168691E-2</c:v>
                </c:pt>
                <c:pt idx="2500">
                  <c:v>0.30952546602782721</c:v>
                </c:pt>
                <c:pt idx="2501">
                  <c:v>0.59473962233268618</c:v>
                </c:pt>
                <c:pt idx="2502">
                  <c:v>-0.15184280290092764</c:v>
                </c:pt>
                <c:pt idx="2503">
                  <c:v>0.18599337006996583</c:v>
                </c:pt>
                <c:pt idx="2504">
                  <c:v>0.29854101851653081</c:v>
                </c:pt>
                <c:pt idx="2505">
                  <c:v>-0.10005101381032824</c:v>
                </c:pt>
                <c:pt idx="2506">
                  <c:v>-0.17071870200246875</c:v>
                </c:pt>
                <c:pt idx="2507">
                  <c:v>-0.30668032118842542</c:v>
                </c:pt>
                <c:pt idx="2508">
                  <c:v>0.18764107818068257</c:v>
                </c:pt>
                <c:pt idx="2509">
                  <c:v>-3.9340024628197315E-2</c:v>
                </c:pt>
                <c:pt idx="2510">
                  <c:v>-0.74057684771858501</c:v>
                </c:pt>
                <c:pt idx="2511">
                  <c:v>-2.3416402123002746E-2</c:v>
                </c:pt>
                <c:pt idx="2512">
                  <c:v>0.38084025031926966</c:v>
                </c:pt>
                <c:pt idx="2513">
                  <c:v>0.29266397339685779</c:v>
                </c:pt>
                <c:pt idx="2514">
                  <c:v>8.8413009726725E-2</c:v>
                </c:pt>
                <c:pt idx="2515">
                  <c:v>0.11076412189980746</c:v>
                </c:pt>
                <c:pt idx="2516">
                  <c:v>-7.6666182490649076E-3</c:v>
                </c:pt>
                <c:pt idx="2517">
                  <c:v>0.21013945740166848</c:v>
                </c:pt>
                <c:pt idx="2518">
                  <c:v>-0.24725140859286618</c:v>
                </c:pt>
                <c:pt idx="2519">
                  <c:v>-0.55131044823115927</c:v>
                </c:pt>
                <c:pt idx="2520">
                  <c:v>-0.50471417062903579</c:v>
                </c:pt>
                <c:pt idx="2521">
                  <c:v>0.71843834862086098</c:v>
                </c:pt>
                <c:pt idx="2522">
                  <c:v>-2.3101606872011158E-3</c:v>
                </c:pt>
                <c:pt idx="2523">
                  <c:v>-0.21039593366842291</c:v>
                </c:pt>
                <c:pt idx="2524">
                  <c:v>-2.2390355314580421E-2</c:v>
                </c:pt>
                <c:pt idx="2525">
                  <c:v>9.1395186011700019E-2</c:v>
                </c:pt>
                <c:pt idx="2526">
                  <c:v>-0.52035552542376429</c:v>
                </c:pt>
                <c:pt idx="2527">
                  <c:v>-0.49025349363434523</c:v>
                </c:pt>
                <c:pt idx="2528">
                  <c:v>0.32630723488627178</c:v>
                </c:pt>
                <c:pt idx="2529">
                  <c:v>-0.20174206735549979</c:v>
                </c:pt>
                <c:pt idx="2530">
                  <c:v>3.8436181656107918E-2</c:v>
                </c:pt>
                <c:pt idx="2531">
                  <c:v>0.13946949503879594</c:v>
                </c:pt>
                <c:pt idx="2532">
                  <c:v>0.49262232857444571</c:v>
                </c:pt>
                <c:pt idx="2533">
                  <c:v>-0.21440760129576947</c:v>
                </c:pt>
                <c:pt idx="2534">
                  <c:v>0.68104439930247851</c:v>
                </c:pt>
                <c:pt idx="2535">
                  <c:v>-6.5067789415843525E-3</c:v>
                </c:pt>
                <c:pt idx="2536">
                  <c:v>-0.29654487340943902</c:v>
                </c:pt>
                <c:pt idx="2537">
                  <c:v>0.47736648006723481</c:v>
                </c:pt>
                <c:pt idx="2538">
                  <c:v>-0.19396471676378066</c:v>
                </c:pt>
                <c:pt idx="2539">
                  <c:v>-0.86433380303095619</c:v>
                </c:pt>
                <c:pt idx="2540">
                  <c:v>0.39495308469636126</c:v>
                </c:pt>
                <c:pt idx="2541">
                  <c:v>0.2215677885384093</c:v>
                </c:pt>
                <c:pt idx="2542">
                  <c:v>-0.11231877065700785</c:v>
                </c:pt>
                <c:pt idx="2543">
                  <c:v>-0.11700487820137295</c:v>
                </c:pt>
                <c:pt idx="2544">
                  <c:v>0.11849262586940462</c:v>
                </c:pt>
                <c:pt idx="2545">
                  <c:v>-0.20756106993536216</c:v>
                </c:pt>
                <c:pt idx="2546">
                  <c:v>0.15029970810168211</c:v>
                </c:pt>
                <c:pt idx="2547">
                  <c:v>0.35614381022527536</c:v>
                </c:pt>
                <c:pt idx="2548">
                  <c:v>0.11116488907888973</c:v>
                </c:pt>
                <c:pt idx="2549">
                  <c:v>-2.7408179196618128</c:v>
                </c:pt>
                <c:pt idx="2550">
                  <c:v>0.10915993896111069</c:v>
                </c:pt>
                <c:pt idx="2551">
                  <c:v>0.26159098896412525</c:v>
                </c:pt>
                <c:pt idx="2552">
                  <c:v>0.33101723601809663</c:v>
                </c:pt>
                <c:pt idx="2553">
                  <c:v>0.10554399219892611</c:v>
                </c:pt>
                <c:pt idx="2554">
                  <c:v>-0.11872693857075141</c:v>
                </c:pt>
                <c:pt idx="2555">
                  <c:v>-7.3241468013534983E-2</c:v>
                </c:pt>
                <c:pt idx="2556">
                  <c:v>-0.332970798589448</c:v>
                </c:pt>
                <c:pt idx="2557">
                  <c:v>0.45838200415601316</c:v>
                </c:pt>
                <c:pt idx="2558">
                  <c:v>-7.6280321250611363E-2</c:v>
                </c:pt>
                <c:pt idx="2559">
                  <c:v>0.52967104834778322</c:v>
                </c:pt>
                <c:pt idx="2560">
                  <c:v>8.4608575317809492E-2</c:v>
                </c:pt>
                <c:pt idx="2561">
                  <c:v>-9.5419565078682433E-2</c:v>
                </c:pt>
                <c:pt idx="2562">
                  <c:v>-0.31563007098699331</c:v>
                </c:pt>
                <c:pt idx="2563">
                  <c:v>-0.13352717028415231</c:v>
                </c:pt>
                <c:pt idx="2564">
                  <c:v>0.20501708816016756</c:v>
                </c:pt>
                <c:pt idx="2565">
                  <c:v>1.0095332331987292E-3</c:v>
                </c:pt>
                <c:pt idx="2566">
                  <c:v>-0.59815112526392433</c:v>
                </c:pt>
                <c:pt idx="2567">
                  <c:v>0.23890911669840434</c:v>
                </c:pt>
                <c:pt idx="2568">
                  <c:v>-0.46833158868484981</c:v>
                </c:pt>
                <c:pt idx="2569">
                  <c:v>0.46027076075250023</c:v>
                </c:pt>
                <c:pt idx="2570">
                  <c:v>0.10205338272918787</c:v>
                </c:pt>
                <c:pt idx="2571">
                  <c:v>0.28510625106125354</c:v>
                </c:pt>
                <c:pt idx="2572">
                  <c:v>-0.13336891930599895</c:v>
                </c:pt>
                <c:pt idx="2573">
                  <c:v>7.3546060915154685E-2</c:v>
                </c:pt>
                <c:pt idx="2574">
                  <c:v>4.5582760019634981E-2</c:v>
                </c:pt>
                <c:pt idx="2575">
                  <c:v>-0.32771044748136852</c:v>
                </c:pt>
                <c:pt idx="2576">
                  <c:v>0.10259094958809113</c:v>
                </c:pt>
                <c:pt idx="2577">
                  <c:v>-0.66657626627480826</c:v>
                </c:pt>
                <c:pt idx="2578">
                  <c:v>0.42760617278189944</c:v>
                </c:pt>
                <c:pt idx="2579">
                  <c:v>-6.2504942605947425E-2</c:v>
                </c:pt>
                <c:pt idx="2580">
                  <c:v>0.44180215462886685</c:v>
                </c:pt>
                <c:pt idx="2581">
                  <c:v>-0.13622009620412232</c:v>
                </c:pt>
                <c:pt idx="2582">
                  <c:v>0.1078217559128536</c:v>
                </c:pt>
                <c:pt idx="2583">
                  <c:v>0.20651820166511539</c:v>
                </c:pt>
                <c:pt idx="2584">
                  <c:v>-3.1503691022062678E-2</c:v>
                </c:pt>
                <c:pt idx="2585">
                  <c:v>0.24622564851987147</c:v>
                </c:pt>
                <c:pt idx="2586">
                  <c:v>-0.33825040018929514</c:v>
                </c:pt>
                <c:pt idx="2587">
                  <c:v>1.661749599810705</c:v>
                </c:pt>
                <c:pt idx="2588">
                  <c:v>-0.4281775931667966</c:v>
                </c:pt>
                <c:pt idx="2589">
                  <c:v>0.57589316477200081</c:v>
                </c:pt>
                <c:pt idx="2590">
                  <c:v>8.5424656252677672E-2</c:v>
                </c:pt>
                <c:pt idx="2591">
                  <c:v>-5.1847728467419085E-2</c:v>
                </c:pt>
                <c:pt idx="2592">
                  <c:v>-7.6280321250611363E-2</c:v>
                </c:pt>
                <c:pt idx="2593">
                  <c:v>0.3083608751986131</c:v>
                </c:pt>
                <c:pt idx="2594">
                  <c:v>-0.14464809891803829</c:v>
                </c:pt>
                <c:pt idx="2595">
                  <c:v>-3.4666297197792711E-3</c:v>
                </c:pt>
                <c:pt idx="2596">
                  <c:v>-0.41234697890767852</c:v>
                </c:pt>
                <c:pt idx="2597">
                  <c:v>-0.43303875768551131</c:v>
                </c:pt>
                <c:pt idx="2598">
                  <c:v>0.25761413004954092</c:v>
                </c:pt>
                <c:pt idx="2599">
                  <c:v>-0.39858872325521189</c:v>
                </c:pt>
                <c:pt idx="2600">
                  <c:v>4.5722535734600563E-2</c:v>
                </c:pt>
                <c:pt idx="2601">
                  <c:v>5.7592692886849527E-3</c:v>
                </c:pt>
                <c:pt idx="2602">
                  <c:v>-5.7842107262206295E-2</c:v>
                </c:pt>
                <c:pt idx="2603">
                  <c:v>0.19244669373504691</c:v>
                </c:pt>
                <c:pt idx="2604">
                  <c:v>-2.0211882193567395E-3</c:v>
                </c:pt>
                <c:pt idx="2605">
                  <c:v>0.11423374442708778</c:v>
                </c:pt>
                <c:pt idx="2606">
                  <c:v>0.28510625106125354</c:v>
                </c:pt>
                <c:pt idx="2607">
                  <c:v>0.45817198959258965</c:v>
                </c:pt>
                <c:pt idx="2608">
                  <c:v>-0.16779859409718018</c:v>
                </c:pt>
                <c:pt idx="2609">
                  <c:v>5.9029568582364064E-3</c:v>
                </c:pt>
                <c:pt idx="2610">
                  <c:v>1.185612862342351</c:v>
                </c:pt>
                <c:pt idx="2611">
                  <c:v>0.33468267993572137</c:v>
                </c:pt>
                <c:pt idx="2612">
                  <c:v>-0.24827921322495461</c:v>
                </c:pt>
                <c:pt idx="2613">
                  <c:v>-8.359979176145306E-2</c:v>
                </c:pt>
                <c:pt idx="2614">
                  <c:v>-0.53428668040403615</c:v>
                </c:pt>
                <c:pt idx="2615">
                  <c:v>2.6587622348084181E-2</c:v>
                </c:pt>
                <c:pt idx="2616">
                  <c:v>-0.11341083508181846</c:v>
                </c:pt>
                <c:pt idx="2617">
                  <c:v>0.36154379796786501</c:v>
                </c:pt>
                <c:pt idx="2618">
                  <c:v>0.22601521640298791</c:v>
                </c:pt>
                <c:pt idx="2619">
                  <c:v>-1.0640123035631439</c:v>
                </c:pt>
                <c:pt idx="2620">
                  <c:v>-0.29938273031836143</c:v>
                </c:pt>
                <c:pt idx="2621">
                  <c:v>-5.6341175956530584E-2</c:v>
                </c:pt>
                <c:pt idx="2622">
                  <c:v>6.8464450966905732E-2</c:v>
                </c:pt>
                <c:pt idx="2623">
                  <c:v>-7.0209002281402644E-2</c:v>
                </c:pt>
                <c:pt idx="2624">
                  <c:v>-9.2801662274084026E-2</c:v>
                </c:pt>
                <c:pt idx="2625">
                  <c:v>0.12591554947472303</c:v>
                </c:pt>
                <c:pt idx="2626">
                  <c:v>-0.15088143344672428</c:v>
                </c:pt>
                <c:pt idx="2627">
                  <c:v>-8.0545498166160787E-2</c:v>
                </c:pt>
                <c:pt idx="2628">
                  <c:v>-0.22044609650511032</c:v>
                </c:pt>
                <c:pt idx="2629">
                  <c:v>0.36524459958906297</c:v>
                </c:pt>
                <c:pt idx="2630">
                  <c:v>-0.1226483735507376</c:v>
                </c:pt>
                <c:pt idx="2631">
                  <c:v>-1.1500807813140215</c:v>
                </c:pt>
                <c:pt idx="2632">
                  <c:v>0.1333004762297765</c:v>
                </c:pt>
                <c:pt idx="2633">
                  <c:v>-0.32698638471039138</c:v>
                </c:pt>
                <c:pt idx="2634">
                  <c:v>0.35321035562400088</c:v>
                </c:pt>
                <c:pt idx="2635">
                  <c:v>-0.51890776309364939</c:v>
                </c:pt>
                <c:pt idx="2636">
                  <c:v>-4.9009100121724408E-2</c:v>
                </c:pt>
                <c:pt idx="2637">
                  <c:v>4.97701518163845E-2</c:v>
                </c:pt>
                <c:pt idx="2638">
                  <c:v>0.21387604338294247</c:v>
                </c:pt>
                <c:pt idx="2639">
                  <c:v>-0.27125227457024231</c:v>
                </c:pt>
                <c:pt idx="2640">
                  <c:v>-2.6058163871946174E-2</c:v>
                </c:pt>
                <c:pt idx="2641">
                  <c:v>-7.7041035763828009E-2</c:v>
                </c:pt>
                <c:pt idx="2642">
                  <c:v>-0.42043363983978749</c:v>
                </c:pt>
                <c:pt idx="2643">
                  <c:v>1.8206856653311863E-2</c:v>
                </c:pt>
                <c:pt idx="2644">
                  <c:v>-0.16860914248688633</c:v>
                </c:pt>
                <c:pt idx="2645">
                  <c:v>-0.78537779935145191</c:v>
                </c:pt>
                <c:pt idx="2646">
                  <c:v>-0.19991807476154869</c:v>
                </c:pt>
                <c:pt idx="2647">
                  <c:v>0.52757083683281958</c:v>
                </c:pt>
                <c:pt idx="2648">
                  <c:v>0.15717309403346449</c:v>
                </c:pt>
                <c:pt idx="2649">
                  <c:v>0.19975085671583689</c:v>
                </c:pt>
                <c:pt idx="2650">
                  <c:v>0.40163046658474055</c:v>
                </c:pt>
                <c:pt idx="2651">
                  <c:v>0.23364268300880972</c:v>
                </c:pt>
                <c:pt idx="2652">
                  <c:v>-1.9833610578862109</c:v>
                </c:pt>
                <c:pt idx="2653">
                  <c:v>0.24938465863022038</c:v>
                </c:pt>
                <c:pt idx="2654">
                  <c:v>0.46477280633473833</c:v>
                </c:pt>
                <c:pt idx="2655">
                  <c:v>-0.2523977697250569</c:v>
                </c:pt>
                <c:pt idx="2656">
                  <c:v>-2.2097333064992043E-2</c:v>
                </c:pt>
                <c:pt idx="2657">
                  <c:v>-6.8997798481946579E-2</c:v>
                </c:pt>
                <c:pt idx="2658">
                  <c:v>0.37917732889080757</c:v>
                </c:pt>
                <c:pt idx="2659">
                  <c:v>3.2100843167024079E-2</c:v>
                </c:pt>
                <c:pt idx="2660">
                  <c:v>-0.34318332035068022</c:v>
                </c:pt>
                <c:pt idx="2661">
                  <c:v>-0.64182882503044569</c:v>
                </c:pt>
                <c:pt idx="2662">
                  <c:v>0.10326262660608464</c:v>
                </c:pt>
                <c:pt idx="2663">
                  <c:v>9.1801369217674345E-2</c:v>
                </c:pt>
                <c:pt idx="2664">
                  <c:v>0.20839239979067614</c:v>
                </c:pt>
                <c:pt idx="2665">
                  <c:v>4.739878887541106E-2</c:v>
                </c:pt>
                <c:pt idx="2666">
                  <c:v>0.107553970289646</c:v>
                </c:pt>
                <c:pt idx="2667">
                  <c:v>0.18459768415576081</c:v>
                </c:pt>
                <c:pt idx="2668">
                  <c:v>-5.7241547344744723E-2</c:v>
                </c:pt>
                <c:pt idx="2669">
                  <c:v>-0.1832774289986982</c:v>
                </c:pt>
                <c:pt idx="2670">
                  <c:v>-0.54182801040741035</c:v>
                </c:pt>
                <c:pt idx="2671">
                  <c:v>-0.65131433066561262</c:v>
                </c:pt>
                <c:pt idx="2672">
                  <c:v>0.56042149513030215</c:v>
                </c:pt>
                <c:pt idx="2673">
                  <c:v>-0.13178736352286938</c:v>
                </c:pt>
                <c:pt idx="2674">
                  <c:v>4.0339012844897151E-3</c:v>
                </c:pt>
                <c:pt idx="2675">
                  <c:v>5.3945424962785253E-2</c:v>
                </c:pt>
                <c:pt idx="2676">
                  <c:v>-7.3765709941899186E-3</c:v>
                </c:pt>
                <c:pt idx="2677">
                  <c:v>-0.28033464622818005</c:v>
                </c:pt>
                <c:pt idx="2678">
                  <c:v>-3.1503691022062678E-2</c:v>
                </c:pt>
                <c:pt idx="2679">
                  <c:v>-1.1151741331035789E-2</c:v>
                </c:pt>
                <c:pt idx="2680">
                  <c:v>0.1585955515008968</c:v>
                </c:pt>
                <c:pt idx="2681">
                  <c:v>-0.21424022557298891</c:v>
                </c:pt>
                <c:pt idx="2682">
                  <c:v>0.2763179926522169</c:v>
                </c:pt>
                <c:pt idx="2683">
                  <c:v>-1.0570302515754394E-2</c:v>
                </c:pt>
                <c:pt idx="2684">
                  <c:v>0.4585919881518557</c:v>
                </c:pt>
                <c:pt idx="2685">
                  <c:v>-3.6377914890592389E-2</c:v>
                </c:pt>
                <c:pt idx="2686">
                  <c:v>-0.22532888767311568</c:v>
                </c:pt>
                <c:pt idx="2687">
                  <c:v>0.90835178637160408</c:v>
                </c:pt>
                <c:pt idx="2688">
                  <c:v>-0.31329778974392242</c:v>
                </c:pt>
                <c:pt idx="2689">
                  <c:v>-0.26395802625003234</c:v>
                </c:pt>
                <c:pt idx="2690">
                  <c:v>-0.76562131066238559</c:v>
                </c:pt>
                <c:pt idx="2691">
                  <c:v>6.364099264269589E-2</c:v>
                </c:pt>
                <c:pt idx="2692">
                  <c:v>0.44646798609732558</c:v>
                </c:pt>
                <c:pt idx="2693">
                  <c:v>0.17517326566379737</c:v>
                </c:pt>
                <c:pt idx="2694">
                  <c:v>-7.7954422968056242E-2</c:v>
                </c:pt>
                <c:pt idx="2695">
                  <c:v>-0.43713483234383582</c:v>
                </c:pt>
                <c:pt idx="2696">
                  <c:v>-0.38627977181994066</c:v>
                </c:pt>
                <c:pt idx="2697">
                  <c:v>0.46602668781373041</c:v>
                </c:pt>
                <c:pt idx="2698">
                  <c:v>0.16156525639703187</c:v>
                </c:pt>
                <c:pt idx="2699">
                  <c:v>0.40686315797653982</c:v>
                </c:pt>
                <c:pt idx="2700">
                  <c:v>0.93100220151805346</c:v>
                </c:pt>
                <c:pt idx="2701">
                  <c:v>9.666666858017911E-2</c:v>
                </c:pt>
                <c:pt idx="2702">
                  <c:v>-0.18229488977282882</c:v>
                </c:pt>
                <c:pt idx="2703">
                  <c:v>0.20526738223450958</c:v>
                </c:pt>
                <c:pt idx="2704">
                  <c:v>-0.23769371099711789</c:v>
                </c:pt>
                <c:pt idx="2705">
                  <c:v>-0.33387969740416884</c:v>
                </c:pt>
                <c:pt idx="2706">
                  <c:v>0.19067806561753306</c:v>
                </c:pt>
                <c:pt idx="2707">
                  <c:v>0.21238257012235723</c:v>
                </c:pt>
                <c:pt idx="2708">
                  <c:v>-8.3294071260014715E-2</c:v>
                </c:pt>
                <c:pt idx="2709">
                  <c:v>9.9227865774861049E-2</c:v>
                </c:pt>
                <c:pt idx="2710">
                  <c:v>0.31185183118705778</c:v>
                </c:pt>
                <c:pt idx="2711">
                  <c:v>-4.1268662432163747E-2</c:v>
                </c:pt>
                <c:pt idx="2712">
                  <c:v>1.6895675439504672</c:v>
                </c:pt>
                <c:pt idx="2713">
                  <c:v>9.1530593120616247E-2</c:v>
                </c:pt>
                <c:pt idx="2714">
                  <c:v>-0.28103566424046145</c:v>
                </c:pt>
                <c:pt idx="2715">
                  <c:v>0.57191946324555731</c:v>
                </c:pt>
                <c:pt idx="2716">
                  <c:v>-9.5882041454141254E-2</c:v>
                </c:pt>
                <c:pt idx="2717">
                  <c:v>4.2644337408493722E-2</c:v>
                </c:pt>
                <c:pt idx="2718">
                  <c:v>-0.56746812126188384</c:v>
                </c:pt>
                <c:pt idx="2719">
                  <c:v>-0.51148499104218792</c:v>
                </c:pt>
                <c:pt idx="2720">
                  <c:v>-6.0698185900316448E-2</c:v>
                </c:pt>
                <c:pt idx="2721">
                  <c:v>-0.51477928684409402</c:v>
                </c:pt>
                <c:pt idx="2722">
                  <c:v>-0.16359106772026177</c:v>
                </c:pt>
                <c:pt idx="2723">
                  <c:v>-7.5520007640977729E-2</c:v>
                </c:pt>
                <c:pt idx="2724">
                  <c:v>-0.16165326347876927</c:v>
                </c:pt>
                <c:pt idx="2725">
                  <c:v>2.570681504625564</c:v>
                </c:pt>
                <c:pt idx="2726">
                  <c:v>1.2377472556299118</c:v>
                </c:pt>
                <c:pt idx="2727">
                  <c:v>0.3477790267022618</c:v>
                </c:pt>
                <c:pt idx="2728">
                  <c:v>-0.30882320318787576</c:v>
                </c:pt>
                <c:pt idx="2729">
                  <c:v>0.39341620047154469</c:v>
                </c:pt>
                <c:pt idx="2730">
                  <c:v>0.24695526504295234</c:v>
                </c:pt>
                <c:pt idx="2731">
                  <c:v>4.4654367703005314E-3</c:v>
                </c:pt>
                <c:pt idx="2732">
                  <c:v>0.33262201375963707</c:v>
                </c:pt>
                <c:pt idx="2733">
                  <c:v>8.4064264788474549E-2</c:v>
                </c:pt>
                <c:pt idx="2734">
                  <c:v>-0.3159892183726889</c:v>
                </c:pt>
                <c:pt idx="2735">
                  <c:v>-6.220365931344831E-2</c:v>
                </c:pt>
                <c:pt idx="2736">
                  <c:v>0.10272531001108826</c:v>
                </c:pt>
                <c:pt idx="2737">
                  <c:v>-0.5153978056277968</c:v>
                </c:pt>
                <c:pt idx="2738">
                  <c:v>0.18091166336856906</c:v>
                </c:pt>
                <c:pt idx="2739">
                  <c:v>7.2174416924316628E-2</c:v>
                </c:pt>
                <c:pt idx="2740">
                  <c:v>-0.11763084416884118</c:v>
                </c:pt>
                <c:pt idx="2741">
                  <c:v>-0.1694201465224594</c:v>
                </c:pt>
                <c:pt idx="2742">
                  <c:v>3.9278795351367586E-2</c:v>
                </c:pt>
                <c:pt idx="2743">
                  <c:v>-6.8241312155091938E-2</c:v>
                </c:pt>
                <c:pt idx="2744">
                  <c:v>-0.2164176260596288</c:v>
                </c:pt>
                <c:pt idx="2745">
                  <c:v>0.14300150624248983</c:v>
                </c:pt>
                <c:pt idx="2746">
                  <c:v>-0.1470423491343473</c:v>
                </c:pt>
                <c:pt idx="2747">
                  <c:v>-0.34281733987157681</c:v>
                </c:pt>
                <c:pt idx="2748">
                  <c:v>3.8014690186715924E-2</c:v>
                </c:pt>
                <c:pt idx="2749">
                  <c:v>0.28534303015925572</c:v>
                </c:pt>
                <c:pt idx="2750">
                  <c:v>7.7242998932460352E-2</c:v>
                </c:pt>
                <c:pt idx="2751">
                  <c:v>0.16620125266270289</c:v>
                </c:pt>
                <c:pt idx="2752">
                  <c:v>-7.430433869111211E-2</c:v>
                </c:pt>
                <c:pt idx="2753">
                  <c:v>-0.5689654696483859</c:v>
                </c:pt>
                <c:pt idx="2754">
                  <c:v>0.27297869537357461</c:v>
                </c:pt>
                <c:pt idx="2755">
                  <c:v>0.56754544764374681</c:v>
                </c:pt>
                <c:pt idx="2756">
                  <c:v>-8.3141235300245864E-2</c:v>
                </c:pt>
                <c:pt idx="2757">
                  <c:v>0.81966818349645554</c:v>
                </c:pt>
                <c:pt idx="2758">
                  <c:v>0.11370049916472832</c:v>
                </c:pt>
                <c:pt idx="2759">
                  <c:v>0.14808808264533596</c:v>
                </c:pt>
                <c:pt idx="2760">
                  <c:v>0.19585150857564437</c:v>
                </c:pt>
                <c:pt idx="2761">
                  <c:v>0.36625226369956387</c:v>
                </c:pt>
                <c:pt idx="2762">
                  <c:v>-1.1228054528737617</c:v>
                </c:pt>
                <c:pt idx="2763">
                  <c:v>-5.3493701310978706E-2</c:v>
                </c:pt>
                <c:pt idx="2764">
                  <c:v>0.15458320905306852</c:v>
                </c:pt>
                <c:pt idx="2765">
                  <c:v>0.24476530756931322</c:v>
                </c:pt>
                <c:pt idx="2766">
                  <c:v>0.27500704749986982</c:v>
                </c:pt>
                <c:pt idx="2767">
                  <c:v>-0.2764851241261953</c:v>
                </c:pt>
                <c:pt idx="2768">
                  <c:v>-0.38627977181994066</c:v>
                </c:pt>
                <c:pt idx="2769">
                  <c:v>-0.22078231068535228</c:v>
                </c:pt>
                <c:pt idx="2770">
                  <c:v>0.22070141650652012</c:v>
                </c:pt>
                <c:pt idx="2771">
                  <c:v>0.12763327972587371</c:v>
                </c:pt>
                <c:pt idx="2772">
                  <c:v>0.64938552918151582</c:v>
                </c:pt>
                <c:pt idx="2773">
                  <c:v>2.0911065581689963E-2</c:v>
                </c:pt>
                <c:pt idx="2774">
                  <c:v>0.22478119439558927</c:v>
                </c:pt>
                <c:pt idx="2775">
                  <c:v>0.10030490579568548</c:v>
                </c:pt>
                <c:pt idx="2776">
                  <c:v>-0.30151479234317652</c:v>
                </c:pt>
                <c:pt idx="2777">
                  <c:v>-0.2409294091930991</c:v>
                </c:pt>
                <c:pt idx="2778">
                  <c:v>-1.7563082232945674E-2</c:v>
                </c:pt>
                <c:pt idx="2779">
                  <c:v>0.1300083041086062</c:v>
                </c:pt>
                <c:pt idx="2780">
                  <c:v>-0.15987922653846787</c:v>
                </c:pt>
                <c:pt idx="2781">
                  <c:v>6.4469017368442544E-2</c:v>
                </c:pt>
                <c:pt idx="2782">
                  <c:v>1.106620140620535E-2</c:v>
                </c:pt>
                <c:pt idx="2783">
                  <c:v>0.25640685379424505</c:v>
                </c:pt>
                <c:pt idx="2784">
                  <c:v>9.7341108796701811E-2</c:v>
                </c:pt>
                <c:pt idx="2785">
                  <c:v>4.9491370165103722E-2</c:v>
                </c:pt>
                <c:pt idx="2786">
                  <c:v>-1.0917250815209409</c:v>
                </c:pt>
                <c:pt idx="2787">
                  <c:v>0.15341624225524791</c:v>
                </c:pt>
                <c:pt idx="2788">
                  <c:v>-0.70768941179557421</c:v>
                </c:pt>
                <c:pt idx="2789">
                  <c:v>8.9498150839102647E-2</c:v>
                </c:pt>
                <c:pt idx="2790">
                  <c:v>-0.28507314158999497</c:v>
                </c:pt>
                <c:pt idx="2791">
                  <c:v>-0.64543500104558982</c:v>
                </c:pt>
                <c:pt idx="2792">
                  <c:v>0.22144405295439859</c:v>
                </c:pt>
                <c:pt idx="2793">
                  <c:v>0.10097764772482092</c:v>
                </c:pt>
                <c:pt idx="2794">
                  <c:v>0.17708860210596758</c:v>
                </c:pt>
                <c:pt idx="2795">
                  <c:v>0.15380533607903549</c:v>
                </c:pt>
                <c:pt idx="2796">
                  <c:v>0.95828590092325761</c:v>
                </c:pt>
                <c:pt idx="2797">
                  <c:v>-0.64678964437599917</c:v>
                </c:pt>
                <c:pt idx="2798">
                  <c:v>-0.67668758224209702</c:v>
                </c:pt>
                <c:pt idx="2799">
                  <c:v>0.23756371831767567</c:v>
                </c:pt>
                <c:pt idx="2800">
                  <c:v>0.10648233046998125</c:v>
                </c:pt>
                <c:pt idx="2801">
                  <c:v>-2.2331080615887773</c:v>
                </c:pt>
                <c:pt idx="2802">
                  <c:v>6.5572311593622076E-2</c:v>
                </c:pt>
                <c:pt idx="2803">
                  <c:v>0.15198866642250583</c:v>
                </c:pt>
                <c:pt idx="2804">
                  <c:v>-0.33879767023729013</c:v>
                </c:pt>
                <c:pt idx="2805">
                  <c:v>-7.2331058828365796E-2</c:v>
                </c:pt>
                <c:pt idx="2806">
                  <c:v>7.382023329167138E-2</c:v>
                </c:pt>
                <c:pt idx="2807">
                  <c:v>-0.40487830800382846</c:v>
                </c:pt>
                <c:pt idx="2808">
                  <c:v>-0.15344651031471868</c:v>
                </c:pt>
                <c:pt idx="2809">
                  <c:v>-0.11794392903137389</c:v>
                </c:pt>
                <c:pt idx="2810">
                  <c:v>-0.6245990710936431</c:v>
                </c:pt>
                <c:pt idx="2811">
                  <c:v>-0.25997912979661736</c:v>
                </c:pt>
                <c:pt idx="2812">
                  <c:v>0.19446533163799662</c:v>
                </c:pt>
                <c:pt idx="2813">
                  <c:v>0.2118844019403045</c:v>
                </c:pt>
                <c:pt idx="2814">
                  <c:v>5.2972274813988696E-2</c:v>
                </c:pt>
                <c:pt idx="2815">
                  <c:v>6.9564695093359566E-2</c:v>
                </c:pt>
                <c:pt idx="2816">
                  <c:v>-6.8695156349330821E-2</c:v>
                </c:pt>
                <c:pt idx="2817">
                  <c:v>0.68410057685597658</c:v>
                </c:pt>
                <c:pt idx="2818">
                  <c:v>0.24926328606119336</c:v>
                </c:pt>
                <c:pt idx="2819">
                  <c:v>0.26315462541145501</c:v>
                </c:pt>
                <c:pt idx="2820">
                  <c:v>-0.10702618472666624</c:v>
                </c:pt>
                <c:pt idx="2821">
                  <c:v>-4.7964695992527992E-2</c:v>
                </c:pt>
                <c:pt idx="2822">
                  <c:v>0.34209956483278436</c:v>
                </c:pt>
                <c:pt idx="2823">
                  <c:v>-0.14193941010035235</c:v>
                </c:pt>
                <c:pt idx="2824">
                  <c:v>-0.20323614209555665</c:v>
                </c:pt>
                <c:pt idx="2825">
                  <c:v>0.11822681379294767</c:v>
                </c:pt>
                <c:pt idx="2826">
                  <c:v>-0.10671545996972767</c:v>
                </c:pt>
                <c:pt idx="2827">
                  <c:v>-0.26378480237507018</c:v>
                </c:pt>
                <c:pt idx="2828">
                  <c:v>0.38150488256730614</c:v>
                </c:pt>
                <c:pt idx="2829">
                  <c:v>-5.3343989793084919E-2</c:v>
                </c:pt>
                <c:pt idx="2830">
                  <c:v>0.27333684715022188</c:v>
                </c:pt>
                <c:pt idx="2831">
                  <c:v>-1.0822245593988842</c:v>
                </c:pt>
                <c:pt idx="2832">
                  <c:v>-0.79085860216140835</c:v>
                </c:pt>
                <c:pt idx="2833">
                  <c:v>0.19736218414916346</c:v>
                </c:pt>
                <c:pt idx="2834">
                  <c:v>-0.87065103278915879</c:v>
                </c:pt>
                <c:pt idx="2835">
                  <c:v>-0.1215492969033361</c:v>
                </c:pt>
                <c:pt idx="2836">
                  <c:v>-0.29035645452906805</c:v>
                </c:pt>
                <c:pt idx="2837">
                  <c:v>-5.0203631376793963E-2</c:v>
                </c:pt>
                <c:pt idx="2838">
                  <c:v>-0.42526873733715537</c:v>
                </c:pt>
                <c:pt idx="2839">
                  <c:v>-0.21910202277017288</c:v>
                </c:pt>
                <c:pt idx="2840">
                  <c:v>0.20526738223450958</c:v>
                </c:pt>
                <c:pt idx="2841">
                  <c:v>-8.2468877554856181E-3</c:v>
                </c:pt>
                <c:pt idx="2842">
                  <c:v>0.2938412992667393</c:v>
                </c:pt>
                <c:pt idx="2843">
                  <c:v>-1.5911794654711495</c:v>
                </c:pt>
                <c:pt idx="2844">
                  <c:v>5.3389419544634928E-2</c:v>
                </c:pt>
                <c:pt idx="2845">
                  <c:v>0.18358179111782255</c:v>
                </c:pt>
                <c:pt idx="2846">
                  <c:v>-0.22887504687163332</c:v>
                </c:pt>
                <c:pt idx="2847">
                  <c:v>-0.47353049535916902</c:v>
                </c:pt>
                <c:pt idx="2848">
                  <c:v>-0.55872900956140092</c:v>
                </c:pt>
                <c:pt idx="2849">
                  <c:v>-0.51601658969942688</c:v>
                </c:pt>
                <c:pt idx="2850">
                  <c:v>-8.0545498166160787E-2</c:v>
                </c:pt>
                <c:pt idx="2851">
                  <c:v>-1.2954821145835616</c:v>
                </c:pt>
                <c:pt idx="2852">
                  <c:v>-0.50001383557812584</c:v>
                </c:pt>
                <c:pt idx="2853">
                  <c:v>0.99342075841288502</c:v>
                </c:pt>
                <c:pt idx="2854">
                  <c:v>0.20376496601865624</c:v>
                </c:pt>
                <c:pt idx="2855">
                  <c:v>2.3184369248263378E-2</c:v>
                </c:pt>
                <c:pt idx="2856">
                  <c:v>-0.20656185827758058</c:v>
                </c:pt>
                <c:pt idx="2857">
                  <c:v>0.48336436071334932</c:v>
                </c:pt>
                <c:pt idx="2858">
                  <c:v>-1.0212186232372655</c:v>
                </c:pt>
                <c:pt idx="2859">
                  <c:v>0.11436702495200024</c:v>
                </c:pt>
                <c:pt idx="2860">
                  <c:v>-9.9278072435885073E-2</c:v>
                </c:pt>
                <c:pt idx="2861">
                  <c:v>0.55630678422497692</c:v>
                </c:pt>
                <c:pt idx="2862">
                  <c:v>0.28628975813409691</c:v>
                </c:pt>
                <c:pt idx="2863">
                  <c:v>-6.796651363875519E-3</c:v>
                </c:pt>
                <c:pt idx="2864">
                  <c:v>0.14365463452603769</c:v>
                </c:pt>
                <c:pt idx="2865">
                  <c:v>0.35985847200125276</c:v>
                </c:pt>
                <c:pt idx="2866">
                  <c:v>-0.33169930146135063</c:v>
                </c:pt>
                <c:pt idx="2867">
                  <c:v>-0.2172559636047999</c:v>
                </c:pt>
                <c:pt idx="2868">
                  <c:v>0.15003969277415322</c:v>
                </c:pt>
                <c:pt idx="2869">
                  <c:v>2.2474346574899225E-2</c:v>
                </c:pt>
                <c:pt idx="2870">
                  <c:v>-0.22566624182895889</c:v>
                </c:pt>
                <c:pt idx="2871">
                  <c:v>-0.22786096877864659</c:v>
                </c:pt>
                <c:pt idx="2872">
                  <c:v>-3.1208812116408833E-2</c:v>
                </c:pt>
                <c:pt idx="2873">
                  <c:v>0.32711247074708549</c:v>
                </c:pt>
                <c:pt idx="2874">
                  <c:v>1.5069321717648203E-2</c:v>
                </c:pt>
                <c:pt idx="2875">
                  <c:v>0.34800574078159829</c:v>
                </c:pt>
                <c:pt idx="2876">
                  <c:v>3.2383005311652981E-2</c:v>
                </c:pt>
                <c:pt idx="2877">
                  <c:v>0.60283691180353871</c:v>
                </c:pt>
                <c:pt idx="2878">
                  <c:v>-0.19942102220163152</c:v>
                </c:pt>
                <c:pt idx="2879">
                  <c:v>0.12141333091586493</c:v>
                </c:pt>
                <c:pt idx="2880">
                  <c:v>0.16966849952308591</c:v>
                </c:pt>
                <c:pt idx="2881">
                  <c:v>-2.291238890816222</c:v>
                </c:pt>
                <c:pt idx="2882">
                  <c:v>-0.40258801244534997</c:v>
                </c:pt>
                <c:pt idx="2883">
                  <c:v>0.37862259552722705</c:v>
                </c:pt>
                <c:pt idx="2884">
                  <c:v>-2.2830000309873453E-2</c:v>
                </c:pt>
                <c:pt idx="2885">
                  <c:v>-0.23820412849435385</c:v>
                </c:pt>
                <c:pt idx="2886">
                  <c:v>0.15432396466047718</c:v>
                </c:pt>
                <c:pt idx="2887">
                  <c:v>-0.27910868375243703</c:v>
                </c:pt>
                <c:pt idx="2888">
                  <c:v>0.11982095212187473</c:v>
                </c:pt>
                <c:pt idx="2889">
                  <c:v>0.23670690199535252</c:v>
                </c:pt>
                <c:pt idx="2890">
                  <c:v>9.1665987521812903E-2</c:v>
                </c:pt>
                <c:pt idx="2891">
                  <c:v>-0.25790753191875182</c:v>
                </c:pt>
                <c:pt idx="2892">
                  <c:v>0.49292990666768804</c:v>
                </c:pt>
                <c:pt idx="2893">
                  <c:v>0.46863544596713697</c:v>
                </c:pt>
                <c:pt idx="2894">
                  <c:v>0.56754544764374681</c:v>
                </c:pt>
                <c:pt idx="2895">
                  <c:v>0.13027195451885909</c:v>
                </c:pt>
                <c:pt idx="2896">
                  <c:v>-5.1997284787553923E-2</c:v>
                </c:pt>
                <c:pt idx="2897">
                  <c:v>-0.12500636106703261</c:v>
                </c:pt>
                <c:pt idx="2898">
                  <c:v>0.292781749227846</c:v>
                </c:pt>
                <c:pt idx="2899">
                  <c:v>0.22589186169034053</c:v>
                </c:pt>
                <c:pt idx="2900">
                  <c:v>0.14990966753492424</c:v>
                </c:pt>
                <c:pt idx="2901">
                  <c:v>-3.0471878432873134E-2</c:v>
                </c:pt>
                <c:pt idx="2902">
                  <c:v>-0.17722906973322358</c:v>
                </c:pt>
                <c:pt idx="2903">
                  <c:v>6.3339337220504853E-3</c:v>
                </c:pt>
                <c:pt idx="2904">
                  <c:v>-0.21089678249861854</c:v>
                </c:pt>
                <c:pt idx="2905">
                  <c:v>-0.26742687870480181</c:v>
                </c:pt>
                <c:pt idx="2906">
                  <c:v>-0.11982386636880067</c:v>
                </c:pt>
                <c:pt idx="2907">
                  <c:v>0.50690655458069334</c:v>
                </c:pt>
                <c:pt idx="2908">
                  <c:v>-2.2683437091289494E-2</c:v>
                </c:pt>
                <c:pt idx="2909">
                  <c:v>0.69126614713828471</c:v>
                </c:pt>
                <c:pt idx="2910">
                  <c:v>-0.47373082793477228</c:v>
                </c:pt>
                <c:pt idx="2911">
                  <c:v>-0.55639334852438527</c:v>
                </c:pt>
                <c:pt idx="2912">
                  <c:v>-0.12673800462151313</c:v>
                </c:pt>
                <c:pt idx="2913">
                  <c:v>0.46058531325366775</c:v>
                </c:pt>
                <c:pt idx="2914">
                  <c:v>-0.14321345371191918</c:v>
                </c:pt>
                <c:pt idx="2915">
                  <c:v>-0.19330474646824172</c:v>
                </c:pt>
                <c:pt idx="2916">
                  <c:v>8.4472516936901498E-2</c:v>
                </c:pt>
                <c:pt idx="2917">
                  <c:v>-0.14976064483409052</c:v>
                </c:pt>
                <c:pt idx="2918">
                  <c:v>-0.41599961671422736</c:v>
                </c:pt>
                <c:pt idx="2919">
                  <c:v>-0.43948067845563149</c:v>
                </c:pt>
                <c:pt idx="2920">
                  <c:v>-0.14672288610361572</c:v>
                </c:pt>
                <c:pt idx="2921">
                  <c:v>0.16272565284620308</c:v>
                </c:pt>
                <c:pt idx="2922">
                  <c:v>0.62077406589450557</c:v>
                </c:pt>
                <c:pt idx="2923">
                  <c:v>-0.59357217547301866</c:v>
                </c:pt>
                <c:pt idx="2924">
                  <c:v>-0.59313684202346018</c:v>
                </c:pt>
                <c:pt idx="2925">
                  <c:v>-9.8438333726085826E-3</c:v>
                </c:pt>
                <c:pt idx="2926">
                  <c:v>-0.12815635149068219</c:v>
                </c:pt>
                <c:pt idx="2927">
                  <c:v>-1.0232697793228471</c:v>
                </c:pt>
                <c:pt idx="2928">
                  <c:v>0.33067312270915716</c:v>
                </c:pt>
                <c:pt idx="2929">
                  <c:v>-0.2931821526602385</c:v>
                </c:pt>
                <c:pt idx="2930">
                  <c:v>0.53953107147415025</c:v>
                </c:pt>
                <c:pt idx="2931">
                  <c:v>-0.5121020987899112</c:v>
                </c:pt>
                <c:pt idx="2932">
                  <c:v>-0.332970798589448</c:v>
                </c:pt>
                <c:pt idx="2933">
                  <c:v>1.9203733973092663E-2</c:v>
                </c:pt>
                <c:pt idx="2934">
                  <c:v>-0.41273103189567489</c:v>
                </c:pt>
                <c:pt idx="2935">
                  <c:v>5.6722242374540217E-2</c:v>
                </c:pt>
                <c:pt idx="2936">
                  <c:v>0.25507768200545078</c:v>
                </c:pt>
                <c:pt idx="2937">
                  <c:v>6.983962506863442E-2</c:v>
                </c:pt>
                <c:pt idx="2938">
                  <c:v>-0.48479218096417925</c:v>
                </c:pt>
                <c:pt idx="2939">
                  <c:v>-0.13526907768524885</c:v>
                </c:pt>
                <c:pt idx="2940">
                  <c:v>-2.0211882193567395E-3</c:v>
                </c:pt>
                <c:pt idx="2941">
                  <c:v>0.22181522787370223</c:v>
                </c:pt>
                <c:pt idx="2942">
                  <c:v>0.38084025031926966</c:v>
                </c:pt>
                <c:pt idx="2943">
                  <c:v>0.30439421966803015</c:v>
                </c:pt>
                <c:pt idx="2944">
                  <c:v>-0.41715500522303456</c:v>
                </c:pt>
                <c:pt idx="2945">
                  <c:v>-0.12736820886474998</c:v>
                </c:pt>
                <c:pt idx="2946">
                  <c:v>-0.34428181916585088</c:v>
                </c:pt>
                <c:pt idx="2947">
                  <c:v>-0.2404180267664453</c:v>
                </c:pt>
                <c:pt idx="2948">
                  <c:v>0.77888139676280133</c:v>
                </c:pt>
                <c:pt idx="2949">
                  <c:v>1.106620140620535E-2</c:v>
                </c:pt>
                <c:pt idx="2950">
                  <c:v>0.17912882877215228</c:v>
                </c:pt>
                <c:pt idx="2951">
                  <c:v>0.52004502403981767</c:v>
                </c:pt>
                <c:pt idx="2952">
                  <c:v>0.57279267725842908</c:v>
                </c:pt>
                <c:pt idx="2953">
                  <c:v>0.16272565284620308</c:v>
                </c:pt>
                <c:pt idx="2954">
                  <c:v>0.14561224716647592</c:v>
                </c:pt>
                <c:pt idx="2955">
                  <c:v>-0.34923544088309766</c:v>
                </c:pt>
                <c:pt idx="2956">
                  <c:v>1.2068023309090343E-2</c:v>
                </c:pt>
                <c:pt idx="2957">
                  <c:v>-9.4649100419041649E-2</c:v>
                </c:pt>
                <c:pt idx="2958">
                  <c:v>-0.27299444968943987</c:v>
                </c:pt>
                <c:pt idx="2959">
                  <c:v>-0.81273899515830306</c:v>
                </c:pt>
                <c:pt idx="2960">
                  <c:v>0.95873133756783624</c:v>
                </c:pt>
                <c:pt idx="2961">
                  <c:v>-0.12752580294878771</c:v>
                </c:pt>
                <c:pt idx="2962">
                  <c:v>-2.6939827195915918E-2</c:v>
                </c:pt>
                <c:pt idx="2963">
                  <c:v>-0.49879017558883065</c:v>
                </c:pt>
                <c:pt idx="2964">
                  <c:v>3.8155201025968831E-2</c:v>
                </c:pt>
                <c:pt idx="2965">
                  <c:v>-0.15200309344504997</c:v>
                </c:pt>
                <c:pt idx="2966">
                  <c:v>-2.0779468942091602E-2</c:v>
                </c:pt>
                <c:pt idx="2967">
                  <c:v>-0.11481613367964889</c:v>
                </c:pt>
                <c:pt idx="2968">
                  <c:v>-0.19925537606322247</c:v>
                </c:pt>
                <c:pt idx="2969">
                  <c:v>0.28782686728508117</c:v>
                </c:pt>
                <c:pt idx="2970">
                  <c:v>-0.2155797753822157</c:v>
                </c:pt>
                <c:pt idx="2971">
                  <c:v>-0.50532838835245042</c:v>
                </c:pt>
                <c:pt idx="2972">
                  <c:v>0.17018145776525037</c:v>
                </c:pt>
                <c:pt idx="2973">
                  <c:v>5.2415894151138537E-2</c:v>
                </c:pt>
                <c:pt idx="2974">
                  <c:v>0.13619138628714406</c:v>
                </c:pt>
                <c:pt idx="2975">
                  <c:v>-0.2055633381955779</c:v>
                </c:pt>
                <c:pt idx="2976">
                  <c:v>0.26699637198621584</c:v>
                </c:pt>
                <c:pt idx="2977">
                  <c:v>-0.45146473286154909</c:v>
                </c:pt>
                <c:pt idx="2978">
                  <c:v>-2.8999139390230196E-2</c:v>
                </c:pt>
                <c:pt idx="2979">
                  <c:v>0.29372360990493412</c:v>
                </c:pt>
                <c:pt idx="2980">
                  <c:v>-5.5141554192460952E-2</c:v>
                </c:pt>
                <c:pt idx="2981">
                  <c:v>-1.1847524936393254</c:v>
                </c:pt>
                <c:pt idx="2982">
                  <c:v>0.28735408502920678</c:v>
                </c:pt>
                <c:pt idx="2983">
                  <c:v>-0.35310005137805189</c:v>
                </c:pt>
                <c:pt idx="2984">
                  <c:v>0.3947336300198066</c:v>
                </c:pt>
                <c:pt idx="2985">
                  <c:v>-0.28683209699063023</c:v>
                </c:pt>
                <c:pt idx="2986">
                  <c:v>-5.5141554192460952E-2</c:v>
                </c:pt>
                <c:pt idx="2987">
                  <c:v>3.8576651452323155E-2</c:v>
                </c:pt>
                <c:pt idx="2988">
                  <c:v>0.27058874197206723</c:v>
                </c:pt>
                <c:pt idx="2989">
                  <c:v>-0.32102669214583013</c:v>
                </c:pt>
                <c:pt idx="2990">
                  <c:v>-0.20141026076689628</c:v>
                </c:pt>
                <c:pt idx="2991">
                  <c:v>-0.20506433719646369</c:v>
                </c:pt>
                <c:pt idx="2992">
                  <c:v>-2.2243836750407486E-2</c:v>
                </c:pt>
                <c:pt idx="2993">
                  <c:v>7.4779426496613344E-2</c:v>
                </c:pt>
                <c:pt idx="2994">
                  <c:v>-4.7219155672650559E-2</c:v>
                </c:pt>
                <c:pt idx="2995">
                  <c:v>-0.35771431694042305</c:v>
                </c:pt>
                <c:pt idx="2996">
                  <c:v>1.3163774819197303</c:v>
                </c:pt>
                <c:pt idx="2997">
                  <c:v>-0.11356691178894193</c:v>
                </c:pt>
                <c:pt idx="2998">
                  <c:v>0.84334071686019341</c:v>
                </c:pt>
                <c:pt idx="2999">
                  <c:v>-0.75122230635028753</c:v>
                </c:pt>
                <c:pt idx="3000">
                  <c:v>-0.2563557832937402</c:v>
                </c:pt>
                <c:pt idx="3001">
                  <c:v>2.4461530140995814E-2</c:v>
                </c:pt>
                <c:pt idx="3002">
                  <c:v>-0.39839855716505468</c:v>
                </c:pt>
                <c:pt idx="3003">
                  <c:v>-0.13971253748925902</c:v>
                </c:pt>
                <c:pt idx="3004">
                  <c:v>-0.14992070419420242</c:v>
                </c:pt>
                <c:pt idx="3005">
                  <c:v>0.22675512326982</c:v>
                </c:pt>
                <c:pt idx="3006">
                  <c:v>-0.26621183137481796</c:v>
                </c:pt>
                <c:pt idx="3007">
                  <c:v>0.23376537680833839</c:v>
                </c:pt>
                <c:pt idx="3008">
                  <c:v>-9.1177298589224832E-3</c:v>
                </c:pt>
                <c:pt idx="3009">
                  <c:v>0.29901014949892291</c:v>
                </c:pt>
                <c:pt idx="3010">
                  <c:v>0.10889240163240912</c:v>
                </c:pt>
                <c:pt idx="3011">
                  <c:v>-0.66017849507665749</c:v>
                </c:pt>
                <c:pt idx="3012">
                  <c:v>0.42717705468210015</c:v>
                </c:pt>
                <c:pt idx="3013">
                  <c:v>-0.34941923539775971</c:v>
                </c:pt>
                <c:pt idx="3014">
                  <c:v>-0.73216460790238502</c:v>
                </c:pt>
                <c:pt idx="3015">
                  <c:v>6.1983516108957325E-2</c:v>
                </c:pt>
                <c:pt idx="3016">
                  <c:v>0.10151561549124424</c:v>
                </c:pt>
                <c:pt idx="3017">
                  <c:v>1.4055567633437569</c:v>
                </c:pt>
                <c:pt idx="3018">
                  <c:v>0.18370881687541188</c:v>
                </c:pt>
                <c:pt idx="3019">
                  <c:v>0.11742908358689449</c:v>
                </c:pt>
                <c:pt idx="3020">
                  <c:v>1.5497569395325591E-2</c:v>
                </c:pt>
                <c:pt idx="3021">
                  <c:v>3.9278795351367586E-2</c:v>
                </c:pt>
                <c:pt idx="3022">
                  <c:v>0.5697827124241277</c:v>
                </c:pt>
                <c:pt idx="3023">
                  <c:v>-0.14146193366346418</c:v>
                </c:pt>
                <c:pt idx="3024">
                  <c:v>0.18991941790107361</c:v>
                </c:pt>
                <c:pt idx="3025">
                  <c:v>-5.7391663888336684E-2</c:v>
                </c:pt>
                <c:pt idx="3026">
                  <c:v>-3.0328451890577856E-3</c:v>
                </c:pt>
                <c:pt idx="3027">
                  <c:v>4.4883678239764788E-2</c:v>
                </c:pt>
                <c:pt idx="3028">
                  <c:v>0.36904764345591323</c:v>
                </c:pt>
                <c:pt idx="3029">
                  <c:v>-0.25842515258120435</c:v>
                </c:pt>
                <c:pt idx="3030">
                  <c:v>-0.11512860824030058</c:v>
                </c:pt>
                <c:pt idx="3031">
                  <c:v>-0.39516956290089739</c:v>
                </c:pt>
                <c:pt idx="3032">
                  <c:v>-0.57669076275761311</c:v>
                </c:pt>
                <c:pt idx="3033">
                  <c:v>0.26903314645523702</c:v>
                </c:pt>
                <c:pt idx="3034">
                  <c:v>0.30556201562048441</c:v>
                </c:pt>
                <c:pt idx="3035">
                  <c:v>-0.46593839757888178</c:v>
                </c:pt>
                <c:pt idx="3036">
                  <c:v>0.19899696624010865</c:v>
                </c:pt>
                <c:pt idx="3037">
                  <c:v>-4.915836245085127E-2</c:v>
                </c:pt>
                <c:pt idx="3038">
                  <c:v>-9.6190441421302994E-2</c:v>
                </c:pt>
                <c:pt idx="3039">
                  <c:v>-0.48337965336183386</c:v>
                </c:pt>
                <c:pt idx="3040">
                  <c:v>0.5651096965318344</c:v>
                </c:pt>
                <c:pt idx="3041">
                  <c:v>-1.1078032895345149</c:v>
                </c:pt>
                <c:pt idx="3042">
                  <c:v>-0.20989525865354564</c:v>
                </c:pt>
                <c:pt idx="3043">
                  <c:v>0.27022990723799772</c:v>
                </c:pt>
                <c:pt idx="3044">
                  <c:v>0.16014572540457925</c:v>
                </c:pt>
                <c:pt idx="3045">
                  <c:v>0.44562077471519318</c:v>
                </c:pt>
                <c:pt idx="3046">
                  <c:v>5.616730630042658E-2</c:v>
                </c:pt>
                <c:pt idx="3047">
                  <c:v>3.0406710426045754E-2</c:v>
                </c:pt>
                <c:pt idx="3048">
                  <c:v>-0.69292126146018473</c:v>
                </c:pt>
                <c:pt idx="3049">
                  <c:v>-0.26084317428605414</c:v>
                </c:pt>
                <c:pt idx="3050">
                  <c:v>-1.7855184894581086E-2</c:v>
                </c:pt>
                <c:pt idx="3051">
                  <c:v>9.1124333661164736E-2</c:v>
                </c:pt>
                <c:pt idx="3052">
                  <c:v>0.26939227894040618</c:v>
                </c:pt>
                <c:pt idx="3053">
                  <c:v>0.68912021051818673</c:v>
                </c:pt>
                <c:pt idx="3054">
                  <c:v>0.34891224099419954</c:v>
                </c:pt>
                <c:pt idx="3055">
                  <c:v>0.28368475981474189</c:v>
                </c:pt>
                <c:pt idx="3056">
                  <c:v>-0.15875142869375186</c:v>
                </c:pt>
                <c:pt idx="3057">
                  <c:v>6.9564695093359566E-2</c:v>
                </c:pt>
                <c:pt idx="3058">
                  <c:v>0.47477347631213329</c:v>
                </c:pt>
                <c:pt idx="3059">
                  <c:v>-0.1569809542762316</c:v>
                </c:pt>
                <c:pt idx="3060">
                  <c:v>-2.0391917746110204</c:v>
                </c:pt>
                <c:pt idx="3061">
                  <c:v>0.48418970114826698</c:v>
                </c:pt>
                <c:pt idx="3062">
                  <c:v>-0.10889193997006984</c:v>
                </c:pt>
                <c:pt idx="3063">
                  <c:v>-2.1071815722049672</c:v>
                </c:pt>
                <c:pt idx="3064">
                  <c:v>0.28877196724740212</c:v>
                </c:pt>
                <c:pt idx="3065">
                  <c:v>9.0311471376036581E-2</c:v>
                </c:pt>
                <c:pt idx="3066">
                  <c:v>0.11928976837475146</c:v>
                </c:pt>
                <c:pt idx="3067">
                  <c:v>0.30719534351388472</c:v>
                </c:pt>
                <c:pt idx="3068">
                  <c:v>-0.40506933018760816</c:v>
                </c:pt>
                <c:pt idx="3069">
                  <c:v>-0.28278970098040423</c:v>
                </c:pt>
                <c:pt idx="3070">
                  <c:v>-0.46813200439444519</c:v>
                </c:pt>
                <c:pt idx="3071">
                  <c:v>7.7789888643667648E-2</c:v>
                </c:pt>
                <c:pt idx="3072">
                  <c:v>0.26279393662065453</c:v>
                </c:pt>
                <c:pt idx="3073">
                  <c:v>7.0526720876682436E-2</c:v>
                </c:pt>
                <c:pt idx="3074">
                  <c:v>0.4463621118785947</c:v>
                </c:pt>
                <c:pt idx="3075">
                  <c:v>-9.3725085630267088E-2</c:v>
                </c:pt>
                <c:pt idx="3076">
                  <c:v>0.84783659819977775</c:v>
                </c:pt>
                <c:pt idx="3077">
                  <c:v>-0.18033181650354449</c:v>
                </c:pt>
                <c:pt idx="3078">
                  <c:v>-0.11076011121316849</c:v>
                </c:pt>
                <c:pt idx="3079">
                  <c:v>-5.0801268104846878E-2</c:v>
                </c:pt>
                <c:pt idx="3080">
                  <c:v>0.34879895961210772</c:v>
                </c:pt>
                <c:pt idx="3081">
                  <c:v>0.21536797220347947</c:v>
                </c:pt>
                <c:pt idx="3082">
                  <c:v>7.0519425164900255E-3</c:v>
                </c:pt>
                <c:pt idx="3083">
                  <c:v>-0.36605736876439621</c:v>
                </c:pt>
                <c:pt idx="3084">
                  <c:v>-3.4666297197792711E-3</c:v>
                </c:pt>
                <c:pt idx="3085">
                  <c:v>0.44847812141147719</c:v>
                </c:pt>
                <c:pt idx="3086">
                  <c:v>0.23780842954562034</c:v>
                </c:pt>
                <c:pt idx="3087">
                  <c:v>0.60369161711557306</c:v>
                </c:pt>
                <c:pt idx="3088">
                  <c:v>0.22946487314009217</c:v>
                </c:pt>
                <c:pt idx="3089">
                  <c:v>0.15471281378215795</c:v>
                </c:pt>
                <c:pt idx="3090">
                  <c:v>-0.37969511848664678</c:v>
                </c:pt>
                <c:pt idx="3091">
                  <c:v>-0.87540717459417727</c:v>
                </c:pt>
                <c:pt idx="3092">
                  <c:v>-0.27177470624022387</c:v>
                </c:pt>
                <c:pt idx="3093">
                  <c:v>0.5126820033395475</c:v>
                </c:pt>
                <c:pt idx="3094">
                  <c:v>-0.30685877316971411</c:v>
                </c:pt>
                <c:pt idx="3095">
                  <c:v>-0.38609122120333705</c:v>
                </c:pt>
                <c:pt idx="3096">
                  <c:v>-0.19627699322584216</c:v>
                </c:pt>
                <c:pt idx="3097">
                  <c:v>-0.80062603927817899</c:v>
                </c:pt>
                <c:pt idx="3098">
                  <c:v>-0.25428937801199908</c:v>
                </c:pt>
                <c:pt idx="3099">
                  <c:v>0.48284828306846539</c:v>
                </c:pt>
                <c:pt idx="3100">
                  <c:v>-0.22988983826697154</c:v>
                </c:pt>
                <c:pt idx="3101">
                  <c:v>0.2719037062632752</c:v>
                </c:pt>
                <c:pt idx="3102">
                  <c:v>3.0406710426045754E-2</c:v>
                </c:pt>
                <c:pt idx="3103">
                  <c:v>0.24865627000440324</c:v>
                </c:pt>
                <c:pt idx="3104">
                  <c:v>0.51086067396761548</c:v>
                </c:pt>
                <c:pt idx="3105">
                  <c:v>0.26207228839841024</c:v>
                </c:pt>
                <c:pt idx="3106">
                  <c:v>-0.29725381447573895</c:v>
                </c:pt>
                <c:pt idx="3107">
                  <c:v>0.13014013533644853</c:v>
                </c:pt>
                <c:pt idx="3108">
                  <c:v>-0.46553991807327183</c:v>
                </c:pt>
                <c:pt idx="3109">
                  <c:v>3.7461392328946375E-3</c:v>
                </c:pt>
                <c:pt idx="3110">
                  <c:v>0.22589186169034053</c:v>
                </c:pt>
                <c:pt idx="3111">
                  <c:v>-7.6666182490649076E-3</c:v>
                </c:pt>
                <c:pt idx="3112">
                  <c:v>0.4341344579093358</c:v>
                </c:pt>
                <c:pt idx="3113">
                  <c:v>0.10043947928031166</c:v>
                </c:pt>
                <c:pt idx="3114">
                  <c:v>8.8955682308218403E-2</c:v>
                </c:pt>
                <c:pt idx="3115">
                  <c:v>0.17056605679206857</c:v>
                </c:pt>
                <c:pt idx="3116">
                  <c:v>7.6969476315110794E-2</c:v>
                </c:pt>
                <c:pt idx="3117">
                  <c:v>0.12048465689545584</c:v>
                </c:pt>
                <c:pt idx="3118">
                  <c:v>0.28249911293597063</c:v>
                </c:pt>
                <c:pt idx="3119">
                  <c:v>1.8918982163051733E-2</c:v>
                </c:pt>
                <c:pt idx="3120">
                  <c:v>0.34130265297300877</c:v>
                </c:pt>
                <c:pt idx="3121">
                  <c:v>0.25350526218669706</c:v>
                </c:pt>
                <c:pt idx="3122">
                  <c:v>-0.17902458339483771</c:v>
                </c:pt>
                <c:pt idx="3123">
                  <c:v>5.0406167005301369E-3</c:v>
                </c:pt>
                <c:pt idx="3124">
                  <c:v>-0.11076011121316849</c:v>
                </c:pt>
                <c:pt idx="3125">
                  <c:v>0.27309808917849138</c:v>
                </c:pt>
                <c:pt idx="3126">
                  <c:v>1.1209361420303354E-2</c:v>
                </c:pt>
                <c:pt idx="3127">
                  <c:v>-1.867225766723674</c:v>
                </c:pt>
                <c:pt idx="3128">
                  <c:v>-0.432843996289213</c:v>
                </c:pt>
                <c:pt idx="3129">
                  <c:v>0.41986245037752395</c:v>
                </c:pt>
                <c:pt idx="3130">
                  <c:v>-8.5129366799652328E-2</c:v>
                </c:pt>
                <c:pt idx="3131">
                  <c:v>0.14821827215414507</c:v>
                </c:pt>
                <c:pt idx="3132">
                  <c:v>-8.1766439773688651E-2</c:v>
                </c:pt>
                <c:pt idx="3133">
                  <c:v>-0.4217858345275457</c:v>
                </c:pt>
                <c:pt idx="3134">
                  <c:v>-0.27456420809468807</c:v>
                </c:pt>
                <c:pt idx="3135">
                  <c:v>-1.4398720239187364</c:v>
                </c:pt>
                <c:pt idx="3136">
                  <c:v>6.7776372048492753E-2</c:v>
                </c:pt>
                <c:pt idx="3137">
                  <c:v>-0.24690896970189485</c:v>
                </c:pt>
                <c:pt idx="3138">
                  <c:v>-8.682243099800882E-3</c:v>
                </c:pt>
                <c:pt idx="3139">
                  <c:v>-0.17136841831198107</c:v>
                </c:pt>
                <c:pt idx="3140">
                  <c:v>-0.45739524973924206</c:v>
                </c:pt>
                <c:pt idx="3141">
                  <c:v>0.50131174924366007</c:v>
                </c:pt>
                <c:pt idx="3142">
                  <c:v>3.3088169332187757E-2</c:v>
                </c:pt>
                <c:pt idx="3143">
                  <c:v>0.17683337078449007</c:v>
                </c:pt>
                <c:pt idx="3144">
                  <c:v>-2.5617534179269933E-2</c:v>
                </c:pt>
                <c:pt idx="3145">
                  <c:v>-0.47613699117365027</c:v>
                </c:pt>
                <c:pt idx="3146">
                  <c:v>-0.7933567760166047</c:v>
                </c:pt>
                <c:pt idx="3147">
                  <c:v>-1.7417053077409407E-2</c:v>
                </c:pt>
                <c:pt idx="3148">
                  <c:v>1.1209361420303354E-2</c:v>
                </c:pt>
                <c:pt idx="3149">
                  <c:v>0.53992804335280231</c:v>
                </c:pt>
                <c:pt idx="3150">
                  <c:v>0.3060288694522062</c:v>
                </c:pt>
                <c:pt idx="3151">
                  <c:v>-6.6427361738976065E-2</c:v>
                </c:pt>
                <c:pt idx="3152">
                  <c:v>-0.14720210718122878</c:v>
                </c:pt>
                <c:pt idx="3153">
                  <c:v>-0.26638534692507693</c:v>
                </c:pt>
                <c:pt idx="3154">
                  <c:v>0.37217205191235059</c:v>
                </c:pt>
                <c:pt idx="3155">
                  <c:v>-0.18409672315490333</c:v>
                </c:pt>
                <c:pt idx="3156">
                  <c:v>-0.3817613444045454</c:v>
                </c:pt>
                <c:pt idx="3157">
                  <c:v>-0.13796526004476725</c:v>
                </c:pt>
                <c:pt idx="3158">
                  <c:v>0.31359414657239121</c:v>
                </c:pt>
                <c:pt idx="3159">
                  <c:v>3.4356596646641591E-2</c:v>
                </c:pt>
                <c:pt idx="3160">
                  <c:v>-1.2990101791033478E-3</c:v>
                </c:pt>
                <c:pt idx="3161">
                  <c:v>6.3364878758429374E-2</c:v>
                </c:pt>
                <c:pt idx="3162">
                  <c:v>0.27297869537357461</c:v>
                </c:pt>
                <c:pt idx="3163">
                  <c:v>-2.2371834740188943</c:v>
                </c:pt>
                <c:pt idx="3164">
                  <c:v>-0.17625063969172725</c:v>
                </c:pt>
                <c:pt idx="3165">
                  <c:v>8.8820033298585108E-2</c:v>
                </c:pt>
                <c:pt idx="3166">
                  <c:v>6.0466301184147796E-3</c:v>
                </c:pt>
                <c:pt idx="3167">
                  <c:v>0.39604985762503087</c:v>
                </c:pt>
                <c:pt idx="3168">
                  <c:v>-0.45917916909383244</c:v>
                </c:pt>
                <c:pt idx="3169">
                  <c:v>-0.20856097412755825</c:v>
                </c:pt>
                <c:pt idx="3170">
                  <c:v>-5.3194293809460211E-2</c:v>
                </c:pt>
                <c:pt idx="3171">
                  <c:v>0.27857955045842336</c:v>
                </c:pt>
                <c:pt idx="3172">
                  <c:v>0.30999103926006899</c:v>
                </c:pt>
                <c:pt idx="3173">
                  <c:v>3.5905383742127948E-2</c:v>
                </c:pt>
                <c:pt idx="3174">
                  <c:v>0.59359280586459617</c:v>
                </c:pt>
                <c:pt idx="3175">
                  <c:v>0.47394272984657354</c:v>
                </c:pt>
                <c:pt idx="3176">
                  <c:v>0.17287150035227722</c:v>
                </c:pt>
                <c:pt idx="3177">
                  <c:v>0.1437852247086015</c:v>
                </c:pt>
                <c:pt idx="3178">
                  <c:v>-4.4092086702207781E-2</c:v>
                </c:pt>
                <c:pt idx="3179">
                  <c:v>0.46393627950640753</c:v>
                </c:pt>
                <c:pt idx="3180">
                  <c:v>9.8958480088168779E-2</c:v>
                </c:pt>
                <c:pt idx="3181">
                  <c:v>-4.9755566243251247E-2</c:v>
                </c:pt>
                <c:pt idx="3182">
                  <c:v>-9.9432627585305883E-2</c:v>
                </c:pt>
                <c:pt idx="3183">
                  <c:v>0.33273657246386118</c:v>
                </c:pt>
                <c:pt idx="3184">
                  <c:v>0.49692246600807122</c:v>
                </c:pt>
                <c:pt idx="3185">
                  <c:v>0.40827708515304595</c:v>
                </c:pt>
                <c:pt idx="3186">
                  <c:v>0.11436702495200024</c:v>
                </c:pt>
                <c:pt idx="3187">
                  <c:v>0.15003969277415322</c:v>
                </c:pt>
                <c:pt idx="3188">
                  <c:v>-1.4437913282604149</c:v>
                </c:pt>
                <c:pt idx="3189">
                  <c:v>0.79360460973632241</c:v>
                </c:pt>
                <c:pt idx="3190">
                  <c:v>-0.33752102957674851</c:v>
                </c:pt>
                <c:pt idx="3191">
                  <c:v>7.8063255776819121E-2</c:v>
                </c:pt>
                <c:pt idx="3192">
                  <c:v>0.31869283314833541</c:v>
                </c:pt>
                <c:pt idx="3193">
                  <c:v>-0.32463568725085445</c:v>
                </c:pt>
                <c:pt idx="3194">
                  <c:v>-0.77472507013043068</c:v>
                </c:pt>
                <c:pt idx="3195">
                  <c:v>-0.26049749438961439</c:v>
                </c:pt>
                <c:pt idx="3196">
                  <c:v>0.55895330235028873</c:v>
                </c:pt>
                <c:pt idx="3197">
                  <c:v>-3.061923505839206E-2</c:v>
                </c:pt>
                <c:pt idx="3198">
                  <c:v>-1.5269924320838264</c:v>
                </c:pt>
                <c:pt idx="3199">
                  <c:v>-0.45917916909383244</c:v>
                </c:pt>
                <c:pt idx="3200">
                  <c:v>-1.1880358246898062</c:v>
                </c:pt>
                <c:pt idx="3201">
                  <c:v>-0.16844699637366267</c:v>
                </c:pt>
                <c:pt idx="3202">
                  <c:v>0.51793074222391067</c:v>
                </c:pt>
                <c:pt idx="3203">
                  <c:v>-4.364591535463163E-2</c:v>
                </c:pt>
                <c:pt idx="3204">
                  <c:v>0.20876694742141266</c:v>
                </c:pt>
                <c:pt idx="3205">
                  <c:v>-4.1565604913584353E-2</c:v>
                </c:pt>
                <c:pt idx="3206">
                  <c:v>0.65425221343669104</c:v>
                </c:pt>
                <c:pt idx="3207">
                  <c:v>-8.6587681356161176E-4</c:v>
                </c:pt>
                <c:pt idx="3208">
                  <c:v>5.0327553558424928E-2</c:v>
                </c:pt>
                <c:pt idx="3209">
                  <c:v>-0.28542476114837428</c:v>
                </c:pt>
                <c:pt idx="3210">
                  <c:v>0.22909566135537973</c:v>
                </c:pt>
                <c:pt idx="3211">
                  <c:v>-0.32156746620384746</c:v>
                </c:pt>
                <c:pt idx="3212">
                  <c:v>-7.6888860768603282E-2</c:v>
                </c:pt>
                <c:pt idx="3213">
                  <c:v>-9.3417212167534708E-2</c:v>
                </c:pt>
                <c:pt idx="3214">
                  <c:v>0.13960046458551464</c:v>
                </c:pt>
                <c:pt idx="3215">
                  <c:v>0.15432396466047718</c:v>
                </c:pt>
                <c:pt idx="3216">
                  <c:v>0.5697827124241277</c:v>
                </c:pt>
                <c:pt idx="3217">
                  <c:v>0.25471496797691823</c:v>
                </c:pt>
                <c:pt idx="3218">
                  <c:v>-0.15200309344504997</c:v>
                </c:pt>
                <c:pt idx="3219">
                  <c:v>0.51571245195603432</c:v>
                </c:pt>
                <c:pt idx="3220">
                  <c:v>0.45164632788394504</c:v>
                </c:pt>
                <c:pt idx="3221">
                  <c:v>0.3251561177415912</c:v>
                </c:pt>
                <c:pt idx="3222">
                  <c:v>-1.139235797371172</c:v>
                </c:pt>
                <c:pt idx="3223">
                  <c:v>0.10742005883636484</c:v>
                </c:pt>
                <c:pt idx="3224">
                  <c:v>0.14626419486652553</c:v>
                </c:pt>
                <c:pt idx="3225">
                  <c:v>0.44052703187585196</c:v>
                </c:pt>
                <c:pt idx="3226">
                  <c:v>-0.19264507794239591</c:v>
                </c:pt>
                <c:pt idx="3227">
                  <c:v>0.27750872814477806</c:v>
                </c:pt>
                <c:pt idx="3228">
                  <c:v>-0.11622280248379357</c:v>
                </c:pt>
                <c:pt idx="3229">
                  <c:v>0.15003969277415322</c:v>
                </c:pt>
                <c:pt idx="3230">
                  <c:v>-7.8411333515308074E-2</c:v>
                </c:pt>
                <c:pt idx="3231">
                  <c:v>-1.8001258406667484E-2</c:v>
                </c:pt>
                <c:pt idx="3232">
                  <c:v>0.50406100130929277</c:v>
                </c:pt>
                <c:pt idx="3233">
                  <c:v>-2.0421596732937677</c:v>
                </c:pt>
                <c:pt idx="3234">
                  <c:v>6.9427210456014174E-2</c:v>
                </c:pt>
                <c:pt idx="3235">
                  <c:v>0.13487805434311173</c:v>
                </c:pt>
                <c:pt idx="3236">
                  <c:v>0.45890690685086627</c:v>
                </c:pt>
                <c:pt idx="3237">
                  <c:v>9.8419557765544521E-2</c:v>
                </c:pt>
                <c:pt idx="3238">
                  <c:v>0.32929584810251517</c:v>
                </c:pt>
                <c:pt idx="3239">
                  <c:v>-6.1601281417060512E-2</c:v>
                </c:pt>
                <c:pt idx="3240">
                  <c:v>-1.1370130908049096</c:v>
                </c:pt>
                <c:pt idx="3241">
                  <c:v>0.48830933570336321</c:v>
                </c:pt>
                <c:pt idx="3242">
                  <c:v>-0.32517781603817786</c:v>
                </c:pt>
                <c:pt idx="3243">
                  <c:v>-1.893785703909032</c:v>
                </c:pt>
                <c:pt idx="3244">
                  <c:v>0.1443074672630423</c:v>
                </c:pt>
                <c:pt idx="3245">
                  <c:v>0.20050435344652129</c:v>
                </c:pt>
                <c:pt idx="3246">
                  <c:v>0.5982699118832131</c:v>
                </c:pt>
                <c:pt idx="3247">
                  <c:v>-0.24383067186070126</c:v>
                </c:pt>
                <c:pt idx="3248">
                  <c:v>-0.23718347401889431</c:v>
                </c:pt>
                <c:pt idx="3249">
                  <c:v>-9.7733430916929001E-2</c:v>
                </c:pt>
                <c:pt idx="3250">
                  <c:v>-4.6921047387492573E-2</c:v>
                </c:pt>
                <c:pt idx="3251">
                  <c:v>-3.6112535523788363E-3</c:v>
                </c:pt>
                <c:pt idx="3252">
                  <c:v>0.38161562484645389</c:v>
                </c:pt>
                <c:pt idx="3253">
                  <c:v>0.25059782304823369</c:v>
                </c:pt>
                <c:pt idx="3254">
                  <c:v>4.0541793862846835E-2</c:v>
                </c:pt>
                <c:pt idx="3255">
                  <c:v>0.66238781925968371</c:v>
                </c:pt>
                <c:pt idx="3256">
                  <c:v>0.57686070222419183</c:v>
                </c:pt>
                <c:pt idx="3257">
                  <c:v>4.9630767724600428E-2</c:v>
                </c:pt>
                <c:pt idx="3258">
                  <c:v>-9.0188501291661727E-2</c:v>
                </c:pt>
                <c:pt idx="3259">
                  <c:v>-1.1587974275211846E-2</c:v>
                </c:pt>
                <c:pt idx="3260">
                  <c:v>-0.87752605882435541</c:v>
                </c:pt>
                <c:pt idx="3261">
                  <c:v>0.43028527297778069</c:v>
                </c:pt>
                <c:pt idx="3262">
                  <c:v>-0.57389629931495101</c:v>
                </c:pt>
                <c:pt idx="3263">
                  <c:v>-0.39953992988351816</c:v>
                </c:pt>
                <c:pt idx="3264">
                  <c:v>-0.65699021744561026</c:v>
                </c:pt>
                <c:pt idx="3265">
                  <c:v>-0.31545053081615754</c:v>
                </c:pt>
                <c:pt idx="3266">
                  <c:v>1.0416635317293617</c:v>
                </c:pt>
                <c:pt idx="3267">
                  <c:v>0.10205338272918787</c:v>
                </c:pt>
                <c:pt idx="3268">
                  <c:v>-0.12170625659895835</c:v>
                </c:pt>
                <c:pt idx="3269">
                  <c:v>-0.59313684202346018</c:v>
                </c:pt>
                <c:pt idx="3270">
                  <c:v>-0.28560060306959739</c:v>
                </c:pt>
                <c:pt idx="3271">
                  <c:v>0.7870144737734287</c:v>
                </c:pt>
                <c:pt idx="3272">
                  <c:v>0.1554901977475622</c:v>
                </c:pt>
                <c:pt idx="3273">
                  <c:v>0.1812934128854749</c:v>
                </c:pt>
                <c:pt idx="3274">
                  <c:v>9.6396804187157126E-2</c:v>
                </c:pt>
                <c:pt idx="3275">
                  <c:v>0.19421315631120697</c:v>
                </c:pt>
                <c:pt idx="3276">
                  <c:v>0.10245657665073429</c:v>
                </c:pt>
                <c:pt idx="3277">
                  <c:v>-0.62571166083096874</c:v>
                </c:pt>
                <c:pt idx="3278">
                  <c:v>-0.30971701093648801</c:v>
                </c:pt>
                <c:pt idx="3279">
                  <c:v>5.0606173690787397E-2</c:v>
                </c:pt>
                <c:pt idx="3280">
                  <c:v>-6.9906105987850617E-2</c:v>
                </c:pt>
                <c:pt idx="3281">
                  <c:v>-0.1592346626761259</c:v>
                </c:pt>
                <c:pt idx="3282">
                  <c:v>2.1195424514489698E-2</c:v>
                </c:pt>
                <c:pt idx="3283">
                  <c:v>5.4917919128957937E-2</c:v>
                </c:pt>
                <c:pt idx="3284">
                  <c:v>0.18903382439001684</c:v>
                </c:pt>
                <c:pt idx="3285">
                  <c:v>-2.8410464469938029E-2</c:v>
                </c:pt>
                <c:pt idx="3286">
                  <c:v>-3.8006322579744921E-2</c:v>
                </c:pt>
                <c:pt idx="3287">
                  <c:v>-0.17967805188789829</c:v>
                </c:pt>
                <c:pt idx="3288">
                  <c:v>-0.29565918669681096</c:v>
                </c:pt>
                <c:pt idx="3289">
                  <c:v>0.22428728989200139</c:v>
                </c:pt>
                <c:pt idx="3290">
                  <c:v>-0.18114943910456646</c:v>
                </c:pt>
                <c:pt idx="3291">
                  <c:v>2.8003278472752472E-2</c:v>
                </c:pt>
                <c:pt idx="3292">
                  <c:v>-0.11528487090396689</c:v>
                </c:pt>
                <c:pt idx="3293">
                  <c:v>-2.8557610682609706E-2</c:v>
                </c:pt>
                <c:pt idx="3294">
                  <c:v>0.50690655458069334</c:v>
                </c:pt>
                <c:pt idx="3295">
                  <c:v>-0.46494240510515766</c:v>
                </c:pt>
                <c:pt idx="3296">
                  <c:v>-0.18935125221735402</c:v>
                </c:pt>
                <c:pt idx="3297">
                  <c:v>0.13868342797927169</c:v>
                </c:pt>
                <c:pt idx="3298">
                  <c:v>-0.54371951848927458</c:v>
                </c:pt>
                <c:pt idx="3299">
                  <c:v>0.49262232857444571</c:v>
                </c:pt>
                <c:pt idx="3300">
                  <c:v>3.8436181656107918E-2</c:v>
                </c:pt>
                <c:pt idx="3301">
                  <c:v>3.5905383742127948E-2</c:v>
                </c:pt>
                <c:pt idx="3302">
                  <c:v>0.13763467188337281</c:v>
                </c:pt>
                <c:pt idx="3303">
                  <c:v>-0.45838604370778296</c:v>
                </c:pt>
                <c:pt idx="3304">
                  <c:v>3.3088169332187757E-2</c:v>
                </c:pt>
                <c:pt idx="3305">
                  <c:v>0.97702342158068989</c:v>
                </c:pt>
                <c:pt idx="3306">
                  <c:v>0.37617923151752053</c:v>
                </c:pt>
                <c:pt idx="3307">
                  <c:v>-0.58100053456873424</c:v>
                </c:pt>
                <c:pt idx="3308">
                  <c:v>1.5860923540263689E-3</c:v>
                </c:pt>
                <c:pt idx="3309">
                  <c:v>0.20914139783859165</c:v>
                </c:pt>
                <c:pt idx="3310">
                  <c:v>0.12181115114198661</c:v>
                </c:pt>
                <c:pt idx="3311">
                  <c:v>0.42578153870353491</c:v>
                </c:pt>
                <c:pt idx="3312">
                  <c:v>0.13316893348604381</c:v>
                </c:pt>
                <c:pt idx="3313">
                  <c:v>0.49957804701013164</c:v>
                </c:pt>
                <c:pt idx="3314">
                  <c:v>-0.16553147828969708</c:v>
                </c:pt>
                <c:pt idx="3315">
                  <c:v>0.16414264884830632</c:v>
                </c:pt>
                <c:pt idx="3316">
                  <c:v>-4.6921047387492573E-2</c:v>
                </c:pt>
                <c:pt idx="3317">
                  <c:v>0.12617994882319306</c:v>
                </c:pt>
                <c:pt idx="3318">
                  <c:v>0.14143279092929553</c:v>
                </c:pt>
                <c:pt idx="3319">
                  <c:v>0.13290581201150653</c:v>
                </c:pt>
                <c:pt idx="3320">
                  <c:v>-0.35273154689561698</c:v>
                </c:pt>
                <c:pt idx="3321">
                  <c:v>-0.4715286981171079</c:v>
                </c:pt>
                <c:pt idx="3322">
                  <c:v>-0.37557152325372822</c:v>
                </c:pt>
                <c:pt idx="3323">
                  <c:v>-0.59509687785486931</c:v>
                </c:pt>
                <c:pt idx="3324">
                  <c:v>9.8958480088168779E-2</c:v>
                </c:pt>
                <c:pt idx="3325">
                  <c:v>0.79318840368061594</c:v>
                </c:pt>
                <c:pt idx="3326">
                  <c:v>-1.9708651959469772</c:v>
                </c:pt>
                <c:pt idx="3327">
                  <c:v>-0.5326161692422694</c:v>
                </c:pt>
                <c:pt idx="3328">
                  <c:v>0.88916199579537614</c:v>
                </c:pt>
                <c:pt idx="3329">
                  <c:v>-0.31832585820716669</c:v>
                </c:pt>
                <c:pt idx="3330">
                  <c:v>3.1959741397544997E-2</c:v>
                </c:pt>
                <c:pt idx="3331">
                  <c:v>8.6535744325324474E-4</c:v>
                </c:pt>
                <c:pt idx="3332">
                  <c:v>-3.3126603240018884E-2</c:v>
                </c:pt>
                <c:pt idx="3333">
                  <c:v>-7.0360474279115293E-2</c:v>
                </c:pt>
                <c:pt idx="3334">
                  <c:v>-0.33061033798716322</c:v>
                </c:pt>
                <c:pt idx="3335">
                  <c:v>-0.18393282709782408</c:v>
                </c:pt>
                <c:pt idx="3336">
                  <c:v>0.71281585443737183</c:v>
                </c:pt>
                <c:pt idx="3337">
                  <c:v>0.17491769523958806</c:v>
                </c:pt>
                <c:pt idx="3338">
                  <c:v>1.4344547602324029</c:v>
                </c:pt>
                <c:pt idx="3339">
                  <c:v>-0.29035645452906805</c:v>
                </c:pt>
                <c:pt idx="3340">
                  <c:v>2.0057652341253479E-2</c:v>
                </c:pt>
                <c:pt idx="3341">
                  <c:v>5.6583528366367514E-2</c:v>
                </c:pt>
                <c:pt idx="3342">
                  <c:v>9.1259766192678296E-2</c:v>
                </c:pt>
                <c:pt idx="3343">
                  <c:v>0.13592881552640673</c:v>
                </c:pt>
                <c:pt idx="3344">
                  <c:v>-0.14464809891803829</c:v>
                </c:pt>
                <c:pt idx="3345">
                  <c:v>-0.1512018187558111</c:v>
                </c:pt>
                <c:pt idx="3346">
                  <c:v>0.73448202221118541</c:v>
                </c:pt>
                <c:pt idx="3347">
                  <c:v>5.783147456057329E-2</c:v>
                </c:pt>
                <c:pt idx="3348">
                  <c:v>-0.19280996679804013</c:v>
                </c:pt>
                <c:pt idx="3349">
                  <c:v>1.4426229109453829E-4</c:v>
                </c:pt>
                <c:pt idx="3350">
                  <c:v>-0.36512797683578568</c:v>
                </c:pt>
                <c:pt idx="3351">
                  <c:v>-0.15312562618508427</c:v>
                </c:pt>
                <c:pt idx="3352">
                  <c:v>-0.24862197755084561</c:v>
                </c:pt>
                <c:pt idx="3353">
                  <c:v>-3.2831392467372364E-2</c:v>
                </c:pt>
                <c:pt idx="3354">
                  <c:v>0.10554399219892611</c:v>
                </c:pt>
                <c:pt idx="3355">
                  <c:v>-0.87276293807518557</c:v>
                </c:pt>
                <c:pt idx="3356">
                  <c:v>-0.12500636106703261</c:v>
                </c:pt>
                <c:pt idx="3357">
                  <c:v>0.14038603228305635</c:v>
                </c:pt>
                <c:pt idx="3358">
                  <c:v>-6.0547724927046763E-2</c:v>
                </c:pt>
                <c:pt idx="3359">
                  <c:v>0.49988414589190988</c:v>
                </c:pt>
                <c:pt idx="3360">
                  <c:v>0.10661632898778425</c:v>
                </c:pt>
                <c:pt idx="3361">
                  <c:v>-6.1601281417060512E-2</c:v>
                </c:pt>
                <c:pt idx="3362">
                  <c:v>-5.7091446419583011E-2</c:v>
                </c:pt>
                <c:pt idx="3363">
                  <c:v>4.3204498565167566E-2</c:v>
                </c:pt>
                <c:pt idx="3364">
                  <c:v>0.23413339561248248</c:v>
                </c:pt>
                <c:pt idx="3365">
                  <c:v>0.10742005883636484</c:v>
                </c:pt>
                <c:pt idx="3366">
                  <c:v>-0.31204350595551827</c:v>
                </c:pt>
                <c:pt idx="3367">
                  <c:v>-0.56021731052401846</c:v>
                </c:pt>
                <c:pt idx="3368">
                  <c:v>1.6353683577834812E-2</c:v>
                </c:pt>
                <c:pt idx="3369">
                  <c:v>-0.36698735979826891</c:v>
                </c:pt>
                <c:pt idx="3370">
                  <c:v>2.4177814301165262E-2</c:v>
                </c:pt>
                <c:pt idx="3371">
                  <c:v>-1.5933544923279976</c:v>
                </c:pt>
                <c:pt idx="3372">
                  <c:v>-0.12862944381854494</c:v>
                </c:pt>
                <c:pt idx="3373">
                  <c:v>0.19547359238726494</c:v>
                </c:pt>
                <c:pt idx="3374">
                  <c:v>-0.23378649801834464</c:v>
                </c:pt>
                <c:pt idx="3375">
                  <c:v>-0.25721765979998112</c:v>
                </c:pt>
                <c:pt idx="3376">
                  <c:v>-0.19445989268794478</c:v>
                </c:pt>
                <c:pt idx="3377">
                  <c:v>9.4100916438866505E-2</c:v>
                </c:pt>
                <c:pt idx="3378">
                  <c:v>-0.55067634300922041</c:v>
                </c:pt>
                <c:pt idx="3379">
                  <c:v>3.8576651452323155E-2</c:v>
                </c:pt>
                <c:pt idx="3380">
                  <c:v>0.43541524074781401</c:v>
                </c:pt>
                <c:pt idx="3381">
                  <c:v>2.8993411879548688E-2</c:v>
                </c:pt>
                <c:pt idx="3382">
                  <c:v>-0.17886126250929635</c:v>
                </c:pt>
                <c:pt idx="3383">
                  <c:v>1.5782997240927459E-2</c:v>
                </c:pt>
                <c:pt idx="3384">
                  <c:v>0.61485116242210358</c:v>
                </c:pt>
                <c:pt idx="3385">
                  <c:v>-0.12045105691922373</c:v>
                </c:pt>
                <c:pt idx="3386">
                  <c:v>8.343458529334968E-3</c:v>
                </c:pt>
                <c:pt idx="3387">
                  <c:v>-5.4991671584577052E-2</c:v>
                </c:pt>
                <c:pt idx="3388">
                  <c:v>6.2536219895389322E-2</c:v>
                </c:pt>
                <c:pt idx="3389">
                  <c:v>-0.14576492123383</c:v>
                </c:pt>
                <c:pt idx="3390">
                  <c:v>-8.6587681356161176E-4</c:v>
                </c:pt>
                <c:pt idx="3391">
                  <c:v>-7.7193226812113963E-2</c:v>
                </c:pt>
                <c:pt idx="3392">
                  <c:v>0.42201765699418042</c:v>
                </c:pt>
                <c:pt idx="3393">
                  <c:v>-0.46414610590410044</c:v>
                </c:pt>
                <c:pt idx="3394">
                  <c:v>-0.39441084868888587</c:v>
                </c:pt>
                <c:pt idx="3395">
                  <c:v>1.1942762042754209</c:v>
                </c:pt>
                <c:pt idx="3396">
                  <c:v>0.39604985762503087</c:v>
                </c:pt>
                <c:pt idx="3397">
                  <c:v>-0.13368543862295279</c:v>
                </c:pt>
                <c:pt idx="3398">
                  <c:v>3.8155201025968831E-2</c:v>
                </c:pt>
                <c:pt idx="3399">
                  <c:v>-2.1475216763576133</c:v>
                </c:pt>
                <c:pt idx="3400">
                  <c:v>0.14886904353100072</c:v>
                </c:pt>
                <c:pt idx="3401">
                  <c:v>-8.5741651176328579E-2</c:v>
                </c:pt>
                <c:pt idx="3402">
                  <c:v>-9.2629213289679192E-3</c:v>
                </c:pt>
                <c:pt idx="3403">
                  <c:v>-0.12689552987590236</c:v>
                </c:pt>
                <c:pt idx="3404">
                  <c:v>-0.14162107491792908</c:v>
                </c:pt>
                <c:pt idx="3405">
                  <c:v>0.22107278251506318</c:v>
                </c:pt>
                <c:pt idx="3406">
                  <c:v>-0.18294984156747943</c:v>
                </c:pt>
                <c:pt idx="3407">
                  <c:v>1.9061365093430198E-2</c:v>
                </c:pt>
                <c:pt idx="3408">
                  <c:v>0.74743036833646026</c:v>
                </c:pt>
                <c:pt idx="3409">
                  <c:v>5.6155674069098037E-3</c:v>
                </c:pt>
                <c:pt idx="3410">
                  <c:v>-0.17657670931474231</c:v>
                </c:pt>
                <c:pt idx="3411">
                  <c:v>-0.1373304107316016</c:v>
                </c:pt>
                <c:pt idx="3412">
                  <c:v>0.11356715704707816</c:v>
                </c:pt>
                <c:pt idx="3413">
                  <c:v>0.21723071622066917</c:v>
                </c:pt>
                <c:pt idx="3414">
                  <c:v>0.37027589672848954</c:v>
                </c:pt>
                <c:pt idx="3415">
                  <c:v>-0.24742265852373246</c:v>
                </c:pt>
                <c:pt idx="3416">
                  <c:v>0.24634727690091462</c:v>
                </c:pt>
                <c:pt idx="3417">
                  <c:v>-0.45324132956522728</c:v>
                </c:pt>
                <c:pt idx="3418">
                  <c:v>4.0682058803007765E-2</c:v>
                </c:pt>
                <c:pt idx="3419">
                  <c:v>0.13264264253961866</c:v>
                </c:pt>
                <c:pt idx="3420">
                  <c:v>1.1638756246893662E-2</c:v>
                </c:pt>
                <c:pt idx="3421">
                  <c:v>-7.0814985716076778E-2</c:v>
                </c:pt>
                <c:pt idx="3422">
                  <c:v>0.19396093689782179</c:v>
                </c:pt>
                <c:pt idx="3423">
                  <c:v>-0.43012009385192357</c:v>
                </c:pt>
                <c:pt idx="3424">
                  <c:v>0.23167816179851056</c:v>
                </c:pt>
                <c:pt idx="3425">
                  <c:v>0.31718827759650181</c:v>
                </c:pt>
                <c:pt idx="3426">
                  <c:v>-0.42449403196700858</c:v>
                </c:pt>
                <c:pt idx="3427">
                  <c:v>3.3088169332187757E-2</c:v>
                </c:pt>
                <c:pt idx="3428">
                  <c:v>-7.6280321250611363E-2</c:v>
                </c:pt>
                <c:pt idx="3429">
                  <c:v>0.46519088792598229</c:v>
                </c:pt>
                <c:pt idx="3430">
                  <c:v>3.7030730944967026E-2</c:v>
                </c:pt>
                <c:pt idx="3431">
                  <c:v>-0.15617691087310431</c:v>
                </c:pt>
                <c:pt idx="3432">
                  <c:v>-0.10113382791640249</c:v>
                </c:pt>
                <c:pt idx="3433">
                  <c:v>-9.8969011800408166E-2</c:v>
                </c:pt>
                <c:pt idx="3434">
                  <c:v>0.13606010688026618</c:v>
                </c:pt>
                <c:pt idx="3435">
                  <c:v>-0.26673244064523755</c:v>
                </c:pt>
                <c:pt idx="3436">
                  <c:v>0.15911246123085834</c:v>
                </c:pt>
                <c:pt idx="3437">
                  <c:v>-0.2553222106829261</c:v>
                </c:pt>
                <c:pt idx="3438">
                  <c:v>0.52977098219888741</c:v>
                </c:pt>
                <c:pt idx="3439">
                  <c:v>0.271186601597253</c:v>
                </c:pt>
                <c:pt idx="3440">
                  <c:v>5.6155674069098037E-3</c:v>
                </c:pt>
                <c:pt idx="3441">
                  <c:v>0.1891603710363757</c:v>
                </c:pt>
                <c:pt idx="3442">
                  <c:v>4.5582760019634981E-2</c:v>
                </c:pt>
                <c:pt idx="3443">
                  <c:v>7.4368421781553382E-2</c:v>
                </c:pt>
                <c:pt idx="3444">
                  <c:v>8.4744620868467985E-2</c:v>
                </c:pt>
                <c:pt idx="3445">
                  <c:v>0.39484336153086069</c:v>
                </c:pt>
                <c:pt idx="3446">
                  <c:v>6.3088712019284232E-2</c:v>
                </c:pt>
                <c:pt idx="3447">
                  <c:v>0.11543282612034657</c:v>
                </c:pt>
                <c:pt idx="3448">
                  <c:v>-4.0971781056306174E-2</c:v>
                </c:pt>
                <c:pt idx="3449">
                  <c:v>-5.8593158890854979E-2</c:v>
                </c:pt>
                <c:pt idx="3450">
                  <c:v>9.9766486292929807E-2</c:v>
                </c:pt>
                <c:pt idx="3451">
                  <c:v>-3.0029898840683307E-2</c:v>
                </c:pt>
                <c:pt idx="3452">
                  <c:v>0.34460128303667725</c:v>
                </c:pt>
                <c:pt idx="3453">
                  <c:v>0.27893631467923052</c:v>
                </c:pt>
                <c:pt idx="3454">
                  <c:v>7.0664100778789651E-2</c:v>
                </c:pt>
                <c:pt idx="3455">
                  <c:v>7.9019633034838013E-2</c:v>
                </c:pt>
                <c:pt idx="3456">
                  <c:v>0.11463354906893945</c:v>
                </c:pt>
                <c:pt idx="3457">
                  <c:v>-0.31222262260369532</c:v>
                </c:pt>
                <c:pt idx="3458">
                  <c:v>0.29548794305975318</c:v>
                </c:pt>
                <c:pt idx="3459">
                  <c:v>0.23376537680833839</c:v>
                </c:pt>
                <c:pt idx="3460">
                  <c:v>0.27703255187479342</c:v>
                </c:pt>
                <c:pt idx="3461">
                  <c:v>-0.24999384979579936</c:v>
                </c:pt>
                <c:pt idx="3462">
                  <c:v>-9.4649100419041649E-2</c:v>
                </c:pt>
                <c:pt idx="3463">
                  <c:v>0.6802343262632583</c:v>
                </c:pt>
                <c:pt idx="3464">
                  <c:v>0.32400408139442982</c:v>
                </c:pt>
                <c:pt idx="3465">
                  <c:v>-0.43050890804128378</c:v>
                </c:pt>
                <c:pt idx="3466">
                  <c:v>0.1694119519913547</c:v>
                </c:pt>
                <c:pt idx="3467">
                  <c:v>6.8326861434505545E-2</c:v>
                </c:pt>
                <c:pt idx="3468">
                  <c:v>0.92143633080629794</c:v>
                </c:pt>
                <c:pt idx="3469">
                  <c:v>0.26459647949088222</c:v>
                </c:pt>
                <c:pt idx="3470">
                  <c:v>0.30894328812521354</c:v>
                </c:pt>
                <c:pt idx="3471">
                  <c:v>0.1682569232085816</c:v>
                </c:pt>
                <c:pt idx="3472">
                  <c:v>-0.30240408229359855</c:v>
                </c:pt>
                <c:pt idx="3473">
                  <c:v>-0.12689552987590236</c:v>
                </c:pt>
                <c:pt idx="3474">
                  <c:v>0.39121780760289732</c:v>
                </c:pt>
                <c:pt idx="3475">
                  <c:v>0.62975294245713098</c:v>
                </c:pt>
                <c:pt idx="3476">
                  <c:v>0.49528582937096421</c:v>
                </c:pt>
                <c:pt idx="3477">
                  <c:v>2.2332300098056389E-2</c:v>
                </c:pt>
                <c:pt idx="3478">
                  <c:v>-4.1120214107611436E-2</c:v>
                </c:pt>
                <c:pt idx="3479">
                  <c:v>0.19711051471269642</c:v>
                </c:pt>
                <c:pt idx="3480">
                  <c:v>-0.38571419388095374</c:v>
                </c:pt>
                <c:pt idx="3481">
                  <c:v>0.45312244659581252</c:v>
                </c:pt>
                <c:pt idx="3482">
                  <c:v>0.28380327092836583</c:v>
                </c:pt>
                <c:pt idx="3483">
                  <c:v>0.36669988859949043</c:v>
                </c:pt>
                <c:pt idx="3484">
                  <c:v>0.1694119519913547</c:v>
                </c:pt>
                <c:pt idx="3485">
                  <c:v>1.6781550233402012E-2</c:v>
                </c:pt>
                <c:pt idx="3486">
                  <c:v>-0.32644357600985535</c:v>
                </c:pt>
                <c:pt idx="3487">
                  <c:v>0.22292818000261269</c:v>
                </c:pt>
                <c:pt idx="3488">
                  <c:v>-0.51601658969942688</c:v>
                </c:pt>
                <c:pt idx="3489">
                  <c:v>-0.31383567393864076</c:v>
                </c:pt>
                <c:pt idx="3490">
                  <c:v>-0.17559872145158373</c:v>
                </c:pt>
                <c:pt idx="3491">
                  <c:v>0.22305178836844153</c:v>
                </c:pt>
              </c:numCache>
            </c:numRef>
          </c:xVal>
          <c:yVal>
            <c:numRef>
              <c:f>'sDM - NC Prot'!$B$2:$B$3493</c:f>
              <c:numCache>
                <c:formatCode>General</c:formatCode>
                <c:ptCount val="3492"/>
                <c:pt idx="0">
                  <c:v>6.6031611763357242E-2</c:v>
                </c:pt>
                <c:pt idx="1">
                  <c:v>0.74705921152287347</c:v>
                </c:pt>
                <c:pt idx="2">
                  <c:v>0.81331612974745393</c:v>
                </c:pt>
                <c:pt idx="3">
                  <c:v>0.27573483757428507</c:v>
                </c:pt>
                <c:pt idx="4">
                  <c:v>8.9709660546792649E-2</c:v>
                </c:pt>
                <c:pt idx="5">
                  <c:v>0.9093038540273054</c:v>
                </c:pt>
                <c:pt idx="6">
                  <c:v>0.59269996245515666</c:v>
                </c:pt>
                <c:pt idx="7">
                  <c:v>0.40554253937081108</c:v>
                </c:pt>
                <c:pt idx="8">
                  <c:v>0.10402780025108986</c:v>
                </c:pt>
                <c:pt idx="9">
                  <c:v>0.32770060067658158</c:v>
                </c:pt>
                <c:pt idx="10">
                  <c:v>0.69468041129542557</c:v>
                </c:pt>
                <c:pt idx="11">
                  <c:v>0.23254345144109168</c:v>
                </c:pt>
                <c:pt idx="12">
                  <c:v>0.19330253878282586</c:v>
                </c:pt>
                <c:pt idx="13">
                  <c:v>6.9848388355000596E-2</c:v>
                </c:pt>
                <c:pt idx="14">
                  <c:v>0.24010058622619707</c:v>
                </c:pt>
                <c:pt idx="15">
                  <c:v>1.209287211187118</c:v>
                </c:pt>
                <c:pt idx="16">
                  <c:v>0.25409888433009531</c:v>
                </c:pt>
                <c:pt idx="17">
                  <c:v>0.85249520361226028</c:v>
                </c:pt>
                <c:pt idx="18">
                  <c:v>0.27623235124831341</c:v>
                </c:pt>
                <c:pt idx="19">
                  <c:v>0.4465375760534282</c:v>
                </c:pt>
                <c:pt idx="20">
                  <c:v>1.1079964910406193E-2</c:v>
                </c:pt>
                <c:pt idx="21">
                  <c:v>1.4539800101127354</c:v>
                </c:pt>
                <c:pt idx="22">
                  <c:v>0.64453656774368195</c:v>
                </c:pt>
                <c:pt idx="23">
                  <c:v>0.21495169737849923</c:v>
                </c:pt>
                <c:pt idx="24">
                  <c:v>1.6390913769954187E-2</c:v>
                </c:pt>
                <c:pt idx="25">
                  <c:v>0.1615568825310508</c:v>
                </c:pt>
                <c:pt idx="26">
                  <c:v>0.12284826492789427</c:v>
                </c:pt>
                <c:pt idx="27">
                  <c:v>0.16243993360802264</c:v>
                </c:pt>
                <c:pt idx="28">
                  <c:v>0.11334421581726854</c:v>
                </c:pt>
                <c:pt idx="29">
                  <c:v>4.209660142175959E-2</c:v>
                </c:pt>
                <c:pt idx="30">
                  <c:v>0.10628706880082851</c:v>
                </c:pt>
                <c:pt idx="31">
                  <c:v>0.66030082421831637</c:v>
                </c:pt>
                <c:pt idx="32">
                  <c:v>0.23289881339293883</c:v>
                </c:pt>
                <c:pt idx="33">
                  <c:v>0.11435768897530151</c:v>
                </c:pt>
                <c:pt idx="34">
                  <c:v>0.7988737949051411</c:v>
                </c:pt>
                <c:pt idx="35">
                  <c:v>0.22450863928536247</c:v>
                </c:pt>
                <c:pt idx="36">
                  <c:v>1.0087140352188477</c:v>
                </c:pt>
                <c:pt idx="37">
                  <c:v>4.4359152081730746E-2</c:v>
                </c:pt>
                <c:pt idx="38">
                  <c:v>0.49454043560730299</c:v>
                </c:pt>
                <c:pt idx="39">
                  <c:v>6.5959914963383659E-2</c:v>
                </c:pt>
                <c:pt idx="40">
                  <c:v>0.1003030457655827</c:v>
                </c:pt>
                <c:pt idx="41">
                  <c:v>0.76292687099808054</c:v>
                </c:pt>
                <c:pt idx="42">
                  <c:v>0.34565729536823692</c:v>
                </c:pt>
                <c:pt idx="43">
                  <c:v>0.11795973879747047</c:v>
                </c:pt>
                <c:pt idx="44">
                  <c:v>0.28798009701098581</c:v>
                </c:pt>
                <c:pt idx="45">
                  <c:v>0.80177309748354564</c:v>
                </c:pt>
                <c:pt idx="46">
                  <c:v>0.30564850935926052</c:v>
                </c:pt>
                <c:pt idx="47">
                  <c:v>0.42409861485453448</c:v>
                </c:pt>
                <c:pt idx="48">
                  <c:v>0.29770833899098148</c:v>
                </c:pt>
                <c:pt idx="49">
                  <c:v>1.0552270220118189</c:v>
                </c:pt>
                <c:pt idx="50">
                  <c:v>0.57724059205539735</c:v>
                </c:pt>
                <c:pt idx="51">
                  <c:v>1.5196083614883746</c:v>
                </c:pt>
                <c:pt idx="52">
                  <c:v>0.35368757955720431</c:v>
                </c:pt>
                <c:pt idx="53">
                  <c:v>0.17420168710894426</c:v>
                </c:pt>
                <c:pt idx="54">
                  <c:v>0.11891227775316419</c:v>
                </c:pt>
                <c:pt idx="55">
                  <c:v>0.34636093125937206</c:v>
                </c:pt>
                <c:pt idx="56">
                  <c:v>4.1518417391781685E-2</c:v>
                </c:pt>
                <c:pt idx="57">
                  <c:v>1.9500248657025576</c:v>
                </c:pt>
                <c:pt idx="58">
                  <c:v>0.3615663017808986</c:v>
                </c:pt>
                <c:pt idx="59">
                  <c:v>0.61220569738680375</c:v>
                </c:pt>
                <c:pt idx="60">
                  <c:v>3.1089809907340126E-2</c:v>
                </c:pt>
                <c:pt idx="61">
                  <c:v>6.6257689603633887E-2</c:v>
                </c:pt>
                <c:pt idx="62">
                  <c:v>0.30826661577374226</c:v>
                </c:pt>
                <c:pt idx="63">
                  <c:v>0.71119656527811159</c:v>
                </c:pt>
                <c:pt idx="64">
                  <c:v>0.7055007936212655</c:v>
                </c:pt>
                <c:pt idx="65">
                  <c:v>0.31381887070540337</c:v>
                </c:pt>
                <c:pt idx="66">
                  <c:v>0.83982077812710565</c:v>
                </c:pt>
                <c:pt idx="67">
                  <c:v>1.0948689920146033</c:v>
                </c:pt>
                <c:pt idx="68">
                  <c:v>0.57690171856319172</c:v>
                </c:pt>
                <c:pt idx="69">
                  <c:v>0.23520855696042972</c:v>
                </c:pt>
                <c:pt idx="70">
                  <c:v>0.51931067064707326</c:v>
                </c:pt>
                <c:pt idx="71">
                  <c:v>0.41551616238237793</c:v>
                </c:pt>
                <c:pt idx="72">
                  <c:v>1.5668110276369551E-2</c:v>
                </c:pt>
                <c:pt idx="73">
                  <c:v>0.55186553626798718</c:v>
                </c:pt>
                <c:pt idx="74">
                  <c:v>0.72692769510884758</c:v>
                </c:pt>
                <c:pt idx="75">
                  <c:v>0.1748965910506938</c:v>
                </c:pt>
                <c:pt idx="76">
                  <c:v>0.30688250429395153</c:v>
                </c:pt>
                <c:pt idx="77">
                  <c:v>2.0780967594141662</c:v>
                </c:pt>
                <c:pt idx="78">
                  <c:v>0.30724252376188965</c:v>
                </c:pt>
                <c:pt idx="79">
                  <c:v>0.28434042153658279</c:v>
                </c:pt>
                <c:pt idx="80">
                  <c:v>7.4936805891383223E-3</c:v>
                </c:pt>
                <c:pt idx="81">
                  <c:v>0.83829347343061189</c:v>
                </c:pt>
                <c:pt idx="82">
                  <c:v>1.315873212222946</c:v>
                </c:pt>
                <c:pt idx="83">
                  <c:v>7.4819364706141769E-2</c:v>
                </c:pt>
                <c:pt idx="84">
                  <c:v>5.2914387386756696E-2</c:v>
                </c:pt>
                <c:pt idx="85">
                  <c:v>0.10927719138163292</c:v>
                </c:pt>
                <c:pt idx="86">
                  <c:v>9.6615106573354398E-2</c:v>
                </c:pt>
                <c:pt idx="87">
                  <c:v>6.7392647860638005E-2</c:v>
                </c:pt>
                <c:pt idx="88">
                  <c:v>0.17230686064481349</c:v>
                </c:pt>
                <c:pt idx="89">
                  <c:v>1.6561845136354001</c:v>
                </c:pt>
                <c:pt idx="90">
                  <c:v>0.28548149976808246</c:v>
                </c:pt>
                <c:pt idx="91">
                  <c:v>0.17438323339281364</c:v>
                </c:pt>
                <c:pt idx="92">
                  <c:v>0.21797039972759666</c:v>
                </c:pt>
                <c:pt idx="93">
                  <c:v>0.65524438331558488</c:v>
                </c:pt>
                <c:pt idx="94">
                  <c:v>0.43448337524969655</c:v>
                </c:pt>
                <c:pt idx="95">
                  <c:v>1.209950774241483</c:v>
                </c:pt>
                <c:pt idx="96">
                  <c:v>0.23309408159804892</c:v>
                </c:pt>
                <c:pt idx="97">
                  <c:v>0.21689808834751906</c:v>
                </c:pt>
                <c:pt idx="98">
                  <c:v>4.1028880792241013E-2</c:v>
                </c:pt>
                <c:pt idx="99">
                  <c:v>0.82035793725880479</c:v>
                </c:pt>
                <c:pt idx="100">
                  <c:v>0.57327627714832607</c:v>
                </c:pt>
                <c:pt idx="101">
                  <c:v>0.74647854179686068</c:v>
                </c:pt>
                <c:pt idx="102">
                  <c:v>1.8381075275532728</c:v>
                </c:pt>
                <c:pt idx="103">
                  <c:v>1.1823303695172049</c:v>
                </c:pt>
                <c:pt idx="104">
                  <c:v>0.27226144110678641</c:v>
                </c:pt>
                <c:pt idx="105">
                  <c:v>1.1212514303075301</c:v>
                </c:pt>
                <c:pt idx="106">
                  <c:v>8.2455217635216446E-2</c:v>
                </c:pt>
                <c:pt idx="107">
                  <c:v>0.44131726946668237</c:v>
                </c:pt>
                <c:pt idx="108">
                  <c:v>1.1738637013221218</c:v>
                </c:pt>
                <c:pt idx="109">
                  <c:v>4.9205722518440492E-2</c:v>
                </c:pt>
                <c:pt idx="110">
                  <c:v>2.2120401925321818</c:v>
                </c:pt>
                <c:pt idx="111">
                  <c:v>0.43918154486921057</c:v>
                </c:pt>
                <c:pt idx="112">
                  <c:v>0.47037868597619187</c:v>
                </c:pt>
                <c:pt idx="113">
                  <c:v>1.240657054187388</c:v>
                </c:pt>
                <c:pt idx="114">
                  <c:v>5.6862804541719734E-2</c:v>
                </c:pt>
                <c:pt idx="115">
                  <c:v>1.6814684881646166E-2</c:v>
                </c:pt>
                <c:pt idx="116">
                  <c:v>0.37556398518622236</c:v>
                </c:pt>
                <c:pt idx="117">
                  <c:v>0.86030768563065252</c:v>
                </c:pt>
                <c:pt idx="118">
                  <c:v>0.62502433544728508</c:v>
                </c:pt>
                <c:pt idx="119">
                  <c:v>8.712527200130353E-2</c:v>
                </c:pt>
                <c:pt idx="120">
                  <c:v>0.47275905745340469</c:v>
                </c:pt>
                <c:pt idx="121">
                  <c:v>3.2107618722223025E-3</c:v>
                </c:pt>
                <c:pt idx="122">
                  <c:v>0.11093009995673817</c:v>
                </c:pt>
                <c:pt idx="123">
                  <c:v>7.7651914230652277E-2</c:v>
                </c:pt>
                <c:pt idx="124">
                  <c:v>0.54555441565981067</c:v>
                </c:pt>
                <c:pt idx="125">
                  <c:v>0.31486540629528648</c:v>
                </c:pt>
                <c:pt idx="126">
                  <c:v>0.23792492440689231</c:v>
                </c:pt>
                <c:pt idx="127">
                  <c:v>8.9417686212928296E-2</c:v>
                </c:pt>
                <c:pt idx="128">
                  <c:v>0.42146634245688541</c:v>
                </c:pt>
                <c:pt idx="129">
                  <c:v>0.72573249435179776</c:v>
                </c:pt>
                <c:pt idx="130">
                  <c:v>1.1382169537990379</c:v>
                </c:pt>
                <c:pt idx="131">
                  <c:v>0.18115776686104187</c:v>
                </c:pt>
                <c:pt idx="132">
                  <c:v>0.48442705651541684</c:v>
                </c:pt>
                <c:pt idx="133">
                  <c:v>1.8480793174192014E-2</c:v>
                </c:pt>
                <c:pt idx="134">
                  <c:v>1.3081684687052677E-2</c:v>
                </c:pt>
                <c:pt idx="135">
                  <c:v>0.14092852012364127</c:v>
                </c:pt>
                <c:pt idx="136">
                  <c:v>1.8203508912508357E-2</c:v>
                </c:pt>
                <c:pt idx="137">
                  <c:v>0.83467970990140827</c:v>
                </c:pt>
                <c:pt idx="138">
                  <c:v>0.34751780683504596</c:v>
                </c:pt>
                <c:pt idx="139">
                  <c:v>8.3853400158695843E-2</c:v>
                </c:pt>
                <c:pt idx="140">
                  <c:v>0.16308055746801187</c:v>
                </c:pt>
                <c:pt idx="141">
                  <c:v>0.41443948025695398</c:v>
                </c:pt>
                <c:pt idx="142">
                  <c:v>0.15172189767312089</c:v>
                </c:pt>
                <c:pt idx="143">
                  <c:v>0.20503269586754969</c:v>
                </c:pt>
                <c:pt idx="144">
                  <c:v>0.40574404756737609</c:v>
                </c:pt>
                <c:pt idx="145">
                  <c:v>0.45210573659815079</c:v>
                </c:pt>
                <c:pt idx="146">
                  <c:v>0.22917297527582556</c:v>
                </c:pt>
                <c:pt idx="147">
                  <c:v>0.59652651585534522</c:v>
                </c:pt>
                <c:pt idx="148">
                  <c:v>0.1417531931722204</c:v>
                </c:pt>
                <c:pt idx="149">
                  <c:v>0.25998205535583863</c:v>
                </c:pt>
                <c:pt idx="150">
                  <c:v>1.2423777558190856</c:v>
                </c:pt>
                <c:pt idx="151">
                  <c:v>0.24956412208256176</c:v>
                </c:pt>
                <c:pt idx="152">
                  <c:v>0.40703418367185301</c:v>
                </c:pt>
                <c:pt idx="153">
                  <c:v>0.54272711391839201</c:v>
                </c:pt>
                <c:pt idx="154">
                  <c:v>2.6727372348730589</c:v>
                </c:pt>
                <c:pt idx="155">
                  <c:v>0.27398022062039185</c:v>
                </c:pt>
                <c:pt idx="156">
                  <c:v>1.1905041737088184</c:v>
                </c:pt>
                <c:pt idx="157">
                  <c:v>3.309717521353632E-2</c:v>
                </c:pt>
                <c:pt idx="158">
                  <c:v>0.30593373514205086</c:v>
                </c:pt>
                <c:pt idx="159">
                  <c:v>0.68083263791598436</c:v>
                </c:pt>
                <c:pt idx="160">
                  <c:v>5.8118163713162738E-2</c:v>
                </c:pt>
                <c:pt idx="161">
                  <c:v>0.97212250024553615</c:v>
                </c:pt>
                <c:pt idx="162">
                  <c:v>3.2168872427266772E-2</c:v>
                </c:pt>
                <c:pt idx="163">
                  <c:v>1.1992233430086512</c:v>
                </c:pt>
                <c:pt idx="164">
                  <c:v>0.25472442214255431</c:v>
                </c:pt>
                <c:pt idx="165">
                  <c:v>0.3273164435723605</c:v>
                </c:pt>
                <c:pt idx="166">
                  <c:v>0.64550003832011782</c:v>
                </c:pt>
                <c:pt idx="167">
                  <c:v>0.73168006778074213</c:v>
                </c:pt>
                <c:pt idx="168">
                  <c:v>0.92974373563074619</c:v>
                </c:pt>
                <c:pt idx="169">
                  <c:v>0.15612101208714699</c:v>
                </c:pt>
                <c:pt idx="170">
                  <c:v>0.59939681486164442</c:v>
                </c:pt>
                <c:pt idx="171">
                  <c:v>1.4579138153030635</c:v>
                </c:pt>
                <c:pt idx="172">
                  <c:v>0.67259122231892154</c:v>
                </c:pt>
                <c:pt idx="173">
                  <c:v>6.6440597062539075E-2</c:v>
                </c:pt>
                <c:pt idx="174">
                  <c:v>0.36787022789921892</c:v>
                </c:pt>
                <c:pt idx="175">
                  <c:v>0.47654260978132573</c:v>
                </c:pt>
                <c:pt idx="176">
                  <c:v>0.20829963868538637</c:v>
                </c:pt>
                <c:pt idx="177">
                  <c:v>0.41748227534706356</c:v>
                </c:pt>
                <c:pt idx="178">
                  <c:v>1.6359540097701439</c:v>
                </c:pt>
                <c:pt idx="179">
                  <c:v>9.3445963619154304E-2</c:v>
                </c:pt>
                <c:pt idx="180">
                  <c:v>1.0028786768072957</c:v>
                </c:pt>
                <c:pt idx="181">
                  <c:v>6.9703965488162073E-2</c:v>
                </c:pt>
                <c:pt idx="182">
                  <c:v>0.48457872589427031</c:v>
                </c:pt>
                <c:pt idx="183">
                  <c:v>0.6723228384014116</c:v>
                </c:pt>
                <c:pt idx="184">
                  <c:v>0.22644131436515028</c:v>
                </c:pt>
                <c:pt idx="185">
                  <c:v>0.57482224480242139</c:v>
                </c:pt>
                <c:pt idx="186">
                  <c:v>0.73898185107597836</c:v>
                </c:pt>
                <c:pt idx="187">
                  <c:v>0.80891147271991426</c:v>
                </c:pt>
                <c:pt idx="188">
                  <c:v>0.25992334884001189</c:v>
                </c:pt>
                <c:pt idx="189">
                  <c:v>0.16695093170884137</c:v>
                </c:pt>
                <c:pt idx="190">
                  <c:v>4.94493488385679E-2</c:v>
                </c:pt>
                <c:pt idx="191">
                  <c:v>1.1094352727843277</c:v>
                </c:pt>
                <c:pt idx="192">
                  <c:v>8.8509673231148736E-2</c:v>
                </c:pt>
                <c:pt idx="193">
                  <c:v>0.74167811187635335</c:v>
                </c:pt>
                <c:pt idx="194">
                  <c:v>1.3100420954445812E-2</c:v>
                </c:pt>
                <c:pt idx="195">
                  <c:v>0.16263551936493414</c:v>
                </c:pt>
                <c:pt idx="196">
                  <c:v>0.5855683819922588</c:v>
                </c:pt>
                <c:pt idx="197">
                  <c:v>1.3063399593040215</c:v>
                </c:pt>
                <c:pt idx="198">
                  <c:v>0.13598668853134679</c:v>
                </c:pt>
                <c:pt idx="199">
                  <c:v>6.371498061594745E-2</c:v>
                </c:pt>
                <c:pt idx="200">
                  <c:v>0.51796605044595367</c:v>
                </c:pt>
                <c:pt idx="201">
                  <c:v>0.10390217750361004</c:v>
                </c:pt>
                <c:pt idx="202">
                  <c:v>0.43605430761730946</c:v>
                </c:pt>
                <c:pt idx="203">
                  <c:v>0.66895001167809554</c:v>
                </c:pt>
                <c:pt idx="204">
                  <c:v>2.2660956236213142E-2</c:v>
                </c:pt>
                <c:pt idx="205">
                  <c:v>0.63353043852950297</c:v>
                </c:pt>
                <c:pt idx="206">
                  <c:v>1.1525411531900939E-2</c:v>
                </c:pt>
                <c:pt idx="207">
                  <c:v>0.90577384992072207</c:v>
                </c:pt>
                <c:pt idx="208">
                  <c:v>1.9900627665376314</c:v>
                </c:pt>
                <c:pt idx="209">
                  <c:v>8.8718340539638216E-2</c:v>
                </c:pt>
                <c:pt idx="210">
                  <c:v>0.83930972953167637</c:v>
                </c:pt>
                <c:pt idx="211">
                  <c:v>0.61580783351946899</c:v>
                </c:pt>
                <c:pt idx="212">
                  <c:v>1.0073759378706371</c:v>
                </c:pt>
                <c:pt idx="213">
                  <c:v>0.15286248148412629</c:v>
                </c:pt>
                <c:pt idx="214">
                  <c:v>0.88534483946227527</c:v>
                </c:pt>
                <c:pt idx="215">
                  <c:v>0.19648619591836453</c:v>
                </c:pt>
                <c:pt idx="216">
                  <c:v>7.992253994933804E-2</c:v>
                </c:pt>
                <c:pt idx="217">
                  <c:v>0.46532078402906218</c:v>
                </c:pt>
                <c:pt idx="218">
                  <c:v>0.9669970887114171</c:v>
                </c:pt>
                <c:pt idx="219">
                  <c:v>0.3911824492182418</c:v>
                </c:pt>
                <c:pt idx="220">
                  <c:v>0.54640112426881593</c:v>
                </c:pt>
                <c:pt idx="221">
                  <c:v>0.65179062365294615</c:v>
                </c:pt>
                <c:pt idx="222">
                  <c:v>0.23662954056961294</c:v>
                </c:pt>
                <c:pt idx="223">
                  <c:v>0.98733285784949021</c:v>
                </c:pt>
                <c:pt idx="224">
                  <c:v>0.4185798088055846</c:v>
                </c:pt>
                <c:pt idx="225">
                  <c:v>0.80642652200830933</c:v>
                </c:pt>
                <c:pt idx="226">
                  <c:v>0.85519045169063235</c:v>
                </c:pt>
                <c:pt idx="227">
                  <c:v>8.405988395987822E-2</c:v>
                </c:pt>
                <c:pt idx="228">
                  <c:v>0.20354488752573871</c:v>
                </c:pt>
                <c:pt idx="229">
                  <c:v>0.1489395764577785</c:v>
                </c:pt>
                <c:pt idx="230">
                  <c:v>0.33326940827825791</c:v>
                </c:pt>
                <c:pt idx="231">
                  <c:v>1.1139054479457686</c:v>
                </c:pt>
                <c:pt idx="232">
                  <c:v>5.8568629193526046E-2</c:v>
                </c:pt>
                <c:pt idx="233">
                  <c:v>0.26328298028680225</c:v>
                </c:pt>
                <c:pt idx="234">
                  <c:v>0.5977270225300253</c:v>
                </c:pt>
                <c:pt idx="235">
                  <c:v>4.2828058763056821E-2</c:v>
                </c:pt>
                <c:pt idx="236">
                  <c:v>0.92533266139389558</c:v>
                </c:pt>
                <c:pt idx="237">
                  <c:v>0.11456471758306104</c:v>
                </c:pt>
                <c:pt idx="238">
                  <c:v>1.8838651123186331E-2</c:v>
                </c:pt>
                <c:pt idx="239">
                  <c:v>0.10603585481316119</c:v>
                </c:pt>
                <c:pt idx="240">
                  <c:v>1.0418931119605991E-2</c:v>
                </c:pt>
                <c:pt idx="241">
                  <c:v>0.73116895154958961</c:v>
                </c:pt>
                <c:pt idx="242">
                  <c:v>0.77434627178469362</c:v>
                </c:pt>
                <c:pt idx="243">
                  <c:v>0.5597169795713749</c:v>
                </c:pt>
                <c:pt idx="244">
                  <c:v>0.53000255034301147</c:v>
                </c:pt>
                <c:pt idx="245">
                  <c:v>4.3113474297123908E-2</c:v>
                </c:pt>
                <c:pt idx="246">
                  <c:v>0.40397399493308289</c:v>
                </c:pt>
                <c:pt idx="247">
                  <c:v>0.80449869776045035</c:v>
                </c:pt>
                <c:pt idx="248">
                  <c:v>0.35404520907467479</c:v>
                </c:pt>
                <c:pt idx="249">
                  <c:v>1.1521967192981679</c:v>
                </c:pt>
                <c:pt idx="250">
                  <c:v>0.70962748130558839</c:v>
                </c:pt>
                <c:pt idx="251">
                  <c:v>0.51356027718356378</c:v>
                </c:pt>
                <c:pt idx="252">
                  <c:v>0.12851077061142793</c:v>
                </c:pt>
                <c:pt idx="253">
                  <c:v>0.25602877453623696</c:v>
                </c:pt>
                <c:pt idx="254">
                  <c:v>0.13424217803650565</c:v>
                </c:pt>
                <c:pt idx="255">
                  <c:v>0.12145536600229778</c:v>
                </c:pt>
                <c:pt idx="256">
                  <c:v>0.52876215239585456</c:v>
                </c:pt>
                <c:pt idx="257">
                  <c:v>1.3583263199186977</c:v>
                </c:pt>
                <c:pt idx="258">
                  <c:v>0.44813775058744432</c:v>
                </c:pt>
                <c:pt idx="259">
                  <c:v>0.51455267917427971</c:v>
                </c:pt>
                <c:pt idx="260">
                  <c:v>0.3518345801023261</c:v>
                </c:pt>
                <c:pt idx="261">
                  <c:v>0.11546049328275837</c:v>
                </c:pt>
                <c:pt idx="262">
                  <c:v>0.4233442282485565</c:v>
                </c:pt>
                <c:pt idx="263">
                  <c:v>0.10985517753591227</c:v>
                </c:pt>
                <c:pt idx="264">
                  <c:v>7.5233856402600094E-2</c:v>
                </c:pt>
                <c:pt idx="265">
                  <c:v>0.28693760103516591</c:v>
                </c:pt>
                <c:pt idx="266">
                  <c:v>4.3629052378181217E-2</c:v>
                </c:pt>
                <c:pt idx="267">
                  <c:v>0.25862858783313497</c:v>
                </c:pt>
                <c:pt idx="268">
                  <c:v>1.2292470181664219</c:v>
                </c:pt>
                <c:pt idx="269">
                  <c:v>0.46449497030587078</c:v>
                </c:pt>
                <c:pt idx="270">
                  <c:v>0.16386274110998941</c:v>
                </c:pt>
                <c:pt idx="271">
                  <c:v>0.8958248292513098</c:v>
                </c:pt>
                <c:pt idx="272">
                  <c:v>0.62086018117232034</c:v>
                </c:pt>
                <c:pt idx="273">
                  <c:v>0.49645438635336814</c:v>
                </c:pt>
                <c:pt idx="274">
                  <c:v>6.6252919991963588E-2</c:v>
                </c:pt>
                <c:pt idx="275">
                  <c:v>0.57569788235847097</c:v>
                </c:pt>
                <c:pt idx="276">
                  <c:v>1.0228336390547572</c:v>
                </c:pt>
                <c:pt idx="277">
                  <c:v>1.0499408238796584</c:v>
                </c:pt>
                <c:pt idx="278">
                  <c:v>0.60430049714906087</c:v>
                </c:pt>
                <c:pt idx="279">
                  <c:v>0.86975364443398606</c:v>
                </c:pt>
                <c:pt idx="280">
                  <c:v>0.53819153517922536</c:v>
                </c:pt>
                <c:pt idx="281">
                  <c:v>0.48018390021249074</c:v>
                </c:pt>
                <c:pt idx="282">
                  <c:v>2.3459562279333136E-2</c:v>
                </c:pt>
                <c:pt idx="283">
                  <c:v>0.41750737830031648</c:v>
                </c:pt>
                <c:pt idx="284">
                  <c:v>0.15328975831434216</c:v>
                </c:pt>
                <c:pt idx="285">
                  <c:v>3.1445610897488856E-3</c:v>
                </c:pt>
                <c:pt idx="286">
                  <c:v>1.4062898528342478</c:v>
                </c:pt>
                <c:pt idx="287">
                  <c:v>0.73062326334552008</c:v>
                </c:pt>
                <c:pt idx="288">
                  <c:v>0.23294613070164741</c:v>
                </c:pt>
                <c:pt idx="289">
                  <c:v>0.24614354894604895</c:v>
                </c:pt>
                <c:pt idx="290">
                  <c:v>0.10494445192858097</c:v>
                </c:pt>
                <c:pt idx="291">
                  <c:v>3.5692700546176001E-2</c:v>
                </c:pt>
                <c:pt idx="292">
                  <c:v>0.29318262827487718</c:v>
                </c:pt>
                <c:pt idx="293">
                  <c:v>9.345329729899797E-2</c:v>
                </c:pt>
                <c:pt idx="294">
                  <c:v>0.20453349248375918</c:v>
                </c:pt>
                <c:pt idx="295">
                  <c:v>0.97442249578410856</c:v>
                </c:pt>
                <c:pt idx="296">
                  <c:v>0.29389789094975982</c:v>
                </c:pt>
                <c:pt idx="297">
                  <c:v>1.0801210850570904</c:v>
                </c:pt>
                <c:pt idx="298">
                  <c:v>0.48286760358539499</c:v>
                </c:pt>
                <c:pt idx="299">
                  <c:v>0.38327284172729603</c:v>
                </c:pt>
                <c:pt idx="300">
                  <c:v>0.81439978098092736</c:v>
                </c:pt>
                <c:pt idx="301">
                  <c:v>0.1832151375244423</c:v>
                </c:pt>
                <c:pt idx="302">
                  <c:v>0.27580381926079856</c:v>
                </c:pt>
                <c:pt idx="303">
                  <c:v>0.51297274211391086</c:v>
                </c:pt>
                <c:pt idx="304">
                  <c:v>0.51110009971703219</c:v>
                </c:pt>
                <c:pt idx="305">
                  <c:v>0.87935374730872073</c:v>
                </c:pt>
                <c:pt idx="306">
                  <c:v>2.0518113663409828E-2</c:v>
                </c:pt>
                <c:pt idx="307">
                  <c:v>0.53508615811020399</c:v>
                </c:pt>
                <c:pt idx="308">
                  <c:v>0.58552861364565323</c:v>
                </c:pt>
                <c:pt idx="309">
                  <c:v>0.31530482387235637</c:v>
                </c:pt>
                <c:pt idx="310">
                  <c:v>0.25670259644070692</c:v>
                </c:pt>
                <c:pt idx="311">
                  <c:v>0.21951814581751378</c:v>
                </c:pt>
                <c:pt idx="312">
                  <c:v>1.484476064016661</c:v>
                </c:pt>
                <c:pt idx="313">
                  <c:v>1.1324427600963567</c:v>
                </c:pt>
                <c:pt idx="314">
                  <c:v>0.33169288615616732</c:v>
                </c:pt>
                <c:pt idx="315">
                  <c:v>0.52584986281381718</c:v>
                </c:pt>
                <c:pt idx="316">
                  <c:v>0.1675983350469385</c:v>
                </c:pt>
                <c:pt idx="317">
                  <c:v>0.21374853537433422</c:v>
                </c:pt>
                <c:pt idx="318">
                  <c:v>0.36578402161086132</c:v>
                </c:pt>
                <c:pt idx="319">
                  <c:v>1.1429057960796813</c:v>
                </c:pt>
                <c:pt idx="320">
                  <c:v>0.75556430855595003</c:v>
                </c:pt>
                <c:pt idx="321">
                  <c:v>0.17375343209850463</c:v>
                </c:pt>
                <c:pt idx="322">
                  <c:v>0.47142467831649343</c:v>
                </c:pt>
                <c:pt idx="323">
                  <c:v>0.93294728606070354</c:v>
                </c:pt>
                <c:pt idx="324">
                  <c:v>0.70462168974684369</c:v>
                </c:pt>
                <c:pt idx="325">
                  <c:v>0.41099742628739572</c:v>
                </c:pt>
                <c:pt idx="326">
                  <c:v>0.37989567100264948</c:v>
                </c:pt>
                <c:pt idx="327">
                  <c:v>0.35592687366943293</c:v>
                </c:pt>
                <c:pt idx="328">
                  <c:v>0.39656591723028234</c:v>
                </c:pt>
                <c:pt idx="329">
                  <c:v>1.170917254901638</c:v>
                </c:pt>
                <c:pt idx="330">
                  <c:v>0.28655472481521899</c:v>
                </c:pt>
                <c:pt idx="331">
                  <c:v>0.50343119610059006</c:v>
                </c:pt>
                <c:pt idx="332">
                  <c:v>0.84831624107408132</c:v>
                </c:pt>
                <c:pt idx="333">
                  <c:v>0.27634284407866178</c:v>
                </c:pt>
                <c:pt idx="334">
                  <c:v>8.7744624167047425E-2</c:v>
                </c:pt>
                <c:pt idx="335">
                  <c:v>4.9397103017558459E-2</c:v>
                </c:pt>
                <c:pt idx="336">
                  <c:v>0.35751799924855154</c:v>
                </c:pt>
                <c:pt idx="337">
                  <c:v>1.0396697224958764</c:v>
                </c:pt>
                <c:pt idx="338">
                  <c:v>0.25784927334725843</c:v>
                </c:pt>
                <c:pt idx="339">
                  <c:v>0.32485164601450589</c:v>
                </c:pt>
                <c:pt idx="340">
                  <c:v>0.81434171232265939</c:v>
                </c:pt>
                <c:pt idx="341">
                  <c:v>4.2345304789300001E-2</c:v>
                </c:pt>
                <c:pt idx="342">
                  <c:v>0.17262106255843601</c:v>
                </c:pt>
                <c:pt idx="343">
                  <c:v>9.3094493357878796E-2</c:v>
                </c:pt>
                <c:pt idx="344">
                  <c:v>0.5917431797740329</c:v>
                </c:pt>
                <c:pt idx="345">
                  <c:v>0.36610472223852619</c:v>
                </c:pt>
                <c:pt idx="346">
                  <c:v>0.31762632987137057</c:v>
                </c:pt>
                <c:pt idx="347">
                  <c:v>0.54180587667825475</c:v>
                </c:pt>
                <c:pt idx="348">
                  <c:v>0.96636870773708283</c:v>
                </c:pt>
                <c:pt idx="349">
                  <c:v>0.20855951932850206</c:v>
                </c:pt>
                <c:pt idx="350">
                  <c:v>0.26385424526916851</c:v>
                </c:pt>
                <c:pt idx="351">
                  <c:v>0.82960491144429593</c:v>
                </c:pt>
                <c:pt idx="352">
                  <c:v>0.78585690602514513</c:v>
                </c:pt>
                <c:pt idx="353">
                  <c:v>0.12482103424311404</c:v>
                </c:pt>
                <c:pt idx="354">
                  <c:v>0.31912245153077645</c:v>
                </c:pt>
                <c:pt idx="355">
                  <c:v>1.0790250923985294</c:v>
                </c:pt>
                <c:pt idx="356">
                  <c:v>1.1399009977629353</c:v>
                </c:pt>
                <c:pt idx="357">
                  <c:v>7.0654013167623334E-2</c:v>
                </c:pt>
                <c:pt idx="358">
                  <c:v>1.2606060219154624E-2</c:v>
                </c:pt>
                <c:pt idx="359">
                  <c:v>0.61612254118647225</c:v>
                </c:pt>
                <c:pt idx="360">
                  <c:v>0.16748337133092028</c:v>
                </c:pt>
                <c:pt idx="361">
                  <c:v>0.31860231631229985</c:v>
                </c:pt>
                <c:pt idx="362">
                  <c:v>3.1277716386164008E-2</c:v>
                </c:pt>
                <c:pt idx="363">
                  <c:v>1.3941070058134499</c:v>
                </c:pt>
                <c:pt idx="364">
                  <c:v>0.39280235173118089</c:v>
                </c:pt>
                <c:pt idx="365">
                  <c:v>0.29130115264136192</c:v>
                </c:pt>
                <c:pt idx="366">
                  <c:v>2.0211080592289061E-2</c:v>
                </c:pt>
                <c:pt idx="367">
                  <c:v>1.0158488427107442</c:v>
                </c:pt>
                <c:pt idx="368">
                  <c:v>2.0133082234254536</c:v>
                </c:pt>
                <c:pt idx="369">
                  <c:v>0.33846656083167076</c:v>
                </c:pt>
                <c:pt idx="370">
                  <c:v>8.9826283472048532E-2</c:v>
                </c:pt>
                <c:pt idx="371">
                  <c:v>4.6018894320591232E-2</c:v>
                </c:pt>
                <c:pt idx="372">
                  <c:v>0.57106716343923336</c:v>
                </c:pt>
                <c:pt idx="373">
                  <c:v>0.89651849772948322</c:v>
                </c:pt>
                <c:pt idx="374">
                  <c:v>0.55060452692952522</c:v>
                </c:pt>
                <c:pt idx="375">
                  <c:v>1.9112825401727596</c:v>
                </c:pt>
                <c:pt idx="376">
                  <c:v>4.2441384720501463E-2</c:v>
                </c:pt>
                <c:pt idx="377">
                  <c:v>0.12750965443089288</c:v>
                </c:pt>
                <c:pt idx="378">
                  <c:v>0.2837738348065228</c:v>
                </c:pt>
                <c:pt idx="379">
                  <c:v>0.15854402365538275</c:v>
                </c:pt>
                <c:pt idx="380">
                  <c:v>0.59581108803620164</c:v>
                </c:pt>
                <c:pt idx="381">
                  <c:v>0.62012944660648572</c:v>
                </c:pt>
                <c:pt idx="382">
                  <c:v>0.16483091513307024</c:v>
                </c:pt>
                <c:pt idx="383">
                  <c:v>0.20079289080443291</c:v>
                </c:pt>
                <c:pt idx="384">
                  <c:v>0.29955526068989791</c:v>
                </c:pt>
                <c:pt idx="385">
                  <c:v>0.37930604801680251</c:v>
                </c:pt>
                <c:pt idx="386">
                  <c:v>0.51258770850501278</c:v>
                </c:pt>
                <c:pt idx="387">
                  <c:v>0.2732104320571917</c:v>
                </c:pt>
                <c:pt idx="388">
                  <c:v>7.6525298704856456E-2</c:v>
                </c:pt>
                <c:pt idx="389">
                  <c:v>0.69620392243178875</c:v>
                </c:pt>
                <c:pt idx="390">
                  <c:v>0.42544896851276959</c:v>
                </c:pt>
                <c:pt idx="391">
                  <c:v>0.42625567963051569</c:v>
                </c:pt>
                <c:pt idx="392">
                  <c:v>0.53359222782685223</c:v>
                </c:pt>
                <c:pt idx="393">
                  <c:v>0.59611653290958988</c:v>
                </c:pt>
                <c:pt idx="394">
                  <c:v>0.2286750811008143</c:v>
                </c:pt>
                <c:pt idx="395">
                  <c:v>0.54696410101794157</c:v>
                </c:pt>
                <c:pt idx="396">
                  <c:v>0.76712876843942945</c:v>
                </c:pt>
                <c:pt idx="397">
                  <c:v>0.10730345419881479</c:v>
                </c:pt>
                <c:pt idx="398">
                  <c:v>1.0246104677972261</c:v>
                </c:pt>
                <c:pt idx="399">
                  <c:v>0.31488524849735761</c:v>
                </c:pt>
                <c:pt idx="400">
                  <c:v>0.67133884430348301</c:v>
                </c:pt>
                <c:pt idx="401">
                  <c:v>0.74851640418496423</c:v>
                </c:pt>
                <c:pt idx="402">
                  <c:v>1.3555359690715154</c:v>
                </c:pt>
                <c:pt idx="403">
                  <c:v>0.95747692134390083</c:v>
                </c:pt>
                <c:pt idx="404">
                  <c:v>0.45115293239725396</c:v>
                </c:pt>
                <c:pt idx="405">
                  <c:v>8.5607688784785113E-2</c:v>
                </c:pt>
                <c:pt idx="406">
                  <c:v>0.65590686807820653</c:v>
                </c:pt>
                <c:pt idx="407">
                  <c:v>0.48449676714086415</c:v>
                </c:pt>
                <c:pt idx="408">
                  <c:v>0.25784057145641937</c:v>
                </c:pt>
                <c:pt idx="409">
                  <c:v>0.76088521403482134</c:v>
                </c:pt>
                <c:pt idx="410">
                  <c:v>1.1719375757349371</c:v>
                </c:pt>
                <c:pt idx="411">
                  <c:v>1.1726981945726279E-2</c:v>
                </c:pt>
                <c:pt idx="412">
                  <c:v>0.36243457816582969</c:v>
                </c:pt>
                <c:pt idx="413">
                  <c:v>0.33521399474622854</c:v>
                </c:pt>
                <c:pt idx="414">
                  <c:v>0.5321192024382202</c:v>
                </c:pt>
                <c:pt idx="415">
                  <c:v>1.1435685804152418</c:v>
                </c:pt>
                <c:pt idx="416">
                  <c:v>0.13343764728252991</c:v>
                </c:pt>
                <c:pt idx="417">
                  <c:v>0.18304743470191515</c:v>
                </c:pt>
                <c:pt idx="418">
                  <c:v>0.6375481513531962</c:v>
                </c:pt>
                <c:pt idx="419">
                  <c:v>0.13946733893878493</c:v>
                </c:pt>
                <c:pt idx="420">
                  <c:v>4.4637626086661561E-3</c:v>
                </c:pt>
                <c:pt idx="421">
                  <c:v>0.20125658314434391</c:v>
                </c:pt>
                <c:pt idx="422">
                  <c:v>0.18181348117937246</c:v>
                </c:pt>
                <c:pt idx="423">
                  <c:v>0.77115424847859226</c:v>
                </c:pt>
                <c:pt idx="424">
                  <c:v>0.79544956668849942</c:v>
                </c:pt>
                <c:pt idx="425">
                  <c:v>0.24048815942242485</c:v>
                </c:pt>
                <c:pt idx="426">
                  <c:v>1.6995099217327951</c:v>
                </c:pt>
                <c:pt idx="427">
                  <c:v>0.80208060069734954</c:v>
                </c:pt>
                <c:pt idx="428">
                  <c:v>0.61627388211952205</c:v>
                </c:pt>
                <c:pt idx="429">
                  <c:v>3.9354632063914603E-2</c:v>
                </c:pt>
                <c:pt idx="430">
                  <c:v>0.68861025785112229</c:v>
                </c:pt>
                <c:pt idx="431">
                  <c:v>0.18118086734932895</c:v>
                </c:pt>
                <c:pt idx="432">
                  <c:v>1.6618466463641766</c:v>
                </c:pt>
                <c:pt idx="433">
                  <c:v>0.53919628359630467</c:v>
                </c:pt>
                <c:pt idx="434">
                  <c:v>0.65881448129352183</c:v>
                </c:pt>
                <c:pt idx="435">
                  <c:v>0.45213174770098941</c:v>
                </c:pt>
                <c:pt idx="436">
                  <c:v>4.3783425943853477E-3</c:v>
                </c:pt>
                <c:pt idx="437">
                  <c:v>0.14162472695174974</c:v>
                </c:pt>
                <c:pt idx="438">
                  <c:v>0.52452980121916359</c:v>
                </c:pt>
                <c:pt idx="439">
                  <c:v>0.65296603136892128</c:v>
                </c:pt>
                <c:pt idx="440">
                  <c:v>4.0347345498453931E-3</c:v>
                </c:pt>
                <c:pt idx="441">
                  <c:v>0.58608189069673478</c:v>
                </c:pt>
                <c:pt idx="442">
                  <c:v>0.82078924129320774</c:v>
                </c:pt>
                <c:pt idx="443">
                  <c:v>0.12372835091144775</c:v>
                </c:pt>
                <c:pt idx="444">
                  <c:v>0.63868409916180657</c:v>
                </c:pt>
                <c:pt idx="445">
                  <c:v>1.5879818146195399</c:v>
                </c:pt>
                <c:pt idx="446">
                  <c:v>0.42449437712588078</c:v>
                </c:pt>
                <c:pt idx="447">
                  <c:v>0.16401001851504221</c:v>
                </c:pt>
                <c:pt idx="448">
                  <c:v>8.5125615983708214E-2</c:v>
                </c:pt>
                <c:pt idx="449">
                  <c:v>5.0270479173532577E-2</c:v>
                </c:pt>
                <c:pt idx="450">
                  <c:v>3.0050707526593012E-2</c:v>
                </c:pt>
                <c:pt idx="451">
                  <c:v>1.1401936819386966</c:v>
                </c:pt>
                <c:pt idx="452">
                  <c:v>0.35886265375608278</c:v>
                </c:pt>
                <c:pt idx="453">
                  <c:v>0.32142483420542783</c:v>
                </c:pt>
                <c:pt idx="454">
                  <c:v>0.82855745474508291</c:v>
                </c:pt>
                <c:pt idx="455">
                  <c:v>0.42268874682709318</c:v>
                </c:pt>
                <c:pt idx="456">
                  <c:v>0.36712068273052434</c:v>
                </c:pt>
                <c:pt idx="457">
                  <c:v>0.55891764040851133</c:v>
                </c:pt>
                <c:pt idx="458">
                  <c:v>0.58932241864353385</c:v>
                </c:pt>
                <c:pt idx="459">
                  <c:v>1.0683520032714238</c:v>
                </c:pt>
                <c:pt idx="460">
                  <c:v>1.0177660864035312</c:v>
                </c:pt>
                <c:pt idx="461">
                  <c:v>0.70654948104573911</c:v>
                </c:pt>
                <c:pt idx="462">
                  <c:v>0.24467536984960694</c:v>
                </c:pt>
                <c:pt idx="463">
                  <c:v>8.6403097983351849E-3</c:v>
                </c:pt>
                <c:pt idx="464">
                  <c:v>3.868559979693334E-2</c:v>
                </c:pt>
                <c:pt idx="465">
                  <c:v>3.1747033512668658E-2</c:v>
                </c:pt>
                <c:pt idx="466">
                  <c:v>0.65085623820966076</c:v>
                </c:pt>
                <c:pt idx="467">
                  <c:v>0.22229831538591502</c:v>
                </c:pt>
                <c:pt idx="468">
                  <c:v>0.49325402472561153</c:v>
                </c:pt>
                <c:pt idx="469">
                  <c:v>0.25373441936264002</c:v>
                </c:pt>
                <c:pt idx="470">
                  <c:v>0.81346696906508598</c:v>
                </c:pt>
                <c:pt idx="471">
                  <c:v>0.44623043244408728</c:v>
                </c:pt>
                <c:pt idx="472">
                  <c:v>0.68322920813299481</c:v>
                </c:pt>
                <c:pt idx="473">
                  <c:v>0.11732577693441636</c:v>
                </c:pt>
                <c:pt idx="474">
                  <c:v>0.55272623378794861</c:v>
                </c:pt>
                <c:pt idx="475">
                  <c:v>0.86144557073305161</c:v>
                </c:pt>
                <c:pt idx="476">
                  <c:v>1.3310442392690163</c:v>
                </c:pt>
                <c:pt idx="477">
                  <c:v>0.53884005446441763</c:v>
                </c:pt>
                <c:pt idx="478">
                  <c:v>0.75830097953355546</c:v>
                </c:pt>
                <c:pt idx="479">
                  <c:v>0.64627684704117849</c:v>
                </c:pt>
                <c:pt idx="480">
                  <c:v>0.95807580754006771</c:v>
                </c:pt>
                <c:pt idx="481">
                  <c:v>1.1391514216360515E-2</c:v>
                </c:pt>
                <c:pt idx="482">
                  <c:v>1.1676826345082987</c:v>
                </c:pt>
                <c:pt idx="483">
                  <c:v>1.1585202531930003E-2</c:v>
                </c:pt>
                <c:pt idx="484">
                  <c:v>1.1716612078814987</c:v>
                </c:pt>
                <c:pt idx="485">
                  <c:v>0.74689055875107668</c:v>
                </c:pt>
                <c:pt idx="486">
                  <c:v>0.96980404866444314</c:v>
                </c:pt>
                <c:pt idx="487">
                  <c:v>0.58312582979299599</c:v>
                </c:pt>
                <c:pt idx="488">
                  <c:v>1.3411358779138414</c:v>
                </c:pt>
                <c:pt idx="489">
                  <c:v>5.6223689681477687E-2</c:v>
                </c:pt>
                <c:pt idx="490">
                  <c:v>0.26584857209296725</c:v>
                </c:pt>
                <c:pt idx="491">
                  <c:v>0.84960816450894916</c:v>
                </c:pt>
                <c:pt idx="492">
                  <c:v>8.4701644553709481E-3</c:v>
                </c:pt>
                <c:pt idx="493">
                  <c:v>0.12684445505078645</c:v>
                </c:pt>
                <c:pt idx="494">
                  <c:v>0.86017107716647179</c:v>
                </c:pt>
                <c:pt idx="495">
                  <c:v>2.283730460130613</c:v>
                </c:pt>
                <c:pt idx="496">
                  <c:v>0.41970490928686749</c:v>
                </c:pt>
                <c:pt idx="497">
                  <c:v>0.18906971742940662</c:v>
                </c:pt>
                <c:pt idx="498">
                  <c:v>0.58145259191712872</c:v>
                </c:pt>
                <c:pt idx="499">
                  <c:v>0.83927353392121462</c:v>
                </c:pt>
                <c:pt idx="500">
                  <c:v>3.9274398000881602E-2</c:v>
                </c:pt>
                <c:pt idx="501">
                  <c:v>0.8659605030032349</c:v>
                </c:pt>
                <c:pt idx="502">
                  <c:v>0.94774582079264025</c:v>
                </c:pt>
                <c:pt idx="503">
                  <c:v>8.8059258577702873E-2</c:v>
                </c:pt>
                <c:pt idx="504">
                  <c:v>0.59678333541906259</c:v>
                </c:pt>
                <c:pt idx="505">
                  <c:v>0.10942260645194719</c:v>
                </c:pt>
                <c:pt idx="506">
                  <c:v>6.8434428982320716E-2</c:v>
                </c:pt>
                <c:pt idx="507">
                  <c:v>1.0724733049248292</c:v>
                </c:pt>
                <c:pt idx="508">
                  <c:v>0.49189803966884471</c:v>
                </c:pt>
                <c:pt idx="509">
                  <c:v>1.1250104255233178</c:v>
                </c:pt>
                <c:pt idx="510">
                  <c:v>0.12470066867515481</c:v>
                </c:pt>
                <c:pt idx="511">
                  <c:v>2.0440060558909977E-2</c:v>
                </c:pt>
                <c:pt idx="512">
                  <c:v>0.23048779731869706</c:v>
                </c:pt>
                <c:pt idx="513">
                  <c:v>0.11278392471320851</c:v>
                </c:pt>
                <c:pt idx="514">
                  <c:v>0.10008667975597234</c:v>
                </c:pt>
                <c:pt idx="515">
                  <c:v>6.9758518597192815E-2</c:v>
                </c:pt>
                <c:pt idx="516">
                  <c:v>4.7762693191067289E-2</c:v>
                </c:pt>
                <c:pt idx="517">
                  <c:v>0.15822612430695973</c:v>
                </c:pt>
                <c:pt idx="518">
                  <c:v>8.8977585520797001E-2</c:v>
                </c:pt>
                <c:pt idx="519">
                  <c:v>0.42833093101677105</c:v>
                </c:pt>
                <c:pt idx="520">
                  <c:v>0.60096560138605726</c:v>
                </c:pt>
                <c:pt idx="521">
                  <c:v>6.9626364043740216E-2</c:v>
                </c:pt>
                <c:pt idx="522">
                  <c:v>0.15750123961240642</c:v>
                </c:pt>
                <c:pt idx="523">
                  <c:v>0.79752444606730832</c:v>
                </c:pt>
                <c:pt idx="524">
                  <c:v>1.9474935734533669E-2</c:v>
                </c:pt>
                <c:pt idx="525">
                  <c:v>0.72660524564160911</c:v>
                </c:pt>
                <c:pt idx="526">
                  <c:v>0.21952085324246354</c:v>
                </c:pt>
                <c:pt idx="527">
                  <c:v>1.0016135191690747</c:v>
                </c:pt>
                <c:pt idx="528">
                  <c:v>0.23043899186447458</c:v>
                </c:pt>
                <c:pt idx="529">
                  <c:v>0.2734125319426256</c:v>
                </c:pt>
                <c:pt idx="530">
                  <c:v>0.40033041619437792</c:v>
                </c:pt>
                <c:pt idx="531">
                  <c:v>0.10054684067146692</c:v>
                </c:pt>
                <c:pt idx="532">
                  <c:v>0.68614679914286691</c:v>
                </c:pt>
                <c:pt idx="533">
                  <c:v>0.59251229714973352</c:v>
                </c:pt>
                <c:pt idx="534">
                  <c:v>2.7945332160064171</c:v>
                </c:pt>
                <c:pt idx="535">
                  <c:v>1.0749929991361937</c:v>
                </c:pt>
                <c:pt idx="536">
                  <c:v>0.1018069371414458</c:v>
                </c:pt>
                <c:pt idx="537">
                  <c:v>2.1644239458199159</c:v>
                </c:pt>
                <c:pt idx="538">
                  <c:v>0.45160167689712744</c:v>
                </c:pt>
                <c:pt idx="539">
                  <c:v>0.19687537510818587</c:v>
                </c:pt>
                <c:pt idx="540">
                  <c:v>4.8823756992700099E-2</c:v>
                </c:pt>
                <c:pt idx="541">
                  <c:v>0.70400391878174395</c:v>
                </c:pt>
                <c:pt idx="542">
                  <c:v>0.15528327450635696</c:v>
                </c:pt>
                <c:pt idx="543">
                  <c:v>0.4026698214576771</c:v>
                </c:pt>
                <c:pt idx="544">
                  <c:v>0.42332038204371092</c:v>
                </c:pt>
                <c:pt idx="545">
                  <c:v>0.10443146048894549</c:v>
                </c:pt>
                <c:pt idx="546">
                  <c:v>0.40049295070129859</c:v>
                </c:pt>
                <c:pt idx="547">
                  <c:v>0.1602579032485229</c:v>
                </c:pt>
                <c:pt idx="548">
                  <c:v>0.51313394707716764</c:v>
                </c:pt>
                <c:pt idx="549">
                  <c:v>7.8207072298177471E-2</c:v>
                </c:pt>
                <c:pt idx="550">
                  <c:v>0.67221107863503693</c:v>
                </c:pt>
                <c:pt idx="551">
                  <c:v>0.72286037893388333</c:v>
                </c:pt>
                <c:pt idx="552">
                  <c:v>0.89759436255625979</c:v>
                </c:pt>
                <c:pt idx="553">
                  <c:v>0.48868124669195578</c:v>
                </c:pt>
                <c:pt idx="554">
                  <c:v>2.55561393363649</c:v>
                </c:pt>
                <c:pt idx="555">
                  <c:v>0.35554121320932358</c:v>
                </c:pt>
                <c:pt idx="556">
                  <c:v>0.35971598483544293</c:v>
                </c:pt>
                <c:pt idx="557">
                  <c:v>1.3758038002760364</c:v>
                </c:pt>
                <c:pt idx="558">
                  <c:v>0.31660949833159246</c:v>
                </c:pt>
                <c:pt idx="559">
                  <c:v>0.82697691504239568</c:v>
                </c:pt>
                <c:pt idx="560">
                  <c:v>0.1367011768575902</c:v>
                </c:pt>
                <c:pt idx="561">
                  <c:v>1.272779358818003</c:v>
                </c:pt>
                <c:pt idx="562">
                  <c:v>0.69490159078524716</c:v>
                </c:pt>
                <c:pt idx="563">
                  <c:v>0.22914991228692624</c:v>
                </c:pt>
                <c:pt idx="564">
                  <c:v>0.58752283603088484</c:v>
                </c:pt>
                <c:pt idx="565">
                  <c:v>0.5447046627459754</c:v>
                </c:pt>
                <c:pt idx="566">
                  <c:v>0.51290519189029471</c:v>
                </c:pt>
                <c:pt idx="567">
                  <c:v>2.4051686913810935</c:v>
                </c:pt>
                <c:pt idx="568">
                  <c:v>0.89244425842803021</c:v>
                </c:pt>
                <c:pt idx="569">
                  <c:v>9.0439645760886062E-2</c:v>
                </c:pt>
                <c:pt idx="570">
                  <c:v>8.0184677750234037E-2</c:v>
                </c:pt>
                <c:pt idx="571">
                  <c:v>0.40446007218603475</c:v>
                </c:pt>
                <c:pt idx="572">
                  <c:v>0.21122063911150313</c:v>
                </c:pt>
                <c:pt idx="573">
                  <c:v>4.4551105525255603E-2</c:v>
                </c:pt>
                <c:pt idx="574">
                  <c:v>0.29565492924115522</c:v>
                </c:pt>
                <c:pt idx="575">
                  <c:v>0.19316440103546653</c:v>
                </c:pt>
                <c:pt idx="576">
                  <c:v>0.22426582323797642</c:v>
                </c:pt>
                <c:pt idx="577">
                  <c:v>7.852266897546159E-2</c:v>
                </c:pt>
                <c:pt idx="578">
                  <c:v>0.18047679268680031</c:v>
                </c:pt>
                <c:pt idx="579">
                  <c:v>0.4802075280041101</c:v>
                </c:pt>
                <c:pt idx="580">
                  <c:v>4.636673354322688E-2</c:v>
                </c:pt>
                <c:pt idx="581">
                  <c:v>0.25833193222709228</c:v>
                </c:pt>
                <c:pt idx="582">
                  <c:v>1.2949782577910993</c:v>
                </c:pt>
                <c:pt idx="583">
                  <c:v>8.7760704623255081E-2</c:v>
                </c:pt>
                <c:pt idx="584">
                  <c:v>0.75147635699624871</c:v>
                </c:pt>
                <c:pt idx="585">
                  <c:v>0.78406307694535549</c:v>
                </c:pt>
                <c:pt idx="586">
                  <c:v>0.18140461524829282</c:v>
                </c:pt>
                <c:pt idx="587">
                  <c:v>1.2846885494894345</c:v>
                </c:pt>
                <c:pt idx="588">
                  <c:v>0.4196248198657857</c:v>
                </c:pt>
                <c:pt idx="589">
                  <c:v>0.1682060061874561</c:v>
                </c:pt>
                <c:pt idx="590">
                  <c:v>0.26740788503028384</c:v>
                </c:pt>
                <c:pt idx="591">
                  <c:v>0.63334175779973567</c:v>
                </c:pt>
                <c:pt idx="592">
                  <c:v>0.75288883934354167</c:v>
                </c:pt>
                <c:pt idx="593">
                  <c:v>0.11782351849028869</c:v>
                </c:pt>
                <c:pt idx="594">
                  <c:v>0.3585547624722818</c:v>
                </c:pt>
                <c:pt idx="595">
                  <c:v>0.2466574651706222</c:v>
                </c:pt>
                <c:pt idx="596">
                  <c:v>0.6873578103644663</c:v>
                </c:pt>
                <c:pt idx="597">
                  <c:v>7.4035408882821202E-2</c:v>
                </c:pt>
                <c:pt idx="598">
                  <c:v>0.65578578851109648</c:v>
                </c:pt>
                <c:pt idx="599">
                  <c:v>1.0607667798074176</c:v>
                </c:pt>
                <c:pt idx="600">
                  <c:v>4.3207192883265993E-2</c:v>
                </c:pt>
                <c:pt idx="601">
                  <c:v>0.56024025449272041</c:v>
                </c:pt>
                <c:pt idx="602">
                  <c:v>1.3205056596649811</c:v>
                </c:pt>
                <c:pt idx="603">
                  <c:v>0.66890877018768713</c:v>
                </c:pt>
                <c:pt idx="604">
                  <c:v>0.29083266696966303</c:v>
                </c:pt>
                <c:pt idx="605">
                  <c:v>0.93583138803685617</c:v>
                </c:pt>
                <c:pt idx="606">
                  <c:v>0.72901618247566957</c:v>
                </c:pt>
                <c:pt idx="607">
                  <c:v>0.57024479616348667</c:v>
                </c:pt>
                <c:pt idx="608">
                  <c:v>1.067320710885346</c:v>
                </c:pt>
                <c:pt idx="609">
                  <c:v>1.3471028426043852</c:v>
                </c:pt>
                <c:pt idx="610">
                  <c:v>0.29174798453286283</c:v>
                </c:pt>
                <c:pt idx="611">
                  <c:v>0.57760925437560184</c:v>
                </c:pt>
                <c:pt idx="612">
                  <c:v>1.1284995671146385</c:v>
                </c:pt>
                <c:pt idx="613">
                  <c:v>0.10036492701381343</c:v>
                </c:pt>
                <c:pt idx="614">
                  <c:v>1.0348592929415108</c:v>
                </c:pt>
                <c:pt idx="615">
                  <c:v>0.49152794888347429</c:v>
                </c:pt>
                <c:pt idx="616">
                  <c:v>0.595190588547998</c:v>
                </c:pt>
                <c:pt idx="617">
                  <c:v>2.1984196612285858E-2</c:v>
                </c:pt>
                <c:pt idx="618">
                  <c:v>1.2846354669067399</c:v>
                </c:pt>
                <c:pt idx="619">
                  <c:v>1.0672159774543002</c:v>
                </c:pt>
                <c:pt idx="620">
                  <c:v>0.51913058965337522</c:v>
                </c:pt>
                <c:pt idx="621">
                  <c:v>3.9756490443487162E-2</c:v>
                </c:pt>
                <c:pt idx="622">
                  <c:v>0.98421883666348353</c:v>
                </c:pt>
                <c:pt idx="623">
                  <c:v>0.61470509319719036</c:v>
                </c:pt>
                <c:pt idx="624">
                  <c:v>0.19966805884849775</c:v>
                </c:pt>
                <c:pt idx="625">
                  <c:v>0.45109736999208189</c:v>
                </c:pt>
                <c:pt idx="626">
                  <c:v>0.97810722885615875</c:v>
                </c:pt>
                <c:pt idx="627">
                  <c:v>1.4732301303667483</c:v>
                </c:pt>
                <c:pt idx="628">
                  <c:v>0.18714123004118546</c:v>
                </c:pt>
                <c:pt idx="629">
                  <c:v>0.12019581467768366</c:v>
                </c:pt>
                <c:pt idx="630">
                  <c:v>1.7383226370030543E-2</c:v>
                </c:pt>
                <c:pt idx="631">
                  <c:v>2.2037417932018688E-2</c:v>
                </c:pt>
                <c:pt idx="632">
                  <c:v>8.9684675175533107E-2</c:v>
                </c:pt>
                <c:pt idx="633">
                  <c:v>3.8766103180368432E-2</c:v>
                </c:pt>
                <c:pt idx="634">
                  <c:v>0.54706493435103876</c:v>
                </c:pt>
                <c:pt idx="635">
                  <c:v>0.11181507116776701</c:v>
                </c:pt>
                <c:pt idx="636">
                  <c:v>4.9696214333467034E-2</c:v>
                </c:pt>
                <c:pt idx="637">
                  <c:v>8.2731910437594217E-2</c:v>
                </c:pt>
                <c:pt idx="638">
                  <c:v>0.62256570884338791</c:v>
                </c:pt>
                <c:pt idx="639">
                  <c:v>0.9825531354516539</c:v>
                </c:pt>
                <c:pt idx="640">
                  <c:v>0.51767687193526901</c:v>
                </c:pt>
                <c:pt idx="641">
                  <c:v>0.40017276743284957</c:v>
                </c:pt>
                <c:pt idx="642">
                  <c:v>0.20850330650499227</c:v>
                </c:pt>
                <c:pt idx="643">
                  <c:v>0.72250408198623817</c:v>
                </c:pt>
                <c:pt idx="644">
                  <c:v>0.32447615707643168</c:v>
                </c:pt>
                <c:pt idx="645">
                  <c:v>1.083834859028717</c:v>
                </c:pt>
                <c:pt idx="646">
                  <c:v>1.0894615961578507</c:v>
                </c:pt>
                <c:pt idx="647">
                  <c:v>3.8347941247365756E-2</c:v>
                </c:pt>
                <c:pt idx="648">
                  <c:v>1.2589003321146548</c:v>
                </c:pt>
                <c:pt idx="649">
                  <c:v>5.7333287830743707E-2</c:v>
                </c:pt>
                <c:pt idx="650">
                  <c:v>0.30335680538813165</c:v>
                </c:pt>
                <c:pt idx="651">
                  <c:v>0.11187244572096364</c:v>
                </c:pt>
                <c:pt idx="652">
                  <c:v>0.49120729379185402</c:v>
                </c:pt>
                <c:pt idx="653">
                  <c:v>0.41269124874515312</c:v>
                </c:pt>
                <c:pt idx="654">
                  <c:v>0.16307796196110996</c:v>
                </c:pt>
                <c:pt idx="655">
                  <c:v>0.48430214603279487</c:v>
                </c:pt>
                <c:pt idx="656">
                  <c:v>0.29466069700703612</c:v>
                </c:pt>
                <c:pt idx="657">
                  <c:v>1.5113527943449239</c:v>
                </c:pt>
                <c:pt idx="658">
                  <c:v>0.18361092333459572</c:v>
                </c:pt>
                <c:pt idx="659">
                  <c:v>0.164824427669337</c:v>
                </c:pt>
                <c:pt idx="660">
                  <c:v>0.68464967825573275</c:v>
                </c:pt>
                <c:pt idx="661">
                  <c:v>0.47121470090019685</c:v>
                </c:pt>
                <c:pt idx="662">
                  <c:v>0.30905197806135581</c:v>
                </c:pt>
                <c:pt idx="663">
                  <c:v>0.53909614797829708</c:v>
                </c:pt>
                <c:pt idx="664">
                  <c:v>4.7048771400683725E-2</c:v>
                </c:pt>
                <c:pt idx="665">
                  <c:v>0.48106049976664089</c:v>
                </c:pt>
                <c:pt idx="666">
                  <c:v>1.2062150769558342</c:v>
                </c:pt>
                <c:pt idx="667">
                  <c:v>0.20985094096848217</c:v>
                </c:pt>
                <c:pt idx="668">
                  <c:v>1.132543657131051</c:v>
                </c:pt>
                <c:pt idx="669">
                  <c:v>0.1029564775267819</c:v>
                </c:pt>
                <c:pt idx="670">
                  <c:v>0.11922020294466426</c:v>
                </c:pt>
                <c:pt idx="671">
                  <c:v>2.3892724622504906E-2</c:v>
                </c:pt>
                <c:pt idx="672">
                  <c:v>0.67407225415524785</c:v>
                </c:pt>
                <c:pt idx="673">
                  <c:v>0.26318390104866574</c:v>
                </c:pt>
                <c:pt idx="674">
                  <c:v>0.21173841367262333</c:v>
                </c:pt>
                <c:pt idx="675">
                  <c:v>0.28530609925411815</c:v>
                </c:pt>
                <c:pt idx="676">
                  <c:v>1.2683597699566203</c:v>
                </c:pt>
                <c:pt idx="677">
                  <c:v>0.1323777451492523</c:v>
                </c:pt>
                <c:pt idx="678">
                  <c:v>0.36845941842728042</c:v>
                </c:pt>
                <c:pt idx="679">
                  <c:v>0.18246604942319142</c:v>
                </c:pt>
                <c:pt idx="680">
                  <c:v>0.17053596047742145</c:v>
                </c:pt>
                <c:pt idx="681">
                  <c:v>0.11117479394022003</c:v>
                </c:pt>
                <c:pt idx="682">
                  <c:v>0.9927265533476306</c:v>
                </c:pt>
                <c:pt idx="683">
                  <c:v>0.18673139663474678</c:v>
                </c:pt>
                <c:pt idx="684">
                  <c:v>0.59535408925321076</c:v>
                </c:pt>
                <c:pt idx="685">
                  <c:v>6.4970044640671673E-2</c:v>
                </c:pt>
                <c:pt idx="686">
                  <c:v>0.80828763335113407</c:v>
                </c:pt>
                <c:pt idx="687">
                  <c:v>1.0647633657853408</c:v>
                </c:pt>
                <c:pt idx="688">
                  <c:v>0.89968913214594826</c:v>
                </c:pt>
                <c:pt idx="689">
                  <c:v>0.51692167325057958</c:v>
                </c:pt>
                <c:pt idx="690">
                  <c:v>0.50584415407824224</c:v>
                </c:pt>
                <c:pt idx="691">
                  <c:v>1.0465795941445988</c:v>
                </c:pt>
                <c:pt idx="692">
                  <c:v>3.6096790289107852E-2</c:v>
                </c:pt>
                <c:pt idx="693">
                  <c:v>7.5418346385301774E-2</c:v>
                </c:pt>
                <c:pt idx="694">
                  <c:v>0.17674454230948386</c:v>
                </c:pt>
                <c:pt idx="695">
                  <c:v>1.0260074161042791</c:v>
                </c:pt>
                <c:pt idx="696">
                  <c:v>0.25727430316159816</c:v>
                </c:pt>
                <c:pt idx="697">
                  <c:v>0.62971579438642389</c:v>
                </c:pt>
                <c:pt idx="698">
                  <c:v>0.55600735822186187</c:v>
                </c:pt>
                <c:pt idx="699">
                  <c:v>0.39562917517054991</c:v>
                </c:pt>
                <c:pt idx="700">
                  <c:v>0.54627859647379406</c:v>
                </c:pt>
                <c:pt idx="701">
                  <c:v>0.53814195557409694</c:v>
                </c:pt>
                <c:pt idx="702">
                  <c:v>1.0079758485548682</c:v>
                </c:pt>
                <c:pt idx="703">
                  <c:v>1.544036185895554E-2</c:v>
                </c:pt>
                <c:pt idx="704">
                  <c:v>0.43682855939328247</c:v>
                </c:pt>
                <c:pt idx="705">
                  <c:v>0.42967699940919968</c:v>
                </c:pt>
                <c:pt idx="706">
                  <c:v>3.602528718626815E-2</c:v>
                </c:pt>
                <c:pt idx="707">
                  <c:v>0.19094874756851576</c:v>
                </c:pt>
                <c:pt idx="708">
                  <c:v>8.6891395949157246E-3</c:v>
                </c:pt>
                <c:pt idx="709">
                  <c:v>0.18273725404102403</c:v>
                </c:pt>
                <c:pt idx="710">
                  <c:v>0.35175542610685584</c:v>
                </c:pt>
                <c:pt idx="711">
                  <c:v>0.87032762312372502</c:v>
                </c:pt>
                <c:pt idx="712">
                  <c:v>0.48538432559906547</c:v>
                </c:pt>
                <c:pt idx="713">
                  <c:v>1.332531886514418</c:v>
                </c:pt>
                <c:pt idx="714">
                  <c:v>0.2505934834740367</c:v>
                </c:pt>
                <c:pt idx="715">
                  <c:v>1.1321096148922736</c:v>
                </c:pt>
                <c:pt idx="716">
                  <c:v>0.12274819696744244</c:v>
                </c:pt>
                <c:pt idx="717">
                  <c:v>0.53229392420944244</c:v>
                </c:pt>
                <c:pt idx="718">
                  <c:v>0.868319780789224</c:v>
                </c:pt>
                <c:pt idx="719">
                  <c:v>0.41976101950391398</c:v>
                </c:pt>
                <c:pt idx="720">
                  <c:v>0.42531263030526711</c:v>
                </c:pt>
                <c:pt idx="721">
                  <c:v>0.6172376101451017</c:v>
                </c:pt>
                <c:pt idx="722">
                  <c:v>1.162635866740251</c:v>
                </c:pt>
                <c:pt idx="723">
                  <c:v>0.61583103364522229</c:v>
                </c:pt>
                <c:pt idx="724">
                  <c:v>0.31778680320321151</c:v>
                </c:pt>
                <c:pt idx="725">
                  <c:v>0.26990605195545825</c:v>
                </c:pt>
                <c:pt idx="726">
                  <c:v>0.525252409244513</c:v>
                </c:pt>
                <c:pt idx="727">
                  <c:v>1.1967170138683267</c:v>
                </c:pt>
                <c:pt idx="728">
                  <c:v>1.0815453481854249</c:v>
                </c:pt>
                <c:pt idx="729">
                  <c:v>8.4379651126580725E-3</c:v>
                </c:pt>
                <c:pt idx="730">
                  <c:v>0.157773087063588</c:v>
                </c:pt>
                <c:pt idx="731">
                  <c:v>0.36420276958678743</c:v>
                </c:pt>
                <c:pt idx="732">
                  <c:v>0.26218950039902411</c:v>
                </c:pt>
                <c:pt idx="733">
                  <c:v>1.2710992173975413</c:v>
                </c:pt>
                <c:pt idx="734">
                  <c:v>0.98320328078419539</c:v>
                </c:pt>
                <c:pt idx="735">
                  <c:v>0.25561815462666326</c:v>
                </c:pt>
                <c:pt idx="736">
                  <c:v>8.9851438272199574E-2</c:v>
                </c:pt>
                <c:pt idx="737">
                  <c:v>1.1912515187595223</c:v>
                </c:pt>
                <c:pt idx="738">
                  <c:v>1.9404666790188994</c:v>
                </c:pt>
                <c:pt idx="739">
                  <c:v>0.35119813553445722</c:v>
                </c:pt>
                <c:pt idx="740">
                  <c:v>0.16410036844539411</c:v>
                </c:pt>
                <c:pt idx="741">
                  <c:v>1.5858574578284847E-2</c:v>
                </c:pt>
                <c:pt idx="742">
                  <c:v>0.6615624901668038</c:v>
                </c:pt>
                <c:pt idx="743">
                  <c:v>1.2313348556140842</c:v>
                </c:pt>
                <c:pt idx="744">
                  <c:v>1.1969826791936544</c:v>
                </c:pt>
                <c:pt idx="745">
                  <c:v>1.5315790344521369</c:v>
                </c:pt>
                <c:pt idx="746">
                  <c:v>0.39122712316806713</c:v>
                </c:pt>
                <c:pt idx="747">
                  <c:v>0.25082681886167918</c:v>
                </c:pt>
                <c:pt idx="748">
                  <c:v>0.21513713645114454</c:v>
                </c:pt>
                <c:pt idx="749">
                  <c:v>1.7875852585090935E-2</c:v>
                </c:pt>
                <c:pt idx="750">
                  <c:v>1.0216872457268737E-2</c:v>
                </c:pt>
                <c:pt idx="751">
                  <c:v>1.1030968267536911</c:v>
                </c:pt>
                <c:pt idx="752">
                  <c:v>1.0591042209717387</c:v>
                </c:pt>
                <c:pt idx="753">
                  <c:v>0.41353764285967232</c:v>
                </c:pt>
                <c:pt idx="754">
                  <c:v>0.80814666409188474</c:v>
                </c:pt>
                <c:pt idx="755">
                  <c:v>0.72793338713203737</c:v>
                </c:pt>
                <c:pt idx="756">
                  <c:v>0.22473055572959574</c:v>
                </c:pt>
                <c:pt idx="757">
                  <c:v>0.64353343609025837</c:v>
                </c:pt>
                <c:pt idx="758">
                  <c:v>0.16733014983448297</c:v>
                </c:pt>
                <c:pt idx="759">
                  <c:v>2.1454818948061918E-2</c:v>
                </c:pt>
                <c:pt idx="760">
                  <c:v>0.50363766094285622</c:v>
                </c:pt>
                <c:pt idx="761">
                  <c:v>0.64251233495671034</c:v>
                </c:pt>
                <c:pt idx="762">
                  <c:v>0.22009414656270473</c:v>
                </c:pt>
                <c:pt idx="763">
                  <c:v>0.16233041313068711</c:v>
                </c:pt>
                <c:pt idx="764">
                  <c:v>0.39989965603929839</c:v>
                </c:pt>
                <c:pt idx="765">
                  <c:v>0.94389150613743578</c:v>
                </c:pt>
                <c:pt idx="766">
                  <c:v>0.59340388622276052</c:v>
                </c:pt>
                <c:pt idx="767">
                  <c:v>0.14049458334256198</c:v>
                </c:pt>
                <c:pt idx="768">
                  <c:v>1.0155411979702909</c:v>
                </c:pt>
                <c:pt idx="769">
                  <c:v>0.4261818571931737</c:v>
                </c:pt>
                <c:pt idx="770">
                  <c:v>0.40034867279843811</c:v>
                </c:pt>
                <c:pt idx="771">
                  <c:v>0.34084481115552301</c:v>
                </c:pt>
                <c:pt idx="772">
                  <c:v>0.64865636254355952</c:v>
                </c:pt>
                <c:pt idx="773">
                  <c:v>0.74551006744455206</c:v>
                </c:pt>
                <c:pt idx="774">
                  <c:v>0.30748086545555947</c:v>
                </c:pt>
                <c:pt idx="775">
                  <c:v>0.72815393419875551</c:v>
                </c:pt>
                <c:pt idx="776">
                  <c:v>8.3340830486985391E-3</c:v>
                </c:pt>
                <c:pt idx="777">
                  <c:v>0.37613918234657789</c:v>
                </c:pt>
                <c:pt idx="778">
                  <c:v>0.51972144334088566</c:v>
                </c:pt>
                <c:pt idx="779">
                  <c:v>3.1644522500621388</c:v>
                </c:pt>
                <c:pt idx="780">
                  <c:v>0.55208388239478534</c:v>
                </c:pt>
                <c:pt idx="781">
                  <c:v>0.33228370591745021</c:v>
                </c:pt>
                <c:pt idx="782">
                  <c:v>0.36674489786518838</c:v>
                </c:pt>
                <c:pt idx="783">
                  <c:v>1.8358939736741504</c:v>
                </c:pt>
                <c:pt idx="784">
                  <c:v>0.21070520674050561</c:v>
                </c:pt>
                <c:pt idx="785">
                  <c:v>1.1557495922241685</c:v>
                </c:pt>
                <c:pt idx="786">
                  <c:v>4.970694615997192E-2</c:v>
                </c:pt>
                <c:pt idx="787">
                  <c:v>0.32763339898450161</c:v>
                </c:pt>
                <c:pt idx="788">
                  <c:v>0.12509787309536646</c:v>
                </c:pt>
                <c:pt idx="789">
                  <c:v>0.10840978825275359</c:v>
                </c:pt>
                <c:pt idx="790">
                  <c:v>0.21753013633432911</c:v>
                </c:pt>
                <c:pt idx="791">
                  <c:v>0.22845993437951692</c:v>
                </c:pt>
                <c:pt idx="792">
                  <c:v>0.52908654208198436</c:v>
                </c:pt>
                <c:pt idx="793">
                  <c:v>0.3094996466395048</c:v>
                </c:pt>
                <c:pt idx="794">
                  <c:v>0.72256386930643057</c:v>
                </c:pt>
                <c:pt idx="795">
                  <c:v>0.52173043456087798</c:v>
                </c:pt>
                <c:pt idx="796">
                  <c:v>0.38824288138620305</c:v>
                </c:pt>
                <c:pt idx="797">
                  <c:v>0.22151835533089928</c:v>
                </c:pt>
                <c:pt idx="798">
                  <c:v>0.16946408763009282</c:v>
                </c:pt>
                <c:pt idx="799">
                  <c:v>0.52183697986749777</c:v>
                </c:pt>
                <c:pt idx="800">
                  <c:v>0.74454732397796641</c:v>
                </c:pt>
                <c:pt idx="801">
                  <c:v>1.287562983029759</c:v>
                </c:pt>
                <c:pt idx="802">
                  <c:v>0.36764687825388298</c:v>
                </c:pt>
                <c:pt idx="803">
                  <c:v>0.19665451153389929</c:v>
                </c:pt>
                <c:pt idx="804">
                  <c:v>0.48195990533120692</c:v>
                </c:pt>
                <c:pt idx="805">
                  <c:v>0.90160298978557352</c:v>
                </c:pt>
                <c:pt idx="806">
                  <c:v>0.20999408209750553</c:v>
                </c:pt>
                <c:pt idx="807">
                  <c:v>0.36856103993761469</c:v>
                </c:pt>
                <c:pt idx="808">
                  <c:v>0.22860723903113134</c:v>
                </c:pt>
                <c:pt idx="809">
                  <c:v>0.16790631888220575</c:v>
                </c:pt>
                <c:pt idx="810">
                  <c:v>0.84502295826541185</c:v>
                </c:pt>
                <c:pt idx="811">
                  <c:v>1.3870794091691363</c:v>
                </c:pt>
                <c:pt idx="812">
                  <c:v>0.36717224651487479</c:v>
                </c:pt>
                <c:pt idx="813">
                  <c:v>0.79176833970895955</c:v>
                </c:pt>
                <c:pt idx="814">
                  <c:v>0.13161231979171553</c:v>
                </c:pt>
                <c:pt idx="815">
                  <c:v>0.52134278930293509</c:v>
                </c:pt>
                <c:pt idx="816">
                  <c:v>0.20686820882602575</c:v>
                </c:pt>
                <c:pt idx="817">
                  <c:v>1.1870004923621942</c:v>
                </c:pt>
                <c:pt idx="818">
                  <c:v>7.856396292626E-2</c:v>
                </c:pt>
                <c:pt idx="819">
                  <c:v>0.42700029836617759</c:v>
                </c:pt>
                <c:pt idx="820">
                  <c:v>0.98628589609933659</c:v>
                </c:pt>
                <c:pt idx="821">
                  <c:v>0.99891688600835871</c:v>
                </c:pt>
                <c:pt idx="822">
                  <c:v>1.4343997487590352</c:v>
                </c:pt>
                <c:pt idx="823">
                  <c:v>0.2167973616717577</c:v>
                </c:pt>
                <c:pt idx="824">
                  <c:v>0.37810923369100824</c:v>
                </c:pt>
                <c:pt idx="825">
                  <c:v>6.3145441741056144E-2</c:v>
                </c:pt>
                <c:pt idx="826">
                  <c:v>0.91613963570932078</c:v>
                </c:pt>
                <c:pt idx="827">
                  <c:v>0.22990188174323334</c:v>
                </c:pt>
                <c:pt idx="828">
                  <c:v>0.46101142602994699</c:v>
                </c:pt>
                <c:pt idx="829">
                  <c:v>3.2697715889683567</c:v>
                </c:pt>
                <c:pt idx="830">
                  <c:v>0.16147453395972106</c:v>
                </c:pt>
                <c:pt idx="831">
                  <c:v>0.25768301639512869</c:v>
                </c:pt>
                <c:pt idx="832">
                  <c:v>0.20502226133946308</c:v>
                </c:pt>
                <c:pt idx="833">
                  <c:v>1.8716297472860308</c:v>
                </c:pt>
                <c:pt idx="834">
                  <c:v>0.11029329052865246</c:v>
                </c:pt>
                <c:pt idx="835">
                  <c:v>0.56723312756193311</c:v>
                </c:pt>
                <c:pt idx="836">
                  <c:v>9.6963202006469212E-2</c:v>
                </c:pt>
                <c:pt idx="837">
                  <c:v>0.6236939148945807</c:v>
                </c:pt>
                <c:pt idx="838">
                  <c:v>1.0677785377654571E-2</c:v>
                </c:pt>
                <c:pt idx="839">
                  <c:v>0.77113649290667619</c:v>
                </c:pt>
                <c:pt idx="840">
                  <c:v>0.53846950375630509</c:v>
                </c:pt>
                <c:pt idx="841">
                  <c:v>9.571517114601652E-2</c:v>
                </c:pt>
                <c:pt idx="842">
                  <c:v>3.0074039093090778E-2</c:v>
                </c:pt>
                <c:pt idx="843">
                  <c:v>0.3894359735247418</c:v>
                </c:pt>
                <c:pt idx="844">
                  <c:v>0.13781423023434408</c:v>
                </c:pt>
                <c:pt idx="845">
                  <c:v>0.95240620089065431</c:v>
                </c:pt>
                <c:pt idx="846">
                  <c:v>0.36251065013341399</c:v>
                </c:pt>
                <c:pt idx="847">
                  <c:v>1.139283036810953</c:v>
                </c:pt>
                <c:pt idx="848">
                  <c:v>2.6683237256242637E-2</c:v>
                </c:pt>
                <c:pt idx="849">
                  <c:v>0.41759558807892361</c:v>
                </c:pt>
                <c:pt idx="850">
                  <c:v>0.14662342326456038</c:v>
                </c:pt>
                <c:pt idx="851">
                  <c:v>0.63626372979914358</c:v>
                </c:pt>
                <c:pt idx="852">
                  <c:v>0.15550076758540099</c:v>
                </c:pt>
                <c:pt idx="853">
                  <c:v>0.86341168527868828</c:v>
                </c:pt>
                <c:pt idx="854">
                  <c:v>0.62926263551683126</c:v>
                </c:pt>
                <c:pt idx="855">
                  <c:v>0.85164819696114191</c:v>
                </c:pt>
                <c:pt idx="856">
                  <c:v>2.4304722727324021E-2</c:v>
                </c:pt>
                <c:pt idx="857">
                  <c:v>0.58545497074243413</c:v>
                </c:pt>
                <c:pt idx="858">
                  <c:v>0.1799152108468961</c:v>
                </c:pt>
                <c:pt idx="859">
                  <c:v>5.5400078551565791E-2</c:v>
                </c:pt>
                <c:pt idx="860">
                  <c:v>5.4543060781349064E-3</c:v>
                </c:pt>
                <c:pt idx="861">
                  <c:v>1.0842352490713154</c:v>
                </c:pt>
                <c:pt idx="862">
                  <c:v>0.38961627772122792</c:v>
                </c:pt>
                <c:pt idx="863">
                  <c:v>0.27774744302711468</c:v>
                </c:pt>
                <c:pt idx="864">
                  <c:v>0.2829939985612579</c:v>
                </c:pt>
                <c:pt idx="865">
                  <c:v>0.15906902999928116</c:v>
                </c:pt>
                <c:pt idx="866">
                  <c:v>0.28144050342941407</c:v>
                </c:pt>
                <c:pt idx="867">
                  <c:v>9.4460938930828152E-3</c:v>
                </c:pt>
                <c:pt idx="868">
                  <c:v>0.6233090846709326</c:v>
                </c:pt>
                <c:pt idx="869">
                  <c:v>0.1725582766420907</c:v>
                </c:pt>
                <c:pt idx="870">
                  <c:v>0.74587021378392826</c:v>
                </c:pt>
                <c:pt idx="871">
                  <c:v>1.1169321477432277E-2</c:v>
                </c:pt>
                <c:pt idx="872">
                  <c:v>0.17622973422274882</c:v>
                </c:pt>
                <c:pt idx="873">
                  <c:v>0.41835550999158799</c:v>
                </c:pt>
                <c:pt idx="874">
                  <c:v>1.0359790136630449</c:v>
                </c:pt>
                <c:pt idx="875">
                  <c:v>0.36095498517949581</c:v>
                </c:pt>
                <c:pt idx="876">
                  <c:v>0.51171358997709704</c:v>
                </c:pt>
                <c:pt idx="877">
                  <c:v>0.31046792684634494</c:v>
                </c:pt>
                <c:pt idx="878">
                  <c:v>1.2243515591423026</c:v>
                </c:pt>
                <c:pt idx="879">
                  <c:v>0.25058982838124755</c:v>
                </c:pt>
                <c:pt idx="880">
                  <c:v>0.2194761634364788</c:v>
                </c:pt>
                <c:pt idx="881">
                  <c:v>0.63137247602424773</c:v>
                </c:pt>
                <c:pt idx="882">
                  <c:v>0.20259363440106071</c:v>
                </c:pt>
                <c:pt idx="883">
                  <c:v>0.1389907082674878</c:v>
                </c:pt>
                <c:pt idx="884">
                  <c:v>0.90068212211468357</c:v>
                </c:pt>
                <c:pt idx="885">
                  <c:v>6.4547305034777513E-2</c:v>
                </c:pt>
                <c:pt idx="886">
                  <c:v>0.60435085168444425</c:v>
                </c:pt>
                <c:pt idx="887">
                  <c:v>0.51609604114315488</c:v>
                </c:pt>
                <c:pt idx="888">
                  <c:v>0.50296008952593385</c:v>
                </c:pt>
                <c:pt idx="889">
                  <c:v>0.58848744197562575</c:v>
                </c:pt>
                <c:pt idx="890">
                  <c:v>5.1133036730717042E-2</c:v>
                </c:pt>
                <c:pt idx="891">
                  <c:v>0.37232617990028655</c:v>
                </c:pt>
                <c:pt idx="892">
                  <c:v>0.19221053506430219</c:v>
                </c:pt>
                <c:pt idx="893">
                  <c:v>0.30811568778740084</c:v>
                </c:pt>
                <c:pt idx="894">
                  <c:v>0.78734829732018519</c:v>
                </c:pt>
                <c:pt idx="895">
                  <c:v>0.54842559995805051</c:v>
                </c:pt>
                <c:pt idx="896">
                  <c:v>7.7708228970475066E-2</c:v>
                </c:pt>
                <c:pt idx="897">
                  <c:v>1.6396868544134811</c:v>
                </c:pt>
                <c:pt idx="898">
                  <c:v>0.34276282381540613</c:v>
                </c:pt>
                <c:pt idx="899">
                  <c:v>0.13072140820994779</c:v>
                </c:pt>
                <c:pt idx="900">
                  <c:v>0.18231789988637306</c:v>
                </c:pt>
                <c:pt idx="901">
                  <c:v>1.4474322925991874</c:v>
                </c:pt>
                <c:pt idx="902">
                  <c:v>0.26400869997687937</c:v>
                </c:pt>
                <c:pt idx="903">
                  <c:v>0.50565956875783347</c:v>
                </c:pt>
                <c:pt idx="904">
                  <c:v>0.20416272032511601</c:v>
                </c:pt>
                <c:pt idx="905">
                  <c:v>0.4571446551828296</c:v>
                </c:pt>
                <c:pt idx="906">
                  <c:v>0.37198659011749885</c:v>
                </c:pt>
                <c:pt idx="907">
                  <c:v>1.2770206455891093</c:v>
                </c:pt>
                <c:pt idx="908">
                  <c:v>0.2007751310288082</c:v>
                </c:pt>
                <c:pt idx="909">
                  <c:v>0.11036951805964136</c:v>
                </c:pt>
                <c:pt idx="910">
                  <c:v>0.46823521810547253</c:v>
                </c:pt>
                <c:pt idx="911">
                  <c:v>0.35226170958488334</c:v>
                </c:pt>
                <c:pt idx="912">
                  <c:v>0.20239553196831409</c:v>
                </c:pt>
                <c:pt idx="913">
                  <c:v>2.9195036205975605E-2</c:v>
                </c:pt>
                <c:pt idx="914">
                  <c:v>0.37378350197423049</c:v>
                </c:pt>
                <c:pt idx="915">
                  <c:v>1.2823893445023529</c:v>
                </c:pt>
                <c:pt idx="916">
                  <c:v>0.72671335347319743</c:v>
                </c:pt>
                <c:pt idx="917">
                  <c:v>1.2432068520336386</c:v>
                </c:pt>
                <c:pt idx="918">
                  <c:v>4.119872208243322E-2</c:v>
                </c:pt>
                <c:pt idx="919">
                  <c:v>0.44363450965621332</c:v>
                </c:pt>
                <c:pt idx="920">
                  <c:v>0.12200624943710356</c:v>
                </c:pt>
                <c:pt idx="921">
                  <c:v>0.8433949141375342</c:v>
                </c:pt>
                <c:pt idx="922">
                  <c:v>0.23195062443665138</c:v>
                </c:pt>
                <c:pt idx="923">
                  <c:v>1.8589031042292954</c:v>
                </c:pt>
                <c:pt idx="924">
                  <c:v>9.6933239044900407E-2</c:v>
                </c:pt>
                <c:pt idx="925">
                  <c:v>7.7564721843684254E-3</c:v>
                </c:pt>
                <c:pt idx="926">
                  <c:v>5.5530383121280086E-2</c:v>
                </c:pt>
                <c:pt idx="927">
                  <c:v>0.46048386206447939</c:v>
                </c:pt>
                <c:pt idx="928">
                  <c:v>0.24408031073281888</c:v>
                </c:pt>
                <c:pt idx="929">
                  <c:v>0.941951132894425</c:v>
                </c:pt>
                <c:pt idx="930">
                  <c:v>0.74687594559807857</c:v>
                </c:pt>
                <c:pt idx="931">
                  <c:v>0.73496618407252512</c:v>
                </c:pt>
                <c:pt idx="932">
                  <c:v>9.6193727748213526E-2</c:v>
                </c:pt>
                <c:pt idx="933">
                  <c:v>1.2097220511285722</c:v>
                </c:pt>
                <c:pt idx="934">
                  <c:v>0.22034421844954297</c:v>
                </c:pt>
                <c:pt idx="935">
                  <c:v>3.9446973450239162E-2</c:v>
                </c:pt>
                <c:pt idx="936">
                  <c:v>0.46465409503339949</c:v>
                </c:pt>
                <c:pt idx="937">
                  <c:v>6.6478763307409761E-2</c:v>
                </c:pt>
                <c:pt idx="938">
                  <c:v>6.8171085022486633E-3</c:v>
                </c:pt>
                <c:pt idx="939">
                  <c:v>0.65429648085119618</c:v>
                </c:pt>
                <c:pt idx="940">
                  <c:v>1.5815317747979327E-2</c:v>
                </c:pt>
                <c:pt idx="941">
                  <c:v>0.31060575733137696</c:v>
                </c:pt>
                <c:pt idx="942">
                  <c:v>0.41232114878192605</c:v>
                </c:pt>
                <c:pt idx="943">
                  <c:v>1.3226912865417371</c:v>
                </c:pt>
                <c:pt idx="944">
                  <c:v>0.20930318728293656</c:v>
                </c:pt>
                <c:pt idx="945">
                  <c:v>0.10920110356315486</c:v>
                </c:pt>
                <c:pt idx="946">
                  <c:v>0.88392289321488593</c:v>
                </c:pt>
                <c:pt idx="947">
                  <c:v>0.3485168440288775</c:v>
                </c:pt>
                <c:pt idx="948">
                  <c:v>0.62727751424400868</c:v>
                </c:pt>
                <c:pt idx="949">
                  <c:v>0.12657505011915066</c:v>
                </c:pt>
                <c:pt idx="950">
                  <c:v>0.83537956780651146</c:v>
                </c:pt>
                <c:pt idx="951">
                  <c:v>9.8759891117183543E-2</c:v>
                </c:pt>
                <c:pt idx="952">
                  <c:v>0.18222973504889481</c:v>
                </c:pt>
                <c:pt idx="953">
                  <c:v>3.417107704622098E-2</c:v>
                </c:pt>
                <c:pt idx="954">
                  <c:v>7.5245465043913023E-2</c:v>
                </c:pt>
                <c:pt idx="955">
                  <c:v>0.74899443685652634</c:v>
                </c:pt>
                <c:pt idx="956">
                  <c:v>1.6409582219215948</c:v>
                </c:pt>
                <c:pt idx="957">
                  <c:v>0.19775743565989645</c:v>
                </c:pt>
                <c:pt idx="958">
                  <c:v>1.2083027586714278E-3</c:v>
                </c:pt>
                <c:pt idx="959">
                  <c:v>0.38106322954028132</c:v>
                </c:pt>
                <c:pt idx="960">
                  <c:v>0.84725892031049943</c:v>
                </c:pt>
                <c:pt idx="961">
                  <c:v>0.62534532068291848</c:v>
                </c:pt>
                <c:pt idx="962">
                  <c:v>0.71144360740090462</c:v>
                </c:pt>
                <c:pt idx="963">
                  <c:v>0.57729495482349102</c:v>
                </c:pt>
                <c:pt idx="964">
                  <c:v>0.9953832825046246</c:v>
                </c:pt>
                <c:pt idx="965">
                  <c:v>0.80826765632775954</c:v>
                </c:pt>
                <c:pt idx="966">
                  <c:v>0.59312472087520962</c:v>
                </c:pt>
                <c:pt idx="967">
                  <c:v>8.2617983670274675E-2</c:v>
                </c:pt>
                <c:pt idx="968">
                  <c:v>0.14522982751397587</c:v>
                </c:pt>
                <c:pt idx="969">
                  <c:v>0.1148687688584796</c:v>
                </c:pt>
                <c:pt idx="970">
                  <c:v>0.29911154703431653</c:v>
                </c:pt>
                <c:pt idx="971">
                  <c:v>0.3088830959690263</c:v>
                </c:pt>
                <c:pt idx="972">
                  <c:v>0.26581752241471696</c:v>
                </c:pt>
                <c:pt idx="973">
                  <c:v>0.99564959308315237</c:v>
                </c:pt>
                <c:pt idx="974">
                  <c:v>0.167424516142167</c:v>
                </c:pt>
                <c:pt idx="975">
                  <c:v>0.55652179265123425</c:v>
                </c:pt>
                <c:pt idx="976">
                  <c:v>0.25922012251690491</c:v>
                </c:pt>
                <c:pt idx="977">
                  <c:v>0.67519845389135424</c:v>
                </c:pt>
                <c:pt idx="978">
                  <c:v>0.11620256228505324</c:v>
                </c:pt>
                <c:pt idx="979">
                  <c:v>0.34247770616680201</c:v>
                </c:pt>
                <c:pt idx="980">
                  <c:v>0.6738568282424946</c:v>
                </c:pt>
                <c:pt idx="981">
                  <c:v>0.55865599968884483</c:v>
                </c:pt>
                <c:pt idx="982">
                  <c:v>2.1132541111411027E-2</c:v>
                </c:pt>
                <c:pt idx="983">
                  <c:v>0.28266105534567415</c:v>
                </c:pt>
                <c:pt idx="984">
                  <c:v>1.6914245676942259</c:v>
                </c:pt>
                <c:pt idx="985">
                  <c:v>0.41536100412287646</c:v>
                </c:pt>
                <c:pt idx="986">
                  <c:v>1.334519601555487</c:v>
                </c:pt>
                <c:pt idx="987">
                  <c:v>1.1165879809436872</c:v>
                </c:pt>
                <c:pt idx="988">
                  <c:v>5.8215936886905871E-2</c:v>
                </c:pt>
                <c:pt idx="989">
                  <c:v>1.9329992086684664</c:v>
                </c:pt>
                <c:pt idx="990">
                  <c:v>1.0691448469562987</c:v>
                </c:pt>
                <c:pt idx="991">
                  <c:v>0.85674755899819188</c:v>
                </c:pt>
                <c:pt idx="992">
                  <c:v>0.86733073095289259</c:v>
                </c:pt>
                <c:pt idx="993">
                  <c:v>4.7841719005644351E-2</c:v>
                </c:pt>
                <c:pt idx="994">
                  <c:v>0.31366614128177545</c:v>
                </c:pt>
                <c:pt idx="995">
                  <c:v>0.35263799770149101</c:v>
                </c:pt>
                <c:pt idx="996">
                  <c:v>1.1327259435777175</c:v>
                </c:pt>
                <c:pt idx="997">
                  <c:v>0.5357515457179447</c:v>
                </c:pt>
                <c:pt idx="998">
                  <c:v>0.46913646987680258</c:v>
                </c:pt>
                <c:pt idx="999">
                  <c:v>0.32050866986863535</c:v>
                </c:pt>
                <c:pt idx="1000">
                  <c:v>0.20574661922863882</c:v>
                </c:pt>
                <c:pt idx="1001">
                  <c:v>0.12581629855592863</c:v>
                </c:pt>
                <c:pt idx="1002">
                  <c:v>0.63577695166690174</c:v>
                </c:pt>
                <c:pt idx="1003">
                  <c:v>0.29202719429924967</c:v>
                </c:pt>
                <c:pt idx="1004">
                  <c:v>0.48219584408862703</c:v>
                </c:pt>
                <c:pt idx="1005">
                  <c:v>0.21279341359603721</c:v>
                </c:pt>
                <c:pt idx="1006">
                  <c:v>0.1695494783355819</c:v>
                </c:pt>
                <c:pt idx="1007">
                  <c:v>0.25898566600020106</c:v>
                </c:pt>
                <c:pt idx="1008">
                  <c:v>1.7557379748936779</c:v>
                </c:pt>
                <c:pt idx="1009">
                  <c:v>0.37977644117624076</c:v>
                </c:pt>
                <c:pt idx="1010">
                  <c:v>0.45406431169867373</c:v>
                </c:pt>
                <c:pt idx="1011">
                  <c:v>0.72873047416758174</c:v>
                </c:pt>
                <c:pt idx="1012">
                  <c:v>0.22472774398963943</c:v>
                </c:pt>
                <c:pt idx="1013">
                  <c:v>0.16729452695129954</c:v>
                </c:pt>
                <c:pt idx="1014">
                  <c:v>1.2201582699233058</c:v>
                </c:pt>
                <c:pt idx="1015">
                  <c:v>7.7205017547567365E-3</c:v>
                </c:pt>
                <c:pt idx="1016">
                  <c:v>1.2742563545446435</c:v>
                </c:pt>
                <c:pt idx="1017">
                  <c:v>0.55523943254761277</c:v>
                </c:pt>
                <c:pt idx="1018">
                  <c:v>0.15206829379311831</c:v>
                </c:pt>
                <c:pt idx="1019">
                  <c:v>0.18228104111515681</c:v>
                </c:pt>
                <c:pt idx="1020">
                  <c:v>0.26711975638055463</c:v>
                </c:pt>
                <c:pt idx="1021">
                  <c:v>0.1016586510944444</c:v>
                </c:pt>
                <c:pt idx="1022">
                  <c:v>8.8864467059409161E-4</c:v>
                </c:pt>
                <c:pt idx="1023">
                  <c:v>1.0400356734195257</c:v>
                </c:pt>
                <c:pt idx="1024">
                  <c:v>0.16321828328878593</c:v>
                </c:pt>
                <c:pt idx="1025">
                  <c:v>3.7285732929331947E-2</c:v>
                </c:pt>
                <c:pt idx="1026">
                  <c:v>4.345626888542093E-2</c:v>
                </c:pt>
                <c:pt idx="1027">
                  <c:v>1.2637889024064139</c:v>
                </c:pt>
                <c:pt idx="1028">
                  <c:v>0.15671858187794924</c:v>
                </c:pt>
                <c:pt idx="1029">
                  <c:v>0.5437454590287264</c:v>
                </c:pt>
                <c:pt idx="1030">
                  <c:v>2.674707404172314</c:v>
                </c:pt>
                <c:pt idx="1031">
                  <c:v>0.6956976674891322</c:v>
                </c:pt>
                <c:pt idx="1032">
                  <c:v>2.7462511380118543E-2</c:v>
                </c:pt>
                <c:pt idx="1033">
                  <c:v>0.37980704974806562</c:v>
                </c:pt>
                <c:pt idx="1034">
                  <c:v>0.94482296181644065</c:v>
                </c:pt>
                <c:pt idx="1035">
                  <c:v>0.66018679552675441</c:v>
                </c:pt>
                <c:pt idx="1036">
                  <c:v>0.10558267525392506</c:v>
                </c:pt>
                <c:pt idx="1037">
                  <c:v>0.23078003167295924</c:v>
                </c:pt>
                <c:pt idx="1038">
                  <c:v>6.1848063255749139E-2</c:v>
                </c:pt>
                <c:pt idx="1039">
                  <c:v>0.18910556256119893</c:v>
                </c:pt>
                <c:pt idx="1040">
                  <c:v>2.7567568477527511E-2</c:v>
                </c:pt>
                <c:pt idx="1041">
                  <c:v>0.40927117698232657</c:v>
                </c:pt>
                <c:pt idx="1042">
                  <c:v>3.1915957471773677E-2</c:v>
                </c:pt>
                <c:pt idx="1043">
                  <c:v>0.62059174337756184</c:v>
                </c:pt>
                <c:pt idx="1044">
                  <c:v>2.8027406548131453E-3</c:v>
                </c:pt>
                <c:pt idx="1045">
                  <c:v>0.30593012635468009</c:v>
                </c:pt>
                <c:pt idx="1046">
                  <c:v>0.30933461219238451</c:v>
                </c:pt>
                <c:pt idx="1047">
                  <c:v>0.24096457373683813</c:v>
                </c:pt>
                <c:pt idx="1048">
                  <c:v>1.3441856617352756E-3</c:v>
                </c:pt>
                <c:pt idx="1049">
                  <c:v>0.11370322900406804</c:v>
                </c:pt>
                <c:pt idx="1050">
                  <c:v>0.73258018685597115</c:v>
                </c:pt>
                <c:pt idx="1051">
                  <c:v>0.87839710507268554</c:v>
                </c:pt>
                <c:pt idx="1052">
                  <c:v>0.67960889297590465</c:v>
                </c:pt>
                <c:pt idx="1053">
                  <c:v>1.8102717844325048E-2</c:v>
                </c:pt>
                <c:pt idx="1054">
                  <c:v>0.19177513739433308</c:v>
                </c:pt>
                <c:pt idx="1055">
                  <c:v>3.4592657666186785E-2</c:v>
                </c:pt>
                <c:pt idx="1056">
                  <c:v>0.52490317238972217</c:v>
                </c:pt>
                <c:pt idx="1057">
                  <c:v>0.13295538421806841</c:v>
                </c:pt>
                <c:pt idx="1058">
                  <c:v>2.3406427510659654E-2</c:v>
                </c:pt>
                <c:pt idx="1059">
                  <c:v>1.3642916426814753E-2</c:v>
                </c:pt>
                <c:pt idx="1060">
                  <c:v>1.3662172448534335</c:v>
                </c:pt>
                <c:pt idx="1061">
                  <c:v>0.29628222190607256</c:v>
                </c:pt>
                <c:pt idx="1062">
                  <c:v>0.21849744714760763</c:v>
                </c:pt>
                <c:pt idx="1063">
                  <c:v>0.35809308391295375</c:v>
                </c:pt>
                <c:pt idx="1064">
                  <c:v>0.7386652905235801</c:v>
                </c:pt>
                <c:pt idx="1065">
                  <c:v>0.14771373014734948</c:v>
                </c:pt>
                <c:pt idx="1066">
                  <c:v>0.31013283526989116</c:v>
                </c:pt>
                <c:pt idx="1067">
                  <c:v>1.2571140773409886</c:v>
                </c:pt>
                <c:pt idx="1068">
                  <c:v>0.45805667151515189</c:v>
                </c:pt>
                <c:pt idx="1069">
                  <c:v>0.16760668294596479</c:v>
                </c:pt>
                <c:pt idx="1070">
                  <c:v>0.72366054454112727</c:v>
                </c:pt>
                <c:pt idx="1071">
                  <c:v>0.24281058523186175</c:v>
                </c:pt>
                <c:pt idx="1072">
                  <c:v>0.84128378648662461</c:v>
                </c:pt>
                <c:pt idx="1073">
                  <c:v>7.0668049816959566E-2</c:v>
                </c:pt>
                <c:pt idx="1074">
                  <c:v>0.10246471011159841</c:v>
                </c:pt>
                <c:pt idx="1075">
                  <c:v>9.9334887974461619E-2</c:v>
                </c:pt>
                <c:pt idx="1076">
                  <c:v>0.10985446732911884</c:v>
                </c:pt>
                <c:pt idx="1077">
                  <c:v>0.70934359636462663</c:v>
                </c:pt>
                <c:pt idx="1078">
                  <c:v>0.26938247351439043</c:v>
                </c:pt>
                <c:pt idx="1079">
                  <c:v>1.1266666494242619</c:v>
                </c:pt>
                <c:pt idx="1080">
                  <c:v>0.16195115878041907</c:v>
                </c:pt>
                <c:pt idx="1081">
                  <c:v>0.41568096261149651</c:v>
                </c:pt>
                <c:pt idx="1082">
                  <c:v>0.29971849283415747</c:v>
                </c:pt>
                <c:pt idx="1083">
                  <c:v>0.28375913035546774</c:v>
                </c:pt>
                <c:pt idx="1084">
                  <c:v>0.27668297826955468</c:v>
                </c:pt>
                <c:pt idx="1085">
                  <c:v>0.21668252175395339</c:v>
                </c:pt>
                <c:pt idx="1086">
                  <c:v>0.17150820652461024</c:v>
                </c:pt>
                <c:pt idx="1087">
                  <c:v>0.13221623979370464</c:v>
                </c:pt>
                <c:pt idx="1088">
                  <c:v>0.77114933007231534</c:v>
                </c:pt>
                <c:pt idx="1089">
                  <c:v>0.17250305832223273</c:v>
                </c:pt>
                <c:pt idx="1090">
                  <c:v>0.17988151693958623</c:v>
                </c:pt>
                <c:pt idx="1091">
                  <c:v>6.536184685385768E-2</c:v>
                </c:pt>
                <c:pt idx="1092">
                  <c:v>0.45396921774605675</c:v>
                </c:pt>
                <c:pt idx="1093">
                  <c:v>0.65082049570561684</c:v>
                </c:pt>
                <c:pt idx="1094">
                  <c:v>0.66998066763448649</c:v>
                </c:pt>
                <c:pt idx="1095">
                  <c:v>0.55537917900403255</c:v>
                </c:pt>
                <c:pt idx="1096">
                  <c:v>1.1029452696408635</c:v>
                </c:pt>
                <c:pt idx="1097">
                  <c:v>0.56239886322672916</c:v>
                </c:pt>
                <c:pt idx="1098">
                  <c:v>0.15883125736598525</c:v>
                </c:pt>
                <c:pt idx="1099">
                  <c:v>6.3773424233992695E-2</c:v>
                </c:pt>
                <c:pt idx="1100">
                  <c:v>0.93239105865104444</c:v>
                </c:pt>
                <c:pt idx="1101">
                  <c:v>0.62360539871052911</c:v>
                </c:pt>
                <c:pt idx="1102">
                  <c:v>0.76597991293017043</c:v>
                </c:pt>
                <c:pt idx="1103">
                  <c:v>0.83032154477886677</c:v>
                </c:pt>
                <c:pt idx="1104">
                  <c:v>0.38183478856977038</c:v>
                </c:pt>
                <c:pt idx="1105">
                  <c:v>0.64103238762167936</c:v>
                </c:pt>
                <c:pt idx="1106">
                  <c:v>1.603222314096542</c:v>
                </c:pt>
                <c:pt idx="1107">
                  <c:v>0.67023246912520174</c:v>
                </c:pt>
                <c:pt idx="1108">
                  <c:v>0.62297861078434191</c:v>
                </c:pt>
                <c:pt idx="1109">
                  <c:v>0.51250193234194863</c:v>
                </c:pt>
                <c:pt idx="1110">
                  <c:v>9.5240999972916254E-2</c:v>
                </c:pt>
                <c:pt idx="1111">
                  <c:v>1.0409039411350156</c:v>
                </c:pt>
                <c:pt idx="1112">
                  <c:v>8.3062090252577811E-2</c:v>
                </c:pt>
                <c:pt idx="1113">
                  <c:v>1.9409763141434405E-3</c:v>
                </c:pt>
                <c:pt idx="1114">
                  <c:v>0.863193810078144</c:v>
                </c:pt>
                <c:pt idx="1115">
                  <c:v>0.25070217419889312</c:v>
                </c:pt>
                <c:pt idx="1116">
                  <c:v>0.65532006616989524</c:v>
                </c:pt>
                <c:pt idx="1117">
                  <c:v>0.7343718343203659</c:v>
                </c:pt>
                <c:pt idx="1118">
                  <c:v>0.86943349397787462</c:v>
                </c:pt>
                <c:pt idx="1119">
                  <c:v>0.32191148893661725</c:v>
                </c:pt>
                <c:pt idx="1120">
                  <c:v>0.64156905833953681</c:v>
                </c:pt>
                <c:pt idx="1121">
                  <c:v>0.35808187021126237</c:v>
                </c:pt>
                <c:pt idx="1122">
                  <c:v>0.20075479581186564</c:v>
                </c:pt>
                <c:pt idx="1123">
                  <c:v>0.86753427275684702</c:v>
                </c:pt>
                <c:pt idx="1124">
                  <c:v>0.45500074222014159</c:v>
                </c:pt>
                <c:pt idx="1125">
                  <c:v>1.5255278578514069</c:v>
                </c:pt>
                <c:pt idx="1126">
                  <c:v>8.5354336535029746E-2</c:v>
                </c:pt>
                <c:pt idx="1127">
                  <c:v>0.28045637670686818</c:v>
                </c:pt>
                <c:pt idx="1128">
                  <c:v>0.56778677339078021</c:v>
                </c:pt>
                <c:pt idx="1129">
                  <c:v>0.15167671313341344</c:v>
                </c:pt>
                <c:pt idx="1130">
                  <c:v>5.0481476663107497E-2</c:v>
                </c:pt>
                <c:pt idx="1131">
                  <c:v>0.37448362374423011</c:v>
                </c:pt>
                <c:pt idx="1132">
                  <c:v>0.56945651985680013</c:v>
                </c:pt>
                <c:pt idx="1133">
                  <c:v>1.7101936968313647</c:v>
                </c:pt>
                <c:pt idx="1134">
                  <c:v>0.41899986986663729</c:v>
                </c:pt>
                <c:pt idx="1135">
                  <c:v>1.3432399450404866</c:v>
                </c:pt>
                <c:pt idx="1136">
                  <c:v>0.16572625022155318</c:v>
                </c:pt>
                <c:pt idx="1137">
                  <c:v>0.77028244697947545</c:v>
                </c:pt>
                <c:pt idx="1138">
                  <c:v>0.44735599881931748</c:v>
                </c:pt>
                <c:pt idx="1139">
                  <c:v>8.7704011042441896E-2</c:v>
                </c:pt>
                <c:pt idx="1140">
                  <c:v>0.3018650033197301</c:v>
                </c:pt>
                <c:pt idx="1141">
                  <c:v>0.60525889243349618</c:v>
                </c:pt>
                <c:pt idx="1142">
                  <c:v>1.033894746550194</c:v>
                </c:pt>
                <c:pt idx="1143">
                  <c:v>0.57989812494565685</c:v>
                </c:pt>
                <c:pt idx="1144">
                  <c:v>7.155893372661859E-2</c:v>
                </c:pt>
                <c:pt idx="1145">
                  <c:v>2.1087223934536201</c:v>
                </c:pt>
                <c:pt idx="1146">
                  <c:v>0.88464708837207162</c:v>
                </c:pt>
                <c:pt idx="1147">
                  <c:v>0.39852626013413223</c:v>
                </c:pt>
                <c:pt idx="1148">
                  <c:v>0.15374820832709479</c:v>
                </c:pt>
                <c:pt idx="1149">
                  <c:v>1.102701419696843</c:v>
                </c:pt>
                <c:pt idx="1150">
                  <c:v>0.39752555383832328</c:v>
                </c:pt>
                <c:pt idx="1151">
                  <c:v>5.2550425390403055E-2</c:v>
                </c:pt>
                <c:pt idx="1152">
                  <c:v>0.23910419355980247</c:v>
                </c:pt>
                <c:pt idx="1153">
                  <c:v>0.3569111737810266</c:v>
                </c:pt>
                <c:pt idx="1154">
                  <c:v>4.7353068324686012E-2</c:v>
                </c:pt>
                <c:pt idx="1155">
                  <c:v>3.2875400519193278E-2</c:v>
                </c:pt>
                <c:pt idx="1156">
                  <c:v>0.20770492663741627</c:v>
                </c:pt>
                <c:pt idx="1157">
                  <c:v>0.43886537700810435</c:v>
                </c:pt>
                <c:pt idx="1158">
                  <c:v>0.42979091164829192</c:v>
                </c:pt>
                <c:pt idx="1159">
                  <c:v>0.33796740191744284</c:v>
                </c:pt>
                <c:pt idx="1160">
                  <c:v>0.47683973788067513</c:v>
                </c:pt>
                <c:pt idx="1161">
                  <c:v>1.0781139971946343</c:v>
                </c:pt>
                <c:pt idx="1162">
                  <c:v>0.34290692146142082</c:v>
                </c:pt>
                <c:pt idx="1163">
                  <c:v>0.10362228412662415</c:v>
                </c:pt>
                <c:pt idx="1164">
                  <c:v>9.4557025121325522E-2</c:v>
                </c:pt>
                <c:pt idx="1165">
                  <c:v>0.14784861114257922</c:v>
                </c:pt>
                <c:pt idx="1166">
                  <c:v>0.21318438917841362</c:v>
                </c:pt>
                <c:pt idx="1167">
                  <c:v>0.37143431368909985</c:v>
                </c:pt>
                <c:pt idx="1168">
                  <c:v>0.29391214403512861</c:v>
                </c:pt>
                <c:pt idx="1169">
                  <c:v>0.83309650376121702</c:v>
                </c:pt>
                <c:pt idx="1170">
                  <c:v>0.3151355283965383</c:v>
                </c:pt>
                <c:pt idx="1171">
                  <c:v>0.40128125115390961</c:v>
                </c:pt>
                <c:pt idx="1172">
                  <c:v>0.48986905397522429</c:v>
                </c:pt>
                <c:pt idx="1173">
                  <c:v>0.31052992836292082</c:v>
                </c:pt>
                <c:pt idx="1174">
                  <c:v>0.45417227897171303</c:v>
                </c:pt>
                <c:pt idx="1175">
                  <c:v>0.16608125142817373</c:v>
                </c:pt>
                <c:pt idx="1176">
                  <c:v>0.84840873283168905</c:v>
                </c:pt>
                <c:pt idx="1177">
                  <c:v>1.3621757574763727</c:v>
                </c:pt>
                <c:pt idx="1178">
                  <c:v>0.10017100824929263</c:v>
                </c:pt>
                <c:pt idx="1179">
                  <c:v>0.97313933050567514</c:v>
                </c:pt>
                <c:pt idx="1180">
                  <c:v>0.39833001407175622</c:v>
                </c:pt>
                <c:pt idx="1181">
                  <c:v>0.81760939470876515</c:v>
                </c:pt>
                <c:pt idx="1182">
                  <c:v>0.47209020696603582</c:v>
                </c:pt>
                <c:pt idx="1183">
                  <c:v>4.7676491993631866E-2</c:v>
                </c:pt>
                <c:pt idx="1184">
                  <c:v>0.21133719164059087</c:v>
                </c:pt>
                <c:pt idx="1185">
                  <c:v>0.57428400956975068</c:v>
                </c:pt>
                <c:pt idx="1186">
                  <c:v>0.17330933004024388</c:v>
                </c:pt>
                <c:pt idx="1187">
                  <c:v>5.0199850966239475E-2</c:v>
                </c:pt>
                <c:pt idx="1188">
                  <c:v>7.6997355408365123E-2</c:v>
                </c:pt>
                <c:pt idx="1189">
                  <c:v>0.68988855592207821</c:v>
                </c:pt>
                <c:pt idx="1190">
                  <c:v>3.5676604156722434E-2</c:v>
                </c:pt>
                <c:pt idx="1191">
                  <c:v>0.36798645695822385</c:v>
                </c:pt>
                <c:pt idx="1192">
                  <c:v>0.104577797069248</c:v>
                </c:pt>
                <c:pt idx="1193">
                  <c:v>0.10524541894403487</c:v>
                </c:pt>
                <c:pt idx="1194">
                  <c:v>1.1980123873735817</c:v>
                </c:pt>
                <c:pt idx="1195">
                  <c:v>0.37467487180355918</c:v>
                </c:pt>
                <c:pt idx="1196">
                  <c:v>0.1889736184938122</c:v>
                </c:pt>
                <c:pt idx="1197">
                  <c:v>0.67748652351182104</c:v>
                </c:pt>
                <c:pt idx="1198">
                  <c:v>1.2356095340701843</c:v>
                </c:pt>
                <c:pt idx="1199">
                  <c:v>1.2258392022542801</c:v>
                </c:pt>
                <c:pt idx="1200">
                  <c:v>4.4021065690417152E-2</c:v>
                </c:pt>
                <c:pt idx="1201">
                  <c:v>4.9220891149243627E-2</c:v>
                </c:pt>
                <c:pt idx="1202">
                  <c:v>0.56789526092387044</c:v>
                </c:pt>
                <c:pt idx="1203">
                  <c:v>0.6693865111882078</c:v>
                </c:pt>
                <c:pt idx="1204">
                  <c:v>0.53732881331180116</c:v>
                </c:pt>
                <c:pt idx="1205">
                  <c:v>4.3261277879025173E-2</c:v>
                </c:pt>
                <c:pt idx="1206">
                  <c:v>0.90353862951906538</c:v>
                </c:pt>
                <c:pt idx="1207">
                  <c:v>0.62637898832029826</c:v>
                </c:pt>
                <c:pt idx="1208">
                  <c:v>0.52175416516886275</c:v>
                </c:pt>
                <c:pt idx="1209">
                  <c:v>0.12781779968941848</c:v>
                </c:pt>
                <c:pt idx="1210">
                  <c:v>0.38867017312552243</c:v>
                </c:pt>
                <c:pt idx="1211">
                  <c:v>0.12107082188742033</c:v>
                </c:pt>
                <c:pt idx="1212">
                  <c:v>0.80299757985189268</c:v>
                </c:pt>
                <c:pt idx="1213">
                  <c:v>0.18922612540166067</c:v>
                </c:pt>
                <c:pt idx="1214">
                  <c:v>0.79252021444605636</c:v>
                </c:pt>
                <c:pt idx="1215">
                  <c:v>0.7601750017165676</c:v>
                </c:pt>
                <c:pt idx="1216">
                  <c:v>0.63330175116143173</c:v>
                </c:pt>
                <c:pt idx="1217">
                  <c:v>0.67312209381625943</c:v>
                </c:pt>
                <c:pt idx="1218">
                  <c:v>0.52846246885053194</c:v>
                </c:pt>
                <c:pt idx="1219">
                  <c:v>0.23146925911673807</c:v>
                </c:pt>
                <c:pt idx="1220">
                  <c:v>0.14779519508396549</c:v>
                </c:pt>
                <c:pt idx="1221">
                  <c:v>0.10540430747681202</c:v>
                </c:pt>
                <c:pt idx="1222">
                  <c:v>0.32032814654230829</c:v>
                </c:pt>
                <c:pt idx="1223">
                  <c:v>0.16221371413763128</c:v>
                </c:pt>
                <c:pt idx="1224">
                  <c:v>3.0602451795780715E-2</c:v>
                </c:pt>
                <c:pt idx="1225">
                  <c:v>0.67638371222702209</c:v>
                </c:pt>
                <c:pt idx="1226">
                  <c:v>0.61006796340153757</c:v>
                </c:pt>
                <c:pt idx="1227">
                  <c:v>4.3316172739086035E-3</c:v>
                </c:pt>
                <c:pt idx="1228">
                  <c:v>0.41396769511775522</c:v>
                </c:pt>
                <c:pt idx="1229">
                  <c:v>1.0049118721645576</c:v>
                </c:pt>
                <c:pt idx="1230">
                  <c:v>1.2139689893275045</c:v>
                </c:pt>
                <c:pt idx="1231">
                  <c:v>4.6805039402601153E-2</c:v>
                </c:pt>
                <c:pt idx="1232">
                  <c:v>7.7623678705762603E-2</c:v>
                </c:pt>
                <c:pt idx="1233">
                  <c:v>6.4884855871408076E-2</c:v>
                </c:pt>
                <c:pt idx="1234">
                  <c:v>0.1992777119703813</c:v>
                </c:pt>
                <c:pt idx="1235">
                  <c:v>0.15705107635399243</c:v>
                </c:pt>
                <c:pt idx="1236">
                  <c:v>0.23489704985005283</c:v>
                </c:pt>
                <c:pt idx="1237">
                  <c:v>0.27288371903137604</c:v>
                </c:pt>
                <c:pt idx="1238">
                  <c:v>6.928419708352089E-2</c:v>
                </c:pt>
                <c:pt idx="1239">
                  <c:v>5.805016244145083E-2</c:v>
                </c:pt>
                <c:pt idx="1240">
                  <c:v>0.48026124802291836</c:v>
                </c:pt>
                <c:pt idx="1241">
                  <c:v>0.77037730018964135</c:v>
                </c:pt>
                <c:pt idx="1242">
                  <c:v>0.38612553527860127</c:v>
                </c:pt>
                <c:pt idx="1243">
                  <c:v>0.54155818235953768</c:v>
                </c:pt>
                <c:pt idx="1244">
                  <c:v>0.74534816855236763</c:v>
                </c:pt>
                <c:pt idx="1245">
                  <c:v>0.36291268016560924</c:v>
                </c:pt>
                <c:pt idx="1246">
                  <c:v>1.2229331190677104</c:v>
                </c:pt>
                <c:pt idx="1247">
                  <c:v>1.6220528563966152</c:v>
                </c:pt>
                <c:pt idx="1248">
                  <c:v>0.21350292758579545</c:v>
                </c:pt>
                <c:pt idx="1249">
                  <c:v>1.1803600944711448</c:v>
                </c:pt>
                <c:pt idx="1250">
                  <c:v>0.39459488291461481</c:v>
                </c:pt>
                <c:pt idx="1251">
                  <c:v>0.17247940319101196</c:v>
                </c:pt>
                <c:pt idx="1252">
                  <c:v>0.62508057228630376</c:v>
                </c:pt>
                <c:pt idx="1253">
                  <c:v>0.37767045637040431</c:v>
                </c:pt>
                <c:pt idx="1254">
                  <c:v>0.69306757905000616</c:v>
                </c:pt>
                <c:pt idx="1255">
                  <c:v>0.39473994541345392</c:v>
                </c:pt>
                <c:pt idx="1256">
                  <c:v>1.389015318220771</c:v>
                </c:pt>
                <c:pt idx="1257">
                  <c:v>2.4596180849108262E-2</c:v>
                </c:pt>
                <c:pt idx="1258">
                  <c:v>0.9861406275879504</c:v>
                </c:pt>
                <c:pt idx="1259">
                  <c:v>0.13596386238455038</c:v>
                </c:pt>
                <c:pt idx="1260">
                  <c:v>0.18531638849690507</c:v>
                </c:pt>
                <c:pt idx="1261">
                  <c:v>0.31380664781319523</c:v>
                </c:pt>
                <c:pt idx="1262">
                  <c:v>4.2769157733822311E-2</c:v>
                </c:pt>
                <c:pt idx="1263">
                  <c:v>1.1220193898967654</c:v>
                </c:pt>
                <c:pt idx="1264">
                  <c:v>0.15551662287749085</c:v>
                </c:pt>
                <c:pt idx="1265">
                  <c:v>0.78978224014884879</c:v>
                </c:pt>
                <c:pt idx="1266">
                  <c:v>0.24909704915391562</c:v>
                </c:pt>
                <c:pt idx="1267">
                  <c:v>0.15534874939379439</c:v>
                </c:pt>
                <c:pt idx="1268">
                  <c:v>6.9495663229810128E-2</c:v>
                </c:pt>
                <c:pt idx="1269">
                  <c:v>5.9252766654939067E-2</c:v>
                </c:pt>
                <c:pt idx="1270">
                  <c:v>1.7154529659110103</c:v>
                </c:pt>
                <c:pt idx="1271">
                  <c:v>0.67300701806120333</c:v>
                </c:pt>
                <c:pt idx="1272">
                  <c:v>0.50637457579788503</c:v>
                </c:pt>
                <c:pt idx="1273">
                  <c:v>0.59428102614778922</c:v>
                </c:pt>
                <c:pt idx="1274">
                  <c:v>0.51088102610874642</c:v>
                </c:pt>
                <c:pt idx="1275">
                  <c:v>9.893325815385481E-3</c:v>
                </c:pt>
                <c:pt idx="1276">
                  <c:v>0.4145465704371909</c:v>
                </c:pt>
                <c:pt idx="1277">
                  <c:v>0.57357047552936746</c:v>
                </c:pt>
                <c:pt idx="1278">
                  <c:v>0.23323315975446662</c:v>
                </c:pt>
                <c:pt idx="1279">
                  <c:v>7.0367571229019807E-2</c:v>
                </c:pt>
                <c:pt idx="1280">
                  <c:v>1.4827334898081346</c:v>
                </c:pt>
                <c:pt idx="1281">
                  <c:v>0.4535241297441337</c:v>
                </c:pt>
                <c:pt idx="1282">
                  <c:v>0.36265375792706822</c:v>
                </c:pt>
                <c:pt idx="1283">
                  <c:v>1.0011133197728175</c:v>
                </c:pt>
                <c:pt idx="1284">
                  <c:v>3.3716060179525033E-2</c:v>
                </c:pt>
                <c:pt idx="1285">
                  <c:v>0.22135878857934796</c:v>
                </c:pt>
                <c:pt idx="1286">
                  <c:v>8.0518141473495078E-2</c:v>
                </c:pt>
                <c:pt idx="1287">
                  <c:v>0.27488585348474787</c:v>
                </c:pt>
                <c:pt idx="1288">
                  <c:v>0.11958628735501976</c:v>
                </c:pt>
                <c:pt idx="1289">
                  <c:v>0.1931753348875537</c:v>
                </c:pt>
                <c:pt idx="1290">
                  <c:v>0.32692187561044178</c:v>
                </c:pt>
                <c:pt idx="1291">
                  <c:v>0.80508986839294006</c:v>
                </c:pt>
                <c:pt idx="1292">
                  <c:v>0.40951645057808317</c:v>
                </c:pt>
                <c:pt idx="1293">
                  <c:v>0.28195315484817501</c:v>
                </c:pt>
                <c:pt idx="1294">
                  <c:v>0.45334146696721661</c:v>
                </c:pt>
                <c:pt idx="1295">
                  <c:v>1.781180306354639</c:v>
                </c:pt>
                <c:pt idx="1296">
                  <c:v>0.22478716666475787</c:v>
                </c:pt>
                <c:pt idx="1297">
                  <c:v>0.18541725131467454</c:v>
                </c:pt>
                <c:pt idx="1298">
                  <c:v>0.7065896425469429</c:v>
                </c:pt>
                <c:pt idx="1299">
                  <c:v>0.45829797084034801</c:v>
                </c:pt>
                <c:pt idx="1300">
                  <c:v>0.69071380023455597</c:v>
                </c:pt>
                <c:pt idx="1301">
                  <c:v>0.73866586222940978</c:v>
                </c:pt>
                <c:pt idx="1302">
                  <c:v>0.43364563270102524</c:v>
                </c:pt>
                <c:pt idx="1303">
                  <c:v>0.27192036789173119</c:v>
                </c:pt>
                <c:pt idx="1304">
                  <c:v>0.21698228849410531</c:v>
                </c:pt>
                <c:pt idx="1305">
                  <c:v>0.10257981400579226</c:v>
                </c:pt>
                <c:pt idx="1306">
                  <c:v>9.0227391099402476E-2</c:v>
                </c:pt>
                <c:pt idx="1307">
                  <c:v>0.19891132716569321</c:v>
                </c:pt>
                <c:pt idx="1308">
                  <c:v>0.85695489696875171</c:v>
                </c:pt>
                <c:pt idx="1309">
                  <c:v>0.2405922301508692</c:v>
                </c:pt>
                <c:pt idx="1310">
                  <c:v>7.786432404560828E-2</c:v>
                </c:pt>
                <c:pt idx="1311">
                  <c:v>0.39220825082908095</c:v>
                </c:pt>
                <c:pt idx="1312">
                  <c:v>2.0184981547677908E-2</c:v>
                </c:pt>
                <c:pt idx="1313">
                  <c:v>0.58470378680398205</c:v>
                </c:pt>
                <c:pt idx="1314">
                  <c:v>0.90895976155001046</c:v>
                </c:pt>
                <c:pt idx="1315">
                  <c:v>0.56557604188283461</c:v>
                </c:pt>
                <c:pt idx="1316">
                  <c:v>0.19615574178825371</c:v>
                </c:pt>
                <c:pt idx="1317">
                  <c:v>1.0786533700771965</c:v>
                </c:pt>
                <c:pt idx="1318">
                  <c:v>0.57586067316505385</c:v>
                </c:pt>
                <c:pt idx="1319">
                  <c:v>8.867660000326652E-2</c:v>
                </c:pt>
                <c:pt idx="1320">
                  <c:v>0.19967101067848594</c:v>
                </c:pt>
                <c:pt idx="1321">
                  <c:v>0.51138510525825087</c:v>
                </c:pt>
                <c:pt idx="1322">
                  <c:v>0.78078649180997117</c:v>
                </c:pt>
                <c:pt idx="1323">
                  <c:v>0.9942815884549806</c:v>
                </c:pt>
                <c:pt idx="1324">
                  <c:v>0.55999211515731284</c:v>
                </c:pt>
                <c:pt idx="1325">
                  <c:v>1.247790960436278</c:v>
                </c:pt>
                <c:pt idx="1326">
                  <c:v>0.2756173408572381</c:v>
                </c:pt>
                <c:pt idx="1327">
                  <c:v>0.39878818813852063</c:v>
                </c:pt>
                <c:pt idx="1328">
                  <c:v>0.30706377981235089</c:v>
                </c:pt>
                <c:pt idx="1329">
                  <c:v>0.49310691709902826</c:v>
                </c:pt>
                <c:pt idx="1330">
                  <c:v>4.7649043974873947E-2</c:v>
                </c:pt>
                <c:pt idx="1331">
                  <c:v>0.26182051337939405</c:v>
                </c:pt>
                <c:pt idx="1332">
                  <c:v>0.24760213712822757</c:v>
                </c:pt>
                <c:pt idx="1333">
                  <c:v>0.63433469878827953</c:v>
                </c:pt>
                <c:pt idx="1334">
                  <c:v>0.36612661686657183</c:v>
                </c:pt>
                <c:pt idx="1335">
                  <c:v>0.21512220064818188</c:v>
                </c:pt>
                <c:pt idx="1336">
                  <c:v>1.0373464746910792</c:v>
                </c:pt>
                <c:pt idx="1337">
                  <c:v>0.54324692146584408</c:v>
                </c:pt>
                <c:pt idx="1338">
                  <c:v>0.24540773042496888</c:v>
                </c:pt>
                <c:pt idx="1339">
                  <c:v>0.83941719202109999</c:v>
                </c:pt>
                <c:pt idx="1340">
                  <c:v>1.3514889996389365</c:v>
                </c:pt>
                <c:pt idx="1341">
                  <c:v>0.96626906838367954</c:v>
                </c:pt>
                <c:pt idx="1342">
                  <c:v>0.1774380755449706</c:v>
                </c:pt>
                <c:pt idx="1343">
                  <c:v>0.13660937314617863</c:v>
                </c:pt>
                <c:pt idx="1344">
                  <c:v>0.19558026293494107</c:v>
                </c:pt>
                <c:pt idx="1345">
                  <c:v>0.3953560759954769</c:v>
                </c:pt>
                <c:pt idx="1346">
                  <c:v>1.195451238659069</c:v>
                </c:pt>
                <c:pt idx="1347">
                  <c:v>3.0379504658037573</c:v>
                </c:pt>
                <c:pt idx="1348">
                  <c:v>0.31621412813083599</c:v>
                </c:pt>
                <c:pt idx="1349">
                  <c:v>4.7469452102864252E-3</c:v>
                </c:pt>
                <c:pt idx="1350">
                  <c:v>1.2358964466242037</c:v>
                </c:pt>
                <c:pt idx="1351">
                  <c:v>0.11376635952617604</c:v>
                </c:pt>
                <c:pt idx="1352">
                  <c:v>0.14005150288280652</c:v>
                </c:pt>
                <c:pt idx="1353">
                  <c:v>0.71373884587331982</c:v>
                </c:pt>
                <c:pt idx="1354">
                  <c:v>0.17272195142600355</c:v>
                </c:pt>
                <c:pt idx="1355">
                  <c:v>1.0494022573384161</c:v>
                </c:pt>
                <c:pt idx="1356">
                  <c:v>0.13765303784607311</c:v>
                </c:pt>
                <c:pt idx="1357">
                  <c:v>0.52999099713260878</c:v>
                </c:pt>
                <c:pt idx="1358">
                  <c:v>8.5041212015627823E-2</c:v>
                </c:pt>
                <c:pt idx="1359">
                  <c:v>0.97657840492506509</c:v>
                </c:pt>
                <c:pt idx="1360">
                  <c:v>0.12410288767654644</c:v>
                </c:pt>
                <c:pt idx="1361">
                  <c:v>0.16713831824661932</c:v>
                </c:pt>
                <c:pt idx="1362">
                  <c:v>0.60154606487388707</c:v>
                </c:pt>
                <c:pt idx="1363">
                  <c:v>0.51968892929636301</c:v>
                </c:pt>
                <c:pt idx="1364">
                  <c:v>6.0734622467241893E-2</c:v>
                </c:pt>
                <c:pt idx="1365">
                  <c:v>0.28963726030631726</c:v>
                </c:pt>
                <c:pt idx="1366">
                  <c:v>1.7067456044546439E-3</c:v>
                </c:pt>
                <c:pt idx="1367">
                  <c:v>0.83899070699586453</c:v>
                </c:pt>
                <c:pt idx="1368">
                  <c:v>0.38687270936575813</c:v>
                </c:pt>
                <c:pt idx="1369">
                  <c:v>0.88688947982756561</c:v>
                </c:pt>
                <c:pt idx="1370">
                  <c:v>6.4075824303746587E-2</c:v>
                </c:pt>
                <c:pt idx="1371">
                  <c:v>0.29405329113498568</c:v>
                </c:pt>
                <c:pt idx="1372">
                  <c:v>0.22681051692988299</c:v>
                </c:pt>
                <c:pt idx="1373">
                  <c:v>0.49731132807395423</c:v>
                </c:pt>
                <c:pt idx="1374">
                  <c:v>7.0185174951347629E-2</c:v>
                </c:pt>
                <c:pt idx="1375">
                  <c:v>0.77947488052614167</c:v>
                </c:pt>
                <c:pt idx="1376">
                  <c:v>0.50417472579254852</c:v>
                </c:pt>
                <c:pt idx="1377">
                  <c:v>0.13298873740981057</c:v>
                </c:pt>
                <c:pt idx="1378">
                  <c:v>0.22854556851246194</c:v>
                </c:pt>
                <c:pt idx="1379">
                  <c:v>1.7621325301941028E-2</c:v>
                </c:pt>
                <c:pt idx="1380">
                  <c:v>8.0231605823276944E-2</c:v>
                </c:pt>
                <c:pt idx="1381">
                  <c:v>0.30623784397586973</c:v>
                </c:pt>
                <c:pt idx="1382">
                  <c:v>0.38554862767499398</c:v>
                </c:pt>
                <c:pt idx="1383">
                  <c:v>0.92448323373883357</c:v>
                </c:pt>
                <c:pt idx="1384">
                  <c:v>0.22740722208308023</c:v>
                </c:pt>
                <c:pt idx="1385">
                  <c:v>0.57814310518239487</c:v>
                </c:pt>
                <c:pt idx="1386">
                  <c:v>9.3931783761398754E-2</c:v>
                </c:pt>
                <c:pt idx="1387">
                  <c:v>0.29675433576964222</c:v>
                </c:pt>
                <c:pt idx="1388">
                  <c:v>0.16335336514297097</c:v>
                </c:pt>
                <c:pt idx="1389">
                  <c:v>1.1029565204169454</c:v>
                </c:pt>
                <c:pt idx="1390">
                  <c:v>0.1986914227846393</c:v>
                </c:pt>
                <c:pt idx="1391">
                  <c:v>0.11949373141250973</c:v>
                </c:pt>
                <c:pt idx="1392">
                  <c:v>0.43869693001460552</c:v>
                </c:pt>
                <c:pt idx="1393">
                  <c:v>0.19322625554291326</c:v>
                </c:pt>
                <c:pt idx="1394">
                  <c:v>0.32573315454834612</c:v>
                </c:pt>
                <c:pt idx="1395">
                  <c:v>0.2860660901602658</c:v>
                </c:pt>
                <c:pt idx="1396">
                  <c:v>0.388729539265257</c:v>
                </c:pt>
                <c:pt idx="1397">
                  <c:v>0.75485382436133774</c:v>
                </c:pt>
                <c:pt idx="1398">
                  <c:v>0.99553722360214258</c:v>
                </c:pt>
                <c:pt idx="1399">
                  <c:v>0.18577508937003706</c:v>
                </c:pt>
                <c:pt idx="1400">
                  <c:v>0.10542707072212923</c:v>
                </c:pt>
                <c:pt idx="1401">
                  <c:v>6.479937305451304E-2</c:v>
                </c:pt>
                <c:pt idx="1402">
                  <c:v>0.48916474369135354</c:v>
                </c:pt>
                <c:pt idx="1403">
                  <c:v>0.66617208801557226</c:v>
                </c:pt>
                <c:pt idx="1404">
                  <c:v>1.5825857744198646</c:v>
                </c:pt>
                <c:pt idx="1405">
                  <c:v>1.3405608234972008</c:v>
                </c:pt>
                <c:pt idx="1406">
                  <c:v>0.45902529305666401</c:v>
                </c:pt>
                <c:pt idx="1407">
                  <c:v>2.8893368444954545E-2</c:v>
                </c:pt>
                <c:pt idx="1408">
                  <c:v>0.40357990884929473</c:v>
                </c:pt>
                <c:pt idx="1409">
                  <c:v>6.9700554490327069E-2</c:v>
                </c:pt>
                <c:pt idx="1410">
                  <c:v>0.73617628402100499</c:v>
                </c:pt>
                <c:pt idx="1411">
                  <c:v>0.33572073693450921</c:v>
                </c:pt>
                <c:pt idx="1412">
                  <c:v>2.3797374226682717E-2</c:v>
                </c:pt>
                <c:pt idx="1413">
                  <c:v>0.54491579220943931</c:v>
                </c:pt>
                <c:pt idx="1414">
                  <c:v>0.6940653336154935</c:v>
                </c:pt>
                <c:pt idx="1415">
                  <c:v>1.4987113535423426</c:v>
                </c:pt>
                <c:pt idx="1416">
                  <c:v>0.62564640628218327</c:v>
                </c:pt>
                <c:pt idx="1417">
                  <c:v>0.31657903796748199</c:v>
                </c:pt>
                <c:pt idx="1418">
                  <c:v>0.55258419857616048</c:v>
                </c:pt>
                <c:pt idx="1419">
                  <c:v>0.32935877857783091</c:v>
                </c:pt>
                <c:pt idx="1420">
                  <c:v>1.6307742398947054</c:v>
                </c:pt>
                <c:pt idx="1421">
                  <c:v>1.2209059071513166</c:v>
                </c:pt>
                <c:pt idx="1422">
                  <c:v>0.1893934207066871</c:v>
                </c:pt>
                <c:pt idx="1423">
                  <c:v>0.43892546468160754</c:v>
                </c:pt>
                <c:pt idx="1424">
                  <c:v>0.28273298632512522</c:v>
                </c:pt>
                <c:pt idx="1425">
                  <c:v>0.51880915573920627</c:v>
                </c:pt>
                <c:pt idx="1426">
                  <c:v>0.59353388692074371</c:v>
                </c:pt>
                <c:pt idx="1427">
                  <c:v>0.49274303612909337</c:v>
                </c:pt>
                <c:pt idx="1428">
                  <c:v>0.21659487447803094</c:v>
                </c:pt>
                <c:pt idx="1429">
                  <c:v>0.79572619009547274</c:v>
                </c:pt>
                <c:pt idx="1430">
                  <c:v>3.844276417163753E-3</c:v>
                </c:pt>
                <c:pt idx="1431">
                  <c:v>0.30087639553749956</c:v>
                </c:pt>
                <c:pt idx="1432">
                  <c:v>0.48681506127785551</c:v>
                </c:pt>
                <c:pt idx="1433">
                  <c:v>0.31278987049344886</c:v>
                </c:pt>
                <c:pt idx="1434">
                  <c:v>0.71134221792783248</c:v>
                </c:pt>
                <c:pt idx="1435">
                  <c:v>0.25316304924307198</c:v>
                </c:pt>
                <c:pt idx="1436">
                  <c:v>0.5866881520696805</c:v>
                </c:pt>
                <c:pt idx="1437">
                  <c:v>0.15808004960952962</c:v>
                </c:pt>
                <c:pt idx="1438">
                  <c:v>0.14495495566376987</c:v>
                </c:pt>
                <c:pt idx="1439">
                  <c:v>0.26050864492467601</c:v>
                </c:pt>
                <c:pt idx="1440">
                  <c:v>0.64693738613687923</c:v>
                </c:pt>
                <c:pt idx="1441">
                  <c:v>3.889345892040283E-3</c:v>
                </c:pt>
                <c:pt idx="1442">
                  <c:v>0.72023585431485626</c:v>
                </c:pt>
                <c:pt idx="1443">
                  <c:v>0.71490209399551197</c:v>
                </c:pt>
                <c:pt idx="1444">
                  <c:v>0.27915449077104215</c:v>
                </c:pt>
                <c:pt idx="1445">
                  <c:v>0.41195729453863378</c:v>
                </c:pt>
                <c:pt idx="1446">
                  <c:v>0.29376393879336682</c:v>
                </c:pt>
                <c:pt idx="1447">
                  <c:v>0.22348171479718545</c:v>
                </c:pt>
                <c:pt idx="1448">
                  <c:v>1.1544583698234967</c:v>
                </c:pt>
                <c:pt idx="1449">
                  <c:v>0.88230770924167112</c:v>
                </c:pt>
                <c:pt idx="1450">
                  <c:v>0.49638430361175051</c:v>
                </c:pt>
                <c:pt idx="1451">
                  <c:v>0.5867197961632078</c:v>
                </c:pt>
                <c:pt idx="1452">
                  <c:v>0.29168314525501948</c:v>
                </c:pt>
                <c:pt idx="1453">
                  <c:v>0.67426263277731502</c:v>
                </c:pt>
                <c:pt idx="1454">
                  <c:v>0.83791580018598499</c:v>
                </c:pt>
                <c:pt idx="1455">
                  <c:v>0.17881352456273428</c:v>
                </c:pt>
                <c:pt idx="1456">
                  <c:v>0.88930700657024797</c:v>
                </c:pt>
                <c:pt idx="1457">
                  <c:v>0.32415023760311445</c:v>
                </c:pt>
                <c:pt idx="1458">
                  <c:v>0.95610656471705036</c:v>
                </c:pt>
                <c:pt idx="1459">
                  <c:v>0.60697221141140301</c:v>
                </c:pt>
                <c:pt idx="1460">
                  <c:v>0.45149916342025515</c:v>
                </c:pt>
                <c:pt idx="1461">
                  <c:v>0.27742990245533777</c:v>
                </c:pt>
                <c:pt idx="1462">
                  <c:v>0.90193846628161622</c:v>
                </c:pt>
                <c:pt idx="1463">
                  <c:v>0.42845514198892543</c:v>
                </c:pt>
                <c:pt idx="1464">
                  <c:v>0.8770793403371292</c:v>
                </c:pt>
                <c:pt idx="1465">
                  <c:v>0.26578280283734862</c:v>
                </c:pt>
                <c:pt idx="1466">
                  <c:v>3.4129739352266965E-2</c:v>
                </c:pt>
                <c:pt idx="1467">
                  <c:v>0.56621258568133181</c:v>
                </c:pt>
                <c:pt idx="1468">
                  <c:v>0.1989134636248929</c:v>
                </c:pt>
                <c:pt idx="1469">
                  <c:v>5.0187578571013976E-2</c:v>
                </c:pt>
                <c:pt idx="1470">
                  <c:v>0.79830228730578345</c:v>
                </c:pt>
                <c:pt idx="1471">
                  <c:v>1.420248147966271</c:v>
                </c:pt>
                <c:pt idx="1472">
                  <c:v>6.1337318710553299E-2</c:v>
                </c:pt>
                <c:pt idx="1473">
                  <c:v>6.9947693640300942E-2</c:v>
                </c:pt>
                <c:pt idx="1474">
                  <c:v>0.99799911077790537</c:v>
                </c:pt>
                <c:pt idx="1475">
                  <c:v>0.14742212536963062</c:v>
                </c:pt>
                <c:pt idx="1476">
                  <c:v>7.4716981677248384E-2</c:v>
                </c:pt>
                <c:pt idx="1477">
                  <c:v>1.3627258204247483</c:v>
                </c:pt>
                <c:pt idx="1478">
                  <c:v>0.52948929665047317</c:v>
                </c:pt>
                <c:pt idx="1479">
                  <c:v>5.9108446347021469E-2</c:v>
                </c:pt>
                <c:pt idx="1480">
                  <c:v>0.78244318170862226</c:v>
                </c:pt>
                <c:pt idx="1481">
                  <c:v>0.2992448729619413</c:v>
                </c:pt>
                <c:pt idx="1482">
                  <c:v>0.21003300189028914</c:v>
                </c:pt>
                <c:pt idx="1483">
                  <c:v>0.49905291479248132</c:v>
                </c:pt>
                <c:pt idx="1484">
                  <c:v>1.0076961015808736</c:v>
                </c:pt>
                <c:pt idx="1485">
                  <c:v>0.44721347462583377</c:v>
                </c:pt>
                <c:pt idx="1486">
                  <c:v>0.13970217605954396</c:v>
                </c:pt>
                <c:pt idx="1487">
                  <c:v>0.45719081605577561</c:v>
                </c:pt>
                <c:pt idx="1488">
                  <c:v>0.18978089322819652</c:v>
                </c:pt>
                <c:pt idx="1489">
                  <c:v>0.9206738599687655</c:v>
                </c:pt>
                <c:pt idx="1490">
                  <c:v>1.2027956420970294</c:v>
                </c:pt>
                <c:pt idx="1491">
                  <c:v>6.1264589265904959E-2</c:v>
                </c:pt>
                <c:pt idx="1492">
                  <c:v>0.4262866420454145</c:v>
                </c:pt>
                <c:pt idx="1493">
                  <c:v>0.29147239879649739</c:v>
                </c:pt>
                <c:pt idx="1494">
                  <c:v>0.89386104759674778</c:v>
                </c:pt>
                <c:pt idx="1495">
                  <c:v>0.2558357144237563</c:v>
                </c:pt>
                <c:pt idx="1496">
                  <c:v>0.25100365660467622</c:v>
                </c:pt>
                <c:pt idx="1497">
                  <c:v>1.0949496453263654</c:v>
                </c:pt>
                <c:pt idx="1498">
                  <c:v>0.12877389558044544</c:v>
                </c:pt>
                <c:pt idx="1499">
                  <c:v>0.17534461639417934</c:v>
                </c:pt>
                <c:pt idx="1500">
                  <c:v>0.53004802531961981</c:v>
                </c:pt>
                <c:pt idx="1501">
                  <c:v>0.39169514298913355</c:v>
                </c:pt>
                <c:pt idx="1502">
                  <c:v>7.9067901329501769E-2</c:v>
                </c:pt>
                <c:pt idx="1503">
                  <c:v>0.20388772860345067</c:v>
                </c:pt>
                <c:pt idx="1504">
                  <c:v>1.3797802033285827E-2</c:v>
                </c:pt>
                <c:pt idx="1505">
                  <c:v>0.4257887496275079</c:v>
                </c:pt>
                <c:pt idx="1506">
                  <c:v>0.32951806831090474</c:v>
                </c:pt>
                <c:pt idx="1507">
                  <c:v>0.27312100240834969</c:v>
                </c:pt>
                <c:pt idx="1508">
                  <c:v>0.14226211959858523</c:v>
                </c:pt>
                <c:pt idx="1509">
                  <c:v>0.48313774918684932</c:v>
                </c:pt>
                <c:pt idx="1510">
                  <c:v>0.36859744966603669</c:v>
                </c:pt>
                <c:pt idx="1511">
                  <c:v>1.0160393586621643</c:v>
                </c:pt>
                <c:pt idx="1512">
                  <c:v>0.43598683335804583</c:v>
                </c:pt>
                <c:pt idx="1513">
                  <c:v>0.38804543225663968</c:v>
                </c:pt>
                <c:pt idx="1514">
                  <c:v>7.7993700661126056E-2</c:v>
                </c:pt>
                <c:pt idx="1515">
                  <c:v>0.23591072648191472</c:v>
                </c:pt>
                <c:pt idx="1516">
                  <c:v>0.51028139206222378</c:v>
                </c:pt>
                <c:pt idx="1517">
                  <c:v>0.29278688798612745</c:v>
                </c:pt>
                <c:pt idx="1518">
                  <c:v>0.17787845758645227</c:v>
                </c:pt>
                <c:pt idx="1519">
                  <c:v>0.48927215228429488</c:v>
                </c:pt>
                <c:pt idx="1520">
                  <c:v>0.24149935996023</c:v>
                </c:pt>
                <c:pt idx="1521">
                  <c:v>1.5639140136522003</c:v>
                </c:pt>
                <c:pt idx="1522">
                  <c:v>1.0705534385190263</c:v>
                </c:pt>
                <c:pt idx="1523">
                  <c:v>0.13961609857249979</c:v>
                </c:pt>
                <c:pt idx="1524">
                  <c:v>0.47866943658452116</c:v>
                </c:pt>
                <c:pt idx="1525">
                  <c:v>0.3475432234625831</c:v>
                </c:pt>
                <c:pt idx="1526">
                  <c:v>7.935466102075607E-2</c:v>
                </c:pt>
                <c:pt idx="1527">
                  <c:v>0.21666490609426059</c:v>
                </c:pt>
                <c:pt idx="1528">
                  <c:v>0.7363073344114266</c:v>
                </c:pt>
                <c:pt idx="1529">
                  <c:v>1.3851373066168438</c:v>
                </c:pt>
                <c:pt idx="1530">
                  <c:v>2.566283902301152E-2</c:v>
                </c:pt>
                <c:pt idx="1531">
                  <c:v>0.65312184696230946</c:v>
                </c:pt>
                <c:pt idx="1532">
                  <c:v>0.11117191149342945</c:v>
                </c:pt>
                <c:pt idx="1533">
                  <c:v>1.5349807177511066</c:v>
                </c:pt>
                <c:pt idx="1534">
                  <c:v>0.11937259646458012</c:v>
                </c:pt>
                <c:pt idx="1535">
                  <c:v>0.93399383367057909</c:v>
                </c:pt>
                <c:pt idx="1536">
                  <c:v>1.2086721809744716</c:v>
                </c:pt>
                <c:pt idx="1537">
                  <c:v>0.39494567470665093</c:v>
                </c:pt>
                <c:pt idx="1538">
                  <c:v>1.5222121908661381</c:v>
                </c:pt>
                <c:pt idx="1539">
                  <c:v>0.76350864323639234</c:v>
                </c:pt>
                <c:pt idx="1540">
                  <c:v>0.15760891387017062</c:v>
                </c:pt>
                <c:pt idx="1541">
                  <c:v>0.7696258072610429</c:v>
                </c:pt>
                <c:pt idx="1542">
                  <c:v>7.8032214919392565E-2</c:v>
                </c:pt>
                <c:pt idx="1543">
                  <c:v>0.45695786423581636</c:v>
                </c:pt>
                <c:pt idx="1544">
                  <c:v>0.72468747727192528</c:v>
                </c:pt>
                <c:pt idx="1545">
                  <c:v>0.13488817010230081</c:v>
                </c:pt>
                <c:pt idx="1546">
                  <c:v>0.66692126957210729</c:v>
                </c:pt>
                <c:pt idx="1547">
                  <c:v>0.27206775849952858</c:v>
                </c:pt>
                <c:pt idx="1548">
                  <c:v>0.2332498482929658</c:v>
                </c:pt>
                <c:pt idx="1549">
                  <c:v>0.24225491585576808</c:v>
                </c:pt>
                <c:pt idx="1550">
                  <c:v>0.19523617929086937</c:v>
                </c:pt>
                <c:pt idx="1551">
                  <c:v>0.17201110062100064</c:v>
                </c:pt>
                <c:pt idx="1552">
                  <c:v>0.59316076419035946</c:v>
                </c:pt>
                <c:pt idx="1553">
                  <c:v>0.70488459214380994</c:v>
                </c:pt>
                <c:pt idx="1554">
                  <c:v>2.2904246940688942</c:v>
                </c:pt>
                <c:pt idx="1555">
                  <c:v>0.41285334507790633</c:v>
                </c:pt>
                <c:pt idx="1556">
                  <c:v>1.0421058068560058</c:v>
                </c:pt>
                <c:pt idx="1557">
                  <c:v>0.16631002130434117</c:v>
                </c:pt>
                <c:pt idx="1558">
                  <c:v>0.86992395269755074</c:v>
                </c:pt>
                <c:pt idx="1559">
                  <c:v>0.29735987482676679</c:v>
                </c:pt>
                <c:pt idx="1560">
                  <c:v>1.0355332388203089</c:v>
                </c:pt>
                <c:pt idx="1561">
                  <c:v>0.17629549095148087</c:v>
                </c:pt>
                <c:pt idx="1562">
                  <c:v>1.0632072370132037</c:v>
                </c:pt>
                <c:pt idx="1563">
                  <c:v>0.37495016370458456</c:v>
                </c:pt>
                <c:pt idx="1564">
                  <c:v>0.43028890155070232</c:v>
                </c:pt>
                <c:pt idx="1565">
                  <c:v>0.65623614647155837</c:v>
                </c:pt>
                <c:pt idx="1566">
                  <c:v>0.29583637127022044</c:v>
                </c:pt>
                <c:pt idx="1567">
                  <c:v>0.59937159161299025</c:v>
                </c:pt>
                <c:pt idx="1568">
                  <c:v>0.49891587361521772</c:v>
                </c:pt>
                <c:pt idx="1569">
                  <c:v>0.71423508497371202</c:v>
                </c:pt>
                <c:pt idx="1570">
                  <c:v>0.58309036011145288</c:v>
                </c:pt>
                <c:pt idx="1571">
                  <c:v>8.7358461994242562E-2</c:v>
                </c:pt>
                <c:pt idx="1572">
                  <c:v>0.6206742194057433</c:v>
                </c:pt>
                <c:pt idx="1573">
                  <c:v>0.5084102157533793</c:v>
                </c:pt>
                <c:pt idx="1574">
                  <c:v>0.28692214657416565</c:v>
                </c:pt>
                <c:pt idx="1575">
                  <c:v>0.44072914793790391</c:v>
                </c:pt>
                <c:pt idx="1576">
                  <c:v>0.71616040852685481</c:v>
                </c:pt>
                <c:pt idx="1577">
                  <c:v>0.49799339849105262</c:v>
                </c:pt>
                <c:pt idx="1578">
                  <c:v>0.38231090868359596</c:v>
                </c:pt>
                <c:pt idx="1579">
                  <c:v>0.11756287335353485</c:v>
                </c:pt>
                <c:pt idx="1580">
                  <c:v>0.73079378392820726</c:v>
                </c:pt>
                <c:pt idx="1581">
                  <c:v>0.42986997109112202</c:v>
                </c:pt>
                <c:pt idx="1582">
                  <c:v>8.9977282418368609E-2</c:v>
                </c:pt>
                <c:pt idx="1583">
                  <c:v>0.66121213585426009</c:v>
                </c:pt>
                <c:pt idx="1584">
                  <c:v>0.49394726174256554</c:v>
                </c:pt>
                <c:pt idx="1585">
                  <c:v>1.8326745383921851E-2</c:v>
                </c:pt>
                <c:pt idx="1586">
                  <c:v>1.9920882435364769E-2</c:v>
                </c:pt>
                <c:pt idx="1587">
                  <c:v>2.5955320237736959E-2</c:v>
                </c:pt>
                <c:pt idx="1588">
                  <c:v>7.5397420032609574E-2</c:v>
                </c:pt>
                <c:pt idx="1589">
                  <c:v>5.3868060789076404E-2</c:v>
                </c:pt>
                <c:pt idx="1590">
                  <c:v>4.7983065585595182E-2</c:v>
                </c:pt>
                <c:pt idx="1591">
                  <c:v>8.3849190380975949E-2</c:v>
                </c:pt>
                <c:pt idx="1592">
                  <c:v>0.40372806726011834</c:v>
                </c:pt>
                <c:pt idx="1593">
                  <c:v>5.7825870009529856E-3</c:v>
                </c:pt>
                <c:pt idx="1594">
                  <c:v>0.72426956377925422</c:v>
                </c:pt>
                <c:pt idx="1595">
                  <c:v>0.31592599425922135</c:v>
                </c:pt>
                <c:pt idx="1596">
                  <c:v>1.1541346420994041E-2</c:v>
                </c:pt>
                <c:pt idx="1597">
                  <c:v>0.6591407608139036</c:v>
                </c:pt>
                <c:pt idx="1598">
                  <c:v>0.7468467544268198</c:v>
                </c:pt>
                <c:pt idx="1599">
                  <c:v>0.43289525842455939</c:v>
                </c:pt>
                <c:pt idx="1600">
                  <c:v>0.84260417400918208</c:v>
                </c:pt>
                <c:pt idx="1601">
                  <c:v>0.48046524556007136</c:v>
                </c:pt>
                <c:pt idx="1602">
                  <c:v>0.11665078776320979</c:v>
                </c:pt>
                <c:pt idx="1603">
                  <c:v>0.58751627898504566</c:v>
                </c:pt>
                <c:pt idx="1604">
                  <c:v>1.2977563926817477</c:v>
                </c:pt>
                <c:pt idx="1605">
                  <c:v>0.15261778501197981</c:v>
                </c:pt>
                <c:pt idx="1606">
                  <c:v>0.1360854277050961</c:v>
                </c:pt>
                <c:pt idx="1607">
                  <c:v>1.035511562917887</c:v>
                </c:pt>
                <c:pt idx="1608">
                  <c:v>0.30180236197271226</c:v>
                </c:pt>
                <c:pt idx="1609">
                  <c:v>0.27201614847567773</c:v>
                </c:pt>
                <c:pt idx="1610">
                  <c:v>0.32026187390248917</c:v>
                </c:pt>
                <c:pt idx="1611">
                  <c:v>0.25905843832407838</c:v>
                </c:pt>
                <c:pt idx="1612">
                  <c:v>1.176790038718555</c:v>
                </c:pt>
                <c:pt idx="1613">
                  <c:v>1.2632370606436458</c:v>
                </c:pt>
                <c:pt idx="1614">
                  <c:v>0.98241537394786627</c:v>
                </c:pt>
                <c:pt idx="1615">
                  <c:v>0.49865545252868493</c:v>
                </c:pt>
                <c:pt idx="1616">
                  <c:v>0.17868389853913108</c:v>
                </c:pt>
                <c:pt idx="1617">
                  <c:v>0.43215334770994274</c:v>
                </c:pt>
                <c:pt idx="1618">
                  <c:v>2.3375078937364496E-2</c:v>
                </c:pt>
                <c:pt idx="1619">
                  <c:v>0.66234182828996957</c:v>
                </c:pt>
                <c:pt idx="1620">
                  <c:v>0.68045006227702109</c:v>
                </c:pt>
                <c:pt idx="1621">
                  <c:v>0.40935277781303542</c:v>
                </c:pt>
                <c:pt idx="1622">
                  <c:v>1.0283017200399946</c:v>
                </c:pt>
                <c:pt idx="1623">
                  <c:v>2.8732645864593086E-2</c:v>
                </c:pt>
                <c:pt idx="1624">
                  <c:v>0.4498431798005863</c:v>
                </c:pt>
                <c:pt idx="1625">
                  <c:v>0.44071229941344858</c:v>
                </c:pt>
                <c:pt idx="1626">
                  <c:v>0.78426859336075982</c:v>
                </c:pt>
                <c:pt idx="1627">
                  <c:v>0.29304808055298176</c:v>
                </c:pt>
                <c:pt idx="1628">
                  <c:v>0.19296075177377831</c:v>
                </c:pt>
                <c:pt idx="1629">
                  <c:v>0.13654450589753131</c:v>
                </c:pt>
                <c:pt idx="1630">
                  <c:v>0.42802463125317708</c:v>
                </c:pt>
                <c:pt idx="1631">
                  <c:v>0.77922371573430371</c:v>
                </c:pt>
                <c:pt idx="1632">
                  <c:v>0.16714568416042125</c:v>
                </c:pt>
                <c:pt idx="1633">
                  <c:v>0.51360603042086617</c:v>
                </c:pt>
                <c:pt idx="1634">
                  <c:v>0.35637146428406707</c:v>
                </c:pt>
                <c:pt idx="1635">
                  <c:v>4.1313836124433262E-2</c:v>
                </c:pt>
                <c:pt idx="1636">
                  <c:v>0.11049038516051631</c:v>
                </c:pt>
                <c:pt idx="1637">
                  <c:v>0.19804503712111157</c:v>
                </c:pt>
                <c:pt idx="1638">
                  <c:v>9.8974228238115441E-2</c:v>
                </c:pt>
                <c:pt idx="1639">
                  <c:v>0.32217362247722636</c:v>
                </c:pt>
                <c:pt idx="1640">
                  <c:v>6.0905112054442663E-2</c:v>
                </c:pt>
                <c:pt idx="1641">
                  <c:v>0.19260164271799762</c:v>
                </c:pt>
                <c:pt idx="1642">
                  <c:v>1.1300454588294901</c:v>
                </c:pt>
                <c:pt idx="1643">
                  <c:v>0.66054988147927385</c:v>
                </c:pt>
                <c:pt idx="1644">
                  <c:v>0.97812387891908104</c:v>
                </c:pt>
                <c:pt idx="1645">
                  <c:v>0.11485367046252218</c:v>
                </c:pt>
                <c:pt idx="1646">
                  <c:v>0.6572405639306983</c:v>
                </c:pt>
                <c:pt idx="1647">
                  <c:v>1.0617532535736982</c:v>
                </c:pt>
                <c:pt idx="1648">
                  <c:v>0.3498889588208699</c:v>
                </c:pt>
                <c:pt idx="1649">
                  <c:v>0.59084245804971058</c:v>
                </c:pt>
                <c:pt idx="1650">
                  <c:v>2.2906996379836144E-2</c:v>
                </c:pt>
                <c:pt idx="1651">
                  <c:v>0.42045940704627188</c:v>
                </c:pt>
                <c:pt idx="1652">
                  <c:v>0.66465632958327436</c:v>
                </c:pt>
                <c:pt idx="1653">
                  <c:v>0.74393646412149372</c:v>
                </c:pt>
                <c:pt idx="1654">
                  <c:v>0.10492703738736157</c:v>
                </c:pt>
                <c:pt idx="1655">
                  <c:v>1.4613491591662205E-2</c:v>
                </c:pt>
                <c:pt idx="1656">
                  <c:v>0.16316841101462956</c:v>
                </c:pt>
                <c:pt idx="1657">
                  <c:v>0.90994229074200061</c:v>
                </c:pt>
                <c:pt idx="1658">
                  <c:v>0.38582752123764719</c:v>
                </c:pt>
                <c:pt idx="1659">
                  <c:v>1.0049908775992191</c:v>
                </c:pt>
                <c:pt idx="1660">
                  <c:v>7.9629931886486038E-2</c:v>
                </c:pt>
                <c:pt idx="1661">
                  <c:v>0.89164539922086516</c:v>
                </c:pt>
                <c:pt idx="1662">
                  <c:v>1.3005068716061166</c:v>
                </c:pt>
                <c:pt idx="1663">
                  <c:v>0.40747644101627251</c:v>
                </c:pt>
                <c:pt idx="1664">
                  <c:v>0.41909901029216973</c:v>
                </c:pt>
                <c:pt idx="1665">
                  <c:v>0.10274187021874431</c:v>
                </c:pt>
                <c:pt idx="1666">
                  <c:v>1.1314226511922343E-2</c:v>
                </c:pt>
                <c:pt idx="1667">
                  <c:v>0.72329736707295067</c:v>
                </c:pt>
                <c:pt idx="1668">
                  <c:v>0.45936791683297351</c:v>
                </c:pt>
                <c:pt idx="1669">
                  <c:v>0.80742949436061329</c:v>
                </c:pt>
                <c:pt idx="1670">
                  <c:v>0.44548773723592211</c:v>
                </c:pt>
                <c:pt idx="1671">
                  <c:v>2.0043325747058634E-3</c:v>
                </c:pt>
                <c:pt idx="1672">
                  <c:v>0.25716984859637759</c:v>
                </c:pt>
                <c:pt idx="1673">
                  <c:v>0.98614867663466776</c:v>
                </c:pt>
                <c:pt idx="1674">
                  <c:v>0.14051913552884346</c:v>
                </c:pt>
                <c:pt idx="1675">
                  <c:v>0.27215913376065581</c:v>
                </c:pt>
                <c:pt idx="1676">
                  <c:v>0.84660445259781469</c:v>
                </c:pt>
                <c:pt idx="1677">
                  <c:v>1.1065682174625304</c:v>
                </c:pt>
                <c:pt idx="1678">
                  <c:v>0.15812137413352498</c:v>
                </c:pt>
                <c:pt idx="1679">
                  <c:v>0.63930574654883088</c:v>
                </c:pt>
                <c:pt idx="1680">
                  <c:v>5.6115176238798616E-2</c:v>
                </c:pt>
                <c:pt idx="1681">
                  <c:v>0.39918889375323863</c:v>
                </c:pt>
                <c:pt idx="1682">
                  <c:v>0.76502334295883434</c:v>
                </c:pt>
                <c:pt idx="1683">
                  <c:v>0.4761301317971956</c:v>
                </c:pt>
                <c:pt idx="1684">
                  <c:v>0.26832797128410402</c:v>
                </c:pt>
                <c:pt idx="1685">
                  <c:v>0.33767245296594811</c:v>
                </c:pt>
                <c:pt idx="1686">
                  <c:v>0.12142692157076743</c:v>
                </c:pt>
                <c:pt idx="1687">
                  <c:v>1.4603635438939608</c:v>
                </c:pt>
                <c:pt idx="1688">
                  <c:v>0.72734307857240887</c:v>
                </c:pt>
                <c:pt idx="1689">
                  <c:v>0.56917140565226942</c:v>
                </c:pt>
                <c:pt idx="1690">
                  <c:v>6.5964204040171184E-2</c:v>
                </c:pt>
                <c:pt idx="1691">
                  <c:v>0.67863486057842026</c:v>
                </c:pt>
                <c:pt idx="1692">
                  <c:v>0.74628584224443706</c:v>
                </c:pt>
                <c:pt idx="1693">
                  <c:v>0.96530582125815934</c:v>
                </c:pt>
                <c:pt idx="1694">
                  <c:v>8.0635701916703648E-2</c:v>
                </c:pt>
                <c:pt idx="1695">
                  <c:v>5.2193567872602174E-2</c:v>
                </c:pt>
                <c:pt idx="1696">
                  <c:v>0.32859739216954181</c:v>
                </c:pt>
                <c:pt idx="1697">
                  <c:v>0.2053242224432818</c:v>
                </c:pt>
                <c:pt idx="1698">
                  <c:v>0.93926318675077036</c:v>
                </c:pt>
                <c:pt idx="1699">
                  <c:v>9.9726383457650475E-2</c:v>
                </c:pt>
                <c:pt idx="1700">
                  <c:v>0.5193972819878323</c:v>
                </c:pt>
                <c:pt idx="1701">
                  <c:v>0.46238294290703935</c:v>
                </c:pt>
                <c:pt idx="1702">
                  <c:v>0.26718938421051647</c:v>
                </c:pt>
                <c:pt idx="1703">
                  <c:v>1.9927188665549542</c:v>
                </c:pt>
                <c:pt idx="1704">
                  <c:v>0.4671251736486367</c:v>
                </c:pt>
                <c:pt idx="1705">
                  <c:v>0.68923900852836573</c:v>
                </c:pt>
                <c:pt idx="1706">
                  <c:v>0.2348816670909743</c:v>
                </c:pt>
                <c:pt idx="1707">
                  <c:v>0.66307035900554079</c:v>
                </c:pt>
                <c:pt idx="1708">
                  <c:v>0.50923545675244464</c:v>
                </c:pt>
                <c:pt idx="1709">
                  <c:v>0.41405069770842201</c:v>
                </c:pt>
                <c:pt idx="1710">
                  <c:v>0.73321598588527392</c:v>
                </c:pt>
                <c:pt idx="1711">
                  <c:v>7.1531180273806894E-2</c:v>
                </c:pt>
                <c:pt idx="1712">
                  <c:v>0.10252828367617267</c:v>
                </c:pt>
                <c:pt idx="1713">
                  <c:v>0.31080914903110612</c:v>
                </c:pt>
                <c:pt idx="1714">
                  <c:v>0.24061086851589009</c:v>
                </c:pt>
                <c:pt idx="1715">
                  <c:v>1.6670850369960837E-3</c:v>
                </c:pt>
                <c:pt idx="1716">
                  <c:v>1.0150447343478819</c:v>
                </c:pt>
                <c:pt idx="1717">
                  <c:v>1.892616519193065E-2</c:v>
                </c:pt>
                <c:pt idx="1718">
                  <c:v>4.9672706432289798E-2</c:v>
                </c:pt>
                <c:pt idx="1719">
                  <c:v>0.12174693629325611</c:v>
                </c:pt>
                <c:pt idx="1720">
                  <c:v>0.35090438380521383</c:v>
                </c:pt>
                <c:pt idx="1721">
                  <c:v>0.92804746087945678</c:v>
                </c:pt>
                <c:pt idx="1722">
                  <c:v>0.70999151621477852</c:v>
                </c:pt>
                <c:pt idx="1723">
                  <c:v>0.11270390067320628</c:v>
                </c:pt>
                <c:pt idx="1724">
                  <c:v>0.15871805034311068</c:v>
                </c:pt>
                <c:pt idx="1725">
                  <c:v>0.52742861476721126</c:v>
                </c:pt>
                <c:pt idx="1726">
                  <c:v>0.90119585770211341</c:v>
                </c:pt>
                <c:pt idx="1727">
                  <c:v>1.1735009732748423</c:v>
                </c:pt>
                <c:pt idx="1728">
                  <c:v>0.3821737984723716</c:v>
                </c:pt>
                <c:pt idx="1729">
                  <c:v>0.60911109014817788</c:v>
                </c:pt>
                <c:pt idx="1730">
                  <c:v>5.7529964736163695E-2</c:v>
                </c:pt>
                <c:pt idx="1731">
                  <c:v>0.22087049346702323</c:v>
                </c:pt>
                <c:pt idx="1732">
                  <c:v>0.40547057912199846</c:v>
                </c:pt>
                <c:pt idx="1733">
                  <c:v>1.8960631299355786</c:v>
                </c:pt>
                <c:pt idx="1734">
                  <c:v>7.3153986340716598E-2</c:v>
                </c:pt>
                <c:pt idx="1735">
                  <c:v>0.16303498490733326</c:v>
                </c:pt>
                <c:pt idx="1736">
                  <c:v>0.73267467871446146</c:v>
                </c:pt>
                <c:pt idx="1737">
                  <c:v>1.1395696018315913</c:v>
                </c:pt>
                <c:pt idx="1738">
                  <c:v>0.58586425229079542</c:v>
                </c:pt>
                <c:pt idx="1739">
                  <c:v>0.26331463010610212</c:v>
                </c:pt>
                <c:pt idx="1740">
                  <c:v>9.4750664537111909E-2</c:v>
                </c:pt>
                <c:pt idx="1741">
                  <c:v>0.32291502284621632</c:v>
                </c:pt>
                <c:pt idx="1742">
                  <c:v>0.12254746510457523</c:v>
                </c:pt>
                <c:pt idx="1743">
                  <c:v>0.70267114978882561</c:v>
                </c:pt>
                <c:pt idx="1744">
                  <c:v>0.3434724129941969</c:v>
                </c:pt>
                <c:pt idx="1745">
                  <c:v>0.48988021265801357</c:v>
                </c:pt>
                <c:pt idx="1746">
                  <c:v>0.26213976245755316</c:v>
                </c:pt>
                <c:pt idx="1747">
                  <c:v>0.59778393054385393</c:v>
                </c:pt>
                <c:pt idx="1748">
                  <c:v>0.64324332266847184</c:v>
                </c:pt>
                <c:pt idx="1749">
                  <c:v>4.6196793904857321E-3</c:v>
                </c:pt>
                <c:pt idx="1750">
                  <c:v>1.4347214040155016</c:v>
                </c:pt>
                <c:pt idx="1751">
                  <c:v>5.2784315855572625E-2</c:v>
                </c:pt>
                <c:pt idx="1752">
                  <c:v>0.5277242471085053</c:v>
                </c:pt>
                <c:pt idx="1753">
                  <c:v>1.4800579284680657</c:v>
                </c:pt>
                <c:pt idx="1754">
                  <c:v>0.24784749354111754</c:v>
                </c:pt>
                <c:pt idx="1755">
                  <c:v>1.0567490954553538</c:v>
                </c:pt>
                <c:pt idx="1756">
                  <c:v>0.55713449864830966</c:v>
                </c:pt>
                <c:pt idx="1757">
                  <c:v>4.7635218447369509E-2</c:v>
                </c:pt>
                <c:pt idx="1758">
                  <c:v>0.19997218156797231</c:v>
                </c:pt>
                <c:pt idx="1759">
                  <c:v>0.52799176394368552</c:v>
                </c:pt>
                <c:pt idx="1760">
                  <c:v>0.11950129724075569</c:v>
                </c:pt>
                <c:pt idx="1761">
                  <c:v>0.63238061909074883</c:v>
                </c:pt>
                <c:pt idx="1762">
                  <c:v>0.23281270901553203</c:v>
                </c:pt>
                <c:pt idx="1763">
                  <c:v>0.50016352471600123</c:v>
                </c:pt>
                <c:pt idx="1764">
                  <c:v>0.90409577056376234</c:v>
                </c:pt>
                <c:pt idx="1765">
                  <c:v>1.9210997856552375E-2</c:v>
                </c:pt>
                <c:pt idx="1766">
                  <c:v>1.3561055285693426</c:v>
                </c:pt>
                <c:pt idx="1767">
                  <c:v>0.11798769521796737</c:v>
                </c:pt>
                <c:pt idx="1768">
                  <c:v>0.67624987001718084</c:v>
                </c:pt>
                <c:pt idx="1769">
                  <c:v>1.1949433969655607</c:v>
                </c:pt>
                <c:pt idx="1770">
                  <c:v>0.41696313464846685</c:v>
                </c:pt>
                <c:pt idx="1771">
                  <c:v>2.2117734002065497</c:v>
                </c:pt>
                <c:pt idx="1772">
                  <c:v>0.38244391894479557</c:v>
                </c:pt>
                <c:pt idx="1773">
                  <c:v>0.41098584872201072</c:v>
                </c:pt>
                <c:pt idx="1774">
                  <c:v>0.57292853000907296</c:v>
                </c:pt>
                <c:pt idx="1775">
                  <c:v>9.1446792379626857E-2</c:v>
                </c:pt>
                <c:pt idx="1776">
                  <c:v>0.43058933316141818</c:v>
                </c:pt>
                <c:pt idx="1777">
                  <c:v>0.59524160873769405</c:v>
                </c:pt>
                <c:pt idx="1778">
                  <c:v>1.201357147830995</c:v>
                </c:pt>
                <c:pt idx="1779">
                  <c:v>0.1611968289410145</c:v>
                </c:pt>
                <c:pt idx="1780">
                  <c:v>0.14457357088218833</c:v>
                </c:pt>
                <c:pt idx="1781">
                  <c:v>8.2380315526317097E-2</c:v>
                </c:pt>
                <c:pt idx="1782">
                  <c:v>0.18350585516826182</c:v>
                </c:pt>
                <c:pt idx="1783">
                  <c:v>0.98474662970166393</c:v>
                </c:pt>
                <c:pt idx="1784">
                  <c:v>0.64100917709616745</c:v>
                </c:pt>
                <c:pt idx="1785">
                  <c:v>0.64881628500633803</c:v>
                </c:pt>
                <c:pt idx="1786">
                  <c:v>0.98620130617441504</c:v>
                </c:pt>
                <c:pt idx="1787">
                  <c:v>6.2163842039593312E-2</c:v>
                </c:pt>
                <c:pt idx="1788">
                  <c:v>1.4218322755582062</c:v>
                </c:pt>
                <c:pt idx="1789">
                  <c:v>0.48447385896592665</c:v>
                </c:pt>
                <c:pt idx="1790">
                  <c:v>7.7895532720176431E-3</c:v>
                </c:pt>
                <c:pt idx="1791">
                  <c:v>0.22173900901342708</c:v>
                </c:pt>
                <c:pt idx="1792">
                  <c:v>0.22116914918640526</c:v>
                </c:pt>
                <c:pt idx="1793">
                  <c:v>0.13638666509194505</c:v>
                </c:pt>
                <c:pt idx="1794">
                  <c:v>0.12970125154736128</c:v>
                </c:pt>
                <c:pt idx="1795">
                  <c:v>0.27845659867894929</c:v>
                </c:pt>
                <c:pt idx="1796">
                  <c:v>0.67448414009325797</c:v>
                </c:pt>
                <c:pt idx="1797">
                  <c:v>0.4771569591807257</c:v>
                </c:pt>
                <c:pt idx="1798">
                  <c:v>0.55357128906615494</c:v>
                </c:pt>
                <c:pt idx="1799">
                  <c:v>0.19634358956587217</c:v>
                </c:pt>
                <c:pt idx="1800">
                  <c:v>6.28444002660552E-2</c:v>
                </c:pt>
                <c:pt idx="1801">
                  <c:v>0.50323800725615175</c:v>
                </c:pt>
                <c:pt idx="1802">
                  <c:v>7.8425986309689527E-2</c:v>
                </c:pt>
                <c:pt idx="1803">
                  <c:v>0.77792464269120942</c:v>
                </c:pt>
                <c:pt idx="1804">
                  <c:v>1.1195780980571768</c:v>
                </c:pt>
                <c:pt idx="1805">
                  <c:v>0.57933157794277623</c:v>
                </c:pt>
                <c:pt idx="1806">
                  <c:v>0.10639726592879728</c:v>
                </c:pt>
                <c:pt idx="1807">
                  <c:v>1.1408303271106164</c:v>
                </c:pt>
                <c:pt idx="1808">
                  <c:v>0.32705262554061387</c:v>
                </c:pt>
                <c:pt idx="1809">
                  <c:v>0.88169918512157242</c:v>
                </c:pt>
                <c:pt idx="1810">
                  <c:v>0.24335794648275019</c:v>
                </c:pt>
                <c:pt idx="1811">
                  <c:v>0.36313791330413492</c:v>
                </c:pt>
                <c:pt idx="1812">
                  <c:v>0.81101199489586007</c:v>
                </c:pt>
                <c:pt idx="1813">
                  <c:v>0.48799859408243262</c:v>
                </c:pt>
                <c:pt idx="1814">
                  <c:v>0.63061659910797685</c:v>
                </c:pt>
                <c:pt idx="1815">
                  <c:v>0.34622705847193674</c:v>
                </c:pt>
                <c:pt idx="1816">
                  <c:v>1.6046596794485086</c:v>
                </c:pt>
                <c:pt idx="1817">
                  <c:v>4.940142313306832E-2</c:v>
                </c:pt>
                <c:pt idx="1818">
                  <c:v>0.17077547478053065</c:v>
                </c:pt>
                <c:pt idx="1819">
                  <c:v>0.13931003370301495</c:v>
                </c:pt>
                <c:pt idx="1820">
                  <c:v>1.0306234087375039</c:v>
                </c:pt>
                <c:pt idx="1821">
                  <c:v>2.5576840693507054E-2</c:v>
                </c:pt>
                <c:pt idx="1822">
                  <c:v>0.58027552991290954</c:v>
                </c:pt>
                <c:pt idx="1823">
                  <c:v>0.19384884770478597</c:v>
                </c:pt>
                <c:pt idx="1824">
                  <c:v>0.74918012596370487</c:v>
                </c:pt>
                <c:pt idx="1825">
                  <c:v>0.37017192094697376</c:v>
                </c:pt>
                <c:pt idx="1826">
                  <c:v>0.26243602402154115</c:v>
                </c:pt>
                <c:pt idx="1827">
                  <c:v>1.1911647360120294</c:v>
                </c:pt>
                <c:pt idx="1828">
                  <c:v>1.3795799714325426E-2</c:v>
                </c:pt>
                <c:pt idx="1829">
                  <c:v>4.7190246171702643E-2</c:v>
                </c:pt>
                <c:pt idx="1830">
                  <c:v>0.37028477571217217</c:v>
                </c:pt>
                <c:pt idx="1831">
                  <c:v>0.51700768888496695</c:v>
                </c:pt>
                <c:pt idx="1832">
                  <c:v>1.0524998705578501</c:v>
                </c:pt>
                <c:pt idx="1833">
                  <c:v>0.344911491787115</c:v>
                </c:pt>
                <c:pt idx="1834">
                  <c:v>0.50100054384346271</c:v>
                </c:pt>
                <c:pt idx="1835">
                  <c:v>0.52572964299116076</c:v>
                </c:pt>
                <c:pt idx="1836">
                  <c:v>0.28980629302894412</c:v>
                </c:pt>
                <c:pt idx="1837">
                  <c:v>1.418535352468278</c:v>
                </c:pt>
                <c:pt idx="1838">
                  <c:v>5.6788209520261387E-3</c:v>
                </c:pt>
                <c:pt idx="1839">
                  <c:v>0.43331691634659003</c:v>
                </c:pt>
                <c:pt idx="1840">
                  <c:v>4.2968733077039883E-2</c:v>
                </c:pt>
                <c:pt idx="1841">
                  <c:v>7.1765638882465871E-2</c:v>
                </c:pt>
                <c:pt idx="1842">
                  <c:v>0.43567676882794898</c:v>
                </c:pt>
                <c:pt idx="1843">
                  <c:v>0.19320880453543338</c:v>
                </c:pt>
                <c:pt idx="1844">
                  <c:v>1.2705827060189678</c:v>
                </c:pt>
                <c:pt idx="1845">
                  <c:v>1.8550067019116208</c:v>
                </c:pt>
                <c:pt idx="1846">
                  <c:v>0.59312912970971232</c:v>
                </c:pt>
                <c:pt idx="1847">
                  <c:v>1.9727399545519153</c:v>
                </c:pt>
                <c:pt idx="1848">
                  <c:v>0.33519074587995251</c:v>
                </c:pt>
                <c:pt idx="1849">
                  <c:v>0.25043410825004397</c:v>
                </c:pt>
                <c:pt idx="1850">
                  <c:v>0.7153657154193338</c:v>
                </c:pt>
                <c:pt idx="1851">
                  <c:v>7.9502037178958485E-2</c:v>
                </c:pt>
                <c:pt idx="1852">
                  <c:v>0.48627208362887347</c:v>
                </c:pt>
                <c:pt idx="1853">
                  <c:v>0.94379853962187177</c:v>
                </c:pt>
                <c:pt idx="1854">
                  <c:v>0.59516850991552939</c:v>
                </c:pt>
                <c:pt idx="1855">
                  <c:v>0.20234598385794722</c:v>
                </c:pt>
                <c:pt idx="1856">
                  <c:v>0.22448330367290772</c:v>
                </c:pt>
                <c:pt idx="1857">
                  <c:v>0.72095230366869534</c:v>
                </c:pt>
                <c:pt idx="1858">
                  <c:v>1.4135429554216858</c:v>
                </c:pt>
                <c:pt idx="1859">
                  <c:v>0.66236080739954351</c:v>
                </c:pt>
                <c:pt idx="1860">
                  <c:v>0.46371925409861559</c:v>
                </c:pt>
                <c:pt idx="1861">
                  <c:v>1.0345871992378877</c:v>
                </c:pt>
                <c:pt idx="1862">
                  <c:v>2.0550719557064316</c:v>
                </c:pt>
                <c:pt idx="1863">
                  <c:v>0.18382275506974827</c:v>
                </c:pt>
                <c:pt idx="1864">
                  <c:v>0.11758681696597369</c:v>
                </c:pt>
                <c:pt idx="1865">
                  <c:v>8.7867340940805033E-2</c:v>
                </c:pt>
                <c:pt idx="1866">
                  <c:v>0.43989482424730936</c:v>
                </c:pt>
                <c:pt idx="1867">
                  <c:v>0.28984977294459596</c:v>
                </c:pt>
                <c:pt idx="1868">
                  <c:v>0.12203730412384713</c:v>
                </c:pt>
                <c:pt idx="1869">
                  <c:v>0.51295507287073694</c:v>
                </c:pt>
                <c:pt idx="1870">
                  <c:v>0.8510143782101165</c:v>
                </c:pt>
                <c:pt idx="1871">
                  <c:v>4.7870076672215045E-2</c:v>
                </c:pt>
                <c:pt idx="1872">
                  <c:v>1.5197193296137776</c:v>
                </c:pt>
                <c:pt idx="1873">
                  <c:v>1.3680634160023168</c:v>
                </c:pt>
                <c:pt idx="1874">
                  <c:v>0.2406476509140888</c:v>
                </c:pt>
                <c:pt idx="1875">
                  <c:v>0.44039827869055037</c:v>
                </c:pt>
                <c:pt idx="1876">
                  <c:v>6.1586073082488244E-2</c:v>
                </c:pt>
                <c:pt idx="1877">
                  <c:v>0.23924966150941668</c:v>
                </c:pt>
                <c:pt idx="1878">
                  <c:v>0.86850886455273324</c:v>
                </c:pt>
                <c:pt idx="1879">
                  <c:v>0.15195926654224018</c:v>
                </c:pt>
                <c:pt idx="1880">
                  <c:v>0.60572355477609352</c:v>
                </c:pt>
                <c:pt idx="1881">
                  <c:v>0.96882141686792456</c:v>
                </c:pt>
                <c:pt idx="1882">
                  <c:v>1.0623389111995065</c:v>
                </c:pt>
                <c:pt idx="1883">
                  <c:v>0.68871370548884681</c:v>
                </c:pt>
                <c:pt idx="1884">
                  <c:v>0.68020600924098029</c:v>
                </c:pt>
                <c:pt idx="1885">
                  <c:v>0.89601917032096445</c:v>
                </c:pt>
                <c:pt idx="1886">
                  <c:v>0.90707678974050698</c:v>
                </c:pt>
                <c:pt idx="1887">
                  <c:v>1.1842123179552684</c:v>
                </c:pt>
                <c:pt idx="1888">
                  <c:v>9.8114350670972211E-2</c:v>
                </c:pt>
                <c:pt idx="1889">
                  <c:v>0.30293041201130294</c:v>
                </c:pt>
                <c:pt idx="1890">
                  <c:v>0.88487321990653867</c:v>
                </c:pt>
                <c:pt idx="1891">
                  <c:v>0.4522479145913561</c:v>
                </c:pt>
                <c:pt idx="1892">
                  <c:v>0.12518139393439714</c:v>
                </c:pt>
                <c:pt idx="1893">
                  <c:v>0.56388735814067792</c:v>
                </c:pt>
                <c:pt idx="1894">
                  <c:v>0.81077540253742808</c:v>
                </c:pt>
                <c:pt idx="1895">
                  <c:v>0.99381581747602932</c:v>
                </c:pt>
                <c:pt idx="1896">
                  <c:v>0.27565141157373835</c:v>
                </c:pt>
                <c:pt idx="1897">
                  <c:v>1.2951410980093248</c:v>
                </c:pt>
                <c:pt idx="1898">
                  <c:v>0.67763969642388922</c:v>
                </c:pt>
                <c:pt idx="1899">
                  <c:v>0.38279017296470963</c:v>
                </c:pt>
                <c:pt idx="1900">
                  <c:v>1.4879496125847926</c:v>
                </c:pt>
                <c:pt idx="1901">
                  <c:v>0.5862723460081285</c:v>
                </c:pt>
                <c:pt idx="1902">
                  <c:v>1.6506368944831638</c:v>
                </c:pt>
                <c:pt idx="1903">
                  <c:v>0.3084241925775334</c:v>
                </c:pt>
                <c:pt idx="1904">
                  <c:v>0.13456523653476241</c:v>
                </c:pt>
                <c:pt idx="1905">
                  <c:v>3.4161550426322164E-2</c:v>
                </c:pt>
                <c:pt idx="1906">
                  <c:v>0.1214048146085014</c:v>
                </c:pt>
                <c:pt idx="1907">
                  <c:v>0.74905993363583467</c:v>
                </c:pt>
                <c:pt idx="1908">
                  <c:v>0.31767579442779198</c:v>
                </c:pt>
                <c:pt idx="1909">
                  <c:v>1.5688902125814161</c:v>
                </c:pt>
                <c:pt idx="1910">
                  <c:v>8.9399952541618588E-2</c:v>
                </c:pt>
                <c:pt idx="1911">
                  <c:v>0.2778022409871716</c:v>
                </c:pt>
                <c:pt idx="1912">
                  <c:v>0.23603925596918893</c:v>
                </c:pt>
                <c:pt idx="1913">
                  <c:v>4.1753495477891985E-2</c:v>
                </c:pt>
                <c:pt idx="1914">
                  <c:v>0.58707608896148888</c:v>
                </c:pt>
                <c:pt idx="1915">
                  <c:v>0.87441887745605196</c:v>
                </c:pt>
                <c:pt idx="1916">
                  <c:v>0.17957897845535406</c:v>
                </c:pt>
                <c:pt idx="1917">
                  <c:v>0.71562530860152762</c:v>
                </c:pt>
                <c:pt idx="1918">
                  <c:v>0.65562771168888545</c:v>
                </c:pt>
                <c:pt idx="1919">
                  <c:v>0.26083284360979914</c:v>
                </c:pt>
                <c:pt idx="1920">
                  <c:v>0.21671255716406049</c:v>
                </c:pt>
                <c:pt idx="1921">
                  <c:v>1.098498451624123</c:v>
                </c:pt>
                <c:pt idx="1922">
                  <c:v>1.7316588492415871E-3</c:v>
                </c:pt>
                <c:pt idx="1923">
                  <c:v>1.4345092711602692</c:v>
                </c:pt>
                <c:pt idx="1924">
                  <c:v>0.15390432441779112</c:v>
                </c:pt>
                <c:pt idx="1925">
                  <c:v>0.76392685596013876</c:v>
                </c:pt>
                <c:pt idx="1926">
                  <c:v>0.6418744913872716</c:v>
                </c:pt>
                <c:pt idx="1927">
                  <c:v>2.178092711702976</c:v>
                </c:pt>
                <c:pt idx="1928">
                  <c:v>9.9348255850835853E-3</c:v>
                </c:pt>
                <c:pt idx="1929">
                  <c:v>2.0813327821361538</c:v>
                </c:pt>
                <c:pt idx="1930">
                  <c:v>0.25103990847556423</c:v>
                </c:pt>
                <c:pt idx="1931">
                  <c:v>0.49828809083261649</c:v>
                </c:pt>
                <c:pt idx="1932">
                  <c:v>0.14758750233783879</c:v>
                </c:pt>
                <c:pt idx="1933">
                  <c:v>0.98680853406508018</c:v>
                </c:pt>
                <c:pt idx="1934">
                  <c:v>0.54457656019738798</c:v>
                </c:pt>
                <c:pt idx="1935">
                  <c:v>0.54711493394455268</c:v>
                </c:pt>
                <c:pt idx="1936">
                  <c:v>0.91305755381295273</c:v>
                </c:pt>
                <c:pt idx="1937">
                  <c:v>0.17024342610443183</c:v>
                </c:pt>
                <c:pt idx="1938">
                  <c:v>6.6828932536026134E-2</c:v>
                </c:pt>
                <c:pt idx="1939">
                  <c:v>0.39696361152395709</c:v>
                </c:pt>
                <c:pt idx="1940">
                  <c:v>2.1980901307374873E-2</c:v>
                </c:pt>
                <c:pt idx="1941">
                  <c:v>3.8530500478604582E-2</c:v>
                </c:pt>
                <c:pt idx="1942">
                  <c:v>0.13079065253685662</c:v>
                </c:pt>
                <c:pt idx="1943">
                  <c:v>0.29686808051863495</c:v>
                </c:pt>
                <c:pt idx="1944">
                  <c:v>0.16710080353762655</c:v>
                </c:pt>
                <c:pt idx="1945">
                  <c:v>0.96930666204524696</c:v>
                </c:pt>
                <c:pt idx="1946">
                  <c:v>0.31644718821253648</c:v>
                </c:pt>
                <c:pt idx="1947">
                  <c:v>0.76337444846715274</c:v>
                </c:pt>
                <c:pt idx="1948">
                  <c:v>0.44428362064258853</c:v>
                </c:pt>
                <c:pt idx="1949">
                  <c:v>0.30908994597710487</c:v>
                </c:pt>
                <c:pt idx="1950">
                  <c:v>0.48091451313951789</c:v>
                </c:pt>
                <c:pt idx="1951">
                  <c:v>0.114164539305355</c:v>
                </c:pt>
                <c:pt idx="1952">
                  <c:v>0.94970976426340381</c:v>
                </c:pt>
                <c:pt idx="1953">
                  <c:v>0.21203050666131026</c:v>
                </c:pt>
                <c:pt idx="1954">
                  <c:v>2.3664604823752131E-2</c:v>
                </c:pt>
                <c:pt idx="1955">
                  <c:v>5.0130267747697986E-2</c:v>
                </c:pt>
                <c:pt idx="1956">
                  <c:v>0.74265292146324713</c:v>
                </c:pt>
                <c:pt idx="1957">
                  <c:v>0.33994262340156861</c:v>
                </c:pt>
                <c:pt idx="1958">
                  <c:v>0.33992308299987983</c:v>
                </c:pt>
                <c:pt idx="1959">
                  <c:v>9.1961166625855184E-2</c:v>
                </c:pt>
                <c:pt idx="1960">
                  <c:v>0.36513219139255421</c:v>
                </c:pt>
                <c:pt idx="1961">
                  <c:v>0.34639021240646095</c:v>
                </c:pt>
                <c:pt idx="1962">
                  <c:v>0.15282224971414102</c:v>
                </c:pt>
                <c:pt idx="1963">
                  <c:v>0.17801691481268009</c:v>
                </c:pt>
                <c:pt idx="1964">
                  <c:v>1.0014286838746407</c:v>
                </c:pt>
                <c:pt idx="1965">
                  <c:v>0.37174669872680616</c:v>
                </c:pt>
                <c:pt idx="1966">
                  <c:v>1.4956234424760022</c:v>
                </c:pt>
                <c:pt idx="1967">
                  <c:v>0.39957886500015211</c:v>
                </c:pt>
                <c:pt idx="1968">
                  <c:v>9.2494861297672034E-3</c:v>
                </c:pt>
                <c:pt idx="1969">
                  <c:v>1.4817664877055932</c:v>
                </c:pt>
                <c:pt idx="1970">
                  <c:v>0.20231795627019114</c:v>
                </c:pt>
                <c:pt idx="1971">
                  <c:v>0.24524912480882669</c:v>
                </c:pt>
                <c:pt idx="1972">
                  <c:v>0.79593944524859606</c:v>
                </c:pt>
                <c:pt idx="1973">
                  <c:v>0.77090609698927859</c:v>
                </c:pt>
                <c:pt idx="1974">
                  <c:v>0.1522379376656082</c:v>
                </c:pt>
                <c:pt idx="1975">
                  <c:v>1.0621089883614452</c:v>
                </c:pt>
                <c:pt idx="1976">
                  <c:v>0.12884738185024425</c:v>
                </c:pt>
                <c:pt idx="1977">
                  <c:v>6.3292089666049985E-3</c:v>
                </c:pt>
                <c:pt idx="1978">
                  <c:v>7.9578251295567934E-2</c:v>
                </c:pt>
                <c:pt idx="1979">
                  <c:v>0.30208903165832995</c:v>
                </c:pt>
                <c:pt idx="1980">
                  <c:v>0.56708946077201572</c:v>
                </c:pt>
                <c:pt idx="1981">
                  <c:v>7.1726731467374974E-2</c:v>
                </c:pt>
                <c:pt idx="1982">
                  <c:v>0.50192107751727777</c:v>
                </c:pt>
                <c:pt idx="1983">
                  <c:v>1.0089887506329267</c:v>
                </c:pt>
                <c:pt idx="1984">
                  <c:v>0.4356354449184463</c:v>
                </c:pt>
                <c:pt idx="1985">
                  <c:v>0.27247332639982069</c:v>
                </c:pt>
                <c:pt idx="1986">
                  <c:v>0.71922789181968261</c:v>
                </c:pt>
                <c:pt idx="1987">
                  <c:v>0.40730483793958144</c:v>
                </c:pt>
                <c:pt idx="1988">
                  <c:v>0.1087783695974357</c:v>
                </c:pt>
                <c:pt idx="1989">
                  <c:v>0.609040675799711</c:v>
                </c:pt>
                <c:pt idx="1990">
                  <c:v>0.38828474210367109</c:v>
                </c:pt>
                <c:pt idx="1991">
                  <c:v>0.63092971844879486</c:v>
                </c:pt>
                <c:pt idx="1992">
                  <c:v>0.16890941164359377</c:v>
                </c:pt>
                <c:pt idx="1993">
                  <c:v>0.42354183597600781</c:v>
                </c:pt>
                <c:pt idx="1994">
                  <c:v>1.122893339501523</c:v>
                </c:pt>
                <c:pt idx="1995">
                  <c:v>0.2166483962870743</c:v>
                </c:pt>
                <c:pt idx="1996">
                  <c:v>3.6025777175414143E-2</c:v>
                </c:pt>
                <c:pt idx="1997">
                  <c:v>0.70200902075274563</c:v>
                </c:pt>
                <c:pt idx="1998">
                  <c:v>0.45821756256045609</c:v>
                </c:pt>
                <c:pt idx="1999">
                  <c:v>0.24418176065257502</c:v>
                </c:pt>
                <c:pt idx="2000">
                  <c:v>7.7016757031915697E-2</c:v>
                </c:pt>
                <c:pt idx="2001">
                  <c:v>6.5203878808414314E-2</c:v>
                </c:pt>
                <c:pt idx="2002">
                  <c:v>1.518314911886398E-3</c:v>
                </c:pt>
                <c:pt idx="2003">
                  <c:v>0.18739120206207691</c:v>
                </c:pt>
                <c:pt idx="2004">
                  <c:v>0.33588823837403214</c:v>
                </c:pt>
                <c:pt idx="2005">
                  <c:v>0.31413900751941976</c:v>
                </c:pt>
                <c:pt idx="2006">
                  <c:v>0.32431992032020096</c:v>
                </c:pt>
                <c:pt idx="2007">
                  <c:v>0.86233735202652384</c:v>
                </c:pt>
                <c:pt idx="2008">
                  <c:v>1.2662746754539145</c:v>
                </c:pt>
                <c:pt idx="2009">
                  <c:v>6.2129694483026687E-2</c:v>
                </c:pt>
                <c:pt idx="2010">
                  <c:v>0.8506964357181106</c:v>
                </c:pt>
                <c:pt idx="2011">
                  <c:v>1.3201864547548439</c:v>
                </c:pt>
                <c:pt idx="2012">
                  <c:v>0.66576975102596148</c:v>
                </c:pt>
                <c:pt idx="2013">
                  <c:v>0.42710757237079783</c:v>
                </c:pt>
                <c:pt idx="2014">
                  <c:v>0.166020026236194</c:v>
                </c:pt>
                <c:pt idx="2015">
                  <c:v>0.28545333604124484</c:v>
                </c:pt>
                <c:pt idx="2016">
                  <c:v>0.22445521050509112</c:v>
                </c:pt>
                <c:pt idx="2017">
                  <c:v>0.23083735126123833</c:v>
                </c:pt>
                <c:pt idx="2018">
                  <c:v>0.651434807588684</c:v>
                </c:pt>
                <c:pt idx="2019">
                  <c:v>0.45404260235764277</c:v>
                </c:pt>
                <c:pt idx="2020">
                  <c:v>0.2465403547690069</c:v>
                </c:pt>
                <c:pt idx="2021">
                  <c:v>0.81852136662370412</c:v>
                </c:pt>
                <c:pt idx="2022">
                  <c:v>0.10208645986528279</c:v>
                </c:pt>
                <c:pt idx="2023">
                  <c:v>0.25232398314822302</c:v>
                </c:pt>
                <c:pt idx="2024">
                  <c:v>0.68877669095946159</c:v>
                </c:pt>
                <c:pt idx="2025">
                  <c:v>0.3616195294959112</c:v>
                </c:pt>
                <c:pt idx="2026">
                  <c:v>0.65393892834547951</c:v>
                </c:pt>
                <c:pt idx="2027">
                  <c:v>0.55556415840734585</c:v>
                </c:pt>
                <c:pt idx="2028">
                  <c:v>1.0101976684856715</c:v>
                </c:pt>
                <c:pt idx="2029">
                  <c:v>0.49682928021389816</c:v>
                </c:pt>
                <c:pt idx="2030">
                  <c:v>1.5358594870007771</c:v>
                </c:pt>
                <c:pt idx="2031">
                  <c:v>0.20768550544971381</c:v>
                </c:pt>
                <c:pt idx="2032">
                  <c:v>0.53407239594646272</c:v>
                </c:pt>
                <c:pt idx="2033">
                  <c:v>0.52542685595555716</c:v>
                </c:pt>
                <c:pt idx="2034">
                  <c:v>0.14664047050927528</c:v>
                </c:pt>
                <c:pt idx="2035">
                  <c:v>1.237887222147007</c:v>
                </c:pt>
                <c:pt idx="2036">
                  <c:v>9.8278050590766747E-2</c:v>
                </c:pt>
                <c:pt idx="2037">
                  <c:v>0.48208290966571937</c:v>
                </c:pt>
                <c:pt idx="2038">
                  <c:v>0.59789817643747878</c:v>
                </c:pt>
                <c:pt idx="2039">
                  <c:v>0.18355230325115485</c:v>
                </c:pt>
                <c:pt idx="2040">
                  <c:v>0.73203536903288835</c:v>
                </c:pt>
                <c:pt idx="2041">
                  <c:v>6.7900330154245889E-2</c:v>
                </c:pt>
                <c:pt idx="2042">
                  <c:v>2.9291799879332135E-2</c:v>
                </c:pt>
                <c:pt idx="2043">
                  <c:v>0.36487656962037013</c:v>
                </c:pt>
                <c:pt idx="2044">
                  <c:v>0.244993118553814</c:v>
                </c:pt>
                <c:pt idx="2045">
                  <c:v>1.2518847707330556</c:v>
                </c:pt>
                <c:pt idx="2046">
                  <c:v>0.72308758401847006</c:v>
                </c:pt>
                <c:pt idx="2047">
                  <c:v>0.52561189709850797</c:v>
                </c:pt>
                <c:pt idx="2048">
                  <c:v>0.5061611988884116</c:v>
                </c:pt>
                <c:pt idx="2049">
                  <c:v>0.36455434637942447</c:v>
                </c:pt>
                <c:pt idx="2050">
                  <c:v>4.5880179077796367E-2</c:v>
                </c:pt>
                <c:pt idx="2051">
                  <c:v>0.1956025239749335</c:v>
                </c:pt>
                <c:pt idx="2052">
                  <c:v>0.34772128966192256</c:v>
                </c:pt>
                <c:pt idx="2053">
                  <c:v>0.55204268504440812</c:v>
                </c:pt>
                <c:pt idx="2054">
                  <c:v>0.39920622060761224</c:v>
                </c:pt>
                <c:pt idx="2055">
                  <c:v>0.11751166103103496</c:v>
                </c:pt>
                <c:pt idx="2056">
                  <c:v>0.36206778825207925</c:v>
                </c:pt>
                <c:pt idx="2057">
                  <c:v>1.0009041917721688</c:v>
                </c:pt>
                <c:pt idx="2058">
                  <c:v>1.1275521644875166</c:v>
                </c:pt>
                <c:pt idx="2059">
                  <c:v>0.56060274462732085</c:v>
                </c:pt>
                <c:pt idx="2060">
                  <c:v>0.10343009737654596</c:v>
                </c:pt>
                <c:pt idx="2061">
                  <c:v>0.18181499766421955</c:v>
                </c:pt>
                <c:pt idx="2062">
                  <c:v>1.2218894703273881</c:v>
                </c:pt>
                <c:pt idx="2063">
                  <c:v>0.74644519821224808</c:v>
                </c:pt>
                <c:pt idx="2064">
                  <c:v>0.22778396574551529</c:v>
                </c:pt>
                <c:pt idx="2065">
                  <c:v>0.10854402330472289</c:v>
                </c:pt>
                <c:pt idx="2066">
                  <c:v>0.46468765302269699</c:v>
                </c:pt>
                <c:pt idx="2067">
                  <c:v>1.019998299721709</c:v>
                </c:pt>
                <c:pt idx="2068">
                  <c:v>0.16153115664384393</c:v>
                </c:pt>
                <c:pt idx="2069">
                  <c:v>0.72362161498522337</c:v>
                </c:pt>
                <c:pt idx="2070">
                  <c:v>4.7084918832530624E-2</c:v>
                </c:pt>
                <c:pt idx="2071">
                  <c:v>0.10903601645023593</c:v>
                </c:pt>
                <c:pt idx="2072">
                  <c:v>0.69267346063094315</c:v>
                </c:pt>
                <c:pt idx="2073">
                  <c:v>0.22078056954796024</c:v>
                </c:pt>
                <c:pt idx="2074">
                  <c:v>0.64519332464341528</c:v>
                </c:pt>
                <c:pt idx="2075">
                  <c:v>0.5445618105836747</c:v>
                </c:pt>
                <c:pt idx="2076">
                  <c:v>0.24971824992196967</c:v>
                </c:pt>
                <c:pt idx="2077">
                  <c:v>0.17247285109398761</c:v>
                </c:pt>
                <c:pt idx="2078">
                  <c:v>0.84550911531950113</c:v>
                </c:pt>
                <c:pt idx="2079">
                  <c:v>0.28929896715254749</c:v>
                </c:pt>
                <c:pt idx="2080">
                  <c:v>0.30521495249204539</c:v>
                </c:pt>
                <c:pt idx="2081">
                  <c:v>1.1531052203286594</c:v>
                </c:pt>
                <c:pt idx="2082">
                  <c:v>0.95459013723378372</c:v>
                </c:pt>
                <c:pt idx="2083">
                  <c:v>1.4409333796762875</c:v>
                </c:pt>
                <c:pt idx="2084">
                  <c:v>0.10170184210294382</c:v>
                </c:pt>
                <c:pt idx="2085">
                  <c:v>1.4438286057796677</c:v>
                </c:pt>
                <c:pt idx="2086">
                  <c:v>0.30855379657471171</c:v>
                </c:pt>
                <c:pt idx="2087">
                  <c:v>0.67774576225107375</c:v>
                </c:pt>
                <c:pt idx="2088">
                  <c:v>0.15302987932458881</c:v>
                </c:pt>
                <c:pt idx="2089">
                  <c:v>6.7043385740309144E-2</c:v>
                </c:pt>
                <c:pt idx="2090">
                  <c:v>0.33375615911544276</c:v>
                </c:pt>
                <c:pt idx="2091">
                  <c:v>2.5816578542296315E-2</c:v>
                </c:pt>
                <c:pt idx="2092">
                  <c:v>0.18838435006007709</c:v>
                </c:pt>
                <c:pt idx="2093">
                  <c:v>1.560454776117558</c:v>
                </c:pt>
                <c:pt idx="2094">
                  <c:v>0.47422411554278354</c:v>
                </c:pt>
                <c:pt idx="2095">
                  <c:v>0.53307089321469214</c:v>
                </c:pt>
                <c:pt idx="2096">
                  <c:v>0.16312831375664011</c:v>
                </c:pt>
                <c:pt idx="2097">
                  <c:v>0.101477957115197</c:v>
                </c:pt>
                <c:pt idx="2098">
                  <c:v>9.0262281983727405E-2</c:v>
                </c:pt>
                <c:pt idx="2099">
                  <c:v>1.0499451036644836</c:v>
                </c:pt>
                <c:pt idx="2100">
                  <c:v>0.65376882066278497</c:v>
                </c:pt>
                <c:pt idx="2101">
                  <c:v>0.19707530779416968</c:v>
                </c:pt>
                <c:pt idx="2102">
                  <c:v>3.0135702561817065E-2</c:v>
                </c:pt>
                <c:pt idx="2103">
                  <c:v>9.1412873463056682E-2</c:v>
                </c:pt>
                <c:pt idx="2104">
                  <c:v>0.76937418044600614</c:v>
                </c:pt>
                <c:pt idx="2105">
                  <c:v>0.37433838979678719</c:v>
                </c:pt>
                <c:pt idx="2106">
                  <c:v>8.8335629831782364E-2</c:v>
                </c:pt>
                <c:pt idx="2107">
                  <c:v>3.7266868804716961E-2</c:v>
                </c:pt>
                <c:pt idx="2108">
                  <c:v>1.1388561020582531</c:v>
                </c:pt>
                <c:pt idx="2109">
                  <c:v>0.60760248715379639</c:v>
                </c:pt>
                <c:pt idx="2110">
                  <c:v>0.88411602967288905</c:v>
                </c:pt>
                <c:pt idx="2111">
                  <c:v>0.4854383995316417</c:v>
                </c:pt>
                <c:pt idx="2112">
                  <c:v>0.17218832013505453</c:v>
                </c:pt>
                <c:pt idx="2113">
                  <c:v>0.28523470756332336</c:v>
                </c:pt>
                <c:pt idx="2114">
                  <c:v>0.7433992541432316</c:v>
                </c:pt>
                <c:pt idx="2115">
                  <c:v>0.94131739553929317</c:v>
                </c:pt>
                <c:pt idx="2116">
                  <c:v>3.9065244713170799E-2</c:v>
                </c:pt>
                <c:pt idx="2117">
                  <c:v>0.57535457511510379</c:v>
                </c:pt>
                <c:pt idx="2118">
                  <c:v>0.13334914602848916</c:v>
                </c:pt>
                <c:pt idx="2119">
                  <c:v>0.19330326246337295</c:v>
                </c:pt>
                <c:pt idx="2120">
                  <c:v>0.39810291774167916</c:v>
                </c:pt>
                <c:pt idx="2121">
                  <c:v>0.23989295067787278</c:v>
                </c:pt>
                <c:pt idx="2122">
                  <c:v>0.4485084830271967</c:v>
                </c:pt>
                <c:pt idx="2123">
                  <c:v>1.2492549168978184</c:v>
                </c:pt>
                <c:pt idx="2124">
                  <c:v>0.84247725023038011</c:v>
                </c:pt>
                <c:pt idx="2125">
                  <c:v>1.2259950404715003E-2</c:v>
                </c:pt>
                <c:pt idx="2126">
                  <c:v>0.15598928185145114</c:v>
                </c:pt>
                <c:pt idx="2127">
                  <c:v>0.25622003312087993</c:v>
                </c:pt>
                <c:pt idx="2128">
                  <c:v>3.5427754221746613E-2</c:v>
                </c:pt>
                <c:pt idx="2129">
                  <c:v>0.60179886666559501</c:v>
                </c:pt>
                <c:pt idx="2130">
                  <c:v>6.8187190266724457E-2</c:v>
                </c:pt>
                <c:pt idx="2131">
                  <c:v>1.0117760539025848</c:v>
                </c:pt>
                <c:pt idx="2132">
                  <c:v>0.68923280131502407</c:v>
                </c:pt>
                <c:pt idx="2133">
                  <c:v>8.1323680879524476E-2</c:v>
                </c:pt>
                <c:pt idx="2134">
                  <c:v>0.49118959537780055</c:v>
                </c:pt>
                <c:pt idx="2135">
                  <c:v>0.15400750048733158</c:v>
                </c:pt>
                <c:pt idx="2136">
                  <c:v>0.43757713135416604</c:v>
                </c:pt>
                <c:pt idx="2137">
                  <c:v>1.1351930631844873</c:v>
                </c:pt>
                <c:pt idx="2138">
                  <c:v>0.12767856191821209</c:v>
                </c:pt>
                <c:pt idx="2139">
                  <c:v>1.1725073074779666</c:v>
                </c:pt>
                <c:pt idx="2140">
                  <c:v>6.2667028970009239E-3</c:v>
                </c:pt>
                <c:pt idx="2141">
                  <c:v>0.77695114079597172</c:v>
                </c:pt>
                <c:pt idx="2142">
                  <c:v>0.26033679262194864</c:v>
                </c:pt>
                <c:pt idx="2143">
                  <c:v>0.58953891391931235</c:v>
                </c:pt>
                <c:pt idx="2144">
                  <c:v>0.41937178722822954</c:v>
                </c:pt>
                <c:pt idx="2145">
                  <c:v>0.23873953347077084</c:v>
                </c:pt>
                <c:pt idx="2146">
                  <c:v>0.74010586424673475</c:v>
                </c:pt>
                <c:pt idx="2147">
                  <c:v>2.0132450326607674</c:v>
                </c:pt>
                <c:pt idx="2148">
                  <c:v>0.34378140720436495</c:v>
                </c:pt>
                <c:pt idx="2149">
                  <c:v>0.20067137775562555</c:v>
                </c:pt>
                <c:pt idx="2150">
                  <c:v>1.2650447204507247</c:v>
                </c:pt>
                <c:pt idx="2151">
                  <c:v>0.34050012249487815</c:v>
                </c:pt>
                <c:pt idx="2152">
                  <c:v>1.8540968413480741E-2</c:v>
                </c:pt>
                <c:pt idx="2153">
                  <c:v>0.10930109645414893</c:v>
                </c:pt>
                <c:pt idx="2154">
                  <c:v>5.095987687744055E-3</c:v>
                </c:pt>
                <c:pt idx="2155">
                  <c:v>1.8406798875663624E-3</c:v>
                </c:pt>
                <c:pt idx="2156">
                  <c:v>0.29547620307589306</c:v>
                </c:pt>
                <c:pt idx="2157">
                  <c:v>0.26035528961763138</c:v>
                </c:pt>
                <c:pt idx="2158">
                  <c:v>1.1258925310670311</c:v>
                </c:pt>
                <c:pt idx="2159">
                  <c:v>8.6186353321032541E-2</c:v>
                </c:pt>
                <c:pt idx="2160">
                  <c:v>0.68995868771284197</c:v>
                </c:pt>
                <c:pt idx="2161">
                  <c:v>0.30765155697671659</c:v>
                </c:pt>
                <c:pt idx="2162">
                  <c:v>0.22002792130299814</c:v>
                </c:pt>
                <c:pt idx="2163">
                  <c:v>0.58685742026896615</c:v>
                </c:pt>
                <c:pt idx="2164">
                  <c:v>0.19052343671379043</c:v>
                </c:pt>
                <c:pt idx="2165">
                  <c:v>0.33750250819182676</c:v>
                </c:pt>
                <c:pt idx="2166">
                  <c:v>0.54187960009421665</c:v>
                </c:pt>
                <c:pt idx="2167">
                  <c:v>1.8994252960289828</c:v>
                </c:pt>
                <c:pt idx="2168">
                  <c:v>0.72872324583951198</c:v>
                </c:pt>
                <c:pt idx="2169">
                  <c:v>0.46559159372846792</c:v>
                </c:pt>
                <c:pt idx="2170">
                  <c:v>0.53707338606101696</c:v>
                </c:pt>
                <c:pt idx="2171">
                  <c:v>0.36626910046469463</c:v>
                </c:pt>
                <c:pt idx="2172">
                  <c:v>0.30303107276568958</c:v>
                </c:pt>
                <c:pt idx="2173">
                  <c:v>0.35744983306987455</c:v>
                </c:pt>
                <c:pt idx="2174">
                  <c:v>0.11545020485190384</c:v>
                </c:pt>
                <c:pt idx="2175">
                  <c:v>1.4208905675185437</c:v>
                </c:pt>
                <c:pt idx="2176">
                  <c:v>0.97125268580063828</c:v>
                </c:pt>
                <c:pt idx="2177">
                  <c:v>1.1555884696837198</c:v>
                </c:pt>
                <c:pt idx="2178">
                  <c:v>1.449721762602709</c:v>
                </c:pt>
                <c:pt idx="2179">
                  <c:v>0.99764669332441103</c:v>
                </c:pt>
                <c:pt idx="2180">
                  <c:v>0.97999536167738299</c:v>
                </c:pt>
                <c:pt idx="2181">
                  <c:v>0.10718109888945593</c:v>
                </c:pt>
                <c:pt idx="2182">
                  <c:v>0.43814392658353879</c:v>
                </c:pt>
                <c:pt idx="2183">
                  <c:v>5.0635128625132454E-2</c:v>
                </c:pt>
                <c:pt idx="2184">
                  <c:v>0.24255175715211158</c:v>
                </c:pt>
                <c:pt idx="2185">
                  <c:v>0.91819822810980922</c:v>
                </c:pt>
                <c:pt idx="2186">
                  <c:v>0.24678218805579455</c:v>
                </c:pt>
                <c:pt idx="2187">
                  <c:v>0.66418529571622531</c:v>
                </c:pt>
                <c:pt idx="2188">
                  <c:v>8.9965779155416398E-2</c:v>
                </c:pt>
                <c:pt idx="2189">
                  <c:v>0.40865299058906718</c:v>
                </c:pt>
                <c:pt idx="2190">
                  <c:v>0.26187750587641179</c:v>
                </c:pt>
                <c:pt idx="2191">
                  <c:v>1.1406774330830831</c:v>
                </c:pt>
                <c:pt idx="2192">
                  <c:v>0.38438756140114971</c:v>
                </c:pt>
                <c:pt idx="2193">
                  <c:v>1.0923199691903986</c:v>
                </c:pt>
                <c:pt idx="2194">
                  <c:v>0.58097140775354328</c:v>
                </c:pt>
                <c:pt idx="2195">
                  <c:v>0.26280510432567816</c:v>
                </c:pt>
                <c:pt idx="2196">
                  <c:v>0.46720882965005217</c:v>
                </c:pt>
                <c:pt idx="2197">
                  <c:v>1.1632409256834946</c:v>
                </c:pt>
                <c:pt idx="2198">
                  <c:v>0.18384180953684454</c:v>
                </c:pt>
                <c:pt idx="2199">
                  <c:v>8.3248857472227308E-2</c:v>
                </c:pt>
                <c:pt idx="2200">
                  <c:v>0.79513571371544334</c:v>
                </c:pt>
                <c:pt idx="2201">
                  <c:v>0.27164307092549567</c:v>
                </c:pt>
                <c:pt idx="2202">
                  <c:v>0.99101904305276323</c:v>
                </c:pt>
                <c:pt idx="2203">
                  <c:v>0.76189070087212318</c:v>
                </c:pt>
                <c:pt idx="2204">
                  <c:v>0.51934742102065057</c:v>
                </c:pt>
                <c:pt idx="2205">
                  <c:v>8.4119288917416504E-2</c:v>
                </c:pt>
                <c:pt idx="2206">
                  <c:v>0.17234383918739724</c:v>
                </c:pt>
                <c:pt idx="2207">
                  <c:v>0.13625056861879761</c:v>
                </c:pt>
                <c:pt idx="2208">
                  <c:v>5.8246310601627403E-2</c:v>
                </c:pt>
                <c:pt idx="2209">
                  <c:v>0.17398077173891044</c:v>
                </c:pt>
                <c:pt idx="2210">
                  <c:v>0.57670703308739935</c:v>
                </c:pt>
                <c:pt idx="2211">
                  <c:v>0.51602143038456061</c:v>
                </c:pt>
                <c:pt idx="2212">
                  <c:v>0.85958298602027472</c:v>
                </c:pt>
                <c:pt idx="2213">
                  <c:v>1.6764125240269587</c:v>
                </c:pt>
                <c:pt idx="2214">
                  <c:v>0.86828514336060281</c:v>
                </c:pt>
                <c:pt idx="2215">
                  <c:v>1.247164537355594</c:v>
                </c:pt>
                <c:pt idx="2216">
                  <c:v>0.29794537214983385</c:v>
                </c:pt>
                <c:pt idx="2217">
                  <c:v>0.19929707439233355</c:v>
                </c:pt>
                <c:pt idx="2218">
                  <c:v>0.28109827775470686</c:v>
                </c:pt>
                <c:pt idx="2219">
                  <c:v>0.26971462090614268</c:v>
                </c:pt>
                <c:pt idx="2220">
                  <c:v>0.28334590634920703</c:v>
                </c:pt>
                <c:pt idx="2221">
                  <c:v>1.2044519307539541</c:v>
                </c:pt>
                <c:pt idx="2222">
                  <c:v>0.24742444155489307</c:v>
                </c:pt>
                <c:pt idx="2223">
                  <c:v>1.1287304070879376</c:v>
                </c:pt>
                <c:pt idx="2224">
                  <c:v>0.76198319961513417</c:v>
                </c:pt>
                <c:pt idx="2225">
                  <c:v>0.19578889604164623</c:v>
                </c:pt>
                <c:pt idx="2226">
                  <c:v>1.2541498063517367</c:v>
                </c:pt>
                <c:pt idx="2227">
                  <c:v>0.37750981209536572</c:v>
                </c:pt>
                <c:pt idx="2228">
                  <c:v>0.25115677658460545</c:v>
                </c:pt>
                <c:pt idx="2229">
                  <c:v>0.31441986246731285</c:v>
                </c:pt>
                <c:pt idx="2230">
                  <c:v>0.14943751423065038</c:v>
                </c:pt>
                <c:pt idx="2231">
                  <c:v>0.8452622370666053</c:v>
                </c:pt>
                <c:pt idx="2232">
                  <c:v>1.8094658761145247E-2</c:v>
                </c:pt>
                <c:pt idx="2233">
                  <c:v>0.37570261152079792</c:v>
                </c:pt>
                <c:pt idx="2234">
                  <c:v>0.54623891532659308</c:v>
                </c:pt>
                <c:pt idx="2235">
                  <c:v>0.15040859809918708</c:v>
                </c:pt>
                <c:pt idx="2236">
                  <c:v>0.82804089931290603</c:v>
                </c:pt>
                <c:pt idx="2237">
                  <c:v>6.0395166357365641E-3</c:v>
                </c:pt>
                <c:pt idx="2238">
                  <c:v>8.1833127061281305E-2</c:v>
                </c:pt>
                <c:pt idx="2239">
                  <c:v>0.13078203906120534</c:v>
                </c:pt>
                <c:pt idx="2240">
                  <c:v>0.18612430828277662</c:v>
                </c:pt>
                <c:pt idx="2241">
                  <c:v>0.57037553034719635</c:v>
                </c:pt>
                <c:pt idx="2242">
                  <c:v>0.10186911652295337</c:v>
                </c:pt>
                <c:pt idx="2243">
                  <c:v>0.33854819468406877</c:v>
                </c:pt>
                <c:pt idx="2244">
                  <c:v>0.32383645561597779</c:v>
                </c:pt>
                <c:pt idx="2245">
                  <c:v>0.47071912364445478</c:v>
                </c:pt>
                <c:pt idx="2246">
                  <c:v>0.4515456253092659</c:v>
                </c:pt>
                <c:pt idx="2247">
                  <c:v>0.18359139711195807</c:v>
                </c:pt>
                <c:pt idx="2248">
                  <c:v>0.84169998594137063</c:v>
                </c:pt>
                <c:pt idx="2249">
                  <c:v>4.4421067834890686E-2</c:v>
                </c:pt>
                <c:pt idx="2250">
                  <c:v>0.48264776478666482</c:v>
                </c:pt>
                <c:pt idx="2251">
                  <c:v>0.31178030539838747</c:v>
                </c:pt>
                <c:pt idx="2252">
                  <c:v>5.5988092170852433E-2</c:v>
                </c:pt>
                <c:pt idx="2253">
                  <c:v>0.56182309978301648</c:v>
                </c:pt>
                <c:pt idx="2254">
                  <c:v>0.5591996535939614</c:v>
                </c:pt>
                <c:pt idx="2255">
                  <c:v>1.2955270811314039</c:v>
                </c:pt>
                <c:pt idx="2256">
                  <c:v>3.0888969402859644E-2</c:v>
                </c:pt>
                <c:pt idx="2257">
                  <c:v>0.58153235579544793</c:v>
                </c:pt>
                <c:pt idx="2258">
                  <c:v>0.6444938781749503</c:v>
                </c:pt>
                <c:pt idx="2259">
                  <c:v>0.31030597016990574</c:v>
                </c:pt>
                <c:pt idx="2260">
                  <c:v>4.5587684788962725E-2</c:v>
                </c:pt>
                <c:pt idx="2261">
                  <c:v>0.27504545543392678</c:v>
                </c:pt>
                <c:pt idx="2262">
                  <c:v>0.44079607631173828</c:v>
                </c:pt>
                <c:pt idx="2263">
                  <c:v>0.10693226925306294</c:v>
                </c:pt>
                <c:pt idx="2264">
                  <c:v>0.23193963505577739</c:v>
                </c:pt>
                <c:pt idx="2265">
                  <c:v>0.27463590120977693</c:v>
                </c:pt>
                <c:pt idx="2266">
                  <c:v>1.087172142190975</c:v>
                </c:pt>
                <c:pt idx="2267">
                  <c:v>1.1311167713635999</c:v>
                </c:pt>
                <c:pt idx="2268">
                  <c:v>0.44739813108523657</c:v>
                </c:pt>
                <c:pt idx="2269">
                  <c:v>0.2022869471554529</c:v>
                </c:pt>
                <c:pt idx="2270">
                  <c:v>0.65812689402028179</c:v>
                </c:pt>
                <c:pt idx="2271">
                  <c:v>0.1571236218004626</c:v>
                </c:pt>
                <c:pt idx="2272">
                  <c:v>0.74963776069804455</c:v>
                </c:pt>
                <c:pt idx="2273">
                  <c:v>1.1583491295557728</c:v>
                </c:pt>
                <c:pt idx="2274">
                  <c:v>0.69579479301921587</c:v>
                </c:pt>
                <c:pt idx="2275">
                  <c:v>2.6624324705152854E-2</c:v>
                </c:pt>
                <c:pt idx="2276">
                  <c:v>0.14265884482152033</c:v>
                </c:pt>
                <c:pt idx="2277">
                  <c:v>1.091362409610604</c:v>
                </c:pt>
                <c:pt idx="2278">
                  <c:v>0.25523485031083604</c:v>
                </c:pt>
                <c:pt idx="2279">
                  <c:v>0.31984579901674387</c:v>
                </c:pt>
                <c:pt idx="2280">
                  <c:v>0.63561176217639637</c:v>
                </c:pt>
                <c:pt idx="2281">
                  <c:v>0.37519749958228421</c:v>
                </c:pt>
                <c:pt idx="2282">
                  <c:v>0.76121847013267308</c:v>
                </c:pt>
                <c:pt idx="2283">
                  <c:v>0.73674246533006993</c:v>
                </c:pt>
                <c:pt idx="2284">
                  <c:v>1.0171991099897593</c:v>
                </c:pt>
                <c:pt idx="2285">
                  <c:v>0.77139930119029754</c:v>
                </c:pt>
                <c:pt idx="2286">
                  <c:v>1.1215779068238962</c:v>
                </c:pt>
                <c:pt idx="2287">
                  <c:v>0.25885881990822501</c:v>
                </c:pt>
                <c:pt idx="2288">
                  <c:v>0.59271118172447901</c:v>
                </c:pt>
                <c:pt idx="2289">
                  <c:v>3.0456107652198958E-2</c:v>
                </c:pt>
                <c:pt idx="2290">
                  <c:v>1.1793945810583961</c:v>
                </c:pt>
                <c:pt idx="2291">
                  <c:v>1.279255485176751</c:v>
                </c:pt>
                <c:pt idx="2292">
                  <c:v>0.25487203225397392</c:v>
                </c:pt>
                <c:pt idx="2293">
                  <c:v>2.4972972187652809E-2</c:v>
                </c:pt>
                <c:pt idx="2294">
                  <c:v>0.17344552088264245</c:v>
                </c:pt>
                <c:pt idx="2295">
                  <c:v>0.17146799307184515</c:v>
                </c:pt>
                <c:pt idx="2296">
                  <c:v>0.25004875656544728</c:v>
                </c:pt>
                <c:pt idx="2297">
                  <c:v>5.0557537736515862E-2</c:v>
                </c:pt>
                <c:pt idx="2298">
                  <c:v>0.17273322470968461</c:v>
                </c:pt>
                <c:pt idx="2299">
                  <c:v>0.69730806886276042</c:v>
                </c:pt>
                <c:pt idx="2300">
                  <c:v>4.4873950532770351E-2</c:v>
                </c:pt>
                <c:pt idx="2301">
                  <c:v>0.57610532434328854</c:v>
                </c:pt>
                <c:pt idx="2302">
                  <c:v>0.2287819786602367</c:v>
                </c:pt>
                <c:pt idx="2303">
                  <c:v>0.63835258371307912</c:v>
                </c:pt>
                <c:pt idx="2304">
                  <c:v>0.18193199704207627</c:v>
                </c:pt>
                <c:pt idx="2305">
                  <c:v>0.69001039357847171</c:v>
                </c:pt>
                <c:pt idx="2306">
                  <c:v>0.27442539440483599</c:v>
                </c:pt>
                <c:pt idx="2307">
                  <c:v>6.7164203072872672E-2</c:v>
                </c:pt>
                <c:pt idx="2308">
                  <c:v>0.27202231954724904</c:v>
                </c:pt>
                <c:pt idx="2309">
                  <c:v>0.71333012188567868</c:v>
                </c:pt>
                <c:pt idx="2310">
                  <c:v>0.77980043065732119</c:v>
                </c:pt>
                <c:pt idx="2311">
                  <c:v>0.86107199407272395</c:v>
                </c:pt>
                <c:pt idx="2312">
                  <c:v>0.16688330153112768</c:v>
                </c:pt>
                <c:pt idx="2313">
                  <c:v>0.98172105499538576</c:v>
                </c:pt>
                <c:pt idx="2314">
                  <c:v>4.7263619407403958E-2</c:v>
                </c:pt>
                <c:pt idx="2315">
                  <c:v>7.9906896816339543E-2</c:v>
                </c:pt>
                <c:pt idx="2316">
                  <c:v>0.33290363414833735</c:v>
                </c:pt>
                <c:pt idx="2317">
                  <c:v>0.2037835783268426</c:v>
                </c:pt>
                <c:pt idx="2318">
                  <c:v>0.24685784573442279</c:v>
                </c:pt>
                <c:pt idx="2319">
                  <c:v>0.16561804345353281</c:v>
                </c:pt>
                <c:pt idx="2320">
                  <c:v>4.7498808799274025E-2</c:v>
                </c:pt>
                <c:pt idx="2321">
                  <c:v>0.10495103328980521</c:v>
                </c:pt>
                <c:pt idx="2322">
                  <c:v>0.20071351939796239</c:v>
                </c:pt>
                <c:pt idx="2323">
                  <c:v>0.22244645492228995</c:v>
                </c:pt>
                <c:pt idx="2324">
                  <c:v>0.35691521773734014</c:v>
                </c:pt>
                <c:pt idx="2325">
                  <c:v>0.60729355740057267</c:v>
                </c:pt>
                <c:pt idx="2326">
                  <c:v>0.74143589712641644</c:v>
                </c:pt>
                <c:pt idx="2327">
                  <c:v>0.19908616791938816</c:v>
                </c:pt>
                <c:pt idx="2328">
                  <c:v>0.21096143680548854</c:v>
                </c:pt>
                <c:pt idx="2329">
                  <c:v>3.0501512558686369E-2</c:v>
                </c:pt>
                <c:pt idx="2330">
                  <c:v>0.40178767956375366</c:v>
                </c:pt>
                <c:pt idx="2331">
                  <c:v>0.38351097885032415</c:v>
                </c:pt>
                <c:pt idx="2332">
                  <c:v>2.7593583250467582E-2</c:v>
                </c:pt>
                <c:pt idx="2333">
                  <c:v>8.0630719926373023E-2</c:v>
                </c:pt>
                <c:pt idx="2334">
                  <c:v>9.5943714528803459E-2</c:v>
                </c:pt>
                <c:pt idx="2335">
                  <c:v>0.70585901323741873</c:v>
                </c:pt>
                <c:pt idx="2336">
                  <c:v>0.86322965847065491</c:v>
                </c:pt>
                <c:pt idx="2337">
                  <c:v>0.39468750790495988</c:v>
                </c:pt>
                <c:pt idx="2338">
                  <c:v>0.92584637542442216</c:v>
                </c:pt>
                <c:pt idx="2339">
                  <c:v>0.12150665891984795</c:v>
                </c:pt>
                <c:pt idx="2340">
                  <c:v>1.1979025227056387E-2</c:v>
                </c:pt>
                <c:pt idx="2341">
                  <c:v>0.43971296293060502</c:v>
                </c:pt>
                <c:pt idx="2342">
                  <c:v>0.14417105833835794</c:v>
                </c:pt>
                <c:pt idx="2343">
                  <c:v>0.92947187981196788</c:v>
                </c:pt>
                <c:pt idx="2344">
                  <c:v>1.1166751799092136</c:v>
                </c:pt>
                <c:pt idx="2345">
                  <c:v>0.91198868623133011</c:v>
                </c:pt>
                <c:pt idx="2346">
                  <c:v>0.23258755073561696</c:v>
                </c:pt>
                <c:pt idx="2347">
                  <c:v>0.51631896945652123</c:v>
                </c:pt>
                <c:pt idx="2348">
                  <c:v>0.13114990349455127</c:v>
                </c:pt>
                <c:pt idx="2349">
                  <c:v>1.533103354286353</c:v>
                </c:pt>
                <c:pt idx="2350">
                  <c:v>0.24789021744451437</c:v>
                </c:pt>
                <c:pt idx="2351">
                  <c:v>0.14837869339647697</c:v>
                </c:pt>
                <c:pt idx="2352">
                  <c:v>1.2920789339155765</c:v>
                </c:pt>
                <c:pt idx="2353">
                  <c:v>2.23349636053167</c:v>
                </c:pt>
                <c:pt idx="2354">
                  <c:v>1.4400962066629817</c:v>
                </c:pt>
                <c:pt idx="2355">
                  <c:v>2.0695431601270912E-2</c:v>
                </c:pt>
                <c:pt idx="2356">
                  <c:v>0.34459785269027898</c:v>
                </c:pt>
                <c:pt idx="2357">
                  <c:v>0.20535345224235418</c:v>
                </c:pt>
                <c:pt idx="2358">
                  <c:v>0.68829440526976682</c:v>
                </c:pt>
                <c:pt idx="2359">
                  <c:v>1.5936563913091915E-2</c:v>
                </c:pt>
                <c:pt idx="2360">
                  <c:v>0.22558698212528819</c:v>
                </c:pt>
                <c:pt idx="2361">
                  <c:v>0.26775822201306909</c:v>
                </c:pt>
                <c:pt idx="2362">
                  <c:v>0.56162303313358375</c:v>
                </c:pt>
                <c:pt idx="2363">
                  <c:v>0.39324274928774744</c:v>
                </c:pt>
                <c:pt idx="2364">
                  <c:v>1.363595008090027</c:v>
                </c:pt>
                <c:pt idx="2365">
                  <c:v>0.21927028316641906</c:v>
                </c:pt>
                <c:pt idx="2366">
                  <c:v>0.67904373861960055</c:v>
                </c:pt>
                <c:pt idx="2367">
                  <c:v>0.8633016558453166</c:v>
                </c:pt>
                <c:pt idx="2368">
                  <c:v>0.75103783059635842</c:v>
                </c:pt>
                <c:pt idx="2369">
                  <c:v>9.00929753892728E-2</c:v>
                </c:pt>
                <c:pt idx="2370">
                  <c:v>0.332326212200311</c:v>
                </c:pt>
                <c:pt idx="2371">
                  <c:v>0.83899200310752164</c:v>
                </c:pt>
                <c:pt idx="2372">
                  <c:v>0.20602072555906514</c:v>
                </c:pt>
                <c:pt idx="2373">
                  <c:v>0.30842227882191697</c:v>
                </c:pt>
                <c:pt idx="2374">
                  <c:v>0.1718015137381918</c:v>
                </c:pt>
                <c:pt idx="2375">
                  <c:v>0.37155115669839422</c:v>
                </c:pt>
                <c:pt idx="2376">
                  <c:v>1.1727616541879155E-3</c:v>
                </c:pt>
                <c:pt idx="2377">
                  <c:v>0.18022300280882234</c:v>
                </c:pt>
                <c:pt idx="2378">
                  <c:v>0.56515815055366336</c:v>
                </c:pt>
                <c:pt idx="2379">
                  <c:v>0.2042965068500936</c:v>
                </c:pt>
                <c:pt idx="2380">
                  <c:v>0.16254648262914323</c:v>
                </c:pt>
                <c:pt idx="2381">
                  <c:v>0.89023429067517867</c:v>
                </c:pt>
                <c:pt idx="2382">
                  <c:v>0.17732841728309029</c:v>
                </c:pt>
                <c:pt idx="2383">
                  <c:v>0.71578604396443446</c:v>
                </c:pt>
                <c:pt idx="2384">
                  <c:v>0.19897999750384535</c:v>
                </c:pt>
                <c:pt idx="2385">
                  <c:v>1.3083099323026346</c:v>
                </c:pt>
                <c:pt idx="2386">
                  <c:v>0.42030683652752265</c:v>
                </c:pt>
                <c:pt idx="2387">
                  <c:v>0.28141737448203397</c:v>
                </c:pt>
                <c:pt idx="2388">
                  <c:v>0.27138732003347621</c:v>
                </c:pt>
                <c:pt idx="2389">
                  <c:v>7.0073800538035372E-2</c:v>
                </c:pt>
                <c:pt idx="2390">
                  <c:v>1.2659249411682207</c:v>
                </c:pt>
                <c:pt idx="2391">
                  <c:v>0.30188203978868416</c:v>
                </c:pt>
                <c:pt idx="2392">
                  <c:v>0.37869012784473877</c:v>
                </c:pt>
                <c:pt idx="2393">
                  <c:v>6.0192384844916262E-3</c:v>
                </c:pt>
                <c:pt idx="2394">
                  <c:v>0.41042103703065941</c:v>
                </c:pt>
                <c:pt idx="2395">
                  <c:v>0.17373566178557906</c:v>
                </c:pt>
                <c:pt idx="2396">
                  <c:v>1.785470452453368</c:v>
                </c:pt>
                <c:pt idx="2397">
                  <c:v>0.43668910123176924</c:v>
                </c:pt>
                <c:pt idx="2398">
                  <c:v>0.25835850449424486</c:v>
                </c:pt>
                <c:pt idx="2399">
                  <c:v>4.5660776395376045E-2</c:v>
                </c:pt>
                <c:pt idx="2400">
                  <c:v>1.2059035433595366</c:v>
                </c:pt>
                <c:pt idx="2401">
                  <c:v>0.21990765239948948</c:v>
                </c:pt>
                <c:pt idx="2402">
                  <c:v>0.23922230667467848</c:v>
                </c:pt>
                <c:pt idx="2403">
                  <c:v>6.5548974434881002E-2</c:v>
                </c:pt>
                <c:pt idx="2404">
                  <c:v>0.32391849104197123</c:v>
                </c:pt>
                <c:pt idx="2405">
                  <c:v>0.4599623460969951</c:v>
                </c:pt>
                <c:pt idx="2406">
                  <c:v>0.23330776281636473</c:v>
                </c:pt>
                <c:pt idx="2407">
                  <c:v>1.3909891440110244E-2</c:v>
                </c:pt>
                <c:pt idx="2408">
                  <c:v>1.6086706845215175</c:v>
                </c:pt>
                <c:pt idx="2409">
                  <c:v>0.3410613283752682</c:v>
                </c:pt>
                <c:pt idx="2410">
                  <c:v>0.64232254920225251</c:v>
                </c:pt>
                <c:pt idx="2411">
                  <c:v>0.28288271214245653</c:v>
                </c:pt>
                <c:pt idx="2412">
                  <c:v>0.3514072432914</c:v>
                </c:pt>
                <c:pt idx="2413">
                  <c:v>0.84232135196048696</c:v>
                </c:pt>
                <c:pt idx="2414">
                  <c:v>0.26394560930516814</c:v>
                </c:pt>
                <c:pt idx="2415">
                  <c:v>0.33325767347920687</c:v>
                </c:pt>
                <c:pt idx="2416">
                  <c:v>8.1534147120221112E-2</c:v>
                </c:pt>
                <c:pt idx="2417">
                  <c:v>0.64949919728385286</c:v>
                </c:pt>
                <c:pt idx="2418">
                  <c:v>2.3895502085803657</c:v>
                </c:pt>
                <c:pt idx="2419">
                  <c:v>0.11199659521720372</c:v>
                </c:pt>
                <c:pt idx="2420">
                  <c:v>0.54534568006409867</c:v>
                </c:pt>
                <c:pt idx="2421">
                  <c:v>0.31700585473932202</c:v>
                </c:pt>
                <c:pt idx="2422">
                  <c:v>0.16761306517524907</c:v>
                </c:pt>
                <c:pt idx="2423">
                  <c:v>0.10767047079753425</c:v>
                </c:pt>
                <c:pt idx="2424">
                  <c:v>4.8739022482732951E-2</c:v>
                </c:pt>
                <c:pt idx="2425">
                  <c:v>4.7308334989464074E-2</c:v>
                </c:pt>
                <c:pt idx="2426">
                  <c:v>0.60976349303259614</c:v>
                </c:pt>
                <c:pt idx="2427">
                  <c:v>0.24870460020188848</c:v>
                </c:pt>
                <c:pt idx="2428">
                  <c:v>0.96000146560879518</c:v>
                </c:pt>
                <c:pt idx="2429">
                  <c:v>0.77486687633253171</c:v>
                </c:pt>
                <c:pt idx="2430">
                  <c:v>1.2970497368661698</c:v>
                </c:pt>
                <c:pt idx="2431">
                  <c:v>6.9044315431630282E-2</c:v>
                </c:pt>
                <c:pt idx="2432">
                  <c:v>5.9033793747267076E-2</c:v>
                </c:pt>
                <c:pt idx="2433">
                  <c:v>0.17884515074458779</c:v>
                </c:pt>
                <c:pt idx="2434">
                  <c:v>0.56046424757868007</c:v>
                </c:pt>
                <c:pt idx="2435">
                  <c:v>6.5686947870105511E-2</c:v>
                </c:pt>
                <c:pt idx="2436">
                  <c:v>1.1198327769277341</c:v>
                </c:pt>
                <c:pt idx="2437">
                  <c:v>0.1094393796509129</c:v>
                </c:pt>
                <c:pt idx="2438">
                  <c:v>0.29259881736472598</c:v>
                </c:pt>
                <c:pt idx="2439">
                  <c:v>6.6406845901641975E-2</c:v>
                </c:pt>
                <c:pt idx="2440">
                  <c:v>0.28778322131622835</c:v>
                </c:pt>
                <c:pt idx="2441">
                  <c:v>0.26288197249927359</c:v>
                </c:pt>
                <c:pt idx="2442">
                  <c:v>0.26235746156728518</c:v>
                </c:pt>
                <c:pt idx="2443">
                  <c:v>0.10565945126443939</c:v>
                </c:pt>
                <c:pt idx="2444">
                  <c:v>0.30686878179758825</c:v>
                </c:pt>
                <c:pt idx="2445">
                  <c:v>0.24289167826542174</c:v>
                </c:pt>
                <c:pt idx="2446">
                  <c:v>0.11292669475380297</c:v>
                </c:pt>
                <c:pt idx="2447">
                  <c:v>3.7189452700207536E-2</c:v>
                </c:pt>
                <c:pt idx="2448">
                  <c:v>0.97291439670344926</c:v>
                </c:pt>
                <c:pt idx="2449">
                  <c:v>0.35817088481134313</c:v>
                </c:pt>
                <c:pt idx="2450">
                  <c:v>0.35256691391965533</c:v>
                </c:pt>
                <c:pt idx="2451">
                  <c:v>8.5178719722183327E-2</c:v>
                </c:pt>
                <c:pt idx="2452">
                  <c:v>0.85343492674059018</c:v>
                </c:pt>
                <c:pt idx="2453">
                  <c:v>0.18687193969006766</c:v>
                </c:pt>
                <c:pt idx="2454">
                  <c:v>0.51233382904910141</c:v>
                </c:pt>
                <c:pt idx="2455">
                  <c:v>0.3230055614786832</c:v>
                </c:pt>
                <c:pt idx="2456">
                  <c:v>9.8516005205511542E-2</c:v>
                </c:pt>
                <c:pt idx="2457">
                  <c:v>0.63111041994525641</c:v>
                </c:pt>
                <c:pt idx="2458">
                  <c:v>1.019031224014362</c:v>
                </c:pt>
                <c:pt idx="2459">
                  <c:v>0.13291713161602123</c:v>
                </c:pt>
                <c:pt idx="2460">
                  <c:v>0.89440602417918713</c:v>
                </c:pt>
                <c:pt idx="2461">
                  <c:v>0.60391732832627043</c:v>
                </c:pt>
                <c:pt idx="2462">
                  <c:v>0.30644504681043078</c:v>
                </c:pt>
                <c:pt idx="2463">
                  <c:v>0.59477434902276893</c:v>
                </c:pt>
                <c:pt idx="2464">
                  <c:v>0.37921636372547496</c:v>
                </c:pt>
                <c:pt idx="2465">
                  <c:v>0.19869503759414253</c:v>
                </c:pt>
                <c:pt idx="2466">
                  <c:v>0.14654521524063452</c:v>
                </c:pt>
                <c:pt idx="2467">
                  <c:v>0.4987217515160613</c:v>
                </c:pt>
                <c:pt idx="2468">
                  <c:v>0.24788007571213339</c:v>
                </c:pt>
                <c:pt idx="2469">
                  <c:v>0.32713407160836872</c:v>
                </c:pt>
                <c:pt idx="2470">
                  <c:v>0.7994805845477515</c:v>
                </c:pt>
                <c:pt idx="2471">
                  <c:v>0.23226992616361095</c:v>
                </c:pt>
                <c:pt idx="2472">
                  <c:v>1.2498890504916866</c:v>
                </c:pt>
                <c:pt idx="2473">
                  <c:v>1.0394236993633286E-2</c:v>
                </c:pt>
                <c:pt idx="2474">
                  <c:v>0.12908690281717472</c:v>
                </c:pt>
                <c:pt idx="2475">
                  <c:v>9.9408972444896132E-2</c:v>
                </c:pt>
                <c:pt idx="2476">
                  <c:v>0.87300104536195688</c:v>
                </c:pt>
                <c:pt idx="2477">
                  <c:v>8.768714390599526E-2</c:v>
                </c:pt>
                <c:pt idx="2478">
                  <c:v>1.1672533679168988</c:v>
                </c:pt>
                <c:pt idx="2479">
                  <c:v>0.10350645721003433</c:v>
                </c:pt>
                <c:pt idx="2480">
                  <c:v>0.49185857367498415</c:v>
                </c:pt>
                <c:pt idx="2481">
                  <c:v>0.13448920738479309</c:v>
                </c:pt>
                <c:pt idx="2482">
                  <c:v>0.29935142843528495</c:v>
                </c:pt>
                <c:pt idx="2483">
                  <c:v>0.21294359853285333</c:v>
                </c:pt>
                <c:pt idx="2484">
                  <c:v>6.071893328635042E-3</c:v>
                </c:pt>
                <c:pt idx="2485">
                  <c:v>0.15607614509584347</c:v>
                </c:pt>
                <c:pt idx="2486">
                  <c:v>0.46318427189988104</c:v>
                </c:pt>
                <c:pt idx="2487">
                  <c:v>0.24975463511725751</c:v>
                </c:pt>
                <c:pt idx="2488">
                  <c:v>0.42284653732083211</c:v>
                </c:pt>
                <c:pt idx="2489">
                  <c:v>0.41470784332361027</c:v>
                </c:pt>
                <c:pt idx="2490">
                  <c:v>0.37742281221767032</c:v>
                </c:pt>
                <c:pt idx="2491">
                  <c:v>0.53842877255932586</c:v>
                </c:pt>
                <c:pt idx="2492">
                  <c:v>0.48881613516417627</c:v>
                </c:pt>
                <c:pt idx="2493">
                  <c:v>3.5996945016170984E-2</c:v>
                </c:pt>
                <c:pt idx="2494">
                  <c:v>0.2780976909140595</c:v>
                </c:pt>
                <c:pt idx="2495">
                  <c:v>0.61446410015781949</c:v>
                </c:pt>
                <c:pt idx="2496">
                  <c:v>0.24340907127497385</c:v>
                </c:pt>
                <c:pt idx="2497">
                  <c:v>0.49280143703570378</c:v>
                </c:pt>
                <c:pt idx="2498">
                  <c:v>1.7007123470046333</c:v>
                </c:pt>
                <c:pt idx="2499">
                  <c:v>7.3277006231468225E-2</c:v>
                </c:pt>
                <c:pt idx="2500">
                  <c:v>0.45882144040537254</c:v>
                </c:pt>
                <c:pt idx="2501">
                  <c:v>0.40406790347371102</c:v>
                </c:pt>
                <c:pt idx="2502">
                  <c:v>0.20461034328907751</c:v>
                </c:pt>
                <c:pt idx="2503">
                  <c:v>0.13690480614214026</c:v>
                </c:pt>
                <c:pt idx="2504">
                  <c:v>1.0816561759037684</c:v>
                </c:pt>
                <c:pt idx="2505">
                  <c:v>0.13460343746350292</c:v>
                </c:pt>
                <c:pt idx="2506">
                  <c:v>0.25294378256387484</c:v>
                </c:pt>
                <c:pt idx="2507">
                  <c:v>0.38412867119364774</c:v>
                </c:pt>
                <c:pt idx="2508">
                  <c:v>0.39487305687841334</c:v>
                </c:pt>
                <c:pt idx="2509">
                  <c:v>7.7019676590350111E-2</c:v>
                </c:pt>
                <c:pt idx="2510">
                  <c:v>0.5823303875608139</c:v>
                </c:pt>
                <c:pt idx="2511">
                  <c:v>5.330050661063155E-2</c:v>
                </c:pt>
                <c:pt idx="2512">
                  <c:v>0.55749880528724061</c:v>
                </c:pt>
                <c:pt idx="2513">
                  <c:v>0.23437351759187591</c:v>
                </c:pt>
                <c:pt idx="2514">
                  <c:v>0.22713368065617673</c:v>
                </c:pt>
                <c:pt idx="2515">
                  <c:v>0.21878536480415467</c:v>
                </c:pt>
                <c:pt idx="2516">
                  <c:v>6.7756566695335474E-2</c:v>
                </c:pt>
                <c:pt idx="2517">
                  <c:v>0.48601111288225946</c:v>
                </c:pt>
                <c:pt idx="2518">
                  <c:v>0.30508374131919952</c:v>
                </c:pt>
                <c:pt idx="2519">
                  <c:v>0.49344305114435699</c:v>
                </c:pt>
                <c:pt idx="2520">
                  <c:v>0.48877514314100146</c:v>
                </c:pt>
                <c:pt idx="2521">
                  <c:v>0.34940915945045004</c:v>
                </c:pt>
                <c:pt idx="2522">
                  <c:v>6.7843708115351252E-3</c:v>
                </c:pt>
                <c:pt idx="2523">
                  <c:v>1.0219710852860453</c:v>
                </c:pt>
                <c:pt idx="2524">
                  <c:v>7.322863437961466E-2</c:v>
                </c:pt>
                <c:pt idx="2525">
                  <c:v>0.32179945223314083</c:v>
                </c:pt>
                <c:pt idx="2526">
                  <c:v>0.57322637814395394</c:v>
                </c:pt>
                <c:pt idx="2527">
                  <c:v>1.198993372184014</c:v>
                </c:pt>
                <c:pt idx="2528">
                  <c:v>0.6388136820196777</c:v>
                </c:pt>
                <c:pt idx="2529">
                  <c:v>0.3956144472642783</c:v>
                </c:pt>
                <c:pt idx="2530">
                  <c:v>8.6896375793954886E-2</c:v>
                </c:pt>
                <c:pt idx="2531">
                  <c:v>0.67147004409928257</c:v>
                </c:pt>
                <c:pt idx="2532">
                  <c:v>0.47688556931560033</c:v>
                </c:pt>
                <c:pt idx="2533">
                  <c:v>0.22999727333210646</c:v>
                </c:pt>
                <c:pt idx="2534">
                  <c:v>0.6312681569089178</c:v>
                </c:pt>
                <c:pt idx="2535">
                  <c:v>4.372568990528904E-3</c:v>
                </c:pt>
                <c:pt idx="2536">
                  <c:v>0.95693427581659352</c:v>
                </c:pt>
                <c:pt idx="2537">
                  <c:v>0.94805826373072011</c:v>
                </c:pt>
                <c:pt idx="2538">
                  <c:v>0.64050941181368126</c:v>
                </c:pt>
                <c:pt idx="2539">
                  <c:v>0.36689137524513477</c:v>
                </c:pt>
                <c:pt idx="2540">
                  <c:v>0.90412154661635691</c:v>
                </c:pt>
                <c:pt idx="2541">
                  <c:v>0.88053333258690825</c:v>
                </c:pt>
                <c:pt idx="2542">
                  <c:v>0.59836285833325675</c:v>
                </c:pt>
                <c:pt idx="2543">
                  <c:v>0.22378548918234753</c:v>
                </c:pt>
                <c:pt idx="2544">
                  <c:v>0.17430422011135302</c:v>
                </c:pt>
                <c:pt idx="2545">
                  <c:v>0.54916692769031716</c:v>
                </c:pt>
                <c:pt idx="2546">
                  <c:v>8.3076754625496296E-2</c:v>
                </c:pt>
                <c:pt idx="2547">
                  <c:v>0.5925183794780492</c:v>
                </c:pt>
                <c:pt idx="2548">
                  <c:v>9.9109911370405965E-2</c:v>
                </c:pt>
                <c:pt idx="2549">
                  <c:v>0.40140577258046756</c:v>
                </c:pt>
                <c:pt idx="2550">
                  <c:v>0.22918183660156091</c:v>
                </c:pt>
                <c:pt idx="2551">
                  <c:v>0.46943756457575964</c:v>
                </c:pt>
                <c:pt idx="2552">
                  <c:v>0.61681164856688186</c:v>
                </c:pt>
                <c:pt idx="2553">
                  <c:v>0.40104723020438926</c:v>
                </c:pt>
                <c:pt idx="2554">
                  <c:v>0.14120558138813796</c:v>
                </c:pt>
                <c:pt idx="2555">
                  <c:v>0.14099923480381266</c:v>
                </c:pt>
                <c:pt idx="2556">
                  <c:v>0.83800590429345911</c:v>
                </c:pt>
                <c:pt idx="2557">
                  <c:v>0.95689395411361633</c:v>
                </c:pt>
                <c:pt idx="2558">
                  <c:v>7.9077170293492996E-2</c:v>
                </c:pt>
                <c:pt idx="2559">
                  <c:v>0.45461167358202142</c:v>
                </c:pt>
                <c:pt idx="2560">
                  <c:v>0.18624611292788401</c:v>
                </c:pt>
                <c:pt idx="2561">
                  <c:v>0.22923458530751903</c:v>
                </c:pt>
                <c:pt idx="2562">
                  <c:v>0.82736455868438052</c:v>
                </c:pt>
                <c:pt idx="2563">
                  <c:v>0.32900679040671071</c:v>
                </c:pt>
                <c:pt idx="2564">
                  <c:v>0.39482369861303063</c:v>
                </c:pt>
                <c:pt idx="2565">
                  <c:v>1.0379924802257289E-2</c:v>
                </c:pt>
                <c:pt idx="2566">
                  <c:v>0.91461318477588693</c:v>
                </c:pt>
                <c:pt idx="2567">
                  <c:v>0.2628822955654439</c:v>
                </c:pt>
                <c:pt idx="2568">
                  <c:v>1.4277558308574319</c:v>
                </c:pt>
                <c:pt idx="2569">
                  <c:v>1.0539937451754182</c:v>
                </c:pt>
                <c:pt idx="2570">
                  <c:v>0.256523230689156</c:v>
                </c:pt>
                <c:pt idx="2571">
                  <c:v>0.4516108824758191</c:v>
                </c:pt>
                <c:pt idx="2572">
                  <c:v>0.26073408391531022</c:v>
                </c:pt>
                <c:pt idx="2573">
                  <c:v>0.20350362492806365</c:v>
                </c:pt>
                <c:pt idx="2574">
                  <c:v>0.11081891735293488</c:v>
                </c:pt>
                <c:pt idx="2575">
                  <c:v>7.2605007444829367E-2</c:v>
                </c:pt>
                <c:pt idx="2576">
                  <c:v>0.2879819274010767</c:v>
                </c:pt>
                <c:pt idx="2577">
                  <c:v>1.2718648974178617</c:v>
                </c:pt>
                <c:pt idx="2578">
                  <c:v>0.61256053473826655</c:v>
                </c:pt>
                <c:pt idx="2579">
                  <c:v>0.12559838309418067</c:v>
                </c:pt>
                <c:pt idx="2580">
                  <c:v>0.95857033083710463</c:v>
                </c:pt>
                <c:pt idx="2581">
                  <c:v>0.32321729149774647</c:v>
                </c:pt>
                <c:pt idx="2582">
                  <c:v>0.32358492470173084</c:v>
                </c:pt>
                <c:pt idx="2583">
                  <c:v>0.13230691198696984</c:v>
                </c:pt>
                <c:pt idx="2584">
                  <c:v>8.821039916663842E-2</c:v>
                </c:pt>
                <c:pt idx="2585">
                  <c:v>0.38630393643153144</c:v>
                </c:pt>
                <c:pt idx="2586">
                  <c:v>0.66940653614497647</c:v>
                </c:pt>
                <c:pt idx="2587">
                  <c:v>1.2706317259195294</c:v>
                </c:pt>
                <c:pt idx="2588">
                  <c:v>0.47769600558963482</c:v>
                </c:pt>
                <c:pt idx="2589">
                  <c:v>0.84858839570986522</c:v>
                </c:pt>
                <c:pt idx="2590">
                  <c:v>0.18883333000653058</c:v>
                </c:pt>
                <c:pt idx="2591">
                  <c:v>2.4635117330044694E-2</c:v>
                </c:pt>
                <c:pt idx="2592">
                  <c:v>0.18536304524941966</c:v>
                </c:pt>
                <c:pt idx="2593">
                  <c:v>0.69624282798509385</c:v>
                </c:pt>
                <c:pt idx="2594">
                  <c:v>0.58714631837819065</c:v>
                </c:pt>
                <c:pt idx="2595">
                  <c:v>8.7175719049904423E-3</c:v>
                </c:pt>
                <c:pt idx="2596">
                  <c:v>0.89000846713157744</c:v>
                </c:pt>
                <c:pt idx="2597">
                  <c:v>0.63407149543908026</c:v>
                </c:pt>
                <c:pt idx="2598">
                  <c:v>0.39165094094777952</c:v>
                </c:pt>
                <c:pt idx="2599">
                  <c:v>1.4079193617529691</c:v>
                </c:pt>
                <c:pt idx="2600">
                  <c:v>2.8676617642520216E-2</c:v>
                </c:pt>
                <c:pt idx="2601">
                  <c:v>4.0339957742237288E-2</c:v>
                </c:pt>
                <c:pt idx="2602">
                  <c:v>0.20918106454985197</c:v>
                </c:pt>
                <c:pt idx="2603">
                  <c:v>0.36301854405813733</c:v>
                </c:pt>
                <c:pt idx="2604">
                  <c:v>3.9329427640933237E-2</c:v>
                </c:pt>
                <c:pt idx="2605">
                  <c:v>0.38476361724805003</c:v>
                </c:pt>
                <c:pt idx="2606">
                  <c:v>0.37325445207560942</c:v>
                </c:pt>
                <c:pt idx="2607">
                  <c:v>1.1421699463838153</c:v>
                </c:pt>
                <c:pt idx="2608">
                  <c:v>0.33589001726772427</c:v>
                </c:pt>
                <c:pt idx="2609">
                  <c:v>9.7791897255444342E-3</c:v>
                </c:pt>
                <c:pt idx="2610">
                  <c:v>0.71444885455822271</c:v>
                </c:pt>
                <c:pt idx="2611">
                  <c:v>3.4408712548069244E-2</c:v>
                </c:pt>
                <c:pt idx="2612">
                  <c:v>1.4629607093104748</c:v>
                </c:pt>
                <c:pt idx="2613">
                  <c:v>0.30259696083969867</c:v>
                </c:pt>
                <c:pt idx="2614">
                  <c:v>0.3419881553038373</c:v>
                </c:pt>
                <c:pt idx="2615">
                  <c:v>0.1005351984904844</c:v>
                </c:pt>
                <c:pt idx="2616">
                  <c:v>0.17256135638224188</c:v>
                </c:pt>
                <c:pt idx="2617">
                  <c:v>0.38646415984732735</c:v>
                </c:pt>
                <c:pt idx="2618">
                  <c:v>1.1674727741150288</c:v>
                </c:pt>
                <c:pt idx="2619">
                  <c:v>1.2203248104635962</c:v>
                </c:pt>
                <c:pt idx="2620">
                  <c:v>1.5538932508965244</c:v>
                </c:pt>
                <c:pt idx="2621">
                  <c:v>8.7059577066833746E-2</c:v>
                </c:pt>
                <c:pt idx="2622">
                  <c:v>0.11518032288875582</c:v>
                </c:pt>
                <c:pt idx="2623">
                  <c:v>0.21911597167385449</c:v>
                </c:pt>
                <c:pt idx="2624">
                  <c:v>4.4172163811816469E-2</c:v>
                </c:pt>
                <c:pt idx="2625">
                  <c:v>8.3749023526986294E-2</c:v>
                </c:pt>
                <c:pt idx="2626">
                  <c:v>6.8298258176754917E-2</c:v>
                </c:pt>
                <c:pt idx="2627">
                  <c:v>0.16005940390270079</c:v>
                </c:pt>
                <c:pt idx="2628">
                  <c:v>0.2906193765521049</c:v>
                </c:pt>
                <c:pt idx="2629">
                  <c:v>0.53935443750020151</c:v>
                </c:pt>
                <c:pt idx="2630">
                  <c:v>0.43913061805327924</c:v>
                </c:pt>
                <c:pt idx="2631">
                  <c:v>0.74899552072091535</c:v>
                </c:pt>
                <c:pt idx="2632">
                  <c:v>0.33082058435639039</c:v>
                </c:pt>
                <c:pt idx="2633">
                  <c:v>0.28096234983403151</c:v>
                </c:pt>
                <c:pt idx="2634">
                  <c:v>0.4718349249250578</c:v>
                </c:pt>
                <c:pt idx="2635">
                  <c:v>0.79775952299815622</c:v>
                </c:pt>
                <c:pt idx="2636">
                  <c:v>0.11879484857783539</c:v>
                </c:pt>
                <c:pt idx="2637">
                  <c:v>0.19740741014639976</c:v>
                </c:pt>
                <c:pt idx="2638">
                  <c:v>0.52465194667418846</c:v>
                </c:pt>
                <c:pt idx="2639">
                  <c:v>0.37530762008447938</c:v>
                </c:pt>
                <c:pt idx="2640">
                  <c:v>5.9304823450574008E-2</c:v>
                </c:pt>
                <c:pt idx="2641">
                  <c:v>0.18337378666194007</c:v>
                </c:pt>
                <c:pt idx="2642">
                  <c:v>0.76209962260897712</c:v>
                </c:pt>
                <c:pt idx="2643">
                  <c:v>6.742456531210206E-3</c:v>
                </c:pt>
                <c:pt idx="2644">
                  <c:v>0.34876408406123122</c:v>
                </c:pt>
                <c:pt idx="2645">
                  <c:v>0.91190700138961112</c:v>
                </c:pt>
                <c:pt idx="2646">
                  <c:v>0.26780829118066968</c:v>
                </c:pt>
                <c:pt idx="2647">
                  <c:v>0.30682970620181704</c:v>
                </c:pt>
                <c:pt idx="2648">
                  <c:v>0.51117869633368496</c:v>
                </c:pt>
                <c:pt idx="2649">
                  <c:v>0.18618309421442461</c:v>
                </c:pt>
                <c:pt idx="2650">
                  <c:v>1.0451045477712677</c:v>
                </c:pt>
                <c:pt idx="2651">
                  <c:v>0.64113912525502137</c:v>
                </c:pt>
                <c:pt idx="2652">
                  <c:v>1.1443204917943748</c:v>
                </c:pt>
                <c:pt idx="2653">
                  <c:v>0.22051461232371553</c:v>
                </c:pt>
                <c:pt idx="2654">
                  <c:v>0.91502451540634133</c:v>
                </c:pt>
                <c:pt idx="2655">
                  <c:v>0.18030347475169536</c:v>
                </c:pt>
                <c:pt idx="2656">
                  <c:v>4.9348104204690012E-3</c:v>
                </c:pt>
                <c:pt idx="2657">
                  <c:v>6.0669253986013298E-2</c:v>
                </c:pt>
                <c:pt idx="2658">
                  <c:v>0.3932260869037329</c:v>
                </c:pt>
                <c:pt idx="2659">
                  <c:v>8.4267732666151257E-2</c:v>
                </c:pt>
                <c:pt idx="2660">
                  <c:v>2.221044456128669E-4</c:v>
                </c:pt>
                <c:pt idx="2661">
                  <c:v>1.0186936479845403</c:v>
                </c:pt>
                <c:pt idx="2662">
                  <c:v>0.2443886329495461</c:v>
                </c:pt>
                <c:pt idx="2663">
                  <c:v>0.2556334630452135</c:v>
                </c:pt>
                <c:pt idx="2664">
                  <c:v>0.40794350350861075</c:v>
                </c:pt>
                <c:pt idx="2665">
                  <c:v>9.359905958941668E-2</c:v>
                </c:pt>
                <c:pt idx="2666">
                  <c:v>0.36390963246887359</c:v>
                </c:pt>
                <c:pt idx="2667">
                  <c:v>0.93607187489258059</c:v>
                </c:pt>
                <c:pt idx="2668">
                  <c:v>0.10664953368391239</c:v>
                </c:pt>
                <c:pt idx="2669">
                  <c:v>1.0304434786456664</c:v>
                </c:pt>
                <c:pt idx="2670">
                  <c:v>0.59462108856176921</c:v>
                </c:pt>
                <c:pt idx="2671">
                  <c:v>0.65842909185456822</c:v>
                </c:pt>
                <c:pt idx="2672">
                  <c:v>1.1162064306050008</c:v>
                </c:pt>
                <c:pt idx="2673">
                  <c:v>0.49468803484280904</c:v>
                </c:pt>
                <c:pt idx="2674">
                  <c:v>6.1217292873938955E-2</c:v>
                </c:pt>
                <c:pt idx="2675">
                  <c:v>9.2491968404070327E-2</c:v>
                </c:pt>
                <c:pt idx="2676">
                  <c:v>1.6336968010726517E-2</c:v>
                </c:pt>
                <c:pt idx="2677">
                  <c:v>1.4082739744733177</c:v>
                </c:pt>
                <c:pt idx="2678">
                  <c:v>0.12823118612105713</c:v>
                </c:pt>
                <c:pt idx="2679">
                  <c:v>4.289669834927444E-2</c:v>
                </c:pt>
                <c:pt idx="2680">
                  <c:v>0.31226998098146408</c:v>
                </c:pt>
                <c:pt idx="2681">
                  <c:v>5.736657011826559E-2</c:v>
                </c:pt>
                <c:pt idx="2682">
                  <c:v>0.53165588495656679</c:v>
                </c:pt>
                <c:pt idx="2683">
                  <c:v>4.1776139617457679E-2</c:v>
                </c:pt>
                <c:pt idx="2684">
                  <c:v>0.33713904590860827</c:v>
                </c:pt>
                <c:pt idx="2685">
                  <c:v>2.8600725394405765E-2</c:v>
                </c:pt>
                <c:pt idx="2686">
                  <c:v>1.3658439047134097</c:v>
                </c:pt>
                <c:pt idx="2687">
                  <c:v>1.032332201049708</c:v>
                </c:pt>
                <c:pt idx="2688">
                  <c:v>0.25856014028419988</c:v>
                </c:pt>
                <c:pt idx="2689">
                  <c:v>1.9109549588158741</c:v>
                </c:pt>
                <c:pt idx="2690">
                  <c:v>1.029399744628795</c:v>
                </c:pt>
                <c:pt idx="2691">
                  <c:v>0.20447293848306861</c:v>
                </c:pt>
                <c:pt idx="2692">
                  <c:v>1.0174129454982996</c:v>
                </c:pt>
                <c:pt idx="2693">
                  <c:v>0.14366682816656931</c:v>
                </c:pt>
                <c:pt idx="2694">
                  <c:v>8.2431598218148092E-2</c:v>
                </c:pt>
                <c:pt idx="2695">
                  <c:v>0.53077383026407288</c:v>
                </c:pt>
                <c:pt idx="2696">
                  <c:v>0.57111063159172415</c:v>
                </c:pt>
                <c:pt idx="2697">
                  <c:v>0.43111375452154121</c:v>
                </c:pt>
                <c:pt idx="2698">
                  <c:v>0.27133909702643638</c:v>
                </c:pt>
                <c:pt idx="2699">
                  <c:v>0.50852150750250147</c:v>
                </c:pt>
                <c:pt idx="2700">
                  <c:v>0.91156433915680946</c:v>
                </c:pt>
                <c:pt idx="2701">
                  <c:v>0.22119495514675497</c:v>
                </c:pt>
                <c:pt idx="2702">
                  <c:v>0.5234709025107579</c:v>
                </c:pt>
                <c:pt idx="2703">
                  <c:v>0.36148397830759993</c:v>
                </c:pt>
                <c:pt idx="2704">
                  <c:v>0.13057716004545261</c:v>
                </c:pt>
                <c:pt idx="2705">
                  <c:v>0.17632576876715789</c:v>
                </c:pt>
                <c:pt idx="2706">
                  <c:v>0.6792777489499453</c:v>
                </c:pt>
                <c:pt idx="2707">
                  <c:v>0.34802318154479855</c:v>
                </c:pt>
                <c:pt idx="2708">
                  <c:v>0.14001519617789807</c:v>
                </c:pt>
                <c:pt idx="2709">
                  <c:v>0.17649299652415693</c:v>
                </c:pt>
                <c:pt idx="2710">
                  <c:v>0.41159602481534485</c:v>
                </c:pt>
                <c:pt idx="2711">
                  <c:v>0.1784324302850897</c:v>
                </c:pt>
                <c:pt idx="2712">
                  <c:v>0.73160422078963816</c:v>
                </c:pt>
                <c:pt idx="2713">
                  <c:v>0.20094111324612765</c:v>
                </c:pt>
                <c:pt idx="2714">
                  <c:v>0.75296482568522982</c:v>
                </c:pt>
                <c:pt idx="2715">
                  <c:v>2.0153129558739998E-2</c:v>
                </c:pt>
                <c:pt idx="2716">
                  <c:v>0.29033789507146784</c:v>
                </c:pt>
                <c:pt idx="2717">
                  <c:v>0.13639647408213232</c:v>
                </c:pt>
                <c:pt idx="2718">
                  <c:v>1.1555422545390412</c:v>
                </c:pt>
                <c:pt idx="2719">
                  <c:v>0.23218787274482103</c:v>
                </c:pt>
                <c:pt idx="2720">
                  <c:v>3.3590058280255117E-2</c:v>
                </c:pt>
                <c:pt idx="2721">
                  <c:v>0.6637395192082961</c:v>
                </c:pt>
                <c:pt idx="2722">
                  <c:v>0.66200002107275879</c:v>
                </c:pt>
                <c:pt idx="2723">
                  <c:v>7.9837968344497467E-2</c:v>
                </c:pt>
                <c:pt idx="2724">
                  <c:v>0.1124277098558428</c:v>
                </c:pt>
                <c:pt idx="2725">
                  <c:v>1.2613509067504851</c:v>
                </c:pt>
                <c:pt idx="2726">
                  <c:v>0.94632652850784194</c:v>
                </c:pt>
                <c:pt idx="2727">
                  <c:v>1.6408507818044422</c:v>
                </c:pt>
                <c:pt idx="2728">
                  <c:v>0.55993680934577694</c:v>
                </c:pt>
                <c:pt idx="2729">
                  <c:v>1.1937064185359549</c:v>
                </c:pt>
                <c:pt idx="2730">
                  <c:v>0.43566843950404854</c:v>
                </c:pt>
                <c:pt idx="2731">
                  <c:v>1.943840176781355E-2</c:v>
                </c:pt>
                <c:pt idx="2732">
                  <c:v>0.56359492047793469</c:v>
                </c:pt>
                <c:pt idx="2733">
                  <c:v>0.23220593711582505</c:v>
                </c:pt>
                <c:pt idx="2734">
                  <c:v>0.71930501459063656</c:v>
                </c:pt>
                <c:pt idx="2735">
                  <c:v>0.15452030789173929</c:v>
                </c:pt>
                <c:pt idx="2736">
                  <c:v>0.17371653509027762</c:v>
                </c:pt>
                <c:pt idx="2737">
                  <c:v>0.62050926458189959</c:v>
                </c:pt>
                <c:pt idx="2738">
                  <c:v>0.15357469792812808</c:v>
                </c:pt>
                <c:pt idx="2739">
                  <c:v>0.11739014576520049</c:v>
                </c:pt>
                <c:pt idx="2740">
                  <c:v>0.30980349469569946</c:v>
                </c:pt>
                <c:pt idx="2741">
                  <c:v>1.6098798532598164E-2</c:v>
                </c:pt>
                <c:pt idx="2742">
                  <c:v>0.11311066199758497</c:v>
                </c:pt>
                <c:pt idx="2743">
                  <c:v>0.14020732369964778</c:v>
                </c:pt>
                <c:pt idx="2744">
                  <c:v>0.6936615569121678</c:v>
                </c:pt>
                <c:pt idx="2745">
                  <c:v>0.89440164521053667</c:v>
                </c:pt>
                <c:pt idx="2746">
                  <c:v>1.3777557118216031</c:v>
                </c:pt>
                <c:pt idx="2747">
                  <c:v>0.51689688119065103</c:v>
                </c:pt>
                <c:pt idx="2748">
                  <c:v>5.8422046560148391E-2</c:v>
                </c:pt>
                <c:pt idx="2749">
                  <c:v>0.60093221682645281</c:v>
                </c:pt>
                <c:pt idx="2750">
                  <c:v>1.3504226720114674E-2</c:v>
                </c:pt>
                <c:pt idx="2751">
                  <c:v>0.30587194612324647</c:v>
                </c:pt>
                <c:pt idx="2752">
                  <c:v>0.15359572141035957</c:v>
                </c:pt>
                <c:pt idx="2753">
                  <c:v>0.42714915784077623</c:v>
                </c:pt>
                <c:pt idx="2754">
                  <c:v>0.27272589795629071</c:v>
                </c:pt>
                <c:pt idx="2755">
                  <c:v>0.87104195057343481</c:v>
                </c:pt>
                <c:pt idx="2756">
                  <c:v>5.7227077748073896E-2</c:v>
                </c:pt>
                <c:pt idx="2757">
                  <c:v>0.37675043235196454</c:v>
                </c:pt>
                <c:pt idx="2758">
                  <c:v>0.2252957315050316</c:v>
                </c:pt>
                <c:pt idx="2759">
                  <c:v>0.22469945551262407</c:v>
                </c:pt>
                <c:pt idx="2760">
                  <c:v>0.69585622733041075</c:v>
                </c:pt>
                <c:pt idx="2761">
                  <c:v>1.0667834717254852</c:v>
                </c:pt>
                <c:pt idx="2762">
                  <c:v>0.57690183686993157</c:v>
                </c:pt>
                <c:pt idx="2763">
                  <c:v>7.0496686373682838E-2</c:v>
                </c:pt>
                <c:pt idx="2764">
                  <c:v>0.29742068104161085</c:v>
                </c:pt>
                <c:pt idx="2765">
                  <c:v>0.72524448060678426</c:v>
                </c:pt>
                <c:pt idx="2766">
                  <c:v>0.95587005004490611</c:v>
                </c:pt>
                <c:pt idx="2767">
                  <c:v>0.58628370883901704</c:v>
                </c:pt>
                <c:pt idx="2768">
                  <c:v>0.34816013401103552</c:v>
                </c:pt>
                <c:pt idx="2769">
                  <c:v>0.49777421866276161</c:v>
                </c:pt>
                <c:pt idx="2770">
                  <c:v>0.45205028263226232</c:v>
                </c:pt>
                <c:pt idx="2771">
                  <c:v>0.49862706857870132</c:v>
                </c:pt>
                <c:pt idx="2772">
                  <c:v>1.1822334383198387</c:v>
                </c:pt>
                <c:pt idx="2773">
                  <c:v>7.1669997414568851E-2</c:v>
                </c:pt>
                <c:pt idx="2774">
                  <c:v>0.34499313583997926</c:v>
                </c:pt>
                <c:pt idx="2775">
                  <c:v>0.26386885923298126</c:v>
                </c:pt>
                <c:pt idx="2776">
                  <c:v>0.48723267512362278</c:v>
                </c:pt>
                <c:pt idx="2777">
                  <c:v>0.2150140294204145</c:v>
                </c:pt>
                <c:pt idx="2778">
                  <c:v>5.979041453304702E-3</c:v>
                </c:pt>
                <c:pt idx="2779">
                  <c:v>0.28430509040132451</c:v>
                </c:pt>
                <c:pt idx="2780">
                  <c:v>0.2150077382914318</c:v>
                </c:pt>
                <c:pt idx="2781">
                  <c:v>1.1138526111940494E-2</c:v>
                </c:pt>
                <c:pt idx="2782">
                  <c:v>4.5130529163026012E-2</c:v>
                </c:pt>
                <c:pt idx="2783">
                  <c:v>1.2299151490445215</c:v>
                </c:pt>
                <c:pt idx="2784">
                  <c:v>0.16513049764074106</c:v>
                </c:pt>
                <c:pt idx="2785">
                  <c:v>0.14314206533994517</c:v>
                </c:pt>
                <c:pt idx="2786">
                  <c:v>1.0399467690957001</c:v>
                </c:pt>
                <c:pt idx="2787">
                  <c:v>0.20546191617804282</c:v>
                </c:pt>
                <c:pt idx="2788">
                  <c:v>0.94307968466841419</c:v>
                </c:pt>
                <c:pt idx="2789">
                  <c:v>0.11879239706936053</c:v>
                </c:pt>
                <c:pt idx="2790">
                  <c:v>0.72296543711725469</c:v>
                </c:pt>
                <c:pt idx="2791">
                  <c:v>0.38586579753028027</c:v>
                </c:pt>
                <c:pt idx="2792">
                  <c:v>0.30463432831471227</c:v>
                </c:pt>
                <c:pt idx="2793">
                  <c:v>0.29944814128940311</c:v>
                </c:pt>
                <c:pt idx="2794">
                  <c:v>0.47854720068415224</c:v>
                </c:pt>
                <c:pt idx="2795">
                  <c:v>0.40176336696104958</c:v>
                </c:pt>
                <c:pt idx="2796">
                  <c:v>0.96931869424592831</c:v>
                </c:pt>
                <c:pt idx="2797">
                  <c:v>0.74622203043656399</c:v>
                </c:pt>
                <c:pt idx="2798">
                  <c:v>0.53877336682664889</c:v>
                </c:pt>
                <c:pt idx="2799">
                  <c:v>0.3784840531031885</c:v>
                </c:pt>
                <c:pt idx="2800">
                  <c:v>0.41023706502287083</c:v>
                </c:pt>
                <c:pt idx="2801">
                  <c:v>0.6017862947039524</c:v>
                </c:pt>
                <c:pt idx="2802">
                  <c:v>0.18392565251203818</c:v>
                </c:pt>
                <c:pt idx="2803">
                  <c:v>0.12406287905612093</c:v>
                </c:pt>
                <c:pt idx="2804">
                  <c:v>0.6839573927310546</c:v>
                </c:pt>
                <c:pt idx="2805">
                  <c:v>1.5412940091280844E-2</c:v>
                </c:pt>
                <c:pt idx="2806">
                  <c:v>0.18954971683574809</c:v>
                </c:pt>
                <c:pt idx="2807">
                  <c:v>0.22721428708716451</c:v>
                </c:pt>
                <c:pt idx="2808">
                  <c:v>0.37772662168104248</c:v>
                </c:pt>
                <c:pt idx="2809">
                  <c:v>0.1702431044946657</c:v>
                </c:pt>
                <c:pt idx="2810">
                  <c:v>1.1964920690937948</c:v>
                </c:pt>
                <c:pt idx="2811">
                  <c:v>0.74303735339694532</c:v>
                </c:pt>
                <c:pt idx="2812">
                  <c:v>0.29283339608535947</c:v>
                </c:pt>
                <c:pt idx="2813">
                  <c:v>0.86572308957528121</c:v>
                </c:pt>
                <c:pt idx="2814">
                  <c:v>0.11164233004323422</c:v>
                </c:pt>
                <c:pt idx="2815">
                  <c:v>0.16360350949290758</c:v>
                </c:pt>
                <c:pt idx="2816">
                  <c:v>1.0556239618149773E-2</c:v>
                </c:pt>
                <c:pt idx="2817">
                  <c:v>0.6419955797826371</c:v>
                </c:pt>
                <c:pt idx="2818">
                  <c:v>0.5168944479606794</c:v>
                </c:pt>
                <c:pt idx="2819">
                  <c:v>0.66468173128025609</c:v>
                </c:pt>
                <c:pt idx="2820">
                  <c:v>0.12983368345835455</c:v>
                </c:pt>
                <c:pt idx="2821">
                  <c:v>8.9953385217358683E-3</c:v>
                </c:pt>
                <c:pt idx="2822">
                  <c:v>1.6119553810866452</c:v>
                </c:pt>
                <c:pt idx="2823">
                  <c:v>0.27426715769992355</c:v>
                </c:pt>
                <c:pt idx="2824">
                  <c:v>2.0485562419103385</c:v>
                </c:pt>
                <c:pt idx="2825">
                  <c:v>0.15440685048162084</c:v>
                </c:pt>
                <c:pt idx="2826">
                  <c:v>0.13008519292078133</c:v>
                </c:pt>
                <c:pt idx="2827">
                  <c:v>0.28227732381984955</c:v>
                </c:pt>
                <c:pt idx="2828">
                  <c:v>0.97839679995555306</c:v>
                </c:pt>
                <c:pt idx="2829">
                  <c:v>7.6691318622416474E-2</c:v>
                </c:pt>
                <c:pt idx="2830">
                  <c:v>0.99227619611918194</c:v>
                </c:pt>
                <c:pt idx="2831">
                  <c:v>0.69540503033346313</c:v>
                </c:pt>
                <c:pt idx="2832">
                  <c:v>0.62270859379874488</c:v>
                </c:pt>
                <c:pt idx="2833">
                  <c:v>0.27070778213317298</c:v>
                </c:pt>
                <c:pt idx="2834">
                  <c:v>1.1489033150129138</c:v>
                </c:pt>
                <c:pt idx="2835">
                  <c:v>0.43199651346711909</c:v>
                </c:pt>
                <c:pt idx="2836">
                  <c:v>0.42330104512800532</c:v>
                </c:pt>
                <c:pt idx="2837">
                  <c:v>0.15660846152831165</c:v>
                </c:pt>
                <c:pt idx="2838">
                  <c:v>0.71058257098611832</c:v>
                </c:pt>
                <c:pt idx="2839">
                  <c:v>0.62335156513163648</c:v>
                </c:pt>
                <c:pt idx="2840">
                  <c:v>0.51013663748690685</c:v>
                </c:pt>
                <c:pt idx="2841">
                  <c:v>2.12645845717961E-2</c:v>
                </c:pt>
                <c:pt idx="2842">
                  <c:v>0.89844701590081522</c:v>
                </c:pt>
                <c:pt idx="2843">
                  <c:v>0.86102063245716465</c:v>
                </c:pt>
                <c:pt idx="2844">
                  <c:v>4.6959816273665841E-2</c:v>
                </c:pt>
                <c:pt idx="2845">
                  <c:v>0.23369387427100169</c:v>
                </c:pt>
                <c:pt idx="2846">
                  <c:v>0.49618152683833411</c:v>
                </c:pt>
                <c:pt idx="2847">
                  <c:v>2.8549497995002691</c:v>
                </c:pt>
                <c:pt idx="2848">
                  <c:v>1.2256842185961518</c:v>
                </c:pt>
                <c:pt idx="2849">
                  <c:v>0.11441897024932822</c:v>
                </c:pt>
                <c:pt idx="2850">
                  <c:v>0.2190851984213672</c:v>
                </c:pt>
                <c:pt idx="2851">
                  <c:v>0.71031655470940214</c:v>
                </c:pt>
                <c:pt idx="2852">
                  <c:v>0.23327490454649999</c:v>
                </c:pt>
                <c:pt idx="2853">
                  <c:v>1.1019437736277704</c:v>
                </c:pt>
                <c:pt idx="2854">
                  <c:v>0.52221514531082369</c:v>
                </c:pt>
                <c:pt idx="2855">
                  <c:v>8.1700142405745066E-2</c:v>
                </c:pt>
                <c:pt idx="2856">
                  <c:v>7.9760865233284184E-2</c:v>
                </c:pt>
                <c:pt idx="2857">
                  <c:v>0.66818098062187914</c:v>
                </c:pt>
                <c:pt idx="2858">
                  <c:v>1.1747906878752818</c:v>
                </c:pt>
                <c:pt idx="2859">
                  <c:v>0.39951374784900573</c:v>
                </c:pt>
                <c:pt idx="2860">
                  <c:v>8.3508904903191974E-2</c:v>
                </c:pt>
                <c:pt idx="2861">
                  <c:v>1.5036508265364976</c:v>
                </c:pt>
                <c:pt idx="2862">
                  <c:v>1.0944025938870685</c:v>
                </c:pt>
                <c:pt idx="2863">
                  <c:v>4.2516153746014768E-3</c:v>
                </c:pt>
                <c:pt idx="2864">
                  <c:v>0.41431930443100029</c:v>
                </c:pt>
                <c:pt idx="2865">
                  <c:v>0.27647810674501105</c:v>
                </c:pt>
                <c:pt idx="2866">
                  <c:v>0.27076969257441075</c:v>
                </c:pt>
                <c:pt idx="2867">
                  <c:v>8.311493024500103E-3</c:v>
                </c:pt>
                <c:pt idx="2868">
                  <c:v>2.7072727629313613</c:v>
                </c:pt>
                <c:pt idx="2869">
                  <c:v>8.2544277966740978E-2</c:v>
                </c:pt>
                <c:pt idx="2870">
                  <c:v>0.67939696680765993</c:v>
                </c:pt>
                <c:pt idx="2871">
                  <c:v>0.27775776715100797</c:v>
                </c:pt>
                <c:pt idx="2872">
                  <c:v>0.12270711404935661</c:v>
                </c:pt>
                <c:pt idx="2873">
                  <c:v>0.40298763532021986</c:v>
                </c:pt>
                <c:pt idx="2874">
                  <c:v>5.8278736215336982E-2</c:v>
                </c:pt>
                <c:pt idx="2875">
                  <c:v>0.30128831050098492</c:v>
                </c:pt>
                <c:pt idx="2876">
                  <c:v>8.8689292008107753E-2</c:v>
                </c:pt>
                <c:pt idx="2877">
                  <c:v>0.80868898800151512</c:v>
                </c:pt>
                <c:pt idx="2878">
                  <c:v>0.28239268128473416</c:v>
                </c:pt>
                <c:pt idx="2879">
                  <c:v>0.16665284734068667</c:v>
                </c:pt>
                <c:pt idx="2880">
                  <c:v>0.33934018715800968</c:v>
                </c:pt>
                <c:pt idx="2881">
                  <c:v>0.66557366654342498</c:v>
                </c:pt>
                <c:pt idx="2882">
                  <c:v>1.8731901699482754</c:v>
                </c:pt>
                <c:pt idx="2883">
                  <c:v>0.93380818580825331</c:v>
                </c:pt>
                <c:pt idx="2884">
                  <c:v>2.1568389731317368E-2</c:v>
                </c:pt>
                <c:pt idx="2885">
                  <c:v>0.45836643193069815</c:v>
                </c:pt>
                <c:pt idx="2886">
                  <c:v>0.90941687898494372</c:v>
                </c:pt>
                <c:pt idx="2887">
                  <c:v>0.33967185428584079</c:v>
                </c:pt>
                <c:pt idx="2888">
                  <c:v>0.96790302460049626</c:v>
                </c:pt>
                <c:pt idx="2889">
                  <c:v>0.39922062885437076</c:v>
                </c:pt>
                <c:pt idx="2890">
                  <c:v>0.70401120817874407</c:v>
                </c:pt>
                <c:pt idx="2891">
                  <c:v>0.88318963245656668</c:v>
                </c:pt>
                <c:pt idx="2892">
                  <c:v>0.52585735375420728</c:v>
                </c:pt>
                <c:pt idx="2893">
                  <c:v>1.1477751815063233</c:v>
                </c:pt>
                <c:pt idx="2894">
                  <c:v>0.65606984871694685</c:v>
                </c:pt>
                <c:pt idx="2895">
                  <c:v>0.44285934266225979</c:v>
                </c:pt>
                <c:pt idx="2896">
                  <c:v>9.0130321448237433E-2</c:v>
                </c:pt>
                <c:pt idx="2897">
                  <c:v>0.1520768806493846</c:v>
                </c:pt>
                <c:pt idx="2898">
                  <c:v>0.43504942849133782</c:v>
                </c:pt>
                <c:pt idx="2899">
                  <c:v>0.43535272273578018</c:v>
                </c:pt>
                <c:pt idx="2900">
                  <c:v>0.82309779024454299</c:v>
                </c:pt>
                <c:pt idx="2901">
                  <c:v>2.2580848019727005E-2</c:v>
                </c:pt>
                <c:pt idx="2902">
                  <c:v>0.18600865685697623</c:v>
                </c:pt>
                <c:pt idx="2903">
                  <c:v>4.3846484264077031E-3</c:v>
                </c:pt>
                <c:pt idx="2904">
                  <c:v>0.30801573425539913</c:v>
                </c:pt>
                <c:pt idx="2905">
                  <c:v>1.453879008306326</c:v>
                </c:pt>
                <c:pt idx="2906">
                  <c:v>0.60252567726014383</c:v>
                </c:pt>
                <c:pt idx="2907">
                  <c:v>1.4064855986595433</c:v>
                </c:pt>
                <c:pt idx="2908">
                  <c:v>4.3348820835590197E-2</c:v>
                </c:pt>
                <c:pt idx="2909">
                  <c:v>0.69697151291182713</c:v>
                </c:pt>
                <c:pt idx="2910">
                  <c:v>0.10930467846203831</c:v>
                </c:pt>
                <c:pt idx="2911">
                  <c:v>1.1042213247671693</c:v>
                </c:pt>
                <c:pt idx="2912">
                  <c:v>0.43437631745072713</c:v>
                </c:pt>
                <c:pt idx="2913">
                  <c:v>1.7016367030174842</c:v>
                </c:pt>
                <c:pt idx="2914">
                  <c:v>8.0876929590164334E-2</c:v>
                </c:pt>
                <c:pt idx="2915">
                  <c:v>0.2492177383761319</c:v>
                </c:pt>
                <c:pt idx="2916">
                  <c:v>0.20362404316964119</c:v>
                </c:pt>
                <c:pt idx="2917">
                  <c:v>0.22127680404390657</c:v>
                </c:pt>
                <c:pt idx="2918">
                  <c:v>0.15054890810696911</c:v>
                </c:pt>
                <c:pt idx="2919">
                  <c:v>0.91045553604701968</c:v>
                </c:pt>
                <c:pt idx="2920">
                  <c:v>0.34423614890915177</c:v>
                </c:pt>
                <c:pt idx="2921">
                  <c:v>0.46073113370296209</c:v>
                </c:pt>
                <c:pt idx="2922">
                  <c:v>0.75021889161426947</c:v>
                </c:pt>
                <c:pt idx="2923">
                  <c:v>1.769838223226279</c:v>
                </c:pt>
                <c:pt idx="2924">
                  <c:v>0.57223766011289179</c:v>
                </c:pt>
                <c:pt idx="2925">
                  <c:v>2.9625325626360954E-2</c:v>
                </c:pt>
                <c:pt idx="2926">
                  <c:v>0.30749831647232723</c:v>
                </c:pt>
                <c:pt idx="2927">
                  <c:v>0.84076670230991357</c:v>
                </c:pt>
                <c:pt idx="2928">
                  <c:v>0.37265383692055121</c:v>
                </c:pt>
                <c:pt idx="2929">
                  <c:v>0.49337969106823559</c:v>
                </c:pt>
                <c:pt idx="2930">
                  <c:v>0.94318794109046533</c:v>
                </c:pt>
                <c:pt idx="2931">
                  <c:v>0.4766572390876288</c:v>
                </c:pt>
                <c:pt idx="2932">
                  <c:v>6.0349751550821562E-2</c:v>
                </c:pt>
                <c:pt idx="2933">
                  <c:v>3.9062126727634455E-2</c:v>
                </c:pt>
                <c:pt idx="2934">
                  <c:v>0.7952039776004346</c:v>
                </c:pt>
                <c:pt idx="2935">
                  <c:v>5.7467996408413768E-2</c:v>
                </c:pt>
                <c:pt idx="2936">
                  <c:v>0.74814217206248401</c:v>
                </c:pt>
                <c:pt idx="2937">
                  <c:v>9.7597118258732754E-2</c:v>
                </c:pt>
                <c:pt idx="2938">
                  <c:v>0.53803177278592751</c:v>
                </c:pt>
                <c:pt idx="2939">
                  <c:v>0.20412101270423375</c:v>
                </c:pt>
                <c:pt idx="2940">
                  <c:v>6.4543894088668757E-3</c:v>
                </c:pt>
                <c:pt idx="2941">
                  <c:v>0.27134695878642934</c:v>
                </c:pt>
                <c:pt idx="2942">
                  <c:v>3.0078922100263727</c:v>
                </c:pt>
                <c:pt idx="2943">
                  <c:v>0.54593381879679659</c:v>
                </c:pt>
                <c:pt idx="2944">
                  <c:v>1.5005335518220064</c:v>
                </c:pt>
                <c:pt idx="2945">
                  <c:v>0.18493814386703625</c:v>
                </c:pt>
                <c:pt idx="2946">
                  <c:v>0.92060357923579972</c:v>
                </c:pt>
                <c:pt idx="2947">
                  <c:v>0.34619686401699884</c:v>
                </c:pt>
                <c:pt idx="2948">
                  <c:v>0.66058649214482568</c:v>
                </c:pt>
                <c:pt idx="2949">
                  <c:v>4.9179037475397237E-2</c:v>
                </c:pt>
                <c:pt idx="2950">
                  <c:v>0.28912850686020064</c:v>
                </c:pt>
                <c:pt idx="2951">
                  <c:v>0.39822251712433132</c:v>
                </c:pt>
                <c:pt idx="2952">
                  <c:v>0.39559262085358399</c:v>
                </c:pt>
                <c:pt idx="2953">
                  <c:v>0.70151693973061902</c:v>
                </c:pt>
                <c:pt idx="2954">
                  <c:v>0.1809649252042182</c:v>
                </c:pt>
                <c:pt idx="2955">
                  <c:v>0.40878205589143168</c:v>
                </c:pt>
                <c:pt idx="2956">
                  <c:v>7.4525679678466754E-3</c:v>
                </c:pt>
                <c:pt idx="2957">
                  <c:v>0.8177459050957806</c:v>
                </c:pt>
                <c:pt idx="2958">
                  <c:v>0.19977341659608419</c:v>
                </c:pt>
                <c:pt idx="2959">
                  <c:v>0.3006675378333708</c:v>
                </c:pt>
                <c:pt idx="2960">
                  <c:v>0.63099528642024727</c:v>
                </c:pt>
                <c:pt idx="2961">
                  <c:v>0.15930964310794313</c:v>
                </c:pt>
                <c:pt idx="2962">
                  <c:v>9.6822223461762336E-2</c:v>
                </c:pt>
                <c:pt idx="2963">
                  <c:v>0.49870774031448478</c:v>
                </c:pt>
                <c:pt idx="2964">
                  <c:v>8.9662934457838864E-2</c:v>
                </c:pt>
                <c:pt idx="2965">
                  <c:v>0.34149595745940997</c:v>
                </c:pt>
                <c:pt idx="2966">
                  <c:v>8.3398956148803202E-2</c:v>
                </c:pt>
                <c:pt idx="2967">
                  <c:v>2.1389885858778095E-2</c:v>
                </c:pt>
                <c:pt idx="2968">
                  <c:v>0.86369347668192797</c:v>
                </c:pt>
                <c:pt idx="2969">
                  <c:v>0.34777016569823932</c:v>
                </c:pt>
                <c:pt idx="2970">
                  <c:v>0.29570848274656425</c:v>
                </c:pt>
                <c:pt idx="2971">
                  <c:v>0.22333315865939368</c:v>
                </c:pt>
                <c:pt idx="2972">
                  <c:v>0.26310737776605858</c:v>
                </c:pt>
                <c:pt idx="2973">
                  <c:v>0.23025078862680895</c:v>
                </c:pt>
                <c:pt idx="2974">
                  <c:v>0.77743906533643148</c:v>
                </c:pt>
                <c:pt idx="2975">
                  <c:v>0.38233166690730014</c:v>
                </c:pt>
                <c:pt idx="2976">
                  <c:v>0.29462654702287161</c:v>
                </c:pt>
                <c:pt idx="2977">
                  <c:v>0.48840475917926857</c:v>
                </c:pt>
                <c:pt idx="2978">
                  <c:v>7.731687910743075E-2</c:v>
                </c:pt>
                <c:pt idx="2979">
                  <c:v>0.3034492561818346</c:v>
                </c:pt>
                <c:pt idx="2980">
                  <c:v>1.7269818388647246E-2</c:v>
                </c:pt>
                <c:pt idx="2981">
                  <c:v>0.3366668022427749</c:v>
                </c:pt>
                <c:pt idx="2982">
                  <c:v>0.12733410966417008</c:v>
                </c:pt>
                <c:pt idx="2983">
                  <c:v>0.98926618011642586</c:v>
                </c:pt>
                <c:pt idx="2984">
                  <c:v>0.53106317333703446</c:v>
                </c:pt>
                <c:pt idx="2985">
                  <c:v>0.79050362898529802</c:v>
                </c:pt>
                <c:pt idx="2986">
                  <c:v>0.10481865247837187</c:v>
                </c:pt>
                <c:pt idx="2987">
                  <c:v>8.7918676222635592E-2</c:v>
                </c:pt>
                <c:pt idx="2988">
                  <c:v>0.51858448362520759</c:v>
                </c:pt>
                <c:pt idx="2989">
                  <c:v>0.43508027071530503</c:v>
                </c:pt>
                <c:pt idx="2990">
                  <c:v>0.31756725191749852</c:v>
                </c:pt>
                <c:pt idx="2991">
                  <c:v>0.33359850279559466</c:v>
                </c:pt>
                <c:pt idx="2992">
                  <c:v>6.0238305734791241E-2</c:v>
                </c:pt>
                <c:pt idx="2993">
                  <c:v>0.59567544905497016</c:v>
                </c:pt>
                <c:pt idx="2994">
                  <c:v>5.8836751616994608E-2</c:v>
                </c:pt>
                <c:pt idx="2995">
                  <c:v>0.22260117260138215</c:v>
                </c:pt>
                <c:pt idx="2996">
                  <c:v>0.29912176326348111</c:v>
                </c:pt>
                <c:pt idx="2997">
                  <c:v>0.29875154926229947</c:v>
                </c:pt>
                <c:pt idx="2998">
                  <c:v>0.53642752318592934</c:v>
                </c:pt>
                <c:pt idx="2999">
                  <c:v>0.86369340512883519</c:v>
                </c:pt>
                <c:pt idx="3000">
                  <c:v>0.53709105597696316</c:v>
                </c:pt>
                <c:pt idx="3001">
                  <c:v>7.3707970992986052E-2</c:v>
                </c:pt>
                <c:pt idx="3002">
                  <c:v>0.36336092987578827</c:v>
                </c:pt>
                <c:pt idx="3003">
                  <c:v>0.27291407190856753</c:v>
                </c:pt>
                <c:pt idx="3004">
                  <c:v>0.51404385822424148</c:v>
                </c:pt>
                <c:pt idx="3005">
                  <c:v>0.11267971194031674</c:v>
                </c:pt>
                <c:pt idx="3006">
                  <c:v>0.18370023973117505</c:v>
                </c:pt>
                <c:pt idx="3007">
                  <c:v>0.42789574259184521</c:v>
                </c:pt>
                <c:pt idx="3008">
                  <c:v>3.1402753228457078E-2</c:v>
                </c:pt>
                <c:pt idx="3009">
                  <c:v>0.30650449228262794</c:v>
                </c:pt>
                <c:pt idx="3010">
                  <c:v>0.15107008542770134</c:v>
                </c:pt>
                <c:pt idx="3011">
                  <c:v>0.48508233683138802</c:v>
                </c:pt>
                <c:pt idx="3012">
                  <c:v>0.20526893419924652</c:v>
                </c:pt>
                <c:pt idx="3013">
                  <c:v>0.46130557026688462</c:v>
                </c:pt>
                <c:pt idx="3014">
                  <c:v>0.56693457950272408</c:v>
                </c:pt>
                <c:pt idx="3015">
                  <c:v>0.17519221163353116</c:v>
                </c:pt>
                <c:pt idx="3016">
                  <c:v>0.10071996033158878</c:v>
                </c:pt>
                <c:pt idx="3017">
                  <c:v>0.22758297953350268</c:v>
                </c:pt>
                <c:pt idx="3018">
                  <c:v>0.42927461916476789</c:v>
                </c:pt>
                <c:pt idx="3019">
                  <c:v>0.52103659524210155</c:v>
                </c:pt>
                <c:pt idx="3020">
                  <c:v>2.5673642437832649E-2</c:v>
                </c:pt>
                <c:pt idx="3021">
                  <c:v>0.18023294606012996</c:v>
                </c:pt>
                <c:pt idx="3022">
                  <c:v>0.67091155056812457</c:v>
                </c:pt>
                <c:pt idx="3023">
                  <c:v>0.38340301604353832</c:v>
                </c:pt>
                <c:pt idx="3024">
                  <c:v>0.45884773178168881</c:v>
                </c:pt>
                <c:pt idx="3025">
                  <c:v>0.23375454827225467</c:v>
                </c:pt>
                <c:pt idx="3026">
                  <c:v>2.3194764185321827E-2</c:v>
                </c:pt>
                <c:pt idx="3027">
                  <c:v>1.8445221432280362E-2</c:v>
                </c:pt>
                <c:pt idx="3028">
                  <c:v>2.1401075923691364</c:v>
                </c:pt>
                <c:pt idx="3029">
                  <c:v>0.15085320838435623</c:v>
                </c:pt>
                <c:pt idx="3030">
                  <c:v>8.9274309896255288E-2</c:v>
                </c:pt>
                <c:pt idx="3031">
                  <c:v>0.96364277426225198</c:v>
                </c:pt>
                <c:pt idx="3032">
                  <c:v>0.63956739432920118</c:v>
                </c:pt>
                <c:pt idx="3033">
                  <c:v>0.49205501022456644</c:v>
                </c:pt>
                <c:pt idx="3034">
                  <c:v>0.65204257144370947</c:v>
                </c:pt>
                <c:pt idx="3035">
                  <c:v>0.74451694964586834</c:v>
                </c:pt>
                <c:pt idx="3036">
                  <c:v>1.1162423111513522</c:v>
                </c:pt>
                <c:pt idx="3037">
                  <c:v>0.25707702422205314</c:v>
                </c:pt>
                <c:pt idx="3038">
                  <c:v>0.18990570516078864</c:v>
                </c:pt>
                <c:pt idx="3039">
                  <c:v>1.0394461212712365</c:v>
                </c:pt>
                <c:pt idx="3040">
                  <c:v>1.6838993646225029</c:v>
                </c:pt>
                <c:pt idx="3041">
                  <c:v>0.45308146150928175</c:v>
                </c:pt>
                <c:pt idx="3042">
                  <c:v>0.16345706150888223</c:v>
                </c:pt>
                <c:pt idx="3043">
                  <c:v>0.59697229787972561</c:v>
                </c:pt>
                <c:pt idx="3044">
                  <c:v>0.38706948459232915</c:v>
                </c:pt>
                <c:pt idx="3045">
                  <c:v>0.73989544157122877</c:v>
                </c:pt>
                <c:pt idx="3046">
                  <c:v>0.14705499932085736</c:v>
                </c:pt>
                <c:pt idx="3047">
                  <c:v>0.139447319351338</c:v>
                </c:pt>
                <c:pt idx="3048">
                  <c:v>0.64224810086939721</c:v>
                </c:pt>
                <c:pt idx="3049">
                  <c:v>0.53468509707007883</c:v>
                </c:pt>
                <c:pt idx="3050">
                  <c:v>1.4865699640310434E-2</c:v>
                </c:pt>
                <c:pt idx="3051">
                  <c:v>0.27618268645605848</c:v>
                </c:pt>
                <c:pt idx="3052">
                  <c:v>0.45661049531274528</c:v>
                </c:pt>
                <c:pt idx="3053">
                  <c:v>0.70706373628524355</c:v>
                </c:pt>
                <c:pt idx="3054">
                  <c:v>0.71679305824533168</c:v>
                </c:pt>
                <c:pt idx="3055">
                  <c:v>0.69268124463733238</c:v>
                </c:pt>
                <c:pt idx="3056">
                  <c:v>0.86348831474319176</c:v>
                </c:pt>
                <c:pt idx="3057">
                  <c:v>0.6702191570756052</c:v>
                </c:pt>
                <c:pt idx="3058">
                  <c:v>1.0978221017323522</c:v>
                </c:pt>
                <c:pt idx="3059">
                  <c:v>0.35254010298583571</c:v>
                </c:pt>
                <c:pt idx="3060">
                  <c:v>0.45315401069525302</c:v>
                </c:pt>
                <c:pt idx="3061">
                  <c:v>1.2406312073379495</c:v>
                </c:pt>
                <c:pt idx="3062">
                  <c:v>0.15112839058069061</c:v>
                </c:pt>
                <c:pt idx="3063">
                  <c:v>0.80509554072535416</c:v>
                </c:pt>
                <c:pt idx="3064">
                  <c:v>0.55771586627145986</c:v>
                </c:pt>
                <c:pt idx="3065">
                  <c:v>0.19669983436266911</c:v>
                </c:pt>
                <c:pt idx="3066">
                  <c:v>0.21997121359482807</c:v>
                </c:pt>
                <c:pt idx="3067">
                  <c:v>1.1414083383407703</c:v>
                </c:pt>
                <c:pt idx="3068">
                  <c:v>0.9107816142049826</c:v>
                </c:pt>
                <c:pt idx="3069">
                  <c:v>0.59831990511856659</c:v>
                </c:pt>
                <c:pt idx="3070">
                  <c:v>0.53627897047200379</c:v>
                </c:pt>
                <c:pt idx="3071">
                  <c:v>0.33607395272340063</c:v>
                </c:pt>
                <c:pt idx="3072">
                  <c:v>0.46377604501974962</c:v>
                </c:pt>
                <c:pt idx="3073">
                  <c:v>0.26950699754553181</c:v>
                </c:pt>
                <c:pt idx="3074">
                  <c:v>0.52487267654871583</c:v>
                </c:pt>
                <c:pt idx="3075">
                  <c:v>8.9689838928346168E-3</c:v>
                </c:pt>
                <c:pt idx="3076">
                  <c:v>0.54381307482913843</c:v>
                </c:pt>
                <c:pt idx="3077">
                  <c:v>0.52214558732209604</c:v>
                </c:pt>
                <c:pt idx="3078">
                  <c:v>0.26001350912936544</c:v>
                </c:pt>
                <c:pt idx="3079">
                  <c:v>0.15434456986803044</c:v>
                </c:pt>
                <c:pt idx="3080">
                  <c:v>0.20670299224815825</c:v>
                </c:pt>
                <c:pt idx="3081">
                  <c:v>0.73026574764892016</c:v>
                </c:pt>
                <c:pt idx="3082">
                  <c:v>2.0607649282787122E-2</c:v>
                </c:pt>
                <c:pt idx="3083">
                  <c:v>2.1527135479103414</c:v>
                </c:pt>
                <c:pt idx="3084">
                  <c:v>4.1766364326387362E-2</c:v>
                </c:pt>
                <c:pt idx="3085">
                  <c:v>1.6202186224738766</c:v>
                </c:pt>
                <c:pt idx="3086">
                  <c:v>0.3628912278519581</c:v>
                </c:pt>
                <c:pt idx="3087">
                  <c:v>1.1284349097743791</c:v>
                </c:pt>
                <c:pt idx="3088">
                  <c:v>1.0520642944717882</c:v>
                </c:pt>
                <c:pt idx="3089">
                  <c:v>0.48277909331760227</c:v>
                </c:pt>
                <c:pt idx="3090">
                  <c:v>1.3991175518358174</c:v>
                </c:pt>
                <c:pt idx="3091">
                  <c:v>0.55470197196800386</c:v>
                </c:pt>
                <c:pt idx="3092">
                  <c:v>0.32023030581733697</c:v>
                </c:pt>
                <c:pt idx="3093">
                  <c:v>2.4945686394097675</c:v>
                </c:pt>
                <c:pt idx="3094">
                  <c:v>0.2864205083706875</c:v>
                </c:pt>
                <c:pt idx="3095">
                  <c:v>0.63138194924948221</c:v>
                </c:pt>
                <c:pt idx="3096">
                  <c:v>0.30507134439983025</c:v>
                </c:pt>
                <c:pt idx="3097">
                  <c:v>1.1316684210546712</c:v>
                </c:pt>
                <c:pt idx="3098">
                  <c:v>1.1169655897297275</c:v>
                </c:pt>
                <c:pt idx="3099">
                  <c:v>0.474419168479433</c:v>
                </c:pt>
                <c:pt idx="3100">
                  <c:v>0.33498393341226812</c:v>
                </c:pt>
                <c:pt idx="3101">
                  <c:v>2.7710151031048782</c:v>
                </c:pt>
                <c:pt idx="3102">
                  <c:v>4.7238567822779666E-2</c:v>
                </c:pt>
                <c:pt idx="3103">
                  <c:v>0.67836112963631567</c:v>
                </c:pt>
                <c:pt idx="3104">
                  <c:v>0.80961388454160177</c:v>
                </c:pt>
                <c:pt idx="3105">
                  <c:v>1.296550460445892</c:v>
                </c:pt>
                <c:pt idx="3106">
                  <c:v>0.62874172081457003</c:v>
                </c:pt>
                <c:pt idx="3107">
                  <c:v>0.60691712349317406</c:v>
                </c:pt>
                <c:pt idx="3108">
                  <c:v>0.61756050660921324</c:v>
                </c:pt>
                <c:pt idx="3109">
                  <c:v>3.8782904434808849E-2</c:v>
                </c:pt>
                <c:pt idx="3110">
                  <c:v>0.98761048688479858</c:v>
                </c:pt>
                <c:pt idx="3111">
                  <c:v>1.9428283667744854E-2</c:v>
                </c:pt>
                <c:pt idx="3112">
                  <c:v>1.1677024881471334</c:v>
                </c:pt>
                <c:pt idx="3113">
                  <c:v>0.89153106181041819</c:v>
                </c:pt>
                <c:pt idx="3114">
                  <c:v>0.1354036555305233</c:v>
                </c:pt>
                <c:pt idx="3115">
                  <c:v>0.16354912035371877</c:v>
                </c:pt>
                <c:pt idx="3116">
                  <c:v>3.1564851019161295E-2</c:v>
                </c:pt>
                <c:pt idx="3117">
                  <c:v>0.13593377417716868</c:v>
                </c:pt>
                <c:pt idx="3118">
                  <c:v>1.1649845124990161</c:v>
                </c:pt>
                <c:pt idx="3119">
                  <c:v>0.1419220977977011</c:v>
                </c:pt>
                <c:pt idx="3120">
                  <c:v>0.95224420207094207</c:v>
                </c:pt>
                <c:pt idx="3121">
                  <c:v>0.92051076032177148</c:v>
                </c:pt>
                <c:pt idx="3122">
                  <c:v>0.17579722867433417</c:v>
                </c:pt>
                <c:pt idx="3123">
                  <c:v>3.0360205731069815E-3</c:v>
                </c:pt>
                <c:pt idx="3124">
                  <c:v>0.18176847992970713</c:v>
                </c:pt>
                <c:pt idx="3125">
                  <c:v>0.90128124999840187</c:v>
                </c:pt>
                <c:pt idx="3126">
                  <c:v>3.9544490055418081E-2</c:v>
                </c:pt>
                <c:pt idx="3127">
                  <c:v>1.0412126687046239</c:v>
                </c:pt>
                <c:pt idx="3128">
                  <c:v>1.0313829831881847</c:v>
                </c:pt>
                <c:pt idx="3129">
                  <c:v>1.3746664345147401</c:v>
                </c:pt>
                <c:pt idx="3130">
                  <c:v>0.16751419932214479</c:v>
                </c:pt>
                <c:pt idx="3131">
                  <c:v>0.84055534954720712</c:v>
                </c:pt>
                <c:pt idx="3132">
                  <c:v>0.32896525630352369</c:v>
                </c:pt>
                <c:pt idx="3133">
                  <c:v>0.540651779641797</c:v>
                </c:pt>
                <c:pt idx="3134">
                  <c:v>0.39555730889281254</c:v>
                </c:pt>
                <c:pt idx="3135">
                  <c:v>0.36509726680065335</c:v>
                </c:pt>
                <c:pt idx="3136">
                  <c:v>7.4437694906200724E-2</c:v>
                </c:pt>
                <c:pt idx="3137">
                  <c:v>0.87332081170782772</c:v>
                </c:pt>
                <c:pt idx="3138">
                  <c:v>1.0471358158473294E-2</c:v>
                </c:pt>
                <c:pt idx="3139">
                  <c:v>0.94232785069939839</c:v>
                </c:pt>
                <c:pt idx="3140">
                  <c:v>0.93452136949068942</c:v>
                </c:pt>
                <c:pt idx="3141">
                  <c:v>0.82029673847172235</c:v>
                </c:pt>
                <c:pt idx="3142">
                  <c:v>9.5210676160825125E-2</c:v>
                </c:pt>
                <c:pt idx="3143">
                  <c:v>0.70995544695299717</c:v>
                </c:pt>
                <c:pt idx="3144">
                  <c:v>4.5504030117690095E-2</c:v>
                </c:pt>
                <c:pt idx="3145">
                  <c:v>0.8021215431852835</c:v>
                </c:pt>
                <c:pt idx="3146">
                  <c:v>0.9787846591838123</c:v>
                </c:pt>
                <c:pt idx="3147">
                  <c:v>6.8787072768611117E-3</c:v>
                </c:pt>
                <c:pt idx="3148">
                  <c:v>5.9339689746341427E-2</c:v>
                </c:pt>
                <c:pt idx="3149">
                  <c:v>1.3788893116317573</c:v>
                </c:pt>
                <c:pt idx="3150">
                  <c:v>1.0862130776448591</c:v>
                </c:pt>
                <c:pt idx="3151">
                  <c:v>0.35281915194263208</c:v>
                </c:pt>
                <c:pt idx="3152">
                  <c:v>0.52184523574330899</c:v>
                </c:pt>
                <c:pt idx="3153">
                  <c:v>1.4294032642948182</c:v>
                </c:pt>
                <c:pt idx="3154">
                  <c:v>1.0527578974045815</c:v>
                </c:pt>
                <c:pt idx="3155">
                  <c:v>0.48044061414564315</c:v>
                </c:pt>
                <c:pt idx="3156">
                  <c:v>2.0842998118831777</c:v>
                </c:pt>
                <c:pt idx="3157">
                  <c:v>0.68294935764445852</c:v>
                </c:pt>
                <c:pt idx="3158">
                  <c:v>0.56929463634781707</c:v>
                </c:pt>
                <c:pt idx="3159">
                  <c:v>0.10499248018288192</c:v>
                </c:pt>
                <c:pt idx="3160">
                  <c:v>2.1625229520839118E-3</c:v>
                </c:pt>
                <c:pt idx="3161">
                  <c:v>0.11522384724215956</c:v>
                </c:pt>
                <c:pt idx="3162">
                  <c:v>0.3620241480953364</c:v>
                </c:pt>
                <c:pt idx="3163">
                  <c:v>0.73251172862014113</c:v>
                </c:pt>
                <c:pt idx="3164">
                  <c:v>0.2710110333416193</c:v>
                </c:pt>
                <c:pt idx="3165">
                  <c:v>0.27009126211882239</c:v>
                </c:pt>
                <c:pt idx="3166">
                  <c:v>4.3413224981725854E-2</c:v>
                </c:pt>
                <c:pt idx="3167">
                  <c:v>0.55784312376385814</c:v>
                </c:pt>
                <c:pt idx="3168">
                  <c:v>0.23473751858392206</c:v>
                </c:pt>
                <c:pt idx="3169">
                  <c:v>1.1127633496179694</c:v>
                </c:pt>
                <c:pt idx="3170">
                  <c:v>2.6699687751264207E-2</c:v>
                </c:pt>
                <c:pt idx="3171">
                  <c:v>0.89842524044077776</c:v>
                </c:pt>
                <c:pt idx="3172">
                  <c:v>0.57826243717845716</c:v>
                </c:pt>
                <c:pt idx="3173">
                  <c:v>0.10758411868675578</c:v>
                </c:pt>
                <c:pt idx="3174">
                  <c:v>1.0354364105203984</c:v>
                </c:pt>
                <c:pt idx="3175">
                  <c:v>0.59260007709255069</c:v>
                </c:pt>
                <c:pt idx="3176">
                  <c:v>0.63087659332455326</c:v>
                </c:pt>
                <c:pt idx="3177">
                  <c:v>1.5791183738486032</c:v>
                </c:pt>
                <c:pt idx="3178">
                  <c:v>0.13569093678210561</c:v>
                </c:pt>
                <c:pt idx="3179">
                  <c:v>0.50342856255392976</c:v>
                </c:pt>
                <c:pt idx="3180">
                  <c:v>0.51059935911907806</c:v>
                </c:pt>
                <c:pt idx="3181">
                  <c:v>7.6152427329663167E-2</c:v>
                </c:pt>
                <c:pt idx="3182">
                  <c:v>0.24871459399702414</c:v>
                </c:pt>
                <c:pt idx="3183">
                  <c:v>0.67910360749890297</c:v>
                </c:pt>
                <c:pt idx="3184">
                  <c:v>0.68725621302001627</c:v>
                </c:pt>
                <c:pt idx="3185">
                  <c:v>2.1270769284905251</c:v>
                </c:pt>
                <c:pt idx="3186">
                  <c:v>0.17040866527446785</c:v>
                </c:pt>
                <c:pt idx="3187">
                  <c:v>0.24138116215936442</c:v>
                </c:pt>
                <c:pt idx="3188">
                  <c:v>0.41008904606290858</c:v>
                </c:pt>
                <c:pt idx="3189">
                  <c:v>1.0795383465914929</c:v>
                </c:pt>
                <c:pt idx="3190">
                  <c:v>0.77406763161958791</c:v>
                </c:pt>
                <c:pt idx="3191">
                  <c:v>0.16844969346877603</c:v>
                </c:pt>
                <c:pt idx="3192">
                  <c:v>0.44904672299134929</c:v>
                </c:pt>
                <c:pt idx="3193">
                  <c:v>0.84732647583887266</c:v>
                </c:pt>
                <c:pt idx="3194">
                  <c:v>1.0729148085881552</c:v>
                </c:pt>
                <c:pt idx="3195">
                  <c:v>0.73105172348711556</c:v>
                </c:pt>
                <c:pt idx="3196">
                  <c:v>0.72955581204571462</c:v>
                </c:pt>
                <c:pt idx="3197">
                  <c:v>7.7127669302380811E-2</c:v>
                </c:pt>
                <c:pt idx="3198">
                  <c:v>0.64498678595880587</c:v>
                </c:pt>
                <c:pt idx="3199">
                  <c:v>0.67219752816582279</c:v>
                </c:pt>
                <c:pt idx="3200">
                  <c:v>0.59083224988159722</c:v>
                </c:pt>
                <c:pt idx="3201">
                  <c:v>0.44977263694250641</c:v>
                </c:pt>
                <c:pt idx="3202">
                  <c:v>0.57886452598802296</c:v>
                </c:pt>
                <c:pt idx="3203">
                  <c:v>2.8362897022364636E-2</c:v>
                </c:pt>
                <c:pt idx="3204">
                  <c:v>0.30254200380697438</c:v>
                </c:pt>
                <c:pt idx="3205">
                  <c:v>0.11716865025379102</c:v>
                </c:pt>
                <c:pt idx="3206">
                  <c:v>7.8277339989114098E-2</c:v>
                </c:pt>
                <c:pt idx="3207">
                  <c:v>6.3337890234046285E-4</c:v>
                </c:pt>
                <c:pt idx="3208">
                  <c:v>6.5105700481585788E-2</c:v>
                </c:pt>
                <c:pt idx="3209">
                  <c:v>0.30284396814643522</c:v>
                </c:pt>
                <c:pt idx="3210">
                  <c:v>0.30904632505772794</c:v>
                </c:pt>
                <c:pt idx="3211">
                  <c:v>1.0232801834898269</c:v>
                </c:pt>
                <c:pt idx="3212">
                  <c:v>0.50722434671613703</c:v>
                </c:pt>
                <c:pt idx="3213">
                  <c:v>4.470048228458922E-2</c:v>
                </c:pt>
                <c:pt idx="3214">
                  <c:v>0.19971285440640948</c:v>
                </c:pt>
                <c:pt idx="3215">
                  <c:v>0.50762159848709676</c:v>
                </c:pt>
                <c:pt idx="3216">
                  <c:v>1.0412331738082634</c:v>
                </c:pt>
                <c:pt idx="3217">
                  <c:v>0.5947715657977779</c:v>
                </c:pt>
                <c:pt idx="3218">
                  <c:v>0.27814586161790095</c:v>
                </c:pt>
                <c:pt idx="3219">
                  <c:v>1.8411078971277852</c:v>
                </c:pt>
                <c:pt idx="3220">
                  <c:v>0.42993585818153046</c:v>
                </c:pt>
                <c:pt idx="3221">
                  <c:v>0.90785089165390143</c:v>
                </c:pt>
                <c:pt idx="3222">
                  <c:v>0.12264692904266489</c:v>
                </c:pt>
                <c:pt idx="3223">
                  <c:v>0.31051974359562101</c:v>
                </c:pt>
                <c:pt idx="3224">
                  <c:v>1.1508096279321474</c:v>
                </c:pt>
                <c:pt idx="3225">
                  <c:v>0.60455408880231964</c:v>
                </c:pt>
                <c:pt idx="3226">
                  <c:v>0.18945206835782061</c:v>
                </c:pt>
                <c:pt idx="3227">
                  <c:v>0.35003212105693066</c:v>
                </c:pt>
                <c:pt idx="3228">
                  <c:v>0.13764538791347766</c:v>
                </c:pt>
                <c:pt idx="3229">
                  <c:v>0.54539975029544874</c:v>
                </c:pt>
                <c:pt idx="3230">
                  <c:v>0.64155100424873979</c:v>
                </c:pt>
                <c:pt idx="3231">
                  <c:v>6.8429974434251445E-2</c:v>
                </c:pt>
                <c:pt idx="3232">
                  <c:v>0.77906545885262546</c:v>
                </c:pt>
                <c:pt idx="3233">
                  <c:v>1.1960090484327428</c:v>
                </c:pt>
                <c:pt idx="3234">
                  <c:v>0.12503221509887544</c:v>
                </c:pt>
                <c:pt idx="3235">
                  <c:v>0.20866616091780474</c:v>
                </c:pt>
                <c:pt idx="3236">
                  <c:v>2.917150276593611</c:v>
                </c:pt>
                <c:pt idx="3237">
                  <c:v>0.16844780616859642</c:v>
                </c:pt>
                <c:pt idx="3238">
                  <c:v>0.45843858958137301</c:v>
                </c:pt>
                <c:pt idx="3239">
                  <c:v>5.938547744594877E-2</c:v>
                </c:pt>
                <c:pt idx="3240">
                  <c:v>0.44095765211611021</c:v>
                </c:pt>
                <c:pt idx="3241">
                  <c:v>0.95521153975142969</c:v>
                </c:pt>
                <c:pt idx="3242">
                  <c:v>1.0729647708039687</c:v>
                </c:pt>
                <c:pt idx="3243">
                  <c:v>1.1544788080750215</c:v>
                </c:pt>
                <c:pt idx="3244">
                  <c:v>0.26393870331793584</c:v>
                </c:pt>
                <c:pt idx="3245">
                  <c:v>1.3003577387633154</c:v>
                </c:pt>
                <c:pt idx="3246">
                  <c:v>1.5596203175499364</c:v>
                </c:pt>
                <c:pt idx="3247">
                  <c:v>0.97517396169631521</c:v>
                </c:pt>
                <c:pt idx="3248">
                  <c:v>0.29394989273145661</c:v>
                </c:pt>
                <c:pt idx="3249">
                  <c:v>0.24887830721577606</c:v>
                </c:pt>
                <c:pt idx="3250">
                  <c:v>0.20347668092577395</c:v>
                </c:pt>
                <c:pt idx="3251">
                  <c:v>4.2634148185517404E-2</c:v>
                </c:pt>
                <c:pt idx="3252">
                  <c:v>0.11836902372416097</c:v>
                </c:pt>
                <c:pt idx="3253">
                  <c:v>0.40329875733132325</c:v>
                </c:pt>
                <c:pt idx="3254">
                  <c:v>5.2714580981059904E-2</c:v>
                </c:pt>
                <c:pt idx="3255">
                  <c:v>1.0416243293658851</c:v>
                </c:pt>
                <c:pt idx="3256">
                  <c:v>0.81142599006915139</c:v>
                </c:pt>
                <c:pt idx="3257">
                  <c:v>0.18956397140336437</c:v>
                </c:pt>
                <c:pt idx="3258">
                  <c:v>9.3304684764504819E-2</c:v>
                </c:pt>
                <c:pt idx="3259">
                  <c:v>4.0815988376235943E-2</c:v>
                </c:pt>
                <c:pt idx="3260">
                  <c:v>0.39717711198390165</c:v>
                </c:pt>
                <c:pt idx="3261">
                  <c:v>0.81582640636640702</c:v>
                </c:pt>
                <c:pt idx="3262">
                  <c:v>0.86282047456409583</c:v>
                </c:pt>
                <c:pt idx="3263">
                  <c:v>0.75758093405887772</c:v>
                </c:pt>
                <c:pt idx="3264">
                  <c:v>0.75803327451936819</c:v>
                </c:pt>
                <c:pt idx="3265">
                  <c:v>1.0531944509582625</c:v>
                </c:pt>
                <c:pt idx="3266">
                  <c:v>0.93167971968351726</c:v>
                </c:pt>
                <c:pt idx="3267">
                  <c:v>4.848723398429302E-2</c:v>
                </c:pt>
                <c:pt idx="3268">
                  <c:v>0.21864708876461825</c:v>
                </c:pt>
                <c:pt idx="3269">
                  <c:v>0.37651681311750673</c:v>
                </c:pt>
                <c:pt idx="3270">
                  <c:v>0.3244748475766529</c:v>
                </c:pt>
                <c:pt idx="3271">
                  <c:v>0.58968782061214886</c:v>
                </c:pt>
                <c:pt idx="3272">
                  <c:v>1.2797322675753688</c:v>
                </c:pt>
                <c:pt idx="3273">
                  <c:v>0.34129623699022099</c:v>
                </c:pt>
                <c:pt idx="3274">
                  <c:v>0.45011324049617646</c:v>
                </c:pt>
                <c:pt idx="3275">
                  <c:v>0.33974907436622359</c:v>
                </c:pt>
                <c:pt idx="3276">
                  <c:v>0.17685569499419798</c:v>
                </c:pt>
                <c:pt idx="3277">
                  <c:v>0.60564392712319259</c:v>
                </c:pt>
                <c:pt idx="3278">
                  <c:v>0.4780132449575345</c:v>
                </c:pt>
                <c:pt idx="3279">
                  <c:v>0.12355342601644552</c:v>
                </c:pt>
                <c:pt idx="3280">
                  <c:v>0.18726416529486362</c:v>
                </c:pt>
                <c:pt idx="3281">
                  <c:v>0.83171583959251438</c:v>
                </c:pt>
                <c:pt idx="3282">
                  <c:v>5.6090073837723908E-2</c:v>
                </c:pt>
                <c:pt idx="3283">
                  <c:v>9.4847143604635059E-2</c:v>
                </c:pt>
                <c:pt idx="3284">
                  <c:v>0.40023782949141257</c:v>
                </c:pt>
                <c:pt idx="3285">
                  <c:v>3.6042668922562117E-2</c:v>
                </c:pt>
                <c:pt idx="3286">
                  <c:v>0.11310627643572674</c:v>
                </c:pt>
                <c:pt idx="3287">
                  <c:v>0.31148317361637207</c:v>
                </c:pt>
                <c:pt idx="3288">
                  <c:v>0.69133434757129486</c:v>
                </c:pt>
                <c:pt idx="3289">
                  <c:v>0.43946760798166634</c:v>
                </c:pt>
                <c:pt idx="3290">
                  <c:v>0.6532237178113165</c:v>
                </c:pt>
                <c:pt idx="3291">
                  <c:v>0.12315965544920897</c:v>
                </c:pt>
                <c:pt idx="3292">
                  <c:v>0.66652707919682064</c:v>
                </c:pt>
                <c:pt idx="3293">
                  <c:v>5.8233240737808403E-2</c:v>
                </c:pt>
                <c:pt idx="3294">
                  <c:v>0.99566816497717248</c:v>
                </c:pt>
                <c:pt idx="3295">
                  <c:v>0.81924833018811494</c:v>
                </c:pt>
                <c:pt idx="3296">
                  <c:v>0.56145336692392722</c:v>
                </c:pt>
                <c:pt idx="3297">
                  <c:v>0.52575169299281466</c:v>
                </c:pt>
                <c:pt idx="3298">
                  <c:v>0.54292435291204055</c:v>
                </c:pt>
                <c:pt idx="3299">
                  <c:v>2.1079267275624938</c:v>
                </c:pt>
                <c:pt idx="3300">
                  <c:v>0.12859060486618745</c:v>
                </c:pt>
                <c:pt idx="3301">
                  <c:v>0.10806497068520392</c:v>
                </c:pt>
                <c:pt idx="3302">
                  <c:v>0.29218320900757877</c:v>
                </c:pt>
                <c:pt idx="3303">
                  <c:v>0.51052973662974688</c:v>
                </c:pt>
                <c:pt idx="3304">
                  <c:v>0.14071464799180425</c:v>
                </c:pt>
                <c:pt idx="3305">
                  <c:v>1.1634863022283717</c:v>
                </c:pt>
                <c:pt idx="3306">
                  <c:v>0.62020881295210639</c:v>
                </c:pt>
                <c:pt idx="3307">
                  <c:v>1.2471472125406264</c:v>
                </c:pt>
                <c:pt idx="3308">
                  <c:v>1.8777434390109825E-2</c:v>
                </c:pt>
                <c:pt idx="3309">
                  <c:v>0.29167144602044293</c:v>
                </c:pt>
                <c:pt idx="3310">
                  <c:v>0.39111591865853607</c:v>
                </c:pt>
                <c:pt idx="3311">
                  <c:v>0.51079562630806674</c:v>
                </c:pt>
                <c:pt idx="3312">
                  <c:v>0.51545067159591196</c:v>
                </c:pt>
                <c:pt idx="3313">
                  <c:v>1.4570266483915906</c:v>
                </c:pt>
                <c:pt idx="3314">
                  <c:v>0.22513501367190428</c:v>
                </c:pt>
                <c:pt idx="3315">
                  <c:v>0.68853956816924466</c:v>
                </c:pt>
                <c:pt idx="3316">
                  <c:v>4.6481286145789091E-3</c:v>
                </c:pt>
                <c:pt idx="3317">
                  <c:v>0.26116746370942445</c:v>
                </c:pt>
                <c:pt idx="3318">
                  <c:v>0.40435438309904809</c:v>
                </c:pt>
                <c:pt idx="3319">
                  <c:v>0.42584632996670801</c:v>
                </c:pt>
                <c:pt idx="3320">
                  <c:v>0.2916866031597285</c:v>
                </c:pt>
                <c:pt idx="3321">
                  <c:v>0.4013271377194042</c:v>
                </c:pt>
                <c:pt idx="3322">
                  <c:v>0.1865878689303172</c:v>
                </c:pt>
                <c:pt idx="3323">
                  <c:v>0.53734210187667453</c:v>
                </c:pt>
                <c:pt idx="3324">
                  <c:v>3.7464939498312186E-2</c:v>
                </c:pt>
                <c:pt idx="3325">
                  <c:v>1.1536328601043775</c:v>
                </c:pt>
                <c:pt idx="3326">
                  <c:v>0.62057550417027152</c:v>
                </c:pt>
                <c:pt idx="3327">
                  <c:v>1.4614349109848077</c:v>
                </c:pt>
                <c:pt idx="3328">
                  <c:v>1.0751493314332643</c:v>
                </c:pt>
                <c:pt idx="3329">
                  <c:v>0.41142678976642233</c:v>
                </c:pt>
                <c:pt idx="3330">
                  <c:v>9.7061910339924257E-2</c:v>
                </c:pt>
                <c:pt idx="3331">
                  <c:v>0.17916334749452525</c:v>
                </c:pt>
                <c:pt idx="3332">
                  <c:v>1.348082827808309E-2</c:v>
                </c:pt>
                <c:pt idx="3333">
                  <c:v>0.14948472316908398</c:v>
                </c:pt>
                <c:pt idx="3334">
                  <c:v>0.52091614358944693</c:v>
                </c:pt>
                <c:pt idx="3335">
                  <c:v>0.27428635229423576</c:v>
                </c:pt>
                <c:pt idx="3336">
                  <c:v>0.97676173682925382</c:v>
                </c:pt>
                <c:pt idx="3337">
                  <c:v>0.70415935472509916</c:v>
                </c:pt>
                <c:pt idx="3338">
                  <c:v>1.0767375034617148</c:v>
                </c:pt>
                <c:pt idx="3339">
                  <c:v>0.53952282441710553</c:v>
                </c:pt>
                <c:pt idx="3340">
                  <c:v>8.4047530125214404E-2</c:v>
                </c:pt>
                <c:pt idx="3341">
                  <c:v>0.16303786628104003</c:v>
                </c:pt>
                <c:pt idx="3342">
                  <c:v>0.18897264137268169</c:v>
                </c:pt>
                <c:pt idx="3343">
                  <c:v>0.28247813006372785</c:v>
                </c:pt>
                <c:pt idx="3344">
                  <c:v>0.29162325920199689</c:v>
                </c:pt>
                <c:pt idx="3345">
                  <c:v>0.30873506883420121</c:v>
                </c:pt>
                <c:pt idx="3346">
                  <c:v>0.90116810929429914</c:v>
                </c:pt>
                <c:pt idx="3347">
                  <c:v>0.11287688308354743</c:v>
                </c:pt>
                <c:pt idx="3348">
                  <c:v>0.51339594738989658</c:v>
                </c:pt>
                <c:pt idx="3349">
                  <c:v>1.6703321922413493E-2</c:v>
                </c:pt>
                <c:pt idx="3350">
                  <c:v>0.42647418526698744</c:v>
                </c:pt>
                <c:pt idx="3351">
                  <c:v>0.50131040363997137</c:v>
                </c:pt>
                <c:pt idx="3352">
                  <c:v>0.41231802432867665</c:v>
                </c:pt>
                <c:pt idx="3353">
                  <c:v>3.514938108343748E-2</c:v>
                </c:pt>
                <c:pt idx="3354">
                  <c:v>0.42361667922085494</c:v>
                </c:pt>
                <c:pt idx="3355">
                  <c:v>1.1682202409400635</c:v>
                </c:pt>
                <c:pt idx="3356">
                  <c:v>0.16383874964878037</c:v>
                </c:pt>
                <c:pt idx="3357">
                  <c:v>0.23947413365521514</c:v>
                </c:pt>
                <c:pt idx="3358">
                  <c:v>7.4188016737123066E-2</c:v>
                </c:pt>
                <c:pt idx="3359">
                  <c:v>2.1324314309808274</c:v>
                </c:pt>
                <c:pt idx="3360">
                  <c:v>0.16872841210311609</c:v>
                </c:pt>
                <c:pt idx="3361">
                  <c:v>0.10462018123068434</c:v>
                </c:pt>
                <c:pt idx="3362">
                  <c:v>0.16815428977626437</c:v>
                </c:pt>
                <c:pt idx="3363">
                  <c:v>0.15638634581346067</c:v>
                </c:pt>
                <c:pt idx="3364">
                  <c:v>0.7955797504791412</c:v>
                </c:pt>
                <c:pt idx="3365">
                  <c:v>0.70395757115177804</c:v>
                </c:pt>
                <c:pt idx="3366">
                  <c:v>0.67919749907228666</c:v>
                </c:pt>
                <c:pt idx="3367">
                  <c:v>0.77908486402663701</c:v>
                </c:pt>
                <c:pt idx="3368">
                  <c:v>7.4618718359494005E-2</c:v>
                </c:pt>
                <c:pt idx="3369">
                  <c:v>0.98006119773044464</c:v>
                </c:pt>
                <c:pt idx="3370">
                  <c:v>8.2775982964820319E-2</c:v>
                </c:pt>
                <c:pt idx="3371">
                  <c:v>1.0412225652781075</c:v>
                </c:pt>
                <c:pt idx="3372">
                  <c:v>0.33922921956285984</c:v>
                </c:pt>
                <c:pt idx="3373">
                  <c:v>1.6083597629633817</c:v>
                </c:pt>
                <c:pt idx="3374">
                  <c:v>0.5800543651899458</c:v>
                </c:pt>
                <c:pt idx="3375">
                  <c:v>1.1719055141965555</c:v>
                </c:pt>
                <c:pt idx="3376">
                  <c:v>0.32518111529396748</c:v>
                </c:pt>
                <c:pt idx="3377">
                  <c:v>0.49624466089207842</c:v>
                </c:pt>
                <c:pt idx="3378">
                  <c:v>1.1076861195125856</c:v>
                </c:pt>
                <c:pt idx="3379">
                  <c:v>0.2578162364026918</c:v>
                </c:pt>
                <c:pt idx="3380">
                  <c:v>0.57662968363949663</c:v>
                </c:pt>
                <c:pt idx="3381">
                  <c:v>6.6099518954078923E-2</c:v>
                </c:pt>
                <c:pt idx="3382">
                  <c:v>1.1272539356436968</c:v>
                </c:pt>
                <c:pt idx="3383">
                  <c:v>5.3256134253876743E-2</c:v>
                </c:pt>
                <c:pt idx="3384">
                  <c:v>1.2601417408051265</c:v>
                </c:pt>
                <c:pt idx="3385">
                  <c:v>0.79294420023146139</c:v>
                </c:pt>
                <c:pt idx="3386">
                  <c:v>1.0858616093413095E-2</c:v>
                </c:pt>
                <c:pt idx="3387">
                  <c:v>9.6056901482661119E-2</c:v>
                </c:pt>
                <c:pt idx="3388">
                  <c:v>0.56158316204055192</c:v>
                </c:pt>
                <c:pt idx="3389">
                  <c:v>8.9776570507186751E-2</c:v>
                </c:pt>
                <c:pt idx="3390">
                  <c:v>1.8498846568512174E-2</c:v>
                </c:pt>
                <c:pt idx="3391">
                  <c:v>0.2023381445415692</c:v>
                </c:pt>
                <c:pt idx="3392">
                  <c:v>1.1655163404698032</c:v>
                </c:pt>
                <c:pt idx="3393">
                  <c:v>0.81260213016544924</c:v>
                </c:pt>
                <c:pt idx="3394">
                  <c:v>0.94860131897838673</c:v>
                </c:pt>
                <c:pt idx="3395">
                  <c:v>0.29769407135363291</c:v>
                </c:pt>
                <c:pt idx="3396">
                  <c:v>1.4956735949376712</c:v>
                </c:pt>
                <c:pt idx="3397">
                  <c:v>0.24228137249901605</c:v>
                </c:pt>
                <c:pt idx="3398">
                  <c:v>0.12859026238020016</c:v>
                </c:pt>
                <c:pt idx="3399">
                  <c:v>1.0265772801695237</c:v>
                </c:pt>
                <c:pt idx="3400">
                  <c:v>0.76253376076256252</c:v>
                </c:pt>
                <c:pt idx="3401">
                  <c:v>0.16304071114792618</c:v>
                </c:pt>
                <c:pt idx="3402">
                  <c:v>2.9590032894514753E-2</c:v>
                </c:pt>
                <c:pt idx="3403">
                  <c:v>0.37826200489585698</c:v>
                </c:pt>
                <c:pt idx="3404">
                  <c:v>2.6015295854321028E-2</c:v>
                </c:pt>
                <c:pt idx="3405">
                  <c:v>0.48069381603007699</c:v>
                </c:pt>
                <c:pt idx="3406">
                  <c:v>0.36356393133402631</c:v>
                </c:pt>
                <c:pt idx="3407">
                  <c:v>8.8519298863176221E-2</c:v>
                </c:pt>
                <c:pt idx="3408">
                  <c:v>0.9395322653128686</c:v>
                </c:pt>
                <c:pt idx="3409">
                  <c:v>2.577217719510726E-2</c:v>
                </c:pt>
                <c:pt idx="3410">
                  <c:v>0.61303766190854281</c:v>
                </c:pt>
                <c:pt idx="3411">
                  <c:v>0.46026815980278879</c:v>
                </c:pt>
                <c:pt idx="3412">
                  <c:v>0.42471383575124427</c:v>
                </c:pt>
                <c:pt idx="3413">
                  <c:v>0.4402483840880963</c:v>
                </c:pt>
                <c:pt idx="3414">
                  <c:v>0.15807536025307031</c:v>
                </c:pt>
                <c:pt idx="3415">
                  <c:v>0.27235645633307559</c:v>
                </c:pt>
                <c:pt idx="3416">
                  <c:v>0.96235832625278017</c:v>
                </c:pt>
                <c:pt idx="3417">
                  <c:v>0.53440356113059495</c:v>
                </c:pt>
                <c:pt idx="3418">
                  <c:v>7.1224881162327586E-2</c:v>
                </c:pt>
                <c:pt idx="3419">
                  <c:v>0.27835525194887417</c:v>
                </c:pt>
                <c:pt idx="3420">
                  <c:v>4.4116119165837499E-2</c:v>
                </c:pt>
                <c:pt idx="3421">
                  <c:v>2.4229138847554257E-3</c:v>
                </c:pt>
                <c:pt idx="3422">
                  <c:v>0.46111800309746637</c:v>
                </c:pt>
                <c:pt idx="3423">
                  <c:v>0.6477672663350601</c:v>
                </c:pt>
                <c:pt idx="3424">
                  <c:v>0.74773379368166615</c:v>
                </c:pt>
                <c:pt idx="3425">
                  <c:v>0.89757670264443434</c:v>
                </c:pt>
                <c:pt idx="3426">
                  <c:v>1.0505566575974457</c:v>
                </c:pt>
                <c:pt idx="3427">
                  <c:v>5.14755199862909E-2</c:v>
                </c:pt>
                <c:pt idx="3428">
                  <c:v>0.19012671896198888</c:v>
                </c:pt>
                <c:pt idx="3429">
                  <c:v>0.69876138207183336</c:v>
                </c:pt>
                <c:pt idx="3430">
                  <c:v>0.12073008810136637</c:v>
                </c:pt>
                <c:pt idx="3431">
                  <c:v>0.85693188226788186</c:v>
                </c:pt>
                <c:pt idx="3432">
                  <c:v>0.31271102936687667</c:v>
                </c:pt>
                <c:pt idx="3433">
                  <c:v>0.73953839260093823</c:v>
                </c:pt>
                <c:pt idx="3434">
                  <c:v>0.38202047405982154</c:v>
                </c:pt>
                <c:pt idx="3435">
                  <c:v>1.143566308090453</c:v>
                </c:pt>
                <c:pt idx="3436">
                  <c:v>0.5223479337552942</c:v>
                </c:pt>
                <c:pt idx="3437">
                  <c:v>0.8896552946946672</c:v>
                </c:pt>
                <c:pt idx="3438">
                  <c:v>0.72996296452560627</c:v>
                </c:pt>
                <c:pt idx="3439">
                  <c:v>0.41910204249386018</c:v>
                </c:pt>
                <c:pt idx="3440">
                  <c:v>2.6481486448535168E-3</c:v>
                </c:pt>
                <c:pt idx="3441">
                  <c:v>0.66650187838887109</c:v>
                </c:pt>
                <c:pt idx="3442">
                  <c:v>0.18087114349634359</c:v>
                </c:pt>
                <c:pt idx="3443">
                  <c:v>0.26885666664480828</c:v>
                </c:pt>
                <c:pt idx="3444">
                  <c:v>0.13028810508078037</c:v>
                </c:pt>
                <c:pt idx="3445">
                  <c:v>0.55243501065008993</c:v>
                </c:pt>
                <c:pt idx="3446">
                  <c:v>0.11174259721612306</c:v>
                </c:pt>
                <c:pt idx="3447">
                  <c:v>0.87513569541277603</c:v>
                </c:pt>
                <c:pt idx="3448">
                  <c:v>0.16719055234424213</c:v>
                </c:pt>
                <c:pt idx="3449">
                  <c:v>2.0153061480185589E-2</c:v>
                </c:pt>
                <c:pt idx="3450">
                  <c:v>0.11128462833654197</c:v>
                </c:pt>
                <c:pt idx="3451">
                  <c:v>3.035127363978031E-2</c:v>
                </c:pt>
                <c:pt idx="3452">
                  <c:v>0.65268698380683288</c:v>
                </c:pt>
                <c:pt idx="3453">
                  <c:v>0.53111408300225016</c:v>
                </c:pt>
                <c:pt idx="3454">
                  <c:v>0.12838622391682483</c:v>
                </c:pt>
                <c:pt idx="3455">
                  <c:v>6.5174149204025478E-2</c:v>
                </c:pt>
                <c:pt idx="3456">
                  <c:v>0.42299886597215303</c:v>
                </c:pt>
                <c:pt idx="3457">
                  <c:v>1.2408638761779081</c:v>
                </c:pt>
                <c:pt idx="3458">
                  <c:v>0.11360506867926094</c:v>
                </c:pt>
                <c:pt idx="3459">
                  <c:v>1.4811993934807666</c:v>
                </c:pt>
                <c:pt idx="3460">
                  <c:v>0.77406494911914436</c:v>
                </c:pt>
                <c:pt idx="3461">
                  <c:v>0.29259245332359124</c:v>
                </c:pt>
                <c:pt idx="3462">
                  <c:v>0.15881913856403909</c:v>
                </c:pt>
                <c:pt idx="3463">
                  <c:v>0.7842538042695828</c:v>
                </c:pt>
                <c:pt idx="3464">
                  <c:v>1.5176671540931519</c:v>
                </c:pt>
                <c:pt idx="3465">
                  <c:v>0.51911410377953482</c:v>
                </c:pt>
                <c:pt idx="3466">
                  <c:v>0.30686678398548028</c:v>
                </c:pt>
                <c:pt idx="3467">
                  <c:v>9.1484463054205378E-2</c:v>
                </c:pt>
                <c:pt idx="3468">
                  <c:v>0.21463528585232469</c:v>
                </c:pt>
                <c:pt idx="3469">
                  <c:v>0.22067167552507658</c:v>
                </c:pt>
                <c:pt idx="3470">
                  <c:v>0.56940987776675389</c:v>
                </c:pt>
                <c:pt idx="3471">
                  <c:v>0.1148781073197505</c:v>
                </c:pt>
                <c:pt idx="3472">
                  <c:v>0.31508834207161096</c:v>
                </c:pt>
                <c:pt idx="3473">
                  <c:v>0.96294106400402091</c:v>
                </c:pt>
                <c:pt idx="3474">
                  <c:v>1.3774876299474916</c:v>
                </c:pt>
                <c:pt idx="3475">
                  <c:v>1.0630934337985563</c:v>
                </c:pt>
                <c:pt idx="3476">
                  <c:v>0.54582695866314113</c:v>
                </c:pt>
                <c:pt idx="3477">
                  <c:v>3.3227716728712109E-2</c:v>
                </c:pt>
                <c:pt idx="3478">
                  <c:v>0.17557079618589905</c:v>
                </c:pt>
                <c:pt idx="3479">
                  <c:v>0.3779148794529022</c:v>
                </c:pt>
                <c:pt idx="3480">
                  <c:v>0.96925892010834436</c:v>
                </c:pt>
                <c:pt idx="3481">
                  <c:v>0.97978116266755488</c:v>
                </c:pt>
                <c:pt idx="3482">
                  <c:v>0.26043740238787655</c:v>
                </c:pt>
                <c:pt idx="3483">
                  <c:v>1.2587102976025679</c:v>
                </c:pt>
                <c:pt idx="3484">
                  <c:v>0.57391639264143057</c:v>
                </c:pt>
                <c:pt idx="3485">
                  <c:v>3.5610623184774695E-3</c:v>
                </c:pt>
                <c:pt idx="3486">
                  <c:v>0.1270710908208762</c:v>
                </c:pt>
                <c:pt idx="3487">
                  <c:v>0.9900438276421224</c:v>
                </c:pt>
                <c:pt idx="3488">
                  <c:v>0.86437704535582416</c:v>
                </c:pt>
                <c:pt idx="3489">
                  <c:v>0.34064228290141751</c:v>
                </c:pt>
                <c:pt idx="3490">
                  <c:v>0.18989019718586603</c:v>
                </c:pt>
                <c:pt idx="3491">
                  <c:v>7.464137981128471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8EB-4170-9796-DF698A1FB185}"/>
            </c:ext>
          </c:extLst>
        </c:ser>
        <c:ser>
          <c:idx val="1"/>
          <c:order val="1"/>
          <c:tx>
            <c:v>dow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NC Prot'!$E$2:$E$52</c:f>
              <c:numCache>
                <c:formatCode>General</c:formatCode>
                <c:ptCount val="51"/>
                <c:pt idx="0">
                  <c:v>-0.76317066451360027</c:v>
                </c:pt>
                <c:pt idx="1">
                  <c:v>-1.4332335453778196</c:v>
                </c:pt>
                <c:pt idx="2">
                  <c:v>-0.76586660438751752</c:v>
                </c:pt>
                <c:pt idx="3">
                  <c:v>-0.90833401247818712</c:v>
                </c:pt>
                <c:pt idx="4">
                  <c:v>-0.85308415191272491</c:v>
                </c:pt>
                <c:pt idx="5">
                  <c:v>-0.61816291609395257</c:v>
                </c:pt>
                <c:pt idx="6">
                  <c:v>-0.79285679505825113</c:v>
                </c:pt>
                <c:pt idx="7">
                  <c:v>-1.1962769932258421</c:v>
                </c:pt>
                <c:pt idx="8">
                  <c:v>-1.8932496849391323</c:v>
                </c:pt>
                <c:pt idx="9">
                  <c:v>-0.98564470702292994</c:v>
                </c:pt>
                <c:pt idx="10">
                  <c:v>-1.3853372650634239</c:v>
                </c:pt>
                <c:pt idx="11">
                  <c:v>-1.7112280327525979</c:v>
                </c:pt>
                <c:pt idx="12">
                  <c:v>-0.60669363964734724</c:v>
                </c:pt>
                <c:pt idx="13">
                  <c:v>-1.2446850959549021</c:v>
                </c:pt>
                <c:pt idx="14">
                  <c:v>-1.2990276927772837</c:v>
                </c:pt>
                <c:pt idx="15">
                  <c:v>-0.74758434096734949</c:v>
                </c:pt>
                <c:pt idx="16">
                  <c:v>-0.66795091625102576</c:v>
                </c:pt>
                <c:pt idx="17">
                  <c:v>-0.6560805736318116</c:v>
                </c:pt>
                <c:pt idx="18">
                  <c:v>-2.0733932587486836</c:v>
                </c:pt>
                <c:pt idx="19">
                  <c:v>-0.80717459644760881</c:v>
                </c:pt>
                <c:pt idx="20">
                  <c:v>-0.9542774642653995</c:v>
                </c:pt>
                <c:pt idx="21">
                  <c:v>-1.2841944674408474</c:v>
                </c:pt>
                <c:pt idx="22">
                  <c:v>-0.64498373578045021</c:v>
                </c:pt>
                <c:pt idx="23">
                  <c:v>-1.1316293032607678</c:v>
                </c:pt>
                <c:pt idx="24">
                  <c:v>-0.60230654476330869</c:v>
                </c:pt>
                <c:pt idx="25">
                  <c:v>-0.68617370360960195</c:v>
                </c:pt>
                <c:pt idx="26">
                  <c:v>-0.96128289242714648</c:v>
                </c:pt>
                <c:pt idx="27">
                  <c:v>-2.9827907099677771</c:v>
                </c:pt>
                <c:pt idx="28">
                  <c:v>-0.92111695347801081</c:v>
                </c:pt>
                <c:pt idx="29">
                  <c:v>-0.71288236421181894</c:v>
                </c:pt>
                <c:pt idx="30">
                  <c:v>-0.87911726675134794</c:v>
                </c:pt>
                <c:pt idx="31">
                  <c:v>-2.1171613442327493</c:v>
                </c:pt>
                <c:pt idx="32">
                  <c:v>-1.2142402255729889</c:v>
                </c:pt>
                <c:pt idx="33">
                  <c:v>-2.3540217245972155</c:v>
                </c:pt>
                <c:pt idx="34">
                  <c:v>-0.63151099935489641</c:v>
                </c:pt>
                <c:pt idx="35">
                  <c:v>-1.2709040918628955</c:v>
                </c:pt>
                <c:pt idx="36">
                  <c:v>-1.2764851241261954</c:v>
                </c:pt>
                <c:pt idx="37">
                  <c:v>-0.86013763198435911</c:v>
                </c:pt>
                <c:pt idx="38">
                  <c:v>-0.81629118312458815</c:v>
                </c:pt>
                <c:pt idx="39">
                  <c:v>-0.9542774642653995</c:v>
                </c:pt>
                <c:pt idx="40">
                  <c:v>-1.6697858227506985</c:v>
                </c:pt>
                <c:pt idx="41">
                  <c:v>-1.0250302371872846</c:v>
                </c:pt>
                <c:pt idx="42">
                  <c:v>-1.2082275957226341</c:v>
                </c:pt>
                <c:pt idx="43">
                  <c:v>-1.2930053842913487</c:v>
                </c:pt>
                <c:pt idx="44">
                  <c:v>-2.3415371388258905</c:v>
                </c:pt>
                <c:pt idx="45">
                  <c:v>-0.98764586959212597</c:v>
                </c:pt>
                <c:pt idx="46">
                  <c:v>-0.99452814878994045</c:v>
                </c:pt>
                <c:pt idx="47">
                  <c:v>-1.6020875398230945</c:v>
                </c:pt>
                <c:pt idx="48">
                  <c:v>-1.7427479467602123</c:v>
                </c:pt>
                <c:pt idx="49">
                  <c:v>-1.4274013246299679</c:v>
                </c:pt>
                <c:pt idx="50">
                  <c:v>-1.5491978471201813</c:v>
                </c:pt>
              </c:numCache>
            </c:numRef>
          </c:xVal>
          <c:yVal>
            <c:numRef>
              <c:f>'sDM - NC Prot'!$F$2:$F$52</c:f>
              <c:numCache>
                <c:formatCode>General</c:formatCode>
                <c:ptCount val="51"/>
                <c:pt idx="0">
                  <c:v>1.6930781878345325</c:v>
                </c:pt>
                <c:pt idx="1">
                  <c:v>1.9303338383095565</c:v>
                </c:pt>
                <c:pt idx="2">
                  <c:v>1.6341602187782354</c:v>
                </c:pt>
                <c:pt idx="3">
                  <c:v>2.0968917458323104</c:v>
                </c:pt>
                <c:pt idx="4">
                  <c:v>1.960925972314542</c:v>
                </c:pt>
                <c:pt idx="5">
                  <c:v>3.057099250177187</c:v>
                </c:pt>
                <c:pt idx="6">
                  <c:v>3.8285290457782146</c:v>
                </c:pt>
                <c:pt idx="7">
                  <c:v>2.656960138989338</c:v>
                </c:pt>
                <c:pt idx="8">
                  <c:v>2.98166885395751</c:v>
                </c:pt>
                <c:pt idx="9">
                  <c:v>1.3463737267885783</c:v>
                </c:pt>
                <c:pt idx="10">
                  <c:v>1.9705762292973927</c:v>
                </c:pt>
                <c:pt idx="11">
                  <c:v>1.5551102174252847</c:v>
                </c:pt>
                <c:pt idx="12">
                  <c:v>2.1653170920719265</c:v>
                </c:pt>
                <c:pt idx="13">
                  <c:v>2.7656951579027749</c:v>
                </c:pt>
                <c:pt idx="14">
                  <c:v>2.3113435267994453</c:v>
                </c:pt>
                <c:pt idx="15">
                  <c:v>1.7704987598781468</c:v>
                </c:pt>
                <c:pt idx="16">
                  <c:v>1.8306490604940682</c:v>
                </c:pt>
                <c:pt idx="17">
                  <c:v>2.6756269041235958</c:v>
                </c:pt>
                <c:pt idx="18">
                  <c:v>2.1619333104975</c:v>
                </c:pt>
                <c:pt idx="19">
                  <c:v>1.9583381636399302</c:v>
                </c:pt>
                <c:pt idx="20">
                  <c:v>2.6748212387987618</c:v>
                </c:pt>
                <c:pt idx="21">
                  <c:v>2.4227352351838567</c:v>
                </c:pt>
                <c:pt idx="22">
                  <c:v>1.6865495895801002</c:v>
                </c:pt>
                <c:pt idx="23">
                  <c:v>2.2213246193765737</c:v>
                </c:pt>
                <c:pt idx="24">
                  <c:v>1.6767830475519001</c:v>
                </c:pt>
                <c:pt idx="25">
                  <c:v>2.0756822200272955</c:v>
                </c:pt>
                <c:pt idx="26">
                  <c:v>1.4463601050771315</c:v>
                </c:pt>
                <c:pt idx="27">
                  <c:v>1.9588884038407599</c:v>
                </c:pt>
                <c:pt idx="28">
                  <c:v>1.6310801953310885</c:v>
                </c:pt>
                <c:pt idx="29">
                  <c:v>1.3414959107363562</c:v>
                </c:pt>
                <c:pt idx="30">
                  <c:v>1.4057871100709645</c:v>
                </c:pt>
                <c:pt idx="31">
                  <c:v>2.4273993946900472</c:v>
                </c:pt>
                <c:pt idx="32">
                  <c:v>1.9743512929531777</c:v>
                </c:pt>
                <c:pt idx="33">
                  <c:v>1.5688041418214462</c:v>
                </c:pt>
                <c:pt idx="34">
                  <c:v>1.7462139273923818</c:v>
                </c:pt>
                <c:pt idx="35">
                  <c:v>2.8653390725370751</c:v>
                </c:pt>
                <c:pt idx="36">
                  <c:v>1.7857283339114089</c:v>
                </c:pt>
                <c:pt idx="37">
                  <c:v>2.1039920256951632</c:v>
                </c:pt>
                <c:pt idx="38">
                  <c:v>1.5434733479859108</c:v>
                </c:pt>
                <c:pt idx="39">
                  <c:v>1.3301138815422227</c:v>
                </c:pt>
                <c:pt idx="40">
                  <c:v>1.4528383915977572</c:v>
                </c:pt>
                <c:pt idx="41">
                  <c:v>2.048700587488725</c:v>
                </c:pt>
                <c:pt idx="42">
                  <c:v>2.4012839662053733</c:v>
                </c:pt>
                <c:pt idx="43">
                  <c:v>1.5903332211158487</c:v>
                </c:pt>
                <c:pt idx="44">
                  <c:v>1.3475105172094721</c:v>
                </c:pt>
                <c:pt idx="45">
                  <c:v>1.5099523943260651</c:v>
                </c:pt>
                <c:pt idx="46">
                  <c:v>1.8288159855261783</c:v>
                </c:pt>
                <c:pt idx="47">
                  <c:v>2.5370878997069908</c:v>
                </c:pt>
                <c:pt idx="48">
                  <c:v>2.2665513229137475</c:v>
                </c:pt>
                <c:pt idx="49">
                  <c:v>1.7938322638472708</c:v>
                </c:pt>
                <c:pt idx="50">
                  <c:v>1.81114627629508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8EB-4170-9796-DF698A1FB185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NC Prot'!$I$2:$I$103</c:f>
              <c:numCache>
                <c:formatCode>General</c:formatCode>
                <c:ptCount val="102"/>
                <c:pt idx="0">
                  <c:v>1.1458730616010449</c:v>
                </c:pt>
                <c:pt idx="1">
                  <c:v>0.6113612639197511</c:v>
                </c:pt>
                <c:pt idx="2">
                  <c:v>2.3280609220945707</c:v>
                </c:pt>
                <c:pt idx="3">
                  <c:v>0.75240607121538039</c:v>
                </c:pt>
                <c:pt idx="4">
                  <c:v>1.0178506620385386</c:v>
                </c:pt>
                <c:pt idx="5">
                  <c:v>0.8664728297158476</c:v>
                </c:pt>
                <c:pt idx="6">
                  <c:v>0.87176481056067179</c:v>
                </c:pt>
                <c:pt idx="7">
                  <c:v>1.6462087489149269</c:v>
                </c:pt>
                <c:pt idx="8">
                  <c:v>1.0886165358667099</c:v>
                </c:pt>
                <c:pt idx="9">
                  <c:v>1.1007758580831339</c:v>
                </c:pt>
                <c:pt idx="10">
                  <c:v>5.4864086849183415</c:v>
                </c:pt>
                <c:pt idx="11">
                  <c:v>1.9490866474417781</c:v>
                </c:pt>
                <c:pt idx="12">
                  <c:v>0.64634701535134476</c:v>
                </c:pt>
                <c:pt idx="13">
                  <c:v>0.83098541248307556</c:v>
                </c:pt>
                <c:pt idx="14">
                  <c:v>0.60160144283494543</c:v>
                </c:pt>
                <c:pt idx="15">
                  <c:v>0.9057359776670264</c:v>
                </c:pt>
                <c:pt idx="16">
                  <c:v>0.63913953138042845</c:v>
                </c:pt>
                <c:pt idx="17">
                  <c:v>1.0346383179990091</c:v>
                </c:pt>
                <c:pt idx="18">
                  <c:v>1.2925461879503386</c:v>
                </c:pt>
                <c:pt idx="19">
                  <c:v>1.5733745264459442</c:v>
                </c:pt>
                <c:pt idx="20">
                  <c:v>0.6471763358077397</c:v>
                </c:pt>
                <c:pt idx="21">
                  <c:v>0.93243918655347124</c:v>
                </c:pt>
                <c:pt idx="22">
                  <c:v>1.9606970393043122</c:v>
                </c:pt>
                <c:pt idx="23">
                  <c:v>1.08481263883321</c:v>
                </c:pt>
                <c:pt idx="24">
                  <c:v>1.6462548391994503</c:v>
                </c:pt>
                <c:pt idx="25">
                  <c:v>1.1616297473579458</c:v>
                </c:pt>
                <c:pt idx="26">
                  <c:v>0.83244448164530982</c:v>
                </c:pt>
                <c:pt idx="27">
                  <c:v>1.1713349473987686</c:v>
                </c:pt>
                <c:pt idx="28">
                  <c:v>0.66028975142822122</c:v>
                </c:pt>
                <c:pt idx="29">
                  <c:v>1.4901079832881501</c:v>
                </c:pt>
                <c:pt idx="30">
                  <c:v>0.72822529375977607</c:v>
                </c:pt>
                <c:pt idx="31">
                  <c:v>0.85853806633653584</c:v>
                </c:pt>
                <c:pt idx="32">
                  <c:v>0.60026975350900469</c:v>
                </c:pt>
                <c:pt idx="33">
                  <c:v>0.63552224145975378</c:v>
                </c:pt>
                <c:pt idx="34">
                  <c:v>0.65480212578979058</c:v>
                </c:pt>
                <c:pt idx="35">
                  <c:v>0.66375448238334622</c:v>
                </c:pt>
                <c:pt idx="36">
                  <c:v>1.1377658080958786</c:v>
                </c:pt>
                <c:pt idx="37">
                  <c:v>0.77627246816688478</c:v>
                </c:pt>
                <c:pt idx="38">
                  <c:v>1.3764570950111643</c:v>
                </c:pt>
                <c:pt idx="39">
                  <c:v>1.044603950649768</c:v>
                </c:pt>
                <c:pt idx="40">
                  <c:v>1.2729189947656381</c:v>
                </c:pt>
                <c:pt idx="41">
                  <c:v>1.0283569755597401</c:v>
                </c:pt>
                <c:pt idx="42">
                  <c:v>1.0348495729169054</c:v>
                </c:pt>
                <c:pt idx="43">
                  <c:v>0.7695178702795189</c:v>
                </c:pt>
                <c:pt idx="44">
                  <c:v>0.87962735681239812</c:v>
                </c:pt>
                <c:pt idx="45">
                  <c:v>1.9641028540230365</c:v>
                </c:pt>
                <c:pt idx="46">
                  <c:v>0.88354261931332845</c:v>
                </c:pt>
                <c:pt idx="47">
                  <c:v>0.91494715047957698</c:v>
                </c:pt>
                <c:pt idx="48">
                  <c:v>1.0948441035417171</c:v>
                </c:pt>
                <c:pt idx="49">
                  <c:v>1.3857071246579338</c:v>
                </c:pt>
                <c:pt idx="50">
                  <c:v>0.89305150273685041</c:v>
                </c:pt>
                <c:pt idx="51">
                  <c:v>0.970927259352662</c:v>
                </c:pt>
                <c:pt idx="52">
                  <c:v>0.90827491847905906</c:v>
                </c:pt>
                <c:pt idx="53">
                  <c:v>1.3078947755125012</c:v>
                </c:pt>
                <c:pt idx="54">
                  <c:v>0.65278475490875598</c:v>
                </c:pt>
                <c:pt idx="55">
                  <c:v>0.72176636633861535</c:v>
                </c:pt>
                <c:pt idx="56">
                  <c:v>1.0145695387078635</c:v>
                </c:pt>
                <c:pt idx="57">
                  <c:v>0.88651112867524773</c:v>
                </c:pt>
                <c:pt idx="58">
                  <c:v>0.68840418839745809</c:v>
                </c:pt>
                <c:pt idx="59">
                  <c:v>2.4417224924662921</c:v>
                </c:pt>
                <c:pt idx="60">
                  <c:v>0.97394183612805396</c:v>
                </c:pt>
                <c:pt idx="61">
                  <c:v>0.74734442968917403</c:v>
                </c:pt>
                <c:pt idx="62">
                  <c:v>0.96028928366625377</c:v>
                </c:pt>
                <c:pt idx="63">
                  <c:v>0.65416054099561882</c:v>
                </c:pt>
                <c:pt idx="64">
                  <c:v>0.7195777451462646</c:v>
                </c:pt>
                <c:pt idx="65">
                  <c:v>1.4339208835135515</c:v>
                </c:pt>
                <c:pt idx="66">
                  <c:v>1.0903114713760365</c:v>
                </c:pt>
                <c:pt idx="67">
                  <c:v>1.2149951346149233</c:v>
                </c:pt>
                <c:pt idx="68">
                  <c:v>0.86298690919509036</c:v>
                </c:pt>
                <c:pt idx="69">
                  <c:v>0.85957205681724713</c:v>
                </c:pt>
                <c:pt idx="70">
                  <c:v>1.2141248053528473</c:v>
                </c:pt>
                <c:pt idx="71">
                  <c:v>0.85630848971744311</c:v>
                </c:pt>
                <c:pt idx="72">
                  <c:v>1.2474414711444077</c:v>
                </c:pt>
                <c:pt idx="73">
                  <c:v>0.96628279393077754</c:v>
                </c:pt>
                <c:pt idx="74">
                  <c:v>0.83446852171030295</c:v>
                </c:pt>
                <c:pt idx="75">
                  <c:v>0.64210080511469803</c:v>
                </c:pt>
                <c:pt idx="76">
                  <c:v>0.92956378375783344</c:v>
                </c:pt>
                <c:pt idx="77">
                  <c:v>0.87876457126735441</c:v>
                </c:pt>
                <c:pt idx="78">
                  <c:v>0.79908730607400358</c:v>
                </c:pt>
                <c:pt idx="79">
                  <c:v>0.96465738837657788</c:v>
                </c:pt>
                <c:pt idx="80">
                  <c:v>2.7318131967303438</c:v>
                </c:pt>
                <c:pt idx="81">
                  <c:v>0.72403901576726792</c:v>
                </c:pt>
                <c:pt idx="82">
                  <c:v>0.81754140015143362</c:v>
                </c:pt>
                <c:pt idx="83">
                  <c:v>0.64173097813474689</c:v>
                </c:pt>
                <c:pt idx="84">
                  <c:v>2.3481190844624429</c:v>
                </c:pt>
                <c:pt idx="85">
                  <c:v>1.2075180769825455</c:v>
                </c:pt>
                <c:pt idx="86">
                  <c:v>0.85439467775310074</c:v>
                </c:pt>
                <c:pt idx="87">
                  <c:v>0.70221425101044077</c:v>
                </c:pt>
                <c:pt idx="88">
                  <c:v>0.92219784839636698</c:v>
                </c:pt>
                <c:pt idx="89">
                  <c:v>0.63310566628687071</c:v>
                </c:pt>
                <c:pt idx="90">
                  <c:v>1.8331734632383405</c:v>
                </c:pt>
                <c:pt idx="91">
                  <c:v>1.2352368890898153</c:v>
                </c:pt>
                <c:pt idx="92">
                  <c:v>0.75599848379770673</c:v>
                </c:pt>
                <c:pt idx="93">
                  <c:v>0.8317151315178255</c:v>
                </c:pt>
                <c:pt idx="94">
                  <c:v>1.4825901750007069</c:v>
                </c:pt>
                <c:pt idx="95">
                  <c:v>1.6076262208454872</c:v>
                </c:pt>
                <c:pt idx="96">
                  <c:v>1.0309010380104224</c:v>
                </c:pt>
                <c:pt idx="97">
                  <c:v>0.71589337054760505</c:v>
                </c:pt>
                <c:pt idx="98">
                  <c:v>1.3630589098791865</c:v>
                </c:pt>
                <c:pt idx="99">
                  <c:v>2.1626934322112366</c:v>
                </c:pt>
                <c:pt idx="100">
                  <c:v>1.3723392401355283</c:v>
                </c:pt>
                <c:pt idx="101">
                  <c:v>0.62779358268248175</c:v>
                </c:pt>
              </c:numCache>
            </c:numRef>
          </c:xVal>
          <c:yVal>
            <c:numRef>
              <c:f>'sDM - NC Prot'!$J$2:$J$103</c:f>
              <c:numCache>
                <c:formatCode>General</c:formatCode>
                <c:ptCount val="102"/>
                <c:pt idx="0">
                  <c:v>1.8570771329710054</c:v>
                </c:pt>
                <c:pt idx="1">
                  <c:v>3.2451928234679945</c:v>
                </c:pt>
                <c:pt idx="2">
                  <c:v>1.6022431283148417</c:v>
                </c:pt>
                <c:pt idx="3">
                  <c:v>1.6088851834014073</c:v>
                </c:pt>
                <c:pt idx="4">
                  <c:v>1.7322934135871364</c:v>
                </c:pt>
                <c:pt idx="5">
                  <c:v>1.3883275609630799</c:v>
                </c:pt>
                <c:pt idx="6">
                  <c:v>1.5993932480034481</c:v>
                </c:pt>
                <c:pt idx="7">
                  <c:v>1.3725967144504674</c:v>
                </c:pt>
                <c:pt idx="8">
                  <c:v>1.4255691139182722</c:v>
                </c:pt>
                <c:pt idx="9">
                  <c:v>2.0224204381622051</c:v>
                </c:pt>
                <c:pt idx="10">
                  <c:v>3.3402632202312823</c:v>
                </c:pt>
                <c:pt idx="11">
                  <c:v>2.0755539509082959</c:v>
                </c:pt>
                <c:pt idx="12">
                  <c:v>1.4932268605461945</c:v>
                </c:pt>
                <c:pt idx="13">
                  <c:v>1.3977429277011735</c:v>
                </c:pt>
                <c:pt idx="14">
                  <c:v>1.6796095953872794</c:v>
                </c:pt>
                <c:pt idx="15">
                  <c:v>1.616992656899253</c:v>
                </c:pt>
                <c:pt idx="16">
                  <c:v>1.4366052458792136</c:v>
                </c:pt>
                <c:pt idx="17">
                  <c:v>1.3418281876893792</c:v>
                </c:pt>
                <c:pt idx="18">
                  <c:v>2.6180019774617067</c:v>
                </c:pt>
                <c:pt idx="19">
                  <c:v>1.5054499828856185</c:v>
                </c:pt>
                <c:pt idx="20">
                  <c:v>1.3770617145259758</c:v>
                </c:pt>
                <c:pt idx="21">
                  <c:v>1.7755679098011485</c:v>
                </c:pt>
                <c:pt idx="22">
                  <c:v>1.6852290722456376</c:v>
                </c:pt>
                <c:pt idx="23">
                  <c:v>1.7388286086784617</c:v>
                </c:pt>
                <c:pt idx="24">
                  <c:v>1.5174692932778482</c:v>
                </c:pt>
                <c:pt idx="25">
                  <c:v>1.544688669739178</c:v>
                </c:pt>
                <c:pt idx="26">
                  <c:v>1.3140601443427216</c:v>
                </c:pt>
                <c:pt idx="27">
                  <c:v>1.588942927438648</c:v>
                </c:pt>
                <c:pt idx="28">
                  <c:v>2.0430744729527266</c:v>
                </c:pt>
                <c:pt idx="29">
                  <c:v>1.4358051969140231</c:v>
                </c:pt>
                <c:pt idx="30">
                  <c:v>1.5157286293599488</c:v>
                </c:pt>
                <c:pt idx="31">
                  <c:v>1.5854449985530952</c:v>
                </c:pt>
                <c:pt idx="32">
                  <c:v>1.9849073257681249</c:v>
                </c:pt>
                <c:pt idx="33">
                  <c:v>2.0746646868606788</c:v>
                </c:pt>
                <c:pt idx="34">
                  <c:v>1.7213062781973998</c:v>
                </c:pt>
                <c:pt idx="35">
                  <c:v>2.2686831706326234</c:v>
                </c:pt>
                <c:pt idx="36">
                  <c:v>2.1956772826500535</c:v>
                </c:pt>
                <c:pt idx="37">
                  <c:v>1.3841465322776143</c:v>
                </c:pt>
                <c:pt idx="38">
                  <c:v>1.4322068145642706</c:v>
                </c:pt>
                <c:pt idx="39">
                  <c:v>1.5722463372983537</c:v>
                </c:pt>
                <c:pt idx="40">
                  <c:v>1.681083207143842</c:v>
                </c:pt>
                <c:pt idx="41">
                  <c:v>2.0783013321966948</c:v>
                </c:pt>
                <c:pt idx="42">
                  <c:v>1.6416694253331112</c:v>
                </c:pt>
                <c:pt idx="43">
                  <c:v>1.5517674254109732</c:v>
                </c:pt>
                <c:pt idx="44">
                  <c:v>1.3562350448199649</c:v>
                </c:pt>
                <c:pt idx="45">
                  <c:v>1.9295983175477884</c:v>
                </c:pt>
                <c:pt idx="46">
                  <c:v>2.5944544035432444</c:v>
                </c:pt>
                <c:pt idx="47">
                  <c:v>2.0511123200481012</c:v>
                </c:pt>
                <c:pt idx="48">
                  <c:v>1.4022031936932235</c:v>
                </c:pt>
                <c:pt idx="49">
                  <c:v>1.8328576027676922</c:v>
                </c:pt>
                <c:pt idx="50">
                  <c:v>1.3806221008265551</c:v>
                </c:pt>
                <c:pt idx="51">
                  <c:v>1.5615052578055266</c:v>
                </c:pt>
                <c:pt idx="52">
                  <c:v>2.0845548140091279</c:v>
                </c:pt>
                <c:pt idx="53">
                  <c:v>1.5034289242148506</c:v>
                </c:pt>
                <c:pt idx="54">
                  <c:v>2.5282424882440537</c:v>
                </c:pt>
                <c:pt idx="55">
                  <c:v>2.148457444456688</c:v>
                </c:pt>
                <c:pt idx="56">
                  <c:v>1.833202330198755</c:v>
                </c:pt>
                <c:pt idx="57">
                  <c:v>1.9836002676443578</c:v>
                </c:pt>
                <c:pt idx="58">
                  <c:v>1.8255974487556041</c:v>
                </c:pt>
                <c:pt idx="59">
                  <c:v>2.296277066946911</c:v>
                </c:pt>
                <c:pt idx="60">
                  <c:v>1.9841233851799576</c:v>
                </c:pt>
                <c:pt idx="61">
                  <c:v>1.6835352147222902</c:v>
                </c:pt>
                <c:pt idx="62">
                  <c:v>2.0260108125051191</c:v>
                </c:pt>
                <c:pt idx="63">
                  <c:v>2.1680724614503579</c:v>
                </c:pt>
                <c:pt idx="64">
                  <c:v>2.025913829930333</c:v>
                </c:pt>
                <c:pt idx="65">
                  <c:v>1.3336750607769425</c:v>
                </c:pt>
                <c:pt idx="66">
                  <c:v>2.020213643369011</c:v>
                </c:pt>
                <c:pt idx="67">
                  <c:v>1.358230396833179</c:v>
                </c:pt>
                <c:pt idx="68">
                  <c:v>3.0377351668715797</c:v>
                </c:pt>
                <c:pt idx="69">
                  <c:v>1.7445640154660684</c:v>
                </c:pt>
                <c:pt idx="70">
                  <c:v>1.8392751753940473</c:v>
                </c:pt>
                <c:pt idx="71">
                  <c:v>1.9559718629119567</c:v>
                </c:pt>
                <c:pt idx="72">
                  <c:v>2.9222363768191264</c:v>
                </c:pt>
                <c:pt idx="73">
                  <c:v>1.4449228978239679</c:v>
                </c:pt>
                <c:pt idx="74">
                  <c:v>1.3208522986295574</c:v>
                </c:pt>
                <c:pt idx="75">
                  <c:v>1.7457164696428857</c:v>
                </c:pt>
                <c:pt idx="76">
                  <c:v>1.4577540963417985</c:v>
                </c:pt>
                <c:pt idx="77">
                  <c:v>1.4169744513926417</c:v>
                </c:pt>
                <c:pt idx="78">
                  <c:v>1.9468666485761885</c:v>
                </c:pt>
                <c:pt idx="79">
                  <c:v>1.7428257675962253</c:v>
                </c:pt>
                <c:pt idx="80">
                  <c:v>1.580560743222009</c:v>
                </c:pt>
                <c:pt idx="81">
                  <c:v>1.4784770021278297</c:v>
                </c:pt>
                <c:pt idx="82">
                  <c:v>2.2471539774351932</c:v>
                </c:pt>
                <c:pt idx="83">
                  <c:v>2.2568958600985383</c:v>
                </c:pt>
                <c:pt idx="84">
                  <c:v>2.9660579070887412</c:v>
                </c:pt>
                <c:pt idx="85">
                  <c:v>1.5263634269561281</c:v>
                </c:pt>
                <c:pt idx="86">
                  <c:v>2.3020036695144421</c:v>
                </c:pt>
                <c:pt idx="87">
                  <c:v>1.4620042034470404</c:v>
                </c:pt>
                <c:pt idx="88">
                  <c:v>4.5177552670138441</c:v>
                </c:pt>
                <c:pt idx="89">
                  <c:v>1.8543630064608008</c:v>
                </c:pt>
                <c:pt idx="90">
                  <c:v>1.8780955063241289</c:v>
                </c:pt>
                <c:pt idx="91">
                  <c:v>1.3415781645201921</c:v>
                </c:pt>
                <c:pt idx="92">
                  <c:v>1.5416295546495553</c:v>
                </c:pt>
                <c:pt idx="93">
                  <c:v>1.4527536149238107</c:v>
                </c:pt>
                <c:pt idx="94">
                  <c:v>1.8539400805630679</c:v>
                </c:pt>
                <c:pt idx="95">
                  <c:v>1.4030591521207056</c:v>
                </c:pt>
                <c:pt idx="96">
                  <c:v>2.7046512591079757</c:v>
                </c:pt>
                <c:pt idx="97">
                  <c:v>1.3334420214215863</c:v>
                </c:pt>
                <c:pt idx="98">
                  <c:v>1.6346683855241892</c:v>
                </c:pt>
                <c:pt idx="99">
                  <c:v>1.5973596040245996</c:v>
                </c:pt>
                <c:pt idx="100">
                  <c:v>2.0596604030026393</c:v>
                </c:pt>
                <c:pt idx="101">
                  <c:v>1.56562863821812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8EB-4170-9796-DF698A1FB185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88EB-4170-9796-DF698A1FB185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5</c:v>
              </c:pt>
              <c:pt idx="1">
                <c:v>15</c:v>
              </c:pt>
            </c:numLit>
          </c:xVal>
          <c:yVal>
            <c:numLit>
              <c:formatCode>General</c:formatCode>
              <c:ptCount val="2"/>
              <c:pt idx="0">
                <c:v>1.3</c:v>
              </c:pt>
              <c:pt idx="1">
                <c:v>1.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88EB-4170-9796-DF698A1FB185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88EB-4170-9796-DF698A1FB185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88EB-4170-9796-DF698A1FB1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8"/>
          <c:min val="-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</a:t>
                </a:r>
                <a:r>
                  <a:rPr lang="en-US"/>
                  <a:t>sDM /</a:t>
                </a:r>
                <a:r>
                  <a:rPr lang="en-US" baseline="0"/>
                  <a:t> NC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4"/>
      </c:valAx>
      <c:valAx>
        <c:axId val="872775711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</a:t>
                </a:r>
                <a:r>
                  <a:rPr lang="en-US" baseline="-25000"/>
                  <a:t>10</a:t>
                </a:r>
                <a:r>
                  <a:rPr lang="en-US"/>
                  <a:t> 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5"/>
        <c:crossBetween val="midCat"/>
        <c:majorUnit val="2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49578643136832"/>
          <c:y val="7.7611111111111117E-2"/>
          <c:w val="0.7997399373267402"/>
          <c:h val="0.72959555555555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sDM - HFD Prot'!$B$1</c:f>
              <c:strCache>
                <c:ptCount val="1"/>
                <c:pt idx="0">
                  <c:v>-log10q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HFD Prot'!$A$2:$A$3326</c:f>
              <c:numCache>
                <c:formatCode>General</c:formatCode>
                <c:ptCount val="3325"/>
                <c:pt idx="0">
                  <c:v>0.16068533654485087</c:v>
                </c:pt>
                <c:pt idx="1">
                  <c:v>0.14864072625429028</c:v>
                </c:pt>
                <c:pt idx="2">
                  <c:v>-0.34709867062226846</c:v>
                </c:pt>
                <c:pt idx="3">
                  <c:v>-0.40152125010860007</c:v>
                </c:pt>
                <c:pt idx="4">
                  <c:v>-8.079408195824242E-2</c:v>
                </c:pt>
                <c:pt idx="5">
                  <c:v>-0.43327997055725836</c:v>
                </c:pt>
                <c:pt idx="6">
                  <c:v>7.6736701823053879E-2</c:v>
                </c:pt>
                <c:pt idx="7">
                  <c:v>-0.12485746725576014</c:v>
                </c:pt>
                <c:pt idx="8">
                  <c:v>-0.74871883411906492</c:v>
                </c:pt>
                <c:pt idx="9">
                  <c:v>-0.34981817197586046</c:v>
                </c:pt>
                <c:pt idx="10">
                  <c:v>0.62749359101383118</c:v>
                </c:pt>
                <c:pt idx="11">
                  <c:v>-0.37150310520443564</c:v>
                </c:pt>
                <c:pt idx="12">
                  <c:v>-0.3290661744506907</c:v>
                </c:pt>
                <c:pt idx="13">
                  <c:v>-0.10875861436093673</c:v>
                </c:pt>
                <c:pt idx="14">
                  <c:v>6.5672221684630355E-2</c:v>
                </c:pt>
                <c:pt idx="15">
                  <c:v>-0.52536733106569233</c:v>
                </c:pt>
                <c:pt idx="16">
                  <c:v>0.45185934310495268</c:v>
                </c:pt>
                <c:pt idx="17">
                  <c:v>-0.44201456555988794</c:v>
                </c:pt>
                <c:pt idx="18">
                  <c:v>-3.6749476427868286E-2</c:v>
                </c:pt>
                <c:pt idx="19">
                  <c:v>0.16456094677587452</c:v>
                </c:pt>
                <c:pt idx="20">
                  <c:v>-0.13106261678246825</c:v>
                </c:pt>
                <c:pt idx="21">
                  <c:v>0.22246455789192138</c:v>
                </c:pt>
                <c:pt idx="22">
                  <c:v>0.40468731110927669</c:v>
                </c:pt>
                <c:pt idx="23">
                  <c:v>0.50471417062903579</c:v>
                </c:pt>
                <c:pt idx="24">
                  <c:v>0.25670047211174341</c:v>
                </c:pt>
                <c:pt idx="25">
                  <c:v>-0.19585150857564446</c:v>
                </c:pt>
                <c:pt idx="26">
                  <c:v>-0.11596543158680714</c:v>
                </c:pt>
                <c:pt idx="27">
                  <c:v>0.24280603045336266</c:v>
                </c:pt>
                <c:pt idx="28">
                  <c:v>-0.24889910707632629</c:v>
                </c:pt>
                <c:pt idx="29">
                  <c:v>-0.22515151184127313</c:v>
                </c:pt>
                <c:pt idx="30">
                  <c:v>0.27893363126895004</c:v>
                </c:pt>
                <c:pt idx="31">
                  <c:v>-0.15756117609118822</c:v>
                </c:pt>
                <c:pt idx="32">
                  <c:v>0.34501461666269251</c:v>
                </c:pt>
                <c:pt idx="33">
                  <c:v>-3.4215715337912962E-2</c:v>
                </c:pt>
                <c:pt idx="34">
                  <c:v>-8.6783766142066662E-2</c:v>
                </c:pt>
                <c:pt idx="35">
                  <c:v>-0.64837340213022787</c:v>
                </c:pt>
                <c:pt idx="36">
                  <c:v>0.15424903302601112</c:v>
                </c:pt>
                <c:pt idx="37">
                  <c:v>0.14944057937722841</c:v>
                </c:pt>
                <c:pt idx="38">
                  <c:v>2.9588054610526857E-2</c:v>
                </c:pt>
                <c:pt idx="39">
                  <c:v>-3.5623909730721215E-2</c:v>
                </c:pt>
                <c:pt idx="40">
                  <c:v>-0.26771556195170215</c:v>
                </c:pt>
                <c:pt idx="41">
                  <c:v>2.9293566950617283E-2</c:v>
                </c:pt>
                <c:pt idx="42">
                  <c:v>0.10485251550655336</c:v>
                </c:pt>
                <c:pt idx="43">
                  <c:v>-0.31591396543674233</c:v>
                </c:pt>
                <c:pt idx="44">
                  <c:v>-0.479230561206336</c:v>
                </c:pt>
                <c:pt idx="45">
                  <c:v>0.35494398700853047</c:v>
                </c:pt>
                <c:pt idx="46">
                  <c:v>-1.2920160344066964</c:v>
                </c:pt>
                <c:pt idx="47">
                  <c:v>-0.64736056451963464</c:v>
                </c:pt>
                <c:pt idx="48">
                  <c:v>-0.18624698614531165</c:v>
                </c:pt>
                <c:pt idx="49">
                  <c:v>-0.42040155394528178</c:v>
                </c:pt>
                <c:pt idx="50">
                  <c:v>0.58662255473229175</c:v>
                </c:pt>
                <c:pt idx="51">
                  <c:v>0.64160373804334603</c:v>
                </c:pt>
                <c:pt idx="52">
                  <c:v>-0.28190592389719188</c:v>
                </c:pt>
                <c:pt idx="53">
                  <c:v>-0.67635768673285646</c:v>
                </c:pt>
                <c:pt idx="54">
                  <c:v>6.0720794834001396E-3</c:v>
                </c:pt>
                <c:pt idx="55">
                  <c:v>-5.3945424962785225E-2</c:v>
                </c:pt>
                <c:pt idx="56">
                  <c:v>-0.32123543501606444</c:v>
                </c:pt>
                <c:pt idx="57">
                  <c:v>-0.26783539209761498</c:v>
                </c:pt>
                <c:pt idx="58">
                  <c:v>-0.28463257625082961</c:v>
                </c:pt>
                <c:pt idx="59">
                  <c:v>0.25894295902603642</c:v>
                </c:pt>
                <c:pt idx="60">
                  <c:v>0.45107023052360018</c:v>
                </c:pt>
                <c:pt idx="61">
                  <c:v>-0.27309808917849138</c:v>
                </c:pt>
                <c:pt idx="62">
                  <c:v>-0.32019582126612511</c:v>
                </c:pt>
                <c:pt idx="63">
                  <c:v>5.6491198838263902E-2</c:v>
                </c:pt>
                <c:pt idx="64">
                  <c:v>-0.12048465689545593</c:v>
                </c:pt>
                <c:pt idx="65">
                  <c:v>1.0576919438438153</c:v>
                </c:pt>
                <c:pt idx="66">
                  <c:v>0.7280962937367248</c:v>
                </c:pt>
                <c:pt idx="67">
                  <c:v>-0.36893593219790005</c:v>
                </c:pt>
                <c:pt idx="68">
                  <c:v>0.23446525363702297</c:v>
                </c:pt>
                <c:pt idx="69">
                  <c:v>0.24673778073214322</c:v>
                </c:pt>
                <c:pt idx="70">
                  <c:v>-0.12974460550781916</c:v>
                </c:pt>
                <c:pt idx="71">
                  <c:v>-0.42169458118029202</c:v>
                </c:pt>
                <c:pt idx="72">
                  <c:v>0.37819426525283462</c:v>
                </c:pt>
                <c:pt idx="73">
                  <c:v>-7.8746447076648435E-2</c:v>
                </c:pt>
                <c:pt idx="74">
                  <c:v>0.39194777953305082</c:v>
                </c:pt>
                <c:pt idx="75">
                  <c:v>-0.15315678806142044</c:v>
                </c:pt>
                <c:pt idx="76">
                  <c:v>0.26465112981411459</c:v>
                </c:pt>
                <c:pt idx="77">
                  <c:v>-1.0162110331559171</c:v>
                </c:pt>
                <c:pt idx="78">
                  <c:v>0.15072126746921985</c:v>
                </c:pt>
                <c:pt idx="79">
                  <c:v>-8.5968453862165117E-2</c:v>
                </c:pt>
                <c:pt idx="80">
                  <c:v>-8.1612322857889816E-2</c:v>
                </c:pt>
                <c:pt idx="81">
                  <c:v>-0.23069489712191563</c:v>
                </c:pt>
                <c:pt idx="82">
                  <c:v>8.1461107488762743E-2</c:v>
                </c:pt>
                <c:pt idx="83">
                  <c:v>-0.1615652563970319</c:v>
                </c:pt>
                <c:pt idx="84">
                  <c:v>-0.56266982610270222</c:v>
                </c:pt>
                <c:pt idx="85">
                  <c:v>-0.1553606628392023</c:v>
                </c:pt>
                <c:pt idx="86">
                  <c:v>8.4364376569686816E-2</c:v>
                </c:pt>
                <c:pt idx="87">
                  <c:v>-0.50345050900556887</c:v>
                </c:pt>
                <c:pt idx="88">
                  <c:v>-0.31080543106317299</c:v>
                </c:pt>
                <c:pt idx="89">
                  <c:v>-0.27988725484113047</c:v>
                </c:pt>
                <c:pt idx="90">
                  <c:v>-5.8524311840800265E-2</c:v>
                </c:pt>
                <c:pt idx="91">
                  <c:v>-0.15146919750307986</c:v>
                </c:pt>
                <c:pt idx="92">
                  <c:v>-0.77492407618519421</c:v>
                </c:pt>
                <c:pt idx="93">
                  <c:v>0.36327098721025225</c:v>
                </c:pt>
                <c:pt idx="94">
                  <c:v>6.945188075214527E-2</c:v>
                </c:pt>
                <c:pt idx="95">
                  <c:v>0.13780652152440145</c:v>
                </c:pt>
                <c:pt idx="96">
                  <c:v>-5.7970068637329869E-2</c:v>
                </c:pt>
                <c:pt idx="97">
                  <c:v>-0.66129355585530658</c:v>
                </c:pt>
                <c:pt idx="98">
                  <c:v>0.15280481341060489</c:v>
                </c:pt>
                <c:pt idx="99">
                  <c:v>-0.38095104362584725</c:v>
                </c:pt>
                <c:pt idx="100">
                  <c:v>-1.2607483283964476</c:v>
                </c:pt>
                <c:pt idx="101">
                  <c:v>-0.53306492186963761</c:v>
                </c:pt>
                <c:pt idx="102">
                  <c:v>-0.10326262660608471</c:v>
                </c:pt>
                <c:pt idx="103">
                  <c:v>-0.24549566281992088</c:v>
                </c:pt>
                <c:pt idx="104">
                  <c:v>7.4912045120017298E-2</c:v>
                </c:pt>
                <c:pt idx="105">
                  <c:v>-0.12512206056982386</c:v>
                </c:pt>
                <c:pt idx="106">
                  <c:v>-1.4489537961494701</c:v>
                </c:pt>
                <c:pt idx="107">
                  <c:v>9.8505544952424959E-2</c:v>
                </c:pt>
                <c:pt idx="108">
                  <c:v>0.97880457548551036</c:v>
                </c:pt>
                <c:pt idx="109">
                  <c:v>0.22061419380106381</c:v>
                </c:pt>
                <c:pt idx="110">
                  <c:v>4.3497222229955911E-2</c:v>
                </c:pt>
                <c:pt idx="111">
                  <c:v>-0.91907306856590898</c:v>
                </c:pt>
                <c:pt idx="112">
                  <c:v>-0.30451104180995303</c:v>
                </c:pt>
                <c:pt idx="113">
                  <c:v>-0.16221003631430697</c:v>
                </c:pt>
                <c:pt idx="114">
                  <c:v>-0.13671638448831194</c:v>
                </c:pt>
                <c:pt idx="115">
                  <c:v>-1.70667241898333E-2</c:v>
                </c:pt>
                <c:pt idx="116">
                  <c:v>-0.19244669373504683</c:v>
                </c:pt>
                <c:pt idx="117">
                  <c:v>-0.74484997945165676</c:v>
                </c:pt>
                <c:pt idx="118">
                  <c:v>-0.13395801010054909</c:v>
                </c:pt>
                <c:pt idx="119">
                  <c:v>-0.33147592612318894</c:v>
                </c:pt>
                <c:pt idx="120">
                  <c:v>0.18213119827201338</c:v>
                </c:pt>
                <c:pt idx="121">
                  <c:v>0.3233715117570311</c:v>
                </c:pt>
                <c:pt idx="122">
                  <c:v>-0.11782800382748099</c:v>
                </c:pt>
                <c:pt idx="123">
                  <c:v>-1.2093909774674276</c:v>
                </c:pt>
                <c:pt idx="124">
                  <c:v>8.6822430998007728E-3</c:v>
                </c:pt>
                <c:pt idx="125">
                  <c:v>0.19759995988516069</c:v>
                </c:pt>
                <c:pt idx="126">
                  <c:v>8.4211427188055091E-2</c:v>
                </c:pt>
                <c:pt idx="127">
                  <c:v>-0.1915626507007557</c:v>
                </c:pt>
                <c:pt idx="128">
                  <c:v>-0.43616183931445002</c:v>
                </c:pt>
                <c:pt idx="129">
                  <c:v>-0.22687840419626876</c:v>
                </c:pt>
                <c:pt idx="130">
                  <c:v>-0.20201016731643207</c:v>
                </c:pt>
                <c:pt idx="131">
                  <c:v>-0.73621519762492971</c:v>
                </c:pt>
                <c:pt idx="132">
                  <c:v>5.3044613356881036E-2</c:v>
                </c:pt>
                <c:pt idx="133">
                  <c:v>-9.0988888414772262E-2</c:v>
                </c:pt>
                <c:pt idx="134">
                  <c:v>0.1155974470163128</c:v>
                </c:pt>
                <c:pt idx="135">
                  <c:v>-0.41467678042688605</c:v>
                </c:pt>
                <c:pt idx="136">
                  <c:v>0.47673915954728519</c:v>
                </c:pt>
                <c:pt idx="137">
                  <c:v>-0.15613769788898613</c:v>
                </c:pt>
                <c:pt idx="138">
                  <c:v>-0.57211355648423146</c:v>
                </c:pt>
                <c:pt idx="139">
                  <c:v>1.9765317194960945</c:v>
                </c:pt>
                <c:pt idx="140">
                  <c:v>-0.27226212497429564</c:v>
                </c:pt>
                <c:pt idx="141">
                  <c:v>0.21106377075517269</c:v>
                </c:pt>
                <c:pt idx="142">
                  <c:v>1.1733414573826711E-2</c:v>
                </c:pt>
                <c:pt idx="143">
                  <c:v>-0.19861987321921493</c:v>
                </c:pt>
                <c:pt idx="144">
                  <c:v>-0.19509557717721837</c:v>
                </c:pt>
                <c:pt idx="145">
                  <c:v>-0.24281588402684179</c:v>
                </c:pt>
                <c:pt idx="146">
                  <c:v>-0.52596862103308861</c:v>
                </c:pt>
                <c:pt idx="147">
                  <c:v>0.50266866476972538</c:v>
                </c:pt>
                <c:pt idx="148">
                  <c:v>-0.10406822646371668</c:v>
                </c:pt>
                <c:pt idx="149">
                  <c:v>-0.22416378734166367</c:v>
                </c:pt>
                <c:pt idx="150">
                  <c:v>4.4793011362616155E-3</c:v>
                </c:pt>
                <c:pt idx="151">
                  <c:v>-2.7437182706851169E-2</c:v>
                </c:pt>
                <c:pt idx="152">
                  <c:v>-2.4745190197137831E-2</c:v>
                </c:pt>
                <c:pt idx="153">
                  <c:v>0.5920490827614272</c:v>
                </c:pt>
                <c:pt idx="154">
                  <c:v>-0.14025513403491602</c:v>
                </c:pt>
                <c:pt idx="155">
                  <c:v>-4.0261223064434554E-2</c:v>
                </c:pt>
                <c:pt idx="156">
                  <c:v>0.23633347986192646</c:v>
                </c:pt>
                <c:pt idx="157">
                  <c:v>-0.4446670668419076</c:v>
                </c:pt>
                <c:pt idx="158">
                  <c:v>-0.18396283484259496</c:v>
                </c:pt>
                <c:pt idx="159">
                  <c:v>0.24280603045336266</c:v>
                </c:pt>
                <c:pt idx="160">
                  <c:v>5.5441366130549133E-2</c:v>
                </c:pt>
                <c:pt idx="161">
                  <c:v>1.2399068255418599</c:v>
                </c:pt>
                <c:pt idx="162">
                  <c:v>-0.95128937821613313</c:v>
                </c:pt>
                <c:pt idx="163">
                  <c:v>-0.2100147377092727</c:v>
                </c:pt>
                <c:pt idx="164">
                  <c:v>-0.26050747780475464</c:v>
                </c:pt>
                <c:pt idx="165">
                  <c:v>0.28331632812291491</c:v>
                </c:pt>
                <c:pt idx="166">
                  <c:v>0.20789429433709505</c:v>
                </c:pt>
                <c:pt idx="167">
                  <c:v>0.10624949827943411</c:v>
                </c:pt>
                <c:pt idx="168">
                  <c:v>1.2443432655917606</c:v>
                </c:pt>
                <c:pt idx="169">
                  <c:v>0.28630418515664097</c:v>
                </c:pt>
                <c:pt idx="170">
                  <c:v>1.1357445085812596</c:v>
                </c:pt>
                <c:pt idx="171">
                  <c:v>0.37913211553671555</c:v>
                </c:pt>
                <c:pt idx="172">
                  <c:v>0.74976601917324548</c:v>
                </c:pt>
                <c:pt idx="173">
                  <c:v>-0.19194159262148006</c:v>
                </c:pt>
                <c:pt idx="174">
                  <c:v>4.215967329376754E-2</c:v>
                </c:pt>
                <c:pt idx="175">
                  <c:v>0.30347195431932628</c:v>
                </c:pt>
                <c:pt idx="176">
                  <c:v>-0.11676397129772326</c:v>
                </c:pt>
                <c:pt idx="177">
                  <c:v>0.12579321412220129</c:v>
                </c:pt>
                <c:pt idx="178">
                  <c:v>-0.14496000472085785</c:v>
                </c:pt>
                <c:pt idx="179">
                  <c:v>-0.17043786850810769</c:v>
                </c:pt>
                <c:pt idx="180">
                  <c:v>-0.19547359238726494</c:v>
                </c:pt>
                <c:pt idx="181">
                  <c:v>-8.800587129002016E-2</c:v>
                </c:pt>
                <c:pt idx="182">
                  <c:v>-0.80099305748919047</c:v>
                </c:pt>
                <c:pt idx="183">
                  <c:v>0.49410907027004275</c:v>
                </c:pt>
                <c:pt idx="184">
                  <c:v>-0.2828549093225548</c:v>
                </c:pt>
                <c:pt idx="185">
                  <c:v>-0.14613382889337492</c:v>
                </c:pt>
                <c:pt idx="186">
                  <c:v>0.30614509764643477</c:v>
                </c:pt>
                <c:pt idx="187">
                  <c:v>1.1733414573826711E-2</c:v>
                </c:pt>
                <c:pt idx="188">
                  <c:v>0.33497113236296139</c:v>
                </c:pt>
                <c:pt idx="189">
                  <c:v>-2.4886999313179555E-2</c:v>
                </c:pt>
                <c:pt idx="190">
                  <c:v>-0.29278174922784606</c:v>
                </c:pt>
                <c:pt idx="191">
                  <c:v>0.22516024017267372</c:v>
                </c:pt>
                <c:pt idx="192">
                  <c:v>-0.25519856641968952</c:v>
                </c:pt>
                <c:pt idx="193">
                  <c:v>-3.5483152128688591E-2</c:v>
                </c:pt>
                <c:pt idx="194">
                  <c:v>0.21373821488269862</c:v>
                </c:pt>
                <c:pt idx="195">
                  <c:v>-4.0261223064434554E-2</c:v>
                </c:pt>
                <c:pt idx="196">
                  <c:v>-0.31741984983470189</c:v>
                </c:pt>
                <c:pt idx="197">
                  <c:v>3.504694709920065E-2</c:v>
                </c:pt>
                <c:pt idx="198">
                  <c:v>-0.30427738806567511</c:v>
                </c:pt>
                <c:pt idx="199">
                  <c:v>0.29814048099058144</c:v>
                </c:pt>
                <c:pt idx="200">
                  <c:v>0.6829275224630289</c:v>
                </c:pt>
                <c:pt idx="201">
                  <c:v>0.14944057937722841</c:v>
                </c:pt>
                <c:pt idx="202">
                  <c:v>-0.23829772751228745</c:v>
                </c:pt>
                <c:pt idx="203">
                  <c:v>-0.22354611595281834</c:v>
                </c:pt>
                <c:pt idx="204">
                  <c:v>7.7193226812113935E-2</c:v>
                </c:pt>
                <c:pt idx="205">
                  <c:v>0.31401501324409742</c:v>
                </c:pt>
                <c:pt idx="206">
                  <c:v>5.5441366130549133E-2</c:v>
                </c:pt>
                <c:pt idx="207">
                  <c:v>-0.28912622017512168</c:v>
                </c:pt>
                <c:pt idx="208">
                  <c:v>-0.25833801116903743</c:v>
                </c:pt>
                <c:pt idx="209">
                  <c:v>-3.210084316702403E-2</c:v>
                </c:pt>
                <c:pt idx="210">
                  <c:v>-0.29807173493399541</c:v>
                </c:pt>
                <c:pt idx="211">
                  <c:v>1.0570302515754243E-2</c:v>
                </c:pt>
                <c:pt idx="212">
                  <c:v>3.8154450824742697E-2</c:v>
                </c:pt>
                <c:pt idx="213">
                  <c:v>-0.18396283484259496</c:v>
                </c:pt>
                <c:pt idx="214">
                  <c:v>-0.42266359165502176</c:v>
                </c:pt>
                <c:pt idx="215">
                  <c:v>-0.2559236602735635</c:v>
                </c:pt>
                <c:pt idx="216">
                  <c:v>0.16472265669487912</c:v>
                </c:pt>
                <c:pt idx="217">
                  <c:v>-0.12525433903146602</c:v>
                </c:pt>
                <c:pt idx="218">
                  <c:v>4.7219155672650538E-2</c:v>
                </c:pt>
                <c:pt idx="219">
                  <c:v>-0.49159659441044812</c:v>
                </c:pt>
                <c:pt idx="220">
                  <c:v>-0.10285965792205642</c:v>
                </c:pt>
                <c:pt idx="221">
                  <c:v>-0.45659590512621256</c:v>
                </c:pt>
                <c:pt idx="222">
                  <c:v>-0.49916981411524908</c:v>
                </c:pt>
                <c:pt idx="223">
                  <c:v>-0.14860877020522009</c:v>
                </c:pt>
                <c:pt idx="224">
                  <c:v>0.18820018755422674</c:v>
                </c:pt>
                <c:pt idx="225">
                  <c:v>-2.0057652341253399E-2</c:v>
                </c:pt>
                <c:pt idx="226">
                  <c:v>-0.9368169398535352</c:v>
                </c:pt>
                <c:pt idx="227">
                  <c:v>-1.5860923540263658E-3</c:v>
                </c:pt>
                <c:pt idx="228">
                  <c:v>0.56618591554197284</c:v>
                </c:pt>
                <c:pt idx="229">
                  <c:v>0.12957609414180771</c:v>
                </c:pt>
                <c:pt idx="230">
                  <c:v>-3.0124161455128785E-2</c:v>
                </c:pt>
                <c:pt idx="231">
                  <c:v>-8.7734381819725371E-2</c:v>
                </c:pt>
                <c:pt idx="232">
                  <c:v>-0.86552295913996391</c:v>
                </c:pt>
                <c:pt idx="233">
                  <c:v>-0.21163525332714939</c:v>
                </c:pt>
                <c:pt idx="234">
                  <c:v>0.36903545273432331</c:v>
                </c:pt>
                <c:pt idx="235">
                  <c:v>0.50942986955379876</c:v>
                </c:pt>
                <c:pt idx="236">
                  <c:v>2.3709692435232421E-2</c:v>
                </c:pt>
                <c:pt idx="237">
                  <c:v>0.27038197530943575</c:v>
                </c:pt>
                <c:pt idx="238">
                  <c:v>-0.41532600943696718</c:v>
                </c:pt>
                <c:pt idx="239">
                  <c:v>-0.25471496797691834</c:v>
                </c:pt>
                <c:pt idx="240">
                  <c:v>0.18098587751027662</c:v>
                </c:pt>
                <c:pt idx="241">
                  <c:v>-1.6302190647321591</c:v>
                </c:pt>
                <c:pt idx="242">
                  <c:v>-0.62751345678776871</c:v>
                </c:pt>
                <c:pt idx="243">
                  <c:v>-0.1797658083581497</c:v>
                </c:pt>
                <c:pt idx="244">
                  <c:v>-0.26219258817257957</c:v>
                </c:pt>
                <c:pt idx="245">
                  <c:v>4.6325015550512945E-2</c:v>
                </c:pt>
                <c:pt idx="246">
                  <c:v>0.48217001519072616</c:v>
                </c:pt>
                <c:pt idx="247">
                  <c:v>0.1191969483618083</c:v>
                </c:pt>
                <c:pt idx="248">
                  <c:v>-6.3226801996981372E-2</c:v>
                </c:pt>
                <c:pt idx="249">
                  <c:v>0.24229398251865655</c:v>
                </c:pt>
                <c:pt idx="250">
                  <c:v>-0.22576849642959679</c:v>
                </c:pt>
                <c:pt idx="251">
                  <c:v>0.42856588412349073</c:v>
                </c:pt>
                <c:pt idx="252">
                  <c:v>-7.0389327891398012E-2</c:v>
                </c:pt>
                <c:pt idx="253">
                  <c:v>-0.18700756697703319</c:v>
                </c:pt>
                <c:pt idx="254">
                  <c:v>-0.19534759832221918</c:v>
                </c:pt>
                <c:pt idx="255">
                  <c:v>-0.14912926990993297</c:v>
                </c:pt>
                <c:pt idx="256">
                  <c:v>-0.71193535697892152</c:v>
                </c:pt>
                <c:pt idx="257">
                  <c:v>1.4434168696688451E-3</c:v>
                </c:pt>
                <c:pt idx="258">
                  <c:v>-0.39856927559498329</c:v>
                </c:pt>
                <c:pt idx="259">
                  <c:v>-7.0114502661328224E-2</c:v>
                </c:pt>
                <c:pt idx="260">
                  <c:v>0.28630418515664097</c:v>
                </c:pt>
                <c:pt idx="261">
                  <c:v>-0.25035527176304762</c:v>
                </c:pt>
                <c:pt idx="262">
                  <c:v>0.36345657864819891</c:v>
                </c:pt>
                <c:pt idx="263">
                  <c:v>7.0511962181904503E-2</c:v>
                </c:pt>
                <c:pt idx="264">
                  <c:v>0.52242628082576681</c:v>
                </c:pt>
                <c:pt idx="265">
                  <c:v>-0.75369010284334215</c:v>
                </c:pt>
                <c:pt idx="266">
                  <c:v>9.1263935587371295E-2</c:v>
                </c:pt>
                <c:pt idx="267">
                  <c:v>1.5957573902976287E-2</c:v>
                </c:pt>
                <c:pt idx="268">
                  <c:v>-0.23597208277358109</c:v>
                </c:pt>
                <c:pt idx="269">
                  <c:v>6.3559929885785335E-2</c:v>
                </c:pt>
                <c:pt idx="270">
                  <c:v>-0.1325110397991954</c:v>
                </c:pt>
                <c:pt idx="271">
                  <c:v>-9.7880434051913087E-2</c:v>
                </c:pt>
                <c:pt idx="272">
                  <c:v>0.64678964437599906</c:v>
                </c:pt>
                <c:pt idx="273">
                  <c:v>6.945188075214527E-2</c:v>
                </c:pt>
                <c:pt idx="274">
                  <c:v>0.20257191784768683</c:v>
                </c:pt>
                <c:pt idx="275">
                  <c:v>-0.26495671796482234</c:v>
                </c:pt>
                <c:pt idx="276">
                  <c:v>-0.31022376954624697</c:v>
                </c:pt>
                <c:pt idx="277">
                  <c:v>1.249822294406943</c:v>
                </c:pt>
                <c:pt idx="278">
                  <c:v>-0.46602668781373052</c:v>
                </c:pt>
                <c:pt idx="279">
                  <c:v>-0.27619886503224178</c:v>
                </c:pt>
                <c:pt idx="280">
                  <c:v>-0.13277423327632584</c:v>
                </c:pt>
                <c:pt idx="281">
                  <c:v>-0.71510263605760471</c:v>
                </c:pt>
                <c:pt idx="282">
                  <c:v>0.12705307233206631</c:v>
                </c:pt>
                <c:pt idx="283">
                  <c:v>-0.4198624503775239</c:v>
                </c:pt>
                <c:pt idx="284">
                  <c:v>-0.45270085248384417</c:v>
                </c:pt>
                <c:pt idx="285">
                  <c:v>-0.51934060765598244</c:v>
                </c:pt>
                <c:pt idx="286">
                  <c:v>-0.4811955929289537</c:v>
                </c:pt>
                <c:pt idx="287">
                  <c:v>-7.2174416924316601E-2</c:v>
                </c:pt>
                <c:pt idx="288">
                  <c:v>-0.24049751707326048</c:v>
                </c:pt>
                <c:pt idx="289">
                  <c:v>-0.44020807501374976</c:v>
                </c:pt>
                <c:pt idx="290">
                  <c:v>-8.3655897080632508E-2</c:v>
                </c:pt>
                <c:pt idx="291">
                  <c:v>8.8960414355712752E-2</c:v>
                </c:pt>
                <c:pt idx="292">
                  <c:v>-0.1008431244331118</c:v>
                </c:pt>
                <c:pt idx="293">
                  <c:v>-0.19874558184482397</c:v>
                </c:pt>
                <c:pt idx="294">
                  <c:v>0.31832585820716658</c:v>
                </c:pt>
                <c:pt idx="295">
                  <c:v>0.15008078131402142</c:v>
                </c:pt>
                <c:pt idx="296">
                  <c:v>-0.44350056705769231</c:v>
                </c:pt>
                <c:pt idx="297">
                  <c:v>2.8410464469938067E-2</c:v>
                </c:pt>
                <c:pt idx="298">
                  <c:v>3.771011170900114E-2</c:v>
                </c:pt>
                <c:pt idx="299">
                  <c:v>-0.18116617426997683</c:v>
                </c:pt>
                <c:pt idx="300">
                  <c:v>0.41638464341544223</c:v>
                </c:pt>
                <c:pt idx="301">
                  <c:v>0.11107170841543576</c:v>
                </c:pt>
                <c:pt idx="302">
                  <c:v>-0.484086559411609</c:v>
                </c:pt>
                <c:pt idx="303">
                  <c:v>0.63553962603973857</c:v>
                </c:pt>
                <c:pt idx="304">
                  <c:v>0.24827921322495475</c:v>
                </c:pt>
                <c:pt idx="305">
                  <c:v>-0.87420678587779876</c:v>
                </c:pt>
                <c:pt idx="306">
                  <c:v>0.23327764078860672</c:v>
                </c:pt>
                <c:pt idx="307">
                  <c:v>-0.92295896423617219</c:v>
                </c:pt>
                <c:pt idx="308">
                  <c:v>-0.76867131759656837</c:v>
                </c:pt>
                <c:pt idx="309">
                  <c:v>-0.41164317603901396</c:v>
                </c:pt>
                <c:pt idx="310">
                  <c:v>0.67461358534022664</c:v>
                </c:pt>
                <c:pt idx="311">
                  <c:v>0.14704234913434724</c:v>
                </c:pt>
                <c:pt idx="312">
                  <c:v>0.51004609866869444</c:v>
                </c:pt>
                <c:pt idx="313">
                  <c:v>-0.38117260471679754</c:v>
                </c:pt>
                <c:pt idx="314">
                  <c:v>-0.22230997926431556</c:v>
                </c:pt>
                <c:pt idx="315">
                  <c:v>4.9904905826313926E-2</c:v>
                </c:pt>
                <c:pt idx="316">
                  <c:v>0.20989525865354569</c:v>
                </c:pt>
                <c:pt idx="317">
                  <c:v>-1.13284002414397</c:v>
                </c:pt>
                <c:pt idx="318">
                  <c:v>4.9904905826313926E-2</c:v>
                </c:pt>
                <c:pt idx="319">
                  <c:v>-0.75034924058415042</c:v>
                </c:pt>
                <c:pt idx="320">
                  <c:v>-0.41781201761461034</c:v>
                </c:pt>
                <c:pt idx="321">
                  <c:v>4.112021410761147E-2</c:v>
                </c:pt>
                <c:pt idx="322">
                  <c:v>-0.23939804156655572</c:v>
                </c:pt>
                <c:pt idx="323">
                  <c:v>-9.2613392714283788E-2</c:v>
                </c:pt>
                <c:pt idx="324">
                  <c:v>-0.27142567609293461</c:v>
                </c:pt>
                <c:pt idx="325">
                  <c:v>-0.13802804476676125</c:v>
                </c:pt>
                <c:pt idx="326">
                  <c:v>0.27753397552890896</c:v>
                </c:pt>
                <c:pt idx="327">
                  <c:v>0.13653724174087761</c:v>
                </c:pt>
                <c:pt idx="328">
                  <c:v>-0.15730246631897368</c:v>
                </c:pt>
                <c:pt idx="329">
                  <c:v>0.25790753191875176</c:v>
                </c:pt>
                <c:pt idx="330">
                  <c:v>-0.12366619645381972</c:v>
                </c:pt>
                <c:pt idx="331">
                  <c:v>0.26725323784993854</c:v>
                </c:pt>
                <c:pt idx="332">
                  <c:v>-7.8063255776819121E-2</c:v>
                </c:pt>
                <c:pt idx="333">
                  <c:v>-0.25435216273399314</c:v>
                </c:pt>
                <c:pt idx="334">
                  <c:v>0.72237225234099478</c:v>
                </c:pt>
                <c:pt idx="335">
                  <c:v>-0.10272531001108824</c:v>
                </c:pt>
                <c:pt idx="336">
                  <c:v>-0.26975132204837454</c:v>
                </c:pt>
                <c:pt idx="337">
                  <c:v>-0.1949695500934179</c:v>
                </c:pt>
                <c:pt idx="338">
                  <c:v>0.51622291004885101</c:v>
                </c:pt>
                <c:pt idx="339">
                  <c:v>-4.9491370165103701E-2</c:v>
                </c:pt>
                <c:pt idx="340">
                  <c:v>-0.19799116573513395</c:v>
                </c:pt>
                <c:pt idx="341">
                  <c:v>-0.31614574229335646</c:v>
                </c:pt>
                <c:pt idx="342">
                  <c:v>-3.8717107572853661E-2</c:v>
                </c:pt>
                <c:pt idx="343">
                  <c:v>-2.1479727410451344E-2</c:v>
                </c:pt>
                <c:pt idx="344">
                  <c:v>-0.394404385400625</c:v>
                </c:pt>
                <c:pt idx="345">
                  <c:v>-0.21648590720005356</c:v>
                </c:pt>
                <c:pt idx="346">
                  <c:v>0.43012009385192357</c:v>
                </c:pt>
                <c:pt idx="347">
                  <c:v>-0.18192943769006681</c:v>
                </c:pt>
                <c:pt idx="348">
                  <c:v>0.31616882559867743</c:v>
                </c:pt>
                <c:pt idx="349">
                  <c:v>0.25102361075378682</c:v>
                </c:pt>
                <c:pt idx="350">
                  <c:v>-0.30322547767208885</c:v>
                </c:pt>
                <c:pt idx="351">
                  <c:v>-8.0248330092120235E-2</c:v>
                </c:pt>
                <c:pt idx="352">
                  <c:v>-0.28083756861177134</c:v>
                </c:pt>
                <c:pt idx="353">
                  <c:v>1.6339716008428806</c:v>
                </c:pt>
                <c:pt idx="354">
                  <c:v>6.5068394097751947E-2</c:v>
                </c:pt>
                <c:pt idx="355">
                  <c:v>-0.27834165862164245</c:v>
                </c:pt>
                <c:pt idx="356">
                  <c:v>-5.7592692886849432E-3</c:v>
                </c:pt>
                <c:pt idx="357">
                  <c:v>0.19528556376919445</c:v>
                </c:pt>
                <c:pt idx="358">
                  <c:v>6.688063556819214E-2</c:v>
                </c:pt>
                <c:pt idx="359">
                  <c:v>-1.0780632557768193</c:v>
                </c:pt>
                <c:pt idx="360">
                  <c:v>-4.327436039712134E-4</c:v>
                </c:pt>
                <c:pt idx="361">
                  <c:v>-0.19093085956261455</c:v>
                </c:pt>
                <c:pt idx="362">
                  <c:v>0.30721574336598995</c:v>
                </c:pt>
                <c:pt idx="363">
                  <c:v>0.34062340452408862</c:v>
                </c:pt>
                <c:pt idx="364">
                  <c:v>0.35199482018950684</c:v>
                </c:pt>
                <c:pt idx="365">
                  <c:v>-0.65727414074358281</c:v>
                </c:pt>
                <c:pt idx="366">
                  <c:v>-0.29231058820442596</c:v>
                </c:pt>
                <c:pt idx="367">
                  <c:v>-0.70221425101044077</c:v>
                </c:pt>
                <c:pt idx="368">
                  <c:v>-0.11103131238874402</c:v>
                </c:pt>
                <c:pt idx="369">
                  <c:v>-0.12895322038600607</c:v>
                </c:pt>
                <c:pt idx="370">
                  <c:v>0.44261441857647499</c:v>
                </c:pt>
                <c:pt idx="371">
                  <c:v>-0.49221212241845808</c:v>
                </c:pt>
                <c:pt idx="372">
                  <c:v>-0.23302905744518476</c:v>
                </c:pt>
                <c:pt idx="373">
                  <c:v>0.49817873457908973</c:v>
                </c:pt>
                <c:pt idx="374">
                  <c:v>1.2761356763732725</c:v>
                </c:pt>
                <c:pt idx="375">
                  <c:v>0.14193941010035235</c:v>
                </c:pt>
                <c:pt idx="376">
                  <c:v>-0.25156762060824689</c:v>
                </c:pt>
                <c:pt idx="377">
                  <c:v>2.2536888760533245E-2</c:v>
                </c:pt>
                <c:pt idx="378">
                  <c:v>8.9267338097087298E-2</c:v>
                </c:pt>
                <c:pt idx="379">
                  <c:v>-8.6647912755188225E-2</c:v>
                </c:pt>
                <c:pt idx="380">
                  <c:v>2.1804370318348337E-2</c:v>
                </c:pt>
                <c:pt idx="381">
                  <c:v>0.38157338335406943</c:v>
                </c:pt>
                <c:pt idx="382">
                  <c:v>0.14784131633696224</c:v>
                </c:pt>
                <c:pt idx="383">
                  <c:v>4.9009100121724346E-2</c:v>
                </c:pt>
                <c:pt idx="384">
                  <c:v>0.33624551761665378</c:v>
                </c:pt>
                <c:pt idx="385">
                  <c:v>-1.0797023716973781</c:v>
                </c:pt>
                <c:pt idx="386">
                  <c:v>0.24314749673682376</c:v>
                </c:pt>
                <c:pt idx="387">
                  <c:v>6.9906105987850575E-2</c:v>
                </c:pt>
                <c:pt idx="388">
                  <c:v>0.30900192044309216</c:v>
                </c:pt>
                <c:pt idx="389">
                  <c:v>-0.2026371261898377</c:v>
                </c:pt>
                <c:pt idx="390">
                  <c:v>-0.35354913572204427</c:v>
                </c:pt>
                <c:pt idx="391">
                  <c:v>-0.17683337078449005</c:v>
                </c:pt>
                <c:pt idx="392">
                  <c:v>-0.21995839758491761</c:v>
                </c:pt>
                <c:pt idx="393">
                  <c:v>-0.16941195199135478</c:v>
                </c:pt>
                <c:pt idx="394">
                  <c:v>-1.9061365093430219E-2</c:v>
                </c:pt>
                <c:pt idx="395">
                  <c:v>0.25205410725537819</c:v>
                </c:pt>
                <c:pt idx="396">
                  <c:v>0.10268211636816947</c:v>
                </c:pt>
                <c:pt idx="397">
                  <c:v>0.21926996352362363</c:v>
                </c:pt>
                <c:pt idx="398">
                  <c:v>-0.47695191252389668</c:v>
                </c:pt>
                <c:pt idx="399">
                  <c:v>0.63643640620281083</c:v>
                </c:pt>
                <c:pt idx="400">
                  <c:v>-0.34868566933438744</c:v>
                </c:pt>
                <c:pt idx="401">
                  <c:v>0.12154929690333617</c:v>
                </c:pt>
                <c:pt idx="402">
                  <c:v>-7.4231394185791999E-2</c:v>
                </c:pt>
                <c:pt idx="403">
                  <c:v>-0.45901186447638193</c:v>
                </c:pt>
                <c:pt idx="404">
                  <c:v>9.9741787565250248E-2</c:v>
                </c:pt>
                <c:pt idx="405">
                  <c:v>0.18278607574167338</c:v>
                </c:pt>
                <c:pt idx="406">
                  <c:v>6.4917476681338418E-2</c:v>
                </c:pt>
                <c:pt idx="407">
                  <c:v>9.6961729887087802E-2</c:v>
                </c:pt>
                <c:pt idx="408">
                  <c:v>-0.33890927280892141</c:v>
                </c:pt>
                <c:pt idx="409">
                  <c:v>9.1263935587371295E-2</c:v>
                </c:pt>
                <c:pt idx="410">
                  <c:v>-0.24147412570144142</c:v>
                </c:pt>
                <c:pt idx="411">
                  <c:v>0.13099723532474772</c:v>
                </c:pt>
                <c:pt idx="412">
                  <c:v>0.39782820924662077</c:v>
                </c:pt>
                <c:pt idx="413">
                  <c:v>0.88656619739595155</c:v>
                </c:pt>
                <c:pt idx="414">
                  <c:v>0.36829035521439729</c:v>
                </c:pt>
                <c:pt idx="415">
                  <c:v>0.10314692710329339</c:v>
                </c:pt>
                <c:pt idx="416">
                  <c:v>0.26812165119156844</c:v>
                </c:pt>
                <c:pt idx="417">
                  <c:v>3.6969850498809929E-2</c:v>
                </c:pt>
                <c:pt idx="418">
                  <c:v>0.23990682554185994</c:v>
                </c:pt>
                <c:pt idx="419">
                  <c:v>0.30187044254610873</c:v>
                </c:pt>
                <c:pt idx="420">
                  <c:v>-0.34607753453559698</c:v>
                </c:pt>
                <c:pt idx="421">
                  <c:v>-6.4469017368442516E-2</c:v>
                </c:pt>
                <c:pt idx="422">
                  <c:v>0.72213424276512062</c:v>
                </c:pt>
                <c:pt idx="423">
                  <c:v>0.34190279464862838</c:v>
                </c:pt>
                <c:pt idx="424">
                  <c:v>-0.42115596066222349</c:v>
                </c:pt>
                <c:pt idx="425">
                  <c:v>9.8969011800408013E-2</c:v>
                </c:pt>
                <c:pt idx="426">
                  <c:v>-0.57143411587650927</c:v>
                </c:pt>
                <c:pt idx="427">
                  <c:v>-0.37362037324573732</c:v>
                </c:pt>
                <c:pt idx="428">
                  <c:v>1.5924840880536992</c:v>
                </c:pt>
                <c:pt idx="429">
                  <c:v>-0.52356195605701294</c:v>
                </c:pt>
                <c:pt idx="430">
                  <c:v>-2.2474346574899173E-2</c:v>
                </c:pt>
                <c:pt idx="431">
                  <c:v>0.23633347986192646</c:v>
                </c:pt>
                <c:pt idx="432">
                  <c:v>9.0342085689623181E-2</c:v>
                </c:pt>
                <c:pt idx="433">
                  <c:v>3.4899137556436657E-2</c:v>
                </c:pt>
                <c:pt idx="434">
                  <c:v>-0.63068503645575669</c:v>
                </c:pt>
                <c:pt idx="435">
                  <c:v>0.91675258625206379</c:v>
                </c:pt>
                <c:pt idx="436">
                  <c:v>-0.40501208291259222</c:v>
                </c:pt>
                <c:pt idx="437">
                  <c:v>4.6325015550512945E-2</c:v>
                </c:pt>
                <c:pt idx="438">
                  <c:v>-3.7311930641966598E-2</c:v>
                </c:pt>
                <c:pt idx="439">
                  <c:v>8.1017984969644387E-3</c:v>
                </c:pt>
                <c:pt idx="440">
                  <c:v>-0.23143240844796514</c:v>
                </c:pt>
                <c:pt idx="441">
                  <c:v>-0.53545579943529165</c:v>
                </c:pt>
                <c:pt idx="442">
                  <c:v>0.27543703469332909</c:v>
                </c:pt>
                <c:pt idx="443">
                  <c:v>0.10144335270645237</c:v>
                </c:pt>
                <c:pt idx="444">
                  <c:v>1.8001258406667432E-2</c:v>
                </c:pt>
                <c:pt idx="445">
                  <c:v>-0.26050747780475464</c:v>
                </c:pt>
                <c:pt idx="446">
                  <c:v>-0.13343200698073493</c:v>
                </c:pt>
                <c:pt idx="447">
                  <c:v>-1.0443241688122014</c:v>
                </c:pt>
                <c:pt idx="448">
                  <c:v>-0.14456851766471154</c:v>
                </c:pt>
                <c:pt idx="449">
                  <c:v>-1.2640180778770403E-2</c:v>
                </c:pt>
                <c:pt idx="450">
                  <c:v>1.0445383960764982</c:v>
                </c:pt>
                <c:pt idx="451">
                  <c:v>-0.11343380260404853</c:v>
                </c:pt>
                <c:pt idx="452">
                  <c:v>0.6097725631593085</c:v>
                </c:pt>
                <c:pt idx="453">
                  <c:v>-0.33674040696729229</c:v>
                </c:pt>
                <c:pt idx="454">
                  <c:v>5.7719346274549344E-4</c:v>
                </c:pt>
                <c:pt idx="455">
                  <c:v>4.3287344653061296E-4</c:v>
                </c:pt>
                <c:pt idx="456">
                  <c:v>-0.10862481468164864</c:v>
                </c:pt>
                <c:pt idx="457">
                  <c:v>7.0814985716076667E-2</c:v>
                </c:pt>
                <c:pt idx="458">
                  <c:v>-2.5945167084523856E-3</c:v>
                </c:pt>
                <c:pt idx="459">
                  <c:v>0.11512860824030072</c:v>
                </c:pt>
                <c:pt idx="460">
                  <c:v>8.712024186019561E-2</c:v>
                </c:pt>
                <c:pt idx="461">
                  <c:v>3.948828988097549E-2</c:v>
                </c:pt>
                <c:pt idx="462">
                  <c:v>-0.66957107603896582</c:v>
                </c:pt>
                <c:pt idx="463">
                  <c:v>-0.24525225214937735</c:v>
                </c:pt>
                <c:pt idx="464">
                  <c:v>-0.3163774819197302</c:v>
                </c:pt>
                <c:pt idx="465">
                  <c:v>-0.30707873853981515</c:v>
                </c:pt>
                <c:pt idx="466">
                  <c:v>0.20041529863029578</c:v>
                </c:pt>
                <c:pt idx="467">
                  <c:v>-5.8662839378559907E-2</c:v>
                </c:pt>
                <c:pt idx="468">
                  <c:v>0.50594286768631813</c:v>
                </c:pt>
                <c:pt idx="469">
                  <c:v>-8.1475981597958547E-2</c:v>
                </c:pt>
                <c:pt idx="470">
                  <c:v>-0.50019017984198233</c:v>
                </c:pt>
                <c:pt idx="471">
                  <c:v>-8.7737070660160558E-3</c:v>
                </c:pt>
                <c:pt idx="472">
                  <c:v>-2.9841557136715116E-2</c:v>
                </c:pt>
                <c:pt idx="473">
                  <c:v>-1.5925689990254233E-2</c:v>
                </c:pt>
                <c:pt idx="474">
                  <c:v>-0.14156358237500299</c:v>
                </c:pt>
                <c:pt idx="475">
                  <c:v>-0.971589535530062</c:v>
                </c:pt>
                <c:pt idx="476">
                  <c:v>-0.28380327092836588</c:v>
                </c:pt>
                <c:pt idx="477">
                  <c:v>-0.3637878411032891</c:v>
                </c:pt>
                <c:pt idx="478">
                  <c:v>0.22010996065995281</c:v>
                </c:pt>
                <c:pt idx="479">
                  <c:v>-5.1580920630645004E-2</c:v>
                </c:pt>
                <c:pt idx="480">
                  <c:v>-0.47300756791617371</c:v>
                </c:pt>
                <c:pt idx="481">
                  <c:v>6.9149143359178225E-2</c:v>
                </c:pt>
                <c:pt idx="482">
                  <c:v>7.3848726800103251E-2</c:v>
                </c:pt>
                <c:pt idx="483">
                  <c:v>0.27631038966938515</c:v>
                </c:pt>
                <c:pt idx="484">
                  <c:v>3.0471878432872985E-2</c:v>
                </c:pt>
                <c:pt idx="485">
                  <c:v>-1.0127831846982895</c:v>
                </c:pt>
                <c:pt idx="486">
                  <c:v>-0.22675512326982</c:v>
                </c:pt>
                <c:pt idx="487">
                  <c:v>-0.44434902406421772</c:v>
                </c:pt>
                <c:pt idx="488">
                  <c:v>6.7938828656575592E-2</c:v>
                </c:pt>
                <c:pt idx="489">
                  <c:v>-0.74519429807880144</c:v>
                </c:pt>
                <c:pt idx="490">
                  <c:v>0.40087267366503004</c:v>
                </c:pt>
                <c:pt idx="491">
                  <c:v>1.7271038701404142E-2</c:v>
                </c:pt>
                <c:pt idx="492">
                  <c:v>-0.32826202860941289</c:v>
                </c:pt>
                <c:pt idx="493">
                  <c:v>0.61396164011138643</c:v>
                </c:pt>
                <c:pt idx="494">
                  <c:v>0.18787148054872888</c:v>
                </c:pt>
                <c:pt idx="495">
                  <c:v>9.5111329837495373E-2</c:v>
                </c:pt>
                <c:pt idx="496">
                  <c:v>-1.9346088804812044E-2</c:v>
                </c:pt>
                <c:pt idx="497">
                  <c:v>-0.295135249000818</c:v>
                </c:pt>
                <c:pt idx="498">
                  <c:v>0.17771853370429305</c:v>
                </c:pt>
                <c:pt idx="499">
                  <c:v>-0.13040376165803882</c:v>
                </c:pt>
                <c:pt idx="500">
                  <c:v>-0.28368475981474189</c:v>
                </c:pt>
                <c:pt idx="501">
                  <c:v>-0.46999013822107327</c:v>
                </c:pt>
                <c:pt idx="502">
                  <c:v>3.1356244035283004E-2</c:v>
                </c:pt>
                <c:pt idx="503">
                  <c:v>6.7334051854221449E-2</c:v>
                </c:pt>
                <c:pt idx="504">
                  <c:v>-0.37250640898616882</c:v>
                </c:pt>
                <c:pt idx="505">
                  <c:v>-8.5560624872625474E-2</c:v>
                </c:pt>
                <c:pt idx="506">
                  <c:v>-1.96262305284102</c:v>
                </c:pt>
                <c:pt idx="507">
                  <c:v>0.30275995181708248</c:v>
                </c:pt>
                <c:pt idx="508">
                  <c:v>-0.98659296730589685</c:v>
                </c:pt>
                <c:pt idx="509">
                  <c:v>-0.17989317053354814</c:v>
                </c:pt>
                <c:pt idx="510">
                  <c:v>9.5419565078682503E-2</c:v>
                </c:pt>
                <c:pt idx="511">
                  <c:v>-0.14899916258776441</c:v>
                </c:pt>
                <c:pt idx="512">
                  <c:v>-0.150169706295702</c:v>
                </c:pt>
                <c:pt idx="513">
                  <c:v>-0.18320064672542757</c:v>
                </c:pt>
                <c:pt idx="514">
                  <c:v>-9.0853430451113534E-2</c:v>
                </c:pt>
                <c:pt idx="515">
                  <c:v>-0.13592881552640676</c:v>
                </c:pt>
                <c:pt idx="516">
                  <c:v>0.21474241100738778</c:v>
                </c:pt>
                <c:pt idx="517">
                  <c:v>-0.1296127381304697</c:v>
                </c:pt>
                <c:pt idx="518">
                  <c:v>-0.27011027582361774</c:v>
                </c:pt>
                <c:pt idx="519">
                  <c:v>-0.23069489712191563</c:v>
                </c:pt>
                <c:pt idx="520">
                  <c:v>-0.1847246205018801</c:v>
                </c:pt>
                <c:pt idx="521">
                  <c:v>-0.54379280553587672</c:v>
                </c:pt>
                <c:pt idx="522">
                  <c:v>0.25342924858755345</c:v>
                </c:pt>
                <c:pt idx="523">
                  <c:v>-4.2784398089239555E-2</c:v>
                </c:pt>
                <c:pt idx="524">
                  <c:v>0.17234354172922545</c:v>
                </c:pt>
                <c:pt idx="525">
                  <c:v>-0.26519682698441455</c:v>
                </c:pt>
                <c:pt idx="526">
                  <c:v>-0.16645837172253311</c:v>
                </c:pt>
                <c:pt idx="527">
                  <c:v>0.40258801244534997</c:v>
                </c:pt>
                <c:pt idx="528">
                  <c:v>0.1085808131539213</c:v>
                </c:pt>
                <c:pt idx="529">
                  <c:v>-0.312897472897257</c:v>
                </c:pt>
                <c:pt idx="530">
                  <c:v>0.48317797655422379</c:v>
                </c:pt>
                <c:pt idx="531">
                  <c:v>-0.32699746456575879</c:v>
                </c:pt>
                <c:pt idx="532">
                  <c:v>-0.15613769788898613</c:v>
                </c:pt>
                <c:pt idx="533">
                  <c:v>-0.43637508224453886</c:v>
                </c:pt>
                <c:pt idx="534">
                  <c:v>0.11591009086646663</c:v>
                </c:pt>
                <c:pt idx="535">
                  <c:v>0.88017904787812529</c:v>
                </c:pt>
                <c:pt idx="536">
                  <c:v>0.4408508522627429</c:v>
                </c:pt>
                <c:pt idx="537">
                  <c:v>-0.1902987916265946</c:v>
                </c:pt>
                <c:pt idx="538">
                  <c:v>-0.10594621190532467</c:v>
                </c:pt>
                <c:pt idx="539">
                  <c:v>0.1054732297426056</c:v>
                </c:pt>
                <c:pt idx="540">
                  <c:v>-0.32146635859252998</c:v>
                </c:pt>
                <c:pt idx="541">
                  <c:v>0.72618575541296349</c:v>
                </c:pt>
                <c:pt idx="542">
                  <c:v>-0.57143411587650927</c:v>
                </c:pt>
                <c:pt idx="543">
                  <c:v>-0.26435627052581029</c:v>
                </c:pt>
                <c:pt idx="544">
                  <c:v>-0.15081959821213317</c:v>
                </c:pt>
                <c:pt idx="545">
                  <c:v>-0.5044678527053591</c:v>
                </c:pt>
                <c:pt idx="546">
                  <c:v>-0.36681177312712704</c:v>
                </c:pt>
                <c:pt idx="547">
                  <c:v>7.8259013920499554E-2</c:v>
                </c:pt>
                <c:pt idx="548">
                  <c:v>0.45482236538470761</c:v>
                </c:pt>
                <c:pt idx="549">
                  <c:v>-0.83931466345514916</c:v>
                </c:pt>
                <c:pt idx="550">
                  <c:v>0.22128677891389301</c:v>
                </c:pt>
                <c:pt idx="551">
                  <c:v>-0.82391236748780194</c:v>
                </c:pt>
                <c:pt idx="552">
                  <c:v>-0.19232043503449914</c:v>
                </c:pt>
                <c:pt idx="553">
                  <c:v>0.72523143420013425</c:v>
                </c:pt>
                <c:pt idx="554">
                  <c:v>1.1442548637178539E-2</c:v>
                </c:pt>
                <c:pt idx="555">
                  <c:v>-1.651775010621058</c:v>
                </c:pt>
                <c:pt idx="556">
                  <c:v>9.4803160437436584E-2</c:v>
                </c:pt>
                <c:pt idx="557">
                  <c:v>0.16100790670625945</c:v>
                </c:pt>
                <c:pt idx="558">
                  <c:v>0.49960583358420474</c:v>
                </c:pt>
                <c:pt idx="559">
                  <c:v>-0.59521719360418235</c:v>
                </c:pt>
                <c:pt idx="560">
                  <c:v>-0.47092725747512665</c:v>
                </c:pt>
                <c:pt idx="561">
                  <c:v>0.81375301385468835</c:v>
                </c:pt>
                <c:pt idx="562">
                  <c:v>-0.42588893402430433</c:v>
                </c:pt>
                <c:pt idx="563">
                  <c:v>-0.46257588804220418</c:v>
                </c:pt>
                <c:pt idx="564">
                  <c:v>-0.17670573818911436</c:v>
                </c:pt>
                <c:pt idx="565">
                  <c:v>0.24982229440694287</c:v>
                </c:pt>
                <c:pt idx="566">
                  <c:v>-0.16941195199135478</c:v>
                </c:pt>
                <c:pt idx="567">
                  <c:v>-0.26122990898704573</c:v>
                </c:pt>
                <c:pt idx="568">
                  <c:v>-0.2728592916871096</c:v>
                </c:pt>
                <c:pt idx="569">
                  <c:v>-0.24000896473507019</c:v>
                </c:pt>
                <c:pt idx="570">
                  <c:v>0.13987148587711218</c:v>
                </c:pt>
                <c:pt idx="571">
                  <c:v>4.4793011362616155E-3</c:v>
                </c:pt>
                <c:pt idx="572">
                  <c:v>4.8561405768748102E-2</c:v>
                </c:pt>
                <c:pt idx="573">
                  <c:v>-2.602097071437012E-2</c:v>
                </c:pt>
                <c:pt idx="574">
                  <c:v>-0.85734407881420294</c:v>
                </c:pt>
                <c:pt idx="575">
                  <c:v>8.6587681356164699E-4</c:v>
                </c:pt>
                <c:pt idx="576">
                  <c:v>-7.3683153616439886E-2</c:v>
                </c:pt>
                <c:pt idx="577">
                  <c:v>0.49349960956638383</c:v>
                </c:pt>
                <c:pt idx="578">
                  <c:v>-0.18510536254259155</c:v>
                </c:pt>
                <c:pt idx="579">
                  <c:v>-0.16104922490055679</c:v>
                </c:pt>
                <c:pt idx="580">
                  <c:v>-0.26375557307744779</c:v>
                </c:pt>
                <c:pt idx="581">
                  <c:v>-0.29289951544487303</c:v>
                </c:pt>
                <c:pt idx="582">
                  <c:v>-0.22292818000261264</c:v>
                </c:pt>
                <c:pt idx="583">
                  <c:v>-0.34970496170853743</c:v>
                </c:pt>
                <c:pt idx="584">
                  <c:v>0.47333019059787684</c:v>
                </c:pt>
                <c:pt idx="585">
                  <c:v>0.18213119827201338</c:v>
                </c:pt>
                <c:pt idx="586">
                  <c:v>-0.55728754227830779</c:v>
                </c:pt>
                <c:pt idx="587">
                  <c:v>0.89485833967657646</c:v>
                </c:pt>
                <c:pt idx="588">
                  <c:v>0.1669885008416376</c:v>
                </c:pt>
                <c:pt idx="589">
                  <c:v>4.112021410761147E-2</c:v>
                </c:pt>
                <c:pt idx="590">
                  <c:v>0.49309344541930672</c:v>
                </c:pt>
                <c:pt idx="591">
                  <c:v>0.14608417218465469</c:v>
                </c:pt>
                <c:pt idx="592">
                  <c:v>-0.1755565364318401</c:v>
                </c:pt>
                <c:pt idx="593">
                  <c:v>0.2658648628688432</c:v>
                </c:pt>
                <c:pt idx="594">
                  <c:v>-0.48016169934816466</c:v>
                </c:pt>
                <c:pt idx="595">
                  <c:v>0.30882320318787571</c:v>
                </c:pt>
                <c:pt idx="596">
                  <c:v>-9.7745621638518798E-2</c:v>
                </c:pt>
                <c:pt idx="597">
                  <c:v>-0.67671874411843336</c:v>
                </c:pt>
                <c:pt idx="598">
                  <c:v>-0.2509615735332188</c:v>
                </c:pt>
                <c:pt idx="599">
                  <c:v>-1.3700526557159143</c:v>
                </c:pt>
                <c:pt idx="600">
                  <c:v>-0.44010174038750749</c:v>
                </c:pt>
                <c:pt idx="601">
                  <c:v>0.31186441154266487</c:v>
                </c:pt>
                <c:pt idx="602">
                  <c:v>-0.56159497452060714</c:v>
                </c:pt>
                <c:pt idx="603">
                  <c:v>-0.1530270434648234</c:v>
                </c:pt>
                <c:pt idx="604">
                  <c:v>-0.31243283680921863</c:v>
                </c:pt>
                <c:pt idx="605">
                  <c:v>-0.5477459386871435</c:v>
                </c:pt>
                <c:pt idx="606">
                  <c:v>-0.26879367512247893</c:v>
                </c:pt>
                <c:pt idx="607">
                  <c:v>-0.24318160164447206</c:v>
                </c:pt>
                <c:pt idx="608">
                  <c:v>-0.56442694863779375</c:v>
                </c:pt>
                <c:pt idx="609">
                  <c:v>0.1176308441688412</c:v>
                </c:pt>
                <c:pt idx="610">
                  <c:v>2.6645879550056071E-2</c:v>
                </c:pt>
                <c:pt idx="611">
                  <c:v>0.11888359148809841</c:v>
                </c:pt>
                <c:pt idx="612">
                  <c:v>0.17690285265079594</c:v>
                </c:pt>
                <c:pt idx="613">
                  <c:v>-0.44180215462886696</c:v>
                </c:pt>
                <c:pt idx="614">
                  <c:v>0.13844158042797144</c:v>
                </c:pt>
                <c:pt idx="615">
                  <c:v>0.44143846819954291</c:v>
                </c:pt>
                <c:pt idx="616">
                  <c:v>-0.28036248997377788</c:v>
                </c:pt>
                <c:pt idx="617">
                  <c:v>-0.28628975813409691</c:v>
                </c:pt>
                <c:pt idx="618">
                  <c:v>-0.19345636574958544</c:v>
                </c:pt>
                <c:pt idx="619">
                  <c:v>-0.23143240844796514</c:v>
                </c:pt>
                <c:pt idx="620">
                  <c:v>0.21373821488269862</c:v>
                </c:pt>
                <c:pt idx="621">
                  <c:v>2.5323855798431254E-2</c:v>
                </c:pt>
                <c:pt idx="622">
                  <c:v>0.45997273074249279</c:v>
                </c:pt>
                <c:pt idx="623">
                  <c:v>1.3997302464909953</c:v>
                </c:pt>
                <c:pt idx="624">
                  <c:v>8.3446923412606552E-2</c:v>
                </c:pt>
                <c:pt idx="625">
                  <c:v>0.32409376210547691</c:v>
                </c:pt>
                <c:pt idx="626">
                  <c:v>-0.12855736497375747</c:v>
                </c:pt>
                <c:pt idx="627">
                  <c:v>-0.62377323811140895</c:v>
                </c:pt>
                <c:pt idx="628">
                  <c:v>-0.46884394297463755</c:v>
                </c:pt>
                <c:pt idx="629">
                  <c:v>0.14688260877644857</c:v>
                </c:pt>
                <c:pt idx="630">
                  <c:v>0.38138544678884689</c:v>
                </c:pt>
                <c:pt idx="631">
                  <c:v>-0.41294407336871813</c:v>
                </c:pt>
                <c:pt idx="632">
                  <c:v>-8.0111859861598161E-2</c:v>
                </c:pt>
                <c:pt idx="633">
                  <c:v>0.32499708380607312</c:v>
                </c:pt>
                <c:pt idx="634">
                  <c:v>-0.3167250215787496</c:v>
                </c:pt>
                <c:pt idx="635">
                  <c:v>0.20489804187717531</c:v>
                </c:pt>
                <c:pt idx="636">
                  <c:v>0.15649847446317711</c:v>
                </c:pt>
                <c:pt idx="637">
                  <c:v>-7.505336460450733E-2</c:v>
                </c:pt>
                <c:pt idx="638">
                  <c:v>-5.2972274813988661E-2</c:v>
                </c:pt>
                <c:pt idx="639">
                  <c:v>-0.5390347029707544</c:v>
                </c:pt>
                <c:pt idx="640">
                  <c:v>-0.14012422390907064</c:v>
                </c:pt>
                <c:pt idx="641">
                  <c:v>-1.386921282217817</c:v>
                </c:pt>
                <c:pt idx="642">
                  <c:v>6.7182897258149271E-2</c:v>
                </c:pt>
                <c:pt idx="643">
                  <c:v>0.26465112981411459</c:v>
                </c:pt>
                <c:pt idx="644">
                  <c:v>0.10562845003872487</c:v>
                </c:pt>
                <c:pt idx="645">
                  <c:v>-0.42664047750446066</c:v>
                </c:pt>
                <c:pt idx="646">
                  <c:v>-8.2293835951430971E-2</c:v>
                </c:pt>
                <c:pt idx="647">
                  <c:v>6.7938828656575592E-2</c:v>
                </c:pt>
                <c:pt idx="648">
                  <c:v>0.54962011992895887</c:v>
                </c:pt>
                <c:pt idx="649">
                  <c:v>0.20906118622418052</c:v>
                </c:pt>
                <c:pt idx="650">
                  <c:v>-5.6167306300426614E-2</c:v>
                </c:pt>
                <c:pt idx="651">
                  <c:v>-0.59282775478428462</c:v>
                </c:pt>
                <c:pt idx="652">
                  <c:v>0.17266872938773942</c:v>
                </c:pt>
                <c:pt idx="653">
                  <c:v>-9.6261853058403568E-2</c:v>
                </c:pt>
                <c:pt idx="654">
                  <c:v>-0.17107869605868273</c:v>
                </c:pt>
                <c:pt idx="655">
                  <c:v>9.8660017359113825E-2</c:v>
                </c:pt>
                <c:pt idx="656">
                  <c:v>0.70392442504711228</c:v>
                </c:pt>
                <c:pt idx="657">
                  <c:v>8.6201035049303834E-2</c:v>
                </c:pt>
                <c:pt idx="658">
                  <c:v>0.73360322697544633</c:v>
                </c:pt>
                <c:pt idx="659">
                  <c:v>-0.62508341792203381</c:v>
                </c:pt>
                <c:pt idx="660">
                  <c:v>-0.24147412570144142</c:v>
                </c:pt>
                <c:pt idx="661">
                  <c:v>-0.91448798591781144</c:v>
                </c:pt>
                <c:pt idx="662">
                  <c:v>-3.0689204071140435E-2</c:v>
                </c:pt>
                <c:pt idx="663">
                  <c:v>-0.12644429972469101</c:v>
                </c:pt>
                <c:pt idx="664">
                  <c:v>-0.40903785697271844</c:v>
                </c:pt>
                <c:pt idx="665">
                  <c:v>-6.6950243924626979E-2</c:v>
                </c:pt>
                <c:pt idx="666">
                  <c:v>-0.14587306160104477</c:v>
                </c:pt>
                <c:pt idx="667">
                  <c:v>8.7886695175194249E-2</c:v>
                </c:pt>
                <c:pt idx="668">
                  <c:v>-0.30812784417874145</c:v>
                </c:pt>
                <c:pt idx="669">
                  <c:v>0.17185589763437187</c:v>
                </c:pt>
                <c:pt idx="670">
                  <c:v>-1.1209361420303413E-2</c:v>
                </c:pt>
                <c:pt idx="671">
                  <c:v>0.3874115933012825</c:v>
                </c:pt>
                <c:pt idx="672">
                  <c:v>-7.477942649661326E-2</c:v>
                </c:pt>
                <c:pt idx="673">
                  <c:v>-0.26939227894040613</c:v>
                </c:pt>
                <c:pt idx="674">
                  <c:v>-0.28664462101643917</c:v>
                </c:pt>
                <c:pt idx="675">
                  <c:v>-0.31533436033437878</c:v>
                </c:pt>
                <c:pt idx="676">
                  <c:v>-0.16440013502441164</c:v>
                </c:pt>
                <c:pt idx="677">
                  <c:v>-0.25652762689220954</c:v>
                </c:pt>
                <c:pt idx="678">
                  <c:v>7.476009451258947E-2</c:v>
                </c:pt>
                <c:pt idx="679">
                  <c:v>0.24297675349254044</c:v>
                </c:pt>
                <c:pt idx="680">
                  <c:v>-1.1352507229905197E-2</c:v>
                </c:pt>
                <c:pt idx="681">
                  <c:v>3.7562029077011838E-2</c:v>
                </c:pt>
                <c:pt idx="682">
                  <c:v>-0.2847510095342265</c:v>
                </c:pt>
                <c:pt idx="683">
                  <c:v>-0.2903064354249143</c:v>
                </c:pt>
                <c:pt idx="684">
                  <c:v>-0.41629930547987937</c:v>
                </c:pt>
                <c:pt idx="685">
                  <c:v>-0.41748799851366619</c:v>
                </c:pt>
                <c:pt idx="686">
                  <c:v>0.40163479467635543</c:v>
                </c:pt>
                <c:pt idx="687">
                  <c:v>-0.7225534578847046</c:v>
                </c:pt>
                <c:pt idx="688">
                  <c:v>0.26430453640923102</c:v>
                </c:pt>
                <c:pt idx="689">
                  <c:v>-0.52386300882634973</c:v>
                </c:pt>
                <c:pt idx="690">
                  <c:v>0.26309211478961619</c:v>
                </c:pt>
                <c:pt idx="691">
                  <c:v>0.25446146545072973</c:v>
                </c:pt>
                <c:pt idx="692">
                  <c:v>-0.21710660808339191</c:v>
                </c:pt>
                <c:pt idx="693">
                  <c:v>-0.34369206917901884</c:v>
                </c:pt>
                <c:pt idx="694">
                  <c:v>-0.40795091723857285</c:v>
                </c:pt>
                <c:pt idx="695">
                  <c:v>-0.13671638448831194</c:v>
                </c:pt>
                <c:pt idx="696">
                  <c:v>0.34556445915460071</c:v>
                </c:pt>
                <c:pt idx="697">
                  <c:v>-0.75676712406262514</c:v>
                </c:pt>
                <c:pt idx="698">
                  <c:v>-3.4638317999008926E-2</c:v>
                </c:pt>
                <c:pt idx="699">
                  <c:v>-1.5243144702221516</c:v>
                </c:pt>
                <c:pt idx="700">
                  <c:v>0.63576376882600316</c:v>
                </c:pt>
                <c:pt idx="701">
                  <c:v>-0.21586493915324001</c:v>
                </c:pt>
                <c:pt idx="702">
                  <c:v>-0.97438246582073007</c:v>
                </c:pt>
                <c:pt idx="703">
                  <c:v>0.27142639744063529</c:v>
                </c:pt>
                <c:pt idx="704">
                  <c:v>-8.2566351071411803E-2</c:v>
                </c:pt>
                <c:pt idx="705">
                  <c:v>-3.4919984349159564E-2</c:v>
                </c:pt>
                <c:pt idx="706">
                  <c:v>0.37015382103907896</c:v>
                </c:pt>
                <c:pt idx="707">
                  <c:v>-1.0923027184791918E-2</c:v>
                </c:pt>
                <c:pt idx="708">
                  <c:v>0.65426300483595679</c:v>
                </c:pt>
                <c:pt idx="709">
                  <c:v>1.5082594573079778E-2</c:v>
                </c:pt>
                <c:pt idx="710">
                  <c:v>-0.10675031506086764</c:v>
                </c:pt>
                <c:pt idx="711">
                  <c:v>-0.72325273450106764</c:v>
                </c:pt>
                <c:pt idx="712">
                  <c:v>-0.10299399332332571</c:v>
                </c:pt>
                <c:pt idx="713">
                  <c:v>-7.203718077288003E-2</c:v>
                </c:pt>
                <c:pt idx="714">
                  <c:v>0.45107023052360018</c:v>
                </c:pt>
                <c:pt idx="715">
                  <c:v>0.32499708380607312</c:v>
                </c:pt>
                <c:pt idx="716">
                  <c:v>-0.33913738491958523</c:v>
                </c:pt>
                <c:pt idx="717">
                  <c:v>8.5588555718988574E-2</c:v>
                </c:pt>
                <c:pt idx="718">
                  <c:v>-0.75855902704967437</c:v>
                </c:pt>
                <c:pt idx="719">
                  <c:v>8.5129366799652342E-2</c:v>
                </c:pt>
                <c:pt idx="720">
                  <c:v>0.15216340180022239</c:v>
                </c:pt>
                <c:pt idx="721">
                  <c:v>9.4957236909082962E-2</c:v>
                </c:pt>
                <c:pt idx="722">
                  <c:v>-0.26987098323045189</c:v>
                </c:pt>
                <c:pt idx="723">
                  <c:v>-0.32250505751888292</c:v>
                </c:pt>
                <c:pt idx="724">
                  <c:v>0.25291341697218178</c:v>
                </c:pt>
                <c:pt idx="725">
                  <c:v>-7.1350804128843134E-2</c:v>
                </c:pt>
                <c:pt idx="726">
                  <c:v>-0.20964051392760014</c:v>
                </c:pt>
                <c:pt idx="727">
                  <c:v>-8.5288674816987389E-2</c:v>
                </c:pt>
                <c:pt idx="728">
                  <c:v>-0.74260990309458585</c:v>
                </c:pt>
                <c:pt idx="729">
                  <c:v>-9.5856923914830444E-2</c:v>
                </c:pt>
                <c:pt idx="730">
                  <c:v>6.5067789415844826E-3</c:v>
                </c:pt>
                <c:pt idx="731">
                  <c:v>-0.30147058748990174</c:v>
                </c:pt>
                <c:pt idx="732">
                  <c:v>0.20872769222341478</c:v>
                </c:pt>
                <c:pt idx="733">
                  <c:v>3.2536242089729155E-2</c:v>
                </c:pt>
                <c:pt idx="734">
                  <c:v>0.83392732405329395</c:v>
                </c:pt>
                <c:pt idx="735">
                  <c:v>-0.55434326566276404</c:v>
                </c:pt>
                <c:pt idx="736">
                  <c:v>0.45620719446412333</c:v>
                </c:pt>
                <c:pt idx="737">
                  <c:v>0.24827921322495475</c:v>
                </c:pt>
                <c:pt idx="738">
                  <c:v>-8.719124956262303E-2</c:v>
                </c:pt>
                <c:pt idx="739">
                  <c:v>-0.23266075679027501</c:v>
                </c:pt>
                <c:pt idx="740">
                  <c:v>5.0353017350615127E-2</c:v>
                </c:pt>
                <c:pt idx="741">
                  <c:v>0.45363642611456495</c:v>
                </c:pt>
                <c:pt idx="742">
                  <c:v>-0.74708658302781816</c:v>
                </c:pt>
                <c:pt idx="743">
                  <c:v>-0.49733133523027473</c:v>
                </c:pt>
                <c:pt idx="744">
                  <c:v>0.19826189843354244</c:v>
                </c:pt>
                <c:pt idx="745">
                  <c:v>0.17201842735243814</c:v>
                </c:pt>
                <c:pt idx="746">
                  <c:v>0.17185589763437187</c:v>
                </c:pt>
                <c:pt idx="747">
                  <c:v>0.40564254854130716</c:v>
                </c:pt>
                <c:pt idx="748">
                  <c:v>0.13574450858125975</c:v>
                </c:pt>
                <c:pt idx="749">
                  <c:v>-0.26663664251398955</c:v>
                </c:pt>
                <c:pt idx="750">
                  <c:v>-1.7515065686148394</c:v>
                </c:pt>
                <c:pt idx="751">
                  <c:v>-0.24841339205081797</c:v>
                </c:pt>
                <c:pt idx="752">
                  <c:v>-0.50548447951149533</c:v>
                </c:pt>
                <c:pt idx="753">
                  <c:v>-0.58120660883682096</c:v>
                </c:pt>
                <c:pt idx="754">
                  <c:v>7.7193226812113935E-2</c:v>
                </c:pt>
                <c:pt idx="755">
                  <c:v>-0.22761786861065839</c:v>
                </c:pt>
                <c:pt idx="756">
                  <c:v>5.3793170962471965E-2</c:v>
                </c:pt>
                <c:pt idx="757">
                  <c:v>-0.16697247241069541</c:v>
                </c:pt>
                <c:pt idx="758">
                  <c:v>-0.1008431244331118</c:v>
                </c:pt>
                <c:pt idx="759">
                  <c:v>-8.0565548710583943E-3</c:v>
                </c:pt>
                <c:pt idx="760">
                  <c:v>-2.3894042655701012E-2</c:v>
                </c:pt>
                <c:pt idx="761">
                  <c:v>-0.83713591392318309</c:v>
                </c:pt>
                <c:pt idx="762">
                  <c:v>-0.27917410848904672</c:v>
                </c:pt>
                <c:pt idx="763">
                  <c:v>-1.335505866906761E-2</c:v>
                </c:pt>
                <c:pt idx="764">
                  <c:v>0.23395615698730485</c:v>
                </c:pt>
                <c:pt idx="765">
                  <c:v>-0.23817541857737559</c:v>
                </c:pt>
                <c:pt idx="766">
                  <c:v>-8.2293835951430971E-2</c:v>
                </c:pt>
                <c:pt idx="767">
                  <c:v>-0.48398341030057318</c:v>
                </c:pt>
                <c:pt idx="768">
                  <c:v>0.11481613367964895</c:v>
                </c:pt>
                <c:pt idx="769">
                  <c:v>-0.11396714643300215</c:v>
                </c:pt>
                <c:pt idx="770">
                  <c:v>5.0950715977864693E-2</c:v>
                </c:pt>
                <c:pt idx="771">
                  <c:v>0.19050323599911453</c:v>
                </c:pt>
                <c:pt idx="772">
                  <c:v>-1.4426229109457814E-4</c:v>
                </c:pt>
                <c:pt idx="773">
                  <c:v>-6.6261442268721341E-2</c:v>
                </c:pt>
                <c:pt idx="774">
                  <c:v>0.13717174204396412</c:v>
                </c:pt>
                <c:pt idx="775">
                  <c:v>-0.13461524442510853</c:v>
                </c:pt>
                <c:pt idx="776">
                  <c:v>0.65449007574866125</c:v>
                </c:pt>
                <c:pt idx="777">
                  <c:v>-0.79917021719962</c:v>
                </c:pt>
                <c:pt idx="778">
                  <c:v>-0.21909105824619673</c:v>
                </c:pt>
                <c:pt idx="779">
                  <c:v>-6.8877140850307814E-2</c:v>
                </c:pt>
                <c:pt idx="780">
                  <c:v>0.18705004054425084</c:v>
                </c:pt>
                <c:pt idx="781">
                  <c:v>-3.7452509939606603E-2</c:v>
                </c:pt>
                <c:pt idx="782">
                  <c:v>-0.13066733981550696</c:v>
                </c:pt>
                <c:pt idx="783">
                  <c:v>-0.36759472196102894</c:v>
                </c:pt>
                <c:pt idx="784">
                  <c:v>-0.10191895971107164</c:v>
                </c:pt>
                <c:pt idx="785">
                  <c:v>-0.14834844991564905</c:v>
                </c:pt>
                <c:pt idx="786">
                  <c:v>0.4465411903009065</c:v>
                </c:pt>
                <c:pt idx="787">
                  <c:v>0.11653558189767745</c:v>
                </c:pt>
                <c:pt idx="788">
                  <c:v>6.4766575050440187E-2</c:v>
                </c:pt>
                <c:pt idx="789">
                  <c:v>-0.16272565284620316</c:v>
                </c:pt>
                <c:pt idx="790">
                  <c:v>2.4296451992233157E-2</c:v>
                </c:pt>
                <c:pt idx="791">
                  <c:v>-0.37083384817640336</c:v>
                </c:pt>
                <c:pt idx="792">
                  <c:v>0.12910269133497121</c:v>
                </c:pt>
                <c:pt idx="793">
                  <c:v>-0.16208110338237522</c:v>
                </c:pt>
                <c:pt idx="794">
                  <c:v>2.6792845886544278E-2</c:v>
                </c:pt>
                <c:pt idx="795">
                  <c:v>0.54161799584398695</c:v>
                </c:pt>
                <c:pt idx="796">
                  <c:v>-0.69955163252308938</c:v>
                </c:pt>
                <c:pt idx="797">
                  <c:v>-0.11490002395719034</c:v>
                </c:pt>
                <c:pt idx="798">
                  <c:v>0.56810965171381955</c:v>
                </c:pt>
                <c:pt idx="799">
                  <c:v>1.6103455397704802E-2</c:v>
                </c:pt>
                <c:pt idx="800">
                  <c:v>-8.4064264788474632E-2</c:v>
                </c:pt>
                <c:pt idx="801">
                  <c:v>-0.45322782587644728</c:v>
                </c:pt>
                <c:pt idx="802">
                  <c:v>1.4461480318188744</c:v>
                </c:pt>
                <c:pt idx="803">
                  <c:v>-0.1318528459646624</c:v>
                </c:pt>
                <c:pt idx="804">
                  <c:v>-0.32975508574474682</c:v>
                </c:pt>
                <c:pt idx="805">
                  <c:v>-1.4640946881753101E-2</c:v>
                </c:pt>
                <c:pt idx="806">
                  <c:v>-0.82056703348445525</c:v>
                </c:pt>
                <c:pt idx="807">
                  <c:v>-0.7939374881505562</c:v>
                </c:pt>
                <c:pt idx="808">
                  <c:v>-0.19080446812700086</c:v>
                </c:pt>
                <c:pt idx="809">
                  <c:v>-9.0175949790206933E-2</c:v>
                </c:pt>
                <c:pt idx="810">
                  <c:v>0.27753397552890896</c:v>
                </c:pt>
                <c:pt idx="811">
                  <c:v>-0.33285112207215417</c:v>
                </c:pt>
                <c:pt idx="812">
                  <c:v>-0.15471281378215801</c:v>
                </c:pt>
                <c:pt idx="813">
                  <c:v>1.5666131908422642</c:v>
                </c:pt>
                <c:pt idx="814">
                  <c:v>-0.37729036453677728</c:v>
                </c:pt>
                <c:pt idx="815">
                  <c:v>-0.33101723601809663</c:v>
                </c:pt>
                <c:pt idx="816">
                  <c:v>-0.24476530756931317</c:v>
                </c:pt>
                <c:pt idx="817">
                  <c:v>0.39992058820786075</c:v>
                </c:pt>
                <c:pt idx="818">
                  <c:v>-5.4223347337154434E-2</c:v>
                </c:pt>
                <c:pt idx="819">
                  <c:v>2.1365037713555947E-2</c:v>
                </c:pt>
                <c:pt idx="820">
                  <c:v>6.4464819131981876E-2</c:v>
                </c:pt>
                <c:pt idx="821">
                  <c:v>-3.6022366801955379E-3</c:v>
                </c:pt>
                <c:pt idx="822">
                  <c:v>-0.33982150492334245</c:v>
                </c:pt>
                <c:pt idx="823">
                  <c:v>-1.9346088804812044E-2</c:v>
                </c:pt>
                <c:pt idx="824">
                  <c:v>0.32861603726748312</c:v>
                </c:pt>
                <c:pt idx="825">
                  <c:v>-0.16889872002546927</c:v>
                </c:pt>
                <c:pt idx="826">
                  <c:v>-1.0812032604173945</c:v>
                </c:pt>
                <c:pt idx="827">
                  <c:v>0.10345688414410083</c:v>
                </c:pt>
                <c:pt idx="828">
                  <c:v>1.1151741331035669E-2</c:v>
                </c:pt>
                <c:pt idx="829">
                  <c:v>0.3982084161379737</c:v>
                </c:pt>
                <c:pt idx="830">
                  <c:v>-0.52506659207821094</c:v>
                </c:pt>
                <c:pt idx="831">
                  <c:v>-0.34981817197586046</c:v>
                </c:pt>
                <c:pt idx="832">
                  <c:v>-0.64404084292240904</c:v>
                </c:pt>
                <c:pt idx="833">
                  <c:v>0.11044858129598117</c:v>
                </c:pt>
                <c:pt idx="834">
                  <c:v>-0.18497845969333096</c:v>
                </c:pt>
                <c:pt idx="835">
                  <c:v>4.0229844788532691E-2</c:v>
                </c:pt>
                <c:pt idx="836">
                  <c:v>1.0715640252329059E-2</c:v>
                </c:pt>
                <c:pt idx="837">
                  <c:v>-0.38978705373565753</c:v>
                </c:pt>
                <c:pt idx="838">
                  <c:v>0.50123853432814769</c:v>
                </c:pt>
                <c:pt idx="839">
                  <c:v>-0.28332916805164143</c:v>
                </c:pt>
                <c:pt idx="840">
                  <c:v>0.19958668736124274</c:v>
                </c:pt>
                <c:pt idx="841">
                  <c:v>-1.3939652756602428</c:v>
                </c:pt>
                <c:pt idx="842">
                  <c:v>-0.1397314222437436</c:v>
                </c:pt>
                <c:pt idx="843">
                  <c:v>-0.74467778931707385</c:v>
                </c:pt>
                <c:pt idx="844">
                  <c:v>0.71477535453214036</c:v>
                </c:pt>
                <c:pt idx="845">
                  <c:v>9.5533481122112227E-3</c:v>
                </c:pt>
                <c:pt idx="846">
                  <c:v>0.21390553237095675</c:v>
                </c:pt>
                <c:pt idx="847">
                  <c:v>-0.41651550434749357</c:v>
                </c:pt>
                <c:pt idx="848">
                  <c:v>0.5426683745149864</c:v>
                </c:pt>
                <c:pt idx="849">
                  <c:v>-0.3000651367787609</c:v>
                </c:pt>
                <c:pt idx="850">
                  <c:v>0.53763351685560001</c:v>
                </c:pt>
                <c:pt idx="851">
                  <c:v>0.2622267227410604</c:v>
                </c:pt>
                <c:pt idx="852">
                  <c:v>-0.23560453276329887</c:v>
                </c:pt>
                <c:pt idx="853">
                  <c:v>0.28595235122223317</c:v>
                </c:pt>
                <c:pt idx="854">
                  <c:v>0.13352717028415234</c:v>
                </c:pt>
                <c:pt idx="855">
                  <c:v>-0.11862551354424568</c:v>
                </c:pt>
                <c:pt idx="856">
                  <c:v>-0.25193112668858686</c:v>
                </c:pt>
                <c:pt idx="857">
                  <c:v>-0.68068442299448173</c:v>
                </c:pt>
                <c:pt idx="858">
                  <c:v>0.50860863996515782</c:v>
                </c:pt>
                <c:pt idx="859">
                  <c:v>-3.0830430153274472E-2</c:v>
                </c:pt>
                <c:pt idx="860">
                  <c:v>-0.28924428515664252</c:v>
                </c:pt>
                <c:pt idx="861">
                  <c:v>0.23548398620204741</c:v>
                </c:pt>
                <c:pt idx="862">
                  <c:v>-0.47248777146274351</c:v>
                </c:pt>
                <c:pt idx="863">
                  <c:v>-0.30509501066669747</c:v>
                </c:pt>
                <c:pt idx="864">
                  <c:v>0.11107170841543576</c:v>
                </c:pt>
                <c:pt idx="865">
                  <c:v>0.12642300570303716</c:v>
                </c:pt>
                <c:pt idx="866">
                  <c:v>-0.95821164810969039</c:v>
                </c:pt>
                <c:pt idx="867">
                  <c:v>8.5129366799652342E-2</c:v>
                </c:pt>
                <c:pt idx="868">
                  <c:v>-0.11649784050174833</c:v>
                </c:pt>
                <c:pt idx="869">
                  <c:v>0.49797497848230465</c:v>
                </c:pt>
                <c:pt idx="870">
                  <c:v>0.30222618044481386</c:v>
                </c:pt>
                <c:pt idx="871">
                  <c:v>0.11872693857075152</c:v>
                </c:pt>
                <c:pt idx="872">
                  <c:v>-0.44625622988956415</c:v>
                </c:pt>
                <c:pt idx="873">
                  <c:v>-0.37183761733042064</c:v>
                </c:pt>
                <c:pt idx="874">
                  <c:v>-0.16568687702987547</c:v>
                </c:pt>
                <c:pt idx="875">
                  <c:v>-0.69937394977874379</c:v>
                </c:pt>
                <c:pt idx="876">
                  <c:v>0.27404076549081241</c:v>
                </c:pt>
                <c:pt idx="877">
                  <c:v>-0.20664322398339544</c:v>
                </c:pt>
                <c:pt idx="878">
                  <c:v>0.50348651912319764</c:v>
                </c:pt>
                <c:pt idx="879">
                  <c:v>0.64160373804334603</c:v>
                </c:pt>
                <c:pt idx="880">
                  <c:v>-0.2031384971908485</c:v>
                </c:pt>
                <c:pt idx="881">
                  <c:v>1.7983661388303496</c:v>
                </c:pt>
                <c:pt idx="882">
                  <c:v>-0.33502583832169336</c:v>
                </c:pt>
                <c:pt idx="883">
                  <c:v>-2.8993411879548698E-2</c:v>
                </c:pt>
                <c:pt idx="884">
                  <c:v>-6.7087964801146982E-2</c:v>
                </c:pt>
                <c:pt idx="885">
                  <c:v>0.98678788857314881</c:v>
                </c:pt>
                <c:pt idx="886">
                  <c:v>0.83212829197083904</c:v>
                </c:pt>
                <c:pt idx="887">
                  <c:v>-0.39561124850380214</c:v>
                </c:pt>
                <c:pt idx="888">
                  <c:v>-0.47871300244172194</c:v>
                </c:pt>
                <c:pt idx="889">
                  <c:v>-0.19924830684020234</c:v>
                </c:pt>
                <c:pt idx="890">
                  <c:v>-0.33216368795453072</c:v>
                </c:pt>
                <c:pt idx="891">
                  <c:v>0.17739220593975097</c:v>
                </c:pt>
                <c:pt idx="892">
                  <c:v>-1.1209361420303413E-2</c:v>
                </c:pt>
                <c:pt idx="893">
                  <c:v>-0.1260477552059393</c:v>
                </c:pt>
                <c:pt idx="894">
                  <c:v>-7.7516469702095234E-2</c:v>
                </c:pt>
                <c:pt idx="895">
                  <c:v>4.4240841153119458E-2</c:v>
                </c:pt>
                <c:pt idx="896">
                  <c:v>-0.11276684542842838</c:v>
                </c:pt>
                <c:pt idx="897">
                  <c:v>0.35679028242418082</c:v>
                </c:pt>
                <c:pt idx="898">
                  <c:v>0.49940187584853057</c:v>
                </c:pt>
                <c:pt idx="899">
                  <c:v>9.2955525127201497E-2</c:v>
                </c:pt>
                <c:pt idx="900">
                  <c:v>-0.4242771641763054</c:v>
                </c:pt>
                <c:pt idx="901">
                  <c:v>-2.5879273023258945E-2</c:v>
                </c:pt>
                <c:pt idx="902">
                  <c:v>7.8563669193702265E-2</c:v>
                </c:pt>
                <c:pt idx="903">
                  <c:v>0.25102361075378682</c:v>
                </c:pt>
                <c:pt idx="904">
                  <c:v>6.361864568413588E-3</c:v>
                </c:pt>
                <c:pt idx="905">
                  <c:v>0.44634459766710932</c:v>
                </c:pt>
                <c:pt idx="906">
                  <c:v>-0.33479707513388535</c:v>
                </c:pt>
                <c:pt idx="907">
                  <c:v>9.9123533842101277E-2</c:v>
                </c:pt>
                <c:pt idx="908">
                  <c:v>-0.12472515239888854</c:v>
                </c:pt>
                <c:pt idx="909">
                  <c:v>-0.11303366529989152</c:v>
                </c:pt>
                <c:pt idx="910">
                  <c:v>-0.16787170802916093</c:v>
                </c:pt>
                <c:pt idx="911">
                  <c:v>1.086099263176693E-2</c:v>
                </c:pt>
                <c:pt idx="912">
                  <c:v>-0.15730246631897368</c:v>
                </c:pt>
                <c:pt idx="913">
                  <c:v>-0.40042863036469939</c:v>
                </c:pt>
                <c:pt idx="914">
                  <c:v>-0.28959842214018772</c:v>
                </c:pt>
                <c:pt idx="915">
                  <c:v>0.21173191713316278</c:v>
                </c:pt>
                <c:pt idx="916">
                  <c:v>0.30757280191029229</c:v>
                </c:pt>
                <c:pt idx="917">
                  <c:v>-0.34266851820249949</c:v>
                </c:pt>
                <c:pt idx="918">
                  <c:v>-0.10433665981473561</c:v>
                </c:pt>
                <c:pt idx="919">
                  <c:v>-0.20526738223450966</c:v>
                </c:pt>
                <c:pt idx="920">
                  <c:v>0.13463541344276181</c:v>
                </c:pt>
                <c:pt idx="921">
                  <c:v>6.6276302104170848E-2</c:v>
                </c:pt>
                <c:pt idx="922">
                  <c:v>4.0378201520720511E-2</c:v>
                </c:pt>
                <c:pt idx="923">
                  <c:v>0.85673720696138012</c:v>
                </c:pt>
                <c:pt idx="924">
                  <c:v>-0.50029217673416582</c:v>
                </c:pt>
                <c:pt idx="925">
                  <c:v>-0.8239938641713932</c:v>
                </c:pt>
                <c:pt idx="926">
                  <c:v>-0.39319651187040622</c:v>
                </c:pt>
                <c:pt idx="927">
                  <c:v>0.15746359549876118</c:v>
                </c:pt>
                <c:pt idx="928">
                  <c:v>0.28947455766140312</c:v>
                </c:pt>
                <c:pt idx="929">
                  <c:v>0.26655888334687622</c:v>
                </c:pt>
                <c:pt idx="930">
                  <c:v>-0.10205338272918787</c:v>
                </c:pt>
                <c:pt idx="931">
                  <c:v>0.34850049688305257</c:v>
                </c:pt>
                <c:pt idx="932">
                  <c:v>-0.11889125217842655</c:v>
                </c:pt>
                <c:pt idx="933">
                  <c:v>-0.3489122409941996</c:v>
                </c:pt>
                <c:pt idx="934">
                  <c:v>0.38684557156870064</c:v>
                </c:pt>
                <c:pt idx="935">
                  <c:v>-0.3710569683501993</c:v>
                </c:pt>
                <c:pt idx="936">
                  <c:v>0.20622894145577583</c:v>
                </c:pt>
                <c:pt idx="937">
                  <c:v>7.3765709941897729E-3</c:v>
                </c:pt>
                <c:pt idx="938">
                  <c:v>-0.12075005333492554</c:v>
                </c:pt>
                <c:pt idx="939">
                  <c:v>0.32879722345809986</c:v>
                </c:pt>
                <c:pt idx="940">
                  <c:v>-0.32745743429415336</c:v>
                </c:pt>
                <c:pt idx="941">
                  <c:v>-0.73135704978166138</c:v>
                </c:pt>
                <c:pt idx="942">
                  <c:v>-0.47269571251829068</c:v>
                </c:pt>
                <c:pt idx="943">
                  <c:v>-9.0582476362442377E-2</c:v>
                </c:pt>
                <c:pt idx="944">
                  <c:v>-0.17798155631337068</c:v>
                </c:pt>
                <c:pt idx="945">
                  <c:v>0.33770333766328536</c:v>
                </c:pt>
                <c:pt idx="946">
                  <c:v>0.12374828813717702</c:v>
                </c:pt>
                <c:pt idx="947">
                  <c:v>-5.2276765452357779E-2</c:v>
                </c:pt>
                <c:pt idx="948">
                  <c:v>-0.52195527943419995</c:v>
                </c:pt>
                <c:pt idx="949">
                  <c:v>0.14098461520058594</c:v>
                </c:pt>
                <c:pt idx="950">
                  <c:v>0.59771440813000387</c:v>
                </c:pt>
                <c:pt idx="951">
                  <c:v>0.35015464769398952</c:v>
                </c:pt>
                <c:pt idx="952">
                  <c:v>-0.49210955265261275</c:v>
                </c:pt>
                <c:pt idx="953">
                  <c:v>0.25411731109774072</c:v>
                </c:pt>
                <c:pt idx="954">
                  <c:v>-0.34289603673961966</c:v>
                </c:pt>
                <c:pt idx="955">
                  <c:v>-0.35648190225687115</c:v>
                </c:pt>
                <c:pt idx="956">
                  <c:v>-0.23670690199535252</c:v>
                </c:pt>
                <c:pt idx="957">
                  <c:v>0.54035855007138844</c:v>
                </c:pt>
                <c:pt idx="958">
                  <c:v>0.3052534994220934</c:v>
                </c:pt>
                <c:pt idx="959">
                  <c:v>0.55384965987090684</c:v>
                </c:pt>
                <c:pt idx="960">
                  <c:v>2.1072223618601189E-2</c:v>
                </c:pt>
                <c:pt idx="961">
                  <c:v>-0.53615239301918016</c:v>
                </c:pt>
                <c:pt idx="962">
                  <c:v>-0.97826886107380906</c:v>
                </c:pt>
                <c:pt idx="963">
                  <c:v>-0.18865411783672917</c:v>
                </c:pt>
                <c:pt idx="964">
                  <c:v>0.36940814584951637</c:v>
                </c:pt>
                <c:pt idx="965">
                  <c:v>0.49858633312421902</c:v>
                </c:pt>
                <c:pt idx="966">
                  <c:v>-0.18713429147453547</c:v>
                </c:pt>
                <c:pt idx="967">
                  <c:v>-0.11209957977623505</c:v>
                </c:pt>
                <c:pt idx="968">
                  <c:v>-0.4627852625496307</c:v>
                </c:pt>
                <c:pt idx="969">
                  <c:v>0.25532221068292621</c:v>
                </c:pt>
                <c:pt idx="970">
                  <c:v>0.1942948151614888</c:v>
                </c:pt>
                <c:pt idx="971">
                  <c:v>-2.1624211506207792E-3</c:v>
                </c:pt>
                <c:pt idx="972">
                  <c:v>-0.22798745873459306</c:v>
                </c:pt>
                <c:pt idx="973">
                  <c:v>-5.2555009434105307E-2</c:v>
                </c:pt>
                <c:pt idx="974">
                  <c:v>-9.1801369217674303E-2</c:v>
                </c:pt>
                <c:pt idx="975">
                  <c:v>0.22938235334379692</c:v>
                </c:pt>
                <c:pt idx="976">
                  <c:v>2.7380860991847313E-2</c:v>
                </c:pt>
                <c:pt idx="977">
                  <c:v>-0.28688114778816154</c:v>
                </c:pt>
                <c:pt idx="978">
                  <c:v>0.29300538429134892</c:v>
                </c:pt>
                <c:pt idx="979">
                  <c:v>1.9755295146610237E-2</c:v>
                </c:pt>
                <c:pt idx="980">
                  <c:v>-8.0384787414604544E-2</c:v>
                </c:pt>
                <c:pt idx="981">
                  <c:v>-0.30766166918772708</c:v>
                </c:pt>
                <c:pt idx="982">
                  <c:v>-3.7461392328946254E-3</c:v>
                </c:pt>
                <c:pt idx="983">
                  <c:v>0.13036544418660659</c:v>
                </c:pt>
                <c:pt idx="984">
                  <c:v>0.42178583452754564</c:v>
                </c:pt>
                <c:pt idx="985">
                  <c:v>-8.3792032493886531E-2</c:v>
                </c:pt>
                <c:pt idx="986">
                  <c:v>0.16488438474178219</c:v>
                </c:pt>
                <c:pt idx="987">
                  <c:v>0.24742265852373249</c:v>
                </c:pt>
                <c:pt idx="988">
                  <c:v>-1.9929496624808498</c:v>
                </c:pt>
                <c:pt idx="989">
                  <c:v>-0.22404027421793002</c:v>
                </c:pt>
                <c:pt idx="990">
                  <c:v>0.11966711132535983</c:v>
                </c:pt>
                <c:pt idx="991">
                  <c:v>-0.38017531174202518</c:v>
                </c:pt>
                <c:pt idx="992">
                  <c:v>-0.17874650598181621</c:v>
                </c:pt>
                <c:pt idx="993">
                  <c:v>0.13574450858125975</c:v>
                </c:pt>
                <c:pt idx="994">
                  <c:v>-0.41359408240917517</c:v>
                </c:pt>
                <c:pt idx="995">
                  <c:v>-0.31510245307766827</c:v>
                </c:pt>
                <c:pt idx="996">
                  <c:v>0.25136702780870263</c:v>
                </c:pt>
                <c:pt idx="997">
                  <c:v>-0.44530294213651322</c:v>
                </c:pt>
                <c:pt idx="998">
                  <c:v>-0.27453004467162323</c:v>
                </c:pt>
                <c:pt idx="999">
                  <c:v>7.6584558923794607E-2</c:v>
                </c:pt>
                <c:pt idx="1000">
                  <c:v>-4.4603950649767965E-2</c:v>
                </c:pt>
                <c:pt idx="1001">
                  <c:v>-1.606836862765362E-2</c:v>
                </c:pt>
                <c:pt idx="1002">
                  <c:v>-0.71782445448763688</c:v>
                </c:pt>
                <c:pt idx="1003">
                  <c:v>2.885678659263109E-4</c:v>
                </c:pt>
                <c:pt idx="1004">
                  <c:v>-0.60776823469636132</c:v>
                </c:pt>
                <c:pt idx="1005">
                  <c:v>0.53428668040403615</c:v>
                </c:pt>
                <c:pt idx="1006">
                  <c:v>-8.1748651234167885E-2</c:v>
                </c:pt>
                <c:pt idx="1007">
                  <c:v>3.8154450824742697E-2</c:v>
                </c:pt>
                <c:pt idx="1008">
                  <c:v>2.2390355314580345E-2</c:v>
                </c:pt>
                <c:pt idx="1009">
                  <c:v>-0.33101723601809663</c:v>
                </c:pt>
                <c:pt idx="1010">
                  <c:v>-5.7138304393541721E-2</c:v>
                </c:pt>
                <c:pt idx="1011">
                  <c:v>-4.2924445173840885E-2</c:v>
                </c:pt>
                <c:pt idx="1012">
                  <c:v>-0.5285713188707577</c:v>
                </c:pt>
                <c:pt idx="1013">
                  <c:v>0.14066649060373171</c:v>
                </c:pt>
                <c:pt idx="1014">
                  <c:v>-7.0526720876682408E-2</c:v>
                </c:pt>
                <c:pt idx="1015">
                  <c:v>-0.11995371750556842</c:v>
                </c:pt>
                <c:pt idx="1016">
                  <c:v>-0.10581215112923138</c:v>
                </c:pt>
                <c:pt idx="1017">
                  <c:v>-0.74811769328556765</c:v>
                </c:pt>
                <c:pt idx="1018">
                  <c:v>-0.20639316851160394</c:v>
                </c:pt>
                <c:pt idx="1019">
                  <c:v>0.2992052006262787</c:v>
                </c:pt>
                <c:pt idx="1020">
                  <c:v>-0.15120939288489371</c:v>
                </c:pt>
                <c:pt idx="1021">
                  <c:v>0.16084661261017894</c:v>
                </c:pt>
                <c:pt idx="1022">
                  <c:v>-0.16800012451782012</c:v>
                </c:pt>
                <c:pt idx="1023">
                  <c:v>-3.9138393906958314E-2</c:v>
                </c:pt>
                <c:pt idx="1024">
                  <c:v>0.70392442504711228</c:v>
                </c:pt>
                <c:pt idx="1025">
                  <c:v>-0.5633534058553108</c:v>
                </c:pt>
                <c:pt idx="1026">
                  <c:v>8.3905577061641701E-2</c:v>
                </c:pt>
                <c:pt idx="1027">
                  <c:v>-1.6255978060593332</c:v>
                </c:pt>
                <c:pt idx="1028">
                  <c:v>2.8882793248263526E-3</c:v>
                </c:pt>
                <c:pt idx="1029">
                  <c:v>9.6653165017792878E-2</c:v>
                </c:pt>
                <c:pt idx="1030">
                  <c:v>0.14960060322974561</c:v>
                </c:pt>
                <c:pt idx="1031">
                  <c:v>-8.990486842133559E-2</c:v>
                </c:pt>
                <c:pt idx="1032">
                  <c:v>-2.4504992348224289E-3</c:v>
                </c:pt>
                <c:pt idx="1033">
                  <c:v>-0.18548600412807811</c:v>
                </c:pt>
                <c:pt idx="1034">
                  <c:v>0.26291899484690068</c:v>
                </c:pt>
                <c:pt idx="1035">
                  <c:v>-0.29219277390189102</c:v>
                </c:pt>
                <c:pt idx="1036">
                  <c:v>-0.30322547767208885</c:v>
                </c:pt>
                <c:pt idx="1037">
                  <c:v>-0.37651266128847949</c:v>
                </c:pt>
                <c:pt idx="1038">
                  <c:v>9.2629213289680164E-3</c:v>
                </c:pt>
                <c:pt idx="1039">
                  <c:v>-4.2644337408493667E-2</c:v>
                </c:pt>
                <c:pt idx="1040">
                  <c:v>-0.66184079130537121</c:v>
                </c:pt>
                <c:pt idx="1041">
                  <c:v>-4.6092532525896712E-3</c:v>
                </c:pt>
                <c:pt idx="1042">
                  <c:v>-7.2448850069692455E-2</c:v>
                </c:pt>
                <c:pt idx="1043">
                  <c:v>0.15264443377163267</c:v>
                </c:pt>
                <c:pt idx="1044">
                  <c:v>-0.67906341716002283</c:v>
                </c:pt>
                <c:pt idx="1045">
                  <c:v>0.26067032398441692</c:v>
                </c:pt>
                <c:pt idx="1046">
                  <c:v>-0.14795788138710136</c:v>
                </c:pt>
                <c:pt idx="1047">
                  <c:v>7.2152791745922601E-4</c:v>
                </c:pt>
                <c:pt idx="1048">
                  <c:v>-4.1383179019406177E-2</c:v>
                </c:pt>
                <c:pt idx="1049">
                  <c:v>-0.20776793757217066</c:v>
                </c:pt>
                <c:pt idx="1050">
                  <c:v>-0.54665990644083451</c:v>
                </c:pt>
                <c:pt idx="1051">
                  <c:v>-0.27011027582361774</c:v>
                </c:pt>
                <c:pt idx="1052">
                  <c:v>-1.5806761441892663</c:v>
                </c:pt>
                <c:pt idx="1053">
                  <c:v>0.10299197355168209</c:v>
                </c:pt>
                <c:pt idx="1054">
                  <c:v>0.1313132346778651</c:v>
                </c:pt>
                <c:pt idx="1055">
                  <c:v>-0.52777098875335271</c:v>
                </c:pt>
                <c:pt idx="1056">
                  <c:v>0.13289427049734517</c:v>
                </c:pt>
                <c:pt idx="1057">
                  <c:v>-9.8823768379691521E-2</c:v>
                </c:pt>
                <c:pt idx="1058">
                  <c:v>-0.12763327972587377</c:v>
                </c:pt>
                <c:pt idx="1059">
                  <c:v>-6.7363367119610246E-2</c:v>
                </c:pt>
                <c:pt idx="1060">
                  <c:v>0.13336891930599901</c:v>
                </c:pt>
                <c:pt idx="1061">
                  <c:v>0.45028154932812764</c:v>
                </c:pt>
                <c:pt idx="1062">
                  <c:v>-0.44254545610530421</c:v>
                </c:pt>
                <c:pt idx="1063">
                  <c:v>-0.53485845140071864</c:v>
                </c:pt>
                <c:pt idx="1064">
                  <c:v>-4.8933645197922371E-2</c:v>
                </c:pt>
                <c:pt idx="1065">
                  <c:v>-0.11063050809643449</c:v>
                </c:pt>
                <c:pt idx="1066">
                  <c:v>-6.6812509899901784E-2</c:v>
                </c:pt>
                <c:pt idx="1067">
                  <c:v>-3.1395196275534373E-2</c:v>
                </c:pt>
                <c:pt idx="1068">
                  <c:v>-0.50263611720246493</c:v>
                </c:pt>
                <c:pt idx="1069">
                  <c:v>-0.19811692915245538</c:v>
                </c:pt>
                <c:pt idx="1070">
                  <c:v>-8.5560624872625474E-2</c:v>
                </c:pt>
                <c:pt idx="1071">
                  <c:v>-0.17376706773670642</c:v>
                </c:pt>
                <c:pt idx="1072">
                  <c:v>-0.44158971241954637</c:v>
                </c:pt>
                <c:pt idx="1073">
                  <c:v>0.34483138239040839</c:v>
                </c:pt>
                <c:pt idx="1074">
                  <c:v>-0.18840092460321006</c:v>
                </c:pt>
                <c:pt idx="1075">
                  <c:v>-0.53814080907495765</c:v>
                </c:pt>
                <c:pt idx="1076">
                  <c:v>0.25102361075378682</c:v>
                </c:pt>
                <c:pt idx="1077">
                  <c:v>-0.2121335075337562</c:v>
                </c:pt>
                <c:pt idx="1078">
                  <c:v>0.11825708185241855</c:v>
                </c:pt>
                <c:pt idx="1079">
                  <c:v>0.42371974237864468</c:v>
                </c:pt>
                <c:pt idx="1080">
                  <c:v>-3.4074820270572174E-2</c:v>
                </c:pt>
                <c:pt idx="1081">
                  <c:v>-0.49036474998590879</c:v>
                </c:pt>
                <c:pt idx="1082">
                  <c:v>0.21977390311338596</c:v>
                </c:pt>
                <c:pt idx="1083">
                  <c:v>-5.8662839378559907E-2</c:v>
                </c:pt>
                <c:pt idx="1084">
                  <c:v>-0.12379860846262174</c:v>
                </c:pt>
                <c:pt idx="1085">
                  <c:v>-0.34414674773333037</c:v>
                </c:pt>
                <c:pt idx="1086">
                  <c:v>-0.18561286234235091</c:v>
                </c:pt>
                <c:pt idx="1087">
                  <c:v>3.8895320270947185E-2</c:v>
                </c:pt>
                <c:pt idx="1088">
                  <c:v>-0.20439116292978024</c:v>
                </c:pt>
                <c:pt idx="1089">
                  <c:v>1.9901561182208809E-2</c:v>
                </c:pt>
                <c:pt idx="1090">
                  <c:v>0.69292126146018485</c:v>
                </c:pt>
                <c:pt idx="1091">
                  <c:v>-0.4229864505667168</c:v>
                </c:pt>
                <c:pt idx="1092">
                  <c:v>0.28718414556262828</c:v>
                </c:pt>
                <c:pt idx="1093">
                  <c:v>0.16634075359048739</c:v>
                </c:pt>
                <c:pt idx="1094">
                  <c:v>-0.42266359165502176</c:v>
                </c:pt>
                <c:pt idx="1095">
                  <c:v>-2.8710585954140166E-2</c:v>
                </c:pt>
                <c:pt idx="1096">
                  <c:v>-0.18116617426997683</c:v>
                </c:pt>
                <c:pt idx="1097">
                  <c:v>0.56682687595572445</c:v>
                </c:pt>
                <c:pt idx="1098">
                  <c:v>0.20223992036816649</c:v>
                </c:pt>
                <c:pt idx="1099">
                  <c:v>-0.21063822838015026</c:v>
                </c:pt>
                <c:pt idx="1100">
                  <c:v>0.40316024556221525</c:v>
                </c:pt>
                <c:pt idx="1101">
                  <c:v>-0.30975827142463519</c:v>
                </c:pt>
                <c:pt idx="1102">
                  <c:v>-0.18650055764449472</c:v>
                </c:pt>
                <c:pt idx="1103">
                  <c:v>-0.16104922490055679</c:v>
                </c:pt>
                <c:pt idx="1104">
                  <c:v>8.5741651176328634E-2</c:v>
                </c:pt>
                <c:pt idx="1105">
                  <c:v>-0.98761192257842578</c:v>
                </c:pt>
                <c:pt idx="1106">
                  <c:v>0.24759392878461964</c:v>
                </c:pt>
                <c:pt idx="1107">
                  <c:v>0.19528556376919445</c:v>
                </c:pt>
                <c:pt idx="1108">
                  <c:v>-6.2259894470126059E-2</c:v>
                </c:pt>
                <c:pt idx="1109">
                  <c:v>-0.31161936340684354</c:v>
                </c:pt>
                <c:pt idx="1110">
                  <c:v>0.15537331533019214</c:v>
                </c:pt>
                <c:pt idx="1111">
                  <c:v>2.0779468942091643E-2</c:v>
                </c:pt>
                <c:pt idx="1112">
                  <c:v>-0.35940871904276978</c:v>
                </c:pt>
                <c:pt idx="1113">
                  <c:v>-0.48810363312357652</c:v>
                </c:pt>
                <c:pt idx="1114">
                  <c:v>-0.40130279234911409</c:v>
                </c:pt>
                <c:pt idx="1115">
                  <c:v>0.27753397552890896</c:v>
                </c:pt>
                <c:pt idx="1116">
                  <c:v>8.5129366799652342E-2</c:v>
                </c:pt>
                <c:pt idx="1117">
                  <c:v>-0.59473962233268618</c:v>
                </c:pt>
                <c:pt idx="1118">
                  <c:v>7.5064011733197183E-2</c:v>
                </c:pt>
                <c:pt idx="1119">
                  <c:v>1.8001258406667432E-2</c:v>
                </c:pt>
                <c:pt idx="1120">
                  <c:v>-0.18637377746594402</c:v>
                </c:pt>
                <c:pt idx="1121">
                  <c:v>0.60911224044999068</c:v>
                </c:pt>
                <c:pt idx="1122">
                  <c:v>-0.12088273324865219</c:v>
                </c:pt>
                <c:pt idx="1123">
                  <c:v>-2.9982866215714284E-2</c:v>
                </c:pt>
                <c:pt idx="1124">
                  <c:v>-4.30644786649374E-2</c:v>
                </c:pt>
                <c:pt idx="1125">
                  <c:v>-8.8955682308218459E-2</c:v>
                </c:pt>
                <c:pt idx="1126">
                  <c:v>-1.6496319896195929E-2</c:v>
                </c:pt>
                <c:pt idx="1127">
                  <c:v>0.55894153000678604</c:v>
                </c:pt>
                <c:pt idx="1128">
                  <c:v>0.50185127378984906</c:v>
                </c:pt>
                <c:pt idx="1129">
                  <c:v>0.49086158428228954</c:v>
                </c:pt>
                <c:pt idx="1130">
                  <c:v>-0.45291166493996404</c:v>
                </c:pt>
                <c:pt idx="1131">
                  <c:v>0.16100790670625945</c:v>
                </c:pt>
                <c:pt idx="1132">
                  <c:v>0.16909569019794135</c:v>
                </c:pt>
                <c:pt idx="1133">
                  <c:v>-5.7696263152059448E-4</c:v>
                </c:pt>
                <c:pt idx="1134">
                  <c:v>0.22347484857808797</c:v>
                </c:pt>
                <c:pt idx="1135">
                  <c:v>-0.53455968460831615</c:v>
                </c:pt>
                <c:pt idx="1136">
                  <c:v>-9.6936482502957139E-2</c:v>
                </c:pt>
                <c:pt idx="1137">
                  <c:v>0.29902769277728358</c:v>
                </c:pt>
                <c:pt idx="1138">
                  <c:v>-0.41316077559081371</c:v>
                </c:pt>
                <c:pt idx="1139">
                  <c:v>1.9462807554956881E-2</c:v>
                </c:pt>
                <c:pt idx="1140">
                  <c:v>0.25050863839747517</c:v>
                </c:pt>
                <c:pt idx="1141">
                  <c:v>-2.9334026772635435</c:v>
                </c:pt>
                <c:pt idx="1142">
                  <c:v>-0.47123949533824133</c:v>
                </c:pt>
                <c:pt idx="1143">
                  <c:v>-0.16825692320858163</c:v>
                </c:pt>
                <c:pt idx="1144">
                  <c:v>2.3416402123002722E-2</c:v>
                </c:pt>
                <c:pt idx="1145">
                  <c:v>-0.25156762060824689</c:v>
                </c:pt>
                <c:pt idx="1146">
                  <c:v>8.0545498166160925E-2</c:v>
                </c:pt>
                <c:pt idx="1147">
                  <c:v>0.1067154599697278</c:v>
                </c:pt>
                <c:pt idx="1148">
                  <c:v>-0.19899696624010862</c:v>
                </c:pt>
                <c:pt idx="1149">
                  <c:v>-0.68338205848670064</c:v>
                </c:pt>
                <c:pt idx="1150">
                  <c:v>-0.34743888876814133</c:v>
                </c:pt>
                <c:pt idx="1151">
                  <c:v>-4.327436039712134E-4</c:v>
                </c:pt>
                <c:pt idx="1152">
                  <c:v>-0.20175930745822906</c:v>
                </c:pt>
                <c:pt idx="1153">
                  <c:v>-0.38769339625331289</c:v>
                </c:pt>
                <c:pt idx="1154">
                  <c:v>-0.35253255667289635</c:v>
                </c:pt>
                <c:pt idx="1155">
                  <c:v>-0.12855736497375747</c:v>
                </c:pt>
                <c:pt idx="1156">
                  <c:v>0.16068533654485087</c:v>
                </c:pt>
                <c:pt idx="1157">
                  <c:v>-0.13079911083819429</c:v>
                </c:pt>
                <c:pt idx="1158">
                  <c:v>-0.32492578405532108</c:v>
                </c:pt>
                <c:pt idx="1159">
                  <c:v>-0.19232043503449914</c:v>
                </c:pt>
                <c:pt idx="1160">
                  <c:v>0.42546247869793652</c:v>
                </c:pt>
                <c:pt idx="1161">
                  <c:v>0.13178736352286949</c:v>
                </c:pt>
                <c:pt idx="1162">
                  <c:v>-0.29678041742642514</c:v>
                </c:pt>
                <c:pt idx="1163">
                  <c:v>-5.1302488700631102E-2</c:v>
                </c:pt>
                <c:pt idx="1164">
                  <c:v>0.48559996096338387</c:v>
                </c:pt>
                <c:pt idx="1165">
                  <c:v>0.65426300483595679</c:v>
                </c:pt>
                <c:pt idx="1166">
                  <c:v>3.2683809730719861E-2</c:v>
                </c:pt>
                <c:pt idx="1167">
                  <c:v>0.11263070472111801</c:v>
                </c:pt>
                <c:pt idx="1168">
                  <c:v>0.42507502199065555</c:v>
                </c:pt>
                <c:pt idx="1169">
                  <c:v>-0.23364268300880972</c:v>
                </c:pt>
                <c:pt idx="1170">
                  <c:v>0.66131887537545375</c:v>
                </c:pt>
                <c:pt idx="1171">
                  <c:v>-0.40871186102942875</c:v>
                </c:pt>
                <c:pt idx="1172">
                  <c:v>0.10097909042058302</c:v>
                </c:pt>
                <c:pt idx="1173">
                  <c:v>-5.7970068637329869E-2</c:v>
                </c:pt>
                <c:pt idx="1174">
                  <c:v>0.34117157565634615</c:v>
                </c:pt>
                <c:pt idx="1175">
                  <c:v>0.259115602482341</c:v>
                </c:pt>
                <c:pt idx="1176">
                  <c:v>-0.32273577798009562</c:v>
                </c:pt>
                <c:pt idx="1177">
                  <c:v>-0.32111995936539328</c:v>
                </c:pt>
                <c:pt idx="1178">
                  <c:v>-0.50120982441116935</c:v>
                </c:pt>
                <c:pt idx="1179">
                  <c:v>-0.5849625007211563</c:v>
                </c:pt>
                <c:pt idx="1180">
                  <c:v>-0.20476675065461344</c:v>
                </c:pt>
                <c:pt idx="1181">
                  <c:v>-0.17223146882548127</c:v>
                </c:pt>
                <c:pt idx="1182">
                  <c:v>0.58900771277910513</c:v>
                </c:pt>
                <c:pt idx="1183">
                  <c:v>6.1902438925906932E-2</c:v>
                </c:pt>
                <c:pt idx="1184">
                  <c:v>-0.4822287461103808</c:v>
                </c:pt>
                <c:pt idx="1185">
                  <c:v>-0.32250505751888292</c:v>
                </c:pt>
                <c:pt idx="1186">
                  <c:v>-0.43092751740486862</c:v>
                </c:pt>
                <c:pt idx="1187">
                  <c:v>-0.10097764772482096</c:v>
                </c:pt>
                <c:pt idx="1188">
                  <c:v>-0.20489192483723392</c:v>
                </c:pt>
                <c:pt idx="1189">
                  <c:v>6.205304125819975E-2</c:v>
                </c:pt>
                <c:pt idx="1190">
                  <c:v>0.11419138752248358</c:v>
                </c:pt>
                <c:pt idx="1191">
                  <c:v>0.19743452269205608</c:v>
                </c:pt>
                <c:pt idx="1192">
                  <c:v>-9.6936482502957139E-2</c:v>
                </c:pt>
                <c:pt idx="1193">
                  <c:v>7.7954422968056145E-2</c:v>
                </c:pt>
                <c:pt idx="1194">
                  <c:v>0.3677317845004871</c:v>
                </c:pt>
                <c:pt idx="1195">
                  <c:v>-0.3740657182225377</c:v>
                </c:pt>
                <c:pt idx="1196">
                  <c:v>0.57755168776653554</c:v>
                </c:pt>
                <c:pt idx="1197">
                  <c:v>-0.21859520155085688</c:v>
                </c:pt>
                <c:pt idx="1198">
                  <c:v>-0.18637377746594402</c:v>
                </c:pt>
                <c:pt idx="1199">
                  <c:v>-0.69215934617677655</c:v>
                </c:pt>
                <c:pt idx="1200">
                  <c:v>0.12579321412220129</c:v>
                </c:pt>
                <c:pt idx="1201">
                  <c:v>-0.33353822878821682</c:v>
                </c:pt>
                <c:pt idx="1202">
                  <c:v>0.50819820040594876</c:v>
                </c:pt>
                <c:pt idx="1203">
                  <c:v>4.6325015550512945E-2</c:v>
                </c:pt>
                <c:pt idx="1204">
                  <c:v>2.8557610682609712E-2</c:v>
                </c:pt>
                <c:pt idx="1205">
                  <c:v>-0.8902521151570687</c:v>
                </c:pt>
                <c:pt idx="1206">
                  <c:v>-0.2121335075337562</c:v>
                </c:pt>
                <c:pt idx="1207">
                  <c:v>-0.22404027421793002</c:v>
                </c:pt>
                <c:pt idx="1208">
                  <c:v>-0.41153471496007032</c:v>
                </c:pt>
                <c:pt idx="1209">
                  <c:v>-1.3925921956661522</c:v>
                </c:pt>
                <c:pt idx="1210">
                  <c:v>0.21089678249861854</c:v>
                </c:pt>
                <c:pt idx="1211">
                  <c:v>0.28560060306959728</c:v>
                </c:pt>
                <c:pt idx="1212">
                  <c:v>0.34923544088309766</c:v>
                </c:pt>
                <c:pt idx="1213">
                  <c:v>-6.6950243924626979E-2</c:v>
                </c:pt>
                <c:pt idx="1214">
                  <c:v>1.1733414573826711E-2</c:v>
                </c:pt>
                <c:pt idx="1215">
                  <c:v>-0.10111215847415045</c:v>
                </c:pt>
                <c:pt idx="1216">
                  <c:v>6.8695156349330835E-2</c:v>
                </c:pt>
                <c:pt idx="1217">
                  <c:v>6.1601281417060651E-2</c:v>
                </c:pt>
                <c:pt idx="1218">
                  <c:v>-0.10285965792205642</c:v>
                </c:pt>
                <c:pt idx="1219">
                  <c:v>-0.91540616895016536</c:v>
                </c:pt>
                <c:pt idx="1220">
                  <c:v>7.4608159907542576E-2</c:v>
                </c:pt>
                <c:pt idx="1221">
                  <c:v>0.29530506420095126</c:v>
                </c:pt>
                <c:pt idx="1222">
                  <c:v>-0.68463923089119061</c:v>
                </c:pt>
                <c:pt idx="1223">
                  <c:v>-0.55277052443906483</c:v>
                </c:pt>
                <c:pt idx="1224">
                  <c:v>0.40851206160205689</c:v>
                </c:pt>
                <c:pt idx="1225">
                  <c:v>-0.12934896721084113</c:v>
                </c:pt>
                <c:pt idx="1226">
                  <c:v>-0.35817117496955442</c:v>
                </c:pt>
                <c:pt idx="1227">
                  <c:v>-0.3333092295748965</c:v>
                </c:pt>
                <c:pt idx="1228">
                  <c:v>-0.14339341869318778</c:v>
                </c:pt>
                <c:pt idx="1229">
                  <c:v>-0.12008647067252552</c:v>
                </c:pt>
                <c:pt idx="1230">
                  <c:v>-0.10634831950514675</c:v>
                </c:pt>
                <c:pt idx="1231">
                  <c:v>0.10749239737925748</c:v>
                </c:pt>
                <c:pt idx="1232">
                  <c:v>-0.14535138557262012</c:v>
                </c:pt>
                <c:pt idx="1233">
                  <c:v>0.33989283352942157</c:v>
                </c:pt>
                <c:pt idx="1234">
                  <c:v>-0.13053555675618828</c:v>
                </c:pt>
                <c:pt idx="1235">
                  <c:v>0.16617886220941772</c:v>
                </c:pt>
                <c:pt idx="1236">
                  <c:v>-1.4212444812104782E-2</c:v>
                </c:pt>
                <c:pt idx="1237">
                  <c:v>-0.66712005980658218</c:v>
                </c:pt>
                <c:pt idx="1238">
                  <c:v>-0.39429462049465752</c:v>
                </c:pt>
                <c:pt idx="1239">
                  <c:v>-5.6999630385563695E-2</c:v>
                </c:pt>
                <c:pt idx="1240">
                  <c:v>-1.034145269524237</c:v>
                </c:pt>
                <c:pt idx="1241">
                  <c:v>-0.65818862799586142</c:v>
                </c:pt>
                <c:pt idx="1242">
                  <c:v>0.31186441154266487</c:v>
                </c:pt>
                <c:pt idx="1243">
                  <c:v>-0.36535659703048007</c:v>
                </c:pt>
                <c:pt idx="1244">
                  <c:v>-0.55286887101130289</c:v>
                </c:pt>
                <c:pt idx="1245">
                  <c:v>-0.37784561029696562</c:v>
                </c:pt>
                <c:pt idx="1246">
                  <c:v>0.6720827425813517</c:v>
                </c:pt>
                <c:pt idx="1247">
                  <c:v>-9.6531742693628672E-2</c:v>
                </c:pt>
                <c:pt idx="1248">
                  <c:v>0.20956157181479923</c:v>
                </c:pt>
                <c:pt idx="1249">
                  <c:v>-0.23658445811317524</c:v>
                </c:pt>
                <c:pt idx="1250">
                  <c:v>0.8677522017015602</c:v>
                </c:pt>
                <c:pt idx="1251">
                  <c:v>6.205304125819975E-2</c:v>
                </c:pt>
                <c:pt idx="1252">
                  <c:v>0.22718531250080645</c:v>
                </c:pt>
                <c:pt idx="1253">
                  <c:v>0.48580197665241942</c:v>
                </c:pt>
                <c:pt idx="1254">
                  <c:v>-0.20789285164133287</c:v>
                </c:pt>
                <c:pt idx="1255">
                  <c:v>-0.22897256976016078</c:v>
                </c:pt>
                <c:pt idx="1256">
                  <c:v>-0.2081426473377217</c:v>
                </c:pt>
                <c:pt idx="1257">
                  <c:v>-0.13881446890228194</c:v>
                </c:pt>
                <c:pt idx="1258">
                  <c:v>-0.24354722657759406</c:v>
                </c:pt>
                <c:pt idx="1259">
                  <c:v>0.50021787985268817</c:v>
                </c:pt>
                <c:pt idx="1260">
                  <c:v>-9.193673821058522E-2</c:v>
                </c:pt>
                <c:pt idx="1261">
                  <c:v>1.2870081105382027</c:v>
                </c:pt>
                <c:pt idx="1262">
                  <c:v>-0.11569915343158639</c:v>
                </c:pt>
                <c:pt idx="1263">
                  <c:v>-5.672224237454028E-2</c:v>
                </c:pt>
                <c:pt idx="1264">
                  <c:v>4.3645915354631533E-2</c:v>
                </c:pt>
                <c:pt idx="1265">
                  <c:v>-0.34834574511348082</c:v>
                </c:pt>
                <c:pt idx="1266">
                  <c:v>-0.43765387834619252</c:v>
                </c:pt>
                <c:pt idx="1267">
                  <c:v>-0.15665548884685973</c:v>
                </c:pt>
                <c:pt idx="1268">
                  <c:v>6.9416094188469403E-3</c:v>
                </c:pt>
                <c:pt idx="1269">
                  <c:v>-9.0988888414772262E-2</c:v>
                </c:pt>
                <c:pt idx="1270">
                  <c:v>-0.63691458035587789</c:v>
                </c:pt>
                <c:pt idx="1271">
                  <c:v>-0.15820774762573619</c:v>
                </c:pt>
                <c:pt idx="1272">
                  <c:v>0.22162318909167705</c:v>
                </c:pt>
                <c:pt idx="1273">
                  <c:v>-2.0911065581689935E-2</c:v>
                </c:pt>
                <c:pt idx="1274">
                  <c:v>-0.29007046960154059</c:v>
                </c:pt>
                <c:pt idx="1275">
                  <c:v>-0.36725922448866971</c:v>
                </c:pt>
                <c:pt idx="1276">
                  <c:v>-0.54270379224348964</c:v>
                </c:pt>
                <c:pt idx="1277">
                  <c:v>-0.25035527176304762</c:v>
                </c:pt>
                <c:pt idx="1278">
                  <c:v>-7.6422275458602432E-2</c:v>
                </c:pt>
                <c:pt idx="1279">
                  <c:v>6.3559929885785335E-2</c:v>
                </c:pt>
                <c:pt idx="1280">
                  <c:v>-4.8096653272943955E-2</c:v>
                </c:pt>
                <c:pt idx="1281">
                  <c:v>0.27142639744063529</c:v>
                </c:pt>
                <c:pt idx="1282">
                  <c:v>-5.6155674069098558E-3</c:v>
                </c:pt>
                <c:pt idx="1283">
                  <c:v>4.6623000688593728E-2</c:v>
                </c:pt>
                <c:pt idx="1284">
                  <c:v>-0.60748419301389078</c:v>
                </c:pt>
                <c:pt idx="1285">
                  <c:v>-0.16104922490055679</c:v>
                </c:pt>
                <c:pt idx="1286">
                  <c:v>0.2747387311749091</c:v>
                </c:pt>
                <c:pt idx="1287">
                  <c:v>0.44438014333187215</c:v>
                </c:pt>
                <c:pt idx="1288">
                  <c:v>0.18803582468980623</c:v>
                </c:pt>
                <c:pt idx="1289">
                  <c:v>-0.80107585916745738</c:v>
                </c:pt>
                <c:pt idx="1290">
                  <c:v>-0.49896565434120294</c:v>
                </c:pt>
                <c:pt idx="1291">
                  <c:v>-0.22119654994454649</c:v>
                </c:pt>
                <c:pt idx="1292">
                  <c:v>-0.37484474128973438</c:v>
                </c:pt>
                <c:pt idx="1293">
                  <c:v>0.57389629931495101</c:v>
                </c:pt>
                <c:pt idx="1294">
                  <c:v>-0.139862368015641</c:v>
                </c:pt>
                <c:pt idx="1295">
                  <c:v>-0.20851725980554395</c:v>
                </c:pt>
                <c:pt idx="1296">
                  <c:v>-0.36625226369956393</c:v>
                </c:pt>
                <c:pt idx="1297">
                  <c:v>5.1847728467419155E-2</c:v>
                </c:pt>
                <c:pt idx="1298">
                  <c:v>-0.15432396466047718</c:v>
                </c:pt>
                <c:pt idx="1299">
                  <c:v>2.7233834745515082E-2</c:v>
                </c:pt>
                <c:pt idx="1300">
                  <c:v>-0.50406100130929288</c:v>
                </c:pt>
                <c:pt idx="1301">
                  <c:v>-9.7206245974365821E-2</c:v>
                </c:pt>
                <c:pt idx="1302">
                  <c:v>0.61440330398775445</c:v>
                </c:pt>
                <c:pt idx="1303">
                  <c:v>0.34978689468641871</c:v>
                </c:pt>
                <c:pt idx="1304">
                  <c:v>-0.40621010853156514</c:v>
                </c:pt>
                <c:pt idx="1305">
                  <c:v>-0.32123543501606444</c:v>
                </c:pt>
                <c:pt idx="1306">
                  <c:v>0.68803194896828357</c:v>
                </c:pt>
                <c:pt idx="1307">
                  <c:v>-2.9417546835091686E-2</c:v>
                </c:pt>
                <c:pt idx="1308">
                  <c:v>-0.17402284205541382</c:v>
                </c:pt>
                <c:pt idx="1309">
                  <c:v>-0.6466235084765829</c:v>
                </c:pt>
                <c:pt idx="1310">
                  <c:v>0.25050863839747517</c:v>
                </c:pt>
                <c:pt idx="1311">
                  <c:v>0.11684842913752182</c:v>
                </c:pt>
                <c:pt idx="1312">
                  <c:v>0.13495221077405009</c:v>
                </c:pt>
                <c:pt idx="1313">
                  <c:v>0.15424903302601112</c:v>
                </c:pt>
                <c:pt idx="1314">
                  <c:v>-0.1476974436138713</c:v>
                </c:pt>
                <c:pt idx="1315">
                  <c:v>-0.36019569473235824</c:v>
                </c:pt>
                <c:pt idx="1316">
                  <c:v>-0.35659458199613175</c:v>
                </c:pt>
                <c:pt idx="1317">
                  <c:v>0.53993897902265864</c:v>
                </c:pt>
                <c:pt idx="1318">
                  <c:v>0.18557262613875175</c:v>
                </c:pt>
                <c:pt idx="1319">
                  <c:v>0.51066259111061818</c:v>
                </c:pt>
                <c:pt idx="1320">
                  <c:v>-0.26987098323045189</c:v>
                </c:pt>
                <c:pt idx="1321">
                  <c:v>0.55660552516141582</c:v>
                </c:pt>
                <c:pt idx="1322">
                  <c:v>-0.35275852504063676</c:v>
                </c:pt>
                <c:pt idx="1323">
                  <c:v>-0.48439596250266631</c:v>
                </c:pt>
                <c:pt idx="1324">
                  <c:v>0.36717342996566277</c:v>
                </c:pt>
                <c:pt idx="1325">
                  <c:v>-0.53913399033467568</c:v>
                </c:pt>
                <c:pt idx="1326">
                  <c:v>-3.1959741397545004E-2</c:v>
                </c:pt>
                <c:pt idx="1327">
                  <c:v>-0.20801775489589236</c:v>
                </c:pt>
                <c:pt idx="1328">
                  <c:v>0.56896546964838579</c:v>
                </c:pt>
                <c:pt idx="1329">
                  <c:v>8.9420824457239437E-2</c:v>
                </c:pt>
                <c:pt idx="1330">
                  <c:v>-0.26627682332247754</c:v>
                </c:pt>
                <c:pt idx="1331">
                  <c:v>-1.153870174848552</c:v>
                </c:pt>
                <c:pt idx="1332">
                  <c:v>-0.23499174124880234</c:v>
                </c:pt>
                <c:pt idx="1333">
                  <c:v>-0.41316077559081371</c:v>
                </c:pt>
                <c:pt idx="1334">
                  <c:v>0.29265191251673028</c:v>
                </c:pt>
                <c:pt idx="1335">
                  <c:v>-0.14704614341731542</c:v>
                </c:pt>
                <c:pt idx="1336">
                  <c:v>-0.70487196445635292</c:v>
                </c:pt>
                <c:pt idx="1337">
                  <c:v>-6.5434445948633138E-2</c:v>
                </c:pt>
                <c:pt idx="1338">
                  <c:v>-0.30917618747851455</c:v>
                </c:pt>
                <c:pt idx="1339">
                  <c:v>-0.27250102132206599</c:v>
                </c:pt>
                <c:pt idx="1340">
                  <c:v>-0.49549051051493925</c:v>
                </c:pt>
                <c:pt idx="1341">
                  <c:v>-0.26627682332247754</c:v>
                </c:pt>
                <c:pt idx="1342">
                  <c:v>-6.7914014088466382E-2</c:v>
                </c:pt>
                <c:pt idx="1343">
                  <c:v>-5.9770581090254661E-2</c:v>
                </c:pt>
                <c:pt idx="1344">
                  <c:v>0.59771440813000387</c:v>
                </c:pt>
                <c:pt idx="1345">
                  <c:v>0.36903545273432331</c:v>
                </c:pt>
                <c:pt idx="1346">
                  <c:v>2.1218623237265526E-2</c:v>
                </c:pt>
                <c:pt idx="1347">
                  <c:v>1.2165852546011395</c:v>
                </c:pt>
                <c:pt idx="1348">
                  <c:v>-0.44530294213651322</c:v>
                </c:pt>
                <c:pt idx="1349">
                  <c:v>-0.34743888876814133</c:v>
                </c:pt>
                <c:pt idx="1350">
                  <c:v>-0.58746100737793827</c:v>
                </c:pt>
                <c:pt idx="1351">
                  <c:v>-0.17836408184680327</c:v>
                </c:pt>
                <c:pt idx="1352">
                  <c:v>-6.8189258778968032E-2</c:v>
                </c:pt>
                <c:pt idx="1353">
                  <c:v>-0.43861223210088557</c:v>
                </c:pt>
                <c:pt idx="1354">
                  <c:v>-0.9057359776670264</c:v>
                </c:pt>
                <c:pt idx="1355">
                  <c:v>-0.49241724007585758</c:v>
                </c:pt>
                <c:pt idx="1356">
                  <c:v>-0.40555676334375684</c:v>
                </c:pt>
                <c:pt idx="1357">
                  <c:v>-0.27166471097723405</c:v>
                </c:pt>
                <c:pt idx="1358">
                  <c:v>0.45245146092196087</c:v>
                </c:pt>
                <c:pt idx="1359">
                  <c:v>-6.46069752973919E-2</c:v>
                </c:pt>
                <c:pt idx="1360">
                  <c:v>0.36308541964412222</c:v>
                </c:pt>
                <c:pt idx="1361">
                  <c:v>-0.19421315631120692</c:v>
                </c:pt>
                <c:pt idx="1362">
                  <c:v>-8.7462841250339429E-2</c:v>
                </c:pt>
                <c:pt idx="1363">
                  <c:v>0.54645608245731347</c:v>
                </c:pt>
                <c:pt idx="1364">
                  <c:v>0.48499408356627061</c:v>
                </c:pt>
                <c:pt idx="1365">
                  <c:v>0.99251742366879381</c:v>
                </c:pt>
                <c:pt idx="1366">
                  <c:v>-7.8473209378693634E-2</c:v>
                </c:pt>
                <c:pt idx="1367">
                  <c:v>-0.35985847200125282</c:v>
                </c:pt>
                <c:pt idx="1368">
                  <c:v>0.14816102715065588</c:v>
                </c:pt>
                <c:pt idx="1369">
                  <c:v>-0.26579692475975242</c:v>
                </c:pt>
                <c:pt idx="1370">
                  <c:v>-0.40304952889652457</c:v>
                </c:pt>
                <c:pt idx="1371">
                  <c:v>-0.14665522211946508</c:v>
                </c:pt>
                <c:pt idx="1372">
                  <c:v>-0.48717760838914792</c:v>
                </c:pt>
                <c:pt idx="1373">
                  <c:v>-0.12802938874064099</c:v>
                </c:pt>
                <c:pt idx="1374">
                  <c:v>0.70698272795049166</c:v>
                </c:pt>
                <c:pt idx="1375">
                  <c:v>-0.56696124231448874</c:v>
                </c:pt>
                <c:pt idx="1376">
                  <c:v>0.16974467583231712</c:v>
                </c:pt>
                <c:pt idx="1377">
                  <c:v>-0.380507819339446</c:v>
                </c:pt>
                <c:pt idx="1378">
                  <c:v>0.58835682396098599</c:v>
                </c:pt>
                <c:pt idx="1379">
                  <c:v>-0.57975942741254338</c:v>
                </c:pt>
                <c:pt idx="1380">
                  <c:v>0.10531802614492047</c:v>
                </c:pt>
                <c:pt idx="1381">
                  <c:v>5.7823525940061777E-3</c:v>
                </c:pt>
                <c:pt idx="1382">
                  <c:v>0.10221745533858326</c:v>
                </c:pt>
                <c:pt idx="1383">
                  <c:v>0.21290191838899544</c:v>
                </c:pt>
                <c:pt idx="1384">
                  <c:v>0.11606643820239743</c:v>
                </c:pt>
                <c:pt idx="1385">
                  <c:v>0.21273471724829851</c:v>
                </c:pt>
                <c:pt idx="1386">
                  <c:v>-0.30812784417874145</c:v>
                </c:pt>
                <c:pt idx="1387">
                  <c:v>-0.17963843493813234</c:v>
                </c:pt>
                <c:pt idx="1388">
                  <c:v>5.2030733086129953E-3</c:v>
                </c:pt>
                <c:pt idx="1389">
                  <c:v>0.14066649060373171</c:v>
                </c:pt>
                <c:pt idx="1390">
                  <c:v>-7.3957299943324423E-2</c:v>
                </c:pt>
                <c:pt idx="1391">
                  <c:v>-2.7012465062581596E-2</c:v>
                </c:pt>
                <c:pt idx="1392">
                  <c:v>0.68223286148778017</c:v>
                </c:pt>
                <c:pt idx="1393">
                  <c:v>-0.13277423327632584</c:v>
                </c:pt>
                <c:pt idx="1394">
                  <c:v>-8.4744620868467999E-2</c:v>
                </c:pt>
                <c:pt idx="1395">
                  <c:v>-9.7771216115299722E-3</c:v>
                </c:pt>
                <c:pt idx="1396">
                  <c:v>-9.4641454115062237E-2</c:v>
                </c:pt>
                <c:pt idx="1397">
                  <c:v>0.2465666120731195</c:v>
                </c:pt>
                <c:pt idx="1398">
                  <c:v>-0.59712589936766203</c:v>
                </c:pt>
                <c:pt idx="1399">
                  <c:v>-0.37962096205570822</c:v>
                </c:pt>
                <c:pt idx="1400">
                  <c:v>-4.1663531729361478E-2</c:v>
                </c:pt>
                <c:pt idx="1401">
                  <c:v>-0.14678554098870059</c:v>
                </c:pt>
                <c:pt idx="1402">
                  <c:v>0.43362319967887536</c:v>
                </c:pt>
                <c:pt idx="1403">
                  <c:v>-0.44805516771718756</c:v>
                </c:pt>
                <c:pt idx="1404">
                  <c:v>0.17984146526983541</c:v>
                </c:pt>
                <c:pt idx="1405">
                  <c:v>0.29583628054603461</c:v>
                </c:pt>
                <c:pt idx="1406">
                  <c:v>6.651707872430219E-3</c:v>
                </c:pt>
                <c:pt idx="1407">
                  <c:v>-0.50589092972995731</c:v>
                </c:pt>
                <c:pt idx="1408">
                  <c:v>-0.30392683648069463</c:v>
                </c:pt>
                <c:pt idx="1409">
                  <c:v>-2.61626544896757E-2</c:v>
                </c:pt>
                <c:pt idx="1410">
                  <c:v>-0.23339726410188322</c:v>
                </c:pt>
                <c:pt idx="1411">
                  <c:v>-8.3247413747936178E-2</c:v>
                </c:pt>
                <c:pt idx="1412">
                  <c:v>-0.12419577158719186</c:v>
                </c:pt>
                <c:pt idx="1413">
                  <c:v>-0.1202192116249943</c:v>
                </c:pt>
                <c:pt idx="1414">
                  <c:v>-7.6695901830382954E-2</c:v>
                </c:pt>
                <c:pt idx="1415">
                  <c:v>0.18442457113742758</c:v>
                </c:pt>
                <c:pt idx="1416">
                  <c:v>-0.10487337672601837</c:v>
                </c:pt>
                <c:pt idx="1417">
                  <c:v>-0.14652489147744246</c:v>
                </c:pt>
                <c:pt idx="1418">
                  <c:v>-0.20363969401398505</c:v>
                </c:pt>
                <c:pt idx="1419">
                  <c:v>-0.17530103390024357</c:v>
                </c:pt>
                <c:pt idx="1420">
                  <c:v>0.17088110365073933</c:v>
                </c:pt>
                <c:pt idx="1421">
                  <c:v>0.58922474099175781</c:v>
                </c:pt>
                <c:pt idx="1422">
                  <c:v>-0.31092173523034372</c:v>
                </c:pt>
                <c:pt idx="1423">
                  <c:v>-9.0853430451113534E-2</c:v>
                </c:pt>
                <c:pt idx="1424">
                  <c:v>8.5435476506060551E-2</c:v>
                </c:pt>
                <c:pt idx="1425">
                  <c:v>-0.40838579140641373</c:v>
                </c:pt>
                <c:pt idx="1426">
                  <c:v>-0.62143066779044787</c:v>
                </c:pt>
                <c:pt idx="1427">
                  <c:v>6.039727964395631E-2</c:v>
                </c:pt>
                <c:pt idx="1428">
                  <c:v>-0.19118360922003902</c:v>
                </c:pt>
                <c:pt idx="1429">
                  <c:v>-1.4640946881753101E-2</c:v>
                </c:pt>
                <c:pt idx="1430">
                  <c:v>-0.20801775489589236</c:v>
                </c:pt>
                <c:pt idx="1431">
                  <c:v>-0.30345930182833641</c:v>
                </c:pt>
                <c:pt idx="1432">
                  <c:v>-0.29042440386529972</c:v>
                </c:pt>
                <c:pt idx="1433">
                  <c:v>-0.21933892269846675</c:v>
                </c:pt>
                <c:pt idx="1434">
                  <c:v>-0.53605290024020968</c:v>
                </c:pt>
                <c:pt idx="1435">
                  <c:v>-0.49876146567185226</c:v>
                </c:pt>
                <c:pt idx="1436">
                  <c:v>0.46056818856516701</c:v>
                </c:pt>
                <c:pt idx="1437">
                  <c:v>-0.47092725747512665</c:v>
                </c:pt>
                <c:pt idx="1438">
                  <c:v>-0.37673490499852191</c:v>
                </c:pt>
                <c:pt idx="1439">
                  <c:v>-4.2644337408493667E-2</c:v>
                </c:pt>
                <c:pt idx="1440">
                  <c:v>0.51230786004546791</c:v>
                </c:pt>
                <c:pt idx="1441">
                  <c:v>0.65131433066561262</c:v>
                </c:pt>
                <c:pt idx="1442">
                  <c:v>-9.4371210592517171E-2</c:v>
                </c:pt>
                <c:pt idx="1443">
                  <c:v>-1.0764906869170352</c:v>
                </c:pt>
                <c:pt idx="1444">
                  <c:v>-0.21424917025451382</c:v>
                </c:pt>
                <c:pt idx="1445">
                  <c:v>0.33642766458247736</c:v>
                </c:pt>
                <c:pt idx="1446">
                  <c:v>0.15778544603905603</c:v>
                </c:pt>
                <c:pt idx="1447">
                  <c:v>-0.19572554751205631</c:v>
                </c:pt>
                <c:pt idx="1448">
                  <c:v>-3.9559557255705827E-2</c:v>
                </c:pt>
                <c:pt idx="1449">
                  <c:v>-0.57191946324555709</c:v>
                </c:pt>
                <c:pt idx="1450">
                  <c:v>0.4779442508390358</c:v>
                </c:pt>
                <c:pt idx="1451">
                  <c:v>-0.29313501904332101</c:v>
                </c:pt>
                <c:pt idx="1452">
                  <c:v>0.6434054180038683</c:v>
                </c:pt>
                <c:pt idx="1453">
                  <c:v>0.18033181650354443</c:v>
                </c:pt>
                <c:pt idx="1454">
                  <c:v>0.33369787182690513</c:v>
                </c:pt>
                <c:pt idx="1455">
                  <c:v>-0.36546858577813091</c:v>
                </c:pt>
                <c:pt idx="1456">
                  <c:v>0.18245859984856638</c:v>
                </c:pt>
                <c:pt idx="1457">
                  <c:v>0.742989381793976</c:v>
                </c:pt>
                <c:pt idx="1458">
                  <c:v>-0.10259094958809112</c:v>
                </c:pt>
                <c:pt idx="1459">
                  <c:v>0.73312352787181201</c:v>
                </c:pt>
                <c:pt idx="1460">
                  <c:v>-0.1837088168754118</c:v>
                </c:pt>
                <c:pt idx="1461">
                  <c:v>-0.56764279220306924</c:v>
                </c:pt>
                <c:pt idx="1462">
                  <c:v>-0.11862551354424568</c:v>
                </c:pt>
                <c:pt idx="1463">
                  <c:v>0.33660983454810717</c:v>
                </c:pt>
                <c:pt idx="1464">
                  <c:v>-0.66875453321504263</c:v>
                </c:pt>
                <c:pt idx="1465">
                  <c:v>-8.9170947360530575E-3</c:v>
                </c:pt>
                <c:pt idx="1466">
                  <c:v>0.34336634541161559</c:v>
                </c:pt>
                <c:pt idx="1467">
                  <c:v>-9.3424959419102865E-2</c:v>
                </c:pt>
                <c:pt idx="1468">
                  <c:v>0.10376690779220253</c:v>
                </c:pt>
                <c:pt idx="1469">
                  <c:v>0.20972840558669803</c:v>
                </c:pt>
                <c:pt idx="1470">
                  <c:v>-0.17159115323160118</c:v>
                </c:pt>
                <c:pt idx="1471">
                  <c:v>0.29548211458356155</c:v>
                </c:pt>
                <c:pt idx="1472">
                  <c:v>-0.3967075213839758</c:v>
                </c:pt>
                <c:pt idx="1473">
                  <c:v>-0.20689323612177138</c:v>
                </c:pt>
                <c:pt idx="1474">
                  <c:v>-3.210084316702403E-2</c:v>
                </c:pt>
                <c:pt idx="1475">
                  <c:v>0.2679479266997109</c:v>
                </c:pt>
                <c:pt idx="1476">
                  <c:v>-0.597793350242805</c:v>
                </c:pt>
                <c:pt idx="1477">
                  <c:v>0.15698095427623157</c:v>
                </c:pt>
                <c:pt idx="1478">
                  <c:v>0.16084661261017894</c:v>
                </c:pt>
                <c:pt idx="1479">
                  <c:v>-0.27560307933684935</c:v>
                </c:pt>
                <c:pt idx="1480">
                  <c:v>-0.59110490506477886</c:v>
                </c:pt>
                <c:pt idx="1481">
                  <c:v>1.2968993003958402</c:v>
                </c:pt>
                <c:pt idx="1482">
                  <c:v>0.76733924320972491</c:v>
                </c:pt>
                <c:pt idx="1483">
                  <c:v>0.22516024017267372</c:v>
                </c:pt>
                <c:pt idx="1484">
                  <c:v>-0.52646950464083098</c:v>
                </c:pt>
                <c:pt idx="1485">
                  <c:v>-3.3508649460172708</c:v>
                </c:pt>
                <c:pt idx="1486">
                  <c:v>1.027086823481222</c:v>
                </c:pt>
                <c:pt idx="1487">
                  <c:v>0.14864072625429028</c:v>
                </c:pt>
                <c:pt idx="1488">
                  <c:v>-0.26675656230466488</c:v>
                </c:pt>
                <c:pt idx="1489">
                  <c:v>-0.45932669154601946</c:v>
                </c:pt>
                <c:pt idx="1490">
                  <c:v>-0.12829340100981748</c:v>
                </c:pt>
                <c:pt idx="1491">
                  <c:v>-0.16568687702987547</c:v>
                </c:pt>
                <c:pt idx="1492">
                  <c:v>-0.20050435344652129</c:v>
                </c:pt>
                <c:pt idx="1493">
                  <c:v>-0.44127099043859908</c:v>
                </c:pt>
                <c:pt idx="1494">
                  <c:v>0.19793089119545182</c:v>
                </c:pt>
                <c:pt idx="1495">
                  <c:v>0.6449837357804501</c:v>
                </c:pt>
                <c:pt idx="1496">
                  <c:v>0.12705307233206631</c:v>
                </c:pt>
                <c:pt idx="1497">
                  <c:v>-4.9630767724600434E-2</c:v>
                </c:pt>
                <c:pt idx="1498">
                  <c:v>-0.67201793526453191</c:v>
                </c:pt>
                <c:pt idx="1499">
                  <c:v>-0.52034681151940121</c:v>
                </c:pt>
                <c:pt idx="1500">
                  <c:v>-0.16298339202346537</c:v>
                </c:pt>
                <c:pt idx="1501">
                  <c:v>-0.10594621190532467</c:v>
                </c:pt>
                <c:pt idx="1502">
                  <c:v>-0.72813820341892777</c:v>
                </c:pt>
                <c:pt idx="1503">
                  <c:v>-0.3290661744506907</c:v>
                </c:pt>
                <c:pt idx="1504">
                  <c:v>-0.59817461214800716</c:v>
                </c:pt>
                <c:pt idx="1505">
                  <c:v>3.5194771787161482E-2</c:v>
                </c:pt>
                <c:pt idx="1506">
                  <c:v>0.57303755224144748</c:v>
                </c:pt>
                <c:pt idx="1507">
                  <c:v>-0.62049257357644116</c:v>
                </c:pt>
                <c:pt idx="1508">
                  <c:v>-0.15846629512479551</c:v>
                </c:pt>
                <c:pt idx="1509">
                  <c:v>0.58207999218803463</c:v>
                </c:pt>
                <c:pt idx="1510">
                  <c:v>-0.65837145590649626</c:v>
                </c:pt>
                <c:pt idx="1511">
                  <c:v>-0.21623755205382328</c:v>
                </c:pt>
                <c:pt idx="1512">
                  <c:v>-0.26122990898704573</c:v>
                </c:pt>
                <c:pt idx="1513">
                  <c:v>-0.49569516262406882</c:v>
                </c:pt>
                <c:pt idx="1514">
                  <c:v>-0.50436615061227197</c:v>
                </c:pt>
                <c:pt idx="1515">
                  <c:v>-0.22687840419626876</c:v>
                </c:pt>
                <c:pt idx="1516">
                  <c:v>-0.16375633339790882</c:v>
                </c:pt>
                <c:pt idx="1517">
                  <c:v>3.4603563894085393E-2</c:v>
                </c:pt>
                <c:pt idx="1518">
                  <c:v>-0.32986987231765924</c:v>
                </c:pt>
                <c:pt idx="1519">
                  <c:v>-0.21350281998391657</c:v>
                </c:pt>
                <c:pt idx="1520">
                  <c:v>0.46394709975979032</c:v>
                </c:pt>
                <c:pt idx="1521">
                  <c:v>-0.25386828044171939</c:v>
                </c:pt>
                <c:pt idx="1522">
                  <c:v>0.19264507794239583</c:v>
                </c:pt>
                <c:pt idx="1523">
                  <c:v>0.4018253878519929</c:v>
                </c:pt>
                <c:pt idx="1524">
                  <c:v>-0.11569915343158639</c:v>
                </c:pt>
                <c:pt idx="1525">
                  <c:v>-9.0853430451113534E-2</c:v>
                </c:pt>
                <c:pt idx="1526">
                  <c:v>-0.45649077158337947</c:v>
                </c:pt>
                <c:pt idx="1527">
                  <c:v>-0.38427089254241481</c:v>
                </c:pt>
                <c:pt idx="1528">
                  <c:v>0.33278908751912917</c:v>
                </c:pt>
                <c:pt idx="1529">
                  <c:v>-0.27929299069758412</c:v>
                </c:pt>
                <c:pt idx="1530">
                  <c:v>-0.37651266128847949</c:v>
                </c:pt>
                <c:pt idx="1531">
                  <c:v>-0.1549719883163839</c:v>
                </c:pt>
                <c:pt idx="1532">
                  <c:v>-0.27607972757473248</c:v>
                </c:pt>
                <c:pt idx="1533">
                  <c:v>-0.6344074020398196</c:v>
                </c:pt>
                <c:pt idx="1534">
                  <c:v>-0.38548625891333682</c:v>
                </c:pt>
                <c:pt idx="1535">
                  <c:v>-5.561215668669247E-2</c:v>
                </c:pt>
                <c:pt idx="1536">
                  <c:v>0.43498781910177542</c:v>
                </c:pt>
                <c:pt idx="1537">
                  <c:v>0.4204336398397876</c:v>
                </c:pt>
                <c:pt idx="1538">
                  <c:v>0.58186403604050352</c:v>
                </c:pt>
                <c:pt idx="1539">
                  <c:v>-0.37939916252557832</c:v>
                </c:pt>
                <c:pt idx="1540">
                  <c:v>-0.36591645385806104</c:v>
                </c:pt>
                <c:pt idx="1541">
                  <c:v>-0.26159098896412519</c:v>
                </c:pt>
                <c:pt idx="1542">
                  <c:v>0.30436245187299177</c:v>
                </c:pt>
                <c:pt idx="1543">
                  <c:v>-0.37128005402265407</c:v>
                </c:pt>
                <c:pt idx="1544">
                  <c:v>9.326330007042502E-2</c:v>
                </c:pt>
                <c:pt idx="1545">
                  <c:v>-0.20501708816016748</c:v>
                </c:pt>
                <c:pt idx="1546">
                  <c:v>0.39668818939995176</c:v>
                </c:pt>
                <c:pt idx="1547">
                  <c:v>7.3848726800103251E-2</c:v>
                </c:pt>
                <c:pt idx="1548">
                  <c:v>-0.45301705961735977</c:v>
                </c:pt>
                <c:pt idx="1549">
                  <c:v>2.1072223618601189E-2</c:v>
                </c:pt>
                <c:pt idx="1550">
                  <c:v>-9.8419557765544508E-2</c:v>
                </c:pt>
                <c:pt idx="1551">
                  <c:v>-0.811306611469781</c:v>
                </c:pt>
                <c:pt idx="1552">
                  <c:v>0.42468766931256319</c:v>
                </c:pt>
                <c:pt idx="1553">
                  <c:v>1.0733932587486834</c:v>
                </c:pt>
                <c:pt idx="1554">
                  <c:v>-0.39198762621980016</c:v>
                </c:pt>
                <c:pt idx="1555">
                  <c:v>5.7541796053609713E-2</c:v>
                </c:pt>
                <c:pt idx="1556">
                  <c:v>-0.27703255187479348</c:v>
                </c:pt>
                <c:pt idx="1557">
                  <c:v>0.76709369899316959</c:v>
                </c:pt>
                <c:pt idx="1558">
                  <c:v>-6.9839625068634462E-2</c:v>
                </c:pt>
                <c:pt idx="1559">
                  <c:v>-0.69117679681212429</c:v>
                </c:pt>
                <c:pt idx="1560">
                  <c:v>-0.538538163629804</c:v>
                </c:pt>
                <c:pt idx="1561">
                  <c:v>-1.4544917772233135</c:v>
                </c:pt>
                <c:pt idx="1562">
                  <c:v>0.14178023372893375</c:v>
                </c:pt>
                <c:pt idx="1563">
                  <c:v>-0.3256166748216045</c:v>
                </c:pt>
                <c:pt idx="1564">
                  <c:v>0.17543578791017275</c:v>
                </c:pt>
                <c:pt idx="1565">
                  <c:v>-0.12591554947472297</c:v>
                </c:pt>
                <c:pt idx="1566">
                  <c:v>-0.12644429972469101</c:v>
                </c:pt>
                <c:pt idx="1567">
                  <c:v>-0.25168879947866307</c:v>
                </c:pt>
                <c:pt idx="1568">
                  <c:v>-0.24061962931175984</c:v>
                </c:pt>
                <c:pt idx="1569">
                  <c:v>-2.3264222961010628</c:v>
                </c:pt>
                <c:pt idx="1570">
                  <c:v>-0.20539251298968492</c:v>
                </c:pt>
                <c:pt idx="1571">
                  <c:v>-0.1947174628935997</c:v>
                </c:pt>
                <c:pt idx="1572">
                  <c:v>0.30454061736144161</c:v>
                </c:pt>
                <c:pt idx="1573">
                  <c:v>-3.1395196275534373E-2</c:v>
                </c:pt>
                <c:pt idx="1574">
                  <c:v>0.21340363810919336</c:v>
                </c:pt>
                <c:pt idx="1575">
                  <c:v>-0.45154083301783193</c:v>
                </c:pt>
                <c:pt idx="1576">
                  <c:v>0.22296961479919358</c:v>
                </c:pt>
                <c:pt idx="1577">
                  <c:v>0.29565918669681107</c:v>
                </c:pt>
                <c:pt idx="1578">
                  <c:v>4.617604605883343E-2</c:v>
                </c:pt>
                <c:pt idx="1579">
                  <c:v>-0.43839931960922279</c:v>
                </c:pt>
                <c:pt idx="1580">
                  <c:v>2.2243836750407465E-2</c:v>
                </c:pt>
                <c:pt idx="1581">
                  <c:v>1.004913520865917</c:v>
                </c:pt>
                <c:pt idx="1582">
                  <c:v>0.71311885221183857</c:v>
                </c:pt>
                <c:pt idx="1583">
                  <c:v>-0.41164317603901396</c:v>
                </c:pt>
                <c:pt idx="1584">
                  <c:v>-0.10178452416693225</c:v>
                </c:pt>
                <c:pt idx="1585">
                  <c:v>0.18278607574167338</c:v>
                </c:pt>
                <c:pt idx="1586">
                  <c:v>-0.19181528970689815</c:v>
                </c:pt>
                <c:pt idx="1587">
                  <c:v>0.24742265852373249</c:v>
                </c:pt>
                <c:pt idx="1588">
                  <c:v>0.14688260877644857</c:v>
                </c:pt>
                <c:pt idx="1589">
                  <c:v>-0.19622932579422089</c:v>
                </c:pt>
                <c:pt idx="1590">
                  <c:v>0.15537331533019214</c:v>
                </c:pt>
                <c:pt idx="1591">
                  <c:v>-0.60017458578965965</c:v>
                </c:pt>
                <c:pt idx="1592">
                  <c:v>0.25050863839747517</c:v>
                </c:pt>
                <c:pt idx="1593">
                  <c:v>-0.849118566553276</c:v>
                </c:pt>
                <c:pt idx="1594">
                  <c:v>-0.72430101432258498</c:v>
                </c:pt>
                <c:pt idx="1595">
                  <c:v>-0.21710660808339191</c:v>
                </c:pt>
                <c:pt idx="1596">
                  <c:v>9.9890979390996667E-3</c:v>
                </c:pt>
                <c:pt idx="1597">
                  <c:v>-8.990486842133559E-2</c:v>
                </c:pt>
                <c:pt idx="1598">
                  <c:v>-0.19711051471269642</c:v>
                </c:pt>
                <c:pt idx="1599">
                  <c:v>-0.20776793757217066</c:v>
                </c:pt>
                <c:pt idx="1600">
                  <c:v>0.45462464112744078</c:v>
                </c:pt>
                <c:pt idx="1601">
                  <c:v>-0.17568427073099727</c:v>
                </c:pt>
                <c:pt idx="1602">
                  <c:v>-0.68535712356801248</c:v>
                </c:pt>
                <c:pt idx="1603">
                  <c:v>-0.20964051392760014</c:v>
                </c:pt>
                <c:pt idx="1604">
                  <c:v>0.1120069040235217</c:v>
                </c:pt>
                <c:pt idx="1605">
                  <c:v>-0.12829340100981748</c:v>
                </c:pt>
                <c:pt idx="1606">
                  <c:v>0.36419918324104011</c:v>
                </c:pt>
                <c:pt idx="1607">
                  <c:v>7.066346599311131E-2</c:v>
                </c:pt>
                <c:pt idx="1608">
                  <c:v>-0.11436702495200027</c:v>
                </c:pt>
                <c:pt idx="1609">
                  <c:v>0.37426193809135228</c:v>
                </c:pt>
                <c:pt idx="1610">
                  <c:v>0.21240037308900628</c:v>
                </c:pt>
                <c:pt idx="1611">
                  <c:v>0.5045094894850608</c:v>
                </c:pt>
                <c:pt idx="1612">
                  <c:v>6.1601281417060651E-2</c:v>
                </c:pt>
                <c:pt idx="1613">
                  <c:v>0.19264507794239583</c:v>
                </c:pt>
                <c:pt idx="1614">
                  <c:v>-0.42061713897869074</c:v>
                </c:pt>
                <c:pt idx="1615">
                  <c:v>7.7193226812113935E-2</c:v>
                </c:pt>
                <c:pt idx="1616">
                  <c:v>-0.15276751926176871</c:v>
                </c:pt>
                <c:pt idx="1617">
                  <c:v>-0.41608307420835816</c:v>
                </c:pt>
                <c:pt idx="1618">
                  <c:v>-0.4581719895925897</c:v>
                </c:pt>
                <c:pt idx="1619">
                  <c:v>7.5215994355501276E-2</c:v>
                </c:pt>
                <c:pt idx="1620">
                  <c:v>-0.44031440180311804</c:v>
                </c:pt>
                <c:pt idx="1621">
                  <c:v>2.5177039023166908E-2</c:v>
                </c:pt>
                <c:pt idx="1622">
                  <c:v>-0.28794503864451887</c:v>
                </c:pt>
                <c:pt idx="1623">
                  <c:v>-2.0295588974491166</c:v>
                </c:pt>
                <c:pt idx="1624">
                  <c:v>1.170718702002469</c:v>
                </c:pt>
                <c:pt idx="1625">
                  <c:v>0.38854430341512686</c:v>
                </c:pt>
                <c:pt idx="1626">
                  <c:v>-0.19307782154636699</c:v>
                </c:pt>
                <c:pt idx="1627">
                  <c:v>0.16262184024619328</c:v>
                </c:pt>
                <c:pt idx="1628">
                  <c:v>-0.20539251298968492</c:v>
                </c:pt>
                <c:pt idx="1629">
                  <c:v>-0.18320064672542757</c:v>
                </c:pt>
                <c:pt idx="1630">
                  <c:v>-0.37194910413862786</c:v>
                </c:pt>
                <c:pt idx="1631">
                  <c:v>0.41196302812939373</c:v>
                </c:pt>
                <c:pt idx="1632">
                  <c:v>8.5894762881528211E-2</c:v>
                </c:pt>
                <c:pt idx="1633">
                  <c:v>-0.45701636270030366</c:v>
                </c:pt>
                <c:pt idx="1634">
                  <c:v>-0.25483588278576313</c:v>
                </c:pt>
                <c:pt idx="1635">
                  <c:v>0.45600928033515004</c:v>
                </c:pt>
                <c:pt idx="1636">
                  <c:v>-0.44137723892271336</c:v>
                </c:pt>
                <c:pt idx="1637">
                  <c:v>0.34409867793540644</c:v>
                </c:pt>
                <c:pt idx="1638">
                  <c:v>-0.24659050290518095</c:v>
                </c:pt>
                <c:pt idx="1639">
                  <c:v>0.13622009620412245</c:v>
                </c:pt>
                <c:pt idx="1640">
                  <c:v>0.79560883707021979</c:v>
                </c:pt>
                <c:pt idx="1641">
                  <c:v>-0.31010740909605777</c:v>
                </c:pt>
                <c:pt idx="1642">
                  <c:v>0.10454225850731687</c:v>
                </c:pt>
                <c:pt idx="1643">
                  <c:v>-0.25519856641968952</c:v>
                </c:pt>
                <c:pt idx="1644">
                  <c:v>0.39782820924662077</c:v>
                </c:pt>
                <c:pt idx="1645">
                  <c:v>-6.2398063798478474E-2</c:v>
                </c:pt>
                <c:pt idx="1646">
                  <c:v>-0.33582622394049627</c:v>
                </c:pt>
                <c:pt idx="1647">
                  <c:v>0.59161420859358627</c:v>
                </c:pt>
                <c:pt idx="1648">
                  <c:v>-0.2281106344051814</c:v>
                </c:pt>
                <c:pt idx="1649">
                  <c:v>-0.66184079130537121</c:v>
                </c:pt>
                <c:pt idx="1650">
                  <c:v>-0.71026092987810552</c:v>
                </c:pt>
                <c:pt idx="1651">
                  <c:v>-7.3683153616439886E-2</c:v>
                </c:pt>
                <c:pt idx="1652">
                  <c:v>-0.37128005402265407</c:v>
                </c:pt>
                <c:pt idx="1653">
                  <c:v>0.26777422312465449</c:v>
                </c:pt>
                <c:pt idx="1654">
                  <c:v>0.77818477212629789</c:v>
                </c:pt>
                <c:pt idx="1655">
                  <c:v>-0.42889276178591579</c:v>
                </c:pt>
                <c:pt idx="1656">
                  <c:v>-1.6496319896195929E-2</c:v>
                </c:pt>
                <c:pt idx="1657">
                  <c:v>-0.27345621132030545</c:v>
                </c:pt>
                <c:pt idx="1658">
                  <c:v>0.4010631661774729</c:v>
                </c:pt>
                <c:pt idx="1659">
                  <c:v>3.8747115941792212E-2</c:v>
                </c:pt>
                <c:pt idx="1660">
                  <c:v>-0.71255176162016753</c:v>
                </c:pt>
                <c:pt idx="1661">
                  <c:v>-0.33479707513388535</c:v>
                </c:pt>
                <c:pt idx="1662">
                  <c:v>0.28560060306959728</c:v>
                </c:pt>
                <c:pt idx="1663">
                  <c:v>-0.42169458118029202</c:v>
                </c:pt>
                <c:pt idx="1664">
                  <c:v>0.24827921322495475</c:v>
                </c:pt>
                <c:pt idx="1665">
                  <c:v>-0.21300503854504765</c:v>
                </c:pt>
                <c:pt idx="1666">
                  <c:v>0.652674508366198</c:v>
                </c:pt>
                <c:pt idx="1667">
                  <c:v>0.61153490271684641</c:v>
                </c:pt>
                <c:pt idx="1668">
                  <c:v>0.18754284841954269</c:v>
                </c:pt>
                <c:pt idx="1669">
                  <c:v>-3.0895659450657957</c:v>
                </c:pt>
                <c:pt idx="1670">
                  <c:v>0.16068533654485087</c:v>
                </c:pt>
                <c:pt idx="1671">
                  <c:v>-0.41218535915670668</c:v>
                </c:pt>
                <c:pt idx="1672">
                  <c:v>-0.11436702495200027</c:v>
                </c:pt>
                <c:pt idx="1673">
                  <c:v>-0.18852752677440165</c:v>
                </c:pt>
                <c:pt idx="1674">
                  <c:v>-8.2293835951430971E-2</c:v>
                </c:pt>
                <c:pt idx="1675">
                  <c:v>-0.15328652099086271</c:v>
                </c:pt>
                <c:pt idx="1676">
                  <c:v>0.58207999218803463</c:v>
                </c:pt>
                <c:pt idx="1677">
                  <c:v>-0.12247394117564456</c:v>
                </c:pt>
                <c:pt idx="1678">
                  <c:v>0.11528487090396687</c:v>
                </c:pt>
                <c:pt idx="1679">
                  <c:v>-0.81105994774007961</c:v>
                </c:pt>
                <c:pt idx="1680">
                  <c:v>-0.23216954294797815</c:v>
                </c:pt>
                <c:pt idx="1681">
                  <c:v>-0.4665488169645523</c:v>
                </c:pt>
                <c:pt idx="1682">
                  <c:v>-0.49733133523027473</c:v>
                </c:pt>
                <c:pt idx="1683">
                  <c:v>0.25274151407762152</c:v>
                </c:pt>
                <c:pt idx="1684">
                  <c:v>-4.97701518163845E-2</c:v>
                </c:pt>
                <c:pt idx="1685">
                  <c:v>-0.33262201375963696</c:v>
                </c:pt>
                <c:pt idx="1686">
                  <c:v>0.11966711132535983</c:v>
                </c:pt>
                <c:pt idx="1687">
                  <c:v>0.2915920165164036</c:v>
                </c:pt>
                <c:pt idx="1688">
                  <c:v>-0.12273897195454532</c:v>
                </c:pt>
                <c:pt idx="1689">
                  <c:v>-0.3872522388335039</c:v>
                </c:pt>
                <c:pt idx="1690">
                  <c:v>-0.17772648293206811</c:v>
                </c:pt>
                <c:pt idx="1691">
                  <c:v>-0.60530468023834227</c:v>
                </c:pt>
                <c:pt idx="1692">
                  <c:v>8.650737224992168E-2</c:v>
                </c:pt>
                <c:pt idx="1693">
                  <c:v>8.4517342168185516E-2</c:v>
                </c:pt>
                <c:pt idx="1694">
                  <c:v>4.3051234785251288E-2</c:v>
                </c:pt>
                <c:pt idx="1695">
                  <c:v>0.38232537453131854</c:v>
                </c:pt>
                <c:pt idx="1696">
                  <c:v>0.33879767023729018</c:v>
                </c:pt>
                <c:pt idx="1697">
                  <c:v>-7.2723231021620441E-2</c:v>
                </c:pt>
                <c:pt idx="1698">
                  <c:v>-0.71940251193326066</c:v>
                </c:pt>
                <c:pt idx="1699">
                  <c:v>0.27351751273495034</c:v>
                </c:pt>
                <c:pt idx="1700">
                  <c:v>3.3421874432389788E-2</c:v>
                </c:pt>
                <c:pt idx="1701">
                  <c:v>-0.80545756146503589</c:v>
                </c:pt>
                <c:pt idx="1702">
                  <c:v>0.12784104277106004</c:v>
                </c:pt>
                <c:pt idx="1703">
                  <c:v>0.24588214044795009</c:v>
                </c:pt>
                <c:pt idx="1704">
                  <c:v>-0.27381424458703668</c:v>
                </c:pt>
                <c:pt idx="1705">
                  <c:v>0.13416034784133746</c:v>
                </c:pt>
                <c:pt idx="1706">
                  <c:v>0.10795876073902885</c:v>
                </c:pt>
                <c:pt idx="1707">
                  <c:v>-0.11569915343158639</c:v>
                </c:pt>
                <c:pt idx="1708">
                  <c:v>0.30703724722708137</c:v>
                </c:pt>
                <c:pt idx="1709">
                  <c:v>0.13226164823731201</c:v>
                </c:pt>
                <c:pt idx="1710">
                  <c:v>-0.38305450144979242</c:v>
                </c:pt>
                <c:pt idx="1711">
                  <c:v>0.12107852025014947</c:v>
                </c:pt>
                <c:pt idx="1712">
                  <c:v>-0.24610400988391648</c:v>
                </c:pt>
                <c:pt idx="1713">
                  <c:v>0.58143222070028822</c:v>
                </c:pt>
                <c:pt idx="1714">
                  <c:v>0.55088768045058401</c:v>
                </c:pt>
                <c:pt idx="1715">
                  <c:v>-0.21859520155085688</c:v>
                </c:pt>
                <c:pt idx="1716">
                  <c:v>0.75560000875445066</c:v>
                </c:pt>
                <c:pt idx="1717">
                  <c:v>0.45126746820808122</c:v>
                </c:pt>
                <c:pt idx="1718">
                  <c:v>2.7437279454271915E-3</c:v>
                </c:pt>
                <c:pt idx="1719">
                  <c:v>0.14496710279792033</c:v>
                </c:pt>
                <c:pt idx="1720">
                  <c:v>0.13226164823731201</c:v>
                </c:pt>
                <c:pt idx="1721">
                  <c:v>5.1100179333698023E-2</c:v>
                </c:pt>
                <c:pt idx="1722">
                  <c:v>0.50901919632560888</c:v>
                </c:pt>
                <c:pt idx="1723">
                  <c:v>0.32445502291640155</c:v>
                </c:pt>
                <c:pt idx="1724">
                  <c:v>1.5082594573079778E-2</c:v>
                </c:pt>
                <c:pt idx="1725">
                  <c:v>-0.46592223930393728</c:v>
                </c:pt>
                <c:pt idx="1726">
                  <c:v>0.82776853117451865</c:v>
                </c:pt>
                <c:pt idx="1727">
                  <c:v>2.9735320985471193E-2</c:v>
                </c:pt>
                <c:pt idx="1728">
                  <c:v>4.5133690098102953E-2</c:v>
                </c:pt>
                <c:pt idx="1729">
                  <c:v>-0.45649077158337947</c:v>
                </c:pt>
                <c:pt idx="1730">
                  <c:v>-6.018576504656304E-2</c:v>
                </c:pt>
                <c:pt idx="1731">
                  <c:v>-0.72202877790284348</c:v>
                </c:pt>
                <c:pt idx="1732">
                  <c:v>0.59161420859358627</c:v>
                </c:pt>
                <c:pt idx="1733">
                  <c:v>0.56128132343520898</c:v>
                </c:pt>
                <c:pt idx="1734">
                  <c:v>-0.44148347958264489</c:v>
                </c:pt>
                <c:pt idx="1735">
                  <c:v>-0.40860317934337131</c:v>
                </c:pt>
                <c:pt idx="1736">
                  <c:v>-0.52084965040807518</c:v>
                </c:pt>
                <c:pt idx="1737">
                  <c:v>0.13368543862295271</c:v>
                </c:pt>
                <c:pt idx="1738">
                  <c:v>-0.41597494641809668</c:v>
                </c:pt>
                <c:pt idx="1739">
                  <c:v>-2.2190239634065936E-2</c:v>
                </c:pt>
                <c:pt idx="1740">
                  <c:v>0.20390067229656861</c:v>
                </c:pt>
                <c:pt idx="1741">
                  <c:v>0.21759143507262685</c:v>
                </c:pt>
                <c:pt idx="1742">
                  <c:v>-5.7592692886849432E-3</c:v>
                </c:pt>
                <c:pt idx="1743">
                  <c:v>-1.0095332331986641E-3</c:v>
                </c:pt>
                <c:pt idx="1744">
                  <c:v>-5.4917919128957986E-2</c:v>
                </c:pt>
                <c:pt idx="1745">
                  <c:v>-8.2000138321361195E-3</c:v>
                </c:pt>
                <c:pt idx="1746">
                  <c:v>-0.14886904353100078</c:v>
                </c:pt>
                <c:pt idx="1747">
                  <c:v>-0.21138606167942939</c:v>
                </c:pt>
                <c:pt idx="1748">
                  <c:v>0.16036283849033048</c:v>
                </c:pt>
                <c:pt idx="1749">
                  <c:v>9.7424700969059419E-2</c:v>
                </c:pt>
                <c:pt idx="1750">
                  <c:v>5.4691953074952546E-2</c:v>
                </c:pt>
                <c:pt idx="1751">
                  <c:v>0.78066107730153333</c:v>
                </c:pt>
                <c:pt idx="1752">
                  <c:v>-0.39033751161592423</c:v>
                </c:pt>
                <c:pt idx="1753">
                  <c:v>-0.39659793157489981</c:v>
                </c:pt>
                <c:pt idx="1754">
                  <c:v>0.54603473460359164</c:v>
                </c:pt>
                <c:pt idx="1755">
                  <c:v>0.259115602482341</c:v>
                </c:pt>
                <c:pt idx="1756">
                  <c:v>-4.5023521698497736E-2</c:v>
                </c:pt>
                <c:pt idx="1757">
                  <c:v>0.7923569873134676</c:v>
                </c:pt>
                <c:pt idx="1758">
                  <c:v>-0.5226584206342787</c:v>
                </c:pt>
                <c:pt idx="1759">
                  <c:v>0.21089678249861854</c:v>
                </c:pt>
                <c:pt idx="1760">
                  <c:v>7.2152791745922601E-4</c:v>
                </c:pt>
                <c:pt idx="1761">
                  <c:v>-0.23437868933761455</c:v>
                </c:pt>
                <c:pt idx="1762">
                  <c:v>0.24742265852373249</c:v>
                </c:pt>
                <c:pt idx="1763">
                  <c:v>0.41196302812939373</c:v>
                </c:pt>
                <c:pt idx="1764">
                  <c:v>0.47433199262472175</c:v>
                </c:pt>
                <c:pt idx="1765">
                  <c:v>0.38684557156870064</c:v>
                </c:pt>
                <c:pt idx="1766">
                  <c:v>-0.15315678806142044</c:v>
                </c:pt>
                <c:pt idx="1767">
                  <c:v>-0.13211615953372516</c:v>
                </c:pt>
                <c:pt idx="1768">
                  <c:v>0.34135434566240408</c:v>
                </c:pt>
                <c:pt idx="1769">
                  <c:v>0.12343394124827907</c:v>
                </c:pt>
                <c:pt idx="1770">
                  <c:v>0.47252924954141939</c:v>
                </c:pt>
                <c:pt idx="1771">
                  <c:v>-0.27142567609293461</c:v>
                </c:pt>
                <c:pt idx="1772">
                  <c:v>-0.49916981411524908</c:v>
                </c:pt>
                <c:pt idx="1773">
                  <c:v>-0.44530294213651322</c:v>
                </c:pt>
                <c:pt idx="1774">
                  <c:v>-0.1755565364318401</c:v>
                </c:pt>
                <c:pt idx="1775">
                  <c:v>-0.3305584000308025</c:v>
                </c:pt>
                <c:pt idx="1776">
                  <c:v>-0.34936527759421326</c:v>
                </c:pt>
                <c:pt idx="1777">
                  <c:v>-0.36770653711635637</c:v>
                </c:pt>
                <c:pt idx="1778">
                  <c:v>0.14656318111193348</c:v>
                </c:pt>
                <c:pt idx="1779">
                  <c:v>-0.10755397028964594</c:v>
                </c:pt>
                <c:pt idx="1780">
                  <c:v>-0.19924830684020234</c:v>
                </c:pt>
                <c:pt idx="1781">
                  <c:v>-0.30964187342216054</c:v>
                </c:pt>
                <c:pt idx="1782">
                  <c:v>0.51498543030959998</c:v>
                </c:pt>
                <c:pt idx="1783">
                  <c:v>-0.32849183030484769</c:v>
                </c:pt>
                <c:pt idx="1784">
                  <c:v>7.036047427911532E-2</c:v>
                </c:pt>
                <c:pt idx="1785">
                  <c:v>3.6377914890592319E-2</c:v>
                </c:pt>
                <c:pt idx="1786">
                  <c:v>-6.1983516108957304E-2</c:v>
                </c:pt>
                <c:pt idx="1787">
                  <c:v>0.20539698535124387</c:v>
                </c:pt>
                <c:pt idx="1788">
                  <c:v>4.4092086702207753E-2</c:v>
                </c:pt>
                <c:pt idx="1789">
                  <c:v>0.23073604337123008</c:v>
                </c:pt>
                <c:pt idx="1790">
                  <c:v>-0.47902355998051438</c:v>
                </c:pt>
                <c:pt idx="1791">
                  <c:v>-3.4497464199444855E-2</c:v>
                </c:pt>
                <c:pt idx="1792">
                  <c:v>-0.1925729413869226</c:v>
                </c:pt>
                <c:pt idx="1793">
                  <c:v>-0.31927109081806315</c:v>
                </c:pt>
                <c:pt idx="1794">
                  <c:v>0.62437665607109649</c:v>
                </c:pt>
                <c:pt idx="1795">
                  <c:v>-8.5696580679246251E-2</c:v>
                </c:pt>
                <c:pt idx="1796">
                  <c:v>-0.10581215112923138</c:v>
                </c:pt>
                <c:pt idx="1797">
                  <c:v>-0.4271770546821001</c:v>
                </c:pt>
                <c:pt idx="1798">
                  <c:v>-0.16465757525366179</c:v>
                </c:pt>
                <c:pt idx="1799">
                  <c:v>0.52616114710496997</c:v>
                </c:pt>
                <c:pt idx="1800">
                  <c:v>0.35254732994575427</c:v>
                </c:pt>
                <c:pt idx="1801">
                  <c:v>-0.23842002607895987</c:v>
                </c:pt>
                <c:pt idx="1802">
                  <c:v>1.2915920165164037</c:v>
                </c:pt>
                <c:pt idx="1803">
                  <c:v>-0.29631056070809231</c:v>
                </c:pt>
                <c:pt idx="1804">
                  <c:v>-0.41554235419869695</c:v>
                </c:pt>
                <c:pt idx="1805">
                  <c:v>-0.15730246631897368</c:v>
                </c:pt>
                <c:pt idx="1806">
                  <c:v>-0.37973184903480972</c:v>
                </c:pt>
                <c:pt idx="1807">
                  <c:v>0.38119753470249973</c:v>
                </c:pt>
                <c:pt idx="1808">
                  <c:v>-0.81524750636067478</c:v>
                </c:pt>
                <c:pt idx="1809">
                  <c:v>0.18885782633069192</c:v>
                </c:pt>
                <c:pt idx="1810">
                  <c:v>-6.8739590672305104E-2</c:v>
                </c:pt>
                <c:pt idx="1811">
                  <c:v>0.33224409158962775</c:v>
                </c:pt>
                <c:pt idx="1812">
                  <c:v>0.27073003201580148</c:v>
                </c:pt>
                <c:pt idx="1813">
                  <c:v>-4.2224073762984954E-2</c:v>
                </c:pt>
                <c:pt idx="1814">
                  <c:v>-0.43573525887346853</c:v>
                </c:pt>
                <c:pt idx="1815">
                  <c:v>0.27351751273495034</c:v>
                </c:pt>
                <c:pt idx="1816">
                  <c:v>-0.23118661322786488</c:v>
                </c:pt>
                <c:pt idx="1817">
                  <c:v>0.27858359001019306</c:v>
                </c:pt>
                <c:pt idx="1818">
                  <c:v>-0.2938412992667393</c:v>
                </c:pt>
                <c:pt idx="1819">
                  <c:v>-0.3586213138315178</c:v>
                </c:pt>
                <c:pt idx="1820">
                  <c:v>0.12736820886475</c:v>
                </c:pt>
                <c:pt idx="1821">
                  <c:v>0.41215499074572254</c:v>
                </c:pt>
                <c:pt idx="1822">
                  <c:v>-0.3637878411032891</c:v>
                </c:pt>
                <c:pt idx="1823">
                  <c:v>-0.43797340033802429</c:v>
                </c:pt>
                <c:pt idx="1824">
                  <c:v>-0.57162827441806974</c:v>
                </c:pt>
                <c:pt idx="1825">
                  <c:v>2.649892818340108E-2</c:v>
                </c:pt>
                <c:pt idx="1826">
                  <c:v>0.16100790670625945</c:v>
                </c:pt>
                <c:pt idx="1827">
                  <c:v>-9.7071370543903579E-2</c:v>
                </c:pt>
                <c:pt idx="1828">
                  <c:v>0.35365298464865536</c:v>
                </c:pt>
                <c:pt idx="1829">
                  <c:v>-0.38504442595960747</c:v>
                </c:pt>
                <c:pt idx="1830">
                  <c:v>5.5591295467227721E-2</c:v>
                </c:pt>
                <c:pt idx="1831">
                  <c:v>6.3559929885785335E-2</c:v>
                </c:pt>
                <c:pt idx="1832">
                  <c:v>-0.29560548858806113</c:v>
                </c:pt>
                <c:pt idx="1833">
                  <c:v>1.2511953090629322</c:v>
                </c:pt>
                <c:pt idx="1834">
                  <c:v>8.283561194545605E-2</c:v>
                </c:pt>
                <c:pt idx="1835">
                  <c:v>-0.24683368791054233</c:v>
                </c:pt>
                <c:pt idx="1836">
                  <c:v>-8.990486842133559E-2</c:v>
                </c:pt>
                <c:pt idx="1837">
                  <c:v>-0.17530103390024357</c:v>
                </c:pt>
                <c:pt idx="1838">
                  <c:v>0.30115922979279042</c:v>
                </c:pt>
                <c:pt idx="1839">
                  <c:v>0.49879017558883065</c:v>
                </c:pt>
                <c:pt idx="1840">
                  <c:v>-7.4642437934492795E-2</c:v>
                </c:pt>
                <c:pt idx="1841">
                  <c:v>-0.42083269180157618</c:v>
                </c:pt>
                <c:pt idx="1842">
                  <c:v>1.4173476599660448</c:v>
                </c:pt>
                <c:pt idx="1843">
                  <c:v>0.13384372432620978</c:v>
                </c:pt>
                <c:pt idx="1844">
                  <c:v>-7.2723231021620441E-2</c:v>
                </c:pt>
                <c:pt idx="1845">
                  <c:v>0.8426975336810264</c:v>
                </c:pt>
                <c:pt idx="1846">
                  <c:v>-0.39539189392821011</c:v>
                </c:pt>
                <c:pt idx="1847">
                  <c:v>-9.8823768379691521E-2</c:v>
                </c:pt>
                <c:pt idx="1848">
                  <c:v>0.17006927816035738</c:v>
                </c:pt>
                <c:pt idx="1849">
                  <c:v>0.15152227523000486</c:v>
                </c:pt>
                <c:pt idx="1850">
                  <c:v>0.35568222166242264</c:v>
                </c:pt>
                <c:pt idx="1851">
                  <c:v>-0.31185183118705795</c:v>
                </c:pt>
                <c:pt idx="1852">
                  <c:v>-0.53426085593167461</c:v>
                </c:pt>
                <c:pt idx="1853">
                  <c:v>0.56661319084226425</c:v>
                </c:pt>
                <c:pt idx="1854">
                  <c:v>-0.22786427254650735</c:v>
                </c:pt>
                <c:pt idx="1855">
                  <c:v>5.3493701310978727E-2</c:v>
                </c:pt>
                <c:pt idx="1856">
                  <c:v>-0.1983684231025194</c:v>
                </c:pt>
                <c:pt idx="1857">
                  <c:v>-0.11089772332981356</c:v>
                </c:pt>
                <c:pt idx="1858">
                  <c:v>-0.60046007011648195</c:v>
                </c:pt>
                <c:pt idx="1859">
                  <c:v>0.18409672315490327</c:v>
                </c:pt>
                <c:pt idx="1860">
                  <c:v>0.91756990005405081</c:v>
                </c:pt>
                <c:pt idx="1861">
                  <c:v>-0.11249997620071794</c:v>
                </c:pt>
                <c:pt idx="1862">
                  <c:v>-0.23842002607895987</c:v>
                </c:pt>
                <c:pt idx="1863">
                  <c:v>7.7802151603633005E-2</c:v>
                </c:pt>
                <c:pt idx="1864">
                  <c:v>0.10144335270645237</c:v>
                </c:pt>
                <c:pt idx="1865">
                  <c:v>0.62482152041038774</c:v>
                </c:pt>
                <c:pt idx="1866">
                  <c:v>-8.5288674816987389E-2</c:v>
                </c:pt>
                <c:pt idx="1867">
                  <c:v>4.8113850300325819E-2</c:v>
                </c:pt>
                <c:pt idx="1868">
                  <c:v>-0.57908357896208906</c:v>
                </c:pt>
                <c:pt idx="1869">
                  <c:v>0.19859298163428168</c:v>
                </c:pt>
                <c:pt idx="1870">
                  <c:v>-0.3967075213839758</c:v>
                </c:pt>
                <c:pt idx="1871">
                  <c:v>-0.47363107655120013</c:v>
                </c:pt>
                <c:pt idx="1872">
                  <c:v>4.8113850300325819E-2</c:v>
                </c:pt>
                <c:pt idx="1873">
                  <c:v>-0.38692128221781685</c:v>
                </c:pt>
                <c:pt idx="1874">
                  <c:v>0.63845620203213493</c:v>
                </c:pt>
                <c:pt idx="1875">
                  <c:v>0.2342955347919489</c:v>
                </c:pt>
                <c:pt idx="1876">
                  <c:v>-4.1663531729361478E-2</c:v>
                </c:pt>
                <c:pt idx="1877">
                  <c:v>0.24075892824272171</c:v>
                </c:pt>
                <c:pt idx="1878">
                  <c:v>0.13083926159988277</c:v>
                </c:pt>
                <c:pt idx="1879">
                  <c:v>0.31724693876945403</c:v>
                </c:pt>
                <c:pt idx="1880">
                  <c:v>-0.17900139909924434</c:v>
                </c:pt>
                <c:pt idx="1881">
                  <c:v>-0.30905974250158447</c:v>
                </c:pt>
                <c:pt idx="1882">
                  <c:v>-0.36994102225426639</c:v>
                </c:pt>
                <c:pt idx="1883">
                  <c:v>-0.16208110338237522</c:v>
                </c:pt>
                <c:pt idx="1884">
                  <c:v>-0.34369206917901884</c:v>
                </c:pt>
                <c:pt idx="1885">
                  <c:v>-0.60055521900626996</c:v>
                </c:pt>
                <c:pt idx="1886">
                  <c:v>-0.29771967204351296</c:v>
                </c:pt>
                <c:pt idx="1887">
                  <c:v>1.0646156892017546</c:v>
                </c:pt>
                <c:pt idx="1888">
                  <c:v>-1.1705660567920686</c:v>
                </c:pt>
                <c:pt idx="1889">
                  <c:v>4.8710621783866807E-2</c:v>
                </c:pt>
                <c:pt idx="1890">
                  <c:v>-0.54833797550862029</c:v>
                </c:pt>
                <c:pt idx="1891">
                  <c:v>0.13511063553025035</c:v>
                </c:pt>
                <c:pt idx="1892">
                  <c:v>0.2489648233321381</c:v>
                </c:pt>
                <c:pt idx="1893">
                  <c:v>0.25222592825729495</c:v>
                </c:pt>
                <c:pt idx="1894">
                  <c:v>0.2808603778006748</c:v>
                </c:pt>
                <c:pt idx="1895">
                  <c:v>0.44457646843809989</c:v>
                </c:pt>
                <c:pt idx="1896">
                  <c:v>0.50901919632560888</c:v>
                </c:pt>
                <c:pt idx="1897">
                  <c:v>-0.10608026022513201</c:v>
                </c:pt>
                <c:pt idx="1898">
                  <c:v>-0.27202318906104861</c:v>
                </c:pt>
                <c:pt idx="1899">
                  <c:v>7.3848726800103251E-2</c:v>
                </c:pt>
                <c:pt idx="1900">
                  <c:v>-7.7653185650161355E-2</c:v>
                </c:pt>
                <c:pt idx="1901">
                  <c:v>-0.48398341030057318</c:v>
                </c:pt>
                <c:pt idx="1902">
                  <c:v>0.46514154859928136</c:v>
                </c:pt>
                <c:pt idx="1903">
                  <c:v>-0.20664322398339544</c:v>
                </c:pt>
                <c:pt idx="1904">
                  <c:v>-0.21536797220347956</c:v>
                </c:pt>
                <c:pt idx="1905">
                  <c:v>1.1015981400078068</c:v>
                </c:pt>
                <c:pt idx="1906">
                  <c:v>-0.12736914661622184</c:v>
                </c:pt>
                <c:pt idx="1907">
                  <c:v>0.36215793967589516</c:v>
                </c:pt>
                <c:pt idx="1908">
                  <c:v>-0.17389496056431486</c:v>
                </c:pt>
                <c:pt idx="1909">
                  <c:v>0.45403163089470738</c:v>
                </c:pt>
                <c:pt idx="1910">
                  <c:v>0.37314038190046273</c:v>
                </c:pt>
                <c:pt idx="1911">
                  <c:v>-3.9278795351367558E-2</c:v>
                </c:pt>
                <c:pt idx="1912">
                  <c:v>0.20190799927136394</c:v>
                </c:pt>
                <c:pt idx="1913">
                  <c:v>-0.36513259345252991</c:v>
                </c:pt>
                <c:pt idx="1914">
                  <c:v>0.30668032118842542</c:v>
                </c:pt>
                <c:pt idx="1915">
                  <c:v>0.10345688414410083</c:v>
                </c:pt>
                <c:pt idx="1916">
                  <c:v>-0.4369080517141522</c:v>
                </c:pt>
                <c:pt idx="1917">
                  <c:v>0.58944180185741801</c:v>
                </c:pt>
                <c:pt idx="1918">
                  <c:v>0.53868099750924581</c:v>
                </c:pt>
                <c:pt idx="1919">
                  <c:v>-0.10661632898778417</c:v>
                </c:pt>
                <c:pt idx="1920">
                  <c:v>0.79060902253257237</c:v>
                </c:pt>
                <c:pt idx="1921">
                  <c:v>0.29053289861182818</c:v>
                </c:pt>
                <c:pt idx="1922">
                  <c:v>-0.6113612639197511</c:v>
                </c:pt>
                <c:pt idx="1923">
                  <c:v>-0.10178452416693225</c:v>
                </c:pt>
                <c:pt idx="1924">
                  <c:v>-0.42685513232421202</c:v>
                </c:pt>
                <c:pt idx="1925">
                  <c:v>-0.47487728599312001</c:v>
                </c:pt>
                <c:pt idx="1926">
                  <c:v>0.18754284841954269</c:v>
                </c:pt>
                <c:pt idx="1927">
                  <c:v>0.45363642611456495</c:v>
                </c:pt>
                <c:pt idx="1928">
                  <c:v>-0.13527217947625234</c:v>
                </c:pt>
                <c:pt idx="1929">
                  <c:v>0.17592464374843778</c:v>
                </c:pt>
                <c:pt idx="1930">
                  <c:v>0.44320275340725684</c:v>
                </c:pt>
                <c:pt idx="1931">
                  <c:v>0.15537331533019214</c:v>
                </c:pt>
                <c:pt idx="1932">
                  <c:v>-8.2975027257768189E-2</c:v>
                </c:pt>
                <c:pt idx="1933">
                  <c:v>-0.17657809430131699</c:v>
                </c:pt>
                <c:pt idx="1934">
                  <c:v>0.12390548727009068</c:v>
                </c:pt>
                <c:pt idx="1935">
                  <c:v>-9.0988888414772262E-2</c:v>
                </c:pt>
                <c:pt idx="1936">
                  <c:v>-0.39429462049465752</c:v>
                </c:pt>
                <c:pt idx="1937">
                  <c:v>-0.29242839288671785</c:v>
                </c:pt>
                <c:pt idx="1938">
                  <c:v>-0.39473363001980655</c:v>
                </c:pt>
                <c:pt idx="1939">
                  <c:v>0.33369787182690513</c:v>
                </c:pt>
                <c:pt idx="1940">
                  <c:v>-1.7301961388826871E-3</c:v>
                </c:pt>
                <c:pt idx="1941">
                  <c:v>-0.17018145776525029</c:v>
                </c:pt>
                <c:pt idx="1942">
                  <c:v>-0.24561735275638452</c:v>
                </c:pt>
                <c:pt idx="1943">
                  <c:v>-7.4368421781553354E-2</c:v>
                </c:pt>
                <c:pt idx="1944">
                  <c:v>0.12233426620334215</c:v>
                </c:pt>
                <c:pt idx="1945">
                  <c:v>0.45858428418090685</c:v>
                </c:pt>
                <c:pt idx="1946">
                  <c:v>-0.49436440469584991</c:v>
                </c:pt>
                <c:pt idx="1947">
                  <c:v>-0.30334239448733091</c:v>
                </c:pt>
                <c:pt idx="1948">
                  <c:v>-0.32008026236976084</c:v>
                </c:pt>
                <c:pt idx="1949">
                  <c:v>-0.39088775955000937</c:v>
                </c:pt>
                <c:pt idx="1950">
                  <c:v>-1.4926544238102812E-2</c:v>
                </c:pt>
                <c:pt idx="1951">
                  <c:v>-0.46079497682632126</c:v>
                </c:pt>
                <c:pt idx="1952">
                  <c:v>-0.14143279092929562</c:v>
                </c:pt>
                <c:pt idx="1953">
                  <c:v>-0.25894096810550637</c:v>
                </c:pt>
                <c:pt idx="1954">
                  <c:v>0.31096927281512715</c:v>
                </c:pt>
                <c:pt idx="1955">
                  <c:v>0.41253899262206173</c:v>
                </c:pt>
                <c:pt idx="1956">
                  <c:v>-0.81385300358286849</c:v>
                </c:pt>
                <c:pt idx="1957">
                  <c:v>0.30329392074831124</c:v>
                </c:pt>
                <c:pt idx="1958">
                  <c:v>0.24827921322495475</c:v>
                </c:pt>
                <c:pt idx="1959">
                  <c:v>-0.47622613254623242</c:v>
                </c:pt>
                <c:pt idx="1960">
                  <c:v>-1.5397295710673209</c:v>
                </c:pt>
                <c:pt idx="1961">
                  <c:v>0.89700600667667429</c:v>
                </c:pt>
                <c:pt idx="1962">
                  <c:v>4.4984843562929477E-2</c:v>
                </c:pt>
                <c:pt idx="1963">
                  <c:v>-0.56442694863779375</c:v>
                </c:pt>
                <c:pt idx="1964">
                  <c:v>-0.88448070336104656</c:v>
                </c:pt>
                <c:pt idx="1965">
                  <c:v>0.2592882666008991</c:v>
                </c:pt>
                <c:pt idx="1966">
                  <c:v>1.6979054276021872E-2</c:v>
                </c:pt>
                <c:pt idx="1967">
                  <c:v>-0.43541524074781401</c:v>
                </c:pt>
                <c:pt idx="1968">
                  <c:v>0.11669199703751625</c:v>
                </c:pt>
                <c:pt idx="1969">
                  <c:v>-0.21437352443645422</c:v>
                </c:pt>
                <c:pt idx="1970">
                  <c:v>0.10982572320065562</c:v>
                </c:pt>
                <c:pt idx="1971">
                  <c:v>0.40201600621005401</c:v>
                </c:pt>
                <c:pt idx="1972">
                  <c:v>0.11372300538291501</c:v>
                </c:pt>
                <c:pt idx="1973">
                  <c:v>-0.11583229865256485</c:v>
                </c:pt>
                <c:pt idx="1974">
                  <c:v>-0.11503324294624002</c:v>
                </c:pt>
                <c:pt idx="1975">
                  <c:v>-0.22404027421793002</c:v>
                </c:pt>
                <c:pt idx="1976">
                  <c:v>0.98793197669090971</c:v>
                </c:pt>
                <c:pt idx="1977">
                  <c:v>0.31688747818683233</c:v>
                </c:pt>
                <c:pt idx="1978">
                  <c:v>1.1739702135002612</c:v>
                </c:pt>
                <c:pt idx="1979">
                  <c:v>0.13289427049734517</c:v>
                </c:pt>
                <c:pt idx="1980">
                  <c:v>0.41888982477445036</c:v>
                </c:pt>
                <c:pt idx="1981">
                  <c:v>0.36067521082915455</c:v>
                </c:pt>
                <c:pt idx="1982">
                  <c:v>0.17250612639620203</c:v>
                </c:pt>
                <c:pt idx="1983">
                  <c:v>-0.19307782154636699</c:v>
                </c:pt>
                <c:pt idx="1984">
                  <c:v>-0.36030808479519616</c:v>
                </c:pt>
                <c:pt idx="1985">
                  <c:v>-3.7874165661120153E-2</c:v>
                </c:pt>
                <c:pt idx="1986">
                  <c:v>8.3141235300245878E-2</c:v>
                </c:pt>
                <c:pt idx="1987">
                  <c:v>-0.15600822110712775</c:v>
                </c:pt>
                <c:pt idx="1988">
                  <c:v>0.32716736633778648</c:v>
                </c:pt>
                <c:pt idx="1989">
                  <c:v>-0.25797611601076481</c:v>
                </c:pt>
                <c:pt idx="1990">
                  <c:v>-0.83309248347121267</c:v>
                </c:pt>
                <c:pt idx="1991">
                  <c:v>-0.31301360854158522</c:v>
                </c:pt>
                <c:pt idx="1992">
                  <c:v>-0.2118844019403045</c:v>
                </c:pt>
                <c:pt idx="1993">
                  <c:v>0.67968862909295857</c:v>
                </c:pt>
                <c:pt idx="1994">
                  <c:v>2.2243836750407465E-2</c:v>
                </c:pt>
                <c:pt idx="1995">
                  <c:v>0.43070335443835533</c:v>
                </c:pt>
                <c:pt idx="1996">
                  <c:v>-0.59969865300373515</c:v>
                </c:pt>
                <c:pt idx="1997">
                  <c:v>-0.81155323303354143</c:v>
                </c:pt>
                <c:pt idx="1998">
                  <c:v>0.13669584065720147</c:v>
                </c:pt>
                <c:pt idx="1999">
                  <c:v>-0.19975085671583698</c:v>
                </c:pt>
                <c:pt idx="2000">
                  <c:v>0.44811489652827524</c:v>
                </c:pt>
                <c:pt idx="2001">
                  <c:v>6.945188075214527E-2</c:v>
                </c:pt>
                <c:pt idx="2002">
                  <c:v>-0.19055165203227017</c:v>
                </c:pt>
                <c:pt idx="2003">
                  <c:v>-0.15717309403346447</c:v>
                </c:pt>
                <c:pt idx="2004">
                  <c:v>0.21675290262188343</c:v>
                </c:pt>
                <c:pt idx="2005">
                  <c:v>0.26170773657050572</c:v>
                </c:pt>
                <c:pt idx="2006">
                  <c:v>0.73264398821611254</c:v>
                </c:pt>
                <c:pt idx="2007">
                  <c:v>2.1657911251080044E-2</c:v>
                </c:pt>
                <c:pt idx="2008">
                  <c:v>4.5133690098102953E-2</c:v>
                </c:pt>
                <c:pt idx="2009">
                  <c:v>-0.12406339602707804</c:v>
                </c:pt>
                <c:pt idx="2010">
                  <c:v>-0.51712448580564319</c:v>
                </c:pt>
                <c:pt idx="2011">
                  <c:v>-0.37306349863316074</c:v>
                </c:pt>
                <c:pt idx="2012">
                  <c:v>0.14784131633696224</c:v>
                </c:pt>
                <c:pt idx="2013">
                  <c:v>-0.51621690842499746</c:v>
                </c:pt>
                <c:pt idx="2014">
                  <c:v>-0.40501208291259222</c:v>
                </c:pt>
                <c:pt idx="2015">
                  <c:v>0.56213309912984899</c:v>
                </c:pt>
                <c:pt idx="2016">
                  <c:v>0.25859773408040992</c:v>
                </c:pt>
                <c:pt idx="2017">
                  <c:v>-0.33067312270915716</c:v>
                </c:pt>
                <c:pt idx="2018">
                  <c:v>0.18213119827201338</c:v>
                </c:pt>
                <c:pt idx="2019">
                  <c:v>-0.41261895899193063</c:v>
                </c:pt>
                <c:pt idx="2020">
                  <c:v>-1.3926706042921785E-2</c:v>
                </c:pt>
                <c:pt idx="2021">
                  <c:v>0.40373270574070247</c:v>
                </c:pt>
                <c:pt idx="2022">
                  <c:v>0.17120596180137773</c:v>
                </c:pt>
                <c:pt idx="2023">
                  <c:v>-5.7415612427242975E-2</c:v>
                </c:pt>
                <c:pt idx="2024">
                  <c:v>-1.2926174444269982E-2</c:v>
                </c:pt>
                <c:pt idx="2025">
                  <c:v>-1.0560979242800275</c:v>
                </c:pt>
                <c:pt idx="2026">
                  <c:v>6.3861496576032323E-2</c:v>
                </c:pt>
                <c:pt idx="2027">
                  <c:v>-0.14378522470860158</c:v>
                </c:pt>
                <c:pt idx="2028">
                  <c:v>-0.78123380009933452</c:v>
                </c:pt>
                <c:pt idx="2029">
                  <c:v>-1.4355292977070055E-2</c:v>
                </c:pt>
                <c:pt idx="2030">
                  <c:v>0.71667083194835857</c:v>
                </c:pt>
                <c:pt idx="2031">
                  <c:v>-0.46842691882347864</c:v>
                </c:pt>
                <c:pt idx="2032">
                  <c:v>-8.719124956262303E-2</c:v>
                </c:pt>
                <c:pt idx="2033">
                  <c:v>0.45343886431475061</c:v>
                </c:pt>
                <c:pt idx="2034">
                  <c:v>-0.70752479089960785</c:v>
                </c:pt>
                <c:pt idx="2035">
                  <c:v>-0.18548600412807811</c:v>
                </c:pt>
                <c:pt idx="2036">
                  <c:v>0.57067863005855834</c:v>
                </c:pt>
                <c:pt idx="2037">
                  <c:v>-0.18852752677440165</c:v>
                </c:pt>
                <c:pt idx="2038">
                  <c:v>-0.44689140529205573</c:v>
                </c:pt>
                <c:pt idx="2039">
                  <c:v>-0.22292818000261264</c:v>
                </c:pt>
                <c:pt idx="2040">
                  <c:v>-0.25471496797691834</c:v>
                </c:pt>
                <c:pt idx="2041">
                  <c:v>-0.41186007373781963</c:v>
                </c:pt>
                <c:pt idx="2042">
                  <c:v>0.5561812030875074</c:v>
                </c:pt>
                <c:pt idx="2043">
                  <c:v>0.23616354110904847</c:v>
                </c:pt>
                <c:pt idx="2044">
                  <c:v>0.31311853956777219</c:v>
                </c:pt>
                <c:pt idx="2045">
                  <c:v>-3.7733627446514942E-2</c:v>
                </c:pt>
                <c:pt idx="2046">
                  <c:v>0.24588214044795009</c:v>
                </c:pt>
                <c:pt idx="2047">
                  <c:v>4.7517325569524552E-2</c:v>
                </c:pt>
                <c:pt idx="2048">
                  <c:v>-0.2828549093225548</c:v>
                </c:pt>
                <c:pt idx="2049">
                  <c:v>0.19280996679804011</c:v>
                </c:pt>
                <c:pt idx="2050">
                  <c:v>-0.27345621132030545</c:v>
                </c:pt>
                <c:pt idx="2051">
                  <c:v>-9.2072094502929108E-2</c:v>
                </c:pt>
                <c:pt idx="2052">
                  <c:v>0.30935942138430667</c:v>
                </c:pt>
                <c:pt idx="2053">
                  <c:v>9.20325940534681E-2</c:v>
                </c:pt>
                <c:pt idx="2054">
                  <c:v>3.9636570372486739E-2</c:v>
                </c:pt>
                <c:pt idx="2055">
                  <c:v>0.16860914248688641</c:v>
                </c:pt>
                <c:pt idx="2056">
                  <c:v>-0.24123003551544539</c:v>
                </c:pt>
                <c:pt idx="2057">
                  <c:v>-0.1641426488483064</c:v>
                </c:pt>
                <c:pt idx="2058">
                  <c:v>-0.70336652800663613</c:v>
                </c:pt>
                <c:pt idx="2059">
                  <c:v>-0.95620537619387458</c:v>
                </c:pt>
                <c:pt idx="2060">
                  <c:v>0.32915966411843811</c:v>
                </c:pt>
                <c:pt idx="2061">
                  <c:v>-0.18523225423016088</c:v>
                </c:pt>
                <c:pt idx="2062">
                  <c:v>0.11231877065700796</c:v>
                </c:pt>
                <c:pt idx="2063">
                  <c:v>-1.6496319896195929E-2</c:v>
                </c:pt>
                <c:pt idx="2064">
                  <c:v>-0.78232468487031948</c:v>
                </c:pt>
                <c:pt idx="2065">
                  <c:v>-0.17887395816979521</c:v>
                </c:pt>
                <c:pt idx="2066">
                  <c:v>-0.11835972595305726</c:v>
                </c:pt>
                <c:pt idx="2067">
                  <c:v>-0.34789238819533774</c:v>
                </c:pt>
                <c:pt idx="2068">
                  <c:v>0.51374901111589144</c:v>
                </c:pt>
                <c:pt idx="2069">
                  <c:v>-0.37339764919421214</c:v>
                </c:pt>
                <c:pt idx="2070">
                  <c:v>-0.17030966883317647</c:v>
                </c:pt>
                <c:pt idx="2071">
                  <c:v>-0.50131174924365984</c:v>
                </c:pt>
                <c:pt idx="2072">
                  <c:v>0.34428181916585099</c:v>
                </c:pt>
                <c:pt idx="2073">
                  <c:v>5.9043977614659619E-2</c:v>
                </c:pt>
                <c:pt idx="2074">
                  <c:v>9.9123533842101277E-2</c:v>
                </c:pt>
                <c:pt idx="2075">
                  <c:v>0.28401879681160264</c:v>
                </c:pt>
                <c:pt idx="2076">
                  <c:v>-0.53555533339930983</c:v>
                </c:pt>
                <c:pt idx="2077">
                  <c:v>0.40296947596975347</c:v>
                </c:pt>
                <c:pt idx="2078">
                  <c:v>-0.13277423327632584</c:v>
                </c:pt>
                <c:pt idx="2079">
                  <c:v>9.1110253026279217E-2</c:v>
                </c:pt>
                <c:pt idx="2080">
                  <c:v>-0.13881446890228194</c:v>
                </c:pt>
                <c:pt idx="2081">
                  <c:v>-7.0664100778789735E-2</c:v>
                </c:pt>
                <c:pt idx="2082">
                  <c:v>-0.22946487314009217</c:v>
                </c:pt>
                <c:pt idx="2083">
                  <c:v>0.22701644786189529</c:v>
                </c:pt>
                <c:pt idx="2084">
                  <c:v>-1.1310626167824682</c:v>
                </c:pt>
                <c:pt idx="2085">
                  <c:v>-0.24488705912353456</c:v>
                </c:pt>
                <c:pt idx="2086">
                  <c:v>-1.0010816157254516</c:v>
                </c:pt>
                <c:pt idx="2087">
                  <c:v>-0.55777767139492584</c:v>
                </c:pt>
                <c:pt idx="2088">
                  <c:v>8.5282413534096907E-2</c:v>
                </c:pt>
                <c:pt idx="2089">
                  <c:v>0.96409461625787207</c:v>
                </c:pt>
                <c:pt idx="2090">
                  <c:v>-0.34437403328573252</c:v>
                </c:pt>
                <c:pt idx="2091">
                  <c:v>0.93981423495343708</c:v>
                </c:pt>
                <c:pt idx="2092">
                  <c:v>-0.41651550434749357</c:v>
                </c:pt>
                <c:pt idx="2093">
                  <c:v>-0.14339341869318778</c:v>
                </c:pt>
                <c:pt idx="2094">
                  <c:v>-0.54181216952889466</c:v>
                </c:pt>
                <c:pt idx="2095">
                  <c:v>-1.8206856653311884E-2</c:v>
                </c:pt>
                <c:pt idx="2096">
                  <c:v>-0.36199288592196255</c:v>
                </c:pt>
                <c:pt idx="2097">
                  <c:v>-8.8820033298585108E-2</c:v>
                </c:pt>
                <c:pt idx="2098">
                  <c:v>-0.38989716211509579</c:v>
                </c:pt>
                <c:pt idx="2099">
                  <c:v>-0.55453973781898336</c:v>
                </c:pt>
                <c:pt idx="2100">
                  <c:v>8.4976336299281974E-2</c:v>
                </c:pt>
                <c:pt idx="2101">
                  <c:v>-0.30649557225963681</c:v>
                </c:pt>
                <c:pt idx="2102">
                  <c:v>9.1571349831212623E-2</c:v>
                </c:pt>
                <c:pt idx="2103">
                  <c:v>-0.32722746776128592</c:v>
                </c:pt>
                <c:pt idx="2104">
                  <c:v>-0.20012765427360202</c:v>
                </c:pt>
                <c:pt idx="2105">
                  <c:v>-0.24926328606119341</c:v>
                </c:pt>
                <c:pt idx="2106">
                  <c:v>-0.46978180680686454</c:v>
                </c:pt>
                <c:pt idx="2107">
                  <c:v>-0.47487728599312001</c:v>
                </c:pt>
                <c:pt idx="2108">
                  <c:v>-0.10245657665073434</c:v>
                </c:pt>
                <c:pt idx="2109">
                  <c:v>1.1913266450967985</c:v>
                </c:pt>
                <c:pt idx="2110">
                  <c:v>-0.1650436494830444</c:v>
                </c:pt>
                <c:pt idx="2111">
                  <c:v>0.9145753437473223</c:v>
                </c:pt>
                <c:pt idx="2112">
                  <c:v>0.14944057937722841</c:v>
                </c:pt>
                <c:pt idx="2113">
                  <c:v>0.15232372797040333</c:v>
                </c:pt>
                <c:pt idx="2114">
                  <c:v>0.26413127092642058</c:v>
                </c:pt>
                <c:pt idx="2115">
                  <c:v>0.19693832490869895</c:v>
                </c:pt>
                <c:pt idx="2116">
                  <c:v>0.20972840558669803</c:v>
                </c:pt>
                <c:pt idx="2117">
                  <c:v>-5.8662839378559907E-2</c:v>
                </c:pt>
                <c:pt idx="2118">
                  <c:v>-0.35140218362996428</c:v>
                </c:pt>
                <c:pt idx="2119">
                  <c:v>-0.16954023145979721</c:v>
                </c:pt>
                <c:pt idx="2120">
                  <c:v>-0.3001823099801158</c:v>
                </c:pt>
                <c:pt idx="2121">
                  <c:v>0.29247520910039215</c:v>
                </c:pt>
                <c:pt idx="2122">
                  <c:v>-0.42792792761523452</c:v>
                </c:pt>
                <c:pt idx="2123">
                  <c:v>-0.14130198762525836</c:v>
                </c:pt>
                <c:pt idx="2124">
                  <c:v>0.16796066734802631</c:v>
                </c:pt>
                <c:pt idx="2125">
                  <c:v>0.17608763251219806</c:v>
                </c:pt>
                <c:pt idx="2126">
                  <c:v>-9.666666858017911E-2</c:v>
                </c:pt>
                <c:pt idx="2127">
                  <c:v>-0.28889006122208344</c:v>
                </c:pt>
                <c:pt idx="2128">
                  <c:v>1.4936816263362275E-2</c:v>
                </c:pt>
                <c:pt idx="2129">
                  <c:v>-9.4371210592517171E-2</c:v>
                </c:pt>
                <c:pt idx="2130">
                  <c:v>0.4538340149720797</c:v>
                </c:pt>
                <c:pt idx="2131">
                  <c:v>0.15762451179371223</c:v>
                </c:pt>
                <c:pt idx="2132">
                  <c:v>0.43908943912011134</c:v>
                </c:pt>
                <c:pt idx="2133">
                  <c:v>-0.13697881196350373</c:v>
                </c:pt>
                <c:pt idx="2134">
                  <c:v>6.43139648378213E-2</c:v>
                </c:pt>
                <c:pt idx="2135">
                  <c:v>0.13526907768524882</c:v>
                </c:pt>
                <c:pt idx="2136">
                  <c:v>-4.6421211248710403E-2</c:v>
                </c:pt>
                <c:pt idx="2137">
                  <c:v>-0.78324709737811649</c:v>
                </c:pt>
                <c:pt idx="2138">
                  <c:v>0.63666068837052092</c:v>
                </c:pt>
                <c:pt idx="2139">
                  <c:v>-9.0311471376036651E-2</c:v>
                </c:pt>
                <c:pt idx="2140">
                  <c:v>-0.50893566186439532</c:v>
                </c:pt>
                <c:pt idx="2141">
                  <c:v>-0.16427139768074103</c:v>
                </c:pt>
                <c:pt idx="2142">
                  <c:v>1.237863830098888</c:v>
                </c:pt>
                <c:pt idx="2143">
                  <c:v>6.1300186760663795E-2</c:v>
                </c:pt>
                <c:pt idx="2144">
                  <c:v>-4.2504263128963438E-2</c:v>
                </c:pt>
                <c:pt idx="2145">
                  <c:v>0.52118347095058493</c:v>
                </c:pt>
                <c:pt idx="2146">
                  <c:v>-0.28344770837797972</c:v>
                </c:pt>
                <c:pt idx="2147">
                  <c:v>0.22887504687163343</c:v>
                </c:pt>
                <c:pt idx="2148">
                  <c:v>-7.4825763312062017E-3</c:v>
                </c:pt>
                <c:pt idx="2149">
                  <c:v>-0.64929354696713992</c:v>
                </c:pt>
                <c:pt idx="2150">
                  <c:v>-6.5158675128546908E-2</c:v>
                </c:pt>
                <c:pt idx="2151">
                  <c:v>-0.42223300068304787</c:v>
                </c:pt>
                <c:pt idx="2152">
                  <c:v>-0.10245657665073434</c:v>
                </c:pt>
                <c:pt idx="2153">
                  <c:v>-0.37083384817640336</c:v>
                </c:pt>
                <c:pt idx="2154">
                  <c:v>-0.46790546906145342</c:v>
                </c:pt>
                <c:pt idx="2155">
                  <c:v>-9.0988888414772262E-2</c:v>
                </c:pt>
                <c:pt idx="2156">
                  <c:v>-1.8776585179183222E-2</c:v>
                </c:pt>
                <c:pt idx="2157">
                  <c:v>-0.97819562968165175</c:v>
                </c:pt>
                <c:pt idx="2158">
                  <c:v>-0.5252670917020329</c:v>
                </c:pt>
                <c:pt idx="2159">
                  <c:v>-1.5946918565094863</c:v>
                </c:pt>
                <c:pt idx="2160">
                  <c:v>-0.48429283551160129</c:v>
                </c:pt>
                <c:pt idx="2161">
                  <c:v>0.38270151715915363</c:v>
                </c:pt>
                <c:pt idx="2162">
                  <c:v>-1.6902382841368431</c:v>
                </c:pt>
                <c:pt idx="2163">
                  <c:v>1.2990101791032606E-3</c:v>
                </c:pt>
                <c:pt idx="2164">
                  <c:v>0.14003045177897405</c:v>
                </c:pt>
                <c:pt idx="2165">
                  <c:v>-0.13277423327632584</c:v>
                </c:pt>
                <c:pt idx="2166">
                  <c:v>0.10904752854297761</c:v>
                </c:pt>
                <c:pt idx="2167">
                  <c:v>0.12280545287376164</c:v>
                </c:pt>
                <c:pt idx="2168">
                  <c:v>-0.9938554797020992</c:v>
                </c:pt>
                <c:pt idx="2169">
                  <c:v>0.32120692764370817</c:v>
                </c:pt>
                <c:pt idx="2170">
                  <c:v>-3.1959741397545004E-2</c:v>
                </c:pt>
                <c:pt idx="2171">
                  <c:v>0.2172559636047999</c:v>
                </c:pt>
                <c:pt idx="2172">
                  <c:v>0.82316662921550998</c:v>
                </c:pt>
                <c:pt idx="2173">
                  <c:v>0.32445502291640155</c:v>
                </c:pt>
                <c:pt idx="2174">
                  <c:v>-0.91195996528691492</c:v>
                </c:pt>
                <c:pt idx="2175">
                  <c:v>5.7691943843815242E-2</c:v>
                </c:pt>
                <c:pt idx="2176">
                  <c:v>0.60099301352760293</c:v>
                </c:pt>
                <c:pt idx="2177">
                  <c:v>-3.0124161455128785E-2</c:v>
                </c:pt>
                <c:pt idx="2178">
                  <c:v>0.15152227523000486</c:v>
                </c:pt>
                <c:pt idx="2179">
                  <c:v>-0.27727065965564229</c:v>
                </c:pt>
                <c:pt idx="2180">
                  <c:v>-0.81901412248972338</c:v>
                </c:pt>
                <c:pt idx="2181">
                  <c:v>-0.25483588278576313</c:v>
                </c:pt>
                <c:pt idx="2182">
                  <c:v>-0.2013829358640542</c:v>
                </c:pt>
                <c:pt idx="2183">
                  <c:v>-0.25483588278576313</c:v>
                </c:pt>
                <c:pt idx="2184">
                  <c:v>1.4173476599660448</c:v>
                </c:pt>
                <c:pt idx="2185">
                  <c:v>-5.0327553558424894E-2</c:v>
                </c:pt>
                <c:pt idx="2186">
                  <c:v>-0.23315180343929381</c:v>
                </c:pt>
                <c:pt idx="2187">
                  <c:v>1.2477652193803555</c:v>
                </c:pt>
                <c:pt idx="2188">
                  <c:v>-0.25120402291466304</c:v>
                </c:pt>
                <c:pt idx="2189">
                  <c:v>0.19495523862959685</c:v>
                </c:pt>
                <c:pt idx="2190">
                  <c:v>-4.4184257544003791E-2</c:v>
                </c:pt>
                <c:pt idx="2191">
                  <c:v>0.2207823106853522</c:v>
                </c:pt>
                <c:pt idx="2192">
                  <c:v>-0.17734378828172609</c:v>
                </c:pt>
                <c:pt idx="2193">
                  <c:v>0.18278607574167338</c:v>
                </c:pt>
                <c:pt idx="2194">
                  <c:v>3.0766606736428961E-2</c:v>
                </c:pt>
                <c:pt idx="2195">
                  <c:v>0.10221745533858326</c:v>
                </c:pt>
                <c:pt idx="2196">
                  <c:v>-7.737974079701361E-2</c:v>
                </c:pt>
                <c:pt idx="2197">
                  <c:v>-0.23450132056221065</c:v>
                </c:pt>
                <c:pt idx="2198">
                  <c:v>-0.34335096620050848</c:v>
                </c:pt>
                <c:pt idx="2199">
                  <c:v>-0.75189213840430913</c:v>
                </c:pt>
                <c:pt idx="2200">
                  <c:v>0.21625001699282514</c:v>
                </c:pt>
                <c:pt idx="2201">
                  <c:v>-6.4055064410443313E-2</c:v>
                </c:pt>
                <c:pt idx="2202">
                  <c:v>-0.10996225339881806</c:v>
                </c:pt>
                <c:pt idx="2203">
                  <c:v>0.22061419380106381</c:v>
                </c:pt>
                <c:pt idx="2204">
                  <c:v>0.16536967769053795</c:v>
                </c:pt>
                <c:pt idx="2205">
                  <c:v>-1.3215818065212825</c:v>
                </c:pt>
                <c:pt idx="2206">
                  <c:v>0.16181464778912144</c:v>
                </c:pt>
                <c:pt idx="2207">
                  <c:v>-0.3768460140163204</c:v>
                </c:pt>
                <c:pt idx="2208">
                  <c:v>-0.19522159325284463</c:v>
                </c:pt>
                <c:pt idx="2209">
                  <c:v>7.8411333515308143E-2</c:v>
                </c:pt>
                <c:pt idx="2210">
                  <c:v>-0.23707417130215749</c:v>
                </c:pt>
                <c:pt idx="2211">
                  <c:v>0.26291899484690068</c:v>
                </c:pt>
                <c:pt idx="2212">
                  <c:v>-0.15898325116038658</c:v>
                </c:pt>
                <c:pt idx="2213">
                  <c:v>-0.69501387263258185</c:v>
                </c:pt>
                <c:pt idx="2214">
                  <c:v>-0.27034952873310286</c:v>
                </c:pt>
                <c:pt idx="2215">
                  <c:v>-0.19887127951781902</c:v>
                </c:pt>
                <c:pt idx="2216">
                  <c:v>4.7666433630314267E-2</c:v>
                </c:pt>
                <c:pt idx="2217">
                  <c:v>0.30721574336598995</c:v>
                </c:pt>
                <c:pt idx="2218">
                  <c:v>-0.19962523565773241</c:v>
                </c:pt>
                <c:pt idx="2219">
                  <c:v>0.10624949827943411</c:v>
                </c:pt>
                <c:pt idx="2220">
                  <c:v>-9.3289730001476709E-2</c:v>
                </c:pt>
                <c:pt idx="2221">
                  <c:v>-0.16774328010893647</c:v>
                </c:pt>
                <c:pt idx="2222">
                  <c:v>-2.3468280503905394E-2</c:v>
                </c:pt>
                <c:pt idx="2223">
                  <c:v>-0.80041331263875726</c:v>
                </c:pt>
                <c:pt idx="2224">
                  <c:v>0.27805868731534011</c:v>
                </c:pt>
                <c:pt idx="2225">
                  <c:v>3.8302594280321761E-2</c:v>
                </c:pt>
                <c:pt idx="2226">
                  <c:v>-0.39473363001980655</c:v>
                </c:pt>
                <c:pt idx="2227">
                  <c:v>-0.348119084462443</c:v>
                </c:pt>
                <c:pt idx="2228">
                  <c:v>-0.21822319715473792</c:v>
                </c:pt>
                <c:pt idx="2229">
                  <c:v>-0.12340133597191383</c:v>
                </c:pt>
                <c:pt idx="2230">
                  <c:v>-0.72438833660211943</c:v>
                </c:pt>
                <c:pt idx="2231">
                  <c:v>-0.31799861786143496</c:v>
                </c:pt>
                <c:pt idx="2232">
                  <c:v>0.17397021350026112</c:v>
                </c:pt>
                <c:pt idx="2233">
                  <c:v>-0.37473347803121398</c:v>
                </c:pt>
                <c:pt idx="2234">
                  <c:v>-0.2911320120087531</c:v>
                </c:pt>
                <c:pt idx="2235">
                  <c:v>-8.6647912755188225E-2</c:v>
                </c:pt>
                <c:pt idx="2236">
                  <c:v>0.17592464374843778</c:v>
                </c:pt>
                <c:pt idx="2237">
                  <c:v>-1.5081750810326742</c:v>
                </c:pt>
                <c:pt idx="2238">
                  <c:v>1.6249351645074715E-2</c:v>
                </c:pt>
                <c:pt idx="2239">
                  <c:v>0.32409376210547691</c:v>
                </c:pt>
                <c:pt idx="2240">
                  <c:v>0.54287854204990393</c:v>
                </c:pt>
                <c:pt idx="2241">
                  <c:v>-3.6046100156859551E-2</c:v>
                </c:pt>
                <c:pt idx="2242">
                  <c:v>0.11700487820137304</c:v>
                </c:pt>
                <c:pt idx="2243">
                  <c:v>9.1878829593861872E-2</c:v>
                </c:pt>
                <c:pt idx="2244">
                  <c:v>-0.10312831621722553</c:v>
                </c:pt>
                <c:pt idx="2245">
                  <c:v>-0.26026658699756811</c:v>
                </c:pt>
                <c:pt idx="2246">
                  <c:v>-0.19975085671583698</c:v>
                </c:pt>
                <c:pt idx="2247">
                  <c:v>-0.15781983947886266</c:v>
                </c:pt>
                <c:pt idx="2248">
                  <c:v>-0.5159142557108588</c:v>
                </c:pt>
                <c:pt idx="2249">
                  <c:v>0.66063453903205571</c:v>
                </c:pt>
                <c:pt idx="2250">
                  <c:v>-0.15237814540103931</c:v>
                </c:pt>
                <c:pt idx="2251">
                  <c:v>0.2761356763732723</c:v>
                </c:pt>
                <c:pt idx="2252">
                  <c:v>-0.19635524288274839</c:v>
                </c:pt>
                <c:pt idx="2253">
                  <c:v>-0.4474205045904967</c:v>
                </c:pt>
                <c:pt idx="2254">
                  <c:v>-0.10191895971107164</c:v>
                </c:pt>
                <c:pt idx="2255">
                  <c:v>-0.10902617649836698</c:v>
                </c:pt>
                <c:pt idx="2256">
                  <c:v>-3.308816933218782E-2</c:v>
                </c:pt>
                <c:pt idx="2257">
                  <c:v>0.58835682396098599</c:v>
                </c:pt>
                <c:pt idx="2258">
                  <c:v>-4.2504263128963438E-2</c:v>
                </c:pt>
                <c:pt idx="2259">
                  <c:v>-0.39835037034596488</c:v>
                </c:pt>
                <c:pt idx="2260">
                  <c:v>-0.13750352374993496</c:v>
                </c:pt>
                <c:pt idx="2261">
                  <c:v>-8.2157559085425935E-2</c:v>
                </c:pt>
                <c:pt idx="2262">
                  <c:v>0.21692057012638846</c:v>
                </c:pt>
                <c:pt idx="2263">
                  <c:v>0.46693507813036245</c:v>
                </c:pt>
                <c:pt idx="2264">
                  <c:v>-0.41651550434749357</c:v>
                </c:pt>
                <c:pt idx="2265">
                  <c:v>-0.13132607460659132</c:v>
                </c:pt>
                <c:pt idx="2266">
                  <c:v>0.49492208524838549</c:v>
                </c:pt>
                <c:pt idx="2267">
                  <c:v>0.18393282709782399</c:v>
                </c:pt>
                <c:pt idx="2268">
                  <c:v>0.1325779246916948</c:v>
                </c:pt>
                <c:pt idx="2269">
                  <c:v>-0.57898700333257969</c:v>
                </c:pt>
                <c:pt idx="2270">
                  <c:v>7.6432432067441464E-2</c:v>
                </c:pt>
                <c:pt idx="2271">
                  <c:v>0.15040098884854838</c:v>
                </c:pt>
                <c:pt idx="2272">
                  <c:v>0.55279111184418983</c:v>
                </c:pt>
                <c:pt idx="2273">
                  <c:v>-1.1309967448083507</c:v>
                </c:pt>
                <c:pt idx="2274">
                  <c:v>-0.31115431544056682</c:v>
                </c:pt>
                <c:pt idx="2275">
                  <c:v>0.13542753724286744</c:v>
                </c:pt>
                <c:pt idx="2276">
                  <c:v>0.22650997250444194</c:v>
                </c:pt>
                <c:pt idx="2277">
                  <c:v>0.24502700733009836</c:v>
                </c:pt>
                <c:pt idx="2278">
                  <c:v>0.33006616433103947</c:v>
                </c:pt>
                <c:pt idx="2279">
                  <c:v>0.61838437515354616</c:v>
                </c:pt>
                <c:pt idx="2280">
                  <c:v>-0.11955538469528249</c:v>
                </c:pt>
                <c:pt idx="2281">
                  <c:v>0.11138337293185385</c:v>
                </c:pt>
                <c:pt idx="2282">
                  <c:v>-0.20589292750767063</c:v>
                </c:pt>
                <c:pt idx="2283">
                  <c:v>-7.8746447076648435E-2</c:v>
                </c:pt>
                <c:pt idx="2284">
                  <c:v>-0.43935717847425693</c:v>
                </c:pt>
                <c:pt idx="2285">
                  <c:v>-0.16774328010893647</c:v>
                </c:pt>
                <c:pt idx="2286">
                  <c:v>-3.9278795351367558E-2</c:v>
                </c:pt>
                <c:pt idx="2287">
                  <c:v>-0.59033853317908758</c:v>
                </c:pt>
                <c:pt idx="2288">
                  <c:v>-7.9702371697378219E-2</c:v>
                </c:pt>
                <c:pt idx="2289">
                  <c:v>-0.12578333162732366</c:v>
                </c:pt>
                <c:pt idx="2290">
                  <c:v>-1.4640946881753101E-2</c:v>
                </c:pt>
                <c:pt idx="2291">
                  <c:v>-0.40119355106326404</c:v>
                </c:pt>
                <c:pt idx="2292">
                  <c:v>0.26326525550880248</c:v>
                </c:pt>
                <c:pt idx="2293">
                  <c:v>0.1942948151614888</c:v>
                </c:pt>
                <c:pt idx="2294">
                  <c:v>-8.0111859861598161E-2</c:v>
                </c:pt>
                <c:pt idx="2295">
                  <c:v>-0.41878363851173855</c:v>
                </c:pt>
                <c:pt idx="2296">
                  <c:v>-0.18802105141694828</c:v>
                </c:pt>
                <c:pt idx="2297">
                  <c:v>0.13637866025779505</c:v>
                </c:pt>
                <c:pt idx="2298">
                  <c:v>-0.28356623896514654</c:v>
                </c:pt>
                <c:pt idx="2299">
                  <c:v>0.44870547921001191</c:v>
                </c:pt>
                <c:pt idx="2300">
                  <c:v>0.18852896947016404</c:v>
                </c:pt>
                <c:pt idx="2301">
                  <c:v>8.8346762691467837E-2</c:v>
                </c:pt>
                <c:pt idx="2302">
                  <c:v>-7.3390460081620614E-3</c:v>
                </c:pt>
                <c:pt idx="2303">
                  <c:v>-0.18269229751619034</c:v>
                </c:pt>
                <c:pt idx="2304">
                  <c:v>-0.13894549792384139</c:v>
                </c:pt>
                <c:pt idx="2305">
                  <c:v>0.57604540598510312</c:v>
                </c:pt>
                <c:pt idx="2306">
                  <c:v>-0.21760297658678801</c:v>
                </c:pt>
                <c:pt idx="2307">
                  <c:v>-0.38482345872975471</c:v>
                </c:pt>
                <c:pt idx="2308">
                  <c:v>0.14432916555962896</c:v>
                </c:pt>
                <c:pt idx="2309">
                  <c:v>-2.1053252054075225E-2</c:v>
                </c:pt>
                <c:pt idx="2310">
                  <c:v>0.12532105079254455</c:v>
                </c:pt>
                <c:pt idx="2311">
                  <c:v>-1.39829563884343</c:v>
                </c:pt>
                <c:pt idx="2312">
                  <c:v>-0.59626729425929748</c:v>
                </c:pt>
                <c:pt idx="2313">
                  <c:v>5.7541796053609713E-2</c:v>
                </c:pt>
                <c:pt idx="2314">
                  <c:v>-0.58640447489506276</c:v>
                </c:pt>
                <c:pt idx="2315">
                  <c:v>9.4187019048234247E-2</c:v>
                </c:pt>
                <c:pt idx="2316">
                  <c:v>-0.23780842954562026</c:v>
                </c:pt>
                <c:pt idx="2317">
                  <c:v>-0.20150840397222453</c:v>
                </c:pt>
                <c:pt idx="2318">
                  <c:v>-0.25374728450581674</c:v>
                </c:pt>
                <c:pt idx="2319">
                  <c:v>-0.42255595595975115</c:v>
                </c:pt>
                <c:pt idx="2320">
                  <c:v>0.32590097146228619</c:v>
                </c:pt>
                <c:pt idx="2321">
                  <c:v>-0.20100646605609301</c:v>
                </c:pt>
                <c:pt idx="2322">
                  <c:v>8.7886695175194249E-2</c:v>
                </c:pt>
                <c:pt idx="2323">
                  <c:v>-1.0069801577153366</c:v>
                </c:pt>
                <c:pt idx="2324">
                  <c:v>0.41561469274158935</c:v>
                </c:pt>
                <c:pt idx="2325">
                  <c:v>-1.4212444812104782E-2</c:v>
                </c:pt>
                <c:pt idx="2326">
                  <c:v>0.18508049069448132</c:v>
                </c:pt>
                <c:pt idx="2327">
                  <c:v>0.15987922653846784</c:v>
                </c:pt>
                <c:pt idx="2328">
                  <c:v>0.35420612992000644</c:v>
                </c:pt>
                <c:pt idx="2329">
                  <c:v>0.23837430779751667</c:v>
                </c:pt>
                <c:pt idx="2330">
                  <c:v>-0.26699637198621573</c:v>
                </c:pt>
                <c:pt idx="2331">
                  <c:v>-9.8015233868959495E-2</c:v>
                </c:pt>
                <c:pt idx="2332">
                  <c:v>5.3643428366366007E-2</c:v>
                </c:pt>
                <c:pt idx="2333">
                  <c:v>0.56106845806545513</c:v>
                </c:pt>
                <c:pt idx="2334">
                  <c:v>7.0814985716076667E-2</c:v>
                </c:pt>
                <c:pt idx="2335">
                  <c:v>-0.10030490579568552</c:v>
                </c:pt>
                <c:pt idx="2336">
                  <c:v>0.10485251550655336</c:v>
                </c:pt>
                <c:pt idx="2337">
                  <c:v>0.31240176149271787</c:v>
                </c:pt>
                <c:pt idx="2338">
                  <c:v>7.066346599311131E-2</c:v>
                </c:pt>
                <c:pt idx="2339">
                  <c:v>8.8193390550687784E-2</c:v>
                </c:pt>
                <c:pt idx="2340">
                  <c:v>0.39535930381534051</c:v>
                </c:pt>
                <c:pt idx="2341">
                  <c:v>-0.11968817451919593</c:v>
                </c:pt>
                <c:pt idx="2342">
                  <c:v>-6.0466301184148516E-3</c:v>
                </c:pt>
                <c:pt idx="2343">
                  <c:v>0.50225991139090687</c:v>
                </c:pt>
                <c:pt idx="2344">
                  <c:v>-0.55542353156190016</c:v>
                </c:pt>
                <c:pt idx="2345">
                  <c:v>0.33024753274423807</c:v>
                </c:pt>
                <c:pt idx="2346">
                  <c:v>9.2340172146710503E-2</c:v>
                </c:pt>
                <c:pt idx="2347">
                  <c:v>-0.6889412383010004</c:v>
                </c:pt>
                <c:pt idx="2348">
                  <c:v>-0.19383481065383809</c:v>
                </c:pt>
                <c:pt idx="2349">
                  <c:v>-0.65846286117410946</c:v>
                </c:pt>
                <c:pt idx="2350">
                  <c:v>-0.29889288105416112</c:v>
                </c:pt>
                <c:pt idx="2351">
                  <c:v>0.24348904385984158</c:v>
                </c:pt>
                <c:pt idx="2352">
                  <c:v>-6.8464450966905774E-2</c:v>
                </c:pt>
                <c:pt idx="2353">
                  <c:v>0.24999384979579925</c:v>
                </c:pt>
                <c:pt idx="2354">
                  <c:v>0.23344723992368566</c:v>
                </c:pt>
                <c:pt idx="2355">
                  <c:v>1.2315322433238985E-2</c:v>
                </c:pt>
                <c:pt idx="2356">
                  <c:v>-0.4772628493491719</c:v>
                </c:pt>
                <c:pt idx="2357">
                  <c:v>-3.1395196275534373E-2</c:v>
                </c:pt>
                <c:pt idx="2358">
                  <c:v>-0.12895322038600607</c:v>
                </c:pt>
                <c:pt idx="2359">
                  <c:v>-0.56384147888032798</c:v>
                </c:pt>
                <c:pt idx="2360">
                  <c:v>7.9325588958381987E-2</c:v>
                </c:pt>
                <c:pt idx="2361">
                  <c:v>-0.11036324336041807</c:v>
                </c:pt>
                <c:pt idx="2362">
                  <c:v>0.36922178725713822</c:v>
                </c:pt>
                <c:pt idx="2363">
                  <c:v>-6.8189258778968032E-2</c:v>
                </c:pt>
                <c:pt idx="2364">
                  <c:v>0.21943792382894031</c:v>
                </c:pt>
                <c:pt idx="2365">
                  <c:v>1.5520017904811976E-2</c:v>
                </c:pt>
                <c:pt idx="2366">
                  <c:v>-0.28557977040279481</c:v>
                </c:pt>
                <c:pt idx="2367">
                  <c:v>-5.1859298835249805E-2</c:v>
                </c:pt>
                <c:pt idx="2368">
                  <c:v>0.39973024649099526</c:v>
                </c:pt>
                <c:pt idx="2369">
                  <c:v>-0.14352403252161328</c:v>
                </c:pt>
                <c:pt idx="2370">
                  <c:v>-0.35219353774503176</c:v>
                </c:pt>
                <c:pt idx="2371">
                  <c:v>-3.4779158048018989E-2</c:v>
                </c:pt>
                <c:pt idx="2372">
                  <c:v>9.9741787565250248E-2</c:v>
                </c:pt>
                <c:pt idx="2373">
                  <c:v>-0.11330043583336068</c:v>
                </c:pt>
                <c:pt idx="2374">
                  <c:v>0.82036156506186775</c:v>
                </c:pt>
                <c:pt idx="2375">
                  <c:v>-0.2903064354249143</c:v>
                </c:pt>
                <c:pt idx="2376">
                  <c:v>1.6638308895359908</c:v>
                </c:pt>
                <c:pt idx="2377">
                  <c:v>-0.37506724206761038</c:v>
                </c:pt>
                <c:pt idx="2378">
                  <c:v>-9.1395186011700061E-2</c:v>
                </c:pt>
                <c:pt idx="2379">
                  <c:v>0.21574730659542007</c:v>
                </c:pt>
                <c:pt idx="2380">
                  <c:v>2.6351991783529854E-2</c:v>
                </c:pt>
                <c:pt idx="2381">
                  <c:v>-0.15458320905306844</c:v>
                </c:pt>
                <c:pt idx="2382">
                  <c:v>0.63017061984607103</c:v>
                </c:pt>
                <c:pt idx="2383">
                  <c:v>8.1461107488762743E-2</c:v>
                </c:pt>
                <c:pt idx="2384">
                  <c:v>-0.14482952083880901</c:v>
                </c:pt>
                <c:pt idx="2385">
                  <c:v>-0.4979444218777429</c:v>
                </c:pt>
                <c:pt idx="2386">
                  <c:v>-0.4798513867373489</c:v>
                </c:pt>
                <c:pt idx="2387">
                  <c:v>-1.478375262707031E-2</c:v>
                </c:pt>
                <c:pt idx="2388">
                  <c:v>-0.69537029164270514</c:v>
                </c:pt>
                <c:pt idx="2389">
                  <c:v>-0.35094978631020551</c:v>
                </c:pt>
                <c:pt idx="2390">
                  <c:v>0.42798348687105953</c:v>
                </c:pt>
                <c:pt idx="2391">
                  <c:v>-0.21200896011356482</c:v>
                </c:pt>
                <c:pt idx="2392">
                  <c:v>0.13241977779749536</c:v>
                </c:pt>
                <c:pt idx="2393">
                  <c:v>-4.2784398089239555E-2</c:v>
                </c:pt>
                <c:pt idx="2394">
                  <c:v>0.30935942138430667</c:v>
                </c:pt>
                <c:pt idx="2395">
                  <c:v>7.6888860768603282E-2</c:v>
                </c:pt>
                <c:pt idx="2396">
                  <c:v>0.19611170766217523</c:v>
                </c:pt>
                <c:pt idx="2397">
                  <c:v>0.10609421115363012</c:v>
                </c:pt>
                <c:pt idx="2398">
                  <c:v>-0.23695175858808054</c:v>
                </c:pt>
                <c:pt idx="2399">
                  <c:v>-3.2241931137493886E-2</c:v>
                </c:pt>
                <c:pt idx="2400">
                  <c:v>-0.52596862103308861</c:v>
                </c:pt>
                <c:pt idx="2401">
                  <c:v>0.2489648233321381</c:v>
                </c:pt>
                <c:pt idx="2402">
                  <c:v>0.1015981400078067</c:v>
                </c:pt>
                <c:pt idx="2403">
                  <c:v>0.15891248870406585</c:v>
                </c:pt>
                <c:pt idx="2404">
                  <c:v>-0.1632410851635431</c:v>
                </c:pt>
                <c:pt idx="2405">
                  <c:v>-0.1530270434648234</c:v>
                </c:pt>
                <c:pt idx="2406">
                  <c:v>-0.44731470025317616</c:v>
                </c:pt>
                <c:pt idx="2407">
                  <c:v>0.33606339364482973</c:v>
                </c:pt>
                <c:pt idx="2408">
                  <c:v>-0.31336195939221867</c:v>
                </c:pt>
                <c:pt idx="2409">
                  <c:v>-0.34528281759350843</c:v>
                </c:pt>
                <c:pt idx="2410">
                  <c:v>-0.1202192116249943</c:v>
                </c:pt>
                <c:pt idx="2411">
                  <c:v>9.4033024807720023E-2</c:v>
                </c:pt>
                <c:pt idx="2412">
                  <c:v>0.12626553203144181</c:v>
                </c:pt>
                <c:pt idx="2413">
                  <c:v>0.4289542796140286</c:v>
                </c:pt>
                <c:pt idx="2414">
                  <c:v>0.17853467619417446</c:v>
                </c:pt>
                <c:pt idx="2415">
                  <c:v>-0.14886904353100078</c:v>
                </c:pt>
                <c:pt idx="2416">
                  <c:v>0.4289542796140286</c:v>
                </c:pt>
                <c:pt idx="2417">
                  <c:v>0.75340949709481908</c:v>
                </c:pt>
                <c:pt idx="2418">
                  <c:v>-0.41348576790475927</c:v>
                </c:pt>
                <c:pt idx="2419">
                  <c:v>0.47032895165221683</c:v>
                </c:pt>
                <c:pt idx="2420">
                  <c:v>-0.39187767727786604</c:v>
                </c:pt>
                <c:pt idx="2421">
                  <c:v>-0.16040392586001356</c:v>
                </c:pt>
                <c:pt idx="2422">
                  <c:v>5.9043977614659619E-2</c:v>
                </c:pt>
                <c:pt idx="2423">
                  <c:v>-0.24098590402473871</c:v>
                </c:pt>
                <c:pt idx="2424">
                  <c:v>0.34905166978025831</c:v>
                </c:pt>
                <c:pt idx="2425">
                  <c:v>4.045212057948791E-3</c:v>
                </c:pt>
                <c:pt idx="2426">
                  <c:v>0.30507524588002571</c:v>
                </c:pt>
                <c:pt idx="2427">
                  <c:v>-0.16401388852505702</c:v>
                </c:pt>
                <c:pt idx="2428">
                  <c:v>-2.4504992348224289E-3</c:v>
                </c:pt>
                <c:pt idx="2429">
                  <c:v>0.42643157596074055</c:v>
                </c:pt>
                <c:pt idx="2430">
                  <c:v>7.9478021209660979E-2</c:v>
                </c:pt>
                <c:pt idx="2431">
                  <c:v>0.17984146526983541</c:v>
                </c:pt>
                <c:pt idx="2432">
                  <c:v>5.2595665153199467E-2</c:v>
                </c:pt>
                <c:pt idx="2433">
                  <c:v>-0.13855237515264865</c:v>
                </c:pt>
                <c:pt idx="2434">
                  <c:v>-0.86203473995523283</c:v>
                </c:pt>
                <c:pt idx="2435">
                  <c:v>7.2027716724453877E-2</c:v>
                </c:pt>
                <c:pt idx="2436">
                  <c:v>0.15296521088043374</c:v>
                </c:pt>
                <c:pt idx="2437">
                  <c:v>5.2030733086129953E-3</c:v>
                </c:pt>
                <c:pt idx="2438">
                  <c:v>0.68454970001506754</c:v>
                </c:pt>
                <c:pt idx="2439">
                  <c:v>0.31079031169836979</c:v>
                </c:pt>
                <c:pt idx="2440">
                  <c:v>-0.20664322398339544</c:v>
                </c:pt>
                <c:pt idx="2441">
                  <c:v>0.17869796011047018</c:v>
                </c:pt>
                <c:pt idx="2442">
                  <c:v>8.7273499951473529E-2</c:v>
                </c:pt>
                <c:pt idx="2443">
                  <c:v>-0.14287084509664238</c:v>
                </c:pt>
                <c:pt idx="2444">
                  <c:v>-0.60207674842382886</c:v>
                </c:pt>
                <c:pt idx="2445">
                  <c:v>-0.51288423140840789</c:v>
                </c:pt>
                <c:pt idx="2446">
                  <c:v>0.57669076275761311</c:v>
                </c:pt>
                <c:pt idx="2447">
                  <c:v>-0.15445359267987244</c:v>
                </c:pt>
                <c:pt idx="2448">
                  <c:v>0.44575498044990214</c:v>
                </c:pt>
                <c:pt idx="2449">
                  <c:v>6.6125258284644245E-2</c:v>
                </c:pt>
                <c:pt idx="2450">
                  <c:v>8.8040034713085177E-2</c:v>
                </c:pt>
                <c:pt idx="2451">
                  <c:v>-0.17504548611091383</c:v>
                </c:pt>
                <c:pt idx="2452">
                  <c:v>0.13336891930599901</c:v>
                </c:pt>
                <c:pt idx="2453">
                  <c:v>0.15440959115214536</c:v>
                </c:pt>
                <c:pt idx="2454">
                  <c:v>-0.94747914596667471</c:v>
                </c:pt>
                <c:pt idx="2455">
                  <c:v>-4.3484497603579503E-2</c:v>
                </c:pt>
                <c:pt idx="2456">
                  <c:v>-0.21175983301211865</c:v>
                </c:pt>
                <c:pt idx="2457">
                  <c:v>-0.23094077612394043</c:v>
                </c:pt>
                <c:pt idx="2458">
                  <c:v>4.8412205185245916E-2</c:v>
                </c:pt>
                <c:pt idx="2459">
                  <c:v>0.32734837067161515</c:v>
                </c:pt>
                <c:pt idx="2460">
                  <c:v>-0.55865948441215851</c:v>
                </c:pt>
                <c:pt idx="2461">
                  <c:v>0.47814519728979449</c:v>
                </c:pt>
                <c:pt idx="2462">
                  <c:v>-0.37673490499852191</c:v>
                </c:pt>
                <c:pt idx="2463">
                  <c:v>0.81502154030666918</c:v>
                </c:pt>
                <c:pt idx="2464">
                  <c:v>-0.14260948729866504</c:v>
                </c:pt>
                <c:pt idx="2465">
                  <c:v>0.41888982477445036</c:v>
                </c:pt>
                <c:pt idx="2466">
                  <c:v>-0.42007811597937394</c:v>
                </c:pt>
                <c:pt idx="2467">
                  <c:v>0.1929748745013562</c:v>
                </c:pt>
                <c:pt idx="2468">
                  <c:v>-8.2566351071411803E-2</c:v>
                </c:pt>
                <c:pt idx="2469">
                  <c:v>-0.4432883748171435</c:v>
                </c:pt>
                <c:pt idx="2470">
                  <c:v>-2.729562405090754E-2</c:v>
                </c:pt>
                <c:pt idx="2471">
                  <c:v>0.15152227523000486</c:v>
                </c:pt>
                <c:pt idx="2472">
                  <c:v>-0.25628607058509173</c:v>
                </c:pt>
                <c:pt idx="2473">
                  <c:v>1.8439567703944237E-2</c:v>
                </c:pt>
                <c:pt idx="2474">
                  <c:v>0.46932992450829392</c:v>
                </c:pt>
                <c:pt idx="2475">
                  <c:v>0.30775136432662148</c:v>
                </c:pt>
                <c:pt idx="2476">
                  <c:v>0.44065503345811374</c:v>
                </c:pt>
                <c:pt idx="2477">
                  <c:v>-1.9061365093430219E-2</c:v>
                </c:pt>
                <c:pt idx="2478">
                  <c:v>0.16423758130530874</c:v>
                </c:pt>
                <c:pt idx="2479">
                  <c:v>8.2071836692883426E-2</c:v>
                </c:pt>
                <c:pt idx="2480">
                  <c:v>-0.42974985080021599</c:v>
                </c:pt>
                <c:pt idx="2481">
                  <c:v>0.13226164823731201</c:v>
                </c:pt>
                <c:pt idx="2482">
                  <c:v>-0.261470639012782</c:v>
                </c:pt>
                <c:pt idx="2483">
                  <c:v>-1.0493419248452684E-2</c:v>
                </c:pt>
                <c:pt idx="2484">
                  <c:v>-3.1677496450760192E-2</c:v>
                </c:pt>
                <c:pt idx="2485">
                  <c:v>-0.20551763289270669</c:v>
                </c:pt>
                <c:pt idx="2486">
                  <c:v>-0.19333019538430429</c:v>
                </c:pt>
                <c:pt idx="2487">
                  <c:v>-0.29924465779607262</c:v>
                </c:pt>
                <c:pt idx="2488">
                  <c:v>0.12123542873264555</c:v>
                </c:pt>
                <c:pt idx="2489">
                  <c:v>-0.69260573840809536</c:v>
                </c:pt>
                <c:pt idx="2490">
                  <c:v>0.18754284841954269</c:v>
                </c:pt>
                <c:pt idx="2491">
                  <c:v>0.14003045177897405</c:v>
                </c:pt>
                <c:pt idx="2492">
                  <c:v>-0.55316387050949656</c:v>
                </c:pt>
                <c:pt idx="2493">
                  <c:v>-0.54497988325580382</c:v>
                </c:pt>
                <c:pt idx="2494">
                  <c:v>-3.1959741397545004E-2</c:v>
                </c:pt>
                <c:pt idx="2495">
                  <c:v>-0.16825692320858163</c:v>
                </c:pt>
                <c:pt idx="2496">
                  <c:v>-0.13343200698073493</c:v>
                </c:pt>
                <c:pt idx="2497">
                  <c:v>-0.39824090526446843</c:v>
                </c:pt>
                <c:pt idx="2498">
                  <c:v>0.34997075947235406</c:v>
                </c:pt>
                <c:pt idx="2499">
                  <c:v>0.12264837355073749</c:v>
                </c:pt>
                <c:pt idx="2500">
                  <c:v>-0.20551763289270669</c:v>
                </c:pt>
                <c:pt idx="2501">
                  <c:v>2.4589921285533362E-2</c:v>
                </c:pt>
                <c:pt idx="2502">
                  <c:v>0.39535930381534051</c:v>
                </c:pt>
                <c:pt idx="2503">
                  <c:v>0.73048803009500118</c:v>
                </c:pt>
                <c:pt idx="2504">
                  <c:v>-1.7605190371529962</c:v>
                </c:pt>
                <c:pt idx="2505">
                  <c:v>0.14480759204084617</c:v>
                </c:pt>
                <c:pt idx="2506">
                  <c:v>9.6498907328163228E-2</c:v>
                </c:pt>
                <c:pt idx="2507">
                  <c:v>-0.22032995487955548</c:v>
                </c:pt>
                <c:pt idx="2508">
                  <c:v>-0.86916073840011721</c:v>
                </c:pt>
                <c:pt idx="2509">
                  <c:v>-0.38636951908687456</c:v>
                </c:pt>
                <c:pt idx="2510">
                  <c:v>-0.2520522750315129</c:v>
                </c:pt>
                <c:pt idx="2511">
                  <c:v>0.20756106993536205</c:v>
                </c:pt>
                <c:pt idx="2512">
                  <c:v>-0.12670860219696833</c:v>
                </c:pt>
                <c:pt idx="2513">
                  <c:v>-9.7206245974365821E-2</c:v>
                </c:pt>
                <c:pt idx="2514">
                  <c:v>-0.16697247241069541</c:v>
                </c:pt>
                <c:pt idx="2515">
                  <c:v>-0.78005807789837478</c:v>
                </c:pt>
                <c:pt idx="2516">
                  <c:v>0.41407602304139884</c:v>
                </c:pt>
                <c:pt idx="2517">
                  <c:v>-0.17223146882548127</c:v>
                </c:pt>
                <c:pt idx="2518">
                  <c:v>0.27596098423273202</c:v>
                </c:pt>
                <c:pt idx="2519">
                  <c:v>-0.48758924832086231</c:v>
                </c:pt>
                <c:pt idx="2520">
                  <c:v>0.1914913833260255</c:v>
                </c:pt>
                <c:pt idx="2521">
                  <c:v>-0.66138477617975844</c:v>
                </c:pt>
                <c:pt idx="2522">
                  <c:v>-0.14938944935894985</c:v>
                </c:pt>
                <c:pt idx="2523">
                  <c:v>0.1837689496578922</c:v>
                </c:pt>
                <c:pt idx="2524">
                  <c:v>-0.73569546359076898</c:v>
                </c:pt>
                <c:pt idx="2525">
                  <c:v>-0.17056605679206854</c:v>
                </c:pt>
                <c:pt idx="2526">
                  <c:v>0.24622433566798188</c:v>
                </c:pt>
                <c:pt idx="2527">
                  <c:v>-0.32711247074708544</c:v>
                </c:pt>
                <c:pt idx="2528">
                  <c:v>-0.27822269799152832</c:v>
                </c:pt>
                <c:pt idx="2529">
                  <c:v>0.18524451719012613</c:v>
                </c:pt>
                <c:pt idx="2530">
                  <c:v>4.5580321867076064E-2</c:v>
                </c:pt>
                <c:pt idx="2531">
                  <c:v>-0.22823379956006801</c:v>
                </c:pt>
                <c:pt idx="2532">
                  <c:v>-0.65480212578979058</c:v>
                </c:pt>
                <c:pt idx="2533">
                  <c:v>-0.71545412711571765</c:v>
                </c:pt>
                <c:pt idx="2534">
                  <c:v>-6.5296567127780938E-2</c:v>
                </c:pt>
                <c:pt idx="2535">
                  <c:v>0.30650189127775485</c:v>
                </c:pt>
                <c:pt idx="2536">
                  <c:v>1.6687128932879207E-2</c:v>
                </c:pt>
                <c:pt idx="2537">
                  <c:v>-0.30439421966803021</c:v>
                </c:pt>
                <c:pt idx="2538">
                  <c:v>0.20756106993536205</c:v>
                </c:pt>
                <c:pt idx="2539">
                  <c:v>-0.36804193059476764</c:v>
                </c:pt>
                <c:pt idx="2540">
                  <c:v>-0.27034952873310286</c:v>
                </c:pt>
                <c:pt idx="2541">
                  <c:v>-0.23890911669840439</c:v>
                </c:pt>
                <c:pt idx="2542">
                  <c:v>-1.0684644509669059</c:v>
                </c:pt>
                <c:pt idx="2543">
                  <c:v>0.83392732405329395</c:v>
                </c:pt>
                <c:pt idx="2544">
                  <c:v>-0.6535186707535996</c:v>
                </c:pt>
                <c:pt idx="2545">
                  <c:v>-0.28688114778816154</c:v>
                </c:pt>
                <c:pt idx="2546">
                  <c:v>3.8006322579745053E-2</c:v>
                </c:pt>
                <c:pt idx="2547">
                  <c:v>-0.32481060342048373</c:v>
                </c:pt>
                <c:pt idx="2548">
                  <c:v>7.0814985716076667E-2</c:v>
                </c:pt>
                <c:pt idx="2549">
                  <c:v>0.11622280248379367</c:v>
                </c:pt>
                <c:pt idx="2550">
                  <c:v>-0.14574266027760552</c:v>
                </c:pt>
                <c:pt idx="2551">
                  <c:v>-4.2224073762984954E-2</c:v>
                </c:pt>
                <c:pt idx="2552">
                  <c:v>-0.67572561879683646</c:v>
                </c:pt>
                <c:pt idx="2553">
                  <c:v>-0.18142064028014168</c:v>
                </c:pt>
                <c:pt idx="2554">
                  <c:v>-8.2838814724891699E-2</c:v>
                </c:pt>
                <c:pt idx="2555">
                  <c:v>0.26465112981411459</c:v>
                </c:pt>
                <c:pt idx="2556">
                  <c:v>-9.3965750369447515E-2</c:v>
                </c:pt>
                <c:pt idx="2557">
                  <c:v>0.35642083426828514</c:v>
                </c:pt>
                <c:pt idx="2558">
                  <c:v>-5.4640130538345412E-2</c:v>
                </c:pt>
                <c:pt idx="2559">
                  <c:v>-0.24926328606119341</c:v>
                </c:pt>
                <c:pt idx="2560">
                  <c:v>4.4687196555294524E-2</c:v>
                </c:pt>
                <c:pt idx="2561">
                  <c:v>0.33460722895810863</c:v>
                </c:pt>
                <c:pt idx="2562">
                  <c:v>-0.28829949465733073</c:v>
                </c:pt>
                <c:pt idx="2563">
                  <c:v>-0.5226584206342787</c:v>
                </c:pt>
                <c:pt idx="2564">
                  <c:v>-0.58120660883682096</c:v>
                </c:pt>
                <c:pt idx="2565">
                  <c:v>-0.57715083697446867</c:v>
                </c:pt>
                <c:pt idx="2566">
                  <c:v>-0.4439248579337417</c:v>
                </c:pt>
                <c:pt idx="2567">
                  <c:v>-0.15704371014557997</c:v>
                </c:pt>
                <c:pt idx="2568">
                  <c:v>-0.28723586525277423</c:v>
                </c:pt>
                <c:pt idx="2569">
                  <c:v>0.56341170633988236</c:v>
                </c:pt>
                <c:pt idx="2570">
                  <c:v>0.4206267329326126</c:v>
                </c:pt>
                <c:pt idx="2571">
                  <c:v>-0.12829340100981748</c:v>
                </c:pt>
                <c:pt idx="2572">
                  <c:v>-0.21088754922081027</c:v>
                </c:pt>
                <c:pt idx="2573">
                  <c:v>0.73937209187330133</c:v>
                </c:pt>
                <c:pt idx="2574">
                  <c:v>0.4408508522627429</c:v>
                </c:pt>
                <c:pt idx="2575">
                  <c:v>1.1568201097428259</c:v>
                </c:pt>
                <c:pt idx="2576">
                  <c:v>-0.34482849699744128</c:v>
                </c:pt>
                <c:pt idx="2577">
                  <c:v>0.15987922653846784</c:v>
                </c:pt>
                <c:pt idx="2578">
                  <c:v>0.56789577653132295</c:v>
                </c:pt>
                <c:pt idx="2579">
                  <c:v>-0.85127930838577515</c:v>
                </c:pt>
                <c:pt idx="2580">
                  <c:v>-0.21387604338294244</c:v>
                </c:pt>
                <c:pt idx="2581">
                  <c:v>0.41599961671422742</c:v>
                </c:pt>
                <c:pt idx="2582">
                  <c:v>-0.34947851451910866</c:v>
                </c:pt>
                <c:pt idx="2583">
                  <c:v>-5.7970068637329869E-2</c:v>
                </c:pt>
                <c:pt idx="2584">
                  <c:v>-5.2833199762944642E-2</c:v>
                </c:pt>
                <c:pt idx="2585">
                  <c:v>0.23854450717727954</c:v>
                </c:pt>
                <c:pt idx="2586">
                  <c:v>-0.17095055331836753</c:v>
                </c:pt>
                <c:pt idx="2587">
                  <c:v>-0.29595806772082212</c:v>
                </c:pt>
                <c:pt idx="2588">
                  <c:v>-0.30987466003676639</c:v>
                </c:pt>
                <c:pt idx="2589">
                  <c:v>7.2315692310757299E-3</c:v>
                </c:pt>
                <c:pt idx="2590">
                  <c:v>1.0309139934700597</c:v>
                </c:pt>
                <c:pt idx="2591">
                  <c:v>-0.36971772941356534</c:v>
                </c:pt>
                <c:pt idx="2592">
                  <c:v>-0.42115596066222349</c:v>
                </c:pt>
                <c:pt idx="2593">
                  <c:v>-5.7138304393541721E-2</c:v>
                </c:pt>
                <c:pt idx="2594">
                  <c:v>-3.9559557255705827E-2</c:v>
                </c:pt>
                <c:pt idx="2595">
                  <c:v>-0.18154785645595636</c:v>
                </c:pt>
                <c:pt idx="2596">
                  <c:v>4.8710621783866807E-2</c:v>
                </c:pt>
                <c:pt idx="2597">
                  <c:v>0.20207395027412228</c:v>
                </c:pt>
                <c:pt idx="2598">
                  <c:v>-0.40849448946944411</c:v>
                </c:pt>
                <c:pt idx="2599">
                  <c:v>-0.16722945407166859</c:v>
                </c:pt>
                <c:pt idx="2600">
                  <c:v>0.16974467583231712</c:v>
                </c:pt>
                <c:pt idx="2601">
                  <c:v>-8.6535744325329299E-4</c:v>
                </c:pt>
                <c:pt idx="2602">
                  <c:v>0.58922474099175781</c:v>
                </c:pt>
                <c:pt idx="2603">
                  <c:v>0.18016834757346301</c:v>
                </c:pt>
                <c:pt idx="2604">
                  <c:v>-0.36300282298867942</c:v>
                </c:pt>
                <c:pt idx="2605">
                  <c:v>-3.3652052489997121E-2</c:v>
                </c:pt>
                <c:pt idx="2606">
                  <c:v>-0.16671544496642235</c:v>
                </c:pt>
                <c:pt idx="2607">
                  <c:v>-0.1983684231025194</c:v>
                </c:pt>
                <c:pt idx="2608">
                  <c:v>2.3709692435232421E-2</c:v>
                </c:pt>
                <c:pt idx="2609">
                  <c:v>-0.19067806561753309</c:v>
                </c:pt>
                <c:pt idx="2610">
                  <c:v>-0.34539637539126772</c:v>
                </c:pt>
                <c:pt idx="2611">
                  <c:v>-0.16954023145979721</c:v>
                </c:pt>
                <c:pt idx="2612">
                  <c:v>-4.6281503211910241E-2</c:v>
                </c:pt>
                <c:pt idx="2613">
                  <c:v>-0.38758311954461105</c:v>
                </c:pt>
                <c:pt idx="2614">
                  <c:v>8.2468877554854846E-3</c:v>
                </c:pt>
                <c:pt idx="2615">
                  <c:v>-0.46288993840970843</c:v>
                </c:pt>
                <c:pt idx="2616">
                  <c:v>0.36810414094619553</c:v>
                </c:pt>
                <c:pt idx="2617">
                  <c:v>-0.13343200698073493</c:v>
                </c:pt>
                <c:pt idx="2618">
                  <c:v>0.1313132346778651</c:v>
                </c:pt>
                <c:pt idx="2619">
                  <c:v>-0.21151066288353917</c:v>
                </c:pt>
                <c:pt idx="2620">
                  <c:v>-0.742954756697492</c:v>
                </c:pt>
                <c:pt idx="2621">
                  <c:v>-7.9702371697378219E-2</c:v>
                </c:pt>
                <c:pt idx="2622">
                  <c:v>0.41062000452203595</c:v>
                </c:pt>
                <c:pt idx="2623">
                  <c:v>-0.41619119389521425</c:v>
                </c:pt>
                <c:pt idx="2624">
                  <c:v>7.5064011733197183E-2</c:v>
                </c:pt>
                <c:pt idx="2625">
                  <c:v>5.0203631376793977E-2</c:v>
                </c:pt>
                <c:pt idx="2626">
                  <c:v>8.1003230190799608E-2</c:v>
                </c:pt>
                <c:pt idx="2627">
                  <c:v>0.69035812657783946</c:v>
                </c:pt>
                <c:pt idx="2628">
                  <c:v>-5.8247216854662762E-2</c:v>
                </c:pt>
                <c:pt idx="2629">
                  <c:v>-8.6535744325329299E-4</c:v>
                </c:pt>
                <c:pt idx="2630">
                  <c:v>-0.27453004467162323</c:v>
                </c:pt>
                <c:pt idx="2631">
                  <c:v>-0.10017031975697697</c:v>
                </c:pt>
                <c:pt idx="2632">
                  <c:v>8.3919916068413859E-3</c:v>
                </c:pt>
                <c:pt idx="2633">
                  <c:v>0.24092940919309916</c:v>
                </c:pt>
                <c:pt idx="2634">
                  <c:v>0.16504613092064882</c:v>
                </c:pt>
                <c:pt idx="2635">
                  <c:v>-0.7689253355637512</c:v>
                </c:pt>
                <c:pt idx="2636">
                  <c:v>0.20989525865354569</c:v>
                </c:pt>
                <c:pt idx="2637">
                  <c:v>0.46374812106271068</c:v>
                </c:pt>
                <c:pt idx="2638">
                  <c:v>0.41734765996604478</c:v>
                </c:pt>
                <c:pt idx="2639">
                  <c:v>0.11669199703751625</c:v>
                </c:pt>
                <c:pt idx="2640">
                  <c:v>-0.89242988586252148</c:v>
                </c:pt>
                <c:pt idx="2641">
                  <c:v>-0.21549222999098055</c:v>
                </c:pt>
                <c:pt idx="2642">
                  <c:v>0.37501012690152896</c:v>
                </c:pt>
                <c:pt idx="2643">
                  <c:v>-0.19962523565773241</c:v>
                </c:pt>
                <c:pt idx="2644">
                  <c:v>-0.10138114235502453</c:v>
                </c:pt>
                <c:pt idx="2645">
                  <c:v>-0.20676823546832154</c:v>
                </c:pt>
                <c:pt idx="2646">
                  <c:v>-0.21051355180046855</c:v>
                </c:pt>
                <c:pt idx="2647">
                  <c:v>-0.10675031506086764</c:v>
                </c:pt>
                <c:pt idx="2648">
                  <c:v>-4.4603950649767965E-2</c:v>
                </c:pt>
                <c:pt idx="2649">
                  <c:v>0.16456094677587452</c:v>
                </c:pt>
                <c:pt idx="2650">
                  <c:v>8.4211427188055091E-2</c:v>
                </c:pt>
                <c:pt idx="2651">
                  <c:v>-1.0051843758597232</c:v>
                </c:pt>
                <c:pt idx="2652">
                  <c:v>0.23192156498354444</c:v>
                </c:pt>
                <c:pt idx="2653">
                  <c:v>-0.57444064086413371</c:v>
                </c:pt>
                <c:pt idx="2654">
                  <c:v>-1.3771237491294872</c:v>
                </c:pt>
                <c:pt idx="2655">
                  <c:v>0.12421993693151206</c:v>
                </c:pt>
                <c:pt idx="2656">
                  <c:v>-0.25290002870008071</c:v>
                </c:pt>
                <c:pt idx="2657">
                  <c:v>-0.31938671454410283</c:v>
                </c:pt>
                <c:pt idx="2658">
                  <c:v>0.11716134423274914</c:v>
                </c:pt>
                <c:pt idx="2659">
                  <c:v>-0.15665548884685973</c:v>
                </c:pt>
                <c:pt idx="2660">
                  <c:v>-7.2448850069692455E-2</c:v>
                </c:pt>
                <c:pt idx="2661">
                  <c:v>-0.41802798992652396</c:v>
                </c:pt>
                <c:pt idx="2662">
                  <c:v>0.51560403749733374</c:v>
                </c:pt>
                <c:pt idx="2663">
                  <c:v>-0.37462220619120751</c:v>
                </c:pt>
                <c:pt idx="2664">
                  <c:v>-0.47653722581771041</c:v>
                </c:pt>
                <c:pt idx="2665">
                  <c:v>-0.38515489688434384</c:v>
                </c:pt>
                <c:pt idx="2666">
                  <c:v>0.3415371388258906</c:v>
                </c:pt>
                <c:pt idx="2667">
                  <c:v>7.430433869111211E-2</c:v>
                </c:pt>
                <c:pt idx="2668">
                  <c:v>2.4305089080412841</c:v>
                </c:pt>
                <c:pt idx="2669">
                  <c:v>0.23446525363702297</c:v>
                </c:pt>
                <c:pt idx="2670">
                  <c:v>-5.9216816553798721E-2</c:v>
                </c:pt>
                <c:pt idx="2671">
                  <c:v>-4.5722535734600604E-2</c:v>
                </c:pt>
                <c:pt idx="2672">
                  <c:v>0.20489804187717531</c:v>
                </c:pt>
                <c:pt idx="2673">
                  <c:v>-7.9838880666670498E-2</c:v>
                </c:pt>
                <c:pt idx="2674">
                  <c:v>-1.0636636108737023E-2</c:v>
                </c:pt>
                <c:pt idx="2675">
                  <c:v>-4.3204498565167553E-2</c:v>
                </c:pt>
                <c:pt idx="2676">
                  <c:v>-9.0175949790206933E-2</c:v>
                </c:pt>
                <c:pt idx="2677">
                  <c:v>-0.63170964478560276</c:v>
                </c:pt>
                <c:pt idx="2678">
                  <c:v>-0.29631056070809231</c:v>
                </c:pt>
                <c:pt idx="2679">
                  <c:v>8.9267338097087298E-2</c:v>
                </c:pt>
                <c:pt idx="2680">
                  <c:v>-0.27022990723799778</c:v>
                </c:pt>
                <c:pt idx="2681">
                  <c:v>-6.1568849268002775E-2</c:v>
                </c:pt>
                <c:pt idx="2682">
                  <c:v>-0.18129341288547496</c:v>
                </c:pt>
                <c:pt idx="2683">
                  <c:v>-0.51611603124138195</c:v>
                </c:pt>
                <c:pt idx="2684">
                  <c:v>0.43654896632933232</c:v>
                </c:pt>
                <c:pt idx="2685">
                  <c:v>4.9158362450851298E-2</c:v>
                </c:pt>
                <c:pt idx="2686">
                  <c:v>0.54224813127260652</c:v>
                </c:pt>
                <c:pt idx="2687">
                  <c:v>-4.1383179019406177E-2</c:v>
                </c:pt>
                <c:pt idx="2688">
                  <c:v>-8.6104371243290859E-2</c:v>
                </c:pt>
                <c:pt idx="2689">
                  <c:v>5.7992286312036151E-2</c:v>
                </c:pt>
                <c:pt idx="2690">
                  <c:v>-0.46351783412869663</c:v>
                </c:pt>
                <c:pt idx="2691">
                  <c:v>-5.5473335898431508E-2</c:v>
                </c:pt>
                <c:pt idx="2692">
                  <c:v>-0.29313501904332101</c:v>
                </c:pt>
                <c:pt idx="2693">
                  <c:v>-0.53664975402003412</c:v>
                </c:pt>
                <c:pt idx="2694">
                  <c:v>0.30685877316971416</c:v>
                </c:pt>
                <c:pt idx="2695">
                  <c:v>-1.0545706750324282</c:v>
                </c:pt>
                <c:pt idx="2696">
                  <c:v>0.33079177482836164</c:v>
                </c:pt>
                <c:pt idx="2697">
                  <c:v>0.3384328004728544</c:v>
                </c:pt>
                <c:pt idx="2698">
                  <c:v>0.23735353296184941</c:v>
                </c:pt>
                <c:pt idx="2699">
                  <c:v>-0.59931779369822624</c:v>
                </c:pt>
                <c:pt idx="2700">
                  <c:v>-0.32550154933449976</c:v>
                </c:pt>
                <c:pt idx="2701">
                  <c:v>0.45343886431475061</c:v>
                </c:pt>
                <c:pt idx="2702">
                  <c:v>-0.88479326254352653</c:v>
                </c:pt>
                <c:pt idx="2703">
                  <c:v>-0.85885629619133663</c:v>
                </c:pt>
                <c:pt idx="2704">
                  <c:v>-0.47217580367238565</c:v>
                </c:pt>
                <c:pt idx="2705">
                  <c:v>-0.35772089561481024</c:v>
                </c:pt>
                <c:pt idx="2706">
                  <c:v>-0.14808808264533602</c:v>
                </c:pt>
                <c:pt idx="2707">
                  <c:v>0.20190799927136394</c:v>
                </c:pt>
                <c:pt idx="2708">
                  <c:v>-0.13066733981550696</c:v>
                </c:pt>
                <c:pt idx="2709">
                  <c:v>0.11481613367964895</c:v>
                </c:pt>
                <c:pt idx="2710">
                  <c:v>0.21608242739620423</c:v>
                </c:pt>
                <c:pt idx="2711">
                  <c:v>0.23701343511942355</c:v>
                </c:pt>
                <c:pt idx="2712">
                  <c:v>0.70627639009506593</c:v>
                </c:pt>
                <c:pt idx="2713">
                  <c:v>-0.37250640898616882</c:v>
                </c:pt>
                <c:pt idx="2714">
                  <c:v>-0.42083269180157618</c:v>
                </c:pt>
                <c:pt idx="2715">
                  <c:v>-0.64634701535134464</c:v>
                </c:pt>
                <c:pt idx="2716">
                  <c:v>-1.0063683344697424E-2</c:v>
                </c:pt>
                <c:pt idx="2717">
                  <c:v>9.4957236909082962E-2</c:v>
                </c:pt>
                <c:pt idx="2718">
                  <c:v>0.3889220711682379</c:v>
                </c:pt>
                <c:pt idx="2719">
                  <c:v>-8.5288674816987389E-2</c:v>
                </c:pt>
                <c:pt idx="2720">
                  <c:v>0.26153478266022367</c:v>
                </c:pt>
                <c:pt idx="2721">
                  <c:v>-0.47425431583264238</c:v>
                </c:pt>
                <c:pt idx="2722">
                  <c:v>-9.3289730001476709E-2</c:v>
                </c:pt>
                <c:pt idx="2723">
                  <c:v>0.17706595197162875</c:v>
                </c:pt>
                <c:pt idx="2724">
                  <c:v>0.22465441592596011</c:v>
                </c:pt>
                <c:pt idx="2725">
                  <c:v>0.21206610639592413</c:v>
                </c:pt>
                <c:pt idx="2726">
                  <c:v>6.8846469479773936E-2</c:v>
                </c:pt>
                <c:pt idx="2727">
                  <c:v>0.26760054046136289</c:v>
                </c:pt>
                <c:pt idx="2728">
                  <c:v>0.29867274258705928</c:v>
                </c:pt>
                <c:pt idx="2729">
                  <c:v>-5.9632159882099564E-2</c:v>
                </c:pt>
                <c:pt idx="2730">
                  <c:v>0.1302075396233352</c:v>
                </c:pt>
                <c:pt idx="2731">
                  <c:v>2.3101606872010416E-3</c:v>
                </c:pt>
                <c:pt idx="2732">
                  <c:v>-0.36176835941915342</c:v>
                </c:pt>
                <c:pt idx="2733">
                  <c:v>-0.38989716211509579</c:v>
                </c:pt>
                <c:pt idx="2734">
                  <c:v>0.19462498910523179</c:v>
                </c:pt>
                <c:pt idx="2735">
                  <c:v>-0.28640805546029896</c:v>
                </c:pt>
                <c:pt idx="2736">
                  <c:v>-0.43221114917121922</c:v>
                </c:pt>
                <c:pt idx="2737">
                  <c:v>0.31293931166010763</c:v>
                </c:pt>
                <c:pt idx="2738">
                  <c:v>0.50001383557812584</c:v>
                </c:pt>
                <c:pt idx="2739">
                  <c:v>-0.30275771563803605</c:v>
                </c:pt>
                <c:pt idx="2740">
                  <c:v>-0.1955995754499035</c:v>
                </c:pt>
                <c:pt idx="2741">
                  <c:v>0.28208783035557117</c:v>
                </c:pt>
                <c:pt idx="2742">
                  <c:v>-0.29242839288671785</c:v>
                </c:pt>
                <c:pt idx="2743">
                  <c:v>0.54814270552346023</c:v>
                </c:pt>
                <c:pt idx="2744">
                  <c:v>0.11700487820137304</c:v>
                </c:pt>
                <c:pt idx="2745">
                  <c:v>-0.45459705653454957</c:v>
                </c:pt>
                <c:pt idx="2746">
                  <c:v>-1.9630756335508377E-2</c:v>
                </c:pt>
                <c:pt idx="2747">
                  <c:v>-0.58361535658455777</c:v>
                </c:pt>
                <c:pt idx="2748">
                  <c:v>-0.16362753858990581</c:v>
                </c:pt>
                <c:pt idx="2749">
                  <c:v>0.32499708380607312</c:v>
                </c:pt>
                <c:pt idx="2750">
                  <c:v>-9.2613392714283788E-2</c:v>
                </c:pt>
                <c:pt idx="2751">
                  <c:v>0.24639546372000473</c:v>
                </c:pt>
                <c:pt idx="2752">
                  <c:v>-0.41446030581609811</c:v>
                </c:pt>
                <c:pt idx="2753">
                  <c:v>0.25790753191875176</c:v>
                </c:pt>
                <c:pt idx="2754">
                  <c:v>5.347871325584755E-3</c:v>
                </c:pt>
                <c:pt idx="2755">
                  <c:v>4.4984843562929477E-2</c:v>
                </c:pt>
                <c:pt idx="2756">
                  <c:v>5.3643428366366007E-2</c:v>
                </c:pt>
                <c:pt idx="2757">
                  <c:v>-0.19522159325284463</c:v>
                </c:pt>
                <c:pt idx="2758">
                  <c:v>0.12736820886475</c:v>
                </c:pt>
                <c:pt idx="2759">
                  <c:v>-6.3226801996981372E-2</c:v>
                </c:pt>
                <c:pt idx="2760">
                  <c:v>6.7334051854221449E-2</c:v>
                </c:pt>
                <c:pt idx="2761">
                  <c:v>-0.11889125217842655</c:v>
                </c:pt>
                <c:pt idx="2762">
                  <c:v>-0.11063050809643449</c:v>
                </c:pt>
                <c:pt idx="2763">
                  <c:v>-2.431967919541294E-2</c:v>
                </c:pt>
                <c:pt idx="2764">
                  <c:v>-0.19949960366036229</c:v>
                </c:pt>
                <c:pt idx="2765">
                  <c:v>0.54772086486522376</c:v>
                </c:pt>
                <c:pt idx="2766">
                  <c:v>-0.2860531343774752</c:v>
                </c:pt>
                <c:pt idx="2767">
                  <c:v>3.0177210327092058E-2</c:v>
                </c:pt>
                <c:pt idx="2768">
                  <c:v>-0.36971772941356534</c:v>
                </c:pt>
                <c:pt idx="2769">
                  <c:v>0.28138630102451556</c:v>
                </c:pt>
                <c:pt idx="2770">
                  <c:v>-3.5905383742127997E-2</c:v>
                </c:pt>
                <c:pt idx="2771">
                  <c:v>0.99855802582609376</c:v>
                </c:pt>
                <c:pt idx="2772">
                  <c:v>-0.46058531325366786</c:v>
                </c:pt>
                <c:pt idx="2773">
                  <c:v>9.989639240287207E-2</c:v>
                </c:pt>
                <c:pt idx="2774">
                  <c:v>0.48883561141615006</c:v>
                </c:pt>
                <c:pt idx="2775">
                  <c:v>-0.11356715704707813</c:v>
                </c:pt>
                <c:pt idx="2776">
                  <c:v>-0.75634015225185269</c:v>
                </c:pt>
                <c:pt idx="2777">
                  <c:v>-0.35974604690547085</c:v>
                </c:pt>
                <c:pt idx="2778">
                  <c:v>-0.3853758133599135</c:v>
                </c:pt>
                <c:pt idx="2779">
                  <c:v>-0.19949960366036229</c:v>
                </c:pt>
                <c:pt idx="2780">
                  <c:v>-4.1943829970167296E-2</c:v>
                </c:pt>
                <c:pt idx="2781">
                  <c:v>-0.46946925326726568</c:v>
                </c:pt>
                <c:pt idx="2782">
                  <c:v>0.19826189843354244</c:v>
                </c:pt>
                <c:pt idx="2783">
                  <c:v>0.54962011992895887</c:v>
                </c:pt>
                <c:pt idx="2784">
                  <c:v>-0.55601242674970375</c:v>
                </c:pt>
                <c:pt idx="2785">
                  <c:v>9.4649100419041718E-2</c:v>
                </c:pt>
                <c:pt idx="2786">
                  <c:v>-1.1992483068402022</c:v>
                </c:pt>
                <c:pt idx="2787">
                  <c:v>-0.27178421356921695</c:v>
                </c:pt>
                <c:pt idx="2788">
                  <c:v>-0.24318160164447206</c:v>
                </c:pt>
                <c:pt idx="2789">
                  <c:v>-0.81852338206629816</c:v>
                </c:pt>
                <c:pt idx="2790">
                  <c:v>4.0378201520720511E-2</c:v>
                </c:pt>
                <c:pt idx="2791">
                  <c:v>7.5520007640977674E-2</c:v>
                </c:pt>
                <c:pt idx="2792">
                  <c:v>0.5168420481919157</c:v>
                </c:pt>
                <c:pt idx="2793">
                  <c:v>0.22128677891389301</c:v>
                </c:pt>
                <c:pt idx="2794">
                  <c:v>-0.24135208577065867</c:v>
                </c:pt>
                <c:pt idx="2795">
                  <c:v>-0.43253187873811627</c:v>
                </c:pt>
                <c:pt idx="2796">
                  <c:v>0.30347195431932628</c:v>
                </c:pt>
                <c:pt idx="2797">
                  <c:v>0.29194522867164791</c:v>
                </c:pt>
                <c:pt idx="2798">
                  <c:v>-0.11569915343158639</c:v>
                </c:pt>
                <c:pt idx="2799">
                  <c:v>-0.44985186519090592</c:v>
                </c:pt>
                <c:pt idx="2800">
                  <c:v>0.19975237154642508</c:v>
                </c:pt>
                <c:pt idx="2801">
                  <c:v>0.52595340068069441</c:v>
                </c:pt>
                <c:pt idx="2802">
                  <c:v>0.23073604337123008</c:v>
                </c:pt>
                <c:pt idx="2803">
                  <c:v>0.16068533654485087</c:v>
                </c:pt>
                <c:pt idx="2804">
                  <c:v>-0.25459404303314104</c:v>
                </c:pt>
                <c:pt idx="2805">
                  <c:v>3.8450752949606079E-2</c:v>
                </c:pt>
                <c:pt idx="2806">
                  <c:v>-0.28154989336664171</c:v>
                </c:pt>
                <c:pt idx="2807">
                  <c:v>0.3041843083843554</c:v>
                </c:pt>
                <c:pt idx="2808">
                  <c:v>6.2203659313448408E-2</c:v>
                </c:pt>
                <c:pt idx="2809">
                  <c:v>0.40144422667648921</c:v>
                </c:pt>
                <c:pt idx="2810">
                  <c:v>-0.34403309152805739</c:v>
                </c:pt>
                <c:pt idx="2811">
                  <c:v>0.66520292486611465</c:v>
                </c:pt>
                <c:pt idx="2812">
                  <c:v>-0.19761380969107428</c:v>
                </c:pt>
                <c:pt idx="2813">
                  <c:v>-0.89032994931537257</c:v>
                </c:pt>
                <c:pt idx="2814">
                  <c:v>-0.25241565903265056</c:v>
                </c:pt>
                <c:pt idx="2815">
                  <c:v>-0.23584957650756344</c:v>
                </c:pt>
                <c:pt idx="2816">
                  <c:v>-0.55826763405573587</c:v>
                </c:pt>
                <c:pt idx="2817">
                  <c:v>-1.2230517883684418</c:v>
                </c:pt>
                <c:pt idx="2818">
                  <c:v>0.399539929883518</c:v>
                </c:pt>
                <c:pt idx="2819">
                  <c:v>-5.2276765452357779E-2</c:v>
                </c:pt>
                <c:pt idx="2820">
                  <c:v>-0.49313492230550487</c:v>
                </c:pt>
                <c:pt idx="2821">
                  <c:v>0.20906118622418052</c:v>
                </c:pt>
                <c:pt idx="2822">
                  <c:v>-0.49149398087216473</c:v>
                </c:pt>
                <c:pt idx="2823">
                  <c:v>-0.29054236266025441</c:v>
                </c:pt>
                <c:pt idx="2824">
                  <c:v>0.35660554652010762</c:v>
                </c:pt>
                <c:pt idx="2825">
                  <c:v>-0.15237814540103931</c:v>
                </c:pt>
                <c:pt idx="2826">
                  <c:v>0.2603246854966858</c:v>
                </c:pt>
                <c:pt idx="2827">
                  <c:v>2.0340448284175573E-2</c:v>
                </c:pt>
                <c:pt idx="2828">
                  <c:v>-0.24135208577065867</c:v>
                </c:pt>
                <c:pt idx="2829">
                  <c:v>-0.56510969653183429</c:v>
                </c:pt>
                <c:pt idx="2830">
                  <c:v>-0.20701822594562194</c:v>
                </c:pt>
                <c:pt idx="2831">
                  <c:v>0.16504613092064882</c:v>
                </c:pt>
                <c:pt idx="2832">
                  <c:v>0.32066628868632691</c:v>
                </c:pt>
                <c:pt idx="2833">
                  <c:v>-0.28924428515664252</c:v>
                </c:pt>
                <c:pt idx="2834">
                  <c:v>-3.8857550020362161E-2</c:v>
                </c:pt>
                <c:pt idx="2835">
                  <c:v>-0.41500143145197183</c:v>
                </c:pt>
                <c:pt idx="2836">
                  <c:v>-5.7692867168345957E-2</c:v>
                </c:pt>
                <c:pt idx="2837">
                  <c:v>0.3116853393596149</c:v>
                </c:pt>
                <c:pt idx="2838">
                  <c:v>0.39649827364362034</c:v>
                </c:pt>
                <c:pt idx="2839">
                  <c:v>-0.11410045158818023</c:v>
                </c:pt>
                <c:pt idx="2840">
                  <c:v>-9.8015233868959495E-2</c:v>
                </c:pt>
                <c:pt idx="2841">
                  <c:v>0.70604102097130561</c:v>
                </c:pt>
                <c:pt idx="2842">
                  <c:v>-0.18231091802569632</c:v>
                </c:pt>
                <c:pt idx="2843">
                  <c:v>-8.1339627451938831E-2</c:v>
                </c:pt>
                <c:pt idx="2844">
                  <c:v>-6.0600829554117067E-2</c:v>
                </c:pt>
                <c:pt idx="2845">
                  <c:v>-1.0371010360077662</c:v>
                </c:pt>
                <c:pt idx="2846">
                  <c:v>-0.60947131141145072</c:v>
                </c:pt>
                <c:pt idx="2847">
                  <c:v>0.19198571091040226</c:v>
                </c:pt>
                <c:pt idx="2848">
                  <c:v>-0.39933518250207151</c:v>
                </c:pt>
                <c:pt idx="2849">
                  <c:v>-0.4298569511336523</c:v>
                </c:pt>
                <c:pt idx="2850">
                  <c:v>-0.53674920564802608</c:v>
                </c:pt>
                <c:pt idx="2851">
                  <c:v>-0.10808949184029734</c:v>
                </c:pt>
                <c:pt idx="2852">
                  <c:v>-0.5477459386871435</c:v>
                </c:pt>
                <c:pt idx="2853">
                  <c:v>-0.2740528840782579</c:v>
                </c:pt>
                <c:pt idx="2854">
                  <c:v>-0.41261895899193063</c:v>
                </c:pt>
                <c:pt idx="2855">
                  <c:v>6.8392577690317299E-2</c:v>
                </c:pt>
                <c:pt idx="2856">
                  <c:v>0.62171034690454929</c:v>
                </c:pt>
                <c:pt idx="2857">
                  <c:v>0.26951220073622362</c:v>
                </c:pt>
                <c:pt idx="2858">
                  <c:v>7.5367992990303445E-2</c:v>
                </c:pt>
                <c:pt idx="2859">
                  <c:v>-0.12313642685605965</c:v>
                </c:pt>
                <c:pt idx="2860">
                  <c:v>0.5597919249862503</c:v>
                </c:pt>
                <c:pt idx="2861">
                  <c:v>-0.30905974250158447</c:v>
                </c:pt>
                <c:pt idx="2862">
                  <c:v>-0.41608307420835816</c:v>
                </c:pt>
                <c:pt idx="2863">
                  <c:v>-0.19899696624010862</c:v>
                </c:pt>
                <c:pt idx="2864">
                  <c:v>0.12390548727009068</c:v>
                </c:pt>
                <c:pt idx="2865">
                  <c:v>-0.22650852980867972</c:v>
                </c:pt>
                <c:pt idx="2866">
                  <c:v>1.2933589426905916</c:v>
                </c:pt>
                <c:pt idx="2867">
                  <c:v>0.34923544088309766</c:v>
                </c:pt>
                <c:pt idx="2868">
                  <c:v>0.13083926159988277</c:v>
                </c:pt>
                <c:pt idx="2869">
                  <c:v>-6.1292338478294031E-2</c:v>
                </c:pt>
                <c:pt idx="2870">
                  <c:v>1.5374195390826068E-2</c:v>
                </c:pt>
                <c:pt idx="2871">
                  <c:v>0.73048803009500118</c:v>
                </c:pt>
                <c:pt idx="2872">
                  <c:v>-0.20839239979067614</c:v>
                </c:pt>
                <c:pt idx="2873">
                  <c:v>-0.23167816179851064</c:v>
                </c:pt>
                <c:pt idx="2874">
                  <c:v>-5.5750964118453296E-2</c:v>
                </c:pt>
                <c:pt idx="2875">
                  <c:v>-0.1838358314496796</c:v>
                </c:pt>
                <c:pt idx="2876">
                  <c:v>0.27875860002325281</c:v>
                </c:pt>
                <c:pt idx="2877">
                  <c:v>0.42371974237864468</c:v>
                </c:pt>
                <c:pt idx="2878">
                  <c:v>0.50799302440604521</c:v>
                </c:pt>
                <c:pt idx="2879">
                  <c:v>3.2831392467372503E-2</c:v>
                </c:pt>
                <c:pt idx="2880">
                  <c:v>-0.32883646422953988</c:v>
                </c:pt>
                <c:pt idx="2881">
                  <c:v>-8.8141596869017527E-2</c:v>
                </c:pt>
                <c:pt idx="2882">
                  <c:v>0.1155974470163128</c:v>
                </c:pt>
                <c:pt idx="2883">
                  <c:v>0.35642083426828514</c:v>
                </c:pt>
                <c:pt idx="2884">
                  <c:v>-0.97482296097683319</c:v>
                </c:pt>
                <c:pt idx="2885">
                  <c:v>-9.8419557765544508E-2</c:v>
                </c:pt>
                <c:pt idx="2886">
                  <c:v>-0.1318528459646624</c:v>
                </c:pt>
                <c:pt idx="2887">
                  <c:v>-0.11503324294624002</c:v>
                </c:pt>
                <c:pt idx="2888">
                  <c:v>-0.23167816179851064</c:v>
                </c:pt>
                <c:pt idx="2889">
                  <c:v>5.4691953074952546E-2</c:v>
                </c:pt>
                <c:pt idx="2890">
                  <c:v>0.55342614745310303</c:v>
                </c:pt>
                <c:pt idx="2891">
                  <c:v>4.1898939054236814E-3</c:v>
                </c:pt>
                <c:pt idx="2892">
                  <c:v>0.30400618689009989</c:v>
                </c:pt>
                <c:pt idx="2893">
                  <c:v>0.54983130269167069</c:v>
                </c:pt>
                <c:pt idx="2894">
                  <c:v>-0.31487050853683279</c:v>
                </c:pt>
                <c:pt idx="2895">
                  <c:v>0.36067521082915455</c:v>
                </c:pt>
                <c:pt idx="2896">
                  <c:v>0.19627699322584224</c:v>
                </c:pt>
                <c:pt idx="2897">
                  <c:v>-0.24610400988391648</c:v>
                </c:pt>
                <c:pt idx="2898">
                  <c:v>0.26395802625003234</c:v>
                </c:pt>
                <c:pt idx="2899">
                  <c:v>2.767495844284823E-2</c:v>
                </c:pt>
                <c:pt idx="2900">
                  <c:v>-2.9134804053022781E-2</c:v>
                </c:pt>
                <c:pt idx="2901">
                  <c:v>0.70228032795648709</c:v>
                </c:pt>
                <c:pt idx="2902">
                  <c:v>0.64746744332710371</c:v>
                </c:pt>
                <c:pt idx="2903">
                  <c:v>8.3905577061641701E-2</c:v>
                </c:pt>
                <c:pt idx="2904">
                  <c:v>-0.10366548276569655</c:v>
                </c:pt>
                <c:pt idx="2905">
                  <c:v>-0.10460504322931086</c:v>
                </c:pt>
                <c:pt idx="2906">
                  <c:v>1.7125039101938314E-2</c:v>
                </c:pt>
                <c:pt idx="2907">
                  <c:v>7.9782934037782915E-2</c:v>
                </c:pt>
                <c:pt idx="2908">
                  <c:v>3.3126603240018822E-2</c:v>
                </c:pt>
                <c:pt idx="2909">
                  <c:v>-2.4138648330979477</c:v>
                </c:pt>
                <c:pt idx="2910">
                  <c:v>0.24485604151359333</c:v>
                </c:pt>
                <c:pt idx="2911">
                  <c:v>-7.3683153616439886E-2</c:v>
                </c:pt>
                <c:pt idx="2912">
                  <c:v>0.24365984774814736</c:v>
                </c:pt>
                <c:pt idx="2913">
                  <c:v>-0.29607557495288772</c:v>
                </c:pt>
                <c:pt idx="2914">
                  <c:v>-0.3167250215787496</c:v>
                </c:pt>
                <c:pt idx="2915">
                  <c:v>2.9440803266598248E-2</c:v>
                </c:pt>
                <c:pt idx="2916">
                  <c:v>6.6276302104170848E-2</c:v>
                </c:pt>
                <c:pt idx="2917">
                  <c:v>-0.14352403252161328</c:v>
                </c:pt>
                <c:pt idx="2918">
                  <c:v>-0.55473618322245821</c:v>
                </c:pt>
                <c:pt idx="2919">
                  <c:v>-4.6002046544520503E-2</c:v>
                </c:pt>
                <c:pt idx="2920">
                  <c:v>0.15842936260448298</c:v>
                </c:pt>
                <c:pt idx="2921">
                  <c:v>-0.12075005333492554</c:v>
                </c:pt>
                <c:pt idx="2922">
                  <c:v>8.4517342168185516E-2</c:v>
                </c:pt>
                <c:pt idx="2923">
                  <c:v>-0.25326319925980567</c:v>
                </c:pt>
                <c:pt idx="2924">
                  <c:v>-0.68041438180681668</c:v>
                </c:pt>
                <c:pt idx="2925">
                  <c:v>-0.17708860210596752</c:v>
                </c:pt>
                <c:pt idx="2926">
                  <c:v>-0.22020611308018431</c:v>
                </c:pt>
                <c:pt idx="2927">
                  <c:v>-0.16632981792063126</c:v>
                </c:pt>
                <c:pt idx="2928">
                  <c:v>0.65040825744324826</c:v>
                </c:pt>
                <c:pt idx="2929">
                  <c:v>-4.30644786649374E-2</c:v>
                </c:pt>
                <c:pt idx="2930">
                  <c:v>0.12045105691922364</c:v>
                </c:pt>
                <c:pt idx="2931">
                  <c:v>-0.16645837172253311</c:v>
                </c:pt>
                <c:pt idx="2932">
                  <c:v>3.4751343155765516E-2</c:v>
                </c:pt>
                <c:pt idx="2933">
                  <c:v>9.8196649749256057E-2</c:v>
                </c:pt>
                <c:pt idx="2934">
                  <c:v>0.19379969588388812</c:v>
                </c:pt>
                <c:pt idx="2935">
                  <c:v>0.85517047916119093</c:v>
                </c:pt>
                <c:pt idx="2936">
                  <c:v>-0.16440013502441164</c:v>
                </c:pt>
                <c:pt idx="2937">
                  <c:v>-0.29572302453996846</c:v>
                </c:pt>
                <c:pt idx="2938">
                  <c:v>-0.27715161067749261</c:v>
                </c:pt>
                <c:pt idx="2939">
                  <c:v>-0.16143626582598719</c:v>
                </c:pt>
                <c:pt idx="2940">
                  <c:v>-0.17402284205541382</c:v>
                </c:pt>
                <c:pt idx="2941">
                  <c:v>0.45245146092196087</c:v>
                </c:pt>
                <c:pt idx="2942">
                  <c:v>0.2489648233321381</c:v>
                </c:pt>
                <c:pt idx="2943">
                  <c:v>-0.48758924832086231</c:v>
                </c:pt>
                <c:pt idx="2944">
                  <c:v>-0.19408705211630234</c:v>
                </c:pt>
                <c:pt idx="2945">
                  <c:v>0.49716024174406837</c:v>
                </c:pt>
                <c:pt idx="2946">
                  <c:v>0.19644229772798674</c:v>
                </c:pt>
                <c:pt idx="2947">
                  <c:v>1.4208145587288765E-2</c:v>
                </c:pt>
                <c:pt idx="2948">
                  <c:v>0.34098882880185016</c:v>
                </c:pt>
                <c:pt idx="2949">
                  <c:v>0.3673595241343684</c:v>
                </c:pt>
                <c:pt idx="2950">
                  <c:v>-0.43967632349068703</c:v>
                </c:pt>
                <c:pt idx="2951">
                  <c:v>-0.10420244938244289</c:v>
                </c:pt>
                <c:pt idx="2952">
                  <c:v>-0.62611201085861334</c:v>
                </c:pt>
                <c:pt idx="2953">
                  <c:v>-0.41899946543126576</c:v>
                </c:pt>
                <c:pt idx="2954">
                  <c:v>-0.29936189765155863</c:v>
                </c:pt>
                <c:pt idx="2955">
                  <c:v>-0.55699338486248839</c:v>
                </c:pt>
                <c:pt idx="2956">
                  <c:v>0.24195271816676631</c:v>
                </c:pt>
                <c:pt idx="2957">
                  <c:v>1.3188624542768148E-2</c:v>
                </c:pt>
                <c:pt idx="2958">
                  <c:v>0.20307005736148867</c:v>
                </c:pt>
                <c:pt idx="2959">
                  <c:v>-0.16452886088136864</c:v>
                </c:pt>
                <c:pt idx="2960">
                  <c:v>0.78886317301772479</c:v>
                </c:pt>
                <c:pt idx="2961">
                  <c:v>0.84140444849910312</c:v>
                </c:pt>
                <c:pt idx="2962">
                  <c:v>-0.15081959821213317</c:v>
                </c:pt>
                <c:pt idx="2963">
                  <c:v>-0.75821788374212862</c:v>
                </c:pt>
                <c:pt idx="2964">
                  <c:v>1.1587974275211826E-2</c:v>
                </c:pt>
                <c:pt idx="2965">
                  <c:v>1.0862010350493039</c:v>
                </c:pt>
                <c:pt idx="2966">
                  <c:v>7.0057546185427144E-2</c:v>
                </c:pt>
                <c:pt idx="2967">
                  <c:v>-7.8609834696366496E-2</c:v>
                </c:pt>
                <c:pt idx="2968">
                  <c:v>-0.29971356006424188</c:v>
                </c:pt>
                <c:pt idx="2969">
                  <c:v>0.63419550012801851</c:v>
                </c:pt>
                <c:pt idx="2970">
                  <c:v>0.44359510996145368</c:v>
                </c:pt>
                <c:pt idx="2971">
                  <c:v>-0.16915535883089375</c:v>
                </c:pt>
                <c:pt idx="2972">
                  <c:v>-0.17593970540604287</c:v>
                </c:pt>
                <c:pt idx="2973">
                  <c:v>8.5129366799652342E-2</c:v>
                </c:pt>
                <c:pt idx="2974">
                  <c:v>0.98450243060467435</c:v>
                </c:pt>
                <c:pt idx="2975">
                  <c:v>1.0549916715845771</c:v>
                </c:pt>
                <c:pt idx="2976">
                  <c:v>-0.18840092460321006</c:v>
                </c:pt>
                <c:pt idx="2977">
                  <c:v>-0.15574923267794491</c:v>
                </c:pt>
                <c:pt idx="2978">
                  <c:v>-0.1650436494830444</c:v>
                </c:pt>
                <c:pt idx="2979">
                  <c:v>-0.38813441881414545</c:v>
                </c:pt>
                <c:pt idx="2980">
                  <c:v>-0.3761792315175207</c:v>
                </c:pt>
                <c:pt idx="2981">
                  <c:v>-8.4064264788474632E-2</c:v>
                </c:pt>
                <c:pt idx="2982">
                  <c:v>-0.3636757218072631</c:v>
                </c:pt>
                <c:pt idx="2983">
                  <c:v>-0.29372360990493407</c:v>
                </c:pt>
                <c:pt idx="2984">
                  <c:v>1.1494405793772284</c:v>
                </c:pt>
                <c:pt idx="2985">
                  <c:v>-0.25869981556990257</c:v>
                </c:pt>
                <c:pt idx="2986">
                  <c:v>-0.29713270957116261</c:v>
                </c:pt>
                <c:pt idx="2987">
                  <c:v>0.34062340452408862</c:v>
                </c:pt>
                <c:pt idx="2988">
                  <c:v>1.1151741331035669E-2</c:v>
                </c:pt>
                <c:pt idx="2989">
                  <c:v>0.58944180185741801</c:v>
                </c:pt>
                <c:pt idx="2990">
                  <c:v>8.8500151138891966E-2</c:v>
                </c:pt>
                <c:pt idx="2991">
                  <c:v>-1.1851688097814648</c:v>
                </c:pt>
                <c:pt idx="2992">
                  <c:v>-0.10581215112923138</c:v>
                </c:pt>
                <c:pt idx="2993">
                  <c:v>-6.5710164065265683E-2</c:v>
                </c:pt>
                <c:pt idx="2994">
                  <c:v>0.24725140859286615</c:v>
                </c:pt>
                <c:pt idx="2995">
                  <c:v>0.18639322512617296</c:v>
                </c:pt>
                <c:pt idx="2996">
                  <c:v>0.34574778656330901</c:v>
                </c:pt>
                <c:pt idx="2997">
                  <c:v>-0.23180102277715736</c:v>
                </c:pt>
                <c:pt idx="2998">
                  <c:v>0.19528556376919445</c:v>
                </c:pt>
                <c:pt idx="2999">
                  <c:v>-0.13330047622977645</c:v>
                </c:pt>
                <c:pt idx="3000">
                  <c:v>0.37838178654261423</c:v>
                </c:pt>
                <c:pt idx="3001">
                  <c:v>0.31383567393864081</c:v>
                </c:pt>
                <c:pt idx="3002">
                  <c:v>0.45858428418090685</c:v>
                </c:pt>
                <c:pt idx="3003">
                  <c:v>-0.26086873861567933</c:v>
                </c:pt>
                <c:pt idx="3004">
                  <c:v>4.768766434361347E-3</c:v>
                </c:pt>
                <c:pt idx="3005">
                  <c:v>-0.10272531001108824</c:v>
                </c:pt>
                <c:pt idx="3006">
                  <c:v>-0.25047655250296924</c:v>
                </c:pt>
                <c:pt idx="3007">
                  <c:v>0.45087301980073297</c:v>
                </c:pt>
                <c:pt idx="3008">
                  <c:v>0.26465112981411459</c:v>
                </c:pt>
                <c:pt idx="3009">
                  <c:v>-5.8108649401173912E-2</c:v>
                </c:pt>
                <c:pt idx="3010">
                  <c:v>-2.5945167084523856E-3</c:v>
                </c:pt>
                <c:pt idx="3011">
                  <c:v>-0.10594621190532467</c:v>
                </c:pt>
                <c:pt idx="3012">
                  <c:v>7.0966521354143594E-2</c:v>
                </c:pt>
                <c:pt idx="3013">
                  <c:v>-0.29525282326769292</c:v>
                </c:pt>
                <c:pt idx="3014">
                  <c:v>-0.42728434617368177</c:v>
                </c:pt>
                <c:pt idx="3015">
                  <c:v>-0.22527492986956929</c:v>
                </c:pt>
                <c:pt idx="3016">
                  <c:v>2.2536888760533245E-2</c:v>
                </c:pt>
                <c:pt idx="3017">
                  <c:v>-0.42169458118029202</c:v>
                </c:pt>
                <c:pt idx="3018">
                  <c:v>-3.1112840850249276E-2</c:v>
                </c:pt>
                <c:pt idx="3019">
                  <c:v>7.0966521354143594E-2</c:v>
                </c:pt>
                <c:pt idx="3020">
                  <c:v>0.12484904194132311</c:v>
                </c:pt>
                <c:pt idx="3021">
                  <c:v>7.8259013920499554E-2</c:v>
                </c:pt>
                <c:pt idx="3022">
                  <c:v>6.8543859087287912E-2</c:v>
                </c:pt>
                <c:pt idx="3023">
                  <c:v>-7.1955014042037252E-3</c:v>
                </c:pt>
                <c:pt idx="3024">
                  <c:v>-0.29266397339685785</c:v>
                </c:pt>
                <c:pt idx="3025">
                  <c:v>-7.8609834696366496E-2</c:v>
                </c:pt>
                <c:pt idx="3026">
                  <c:v>0.24434326559176051</c:v>
                </c:pt>
                <c:pt idx="3027">
                  <c:v>3.3864894562046055E-2</c:v>
                </c:pt>
                <c:pt idx="3028">
                  <c:v>-0.40261304298717016</c:v>
                </c:pt>
                <c:pt idx="3029">
                  <c:v>-0.15859555150089683</c:v>
                </c:pt>
                <c:pt idx="3030">
                  <c:v>-0.10003572116184385</c:v>
                </c:pt>
                <c:pt idx="3031">
                  <c:v>0.39706809593036041</c:v>
                </c:pt>
                <c:pt idx="3032">
                  <c:v>1.1187269385707517</c:v>
                </c:pt>
                <c:pt idx="3033">
                  <c:v>0.23769371099711789</c:v>
                </c:pt>
                <c:pt idx="3034">
                  <c:v>-0.21400042972960656</c:v>
                </c:pt>
                <c:pt idx="3035">
                  <c:v>0.50819820040594876</c:v>
                </c:pt>
                <c:pt idx="3036">
                  <c:v>0.54035855007138844</c:v>
                </c:pt>
                <c:pt idx="3037">
                  <c:v>0.16116921883712429</c:v>
                </c:pt>
                <c:pt idx="3038">
                  <c:v>0.10175294391813194</c:v>
                </c:pt>
                <c:pt idx="3039">
                  <c:v>0.58316025808717087</c:v>
                </c:pt>
                <c:pt idx="3040">
                  <c:v>-0.22354611595281834</c:v>
                </c:pt>
                <c:pt idx="3041">
                  <c:v>-2.5737561413608261E-2</c:v>
                </c:pt>
                <c:pt idx="3042">
                  <c:v>-0.55247544449103303</c:v>
                </c:pt>
                <c:pt idx="3043">
                  <c:v>-0.30567874324228744</c:v>
                </c:pt>
                <c:pt idx="3044">
                  <c:v>-0.62592504849965402</c:v>
                </c:pt>
                <c:pt idx="3045">
                  <c:v>-0.30451104180995303</c:v>
                </c:pt>
                <c:pt idx="3046">
                  <c:v>-3.1279138681786263</c:v>
                </c:pt>
                <c:pt idx="3047">
                  <c:v>-2.5945167084523856E-3</c:v>
                </c:pt>
                <c:pt idx="3048">
                  <c:v>0.22212795148794712</c:v>
                </c:pt>
                <c:pt idx="3049">
                  <c:v>0.10113382791640257</c:v>
                </c:pt>
                <c:pt idx="3050">
                  <c:v>9.5533481122112227E-3</c:v>
                </c:pt>
                <c:pt idx="3051">
                  <c:v>-0.21063822838015026</c:v>
                </c:pt>
                <c:pt idx="3052">
                  <c:v>-0.68508795567502923</c:v>
                </c:pt>
                <c:pt idx="3053">
                  <c:v>7.3241468013535024E-2</c:v>
                </c:pt>
                <c:pt idx="3054">
                  <c:v>-0.15029970810168206</c:v>
                </c:pt>
                <c:pt idx="3055">
                  <c:v>0.46235603807011516</c:v>
                </c:pt>
                <c:pt idx="3056">
                  <c:v>8.4364376569686816E-2</c:v>
                </c:pt>
                <c:pt idx="3057">
                  <c:v>1.5713215900517696</c:v>
                </c:pt>
                <c:pt idx="3058">
                  <c:v>-6.7914014088466382E-2</c:v>
                </c:pt>
                <c:pt idx="3059">
                  <c:v>-6.0047383669938871E-2</c:v>
                </c:pt>
                <c:pt idx="3060">
                  <c:v>0.40698094440778554</c:v>
                </c:pt>
                <c:pt idx="3061">
                  <c:v>-0.25556115890035369</c:v>
                </c:pt>
                <c:pt idx="3062">
                  <c:v>-0.38128337250378352</c:v>
                </c:pt>
                <c:pt idx="3063">
                  <c:v>-0.12948085869887838</c:v>
                </c:pt>
                <c:pt idx="3064">
                  <c:v>-0.13737236369339778</c:v>
                </c:pt>
                <c:pt idx="3065">
                  <c:v>0.10190776444099212</c:v>
                </c:pt>
                <c:pt idx="3066">
                  <c:v>3.3274231282192986E-2</c:v>
                </c:pt>
                <c:pt idx="3067">
                  <c:v>-0.28995247221539644</c:v>
                </c:pt>
                <c:pt idx="3068">
                  <c:v>0.2209504471625415</c:v>
                </c:pt>
                <c:pt idx="3069">
                  <c:v>-3.9699917720951494E-2</c:v>
                </c:pt>
                <c:pt idx="3070">
                  <c:v>-0.13040376165803882</c:v>
                </c:pt>
                <c:pt idx="3071">
                  <c:v>-0.34845906208647165</c:v>
                </c:pt>
                <c:pt idx="3072">
                  <c:v>-0.23167816179851064</c:v>
                </c:pt>
                <c:pt idx="3073">
                  <c:v>-1.044603950649768</c:v>
                </c:pt>
                <c:pt idx="3074">
                  <c:v>6.9300504114800529E-2</c:v>
                </c:pt>
                <c:pt idx="3075">
                  <c:v>0.5918316292918937</c:v>
                </c:pt>
                <c:pt idx="3076">
                  <c:v>0.15473076102009867</c:v>
                </c:pt>
                <c:pt idx="3077">
                  <c:v>0.19017400390254918</c:v>
                </c:pt>
                <c:pt idx="3078">
                  <c:v>3.7265909404196919E-2</c:v>
                </c:pt>
                <c:pt idx="3079">
                  <c:v>0.23531414747786647</c:v>
                </c:pt>
                <c:pt idx="3080">
                  <c:v>-0.26279393662065459</c:v>
                </c:pt>
                <c:pt idx="3081">
                  <c:v>-0.29783703588664368</c:v>
                </c:pt>
                <c:pt idx="3082">
                  <c:v>-6.3226801996981372E-2</c:v>
                </c:pt>
                <c:pt idx="3083">
                  <c:v>0.50881390354107336</c:v>
                </c:pt>
                <c:pt idx="3084">
                  <c:v>-4.3484497603579503E-2</c:v>
                </c:pt>
                <c:pt idx="3085">
                  <c:v>0.42934277969470908</c:v>
                </c:pt>
                <c:pt idx="3086">
                  <c:v>7.8116637466877316E-3</c:v>
                </c:pt>
                <c:pt idx="3087">
                  <c:v>1.8001258406667432E-2</c:v>
                </c:pt>
                <c:pt idx="3088">
                  <c:v>-0.42889276178591579</c:v>
                </c:pt>
                <c:pt idx="3089">
                  <c:v>-1.0567915943774804</c:v>
                </c:pt>
                <c:pt idx="3090">
                  <c:v>0.30009306762512383</c:v>
                </c:pt>
                <c:pt idx="3091">
                  <c:v>-0.58774901836692772</c:v>
                </c:pt>
                <c:pt idx="3092">
                  <c:v>-1.2798278394408837</c:v>
                </c:pt>
                <c:pt idx="3093">
                  <c:v>-1.6496319896195929E-2</c:v>
                </c:pt>
                <c:pt idx="3094">
                  <c:v>0.42081985187284998</c:v>
                </c:pt>
                <c:pt idx="3095">
                  <c:v>-0.29924465779607262</c:v>
                </c:pt>
                <c:pt idx="3096">
                  <c:v>-0.28392177230761756</c:v>
                </c:pt>
                <c:pt idx="3097">
                  <c:v>-0.22761786861065839</c:v>
                </c:pt>
                <c:pt idx="3098">
                  <c:v>0.16342948458284823</c:v>
                </c:pt>
                <c:pt idx="3099">
                  <c:v>-0.21063822838015026</c:v>
                </c:pt>
                <c:pt idx="3100">
                  <c:v>-3.6890110540265988E-2</c:v>
                </c:pt>
                <c:pt idx="3101">
                  <c:v>0.27194889217957091</c:v>
                </c:pt>
                <c:pt idx="3102">
                  <c:v>-0.20125745684324101</c:v>
                </c:pt>
                <c:pt idx="3103">
                  <c:v>0.24725140859286615</c:v>
                </c:pt>
                <c:pt idx="3104">
                  <c:v>1.1338437243262098</c:v>
                </c:pt>
                <c:pt idx="3105">
                  <c:v>-0.6248027652529472</c:v>
                </c:pt>
                <c:pt idx="3106">
                  <c:v>-0.18434377795290743</c:v>
                </c:pt>
                <c:pt idx="3107">
                  <c:v>1.6541188409676392E-2</c:v>
                </c:pt>
                <c:pt idx="3108">
                  <c:v>-2.6555350163521045</c:v>
                </c:pt>
                <c:pt idx="3109">
                  <c:v>0.16569329703709218</c:v>
                </c:pt>
                <c:pt idx="3110">
                  <c:v>-0.33742566428268805</c:v>
                </c:pt>
                <c:pt idx="3111">
                  <c:v>-0.16620125266270294</c:v>
                </c:pt>
                <c:pt idx="3112">
                  <c:v>-1.056375432343569</c:v>
                </c:pt>
                <c:pt idx="3113">
                  <c:v>-0.55914914773725721</c:v>
                </c:pt>
                <c:pt idx="3114">
                  <c:v>-1.7921907997262298E-2</c:v>
                </c:pt>
                <c:pt idx="3115">
                  <c:v>-0.27750872814477806</c:v>
                </c:pt>
                <c:pt idx="3116">
                  <c:v>-1.3345110701291047</c:v>
                </c:pt>
                <c:pt idx="3117">
                  <c:v>-9.1259766192678352E-2</c:v>
                </c:pt>
                <c:pt idx="3118">
                  <c:v>0.18196752534190558</c:v>
                </c:pt>
                <c:pt idx="3119">
                  <c:v>-3.9559557255705827E-2</c:v>
                </c:pt>
                <c:pt idx="3120">
                  <c:v>8.9727846173845799E-2</c:v>
                </c:pt>
                <c:pt idx="3121">
                  <c:v>6.5068394097751947E-2</c:v>
                </c:pt>
                <c:pt idx="3122">
                  <c:v>-4.1242982231881394E-2</c:v>
                </c:pt>
                <c:pt idx="3123">
                  <c:v>-0.19509557717721837</c:v>
                </c:pt>
                <c:pt idx="3124">
                  <c:v>-0.58043495940162249</c:v>
                </c:pt>
                <c:pt idx="3125">
                  <c:v>-0.18269229751619034</c:v>
                </c:pt>
                <c:pt idx="3126">
                  <c:v>0.34483138239040839</c:v>
                </c:pt>
                <c:pt idx="3127">
                  <c:v>-0.13697881196350373</c:v>
                </c:pt>
                <c:pt idx="3128">
                  <c:v>-0.23976462651094668</c:v>
                </c:pt>
                <c:pt idx="3129">
                  <c:v>0.51477928684409402</c:v>
                </c:pt>
                <c:pt idx="3130">
                  <c:v>3.5934122513581551E-2</c:v>
                </c:pt>
                <c:pt idx="3131">
                  <c:v>-0.51692285127828674</c:v>
                </c:pt>
                <c:pt idx="3132">
                  <c:v>-0.46309926734810375</c:v>
                </c:pt>
                <c:pt idx="3133">
                  <c:v>8.3919916068413859E-3</c:v>
                </c:pt>
                <c:pt idx="3134">
                  <c:v>-0.38956681176272573</c:v>
                </c:pt>
                <c:pt idx="3135">
                  <c:v>1.0570302515754243E-2</c:v>
                </c:pt>
                <c:pt idx="3136">
                  <c:v>-0.10205338272918787</c:v>
                </c:pt>
                <c:pt idx="3137">
                  <c:v>-5.7692867168345957E-2</c:v>
                </c:pt>
                <c:pt idx="3138">
                  <c:v>-0.3561438102252753</c:v>
                </c:pt>
                <c:pt idx="3139">
                  <c:v>0.45462464112744078</c:v>
                </c:pt>
                <c:pt idx="3140">
                  <c:v>0.36345657864819891</c:v>
                </c:pt>
                <c:pt idx="3141">
                  <c:v>-0.25059782304823364</c:v>
                </c:pt>
                <c:pt idx="3142">
                  <c:v>-0.26615686364661811</c:v>
                </c:pt>
                <c:pt idx="3143">
                  <c:v>0.23175214509715544</c:v>
                </c:pt>
                <c:pt idx="3144">
                  <c:v>-0.72622088460951295</c:v>
                </c:pt>
                <c:pt idx="3145">
                  <c:v>-6.942721045601416E-2</c:v>
                </c:pt>
                <c:pt idx="3146">
                  <c:v>-0.13211615953372516</c:v>
                </c:pt>
                <c:pt idx="3147">
                  <c:v>7.956723828343084E-3</c:v>
                </c:pt>
                <c:pt idx="3148">
                  <c:v>8.4976336299281974E-2</c:v>
                </c:pt>
                <c:pt idx="3149">
                  <c:v>0.13606154957602826</c:v>
                </c:pt>
                <c:pt idx="3150">
                  <c:v>1.006941609418847</c:v>
                </c:pt>
                <c:pt idx="3151">
                  <c:v>-0.13356352574110586</c:v>
                </c:pt>
                <c:pt idx="3152">
                  <c:v>-1.0170667241898332</c:v>
                </c:pt>
                <c:pt idx="3153">
                  <c:v>-0.11316705673273475</c:v>
                </c:pt>
                <c:pt idx="3154">
                  <c:v>-0.14117117246074129</c:v>
                </c:pt>
                <c:pt idx="3155">
                  <c:v>0.61440330398775445</c:v>
                </c:pt>
                <c:pt idx="3156">
                  <c:v>-0.16298339202346537</c:v>
                </c:pt>
                <c:pt idx="3157">
                  <c:v>0.57046437372180336</c:v>
                </c:pt>
                <c:pt idx="3158">
                  <c:v>-7.3957299943324423E-2</c:v>
                </c:pt>
                <c:pt idx="3159">
                  <c:v>0.24588214044795009</c:v>
                </c:pt>
                <c:pt idx="3160">
                  <c:v>0.10097909042058302</c:v>
                </c:pt>
                <c:pt idx="3161">
                  <c:v>0.16650266314016507</c:v>
                </c:pt>
                <c:pt idx="3162">
                  <c:v>2.7233834745515082E-2</c:v>
                </c:pt>
                <c:pt idx="3163">
                  <c:v>-1.5069321717648148E-2</c:v>
                </c:pt>
                <c:pt idx="3164">
                  <c:v>5.3343989793084842E-2</c:v>
                </c:pt>
                <c:pt idx="3165">
                  <c:v>0.16278333294697078</c:v>
                </c:pt>
                <c:pt idx="3166">
                  <c:v>-1.110697316544935</c:v>
                </c:pt>
                <c:pt idx="3167">
                  <c:v>7.036047427911532E-2</c:v>
                </c:pt>
                <c:pt idx="3168">
                  <c:v>-0.43562859405209053</c:v>
                </c:pt>
                <c:pt idx="3169">
                  <c:v>-0.65553501635210443</c:v>
                </c:pt>
                <c:pt idx="3170">
                  <c:v>-0.33696886223948608</c:v>
                </c:pt>
                <c:pt idx="3171">
                  <c:v>-9.6801581849168691E-2</c:v>
                </c:pt>
                <c:pt idx="3172">
                  <c:v>-1.5977456854194458</c:v>
                </c:pt>
                <c:pt idx="3173">
                  <c:v>-0.55326219027243284</c:v>
                </c:pt>
                <c:pt idx="3174">
                  <c:v>0.82138095746668194</c:v>
                </c:pt>
                <c:pt idx="3175">
                  <c:v>4.6623000688593728E-2</c:v>
                </c:pt>
                <c:pt idx="3176">
                  <c:v>-0.44084591823726571</c:v>
                </c:pt>
                <c:pt idx="3177">
                  <c:v>-0.21424917025451382</c:v>
                </c:pt>
                <c:pt idx="3178">
                  <c:v>-1.8296466348790437</c:v>
                </c:pt>
                <c:pt idx="3179">
                  <c:v>-0.54557305603503203</c:v>
                </c:pt>
                <c:pt idx="3180">
                  <c:v>0.40698094440778554</c:v>
                </c:pt>
                <c:pt idx="3181">
                  <c:v>-0.16877038350082052</c:v>
                </c:pt>
                <c:pt idx="3182">
                  <c:v>0.10764783508246119</c:v>
                </c:pt>
                <c:pt idx="3183">
                  <c:v>0.16763653905169781</c:v>
                </c:pt>
                <c:pt idx="3184">
                  <c:v>0.21039593366842285</c:v>
                </c:pt>
                <c:pt idx="3185">
                  <c:v>1.1130987323135082</c:v>
                </c:pt>
                <c:pt idx="3186">
                  <c:v>-0.48016169934816466</c:v>
                </c:pt>
                <c:pt idx="3187">
                  <c:v>-0.15042969819420529</c:v>
                </c:pt>
                <c:pt idx="3188">
                  <c:v>-6.8189258778968032E-2</c:v>
                </c:pt>
                <c:pt idx="3189">
                  <c:v>0.59924349681674871</c:v>
                </c:pt>
                <c:pt idx="3190">
                  <c:v>0.4408508522627429</c:v>
                </c:pt>
                <c:pt idx="3191">
                  <c:v>0.1989241408325427</c:v>
                </c:pt>
                <c:pt idx="3192">
                  <c:v>-0.22515151184127313</c:v>
                </c:pt>
                <c:pt idx="3193">
                  <c:v>0.12941827594541441</c:v>
                </c:pt>
                <c:pt idx="3194">
                  <c:v>0.33624551761665378</c:v>
                </c:pt>
                <c:pt idx="3195">
                  <c:v>-9.4371210592517171E-2</c:v>
                </c:pt>
                <c:pt idx="3196">
                  <c:v>-0.25519856641968952</c:v>
                </c:pt>
                <c:pt idx="3197">
                  <c:v>5.1399152506644459E-2</c:v>
                </c:pt>
                <c:pt idx="3198">
                  <c:v>0.66383088953599101</c:v>
                </c:pt>
                <c:pt idx="3199">
                  <c:v>1.8084373492992443</c:v>
                </c:pt>
                <c:pt idx="3200">
                  <c:v>-3.9699917720951494E-2</c:v>
                </c:pt>
                <c:pt idx="3201">
                  <c:v>-1.1461990133524795</c:v>
                </c:pt>
                <c:pt idx="3202">
                  <c:v>9.3725085630267033E-2</c:v>
                </c:pt>
                <c:pt idx="3203">
                  <c:v>-7.6011738569641302E-2</c:v>
                </c:pt>
                <c:pt idx="3204">
                  <c:v>-4.684025420297229E-2</c:v>
                </c:pt>
                <c:pt idx="3205">
                  <c:v>-0.48810363312357652</c:v>
                </c:pt>
                <c:pt idx="3206">
                  <c:v>-0.19118360922003902</c:v>
                </c:pt>
                <c:pt idx="3207">
                  <c:v>-0.25362627842137681</c:v>
                </c:pt>
                <c:pt idx="3208">
                  <c:v>-0.20976526597410355</c:v>
                </c:pt>
                <c:pt idx="3209">
                  <c:v>0.1413028099616663</c:v>
                </c:pt>
                <c:pt idx="3210">
                  <c:v>4.5431429247006064E-2</c:v>
                </c:pt>
                <c:pt idx="3211">
                  <c:v>-3.9980597690881171E-2</c:v>
                </c:pt>
                <c:pt idx="3212">
                  <c:v>2.0194137747983135E-2</c:v>
                </c:pt>
                <c:pt idx="3213">
                  <c:v>-0.74183368096448699</c:v>
                </c:pt>
                <c:pt idx="3214">
                  <c:v>-0.52977098219888763</c:v>
                </c:pt>
                <c:pt idx="3215">
                  <c:v>-4.1242982231881394E-2</c:v>
                </c:pt>
                <c:pt idx="3216">
                  <c:v>-0.29959634878409525</c:v>
                </c:pt>
                <c:pt idx="3217">
                  <c:v>-0.10057404021319748</c:v>
                </c:pt>
                <c:pt idx="3218">
                  <c:v>2.1804370318348337E-2</c:v>
                </c:pt>
                <c:pt idx="3219">
                  <c:v>-0.33491146126206339</c:v>
                </c:pt>
                <c:pt idx="3220">
                  <c:v>-8.4336445723323647E-2</c:v>
                </c:pt>
                <c:pt idx="3221">
                  <c:v>-6.5020769948411342E-2</c:v>
                </c:pt>
                <c:pt idx="3222">
                  <c:v>-0.1210154009613658</c:v>
                </c:pt>
                <c:pt idx="3223">
                  <c:v>0.2599791297966173</c:v>
                </c:pt>
                <c:pt idx="3224">
                  <c:v>-0.16774328010893647</c:v>
                </c:pt>
                <c:pt idx="3225">
                  <c:v>-2.0057652341253399E-2</c:v>
                </c:pt>
                <c:pt idx="3226">
                  <c:v>-5.6583528366367597E-2</c:v>
                </c:pt>
                <c:pt idx="3227">
                  <c:v>7.9630469568326478E-2</c:v>
                </c:pt>
                <c:pt idx="3228">
                  <c:v>-6.6674762724460129E-2</c:v>
                </c:pt>
                <c:pt idx="3229">
                  <c:v>0.12610807554660461</c:v>
                </c:pt>
                <c:pt idx="3230">
                  <c:v>-0.33514020631421348</c:v>
                </c:pt>
                <c:pt idx="3231">
                  <c:v>-0.24476530756931317</c:v>
                </c:pt>
                <c:pt idx="3232">
                  <c:v>-0.45617532497867025</c:v>
                </c:pt>
                <c:pt idx="3233">
                  <c:v>2.4149739728834375E-2</c:v>
                </c:pt>
                <c:pt idx="3234">
                  <c:v>-0.15781983947886266</c:v>
                </c:pt>
                <c:pt idx="3235">
                  <c:v>4.2605385168242478E-2</c:v>
                </c:pt>
                <c:pt idx="3236">
                  <c:v>0.22465441592596011</c:v>
                </c:pt>
                <c:pt idx="3237">
                  <c:v>-0.2740528840782579</c:v>
                </c:pt>
                <c:pt idx="3238">
                  <c:v>1.0326838097307198</c:v>
                </c:pt>
                <c:pt idx="3239">
                  <c:v>0.39024503782755648</c:v>
                </c:pt>
                <c:pt idx="3240">
                  <c:v>-0.16349873228287951</c:v>
                </c:pt>
                <c:pt idx="3241">
                  <c:v>-1.2783184698289561E-2</c:v>
                </c:pt>
                <c:pt idx="3242">
                  <c:v>-0.49937394500216747</c:v>
                </c:pt>
                <c:pt idx="3243">
                  <c:v>-3.8295698181544449E-2</c:v>
                </c:pt>
                <c:pt idx="3244">
                  <c:v>-1.2354130407874147E-2</c:v>
                </c:pt>
                <c:pt idx="3245">
                  <c:v>-0.18814768692643408</c:v>
                </c:pt>
                <c:pt idx="3246">
                  <c:v>-1.4525427229236607</c:v>
                </c:pt>
                <c:pt idx="3247">
                  <c:v>0.21591485726524309</c:v>
                </c:pt>
                <c:pt idx="3248">
                  <c:v>1.100635965701869E-2</c:v>
                </c:pt>
                <c:pt idx="3249">
                  <c:v>0.58510677743920125</c:v>
                </c:pt>
                <c:pt idx="3250">
                  <c:v>-8.9170947360530575E-3</c:v>
                </c:pt>
                <c:pt idx="3251">
                  <c:v>-0.28983446517750899</c:v>
                </c:pt>
                <c:pt idx="3252">
                  <c:v>-0.31626161675957576</c:v>
                </c:pt>
                <c:pt idx="3253">
                  <c:v>-8.6104371243290859E-2</c:v>
                </c:pt>
                <c:pt idx="3254">
                  <c:v>0.15264443377163267</c:v>
                </c:pt>
                <c:pt idx="3255">
                  <c:v>-8.4472516936901526E-2</c:v>
                </c:pt>
                <c:pt idx="3256">
                  <c:v>0.6436307862837749</c:v>
                </c:pt>
                <c:pt idx="3257">
                  <c:v>-8.4200361674655208E-2</c:v>
                </c:pt>
                <c:pt idx="3258">
                  <c:v>-9.7745621638518798E-2</c:v>
                </c:pt>
                <c:pt idx="3259">
                  <c:v>-9.8554307220729401E-2</c:v>
                </c:pt>
                <c:pt idx="3260">
                  <c:v>-0.34460128303667714</c:v>
                </c:pt>
                <c:pt idx="3261">
                  <c:v>-3.8576651452323113E-2</c:v>
                </c:pt>
                <c:pt idx="3262">
                  <c:v>-5.6306060331876503E-2</c:v>
                </c:pt>
                <c:pt idx="3263">
                  <c:v>-0.56139946089503501</c:v>
                </c:pt>
                <c:pt idx="3264">
                  <c:v>-0.34641799354387653</c:v>
                </c:pt>
                <c:pt idx="3265">
                  <c:v>0.12989178233582188</c:v>
                </c:pt>
                <c:pt idx="3266">
                  <c:v>-0.14496000472085785</c:v>
                </c:pt>
                <c:pt idx="3267">
                  <c:v>-0.29689785770007771</c:v>
                </c:pt>
                <c:pt idx="3268">
                  <c:v>3.3274231282192986E-2</c:v>
                </c:pt>
                <c:pt idx="3269">
                  <c:v>-9.666666858017911E-2</c:v>
                </c:pt>
                <c:pt idx="3270">
                  <c:v>-0.2031384971908485</c:v>
                </c:pt>
                <c:pt idx="3271">
                  <c:v>-0.39121780760289732</c:v>
                </c:pt>
                <c:pt idx="3272">
                  <c:v>-0.16427139768074103</c:v>
                </c:pt>
                <c:pt idx="3273">
                  <c:v>0.39858872325521177</c:v>
                </c:pt>
                <c:pt idx="3274">
                  <c:v>-9.9901110007942676E-2</c:v>
                </c:pt>
                <c:pt idx="3275">
                  <c:v>-0.41737997597302273</c:v>
                </c:pt>
                <c:pt idx="3276">
                  <c:v>8.9113868064402829E-2</c:v>
                </c:pt>
                <c:pt idx="3277">
                  <c:v>-0.32745743429415336</c:v>
                </c:pt>
                <c:pt idx="3278">
                  <c:v>0.20639539026367779</c:v>
                </c:pt>
                <c:pt idx="3279">
                  <c:v>-0.20125745684324101</c:v>
                </c:pt>
                <c:pt idx="3280">
                  <c:v>-0.14313215555576803</c:v>
                </c:pt>
                <c:pt idx="3281">
                  <c:v>-6.018576504656304E-2</c:v>
                </c:pt>
                <c:pt idx="3282">
                  <c:v>5.3044613356881036E-2</c:v>
                </c:pt>
                <c:pt idx="3283">
                  <c:v>0.12484904194132311</c:v>
                </c:pt>
                <c:pt idx="3284">
                  <c:v>0.49593899869070712</c:v>
                </c:pt>
                <c:pt idx="3285">
                  <c:v>-0.86132020039419332</c:v>
                </c:pt>
                <c:pt idx="3286">
                  <c:v>-2.729562405090754E-2</c:v>
                </c:pt>
                <c:pt idx="3287">
                  <c:v>-6.1845307071069479E-2</c:v>
                </c:pt>
                <c:pt idx="3288">
                  <c:v>0.73144583596645674</c:v>
                </c:pt>
                <c:pt idx="3289">
                  <c:v>-0.15574923267794491</c:v>
                </c:pt>
                <c:pt idx="3290">
                  <c:v>-0.37695711447772751</c:v>
                </c:pt>
                <c:pt idx="3291">
                  <c:v>-0.51913928264297227</c:v>
                </c:pt>
                <c:pt idx="3292">
                  <c:v>-0.51500591643372939</c:v>
                </c:pt>
                <c:pt idx="3293">
                  <c:v>-0.57860063615274271</c:v>
                </c:pt>
                <c:pt idx="3294">
                  <c:v>7.2179379803793589E-2</c:v>
                </c:pt>
                <c:pt idx="3295">
                  <c:v>-0.49272486189177606</c:v>
                </c:pt>
                <c:pt idx="3296">
                  <c:v>-5.7970068637329869E-2</c:v>
                </c:pt>
                <c:pt idx="3297">
                  <c:v>-0.12512206056982386</c:v>
                </c:pt>
                <c:pt idx="3298">
                  <c:v>0.27823363366138454</c:v>
                </c:pt>
                <c:pt idx="3299">
                  <c:v>-0.18358179111782252</c:v>
                </c:pt>
                <c:pt idx="3300">
                  <c:v>-0.22379321624303261</c:v>
                </c:pt>
                <c:pt idx="3301">
                  <c:v>1.0442408411531194</c:v>
                </c:pt>
                <c:pt idx="3302">
                  <c:v>-0.4887206528952836</c:v>
                </c:pt>
                <c:pt idx="3303">
                  <c:v>0.46017118937694684</c:v>
                </c:pt>
                <c:pt idx="3304">
                  <c:v>-0.6851776838860788</c:v>
                </c:pt>
                <c:pt idx="3305">
                  <c:v>0.21240037308900628</c:v>
                </c:pt>
                <c:pt idx="3306">
                  <c:v>0.52740825426306714</c:v>
                </c:pt>
                <c:pt idx="3307">
                  <c:v>-0.19849415363908318</c:v>
                </c:pt>
                <c:pt idx="3308">
                  <c:v>-0.14208662961752691</c:v>
                </c:pt>
                <c:pt idx="3309">
                  <c:v>-0.56647422376316414</c:v>
                </c:pt>
                <c:pt idx="3310">
                  <c:v>-0.10259094958809112</c:v>
                </c:pt>
                <c:pt idx="3311">
                  <c:v>0.20739448659231124</c:v>
                </c:pt>
                <c:pt idx="3312">
                  <c:v>-0.27524548978466823</c:v>
                </c:pt>
                <c:pt idx="3313">
                  <c:v>0.29459707987027173</c:v>
                </c:pt>
                <c:pt idx="3314">
                  <c:v>8.9420824457239437E-2</c:v>
                </c:pt>
                <c:pt idx="3315">
                  <c:v>-8.8955682308218459E-2</c:v>
                </c:pt>
                <c:pt idx="3316">
                  <c:v>-0.2041407167802253</c:v>
                </c:pt>
                <c:pt idx="3317">
                  <c:v>-0.92447999235902245</c:v>
                </c:pt>
                <c:pt idx="3318">
                  <c:v>1.9901561182208809E-2</c:v>
                </c:pt>
                <c:pt idx="3319">
                  <c:v>8.2377298273717453E-2</c:v>
                </c:pt>
                <c:pt idx="3320">
                  <c:v>-0.11423374442708781</c:v>
                </c:pt>
                <c:pt idx="3321">
                  <c:v>0.19859298163428168</c:v>
                </c:pt>
                <c:pt idx="3322">
                  <c:v>-0.13684760419288095</c:v>
                </c:pt>
                <c:pt idx="3323">
                  <c:v>0.83701660797653477</c:v>
                </c:pt>
                <c:pt idx="3324">
                  <c:v>1.2639580262500325</c:v>
                </c:pt>
              </c:numCache>
            </c:numRef>
          </c:xVal>
          <c:yVal>
            <c:numRef>
              <c:f>'sDM - HFD Prot'!$B$2:$B$3326</c:f>
              <c:numCache>
                <c:formatCode>General</c:formatCode>
                <c:ptCount val="3325"/>
                <c:pt idx="0">
                  <c:v>0.15729492641777459</c:v>
                </c:pt>
                <c:pt idx="1">
                  <c:v>0.26691101533306372</c:v>
                </c:pt>
                <c:pt idx="2">
                  <c:v>0.50158221333599617</c:v>
                </c:pt>
                <c:pt idx="3">
                  <c:v>0.74277687127023995</c:v>
                </c:pt>
                <c:pt idx="4">
                  <c:v>8.0640486128286032E-2</c:v>
                </c:pt>
                <c:pt idx="5">
                  <c:v>0.55043906114564356</c:v>
                </c:pt>
                <c:pt idx="6">
                  <c:v>0.15520774413634389</c:v>
                </c:pt>
                <c:pt idx="7">
                  <c:v>0.76080433427887295</c:v>
                </c:pt>
                <c:pt idx="8">
                  <c:v>0.64320257481363363</c:v>
                </c:pt>
                <c:pt idx="9">
                  <c:v>0.79922934537381352</c:v>
                </c:pt>
                <c:pt idx="10">
                  <c:v>1.0685400566732903</c:v>
                </c:pt>
                <c:pt idx="11">
                  <c:v>0.52677925606289699</c:v>
                </c:pt>
                <c:pt idx="12">
                  <c:v>0.60823742844049189</c:v>
                </c:pt>
                <c:pt idx="13">
                  <c:v>9.7641276480792086E-2</c:v>
                </c:pt>
                <c:pt idx="14">
                  <c:v>7.7511563453811716E-2</c:v>
                </c:pt>
                <c:pt idx="15">
                  <c:v>0.98711587454342264</c:v>
                </c:pt>
                <c:pt idx="16">
                  <c:v>0.57831783833260875</c:v>
                </c:pt>
                <c:pt idx="17">
                  <c:v>1.2868247898873053</c:v>
                </c:pt>
                <c:pt idx="18">
                  <c:v>0.10902690497019026</c:v>
                </c:pt>
                <c:pt idx="19">
                  <c:v>0.34623655531650088</c:v>
                </c:pt>
                <c:pt idx="20">
                  <c:v>0.26046984250404398</c:v>
                </c:pt>
                <c:pt idx="21">
                  <c:v>0.2267129901611695</c:v>
                </c:pt>
                <c:pt idx="22">
                  <c:v>1.1173223001203128</c:v>
                </c:pt>
                <c:pt idx="23">
                  <c:v>0.31893590278597939</c:v>
                </c:pt>
                <c:pt idx="24">
                  <c:v>0.38667193688808865</c:v>
                </c:pt>
                <c:pt idx="25">
                  <c:v>0.69835764656796662</c:v>
                </c:pt>
                <c:pt idx="26">
                  <c:v>0.13492949074849486</c:v>
                </c:pt>
                <c:pt idx="27">
                  <c:v>0.40701749369456591</c:v>
                </c:pt>
                <c:pt idx="28">
                  <c:v>0.83366055993586663</c:v>
                </c:pt>
                <c:pt idx="29">
                  <c:v>1.0378265790443686</c:v>
                </c:pt>
                <c:pt idx="30">
                  <c:v>0.37483420807311024</c:v>
                </c:pt>
                <c:pt idx="31">
                  <c:v>0.30174970737636914</c:v>
                </c:pt>
                <c:pt idx="32">
                  <c:v>2.1023559693571419</c:v>
                </c:pt>
                <c:pt idx="33">
                  <c:v>6.8710066413307777E-2</c:v>
                </c:pt>
                <c:pt idx="34">
                  <c:v>0.1011835764593611</c:v>
                </c:pt>
                <c:pt idx="35">
                  <c:v>0.52332771799265332</c:v>
                </c:pt>
                <c:pt idx="36">
                  <c:v>0.43750382942408389</c:v>
                </c:pt>
                <c:pt idx="37">
                  <c:v>0.58163764710794286</c:v>
                </c:pt>
                <c:pt idx="38">
                  <c:v>4.6238231029364342E-2</c:v>
                </c:pt>
                <c:pt idx="39">
                  <c:v>2.8712589559534814E-2</c:v>
                </c:pt>
                <c:pt idx="40">
                  <c:v>0.35336164675298432</c:v>
                </c:pt>
                <c:pt idx="41">
                  <c:v>5.0423027076384762E-2</c:v>
                </c:pt>
                <c:pt idx="42">
                  <c:v>0.26360326693682834</c:v>
                </c:pt>
                <c:pt idx="43">
                  <c:v>2.5846135335054456</c:v>
                </c:pt>
                <c:pt idx="44">
                  <c:v>0.51492431205627032</c:v>
                </c:pt>
                <c:pt idx="45">
                  <c:v>0.95663424486754223</c:v>
                </c:pt>
                <c:pt idx="46">
                  <c:v>1.1113224831582653</c:v>
                </c:pt>
                <c:pt idx="47">
                  <c:v>1.0893157365594617</c:v>
                </c:pt>
                <c:pt idx="48">
                  <c:v>1.1943606410408094</c:v>
                </c:pt>
                <c:pt idx="49">
                  <c:v>0.29101181013746502</c:v>
                </c:pt>
                <c:pt idx="50">
                  <c:v>0.5701081669384519</c:v>
                </c:pt>
                <c:pt idx="51">
                  <c:v>0.79468012887299133</c:v>
                </c:pt>
                <c:pt idx="52">
                  <c:v>0.93918319031106523</c:v>
                </c:pt>
                <c:pt idx="53">
                  <c:v>0.83663246180366679</c:v>
                </c:pt>
                <c:pt idx="54">
                  <c:v>2.2371276145859681E-2</c:v>
                </c:pt>
                <c:pt idx="55">
                  <c:v>8.3820489846644558E-2</c:v>
                </c:pt>
                <c:pt idx="56">
                  <c:v>0.44492235858411133</c:v>
                </c:pt>
                <c:pt idx="57">
                  <c:v>1.1774361808426586</c:v>
                </c:pt>
                <c:pt idx="58">
                  <c:v>1.0647287380502801</c:v>
                </c:pt>
                <c:pt idx="59">
                  <c:v>1.06446705662981</c:v>
                </c:pt>
                <c:pt idx="60">
                  <c:v>0.35841705391668882</c:v>
                </c:pt>
                <c:pt idx="61">
                  <c:v>0.16018318676377352</c:v>
                </c:pt>
                <c:pt idx="62">
                  <c:v>0.76815427578236817</c:v>
                </c:pt>
                <c:pt idx="63">
                  <c:v>6.2281093263247725E-2</c:v>
                </c:pt>
                <c:pt idx="64">
                  <c:v>0.256713551917782</c:v>
                </c:pt>
                <c:pt idx="65">
                  <c:v>1.2783930264560526</c:v>
                </c:pt>
                <c:pt idx="66">
                  <c:v>0.75793662018736829</c:v>
                </c:pt>
                <c:pt idx="67">
                  <c:v>0.28815890326955057</c:v>
                </c:pt>
                <c:pt idx="68">
                  <c:v>0.21428513566812604</c:v>
                </c:pt>
                <c:pt idx="69">
                  <c:v>0.74491389092304749</c:v>
                </c:pt>
                <c:pt idx="70">
                  <c:v>0.13648710780709153</c:v>
                </c:pt>
                <c:pt idx="71">
                  <c:v>1.0548127871002997</c:v>
                </c:pt>
                <c:pt idx="72">
                  <c:v>1.3047117085452937</c:v>
                </c:pt>
                <c:pt idx="73">
                  <c:v>0.10799896360538232</c:v>
                </c:pt>
                <c:pt idx="74">
                  <c:v>1.1181441093435596</c:v>
                </c:pt>
                <c:pt idx="75">
                  <c:v>0.36969964437262193</c:v>
                </c:pt>
                <c:pt idx="76">
                  <c:v>0.55702997734434267</c:v>
                </c:pt>
                <c:pt idx="77">
                  <c:v>0.94678115281699626</c:v>
                </c:pt>
                <c:pt idx="78">
                  <c:v>0.41211605841272969</c:v>
                </c:pt>
                <c:pt idx="79">
                  <c:v>0.14511527326245571</c:v>
                </c:pt>
                <c:pt idx="80">
                  <c:v>0.15159646338447599</c:v>
                </c:pt>
                <c:pt idx="81">
                  <c:v>0.97919986285002902</c:v>
                </c:pt>
                <c:pt idx="82">
                  <c:v>0.13912070286966852</c:v>
                </c:pt>
                <c:pt idx="83">
                  <c:v>1.1371086264850017</c:v>
                </c:pt>
                <c:pt idx="84">
                  <c:v>1.183134622117443</c:v>
                </c:pt>
                <c:pt idx="85">
                  <c:v>0.12943999750555932</c:v>
                </c:pt>
                <c:pt idx="86">
                  <c:v>0.16016117767991067</c:v>
                </c:pt>
                <c:pt idx="87">
                  <c:v>1.562842084151322</c:v>
                </c:pt>
                <c:pt idx="88">
                  <c:v>1.3645327233936433</c:v>
                </c:pt>
                <c:pt idx="89">
                  <c:v>0.87276896783666613</c:v>
                </c:pt>
                <c:pt idx="90">
                  <c:v>0.20053938030750576</c:v>
                </c:pt>
                <c:pt idx="91">
                  <c:v>0.3251448850127106</c:v>
                </c:pt>
                <c:pt idx="92">
                  <c:v>1.0474908921811661</c:v>
                </c:pt>
                <c:pt idx="93">
                  <c:v>0.39210856089061397</c:v>
                </c:pt>
                <c:pt idx="94">
                  <c:v>0.16983275591350575</c:v>
                </c:pt>
                <c:pt idx="95">
                  <c:v>0.28394791154603011</c:v>
                </c:pt>
                <c:pt idx="96">
                  <c:v>0.19271550719942235</c:v>
                </c:pt>
                <c:pt idx="97">
                  <c:v>1.2520382921951043</c:v>
                </c:pt>
                <c:pt idx="98">
                  <c:v>0.40468237572809485</c:v>
                </c:pt>
                <c:pt idx="99">
                  <c:v>0.94096594372535558</c:v>
                </c:pt>
                <c:pt idx="100">
                  <c:v>0.33564567942928419</c:v>
                </c:pt>
                <c:pt idx="101">
                  <c:v>0.95563362981935596</c:v>
                </c:pt>
                <c:pt idx="102">
                  <c:v>0.20844369840594065</c:v>
                </c:pt>
                <c:pt idx="103">
                  <c:v>0.44820731110012063</c:v>
                </c:pt>
                <c:pt idx="104">
                  <c:v>3.8422080843507081E-2</c:v>
                </c:pt>
                <c:pt idx="105">
                  <c:v>0.11009579247555716</c:v>
                </c:pt>
                <c:pt idx="106">
                  <c:v>1.1583074624045873</c:v>
                </c:pt>
                <c:pt idx="107">
                  <c:v>0.22643448563328566</c:v>
                </c:pt>
                <c:pt idx="108">
                  <c:v>1.1625950174933248</c:v>
                </c:pt>
                <c:pt idx="109">
                  <c:v>0.50776820171248316</c:v>
                </c:pt>
                <c:pt idx="110">
                  <c:v>0.19761749197326572</c:v>
                </c:pt>
                <c:pt idx="111">
                  <c:v>0.78981357392641038</c:v>
                </c:pt>
                <c:pt idx="112">
                  <c:v>0.17243329081292824</c:v>
                </c:pt>
                <c:pt idx="113">
                  <c:v>0.56308929701302135</c:v>
                </c:pt>
                <c:pt idx="114">
                  <c:v>0.2510183245219233</c:v>
                </c:pt>
                <c:pt idx="115">
                  <c:v>4.568309260360727E-2</c:v>
                </c:pt>
                <c:pt idx="116">
                  <c:v>0.58166684403770497</c:v>
                </c:pt>
                <c:pt idx="117">
                  <c:v>0.94375349942409903</c:v>
                </c:pt>
                <c:pt idx="118">
                  <c:v>0.15239886233842848</c:v>
                </c:pt>
                <c:pt idx="119">
                  <c:v>0.80664877150507597</c:v>
                </c:pt>
                <c:pt idx="120">
                  <c:v>0.19235111016907752</c:v>
                </c:pt>
                <c:pt idx="121">
                  <c:v>0.66932161974582638</c:v>
                </c:pt>
                <c:pt idx="122">
                  <c:v>0.48275675175946209</c:v>
                </c:pt>
                <c:pt idx="123">
                  <c:v>0.8210136364909183</c:v>
                </c:pt>
                <c:pt idx="124">
                  <c:v>5.8299718363141739E-2</c:v>
                </c:pt>
                <c:pt idx="125">
                  <c:v>0.9086818597279267</c:v>
                </c:pt>
                <c:pt idx="126">
                  <c:v>6.2177144900341069E-2</c:v>
                </c:pt>
                <c:pt idx="127">
                  <c:v>0.22848004316260884</c:v>
                </c:pt>
                <c:pt idx="128">
                  <c:v>0.77383181988170968</c:v>
                </c:pt>
                <c:pt idx="129">
                  <c:v>0.40336539559874879</c:v>
                </c:pt>
                <c:pt idx="130">
                  <c:v>0.24465176433862526</c:v>
                </c:pt>
                <c:pt idx="131">
                  <c:v>0.79429239454129208</c:v>
                </c:pt>
                <c:pt idx="132">
                  <c:v>0.12784061361770574</c:v>
                </c:pt>
                <c:pt idx="133">
                  <c:v>0.1626163717482933</c:v>
                </c:pt>
                <c:pt idx="134">
                  <c:v>0.22740619305763751</c:v>
                </c:pt>
                <c:pt idx="135">
                  <c:v>0.26318444828123555</c:v>
                </c:pt>
                <c:pt idx="136">
                  <c:v>1.6316290068031987</c:v>
                </c:pt>
                <c:pt idx="137">
                  <c:v>0.48545600401263578</c:v>
                </c:pt>
                <c:pt idx="138">
                  <c:v>1.3143790120448937</c:v>
                </c:pt>
                <c:pt idx="139">
                  <c:v>1.0613501687994926</c:v>
                </c:pt>
                <c:pt idx="140">
                  <c:v>0.51625295331403576</c:v>
                </c:pt>
                <c:pt idx="141">
                  <c:v>0.67071515913926971</c:v>
                </c:pt>
                <c:pt idx="142">
                  <c:v>4.6793460101499415E-2</c:v>
                </c:pt>
                <c:pt idx="143">
                  <c:v>0.17472899982775666</c:v>
                </c:pt>
                <c:pt idx="144">
                  <c:v>0.99073951479645828</c:v>
                </c:pt>
                <c:pt idx="145">
                  <c:v>0.34812514017949803</c:v>
                </c:pt>
                <c:pt idx="146">
                  <c:v>0.58265986811783055</c:v>
                </c:pt>
                <c:pt idx="147">
                  <c:v>0.49365830235476094</c:v>
                </c:pt>
                <c:pt idx="148">
                  <c:v>0.29025184993796094</c:v>
                </c:pt>
                <c:pt idx="149">
                  <c:v>1.108554847244269</c:v>
                </c:pt>
                <c:pt idx="150">
                  <c:v>2.4128532903209036E-2</c:v>
                </c:pt>
                <c:pt idx="151">
                  <c:v>9.2846990913505539E-2</c:v>
                </c:pt>
                <c:pt idx="152">
                  <c:v>6.1961597796827035E-2</c:v>
                </c:pt>
                <c:pt idx="153">
                  <c:v>0.64625674427503454</c:v>
                </c:pt>
                <c:pt idx="154">
                  <c:v>0.27291210548050582</c:v>
                </c:pt>
                <c:pt idx="155">
                  <c:v>1.7165910793951304E-2</c:v>
                </c:pt>
                <c:pt idx="156">
                  <c:v>0.79448055907284409</c:v>
                </c:pt>
                <c:pt idx="157">
                  <c:v>1.0233600613727925</c:v>
                </c:pt>
                <c:pt idx="158">
                  <c:v>1.0531637028034575</c:v>
                </c:pt>
                <c:pt idx="159">
                  <c:v>0.38185619971386808</c:v>
                </c:pt>
                <c:pt idx="160">
                  <c:v>0.10274669924642625</c:v>
                </c:pt>
                <c:pt idx="161">
                  <c:v>0.97748722136770605</c:v>
                </c:pt>
                <c:pt idx="162">
                  <c:v>0.89867440388453135</c:v>
                </c:pt>
                <c:pt idx="163">
                  <c:v>0.2531914177350254</c:v>
                </c:pt>
                <c:pt idx="164">
                  <c:v>0.2102604188769798</c:v>
                </c:pt>
                <c:pt idx="165">
                  <c:v>0.91039775439292536</c:v>
                </c:pt>
                <c:pt idx="166">
                  <c:v>0.22246498780145235</c:v>
                </c:pt>
                <c:pt idx="167">
                  <c:v>0.49086437454099108</c:v>
                </c:pt>
                <c:pt idx="168">
                  <c:v>0.4086889920132441</c:v>
                </c:pt>
                <c:pt idx="169">
                  <c:v>0.8805908541002041</c:v>
                </c:pt>
                <c:pt idx="170">
                  <c:v>0.66015120035741337</c:v>
                </c:pt>
                <c:pt idx="171">
                  <c:v>0.44337060539820777</c:v>
                </c:pt>
                <c:pt idx="172">
                  <c:v>1.0294664975459331</c:v>
                </c:pt>
                <c:pt idx="173">
                  <c:v>0.57863821539408422</c:v>
                </c:pt>
                <c:pt idx="174">
                  <c:v>0.11285017893012225</c:v>
                </c:pt>
                <c:pt idx="175">
                  <c:v>0.74937221899421314</c:v>
                </c:pt>
                <c:pt idx="176">
                  <c:v>0.16423177619161361</c:v>
                </c:pt>
                <c:pt idx="177">
                  <c:v>0.10179637188320709</c:v>
                </c:pt>
                <c:pt idx="178">
                  <c:v>0.3109869896074382</c:v>
                </c:pt>
                <c:pt idx="179">
                  <c:v>0.22582752962214861</c:v>
                </c:pt>
                <c:pt idx="180">
                  <c:v>0.42334877900647072</c:v>
                </c:pt>
                <c:pt idx="181">
                  <c:v>0.1740644154949505</c:v>
                </c:pt>
                <c:pt idx="182">
                  <c:v>1.0100225122343034</c:v>
                </c:pt>
                <c:pt idx="183">
                  <c:v>1.1449878579887387</c:v>
                </c:pt>
                <c:pt idx="184">
                  <c:v>0.7606561017918827</c:v>
                </c:pt>
                <c:pt idx="185">
                  <c:v>0.61712750021262719</c:v>
                </c:pt>
                <c:pt idx="186">
                  <c:v>0.10200501770884839</c:v>
                </c:pt>
                <c:pt idx="187">
                  <c:v>6.1135610728691427E-2</c:v>
                </c:pt>
                <c:pt idx="188">
                  <c:v>1.6180813196483594</c:v>
                </c:pt>
                <c:pt idx="189">
                  <c:v>9.5303390324620318E-2</c:v>
                </c:pt>
                <c:pt idx="190">
                  <c:v>0.77339377853835811</c:v>
                </c:pt>
                <c:pt idx="191">
                  <c:v>0.41506964907654653</c:v>
                </c:pt>
                <c:pt idx="192">
                  <c:v>0.26583594407115863</c:v>
                </c:pt>
                <c:pt idx="193">
                  <c:v>0.28539743685651792</c:v>
                </c:pt>
                <c:pt idx="194">
                  <c:v>1.1689447221270195</c:v>
                </c:pt>
                <c:pt idx="195">
                  <c:v>0.19610857579028193</c:v>
                </c:pt>
                <c:pt idx="196">
                  <c:v>0.45957015769887544</c:v>
                </c:pt>
                <c:pt idx="197">
                  <c:v>0.20394483266763372</c:v>
                </c:pt>
                <c:pt idx="198">
                  <c:v>0.88537328644196667</c:v>
                </c:pt>
                <c:pt idx="199">
                  <c:v>0.46836233019050943</c:v>
                </c:pt>
                <c:pt idx="200">
                  <c:v>1.2795057696442653</c:v>
                </c:pt>
                <c:pt idx="201">
                  <c:v>3.1632892610322698E-2</c:v>
                </c:pt>
                <c:pt idx="202">
                  <c:v>0.60054840774676532</c:v>
                </c:pt>
                <c:pt idx="203">
                  <c:v>0.51975535050823762</c:v>
                </c:pt>
                <c:pt idx="204">
                  <c:v>0.18242904278305555</c:v>
                </c:pt>
                <c:pt idx="205">
                  <c:v>0.23314854858322129</c:v>
                </c:pt>
                <c:pt idx="206">
                  <c:v>1.832457701510341E-2</c:v>
                </c:pt>
                <c:pt idx="207">
                  <c:v>0.26096348532401359</c:v>
                </c:pt>
                <c:pt idx="208">
                  <c:v>0.93187326570058782</c:v>
                </c:pt>
                <c:pt idx="209">
                  <c:v>4.8148972569694685E-2</c:v>
                </c:pt>
                <c:pt idx="210">
                  <c:v>1.0948783408553742</c:v>
                </c:pt>
                <c:pt idx="211">
                  <c:v>3.1744325853002617E-2</c:v>
                </c:pt>
                <c:pt idx="212">
                  <c:v>1.0284728041972684E-2</c:v>
                </c:pt>
                <c:pt idx="213">
                  <c:v>0.89460348205617002</c:v>
                </c:pt>
                <c:pt idx="214">
                  <c:v>0.4842079703831465</c:v>
                </c:pt>
                <c:pt idx="215">
                  <c:v>1.7253411554276417</c:v>
                </c:pt>
                <c:pt idx="216">
                  <c:v>0.37680340579041943</c:v>
                </c:pt>
                <c:pt idx="217">
                  <c:v>0.21183104604899874</c:v>
                </c:pt>
                <c:pt idx="218">
                  <c:v>0.10343919960225643</c:v>
                </c:pt>
                <c:pt idx="219">
                  <c:v>1.0962831061798601</c:v>
                </c:pt>
                <c:pt idx="220">
                  <c:v>0.13560625360395739</c:v>
                </c:pt>
                <c:pt idx="221">
                  <c:v>0.56320399266091736</c:v>
                </c:pt>
                <c:pt idx="222">
                  <c:v>1.0274588739454393</c:v>
                </c:pt>
                <c:pt idx="223">
                  <c:v>0.11357719098151563</c:v>
                </c:pt>
                <c:pt idx="224">
                  <c:v>0.47027104355409266</c:v>
                </c:pt>
                <c:pt idx="225">
                  <c:v>1.4457657243326301E-2</c:v>
                </c:pt>
                <c:pt idx="226">
                  <c:v>0.72152048611176323</c:v>
                </c:pt>
                <c:pt idx="227">
                  <c:v>3.4881138259537349E-2</c:v>
                </c:pt>
                <c:pt idx="228">
                  <c:v>0.8777251830275592</c:v>
                </c:pt>
                <c:pt idx="229">
                  <c:v>0.23541133797159067</c:v>
                </c:pt>
                <c:pt idx="230">
                  <c:v>6.7921649158648872E-2</c:v>
                </c:pt>
                <c:pt idx="231">
                  <c:v>0.24875126044085621</c:v>
                </c:pt>
                <c:pt idx="232">
                  <c:v>0.84469570971507368</c:v>
                </c:pt>
                <c:pt idx="233">
                  <c:v>0.32867494846949602</c:v>
                </c:pt>
                <c:pt idx="234">
                  <c:v>0.63730898728524754</c:v>
                </c:pt>
                <c:pt idx="235">
                  <c:v>1.3580614754411382</c:v>
                </c:pt>
                <c:pt idx="236">
                  <c:v>8.3858429333344572E-2</c:v>
                </c:pt>
                <c:pt idx="237">
                  <c:v>0.40757081006106655</c:v>
                </c:pt>
                <c:pt idx="238">
                  <c:v>0.66761501230544118</c:v>
                </c:pt>
                <c:pt idx="239">
                  <c:v>0.41895474872148231</c:v>
                </c:pt>
                <c:pt idx="240">
                  <c:v>1.0221532588115241</c:v>
                </c:pt>
                <c:pt idx="241">
                  <c:v>0.76172871378921692</c:v>
                </c:pt>
                <c:pt idx="242">
                  <c:v>1.1168979974656288</c:v>
                </c:pt>
                <c:pt idx="243">
                  <c:v>0.30862624740990208</c:v>
                </c:pt>
                <c:pt idx="244">
                  <c:v>0.86885013031546299</c:v>
                </c:pt>
                <c:pt idx="245">
                  <c:v>0.3018665462000038</c:v>
                </c:pt>
                <c:pt idx="246">
                  <c:v>0.80278053017336537</c:v>
                </c:pt>
                <c:pt idx="247">
                  <c:v>0.22553028285974111</c:v>
                </c:pt>
                <c:pt idx="248">
                  <c:v>0.10835189167307496</c:v>
                </c:pt>
                <c:pt idx="249">
                  <c:v>0.59980708075350753</c:v>
                </c:pt>
                <c:pt idx="250">
                  <c:v>0.66348795998095211</c:v>
                </c:pt>
                <c:pt idx="251">
                  <c:v>0.46227081898657063</c:v>
                </c:pt>
                <c:pt idx="252">
                  <c:v>0.22250507820462587</c:v>
                </c:pt>
                <c:pt idx="253">
                  <c:v>0.22056902279845048</c:v>
                </c:pt>
                <c:pt idx="254">
                  <c:v>1.5336872978004497</c:v>
                </c:pt>
                <c:pt idx="255">
                  <c:v>0.3348584576038135</c:v>
                </c:pt>
                <c:pt idx="256">
                  <c:v>0.83187840541448954</c:v>
                </c:pt>
                <c:pt idx="257">
                  <c:v>1.2340410134319953E-3</c:v>
                </c:pt>
                <c:pt idx="258">
                  <c:v>5.3932198143733248E-2</c:v>
                </c:pt>
                <c:pt idx="259">
                  <c:v>0.10285379620158643</c:v>
                </c:pt>
                <c:pt idx="260">
                  <c:v>1.0943845801357519</c:v>
                </c:pt>
                <c:pt idx="261">
                  <c:v>0.1069225757526502</c:v>
                </c:pt>
                <c:pt idx="262">
                  <c:v>1.1571281174896597</c:v>
                </c:pt>
                <c:pt idx="263">
                  <c:v>9.263001287206786E-2</c:v>
                </c:pt>
                <c:pt idx="264">
                  <c:v>0.69080409998889469</c:v>
                </c:pt>
                <c:pt idx="265">
                  <c:v>0.55534167050607508</c:v>
                </c:pt>
                <c:pt idx="266">
                  <c:v>0.16775769649204028</c:v>
                </c:pt>
                <c:pt idx="267">
                  <c:v>2.2463848223517317E-2</c:v>
                </c:pt>
                <c:pt idx="268">
                  <c:v>0.41813929120117999</c:v>
                </c:pt>
                <c:pt idx="269">
                  <c:v>0.21133933520778431</c:v>
                </c:pt>
                <c:pt idx="270">
                  <c:v>0.22830541980453528</c:v>
                </c:pt>
                <c:pt idx="271">
                  <c:v>0.14098609394064926</c:v>
                </c:pt>
                <c:pt idx="272">
                  <c:v>0.34441385710021177</c:v>
                </c:pt>
                <c:pt idx="273">
                  <c:v>0.17971062107452684</c:v>
                </c:pt>
                <c:pt idx="274">
                  <c:v>0.26172401533612377</c:v>
                </c:pt>
                <c:pt idx="275">
                  <c:v>0.87134474994676669</c:v>
                </c:pt>
                <c:pt idx="276">
                  <c:v>0.32157065570139698</c:v>
                </c:pt>
                <c:pt idx="277">
                  <c:v>0.67906388029874365</c:v>
                </c:pt>
                <c:pt idx="278">
                  <c:v>0.88556424116113552</c:v>
                </c:pt>
                <c:pt idx="279">
                  <c:v>0.52687899464297627</c:v>
                </c:pt>
                <c:pt idx="280">
                  <c:v>0.47574481728805373</c:v>
                </c:pt>
                <c:pt idx="281">
                  <c:v>0.40383423858436551</c:v>
                </c:pt>
                <c:pt idx="282">
                  <c:v>0.19249780100624225</c:v>
                </c:pt>
                <c:pt idx="283">
                  <c:v>0.4723997063189555</c:v>
                </c:pt>
                <c:pt idx="284">
                  <c:v>1.4471460553216422</c:v>
                </c:pt>
                <c:pt idx="285">
                  <c:v>1.1093231167118949</c:v>
                </c:pt>
                <c:pt idx="286">
                  <c:v>0.74003806433604635</c:v>
                </c:pt>
                <c:pt idx="287">
                  <c:v>1.3585760693833064E-2</c:v>
                </c:pt>
                <c:pt idx="288">
                  <c:v>1.389316339123985E-2</c:v>
                </c:pt>
                <c:pt idx="289">
                  <c:v>1.4252466936423027</c:v>
                </c:pt>
                <c:pt idx="290">
                  <c:v>0.2097962586497856</c:v>
                </c:pt>
                <c:pt idx="291">
                  <c:v>0.20042018624801974</c:v>
                </c:pt>
                <c:pt idx="292">
                  <c:v>0.2135223509588477</c:v>
                </c:pt>
                <c:pt idx="293">
                  <c:v>0.17135814182853046</c:v>
                </c:pt>
                <c:pt idx="294">
                  <c:v>1.3723344864595861</c:v>
                </c:pt>
                <c:pt idx="295">
                  <c:v>0.2322264617988205</c:v>
                </c:pt>
                <c:pt idx="296">
                  <c:v>1.1267528780269833</c:v>
                </c:pt>
                <c:pt idx="297">
                  <c:v>2.7538006799504609E-2</c:v>
                </c:pt>
                <c:pt idx="298">
                  <c:v>4.7611562883471251E-2</c:v>
                </c:pt>
                <c:pt idx="299">
                  <c:v>0.10982498367753969</c:v>
                </c:pt>
                <c:pt idx="300">
                  <c:v>1.1179889433021577</c:v>
                </c:pt>
                <c:pt idx="301">
                  <c:v>0.54018628485668951</c:v>
                </c:pt>
                <c:pt idx="302">
                  <c:v>0.62184278756374056</c:v>
                </c:pt>
                <c:pt idx="303">
                  <c:v>1.0489146286832929</c:v>
                </c:pt>
                <c:pt idx="304">
                  <c:v>0.5900475472139165</c:v>
                </c:pt>
                <c:pt idx="305">
                  <c:v>0.29225459923726821</c:v>
                </c:pt>
                <c:pt idx="306">
                  <c:v>0.96471261523358198</c:v>
                </c:pt>
                <c:pt idx="307">
                  <c:v>0.2276024807321971</c:v>
                </c:pt>
                <c:pt idx="308">
                  <c:v>0.98982990134588578</c:v>
                </c:pt>
                <c:pt idx="309">
                  <c:v>0.36224954533607068</c:v>
                </c:pt>
                <c:pt idx="310">
                  <c:v>1.0082858355967814</c:v>
                </c:pt>
                <c:pt idx="311">
                  <c:v>0.34275381576924752</c:v>
                </c:pt>
                <c:pt idx="312">
                  <c:v>0.69644106347115364</c:v>
                </c:pt>
                <c:pt idx="313">
                  <c:v>1.2092596485024081</c:v>
                </c:pt>
                <c:pt idx="314">
                  <c:v>0.44209674856008141</c:v>
                </c:pt>
                <c:pt idx="315">
                  <c:v>9.1105351456723271E-2</c:v>
                </c:pt>
                <c:pt idx="316">
                  <c:v>0.3056687146001964</c:v>
                </c:pt>
                <c:pt idx="317">
                  <c:v>0.95011246846622344</c:v>
                </c:pt>
                <c:pt idx="318">
                  <c:v>0.16634160601309866</c:v>
                </c:pt>
                <c:pt idx="319">
                  <c:v>0.8851838333644928</c:v>
                </c:pt>
                <c:pt idx="320">
                  <c:v>1.0677343465219409</c:v>
                </c:pt>
                <c:pt idx="321">
                  <c:v>0.13209155346230664</c:v>
                </c:pt>
                <c:pt idx="322">
                  <c:v>0.17703344049966166</c:v>
                </c:pt>
                <c:pt idx="323">
                  <c:v>0.1395217546735889</c:v>
                </c:pt>
                <c:pt idx="324">
                  <c:v>0.58520122484344805</c:v>
                </c:pt>
                <c:pt idx="325">
                  <c:v>9.9735021718947617E-2</c:v>
                </c:pt>
                <c:pt idx="326">
                  <c:v>0.55996650604789944</c:v>
                </c:pt>
                <c:pt idx="327">
                  <c:v>0.56517168060693723</c:v>
                </c:pt>
                <c:pt idx="328">
                  <c:v>2.4997716609744567E-2</c:v>
                </c:pt>
                <c:pt idx="329">
                  <c:v>0.9025210439709328</c:v>
                </c:pt>
                <c:pt idx="330">
                  <c:v>0.29827688207240977</c:v>
                </c:pt>
                <c:pt idx="331">
                  <c:v>0.32963557644136499</c:v>
                </c:pt>
                <c:pt idx="332">
                  <c:v>0.19265734267057022</c:v>
                </c:pt>
                <c:pt idx="333">
                  <c:v>0.38120736802892202</c:v>
                </c:pt>
                <c:pt idx="334">
                  <c:v>1.2487281297679615</c:v>
                </c:pt>
                <c:pt idx="335">
                  <c:v>0.34948114349751741</c:v>
                </c:pt>
                <c:pt idx="336">
                  <c:v>0.32511915161879335</c:v>
                </c:pt>
                <c:pt idx="337">
                  <c:v>0.87748533808656404</c:v>
                </c:pt>
                <c:pt idx="338">
                  <c:v>0.38223988891246924</c:v>
                </c:pt>
                <c:pt idx="339">
                  <c:v>4.3924474092838249E-2</c:v>
                </c:pt>
                <c:pt idx="340">
                  <c:v>0.67477314725484583</c:v>
                </c:pt>
                <c:pt idx="341">
                  <c:v>0.93844505483328788</c:v>
                </c:pt>
                <c:pt idx="342">
                  <c:v>9.6974687756054972E-2</c:v>
                </c:pt>
                <c:pt idx="343">
                  <c:v>9.3302947732804328E-2</c:v>
                </c:pt>
                <c:pt idx="344">
                  <c:v>0.71776996866107967</c:v>
                </c:pt>
                <c:pt idx="345">
                  <c:v>0.26227026921264784</c:v>
                </c:pt>
                <c:pt idx="346">
                  <c:v>1.886614479880079</c:v>
                </c:pt>
                <c:pt idx="347">
                  <c:v>7.3591289861742432E-2</c:v>
                </c:pt>
                <c:pt idx="348">
                  <c:v>0.38657457223610425</c:v>
                </c:pt>
                <c:pt idx="349">
                  <c:v>0.28356879661519407</c:v>
                </c:pt>
                <c:pt idx="350">
                  <c:v>0.99913658497372115</c:v>
                </c:pt>
                <c:pt idx="351">
                  <c:v>1.0422524250026554E-2</c:v>
                </c:pt>
                <c:pt idx="352">
                  <c:v>0.43726554168994825</c:v>
                </c:pt>
                <c:pt idx="353">
                  <c:v>0.10677409591727273</c:v>
                </c:pt>
                <c:pt idx="354">
                  <c:v>0.21634696952710544</c:v>
                </c:pt>
                <c:pt idx="355">
                  <c:v>0.38848830646003818</c:v>
                </c:pt>
                <c:pt idx="356">
                  <c:v>5.8826388227351541E-2</c:v>
                </c:pt>
                <c:pt idx="357">
                  <c:v>0.30030082995538732</c:v>
                </c:pt>
                <c:pt idx="358">
                  <c:v>0.14746091240243359</c:v>
                </c:pt>
                <c:pt idx="359">
                  <c:v>0.56499375172957111</c:v>
                </c:pt>
                <c:pt idx="360">
                  <c:v>1.7967825460982807E-2</c:v>
                </c:pt>
                <c:pt idx="361">
                  <c:v>0.92773305276888895</c:v>
                </c:pt>
                <c:pt idx="362">
                  <c:v>1.1897144821949017</c:v>
                </c:pt>
                <c:pt idx="363">
                  <c:v>0.21834563463294918</c:v>
                </c:pt>
                <c:pt idx="364">
                  <c:v>0.4957398287049517</c:v>
                </c:pt>
                <c:pt idx="365">
                  <c:v>0.90680739284754719</c:v>
                </c:pt>
                <c:pt idx="366">
                  <c:v>1.1184027861021963</c:v>
                </c:pt>
                <c:pt idx="367">
                  <c:v>0.62106300316796104</c:v>
                </c:pt>
                <c:pt idx="368">
                  <c:v>0.20352572705032185</c:v>
                </c:pt>
                <c:pt idx="369">
                  <c:v>0.19998998620553102</c:v>
                </c:pt>
                <c:pt idx="370">
                  <c:v>1.0399246978647212</c:v>
                </c:pt>
                <c:pt idx="371">
                  <c:v>0.76586192069694414</c:v>
                </c:pt>
                <c:pt idx="372">
                  <c:v>2.0171466564641989</c:v>
                </c:pt>
                <c:pt idx="373">
                  <c:v>0.35516784851765038</c:v>
                </c:pt>
                <c:pt idx="374">
                  <c:v>0.92212483684233637</c:v>
                </c:pt>
                <c:pt idx="375">
                  <c:v>0.50024332543999994</c:v>
                </c:pt>
                <c:pt idx="376">
                  <c:v>0.17046355901480542</c:v>
                </c:pt>
                <c:pt idx="377">
                  <c:v>5.3789977291020245E-2</c:v>
                </c:pt>
                <c:pt idx="378">
                  <c:v>0.1626296011589313</c:v>
                </c:pt>
                <c:pt idx="379">
                  <c:v>0.17647694847108131</c:v>
                </c:pt>
                <c:pt idx="380">
                  <c:v>0.15650407438213432</c:v>
                </c:pt>
                <c:pt idx="381">
                  <c:v>0.5933424299135539</c:v>
                </c:pt>
                <c:pt idx="382">
                  <c:v>0.48163918066264888</c:v>
                </c:pt>
                <c:pt idx="383">
                  <c:v>0.30023157718430216</c:v>
                </c:pt>
                <c:pt idx="384">
                  <c:v>0.49853457476152041</c:v>
                </c:pt>
                <c:pt idx="385">
                  <c:v>1.0511396335868346</c:v>
                </c:pt>
                <c:pt idx="386">
                  <c:v>0.61084026949558579</c:v>
                </c:pt>
                <c:pt idx="387">
                  <c:v>0.66461201367770883</c:v>
                </c:pt>
                <c:pt idx="388">
                  <c:v>0.57460065898125579</c:v>
                </c:pt>
                <c:pt idx="389">
                  <c:v>0.67453505989204032</c:v>
                </c:pt>
                <c:pt idx="390">
                  <c:v>0.41474334832563753</c:v>
                </c:pt>
                <c:pt idx="391">
                  <c:v>0.22329590023789392</c:v>
                </c:pt>
                <c:pt idx="392">
                  <c:v>0.68789772334896926</c:v>
                </c:pt>
                <c:pt idx="393">
                  <c:v>0.30489954342892212</c:v>
                </c:pt>
                <c:pt idx="394">
                  <c:v>1.8110027856872907E-2</c:v>
                </c:pt>
                <c:pt idx="395">
                  <c:v>1.2267894947609082</c:v>
                </c:pt>
                <c:pt idx="396">
                  <c:v>0.18380925114982474</c:v>
                </c:pt>
                <c:pt idx="397">
                  <c:v>0.58694464412897029</c:v>
                </c:pt>
                <c:pt idx="398">
                  <c:v>0.76899939631514769</c:v>
                </c:pt>
                <c:pt idx="399">
                  <c:v>0.59606328491511962</c:v>
                </c:pt>
                <c:pt idx="400">
                  <c:v>0.55995294394553197</c:v>
                </c:pt>
                <c:pt idx="401">
                  <c:v>0.11032912433318953</c:v>
                </c:pt>
                <c:pt idx="402">
                  <c:v>5.727530299113133E-2</c:v>
                </c:pt>
                <c:pt idx="403">
                  <c:v>0.68650297248154013</c:v>
                </c:pt>
                <c:pt idx="404">
                  <c:v>0.12442055725516696</c:v>
                </c:pt>
                <c:pt idx="405">
                  <c:v>0.33893072762347193</c:v>
                </c:pt>
                <c:pt idx="406">
                  <c:v>3.3669170437437897E-2</c:v>
                </c:pt>
                <c:pt idx="407">
                  <c:v>0.13883049704867242</c:v>
                </c:pt>
                <c:pt idx="408">
                  <c:v>0.43315760025905869</c:v>
                </c:pt>
                <c:pt idx="409">
                  <c:v>0.2516784083056286</c:v>
                </c:pt>
                <c:pt idx="410">
                  <c:v>0.49069110689438289</c:v>
                </c:pt>
                <c:pt idx="411">
                  <c:v>0.10862124392845364</c:v>
                </c:pt>
                <c:pt idx="412">
                  <c:v>0.47866590554470689</c:v>
                </c:pt>
                <c:pt idx="413">
                  <c:v>1.1138531123224968</c:v>
                </c:pt>
                <c:pt idx="414">
                  <c:v>0.51304973107948781</c:v>
                </c:pt>
                <c:pt idx="415">
                  <c:v>0.12119124821737884</c:v>
                </c:pt>
                <c:pt idx="416">
                  <c:v>0.46396102831197039</c:v>
                </c:pt>
                <c:pt idx="417">
                  <c:v>2.3080500850359967E-2</c:v>
                </c:pt>
                <c:pt idx="418">
                  <c:v>0.47419856683196493</c:v>
                </c:pt>
                <c:pt idx="419">
                  <c:v>0.41171998669582616</c:v>
                </c:pt>
                <c:pt idx="420">
                  <c:v>0.47934347995967597</c:v>
                </c:pt>
                <c:pt idx="421">
                  <c:v>0.13731458440294983</c:v>
                </c:pt>
                <c:pt idx="422">
                  <c:v>0.88807615421867725</c:v>
                </c:pt>
                <c:pt idx="423">
                  <c:v>1.3749420181919159</c:v>
                </c:pt>
                <c:pt idx="424">
                  <c:v>1.5124711041805718</c:v>
                </c:pt>
                <c:pt idx="425">
                  <c:v>9.5955648214341271E-2</c:v>
                </c:pt>
                <c:pt idx="426">
                  <c:v>0.76493597211091369</c:v>
                </c:pt>
                <c:pt idx="427">
                  <c:v>1.465247354119559</c:v>
                </c:pt>
                <c:pt idx="428">
                  <c:v>0.88345875121719597</c:v>
                </c:pt>
                <c:pt idx="429">
                  <c:v>1.2782236751580229</c:v>
                </c:pt>
                <c:pt idx="430">
                  <c:v>7.434296396522834E-2</c:v>
                </c:pt>
                <c:pt idx="431">
                  <c:v>0.36750568806227313</c:v>
                </c:pt>
                <c:pt idx="432">
                  <c:v>9.6487576965757327E-2</c:v>
                </c:pt>
                <c:pt idx="433">
                  <c:v>6.182425515367438E-2</c:v>
                </c:pt>
                <c:pt idx="434">
                  <c:v>0.70318198125661147</c:v>
                </c:pt>
                <c:pt idx="435">
                  <c:v>1.0233392896194071</c:v>
                </c:pt>
                <c:pt idx="436">
                  <c:v>0.68678671201921604</c:v>
                </c:pt>
                <c:pt idx="437">
                  <c:v>0.18650443634386848</c:v>
                </c:pt>
                <c:pt idx="438">
                  <c:v>2.0404379467843948E-2</c:v>
                </c:pt>
                <c:pt idx="439">
                  <c:v>0.11534131779605233</c:v>
                </c:pt>
                <c:pt idx="440">
                  <c:v>0.29741130166196927</c:v>
                </c:pt>
                <c:pt idx="441">
                  <c:v>0.32067617767899609</c:v>
                </c:pt>
                <c:pt idx="442">
                  <c:v>0.72245790832282952</c:v>
                </c:pt>
                <c:pt idx="443">
                  <c:v>0.64103133688450153</c:v>
                </c:pt>
                <c:pt idx="444">
                  <c:v>2.7978807598361662E-3</c:v>
                </c:pt>
                <c:pt idx="445">
                  <c:v>0.51090691645776076</c:v>
                </c:pt>
                <c:pt idx="446">
                  <c:v>0.31086027968400287</c:v>
                </c:pt>
                <c:pt idx="447">
                  <c:v>0.47938367818196054</c:v>
                </c:pt>
                <c:pt idx="448">
                  <c:v>0.61757334737397618</c:v>
                </c:pt>
                <c:pt idx="449">
                  <c:v>6.266289283857282E-2</c:v>
                </c:pt>
                <c:pt idx="450">
                  <c:v>0.98181067198052541</c:v>
                </c:pt>
                <c:pt idx="451">
                  <c:v>0.10290358631059839</c:v>
                </c:pt>
                <c:pt idx="452">
                  <c:v>0.54001634844635249</c:v>
                </c:pt>
                <c:pt idx="453">
                  <c:v>3.6487354518471009E-2</c:v>
                </c:pt>
                <c:pt idx="454">
                  <c:v>2.8354591951021365E-3</c:v>
                </c:pt>
                <c:pt idx="455">
                  <c:v>2.172562306815359E-2</c:v>
                </c:pt>
                <c:pt idx="456">
                  <c:v>1.1222464182864586E-3</c:v>
                </c:pt>
                <c:pt idx="457">
                  <c:v>1.2764888047720693</c:v>
                </c:pt>
                <c:pt idx="458">
                  <c:v>5.9620817318170019E-4</c:v>
                </c:pt>
                <c:pt idx="459">
                  <c:v>0.3626566327999281</c:v>
                </c:pt>
                <c:pt idx="460">
                  <c:v>0.17092098459735858</c:v>
                </c:pt>
                <c:pt idx="461">
                  <c:v>5.6516244940186026E-2</c:v>
                </c:pt>
                <c:pt idx="462">
                  <c:v>0.51047627032294651</c:v>
                </c:pt>
                <c:pt idx="463">
                  <c:v>0.33715810837992088</c:v>
                </c:pt>
                <c:pt idx="464">
                  <c:v>0.44166289014208548</c:v>
                </c:pt>
                <c:pt idx="465">
                  <c:v>0.82071578862974914</c:v>
                </c:pt>
                <c:pt idx="466">
                  <c:v>0.76885348481224958</c:v>
                </c:pt>
                <c:pt idx="467">
                  <c:v>0.41779172404700499</c:v>
                </c:pt>
                <c:pt idx="468">
                  <c:v>0.9151670655333769</c:v>
                </c:pt>
                <c:pt idx="469">
                  <c:v>9.9067536894608177E-2</c:v>
                </c:pt>
                <c:pt idx="470">
                  <c:v>0.35443261737078668</c:v>
                </c:pt>
                <c:pt idx="471">
                  <c:v>1.532025018697357E-3</c:v>
                </c:pt>
                <c:pt idx="472">
                  <c:v>0.16174756073102192</c:v>
                </c:pt>
                <c:pt idx="473">
                  <c:v>4.2507839755542988E-2</c:v>
                </c:pt>
                <c:pt idx="474">
                  <c:v>0.52538928292345533</c:v>
                </c:pt>
                <c:pt idx="475">
                  <c:v>1.2022001926392387</c:v>
                </c:pt>
                <c:pt idx="476">
                  <c:v>1.148806000883978</c:v>
                </c:pt>
                <c:pt idx="477">
                  <c:v>1.3125962821674195</c:v>
                </c:pt>
                <c:pt idx="478">
                  <c:v>1.1093407704756759</c:v>
                </c:pt>
                <c:pt idx="479">
                  <c:v>0.11383922538578897</c:v>
                </c:pt>
                <c:pt idx="480">
                  <c:v>0.88420736600374716</c:v>
                </c:pt>
                <c:pt idx="481">
                  <c:v>0.31067530595263404</c:v>
                </c:pt>
                <c:pt idx="482">
                  <c:v>0.19969980853753488</c:v>
                </c:pt>
                <c:pt idx="483">
                  <c:v>0.56688834570637192</c:v>
                </c:pt>
                <c:pt idx="484">
                  <c:v>2.1280066322780528E-3</c:v>
                </c:pt>
                <c:pt idx="485">
                  <c:v>1.1517641725617931</c:v>
                </c:pt>
                <c:pt idx="486">
                  <c:v>0.56787796398544454</c:v>
                </c:pt>
                <c:pt idx="487">
                  <c:v>0.22072642919880492</c:v>
                </c:pt>
                <c:pt idx="488">
                  <c:v>5.7571042092060043E-2</c:v>
                </c:pt>
                <c:pt idx="489">
                  <c:v>0.90278992628110422</c:v>
                </c:pt>
                <c:pt idx="490">
                  <c:v>1.4919770309022908</c:v>
                </c:pt>
                <c:pt idx="491">
                  <c:v>3.7917313718366388E-2</c:v>
                </c:pt>
                <c:pt idx="492">
                  <c:v>0.63594084514980875</c:v>
                </c:pt>
                <c:pt idx="493">
                  <c:v>0.94254921161425342</c:v>
                </c:pt>
                <c:pt idx="494">
                  <c:v>0.25466047689747312</c:v>
                </c:pt>
                <c:pt idx="495">
                  <c:v>0.22567164189953826</c:v>
                </c:pt>
                <c:pt idx="496">
                  <c:v>2.5628404488084133E-2</c:v>
                </c:pt>
                <c:pt idx="497">
                  <c:v>0.93515803264246511</c:v>
                </c:pt>
                <c:pt idx="498">
                  <c:v>0.34250199122070601</c:v>
                </c:pt>
                <c:pt idx="499">
                  <c:v>8.5954731655360217E-3</c:v>
                </c:pt>
                <c:pt idx="500">
                  <c:v>0.29427517928451657</c:v>
                </c:pt>
                <c:pt idx="501">
                  <c:v>1.0920821199677295</c:v>
                </c:pt>
                <c:pt idx="502">
                  <c:v>2.1396437399150606E-2</c:v>
                </c:pt>
                <c:pt idx="503">
                  <c:v>0.18272471158825257</c:v>
                </c:pt>
                <c:pt idx="504">
                  <c:v>0.55757081519970908</c:v>
                </c:pt>
                <c:pt idx="505">
                  <c:v>0.31334905844180017</c:v>
                </c:pt>
                <c:pt idx="506">
                  <c:v>1.2574709884887347</c:v>
                </c:pt>
                <c:pt idx="507">
                  <c:v>0.65006255472875951</c:v>
                </c:pt>
                <c:pt idx="508">
                  <c:v>0.91095923166793358</c:v>
                </c:pt>
                <c:pt idx="509">
                  <c:v>0.34373593998514107</c:v>
                </c:pt>
                <c:pt idx="510">
                  <c:v>0.24038591934446107</c:v>
                </c:pt>
                <c:pt idx="511">
                  <c:v>0.18643792077649074</c:v>
                </c:pt>
                <c:pt idx="512">
                  <c:v>0.18970756508472641</c:v>
                </c:pt>
                <c:pt idx="513">
                  <c:v>0.39973600159812528</c:v>
                </c:pt>
                <c:pt idx="514">
                  <c:v>0.17983967681469756</c:v>
                </c:pt>
                <c:pt idx="515">
                  <c:v>0.16080087619692415</c:v>
                </c:pt>
                <c:pt idx="516">
                  <c:v>0.55851329994532617</c:v>
                </c:pt>
                <c:pt idx="517">
                  <c:v>7.3527277196910254E-2</c:v>
                </c:pt>
                <c:pt idx="518">
                  <c:v>1.3328302772747929</c:v>
                </c:pt>
                <c:pt idx="519">
                  <c:v>1.1042083882157177</c:v>
                </c:pt>
                <c:pt idx="520">
                  <c:v>0.32335073895323951</c:v>
                </c:pt>
                <c:pt idx="521">
                  <c:v>0.57519832267539983</c:v>
                </c:pt>
                <c:pt idx="522">
                  <c:v>0.49035461767583255</c:v>
                </c:pt>
                <c:pt idx="523">
                  <c:v>8.0314603235304829E-2</c:v>
                </c:pt>
                <c:pt idx="524">
                  <c:v>0.18378732034683018</c:v>
                </c:pt>
                <c:pt idx="525">
                  <c:v>0.4826476711302527</c:v>
                </c:pt>
                <c:pt idx="526">
                  <c:v>1.0657327462549178</c:v>
                </c:pt>
                <c:pt idx="527">
                  <c:v>0.54651339289634882</c:v>
                </c:pt>
                <c:pt idx="528">
                  <c:v>0.16587408381513735</c:v>
                </c:pt>
                <c:pt idx="529">
                  <c:v>1.3433605091593701</c:v>
                </c:pt>
                <c:pt idx="530">
                  <c:v>1.5465525692552555</c:v>
                </c:pt>
                <c:pt idx="531">
                  <c:v>0.32360677544297861</c:v>
                </c:pt>
                <c:pt idx="532">
                  <c:v>0.21204697702463551</c:v>
                </c:pt>
                <c:pt idx="533">
                  <c:v>1.1741112546693988</c:v>
                </c:pt>
                <c:pt idx="534">
                  <c:v>0.21134858830005451</c:v>
                </c:pt>
                <c:pt idx="535">
                  <c:v>1.2634381229389906</c:v>
                </c:pt>
                <c:pt idx="536">
                  <c:v>0.48052435075345123</c:v>
                </c:pt>
                <c:pt idx="537">
                  <c:v>0.39257357976487783</c:v>
                </c:pt>
                <c:pt idx="538">
                  <c:v>0.19829109252541383</c:v>
                </c:pt>
                <c:pt idx="539">
                  <c:v>0.1052587944702353</c:v>
                </c:pt>
                <c:pt idx="540">
                  <c:v>1.8462761681983233</c:v>
                </c:pt>
                <c:pt idx="541">
                  <c:v>0.36173131759647531</c:v>
                </c:pt>
                <c:pt idx="542">
                  <c:v>1.6558159426721475</c:v>
                </c:pt>
                <c:pt idx="543">
                  <c:v>0.44849415476449983</c:v>
                </c:pt>
                <c:pt idx="544">
                  <c:v>0.37639279137253534</c:v>
                </c:pt>
                <c:pt idx="545">
                  <c:v>1.1782439327249794</c:v>
                </c:pt>
                <c:pt idx="546">
                  <c:v>1.2804637282616833</c:v>
                </c:pt>
                <c:pt idx="547">
                  <c:v>9.8642034118636535E-2</c:v>
                </c:pt>
                <c:pt idx="548">
                  <c:v>0.82762897211154285</c:v>
                </c:pt>
                <c:pt idx="549">
                  <c:v>1.2784836232043635</c:v>
                </c:pt>
                <c:pt idx="550">
                  <c:v>0.18195346627396633</c:v>
                </c:pt>
                <c:pt idx="551">
                  <c:v>0.41649937705901308</c:v>
                </c:pt>
                <c:pt idx="552">
                  <c:v>5.6775302587294754E-2</c:v>
                </c:pt>
                <c:pt idx="553">
                  <c:v>0.76713721948781355</c:v>
                </c:pt>
                <c:pt idx="554">
                  <c:v>0.10829447412351299</c:v>
                </c:pt>
                <c:pt idx="555">
                  <c:v>0.74597863283924182</c:v>
                </c:pt>
                <c:pt idx="556">
                  <c:v>0.12118635503974907</c:v>
                </c:pt>
                <c:pt idx="557">
                  <c:v>0.4290345784581443</c:v>
                </c:pt>
                <c:pt idx="558">
                  <c:v>0.74932424010170939</c:v>
                </c:pt>
                <c:pt idx="559">
                  <c:v>0.83998083473059637</c:v>
                </c:pt>
                <c:pt idx="560">
                  <c:v>0.59162914623807328</c:v>
                </c:pt>
                <c:pt idx="561">
                  <c:v>0.20921883738910557</c:v>
                </c:pt>
                <c:pt idx="562">
                  <c:v>0.75156868363581308</c:v>
                </c:pt>
                <c:pt idx="563">
                  <c:v>0.82156927525241841</c:v>
                </c:pt>
                <c:pt idx="564">
                  <c:v>0.56448365977549897</c:v>
                </c:pt>
                <c:pt idx="565">
                  <c:v>0.16492287819246751</c:v>
                </c:pt>
                <c:pt idx="566">
                  <c:v>0.22468302211836672</c:v>
                </c:pt>
                <c:pt idx="567">
                  <c:v>1.2610570357342348</c:v>
                </c:pt>
                <c:pt idx="568">
                  <c:v>0.33268653371941675</c:v>
                </c:pt>
                <c:pt idx="569">
                  <c:v>0.54977708575096129</c:v>
                </c:pt>
                <c:pt idx="570">
                  <c:v>2.8244013273940688E-2</c:v>
                </c:pt>
                <c:pt idx="571">
                  <c:v>3.2314867609659889E-2</c:v>
                </c:pt>
                <c:pt idx="572">
                  <c:v>0.18501506753529764</c:v>
                </c:pt>
                <c:pt idx="573">
                  <c:v>4.8977439904113046E-2</c:v>
                </c:pt>
                <c:pt idx="574">
                  <c:v>0.70950231213722748</c:v>
                </c:pt>
                <c:pt idx="575">
                  <c:v>1.0521422281985699E-2</c:v>
                </c:pt>
                <c:pt idx="576">
                  <c:v>2.5455659166644069E-2</c:v>
                </c:pt>
                <c:pt idx="577">
                  <c:v>0.71794696096998578</c:v>
                </c:pt>
                <c:pt idx="578">
                  <c:v>0.80241045058382621</c:v>
                </c:pt>
                <c:pt idx="579">
                  <c:v>1.2284671396772258</c:v>
                </c:pt>
                <c:pt idx="580">
                  <c:v>0.7383911283596527</c:v>
                </c:pt>
                <c:pt idx="581">
                  <c:v>0.58564625835675466</c:v>
                </c:pt>
                <c:pt idx="582">
                  <c:v>0.68174060274419934</c:v>
                </c:pt>
                <c:pt idx="583">
                  <c:v>0.46050858905518804</c:v>
                </c:pt>
                <c:pt idx="584">
                  <c:v>0.9252677003160833</c:v>
                </c:pt>
                <c:pt idx="585">
                  <c:v>0.25370103879139017</c:v>
                </c:pt>
                <c:pt idx="586">
                  <c:v>1.1333163441058214</c:v>
                </c:pt>
                <c:pt idx="587">
                  <c:v>1.2648285254208878</c:v>
                </c:pt>
                <c:pt idx="588">
                  <c:v>0.52069803950863036</c:v>
                </c:pt>
                <c:pt idx="589">
                  <c:v>9.1338785971837588E-2</c:v>
                </c:pt>
                <c:pt idx="590">
                  <c:v>0.58521685044590599</c:v>
                </c:pt>
                <c:pt idx="591">
                  <c:v>0.34045144104527808</c:v>
                </c:pt>
                <c:pt idx="592">
                  <c:v>0.24303834081835235</c:v>
                </c:pt>
                <c:pt idx="593">
                  <c:v>0.49486112972732116</c:v>
                </c:pt>
                <c:pt idx="594">
                  <c:v>0.79065100873371841</c:v>
                </c:pt>
                <c:pt idx="595">
                  <c:v>1.4419620609484913</c:v>
                </c:pt>
                <c:pt idx="596">
                  <c:v>5.6533993238938741E-2</c:v>
                </c:pt>
                <c:pt idx="597">
                  <c:v>0.3277831399298437</c:v>
                </c:pt>
                <c:pt idx="598">
                  <c:v>0.82714741017504489</c:v>
                </c:pt>
                <c:pt idx="599">
                  <c:v>0.96702020684396706</c:v>
                </c:pt>
                <c:pt idx="600">
                  <c:v>0.86683856085811106</c:v>
                </c:pt>
                <c:pt idx="601">
                  <c:v>0.91183039281988432</c:v>
                </c:pt>
                <c:pt idx="602">
                  <c:v>1.1002294486395137</c:v>
                </c:pt>
                <c:pt idx="603">
                  <c:v>0.3822478538217241</c:v>
                </c:pt>
                <c:pt idx="604">
                  <c:v>0.92240144701969484</c:v>
                </c:pt>
                <c:pt idx="605">
                  <c:v>1.4316140583223855</c:v>
                </c:pt>
                <c:pt idx="606">
                  <c:v>0.13730069166136707</c:v>
                </c:pt>
                <c:pt idx="607">
                  <c:v>0.41945240169782078</c:v>
                </c:pt>
                <c:pt idx="608">
                  <c:v>0.60265622663820118</c:v>
                </c:pt>
                <c:pt idx="609">
                  <c:v>6.6345368663286219E-2</c:v>
                </c:pt>
                <c:pt idx="610">
                  <c:v>8.6985783736716005E-2</c:v>
                </c:pt>
                <c:pt idx="611">
                  <c:v>9.8589864450873196E-3</c:v>
                </c:pt>
                <c:pt idx="612">
                  <c:v>0.67530852067684077</c:v>
                </c:pt>
                <c:pt idx="613">
                  <c:v>0.98670683142414262</c:v>
                </c:pt>
                <c:pt idx="614">
                  <c:v>0.23259148513614297</c:v>
                </c:pt>
                <c:pt idx="615">
                  <c:v>0.84429429390451272</c:v>
                </c:pt>
                <c:pt idx="616">
                  <c:v>0.44770755181665428</c:v>
                </c:pt>
                <c:pt idx="617">
                  <c:v>1.2203581446049887</c:v>
                </c:pt>
                <c:pt idx="618">
                  <c:v>0.63037232522057285</c:v>
                </c:pt>
                <c:pt idx="619">
                  <c:v>0.74938925097965248</c:v>
                </c:pt>
                <c:pt idx="620">
                  <c:v>0.72420930758321289</c:v>
                </c:pt>
                <c:pt idx="621">
                  <c:v>0.11125913126391918</c:v>
                </c:pt>
                <c:pt idx="622">
                  <c:v>1.1244272048383159</c:v>
                </c:pt>
                <c:pt idx="623">
                  <c:v>0.84147068262648994</c:v>
                </c:pt>
                <c:pt idx="624">
                  <c:v>0.1413045584669633</c:v>
                </c:pt>
                <c:pt idx="625">
                  <c:v>0.27848567090211285</c:v>
                </c:pt>
                <c:pt idx="626">
                  <c:v>0.42825786264388566</c:v>
                </c:pt>
                <c:pt idx="627">
                  <c:v>0.59965562667988614</c:v>
                </c:pt>
                <c:pt idx="628">
                  <c:v>0.54164991240400273</c:v>
                </c:pt>
                <c:pt idx="629">
                  <c:v>0.52391411957600453</c:v>
                </c:pt>
                <c:pt idx="630">
                  <c:v>0.17898406518434734</c:v>
                </c:pt>
                <c:pt idx="631">
                  <c:v>1.8926472648981585</c:v>
                </c:pt>
                <c:pt idx="632">
                  <c:v>0.16227505244609855</c:v>
                </c:pt>
                <c:pt idx="633">
                  <c:v>0.58025356954962526</c:v>
                </c:pt>
                <c:pt idx="634">
                  <c:v>0.83896757352536833</c:v>
                </c:pt>
                <c:pt idx="635">
                  <c:v>0.21841800514257514</c:v>
                </c:pt>
                <c:pt idx="636">
                  <c:v>0.28161543668527517</c:v>
                </c:pt>
                <c:pt idx="637">
                  <c:v>0.15675968165724094</c:v>
                </c:pt>
                <c:pt idx="638">
                  <c:v>0.13526126944332287</c:v>
                </c:pt>
                <c:pt idx="639">
                  <c:v>1.0173061476164247</c:v>
                </c:pt>
                <c:pt idx="640">
                  <c:v>0.31841732358749397</c:v>
                </c:pt>
                <c:pt idx="641">
                  <c:v>1.1465105846695003</c:v>
                </c:pt>
                <c:pt idx="642">
                  <c:v>3.7640809262507978E-2</c:v>
                </c:pt>
                <c:pt idx="643">
                  <c:v>2.3097634783433074</c:v>
                </c:pt>
                <c:pt idx="644">
                  <c:v>0.1879503940806779</c:v>
                </c:pt>
                <c:pt idx="645">
                  <c:v>0.93140777983010214</c:v>
                </c:pt>
                <c:pt idx="646">
                  <c:v>0.19545547325820134</c:v>
                </c:pt>
                <c:pt idx="647">
                  <c:v>9.0836072210147653E-2</c:v>
                </c:pt>
                <c:pt idx="648">
                  <c:v>1.1327266332475647</c:v>
                </c:pt>
                <c:pt idx="649">
                  <c:v>0.47435222832852303</c:v>
                </c:pt>
                <c:pt idx="650">
                  <c:v>0.17991297263534864</c:v>
                </c:pt>
                <c:pt idx="651">
                  <c:v>0.76798950960260626</c:v>
                </c:pt>
                <c:pt idx="652">
                  <c:v>0.44383314347199065</c:v>
                </c:pt>
                <c:pt idx="653">
                  <c:v>0.34769607451351248</c:v>
                </c:pt>
                <c:pt idx="654">
                  <c:v>9.6947728794305563E-2</c:v>
                </c:pt>
                <c:pt idx="655">
                  <c:v>9.1386543616518559E-2</c:v>
                </c:pt>
                <c:pt idx="656">
                  <c:v>0.91553375180066443</c:v>
                </c:pt>
                <c:pt idx="657">
                  <c:v>0.15080639357397815</c:v>
                </c:pt>
                <c:pt idx="658">
                  <c:v>1.1055416434539633</c:v>
                </c:pt>
                <c:pt idx="659">
                  <c:v>0.97021705516285184</c:v>
                </c:pt>
                <c:pt idx="660">
                  <c:v>0.20781192858412864</c:v>
                </c:pt>
                <c:pt idx="661">
                  <c:v>1.259059003347099</c:v>
                </c:pt>
                <c:pt idx="662">
                  <c:v>8.9425310176322853E-2</c:v>
                </c:pt>
                <c:pt idx="663">
                  <c:v>0.62393606620869713</c:v>
                </c:pt>
                <c:pt idx="664">
                  <c:v>1.4037579709462189</c:v>
                </c:pt>
                <c:pt idx="665">
                  <c:v>8.3492973490332439E-2</c:v>
                </c:pt>
                <c:pt idx="666">
                  <c:v>7.3027327908817025E-2</c:v>
                </c:pt>
                <c:pt idx="667">
                  <c:v>0.19926007950148078</c:v>
                </c:pt>
                <c:pt idx="668">
                  <c:v>0.55129613738146155</c:v>
                </c:pt>
                <c:pt idx="669">
                  <c:v>0.54007789265541573</c:v>
                </c:pt>
                <c:pt idx="670">
                  <c:v>2.8834966424067732E-2</c:v>
                </c:pt>
                <c:pt idx="671">
                  <c:v>1.0174560214008628</c:v>
                </c:pt>
                <c:pt idx="672">
                  <c:v>0.3408486854487961</c:v>
                </c:pt>
                <c:pt idx="673">
                  <c:v>0.21057614629035115</c:v>
                </c:pt>
                <c:pt idx="674">
                  <c:v>0.78636500041894686</c:v>
                </c:pt>
                <c:pt idx="675">
                  <c:v>0.2204321465356211</c:v>
                </c:pt>
                <c:pt idx="676">
                  <c:v>0.86243785377852944</c:v>
                </c:pt>
                <c:pt idx="677">
                  <c:v>0.87787179917001845</c:v>
                </c:pt>
                <c:pt idx="678">
                  <c:v>0.12362077255663775</c:v>
                </c:pt>
                <c:pt idx="679">
                  <c:v>0.71265017309102152</c:v>
                </c:pt>
                <c:pt idx="680">
                  <c:v>2.2464290712336903E-2</c:v>
                </c:pt>
                <c:pt idx="681">
                  <c:v>5.6593668317912064E-2</c:v>
                </c:pt>
                <c:pt idx="682">
                  <c:v>0.44697448636715914</c:v>
                </c:pt>
                <c:pt idx="683">
                  <c:v>0.85400972903519345</c:v>
                </c:pt>
                <c:pt idx="684">
                  <c:v>1.2986295543280888</c:v>
                </c:pt>
                <c:pt idx="685">
                  <c:v>0.40774448873399383</c:v>
                </c:pt>
                <c:pt idx="686">
                  <c:v>0.50802537065831788</c:v>
                </c:pt>
                <c:pt idx="687">
                  <c:v>0.67872769134365152</c:v>
                </c:pt>
                <c:pt idx="688">
                  <c:v>0.30412606754770566</c:v>
                </c:pt>
                <c:pt idx="689">
                  <c:v>0.73623070211369301</c:v>
                </c:pt>
                <c:pt idx="690">
                  <c:v>0.44814774342296149</c:v>
                </c:pt>
                <c:pt idx="691">
                  <c:v>0.27717989242761887</c:v>
                </c:pt>
                <c:pt idx="692">
                  <c:v>0.16871833828178118</c:v>
                </c:pt>
                <c:pt idx="693">
                  <c:v>1.5938413358532428</c:v>
                </c:pt>
                <c:pt idx="694">
                  <c:v>0.93155449690875647</c:v>
                </c:pt>
                <c:pt idx="695">
                  <c:v>0.46927016006751654</c:v>
                </c:pt>
                <c:pt idx="696">
                  <c:v>0.72512801957591777</c:v>
                </c:pt>
                <c:pt idx="697">
                  <c:v>0.91243201492196457</c:v>
                </c:pt>
                <c:pt idx="698">
                  <c:v>5.4221546669023742E-2</c:v>
                </c:pt>
                <c:pt idx="699">
                  <c:v>1.2214127010637732</c:v>
                </c:pt>
                <c:pt idx="700">
                  <c:v>0.57895880925326959</c:v>
                </c:pt>
                <c:pt idx="701">
                  <c:v>0.34230975864666979</c:v>
                </c:pt>
                <c:pt idx="702">
                  <c:v>0.7146467665514159</c:v>
                </c:pt>
                <c:pt idx="703">
                  <c:v>1.0755783672755261</c:v>
                </c:pt>
                <c:pt idx="704">
                  <c:v>0.1633876030113865</c:v>
                </c:pt>
                <c:pt idx="705">
                  <c:v>8.7675739501572397E-2</c:v>
                </c:pt>
                <c:pt idx="706">
                  <c:v>1.8776302384906178E-2</c:v>
                </c:pt>
                <c:pt idx="707">
                  <c:v>3.5578346721643971E-2</c:v>
                </c:pt>
                <c:pt idx="708">
                  <c:v>1.1350429891227438</c:v>
                </c:pt>
                <c:pt idx="709">
                  <c:v>3.6337356948279859E-2</c:v>
                </c:pt>
                <c:pt idx="710">
                  <c:v>0.2877163287803709</c:v>
                </c:pt>
                <c:pt idx="711">
                  <c:v>0.74962889073680194</c:v>
                </c:pt>
                <c:pt idx="712">
                  <c:v>0.19955867257539961</c:v>
                </c:pt>
                <c:pt idx="713">
                  <c:v>2.3285728928701503E-2</c:v>
                </c:pt>
                <c:pt idx="714">
                  <c:v>0.85569458950781296</c:v>
                </c:pt>
                <c:pt idx="715">
                  <c:v>0.72921794927514294</c:v>
                </c:pt>
                <c:pt idx="716">
                  <c:v>0.63017847381822711</c:v>
                </c:pt>
                <c:pt idx="717">
                  <c:v>0.16907083828306627</c:v>
                </c:pt>
                <c:pt idx="718">
                  <c:v>0.89405194088408935</c:v>
                </c:pt>
                <c:pt idx="719">
                  <c:v>3.6950205854867607E-2</c:v>
                </c:pt>
                <c:pt idx="720">
                  <c:v>0.32337907142689698</c:v>
                </c:pt>
                <c:pt idx="721">
                  <c:v>0.14506705995813743</c:v>
                </c:pt>
                <c:pt idx="722">
                  <c:v>0.47190643976729985</c:v>
                </c:pt>
                <c:pt idx="723">
                  <c:v>0.62159814994558071</c:v>
                </c:pt>
                <c:pt idx="724">
                  <c:v>1.2490022916837313</c:v>
                </c:pt>
                <c:pt idx="725">
                  <c:v>0.82090050855087893</c:v>
                </c:pt>
                <c:pt idx="726">
                  <c:v>0.72901207870875295</c:v>
                </c:pt>
                <c:pt idx="727">
                  <c:v>0.30569390942724456</c:v>
                </c:pt>
                <c:pt idx="728">
                  <c:v>0.33597036491760673</c:v>
                </c:pt>
                <c:pt idx="729">
                  <c:v>0.20122701686867533</c:v>
                </c:pt>
                <c:pt idx="730">
                  <c:v>3.2484190286033286E-4</c:v>
                </c:pt>
                <c:pt idx="731">
                  <c:v>0.83121882291654803</c:v>
                </c:pt>
                <c:pt idx="732">
                  <c:v>0.64891733413293784</c:v>
                </c:pt>
                <c:pt idx="733">
                  <c:v>9.6888403283610744E-2</c:v>
                </c:pt>
                <c:pt idx="734">
                  <c:v>0.89530910460537105</c:v>
                </c:pt>
                <c:pt idx="735">
                  <c:v>0.74008991734868113</c:v>
                </c:pt>
                <c:pt idx="736">
                  <c:v>1.3802079432217422</c:v>
                </c:pt>
                <c:pt idx="737">
                  <c:v>0.35558501934849807</c:v>
                </c:pt>
                <c:pt idx="738">
                  <c:v>0.17747522295940382</c:v>
                </c:pt>
                <c:pt idx="739">
                  <c:v>3.8699820673879448E-2</c:v>
                </c:pt>
                <c:pt idx="740">
                  <c:v>0.23176153852965367</c:v>
                </c:pt>
                <c:pt idx="741">
                  <c:v>0.59624576865110046</c:v>
                </c:pt>
                <c:pt idx="742">
                  <c:v>0.99996885295926918</c:v>
                </c:pt>
                <c:pt idx="743">
                  <c:v>0.78103698410874045</c:v>
                </c:pt>
                <c:pt idx="744">
                  <c:v>0.24251630221628359</c:v>
                </c:pt>
                <c:pt idx="745">
                  <c:v>0.28637432184171774</c:v>
                </c:pt>
                <c:pt idx="746">
                  <c:v>0.30493760918270113</c:v>
                </c:pt>
                <c:pt idx="747">
                  <c:v>0.93487516781833269</c:v>
                </c:pt>
                <c:pt idx="748">
                  <c:v>0.11523647776124302</c:v>
                </c:pt>
                <c:pt idx="749">
                  <c:v>1.4868973385563022</c:v>
                </c:pt>
                <c:pt idx="750">
                  <c:v>1.3005037648752857</c:v>
                </c:pt>
                <c:pt idx="751">
                  <c:v>0.34616470038074426</c:v>
                </c:pt>
                <c:pt idx="752">
                  <c:v>0.99371555697338509</c:v>
                </c:pt>
                <c:pt idx="753">
                  <c:v>0.91513866119549458</c:v>
                </c:pt>
                <c:pt idx="754">
                  <c:v>8.168614996837481E-2</c:v>
                </c:pt>
                <c:pt idx="755">
                  <c:v>1.5451998673987057</c:v>
                </c:pt>
                <c:pt idx="756">
                  <c:v>0.15852346727708494</c:v>
                </c:pt>
                <c:pt idx="757">
                  <c:v>0.31751538192066042</c:v>
                </c:pt>
                <c:pt idx="758">
                  <c:v>0.32849233668675137</c:v>
                </c:pt>
                <c:pt idx="759">
                  <c:v>3.4154562324057829E-2</c:v>
                </c:pt>
                <c:pt idx="760">
                  <c:v>1.3656017102522981E-3</c:v>
                </c:pt>
                <c:pt idx="761">
                  <c:v>0.80340928302481673</c:v>
                </c:pt>
                <c:pt idx="762">
                  <c:v>0.77294351201990885</c:v>
                </c:pt>
                <c:pt idx="763">
                  <c:v>2.3246992847396567E-2</c:v>
                </c:pt>
                <c:pt idx="764">
                  <c:v>0.30063146240224337</c:v>
                </c:pt>
                <c:pt idx="765">
                  <c:v>0.37823586350787985</c:v>
                </c:pt>
                <c:pt idx="766">
                  <c:v>0.13876214697821113</c:v>
                </c:pt>
                <c:pt idx="767">
                  <c:v>0.98683542439780247</c:v>
                </c:pt>
                <c:pt idx="768">
                  <c:v>0.13757543198378522</c:v>
                </c:pt>
                <c:pt idx="769">
                  <c:v>0.37735640302515355</c:v>
                </c:pt>
                <c:pt idx="770">
                  <c:v>0.18373258537098719</c:v>
                </c:pt>
                <c:pt idx="771">
                  <c:v>6.9108180677615885E-2</c:v>
                </c:pt>
                <c:pt idx="772">
                  <c:v>4.0946972203460552E-2</c:v>
                </c:pt>
                <c:pt idx="773">
                  <c:v>8.6990305818534286E-2</c:v>
                </c:pt>
                <c:pt idx="774">
                  <c:v>0.41243284501266481</c:v>
                </c:pt>
                <c:pt idx="775">
                  <c:v>0.13028873529912308</c:v>
                </c:pt>
                <c:pt idx="776">
                  <c:v>0.31175233288243831</c:v>
                </c:pt>
                <c:pt idx="777">
                  <c:v>0.73998515330584047</c:v>
                </c:pt>
                <c:pt idx="778">
                  <c:v>8.4899232515587522E-2</c:v>
                </c:pt>
                <c:pt idx="779">
                  <c:v>8.9877428076609756E-2</c:v>
                </c:pt>
                <c:pt idx="780">
                  <c:v>3.2803765571912946E-2</c:v>
                </c:pt>
                <c:pt idx="781">
                  <c:v>0.15089175139105582</c:v>
                </c:pt>
                <c:pt idx="782">
                  <c:v>0.13632978000645848</c:v>
                </c:pt>
                <c:pt idx="783">
                  <c:v>1.106754088239819</c:v>
                </c:pt>
                <c:pt idx="784">
                  <c:v>7.9532481955251311E-2</c:v>
                </c:pt>
                <c:pt idx="785">
                  <c:v>0.44765218112133487</c:v>
                </c:pt>
                <c:pt idx="786">
                  <c:v>0.67273760491661128</c:v>
                </c:pt>
                <c:pt idx="787">
                  <c:v>0.25105060581281924</c:v>
                </c:pt>
                <c:pt idx="788">
                  <c:v>0.1955745643177707</c:v>
                </c:pt>
                <c:pt idx="789">
                  <c:v>0.53357496939619131</c:v>
                </c:pt>
                <c:pt idx="790">
                  <c:v>1.8288723955386953E-2</c:v>
                </c:pt>
                <c:pt idx="791">
                  <c:v>1.0392809267518115</c:v>
                </c:pt>
                <c:pt idx="792">
                  <c:v>0.26275173177325889</c:v>
                </c:pt>
                <c:pt idx="793">
                  <c:v>0.31738176074047547</c:v>
                </c:pt>
                <c:pt idx="794">
                  <c:v>4.3282260585962108E-2</c:v>
                </c:pt>
                <c:pt idx="795">
                  <c:v>1.2477379147671064</c:v>
                </c:pt>
                <c:pt idx="796">
                  <c:v>1.1456375615695435</c:v>
                </c:pt>
                <c:pt idx="797">
                  <c:v>0.35377153513636317</c:v>
                </c:pt>
                <c:pt idx="798">
                  <c:v>0.68534565866966324</c:v>
                </c:pt>
                <c:pt idx="799">
                  <c:v>7.0091300379161212E-2</c:v>
                </c:pt>
                <c:pt idx="800">
                  <c:v>0.18476359709629889</c:v>
                </c:pt>
                <c:pt idx="801">
                  <c:v>0.39823024956218694</c:v>
                </c:pt>
                <c:pt idx="802">
                  <c:v>1.1943447085606373</c:v>
                </c:pt>
                <c:pt idx="803">
                  <c:v>0.61302390485209557</c:v>
                </c:pt>
                <c:pt idx="804">
                  <c:v>0.21116726895607299</c:v>
                </c:pt>
                <c:pt idx="805">
                  <c:v>4.5765856849731341E-2</c:v>
                </c:pt>
                <c:pt idx="806">
                  <c:v>1.1442377092665927</c:v>
                </c:pt>
                <c:pt idx="807">
                  <c:v>0.69620319094708127</c:v>
                </c:pt>
                <c:pt idx="808">
                  <c:v>0.20257500359338398</c:v>
                </c:pt>
                <c:pt idx="809">
                  <c:v>0.21985206404332366</c:v>
                </c:pt>
                <c:pt idx="810">
                  <c:v>0.20408218011230195</c:v>
                </c:pt>
                <c:pt idx="811">
                  <c:v>0.92284130957726351</c:v>
                </c:pt>
                <c:pt idx="812">
                  <c:v>0.18918165973834275</c:v>
                </c:pt>
                <c:pt idx="813">
                  <c:v>0.81327008804355327</c:v>
                </c:pt>
                <c:pt idx="814">
                  <c:v>0.53982319985604366</c:v>
                </c:pt>
                <c:pt idx="815">
                  <c:v>0.64630589542242367</c:v>
                </c:pt>
                <c:pt idx="816">
                  <c:v>0.42386070616083055</c:v>
                </c:pt>
                <c:pt idx="817">
                  <c:v>0.46686925115223177</c:v>
                </c:pt>
                <c:pt idx="818">
                  <c:v>0.29393771669217456</c:v>
                </c:pt>
                <c:pt idx="819">
                  <c:v>6.5552288301394049E-2</c:v>
                </c:pt>
                <c:pt idx="820">
                  <c:v>0.23533235993763568</c:v>
                </c:pt>
                <c:pt idx="821">
                  <c:v>4.0042026287185513E-3</c:v>
                </c:pt>
                <c:pt idx="822">
                  <c:v>0.46770809097175231</c:v>
                </c:pt>
                <c:pt idx="823">
                  <c:v>4.2576099179716921E-2</c:v>
                </c:pt>
                <c:pt idx="824">
                  <c:v>0.71976470620255528</c:v>
                </c:pt>
                <c:pt idx="825">
                  <c:v>0.18087285708900946</c:v>
                </c:pt>
                <c:pt idx="826">
                  <c:v>0.95178438551724576</c:v>
                </c:pt>
                <c:pt idx="827">
                  <c:v>0.19192699576134253</c:v>
                </c:pt>
                <c:pt idx="828">
                  <c:v>1.7653343998243434E-2</c:v>
                </c:pt>
                <c:pt idx="829">
                  <c:v>1.2427196225644774</c:v>
                </c:pt>
                <c:pt idx="830">
                  <c:v>1.1445582323493275</c:v>
                </c:pt>
                <c:pt idx="831">
                  <c:v>0.68003966383863701</c:v>
                </c:pt>
                <c:pt idx="832">
                  <c:v>0.50409209974998193</c:v>
                </c:pt>
                <c:pt idx="833">
                  <c:v>0.20566384951783132</c:v>
                </c:pt>
                <c:pt idx="834">
                  <c:v>0.46745089834936282</c:v>
                </c:pt>
                <c:pt idx="835">
                  <c:v>9.8353133793561073E-2</c:v>
                </c:pt>
                <c:pt idx="836">
                  <c:v>2.5892444637327879E-2</c:v>
                </c:pt>
                <c:pt idx="837">
                  <c:v>0.94050501259231545</c:v>
                </c:pt>
                <c:pt idx="838">
                  <c:v>8.0274011603600676E-2</c:v>
                </c:pt>
                <c:pt idx="839">
                  <c:v>0.68363227312827946</c:v>
                </c:pt>
                <c:pt idx="840">
                  <c:v>0.63734693958929456</c:v>
                </c:pt>
                <c:pt idx="841">
                  <c:v>1.1096953717255371</c:v>
                </c:pt>
                <c:pt idx="842">
                  <c:v>0.71354284498727449</c:v>
                </c:pt>
                <c:pt idx="843">
                  <c:v>1.226715728187499</c:v>
                </c:pt>
                <c:pt idx="844">
                  <c:v>1.0707394784464306</c:v>
                </c:pt>
                <c:pt idx="845">
                  <c:v>1.2863638096869198E-4</c:v>
                </c:pt>
                <c:pt idx="846">
                  <c:v>0.55046008567750648</c:v>
                </c:pt>
                <c:pt idx="847">
                  <c:v>0.61010668957570435</c:v>
                </c:pt>
                <c:pt idx="848">
                  <c:v>0.81535820582573504</c:v>
                </c:pt>
                <c:pt idx="849">
                  <c:v>0.83024962461556473</c:v>
                </c:pt>
                <c:pt idx="850">
                  <c:v>0.97353377626491255</c:v>
                </c:pt>
                <c:pt idx="851">
                  <c:v>0.32596159644318201</c:v>
                </c:pt>
                <c:pt idx="852">
                  <c:v>0.72853388744453651</c:v>
                </c:pt>
                <c:pt idx="853">
                  <c:v>0.5838919291689697</c:v>
                </c:pt>
                <c:pt idx="854">
                  <c:v>0.24005934463328094</c:v>
                </c:pt>
                <c:pt idx="855">
                  <c:v>0.30352257993082982</c:v>
                </c:pt>
                <c:pt idx="856">
                  <c:v>0.95329076075441255</c:v>
                </c:pt>
                <c:pt idx="857">
                  <c:v>0.9060726578328625</c:v>
                </c:pt>
                <c:pt idx="858">
                  <c:v>0.81302036341957717</c:v>
                </c:pt>
                <c:pt idx="859">
                  <c:v>0.13663647769980314</c:v>
                </c:pt>
                <c:pt idx="860">
                  <c:v>0.21327192809680653</c:v>
                </c:pt>
                <c:pt idx="861">
                  <c:v>5.7925156411849546E-2</c:v>
                </c:pt>
                <c:pt idx="862">
                  <c:v>0.77877800095282268</c:v>
                </c:pt>
                <c:pt idx="863">
                  <c:v>0.64521629234699107</c:v>
                </c:pt>
                <c:pt idx="864">
                  <c:v>5.5245281967704084E-2</c:v>
                </c:pt>
                <c:pt idx="865">
                  <c:v>0.22043376414764065</c:v>
                </c:pt>
                <c:pt idx="866">
                  <c:v>0.97522842417622158</c:v>
                </c:pt>
                <c:pt idx="867">
                  <c:v>7.6059146355040547E-2</c:v>
                </c:pt>
                <c:pt idx="868">
                  <c:v>0.26513612349045862</c:v>
                </c:pt>
                <c:pt idx="869">
                  <c:v>1.1475646661171657</c:v>
                </c:pt>
                <c:pt idx="870">
                  <c:v>0.31511166491256309</c:v>
                </c:pt>
                <c:pt idx="871">
                  <c:v>0.5597489397039207</c:v>
                </c:pt>
                <c:pt idx="872">
                  <c:v>1.0930157714204289</c:v>
                </c:pt>
                <c:pt idx="873">
                  <c:v>0.38059810159696777</c:v>
                </c:pt>
                <c:pt idx="874">
                  <c:v>0.59950206856957977</c:v>
                </c:pt>
                <c:pt idx="875">
                  <c:v>1.24028869453888</c:v>
                </c:pt>
                <c:pt idx="876">
                  <c:v>0.66014262302856619</c:v>
                </c:pt>
                <c:pt idx="877">
                  <c:v>0.80663162684742684</c:v>
                </c:pt>
                <c:pt idx="878">
                  <c:v>1.0961602207104768</c:v>
                </c:pt>
                <c:pt idx="879">
                  <c:v>0.63128532082690825</c:v>
                </c:pt>
                <c:pt idx="880">
                  <c:v>0.73142134009256266</c:v>
                </c:pt>
                <c:pt idx="881">
                  <c:v>1.1949494333137798</c:v>
                </c:pt>
                <c:pt idx="882">
                  <c:v>0.20301155154777706</c:v>
                </c:pt>
                <c:pt idx="883">
                  <c:v>7.1428389849070059E-2</c:v>
                </c:pt>
                <c:pt idx="884">
                  <c:v>8.0541664395529899E-2</c:v>
                </c:pt>
                <c:pt idx="885">
                  <c:v>0.92260885480248545</c:v>
                </c:pt>
                <c:pt idx="886">
                  <c:v>0.86892866587135642</c:v>
                </c:pt>
                <c:pt idx="887">
                  <c:v>1.3283796671927945</c:v>
                </c:pt>
                <c:pt idx="888">
                  <c:v>1.8364349065892609</c:v>
                </c:pt>
                <c:pt idx="889">
                  <c:v>0.46332222707325799</c:v>
                </c:pt>
                <c:pt idx="890">
                  <c:v>1.4738686418110369</c:v>
                </c:pt>
                <c:pt idx="891">
                  <c:v>0.32346307843230088</c:v>
                </c:pt>
                <c:pt idx="892">
                  <c:v>8.1158465784396221E-3</c:v>
                </c:pt>
                <c:pt idx="893">
                  <c:v>0.23350207093466543</c:v>
                </c:pt>
                <c:pt idx="894">
                  <c:v>6.385010190380383E-2</c:v>
                </c:pt>
                <c:pt idx="895">
                  <c:v>0.1055783121301843</c:v>
                </c:pt>
                <c:pt idx="896">
                  <c:v>0.12093326859540879</c:v>
                </c:pt>
                <c:pt idx="897">
                  <c:v>0.63896098347984087</c:v>
                </c:pt>
                <c:pt idx="898">
                  <c:v>1.0340107613643428</c:v>
                </c:pt>
                <c:pt idx="899">
                  <c:v>0.18404472135445671</c:v>
                </c:pt>
                <c:pt idx="900">
                  <c:v>0.16845051087601162</c:v>
                </c:pt>
                <c:pt idx="901">
                  <c:v>8.2819987632498246E-2</c:v>
                </c:pt>
                <c:pt idx="902">
                  <c:v>7.5817941480004716E-2</c:v>
                </c:pt>
                <c:pt idx="903">
                  <c:v>0.23908561454744784</c:v>
                </c:pt>
                <c:pt idx="904">
                  <c:v>9.1892623045740571E-3</c:v>
                </c:pt>
                <c:pt idx="905">
                  <c:v>0.80337173058532074</c:v>
                </c:pt>
                <c:pt idx="906">
                  <c:v>0.43000118740386506</c:v>
                </c:pt>
                <c:pt idx="907">
                  <c:v>0.15668440635645098</c:v>
                </c:pt>
                <c:pt idx="908">
                  <c:v>0.1354378594038543</c:v>
                </c:pt>
                <c:pt idx="909">
                  <c:v>0.33761991424204846</c:v>
                </c:pt>
                <c:pt idx="910">
                  <c:v>0.83973592588935442</c:v>
                </c:pt>
                <c:pt idx="911">
                  <c:v>6.4025039405917555E-2</c:v>
                </c:pt>
                <c:pt idx="912">
                  <c:v>0.13669180587793253</c:v>
                </c:pt>
                <c:pt idx="913">
                  <c:v>2.2992596053632863</c:v>
                </c:pt>
                <c:pt idx="914">
                  <c:v>0.47984697183669944</c:v>
                </c:pt>
                <c:pt idx="915">
                  <c:v>0.26184553238017433</c:v>
                </c:pt>
                <c:pt idx="916">
                  <c:v>0.50552665218039128</c:v>
                </c:pt>
                <c:pt idx="917">
                  <c:v>0.8443067166632493</c:v>
                </c:pt>
                <c:pt idx="918">
                  <c:v>0.20250806285118764</c:v>
                </c:pt>
                <c:pt idx="919">
                  <c:v>0.33190164394726307</c:v>
                </c:pt>
                <c:pt idx="920">
                  <c:v>0.16281597303108519</c:v>
                </c:pt>
                <c:pt idx="921">
                  <c:v>0.10865035531305513</c:v>
                </c:pt>
                <c:pt idx="922">
                  <c:v>0.19710469604604694</c:v>
                </c:pt>
                <c:pt idx="923">
                  <c:v>1.181113082538181</c:v>
                </c:pt>
                <c:pt idx="924">
                  <c:v>1.5205661607865399</c:v>
                </c:pt>
                <c:pt idx="925">
                  <c:v>0.19625568992677064</c:v>
                </c:pt>
                <c:pt idx="926">
                  <c:v>0.92761367459659305</c:v>
                </c:pt>
                <c:pt idx="927">
                  <c:v>0.30020915331337672</c:v>
                </c:pt>
                <c:pt idx="928">
                  <c:v>0.37146488960032015</c:v>
                </c:pt>
                <c:pt idx="929">
                  <c:v>9.4472902530472858E-2</c:v>
                </c:pt>
                <c:pt idx="930">
                  <c:v>0.11382175924929756</c:v>
                </c:pt>
                <c:pt idx="931">
                  <c:v>0.39116112626675503</c:v>
                </c:pt>
                <c:pt idx="932">
                  <c:v>0.11044768556603239</c:v>
                </c:pt>
                <c:pt idx="933">
                  <c:v>1.1322912264694702</c:v>
                </c:pt>
                <c:pt idx="934">
                  <c:v>0.31984382622510554</c:v>
                </c:pt>
                <c:pt idx="935">
                  <c:v>1.1193673179831698</c:v>
                </c:pt>
                <c:pt idx="936">
                  <c:v>0.21373366992245799</c:v>
                </c:pt>
                <c:pt idx="937">
                  <c:v>2.7840796703646484E-3</c:v>
                </c:pt>
                <c:pt idx="938">
                  <c:v>5.5273395514254413E-2</c:v>
                </c:pt>
                <c:pt idx="939">
                  <c:v>1.0863324224667634</c:v>
                </c:pt>
                <c:pt idx="940">
                  <c:v>0.30485913071091375</c:v>
                </c:pt>
                <c:pt idx="941">
                  <c:v>1.2227775999140766</c:v>
                </c:pt>
                <c:pt idx="942">
                  <c:v>0.41634010866428778</c:v>
                </c:pt>
                <c:pt idx="943">
                  <c:v>1.3375793793866018E-2</c:v>
                </c:pt>
                <c:pt idx="944">
                  <c:v>1.3909000729104559E-3</c:v>
                </c:pt>
                <c:pt idx="945">
                  <c:v>0.34182792611826207</c:v>
                </c:pt>
                <c:pt idx="946">
                  <c:v>0.1431710397645703</c:v>
                </c:pt>
                <c:pt idx="947">
                  <c:v>0.71150102006121207</c:v>
                </c:pt>
                <c:pt idx="948">
                  <c:v>1.3258149915443946</c:v>
                </c:pt>
                <c:pt idx="949">
                  <c:v>0.13022585179177582</c:v>
                </c:pt>
                <c:pt idx="950">
                  <c:v>1.2655153496892952</c:v>
                </c:pt>
                <c:pt idx="951">
                  <c:v>1.263175562620257</c:v>
                </c:pt>
                <c:pt idx="952">
                  <c:v>0.91980362634153268</c:v>
                </c:pt>
                <c:pt idx="953">
                  <c:v>1.1032571778222546</c:v>
                </c:pt>
                <c:pt idx="954">
                  <c:v>1.3707086767810426</c:v>
                </c:pt>
                <c:pt idx="955">
                  <c:v>1.1858501060599409</c:v>
                </c:pt>
                <c:pt idx="956">
                  <c:v>0.44775459067049356</c:v>
                </c:pt>
                <c:pt idx="957">
                  <c:v>0.49138029753102636</c:v>
                </c:pt>
                <c:pt idx="958">
                  <c:v>0.45658163034942506</c:v>
                </c:pt>
                <c:pt idx="959">
                  <c:v>1.0984622874909589</c:v>
                </c:pt>
                <c:pt idx="960">
                  <c:v>3.9564729861955569E-2</c:v>
                </c:pt>
                <c:pt idx="961">
                  <c:v>0.61562146202417278</c:v>
                </c:pt>
                <c:pt idx="962">
                  <c:v>0.92984716755978292</c:v>
                </c:pt>
                <c:pt idx="963">
                  <c:v>0.63732474784589588</c:v>
                </c:pt>
                <c:pt idx="964">
                  <c:v>0.81733267770375462</c:v>
                </c:pt>
                <c:pt idx="965">
                  <c:v>0.54999786170233389</c:v>
                </c:pt>
                <c:pt idx="966">
                  <c:v>0.19787041477917347</c:v>
                </c:pt>
                <c:pt idx="967">
                  <c:v>0.30237961568488819</c:v>
                </c:pt>
                <c:pt idx="968">
                  <c:v>0.79314654660359085</c:v>
                </c:pt>
                <c:pt idx="969">
                  <c:v>0.35262223552838878</c:v>
                </c:pt>
                <c:pt idx="970">
                  <c:v>0.22188421483788673</c:v>
                </c:pt>
                <c:pt idx="971">
                  <c:v>6.2872000683159425E-4</c:v>
                </c:pt>
                <c:pt idx="972">
                  <c:v>0.42754249259554111</c:v>
                </c:pt>
                <c:pt idx="973">
                  <c:v>0.1443374686625232</c:v>
                </c:pt>
                <c:pt idx="974">
                  <c:v>0.5023869895265678</c:v>
                </c:pt>
                <c:pt idx="975">
                  <c:v>0.34776338979414517</c:v>
                </c:pt>
                <c:pt idx="976">
                  <c:v>9.9528810141719229E-2</c:v>
                </c:pt>
                <c:pt idx="977">
                  <c:v>0.68598976053966165</c:v>
                </c:pt>
                <c:pt idx="978">
                  <c:v>1.2697476478797807</c:v>
                </c:pt>
                <c:pt idx="979">
                  <c:v>6.9885949880561571E-2</c:v>
                </c:pt>
                <c:pt idx="980">
                  <c:v>7.9993932914330185E-2</c:v>
                </c:pt>
                <c:pt idx="981">
                  <c:v>0.61760522438030185</c:v>
                </c:pt>
                <c:pt idx="982">
                  <c:v>5.067731660340289E-2</c:v>
                </c:pt>
                <c:pt idx="983">
                  <c:v>0.1691201780115881</c:v>
                </c:pt>
                <c:pt idx="984">
                  <c:v>1.3360190489699419</c:v>
                </c:pt>
                <c:pt idx="985">
                  <c:v>0.11413418282752899</c:v>
                </c:pt>
                <c:pt idx="986">
                  <c:v>0.39043266662800263</c:v>
                </c:pt>
                <c:pt idx="987">
                  <c:v>0.81852912201744243</c:v>
                </c:pt>
                <c:pt idx="988">
                  <c:v>1.2482410168163991</c:v>
                </c:pt>
                <c:pt idx="989">
                  <c:v>0.60012596027526488</c:v>
                </c:pt>
                <c:pt idx="990">
                  <c:v>0.11226225375849122</c:v>
                </c:pt>
                <c:pt idx="991">
                  <c:v>0.55584313651499839</c:v>
                </c:pt>
                <c:pt idx="992">
                  <c:v>7.6799509808882269E-2</c:v>
                </c:pt>
                <c:pt idx="993">
                  <c:v>0.18943135285419344</c:v>
                </c:pt>
                <c:pt idx="994">
                  <c:v>1.6016022558590532</c:v>
                </c:pt>
                <c:pt idx="995">
                  <c:v>0.61325219952712995</c:v>
                </c:pt>
                <c:pt idx="996">
                  <c:v>0.37593874536269295</c:v>
                </c:pt>
                <c:pt idx="997">
                  <c:v>0.88955751112854786</c:v>
                </c:pt>
                <c:pt idx="998">
                  <c:v>1.1494129061850626</c:v>
                </c:pt>
                <c:pt idx="999">
                  <c:v>0.19191941853439601</c:v>
                </c:pt>
                <c:pt idx="1000">
                  <c:v>0.11944688524542828</c:v>
                </c:pt>
                <c:pt idx="1001">
                  <c:v>2.4493347919037449E-2</c:v>
                </c:pt>
                <c:pt idx="1002">
                  <c:v>0.61477126088858758</c:v>
                </c:pt>
                <c:pt idx="1003">
                  <c:v>4.2991765933572311E-2</c:v>
                </c:pt>
                <c:pt idx="1004">
                  <c:v>0.38402851075701322</c:v>
                </c:pt>
                <c:pt idx="1005">
                  <c:v>0.69862299466309019</c:v>
                </c:pt>
                <c:pt idx="1006">
                  <c:v>0.41466063877154657</c:v>
                </c:pt>
                <c:pt idx="1007">
                  <c:v>0.10179004794504468</c:v>
                </c:pt>
                <c:pt idx="1008">
                  <c:v>7.6979679495157438E-2</c:v>
                </c:pt>
                <c:pt idx="1009">
                  <c:v>0.54716463485357225</c:v>
                </c:pt>
                <c:pt idx="1010">
                  <c:v>0.12179152489889181</c:v>
                </c:pt>
                <c:pt idx="1011">
                  <c:v>0.17536231073485947</c:v>
                </c:pt>
                <c:pt idx="1012">
                  <c:v>0.16338860166886462</c:v>
                </c:pt>
                <c:pt idx="1013">
                  <c:v>0.44994856900624952</c:v>
                </c:pt>
                <c:pt idx="1014">
                  <c:v>0.15409260318329018</c:v>
                </c:pt>
                <c:pt idx="1015">
                  <c:v>0.32797745910722803</c:v>
                </c:pt>
                <c:pt idx="1016">
                  <c:v>0.40686486454441118</c:v>
                </c:pt>
                <c:pt idx="1017">
                  <c:v>0.57730534311280646</c:v>
                </c:pt>
                <c:pt idx="1018">
                  <c:v>0.22991779901802986</c:v>
                </c:pt>
                <c:pt idx="1019">
                  <c:v>0.12769861128912305</c:v>
                </c:pt>
                <c:pt idx="1020">
                  <c:v>0.15013823481332667</c:v>
                </c:pt>
                <c:pt idx="1021">
                  <c:v>0.2653910774484719</c:v>
                </c:pt>
                <c:pt idx="1022">
                  <c:v>0.2440443942024742</c:v>
                </c:pt>
                <c:pt idx="1023">
                  <c:v>9.6916428425307177E-2</c:v>
                </c:pt>
                <c:pt idx="1024">
                  <c:v>1.1283640528374286</c:v>
                </c:pt>
                <c:pt idx="1025">
                  <c:v>1.4469911036308949</c:v>
                </c:pt>
                <c:pt idx="1026">
                  <c:v>1.9091374370209687E-2</c:v>
                </c:pt>
                <c:pt idx="1027">
                  <c:v>1.1038176435730331</c:v>
                </c:pt>
                <c:pt idx="1028">
                  <c:v>4.5206458102297854E-3</c:v>
                </c:pt>
                <c:pt idx="1029">
                  <c:v>0.13047154533257843</c:v>
                </c:pt>
                <c:pt idx="1030">
                  <c:v>0.26497122004406126</c:v>
                </c:pt>
                <c:pt idx="1031">
                  <c:v>0.11645456762828742</c:v>
                </c:pt>
                <c:pt idx="1032">
                  <c:v>3.7506771400162064E-2</c:v>
                </c:pt>
                <c:pt idx="1033">
                  <c:v>0.22048821832668872</c:v>
                </c:pt>
                <c:pt idx="1034">
                  <c:v>0.49761722912229711</c:v>
                </c:pt>
                <c:pt idx="1035">
                  <c:v>1.2479209798025421</c:v>
                </c:pt>
                <c:pt idx="1036">
                  <c:v>0.38499612868446231</c:v>
                </c:pt>
                <c:pt idx="1037">
                  <c:v>0.83592812938932404</c:v>
                </c:pt>
                <c:pt idx="1038">
                  <c:v>4.5125368271651353E-2</c:v>
                </c:pt>
                <c:pt idx="1039">
                  <c:v>0.13430716010680852</c:v>
                </c:pt>
                <c:pt idx="1040">
                  <c:v>0.70127079540466442</c:v>
                </c:pt>
                <c:pt idx="1041">
                  <c:v>1.4984674318966648E-2</c:v>
                </c:pt>
                <c:pt idx="1042">
                  <c:v>0.14457583355708239</c:v>
                </c:pt>
                <c:pt idx="1043">
                  <c:v>0.97938324171290425</c:v>
                </c:pt>
                <c:pt idx="1044">
                  <c:v>1.1643441272788735</c:v>
                </c:pt>
                <c:pt idx="1045">
                  <c:v>0.92644112224270092</c:v>
                </c:pt>
                <c:pt idx="1046">
                  <c:v>0.68939788022474757</c:v>
                </c:pt>
                <c:pt idx="1047">
                  <c:v>2.9500481284191894E-2</c:v>
                </c:pt>
                <c:pt idx="1048">
                  <c:v>0.12482204999629061</c:v>
                </c:pt>
                <c:pt idx="1049">
                  <c:v>0.57889064518470668</c:v>
                </c:pt>
                <c:pt idx="1050">
                  <c:v>1.0940532764300177</c:v>
                </c:pt>
                <c:pt idx="1051">
                  <c:v>0.26402031398491171</c:v>
                </c:pt>
                <c:pt idx="1052">
                  <c:v>1.2103673687133307</c:v>
                </c:pt>
                <c:pt idx="1053">
                  <c:v>0.15184489246753827</c:v>
                </c:pt>
                <c:pt idx="1054">
                  <c:v>0.36090570559294627</c:v>
                </c:pt>
                <c:pt idx="1055">
                  <c:v>0.61910702629903991</c:v>
                </c:pt>
                <c:pt idx="1056">
                  <c:v>0.4159470352389143</c:v>
                </c:pt>
                <c:pt idx="1057">
                  <c:v>0.36267060035116971</c:v>
                </c:pt>
                <c:pt idx="1058">
                  <c:v>4.873369680533831E-2</c:v>
                </c:pt>
                <c:pt idx="1059">
                  <c:v>0.19122127831274804</c:v>
                </c:pt>
                <c:pt idx="1060">
                  <c:v>7.2092549628395147E-2</c:v>
                </c:pt>
                <c:pt idx="1061">
                  <c:v>1.6029648067522175</c:v>
                </c:pt>
                <c:pt idx="1062">
                  <c:v>0.73959431628680761</c:v>
                </c:pt>
                <c:pt idx="1063">
                  <c:v>1.3319534185830635</c:v>
                </c:pt>
                <c:pt idx="1064">
                  <c:v>0.12464145131698071</c:v>
                </c:pt>
                <c:pt idx="1065">
                  <c:v>0.10317156873579549</c:v>
                </c:pt>
                <c:pt idx="1066">
                  <c:v>0.1374762407892525</c:v>
                </c:pt>
                <c:pt idx="1067">
                  <c:v>2.2805560732753305E-2</c:v>
                </c:pt>
                <c:pt idx="1068">
                  <c:v>1.662953758633902</c:v>
                </c:pt>
                <c:pt idx="1069">
                  <c:v>2.0214732828370665</c:v>
                </c:pt>
                <c:pt idx="1070">
                  <c:v>0.17693837616876049</c:v>
                </c:pt>
                <c:pt idx="1071">
                  <c:v>0.74894807584123724</c:v>
                </c:pt>
                <c:pt idx="1072">
                  <c:v>0.49905108809816157</c:v>
                </c:pt>
                <c:pt idx="1073">
                  <c:v>1.2666866069550584</c:v>
                </c:pt>
                <c:pt idx="1074">
                  <c:v>0.52667350063303231</c:v>
                </c:pt>
                <c:pt idx="1075">
                  <c:v>0.87257256228053648</c:v>
                </c:pt>
                <c:pt idx="1076">
                  <c:v>0.34136121601161762</c:v>
                </c:pt>
                <c:pt idx="1077">
                  <c:v>0.34167700044181987</c:v>
                </c:pt>
                <c:pt idx="1078">
                  <c:v>0.4618503753457619</c:v>
                </c:pt>
                <c:pt idx="1079">
                  <c:v>0.88001708841837656</c:v>
                </c:pt>
                <c:pt idx="1080">
                  <c:v>3.9454792408231625E-2</c:v>
                </c:pt>
                <c:pt idx="1081">
                  <c:v>1.9261733974884674</c:v>
                </c:pt>
                <c:pt idx="1082">
                  <c:v>0.17394938748634295</c:v>
                </c:pt>
                <c:pt idx="1083">
                  <c:v>9.7675375258496816E-2</c:v>
                </c:pt>
                <c:pt idx="1084">
                  <c:v>0.15667376058953811</c:v>
                </c:pt>
                <c:pt idx="1085">
                  <c:v>1.0172284453769269</c:v>
                </c:pt>
                <c:pt idx="1086">
                  <c:v>0.41086326388654582</c:v>
                </c:pt>
                <c:pt idx="1087">
                  <c:v>8.325121024200989E-2</c:v>
                </c:pt>
                <c:pt idx="1088">
                  <c:v>0.14592998719182759</c:v>
                </c:pt>
                <c:pt idx="1089">
                  <c:v>8.025886280022923E-2</c:v>
                </c:pt>
                <c:pt idx="1090">
                  <c:v>1.0573116389899959</c:v>
                </c:pt>
                <c:pt idx="1091">
                  <c:v>0.42381859279972189</c:v>
                </c:pt>
                <c:pt idx="1092">
                  <c:v>0.43093487327489255</c:v>
                </c:pt>
                <c:pt idx="1093">
                  <c:v>0.27501849862104483</c:v>
                </c:pt>
                <c:pt idx="1094">
                  <c:v>0.89527500100035717</c:v>
                </c:pt>
                <c:pt idx="1095">
                  <c:v>2.7286877823707503E-2</c:v>
                </c:pt>
                <c:pt idx="1096">
                  <c:v>0.51251753751896345</c:v>
                </c:pt>
                <c:pt idx="1097">
                  <c:v>1.1020633964370525</c:v>
                </c:pt>
                <c:pt idx="1098">
                  <c:v>0.65230299064900044</c:v>
                </c:pt>
                <c:pt idx="1099">
                  <c:v>0.22654586280249592</c:v>
                </c:pt>
                <c:pt idx="1100">
                  <c:v>0.91271664891972504</c:v>
                </c:pt>
                <c:pt idx="1101">
                  <c:v>0.65342736596551243</c:v>
                </c:pt>
                <c:pt idx="1102">
                  <c:v>0.3208235351033511</c:v>
                </c:pt>
                <c:pt idx="1103">
                  <c:v>0.10165830161944965</c:v>
                </c:pt>
                <c:pt idx="1104">
                  <c:v>0.43947989958904665</c:v>
                </c:pt>
                <c:pt idx="1105">
                  <c:v>0.77119486593448883</c:v>
                </c:pt>
                <c:pt idx="1106">
                  <c:v>0.1989143767986066</c:v>
                </c:pt>
                <c:pt idx="1107">
                  <c:v>0.39479707726778329</c:v>
                </c:pt>
                <c:pt idx="1108">
                  <c:v>0.13352604577618327</c:v>
                </c:pt>
                <c:pt idx="1109">
                  <c:v>0.33891503091511477</c:v>
                </c:pt>
                <c:pt idx="1110">
                  <c:v>0.43598270562578473</c:v>
                </c:pt>
                <c:pt idx="1111">
                  <c:v>4.1660713911445303E-2</c:v>
                </c:pt>
                <c:pt idx="1112">
                  <c:v>1.0368877521573914</c:v>
                </c:pt>
                <c:pt idx="1113">
                  <c:v>1.2419675060706592</c:v>
                </c:pt>
                <c:pt idx="1114">
                  <c:v>0.84558132266760899</c:v>
                </c:pt>
                <c:pt idx="1115">
                  <c:v>0.33861708202890817</c:v>
                </c:pt>
                <c:pt idx="1116">
                  <c:v>0.3003036474495967</c:v>
                </c:pt>
                <c:pt idx="1117">
                  <c:v>0.93193459394706835</c:v>
                </c:pt>
                <c:pt idx="1118">
                  <c:v>0.12851737230977478</c:v>
                </c:pt>
                <c:pt idx="1119">
                  <c:v>7.1417510133157905E-2</c:v>
                </c:pt>
                <c:pt idx="1120">
                  <c:v>0.26306923913588443</c:v>
                </c:pt>
                <c:pt idx="1121">
                  <c:v>0.68969135566541839</c:v>
                </c:pt>
                <c:pt idx="1122">
                  <c:v>0.36521629933477001</c:v>
                </c:pt>
                <c:pt idx="1123">
                  <c:v>1.5776463672390609E-2</c:v>
                </c:pt>
                <c:pt idx="1124">
                  <c:v>8.8086851643627312E-2</c:v>
                </c:pt>
                <c:pt idx="1125">
                  <c:v>0.25176229357554986</c:v>
                </c:pt>
                <c:pt idx="1126">
                  <c:v>6.9393661623368588E-2</c:v>
                </c:pt>
                <c:pt idx="1127">
                  <c:v>1.3159112232927348</c:v>
                </c:pt>
                <c:pt idx="1128">
                  <c:v>0.48956919803732896</c:v>
                </c:pt>
                <c:pt idx="1129">
                  <c:v>0.64931677144778477</c:v>
                </c:pt>
                <c:pt idx="1130">
                  <c:v>0.14912404010363745</c:v>
                </c:pt>
                <c:pt idx="1131">
                  <c:v>0.15377422299392152</c:v>
                </c:pt>
                <c:pt idx="1132">
                  <c:v>0.37570476611078668</c:v>
                </c:pt>
                <c:pt idx="1133">
                  <c:v>3.3731894453254523E-2</c:v>
                </c:pt>
                <c:pt idx="1134">
                  <c:v>0.19956633048351277</c:v>
                </c:pt>
                <c:pt idx="1135">
                  <c:v>1.0209226368939111</c:v>
                </c:pt>
                <c:pt idx="1136">
                  <c:v>4.2850855232832198E-2</c:v>
                </c:pt>
                <c:pt idx="1137">
                  <c:v>0.55960405298984239</c:v>
                </c:pt>
                <c:pt idx="1138">
                  <c:v>1.1005975231428347</c:v>
                </c:pt>
                <c:pt idx="1139">
                  <c:v>6.3354620498526013E-2</c:v>
                </c:pt>
                <c:pt idx="1140">
                  <c:v>0.26313555160654628</c:v>
                </c:pt>
                <c:pt idx="1141">
                  <c:v>0.78746705004610651</c:v>
                </c:pt>
                <c:pt idx="1142">
                  <c:v>1.0215639785145632</c:v>
                </c:pt>
                <c:pt idx="1143">
                  <c:v>5.3754600540381996E-2</c:v>
                </c:pt>
                <c:pt idx="1144">
                  <c:v>6.4308202954249903E-3</c:v>
                </c:pt>
                <c:pt idx="1145">
                  <c:v>1.0670379921312962</c:v>
                </c:pt>
                <c:pt idx="1146">
                  <c:v>0.17453134008383125</c:v>
                </c:pt>
                <c:pt idx="1147">
                  <c:v>0.18157279273778421</c:v>
                </c:pt>
                <c:pt idx="1148">
                  <c:v>0.30639598441881893</c:v>
                </c:pt>
                <c:pt idx="1149">
                  <c:v>0.51253032559479328</c:v>
                </c:pt>
                <c:pt idx="1150">
                  <c:v>1.4073818098986148</c:v>
                </c:pt>
                <c:pt idx="1151">
                  <c:v>1.3849152884564423E-2</c:v>
                </c:pt>
                <c:pt idx="1152">
                  <c:v>0.28839242226630002</c:v>
                </c:pt>
                <c:pt idx="1153">
                  <c:v>0.12557099571471925</c:v>
                </c:pt>
                <c:pt idx="1154">
                  <c:v>1.2296577589128501</c:v>
                </c:pt>
                <c:pt idx="1155">
                  <c:v>0.20336866066025017</c:v>
                </c:pt>
                <c:pt idx="1156">
                  <c:v>0.81874161873019935</c:v>
                </c:pt>
                <c:pt idx="1157">
                  <c:v>0.22773216022422976</c:v>
                </c:pt>
                <c:pt idx="1158">
                  <c:v>0.31027132016807146</c:v>
                </c:pt>
                <c:pt idx="1159">
                  <c:v>5.176571363606837E-2</c:v>
                </c:pt>
                <c:pt idx="1160">
                  <c:v>0.97279897942874138</c:v>
                </c:pt>
                <c:pt idx="1161">
                  <c:v>0.30866193436820494</c:v>
                </c:pt>
                <c:pt idx="1162">
                  <c:v>0.55068525011570091</c:v>
                </c:pt>
                <c:pt idx="1163">
                  <c:v>0.11440015696530259</c:v>
                </c:pt>
                <c:pt idx="1164">
                  <c:v>0.72178113591762383</c:v>
                </c:pt>
                <c:pt idx="1165">
                  <c:v>0.83134071653312036</c:v>
                </c:pt>
                <c:pt idx="1166">
                  <c:v>3.254945348115784E-3</c:v>
                </c:pt>
                <c:pt idx="1167">
                  <c:v>6.787598066534907E-2</c:v>
                </c:pt>
                <c:pt idx="1168">
                  <c:v>1.5898536471050109</c:v>
                </c:pt>
                <c:pt idx="1169">
                  <c:v>0.42776478098850657</c:v>
                </c:pt>
                <c:pt idx="1170">
                  <c:v>0.96463697407884041</c:v>
                </c:pt>
                <c:pt idx="1171">
                  <c:v>1.5766779830611075</c:v>
                </c:pt>
                <c:pt idx="1172">
                  <c:v>7.4801140875510206E-3</c:v>
                </c:pt>
                <c:pt idx="1173">
                  <c:v>3.0178916128907143E-3</c:v>
                </c:pt>
                <c:pt idx="1174">
                  <c:v>0.72544491932745103</c:v>
                </c:pt>
                <c:pt idx="1175">
                  <c:v>0.36764219573171208</c:v>
                </c:pt>
                <c:pt idx="1176">
                  <c:v>0.54043729504352567</c:v>
                </c:pt>
                <c:pt idx="1177">
                  <c:v>0.95387173940861592</c:v>
                </c:pt>
                <c:pt idx="1178">
                  <c:v>0.44142947737081889</c:v>
                </c:pt>
                <c:pt idx="1179">
                  <c:v>1.481657489831808</c:v>
                </c:pt>
                <c:pt idx="1180">
                  <c:v>0.42078235525117547</c:v>
                </c:pt>
                <c:pt idx="1181">
                  <c:v>0.44715470802232388</c:v>
                </c:pt>
                <c:pt idx="1182">
                  <c:v>0.64366543222663442</c:v>
                </c:pt>
                <c:pt idx="1183">
                  <c:v>0.19523972031499673</c:v>
                </c:pt>
                <c:pt idx="1184">
                  <c:v>1.2028010641852012</c:v>
                </c:pt>
                <c:pt idx="1185">
                  <c:v>1.1783755234706945</c:v>
                </c:pt>
                <c:pt idx="1186">
                  <c:v>0.66472941269366759</c:v>
                </c:pt>
                <c:pt idx="1187">
                  <c:v>0.16625233283573948</c:v>
                </c:pt>
                <c:pt idx="1188">
                  <c:v>0.48562539151206413</c:v>
                </c:pt>
                <c:pt idx="1189">
                  <c:v>0.10283949147048788</c:v>
                </c:pt>
                <c:pt idx="1190">
                  <c:v>0.19258389862935585</c:v>
                </c:pt>
                <c:pt idx="1191">
                  <c:v>0.24109860819571657</c:v>
                </c:pt>
                <c:pt idx="1192">
                  <c:v>0.1350030720786414</c:v>
                </c:pt>
                <c:pt idx="1193">
                  <c:v>0.1551128822680046</c:v>
                </c:pt>
                <c:pt idx="1194">
                  <c:v>2.0430069418335743</c:v>
                </c:pt>
                <c:pt idx="1195">
                  <c:v>0.41911712010875984</c:v>
                </c:pt>
                <c:pt idx="1196">
                  <c:v>3.2940945245116908</c:v>
                </c:pt>
                <c:pt idx="1197">
                  <c:v>0.34406746528041571</c:v>
                </c:pt>
                <c:pt idx="1198">
                  <c:v>0.17001487493517806</c:v>
                </c:pt>
                <c:pt idx="1199">
                  <c:v>0.72614606074824661</c:v>
                </c:pt>
                <c:pt idx="1200">
                  <c:v>0.31735097848876159</c:v>
                </c:pt>
                <c:pt idx="1201">
                  <c:v>0.84768550658805941</c:v>
                </c:pt>
                <c:pt idx="1202">
                  <c:v>0.89545358093592109</c:v>
                </c:pt>
                <c:pt idx="1203">
                  <c:v>0.11319309146801354</c:v>
                </c:pt>
                <c:pt idx="1204">
                  <c:v>7.1027086864301606E-2</c:v>
                </c:pt>
                <c:pt idx="1205">
                  <c:v>1.0499558844086636</c:v>
                </c:pt>
                <c:pt idx="1206">
                  <c:v>0.68345272155444781</c:v>
                </c:pt>
                <c:pt idx="1207">
                  <c:v>0.47055732432883385</c:v>
                </c:pt>
                <c:pt idx="1208">
                  <c:v>1.0325043697561818</c:v>
                </c:pt>
                <c:pt idx="1209">
                  <c:v>1.2695709226981557</c:v>
                </c:pt>
                <c:pt idx="1210">
                  <c:v>0.61377100502726034</c:v>
                </c:pt>
                <c:pt idx="1211">
                  <c:v>1.4936768721908324</c:v>
                </c:pt>
                <c:pt idx="1212">
                  <c:v>0.64546460286330498</c:v>
                </c:pt>
                <c:pt idx="1213">
                  <c:v>0.16786631555105688</c:v>
                </c:pt>
                <c:pt idx="1214">
                  <c:v>6.0176748936800611E-2</c:v>
                </c:pt>
                <c:pt idx="1215">
                  <c:v>7.0157103900889597E-2</c:v>
                </c:pt>
                <c:pt idx="1216">
                  <c:v>7.806104130689083E-2</c:v>
                </c:pt>
                <c:pt idx="1217">
                  <c:v>0.16986632818003281</c:v>
                </c:pt>
                <c:pt idx="1218">
                  <c:v>0.11597277985946443</c:v>
                </c:pt>
                <c:pt idx="1219">
                  <c:v>1.2051190464805475</c:v>
                </c:pt>
                <c:pt idx="1220">
                  <c:v>0.1612086372242654</c:v>
                </c:pt>
                <c:pt idx="1221">
                  <c:v>1.3918351756034351</c:v>
                </c:pt>
                <c:pt idx="1222">
                  <c:v>1.1238003325359374</c:v>
                </c:pt>
                <c:pt idx="1223">
                  <c:v>1.426828605409812</c:v>
                </c:pt>
                <c:pt idx="1224">
                  <c:v>7.4758837911741441E-2</c:v>
                </c:pt>
                <c:pt idx="1225">
                  <c:v>0.15631854825888444</c:v>
                </c:pt>
                <c:pt idx="1226">
                  <c:v>1.1076048939217558</c:v>
                </c:pt>
                <c:pt idx="1227">
                  <c:v>0.66149650016797312</c:v>
                </c:pt>
                <c:pt idx="1228">
                  <c:v>0.22724331038642678</c:v>
                </c:pt>
                <c:pt idx="1229">
                  <c:v>0.26894285454882388</c:v>
                </c:pt>
                <c:pt idx="1230">
                  <c:v>9.0617700193845074E-2</c:v>
                </c:pt>
                <c:pt idx="1231">
                  <c:v>0.3956771045908376</c:v>
                </c:pt>
                <c:pt idx="1232">
                  <c:v>0.20686004477454042</c:v>
                </c:pt>
                <c:pt idx="1233">
                  <c:v>0.64807699886177206</c:v>
                </c:pt>
                <c:pt idx="1234">
                  <c:v>0.17300985526604251</c:v>
                </c:pt>
                <c:pt idx="1235">
                  <c:v>3.4341124095603526E-2</c:v>
                </c:pt>
                <c:pt idx="1236">
                  <c:v>4.1832017851013998E-3</c:v>
                </c:pt>
                <c:pt idx="1237">
                  <c:v>1.2184021568641878</c:v>
                </c:pt>
                <c:pt idx="1238">
                  <c:v>1.0328257332513131</c:v>
                </c:pt>
                <c:pt idx="1239">
                  <c:v>7.3149046997836947E-2</c:v>
                </c:pt>
                <c:pt idx="1240">
                  <c:v>1.1805440182997322</c:v>
                </c:pt>
                <c:pt idx="1241">
                  <c:v>0.40635514329427702</c:v>
                </c:pt>
                <c:pt idx="1242">
                  <c:v>9.7517089422903727E-2</c:v>
                </c:pt>
                <c:pt idx="1243">
                  <c:v>0.43272612163851337</c:v>
                </c:pt>
                <c:pt idx="1244">
                  <c:v>0.84163483661552019</c:v>
                </c:pt>
                <c:pt idx="1245">
                  <c:v>0.68722093266552631</c:v>
                </c:pt>
                <c:pt idx="1246">
                  <c:v>0.74427199187543591</c:v>
                </c:pt>
                <c:pt idx="1247">
                  <c:v>9.1042679505104224E-2</c:v>
                </c:pt>
                <c:pt idx="1248">
                  <c:v>0.58248185868683766</c:v>
                </c:pt>
                <c:pt idx="1249">
                  <c:v>0.69133008950241726</c:v>
                </c:pt>
                <c:pt idx="1250">
                  <c:v>0.78677804744242263</c:v>
                </c:pt>
                <c:pt idx="1251">
                  <c:v>0.10946541474043044</c:v>
                </c:pt>
                <c:pt idx="1252">
                  <c:v>0.1776025561539156</c:v>
                </c:pt>
                <c:pt idx="1253">
                  <c:v>0.44898016252082068</c:v>
                </c:pt>
                <c:pt idx="1254">
                  <c:v>0.38047287814180525</c:v>
                </c:pt>
                <c:pt idx="1255">
                  <c:v>0.48416421103628454</c:v>
                </c:pt>
                <c:pt idx="1256">
                  <c:v>0.53217482212115874</c:v>
                </c:pt>
                <c:pt idx="1257">
                  <c:v>0.23969040844069539</c:v>
                </c:pt>
                <c:pt idx="1258">
                  <c:v>0.60563554026198008</c:v>
                </c:pt>
                <c:pt idx="1259">
                  <c:v>1.6300402241929552</c:v>
                </c:pt>
                <c:pt idx="1260">
                  <c:v>0.32882017719479817</c:v>
                </c:pt>
                <c:pt idx="1261">
                  <c:v>0.84857854035549218</c:v>
                </c:pt>
                <c:pt idx="1262">
                  <c:v>0.31391892029540469</c:v>
                </c:pt>
                <c:pt idx="1263">
                  <c:v>0.21719339667110471</c:v>
                </c:pt>
                <c:pt idx="1264">
                  <c:v>0.11902059631778147</c:v>
                </c:pt>
                <c:pt idx="1265">
                  <c:v>0.47281878835296137</c:v>
                </c:pt>
                <c:pt idx="1266">
                  <c:v>1.3256622899224346</c:v>
                </c:pt>
                <c:pt idx="1267">
                  <c:v>0.37118999180664619</c:v>
                </c:pt>
                <c:pt idx="1268">
                  <c:v>4.9218104643016937E-2</c:v>
                </c:pt>
                <c:pt idx="1269">
                  <c:v>0.35279105119806342</c:v>
                </c:pt>
                <c:pt idx="1270">
                  <c:v>0.7025266829499025</c:v>
                </c:pt>
                <c:pt idx="1271">
                  <c:v>0.71723403872346891</c:v>
                </c:pt>
                <c:pt idx="1272">
                  <c:v>0.86375911328896249</c:v>
                </c:pt>
                <c:pt idx="1273">
                  <c:v>2.0791553853230931E-2</c:v>
                </c:pt>
                <c:pt idx="1274">
                  <c:v>0.64192881105557908</c:v>
                </c:pt>
                <c:pt idx="1275">
                  <c:v>0.45392071408561657</c:v>
                </c:pt>
                <c:pt idx="1276">
                  <c:v>1.2421029535277808</c:v>
                </c:pt>
                <c:pt idx="1277">
                  <c:v>0.66174989147745755</c:v>
                </c:pt>
                <c:pt idx="1278">
                  <c:v>0.14083276140551057</c:v>
                </c:pt>
                <c:pt idx="1279">
                  <c:v>0.20597647192832108</c:v>
                </c:pt>
                <c:pt idx="1280">
                  <c:v>3.5806881332176917E-2</c:v>
                </c:pt>
                <c:pt idx="1281">
                  <c:v>0.64990956959663015</c:v>
                </c:pt>
                <c:pt idx="1282">
                  <c:v>5.1400863483016791E-2</c:v>
                </c:pt>
                <c:pt idx="1283">
                  <c:v>0.4916192154316657</c:v>
                </c:pt>
                <c:pt idx="1284">
                  <c:v>0.78076287552092971</c:v>
                </c:pt>
                <c:pt idx="1285">
                  <c:v>0.30025052654290951</c:v>
                </c:pt>
                <c:pt idx="1286">
                  <c:v>0.48252201207996148</c:v>
                </c:pt>
                <c:pt idx="1287">
                  <c:v>0.72704005216480538</c:v>
                </c:pt>
                <c:pt idx="1288">
                  <c:v>0.28459592118698229</c:v>
                </c:pt>
                <c:pt idx="1289">
                  <c:v>0.62607450117338281</c:v>
                </c:pt>
                <c:pt idx="1290">
                  <c:v>1.0322662128728766</c:v>
                </c:pt>
                <c:pt idx="1291">
                  <c:v>1.1139417921576853</c:v>
                </c:pt>
                <c:pt idx="1292">
                  <c:v>0.93918922513071756</c:v>
                </c:pt>
                <c:pt idx="1293">
                  <c:v>0.8213917750529558</c:v>
                </c:pt>
                <c:pt idx="1294">
                  <c:v>4.8665168201492609E-2</c:v>
                </c:pt>
                <c:pt idx="1295">
                  <c:v>1.7744216615230417</c:v>
                </c:pt>
                <c:pt idx="1296">
                  <c:v>0.40306385872585909</c:v>
                </c:pt>
                <c:pt idx="1297">
                  <c:v>8.5562237915428468E-3</c:v>
                </c:pt>
                <c:pt idx="1298">
                  <c:v>0.18746939097021151</c:v>
                </c:pt>
                <c:pt idx="1299">
                  <c:v>4.5658359860349169E-2</c:v>
                </c:pt>
                <c:pt idx="1300">
                  <c:v>0.60115587863773801</c:v>
                </c:pt>
                <c:pt idx="1301">
                  <c:v>8.2803215170174513E-2</c:v>
                </c:pt>
                <c:pt idx="1302">
                  <c:v>0.73295841652358618</c:v>
                </c:pt>
                <c:pt idx="1303">
                  <c:v>0.91868849180862655</c:v>
                </c:pt>
                <c:pt idx="1304">
                  <c:v>0.7915629122438026</c:v>
                </c:pt>
                <c:pt idx="1305">
                  <c:v>0.40112696664178288</c:v>
                </c:pt>
                <c:pt idx="1306">
                  <c:v>0.26069885472433035</c:v>
                </c:pt>
                <c:pt idx="1307">
                  <c:v>5.3993959349044128E-2</c:v>
                </c:pt>
                <c:pt idx="1308">
                  <c:v>0.46288545522781355</c:v>
                </c:pt>
                <c:pt idx="1309">
                  <c:v>1.0320587148263287</c:v>
                </c:pt>
                <c:pt idx="1310">
                  <c:v>7.5339228204663072E-2</c:v>
                </c:pt>
                <c:pt idx="1311">
                  <c:v>0.20249863566343995</c:v>
                </c:pt>
                <c:pt idx="1312">
                  <c:v>1.0916089156181061</c:v>
                </c:pt>
                <c:pt idx="1313">
                  <c:v>0.30184165758857956</c:v>
                </c:pt>
                <c:pt idx="1314">
                  <c:v>1.9224167919463794E-2</c:v>
                </c:pt>
                <c:pt idx="1315">
                  <c:v>0.33945176549035416</c:v>
                </c:pt>
                <c:pt idx="1316">
                  <c:v>0.30285989815435665</c:v>
                </c:pt>
                <c:pt idx="1317">
                  <c:v>1.117710693842503</c:v>
                </c:pt>
                <c:pt idx="1318">
                  <c:v>0.38193221716237535</c:v>
                </c:pt>
                <c:pt idx="1319">
                  <c:v>0.44981140570161099</c:v>
                </c:pt>
                <c:pt idx="1320">
                  <c:v>1.1598807432728451</c:v>
                </c:pt>
                <c:pt idx="1321">
                  <c:v>4.9169034919032406E-2</c:v>
                </c:pt>
                <c:pt idx="1322">
                  <c:v>0.41348047734672105</c:v>
                </c:pt>
                <c:pt idx="1323">
                  <c:v>0.75519559536916991</c:v>
                </c:pt>
                <c:pt idx="1324">
                  <c:v>1.161424943163434</c:v>
                </c:pt>
                <c:pt idx="1325">
                  <c:v>0.94524023172819271</c:v>
                </c:pt>
                <c:pt idx="1326">
                  <c:v>8.2002575395067404E-2</c:v>
                </c:pt>
                <c:pt idx="1327">
                  <c:v>0.26148946132461254</c:v>
                </c:pt>
                <c:pt idx="1328">
                  <c:v>2.1469103987345264</c:v>
                </c:pt>
                <c:pt idx="1329">
                  <c:v>0.30294355959022379</c:v>
                </c:pt>
                <c:pt idx="1330">
                  <c:v>0.36083694345605716</c:v>
                </c:pt>
                <c:pt idx="1331">
                  <c:v>0.62654783822830884</c:v>
                </c:pt>
                <c:pt idx="1332">
                  <c:v>0.45282655789344989</c:v>
                </c:pt>
                <c:pt idx="1333">
                  <c:v>0.86853407627021739</c:v>
                </c:pt>
                <c:pt idx="1334">
                  <c:v>9.9567036181319749E-2</c:v>
                </c:pt>
                <c:pt idx="1335">
                  <c:v>0.82072304700179133</c:v>
                </c:pt>
                <c:pt idx="1336">
                  <c:v>1.0050367456872162</c:v>
                </c:pt>
                <c:pt idx="1337">
                  <c:v>5.0164450352808004E-2</c:v>
                </c:pt>
                <c:pt idx="1338">
                  <c:v>0.86987193012458441</c:v>
                </c:pt>
                <c:pt idx="1339">
                  <c:v>0.48258779778079225</c:v>
                </c:pt>
                <c:pt idx="1340">
                  <c:v>1.9916554754967921</c:v>
                </c:pt>
                <c:pt idx="1341">
                  <c:v>0.37804695335797078</c:v>
                </c:pt>
                <c:pt idx="1342">
                  <c:v>0.11897030088641092</c:v>
                </c:pt>
                <c:pt idx="1343">
                  <c:v>5.89584936855947E-2</c:v>
                </c:pt>
                <c:pt idx="1344">
                  <c:v>0.9057856065710731</c:v>
                </c:pt>
                <c:pt idx="1345">
                  <c:v>0.34330185009759212</c:v>
                </c:pt>
                <c:pt idx="1346">
                  <c:v>6.491659229363099E-2</c:v>
                </c:pt>
                <c:pt idx="1347">
                  <c:v>0.85584745222087855</c:v>
                </c:pt>
                <c:pt idx="1348">
                  <c:v>1.2645700831957463</c:v>
                </c:pt>
                <c:pt idx="1349">
                  <c:v>1.0453597224289564</c:v>
                </c:pt>
                <c:pt idx="1350">
                  <c:v>0.91127901215804352</c:v>
                </c:pt>
                <c:pt idx="1351">
                  <c:v>0.68198829612234424</c:v>
                </c:pt>
                <c:pt idx="1352">
                  <c:v>0.37506866811858042</c:v>
                </c:pt>
                <c:pt idx="1353">
                  <c:v>0.91118229170025833</c:v>
                </c:pt>
                <c:pt idx="1354">
                  <c:v>0.66944669018333303</c:v>
                </c:pt>
                <c:pt idx="1355">
                  <c:v>0.17615577198995344</c:v>
                </c:pt>
                <c:pt idx="1356">
                  <c:v>0.66529114911510412</c:v>
                </c:pt>
                <c:pt idx="1357">
                  <c:v>0.77852652991878823</c:v>
                </c:pt>
                <c:pt idx="1358">
                  <c:v>0.59304970553418357</c:v>
                </c:pt>
                <c:pt idx="1359">
                  <c:v>0.17168297782947378</c:v>
                </c:pt>
                <c:pt idx="1360">
                  <c:v>1.4895182682685244</c:v>
                </c:pt>
                <c:pt idx="1361">
                  <c:v>0.16971533986011952</c:v>
                </c:pt>
                <c:pt idx="1362">
                  <c:v>0.1958591163276317</c:v>
                </c:pt>
                <c:pt idx="1363">
                  <c:v>0.8796552969945528</c:v>
                </c:pt>
                <c:pt idx="1364">
                  <c:v>1.3724488815750127</c:v>
                </c:pt>
                <c:pt idx="1365">
                  <c:v>0.87915400245122044</c:v>
                </c:pt>
                <c:pt idx="1366">
                  <c:v>0.29696801013896607</c:v>
                </c:pt>
                <c:pt idx="1367">
                  <c:v>0.61207685272045498</c:v>
                </c:pt>
                <c:pt idx="1368">
                  <c:v>0.22633576861979265</c:v>
                </c:pt>
                <c:pt idx="1369">
                  <c:v>1.2342565228664899</c:v>
                </c:pt>
                <c:pt idx="1370">
                  <c:v>1.1443562480636689</c:v>
                </c:pt>
                <c:pt idx="1371">
                  <c:v>0.35245916644347747</c:v>
                </c:pt>
                <c:pt idx="1372">
                  <c:v>0.51561782750998708</c:v>
                </c:pt>
                <c:pt idx="1373">
                  <c:v>0.44183626269551068</c:v>
                </c:pt>
                <c:pt idx="1374">
                  <c:v>0.92375956067905152</c:v>
                </c:pt>
                <c:pt idx="1375">
                  <c:v>1.3315131017906117</c:v>
                </c:pt>
                <c:pt idx="1376">
                  <c:v>0.11021431466441153</c:v>
                </c:pt>
                <c:pt idx="1377">
                  <c:v>0.55499266044497442</c:v>
                </c:pt>
                <c:pt idx="1378">
                  <c:v>0.42519766387086561</c:v>
                </c:pt>
                <c:pt idx="1379">
                  <c:v>1.2532933816992817</c:v>
                </c:pt>
                <c:pt idx="1380">
                  <c:v>0.36761004094193456</c:v>
                </c:pt>
                <c:pt idx="1381">
                  <c:v>2.4527359992361785E-2</c:v>
                </c:pt>
                <c:pt idx="1382">
                  <c:v>0.22324830241600299</c:v>
                </c:pt>
                <c:pt idx="1383">
                  <c:v>0.43936485896237015</c:v>
                </c:pt>
                <c:pt idx="1384">
                  <c:v>0.29753108155815372</c:v>
                </c:pt>
                <c:pt idx="1385">
                  <c:v>0.38246534955036537</c:v>
                </c:pt>
                <c:pt idx="1386">
                  <c:v>0.47015755403065995</c:v>
                </c:pt>
                <c:pt idx="1387">
                  <c:v>0.44147350793023288</c:v>
                </c:pt>
                <c:pt idx="1388">
                  <c:v>4.5745115228003022E-2</c:v>
                </c:pt>
                <c:pt idx="1389">
                  <c:v>0.45719264380885366</c:v>
                </c:pt>
                <c:pt idx="1390">
                  <c:v>3.0720120493738467E-2</c:v>
                </c:pt>
                <c:pt idx="1391">
                  <c:v>4.4332652841957663E-2</c:v>
                </c:pt>
                <c:pt idx="1392">
                  <c:v>0.32604425570903023</c:v>
                </c:pt>
                <c:pt idx="1393">
                  <c:v>0.29426011668330859</c:v>
                </c:pt>
                <c:pt idx="1394">
                  <c:v>0.18193320145184938</c:v>
                </c:pt>
                <c:pt idx="1395">
                  <c:v>2.0392997759955428E-2</c:v>
                </c:pt>
                <c:pt idx="1396">
                  <c:v>0.36536554214359618</c:v>
                </c:pt>
                <c:pt idx="1397">
                  <c:v>0.39025931607635922</c:v>
                </c:pt>
                <c:pt idx="1398">
                  <c:v>2.0892503218665865</c:v>
                </c:pt>
                <c:pt idx="1399">
                  <c:v>0.52089514055287534</c:v>
                </c:pt>
                <c:pt idx="1400">
                  <c:v>0.16686877660127433</c:v>
                </c:pt>
                <c:pt idx="1401">
                  <c:v>0.31563002907325821</c:v>
                </c:pt>
                <c:pt idx="1402">
                  <c:v>0.65296711189254808</c:v>
                </c:pt>
                <c:pt idx="1403">
                  <c:v>0.35333484155098011</c:v>
                </c:pt>
                <c:pt idx="1404">
                  <c:v>0.34354251869372066</c:v>
                </c:pt>
                <c:pt idx="1405">
                  <c:v>1.0565579768583506</c:v>
                </c:pt>
                <c:pt idx="1406">
                  <c:v>9.7677021623941828E-3</c:v>
                </c:pt>
                <c:pt idx="1407">
                  <c:v>0.77775754659095586</c:v>
                </c:pt>
                <c:pt idx="1408">
                  <c:v>0.57992303877688511</c:v>
                </c:pt>
                <c:pt idx="1409">
                  <c:v>4.2019843604863535E-2</c:v>
                </c:pt>
                <c:pt idx="1410">
                  <c:v>0.60573562136197312</c:v>
                </c:pt>
                <c:pt idx="1411">
                  <c:v>0.12601264160299588</c:v>
                </c:pt>
                <c:pt idx="1412">
                  <c:v>8.6028843548261888E-2</c:v>
                </c:pt>
                <c:pt idx="1413">
                  <c:v>9.8988090270579254E-2</c:v>
                </c:pt>
                <c:pt idx="1414">
                  <c:v>0.16542127127729847</c:v>
                </c:pt>
                <c:pt idx="1415">
                  <c:v>0.63292506009406946</c:v>
                </c:pt>
                <c:pt idx="1416">
                  <c:v>0.19622385418817889</c:v>
                </c:pt>
                <c:pt idx="1417">
                  <c:v>0.25605663265466061</c:v>
                </c:pt>
                <c:pt idx="1418">
                  <c:v>0.6225059932701249</c:v>
                </c:pt>
                <c:pt idx="1419">
                  <c:v>0.11810260210079422</c:v>
                </c:pt>
                <c:pt idx="1420">
                  <c:v>0.20188050126311524</c:v>
                </c:pt>
                <c:pt idx="1421">
                  <c:v>1.6347331250670476</c:v>
                </c:pt>
                <c:pt idx="1422">
                  <c:v>0.51222210507088817</c:v>
                </c:pt>
                <c:pt idx="1423">
                  <c:v>0.24317189492261249</c:v>
                </c:pt>
                <c:pt idx="1424">
                  <c:v>7.4867432959467739E-2</c:v>
                </c:pt>
                <c:pt idx="1425">
                  <c:v>0.96228080727437326</c:v>
                </c:pt>
                <c:pt idx="1426">
                  <c:v>0.54846366480126985</c:v>
                </c:pt>
                <c:pt idx="1427">
                  <c:v>0.25244048311865375</c:v>
                </c:pt>
                <c:pt idx="1428">
                  <c:v>0.48427527885938643</c:v>
                </c:pt>
                <c:pt idx="1429">
                  <c:v>4.2991007617489911E-2</c:v>
                </c:pt>
                <c:pt idx="1430">
                  <c:v>0.30179672215204906</c:v>
                </c:pt>
                <c:pt idx="1431">
                  <c:v>0.6353352371789931</c:v>
                </c:pt>
                <c:pt idx="1432">
                  <c:v>0.59295271528629934</c:v>
                </c:pt>
                <c:pt idx="1433">
                  <c:v>0.25748573354145105</c:v>
                </c:pt>
                <c:pt idx="1434">
                  <c:v>1.0648464371808757</c:v>
                </c:pt>
                <c:pt idx="1435">
                  <c:v>0.70328589676391018</c:v>
                </c:pt>
                <c:pt idx="1436">
                  <c:v>0.87813801368701372</c:v>
                </c:pt>
                <c:pt idx="1437">
                  <c:v>0.58821408130465214</c:v>
                </c:pt>
                <c:pt idx="1438">
                  <c:v>1.5131218850452166</c:v>
                </c:pt>
                <c:pt idx="1439">
                  <c:v>8.1809823870024681E-2</c:v>
                </c:pt>
                <c:pt idx="1440">
                  <c:v>0.45081300435645422</c:v>
                </c:pt>
                <c:pt idx="1441">
                  <c:v>0.78181321841115992</c:v>
                </c:pt>
                <c:pt idx="1442">
                  <c:v>0.15334679243623459</c:v>
                </c:pt>
                <c:pt idx="1443">
                  <c:v>1.1004616977299833</c:v>
                </c:pt>
                <c:pt idx="1444">
                  <c:v>0.59817449706286963</c:v>
                </c:pt>
                <c:pt idx="1445">
                  <c:v>0.46789180237757766</c:v>
                </c:pt>
                <c:pt idx="1446">
                  <c:v>0.12278510709928411</c:v>
                </c:pt>
                <c:pt idx="1447">
                  <c:v>0.95187519067941295</c:v>
                </c:pt>
                <c:pt idx="1448">
                  <c:v>6.8682102064129114E-2</c:v>
                </c:pt>
                <c:pt idx="1449">
                  <c:v>0.82805425693696799</c:v>
                </c:pt>
                <c:pt idx="1450">
                  <c:v>0.46751576309798409</c:v>
                </c:pt>
                <c:pt idx="1451">
                  <c:v>0.30572653062032695</c:v>
                </c:pt>
                <c:pt idx="1452">
                  <c:v>0.35812482315486543</c:v>
                </c:pt>
                <c:pt idx="1453">
                  <c:v>1.4835136999468401</c:v>
                </c:pt>
                <c:pt idx="1454">
                  <c:v>0.40424812945908395</c:v>
                </c:pt>
                <c:pt idx="1455">
                  <c:v>0.46038160058240912</c:v>
                </c:pt>
                <c:pt idx="1456">
                  <c:v>0.3393913615754654</c:v>
                </c:pt>
                <c:pt idx="1457">
                  <c:v>0.68215993242010198</c:v>
                </c:pt>
                <c:pt idx="1458">
                  <c:v>0.52944675941216623</c:v>
                </c:pt>
                <c:pt idx="1459">
                  <c:v>4.1807229909536558E-2</c:v>
                </c:pt>
                <c:pt idx="1460">
                  <c:v>0.2169263544548094</c:v>
                </c:pt>
                <c:pt idx="1461">
                  <c:v>2.3717198382727407</c:v>
                </c:pt>
                <c:pt idx="1462">
                  <c:v>0.20027248991634761</c:v>
                </c:pt>
                <c:pt idx="1463">
                  <c:v>0.55649041602430904</c:v>
                </c:pt>
                <c:pt idx="1464">
                  <c:v>0.7505855429610363</c:v>
                </c:pt>
                <c:pt idx="1465">
                  <c:v>4.0845699162227293E-2</c:v>
                </c:pt>
                <c:pt idx="1466">
                  <c:v>0.22105229132768933</c:v>
                </c:pt>
                <c:pt idx="1467">
                  <c:v>0.1485309916141461</c:v>
                </c:pt>
                <c:pt idx="1468">
                  <c:v>0.28647299970125883</c:v>
                </c:pt>
                <c:pt idx="1469">
                  <c:v>0.36056968351131097</c:v>
                </c:pt>
                <c:pt idx="1470">
                  <c:v>0.23230183891849332</c:v>
                </c:pt>
                <c:pt idx="1471">
                  <c:v>0.37464666948000225</c:v>
                </c:pt>
                <c:pt idx="1472">
                  <c:v>1.1502078979034862</c:v>
                </c:pt>
                <c:pt idx="1473">
                  <c:v>0.76771597629014066</c:v>
                </c:pt>
                <c:pt idx="1474">
                  <c:v>4.8786288351971734E-2</c:v>
                </c:pt>
                <c:pt idx="1475">
                  <c:v>0.481649511177204</c:v>
                </c:pt>
                <c:pt idx="1476">
                  <c:v>0.87466628531106039</c:v>
                </c:pt>
                <c:pt idx="1477">
                  <c:v>0.22462323754292718</c:v>
                </c:pt>
                <c:pt idx="1478">
                  <c:v>7.2718464142208727E-2</c:v>
                </c:pt>
                <c:pt idx="1479">
                  <c:v>1.1564762268520701</c:v>
                </c:pt>
                <c:pt idx="1480">
                  <c:v>2.5568216333844767</c:v>
                </c:pt>
                <c:pt idx="1481">
                  <c:v>1.2133518477377874</c:v>
                </c:pt>
                <c:pt idx="1482">
                  <c:v>1.168270413776904</c:v>
                </c:pt>
                <c:pt idx="1483">
                  <c:v>0.74367368891842844</c:v>
                </c:pt>
                <c:pt idx="1484">
                  <c:v>0.38601150258614769</c:v>
                </c:pt>
                <c:pt idx="1485">
                  <c:v>0.11577906121735963</c:v>
                </c:pt>
                <c:pt idx="1486">
                  <c:v>0.69135219885324528</c:v>
                </c:pt>
                <c:pt idx="1487">
                  <c:v>0.38860386956447396</c:v>
                </c:pt>
                <c:pt idx="1488">
                  <c:v>0.80057578201550728</c:v>
                </c:pt>
                <c:pt idx="1489">
                  <c:v>1.0644524377002595</c:v>
                </c:pt>
                <c:pt idx="1490">
                  <c:v>0.36008016608569804</c:v>
                </c:pt>
                <c:pt idx="1491">
                  <c:v>0.74681687325838664</c:v>
                </c:pt>
                <c:pt idx="1492">
                  <c:v>0.4773953222323824</c:v>
                </c:pt>
                <c:pt idx="1493">
                  <c:v>0.39550274637078675</c:v>
                </c:pt>
                <c:pt idx="1494">
                  <c:v>0.30537956574221592</c:v>
                </c:pt>
                <c:pt idx="1495">
                  <c:v>0.5089677582345068</c:v>
                </c:pt>
                <c:pt idx="1496">
                  <c:v>4.7291059341781252E-2</c:v>
                </c:pt>
                <c:pt idx="1497">
                  <c:v>4.6514532473434664E-2</c:v>
                </c:pt>
                <c:pt idx="1498">
                  <c:v>0.67695732144032827</c:v>
                </c:pt>
                <c:pt idx="1499">
                  <c:v>1.0452424972248315</c:v>
                </c:pt>
                <c:pt idx="1500">
                  <c:v>0.27244866269818702</c:v>
                </c:pt>
                <c:pt idx="1501">
                  <c:v>0.33157388854115311</c:v>
                </c:pt>
                <c:pt idx="1502">
                  <c:v>0.50696890467330924</c:v>
                </c:pt>
                <c:pt idx="1503">
                  <c:v>0.49916065381898223</c:v>
                </c:pt>
                <c:pt idx="1504">
                  <c:v>0.60123794444954437</c:v>
                </c:pt>
                <c:pt idx="1505">
                  <c:v>0.11016870942331387</c:v>
                </c:pt>
                <c:pt idx="1506">
                  <c:v>1.0784258953498995</c:v>
                </c:pt>
                <c:pt idx="1507">
                  <c:v>1.2530093537368929</c:v>
                </c:pt>
                <c:pt idx="1508">
                  <c:v>1.2869424678087316</c:v>
                </c:pt>
                <c:pt idx="1509">
                  <c:v>0.81436219626678708</c:v>
                </c:pt>
                <c:pt idx="1510">
                  <c:v>0.31686284385957758</c:v>
                </c:pt>
                <c:pt idx="1511">
                  <c:v>0.87930938469264031</c:v>
                </c:pt>
                <c:pt idx="1512">
                  <c:v>0.60615377128450987</c:v>
                </c:pt>
                <c:pt idx="1513">
                  <c:v>0.67438242578779439</c:v>
                </c:pt>
                <c:pt idx="1514">
                  <c:v>0.43021254440682494</c:v>
                </c:pt>
                <c:pt idx="1515">
                  <c:v>0.88936795045670414</c:v>
                </c:pt>
                <c:pt idx="1516">
                  <c:v>0.17066056104483898</c:v>
                </c:pt>
                <c:pt idx="1517">
                  <c:v>4.0143852330249891E-2</c:v>
                </c:pt>
                <c:pt idx="1518">
                  <c:v>0.3690198896874925</c:v>
                </c:pt>
                <c:pt idx="1519">
                  <c:v>0.45534273590979657</c:v>
                </c:pt>
                <c:pt idx="1520">
                  <c:v>0.26903984910815276</c:v>
                </c:pt>
                <c:pt idx="1521">
                  <c:v>0.25562183127855909</c:v>
                </c:pt>
                <c:pt idx="1522">
                  <c:v>0.70700629257044989</c:v>
                </c:pt>
                <c:pt idx="1523">
                  <c:v>0.85532315766171585</c:v>
                </c:pt>
                <c:pt idx="1524">
                  <c:v>0.29439815673882991</c:v>
                </c:pt>
                <c:pt idx="1525">
                  <c:v>0.44192961825499688</c:v>
                </c:pt>
                <c:pt idx="1526">
                  <c:v>0.66904962189717354</c:v>
                </c:pt>
                <c:pt idx="1527">
                  <c:v>0.32147065479908271</c:v>
                </c:pt>
                <c:pt idx="1528">
                  <c:v>0.3408215600343153</c:v>
                </c:pt>
                <c:pt idx="1529">
                  <c:v>0.54531205001831784</c:v>
                </c:pt>
                <c:pt idx="1530">
                  <c:v>0.58896500423704057</c:v>
                </c:pt>
                <c:pt idx="1531">
                  <c:v>0.34912820534542954</c:v>
                </c:pt>
                <c:pt idx="1532">
                  <c:v>0.7396358308839811</c:v>
                </c:pt>
                <c:pt idx="1533">
                  <c:v>0.96035692538409512</c:v>
                </c:pt>
                <c:pt idx="1534">
                  <c:v>0.35896502488406673</c:v>
                </c:pt>
                <c:pt idx="1535">
                  <c:v>0.16315391976425545</c:v>
                </c:pt>
                <c:pt idx="1536">
                  <c:v>0.87659326404758198</c:v>
                </c:pt>
                <c:pt idx="1537">
                  <c:v>0.44090742576946351</c:v>
                </c:pt>
                <c:pt idx="1538">
                  <c:v>0.81285443965309945</c:v>
                </c:pt>
                <c:pt idx="1539">
                  <c:v>0.74883661330631368</c:v>
                </c:pt>
                <c:pt idx="1540">
                  <c:v>2.0955680810364559</c:v>
                </c:pt>
                <c:pt idx="1541">
                  <c:v>1.1891181031921809</c:v>
                </c:pt>
                <c:pt idx="1542">
                  <c:v>0.80586111129941496</c:v>
                </c:pt>
                <c:pt idx="1543">
                  <c:v>0.17742950844833416</c:v>
                </c:pt>
                <c:pt idx="1544">
                  <c:v>0.24686063617491422</c:v>
                </c:pt>
                <c:pt idx="1545">
                  <c:v>0.66437260977288526</c:v>
                </c:pt>
                <c:pt idx="1546">
                  <c:v>1.2583770544086659</c:v>
                </c:pt>
                <c:pt idx="1547">
                  <c:v>0.16420222098522433</c:v>
                </c:pt>
                <c:pt idx="1548">
                  <c:v>0.39397671877350177</c:v>
                </c:pt>
                <c:pt idx="1549">
                  <c:v>0.12605796233312946</c:v>
                </c:pt>
                <c:pt idx="1550">
                  <c:v>4.1509842678110052E-2</c:v>
                </c:pt>
                <c:pt idx="1551">
                  <c:v>0.59140139805638237</c:v>
                </c:pt>
                <c:pt idx="1552">
                  <c:v>2.1975882395958855</c:v>
                </c:pt>
                <c:pt idx="1553">
                  <c:v>0.14744942120279372</c:v>
                </c:pt>
                <c:pt idx="1554">
                  <c:v>1.5193406334426311</c:v>
                </c:pt>
                <c:pt idx="1555">
                  <c:v>0.11598219118710881</c:v>
                </c:pt>
                <c:pt idx="1556">
                  <c:v>0.22589413396013658</c:v>
                </c:pt>
                <c:pt idx="1557">
                  <c:v>0.24878892528012231</c:v>
                </c:pt>
                <c:pt idx="1558">
                  <c:v>0.16871667011966482</c:v>
                </c:pt>
                <c:pt idx="1559">
                  <c:v>1.147050873696424</c:v>
                </c:pt>
                <c:pt idx="1560">
                  <c:v>0.54081205333329729</c:v>
                </c:pt>
                <c:pt idx="1561">
                  <c:v>1.2944511272218386</c:v>
                </c:pt>
                <c:pt idx="1562">
                  <c:v>3.7939054752567355E-2</c:v>
                </c:pt>
                <c:pt idx="1563">
                  <c:v>0.31677906998692806</c:v>
                </c:pt>
                <c:pt idx="1564">
                  <c:v>0.38746540754779774</c:v>
                </c:pt>
                <c:pt idx="1565">
                  <c:v>7.7120418055475329E-2</c:v>
                </c:pt>
                <c:pt idx="1566">
                  <c:v>9.1663012251992464E-3</c:v>
                </c:pt>
                <c:pt idx="1567">
                  <c:v>1.3025561944799711</c:v>
                </c:pt>
                <c:pt idx="1568">
                  <c:v>0.45105461387949541</c:v>
                </c:pt>
                <c:pt idx="1569">
                  <c:v>1.2269269572574486</c:v>
                </c:pt>
                <c:pt idx="1570">
                  <c:v>0.3813944682310485</c:v>
                </c:pt>
                <c:pt idx="1571">
                  <c:v>0.43494436110280454</c:v>
                </c:pt>
                <c:pt idx="1572">
                  <c:v>0.49173860269495112</c:v>
                </c:pt>
                <c:pt idx="1573">
                  <c:v>0.12420374999060312</c:v>
                </c:pt>
                <c:pt idx="1574">
                  <c:v>0.8546200450753525</c:v>
                </c:pt>
                <c:pt idx="1575">
                  <c:v>0.16732460236041868</c:v>
                </c:pt>
                <c:pt idx="1576">
                  <c:v>0.21701351200052735</c:v>
                </c:pt>
                <c:pt idx="1577">
                  <c:v>0.47577230284934285</c:v>
                </c:pt>
                <c:pt idx="1578">
                  <c:v>0.10311339666040402</c:v>
                </c:pt>
                <c:pt idx="1579">
                  <c:v>1.074502434272117</c:v>
                </c:pt>
                <c:pt idx="1580">
                  <c:v>3.8366475638151293E-2</c:v>
                </c:pt>
                <c:pt idx="1581">
                  <c:v>1.0572344224834103</c:v>
                </c:pt>
                <c:pt idx="1582">
                  <c:v>0.48002522478323134</c:v>
                </c:pt>
                <c:pt idx="1583">
                  <c:v>0.9183588486402654</c:v>
                </c:pt>
                <c:pt idx="1584">
                  <c:v>0.5027003075125438</c:v>
                </c:pt>
                <c:pt idx="1585">
                  <c:v>0.31199932849711542</c:v>
                </c:pt>
                <c:pt idx="1586">
                  <c:v>0.4021855768477034</c:v>
                </c:pt>
                <c:pt idx="1587">
                  <c:v>0.50697228283317108</c:v>
                </c:pt>
                <c:pt idx="1588">
                  <c:v>0.18364980033901843</c:v>
                </c:pt>
                <c:pt idx="1589">
                  <c:v>0.29055138697964999</c:v>
                </c:pt>
                <c:pt idx="1590">
                  <c:v>0.26701264312048073</c:v>
                </c:pt>
                <c:pt idx="1591">
                  <c:v>6.6677755628527693E-2</c:v>
                </c:pt>
                <c:pt idx="1592">
                  <c:v>0.33426222378334502</c:v>
                </c:pt>
                <c:pt idx="1593">
                  <c:v>1.1037670827466242</c:v>
                </c:pt>
                <c:pt idx="1594">
                  <c:v>0.90279321311278304</c:v>
                </c:pt>
                <c:pt idx="1595">
                  <c:v>0.22614871493945859</c:v>
                </c:pt>
                <c:pt idx="1596">
                  <c:v>1.2047423803213284E-2</c:v>
                </c:pt>
                <c:pt idx="1597">
                  <c:v>0.16611275077859949</c:v>
                </c:pt>
                <c:pt idx="1598">
                  <c:v>0.4640160107452973</c:v>
                </c:pt>
                <c:pt idx="1599">
                  <c:v>0.13559530883612936</c:v>
                </c:pt>
                <c:pt idx="1600">
                  <c:v>0.97235538076573957</c:v>
                </c:pt>
                <c:pt idx="1601">
                  <c:v>0.94576054703828927</c:v>
                </c:pt>
                <c:pt idx="1602">
                  <c:v>0.98474924351620752</c:v>
                </c:pt>
                <c:pt idx="1603">
                  <c:v>0.81168120454113635</c:v>
                </c:pt>
                <c:pt idx="1604">
                  <c:v>0.3994868754289293</c:v>
                </c:pt>
                <c:pt idx="1605">
                  <c:v>0.42357734673637204</c:v>
                </c:pt>
                <c:pt idx="1606">
                  <c:v>0.73165797062384952</c:v>
                </c:pt>
                <c:pt idx="1607">
                  <c:v>0.22575236461490336</c:v>
                </c:pt>
                <c:pt idx="1608">
                  <c:v>0.16206806562446627</c:v>
                </c:pt>
                <c:pt idx="1609">
                  <c:v>0.48193350203133734</c:v>
                </c:pt>
                <c:pt idx="1610">
                  <c:v>0.36260612437007178</c:v>
                </c:pt>
                <c:pt idx="1611">
                  <c:v>0.7347882633656978</c:v>
                </c:pt>
                <c:pt idx="1612">
                  <c:v>0.11610287461558362</c:v>
                </c:pt>
                <c:pt idx="1613">
                  <c:v>0.26677107798428634</c:v>
                </c:pt>
                <c:pt idx="1614">
                  <c:v>0.47202191400072913</c:v>
                </c:pt>
                <c:pt idx="1615">
                  <c:v>0.37532584542819758</c:v>
                </c:pt>
                <c:pt idx="1616">
                  <c:v>0.86206861246798783</c:v>
                </c:pt>
                <c:pt idx="1617">
                  <c:v>0.58993632905203863</c:v>
                </c:pt>
                <c:pt idx="1618">
                  <c:v>0.30251171070232269</c:v>
                </c:pt>
                <c:pt idx="1619">
                  <c:v>0.17185304055436837</c:v>
                </c:pt>
                <c:pt idx="1620">
                  <c:v>1.0528505354174673</c:v>
                </c:pt>
                <c:pt idx="1621">
                  <c:v>7.2075545458028745E-2</c:v>
                </c:pt>
                <c:pt idx="1622">
                  <c:v>1.274840753152205</c:v>
                </c:pt>
                <c:pt idx="1623">
                  <c:v>0.54155741014795789</c:v>
                </c:pt>
                <c:pt idx="1624">
                  <c:v>0.84517883715925812</c:v>
                </c:pt>
                <c:pt idx="1625">
                  <c:v>0.49852662173418755</c:v>
                </c:pt>
                <c:pt idx="1626">
                  <c:v>0.56890045907551889</c:v>
                </c:pt>
                <c:pt idx="1627">
                  <c:v>0.23700298884317497</c:v>
                </c:pt>
                <c:pt idx="1628">
                  <c:v>0.17664345273104193</c:v>
                </c:pt>
                <c:pt idx="1629">
                  <c:v>0.28883395249056715</c:v>
                </c:pt>
                <c:pt idx="1630">
                  <c:v>1.6331009665872385</c:v>
                </c:pt>
                <c:pt idx="1631">
                  <c:v>1.0222694356341913</c:v>
                </c:pt>
                <c:pt idx="1632">
                  <c:v>0.19700379216421302</c:v>
                </c:pt>
                <c:pt idx="1633">
                  <c:v>1.3087802634710328</c:v>
                </c:pt>
                <c:pt idx="1634">
                  <c:v>0.49341773262868943</c:v>
                </c:pt>
                <c:pt idx="1635">
                  <c:v>1.196319083411715</c:v>
                </c:pt>
                <c:pt idx="1636">
                  <c:v>1.3782370991915924</c:v>
                </c:pt>
                <c:pt idx="1637">
                  <c:v>0.64642307300600543</c:v>
                </c:pt>
                <c:pt idx="1638">
                  <c:v>1.0533084666181578</c:v>
                </c:pt>
                <c:pt idx="1639">
                  <c:v>0.339410545641812</c:v>
                </c:pt>
                <c:pt idx="1640">
                  <c:v>1.2183691486369244</c:v>
                </c:pt>
                <c:pt idx="1641">
                  <c:v>0.6510611651734528</c:v>
                </c:pt>
                <c:pt idx="1642">
                  <c:v>0.18666005355216711</c:v>
                </c:pt>
                <c:pt idx="1643">
                  <c:v>0.43555956280466729</c:v>
                </c:pt>
                <c:pt idx="1644">
                  <c:v>0.88500831805386571</c:v>
                </c:pt>
                <c:pt idx="1645">
                  <c:v>2.8371007220651393E-2</c:v>
                </c:pt>
                <c:pt idx="1646">
                  <c:v>0.71439558210626775</c:v>
                </c:pt>
                <c:pt idx="1647">
                  <c:v>0.88501999505513418</c:v>
                </c:pt>
                <c:pt idx="1648">
                  <c:v>0.75927074409369755</c:v>
                </c:pt>
                <c:pt idx="1649">
                  <c:v>1.0863867561389329</c:v>
                </c:pt>
                <c:pt idx="1650">
                  <c:v>1.0702488276211983</c:v>
                </c:pt>
                <c:pt idx="1651">
                  <c:v>0.2406225880182849</c:v>
                </c:pt>
                <c:pt idx="1652">
                  <c:v>0.44939762446560927</c:v>
                </c:pt>
                <c:pt idx="1653">
                  <c:v>0.53019819097802656</c:v>
                </c:pt>
                <c:pt idx="1654">
                  <c:v>0.78193853310554284</c:v>
                </c:pt>
                <c:pt idx="1655">
                  <c:v>0.96992047779353918</c:v>
                </c:pt>
                <c:pt idx="1656">
                  <c:v>3.2086070765714007E-2</c:v>
                </c:pt>
                <c:pt idx="1657">
                  <c:v>0.35172002158309013</c:v>
                </c:pt>
                <c:pt idx="1658">
                  <c:v>0.68592111821862023</c:v>
                </c:pt>
                <c:pt idx="1659">
                  <c:v>0.296836059850487</c:v>
                </c:pt>
                <c:pt idx="1660">
                  <c:v>0.40900850466638866</c:v>
                </c:pt>
                <c:pt idx="1661">
                  <c:v>0.3321838209045605</c:v>
                </c:pt>
                <c:pt idx="1662">
                  <c:v>0.3487992371339661</c:v>
                </c:pt>
                <c:pt idx="1663">
                  <c:v>1.2137132991768014</c:v>
                </c:pt>
                <c:pt idx="1664">
                  <c:v>0.66508923718086488</c:v>
                </c:pt>
                <c:pt idx="1665">
                  <c:v>0.8205295120618662</c:v>
                </c:pt>
                <c:pt idx="1666">
                  <c:v>1.1485533110350097</c:v>
                </c:pt>
                <c:pt idx="1667">
                  <c:v>1.2102025768690992</c:v>
                </c:pt>
                <c:pt idx="1668">
                  <c:v>0.99452498904115316</c:v>
                </c:pt>
                <c:pt idx="1669">
                  <c:v>0.91627416671181761</c:v>
                </c:pt>
                <c:pt idx="1670">
                  <c:v>0.15108289976288233</c:v>
                </c:pt>
                <c:pt idx="1671">
                  <c:v>0.79114453222658376</c:v>
                </c:pt>
                <c:pt idx="1672">
                  <c:v>8.4761670331258906E-2</c:v>
                </c:pt>
                <c:pt idx="1673">
                  <c:v>0.3834633298024987</c:v>
                </c:pt>
                <c:pt idx="1674">
                  <c:v>0.10713887440768737</c:v>
                </c:pt>
                <c:pt idx="1675">
                  <c:v>0.4546259797406712</c:v>
                </c:pt>
                <c:pt idx="1676">
                  <c:v>1.1377296323620991</c:v>
                </c:pt>
                <c:pt idx="1677">
                  <c:v>0.37395117760247437</c:v>
                </c:pt>
                <c:pt idx="1678">
                  <c:v>0.19070780037429241</c:v>
                </c:pt>
                <c:pt idx="1679">
                  <c:v>0.96718247925721701</c:v>
                </c:pt>
                <c:pt idx="1680">
                  <c:v>0.50309110609502228</c:v>
                </c:pt>
                <c:pt idx="1681">
                  <c:v>1.3865371551359313</c:v>
                </c:pt>
                <c:pt idx="1682">
                  <c:v>0.80099918194688846</c:v>
                </c:pt>
                <c:pt idx="1683">
                  <c:v>0.39799770908306076</c:v>
                </c:pt>
                <c:pt idx="1684">
                  <c:v>0.10887131105942276</c:v>
                </c:pt>
                <c:pt idx="1685">
                  <c:v>0.44098438126924111</c:v>
                </c:pt>
                <c:pt idx="1686">
                  <c:v>0.38558811554049727</c:v>
                </c:pt>
                <c:pt idx="1687">
                  <c:v>0.87680130233664078</c:v>
                </c:pt>
                <c:pt idx="1688">
                  <c:v>0.11466327870986572</c:v>
                </c:pt>
                <c:pt idx="1689">
                  <c:v>0.92629785022624489</c:v>
                </c:pt>
                <c:pt idx="1690">
                  <c:v>0.34277874767213345</c:v>
                </c:pt>
                <c:pt idx="1691">
                  <c:v>1.1858542918464865</c:v>
                </c:pt>
                <c:pt idx="1692">
                  <c:v>0.26086017463546568</c:v>
                </c:pt>
                <c:pt idx="1693">
                  <c:v>9.7082615921228632E-2</c:v>
                </c:pt>
                <c:pt idx="1694">
                  <c:v>4.153928725985858E-2</c:v>
                </c:pt>
                <c:pt idx="1695">
                  <c:v>1.1661138503527735</c:v>
                </c:pt>
                <c:pt idx="1696">
                  <c:v>1.3981133453795167</c:v>
                </c:pt>
                <c:pt idx="1697">
                  <c:v>0.19755328484538034</c:v>
                </c:pt>
                <c:pt idx="1698">
                  <c:v>1.1598559813694571</c:v>
                </c:pt>
                <c:pt idx="1699">
                  <c:v>0.34173080194743533</c:v>
                </c:pt>
                <c:pt idx="1700">
                  <c:v>0.14499203321935267</c:v>
                </c:pt>
                <c:pt idx="1701">
                  <c:v>1.1571310154659327</c:v>
                </c:pt>
                <c:pt idx="1702">
                  <c:v>0.37622892080937514</c:v>
                </c:pt>
                <c:pt idx="1703">
                  <c:v>0.47954800582240026</c:v>
                </c:pt>
                <c:pt idx="1704">
                  <c:v>2.1708801806577944</c:v>
                </c:pt>
                <c:pt idx="1705">
                  <c:v>0.33296799119609644</c:v>
                </c:pt>
                <c:pt idx="1706">
                  <c:v>5.7236211781281986E-2</c:v>
                </c:pt>
                <c:pt idx="1707">
                  <c:v>0.31258247633766828</c:v>
                </c:pt>
                <c:pt idx="1708">
                  <c:v>2.002666050595884</c:v>
                </c:pt>
                <c:pt idx="1709">
                  <c:v>1.0994398248301382</c:v>
                </c:pt>
                <c:pt idx="1710">
                  <c:v>0.32280569158974359</c:v>
                </c:pt>
                <c:pt idx="1711">
                  <c:v>0.13745288804610412</c:v>
                </c:pt>
                <c:pt idx="1712">
                  <c:v>0.58552755606894547</c:v>
                </c:pt>
                <c:pt idx="1713">
                  <c:v>1.2494220232118756</c:v>
                </c:pt>
                <c:pt idx="1714">
                  <c:v>0.84761458976145432</c:v>
                </c:pt>
                <c:pt idx="1715">
                  <c:v>0.73645189711487125</c:v>
                </c:pt>
                <c:pt idx="1716">
                  <c:v>0.81026069150477065</c:v>
                </c:pt>
                <c:pt idx="1717">
                  <c:v>0.34278157327900655</c:v>
                </c:pt>
                <c:pt idx="1718">
                  <c:v>2.5237698503245788E-2</c:v>
                </c:pt>
                <c:pt idx="1719">
                  <c:v>0.67231550030035425</c:v>
                </c:pt>
                <c:pt idx="1720">
                  <c:v>0.2214182086899262</c:v>
                </c:pt>
                <c:pt idx="1721">
                  <c:v>3.3830860730706069E-2</c:v>
                </c:pt>
                <c:pt idx="1722">
                  <c:v>1.0434602284086616</c:v>
                </c:pt>
                <c:pt idx="1723">
                  <c:v>5.2114061112572649E-2</c:v>
                </c:pt>
                <c:pt idx="1724">
                  <c:v>4.3578872631472127E-3</c:v>
                </c:pt>
                <c:pt idx="1725">
                  <c:v>0.3786688247257089</c:v>
                </c:pt>
                <c:pt idx="1726">
                  <c:v>0.80761785753001203</c:v>
                </c:pt>
                <c:pt idx="1727">
                  <c:v>2.1083705267838752E-2</c:v>
                </c:pt>
                <c:pt idx="1728">
                  <c:v>0.1162088428309363</c:v>
                </c:pt>
                <c:pt idx="1729">
                  <c:v>0.57963828612737212</c:v>
                </c:pt>
                <c:pt idx="1730">
                  <c:v>0.12453084119003048</c:v>
                </c:pt>
                <c:pt idx="1731">
                  <c:v>1.1111210390081492</c:v>
                </c:pt>
                <c:pt idx="1732">
                  <c:v>1.4552844335340622</c:v>
                </c:pt>
                <c:pt idx="1733">
                  <c:v>2.324500167812638</c:v>
                </c:pt>
                <c:pt idx="1734">
                  <c:v>0.38212899175169701</c:v>
                </c:pt>
                <c:pt idx="1735">
                  <c:v>0.69813809283724038</c:v>
                </c:pt>
                <c:pt idx="1736">
                  <c:v>0.98838585608073803</c:v>
                </c:pt>
                <c:pt idx="1737">
                  <c:v>0.28039635709206756</c:v>
                </c:pt>
                <c:pt idx="1738">
                  <c:v>1.4784403533319959</c:v>
                </c:pt>
                <c:pt idx="1739">
                  <c:v>2.506908648915103E-2</c:v>
                </c:pt>
                <c:pt idx="1740">
                  <c:v>1.1825715733240769</c:v>
                </c:pt>
                <c:pt idx="1741">
                  <c:v>1.0875206498374494</c:v>
                </c:pt>
                <c:pt idx="1742">
                  <c:v>2.4221308115500145E-2</c:v>
                </c:pt>
                <c:pt idx="1743">
                  <c:v>4.5359390536528606E-2</c:v>
                </c:pt>
                <c:pt idx="1744">
                  <c:v>0.13610786946537295</c:v>
                </c:pt>
                <c:pt idx="1745">
                  <c:v>2.288206737311315E-2</c:v>
                </c:pt>
                <c:pt idx="1746">
                  <c:v>7.7548815905877047E-2</c:v>
                </c:pt>
                <c:pt idx="1747">
                  <c:v>1.6721852560477901</c:v>
                </c:pt>
                <c:pt idx="1748">
                  <c:v>0.74299024482322507</c:v>
                </c:pt>
                <c:pt idx="1749">
                  <c:v>0.13521384534610392</c:v>
                </c:pt>
                <c:pt idx="1750">
                  <c:v>0.16965211040753198</c:v>
                </c:pt>
                <c:pt idx="1751">
                  <c:v>0.76559238412392439</c:v>
                </c:pt>
                <c:pt idx="1752">
                  <c:v>0.79201644364883717</c:v>
                </c:pt>
                <c:pt idx="1753">
                  <c:v>0.83191496875094018</c:v>
                </c:pt>
                <c:pt idx="1754">
                  <c:v>2.1559818302274159</c:v>
                </c:pt>
                <c:pt idx="1755">
                  <c:v>0.52364810306373633</c:v>
                </c:pt>
                <c:pt idx="1756">
                  <c:v>5.4351046771429677E-2</c:v>
                </c:pt>
                <c:pt idx="1757">
                  <c:v>0.16410083224633026</c:v>
                </c:pt>
                <c:pt idx="1758">
                  <c:v>1.9281422564580373</c:v>
                </c:pt>
                <c:pt idx="1759">
                  <c:v>0.3000569019609951</c:v>
                </c:pt>
                <c:pt idx="1760">
                  <c:v>1.9825255135275811E-2</c:v>
                </c:pt>
                <c:pt idx="1761">
                  <c:v>0.27526884701337373</c:v>
                </c:pt>
                <c:pt idx="1762">
                  <c:v>4.3616190741771865E-2</c:v>
                </c:pt>
                <c:pt idx="1763">
                  <c:v>0.91536208420799137</c:v>
                </c:pt>
                <c:pt idx="1764">
                  <c:v>1.0606157994976944</c:v>
                </c:pt>
                <c:pt idx="1765">
                  <c:v>0.52201564188417482</c:v>
                </c:pt>
                <c:pt idx="1766">
                  <c:v>0.60203488972343744</c:v>
                </c:pt>
                <c:pt idx="1767">
                  <c:v>0.34306219116562309</c:v>
                </c:pt>
                <c:pt idx="1768">
                  <c:v>0.65755689595748779</c:v>
                </c:pt>
                <c:pt idx="1769">
                  <c:v>0.36231609445968538</c:v>
                </c:pt>
                <c:pt idx="1770">
                  <c:v>0.36287307297516436</c:v>
                </c:pt>
                <c:pt idx="1771">
                  <c:v>1.0708252051522456</c:v>
                </c:pt>
                <c:pt idx="1772">
                  <c:v>0.58057783734692536</c:v>
                </c:pt>
                <c:pt idx="1773">
                  <c:v>0.76292903231614451</c:v>
                </c:pt>
                <c:pt idx="1774">
                  <c:v>3.6216898363055368E-2</c:v>
                </c:pt>
                <c:pt idx="1775">
                  <c:v>0.48331179645555139</c:v>
                </c:pt>
                <c:pt idx="1776">
                  <c:v>0.68831233006038839</c:v>
                </c:pt>
                <c:pt idx="1777">
                  <c:v>1.0750293235198805</c:v>
                </c:pt>
                <c:pt idx="1778">
                  <c:v>0.14503844932388038</c:v>
                </c:pt>
                <c:pt idx="1779">
                  <c:v>0.6618567088756051</c:v>
                </c:pt>
                <c:pt idx="1780">
                  <c:v>0.55350572649900487</c:v>
                </c:pt>
                <c:pt idx="1781">
                  <c:v>1.7038150036834085</c:v>
                </c:pt>
                <c:pt idx="1782">
                  <c:v>1.1863524466411297</c:v>
                </c:pt>
                <c:pt idx="1783">
                  <c:v>0.42129215362046041</c:v>
                </c:pt>
                <c:pt idx="1784">
                  <c:v>0.24667444222338095</c:v>
                </c:pt>
                <c:pt idx="1785">
                  <c:v>9.8135054546622857E-2</c:v>
                </c:pt>
                <c:pt idx="1786">
                  <c:v>6.8470457283305197E-2</c:v>
                </c:pt>
                <c:pt idx="1787">
                  <c:v>0.29994838438439331</c:v>
                </c:pt>
                <c:pt idx="1788">
                  <c:v>0.12082098479941238</c:v>
                </c:pt>
                <c:pt idx="1789">
                  <c:v>0.48216280675867745</c:v>
                </c:pt>
                <c:pt idx="1790">
                  <c:v>0.74300529700037421</c:v>
                </c:pt>
                <c:pt idx="1791">
                  <c:v>0.12155705857695988</c:v>
                </c:pt>
                <c:pt idx="1792">
                  <c:v>0.59000338039171252</c:v>
                </c:pt>
                <c:pt idx="1793">
                  <c:v>0.24741337037649616</c:v>
                </c:pt>
                <c:pt idx="1794">
                  <c:v>0.60183717965945893</c:v>
                </c:pt>
                <c:pt idx="1795">
                  <c:v>0.34718597768996295</c:v>
                </c:pt>
                <c:pt idx="1796">
                  <c:v>0.16911180095325432</c:v>
                </c:pt>
                <c:pt idx="1797">
                  <c:v>1.4598141067136725</c:v>
                </c:pt>
                <c:pt idx="1798">
                  <c:v>0.22234385382856248</c:v>
                </c:pt>
                <c:pt idx="1799">
                  <c:v>0.88081234935435238</c:v>
                </c:pt>
                <c:pt idx="1800">
                  <c:v>1.1810953986217054</c:v>
                </c:pt>
                <c:pt idx="1801">
                  <c:v>0.38744059623979349</c:v>
                </c:pt>
                <c:pt idx="1802">
                  <c:v>0.32349300752682347</c:v>
                </c:pt>
                <c:pt idx="1803">
                  <c:v>0.74366479453074574</c:v>
                </c:pt>
                <c:pt idx="1804">
                  <c:v>2.0026765362992713</c:v>
                </c:pt>
                <c:pt idx="1805">
                  <c:v>0.48353844298843374</c:v>
                </c:pt>
                <c:pt idx="1806">
                  <c:v>1.4289766888308479</c:v>
                </c:pt>
                <c:pt idx="1807">
                  <c:v>0.71770578050002132</c:v>
                </c:pt>
                <c:pt idx="1808">
                  <c:v>0.78468655845502377</c:v>
                </c:pt>
                <c:pt idx="1809">
                  <c:v>1.7706979413819539</c:v>
                </c:pt>
                <c:pt idx="1810">
                  <c:v>6.7973823936719135E-2</c:v>
                </c:pt>
                <c:pt idx="1811">
                  <c:v>0.81524172693106645</c:v>
                </c:pt>
                <c:pt idx="1812">
                  <c:v>1.0535138900001757</c:v>
                </c:pt>
                <c:pt idx="1813">
                  <c:v>7.0823754823723412E-2</c:v>
                </c:pt>
                <c:pt idx="1814">
                  <c:v>0.67460410240049318</c:v>
                </c:pt>
                <c:pt idx="1815">
                  <c:v>0.71606828843976922</c:v>
                </c:pt>
                <c:pt idx="1816">
                  <c:v>0.76935187763991464</c:v>
                </c:pt>
                <c:pt idx="1817">
                  <c:v>0.26939969476127446</c:v>
                </c:pt>
                <c:pt idx="1818">
                  <c:v>0.25802501550833284</c:v>
                </c:pt>
                <c:pt idx="1819">
                  <c:v>0.21507931336553607</c:v>
                </c:pt>
                <c:pt idx="1820">
                  <c:v>7.6718829818963136E-2</c:v>
                </c:pt>
                <c:pt idx="1821">
                  <c:v>2.1559160697439705</c:v>
                </c:pt>
                <c:pt idx="1822">
                  <c:v>0.65686138276681583</c:v>
                </c:pt>
                <c:pt idx="1823">
                  <c:v>1.5009878574185931</c:v>
                </c:pt>
                <c:pt idx="1824">
                  <c:v>1.7027517052299148</c:v>
                </c:pt>
                <c:pt idx="1825">
                  <c:v>9.1199209837265052E-2</c:v>
                </c:pt>
                <c:pt idx="1826">
                  <c:v>0.28308103529522433</c:v>
                </c:pt>
                <c:pt idx="1827">
                  <c:v>0.19800085755613392</c:v>
                </c:pt>
                <c:pt idx="1828">
                  <c:v>0.63645409267060493</c:v>
                </c:pt>
                <c:pt idx="1829">
                  <c:v>0.11098923764165373</c:v>
                </c:pt>
                <c:pt idx="1830">
                  <c:v>0.1309085817950883</c:v>
                </c:pt>
                <c:pt idx="1831">
                  <c:v>0.13350149523357296</c:v>
                </c:pt>
                <c:pt idx="1832">
                  <c:v>0.58323289286208446</c:v>
                </c:pt>
                <c:pt idx="1833">
                  <c:v>3.1983693732579775E-2</c:v>
                </c:pt>
                <c:pt idx="1834">
                  <c:v>0.1367056302333004</c:v>
                </c:pt>
                <c:pt idx="1835">
                  <c:v>3.571138815007241E-2</c:v>
                </c:pt>
                <c:pt idx="1836">
                  <c:v>0.11840945488368128</c:v>
                </c:pt>
                <c:pt idx="1837">
                  <c:v>0.42573457278602311</c:v>
                </c:pt>
                <c:pt idx="1838">
                  <c:v>0.38138321864734193</c:v>
                </c:pt>
                <c:pt idx="1839">
                  <c:v>0.76735649283432505</c:v>
                </c:pt>
                <c:pt idx="1840">
                  <c:v>6.7356747920582299E-2</c:v>
                </c:pt>
                <c:pt idx="1841">
                  <c:v>2.022121594340422</c:v>
                </c:pt>
                <c:pt idx="1842">
                  <c:v>0.50319831151155381</c:v>
                </c:pt>
                <c:pt idx="1843">
                  <c:v>0.36908383738128248</c:v>
                </c:pt>
                <c:pt idx="1844">
                  <c:v>1.985854841688113E-2</c:v>
                </c:pt>
                <c:pt idx="1845">
                  <c:v>0.98365603099765353</c:v>
                </c:pt>
                <c:pt idx="1846">
                  <c:v>0.96593508587904586</c:v>
                </c:pt>
                <c:pt idx="1847">
                  <c:v>0.35388970172630357</c:v>
                </c:pt>
                <c:pt idx="1848">
                  <c:v>1.1336747288539195</c:v>
                </c:pt>
                <c:pt idx="1849">
                  <c:v>4.8513506611656291E-3</c:v>
                </c:pt>
                <c:pt idx="1850">
                  <c:v>0.64820939225879226</c:v>
                </c:pt>
                <c:pt idx="1851">
                  <c:v>0.48492789046842999</c:v>
                </c:pt>
                <c:pt idx="1852">
                  <c:v>0.9475069839844098</c:v>
                </c:pt>
                <c:pt idx="1853">
                  <c:v>1.0512113713364193</c:v>
                </c:pt>
                <c:pt idx="1854">
                  <c:v>1.0996627559711647</c:v>
                </c:pt>
                <c:pt idx="1855">
                  <c:v>0.17316978892019722</c:v>
                </c:pt>
                <c:pt idx="1856">
                  <c:v>0.21794718396088134</c:v>
                </c:pt>
                <c:pt idx="1857">
                  <c:v>0.34583642398041081</c:v>
                </c:pt>
                <c:pt idx="1858">
                  <c:v>1.1340036821902062</c:v>
                </c:pt>
                <c:pt idx="1859">
                  <c:v>0.27172140443086984</c:v>
                </c:pt>
                <c:pt idx="1860">
                  <c:v>1.0183059043440297</c:v>
                </c:pt>
                <c:pt idx="1861">
                  <c:v>0.4601847535349527</c:v>
                </c:pt>
                <c:pt idx="1862">
                  <c:v>0.19334281682564267</c:v>
                </c:pt>
                <c:pt idx="1863">
                  <c:v>0.19949867380455535</c:v>
                </c:pt>
                <c:pt idx="1864">
                  <c:v>0.1946225343187859</c:v>
                </c:pt>
                <c:pt idx="1865">
                  <c:v>0.50942751389061458</c:v>
                </c:pt>
                <c:pt idx="1866">
                  <c:v>0.15416226274082448</c:v>
                </c:pt>
                <c:pt idx="1867">
                  <c:v>0.12096872433254471</c:v>
                </c:pt>
                <c:pt idx="1868">
                  <c:v>0.85663225571808721</c:v>
                </c:pt>
                <c:pt idx="1869">
                  <c:v>0.47065363521132658</c:v>
                </c:pt>
                <c:pt idx="1870">
                  <c:v>0.81814591625464872</c:v>
                </c:pt>
                <c:pt idx="1871">
                  <c:v>0.32437915541584972</c:v>
                </c:pt>
                <c:pt idx="1872">
                  <c:v>6.9766144567839014E-2</c:v>
                </c:pt>
                <c:pt idx="1873">
                  <c:v>0.29829529899691021</c:v>
                </c:pt>
                <c:pt idx="1874">
                  <c:v>0.24163185050156888</c:v>
                </c:pt>
                <c:pt idx="1875">
                  <c:v>0.18694313802675691</c:v>
                </c:pt>
                <c:pt idx="1876">
                  <c:v>0.10122174677839046</c:v>
                </c:pt>
                <c:pt idx="1877">
                  <c:v>0.55749397658984601</c:v>
                </c:pt>
                <c:pt idx="1878">
                  <c:v>0.95936197973827309</c:v>
                </c:pt>
                <c:pt idx="1879">
                  <c:v>0.91887324031959783</c:v>
                </c:pt>
                <c:pt idx="1880">
                  <c:v>0.8491888295196689</c:v>
                </c:pt>
                <c:pt idx="1881">
                  <c:v>1.5182652028535839</c:v>
                </c:pt>
                <c:pt idx="1882">
                  <c:v>0.46467737688826471</c:v>
                </c:pt>
                <c:pt idx="1883">
                  <c:v>0.21781863255430089</c:v>
                </c:pt>
                <c:pt idx="1884">
                  <c:v>1.805912332627557</c:v>
                </c:pt>
                <c:pt idx="1885">
                  <c:v>0.61615339295672444</c:v>
                </c:pt>
                <c:pt idx="1886">
                  <c:v>0.43633744961611282</c:v>
                </c:pt>
                <c:pt idx="1887">
                  <c:v>1.2821441692380162</c:v>
                </c:pt>
                <c:pt idx="1888">
                  <c:v>0.62762431755384096</c:v>
                </c:pt>
                <c:pt idx="1889">
                  <c:v>4.4273893324376458E-2</c:v>
                </c:pt>
                <c:pt idx="1890">
                  <c:v>0.69989889796077465</c:v>
                </c:pt>
                <c:pt idx="1891">
                  <c:v>0.2243990809152365</c:v>
                </c:pt>
                <c:pt idx="1892">
                  <c:v>1.3831041851069348</c:v>
                </c:pt>
                <c:pt idx="1893">
                  <c:v>0.32821796732167008</c:v>
                </c:pt>
                <c:pt idx="1894">
                  <c:v>0.42455056512708056</c:v>
                </c:pt>
                <c:pt idx="1895">
                  <c:v>1.124260207587527</c:v>
                </c:pt>
                <c:pt idx="1896">
                  <c:v>1.8155088292804926</c:v>
                </c:pt>
                <c:pt idx="1897">
                  <c:v>0.4817230153148917</c:v>
                </c:pt>
                <c:pt idx="1898">
                  <c:v>0.67912491736941394</c:v>
                </c:pt>
                <c:pt idx="1899">
                  <c:v>0.16647220901398124</c:v>
                </c:pt>
                <c:pt idx="1900">
                  <c:v>0.20202523101694983</c:v>
                </c:pt>
                <c:pt idx="1901">
                  <c:v>0.63128567349545095</c:v>
                </c:pt>
                <c:pt idx="1902">
                  <c:v>0.83685035366305305</c:v>
                </c:pt>
                <c:pt idx="1903">
                  <c:v>0.4901323840219361</c:v>
                </c:pt>
                <c:pt idx="1904">
                  <c:v>0.63844035014983946</c:v>
                </c:pt>
                <c:pt idx="1905">
                  <c:v>0.6450882141788461</c:v>
                </c:pt>
                <c:pt idx="1906">
                  <c:v>7.5031730987418721E-2</c:v>
                </c:pt>
                <c:pt idx="1907">
                  <c:v>0.63549558435191489</c:v>
                </c:pt>
                <c:pt idx="1908">
                  <c:v>0.27979722973026122</c:v>
                </c:pt>
                <c:pt idx="1909">
                  <c:v>0.36593194554702535</c:v>
                </c:pt>
                <c:pt idx="1910">
                  <c:v>0.60193124730894776</c:v>
                </c:pt>
                <c:pt idx="1911">
                  <c:v>6.8542547111359306E-2</c:v>
                </c:pt>
                <c:pt idx="1912">
                  <c:v>0.89264405206652453</c:v>
                </c:pt>
                <c:pt idx="1913">
                  <c:v>0.42562377506666782</c:v>
                </c:pt>
                <c:pt idx="1914">
                  <c:v>0.55216566461775052</c:v>
                </c:pt>
                <c:pt idx="1915">
                  <c:v>2.7637950637592803E-2</c:v>
                </c:pt>
                <c:pt idx="1916">
                  <c:v>1.0417451086364924</c:v>
                </c:pt>
                <c:pt idx="1917">
                  <c:v>0.87849521031526989</c:v>
                </c:pt>
                <c:pt idx="1918">
                  <c:v>0.62932010190539545</c:v>
                </c:pt>
                <c:pt idx="1919">
                  <c:v>0.12692147103590767</c:v>
                </c:pt>
                <c:pt idx="1920">
                  <c:v>0.90129617804254369</c:v>
                </c:pt>
                <c:pt idx="1921">
                  <c:v>1.3021972358526797</c:v>
                </c:pt>
                <c:pt idx="1922">
                  <c:v>0.70856182765619447</c:v>
                </c:pt>
                <c:pt idx="1923">
                  <c:v>0.4583421652183155</c:v>
                </c:pt>
                <c:pt idx="1924">
                  <c:v>0.24711605236675629</c:v>
                </c:pt>
                <c:pt idx="1925">
                  <c:v>0.28213829100965171</c:v>
                </c:pt>
                <c:pt idx="1926">
                  <c:v>0.16748861662442263</c:v>
                </c:pt>
                <c:pt idx="1927">
                  <c:v>1.9993065397698049</c:v>
                </c:pt>
                <c:pt idx="1928">
                  <c:v>0.17242828118852296</c:v>
                </c:pt>
                <c:pt idx="1929">
                  <c:v>0.43722373119731989</c:v>
                </c:pt>
                <c:pt idx="1930">
                  <c:v>1.0387136357760181</c:v>
                </c:pt>
                <c:pt idx="1931">
                  <c:v>0.17720615055629307</c:v>
                </c:pt>
                <c:pt idx="1932">
                  <c:v>0.17367399443004974</c:v>
                </c:pt>
                <c:pt idx="1933">
                  <c:v>0.20005399523459036</c:v>
                </c:pt>
                <c:pt idx="1934">
                  <c:v>0.45022764837521667</c:v>
                </c:pt>
                <c:pt idx="1935">
                  <c:v>1.7115641564414915E-2</c:v>
                </c:pt>
                <c:pt idx="1936">
                  <c:v>1.6047066069244511</c:v>
                </c:pt>
                <c:pt idx="1937">
                  <c:v>1.0677731976654448</c:v>
                </c:pt>
                <c:pt idx="1938">
                  <c:v>0.91895529131341691</c:v>
                </c:pt>
                <c:pt idx="1939">
                  <c:v>1.2202129478128914</c:v>
                </c:pt>
                <c:pt idx="1940">
                  <c:v>2.87317406544376E-2</c:v>
                </c:pt>
                <c:pt idx="1941">
                  <c:v>0.35389270289037839</c:v>
                </c:pt>
                <c:pt idx="1942">
                  <c:v>1.0877579475310299</c:v>
                </c:pt>
                <c:pt idx="1943">
                  <c:v>0.12937409449318513</c:v>
                </c:pt>
                <c:pt idx="1944">
                  <c:v>3.4022460079612456E-3</c:v>
                </c:pt>
                <c:pt idx="1945">
                  <c:v>0.42099812776714873</c:v>
                </c:pt>
                <c:pt idx="1946">
                  <c:v>0.49306617324512864</c:v>
                </c:pt>
                <c:pt idx="1947">
                  <c:v>0.50256342942588728</c:v>
                </c:pt>
                <c:pt idx="1948">
                  <c:v>1.8624589421068132E-2</c:v>
                </c:pt>
                <c:pt idx="1949">
                  <c:v>1.0997691104021448</c:v>
                </c:pt>
                <c:pt idx="1950">
                  <c:v>4.494087115105342E-2</c:v>
                </c:pt>
                <c:pt idx="1951">
                  <c:v>1.7301277548865783</c:v>
                </c:pt>
                <c:pt idx="1952">
                  <c:v>0.35754922911915282</c:v>
                </c:pt>
                <c:pt idx="1953">
                  <c:v>0.54170974828900054</c:v>
                </c:pt>
                <c:pt idx="1954">
                  <c:v>0.51942938662207305</c:v>
                </c:pt>
                <c:pt idx="1955">
                  <c:v>0.46149497499918013</c:v>
                </c:pt>
                <c:pt idx="1956">
                  <c:v>0.84698450207476572</c:v>
                </c:pt>
                <c:pt idx="1957">
                  <c:v>0.71876076236385189</c:v>
                </c:pt>
                <c:pt idx="1958">
                  <c:v>0.59970224130935978</c:v>
                </c:pt>
                <c:pt idx="1959">
                  <c:v>0.50553858793388662</c:v>
                </c:pt>
                <c:pt idx="1960">
                  <c:v>1.0914043296654894</c:v>
                </c:pt>
                <c:pt idx="1961">
                  <c:v>1.0668599137791057</c:v>
                </c:pt>
                <c:pt idx="1962">
                  <c:v>0.14535458483577646</c:v>
                </c:pt>
                <c:pt idx="1963">
                  <c:v>2.253804721201949</c:v>
                </c:pt>
                <c:pt idx="1964">
                  <c:v>0.47915367487311089</c:v>
                </c:pt>
                <c:pt idx="1965">
                  <c:v>2.3766626419565805E-2</c:v>
                </c:pt>
                <c:pt idx="1966">
                  <c:v>1.8804245158292942E-2</c:v>
                </c:pt>
                <c:pt idx="1967">
                  <c:v>3.4693340209050759E-2</c:v>
                </c:pt>
                <c:pt idx="1968">
                  <c:v>0.55012045275781762</c:v>
                </c:pt>
                <c:pt idx="1969">
                  <c:v>0.67211116058234255</c:v>
                </c:pt>
                <c:pt idx="1970">
                  <c:v>0.36457332519671315</c:v>
                </c:pt>
                <c:pt idx="1971">
                  <c:v>0.45482180715703052</c:v>
                </c:pt>
                <c:pt idx="1972">
                  <c:v>0.29485580066310701</c:v>
                </c:pt>
                <c:pt idx="1973">
                  <c:v>0.13967024353931737</c:v>
                </c:pt>
                <c:pt idx="1974">
                  <c:v>0.24185167904400459</c:v>
                </c:pt>
                <c:pt idx="1975">
                  <c:v>9.9951403247379667E-2</c:v>
                </c:pt>
                <c:pt idx="1976">
                  <c:v>0.53181536537496088</c:v>
                </c:pt>
                <c:pt idx="1977">
                  <c:v>0.24798921025429901</c:v>
                </c:pt>
                <c:pt idx="1978">
                  <c:v>1.2398043808959627</c:v>
                </c:pt>
                <c:pt idx="1979">
                  <c:v>0.36817812682270418</c:v>
                </c:pt>
                <c:pt idx="1980">
                  <c:v>0.39664017721936728</c:v>
                </c:pt>
                <c:pt idx="1981">
                  <c:v>0.76547735614135859</c:v>
                </c:pt>
                <c:pt idx="1982">
                  <c:v>0.12473462013855499</c:v>
                </c:pt>
                <c:pt idx="1983">
                  <c:v>0.45000931646923942</c:v>
                </c:pt>
                <c:pt idx="1984">
                  <c:v>1.7189413678522392</c:v>
                </c:pt>
                <c:pt idx="1985">
                  <c:v>0.14895059750708298</c:v>
                </c:pt>
                <c:pt idx="1986">
                  <c:v>0.18456026726271019</c:v>
                </c:pt>
                <c:pt idx="1987">
                  <c:v>0.4399743151958051</c:v>
                </c:pt>
                <c:pt idx="1988">
                  <c:v>1.3958829921959774</c:v>
                </c:pt>
                <c:pt idx="1989">
                  <c:v>0.31180782769266557</c:v>
                </c:pt>
                <c:pt idx="1990">
                  <c:v>0.33972758348102861</c:v>
                </c:pt>
                <c:pt idx="1991">
                  <c:v>0.5551092648406537</c:v>
                </c:pt>
                <c:pt idx="1992">
                  <c:v>0.80885015572786834</c:v>
                </c:pt>
                <c:pt idx="1993">
                  <c:v>1.1935658829692624</c:v>
                </c:pt>
                <c:pt idx="1994">
                  <c:v>7.22641238332396E-3</c:v>
                </c:pt>
                <c:pt idx="1995">
                  <c:v>3.8045622124043761</c:v>
                </c:pt>
                <c:pt idx="1996">
                  <c:v>1.5139003148778745</c:v>
                </c:pt>
                <c:pt idx="1997">
                  <c:v>0.62744609366542325</c:v>
                </c:pt>
                <c:pt idx="1998">
                  <c:v>0.18070676844459163</c:v>
                </c:pt>
                <c:pt idx="1999">
                  <c:v>0.89941181786281743</c:v>
                </c:pt>
                <c:pt idx="2000">
                  <c:v>1.1046877190616471</c:v>
                </c:pt>
                <c:pt idx="2001">
                  <c:v>7.3116788418767439E-2</c:v>
                </c:pt>
                <c:pt idx="2002">
                  <c:v>2.3474419477292556E-2</c:v>
                </c:pt>
                <c:pt idx="2003">
                  <c:v>1.0522102184561191</c:v>
                </c:pt>
                <c:pt idx="2004">
                  <c:v>1.2080059058341404</c:v>
                </c:pt>
                <c:pt idx="2005">
                  <c:v>0.91188963723892358</c:v>
                </c:pt>
                <c:pt idx="2006">
                  <c:v>0.44963139195050861</c:v>
                </c:pt>
                <c:pt idx="2007">
                  <c:v>3.3063351418804059E-2</c:v>
                </c:pt>
                <c:pt idx="2008">
                  <c:v>0.1233325846963423</c:v>
                </c:pt>
                <c:pt idx="2009">
                  <c:v>0.23063060065702481</c:v>
                </c:pt>
                <c:pt idx="2010">
                  <c:v>0.74020212737719671</c:v>
                </c:pt>
                <c:pt idx="2011">
                  <c:v>1.2083985378267286</c:v>
                </c:pt>
                <c:pt idx="2012">
                  <c:v>0.24596096965047706</c:v>
                </c:pt>
                <c:pt idx="2013">
                  <c:v>0.79826311831982599</c:v>
                </c:pt>
                <c:pt idx="2014">
                  <c:v>0.54080979062358947</c:v>
                </c:pt>
                <c:pt idx="2015">
                  <c:v>0.73587694906677636</c:v>
                </c:pt>
                <c:pt idx="2016">
                  <c:v>0.88653886341862564</c:v>
                </c:pt>
                <c:pt idx="2017">
                  <c:v>0.44518244867514883</c:v>
                </c:pt>
                <c:pt idx="2018">
                  <c:v>0.4326260001610146</c:v>
                </c:pt>
                <c:pt idx="2019">
                  <c:v>0.97839732691901726</c:v>
                </c:pt>
                <c:pt idx="2020">
                  <c:v>8.7981683248060216E-2</c:v>
                </c:pt>
                <c:pt idx="2021">
                  <c:v>1.1075137855101536</c:v>
                </c:pt>
                <c:pt idx="2022">
                  <c:v>0.272348879094858</c:v>
                </c:pt>
                <c:pt idx="2023">
                  <c:v>8.688865695120325E-2</c:v>
                </c:pt>
                <c:pt idx="2024">
                  <c:v>1.494910196637712E-2</c:v>
                </c:pt>
                <c:pt idx="2025">
                  <c:v>0.50433165805814018</c:v>
                </c:pt>
                <c:pt idx="2026">
                  <c:v>0.12365418344138802</c:v>
                </c:pt>
                <c:pt idx="2027">
                  <c:v>0.13924318974723307</c:v>
                </c:pt>
                <c:pt idx="2028">
                  <c:v>0.50836825122853813</c:v>
                </c:pt>
                <c:pt idx="2029">
                  <c:v>3.2236223084062508E-2</c:v>
                </c:pt>
                <c:pt idx="2030">
                  <c:v>0.97958203535628607</c:v>
                </c:pt>
                <c:pt idx="2031">
                  <c:v>0.77069097369897055</c:v>
                </c:pt>
                <c:pt idx="2032">
                  <c:v>0.15456647539537535</c:v>
                </c:pt>
                <c:pt idx="2033">
                  <c:v>1.1411749648332496</c:v>
                </c:pt>
                <c:pt idx="2034">
                  <c:v>0.46565728004908657</c:v>
                </c:pt>
                <c:pt idx="2035">
                  <c:v>7.6882483479298366E-2</c:v>
                </c:pt>
                <c:pt idx="2036">
                  <c:v>1.7902905817657147</c:v>
                </c:pt>
                <c:pt idx="2037">
                  <c:v>0.73643559919019019</c:v>
                </c:pt>
                <c:pt idx="2038">
                  <c:v>9.7186995958771602E-2</c:v>
                </c:pt>
                <c:pt idx="2039">
                  <c:v>0.73047547629060672</c:v>
                </c:pt>
                <c:pt idx="2040">
                  <c:v>0.93369037465917171</c:v>
                </c:pt>
                <c:pt idx="2041">
                  <c:v>0.50858689198729123</c:v>
                </c:pt>
                <c:pt idx="2042">
                  <c:v>0.88863896877212323</c:v>
                </c:pt>
                <c:pt idx="2043">
                  <c:v>0.46278217223412593</c:v>
                </c:pt>
                <c:pt idx="2044">
                  <c:v>0.66246813820763562</c:v>
                </c:pt>
                <c:pt idx="2045">
                  <c:v>3.431156501635875E-2</c:v>
                </c:pt>
                <c:pt idx="2046">
                  <c:v>0.2144034872523066</c:v>
                </c:pt>
                <c:pt idx="2047">
                  <c:v>5.28339315189515E-3</c:v>
                </c:pt>
                <c:pt idx="2048">
                  <c:v>1.1509261673887239</c:v>
                </c:pt>
                <c:pt idx="2049">
                  <c:v>1.5796321048243773E-3</c:v>
                </c:pt>
                <c:pt idx="2050">
                  <c:v>0.19362643391927833</c:v>
                </c:pt>
                <c:pt idx="2051">
                  <c:v>0.24921286631187584</c:v>
                </c:pt>
                <c:pt idx="2052">
                  <c:v>0.64438536202832708</c:v>
                </c:pt>
                <c:pt idx="2053">
                  <c:v>0.28053358305438159</c:v>
                </c:pt>
                <c:pt idx="2054">
                  <c:v>3.416211325170166E-2</c:v>
                </c:pt>
                <c:pt idx="2055">
                  <c:v>0.12139988820684038</c:v>
                </c:pt>
                <c:pt idx="2056">
                  <c:v>0.24225768967919359</c:v>
                </c:pt>
                <c:pt idx="2057">
                  <c:v>0.50815873608055839</c:v>
                </c:pt>
                <c:pt idx="2058">
                  <c:v>0.89909262989923755</c:v>
                </c:pt>
                <c:pt idx="2059">
                  <c:v>0.6325343110147631</c:v>
                </c:pt>
                <c:pt idx="2060">
                  <c:v>0.6575145120442466</c:v>
                </c:pt>
                <c:pt idx="2061">
                  <c:v>0.42405595587743578</c:v>
                </c:pt>
                <c:pt idx="2062">
                  <c:v>0.17094094032598886</c:v>
                </c:pt>
                <c:pt idx="2063">
                  <c:v>1.2711648401580592E-2</c:v>
                </c:pt>
                <c:pt idx="2064">
                  <c:v>0.71332578971499505</c:v>
                </c:pt>
                <c:pt idx="2065">
                  <c:v>0.47610336189225533</c:v>
                </c:pt>
                <c:pt idx="2066">
                  <c:v>0.87852717891573617</c:v>
                </c:pt>
                <c:pt idx="2067">
                  <c:v>0.65828112058110255</c:v>
                </c:pt>
                <c:pt idx="2068">
                  <c:v>0.96394887924096306</c:v>
                </c:pt>
                <c:pt idx="2069">
                  <c:v>0.35627398009516675</c:v>
                </c:pt>
                <c:pt idx="2070">
                  <c:v>0.35405883883517869</c:v>
                </c:pt>
                <c:pt idx="2071">
                  <c:v>1.2972548742953751</c:v>
                </c:pt>
                <c:pt idx="2072">
                  <c:v>0.84597703269043922</c:v>
                </c:pt>
                <c:pt idx="2073">
                  <c:v>0.38688056801767412</c:v>
                </c:pt>
                <c:pt idx="2074">
                  <c:v>0.29287549959392639</c:v>
                </c:pt>
                <c:pt idx="2075">
                  <c:v>0.2549814424149881</c:v>
                </c:pt>
                <c:pt idx="2076">
                  <c:v>2.5008116906046087</c:v>
                </c:pt>
                <c:pt idx="2077">
                  <c:v>1.2361072134335631</c:v>
                </c:pt>
                <c:pt idx="2078">
                  <c:v>0.31789014253324416</c:v>
                </c:pt>
                <c:pt idx="2079">
                  <c:v>0.13990482199989041</c:v>
                </c:pt>
                <c:pt idx="2080">
                  <c:v>0.14558587003449164</c:v>
                </c:pt>
                <c:pt idx="2081">
                  <c:v>0.33218715770784635</c:v>
                </c:pt>
                <c:pt idx="2082">
                  <c:v>0.50629537487108922</c:v>
                </c:pt>
                <c:pt idx="2083">
                  <c:v>0.22373278168402883</c:v>
                </c:pt>
                <c:pt idx="2084">
                  <c:v>0.6888058257787123</c:v>
                </c:pt>
                <c:pt idx="2085">
                  <c:v>0.49186410577718592</c:v>
                </c:pt>
                <c:pt idx="2086">
                  <c:v>0.95566376464568337</c:v>
                </c:pt>
                <c:pt idx="2087">
                  <c:v>0.71234101078581891</c:v>
                </c:pt>
                <c:pt idx="2088">
                  <c:v>0.13301301978780891</c:v>
                </c:pt>
                <c:pt idx="2089">
                  <c:v>1.1165205264045832</c:v>
                </c:pt>
                <c:pt idx="2090">
                  <c:v>0.76761844442991733</c:v>
                </c:pt>
                <c:pt idx="2091">
                  <c:v>0.94942377643109965</c:v>
                </c:pt>
                <c:pt idx="2092">
                  <c:v>0.8284813461151892</c:v>
                </c:pt>
                <c:pt idx="2093">
                  <c:v>0.61567898087098349</c:v>
                </c:pt>
                <c:pt idx="2094">
                  <c:v>1.700633371762335</c:v>
                </c:pt>
                <c:pt idx="2095">
                  <c:v>6.918877211901471E-2</c:v>
                </c:pt>
                <c:pt idx="2096">
                  <c:v>0.69764449625016034</c:v>
                </c:pt>
                <c:pt idx="2097">
                  <c:v>0.11916223276363486</c:v>
                </c:pt>
                <c:pt idx="2098">
                  <c:v>0.7500939756817494</c:v>
                </c:pt>
                <c:pt idx="2099">
                  <c:v>0.85705402065757474</c:v>
                </c:pt>
                <c:pt idx="2100">
                  <c:v>4.582187600620078E-2</c:v>
                </c:pt>
                <c:pt idx="2101">
                  <c:v>0.36055997714771798</c:v>
                </c:pt>
                <c:pt idx="2102">
                  <c:v>0.15377478268746317</c:v>
                </c:pt>
                <c:pt idx="2103">
                  <c:v>0.46399222398490647</c:v>
                </c:pt>
                <c:pt idx="2104">
                  <c:v>0.33410090010616045</c:v>
                </c:pt>
                <c:pt idx="2105">
                  <c:v>0.27322907742257646</c:v>
                </c:pt>
                <c:pt idx="2106">
                  <c:v>1.0440095392277471</c:v>
                </c:pt>
                <c:pt idx="2107">
                  <c:v>1.2132879249550099</c:v>
                </c:pt>
                <c:pt idx="2108">
                  <c:v>9.9582420314705655E-2</c:v>
                </c:pt>
                <c:pt idx="2109">
                  <c:v>0.98223443173716007</c:v>
                </c:pt>
                <c:pt idx="2110">
                  <c:v>0.48738513883844564</c:v>
                </c:pt>
                <c:pt idx="2111">
                  <c:v>1.1305087923948667</c:v>
                </c:pt>
                <c:pt idx="2112">
                  <c:v>0.19498251391252056</c:v>
                </c:pt>
                <c:pt idx="2113">
                  <c:v>0.64725102350887487</c:v>
                </c:pt>
                <c:pt idx="2114">
                  <c:v>0.73889715693541169</c:v>
                </c:pt>
                <c:pt idx="2115">
                  <c:v>0.26249522210826287</c:v>
                </c:pt>
                <c:pt idx="2116">
                  <c:v>0.36782341540970692</c:v>
                </c:pt>
                <c:pt idx="2117">
                  <c:v>3.4652632113390251E-2</c:v>
                </c:pt>
                <c:pt idx="2118">
                  <c:v>0.41985032473684702</c:v>
                </c:pt>
                <c:pt idx="2119">
                  <c:v>0.64766649477357774</c:v>
                </c:pt>
                <c:pt idx="2120">
                  <c:v>0.7621221663463974</c:v>
                </c:pt>
                <c:pt idx="2121">
                  <c:v>0.58489295793646368</c:v>
                </c:pt>
                <c:pt idx="2122">
                  <c:v>1.8814992072836525</c:v>
                </c:pt>
                <c:pt idx="2123">
                  <c:v>0.46935905457065086</c:v>
                </c:pt>
                <c:pt idx="2124">
                  <c:v>0.44639093397836743</c:v>
                </c:pt>
                <c:pt idx="2125">
                  <c:v>0.18936232200489383</c:v>
                </c:pt>
                <c:pt idx="2126">
                  <c:v>7.3172262836733379E-2</c:v>
                </c:pt>
                <c:pt idx="2127">
                  <c:v>0.41930732806033139</c:v>
                </c:pt>
                <c:pt idx="2128">
                  <c:v>7.7551532369602175E-2</c:v>
                </c:pt>
                <c:pt idx="2129">
                  <c:v>0.3989209548858299</c:v>
                </c:pt>
                <c:pt idx="2130">
                  <c:v>1.2925857364009032</c:v>
                </c:pt>
                <c:pt idx="2131">
                  <c:v>0.42001988870485713</c:v>
                </c:pt>
                <c:pt idx="2132">
                  <c:v>0.81224626625842899</c:v>
                </c:pt>
                <c:pt idx="2133">
                  <c:v>0.2715876283755842</c:v>
                </c:pt>
                <c:pt idx="2134">
                  <c:v>4.7240072301268067E-2</c:v>
                </c:pt>
                <c:pt idx="2135">
                  <c:v>0.67355403108601342</c:v>
                </c:pt>
                <c:pt idx="2136">
                  <c:v>0.24996528440913385</c:v>
                </c:pt>
                <c:pt idx="2137">
                  <c:v>0.60067374266713058</c:v>
                </c:pt>
                <c:pt idx="2138">
                  <c:v>0.81608753628870978</c:v>
                </c:pt>
                <c:pt idx="2139">
                  <c:v>1.9454067026820038E-2</c:v>
                </c:pt>
                <c:pt idx="2140">
                  <c:v>0.41422029282914974</c:v>
                </c:pt>
                <c:pt idx="2141">
                  <c:v>0.58721335255273599</c:v>
                </c:pt>
                <c:pt idx="2142">
                  <c:v>0.45569495677840616</c:v>
                </c:pt>
                <c:pt idx="2143">
                  <c:v>0.14018844749205281</c:v>
                </c:pt>
                <c:pt idx="2144">
                  <c:v>3.9316439553121682E-3</c:v>
                </c:pt>
                <c:pt idx="2145">
                  <c:v>0.77514210421217455</c:v>
                </c:pt>
                <c:pt idx="2146">
                  <c:v>0.83509086466584981</c:v>
                </c:pt>
                <c:pt idx="2147">
                  <c:v>0.52410562315623899</c:v>
                </c:pt>
                <c:pt idx="2148">
                  <c:v>2.6450691748501773E-2</c:v>
                </c:pt>
                <c:pt idx="2149">
                  <c:v>1.0579464517737944</c:v>
                </c:pt>
                <c:pt idx="2150">
                  <c:v>0.10011750904330198</c:v>
                </c:pt>
                <c:pt idx="2151">
                  <c:v>0.53127504578916696</c:v>
                </c:pt>
                <c:pt idx="2152">
                  <c:v>0.20478273658453666</c:v>
                </c:pt>
                <c:pt idx="2153">
                  <c:v>1.1324702872356296</c:v>
                </c:pt>
                <c:pt idx="2154">
                  <c:v>1.571650655495642</c:v>
                </c:pt>
                <c:pt idx="2155">
                  <c:v>0.1892763638617338</c:v>
                </c:pt>
                <c:pt idx="2156">
                  <c:v>0.10090153363918471</c:v>
                </c:pt>
                <c:pt idx="2157">
                  <c:v>1.2140197165741906</c:v>
                </c:pt>
                <c:pt idx="2158">
                  <c:v>0.85868301640635059</c:v>
                </c:pt>
                <c:pt idx="2159">
                  <c:v>0.92227117961444571</c:v>
                </c:pt>
                <c:pt idx="2160">
                  <c:v>1.8210147192918928</c:v>
                </c:pt>
                <c:pt idx="2161">
                  <c:v>0.32415973757437916</c:v>
                </c:pt>
                <c:pt idx="2162">
                  <c:v>1.2672253074443312</c:v>
                </c:pt>
                <c:pt idx="2163">
                  <c:v>1.3094555796084201E-2</c:v>
                </c:pt>
                <c:pt idx="2164">
                  <c:v>0.37176776344508411</c:v>
                </c:pt>
                <c:pt idx="2165">
                  <c:v>6.2763091639371021E-2</c:v>
                </c:pt>
                <c:pt idx="2166">
                  <c:v>0.68674367659935098</c:v>
                </c:pt>
                <c:pt idx="2167">
                  <c:v>0.32742460419731634</c:v>
                </c:pt>
                <c:pt idx="2168">
                  <c:v>0.40033757862763319</c:v>
                </c:pt>
                <c:pt idx="2169">
                  <c:v>0.73064237166737767</c:v>
                </c:pt>
                <c:pt idx="2170">
                  <c:v>2.9252807535671589E-2</c:v>
                </c:pt>
                <c:pt idx="2171">
                  <c:v>0.63205567688009012</c:v>
                </c:pt>
                <c:pt idx="2172">
                  <c:v>0.59093813346072577</c:v>
                </c:pt>
                <c:pt idx="2173">
                  <c:v>0.84900769717560254</c:v>
                </c:pt>
                <c:pt idx="2174">
                  <c:v>0.92290832342649265</c:v>
                </c:pt>
                <c:pt idx="2175">
                  <c:v>8.8194222266373912E-2</c:v>
                </c:pt>
                <c:pt idx="2176">
                  <c:v>0.66766591997024294</c:v>
                </c:pt>
                <c:pt idx="2177">
                  <c:v>5.6767055510442581E-2</c:v>
                </c:pt>
                <c:pt idx="2178">
                  <c:v>0.30013293657421469</c:v>
                </c:pt>
                <c:pt idx="2179">
                  <c:v>0.22131162454785547</c:v>
                </c:pt>
                <c:pt idx="2180">
                  <c:v>0.953703736484665</c:v>
                </c:pt>
                <c:pt idx="2181">
                  <c:v>0.35053066476533307</c:v>
                </c:pt>
                <c:pt idx="2182">
                  <c:v>0.59456578069503863</c:v>
                </c:pt>
                <c:pt idx="2183">
                  <c:v>1.345107447023054</c:v>
                </c:pt>
                <c:pt idx="2184">
                  <c:v>0.44587488611219533</c:v>
                </c:pt>
                <c:pt idx="2185">
                  <c:v>2.8301890621634691E-2</c:v>
                </c:pt>
                <c:pt idx="2186">
                  <c:v>1.1297506556298276</c:v>
                </c:pt>
                <c:pt idx="2187">
                  <c:v>1.2293494459564742</c:v>
                </c:pt>
                <c:pt idx="2188">
                  <c:v>0.49512068231728096</c:v>
                </c:pt>
                <c:pt idx="2189">
                  <c:v>0.22386469143994922</c:v>
                </c:pt>
                <c:pt idx="2190">
                  <c:v>2.2428464977489543E-2</c:v>
                </c:pt>
                <c:pt idx="2191">
                  <c:v>9.6003941265329407E-2</c:v>
                </c:pt>
                <c:pt idx="2192">
                  <c:v>0.27443841569300076</c:v>
                </c:pt>
                <c:pt idx="2193">
                  <c:v>0.36457475087540209</c:v>
                </c:pt>
                <c:pt idx="2194">
                  <c:v>8.9731482050871877E-2</c:v>
                </c:pt>
                <c:pt idx="2195">
                  <c:v>0.10151673738493278</c:v>
                </c:pt>
                <c:pt idx="2196">
                  <c:v>0.37793960553079048</c:v>
                </c:pt>
                <c:pt idx="2197">
                  <c:v>0.19613425579325158</c:v>
                </c:pt>
                <c:pt idx="2198">
                  <c:v>0.54776403165919152</c:v>
                </c:pt>
                <c:pt idx="2199">
                  <c:v>0.42882849867176476</c:v>
                </c:pt>
                <c:pt idx="2200">
                  <c:v>0.8294229853610624</c:v>
                </c:pt>
                <c:pt idx="2201">
                  <c:v>3.0083484030245237E-2</c:v>
                </c:pt>
                <c:pt idx="2202">
                  <c:v>0.22901191502609008</c:v>
                </c:pt>
                <c:pt idx="2203">
                  <c:v>0.31025871342546274</c:v>
                </c:pt>
                <c:pt idx="2204">
                  <c:v>0.22193491378493424</c:v>
                </c:pt>
                <c:pt idx="2205">
                  <c:v>0.76084773105041104</c:v>
                </c:pt>
                <c:pt idx="2206">
                  <c:v>0.25193852168672609</c:v>
                </c:pt>
                <c:pt idx="2207">
                  <c:v>0.48562598436162946</c:v>
                </c:pt>
                <c:pt idx="2208">
                  <c:v>0.33694862565919809</c:v>
                </c:pt>
                <c:pt idx="2209">
                  <c:v>0.16001842599595517</c:v>
                </c:pt>
                <c:pt idx="2210">
                  <c:v>0.38762554630577939</c:v>
                </c:pt>
                <c:pt idx="2211">
                  <c:v>0.36761500560622301</c:v>
                </c:pt>
                <c:pt idx="2212">
                  <c:v>0.42384004919798579</c:v>
                </c:pt>
                <c:pt idx="2213">
                  <c:v>1.2267104815159278</c:v>
                </c:pt>
                <c:pt idx="2214">
                  <c:v>0.42849150555823995</c:v>
                </c:pt>
                <c:pt idx="2215">
                  <c:v>2.7861871622842553</c:v>
                </c:pt>
                <c:pt idx="2216">
                  <c:v>7.9880493650476905E-2</c:v>
                </c:pt>
                <c:pt idx="2217">
                  <c:v>0.33193023642586378</c:v>
                </c:pt>
                <c:pt idx="2218">
                  <c:v>0.57348782930995379</c:v>
                </c:pt>
                <c:pt idx="2219">
                  <c:v>0.13052149760156467</c:v>
                </c:pt>
                <c:pt idx="2220">
                  <c:v>0.3692827632226065</c:v>
                </c:pt>
                <c:pt idx="2221">
                  <c:v>0.23829582387309178</c:v>
                </c:pt>
                <c:pt idx="2222">
                  <c:v>3.0886076824998519E-2</c:v>
                </c:pt>
                <c:pt idx="2223">
                  <c:v>0.76900338611300278</c:v>
                </c:pt>
                <c:pt idx="2224">
                  <c:v>0.93267945517707218</c:v>
                </c:pt>
                <c:pt idx="2225">
                  <c:v>1.7021950189221704E-3</c:v>
                </c:pt>
                <c:pt idx="2226">
                  <c:v>0.51269278289055131</c:v>
                </c:pt>
                <c:pt idx="2227">
                  <c:v>0.89744323585665664</c:v>
                </c:pt>
                <c:pt idx="2228">
                  <c:v>0.36480349929142031</c:v>
                </c:pt>
                <c:pt idx="2229">
                  <c:v>0.31217846382542269</c:v>
                </c:pt>
                <c:pt idx="2230">
                  <c:v>0.25281311582456784</c:v>
                </c:pt>
                <c:pt idx="2231">
                  <c:v>1.723840627561948</c:v>
                </c:pt>
                <c:pt idx="2232">
                  <c:v>0.24957132249679698</c:v>
                </c:pt>
                <c:pt idx="2233">
                  <c:v>0.36506376782177291</c:v>
                </c:pt>
                <c:pt idx="2234">
                  <c:v>0.8323127922903828</c:v>
                </c:pt>
                <c:pt idx="2235">
                  <c:v>0.27108335514099641</c:v>
                </c:pt>
                <c:pt idx="2236">
                  <c:v>0.36433482771174364</c:v>
                </c:pt>
                <c:pt idx="2237">
                  <c:v>0.5842236773151418</c:v>
                </c:pt>
                <c:pt idx="2238">
                  <c:v>7.2998889100874806E-2</c:v>
                </c:pt>
                <c:pt idx="2239">
                  <c:v>0.67015601658123458</c:v>
                </c:pt>
                <c:pt idx="2240">
                  <c:v>1.0892994224897112</c:v>
                </c:pt>
                <c:pt idx="2241">
                  <c:v>0.11444893936911459</c:v>
                </c:pt>
                <c:pt idx="2242">
                  <c:v>0.14371832106964694</c:v>
                </c:pt>
                <c:pt idx="2243">
                  <c:v>0.26319720845285954</c:v>
                </c:pt>
                <c:pt idx="2244">
                  <c:v>0.17872482912355384</c:v>
                </c:pt>
                <c:pt idx="2245">
                  <c:v>0.42541560597094419</c:v>
                </c:pt>
                <c:pt idx="2246">
                  <c:v>0.13091113703067564</c:v>
                </c:pt>
                <c:pt idx="2247">
                  <c:v>0.52819674802139049</c:v>
                </c:pt>
                <c:pt idx="2248">
                  <c:v>0.79656350634191619</c:v>
                </c:pt>
                <c:pt idx="2249">
                  <c:v>0.29422804682393139</c:v>
                </c:pt>
                <c:pt idx="2250">
                  <c:v>0.1123139086764605</c:v>
                </c:pt>
                <c:pt idx="2251">
                  <c:v>0.34345200006668797</c:v>
                </c:pt>
                <c:pt idx="2252">
                  <c:v>0.35999020155780626</c:v>
                </c:pt>
                <c:pt idx="2253">
                  <c:v>1.9243422039071711</c:v>
                </c:pt>
                <c:pt idx="2254">
                  <c:v>0.31626679534795993</c:v>
                </c:pt>
                <c:pt idx="2255">
                  <c:v>0.38461224804670674</c:v>
                </c:pt>
                <c:pt idx="2256">
                  <c:v>0.11438239893906486</c:v>
                </c:pt>
                <c:pt idx="2257">
                  <c:v>0.49256567200462575</c:v>
                </c:pt>
                <c:pt idx="2258">
                  <c:v>9.5731943668459862E-4</c:v>
                </c:pt>
                <c:pt idx="2259">
                  <c:v>0.3340491156337676</c:v>
                </c:pt>
                <c:pt idx="2260">
                  <c:v>0.32472312484888199</c:v>
                </c:pt>
                <c:pt idx="2261">
                  <c:v>0.17289300957600415</c:v>
                </c:pt>
                <c:pt idx="2262">
                  <c:v>0.29759888497973092</c:v>
                </c:pt>
                <c:pt idx="2263">
                  <c:v>0.36534913017881504</c:v>
                </c:pt>
                <c:pt idx="2264">
                  <c:v>0.76942427820073456</c:v>
                </c:pt>
                <c:pt idx="2265">
                  <c:v>0.12144731186270019</c:v>
                </c:pt>
                <c:pt idx="2266">
                  <c:v>2.2720615542290155</c:v>
                </c:pt>
                <c:pt idx="2267">
                  <c:v>0.45166636256319709</c:v>
                </c:pt>
                <c:pt idx="2268">
                  <c:v>0.17758269528747112</c:v>
                </c:pt>
                <c:pt idx="2269">
                  <c:v>0.48191539405236183</c:v>
                </c:pt>
                <c:pt idx="2270">
                  <c:v>0.22134018609947251</c:v>
                </c:pt>
                <c:pt idx="2271">
                  <c:v>0.44053929087626781</c:v>
                </c:pt>
                <c:pt idx="2272">
                  <c:v>1.0596699985791938</c:v>
                </c:pt>
                <c:pt idx="2273">
                  <c:v>0.9908492385010732</c:v>
                </c:pt>
                <c:pt idx="2274">
                  <c:v>0.37226302548660861</c:v>
                </c:pt>
                <c:pt idx="2275">
                  <c:v>0.22050827981662161</c:v>
                </c:pt>
                <c:pt idx="2276">
                  <c:v>5.0158832220876116E-2</c:v>
                </c:pt>
                <c:pt idx="2277">
                  <c:v>5.3788890227237866E-2</c:v>
                </c:pt>
                <c:pt idx="2278">
                  <c:v>0.54183000539476611</c:v>
                </c:pt>
                <c:pt idx="2279">
                  <c:v>0.45652878058047636</c:v>
                </c:pt>
                <c:pt idx="2280">
                  <c:v>0.5126370920189367</c:v>
                </c:pt>
                <c:pt idx="2281">
                  <c:v>0.31534607981315949</c:v>
                </c:pt>
                <c:pt idx="2282">
                  <c:v>0.84109945764210503</c:v>
                </c:pt>
                <c:pt idx="2283">
                  <c:v>0.30266972337484738</c:v>
                </c:pt>
                <c:pt idx="2284">
                  <c:v>1.6689573410838898</c:v>
                </c:pt>
                <c:pt idx="2285">
                  <c:v>0.71989526116587321</c:v>
                </c:pt>
                <c:pt idx="2286">
                  <c:v>4.9427078604706937E-2</c:v>
                </c:pt>
                <c:pt idx="2287">
                  <c:v>1.0193929361820249</c:v>
                </c:pt>
                <c:pt idx="2288">
                  <c:v>0.104121522548889</c:v>
                </c:pt>
                <c:pt idx="2289">
                  <c:v>0.64822054809887153</c:v>
                </c:pt>
                <c:pt idx="2290">
                  <c:v>1.8044555163971637E-3</c:v>
                </c:pt>
                <c:pt idx="2291">
                  <c:v>0.43753216560550362</c:v>
                </c:pt>
                <c:pt idx="2292">
                  <c:v>0.65998299320110276</c:v>
                </c:pt>
                <c:pt idx="2293">
                  <c:v>0.84670355432971223</c:v>
                </c:pt>
                <c:pt idx="2294">
                  <c:v>0.29705187881680378</c:v>
                </c:pt>
                <c:pt idx="2295">
                  <c:v>0.49180757982885193</c:v>
                </c:pt>
                <c:pt idx="2296">
                  <c:v>0.33447183142727338</c:v>
                </c:pt>
                <c:pt idx="2297">
                  <c:v>7.7728399302647619E-2</c:v>
                </c:pt>
                <c:pt idx="2298">
                  <c:v>0.82686438689117836</c:v>
                </c:pt>
                <c:pt idx="2299">
                  <c:v>0.42514651591364422</c:v>
                </c:pt>
                <c:pt idx="2300">
                  <c:v>0.68368292105032591</c:v>
                </c:pt>
                <c:pt idx="2301">
                  <c:v>0.2579724641485443</c:v>
                </c:pt>
                <c:pt idx="2302">
                  <c:v>1.9610540025465509E-3</c:v>
                </c:pt>
                <c:pt idx="2303">
                  <c:v>0.72957614665305548</c:v>
                </c:pt>
                <c:pt idx="2304">
                  <c:v>0.18932735746083371</c:v>
                </c:pt>
                <c:pt idx="2305">
                  <c:v>0.92800376649614424</c:v>
                </c:pt>
                <c:pt idx="2306">
                  <c:v>0.32963498073300451</c:v>
                </c:pt>
                <c:pt idx="2307">
                  <c:v>0.73624882166409567</c:v>
                </c:pt>
                <c:pt idx="2308">
                  <c:v>1.1747446772695442E-2</c:v>
                </c:pt>
                <c:pt idx="2309">
                  <c:v>3.04759736075874E-2</c:v>
                </c:pt>
                <c:pt idx="2310">
                  <c:v>0.31406626160354234</c:v>
                </c:pt>
                <c:pt idx="2311">
                  <c:v>0.88786497246872842</c:v>
                </c:pt>
                <c:pt idx="2312">
                  <c:v>2.2335687174290233</c:v>
                </c:pt>
                <c:pt idx="2313">
                  <c:v>0.14757380445356102</c:v>
                </c:pt>
                <c:pt idx="2314">
                  <c:v>1.2589050324739295</c:v>
                </c:pt>
                <c:pt idx="2315">
                  <c:v>0.40873416961775361</c:v>
                </c:pt>
                <c:pt idx="2316">
                  <c:v>0.98483542454257078</c:v>
                </c:pt>
                <c:pt idx="2317">
                  <c:v>0.40808953867584824</c:v>
                </c:pt>
                <c:pt idx="2318">
                  <c:v>0.32786447373445032</c:v>
                </c:pt>
                <c:pt idx="2319">
                  <c:v>1.0573438111583575</c:v>
                </c:pt>
                <c:pt idx="2320">
                  <c:v>0.40169097600453763</c:v>
                </c:pt>
                <c:pt idx="2321">
                  <c:v>0.71044176991350838</c:v>
                </c:pt>
                <c:pt idx="2322">
                  <c:v>0.14750658795971128</c:v>
                </c:pt>
                <c:pt idx="2323">
                  <c:v>0.73974039441519679</c:v>
                </c:pt>
                <c:pt idx="2324">
                  <c:v>1.4112634839736493</c:v>
                </c:pt>
                <c:pt idx="2325">
                  <c:v>7.7501504556598641E-2</c:v>
                </c:pt>
                <c:pt idx="2326">
                  <c:v>0.35463937644864396</c:v>
                </c:pt>
                <c:pt idx="2327">
                  <c:v>0.24093175240050385</c:v>
                </c:pt>
                <c:pt idx="2328">
                  <c:v>0.91342626745028921</c:v>
                </c:pt>
                <c:pt idx="2329">
                  <c:v>0.64211149232067355</c:v>
                </c:pt>
                <c:pt idx="2330">
                  <c:v>1.2635456588075078</c:v>
                </c:pt>
                <c:pt idx="2331">
                  <c:v>0.23545391720228412</c:v>
                </c:pt>
                <c:pt idx="2332">
                  <c:v>2.6487667653381539E-2</c:v>
                </c:pt>
                <c:pt idx="2333">
                  <c:v>0.83765243591961358</c:v>
                </c:pt>
                <c:pt idx="2334">
                  <c:v>0.12635279141478892</c:v>
                </c:pt>
                <c:pt idx="2335">
                  <c:v>5.779807890135237E-2</c:v>
                </c:pt>
                <c:pt idx="2336">
                  <c:v>0.19155635308304142</c:v>
                </c:pt>
                <c:pt idx="2337">
                  <c:v>1.1498809848199361</c:v>
                </c:pt>
                <c:pt idx="2338">
                  <c:v>0.26947713076535279</c:v>
                </c:pt>
                <c:pt idx="2339">
                  <c:v>0.17326785325214997</c:v>
                </c:pt>
                <c:pt idx="2340">
                  <c:v>1.1075087111683439</c:v>
                </c:pt>
                <c:pt idx="2341">
                  <c:v>0.19174828864159663</c:v>
                </c:pt>
                <c:pt idx="2342">
                  <c:v>4.2439553178767221E-2</c:v>
                </c:pt>
                <c:pt idx="2343">
                  <c:v>0.34513476248071667</c:v>
                </c:pt>
                <c:pt idx="2344">
                  <c:v>1.0852184174010113</c:v>
                </c:pt>
                <c:pt idx="2345">
                  <c:v>0.38176173974367072</c:v>
                </c:pt>
                <c:pt idx="2346">
                  <c:v>1.4149875559802934</c:v>
                </c:pt>
                <c:pt idx="2347">
                  <c:v>1.2511726810872676</c:v>
                </c:pt>
                <c:pt idx="2348">
                  <c:v>0.22521923646337341</c:v>
                </c:pt>
                <c:pt idx="2349">
                  <c:v>0.62965177301447695</c:v>
                </c:pt>
                <c:pt idx="2350">
                  <c:v>0.36335083284410474</c:v>
                </c:pt>
                <c:pt idx="2351">
                  <c:v>0.83515942271480292</c:v>
                </c:pt>
                <c:pt idx="2352">
                  <c:v>0.1738113770774789</c:v>
                </c:pt>
                <c:pt idx="2353">
                  <c:v>0.34307925726750349</c:v>
                </c:pt>
                <c:pt idx="2354">
                  <c:v>0.44871156443423293</c:v>
                </c:pt>
                <c:pt idx="2355">
                  <c:v>8.8282734562509305E-2</c:v>
                </c:pt>
                <c:pt idx="2356">
                  <c:v>0.74529087678325789</c:v>
                </c:pt>
                <c:pt idx="2357">
                  <c:v>4.5814950391437889E-2</c:v>
                </c:pt>
                <c:pt idx="2358">
                  <c:v>0.21625674917486276</c:v>
                </c:pt>
                <c:pt idx="2359">
                  <c:v>0.41505065444333833</c:v>
                </c:pt>
                <c:pt idx="2360">
                  <c:v>0.19584977013744356</c:v>
                </c:pt>
                <c:pt idx="2361">
                  <c:v>7.4117643097153824E-2</c:v>
                </c:pt>
                <c:pt idx="2362">
                  <c:v>0.54485718399803529</c:v>
                </c:pt>
                <c:pt idx="2363">
                  <c:v>0.13546172423383263</c:v>
                </c:pt>
                <c:pt idx="2364">
                  <c:v>0.47587281936507825</c:v>
                </c:pt>
                <c:pt idx="2365">
                  <c:v>1.0131740351730147E-2</c:v>
                </c:pt>
                <c:pt idx="2366">
                  <c:v>0.17974975360444612</c:v>
                </c:pt>
                <c:pt idx="2367">
                  <c:v>9.1597686660048847E-2</c:v>
                </c:pt>
                <c:pt idx="2368">
                  <c:v>1.5814659992555931</c:v>
                </c:pt>
                <c:pt idx="2369">
                  <c:v>6.2326299699420877E-2</c:v>
                </c:pt>
                <c:pt idx="2370">
                  <c:v>0.16724591892844676</c:v>
                </c:pt>
                <c:pt idx="2371">
                  <c:v>2.3239697239558373E-2</c:v>
                </c:pt>
                <c:pt idx="2372">
                  <c:v>0.25844279320854269</c:v>
                </c:pt>
                <c:pt idx="2373">
                  <c:v>0.44951752510224841</c:v>
                </c:pt>
                <c:pt idx="2374">
                  <c:v>0.88720051341705108</c:v>
                </c:pt>
                <c:pt idx="2375">
                  <c:v>0.88162190187702338</c:v>
                </c:pt>
                <c:pt idx="2376">
                  <c:v>0.82970879968630173</c:v>
                </c:pt>
                <c:pt idx="2377">
                  <c:v>1.092045032305238</c:v>
                </c:pt>
                <c:pt idx="2378">
                  <c:v>0.13419801128474518</c:v>
                </c:pt>
                <c:pt idx="2379">
                  <c:v>0.41563571604458244</c:v>
                </c:pt>
                <c:pt idx="2380">
                  <c:v>1.8265845055731849E-3</c:v>
                </c:pt>
                <c:pt idx="2381">
                  <c:v>0.217212735385998</c:v>
                </c:pt>
                <c:pt idx="2382">
                  <c:v>0.33723807379661391</c:v>
                </c:pt>
                <c:pt idx="2383">
                  <c:v>6.5630409600733408E-2</c:v>
                </c:pt>
                <c:pt idx="2384">
                  <c:v>6.6902674721338587E-3</c:v>
                </c:pt>
                <c:pt idx="2385">
                  <c:v>1.3423795975907926</c:v>
                </c:pt>
                <c:pt idx="2386">
                  <c:v>0.30861870488128507</c:v>
                </c:pt>
                <c:pt idx="2387">
                  <c:v>7.4254098177950381E-2</c:v>
                </c:pt>
                <c:pt idx="2388">
                  <c:v>0.85670985908660902</c:v>
                </c:pt>
                <c:pt idx="2389">
                  <c:v>0.21446756915483142</c:v>
                </c:pt>
                <c:pt idx="2390">
                  <c:v>0.83434238522876558</c:v>
                </c:pt>
                <c:pt idx="2391">
                  <c:v>0.43920924600621264</c:v>
                </c:pt>
                <c:pt idx="2392">
                  <c:v>0.15828885295695469</c:v>
                </c:pt>
                <c:pt idx="2393">
                  <c:v>4.9612973499058487E-2</c:v>
                </c:pt>
                <c:pt idx="2394">
                  <c:v>0.1946291090217725</c:v>
                </c:pt>
                <c:pt idx="2395">
                  <c:v>0.14739798264419179</c:v>
                </c:pt>
                <c:pt idx="2396">
                  <c:v>1.0051424278748102</c:v>
                </c:pt>
                <c:pt idx="2397">
                  <c:v>9.8483339046537902E-2</c:v>
                </c:pt>
                <c:pt idx="2398">
                  <c:v>0.68548841971788932</c:v>
                </c:pt>
                <c:pt idx="2399">
                  <c:v>1.745096609964961E-2</c:v>
                </c:pt>
                <c:pt idx="2400">
                  <c:v>0.35856709441063023</c:v>
                </c:pt>
                <c:pt idx="2401">
                  <c:v>7.3050510801344878E-2</c:v>
                </c:pt>
                <c:pt idx="2402">
                  <c:v>0.24025660759958498</c:v>
                </c:pt>
                <c:pt idx="2403">
                  <c:v>0.44643695445527071</c:v>
                </c:pt>
                <c:pt idx="2404">
                  <c:v>0.50525076210014641</c:v>
                </c:pt>
                <c:pt idx="2405">
                  <c:v>0.63206772206333595</c:v>
                </c:pt>
                <c:pt idx="2406">
                  <c:v>1.1278529762505176</c:v>
                </c:pt>
                <c:pt idx="2407">
                  <c:v>0.66894878360856025</c:v>
                </c:pt>
                <c:pt idx="2408">
                  <c:v>0.68885822512514494</c:v>
                </c:pt>
                <c:pt idx="2409">
                  <c:v>1.2696455734982428</c:v>
                </c:pt>
                <c:pt idx="2410">
                  <c:v>0.26576738006378658</c:v>
                </c:pt>
                <c:pt idx="2411">
                  <c:v>3.4166975671647767E-2</c:v>
                </c:pt>
                <c:pt idx="2412">
                  <c:v>0.31983564968593642</c:v>
                </c:pt>
                <c:pt idx="2413">
                  <c:v>0.3432667186450854</c:v>
                </c:pt>
                <c:pt idx="2414">
                  <c:v>0.73327087170814442</c:v>
                </c:pt>
                <c:pt idx="2415">
                  <c:v>0.4108929310297062</c:v>
                </c:pt>
                <c:pt idx="2416">
                  <c:v>0.94219089937063083</c:v>
                </c:pt>
                <c:pt idx="2417">
                  <c:v>1.1012398073161591</c:v>
                </c:pt>
                <c:pt idx="2418">
                  <c:v>1.5799639274697146</c:v>
                </c:pt>
                <c:pt idx="2419">
                  <c:v>0.91975178768715593</c:v>
                </c:pt>
                <c:pt idx="2420">
                  <c:v>1.2714432124149375</c:v>
                </c:pt>
                <c:pt idx="2421">
                  <c:v>0.59339337841714723</c:v>
                </c:pt>
                <c:pt idx="2422">
                  <c:v>8.268195718331324E-2</c:v>
                </c:pt>
                <c:pt idx="2423">
                  <c:v>0.29710994105816979</c:v>
                </c:pt>
                <c:pt idx="2424">
                  <c:v>0.29545636518770507</c:v>
                </c:pt>
                <c:pt idx="2425">
                  <c:v>1.9712005660554831E-2</c:v>
                </c:pt>
                <c:pt idx="2426">
                  <c:v>0.31967330005223937</c:v>
                </c:pt>
                <c:pt idx="2427">
                  <c:v>0.16042066945529579</c:v>
                </c:pt>
                <c:pt idx="2428">
                  <c:v>2.7880132305306556E-2</c:v>
                </c:pt>
                <c:pt idx="2429">
                  <c:v>1.2544137512936671</c:v>
                </c:pt>
                <c:pt idx="2430">
                  <c:v>0.10782114880465012</c:v>
                </c:pt>
                <c:pt idx="2431">
                  <c:v>0.425334291815959</c:v>
                </c:pt>
                <c:pt idx="2432">
                  <c:v>0.12490574147478058</c:v>
                </c:pt>
                <c:pt idx="2433">
                  <c:v>0.50810625052934477</c:v>
                </c:pt>
                <c:pt idx="2434">
                  <c:v>0.96133650510431601</c:v>
                </c:pt>
                <c:pt idx="2435">
                  <c:v>0.31005299593824831</c:v>
                </c:pt>
                <c:pt idx="2436">
                  <c:v>0.24390856723048435</c:v>
                </c:pt>
                <c:pt idx="2437">
                  <c:v>5.1509155785486198E-2</c:v>
                </c:pt>
                <c:pt idx="2438">
                  <c:v>0.5906953217981521</c:v>
                </c:pt>
                <c:pt idx="2439">
                  <c:v>0.69339189967262527</c:v>
                </c:pt>
                <c:pt idx="2440">
                  <c:v>0.87475172183618466</c:v>
                </c:pt>
                <c:pt idx="2441">
                  <c:v>0.38100793570066582</c:v>
                </c:pt>
                <c:pt idx="2442">
                  <c:v>0.14256996647417505</c:v>
                </c:pt>
                <c:pt idx="2443">
                  <c:v>0.77824262027782598</c:v>
                </c:pt>
                <c:pt idx="2444">
                  <c:v>1.1739831672600696</c:v>
                </c:pt>
                <c:pt idx="2445">
                  <c:v>0.80010265933721736</c:v>
                </c:pt>
                <c:pt idx="2446">
                  <c:v>0.70571686848943105</c:v>
                </c:pt>
                <c:pt idx="2447">
                  <c:v>0.45280613470462455</c:v>
                </c:pt>
                <c:pt idx="2448">
                  <c:v>0.83342342660472857</c:v>
                </c:pt>
                <c:pt idx="2449">
                  <c:v>0.14736699699371833</c:v>
                </c:pt>
                <c:pt idx="2450">
                  <c:v>0.27489492566605223</c:v>
                </c:pt>
                <c:pt idx="2451">
                  <c:v>0.61409347782339041</c:v>
                </c:pt>
                <c:pt idx="2452">
                  <c:v>0.11621629899138118</c:v>
                </c:pt>
                <c:pt idx="2453">
                  <c:v>0.34840432955784184</c:v>
                </c:pt>
                <c:pt idx="2454">
                  <c:v>1.0437687827747979</c:v>
                </c:pt>
                <c:pt idx="2455">
                  <c:v>7.9029624425218797E-2</c:v>
                </c:pt>
                <c:pt idx="2456">
                  <c:v>0.2716254596071645</c:v>
                </c:pt>
                <c:pt idx="2457">
                  <c:v>0.70923897180871087</c:v>
                </c:pt>
                <c:pt idx="2458">
                  <c:v>0.30442915458120584</c:v>
                </c:pt>
                <c:pt idx="2459">
                  <c:v>0.25633558652293781</c:v>
                </c:pt>
                <c:pt idx="2460">
                  <c:v>1.2538701121091296</c:v>
                </c:pt>
                <c:pt idx="2461">
                  <c:v>0.74606774136676623</c:v>
                </c:pt>
                <c:pt idx="2462">
                  <c:v>0.73255313596348648</c:v>
                </c:pt>
                <c:pt idx="2463">
                  <c:v>0.54543161447120414</c:v>
                </c:pt>
                <c:pt idx="2464">
                  <c:v>0.17073011161963497</c:v>
                </c:pt>
                <c:pt idx="2465">
                  <c:v>0.46674633531944937</c:v>
                </c:pt>
                <c:pt idx="2466">
                  <c:v>1.1940853033904184</c:v>
                </c:pt>
                <c:pt idx="2467">
                  <c:v>0.11865596511761675</c:v>
                </c:pt>
                <c:pt idx="2468">
                  <c:v>0.20756320120829938</c:v>
                </c:pt>
                <c:pt idx="2469">
                  <c:v>0.59505648751002882</c:v>
                </c:pt>
                <c:pt idx="2470">
                  <c:v>7.0580137069284283E-3</c:v>
                </c:pt>
                <c:pt idx="2471">
                  <c:v>0.50965459259666479</c:v>
                </c:pt>
                <c:pt idx="2472">
                  <c:v>0.31154443927258374</c:v>
                </c:pt>
                <c:pt idx="2473">
                  <c:v>8.3661656384657734E-3</c:v>
                </c:pt>
                <c:pt idx="2474">
                  <c:v>3.0291025850938063</c:v>
                </c:pt>
                <c:pt idx="2475">
                  <c:v>0.56017231349529517</c:v>
                </c:pt>
                <c:pt idx="2476">
                  <c:v>0.59036924227061782</c:v>
                </c:pt>
                <c:pt idx="2477">
                  <c:v>7.548125493874072E-3</c:v>
                </c:pt>
                <c:pt idx="2478">
                  <c:v>0.38291772416908798</c:v>
                </c:pt>
                <c:pt idx="2479">
                  <c:v>0.22146027093779233</c:v>
                </c:pt>
                <c:pt idx="2480">
                  <c:v>0.52578694053140673</c:v>
                </c:pt>
                <c:pt idx="2481">
                  <c:v>0.19739724829718011</c:v>
                </c:pt>
                <c:pt idx="2482">
                  <c:v>1.3967424656045948</c:v>
                </c:pt>
                <c:pt idx="2483">
                  <c:v>2.7247480529327101E-2</c:v>
                </c:pt>
                <c:pt idx="2484">
                  <c:v>0.17692167403797682</c:v>
                </c:pt>
                <c:pt idx="2485">
                  <c:v>0.90786421777092963</c:v>
                </c:pt>
                <c:pt idx="2486">
                  <c:v>0.55639741822014976</c:v>
                </c:pt>
                <c:pt idx="2487">
                  <c:v>1.4160901880823538</c:v>
                </c:pt>
                <c:pt idx="2488">
                  <c:v>0.6147209419642784</c:v>
                </c:pt>
                <c:pt idx="2489">
                  <c:v>1.1444588351836571</c:v>
                </c:pt>
                <c:pt idx="2490">
                  <c:v>0.36870781503161137</c:v>
                </c:pt>
                <c:pt idx="2491">
                  <c:v>0.30103645510928206</c:v>
                </c:pt>
                <c:pt idx="2492">
                  <c:v>0.98044066596643298</c:v>
                </c:pt>
                <c:pt idx="2493">
                  <c:v>2.7712074105002475</c:v>
                </c:pt>
                <c:pt idx="2494">
                  <c:v>6.1067160071354487E-2</c:v>
                </c:pt>
                <c:pt idx="2495">
                  <c:v>0.42511810022985785</c:v>
                </c:pt>
                <c:pt idx="2496">
                  <c:v>0.25034881545398546</c:v>
                </c:pt>
                <c:pt idx="2497">
                  <c:v>0.47780433283145479</c:v>
                </c:pt>
                <c:pt idx="2498">
                  <c:v>0.38074486888712594</c:v>
                </c:pt>
                <c:pt idx="2499">
                  <c:v>0.15142326782266741</c:v>
                </c:pt>
                <c:pt idx="2500">
                  <c:v>0.59052130180512041</c:v>
                </c:pt>
                <c:pt idx="2501">
                  <c:v>4.8585109277966776E-2</c:v>
                </c:pt>
                <c:pt idx="2502">
                  <c:v>0.39675131712909389</c:v>
                </c:pt>
                <c:pt idx="2503">
                  <c:v>1.1745308184096248</c:v>
                </c:pt>
                <c:pt idx="2504">
                  <c:v>0.63933619425908805</c:v>
                </c:pt>
                <c:pt idx="2505">
                  <c:v>0.48144262804927274</c:v>
                </c:pt>
                <c:pt idx="2506">
                  <c:v>0.11940688225056935</c:v>
                </c:pt>
                <c:pt idx="2507">
                  <c:v>1.0229800492672354</c:v>
                </c:pt>
                <c:pt idx="2508">
                  <c:v>0.54608208448495033</c:v>
                </c:pt>
                <c:pt idx="2509">
                  <c:v>1.2429821067306213</c:v>
                </c:pt>
                <c:pt idx="2510">
                  <c:v>0.53206729797216068</c:v>
                </c:pt>
                <c:pt idx="2511">
                  <c:v>0.41644186098926605</c:v>
                </c:pt>
                <c:pt idx="2512">
                  <c:v>4.6074366694936565E-2</c:v>
                </c:pt>
                <c:pt idx="2513">
                  <c:v>0.42030520794070131</c:v>
                </c:pt>
                <c:pt idx="2514">
                  <c:v>0.42870482509895474</c:v>
                </c:pt>
                <c:pt idx="2515">
                  <c:v>1.2822661979897969</c:v>
                </c:pt>
                <c:pt idx="2516">
                  <c:v>0.72643607973752244</c:v>
                </c:pt>
                <c:pt idx="2517">
                  <c:v>0.40506869348940772</c:v>
                </c:pt>
                <c:pt idx="2518">
                  <c:v>0.16650417371415913</c:v>
                </c:pt>
                <c:pt idx="2519">
                  <c:v>0.64328729199129386</c:v>
                </c:pt>
                <c:pt idx="2520">
                  <c:v>0.45818689067194907</c:v>
                </c:pt>
                <c:pt idx="2521">
                  <c:v>1.0282684168322167</c:v>
                </c:pt>
                <c:pt idx="2522">
                  <c:v>0.39007309362376075</c:v>
                </c:pt>
                <c:pt idx="2523">
                  <c:v>0.68434268444743518</c:v>
                </c:pt>
                <c:pt idx="2524">
                  <c:v>0.62472947752258556</c:v>
                </c:pt>
                <c:pt idx="2525">
                  <c:v>0.29609056957663976</c:v>
                </c:pt>
                <c:pt idx="2526">
                  <c:v>0.40120478741805615</c:v>
                </c:pt>
                <c:pt idx="2527">
                  <c:v>0.41841811261816714</c:v>
                </c:pt>
                <c:pt idx="2528">
                  <c:v>0.65976399371452898</c:v>
                </c:pt>
                <c:pt idx="2529">
                  <c:v>2.4090271154576177</c:v>
                </c:pt>
                <c:pt idx="2530">
                  <c:v>0.10165138482338081</c:v>
                </c:pt>
                <c:pt idx="2531">
                  <c:v>0.80075398273725829</c:v>
                </c:pt>
                <c:pt idx="2532">
                  <c:v>0.47493307006276936</c:v>
                </c:pt>
                <c:pt idx="2533">
                  <c:v>0.79951220849417004</c:v>
                </c:pt>
                <c:pt idx="2534">
                  <c:v>7.4415900135507931E-2</c:v>
                </c:pt>
                <c:pt idx="2535">
                  <c:v>0.57741940280333104</c:v>
                </c:pt>
                <c:pt idx="2536">
                  <c:v>2.1212808295258775E-2</c:v>
                </c:pt>
                <c:pt idx="2537">
                  <c:v>0.77730335941168305</c:v>
                </c:pt>
                <c:pt idx="2538">
                  <c:v>0.56970562408671166</c:v>
                </c:pt>
                <c:pt idx="2539">
                  <c:v>0.54165029640207973</c:v>
                </c:pt>
                <c:pt idx="2540">
                  <c:v>1.2521765142084265</c:v>
                </c:pt>
                <c:pt idx="2541">
                  <c:v>0.31591158856813945</c:v>
                </c:pt>
                <c:pt idx="2542">
                  <c:v>0.82868743866300876</c:v>
                </c:pt>
                <c:pt idx="2543">
                  <c:v>1.2868851574303426</c:v>
                </c:pt>
                <c:pt idx="2544">
                  <c:v>0.3853652071685964</c:v>
                </c:pt>
                <c:pt idx="2545">
                  <c:v>1.1593272270088251</c:v>
                </c:pt>
                <c:pt idx="2546">
                  <c:v>0.11400858387035762</c:v>
                </c:pt>
                <c:pt idx="2547">
                  <c:v>0.72037733196705478</c:v>
                </c:pt>
                <c:pt idx="2548">
                  <c:v>0.13069456415028244</c:v>
                </c:pt>
                <c:pt idx="2549">
                  <c:v>0.14381887355091547</c:v>
                </c:pt>
                <c:pt idx="2550">
                  <c:v>0.37160339476622345</c:v>
                </c:pt>
                <c:pt idx="2551">
                  <c:v>5.0717598604544292E-2</c:v>
                </c:pt>
                <c:pt idx="2552">
                  <c:v>0.97593613046150884</c:v>
                </c:pt>
                <c:pt idx="2553">
                  <c:v>0.3956686734922843</c:v>
                </c:pt>
                <c:pt idx="2554">
                  <c:v>0.14769085218721525</c:v>
                </c:pt>
                <c:pt idx="2555">
                  <c:v>0.14804485645428173</c:v>
                </c:pt>
                <c:pt idx="2556">
                  <c:v>0.2252909477343579</c:v>
                </c:pt>
                <c:pt idx="2557">
                  <c:v>0.38914198004497963</c:v>
                </c:pt>
                <c:pt idx="2558">
                  <c:v>6.2969319740654547E-2</c:v>
                </c:pt>
                <c:pt idx="2559">
                  <c:v>0.61749580593262066</c:v>
                </c:pt>
                <c:pt idx="2560">
                  <c:v>0.11910429297419683</c:v>
                </c:pt>
                <c:pt idx="2561">
                  <c:v>0.66483584062041734</c:v>
                </c:pt>
                <c:pt idx="2562">
                  <c:v>0.35897500472487809</c:v>
                </c:pt>
                <c:pt idx="2563">
                  <c:v>0.83542180055991699</c:v>
                </c:pt>
                <c:pt idx="2564">
                  <c:v>1.3365765580131561</c:v>
                </c:pt>
                <c:pt idx="2565">
                  <c:v>0.53873952291732907</c:v>
                </c:pt>
                <c:pt idx="2566">
                  <c:v>0.3934816969003323</c:v>
                </c:pt>
                <c:pt idx="2567">
                  <c:v>0.13303159297611458</c:v>
                </c:pt>
                <c:pt idx="2568">
                  <c:v>0.45076963787019914</c:v>
                </c:pt>
                <c:pt idx="2569">
                  <c:v>0.46247437878434561</c:v>
                </c:pt>
                <c:pt idx="2570">
                  <c:v>0.55667865835190278</c:v>
                </c:pt>
                <c:pt idx="2571">
                  <c:v>0.60408229463120455</c:v>
                </c:pt>
                <c:pt idx="2572">
                  <c:v>0.46355894234991085</c:v>
                </c:pt>
                <c:pt idx="2573">
                  <c:v>1.1368400149218343</c:v>
                </c:pt>
                <c:pt idx="2574">
                  <c:v>1.0066780889429554</c:v>
                </c:pt>
                <c:pt idx="2575">
                  <c:v>0.59976526228741545</c:v>
                </c:pt>
                <c:pt idx="2576">
                  <c:v>0.80002840738141479</c:v>
                </c:pt>
                <c:pt idx="2577">
                  <c:v>0.74718766185047703</c:v>
                </c:pt>
                <c:pt idx="2578">
                  <c:v>0.47239066778564937</c:v>
                </c:pt>
                <c:pt idx="2579">
                  <c:v>0.6164190093482137</c:v>
                </c:pt>
                <c:pt idx="2580">
                  <c:v>8.5461837797618942E-2</c:v>
                </c:pt>
                <c:pt idx="2581">
                  <c:v>0.56288700236851497</c:v>
                </c:pt>
                <c:pt idx="2582">
                  <c:v>0.79716772251819934</c:v>
                </c:pt>
                <c:pt idx="2583">
                  <c:v>0.11900264968854266</c:v>
                </c:pt>
                <c:pt idx="2584">
                  <c:v>9.0274876564618398E-2</c:v>
                </c:pt>
                <c:pt idx="2585">
                  <c:v>8.1765009065034713E-2</c:v>
                </c:pt>
                <c:pt idx="2586">
                  <c:v>0.36348688351052666</c:v>
                </c:pt>
                <c:pt idx="2587">
                  <c:v>1.2929408103620617</c:v>
                </c:pt>
                <c:pt idx="2588">
                  <c:v>0.32425212233717099</c:v>
                </c:pt>
                <c:pt idx="2589">
                  <c:v>4.3428723468043287E-2</c:v>
                </c:pt>
                <c:pt idx="2590">
                  <c:v>1.1569235757553429</c:v>
                </c:pt>
                <c:pt idx="2591">
                  <c:v>0.9480545820505546</c:v>
                </c:pt>
                <c:pt idx="2592">
                  <c:v>2.2749503172639969</c:v>
                </c:pt>
                <c:pt idx="2593">
                  <c:v>8.0609916562974684E-2</c:v>
                </c:pt>
                <c:pt idx="2594">
                  <c:v>9.9860515329778295E-3</c:v>
                </c:pt>
                <c:pt idx="2595">
                  <c:v>7.3457987300743544E-2</c:v>
                </c:pt>
                <c:pt idx="2596">
                  <c:v>4.2232282712218322E-2</c:v>
                </c:pt>
                <c:pt idx="2597">
                  <c:v>1.3841714929766957</c:v>
                </c:pt>
                <c:pt idx="2598">
                  <c:v>0.47142117062018751</c:v>
                </c:pt>
                <c:pt idx="2599">
                  <c:v>0.24374072556681906</c:v>
                </c:pt>
                <c:pt idx="2600">
                  <c:v>0.25693886326018667</c:v>
                </c:pt>
                <c:pt idx="2601">
                  <c:v>1.2704140655883264E-2</c:v>
                </c:pt>
                <c:pt idx="2602">
                  <c:v>1.1129775361789926</c:v>
                </c:pt>
                <c:pt idx="2603">
                  <c:v>0.72766202852538797</c:v>
                </c:pt>
                <c:pt idx="2604">
                  <c:v>0.65605410303996059</c:v>
                </c:pt>
                <c:pt idx="2605">
                  <c:v>7.7882474406726743E-2</c:v>
                </c:pt>
                <c:pt idx="2606">
                  <c:v>0.38016499614983362</c:v>
                </c:pt>
                <c:pt idx="2607">
                  <c:v>6.0516451239880045E-2</c:v>
                </c:pt>
                <c:pt idx="2608">
                  <c:v>4.7984581304111377E-4</c:v>
                </c:pt>
                <c:pt idx="2609">
                  <c:v>0.33887315507851995</c:v>
                </c:pt>
                <c:pt idx="2610">
                  <c:v>0.85354301134967292</c:v>
                </c:pt>
                <c:pt idx="2611">
                  <c:v>8.4039369939811731E-2</c:v>
                </c:pt>
                <c:pt idx="2612">
                  <c:v>0.1257892909473487</c:v>
                </c:pt>
                <c:pt idx="2613">
                  <c:v>0.63034846289134239</c:v>
                </c:pt>
                <c:pt idx="2614">
                  <c:v>3.4678104164324611E-2</c:v>
                </c:pt>
                <c:pt idx="2615">
                  <c:v>1.3528338468713266</c:v>
                </c:pt>
                <c:pt idx="2616">
                  <c:v>0.62997855495501975</c:v>
                </c:pt>
                <c:pt idx="2617">
                  <c:v>0.2759805816080162</c:v>
                </c:pt>
                <c:pt idx="2618">
                  <c:v>4.0222752541984264E-2</c:v>
                </c:pt>
                <c:pt idx="2619">
                  <c:v>0.64202454504118844</c:v>
                </c:pt>
                <c:pt idx="2620">
                  <c:v>0.90282293602481878</c:v>
                </c:pt>
                <c:pt idx="2621">
                  <c:v>0.16103824418386423</c:v>
                </c:pt>
                <c:pt idx="2622">
                  <c:v>0.50294440402208596</c:v>
                </c:pt>
                <c:pt idx="2623">
                  <c:v>0.71921729953075408</c:v>
                </c:pt>
                <c:pt idx="2624">
                  <c:v>0.11845870343533488</c:v>
                </c:pt>
                <c:pt idx="2625">
                  <c:v>9.1013431724351126E-2</c:v>
                </c:pt>
                <c:pt idx="2626">
                  <c:v>0.11016314990034161</c:v>
                </c:pt>
                <c:pt idx="2627">
                  <c:v>0.9591253059148962</c:v>
                </c:pt>
                <c:pt idx="2628">
                  <c:v>0.18696428663009132</c:v>
                </c:pt>
                <c:pt idx="2629">
                  <c:v>2.4849209628235659E-2</c:v>
                </c:pt>
                <c:pt idx="2630">
                  <c:v>0.11531697430910785</c:v>
                </c:pt>
                <c:pt idx="2631">
                  <c:v>0.43530989304118439</c:v>
                </c:pt>
                <c:pt idx="2632">
                  <c:v>1.812096529177645E-2</c:v>
                </c:pt>
                <c:pt idx="2633">
                  <c:v>0.44047371305178934</c:v>
                </c:pt>
                <c:pt idx="2634">
                  <c:v>0.75899900990129388</c:v>
                </c:pt>
                <c:pt idx="2635">
                  <c:v>0.92459879279011159</c:v>
                </c:pt>
                <c:pt idx="2636">
                  <c:v>0.77516571150277547</c:v>
                </c:pt>
                <c:pt idx="2637">
                  <c:v>1.2637416490341409</c:v>
                </c:pt>
                <c:pt idx="2638">
                  <c:v>0.97124587497658976</c:v>
                </c:pt>
                <c:pt idx="2639">
                  <c:v>0.24830301514780306</c:v>
                </c:pt>
                <c:pt idx="2640">
                  <c:v>0.41748953620308044</c:v>
                </c:pt>
                <c:pt idx="2641">
                  <c:v>0.34138680928290926</c:v>
                </c:pt>
                <c:pt idx="2642">
                  <c:v>0.82752346859095216</c:v>
                </c:pt>
                <c:pt idx="2643">
                  <c:v>0.88730172733457857</c:v>
                </c:pt>
                <c:pt idx="2644">
                  <c:v>0.46342402717895864</c:v>
                </c:pt>
                <c:pt idx="2645">
                  <c:v>0.29626454961088367</c:v>
                </c:pt>
                <c:pt idx="2646">
                  <c:v>0.86088585946110274</c:v>
                </c:pt>
                <c:pt idx="2647">
                  <c:v>0.2629702697267004</c:v>
                </c:pt>
                <c:pt idx="2648">
                  <c:v>9.3947136159232794E-2</c:v>
                </c:pt>
                <c:pt idx="2649">
                  <c:v>0.74269724561143402</c:v>
                </c:pt>
                <c:pt idx="2650">
                  <c:v>0.3073187222519474</c:v>
                </c:pt>
                <c:pt idx="2651">
                  <c:v>0.27372032774141458</c:v>
                </c:pt>
                <c:pt idx="2652">
                  <c:v>0.44759771972149143</c:v>
                </c:pt>
                <c:pt idx="2653">
                  <c:v>1.3267581112271827</c:v>
                </c:pt>
                <c:pt idx="2654">
                  <c:v>1.2947141282516921</c:v>
                </c:pt>
                <c:pt idx="2655">
                  <c:v>0.22096959659583421</c:v>
                </c:pt>
                <c:pt idx="2656">
                  <c:v>7.4301401516427598E-2</c:v>
                </c:pt>
                <c:pt idx="2657">
                  <c:v>0.63681519955568355</c:v>
                </c:pt>
                <c:pt idx="2658">
                  <c:v>0.22059508617479098</c:v>
                </c:pt>
                <c:pt idx="2659">
                  <c:v>0.29928030042959519</c:v>
                </c:pt>
                <c:pt idx="2660">
                  <c:v>0.19503743790907752</c:v>
                </c:pt>
                <c:pt idx="2661">
                  <c:v>1.0196019129385931</c:v>
                </c:pt>
                <c:pt idx="2662">
                  <c:v>1.381341813044086</c:v>
                </c:pt>
                <c:pt idx="2663">
                  <c:v>0.37376175384103716</c:v>
                </c:pt>
                <c:pt idx="2664">
                  <c:v>0.55927386118354339</c:v>
                </c:pt>
                <c:pt idx="2665">
                  <c:v>0.46590678117080936</c:v>
                </c:pt>
                <c:pt idx="2666">
                  <c:v>1.0588308356051308</c:v>
                </c:pt>
                <c:pt idx="2667">
                  <c:v>0.22037955583297991</c:v>
                </c:pt>
                <c:pt idx="2668">
                  <c:v>0.229655962659433</c:v>
                </c:pt>
                <c:pt idx="2669">
                  <c:v>0.68388939906602075</c:v>
                </c:pt>
                <c:pt idx="2670">
                  <c:v>0.11776590434217678</c:v>
                </c:pt>
                <c:pt idx="2671">
                  <c:v>0.26491279797909906</c:v>
                </c:pt>
                <c:pt idx="2672">
                  <c:v>0.33175896048844938</c:v>
                </c:pt>
                <c:pt idx="2673">
                  <c:v>7.2776393821996785E-2</c:v>
                </c:pt>
                <c:pt idx="2674">
                  <c:v>0.12541331182706458</c:v>
                </c:pt>
                <c:pt idx="2675">
                  <c:v>8.7614474435814792E-3</c:v>
                </c:pt>
                <c:pt idx="2676">
                  <c:v>1.6794749397215907E-2</c:v>
                </c:pt>
                <c:pt idx="2677">
                  <c:v>0.4785873089031919</c:v>
                </c:pt>
                <c:pt idx="2678">
                  <c:v>0.47500459910053522</c:v>
                </c:pt>
                <c:pt idx="2679">
                  <c:v>0.11625864850027799</c:v>
                </c:pt>
                <c:pt idx="2680">
                  <c:v>0.58089101448955061</c:v>
                </c:pt>
                <c:pt idx="2681">
                  <c:v>5.2842723844603624E-2</c:v>
                </c:pt>
                <c:pt idx="2682">
                  <c:v>1.1756795588551003</c:v>
                </c:pt>
                <c:pt idx="2683">
                  <c:v>0.56576694720844523</c:v>
                </c:pt>
                <c:pt idx="2684">
                  <c:v>0.48948921377546617</c:v>
                </c:pt>
                <c:pt idx="2685">
                  <c:v>5.1557338016245832E-2</c:v>
                </c:pt>
                <c:pt idx="2686">
                  <c:v>1.2861157479922742</c:v>
                </c:pt>
                <c:pt idx="2687">
                  <c:v>7.4605169712683481E-2</c:v>
                </c:pt>
                <c:pt idx="2688">
                  <c:v>0.19271921392416336</c:v>
                </c:pt>
                <c:pt idx="2689">
                  <c:v>0.74379812170011372</c:v>
                </c:pt>
                <c:pt idx="2690">
                  <c:v>0.98134395980038047</c:v>
                </c:pt>
                <c:pt idx="2691">
                  <c:v>0.20096274582664247</c:v>
                </c:pt>
                <c:pt idx="2692">
                  <c:v>0.63700747288347603</c:v>
                </c:pt>
                <c:pt idx="2693">
                  <c:v>0.65423291076327339</c:v>
                </c:pt>
                <c:pt idx="2694">
                  <c:v>0.20169043266063474</c:v>
                </c:pt>
                <c:pt idx="2695">
                  <c:v>0.95315107546551203</c:v>
                </c:pt>
                <c:pt idx="2696">
                  <c:v>1.1069809647989395</c:v>
                </c:pt>
                <c:pt idx="2697">
                  <c:v>0.61672750806700938</c:v>
                </c:pt>
                <c:pt idx="2698">
                  <c:v>0.56379216672986165</c:v>
                </c:pt>
                <c:pt idx="2699">
                  <c:v>0.66426917979381828</c:v>
                </c:pt>
                <c:pt idx="2700">
                  <c:v>1.5276439320790052E-2</c:v>
                </c:pt>
                <c:pt idx="2701">
                  <c:v>0.70640013432504078</c:v>
                </c:pt>
                <c:pt idx="2702">
                  <c:v>1.047294181729622</c:v>
                </c:pt>
                <c:pt idx="2703">
                  <c:v>1.2670777841501282</c:v>
                </c:pt>
                <c:pt idx="2704">
                  <c:v>0.91964006747138938</c:v>
                </c:pt>
                <c:pt idx="2705">
                  <c:v>0.83553696450162096</c:v>
                </c:pt>
                <c:pt idx="2706">
                  <c:v>0.21821434436577722</c:v>
                </c:pt>
                <c:pt idx="2707">
                  <c:v>0.34624260314420774</c:v>
                </c:pt>
                <c:pt idx="2708">
                  <c:v>0.28902486766852076</c:v>
                </c:pt>
                <c:pt idx="2709">
                  <c:v>0.21429361645438832</c:v>
                </c:pt>
                <c:pt idx="2710">
                  <c:v>1.0130068509207373E-2</c:v>
                </c:pt>
                <c:pt idx="2711">
                  <c:v>0.30342503476854327</c:v>
                </c:pt>
                <c:pt idx="2712">
                  <c:v>0.52131082573610665</c:v>
                </c:pt>
                <c:pt idx="2713">
                  <c:v>1.3762329680618457</c:v>
                </c:pt>
                <c:pt idx="2714">
                  <c:v>2.1214293345491129</c:v>
                </c:pt>
                <c:pt idx="2715">
                  <c:v>0.1685996214648918</c:v>
                </c:pt>
                <c:pt idx="2716">
                  <c:v>2.7310854854796034E-3</c:v>
                </c:pt>
                <c:pt idx="2717">
                  <c:v>0.16088843129944211</c:v>
                </c:pt>
                <c:pt idx="2718">
                  <c:v>0.53650022092765448</c:v>
                </c:pt>
                <c:pt idx="2719">
                  <c:v>3.5050901142834505E-3</c:v>
                </c:pt>
                <c:pt idx="2720">
                  <c:v>0.53367293156360662</c:v>
                </c:pt>
                <c:pt idx="2721">
                  <c:v>1.1323216879177418</c:v>
                </c:pt>
                <c:pt idx="2722">
                  <c:v>0.4031518176653377</c:v>
                </c:pt>
                <c:pt idx="2723">
                  <c:v>0.888532472032045</c:v>
                </c:pt>
                <c:pt idx="2724">
                  <c:v>0.59420978670485602</c:v>
                </c:pt>
                <c:pt idx="2725">
                  <c:v>0.32329360766772886</c:v>
                </c:pt>
                <c:pt idx="2726">
                  <c:v>0.16603632969833335</c:v>
                </c:pt>
                <c:pt idx="2727">
                  <c:v>0.25085039899412936</c:v>
                </c:pt>
                <c:pt idx="2728">
                  <c:v>0.178069234655614</c:v>
                </c:pt>
                <c:pt idx="2729">
                  <c:v>0.12140327442146075</c:v>
                </c:pt>
                <c:pt idx="2730">
                  <c:v>0.55397007960850264</c:v>
                </c:pt>
                <c:pt idx="2731">
                  <c:v>1.7019453313970555E-2</c:v>
                </c:pt>
                <c:pt idx="2732">
                  <c:v>1.1571230179778296</c:v>
                </c:pt>
                <c:pt idx="2733">
                  <c:v>0.68574959802097513</c:v>
                </c:pt>
                <c:pt idx="2734">
                  <c:v>0.23128731130196489</c:v>
                </c:pt>
                <c:pt idx="2735">
                  <c:v>0.88395859551612754</c:v>
                </c:pt>
                <c:pt idx="2736">
                  <c:v>0.3579514100152798</c:v>
                </c:pt>
                <c:pt idx="2737">
                  <c:v>0.86730246630427832</c:v>
                </c:pt>
                <c:pt idx="2738">
                  <c:v>0.68258714043548585</c:v>
                </c:pt>
                <c:pt idx="2739">
                  <c:v>0.50434492935134312</c:v>
                </c:pt>
                <c:pt idx="2740">
                  <c:v>0.43300064326296633</c:v>
                </c:pt>
                <c:pt idx="2741">
                  <c:v>0.58359366234364274</c:v>
                </c:pt>
                <c:pt idx="2742">
                  <c:v>0.49822643536344069</c:v>
                </c:pt>
                <c:pt idx="2743">
                  <c:v>1.3576370942852345</c:v>
                </c:pt>
                <c:pt idx="2744">
                  <c:v>0.19757631698020786</c:v>
                </c:pt>
                <c:pt idx="2745">
                  <c:v>1.1183773680518379</c:v>
                </c:pt>
                <c:pt idx="2746">
                  <c:v>7.1954058052217981E-2</c:v>
                </c:pt>
                <c:pt idx="2747">
                  <c:v>0.85421635293748932</c:v>
                </c:pt>
                <c:pt idx="2748">
                  <c:v>0.37632325392445648</c:v>
                </c:pt>
                <c:pt idx="2749">
                  <c:v>0.65515827690351247</c:v>
                </c:pt>
                <c:pt idx="2750">
                  <c:v>0.14779959107028379</c:v>
                </c:pt>
                <c:pt idx="2751">
                  <c:v>0.84315435817831552</c:v>
                </c:pt>
                <c:pt idx="2752">
                  <c:v>1.2651621274113045</c:v>
                </c:pt>
                <c:pt idx="2753">
                  <c:v>0.66769697415030349</c:v>
                </c:pt>
                <c:pt idx="2754">
                  <c:v>2.0020613625723545E-2</c:v>
                </c:pt>
                <c:pt idx="2755">
                  <c:v>1.3860068752074104E-2</c:v>
                </c:pt>
                <c:pt idx="2756">
                  <c:v>0.13071793182833907</c:v>
                </c:pt>
                <c:pt idx="2757">
                  <c:v>0.40293092008356918</c:v>
                </c:pt>
                <c:pt idx="2758">
                  <c:v>0.20600484537115774</c:v>
                </c:pt>
                <c:pt idx="2759">
                  <c:v>0.23201691375913597</c:v>
                </c:pt>
                <c:pt idx="2760">
                  <c:v>0.10996061200727632</c:v>
                </c:pt>
                <c:pt idx="2761">
                  <c:v>0.40389908178594186</c:v>
                </c:pt>
                <c:pt idx="2762">
                  <c:v>0.18302279404980853</c:v>
                </c:pt>
                <c:pt idx="2763">
                  <c:v>3.0159959381129E-2</c:v>
                </c:pt>
                <c:pt idx="2764">
                  <c:v>0.47200767296152463</c:v>
                </c:pt>
                <c:pt idx="2765">
                  <c:v>0.99811790902144315</c:v>
                </c:pt>
                <c:pt idx="2766">
                  <c:v>0.62329862568545613</c:v>
                </c:pt>
                <c:pt idx="2767">
                  <c:v>9.4525742119337536E-2</c:v>
                </c:pt>
                <c:pt idx="2768">
                  <c:v>1.7523243198669627</c:v>
                </c:pt>
                <c:pt idx="2769">
                  <c:v>0.48238385727686556</c:v>
                </c:pt>
                <c:pt idx="2770">
                  <c:v>3.3097216441582422E-2</c:v>
                </c:pt>
                <c:pt idx="2771">
                  <c:v>0.43536239098834517</c:v>
                </c:pt>
                <c:pt idx="2772">
                  <c:v>0.59945949195791515</c:v>
                </c:pt>
                <c:pt idx="2773">
                  <c:v>0.20397613726660305</c:v>
                </c:pt>
                <c:pt idx="2774">
                  <c:v>1.4958627257324975</c:v>
                </c:pt>
                <c:pt idx="2775">
                  <c:v>0.16705624776915415</c:v>
                </c:pt>
                <c:pt idx="2776">
                  <c:v>0.52089102783385377</c:v>
                </c:pt>
                <c:pt idx="2777">
                  <c:v>1.1937520128382539</c:v>
                </c:pt>
                <c:pt idx="2778">
                  <c:v>1.3821600895210899</c:v>
                </c:pt>
                <c:pt idx="2779">
                  <c:v>0.2635734863775932</c:v>
                </c:pt>
                <c:pt idx="2780">
                  <c:v>0.11606895877046806</c:v>
                </c:pt>
                <c:pt idx="2781">
                  <c:v>0.93914803485731224</c:v>
                </c:pt>
                <c:pt idx="2782">
                  <c:v>0.51876235161762996</c:v>
                </c:pt>
                <c:pt idx="2783">
                  <c:v>0.70920157144600926</c:v>
                </c:pt>
                <c:pt idx="2784">
                  <c:v>1.7006539438388037</c:v>
                </c:pt>
                <c:pt idx="2785">
                  <c:v>0.14579009623091724</c:v>
                </c:pt>
                <c:pt idx="2786">
                  <c:v>1.0078927943199976</c:v>
                </c:pt>
                <c:pt idx="2787">
                  <c:v>0.27986363222954852</c:v>
                </c:pt>
                <c:pt idx="2788">
                  <c:v>1.1181896262558575</c:v>
                </c:pt>
                <c:pt idx="2789">
                  <c:v>0.91842840961069028</c:v>
                </c:pt>
                <c:pt idx="2790">
                  <c:v>5.6363543336003769E-2</c:v>
                </c:pt>
                <c:pt idx="2791">
                  <c:v>7.3257553320052973E-2</c:v>
                </c:pt>
                <c:pt idx="2792">
                  <c:v>0.92698958173531509</c:v>
                </c:pt>
                <c:pt idx="2793">
                  <c:v>1.0103548134982172</c:v>
                </c:pt>
                <c:pt idx="2794">
                  <c:v>0.52382361479099881</c:v>
                </c:pt>
                <c:pt idx="2795">
                  <c:v>0.63363211973589939</c:v>
                </c:pt>
                <c:pt idx="2796">
                  <c:v>0.51029366057485548</c:v>
                </c:pt>
                <c:pt idx="2797">
                  <c:v>0.92494757083755497</c:v>
                </c:pt>
                <c:pt idx="2798">
                  <c:v>0.26026606207486258</c:v>
                </c:pt>
                <c:pt idx="2799">
                  <c:v>0.4460226018142957</c:v>
                </c:pt>
                <c:pt idx="2800">
                  <c:v>0.68650651353403425</c:v>
                </c:pt>
                <c:pt idx="2801">
                  <c:v>0.60406335000893463</c:v>
                </c:pt>
                <c:pt idx="2802">
                  <c:v>0.69694654535474143</c:v>
                </c:pt>
                <c:pt idx="2803">
                  <c:v>0.35466612316099289</c:v>
                </c:pt>
                <c:pt idx="2804">
                  <c:v>0.99168677590250065</c:v>
                </c:pt>
                <c:pt idx="2805">
                  <c:v>9.9264691830688659E-2</c:v>
                </c:pt>
                <c:pt idx="2806">
                  <c:v>0.55195494909797105</c:v>
                </c:pt>
                <c:pt idx="2807">
                  <c:v>0.3599084224224971</c:v>
                </c:pt>
                <c:pt idx="2808">
                  <c:v>0.21104916606897786</c:v>
                </c:pt>
                <c:pt idx="2809">
                  <c:v>0.8791975045678927</c:v>
                </c:pt>
                <c:pt idx="2810">
                  <c:v>0.38920642703247199</c:v>
                </c:pt>
                <c:pt idx="2811">
                  <c:v>0.43418647009489025</c:v>
                </c:pt>
                <c:pt idx="2812">
                  <c:v>0.80142393261209088</c:v>
                </c:pt>
                <c:pt idx="2813">
                  <c:v>1.0102571502973416</c:v>
                </c:pt>
                <c:pt idx="2814">
                  <c:v>0.54181180911705773</c:v>
                </c:pt>
                <c:pt idx="2815">
                  <c:v>1.1753887859838505</c:v>
                </c:pt>
                <c:pt idx="2816">
                  <c:v>0.41171146982864271</c:v>
                </c:pt>
                <c:pt idx="2817">
                  <c:v>0.70401508887211617</c:v>
                </c:pt>
                <c:pt idx="2818">
                  <c:v>0.14415309193183226</c:v>
                </c:pt>
                <c:pt idx="2819">
                  <c:v>0.1160039699379201</c:v>
                </c:pt>
                <c:pt idx="2820">
                  <c:v>1.4216092996924208</c:v>
                </c:pt>
                <c:pt idx="2821">
                  <c:v>0.33844535726260716</c:v>
                </c:pt>
                <c:pt idx="2822">
                  <c:v>1.0047013721290932</c:v>
                </c:pt>
                <c:pt idx="2823">
                  <c:v>1.3689505856498092</c:v>
                </c:pt>
                <c:pt idx="2824">
                  <c:v>0.539846057423223</c:v>
                </c:pt>
                <c:pt idx="2825">
                  <c:v>0.21845356177307229</c:v>
                </c:pt>
                <c:pt idx="2826">
                  <c:v>0.35295086667414666</c:v>
                </c:pt>
                <c:pt idx="2827">
                  <c:v>7.6136957931053378E-2</c:v>
                </c:pt>
                <c:pt idx="2828">
                  <c:v>1.1408389235333318</c:v>
                </c:pt>
                <c:pt idx="2829">
                  <c:v>1.8885979954310643</c:v>
                </c:pt>
                <c:pt idx="2830">
                  <c:v>0.77268886797649416</c:v>
                </c:pt>
                <c:pt idx="2831">
                  <c:v>0.18285936357948426</c:v>
                </c:pt>
                <c:pt idx="2832">
                  <c:v>0.21622138959873632</c:v>
                </c:pt>
                <c:pt idx="2833">
                  <c:v>0.97410586401659249</c:v>
                </c:pt>
                <c:pt idx="2834">
                  <c:v>3.2237301671999168E-2</c:v>
                </c:pt>
                <c:pt idx="2835">
                  <c:v>1.119428980659352</c:v>
                </c:pt>
                <c:pt idx="2836">
                  <c:v>0.22724740987848788</c:v>
                </c:pt>
                <c:pt idx="2837">
                  <c:v>0.93588594169932537</c:v>
                </c:pt>
                <c:pt idx="2838">
                  <c:v>1.2155529631902264</c:v>
                </c:pt>
                <c:pt idx="2839">
                  <c:v>0.18685345816786852</c:v>
                </c:pt>
                <c:pt idx="2840">
                  <c:v>0.21067820552794303</c:v>
                </c:pt>
                <c:pt idx="2841">
                  <c:v>0.89733916044746198</c:v>
                </c:pt>
                <c:pt idx="2842">
                  <c:v>0.37051106659945499</c:v>
                </c:pt>
                <c:pt idx="2843">
                  <c:v>0.18159244536243627</c:v>
                </c:pt>
                <c:pt idx="2844">
                  <c:v>0.19294812800878511</c:v>
                </c:pt>
                <c:pt idx="2845">
                  <c:v>0.72207703113616184</c:v>
                </c:pt>
                <c:pt idx="2846">
                  <c:v>0.88363647048170546</c:v>
                </c:pt>
                <c:pt idx="2847">
                  <c:v>0.10333353026854884</c:v>
                </c:pt>
                <c:pt idx="2848">
                  <c:v>1.9813227710035624</c:v>
                </c:pt>
                <c:pt idx="2849">
                  <c:v>0.83669757856210814</c:v>
                </c:pt>
                <c:pt idx="2850">
                  <c:v>1.318948961495382</c:v>
                </c:pt>
                <c:pt idx="2851">
                  <c:v>0.22587361368218895</c:v>
                </c:pt>
                <c:pt idx="2852">
                  <c:v>0.34096394122624168</c:v>
                </c:pt>
                <c:pt idx="2853">
                  <c:v>0.91366431739092857</c:v>
                </c:pt>
                <c:pt idx="2854">
                  <c:v>1.4863068853341403</c:v>
                </c:pt>
                <c:pt idx="2855">
                  <c:v>5.675923812304217E-2</c:v>
                </c:pt>
                <c:pt idx="2856">
                  <c:v>0.48845734080487185</c:v>
                </c:pt>
                <c:pt idx="2857">
                  <c:v>0.52020304893939551</c:v>
                </c:pt>
                <c:pt idx="2858">
                  <c:v>0.12404902365093619</c:v>
                </c:pt>
                <c:pt idx="2859">
                  <c:v>0.23337971394679291</c:v>
                </c:pt>
                <c:pt idx="2860">
                  <c:v>1.149164216367768</c:v>
                </c:pt>
                <c:pt idx="2861">
                  <c:v>0.49617515314200356</c:v>
                </c:pt>
                <c:pt idx="2862">
                  <c:v>0.29431681140817045</c:v>
                </c:pt>
                <c:pt idx="2863">
                  <c:v>9.8977253069597051E-2</c:v>
                </c:pt>
                <c:pt idx="2864">
                  <c:v>0.54186841738353986</c:v>
                </c:pt>
                <c:pt idx="2865">
                  <c:v>0.47834069129482498</c:v>
                </c:pt>
                <c:pt idx="2866">
                  <c:v>0.20952418308944037</c:v>
                </c:pt>
                <c:pt idx="2867">
                  <c:v>0.58659103894956233</c:v>
                </c:pt>
                <c:pt idx="2868">
                  <c:v>0.65419132545785252</c:v>
                </c:pt>
                <c:pt idx="2869">
                  <c:v>0.20162618096180621</c:v>
                </c:pt>
                <c:pt idx="2870">
                  <c:v>7.3649595585983399E-2</c:v>
                </c:pt>
                <c:pt idx="2871">
                  <c:v>0.86109305052443719</c:v>
                </c:pt>
                <c:pt idx="2872">
                  <c:v>0.48658669294862777</c:v>
                </c:pt>
                <c:pt idx="2873">
                  <c:v>0.35151266528730507</c:v>
                </c:pt>
                <c:pt idx="2874">
                  <c:v>0.18885888536409431</c:v>
                </c:pt>
                <c:pt idx="2875">
                  <c:v>0.43772063905630454</c:v>
                </c:pt>
                <c:pt idx="2876">
                  <c:v>0.25488846578106406</c:v>
                </c:pt>
                <c:pt idx="2877">
                  <c:v>1.7285099779014261</c:v>
                </c:pt>
                <c:pt idx="2878">
                  <c:v>0.95917762180390442</c:v>
                </c:pt>
                <c:pt idx="2879">
                  <c:v>0.15610578597684396</c:v>
                </c:pt>
                <c:pt idx="2880">
                  <c:v>0.33339090972968999</c:v>
                </c:pt>
                <c:pt idx="2881">
                  <c:v>0.15963600471420239</c:v>
                </c:pt>
                <c:pt idx="2882">
                  <c:v>0.49168376236864508</c:v>
                </c:pt>
                <c:pt idx="2883">
                  <c:v>0.88832201539389744</c:v>
                </c:pt>
                <c:pt idx="2884">
                  <c:v>1.1514852274523233</c:v>
                </c:pt>
                <c:pt idx="2885">
                  <c:v>0.38456893213378168</c:v>
                </c:pt>
                <c:pt idx="2886">
                  <c:v>1.1328984159164874</c:v>
                </c:pt>
                <c:pt idx="2887">
                  <c:v>0.20244262107223265</c:v>
                </c:pt>
                <c:pt idx="2888">
                  <c:v>0.34503348955149477</c:v>
                </c:pt>
                <c:pt idx="2889">
                  <c:v>0.11952274833908343</c:v>
                </c:pt>
                <c:pt idx="2890">
                  <c:v>0.78861565843983172</c:v>
                </c:pt>
                <c:pt idx="2891">
                  <c:v>1.7396802998898696E-2</c:v>
                </c:pt>
                <c:pt idx="2892">
                  <c:v>0.63848058487010484</c:v>
                </c:pt>
                <c:pt idx="2893">
                  <c:v>1.1613205223322463</c:v>
                </c:pt>
                <c:pt idx="2894">
                  <c:v>0.9329901717077167</c:v>
                </c:pt>
                <c:pt idx="2895">
                  <c:v>1.7501763372434764</c:v>
                </c:pt>
                <c:pt idx="2896">
                  <c:v>0.16081874560576112</c:v>
                </c:pt>
                <c:pt idx="2897">
                  <c:v>0.52154597114677148</c:v>
                </c:pt>
                <c:pt idx="2898">
                  <c:v>1.7352306951126031</c:v>
                </c:pt>
                <c:pt idx="2899">
                  <c:v>8.0344257177685688E-2</c:v>
                </c:pt>
                <c:pt idx="2900">
                  <c:v>1.0502837055308478E-2</c:v>
                </c:pt>
                <c:pt idx="2901">
                  <c:v>0.95359538844966019</c:v>
                </c:pt>
                <c:pt idx="2902">
                  <c:v>1.0124006892795772</c:v>
                </c:pt>
                <c:pt idx="2903">
                  <c:v>0.21173511962809327</c:v>
                </c:pt>
                <c:pt idx="2904">
                  <c:v>0.20178737271175398</c:v>
                </c:pt>
                <c:pt idx="2905">
                  <c:v>0.22914019093528515</c:v>
                </c:pt>
                <c:pt idx="2906">
                  <c:v>7.4731277694025711E-2</c:v>
                </c:pt>
                <c:pt idx="2907">
                  <c:v>0.11148245755183164</c:v>
                </c:pt>
                <c:pt idx="2908">
                  <c:v>4.2348210322277313E-2</c:v>
                </c:pt>
                <c:pt idx="2909">
                  <c:v>0.4268866796460245</c:v>
                </c:pt>
                <c:pt idx="2910">
                  <c:v>1.01909737582327</c:v>
                </c:pt>
                <c:pt idx="2911">
                  <c:v>1.9846726082411309E-2</c:v>
                </c:pt>
                <c:pt idx="2912">
                  <c:v>3.5364489156101714E-2</c:v>
                </c:pt>
                <c:pt idx="2913">
                  <c:v>0.84399981426861226</c:v>
                </c:pt>
                <c:pt idx="2914">
                  <c:v>0.41895397308792692</c:v>
                </c:pt>
                <c:pt idx="2915">
                  <c:v>4.1243841509816796E-2</c:v>
                </c:pt>
                <c:pt idx="2916">
                  <c:v>0.22414600146685412</c:v>
                </c:pt>
                <c:pt idx="2917">
                  <c:v>0.72017352127827583</c:v>
                </c:pt>
                <c:pt idx="2918">
                  <c:v>0.85041711358603256</c:v>
                </c:pt>
                <c:pt idx="2919">
                  <c:v>0.110735521778673</c:v>
                </c:pt>
                <c:pt idx="2920">
                  <c:v>0.57935951071555603</c:v>
                </c:pt>
                <c:pt idx="2921">
                  <c:v>0.48831269595057958</c:v>
                </c:pt>
                <c:pt idx="2922">
                  <c:v>3.7466270672831203E-2</c:v>
                </c:pt>
                <c:pt idx="2923">
                  <c:v>1.0537010936042208</c:v>
                </c:pt>
                <c:pt idx="2924">
                  <c:v>0.47384698768836864</c:v>
                </c:pt>
                <c:pt idx="2925">
                  <c:v>0.99107842215914677</c:v>
                </c:pt>
                <c:pt idx="2926">
                  <c:v>0.35546075406927957</c:v>
                </c:pt>
                <c:pt idx="2927">
                  <c:v>0.28202077797756159</c:v>
                </c:pt>
                <c:pt idx="2928">
                  <c:v>0.48996421567878845</c:v>
                </c:pt>
                <c:pt idx="2929">
                  <c:v>0.12040196120485248</c:v>
                </c:pt>
                <c:pt idx="2930">
                  <c:v>0.40915908183361166</c:v>
                </c:pt>
                <c:pt idx="2931">
                  <c:v>0.78691197690680481</c:v>
                </c:pt>
                <c:pt idx="2932">
                  <c:v>0.17100243744034593</c:v>
                </c:pt>
                <c:pt idx="2933">
                  <c:v>0.22180437386365046</c:v>
                </c:pt>
                <c:pt idx="2934">
                  <c:v>0.30496094062621176</c:v>
                </c:pt>
                <c:pt idx="2935">
                  <c:v>1.1845670031401763</c:v>
                </c:pt>
                <c:pt idx="2936">
                  <c:v>0.50277246327532166</c:v>
                </c:pt>
                <c:pt idx="2937">
                  <c:v>0.98136876981470211</c:v>
                </c:pt>
                <c:pt idx="2938">
                  <c:v>0.52978544056078092</c:v>
                </c:pt>
                <c:pt idx="2939">
                  <c:v>5.2321917384723658E-2</c:v>
                </c:pt>
                <c:pt idx="2940">
                  <c:v>0.32034080062455578</c:v>
                </c:pt>
                <c:pt idx="2941">
                  <c:v>1.199923739014902</c:v>
                </c:pt>
                <c:pt idx="2942">
                  <c:v>1.0570829764632956</c:v>
                </c:pt>
                <c:pt idx="2943">
                  <c:v>0.4431361847776894</c:v>
                </c:pt>
                <c:pt idx="2944">
                  <c:v>0.39647575166269144</c:v>
                </c:pt>
                <c:pt idx="2945">
                  <c:v>0.52073657593643985</c:v>
                </c:pt>
                <c:pt idx="2946">
                  <c:v>0.46783242299385097</c:v>
                </c:pt>
                <c:pt idx="2947">
                  <c:v>7.0397215623421855E-2</c:v>
                </c:pt>
                <c:pt idx="2948">
                  <c:v>0.6205113597857036</c:v>
                </c:pt>
                <c:pt idx="2949">
                  <c:v>1.5184721322831878</c:v>
                </c:pt>
                <c:pt idx="2950">
                  <c:v>0.49955543060214863</c:v>
                </c:pt>
                <c:pt idx="2951">
                  <c:v>0.17619322375856886</c:v>
                </c:pt>
                <c:pt idx="2952">
                  <c:v>1.1266662476088276</c:v>
                </c:pt>
                <c:pt idx="2953">
                  <c:v>0.55640092499699834</c:v>
                </c:pt>
                <c:pt idx="2954">
                  <c:v>0.27483827459223825</c:v>
                </c:pt>
                <c:pt idx="2955">
                  <c:v>1.3881278361937293</c:v>
                </c:pt>
                <c:pt idx="2956">
                  <c:v>0.59623490972364701</c:v>
                </c:pt>
                <c:pt idx="2957">
                  <c:v>1.9420151996378771E-2</c:v>
                </c:pt>
                <c:pt idx="2958">
                  <c:v>0.32777016692220073</c:v>
                </c:pt>
                <c:pt idx="2959">
                  <c:v>0.75330809814935162</c:v>
                </c:pt>
                <c:pt idx="2960">
                  <c:v>0.8161218408363764</c:v>
                </c:pt>
                <c:pt idx="2961">
                  <c:v>1.0670782601633064</c:v>
                </c:pt>
                <c:pt idx="2962">
                  <c:v>0.16329954169251998</c:v>
                </c:pt>
                <c:pt idx="2963">
                  <c:v>1.2443176875557589</c:v>
                </c:pt>
                <c:pt idx="2964">
                  <c:v>3.6210822274559192E-2</c:v>
                </c:pt>
                <c:pt idx="2965">
                  <c:v>0.88775360152005756</c:v>
                </c:pt>
                <c:pt idx="2966">
                  <c:v>0.21370604332656043</c:v>
                </c:pt>
                <c:pt idx="2967">
                  <c:v>0.16017408149134324</c:v>
                </c:pt>
                <c:pt idx="2968">
                  <c:v>0.44353643590387887</c:v>
                </c:pt>
                <c:pt idx="2969">
                  <c:v>1.2208194665864989</c:v>
                </c:pt>
                <c:pt idx="2970">
                  <c:v>0.12054503501938994</c:v>
                </c:pt>
                <c:pt idx="2971">
                  <c:v>0.25277004755364452</c:v>
                </c:pt>
                <c:pt idx="2972">
                  <c:v>0.14300598644936724</c:v>
                </c:pt>
                <c:pt idx="2973">
                  <c:v>0.1839491772219444</c:v>
                </c:pt>
                <c:pt idx="2974">
                  <c:v>1.1471220188296896</c:v>
                </c:pt>
                <c:pt idx="2975">
                  <c:v>0.17324004654752639</c:v>
                </c:pt>
                <c:pt idx="2976">
                  <c:v>0.24854757043991349</c:v>
                </c:pt>
                <c:pt idx="2977">
                  <c:v>0.71342786226505972</c:v>
                </c:pt>
                <c:pt idx="2978">
                  <c:v>0.3427323592251757</c:v>
                </c:pt>
                <c:pt idx="2979">
                  <c:v>0.4555286459156333</c:v>
                </c:pt>
                <c:pt idx="2980">
                  <c:v>0.21813544244545061</c:v>
                </c:pt>
                <c:pt idx="2981">
                  <c:v>7.6019598443409456E-2</c:v>
                </c:pt>
                <c:pt idx="2982">
                  <c:v>1.3025941997861588</c:v>
                </c:pt>
                <c:pt idx="2983">
                  <c:v>0.62683750071137267</c:v>
                </c:pt>
                <c:pt idx="2984">
                  <c:v>0.279916663694664</c:v>
                </c:pt>
                <c:pt idx="2985">
                  <c:v>0.65650998163558683</c:v>
                </c:pt>
                <c:pt idx="2986">
                  <c:v>0.22161831472109675</c:v>
                </c:pt>
                <c:pt idx="2987">
                  <c:v>0.4952883724265843</c:v>
                </c:pt>
                <c:pt idx="2988">
                  <c:v>5.4971099264205174E-2</c:v>
                </c:pt>
                <c:pt idx="2989">
                  <c:v>1.3982751507280087</c:v>
                </c:pt>
                <c:pt idx="2990">
                  <c:v>0.23334553632897698</c:v>
                </c:pt>
                <c:pt idx="2991">
                  <c:v>1.0417056151897903</c:v>
                </c:pt>
                <c:pt idx="2992">
                  <c:v>0.22049129726795338</c:v>
                </c:pt>
                <c:pt idx="2993">
                  <c:v>0.13314593288884247</c:v>
                </c:pt>
                <c:pt idx="2994">
                  <c:v>0.63126961749057242</c:v>
                </c:pt>
                <c:pt idx="2995">
                  <c:v>0.21834392155378365</c:v>
                </c:pt>
                <c:pt idx="2996">
                  <c:v>1.026919965074844</c:v>
                </c:pt>
                <c:pt idx="2997">
                  <c:v>0.77104282789420353</c:v>
                </c:pt>
                <c:pt idx="2998">
                  <c:v>1.2292108097658556</c:v>
                </c:pt>
                <c:pt idx="2999">
                  <c:v>0.24296432817843716</c:v>
                </c:pt>
                <c:pt idx="3000">
                  <c:v>0.9448459042603593</c:v>
                </c:pt>
                <c:pt idx="3001">
                  <c:v>0.53616215358861041</c:v>
                </c:pt>
                <c:pt idx="3002">
                  <c:v>1.0213842965889914</c:v>
                </c:pt>
                <c:pt idx="3003">
                  <c:v>0.61457432142775992</c:v>
                </c:pt>
                <c:pt idx="3004">
                  <c:v>1.8465837814476485E-2</c:v>
                </c:pt>
                <c:pt idx="3005">
                  <c:v>0.21456260023001106</c:v>
                </c:pt>
                <c:pt idx="3006">
                  <c:v>1.4585753484627055</c:v>
                </c:pt>
                <c:pt idx="3007">
                  <c:v>1.1623477946932748</c:v>
                </c:pt>
                <c:pt idx="3008">
                  <c:v>0.63918890402181272</c:v>
                </c:pt>
                <c:pt idx="3009">
                  <c:v>0.12411953138145811</c:v>
                </c:pt>
                <c:pt idx="3010">
                  <c:v>9.0769260629754642E-2</c:v>
                </c:pt>
                <c:pt idx="3011">
                  <c:v>0.19482120855774784</c:v>
                </c:pt>
                <c:pt idx="3012">
                  <c:v>0.16150482384328926</c:v>
                </c:pt>
                <c:pt idx="3013">
                  <c:v>0.29770083538638248</c:v>
                </c:pt>
                <c:pt idx="3014">
                  <c:v>0.79806023646012836</c:v>
                </c:pt>
                <c:pt idx="3015">
                  <c:v>0.21536075355518378</c:v>
                </c:pt>
                <c:pt idx="3016">
                  <c:v>6.7722685162067156E-2</c:v>
                </c:pt>
                <c:pt idx="3017">
                  <c:v>0.8422858852320374</c:v>
                </c:pt>
                <c:pt idx="3018">
                  <c:v>0.10712642054706008</c:v>
                </c:pt>
                <c:pt idx="3019">
                  <c:v>0.15869811737748596</c:v>
                </c:pt>
                <c:pt idx="3020">
                  <c:v>0.51911408622676314</c:v>
                </c:pt>
                <c:pt idx="3021">
                  <c:v>0.12169183115594749</c:v>
                </c:pt>
                <c:pt idx="3022">
                  <c:v>0.18936269209965251</c:v>
                </c:pt>
                <c:pt idx="3023">
                  <c:v>1.8901629113356876E-2</c:v>
                </c:pt>
                <c:pt idx="3024">
                  <c:v>0.98669171033054104</c:v>
                </c:pt>
                <c:pt idx="3025">
                  <c:v>0.2467298098888584</c:v>
                </c:pt>
                <c:pt idx="3026">
                  <c:v>0.393102567991991</c:v>
                </c:pt>
                <c:pt idx="3027">
                  <c:v>0.18601590413374855</c:v>
                </c:pt>
                <c:pt idx="3028">
                  <c:v>0.70914471256383493</c:v>
                </c:pt>
                <c:pt idx="3029">
                  <c:v>0.28088904581557789</c:v>
                </c:pt>
                <c:pt idx="3030">
                  <c:v>0.41527302208790401</c:v>
                </c:pt>
                <c:pt idx="3031">
                  <c:v>0.6710724831929209</c:v>
                </c:pt>
                <c:pt idx="3032">
                  <c:v>0.93476324108164066</c:v>
                </c:pt>
                <c:pt idx="3033">
                  <c:v>0.75161439807428676</c:v>
                </c:pt>
                <c:pt idx="3034">
                  <c:v>0.43031112942758348</c:v>
                </c:pt>
                <c:pt idx="3035">
                  <c:v>0.89004794682582522</c:v>
                </c:pt>
                <c:pt idx="3036">
                  <c:v>0.19897593432437485</c:v>
                </c:pt>
                <c:pt idx="3037">
                  <c:v>0.27277664056136364</c:v>
                </c:pt>
                <c:pt idx="3038">
                  <c:v>0.23080073337190302</c:v>
                </c:pt>
                <c:pt idx="3039">
                  <c:v>0.7815955027319208</c:v>
                </c:pt>
                <c:pt idx="3040">
                  <c:v>0.50042945452096943</c:v>
                </c:pt>
                <c:pt idx="3041">
                  <c:v>6.9377592072154631E-2</c:v>
                </c:pt>
                <c:pt idx="3042">
                  <c:v>1.1559199905111366</c:v>
                </c:pt>
                <c:pt idx="3043">
                  <c:v>0.1828363967099349</c:v>
                </c:pt>
                <c:pt idx="3044">
                  <c:v>1.1818028283645221</c:v>
                </c:pt>
                <c:pt idx="3045">
                  <c:v>0.48349379582264079</c:v>
                </c:pt>
                <c:pt idx="3046">
                  <c:v>1.2414900156115118</c:v>
                </c:pt>
                <c:pt idx="3047">
                  <c:v>1.6570486936813605E-2</c:v>
                </c:pt>
                <c:pt idx="3048">
                  <c:v>1.0245900018602354</c:v>
                </c:pt>
                <c:pt idx="3049">
                  <c:v>0.18454746349010204</c:v>
                </c:pt>
                <c:pt idx="3050">
                  <c:v>3.7339826419026251E-2</c:v>
                </c:pt>
                <c:pt idx="3051">
                  <c:v>0.34577856505546545</c:v>
                </c:pt>
                <c:pt idx="3052">
                  <c:v>0.92680346367237232</c:v>
                </c:pt>
                <c:pt idx="3053">
                  <c:v>0.10182853413139423</c:v>
                </c:pt>
                <c:pt idx="3054">
                  <c:v>0.42044141165301063</c:v>
                </c:pt>
                <c:pt idx="3055">
                  <c:v>0.74663402201401907</c:v>
                </c:pt>
                <c:pt idx="3056">
                  <c:v>0.14906157890717772</c:v>
                </c:pt>
                <c:pt idx="3057">
                  <c:v>0.18740410037376917</c:v>
                </c:pt>
                <c:pt idx="3058">
                  <c:v>0.26740731565777864</c:v>
                </c:pt>
                <c:pt idx="3059">
                  <c:v>4.6619502158038825E-2</c:v>
                </c:pt>
                <c:pt idx="3060">
                  <c:v>0.20780122599844084</c:v>
                </c:pt>
                <c:pt idx="3061">
                  <c:v>0.45777994751043843</c:v>
                </c:pt>
                <c:pt idx="3062">
                  <c:v>1.2474326000410856</c:v>
                </c:pt>
                <c:pt idx="3063">
                  <c:v>0.34868736895391805</c:v>
                </c:pt>
                <c:pt idx="3064">
                  <c:v>0.37101145918102768</c:v>
                </c:pt>
                <c:pt idx="3065">
                  <c:v>0.31648123194012973</c:v>
                </c:pt>
                <c:pt idx="3066">
                  <c:v>1.9877330815027017E-2</c:v>
                </c:pt>
                <c:pt idx="3067">
                  <c:v>0.61638337032048807</c:v>
                </c:pt>
                <c:pt idx="3068">
                  <c:v>1.0725125858208846</c:v>
                </c:pt>
                <c:pt idx="3069">
                  <c:v>7.8680605666086229E-2</c:v>
                </c:pt>
                <c:pt idx="3070">
                  <c:v>0.16548870391906137</c:v>
                </c:pt>
                <c:pt idx="3071">
                  <c:v>0.12274364947616445</c:v>
                </c:pt>
                <c:pt idx="3072">
                  <c:v>0.46219750406748039</c:v>
                </c:pt>
                <c:pt idx="3073">
                  <c:v>1.0242301860425482</c:v>
                </c:pt>
                <c:pt idx="3074">
                  <c:v>0.86020919657804695</c:v>
                </c:pt>
                <c:pt idx="3075">
                  <c:v>1.0417476576932392</c:v>
                </c:pt>
                <c:pt idx="3076">
                  <c:v>0.16979091284717382</c:v>
                </c:pt>
                <c:pt idx="3077">
                  <c:v>0.37316838685962317</c:v>
                </c:pt>
                <c:pt idx="3078">
                  <c:v>0.15949930232349008</c:v>
                </c:pt>
                <c:pt idx="3079">
                  <c:v>1.5960730870206783</c:v>
                </c:pt>
                <c:pt idx="3080">
                  <c:v>0.8197159189139972</c:v>
                </c:pt>
                <c:pt idx="3081">
                  <c:v>0.4678385340331091</c:v>
                </c:pt>
                <c:pt idx="3082">
                  <c:v>1.3516401028164027E-2</c:v>
                </c:pt>
                <c:pt idx="3083">
                  <c:v>0.86929158642684923</c:v>
                </c:pt>
                <c:pt idx="3084">
                  <c:v>5.9027126790413768E-2</c:v>
                </c:pt>
                <c:pt idx="3085">
                  <c:v>1.0208708470676604</c:v>
                </c:pt>
                <c:pt idx="3086">
                  <c:v>4.1634715128265149E-3</c:v>
                </c:pt>
                <c:pt idx="3087">
                  <c:v>6.27905081626835E-2</c:v>
                </c:pt>
                <c:pt idx="3088">
                  <c:v>0.89519330112278472</c:v>
                </c:pt>
                <c:pt idx="3089">
                  <c:v>0.5834453358753342</c:v>
                </c:pt>
                <c:pt idx="3090">
                  <c:v>0.73711619885140878</c:v>
                </c:pt>
                <c:pt idx="3091">
                  <c:v>1.2004896673033949</c:v>
                </c:pt>
                <c:pt idx="3092">
                  <c:v>1.0588410432600184</c:v>
                </c:pt>
                <c:pt idx="3093">
                  <c:v>1.4886792803999835E-2</c:v>
                </c:pt>
                <c:pt idx="3094">
                  <c:v>0.71963161249660312</c:v>
                </c:pt>
                <c:pt idx="3095">
                  <c:v>1.4315613569830945</c:v>
                </c:pt>
                <c:pt idx="3096">
                  <c:v>0.62322819933911233</c:v>
                </c:pt>
                <c:pt idx="3097">
                  <c:v>0.8553292054206707</c:v>
                </c:pt>
                <c:pt idx="3098">
                  <c:v>0.79774094811374618</c:v>
                </c:pt>
                <c:pt idx="3099">
                  <c:v>0.45312954648158221</c:v>
                </c:pt>
                <c:pt idx="3100">
                  <c:v>3.354514796746981E-2</c:v>
                </c:pt>
                <c:pt idx="3101">
                  <c:v>0.67446401777462472</c:v>
                </c:pt>
                <c:pt idx="3102">
                  <c:v>0.47154877391856453</c:v>
                </c:pt>
                <c:pt idx="3103">
                  <c:v>0.63287394068355185</c:v>
                </c:pt>
                <c:pt idx="3104">
                  <c:v>1.1241960720138031</c:v>
                </c:pt>
                <c:pt idx="3105">
                  <c:v>1.2216663330178028</c:v>
                </c:pt>
                <c:pt idx="3106">
                  <c:v>0.71266173842749858</c:v>
                </c:pt>
                <c:pt idx="3107">
                  <c:v>2.6268530223840892E-2</c:v>
                </c:pt>
                <c:pt idx="3108">
                  <c:v>1.2012832072963817</c:v>
                </c:pt>
                <c:pt idx="3109">
                  <c:v>0.29997957809287834</c:v>
                </c:pt>
                <c:pt idx="3110">
                  <c:v>0.28666813084833215</c:v>
                </c:pt>
                <c:pt idx="3111">
                  <c:v>0.33168199224709827</c:v>
                </c:pt>
                <c:pt idx="3112">
                  <c:v>1.1713537427671101</c:v>
                </c:pt>
                <c:pt idx="3113">
                  <c:v>1.3809949420324941</c:v>
                </c:pt>
                <c:pt idx="3114">
                  <c:v>4.9429024495985366E-2</c:v>
                </c:pt>
                <c:pt idx="3115">
                  <c:v>0.34197516216404761</c:v>
                </c:pt>
                <c:pt idx="3116">
                  <c:v>0.98536818444456187</c:v>
                </c:pt>
                <c:pt idx="3117">
                  <c:v>0.20775833572750985</c:v>
                </c:pt>
                <c:pt idx="3118">
                  <c:v>0.11546201979323398</c:v>
                </c:pt>
                <c:pt idx="3119">
                  <c:v>0.14366603666328473</c:v>
                </c:pt>
                <c:pt idx="3120">
                  <c:v>0.19584623463750742</c:v>
                </c:pt>
                <c:pt idx="3121">
                  <c:v>0.3039731124228765</c:v>
                </c:pt>
                <c:pt idx="3122">
                  <c:v>3.3596747966752253E-3</c:v>
                </c:pt>
                <c:pt idx="3123">
                  <c:v>0.4442020976119514</c:v>
                </c:pt>
                <c:pt idx="3124">
                  <c:v>0.74577651095947473</c:v>
                </c:pt>
                <c:pt idx="3125">
                  <c:v>0.52876560759607416</c:v>
                </c:pt>
                <c:pt idx="3126">
                  <c:v>0.75731654225275125</c:v>
                </c:pt>
                <c:pt idx="3127">
                  <c:v>0.48901436862268149</c:v>
                </c:pt>
                <c:pt idx="3128">
                  <c:v>0.6038359523195308</c:v>
                </c:pt>
                <c:pt idx="3129">
                  <c:v>1.1617717020701104</c:v>
                </c:pt>
                <c:pt idx="3130">
                  <c:v>3.9557757519466309E-2</c:v>
                </c:pt>
                <c:pt idx="3131">
                  <c:v>0.94348504755493234</c:v>
                </c:pt>
                <c:pt idx="3132">
                  <c:v>1.4065280880594995</c:v>
                </c:pt>
                <c:pt idx="3133">
                  <c:v>1.5009433236329599E-2</c:v>
                </c:pt>
                <c:pt idx="3134">
                  <c:v>1.3658333260643576</c:v>
                </c:pt>
                <c:pt idx="3135">
                  <c:v>9.7626913617755037E-2</c:v>
                </c:pt>
                <c:pt idx="3136">
                  <c:v>0.35579165717069799</c:v>
                </c:pt>
                <c:pt idx="3137">
                  <c:v>0.10431891511065268</c:v>
                </c:pt>
                <c:pt idx="3138">
                  <c:v>1.4490612778750376</c:v>
                </c:pt>
                <c:pt idx="3139">
                  <c:v>0.42051344432449078</c:v>
                </c:pt>
                <c:pt idx="3140">
                  <c:v>0.44089755306342004</c:v>
                </c:pt>
                <c:pt idx="3141">
                  <c:v>1.4835396310882838</c:v>
                </c:pt>
                <c:pt idx="3142">
                  <c:v>0.46819908296572227</c:v>
                </c:pt>
                <c:pt idx="3143">
                  <c:v>0.48701642586795985</c:v>
                </c:pt>
                <c:pt idx="3144">
                  <c:v>0.45712190781040551</c:v>
                </c:pt>
                <c:pt idx="3145">
                  <c:v>0.28663566612137398</c:v>
                </c:pt>
                <c:pt idx="3146">
                  <c:v>0.98530089136137389</c:v>
                </c:pt>
                <c:pt idx="3147">
                  <c:v>3.7503016565774337E-2</c:v>
                </c:pt>
                <c:pt idx="3148">
                  <c:v>0.18489330301054446</c:v>
                </c:pt>
                <c:pt idx="3149">
                  <c:v>3.44366144998089E-2</c:v>
                </c:pt>
                <c:pt idx="3150">
                  <c:v>0.70104090626211835</c:v>
                </c:pt>
                <c:pt idx="3151">
                  <c:v>0.34593793899511588</c:v>
                </c:pt>
                <c:pt idx="3152">
                  <c:v>1.2406624168775979</c:v>
                </c:pt>
                <c:pt idx="3153">
                  <c:v>7.9462648309798128E-2</c:v>
                </c:pt>
                <c:pt idx="3154">
                  <c:v>1.0816947971976154</c:v>
                </c:pt>
                <c:pt idx="3155">
                  <c:v>1.2100699645041499</c:v>
                </c:pt>
                <c:pt idx="3156">
                  <c:v>0.84374204450717549</c:v>
                </c:pt>
                <c:pt idx="3157">
                  <c:v>0.77647691374259387</c:v>
                </c:pt>
                <c:pt idx="3158">
                  <c:v>0.32409081162982339</c:v>
                </c:pt>
                <c:pt idx="3159">
                  <c:v>0.45018466154522774</c:v>
                </c:pt>
                <c:pt idx="3160">
                  <c:v>0.9275345177521227</c:v>
                </c:pt>
                <c:pt idx="3161">
                  <c:v>0.67632410373542595</c:v>
                </c:pt>
                <c:pt idx="3162">
                  <c:v>0.1038233535400326</c:v>
                </c:pt>
                <c:pt idx="3163">
                  <c:v>5.5967171893216511E-2</c:v>
                </c:pt>
                <c:pt idx="3164">
                  <c:v>0.10865465870615919</c:v>
                </c:pt>
                <c:pt idx="3165">
                  <c:v>0.11773757107475104</c:v>
                </c:pt>
                <c:pt idx="3166">
                  <c:v>0.95249947647815503</c:v>
                </c:pt>
                <c:pt idx="3167">
                  <c:v>7.5795903860726377E-2</c:v>
                </c:pt>
                <c:pt idx="3168">
                  <c:v>0.51600416673631588</c:v>
                </c:pt>
                <c:pt idx="3169">
                  <c:v>0.66960832411101667</c:v>
                </c:pt>
                <c:pt idx="3170">
                  <c:v>0.68300096050867554</c:v>
                </c:pt>
                <c:pt idx="3171">
                  <c:v>0.14462822753830343</c:v>
                </c:pt>
                <c:pt idx="3172">
                  <c:v>0.50343248028100573</c:v>
                </c:pt>
                <c:pt idx="3173">
                  <c:v>2.1509752316117097</c:v>
                </c:pt>
                <c:pt idx="3174">
                  <c:v>0.78544395018991575</c:v>
                </c:pt>
                <c:pt idx="3175">
                  <c:v>8.4961816881800767E-2</c:v>
                </c:pt>
                <c:pt idx="3176">
                  <c:v>0.50469145665910353</c:v>
                </c:pt>
                <c:pt idx="3177">
                  <c:v>0.85449142645991072</c:v>
                </c:pt>
                <c:pt idx="3178">
                  <c:v>1.0141212356635676</c:v>
                </c:pt>
                <c:pt idx="3179">
                  <c:v>0.63150016645595186</c:v>
                </c:pt>
                <c:pt idx="3180">
                  <c:v>0.1674190022112462</c:v>
                </c:pt>
                <c:pt idx="3181">
                  <c:v>0.2556729735886753</c:v>
                </c:pt>
                <c:pt idx="3182">
                  <c:v>0.20040038146965869</c:v>
                </c:pt>
                <c:pt idx="3183">
                  <c:v>0.17006544035338572</c:v>
                </c:pt>
                <c:pt idx="3184">
                  <c:v>1.314028485520693</c:v>
                </c:pt>
                <c:pt idx="3185">
                  <c:v>0.71500037856789334</c:v>
                </c:pt>
                <c:pt idx="3186">
                  <c:v>1.1057396054111106</c:v>
                </c:pt>
                <c:pt idx="3187">
                  <c:v>0.41854959641481737</c:v>
                </c:pt>
                <c:pt idx="3188">
                  <c:v>0.21879625805928593</c:v>
                </c:pt>
                <c:pt idx="3189">
                  <c:v>0.94152142671520855</c:v>
                </c:pt>
                <c:pt idx="3190">
                  <c:v>0.99244137993267578</c:v>
                </c:pt>
                <c:pt idx="3191">
                  <c:v>0.60461839857957944</c:v>
                </c:pt>
                <c:pt idx="3192">
                  <c:v>0.4556070179209078</c:v>
                </c:pt>
                <c:pt idx="3193">
                  <c:v>0.16240741211871568</c:v>
                </c:pt>
                <c:pt idx="3194">
                  <c:v>1.0150189504746565</c:v>
                </c:pt>
                <c:pt idx="3195">
                  <c:v>0.28319248955291737</c:v>
                </c:pt>
                <c:pt idx="3196">
                  <c:v>1.1382599374198135</c:v>
                </c:pt>
                <c:pt idx="3197">
                  <c:v>4.9278682713736035E-3</c:v>
                </c:pt>
                <c:pt idx="3198">
                  <c:v>0.64357173712524574</c:v>
                </c:pt>
                <c:pt idx="3199">
                  <c:v>0.91571788406357135</c:v>
                </c:pt>
                <c:pt idx="3200">
                  <c:v>0.19325505102023233</c:v>
                </c:pt>
                <c:pt idx="3201">
                  <c:v>0.49397010885247178</c:v>
                </c:pt>
                <c:pt idx="3202">
                  <c:v>0.20035203383560285</c:v>
                </c:pt>
                <c:pt idx="3203">
                  <c:v>9.1835335876381596E-2</c:v>
                </c:pt>
                <c:pt idx="3204">
                  <c:v>6.2076235733520571E-2</c:v>
                </c:pt>
                <c:pt idx="3205">
                  <c:v>0.25470057461149687</c:v>
                </c:pt>
                <c:pt idx="3206">
                  <c:v>0.49763103535604553</c:v>
                </c:pt>
                <c:pt idx="3207">
                  <c:v>0.35802606752857219</c:v>
                </c:pt>
                <c:pt idx="3208">
                  <c:v>0.3373169273383676</c:v>
                </c:pt>
                <c:pt idx="3209">
                  <c:v>0.22922742710765964</c:v>
                </c:pt>
                <c:pt idx="3210">
                  <c:v>0.14957053007848906</c:v>
                </c:pt>
                <c:pt idx="3211">
                  <c:v>0.12505692271733188</c:v>
                </c:pt>
                <c:pt idx="3212">
                  <c:v>7.1948355116625534E-2</c:v>
                </c:pt>
                <c:pt idx="3213">
                  <c:v>0.61907304008863384</c:v>
                </c:pt>
                <c:pt idx="3214">
                  <c:v>1.0678555867338901</c:v>
                </c:pt>
                <c:pt idx="3215">
                  <c:v>0.14515084480999743</c:v>
                </c:pt>
                <c:pt idx="3216">
                  <c:v>0.17166725833962609</c:v>
                </c:pt>
                <c:pt idx="3217">
                  <c:v>0.23522870666459741</c:v>
                </c:pt>
                <c:pt idx="3218">
                  <c:v>0.14601280010375919</c:v>
                </c:pt>
                <c:pt idx="3219">
                  <c:v>1.3147921609115263</c:v>
                </c:pt>
                <c:pt idx="3220">
                  <c:v>0.33899178539101527</c:v>
                </c:pt>
                <c:pt idx="3221">
                  <c:v>0.16363036438005868</c:v>
                </c:pt>
                <c:pt idx="3222">
                  <c:v>0.6084555944472394</c:v>
                </c:pt>
                <c:pt idx="3223">
                  <c:v>0.87333270546771691</c:v>
                </c:pt>
                <c:pt idx="3224">
                  <c:v>0.32400968252612966</c:v>
                </c:pt>
                <c:pt idx="3225">
                  <c:v>5.1146994497276291E-2</c:v>
                </c:pt>
                <c:pt idx="3226">
                  <c:v>0.21853718834084171</c:v>
                </c:pt>
                <c:pt idx="3227">
                  <c:v>0.24930963771081738</c:v>
                </c:pt>
                <c:pt idx="3228">
                  <c:v>0.23928558344036788</c:v>
                </c:pt>
                <c:pt idx="3229">
                  <c:v>0.26872469967575713</c:v>
                </c:pt>
                <c:pt idx="3230">
                  <c:v>0.94520307770823486</c:v>
                </c:pt>
                <c:pt idx="3231">
                  <c:v>0.55551197645889971</c:v>
                </c:pt>
                <c:pt idx="3232">
                  <c:v>0.82169277498335191</c:v>
                </c:pt>
                <c:pt idx="3233">
                  <c:v>0.13045618988945076</c:v>
                </c:pt>
                <c:pt idx="3234">
                  <c:v>0.83197786402760621</c:v>
                </c:pt>
                <c:pt idx="3235">
                  <c:v>0.11898531482188404</c:v>
                </c:pt>
                <c:pt idx="3236">
                  <c:v>0.27346948930910558</c:v>
                </c:pt>
                <c:pt idx="3237">
                  <c:v>0.44752534176930003</c:v>
                </c:pt>
                <c:pt idx="3238">
                  <c:v>0.22411660243316725</c:v>
                </c:pt>
                <c:pt idx="3239">
                  <c:v>0.81285392460936556</c:v>
                </c:pt>
                <c:pt idx="3240">
                  <c:v>0.15698730104687036</c:v>
                </c:pt>
                <c:pt idx="3241">
                  <c:v>4.553247213415211E-2</c:v>
                </c:pt>
                <c:pt idx="3242">
                  <c:v>0.144614494276675</c:v>
                </c:pt>
                <c:pt idx="3243">
                  <c:v>0.11452380211786378</c:v>
                </c:pt>
                <c:pt idx="3244">
                  <c:v>5.5350697401410848E-3</c:v>
                </c:pt>
                <c:pt idx="3245">
                  <c:v>0.65364376692110793</c:v>
                </c:pt>
                <c:pt idx="3246">
                  <c:v>1.0065669622228055</c:v>
                </c:pt>
                <c:pt idx="3247">
                  <c:v>0.62221796308147082</c:v>
                </c:pt>
                <c:pt idx="3248">
                  <c:v>2.5157029588660822E-2</c:v>
                </c:pt>
                <c:pt idx="3249">
                  <c:v>1.5840130879729513</c:v>
                </c:pt>
                <c:pt idx="3250">
                  <c:v>2.2165444691853265E-2</c:v>
                </c:pt>
                <c:pt idx="3251">
                  <c:v>0.35169072030681497</c:v>
                </c:pt>
                <c:pt idx="3252">
                  <c:v>1.1011561906110872</c:v>
                </c:pt>
                <c:pt idx="3253">
                  <c:v>0.22184494333716059</c:v>
                </c:pt>
                <c:pt idx="3254">
                  <c:v>0.49467745647721384</c:v>
                </c:pt>
                <c:pt idx="3255">
                  <c:v>0.2243971690782392</c:v>
                </c:pt>
                <c:pt idx="3256">
                  <c:v>0.38656595725721038</c:v>
                </c:pt>
                <c:pt idx="3257">
                  <c:v>0.17825908560238998</c:v>
                </c:pt>
                <c:pt idx="3258">
                  <c:v>0.42799275862882874</c:v>
                </c:pt>
                <c:pt idx="3259">
                  <c:v>0.22797566171349889</c:v>
                </c:pt>
                <c:pt idx="3260">
                  <c:v>1.2386199373902791</c:v>
                </c:pt>
                <c:pt idx="3261">
                  <c:v>2.4203366402139041E-2</c:v>
                </c:pt>
                <c:pt idx="3262">
                  <c:v>0.13099762451076066</c:v>
                </c:pt>
                <c:pt idx="3263">
                  <c:v>0.76395625477853868</c:v>
                </c:pt>
                <c:pt idx="3264">
                  <c:v>0.85680247090688377</c:v>
                </c:pt>
                <c:pt idx="3265">
                  <c:v>0.42837855391060053</c:v>
                </c:pt>
                <c:pt idx="3266">
                  <c:v>0.47998088587366583</c:v>
                </c:pt>
                <c:pt idx="3267">
                  <c:v>1.1709499937723007</c:v>
                </c:pt>
                <c:pt idx="3268">
                  <c:v>8.2160416948244025E-2</c:v>
                </c:pt>
                <c:pt idx="3269">
                  <c:v>0.2378730814582066</c:v>
                </c:pt>
                <c:pt idx="3270">
                  <c:v>1.0291112236047559</c:v>
                </c:pt>
                <c:pt idx="3271">
                  <c:v>1.5132802469320124</c:v>
                </c:pt>
                <c:pt idx="3272">
                  <c:v>1.4184741322784107</c:v>
                </c:pt>
                <c:pt idx="3273">
                  <c:v>0.92548814175568594</c:v>
                </c:pt>
                <c:pt idx="3274">
                  <c:v>0.28393249434573309</c:v>
                </c:pt>
                <c:pt idx="3275">
                  <c:v>1.5002546076252248</c:v>
                </c:pt>
                <c:pt idx="3276">
                  <c:v>0.30548785035628684</c:v>
                </c:pt>
                <c:pt idx="3277">
                  <c:v>1.0108462728226391</c:v>
                </c:pt>
                <c:pt idx="3278">
                  <c:v>0.20987081497517937</c:v>
                </c:pt>
                <c:pt idx="3279">
                  <c:v>8.6258949486683167E-2</c:v>
                </c:pt>
                <c:pt idx="3280">
                  <c:v>0.22904765265401919</c:v>
                </c:pt>
                <c:pt idx="3281">
                  <c:v>0.16981707187704162</c:v>
                </c:pt>
                <c:pt idx="3282">
                  <c:v>0.22746726556155417</c:v>
                </c:pt>
                <c:pt idx="3283">
                  <c:v>0.38875374023157122</c:v>
                </c:pt>
                <c:pt idx="3284">
                  <c:v>0.97168185151699182</c:v>
                </c:pt>
                <c:pt idx="3285">
                  <c:v>0.16262042417082878</c:v>
                </c:pt>
                <c:pt idx="3286">
                  <c:v>3.3571951982148067E-2</c:v>
                </c:pt>
                <c:pt idx="3287">
                  <c:v>7.5294933108280476E-2</c:v>
                </c:pt>
                <c:pt idx="3288">
                  <c:v>1.1974382018801273</c:v>
                </c:pt>
                <c:pt idx="3289">
                  <c:v>0.20789784366906566</c:v>
                </c:pt>
                <c:pt idx="3290">
                  <c:v>0.48566237380912275</c:v>
                </c:pt>
                <c:pt idx="3291">
                  <c:v>0.40131594399846915</c:v>
                </c:pt>
                <c:pt idx="3292">
                  <c:v>0.77232935118624069</c:v>
                </c:pt>
                <c:pt idx="3293">
                  <c:v>0.81536690179128968</c:v>
                </c:pt>
                <c:pt idx="3294">
                  <c:v>0.19734719553601682</c:v>
                </c:pt>
                <c:pt idx="3295">
                  <c:v>2.7111564382334845</c:v>
                </c:pt>
                <c:pt idx="3296">
                  <c:v>9.3750604699121401E-2</c:v>
                </c:pt>
                <c:pt idx="3297">
                  <c:v>0.44161364918215396</c:v>
                </c:pt>
                <c:pt idx="3298">
                  <c:v>0.37558916901624245</c:v>
                </c:pt>
                <c:pt idx="3299">
                  <c:v>0.22823510885964474</c:v>
                </c:pt>
                <c:pt idx="3300">
                  <c:v>0.3451034378684732</c:v>
                </c:pt>
                <c:pt idx="3301">
                  <c:v>1.2636827274310478</c:v>
                </c:pt>
                <c:pt idx="3302">
                  <c:v>1.4312524575181242</c:v>
                </c:pt>
                <c:pt idx="3303">
                  <c:v>1.0870097908324865</c:v>
                </c:pt>
                <c:pt idx="3304">
                  <c:v>1.2774723245517245</c:v>
                </c:pt>
                <c:pt idx="3305">
                  <c:v>9.1708646358186943E-2</c:v>
                </c:pt>
                <c:pt idx="3306">
                  <c:v>0.57235905416969102</c:v>
                </c:pt>
                <c:pt idx="3307">
                  <c:v>0.54889131911127431</c:v>
                </c:pt>
                <c:pt idx="3308">
                  <c:v>0.26205105905586196</c:v>
                </c:pt>
                <c:pt idx="3309">
                  <c:v>1.0785608757358447</c:v>
                </c:pt>
                <c:pt idx="3310">
                  <c:v>0.32093442412335754</c:v>
                </c:pt>
                <c:pt idx="3311">
                  <c:v>0.3785356779078532</c:v>
                </c:pt>
                <c:pt idx="3312">
                  <c:v>0.63305719758694945</c:v>
                </c:pt>
                <c:pt idx="3313">
                  <c:v>0.30211067586149531</c:v>
                </c:pt>
                <c:pt idx="3314">
                  <c:v>0.19299916481969681</c:v>
                </c:pt>
                <c:pt idx="3315">
                  <c:v>0.23658138484643754</c:v>
                </c:pt>
                <c:pt idx="3316">
                  <c:v>0.86295122811782554</c:v>
                </c:pt>
                <c:pt idx="3317">
                  <c:v>1.2645446039839312</c:v>
                </c:pt>
                <c:pt idx="3318">
                  <c:v>2.6130164759488771E-2</c:v>
                </c:pt>
                <c:pt idx="3319">
                  <c:v>0.20608593036911446</c:v>
                </c:pt>
                <c:pt idx="3320">
                  <c:v>0.30025487993934474</c:v>
                </c:pt>
                <c:pt idx="3321">
                  <c:v>0.48654785233904324</c:v>
                </c:pt>
                <c:pt idx="3322">
                  <c:v>0.45489721025328106</c:v>
                </c:pt>
                <c:pt idx="3323">
                  <c:v>0.82286025435207222</c:v>
                </c:pt>
                <c:pt idx="3324">
                  <c:v>0.498488225806430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CF9-4657-BFEE-C00336E8EEA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343D99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HFD Prot'!$E$2:$E$90</c:f>
              <c:numCache>
                <c:formatCode>General</c:formatCode>
                <c:ptCount val="89"/>
                <c:pt idx="0">
                  <c:v>-0.76247638804698503</c:v>
                </c:pt>
                <c:pt idx="1">
                  <c:v>-0.91792816330711668</c:v>
                </c:pt>
                <c:pt idx="2">
                  <c:v>-1.3774569607040432</c:v>
                </c:pt>
                <c:pt idx="3">
                  <c:v>-0.99015616662739125</c:v>
                </c:pt>
                <c:pt idx="4">
                  <c:v>-0.60587356630284617</c:v>
                </c:pt>
                <c:pt idx="5">
                  <c:v>-0.83616652363581956</c:v>
                </c:pt>
                <c:pt idx="6">
                  <c:v>-1.5451776346152923</c:v>
                </c:pt>
                <c:pt idx="7">
                  <c:v>-1.3339961181964528</c:v>
                </c:pt>
                <c:pt idx="8">
                  <c:v>-1.1444379983683917</c:v>
                </c:pt>
                <c:pt idx="9">
                  <c:v>-1.2838032709283658</c:v>
                </c:pt>
                <c:pt idx="10">
                  <c:v>-0.94200771368796388</c:v>
                </c:pt>
                <c:pt idx="11">
                  <c:v>-1.0229713991348162</c:v>
                </c:pt>
                <c:pt idx="12">
                  <c:v>-0.63747113988475901</c:v>
                </c:pt>
                <c:pt idx="13">
                  <c:v>-0.83689362740974305</c:v>
                </c:pt>
                <c:pt idx="14">
                  <c:v>-1.0302654428576696</c:v>
                </c:pt>
                <c:pt idx="15">
                  <c:v>-0.8628282579560359</c:v>
                </c:pt>
                <c:pt idx="16">
                  <c:v>-1.8349538690793512</c:v>
                </c:pt>
                <c:pt idx="17">
                  <c:v>-1.5365502955359103</c:v>
                </c:pt>
                <c:pt idx="18">
                  <c:v>-1.0240359354555095</c:v>
                </c:pt>
                <c:pt idx="19">
                  <c:v>-0.70239158430805082</c:v>
                </c:pt>
                <c:pt idx="20">
                  <c:v>-1.0312540254705007</c:v>
                </c:pt>
                <c:pt idx="21">
                  <c:v>-1.0574156124272431</c:v>
                </c:pt>
                <c:pt idx="22">
                  <c:v>-0.60112598060182798</c:v>
                </c:pt>
                <c:pt idx="23">
                  <c:v>-0.69144483119113753</c:v>
                </c:pt>
                <c:pt idx="24">
                  <c:v>-0.83866945099319246</c:v>
                </c:pt>
                <c:pt idx="25">
                  <c:v>-1.0729289824955572</c:v>
                </c:pt>
                <c:pt idx="26">
                  <c:v>-0.79618241072000462</c:v>
                </c:pt>
                <c:pt idx="27">
                  <c:v>-0.68275306123054602</c:v>
                </c:pt>
                <c:pt idx="28">
                  <c:v>-1.1123665230725632</c:v>
                </c:pt>
                <c:pt idx="29">
                  <c:v>-0.93900084506951331</c:v>
                </c:pt>
                <c:pt idx="30">
                  <c:v>-0.65791434268037596</c:v>
                </c:pt>
                <c:pt idx="31">
                  <c:v>-1.8183188576126903</c:v>
                </c:pt>
                <c:pt idx="32">
                  <c:v>-0.64376385433734229</c:v>
                </c:pt>
                <c:pt idx="33">
                  <c:v>-1.4129440733687182</c:v>
                </c:pt>
                <c:pt idx="34">
                  <c:v>-0.89390578884636984</c:v>
                </c:pt>
                <c:pt idx="35">
                  <c:v>-0.80405355896735309</c:v>
                </c:pt>
                <c:pt idx="36">
                  <c:v>-1.2918981960466791</c:v>
                </c:pt>
                <c:pt idx="37">
                  <c:v>-0.74562458083450056</c:v>
                </c:pt>
                <c:pt idx="38">
                  <c:v>-0.65416054099561904</c:v>
                </c:pt>
                <c:pt idx="39">
                  <c:v>-1.7657468917998551</c:v>
                </c:pt>
                <c:pt idx="40">
                  <c:v>-1.7833309238236759</c:v>
                </c:pt>
                <c:pt idx="41">
                  <c:v>-0.98797566083537314</c:v>
                </c:pt>
                <c:pt idx="42">
                  <c:v>-1.8968143319082138</c:v>
                </c:pt>
                <c:pt idx="43">
                  <c:v>-0.68697107716927519</c:v>
                </c:pt>
                <c:pt idx="44">
                  <c:v>-1.6083361503476614</c:v>
                </c:pt>
                <c:pt idx="45">
                  <c:v>-0.95932503923913226</c:v>
                </c:pt>
                <c:pt idx="46">
                  <c:v>-0.73734064612219552</c:v>
                </c:pt>
                <c:pt idx="47">
                  <c:v>-0.73777327725893971</c:v>
                </c:pt>
                <c:pt idx="48">
                  <c:v>-1.0964642750180307</c:v>
                </c:pt>
                <c:pt idx="49">
                  <c:v>-1.0483059467824705</c:v>
                </c:pt>
                <c:pt idx="50">
                  <c:v>-1.1516640202677821</c:v>
                </c:pt>
                <c:pt idx="51">
                  <c:v>-0.6152279435788256</c:v>
                </c:pt>
                <c:pt idx="52">
                  <c:v>-2.1284253890288376</c:v>
                </c:pt>
                <c:pt idx="53">
                  <c:v>-1.0099204095930638</c:v>
                </c:pt>
                <c:pt idx="54">
                  <c:v>-0.75094945249059508</c:v>
                </c:pt>
                <c:pt idx="55">
                  <c:v>-0.7911889415033605</c:v>
                </c:pt>
                <c:pt idx="56">
                  <c:v>-1.267595721851879</c:v>
                </c:pt>
                <c:pt idx="57">
                  <c:v>-1.9808296207506739</c:v>
                </c:pt>
                <c:pt idx="58">
                  <c:v>-0.7015046997649127</c:v>
                </c:pt>
                <c:pt idx="59">
                  <c:v>-0.74166113042715764</c:v>
                </c:pt>
                <c:pt idx="60">
                  <c:v>-1.0583164955908229</c:v>
                </c:pt>
                <c:pt idx="61">
                  <c:v>-0.62283666638227653</c:v>
                </c:pt>
                <c:pt idx="62">
                  <c:v>-0.63245435768942204</c:v>
                </c:pt>
                <c:pt idx="63">
                  <c:v>-0.68086442237598654</c:v>
                </c:pt>
                <c:pt idx="64">
                  <c:v>-0.61720443185865026</c:v>
                </c:pt>
                <c:pt idx="65">
                  <c:v>-0.80479702460652669</c:v>
                </c:pt>
                <c:pt idx="66">
                  <c:v>-0.6117389574989458</c:v>
                </c:pt>
                <c:pt idx="67">
                  <c:v>-0.64441007833062824</c:v>
                </c:pt>
                <c:pt idx="68">
                  <c:v>-2.2946354514413301</c:v>
                </c:pt>
                <c:pt idx="69">
                  <c:v>-1.7303573665017598</c:v>
                </c:pt>
                <c:pt idx="70">
                  <c:v>-0.77997406106575684</c:v>
                </c:pt>
                <c:pt idx="71">
                  <c:v>-1.2063931685116041</c:v>
                </c:pt>
                <c:pt idx="72">
                  <c:v>-1.2584586227179009</c:v>
                </c:pt>
                <c:pt idx="73">
                  <c:v>-2.2121023716867065</c:v>
                </c:pt>
                <c:pt idx="74">
                  <c:v>-0.77002556355427931</c:v>
                </c:pt>
                <c:pt idx="75">
                  <c:v>-0.80735492205760429</c:v>
                </c:pt>
                <c:pt idx="76">
                  <c:v>-0.64745267005424578</c:v>
                </c:pt>
                <c:pt idx="77">
                  <c:v>-1.3242921767367395</c:v>
                </c:pt>
                <c:pt idx="78">
                  <c:v>-0.79135566923276024</c:v>
                </c:pt>
                <c:pt idx="79">
                  <c:v>-0.80297898731131634</c:v>
                </c:pt>
                <c:pt idx="80">
                  <c:v>-1.4713435596107205</c:v>
                </c:pt>
                <c:pt idx="81">
                  <c:v>-1.0447438212243978</c:v>
                </c:pt>
                <c:pt idx="82">
                  <c:v>-0.71343188307309102</c:v>
                </c:pt>
                <c:pt idx="83">
                  <c:v>-0.85039939677025445</c:v>
                </c:pt>
                <c:pt idx="84">
                  <c:v>-1.6668020303831266</c:v>
                </c:pt>
                <c:pt idx="85">
                  <c:v>-0.69314122683028578</c:v>
                </c:pt>
                <c:pt idx="86">
                  <c:v>-0.96295614047042577</c:v>
                </c:pt>
                <c:pt idx="87">
                  <c:v>-0.72561029387599807</c:v>
                </c:pt>
                <c:pt idx="88">
                  <c:v>-0.76934859947785939</c:v>
                </c:pt>
              </c:numCache>
            </c:numRef>
          </c:xVal>
          <c:yVal>
            <c:numRef>
              <c:f>'sDM - HFD Prot'!$F$2:$F$90</c:f>
              <c:numCache>
                <c:formatCode>General</c:formatCode>
                <c:ptCount val="89"/>
                <c:pt idx="0">
                  <c:v>1.7893048182366689</c:v>
                </c:pt>
                <c:pt idx="1">
                  <c:v>1.3178108102668684</c:v>
                </c:pt>
                <c:pt idx="2">
                  <c:v>3.3539334519244774</c:v>
                </c:pt>
                <c:pt idx="3">
                  <c:v>1.5952462509101379</c:v>
                </c:pt>
                <c:pt idx="4">
                  <c:v>1.3240988096793871</c:v>
                </c:pt>
                <c:pt idx="5">
                  <c:v>2.2269847810253416</c:v>
                </c:pt>
                <c:pt idx="6">
                  <c:v>1.5936362887508986</c:v>
                </c:pt>
                <c:pt idx="7">
                  <c:v>1.8583335459182879</c:v>
                </c:pt>
                <c:pt idx="8">
                  <c:v>2.0911673839880844</c:v>
                </c:pt>
                <c:pt idx="9">
                  <c:v>1.4523802705052302</c:v>
                </c:pt>
                <c:pt idx="10">
                  <c:v>1.4259009557431539</c:v>
                </c:pt>
                <c:pt idx="11">
                  <c:v>1.619071715332689</c:v>
                </c:pt>
                <c:pt idx="12">
                  <c:v>1.586354703778321</c:v>
                </c:pt>
                <c:pt idx="13">
                  <c:v>1.9570189650821816</c:v>
                </c:pt>
                <c:pt idx="14">
                  <c:v>2.3305899428765979</c:v>
                </c:pt>
                <c:pt idx="15">
                  <c:v>3.2186621807082672</c:v>
                </c:pt>
                <c:pt idx="16">
                  <c:v>2.343751766239508</c:v>
                </c:pt>
                <c:pt idx="17">
                  <c:v>1.6623525319412111</c:v>
                </c:pt>
                <c:pt idx="18">
                  <c:v>1.393425276988207</c:v>
                </c:pt>
                <c:pt idx="19">
                  <c:v>1.4062551729720036</c:v>
                </c:pt>
                <c:pt idx="20">
                  <c:v>1.6286966240723129</c:v>
                </c:pt>
                <c:pt idx="21">
                  <c:v>1.6350634006653859</c:v>
                </c:pt>
                <c:pt idx="22">
                  <c:v>1.3070581963397989</c:v>
                </c:pt>
                <c:pt idx="23">
                  <c:v>2.0170791295615871</c:v>
                </c:pt>
                <c:pt idx="24">
                  <c:v>1.6445531266888997</c:v>
                </c:pt>
                <c:pt idx="25">
                  <c:v>1.9528937239855588</c:v>
                </c:pt>
                <c:pt idx="26">
                  <c:v>1.4312366358241306</c:v>
                </c:pt>
                <c:pt idx="27">
                  <c:v>1.627881155608796</c:v>
                </c:pt>
                <c:pt idx="28">
                  <c:v>1.7369415787525242</c:v>
                </c:pt>
                <c:pt idx="29">
                  <c:v>1.6783534648433382</c:v>
                </c:pt>
                <c:pt idx="30">
                  <c:v>1.8899434484683721</c:v>
                </c:pt>
                <c:pt idx="31">
                  <c:v>1.7378084222626695</c:v>
                </c:pt>
                <c:pt idx="32">
                  <c:v>1.4592786450041551</c:v>
                </c:pt>
                <c:pt idx="33">
                  <c:v>3.0500558562765576</c:v>
                </c:pt>
                <c:pt idx="34">
                  <c:v>1.5561022216150144</c:v>
                </c:pt>
                <c:pt idx="35">
                  <c:v>1.6933939198677026</c:v>
                </c:pt>
                <c:pt idx="36">
                  <c:v>2.076768570069528</c:v>
                </c:pt>
                <c:pt idx="37">
                  <c:v>2.3158234148782717</c:v>
                </c:pt>
                <c:pt idx="38">
                  <c:v>1.4279837266286699</c:v>
                </c:pt>
                <c:pt idx="39">
                  <c:v>1.9882252514291323</c:v>
                </c:pt>
                <c:pt idx="40">
                  <c:v>1.6676533205110677</c:v>
                </c:pt>
                <c:pt idx="41">
                  <c:v>1.8189487585309334</c:v>
                </c:pt>
                <c:pt idx="42">
                  <c:v>2.9401816585021288</c:v>
                </c:pt>
                <c:pt idx="43">
                  <c:v>1.313483267953562</c:v>
                </c:pt>
                <c:pt idx="44">
                  <c:v>1.3506337535677291</c:v>
                </c:pt>
                <c:pt idx="45">
                  <c:v>1.7314566863675869</c:v>
                </c:pt>
                <c:pt idx="46">
                  <c:v>2.9123345953779087</c:v>
                </c:pt>
                <c:pt idx="47">
                  <c:v>1.39248294285255</c:v>
                </c:pt>
                <c:pt idx="48">
                  <c:v>3.0651573964952648</c:v>
                </c:pt>
                <c:pt idx="49">
                  <c:v>2.2442257161475143</c:v>
                </c:pt>
                <c:pt idx="50">
                  <c:v>2.7129604507542409</c:v>
                </c:pt>
                <c:pt idx="51">
                  <c:v>1.32757051288801</c:v>
                </c:pt>
                <c:pt idx="52">
                  <c:v>1.6710807879995806</c:v>
                </c:pt>
                <c:pt idx="53">
                  <c:v>2.9692270599932624</c:v>
                </c:pt>
                <c:pt idx="54">
                  <c:v>1.8337510051418866</c:v>
                </c:pt>
                <c:pt idx="55">
                  <c:v>2.3272326119103162</c:v>
                </c:pt>
                <c:pt idx="56">
                  <c:v>2.0594240490336331</c:v>
                </c:pt>
                <c:pt idx="57">
                  <c:v>1.3442027761922635</c:v>
                </c:pt>
                <c:pt idx="58">
                  <c:v>2.2993843901010216</c:v>
                </c:pt>
                <c:pt idx="59">
                  <c:v>1.8167487093084334</c:v>
                </c:pt>
                <c:pt idx="60">
                  <c:v>1.7069913043999949</c:v>
                </c:pt>
                <c:pt idx="61">
                  <c:v>2.7911419735838678</c:v>
                </c:pt>
                <c:pt idx="62">
                  <c:v>3.1523280650185344</c:v>
                </c:pt>
                <c:pt idx="63">
                  <c:v>1.9947787583365943</c:v>
                </c:pt>
                <c:pt idx="64">
                  <c:v>1.7145960626352665</c:v>
                </c:pt>
                <c:pt idx="65">
                  <c:v>1.3700675105485387</c:v>
                </c:pt>
                <c:pt idx="66">
                  <c:v>1.6631681307330739</c:v>
                </c:pt>
                <c:pt idx="67">
                  <c:v>1.4628412275691671</c:v>
                </c:pt>
                <c:pt idx="68">
                  <c:v>1.8827274679956238</c:v>
                </c:pt>
                <c:pt idx="69">
                  <c:v>2.0385933848054618</c:v>
                </c:pt>
                <c:pt idx="70">
                  <c:v>1.7542794733708404</c:v>
                </c:pt>
                <c:pt idx="71">
                  <c:v>2.2196081993292602</c:v>
                </c:pt>
                <c:pt idx="72">
                  <c:v>1.5777418200181321</c:v>
                </c:pt>
                <c:pt idx="73">
                  <c:v>3.1624529060424136</c:v>
                </c:pt>
                <c:pt idx="74">
                  <c:v>1.6654662583888944</c:v>
                </c:pt>
                <c:pt idx="75">
                  <c:v>1.3433492003945404</c:v>
                </c:pt>
                <c:pt idx="76">
                  <c:v>1.5376300673821055</c:v>
                </c:pt>
                <c:pt idx="77">
                  <c:v>2.0076177447892327</c:v>
                </c:pt>
                <c:pt idx="78">
                  <c:v>2.7741074443907365</c:v>
                </c:pt>
                <c:pt idx="79">
                  <c:v>1.5798028284253025</c:v>
                </c:pt>
                <c:pt idx="80">
                  <c:v>2.5580817057910061</c:v>
                </c:pt>
                <c:pt idx="81">
                  <c:v>1.6374014360802194</c:v>
                </c:pt>
                <c:pt idx="82">
                  <c:v>2.2846849573128631</c:v>
                </c:pt>
                <c:pt idx="83">
                  <c:v>1.8536045062674391</c:v>
                </c:pt>
                <c:pt idx="84">
                  <c:v>1.349874753644341</c:v>
                </c:pt>
                <c:pt idx="85">
                  <c:v>1.8559540339290062</c:v>
                </c:pt>
                <c:pt idx="86">
                  <c:v>1.9142298792826984</c:v>
                </c:pt>
                <c:pt idx="87">
                  <c:v>3.2789656129389861</c:v>
                </c:pt>
                <c:pt idx="88">
                  <c:v>1.66249401971740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F9-4657-BFEE-C00336E8EEA9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rgbClr val="A00828"/>
              </a:solidFill>
              <a:ln w="3175">
                <a:solidFill>
                  <a:schemeClr val="bg1"/>
                </a:solidFill>
              </a:ln>
              <a:effectLst/>
            </c:spPr>
          </c:marker>
          <c:xVal>
            <c:numRef>
              <c:f>'sDM - HFD Prot'!$I$2:$I$72</c:f>
              <c:numCache>
                <c:formatCode>General</c:formatCode>
                <c:ptCount val="71"/>
                <c:pt idx="0">
                  <c:v>0.67346265186004817</c:v>
                </c:pt>
                <c:pt idx="1">
                  <c:v>1.1716933862243561</c:v>
                </c:pt>
                <c:pt idx="2">
                  <c:v>0.80414849142435563</c:v>
                </c:pt>
                <c:pt idx="3">
                  <c:v>0.90968852862396332</c:v>
                </c:pt>
                <c:pt idx="4">
                  <c:v>2.9770995978899211</c:v>
                </c:pt>
                <c:pt idx="5">
                  <c:v>1.4985863331242193</c:v>
                </c:pt>
                <c:pt idx="6">
                  <c:v>1.1046973786666934</c:v>
                </c:pt>
                <c:pt idx="7">
                  <c:v>1.6684094241337628</c:v>
                </c:pt>
                <c:pt idx="8">
                  <c:v>1.8328990310369249</c:v>
                </c:pt>
                <c:pt idx="9">
                  <c:v>0.92933589922121029</c:v>
                </c:pt>
                <c:pt idx="10">
                  <c:v>1.4134994447185751</c:v>
                </c:pt>
                <c:pt idx="11">
                  <c:v>1.1564984744631772</c:v>
                </c:pt>
                <c:pt idx="12">
                  <c:v>1.6357637688260032</c:v>
                </c:pt>
                <c:pt idx="13">
                  <c:v>0.91403154613783488</c:v>
                </c:pt>
                <c:pt idx="14">
                  <c:v>1.4285658841234907</c:v>
                </c:pt>
                <c:pt idx="15">
                  <c:v>0.65176758076072938</c:v>
                </c:pt>
                <c:pt idx="16">
                  <c:v>1.3815733833540695</c:v>
                </c:pt>
                <c:pt idx="17">
                  <c:v>0.86643647425889414</c:v>
                </c:pt>
                <c:pt idx="18">
                  <c:v>0.64408162848772166</c:v>
                </c:pt>
                <c:pt idx="19">
                  <c:v>0.80163157689748055</c:v>
                </c:pt>
                <c:pt idx="20">
                  <c:v>0.92713959806875512</c:v>
                </c:pt>
                <c:pt idx="21">
                  <c:v>1.5340777606960627</c:v>
                </c:pt>
                <c:pt idx="22">
                  <c:v>1.5500425163719964</c:v>
                </c:pt>
                <c:pt idx="23">
                  <c:v>1.5149854303096002</c:v>
                </c:pt>
                <c:pt idx="24">
                  <c:v>0.60581515276321474</c:v>
                </c:pt>
                <c:pt idx="25">
                  <c:v>0.64070374110780282</c:v>
                </c:pt>
                <c:pt idx="26">
                  <c:v>0.81654524582505794</c:v>
                </c:pt>
                <c:pt idx="27">
                  <c:v>1.3107903116983697</c:v>
                </c:pt>
                <c:pt idx="28">
                  <c:v>1.723086516754077</c:v>
                </c:pt>
                <c:pt idx="29">
                  <c:v>0.71619672907163412</c:v>
                </c:pt>
                <c:pt idx="30">
                  <c:v>0.82495451388908625</c:v>
                </c:pt>
                <c:pt idx="31">
                  <c:v>1.0664273617389761</c:v>
                </c:pt>
                <c:pt idx="32">
                  <c:v>1.0712696403889572</c:v>
                </c:pt>
                <c:pt idx="33">
                  <c:v>1.2629189948469006</c:v>
                </c:pt>
                <c:pt idx="34">
                  <c:v>1.6371093573341398</c:v>
                </c:pt>
                <c:pt idx="35">
                  <c:v>1.4394806784556315</c:v>
                </c:pt>
                <c:pt idx="36">
                  <c:v>1.2656914099030931</c:v>
                </c:pt>
                <c:pt idx="37">
                  <c:v>1.1062494982794342</c:v>
                </c:pt>
                <c:pt idx="38">
                  <c:v>0.6999348632212391</c:v>
                </c:pt>
                <c:pt idx="39">
                  <c:v>1.1127866970487705</c:v>
                </c:pt>
                <c:pt idx="40">
                  <c:v>0.68223286148778017</c:v>
                </c:pt>
                <c:pt idx="41">
                  <c:v>0.70110711894583888</c:v>
                </c:pt>
                <c:pt idx="42">
                  <c:v>1.092647815828629</c:v>
                </c:pt>
                <c:pt idx="43">
                  <c:v>0.75901409597526126</c:v>
                </c:pt>
                <c:pt idx="44">
                  <c:v>1.5174614521545846</c:v>
                </c:pt>
                <c:pt idx="45">
                  <c:v>2.2002495382991101</c:v>
                </c:pt>
                <c:pt idx="46">
                  <c:v>0.84944032342461862</c:v>
                </c:pt>
                <c:pt idx="47">
                  <c:v>1.1597180585730553</c:v>
                </c:pt>
                <c:pt idx="48">
                  <c:v>0.98079626602690717</c:v>
                </c:pt>
                <c:pt idx="49">
                  <c:v>0.98336105788621087</c:v>
                </c:pt>
                <c:pt idx="50">
                  <c:v>0.81400662993003414</c:v>
                </c:pt>
                <c:pt idx="51">
                  <c:v>1.4239132758205997</c:v>
                </c:pt>
                <c:pt idx="52">
                  <c:v>1.3857141938809536</c:v>
                </c:pt>
                <c:pt idx="53">
                  <c:v>1.6073528560357369</c:v>
                </c:pt>
                <c:pt idx="54">
                  <c:v>1.1600404125104682</c:v>
                </c:pt>
                <c:pt idx="55">
                  <c:v>1.1668265367616597</c:v>
                </c:pt>
                <c:pt idx="56">
                  <c:v>0.98593041749834409</c:v>
                </c:pt>
                <c:pt idx="57">
                  <c:v>1.2852489406569145</c:v>
                </c:pt>
                <c:pt idx="58">
                  <c:v>0.6829275224630289</c:v>
                </c:pt>
                <c:pt idx="59">
                  <c:v>0.60603472433975736</c:v>
                </c:pt>
                <c:pt idx="60">
                  <c:v>0.64588640750762316</c:v>
                </c:pt>
                <c:pt idx="61">
                  <c:v>1.1860649295186829</c:v>
                </c:pt>
                <c:pt idx="62">
                  <c:v>0.68570951601200392</c:v>
                </c:pt>
                <c:pt idx="63">
                  <c:v>0.9134879534257182</c:v>
                </c:pt>
                <c:pt idx="64">
                  <c:v>2.7216583413783577</c:v>
                </c:pt>
                <c:pt idx="65">
                  <c:v>0.71122803275259794</c:v>
                </c:pt>
                <c:pt idx="66">
                  <c:v>1.0944950568503844</c:v>
                </c:pt>
                <c:pt idx="67">
                  <c:v>0.61087377307529578</c:v>
                </c:pt>
                <c:pt idx="68">
                  <c:v>0.85569253273695767</c:v>
                </c:pt>
                <c:pt idx="69">
                  <c:v>0.96493920309488579</c:v>
                </c:pt>
                <c:pt idx="70">
                  <c:v>1.3695945285176767</c:v>
                </c:pt>
              </c:numCache>
            </c:numRef>
          </c:xVal>
          <c:yVal>
            <c:numRef>
              <c:f>'sDM - HFD Prot'!$J$2:$J$72</c:f>
              <c:numCache>
                <c:formatCode>General</c:formatCode>
                <c:ptCount val="71"/>
                <c:pt idx="0">
                  <c:v>1.9592229591132651</c:v>
                </c:pt>
                <c:pt idx="1">
                  <c:v>1.5436099800788545</c:v>
                </c:pt>
                <c:pt idx="2">
                  <c:v>1.6229221802199869</c:v>
                </c:pt>
                <c:pt idx="3">
                  <c:v>1.4714026683782864</c:v>
                </c:pt>
                <c:pt idx="4">
                  <c:v>2.2500988513090094</c:v>
                </c:pt>
                <c:pt idx="5">
                  <c:v>1.3429319380088085</c:v>
                </c:pt>
                <c:pt idx="6">
                  <c:v>1.6756461742483231</c:v>
                </c:pt>
                <c:pt idx="7">
                  <c:v>1.4855057009877326</c:v>
                </c:pt>
                <c:pt idx="8">
                  <c:v>3.2660106056958544</c:v>
                </c:pt>
                <c:pt idx="9">
                  <c:v>1.8494632659448071</c:v>
                </c:pt>
                <c:pt idx="10">
                  <c:v>2.6859242423681833</c:v>
                </c:pt>
                <c:pt idx="11">
                  <c:v>2.2174724978212255</c:v>
                </c:pt>
                <c:pt idx="12">
                  <c:v>1.7490427171268625</c:v>
                </c:pt>
                <c:pt idx="13">
                  <c:v>2.204497402125412</c:v>
                </c:pt>
                <c:pt idx="14">
                  <c:v>1.6497341734908697</c:v>
                </c:pt>
                <c:pt idx="15">
                  <c:v>1.3318409285894222</c:v>
                </c:pt>
                <c:pt idx="16">
                  <c:v>2.76780989252959</c:v>
                </c:pt>
                <c:pt idx="17">
                  <c:v>1.6436549248158356</c:v>
                </c:pt>
                <c:pt idx="18">
                  <c:v>1.3138717122428336</c:v>
                </c:pt>
                <c:pt idx="19">
                  <c:v>2.1830116222462914</c:v>
                </c:pt>
                <c:pt idx="20">
                  <c:v>2.8730951317626223</c:v>
                </c:pt>
                <c:pt idx="21">
                  <c:v>1.5397727382096731</c:v>
                </c:pt>
                <c:pt idx="22">
                  <c:v>1.568044965587073</c:v>
                </c:pt>
                <c:pt idx="23">
                  <c:v>2.8500490218438621</c:v>
                </c:pt>
                <c:pt idx="24">
                  <c:v>1.6859622568342034</c:v>
                </c:pt>
                <c:pt idx="25">
                  <c:v>1.5230916504041814</c:v>
                </c:pt>
                <c:pt idx="26">
                  <c:v>1.6245746815863005</c:v>
                </c:pt>
                <c:pt idx="27">
                  <c:v>1.6328813662510833</c:v>
                </c:pt>
                <c:pt idx="28">
                  <c:v>1.7782990236895564</c:v>
                </c:pt>
                <c:pt idx="29">
                  <c:v>1.7203221239360815</c:v>
                </c:pt>
                <c:pt idx="30">
                  <c:v>1.5010642887187085</c:v>
                </c:pt>
                <c:pt idx="31">
                  <c:v>2.0733544155342267</c:v>
                </c:pt>
                <c:pt idx="32">
                  <c:v>1.4573132925792172</c:v>
                </c:pt>
                <c:pt idx="33">
                  <c:v>1.6792394958244421</c:v>
                </c:pt>
                <c:pt idx="34">
                  <c:v>1.4919358908085407</c:v>
                </c:pt>
                <c:pt idx="35">
                  <c:v>2.5615508015456587</c:v>
                </c:pt>
                <c:pt idx="36">
                  <c:v>1.9754706661708303</c:v>
                </c:pt>
                <c:pt idx="37">
                  <c:v>1.571726218548378</c:v>
                </c:pt>
                <c:pt idx="38">
                  <c:v>1.4849241940366082</c:v>
                </c:pt>
                <c:pt idx="39">
                  <c:v>1.919186059796971</c:v>
                </c:pt>
                <c:pt idx="40">
                  <c:v>1.5102133805826803</c:v>
                </c:pt>
                <c:pt idx="41">
                  <c:v>1.5438379446836183</c:v>
                </c:pt>
                <c:pt idx="42">
                  <c:v>1.86047466444871</c:v>
                </c:pt>
                <c:pt idx="43">
                  <c:v>2.1929248379426132</c:v>
                </c:pt>
                <c:pt idx="44">
                  <c:v>1.8381246100536113</c:v>
                </c:pt>
                <c:pt idx="45">
                  <c:v>1.3667499259997258</c:v>
                </c:pt>
                <c:pt idx="46">
                  <c:v>1.8504852207386502</c:v>
                </c:pt>
                <c:pt idx="47">
                  <c:v>2.0768846205235305</c:v>
                </c:pt>
                <c:pt idx="48">
                  <c:v>1.9973509825716416</c:v>
                </c:pt>
                <c:pt idx="49">
                  <c:v>1.5066435801246625</c:v>
                </c:pt>
                <c:pt idx="50">
                  <c:v>1.4879150345317602</c:v>
                </c:pt>
                <c:pt idx="51">
                  <c:v>2.3366576335642457</c:v>
                </c:pt>
                <c:pt idx="52">
                  <c:v>1.5512414641546348</c:v>
                </c:pt>
                <c:pt idx="53">
                  <c:v>2.1553679472289358</c:v>
                </c:pt>
                <c:pt idx="54">
                  <c:v>2.3969983314072119</c:v>
                </c:pt>
                <c:pt idx="55">
                  <c:v>1.641528707587532</c:v>
                </c:pt>
                <c:pt idx="56">
                  <c:v>1.7743636849144497</c:v>
                </c:pt>
                <c:pt idx="57">
                  <c:v>3.058995732041625</c:v>
                </c:pt>
                <c:pt idx="58">
                  <c:v>1.3746125081846274</c:v>
                </c:pt>
                <c:pt idx="59">
                  <c:v>1.3164155424550299</c:v>
                </c:pt>
                <c:pt idx="60">
                  <c:v>1.476135695832304</c:v>
                </c:pt>
                <c:pt idx="61">
                  <c:v>2.3894630959599303</c:v>
                </c:pt>
                <c:pt idx="62">
                  <c:v>2.0826983623543014</c:v>
                </c:pt>
                <c:pt idx="63">
                  <c:v>2.2799979910320376</c:v>
                </c:pt>
                <c:pt idx="64">
                  <c:v>1.5468018589913388</c:v>
                </c:pt>
                <c:pt idx="65">
                  <c:v>1.3106006244583723</c:v>
                </c:pt>
                <c:pt idx="66">
                  <c:v>1.6061974344787306</c:v>
                </c:pt>
                <c:pt idx="67">
                  <c:v>1.4624229862090152</c:v>
                </c:pt>
                <c:pt idx="68">
                  <c:v>1.6681596876614939</c:v>
                </c:pt>
                <c:pt idx="69">
                  <c:v>1.8192412020095765</c:v>
                </c:pt>
                <c:pt idx="70">
                  <c:v>3.24080764936567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CF9-4657-BFEE-C00336E8EEA9}"/>
            </c:ext>
          </c:extLst>
        </c:ser>
        <c:ser>
          <c:idx val="3"/>
          <c:order val="3"/>
          <c:tx>
            <c:v>0</c:v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</c:v>
              </c:pt>
              <c:pt idx="1">
                <c:v>0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4CF9-4657-BFEE-C00336E8EEA9}"/>
            </c:ext>
          </c:extLst>
        </c:ser>
        <c:ser>
          <c:idx val="4"/>
          <c:order val="4"/>
          <c:tx>
            <c:v>1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15</c:v>
              </c:pt>
              <c:pt idx="1">
                <c:v>15</c:v>
              </c:pt>
            </c:numLit>
          </c:xVal>
          <c:yVal>
            <c:numLit>
              <c:formatCode>General</c:formatCode>
              <c:ptCount val="2"/>
              <c:pt idx="0">
                <c:v>1.3</c:v>
              </c:pt>
              <c:pt idx="1">
                <c:v>1.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4CF9-4657-BFEE-C00336E8EEA9}"/>
            </c:ext>
          </c:extLst>
        </c:ser>
        <c:ser>
          <c:idx val="5"/>
          <c:order val="5"/>
          <c:tx>
            <c:v>L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-0.6</c:v>
              </c:pt>
              <c:pt idx="1">
                <c:v>-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4CF9-4657-BFEE-C00336E8EEA9}"/>
            </c:ext>
          </c:extLst>
        </c:ser>
        <c:ser>
          <c:idx val="6"/>
          <c:order val="6"/>
          <c:tx>
            <c:v>R</c:v>
          </c:tx>
          <c:spPr>
            <a:ln w="31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Lit>
              <c:formatCode>General</c:formatCode>
              <c:ptCount val="2"/>
              <c:pt idx="0">
                <c:v>0.6</c:v>
              </c:pt>
              <c:pt idx="1">
                <c:v>0.6</c:v>
              </c:pt>
            </c:numLit>
          </c:xVal>
          <c:yVal>
            <c:numLit>
              <c:formatCode>General</c:formatCode>
              <c:ptCount val="2"/>
              <c:pt idx="0">
                <c:v>0</c:v>
              </c:pt>
              <c:pt idx="1">
                <c:v>2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6-4CF9-4657-BFEE-C00336E8EE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2783"/>
        <c:axId val="872775711"/>
      </c:scatterChart>
      <c:valAx>
        <c:axId val="872782783"/>
        <c:scaling>
          <c:orientation val="minMax"/>
          <c:max val="8"/>
          <c:min val="-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2</a:t>
                </a:r>
                <a:r>
                  <a:rPr lang="en-US" baseline="0"/>
                  <a:t> ratio (sDM</a:t>
                </a:r>
                <a:r>
                  <a:rPr lang="en-US"/>
                  <a:t> /</a:t>
                </a:r>
                <a:r>
                  <a:rPr lang="en-US" baseline="0"/>
                  <a:t> HF</a:t>
                </a:r>
                <a:r>
                  <a:rPr lang="en-US" altLang="zh-CN" baseline="0"/>
                  <a:t>HS</a:t>
                </a:r>
                <a:r>
                  <a:rPr lang="en-US" baseline="0"/>
                  <a:t>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75711"/>
        <c:crosses val="autoZero"/>
        <c:crossBetween val="midCat"/>
        <c:majorUnit val="4"/>
      </c:valAx>
      <c:valAx>
        <c:axId val="872775711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og</a:t>
                </a:r>
                <a:r>
                  <a:rPr lang="en-US" baseline="-25000"/>
                  <a:t>10</a:t>
                </a:r>
                <a:r>
                  <a:rPr lang="en-US"/>
                  <a:t> 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2782783"/>
        <c:crossesAt val="-15"/>
        <c:crossBetween val="midCat"/>
        <c:majorUnit val="2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EE67A9-5ACF-49E3-9E41-6007BAFC1AC9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FFCF65-EA5D-4C36-9A98-F436046D7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272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FFCF65-EA5D-4C36-9A98-F436046D7D1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0203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FFCF65-EA5D-4C36-9A98-F436046D7D1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6439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FFCF65-EA5D-4C36-9A98-F436046D7D1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3412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FFCF65-EA5D-4C36-9A98-F436046D7D1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4533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FFCF65-EA5D-4C36-9A98-F436046D7D1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63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517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457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925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720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93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521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745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60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016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69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79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0D57A-C647-4584-9920-50F217DA0A84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60AAC-1246-41F0-8B10-BEBD23C06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20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576000" y="9540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arman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metabolomes detected from the seru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872000" y="720000"/>
            <a:ext cx="3447000" cy="3258000"/>
            <a:chOff x="1872000" y="720000"/>
            <a:chExt cx="3447000" cy="32580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2000" y="720000"/>
              <a:ext cx="3239269" cy="3239269"/>
            </a:xfrm>
            <a:prstGeom prst="rect">
              <a:avLst/>
            </a:prstGeom>
          </p:spPr>
        </p:pic>
        <p:grpSp>
          <p:nvGrpSpPr>
            <p:cNvPr id="103" name="Group 102"/>
            <p:cNvGrpSpPr/>
            <p:nvPr/>
          </p:nvGrpSpPr>
          <p:grpSpPr>
            <a:xfrm>
              <a:off x="2124000" y="3744000"/>
              <a:ext cx="2916000" cy="234000"/>
              <a:chOff x="2124000" y="3744000"/>
              <a:chExt cx="2916000" cy="234000"/>
            </a:xfrm>
          </p:grpSpPr>
          <p:sp>
            <p:nvSpPr>
              <p:cNvPr id="64" name="Rectangle 63"/>
              <p:cNvSpPr/>
              <p:nvPr/>
            </p:nvSpPr>
            <p:spPr>
              <a:xfrm>
                <a:off x="3420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3744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3096000" y="3888000"/>
                <a:ext cx="972000" cy="90000"/>
              </a:xfrm>
              <a:prstGeom prst="rect">
                <a:avLst/>
              </a:prstGeom>
              <a:solidFill>
                <a:srgbClr val="00CB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4068000" y="3888000"/>
                <a:ext cx="972000" cy="90000"/>
              </a:xfrm>
              <a:prstGeom prst="rect">
                <a:avLst/>
              </a:prstGeom>
              <a:solidFill>
                <a:srgbClr val="BEC1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3096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4392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4716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4068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2448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Rectangle 97"/>
              <p:cNvSpPr/>
              <p:nvPr/>
            </p:nvSpPr>
            <p:spPr>
              <a:xfrm>
                <a:off x="2772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2124000" y="3888000"/>
                <a:ext cx="972000" cy="90000"/>
              </a:xfrm>
              <a:prstGeom prst="rect">
                <a:avLst/>
              </a:prstGeom>
              <a:solidFill>
                <a:srgbClr val="FF8A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Rectangle 99"/>
              <p:cNvSpPr/>
              <p:nvPr/>
            </p:nvSpPr>
            <p:spPr>
              <a:xfrm>
                <a:off x="2124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04" name="Group 103"/>
            <p:cNvGrpSpPr/>
            <p:nvPr/>
          </p:nvGrpSpPr>
          <p:grpSpPr>
            <a:xfrm rot="16200000">
              <a:off x="3744000" y="2124000"/>
              <a:ext cx="2916000" cy="234000"/>
              <a:chOff x="2124000" y="3744000"/>
              <a:chExt cx="2916000" cy="234000"/>
            </a:xfrm>
          </p:grpSpPr>
          <p:sp>
            <p:nvSpPr>
              <p:cNvPr id="105" name="Rectangle 104"/>
              <p:cNvSpPr/>
              <p:nvPr/>
            </p:nvSpPr>
            <p:spPr>
              <a:xfrm>
                <a:off x="3420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6" name="Rectangle 105"/>
              <p:cNvSpPr/>
              <p:nvPr/>
            </p:nvSpPr>
            <p:spPr>
              <a:xfrm>
                <a:off x="3744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Rectangle 106"/>
              <p:cNvSpPr/>
              <p:nvPr/>
            </p:nvSpPr>
            <p:spPr>
              <a:xfrm>
                <a:off x="3096000" y="3888000"/>
                <a:ext cx="972000" cy="90000"/>
              </a:xfrm>
              <a:prstGeom prst="rect">
                <a:avLst/>
              </a:prstGeom>
              <a:solidFill>
                <a:srgbClr val="00CB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Rectangle 107"/>
              <p:cNvSpPr/>
              <p:nvPr/>
            </p:nvSpPr>
            <p:spPr>
              <a:xfrm>
                <a:off x="4068000" y="3888000"/>
                <a:ext cx="972000" cy="90000"/>
              </a:xfrm>
              <a:prstGeom prst="rect">
                <a:avLst/>
              </a:prstGeom>
              <a:solidFill>
                <a:srgbClr val="BEC1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Rectangle 108"/>
              <p:cNvSpPr/>
              <p:nvPr/>
            </p:nvSpPr>
            <p:spPr>
              <a:xfrm>
                <a:off x="3096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0" name="Rectangle 109"/>
              <p:cNvSpPr/>
              <p:nvPr/>
            </p:nvSpPr>
            <p:spPr>
              <a:xfrm>
                <a:off x="4392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1" name="Rectangle 110"/>
              <p:cNvSpPr/>
              <p:nvPr/>
            </p:nvSpPr>
            <p:spPr>
              <a:xfrm>
                <a:off x="4716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4068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" name="Rectangle 112"/>
              <p:cNvSpPr/>
              <p:nvPr/>
            </p:nvSpPr>
            <p:spPr>
              <a:xfrm>
                <a:off x="2448000" y="3744000"/>
                <a:ext cx="324000" cy="90000"/>
              </a:xfrm>
              <a:prstGeom prst="rect">
                <a:avLst/>
              </a:prstGeom>
              <a:solidFill>
                <a:srgbClr val="F2766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2772000" y="3744000"/>
                <a:ext cx="324000" cy="90000"/>
              </a:xfrm>
              <a:prstGeom prst="rect">
                <a:avLst/>
              </a:prstGeom>
              <a:solidFill>
                <a:srgbClr val="7093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2124000" y="3888000"/>
                <a:ext cx="972000" cy="90000"/>
              </a:xfrm>
              <a:prstGeom prst="rect">
                <a:avLst/>
              </a:prstGeom>
              <a:solidFill>
                <a:srgbClr val="FF8A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6" name="Rectangle 115"/>
              <p:cNvSpPr/>
              <p:nvPr/>
            </p:nvSpPr>
            <p:spPr>
              <a:xfrm>
                <a:off x="2124000" y="3744000"/>
                <a:ext cx="324000" cy="90000"/>
              </a:xfrm>
              <a:prstGeom prst="rect">
                <a:avLst/>
              </a:prstGeom>
              <a:solidFill>
                <a:srgbClr val="2CB34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625" t="8331" r="13125" b="55000"/>
            <a:stretch/>
          </p:blipFill>
          <p:spPr>
            <a:xfrm>
              <a:off x="2052000" y="748800"/>
              <a:ext cx="648000" cy="1584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85540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6000" y="9396000"/>
            <a:ext cx="6429600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-scores of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s that contributed importantly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P &gt; 1) in the projection of serum samples 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mparison between the PB and HPVB samples with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L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.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0" y="720000"/>
            <a:ext cx="2879604" cy="8639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95935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20000" y="720000"/>
            <a:ext cx="11060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92000" y="2772000"/>
            <a:ext cx="12182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92000" y="4752000"/>
            <a:ext cx="97784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32000" y="2124000"/>
            <a:ext cx="195566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760478" y="4104000"/>
            <a:ext cx="36708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FH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842230" y="6084000"/>
            <a:ext cx="285336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zh-CN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DM</a:t>
            </a:r>
            <a:endParaRPr lang="en-US" altLang="zh-CN" sz="10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7472492"/>
              </p:ext>
            </p:extLst>
          </p:nvPr>
        </p:nvGraphicFramePr>
        <p:xfrm>
          <a:off x="2592000" y="864000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657081"/>
              </p:ext>
            </p:extLst>
          </p:nvPr>
        </p:nvGraphicFramePr>
        <p:xfrm>
          <a:off x="2592000" y="2844000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6337232"/>
              </p:ext>
            </p:extLst>
          </p:nvPr>
        </p:nvGraphicFramePr>
        <p:xfrm>
          <a:off x="2592000" y="4824000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576000" y="9936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volcano plots of the metabolites different between the PB and HPVB samples of the 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FH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 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4835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Group 110"/>
          <p:cNvGrpSpPr/>
          <p:nvPr/>
        </p:nvGrpSpPr>
        <p:grpSpPr>
          <a:xfrm>
            <a:off x="1179066" y="1080000"/>
            <a:ext cx="1422365" cy="1961583"/>
            <a:chOff x="576000" y="3456000"/>
            <a:chExt cx="1422365" cy="1961583"/>
          </a:xfrm>
        </p:grpSpPr>
        <p:sp>
          <p:nvSpPr>
            <p:cNvPr id="112" name="TextBox 111"/>
            <p:cNvSpPr txBox="1"/>
            <p:nvPr/>
          </p:nvSpPr>
          <p:spPr>
            <a:xfrm>
              <a:off x="576000" y="3456000"/>
              <a:ext cx="8496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3" name="Group 112"/>
            <p:cNvGrpSpPr/>
            <p:nvPr/>
          </p:nvGrpSpPr>
          <p:grpSpPr>
            <a:xfrm>
              <a:off x="720000" y="3600000"/>
              <a:ext cx="1278365" cy="1817583"/>
              <a:chOff x="2475903" y="7488000"/>
              <a:chExt cx="1278365" cy="1817583"/>
            </a:xfrm>
          </p:grpSpPr>
          <p:grpSp>
            <p:nvGrpSpPr>
              <p:cNvPr id="114" name="Group 113"/>
              <p:cNvGrpSpPr/>
              <p:nvPr/>
            </p:nvGrpSpPr>
            <p:grpSpPr>
              <a:xfrm>
                <a:off x="2475903" y="7488000"/>
                <a:ext cx="1278365" cy="1577412"/>
                <a:chOff x="2599734" y="2608310"/>
                <a:chExt cx="1278365" cy="1577412"/>
              </a:xfrm>
            </p:grpSpPr>
            <p:sp>
              <p:nvSpPr>
                <p:cNvPr id="116" name="Oval 115"/>
                <p:cNvSpPr>
                  <a:spLocks noChangeAspect="1"/>
                </p:cNvSpPr>
                <p:nvPr/>
              </p:nvSpPr>
              <p:spPr>
                <a:xfrm>
                  <a:off x="2862152" y="3184310"/>
                  <a:ext cx="792000" cy="792000"/>
                </a:xfrm>
                <a:prstGeom prst="ellipse">
                  <a:avLst/>
                </a:prstGeom>
                <a:solidFill>
                  <a:srgbClr val="7030A0">
                    <a:alpha val="15000"/>
                  </a:srgbClr>
                </a:solidFill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7" name="Oval 116"/>
                <p:cNvSpPr>
                  <a:spLocks noChangeAspect="1"/>
                </p:cNvSpPr>
                <p:nvPr/>
              </p:nvSpPr>
              <p:spPr>
                <a:xfrm>
                  <a:off x="2607831" y="2788310"/>
                  <a:ext cx="792000" cy="792000"/>
                </a:xfrm>
                <a:prstGeom prst="ellipse">
                  <a:avLst/>
                </a:prstGeom>
                <a:solidFill>
                  <a:schemeClr val="accent2">
                    <a:lumMod val="75000"/>
                    <a:alpha val="15000"/>
                  </a:schemeClr>
                </a:solidFill>
                <a:ln w="19050"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" name="Oval 117"/>
                <p:cNvSpPr>
                  <a:spLocks noChangeAspect="1"/>
                </p:cNvSpPr>
                <p:nvPr/>
              </p:nvSpPr>
              <p:spPr>
                <a:xfrm>
                  <a:off x="3075831" y="2788310"/>
                  <a:ext cx="792000" cy="792000"/>
                </a:xfrm>
                <a:prstGeom prst="ellipse">
                  <a:avLst/>
                </a:prstGeom>
                <a:solidFill>
                  <a:schemeClr val="accent4">
                    <a:lumMod val="75000"/>
                    <a:alpha val="15000"/>
                  </a:schemeClr>
                </a:solidFill>
                <a:ln w="19050">
                  <a:solidFill>
                    <a:schemeClr val="accent4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2942881" y="4047223"/>
                  <a:ext cx="647613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DM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HFHS</a:t>
                  </a: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2599734" y="2608310"/>
                  <a:ext cx="57708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S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NC</a:t>
                  </a:r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3377962" y="2608310"/>
                  <a:ext cx="500137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/ NC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3180806" y="2998546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8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2853403" y="3060102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3542719" y="3050714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TextBox 124"/>
                <p:cNvSpPr txBox="1"/>
                <p:nvPr/>
              </p:nvSpPr>
              <p:spPr>
                <a:xfrm>
                  <a:off x="3188003" y="3698393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4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>
                  <a:off x="2953647" y="3396234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3180806" y="3271063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9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3392504" y="3408696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9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5" name="TextBox 114"/>
              <p:cNvSpPr txBox="1"/>
              <p:nvPr/>
            </p:nvSpPr>
            <p:spPr>
              <a:xfrm>
                <a:off x="2960781" y="9144000"/>
                <a:ext cx="322204" cy="16158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zh-CN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</p:txBody>
          </p:sp>
        </p:grpSp>
      </p:grpSp>
      <p:grpSp>
        <p:nvGrpSpPr>
          <p:cNvPr id="129" name="Group 128"/>
          <p:cNvGrpSpPr/>
          <p:nvPr/>
        </p:nvGrpSpPr>
        <p:grpSpPr>
          <a:xfrm>
            <a:off x="2835066" y="1080000"/>
            <a:ext cx="1422365" cy="1961583"/>
            <a:chOff x="576000" y="3456000"/>
            <a:chExt cx="1422365" cy="1961583"/>
          </a:xfrm>
        </p:grpSpPr>
        <p:sp>
          <p:nvSpPr>
            <p:cNvPr id="130" name="TextBox 129"/>
            <p:cNvSpPr txBox="1"/>
            <p:nvPr/>
          </p:nvSpPr>
          <p:spPr>
            <a:xfrm>
              <a:off x="576000" y="3456000"/>
              <a:ext cx="8496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Group 130"/>
            <p:cNvGrpSpPr/>
            <p:nvPr/>
          </p:nvGrpSpPr>
          <p:grpSpPr>
            <a:xfrm>
              <a:off x="720000" y="3600000"/>
              <a:ext cx="1278365" cy="1817583"/>
              <a:chOff x="2475903" y="7488000"/>
              <a:chExt cx="1278365" cy="1817583"/>
            </a:xfrm>
          </p:grpSpPr>
          <p:grpSp>
            <p:nvGrpSpPr>
              <p:cNvPr id="132" name="Group 131"/>
              <p:cNvGrpSpPr/>
              <p:nvPr/>
            </p:nvGrpSpPr>
            <p:grpSpPr>
              <a:xfrm>
                <a:off x="2475903" y="7488000"/>
                <a:ext cx="1278365" cy="1577412"/>
                <a:chOff x="2599734" y="2608310"/>
                <a:chExt cx="1278365" cy="1577412"/>
              </a:xfrm>
            </p:grpSpPr>
            <p:sp>
              <p:nvSpPr>
                <p:cNvPr id="134" name="Oval 133"/>
                <p:cNvSpPr>
                  <a:spLocks noChangeAspect="1"/>
                </p:cNvSpPr>
                <p:nvPr/>
              </p:nvSpPr>
              <p:spPr>
                <a:xfrm>
                  <a:off x="2862152" y="3184310"/>
                  <a:ext cx="792000" cy="792000"/>
                </a:xfrm>
                <a:prstGeom prst="ellipse">
                  <a:avLst/>
                </a:prstGeom>
                <a:solidFill>
                  <a:srgbClr val="7030A0">
                    <a:alpha val="15000"/>
                  </a:srgbClr>
                </a:solidFill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5" name="Oval 134"/>
                <p:cNvSpPr>
                  <a:spLocks noChangeAspect="1"/>
                </p:cNvSpPr>
                <p:nvPr/>
              </p:nvSpPr>
              <p:spPr>
                <a:xfrm>
                  <a:off x="2607831" y="2788310"/>
                  <a:ext cx="792000" cy="792000"/>
                </a:xfrm>
                <a:prstGeom prst="ellipse">
                  <a:avLst/>
                </a:prstGeom>
                <a:solidFill>
                  <a:schemeClr val="accent2">
                    <a:lumMod val="75000"/>
                    <a:alpha val="15000"/>
                  </a:schemeClr>
                </a:solidFill>
                <a:ln w="19050"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" name="Oval 135"/>
                <p:cNvSpPr>
                  <a:spLocks noChangeAspect="1"/>
                </p:cNvSpPr>
                <p:nvPr/>
              </p:nvSpPr>
              <p:spPr>
                <a:xfrm>
                  <a:off x="3075831" y="2788310"/>
                  <a:ext cx="792000" cy="792000"/>
                </a:xfrm>
                <a:prstGeom prst="ellipse">
                  <a:avLst/>
                </a:prstGeom>
                <a:solidFill>
                  <a:schemeClr val="accent4">
                    <a:lumMod val="75000"/>
                    <a:alpha val="15000"/>
                  </a:schemeClr>
                </a:solidFill>
                <a:ln w="19050">
                  <a:solidFill>
                    <a:schemeClr val="accent4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2942881" y="4047223"/>
                  <a:ext cx="647613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DM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HFHS</a:t>
                  </a: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2599734" y="2608310"/>
                  <a:ext cx="57708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S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NC</a:t>
                  </a: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3377962" y="2608310"/>
                  <a:ext cx="500137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/ NC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3180806" y="2998546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9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2853403" y="3060102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3542719" y="3050714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3188003" y="3698393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1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2953647" y="3396234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5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3151952" y="3271063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11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3363650" y="3408696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7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3" name="TextBox 132"/>
              <p:cNvSpPr txBox="1"/>
              <p:nvPr/>
            </p:nvSpPr>
            <p:spPr>
              <a:xfrm>
                <a:off x="3028108" y="9144000"/>
                <a:ext cx="187552" cy="16158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zh-CN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</a:p>
            </p:txBody>
          </p:sp>
        </p:grpSp>
      </p:grpSp>
      <p:grpSp>
        <p:nvGrpSpPr>
          <p:cNvPr id="147" name="Group 146"/>
          <p:cNvGrpSpPr/>
          <p:nvPr/>
        </p:nvGrpSpPr>
        <p:grpSpPr>
          <a:xfrm>
            <a:off x="4491066" y="1080000"/>
            <a:ext cx="1422365" cy="1961583"/>
            <a:chOff x="4076907" y="1277324"/>
            <a:chExt cx="1422365" cy="1961583"/>
          </a:xfrm>
        </p:grpSpPr>
        <p:sp>
          <p:nvSpPr>
            <p:cNvPr id="148" name="TextBox 147"/>
            <p:cNvSpPr txBox="1"/>
            <p:nvPr/>
          </p:nvSpPr>
          <p:spPr>
            <a:xfrm>
              <a:off x="4076907" y="1277324"/>
              <a:ext cx="769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49" name="Group 148"/>
            <p:cNvGrpSpPr/>
            <p:nvPr/>
          </p:nvGrpSpPr>
          <p:grpSpPr>
            <a:xfrm>
              <a:off x="4220907" y="1421324"/>
              <a:ext cx="1278365" cy="1817583"/>
              <a:chOff x="2475903" y="7488000"/>
              <a:chExt cx="1278365" cy="1817583"/>
            </a:xfrm>
          </p:grpSpPr>
          <p:grpSp>
            <p:nvGrpSpPr>
              <p:cNvPr id="150" name="Group 149"/>
              <p:cNvGrpSpPr/>
              <p:nvPr/>
            </p:nvGrpSpPr>
            <p:grpSpPr>
              <a:xfrm>
                <a:off x="2475903" y="7488000"/>
                <a:ext cx="1278365" cy="1577412"/>
                <a:chOff x="2599734" y="2608310"/>
                <a:chExt cx="1278365" cy="1577412"/>
              </a:xfrm>
            </p:grpSpPr>
            <p:sp>
              <p:nvSpPr>
                <p:cNvPr id="152" name="Oval 151"/>
                <p:cNvSpPr>
                  <a:spLocks noChangeAspect="1"/>
                </p:cNvSpPr>
                <p:nvPr/>
              </p:nvSpPr>
              <p:spPr>
                <a:xfrm>
                  <a:off x="2862152" y="3184310"/>
                  <a:ext cx="792000" cy="792000"/>
                </a:xfrm>
                <a:prstGeom prst="ellipse">
                  <a:avLst/>
                </a:prstGeom>
                <a:solidFill>
                  <a:srgbClr val="7030A0">
                    <a:alpha val="15000"/>
                  </a:srgbClr>
                </a:solidFill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3" name="Oval 152"/>
                <p:cNvSpPr>
                  <a:spLocks noChangeAspect="1"/>
                </p:cNvSpPr>
                <p:nvPr/>
              </p:nvSpPr>
              <p:spPr>
                <a:xfrm>
                  <a:off x="2607831" y="2788310"/>
                  <a:ext cx="792000" cy="792000"/>
                </a:xfrm>
                <a:prstGeom prst="ellipse">
                  <a:avLst/>
                </a:prstGeom>
                <a:solidFill>
                  <a:schemeClr val="accent2">
                    <a:lumMod val="75000"/>
                    <a:alpha val="15000"/>
                  </a:schemeClr>
                </a:solidFill>
                <a:ln w="19050"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4" name="Oval 153"/>
                <p:cNvSpPr>
                  <a:spLocks noChangeAspect="1"/>
                </p:cNvSpPr>
                <p:nvPr/>
              </p:nvSpPr>
              <p:spPr>
                <a:xfrm>
                  <a:off x="3075831" y="2788310"/>
                  <a:ext cx="792000" cy="792000"/>
                </a:xfrm>
                <a:prstGeom prst="ellipse">
                  <a:avLst/>
                </a:prstGeom>
                <a:solidFill>
                  <a:schemeClr val="accent4">
                    <a:lumMod val="75000"/>
                    <a:alpha val="15000"/>
                  </a:schemeClr>
                </a:solidFill>
                <a:ln w="19050">
                  <a:solidFill>
                    <a:schemeClr val="accent4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2942881" y="4047223"/>
                  <a:ext cx="647613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DM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HFHS</a:t>
                  </a: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2599734" y="2608310"/>
                  <a:ext cx="57708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S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 NC</a:t>
                  </a:r>
                </a:p>
              </p:txBody>
            </p:sp>
            <p:sp>
              <p:nvSpPr>
                <p:cNvPr id="157" name="TextBox 156"/>
                <p:cNvSpPr txBox="1"/>
                <p:nvPr/>
              </p:nvSpPr>
              <p:spPr>
                <a:xfrm>
                  <a:off x="3377962" y="2608310"/>
                  <a:ext cx="500137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/ NC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TextBox 157"/>
                <p:cNvSpPr txBox="1"/>
                <p:nvPr/>
              </p:nvSpPr>
              <p:spPr>
                <a:xfrm>
                  <a:off x="3180806" y="2998546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6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>
                  <a:off x="2853403" y="3060102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8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3542719" y="3050714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4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3188003" y="3698393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2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2982501" y="3396234"/>
                  <a:ext cx="115416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6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3151952" y="3271063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30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3363650" y="3408696"/>
                  <a:ext cx="17312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1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1" name="TextBox 150"/>
              <p:cNvSpPr txBox="1"/>
              <p:nvPr/>
            </p:nvSpPr>
            <p:spPr>
              <a:xfrm>
                <a:off x="2934333" y="9144000"/>
                <a:ext cx="375103" cy="16158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zh-CN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B</a:t>
                </a:r>
              </a:p>
            </p:txBody>
          </p:sp>
        </p:grpSp>
      </p:grpSp>
      <p:sp>
        <p:nvSpPr>
          <p:cNvPr id="165" name="TextBox 164"/>
          <p:cNvSpPr txBox="1"/>
          <p:nvPr/>
        </p:nvSpPr>
        <p:spPr>
          <a:xfrm>
            <a:off x="576000" y="9576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s of significantly different level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 any two of the three group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liver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HPVB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sample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93269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6000" y="9576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z-score of fatty acids across all three samples (the liver, PB, and HPVB) of the three group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00" y="900000"/>
            <a:ext cx="5759970" cy="4319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94749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6000" y="9576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z-score of bile acids across all three samples (the liver, PB, and HPVB) of the three group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20" y="1080000"/>
            <a:ext cx="6119634" cy="4319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07252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76000" y="720000"/>
            <a:ext cx="1678919" cy="1599111"/>
            <a:chOff x="576000" y="720000"/>
            <a:chExt cx="1678919" cy="1599111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000" y="864000"/>
              <a:ext cx="1462919" cy="1280054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576000" y="720000"/>
              <a:ext cx="8496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504000" y="1404000"/>
              <a:ext cx="32701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368000" y="2196000"/>
              <a:ext cx="34464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read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044000" y="972000"/>
              <a:ext cx="14747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896000" y="720000"/>
            <a:ext cx="1678919" cy="1599111"/>
            <a:chOff x="576000" y="2448000"/>
            <a:chExt cx="1678919" cy="1599111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000" y="2592000"/>
              <a:ext cx="1462919" cy="1280054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>
              <a:off x="576000" y="2448000"/>
              <a:ext cx="769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504000" y="3132000"/>
              <a:ext cx="32701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332000" y="3924000"/>
              <a:ext cx="34464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read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044000" y="2700000"/>
              <a:ext cx="21640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D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Picture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000" y="864000"/>
            <a:ext cx="1462919" cy="1280054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2736000" y="720000"/>
            <a:ext cx="8496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2663451" y="1404000"/>
            <a:ext cx="32701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528000" y="2196000"/>
            <a:ext cx="34464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# read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204000" y="972000"/>
            <a:ext cx="27892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SHF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6192000" y="954000"/>
            <a:ext cx="306772" cy="251722"/>
            <a:chOff x="3888000" y="954000"/>
            <a:chExt cx="306772" cy="251722"/>
          </a:xfrm>
        </p:grpSpPr>
        <p:sp>
          <p:nvSpPr>
            <p:cNvPr id="9" name="Rectangle 8"/>
            <p:cNvSpPr/>
            <p:nvPr/>
          </p:nvSpPr>
          <p:spPr>
            <a:xfrm>
              <a:off x="3888000" y="972000"/>
              <a:ext cx="72000" cy="72000"/>
            </a:xfrm>
            <a:prstGeom prst="rect">
              <a:avLst/>
            </a:prstGeom>
            <a:solidFill>
              <a:srgbClr val="0303FF">
                <a:alpha val="40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3888000" y="1116000"/>
              <a:ext cx="72000" cy="72000"/>
            </a:xfrm>
            <a:prstGeom prst="rect">
              <a:avLst/>
            </a:prstGeom>
            <a:solidFill>
              <a:srgbClr val="F5F508">
                <a:alpha val="59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996000" y="1098000"/>
              <a:ext cx="198772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996000" y="954000"/>
              <a:ext cx="187552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76000" y="2376000"/>
            <a:ext cx="1678919" cy="1599111"/>
            <a:chOff x="576000" y="2304000"/>
            <a:chExt cx="1678919" cy="1599111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000" y="2448000"/>
              <a:ext cx="1462919" cy="1280054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576000" y="2304000"/>
              <a:ext cx="8496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504000" y="2988000"/>
              <a:ext cx="32701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137412" y="3780000"/>
              <a:ext cx="880049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(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)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044000" y="2556000"/>
              <a:ext cx="14747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4896000" y="2376000"/>
            <a:ext cx="1678919" cy="1599111"/>
            <a:chOff x="576000" y="3960000"/>
            <a:chExt cx="1678919" cy="1599111"/>
          </a:xfrm>
        </p:grpSpPr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000" y="4104000"/>
              <a:ext cx="1462919" cy="1280054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576000" y="3960000"/>
              <a:ext cx="43282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504000" y="4644000"/>
              <a:ext cx="32701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151761" y="5436000"/>
              <a:ext cx="880049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PKM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044000" y="4212000"/>
              <a:ext cx="21640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D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736000" y="2376000"/>
            <a:ext cx="1642919" cy="1599111"/>
            <a:chOff x="2268000" y="2304000"/>
            <a:chExt cx="1642919" cy="1599111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8000" y="2448000"/>
              <a:ext cx="1462919" cy="1280054"/>
            </a:xfrm>
            <a:prstGeom prst="rect">
              <a:avLst/>
            </a:prstGeom>
          </p:spPr>
        </p:pic>
        <p:sp>
          <p:nvSpPr>
            <p:cNvPr id="81" name="TextBox 80"/>
            <p:cNvSpPr txBox="1"/>
            <p:nvPr/>
          </p:nvSpPr>
          <p:spPr>
            <a:xfrm>
              <a:off x="2268000" y="2304000"/>
              <a:ext cx="8496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 rot="16200000">
              <a:off x="2195451" y="2988000"/>
              <a:ext cx="32701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786688" y="3780000"/>
              <a:ext cx="891271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PKM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736000" y="2556000"/>
              <a:ext cx="27892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FH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576000" y="9216000"/>
            <a:ext cx="6429600" cy="7386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histogram of transcriptomic data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 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 distribution of all sequenced RNAs and genes identified from the NC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HFHS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roups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-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PKM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 distribution of all sequenced RNAs and genes identified from the NC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H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95061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2091" y="6660000"/>
            <a:ext cx="5219711" cy="305943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000" y="504000"/>
            <a:ext cx="5939802" cy="611963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76000" y="9792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sher’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ct tested GO term enrichment (biological process) of the gen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ulat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H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group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20000" y="504000"/>
            <a:ext cx="11060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0000" y="6660000"/>
            <a:ext cx="12182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135670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20000" y="720000"/>
            <a:ext cx="11060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92000" y="2772000"/>
            <a:ext cx="121828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92000" y="4752000"/>
            <a:ext cx="97784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/>
              <a:t>c</a:t>
            </a: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0419968"/>
              </p:ext>
            </p:extLst>
          </p:nvPr>
        </p:nvGraphicFramePr>
        <p:xfrm>
          <a:off x="2592000" y="864000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2956198"/>
              </p:ext>
            </p:extLst>
          </p:nvPr>
        </p:nvGraphicFramePr>
        <p:xfrm>
          <a:off x="2592000" y="2844000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5042814"/>
              </p:ext>
            </p:extLst>
          </p:nvPr>
        </p:nvGraphicFramePr>
        <p:xfrm>
          <a:off x="2592000" y="4788000"/>
          <a:ext cx="2687343" cy="1768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576000" y="9936000"/>
            <a:ext cx="642960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olcano plots of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between the HFHS and 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HFHS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380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50</TotalTime>
  <Words>503</Words>
  <Application>Microsoft Office PowerPoint</Application>
  <PresentationFormat>Custom</PresentationFormat>
  <Paragraphs>99</Paragraphs>
  <Slides>9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ong Kong Baptis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Yang</dc:creator>
  <cp:lastModifiedBy>Zhu Yang</cp:lastModifiedBy>
  <cp:revision>201</cp:revision>
  <dcterms:created xsi:type="dcterms:W3CDTF">2020-12-07T09:28:16Z</dcterms:created>
  <dcterms:modified xsi:type="dcterms:W3CDTF">2021-10-17T09:52:04Z</dcterms:modified>
</cp:coreProperties>
</file>